
<file path=[Content_Types].xml><?xml version="1.0" encoding="utf-8"?>
<Types xmlns="http://schemas.openxmlformats.org/package/2006/content-types">
  <Default Extension="fntdata" ContentType="application/x-fontdata"/>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slides/slide58.xml" ContentType="application/vnd.openxmlformats-officedocument.presentationml.slide+xml"/>
  <Override PartName="/ppt/slides/slide59.xml" ContentType="application/vnd.openxmlformats-officedocument.presentationml.slide+xml"/>
  <Override PartName="/ppt/slides/slide60.xml" ContentType="application/vnd.openxmlformats-officedocument.presentationml.slide+xml"/>
  <Override PartName="/ppt/slides/slide61.xml" ContentType="application/vnd.openxmlformats-officedocument.presentationml.slide+xml"/>
  <Override PartName="/ppt/slides/slide62.xml" ContentType="application/vnd.openxmlformats-officedocument.presentationml.slide+xml"/>
  <Override PartName="/ppt/slides/slide63.xml" ContentType="application/vnd.openxmlformats-officedocument.presentationml.slide+xml"/>
  <Override PartName="/ppt/slides/slide64.xml" ContentType="application/vnd.openxmlformats-officedocument.presentationml.slide+xml"/>
  <Override PartName="/ppt/slides/slide65.xml" ContentType="application/vnd.openxmlformats-officedocument.presentationml.slide+xml"/>
  <Override PartName="/ppt/slides/slide66.xml" ContentType="application/vnd.openxmlformats-officedocument.presentationml.slide+xml"/>
  <Override PartName="/ppt/slides/slide67.xml" ContentType="application/vnd.openxmlformats-officedocument.presentationml.slide+xml"/>
  <Override PartName="/ppt/slides/slide68.xml" ContentType="application/vnd.openxmlformats-officedocument.presentationml.slide+xml"/>
  <Override PartName="/ppt/slides/slide6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strictFirstAndLastChars="0" embedTrueTypeFonts="1" saveSubsetFonts="1" autoCompressPictures="0">
  <p:sldMasterIdLst>
    <p:sldMasterId id="2147483661" r:id="rId1"/>
    <p:sldMasterId id="2147483662" r:id="rId2"/>
  </p:sldMasterIdLst>
  <p:notesMasterIdLst>
    <p:notesMasterId r:id="rId72"/>
  </p:notesMasterIdLst>
  <p:sldIdLst>
    <p:sldId id="256" r:id="rId3"/>
    <p:sldId id="353" r:id="rId4"/>
    <p:sldId id="258" r:id="rId5"/>
    <p:sldId id="259" r:id="rId6"/>
    <p:sldId id="298" r:id="rId7"/>
    <p:sldId id="260" r:id="rId8"/>
    <p:sldId id="299" r:id="rId9"/>
    <p:sldId id="261" r:id="rId10"/>
    <p:sldId id="300" r:id="rId11"/>
    <p:sldId id="262" r:id="rId12"/>
    <p:sldId id="301" r:id="rId13"/>
    <p:sldId id="263" r:id="rId14"/>
    <p:sldId id="302" r:id="rId15"/>
    <p:sldId id="264" r:id="rId16"/>
    <p:sldId id="303" r:id="rId17"/>
    <p:sldId id="317" r:id="rId18"/>
    <p:sldId id="304" r:id="rId19"/>
    <p:sldId id="305" r:id="rId20"/>
    <p:sldId id="306" r:id="rId21"/>
    <p:sldId id="265" r:id="rId22"/>
    <p:sldId id="307" r:id="rId23"/>
    <p:sldId id="318" r:id="rId24"/>
    <p:sldId id="308" r:id="rId25"/>
    <p:sldId id="266" r:id="rId26"/>
    <p:sldId id="319" r:id="rId27"/>
    <p:sldId id="312" r:id="rId28"/>
    <p:sldId id="313" r:id="rId29"/>
    <p:sldId id="314" r:id="rId30"/>
    <p:sldId id="267" r:id="rId31"/>
    <p:sldId id="315" r:id="rId32"/>
    <p:sldId id="320" r:id="rId33"/>
    <p:sldId id="316" r:id="rId34"/>
    <p:sldId id="268" r:id="rId35"/>
    <p:sldId id="321" r:id="rId36"/>
    <p:sldId id="309" r:id="rId37"/>
    <p:sldId id="310" r:id="rId38"/>
    <p:sldId id="311" r:id="rId39"/>
    <p:sldId id="269" r:id="rId40"/>
    <p:sldId id="322" r:id="rId41"/>
    <p:sldId id="270" r:id="rId42"/>
    <p:sldId id="344" r:id="rId43"/>
    <p:sldId id="326" r:id="rId44"/>
    <p:sldId id="323" r:id="rId45"/>
    <p:sldId id="324" r:id="rId46"/>
    <p:sldId id="325" r:id="rId47"/>
    <p:sldId id="271" r:id="rId48"/>
    <p:sldId id="327" r:id="rId49"/>
    <p:sldId id="328" r:id="rId50"/>
    <p:sldId id="329" r:id="rId51"/>
    <p:sldId id="272" r:id="rId52"/>
    <p:sldId id="330" r:id="rId53"/>
    <p:sldId id="331" r:id="rId54"/>
    <p:sldId id="273" r:id="rId55"/>
    <p:sldId id="332" r:id="rId56"/>
    <p:sldId id="333" r:id="rId57"/>
    <p:sldId id="334" r:id="rId58"/>
    <p:sldId id="335" r:id="rId59"/>
    <p:sldId id="274" r:id="rId60"/>
    <p:sldId id="346" r:id="rId61"/>
    <p:sldId id="275" r:id="rId62"/>
    <p:sldId id="347" r:id="rId63"/>
    <p:sldId id="276" r:id="rId64"/>
    <p:sldId id="348" r:id="rId65"/>
    <p:sldId id="277" r:id="rId66"/>
    <p:sldId id="350" r:id="rId67"/>
    <p:sldId id="278" r:id="rId68"/>
    <p:sldId id="351" r:id="rId69"/>
    <p:sldId id="289" r:id="rId70"/>
    <p:sldId id="352" r:id="rId71"/>
  </p:sldIdLst>
  <p:sldSz cx="9144000" cy="5143500" type="screen16x9"/>
  <p:notesSz cx="6858000" cy="9144000"/>
  <p:embeddedFontLst>
    <p:embeddedFont>
      <p:font typeface="Bebas Neue" panose="020B0606020202050201" pitchFamily="34" charset="0"/>
      <p:regular r:id="rId73"/>
    </p:embeddedFont>
    <p:embeddedFont>
      <p:font typeface="Della Respira" panose="020B0604020202020204" charset="0"/>
      <p:regular r:id="rId74"/>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D80A91EA-533A-5C18-F633-E4D3AB8D11BC}" v="28" dt="2024-03-08T14:37:31.962"/>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7"/>
    <p:restoredTop sz="94679"/>
  </p:normalViewPr>
  <p:slideViewPr>
    <p:cSldViewPr snapToGrid="0">
      <p:cViewPr varScale="1">
        <p:scale>
          <a:sx n="150" d="100"/>
          <a:sy n="150" d="100"/>
        </p:scale>
        <p:origin x="760" y="3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slide" Target="slides/slide24.xml"/><Relationship Id="rId21" Type="http://schemas.openxmlformats.org/officeDocument/2006/relationships/slide" Target="slides/slide19.xml"/><Relationship Id="rId42" Type="http://schemas.openxmlformats.org/officeDocument/2006/relationships/slide" Target="slides/slide40.xml"/><Relationship Id="rId47" Type="http://schemas.openxmlformats.org/officeDocument/2006/relationships/slide" Target="slides/slide45.xml"/><Relationship Id="rId63" Type="http://schemas.openxmlformats.org/officeDocument/2006/relationships/slide" Target="slides/slide61.xml"/><Relationship Id="rId68" Type="http://schemas.openxmlformats.org/officeDocument/2006/relationships/slide" Target="slides/slide66.xml"/><Relationship Id="rId16" Type="http://schemas.openxmlformats.org/officeDocument/2006/relationships/slide" Target="slides/slide14.xml"/><Relationship Id="rId11" Type="http://schemas.openxmlformats.org/officeDocument/2006/relationships/slide" Target="slides/slide9.xml"/><Relationship Id="rId24" Type="http://schemas.openxmlformats.org/officeDocument/2006/relationships/slide" Target="slides/slide22.xml"/><Relationship Id="rId32" Type="http://schemas.openxmlformats.org/officeDocument/2006/relationships/slide" Target="slides/slide30.xml"/><Relationship Id="rId37" Type="http://schemas.openxmlformats.org/officeDocument/2006/relationships/slide" Target="slides/slide35.xml"/><Relationship Id="rId40" Type="http://schemas.openxmlformats.org/officeDocument/2006/relationships/slide" Target="slides/slide38.xml"/><Relationship Id="rId45" Type="http://schemas.openxmlformats.org/officeDocument/2006/relationships/slide" Target="slides/slide43.xml"/><Relationship Id="rId53" Type="http://schemas.openxmlformats.org/officeDocument/2006/relationships/slide" Target="slides/slide51.xml"/><Relationship Id="rId58" Type="http://schemas.openxmlformats.org/officeDocument/2006/relationships/slide" Target="slides/slide56.xml"/><Relationship Id="rId66" Type="http://schemas.openxmlformats.org/officeDocument/2006/relationships/slide" Target="slides/slide64.xml"/><Relationship Id="rId74" Type="http://schemas.openxmlformats.org/officeDocument/2006/relationships/font" Target="fonts/font2.fntdata"/><Relationship Id="rId79" Type="http://schemas.microsoft.com/office/2016/11/relationships/changesInfo" Target="changesInfos/changesInfo1.xml"/><Relationship Id="rId5" Type="http://schemas.openxmlformats.org/officeDocument/2006/relationships/slide" Target="slides/slide3.xml"/><Relationship Id="rId61" Type="http://schemas.openxmlformats.org/officeDocument/2006/relationships/slide" Target="slides/slide59.xml"/><Relationship Id="rId19" Type="http://schemas.openxmlformats.org/officeDocument/2006/relationships/slide" Target="slides/slide17.xml"/><Relationship Id="rId14" Type="http://schemas.openxmlformats.org/officeDocument/2006/relationships/slide" Target="slides/slide12.xml"/><Relationship Id="rId22" Type="http://schemas.openxmlformats.org/officeDocument/2006/relationships/slide" Target="slides/slide20.xml"/><Relationship Id="rId27" Type="http://schemas.openxmlformats.org/officeDocument/2006/relationships/slide" Target="slides/slide25.xml"/><Relationship Id="rId30" Type="http://schemas.openxmlformats.org/officeDocument/2006/relationships/slide" Target="slides/slide28.xml"/><Relationship Id="rId35" Type="http://schemas.openxmlformats.org/officeDocument/2006/relationships/slide" Target="slides/slide33.xml"/><Relationship Id="rId43" Type="http://schemas.openxmlformats.org/officeDocument/2006/relationships/slide" Target="slides/slide41.xml"/><Relationship Id="rId48" Type="http://schemas.openxmlformats.org/officeDocument/2006/relationships/slide" Target="slides/slide46.xml"/><Relationship Id="rId56" Type="http://schemas.openxmlformats.org/officeDocument/2006/relationships/slide" Target="slides/slide54.xml"/><Relationship Id="rId64" Type="http://schemas.openxmlformats.org/officeDocument/2006/relationships/slide" Target="slides/slide62.xml"/><Relationship Id="rId69" Type="http://schemas.openxmlformats.org/officeDocument/2006/relationships/slide" Target="slides/slide67.xml"/><Relationship Id="rId77" Type="http://schemas.openxmlformats.org/officeDocument/2006/relationships/theme" Target="theme/theme1.xml"/><Relationship Id="rId8" Type="http://schemas.openxmlformats.org/officeDocument/2006/relationships/slide" Target="slides/slide6.xml"/><Relationship Id="rId51" Type="http://schemas.openxmlformats.org/officeDocument/2006/relationships/slide" Target="slides/slide49.xml"/><Relationship Id="rId72" Type="http://schemas.openxmlformats.org/officeDocument/2006/relationships/notesMaster" Target="notesMasters/notesMaster1.xml"/><Relationship Id="rId80" Type="http://schemas.microsoft.com/office/2015/10/relationships/revisionInfo" Target="revisionInfo.xml"/><Relationship Id="rId3" Type="http://schemas.openxmlformats.org/officeDocument/2006/relationships/slide" Target="slides/slide1.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slide" Target="slides/slide23.xml"/><Relationship Id="rId33" Type="http://schemas.openxmlformats.org/officeDocument/2006/relationships/slide" Target="slides/slide31.xml"/><Relationship Id="rId38" Type="http://schemas.openxmlformats.org/officeDocument/2006/relationships/slide" Target="slides/slide36.xml"/><Relationship Id="rId46" Type="http://schemas.openxmlformats.org/officeDocument/2006/relationships/slide" Target="slides/slide44.xml"/><Relationship Id="rId59" Type="http://schemas.openxmlformats.org/officeDocument/2006/relationships/slide" Target="slides/slide57.xml"/><Relationship Id="rId67" Type="http://schemas.openxmlformats.org/officeDocument/2006/relationships/slide" Target="slides/slide65.xml"/><Relationship Id="rId20" Type="http://schemas.openxmlformats.org/officeDocument/2006/relationships/slide" Target="slides/slide18.xml"/><Relationship Id="rId41" Type="http://schemas.openxmlformats.org/officeDocument/2006/relationships/slide" Target="slides/slide39.xml"/><Relationship Id="rId54" Type="http://schemas.openxmlformats.org/officeDocument/2006/relationships/slide" Target="slides/slide52.xml"/><Relationship Id="rId62" Type="http://schemas.openxmlformats.org/officeDocument/2006/relationships/slide" Target="slides/slide60.xml"/><Relationship Id="rId70" Type="http://schemas.openxmlformats.org/officeDocument/2006/relationships/slide" Target="slides/slide68.xml"/><Relationship Id="rId75"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4.xml"/><Relationship Id="rId15" Type="http://schemas.openxmlformats.org/officeDocument/2006/relationships/slide" Target="slides/slide13.xml"/><Relationship Id="rId23" Type="http://schemas.openxmlformats.org/officeDocument/2006/relationships/slide" Target="slides/slide21.xml"/><Relationship Id="rId28" Type="http://schemas.openxmlformats.org/officeDocument/2006/relationships/slide" Target="slides/slide26.xml"/><Relationship Id="rId36" Type="http://schemas.openxmlformats.org/officeDocument/2006/relationships/slide" Target="slides/slide34.xml"/><Relationship Id="rId49" Type="http://schemas.openxmlformats.org/officeDocument/2006/relationships/slide" Target="slides/slide47.xml"/><Relationship Id="rId57" Type="http://schemas.openxmlformats.org/officeDocument/2006/relationships/slide" Target="slides/slide55.xml"/><Relationship Id="rId10" Type="http://schemas.openxmlformats.org/officeDocument/2006/relationships/slide" Target="slides/slide8.xml"/><Relationship Id="rId31" Type="http://schemas.openxmlformats.org/officeDocument/2006/relationships/slide" Target="slides/slide29.xml"/><Relationship Id="rId44" Type="http://schemas.openxmlformats.org/officeDocument/2006/relationships/slide" Target="slides/slide42.xml"/><Relationship Id="rId52" Type="http://schemas.openxmlformats.org/officeDocument/2006/relationships/slide" Target="slides/slide50.xml"/><Relationship Id="rId60" Type="http://schemas.openxmlformats.org/officeDocument/2006/relationships/slide" Target="slides/slide58.xml"/><Relationship Id="rId65" Type="http://schemas.openxmlformats.org/officeDocument/2006/relationships/slide" Target="slides/slide63.xml"/><Relationship Id="rId73" Type="http://schemas.openxmlformats.org/officeDocument/2006/relationships/font" Target="fonts/font1.fntdata"/><Relationship Id="rId78" Type="http://schemas.openxmlformats.org/officeDocument/2006/relationships/tableStyles" Target="tableStyles.xml"/><Relationship Id="rId4" Type="http://schemas.openxmlformats.org/officeDocument/2006/relationships/slide" Target="slides/slide2.xml"/><Relationship Id="rId9" Type="http://schemas.openxmlformats.org/officeDocument/2006/relationships/slide" Target="slides/slide7.xml"/><Relationship Id="rId13" Type="http://schemas.openxmlformats.org/officeDocument/2006/relationships/slide" Target="slides/slide11.xml"/><Relationship Id="rId18" Type="http://schemas.openxmlformats.org/officeDocument/2006/relationships/slide" Target="slides/slide16.xml"/><Relationship Id="rId39" Type="http://schemas.openxmlformats.org/officeDocument/2006/relationships/slide" Target="slides/slide37.xml"/><Relationship Id="rId34" Type="http://schemas.openxmlformats.org/officeDocument/2006/relationships/slide" Target="slides/slide32.xml"/><Relationship Id="rId50" Type="http://schemas.openxmlformats.org/officeDocument/2006/relationships/slide" Target="slides/slide48.xml"/><Relationship Id="rId55" Type="http://schemas.openxmlformats.org/officeDocument/2006/relationships/slide" Target="slides/slide53.xml"/><Relationship Id="rId76" Type="http://schemas.openxmlformats.org/officeDocument/2006/relationships/viewProps" Target="viewProps.xml"/><Relationship Id="rId7" Type="http://schemas.openxmlformats.org/officeDocument/2006/relationships/slide" Target="slides/slide5.xml"/><Relationship Id="rId71" Type="http://schemas.openxmlformats.org/officeDocument/2006/relationships/slide" Target="slides/slide69.xml"/><Relationship Id="rId2" Type="http://schemas.openxmlformats.org/officeDocument/2006/relationships/slideMaster" Target="slideMasters/slideMaster2.xml"/><Relationship Id="rId29" Type="http://schemas.openxmlformats.org/officeDocument/2006/relationships/slide" Target="slides/slide27.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Bowen, Jimmy (He/Him/His)" userId="f71083e1-97a1-40d2-8747-448f174445d2" providerId="ADAL" clId="{C3DD8D70-FB0B-6443-A059-937A644838EE}"/>
    <pc:docChg chg="custSel modSld">
      <pc:chgData name="Bowen, Jimmy (He/Him/His)" userId="f71083e1-97a1-40d2-8747-448f174445d2" providerId="ADAL" clId="{C3DD8D70-FB0B-6443-A059-937A644838EE}" dt="2023-09-14T15:39:55.934" v="688" actId="20577"/>
      <pc:docMkLst>
        <pc:docMk/>
      </pc:docMkLst>
      <pc:sldChg chg="addSp modSp mod modAnim">
        <pc:chgData name="Bowen, Jimmy (He/Him/His)" userId="f71083e1-97a1-40d2-8747-448f174445d2" providerId="ADAL" clId="{C3DD8D70-FB0B-6443-A059-937A644838EE}" dt="2023-09-14T15:34:13.974" v="465"/>
        <pc:sldMkLst>
          <pc:docMk/>
          <pc:sldMk cId="0" sldId="269"/>
        </pc:sldMkLst>
        <pc:spChg chg="add mod">
          <ac:chgData name="Bowen, Jimmy (He/Him/His)" userId="f71083e1-97a1-40d2-8747-448f174445d2" providerId="ADAL" clId="{C3DD8D70-FB0B-6443-A059-937A644838EE}" dt="2023-09-14T15:29:26.437" v="5" actId="1076"/>
          <ac:spMkLst>
            <pc:docMk/>
            <pc:sldMk cId="0" sldId="269"/>
            <ac:spMk id="3" creationId="{9C7F7E2F-059A-E3B4-F8C7-C92F9E3C1B73}"/>
          </ac:spMkLst>
        </pc:spChg>
      </pc:sldChg>
      <pc:sldChg chg="addSp modSp mod modAnim">
        <pc:chgData name="Bowen, Jimmy (He/Him/His)" userId="f71083e1-97a1-40d2-8747-448f174445d2" providerId="ADAL" clId="{C3DD8D70-FB0B-6443-A059-937A644838EE}" dt="2023-09-14T15:36:08.698" v="478" actId="1076"/>
        <pc:sldMkLst>
          <pc:docMk/>
          <pc:sldMk cId="0" sldId="271"/>
        </pc:sldMkLst>
        <pc:spChg chg="add mod">
          <ac:chgData name="Bowen, Jimmy (He/Him/His)" userId="f71083e1-97a1-40d2-8747-448f174445d2" providerId="ADAL" clId="{C3DD8D70-FB0B-6443-A059-937A644838EE}" dt="2023-09-14T15:35:59.196" v="476" actId="404"/>
          <ac:spMkLst>
            <pc:docMk/>
            <pc:sldMk cId="0" sldId="271"/>
            <ac:spMk id="3" creationId="{27CE6577-218A-1328-0BDD-335F6745BDF2}"/>
          </ac:spMkLst>
        </pc:spChg>
        <pc:picChg chg="mod">
          <ac:chgData name="Bowen, Jimmy (He/Him/His)" userId="f71083e1-97a1-40d2-8747-448f174445d2" providerId="ADAL" clId="{C3DD8D70-FB0B-6443-A059-937A644838EE}" dt="2023-09-14T15:36:08.698" v="478" actId="1076"/>
          <ac:picMkLst>
            <pc:docMk/>
            <pc:sldMk cId="0" sldId="271"/>
            <ac:picMk id="4" creationId="{00000000-0000-0000-0000-000000000000}"/>
          </ac:picMkLst>
        </pc:picChg>
      </pc:sldChg>
      <pc:sldChg chg="addSp modSp mod modAnim">
        <pc:chgData name="Bowen, Jimmy (He/Him/His)" userId="f71083e1-97a1-40d2-8747-448f174445d2" providerId="ADAL" clId="{C3DD8D70-FB0B-6443-A059-937A644838EE}" dt="2023-09-14T15:34:08.447" v="464"/>
        <pc:sldMkLst>
          <pc:docMk/>
          <pc:sldMk cId="2064287918" sldId="323"/>
        </pc:sldMkLst>
        <pc:spChg chg="add mod">
          <ac:chgData name="Bowen, Jimmy (He/Him/His)" userId="f71083e1-97a1-40d2-8747-448f174445d2" providerId="ADAL" clId="{C3DD8D70-FB0B-6443-A059-937A644838EE}" dt="2023-09-14T15:34:05.487" v="463" actId="1076"/>
          <ac:spMkLst>
            <pc:docMk/>
            <pc:sldMk cId="2064287918" sldId="323"/>
            <ac:spMk id="5" creationId="{AA0A404C-8241-B2A7-79B6-F8C6984C450C}"/>
          </ac:spMkLst>
        </pc:spChg>
        <pc:picChg chg="mod">
          <ac:chgData name="Bowen, Jimmy (He/Him/His)" userId="f71083e1-97a1-40d2-8747-448f174445d2" providerId="ADAL" clId="{C3DD8D70-FB0B-6443-A059-937A644838EE}" dt="2023-09-14T15:33:45.996" v="453" actId="1076"/>
          <ac:picMkLst>
            <pc:docMk/>
            <pc:sldMk cId="2064287918" sldId="323"/>
            <ac:picMk id="4" creationId="{00000000-0000-0000-0000-000000000000}"/>
          </ac:picMkLst>
        </pc:picChg>
      </pc:sldChg>
      <pc:sldChg chg="addSp modSp modAnim">
        <pc:chgData name="Bowen, Jimmy (He/Him/His)" userId="f71083e1-97a1-40d2-8747-448f174445d2" providerId="ADAL" clId="{C3DD8D70-FB0B-6443-A059-937A644838EE}" dt="2023-09-14T15:34:30.182" v="466"/>
        <pc:sldMkLst>
          <pc:docMk/>
          <pc:sldMk cId="3487670945" sldId="325"/>
        </pc:sldMkLst>
        <pc:spChg chg="add mod">
          <ac:chgData name="Bowen, Jimmy (He/Him/His)" userId="f71083e1-97a1-40d2-8747-448f174445d2" providerId="ADAL" clId="{C3DD8D70-FB0B-6443-A059-937A644838EE}" dt="2023-09-14T15:34:30.182" v="466"/>
          <ac:spMkLst>
            <pc:docMk/>
            <pc:sldMk cId="3487670945" sldId="325"/>
            <ac:spMk id="5" creationId="{4864A121-40A5-1C7B-AE08-306D0307E2F4}"/>
          </ac:spMkLst>
        </pc:spChg>
      </pc:sldChg>
      <pc:sldChg chg="addSp delSp modSp mod">
        <pc:chgData name="Bowen, Jimmy (He/Him/His)" userId="f71083e1-97a1-40d2-8747-448f174445d2" providerId="ADAL" clId="{C3DD8D70-FB0B-6443-A059-937A644838EE}" dt="2023-09-14T15:32:49.867" v="451" actId="1076"/>
        <pc:sldMkLst>
          <pc:docMk/>
          <pc:sldMk cId="1307015233" sldId="326"/>
        </pc:sldMkLst>
        <pc:spChg chg="mod">
          <ac:chgData name="Bowen, Jimmy (He/Him/His)" userId="f71083e1-97a1-40d2-8747-448f174445d2" providerId="ADAL" clId="{C3DD8D70-FB0B-6443-A059-937A644838EE}" dt="2023-09-14T15:32:18.491" v="436" actId="20577"/>
          <ac:spMkLst>
            <pc:docMk/>
            <pc:sldMk cId="1307015233" sldId="326"/>
            <ac:spMk id="2" creationId="{00000000-0000-0000-0000-000000000000}"/>
          </ac:spMkLst>
        </pc:spChg>
        <pc:spChg chg="add mod">
          <ac:chgData name="Bowen, Jimmy (He/Him/His)" userId="f71083e1-97a1-40d2-8747-448f174445d2" providerId="ADAL" clId="{C3DD8D70-FB0B-6443-A059-937A644838EE}" dt="2023-09-14T15:32:49.867" v="451" actId="1076"/>
          <ac:spMkLst>
            <pc:docMk/>
            <pc:sldMk cId="1307015233" sldId="326"/>
            <ac:spMk id="7" creationId="{6FAA4B1D-01DF-D178-3D85-221DE47E3437}"/>
          </ac:spMkLst>
        </pc:spChg>
        <pc:graphicFrameChg chg="add mod modGraphic">
          <ac:chgData name="Bowen, Jimmy (He/Him/His)" userId="f71083e1-97a1-40d2-8747-448f174445d2" providerId="ADAL" clId="{C3DD8D70-FB0B-6443-A059-937A644838EE}" dt="2023-09-14T15:32:24.642" v="438" actId="1076"/>
          <ac:graphicFrameMkLst>
            <pc:docMk/>
            <pc:sldMk cId="1307015233" sldId="326"/>
            <ac:graphicFrameMk id="5" creationId="{AB19B883-158D-CC85-C8F1-1D378F32F225}"/>
          </ac:graphicFrameMkLst>
        </pc:graphicFrameChg>
        <pc:picChg chg="del mod">
          <ac:chgData name="Bowen, Jimmy (He/Him/His)" userId="f71083e1-97a1-40d2-8747-448f174445d2" providerId="ADAL" clId="{C3DD8D70-FB0B-6443-A059-937A644838EE}" dt="2023-09-14T15:32:06.131" v="410" actId="478"/>
          <ac:picMkLst>
            <pc:docMk/>
            <pc:sldMk cId="1307015233" sldId="326"/>
            <ac:picMk id="4" creationId="{00000000-0000-0000-0000-000000000000}"/>
          </ac:picMkLst>
        </pc:picChg>
      </pc:sldChg>
      <pc:sldChg chg="addSp modSp modAnim">
        <pc:chgData name="Bowen, Jimmy (He/Him/His)" userId="f71083e1-97a1-40d2-8747-448f174445d2" providerId="ADAL" clId="{C3DD8D70-FB0B-6443-A059-937A644838EE}" dt="2023-09-14T15:36:17.077" v="479"/>
        <pc:sldMkLst>
          <pc:docMk/>
          <pc:sldMk cId="2218368193" sldId="327"/>
        </pc:sldMkLst>
        <pc:spChg chg="add mod">
          <ac:chgData name="Bowen, Jimmy (He/Him/His)" userId="f71083e1-97a1-40d2-8747-448f174445d2" providerId="ADAL" clId="{C3DD8D70-FB0B-6443-A059-937A644838EE}" dt="2023-09-14T15:36:17.077" v="479"/>
          <ac:spMkLst>
            <pc:docMk/>
            <pc:sldMk cId="2218368193" sldId="327"/>
            <ac:spMk id="7" creationId="{66E0AEF5-0623-EC8A-D4B8-0CE04155D91B}"/>
          </ac:spMkLst>
        </pc:spChg>
      </pc:sldChg>
      <pc:sldChg chg="delSp modSp mod">
        <pc:chgData name="Bowen, Jimmy (He/Him/His)" userId="f71083e1-97a1-40d2-8747-448f174445d2" providerId="ADAL" clId="{C3DD8D70-FB0B-6443-A059-937A644838EE}" dt="2023-09-14T15:39:55.934" v="688" actId="20577"/>
        <pc:sldMkLst>
          <pc:docMk/>
          <pc:sldMk cId="2740533997" sldId="331"/>
        </pc:sldMkLst>
        <pc:spChg chg="mod">
          <ac:chgData name="Bowen, Jimmy (He/Him/His)" userId="f71083e1-97a1-40d2-8747-448f174445d2" providerId="ADAL" clId="{C3DD8D70-FB0B-6443-A059-937A644838EE}" dt="2023-09-14T15:39:55.934" v="688" actId="20577"/>
          <ac:spMkLst>
            <pc:docMk/>
            <pc:sldMk cId="2740533997" sldId="331"/>
            <ac:spMk id="2" creationId="{00000000-0000-0000-0000-000000000000}"/>
          </ac:spMkLst>
        </pc:spChg>
        <pc:picChg chg="del mod">
          <ac:chgData name="Bowen, Jimmy (He/Him/His)" userId="f71083e1-97a1-40d2-8747-448f174445d2" providerId="ADAL" clId="{C3DD8D70-FB0B-6443-A059-937A644838EE}" dt="2023-09-14T15:39:13.986" v="683" actId="478"/>
          <ac:picMkLst>
            <pc:docMk/>
            <pc:sldMk cId="2740533997" sldId="331"/>
            <ac:picMk id="4" creationId="{00000000-0000-0000-0000-000000000000}"/>
          </ac:picMkLst>
        </pc:picChg>
      </pc:sldChg>
    </pc:docChg>
  </pc:docChgLst>
  <pc:docChgLst>
    <pc:chgData name="Bowen, Jimmy (He/Him/His)" userId="S::james.bowen@cchmc.org::f71083e1-97a1-40d2-8747-448f174445d2" providerId="AD" clId="Web-{D80A91EA-533A-5C18-F633-E4D3AB8D11BC}"/>
    <pc:docChg chg="modSld">
      <pc:chgData name="Bowen, Jimmy (He/Him/His)" userId="S::james.bowen@cchmc.org::f71083e1-97a1-40d2-8747-448f174445d2" providerId="AD" clId="Web-{D80A91EA-533A-5C18-F633-E4D3AB8D11BC}" dt="2024-03-08T14:37:31.477" v="21" actId="20577"/>
      <pc:docMkLst>
        <pc:docMk/>
      </pc:docMkLst>
      <pc:sldChg chg="modSp">
        <pc:chgData name="Bowen, Jimmy (He/Him/His)" userId="S::james.bowen@cchmc.org::f71083e1-97a1-40d2-8747-448f174445d2" providerId="AD" clId="Web-{D80A91EA-533A-5C18-F633-E4D3AB8D11BC}" dt="2024-03-08T14:36:53.992" v="1" actId="20577"/>
        <pc:sldMkLst>
          <pc:docMk/>
          <pc:sldMk cId="0" sldId="258"/>
        </pc:sldMkLst>
        <pc:spChg chg="mod">
          <ac:chgData name="Bowen, Jimmy (He/Him/His)" userId="S::james.bowen@cchmc.org::f71083e1-97a1-40d2-8747-448f174445d2" providerId="AD" clId="Web-{D80A91EA-533A-5C18-F633-E4D3AB8D11BC}" dt="2024-03-08T14:36:53.992" v="1" actId="20577"/>
          <ac:spMkLst>
            <pc:docMk/>
            <pc:sldMk cId="0" sldId="258"/>
            <ac:spMk id="4" creationId="{FF9567D7-FB74-8FB4-074B-52C5DAA84F4B}"/>
          </ac:spMkLst>
        </pc:spChg>
      </pc:sldChg>
      <pc:sldChg chg="modSp">
        <pc:chgData name="Bowen, Jimmy (He/Him/His)" userId="S::james.bowen@cchmc.org::f71083e1-97a1-40d2-8747-448f174445d2" providerId="AD" clId="Web-{D80A91EA-533A-5C18-F633-E4D3AB8D11BC}" dt="2024-03-08T14:37:07.117" v="18" actId="20577"/>
        <pc:sldMkLst>
          <pc:docMk/>
          <pc:sldMk cId="668808694" sldId="298"/>
        </pc:sldMkLst>
        <pc:spChg chg="mod">
          <ac:chgData name="Bowen, Jimmy (He/Him/His)" userId="S::james.bowen@cchmc.org::f71083e1-97a1-40d2-8747-448f174445d2" providerId="AD" clId="Web-{D80A91EA-533A-5C18-F633-E4D3AB8D11BC}" dt="2024-03-08T14:37:07.117" v="18" actId="20577"/>
          <ac:spMkLst>
            <pc:docMk/>
            <pc:sldMk cId="668808694" sldId="298"/>
            <ac:spMk id="2" creationId="{EED5B93B-D6E9-46A1-8E71-B42472829E2E}"/>
          </ac:spMkLst>
        </pc:spChg>
      </pc:sldChg>
      <pc:sldChg chg="modSp">
        <pc:chgData name="Bowen, Jimmy (He/Him/His)" userId="S::james.bowen@cchmc.org::f71083e1-97a1-40d2-8747-448f174445d2" providerId="AD" clId="Web-{D80A91EA-533A-5C18-F633-E4D3AB8D11BC}" dt="2024-03-08T14:37:19.242" v="20" actId="20577"/>
        <pc:sldMkLst>
          <pc:docMk/>
          <pc:sldMk cId="2016827136" sldId="299"/>
        </pc:sldMkLst>
        <pc:spChg chg="mod">
          <ac:chgData name="Bowen, Jimmy (He/Him/His)" userId="S::james.bowen@cchmc.org::f71083e1-97a1-40d2-8747-448f174445d2" providerId="AD" clId="Web-{D80A91EA-533A-5C18-F633-E4D3AB8D11BC}" dt="2024-03-08T14:37:19.242" v="20" actId="20577"/>
          <ac:spMkLst>
            <pc:docMk/>
            <pc:sldMk cId="2016827136" sldId="299"/>
            <ac:spMk id="2" creationId="{FE7B6990-40BC-4427-BECE-8EE6BF1456DE}"/>
          </ac:spMkLst>
        </pc:spChg>
      </pc:sldChg>
      <pc:sldChg chg="modSp">
        <pc:chgData name="Bowen, Jimmy (He/Him/His)" userId="S::james.bowen@cchmc.org::f71083e1-97a1-40d2-8747-448f174445d2" providerId="AD" clId="Web-{D80A91EA-533A-5C18-F633-E4D3AB8D11BC}" dt="2024-03-08T14:37:31.477" v="21" actId="20577"/>
        <pc:sldMkLst>
          <pc:docMk/>
          <pc:sldMk cId="3984489899" sldId="301"/>
        </pc:sldMkLst>
        <pc:spChg chg="mod">
          <ac:chgData name="Bowen, Jimmy (He/Him/His)" userId="S::james.bowen@cchmc.org::f71083e1-97a1-40d2-8747-448f174445d2" providerId="AD" clId="Web-{D80A91EA-533A-5C18-F633-E4D3AB8D11BC}" dt="2024-03-08T14:37:31.477" v="21" actId="20577"/>
          <ac:spMkLst>
            <pc:docMk/>
            <pc:sldMk cId="3984489899" sldId="301"/>
            <ac:spMk id="5" creationId="{3144D86E-A0AE-4AD5-982A-A95306848F2B}"/>
          </ac:spMkLst>
        </pc:spChg>
      </pc:sldChg>
    </pc:docChg>
  </pc:docChgLst>
  <pc:docChgLst>
    <pc:chgData name="Bowen, Jimmy (He/Him/His)" userId="S::james.bowen@cchmc.org::f71083e1-97a1-40d2-8747-448f174445d2" providerId="AD" clId="Web-{7AF133BC-61F1-E9E3-D7D5-AE02444865AA}"/>
    <pc:docChg chg="modSld">
      <pc:chgData name="Bowen, Jimmy (He/Him/His)" userId="S::james.bowen@cchmc.org::f71083e1-97a1-40d2-8747-448f174445d2" providerId="AD" clId="Web-{7AF133BC-61F1-E9E3-D7D5-AE02444865AA}" dt="2024-02-29T20:40:36.513" v="1294"/>
      <pc:docMkLst>
        <pc:docMk/>
      </pc:docMkLst>
      <pc:sldChg chg="modNotes">
        <pc:chgData name="Bowen, Jimmy (He/Him/His)" userId="S::james.bowen@cchmc.org::f71083e1-97a1-40d2-8747-448f174445d2" providerId="AD" clId="Web-{7AF133BC-61F1-E9E3-D7D5-AE02444865AA}" dt="2024-02-29T20:36:24.960" v="417"/>
        <pc:sldMkLst>
          <pc:docMk/>
          <pc:sldMk cId="0" sldId="256"/>
        </pc:sldMkLst>
      </pc:sldChg>
      <pc:sldChg chg="modSp">
        <pc:chgData name="Bowen, Jimmy (He/Him/His)" userId="S::james.bowen@cchmc.org::f71083e1-97a1-40d2-8747-448f174445d2" providerId="AD" clId="Web-{7AF133BC-61F1-E9E3-D7D5-AE02444865AA}" dt="2024-02-29T20:33:50.253" v="2" actId="20577"/>
        <pc:sldMkLst>
          <pc:docMk/>
          <pc:sldMk cId="0" sldId="258"/>
        </pc:sldMkLst>
        <pc:spChg chg="mod">
          <ac:chgData name="Bowen, Jimmy (He/Him/His)" userId="S::james.bowen@cchmc.org::f71083e1-97a1-40d2-8747-448f174445d2" providerId="AD" clId="Web-{7AF133BC-61F1-E9E3-D7D5-AE02444865AA}" dt="2024-02-29T20:33:50.253" v="2" actId="20577"/>
          <ac:spMkLst>
            <pc:docMk/>
            <pc:sldMk cId="0" sldId="258"/>
            <ac:spMk id="4" creationId="{FF9567D7-FB74-8FB4-074B-52C5DAA84F4B}"/>
          </ac:spMkLst>
        </pc:spChg>
      </pc:sldChg>
      <pc:sldChg chg="modSp">
        <pc:chgData name="Bowen, Jimmy (He/Him/His)" userId="S::james.bowen@cchmc.org::f71083e1-97a1-40d2-8747-448f174445d2" providerId="AD" clId="Web-{7AF133BC-61F1-E9E3-D7D5-AE02444865AA}" dt="2024-02-29T20:39:46.730" v="1055" actId="20577"/>
        <pc:sldMkLst>
          <pc:docMk/>
          <pc:sldMk cId="0" sldId="267"/>
        </pc:sldMkLst>
        <pc:spChg chg="mod">
          <ac:chgData name="Bowen, Jimmy (He/Him/His)" userId="S::james.bowen@cchmc.org::f71083e1-97a1-40d2-8747-448f174445d2" providerId="AD" clId="Web-{7AF133BC-61F1-E9E3-D7D5-AE02444865AA}" dt="2024-02-29T20:39:46.730" v="1055" actId="20577"/>
          <ac:spMkLst>
            <pc:docMk/>
            <pc:sldMk cId="0" sldId="267"/>
            <ac:spMk id="325" creationId="{00000000-0000-0000-0000-000000000000}"/>
          </ac:spMkLst>
        </pc:spChg>
      </pc:sldChg>
      <pc:sldChg chg="modNotes">
        <pc:chgData name="Bowen, Jimmy (He/Him/His)" userId="S::james.bowen@cchmc.org::f71083e1-97a1-40d2-8747-448f174445d2" providerId="AD" clId="Web-{7AF133BC-61F1-E9E3-D7D5-AE02444865AA}" dt="2024-02-29T20:37:03.680" v="542"/>
        <pc:sldMkLst>
          <pc:docMk/>
          <pc:sldMk cId="2016827136" sldId="299"/>
        </pc:sldMkLst>
      </pc:sldChg>
      <pc:sldChg chg="modNotes">
        <pc:chgData name="Bowen, Jimmy (He/Him/His)" userId="S::james.bowen@cchmc.org::f71083e1-97a1-40d2-8747-448f174445d2" providerId="AD" clId="Web-{7AF133BC-61F1-E9E3-D7D5-AE02444865AA}" dt="2024-02-29T20:37:36.899" v="589"/>
        <pc:sldMkLst>
          <pc:docMk/>
          <pc:sldMk cId="3984489899" sldId="301"/>
        </pc:sldMkLst>
      </pc:sldChg>
      <pc:sldChg chg="modNotes">
        <pc:chgData name="Bowen, Jimmy (He/Him/His)" userId="S::james.bowen@cchmc.org::f71083e1-97a1-40d2-8747-448f174445d2" providerId="AD" clId="Web-{7AF133BC-61F1-E9E3-D7D5-AE02444865AA}" dt="2024-02-29T20:39:45.918" v="1053"/>
        <pc:sldMkLst>
          <pc:docMk/>
          <pc:sldMk cId="3909737988" sldId="312"/>
        </pc:sldMkLst>
      </pc:sldChg>
      <pc:sldChg chg="modNotes">
        <pc:chgData name="Bowen, Jimmy (He/Him/His)" userId="S::james.bowen@cchmc.org::f71083e1-97a1-40d2-8747-448f174445d2" providerId="AD" clId="Web-{7AF133BC-61F1-E9E3-D7D5-AE02444865AA}" dt="2024-02-29T20:38:23.728" v="720"/>
        <pc:sldMkLst>
          <pc:docMk/>
          <pc:sldMk cId="3675078110" sldId="317"/>
        </pc:sldMkLst>
      </pc:sldChg>
      <pc:sldChg chg="modNotes">
        <pc:chgData name="Bowen, Jimmy (He/Him/His)" userId="S::james.bowen@cchmc.org::f71083e1-97a1-40d2-8747-448f174445d2" providerId="AD" clId="Web-{7AF133BC-61F1-E9E3-D7D5-AE02444865AA}" dt="2024-02-29T20:39:11.542" v="915"/>
        <pc:sldMkLst>
          <pc:docMk/>
          <pc:sldMk cId="1079207296" sldId="318"/>
        </pc:sldMkLst>
      </pc:sldChg>
      <pc:sldChg chg="modNotes">
        <pc:chgData name="Bowen, Jimmy (He/Him/His)" userId="S::james.bowen@cchmc.org::f71083e1-97a1-40d2-8747-448f174445d2" providerId="AD" clId="Web-{7AF133BC-61F1-E9E3-D7D5-AE02444865AA}" dt="2024-02-29T20:40:36.513" v="1294"/>
        <pc:sldMkLst>
          <pc:docMk/>
          <pc:sldMk cId="1798559321" sldId="320"/>
        </pc:sldMkLst>
      </pc:sldChg>
    </pc:docChg>
  </pc:docChgLst>
  <pc:docChgLst>
    <pc:chgData name="Bowen, Jimmy (He/Him/His)" userId="S::james.bowen@cchmc.org::f71083e1-97a1-40d2-8747-448f174445d2" providerId="AD" clId="Web-{0FE4C20C-72FF-EFEA-F562-9B6884936622}"/>
    <pc:docChg chg="addSld modSld">
      <pc:chgData name="Bowen, Jimmy (He/Him/His)" userId="S::james.bowen@cchmc.org::f71083e1-97a1-40d2-8747-448f174445d2" providerId="AD" clId="Web-{0FE4C20C-72FF-EFEA-F562-9B6884936622}" dt="2024-03-04T19:01:48.753" v="1071"/>
      <pc:docMkLst>
        <pc:docMk/>
      </pc:docMkLst>
      <pc:sldChg chg="modNotes">
        <pc:chgData name="Bowen, Jimmy (He/Him/His)" userId="S::james.bowen@cchmc.org::f71083e1-97a1-40d2-8747-448f174445d2" providerId="AD" clId="Web-{0FE4C20C-72FF-EFEA-F562-9B6884936622}" dt="2024-03-04T18:51:35.635" v="248"/>
        <pc:sldMkLst>
          <pc:docMk/>
          <pc:sldMk cId="0" sldId="258"/>
        </pc:sldMkLst>
      </pc:sldChg>
      <pc:sldChg chg="modNotes">
        <pc:chgData name="Bowen, Jimmy (He/Him/His)" userId="S::james.bowen@cchmc.org::f71083e1-97a1-40d2-8747-448f174445d2" providerId="AD" clId="Web-{0FE4C20C-72FF-EFEA-F562-9B6884936622}" dt="2024-03-04T18:50:25.617" v="64"/>
        <pc:sldMkLst>
          <pc:docMk/>
          <pc:sldMk cId="0" sldId="259"/>
        </pc:sldMkLst>
      </pc:sldChg>
      <pc:sldChg chg="modNotes">
        <pc:chgData name="Bowen, Jimmy (He/Him/His)" userId="S::james.bowen@cchmc.org::f71083e1-97a1-40d2-8747-448f174445d2" providerId="AD" clId="Web-{0FE4C20C-72FF-EFEA-F562-9B6884936622}" dt="2024-03-04T18:51:03.853" v="132"/>
        <pc:sldMkLst>
          <pc:docMk/>
          <pc:sldMk cId="2016827136" sldId="299"/>
        </pc:sldMkLst>
      </pc:sldChg>
      <pc:sldChg chg="modNotes">
        <pc:chgData name="Bowen, Jimmy (He/Him/His)" userId="S::james.bowen@cchmc.org::f71083e1-97a1-40d2-8747-448f174445d2" providerId="AD" clId="Web-{0FE4C20C-72FF-EFEA-F562-9B6884936622}" dt="2024-03-04T18:52:40.279" v="356"/>
        <pc:sldMkLst>
          <pc:docMk/>
          <pc:sldMk cId="1207434534" sldId="300"/>
        </pc:sldMkLst>
      </pc:sldChg>
      <pc:sldChg chg="modNotes">
        <pc:chgData name="Bowen, Jimmy (He/Him/His)" userId="S::james.bowen@cchmc.org::f71083e1-97a1-40d2-8747-448f174445d2" providerId="AD" clId="Web-{0FE4C20C-72FF-EFEA-F562-9B6884936622}" dt="2024-03-04T18:53:35.968" v="469"/>
        <pc:sldMkLst>
          <pc:docMk/>
          <pc:sldMk cId="711016228" sldId="302"/>
        </pc:sldMkLst>
      </pc:sldChg>
      <pc:sldChg chg="modNotes">
        <pc:chgData name="Bowen, Jimmy (He/Him/His)" userId="S::james.bowen@cchmc.org::f71083e1-97a1-40d2-8747-448f174445d2" providerId="AD" clId="Web-{0FE4C20C-72FF-EFEA-F562-9B6884936622}" dt="2024-03-04T19:01:42.940" v="1070"/>
        <pc:sldMkLst>
          <pc:docMk/>
          <pc:sldMk cId="3666191697" sldId="311"/>
        </pc:sldMkLst>
      </pc:sldChg>
      <pc:sldChg chg="modNotes">
        <pc:chgData name="Bowen, Jimmy (He/Him/His)" userId="S::james.bowen@cchmc.org::f71083e1-97a1-40d2-8747-448f174445d2" providerId="AD" clId="Web-{0FE4C20C-72FF-EFEA-F562-9B6884936622}" dt="2024-03-04T18:56:08.693" v="917"/>
        <pc:sldMkLst>
          <pc:docMk/>
          <pc:sldMk cId="3909737988" sldId="312"/>
        </pc:sldMkLst>
      </pc:sldChg>
      <pc:sldChg chg="modNotes">
        <pc:chgData name="Bowen, Jimmy (He/Him/His)" userId="S::james.bowen@cchmc.org::f71083e1-97a1-40d2-8747-448f174445d2" providerId="AD" clId="Web-{0FE4C20C-72FF-EFEA-F562-9B6884936622}" dt="2024-03-04T18:54:56.925" v="677"/>
        <pc:sldMkLst>
          <pc:docMk/>
          <pc:sldMk cId="1079207296" sldId="318"/>
        </pc:sldMkLst>
      </pc:sldChg>
      <pc:sldChg chg="modNotes">
        <pc:chgData name="Bowen, Jimmy (He/Him/His)" userId="S::james.bowen@cchmc.org::f71083e1-97a1-40d2-8747-448f174445d2" providerId="AD" clId="Web-{0FE4C20C-72FF-EFEA-F562-9B6884936622}" dt="2024-03-04T19:01:48.753" v="1071"/>
        <pc:sldMkLst>
          <pc:docMk/>
          <pc:sldMk cId="4251026753" sldId="322"/>
        </pc:sldMkLst>
      </pc:sldChg>
      <pc:sldChg chg="modSp add replId">
        <pc:chgData name="Bowen, Jimmy (He/Him/His)" userId="S::james.bowen@cchmc.org::f71083e1-97a1-40d2-8747-448f174445d2" providerId="AD" clId="Web-{0FE4C20C-72FF-EFEA-F562-9B6884936622}" dt="2024-03-04T18:49:01.801" v="7" actId="20577"/>
        <pc:sldMkLst>
          <pc:docMk/>
          <pc:sldMk cId="3496686093" sldId="353"/>
        </pc:sldMkLst>
        <pc:spChg chg="mod">
          <ac:chgData name="Bowen, Jimmy (He/Him/His)" userId="S::james.bowen@cchmc.org::f71083e1-97a1-40d2-8747-448f174445d2" providerId="AD" clId="Web-{0FE4C20C-72FF-EFEA-F562-9B6884936622}" dt="2024-03-04T18:49:01.801" v="7" actId="20577"/>
          <ac:spMkLst>
            <pc:docMk/>
            <pc:sldMk cId="3496686093" sldId="353"/>
            <ac:spMk id="222" creationId="{00000000-0000-0000-0000-000000000000}"/>
          </ac:spMkLst>
        </pc:spChg>
      </pc:sldChg>
    </pc:docChg>
  </pc:docChgLst>
  <pc:docChgLst>
    <pc:chgData name="Bowen, Jimmy (He/Him/His)" userId="S::james.bowen@cchmc.org::f71083e1-97a1-40d2-8747-448f174445d2" providerId="AD" clId="Web-{A7DB61DD-5FF7-58A8-27E9-4096012B6CB7}"/>
    <pc:docChg chg="modSld">
      <pc:chgData name="Bowen, Jimmy (He/Him/His)" userId="S::james.bowen@cchmc.org::f71083e1-97a1-40d2-8747-448f174445d2" providerId="AD" clId="Web-{A7DB61DD-5FF7-58A8-27E9-4096012B6CB7}" dt="2024-03-05T13:12:47.904" v="30"/>
      <pc:docMkLst>
        <pc:docMk/>
      </pc:docMkLst>
      <pc:sldChg chg="modNotes">
        <pc:chgData name="Bowen, Jimmy (He/Him/His)" userId="S::james.bowen@cchmc.org::f71083e1-97a1-40d2-8747-448f174445d2" providerId="AD" clId="Web-{A7DB61DD-5FF7-58A8-27E9-4096012B6CB7}" dt="2024-03-05T13:12:47.904" v="30"/>
        <pc:sldMkLst>
          <pc:docMk/>
          <pc:sldMk cId="0" sldId="256"/>
        </pc:sldMkLst>
      </pc:sldChg>
    </pc:docChg>
  </pc:docChgLst>
  <pc:docChgLst>
    <pc:chgData name="Bowen, Jimmy (He/Him/His)" userId="S::james.bowen@cchmc.org::f71083e1-97a1-40d2-8747-448f174445d2" providerId="AD" clId="Web-{299DFB61-213B-9EE4-F289-4D5AD57A0D15}"/>
    <pc:docChg chg="addSld addMainMaster">
      <pc:chgData name="Bowen, Jimmy (He/Him/His)" userId="S::james.bowen@cchmc.org::f71083e1-97a1-40d2-8747-448f174445d2" providerId="AD" clId="Web-{299DFB61-213B-9EE4-F289-4D5AD57A0D15}" dt="2023-09-14T16:11:44.678" v="0"/>
      <pc:docMkLst>
        <pc:docMk/>
      </pc:docMkLst>
      <pc:sldChg chg="add">
        <pc:chgData name="Bowen, Jimmy (He/Him/His)" userId="S::james.bowen@cchmc.org::f71083e1-97a1-40d2-8747-448f174445d2" providerId="AD" clId="Web-{299DFB61-213B-9EE4-F289-4D5AD57A0D15}" dt="2023-09-14T16:11:44.678" v="0"/>
        <pc:sldMkLst>
          <pc:docMk/>
          <pc:sldMk cId="2804799185" sldId="352"/>
        </pc:sldMkLst>
      </pc:sldChg>
      <pc:sldMasterChg chg="add addSldLayout">
        <pc:chgData name="Bowen, Jimmy (He/Him/His)" userId="S::james.bowen@cchmc.org::f71083e1-97a1-40d2-8747-448f174445d2" providerId="AD" clId="Web-{299DFB61-213B-9EE4-F289-4D5AD57A0D15}" dt="2023-09-14T16:11:44.678" v="0"/>
        <pc:sldMasterMkLst>
          <pc:docMk/>
          <pc:sldMasterMk cId="0" sldId="2147483662"/>
        </pc:sldMasterMkLst>
        <pc:sldLayoutChg chg="add">
          <pc:chgData name="Bowen, Jimmy (He/Him/His)" userId="S::james.bowen@cchmc.org::f71083e1-97a1-40d2-8747-448f174445d2" providerId="AD" clId="Web-{299DFB61-213B-9EE4-F289-4D5AD57A0D15}" dt="2023-09-14T16:11:44.678" v="0"/>
          <pc:sldLayoutMkLst>
            <pc:docMk/>
            <pc:sldMasterMk cId="0" sldId="2147483662"/>
            <pc:sldLayoutMk cId="0" sldId="2147483651"/>
          </pc:sldLayoutMkLst>
        </pc:sldLayoutChg>
        <pc:sldLayoutChg chg="add">
          <pc:chgData name="Bowen, Jimmy (He/Him/His)" userId="S::james.bowen@cchmc.org::f71083e1-97a1-40d2-8747-448f174445d2" providerId="AD" clId="Web-{299DFB61-213B-9EE4-F289-4D5AD57A0D15}" dt="2023-09-14T16:11:44.678" v="0"/>
          <pc:sldLayoutMkLst>
            <pc:docMk/>
            <pc:sldMasterMk cId="0" sldId="2147483662"/>
            <pc:sldLayoutMk cId="0" sldId="2147483652"/>
          </pc:sldLayoutMkLst>
        </pc:sldLayoutChg>
        <pc:sldLayoutChg chg="add">
          <pc:chgData name="Bowen, Jimmy (He/Him/His)" userId="S::james.bowen@cchmc.org::f71083e1-97a1-40d2-8747-448f174445d2" providerId="AD" clId="Web-{299DFB61-213B-9EE4-F289-4D5AD57A0D15}" dt="2023-09-14T16:11:44.678" v="0"/>
          <pc:sldLayoutMkLst>
            <pc:docMk/>
            <pc:sldMasterMk cId="0" sldId="2147483662"/>
            <pc:sldLayoutMk cId="0" sldId="2147483663"/>
          </pc:sldLayoutMkLst>
        </pc:sldLayoutChg>
        <pc:sldLayoutChg chg="add">
          <pc:chgData name="Bowen, Jimmy (He/Him/His)" userId="S::james.bowen@cchmc.org::f71083e1-97a1-40d2-8747-448f174445d2" providerId="AD" clId="Web-{299DFB61-213B-9EE4-F289-4D5AD57A0D15}" dt="2023-09-14T16:11:44.678" v="0"/>
          <pc:sldLayoutMkLst>
            <pc:docMk/>
            <pc:sldMasterMk cId="0" sldId="2147483662"/>
            <pc:sldLayoutMk cId="0" sldId="2147483664"/>
          </pc:sldLayoutMkLst>
        </pc:sldLayoutChg>
        <pc:sldLayoutChg chg="add">
          <pc:chgData name="Bowen, Jimmy (He/Him/His)" userId="S::james.bowen@cchmc.org::f71083e1-97a1-40d2-8747-448f174445d2" providerId="AD" clId="Web-{299DFB61-213B-9EE4-F289-4D5AD57A0D15}" dt="2023-09-14T16:11:44.678" v="0"/>
          <pc:sldLayoutMkLst>
            <pc:docMk/>
            <pc:sldMasterMk cId="0" sldId="2147483662"/>
            <pc:sldLayoutMk cId="0" sldId="2147483665"/>
          </pc:sldLayoutMkLst>
        </pc:sldLayoutChg>
        <pc:sldLayoutChg chg="add">
          <pc:chgData name="Bowen, Jimmy (He/Him/His)" userId="S::james.bowen@cchmc.org::f71083e1-97a1-40d2-8747-448f174445d2" providerId="AD" clId="Web-{299DFB61-213B-9EE4-F289-4D5AD57A0D15}" dt="2023-09-14T16:11:44.678" v="0"/>
          <pc:sldLayoutMkLst>
            <pc:docMk/>
            <pc:sldMasterMk cId="0" sldId="2147483662"/>
            <pc:sldLayoutMk cId="0" sldId="2147483666"/>
          </pc:sldLayoutMkLst>
        </pc:sldLayoutChg>
        <pc:sldLayoutChg chg="add">
          <pc:chgData name="Bowen, Jimmy (He/Him/His)" userId="S::james.bowen@cchmc.org::f71083e1-97a1-40d2-8747-448f174445d2" providerId="AD" clId="Web-{299DFB61-213B-9EE4-F289-4D5AD57A0D15}" dt="2023-09-14T16:11:44.678" v="0"/>
          <pc:sldLayoutMkLst>
            <pc:docMk/>
            <pc:sldMasterMk cId="0" sldId="2147483662"/>
            <pc:sldLayoutMk cId="0" sldId="2147483667"/>
          </pc:sldLayoutMkLst>
        </pc:sldLayoutChg>
        <pc:sldLayoutChg chg="add">
          <pc:chgData name="Bowen, Jimmy (He/Him/His)" userId="S::james.bowen@cchmc.org::f71083e1-97a1-40d2-8747-448f174445d2" providerId="AD" clId="Web-{299DFB61-213B-9EE4-F289-4D5AD57A0D15}" dt="2023-09-14T16:11:44.678" v="0"/>
          <pc:sldLayoutMkLst>
            <pc:docMk/>
            <pc:sldMasterMk cId="0" sldId="2147483662"/>
            <pc:sldLayoutMk cId="0" sldId="2147483668"/>
          </pc:sldLayoutMkLst>
        </pc:sldLayoutChg>
        <pc:sldLayoutChg chg="add">
          <pc:chgData name="Bowen, Jimmy (He/Him/His)" userId="S::james.bowen@cchmc.org::f71083e1-97a1-40d2-8747-448f174445d2" providerId="AD" clId="Web-{299DFB61-213B-9EE4-F289-4D5AD57A0D15}" dt="2023-09-14T16:11:44.678" v="0"/>
          <pc:sldLayoutMkLst>
            <pc:docMk/>
            <pc:sldMasterMk cId="0" sldId="2147483662"/>
            <pc:sldLayoutMk cId="0" sldId="2147483669"/>
          </pc:sldLayoutMkLst>
        </pc:sldLayoutChg>
        <pc:sldLayoutChg chg="add">
          <pc:chgData name="Bowen, Jimmy (He/Him/His)" userId="S::james.bowen@cchmc.org::f71083e1-97a1-40d2-8747-448f174445d2" providerId="AD" clId="Web-{299DFB61-213B-9EE4-F289-4D5AD57A0D15}" dt="2023-09-14T16:11:44.678" v="0"/>
          <pc:sldLayoutMkLst>
            <pc:docMk/>
            <pc:sldMasterMk cId="0" sldId="2147483662"/>
            <pc:sldLayoutMk cId="0" sldId="2147483670"/>
          </pc:sldLayoutMkLst>
        </pc:sldLayoutChg>
        <pc:sldLayoutChg chg="add">
          <pc:chgData name="Bowen, Jimmy (He/Him/His)" userId="S::james.bowen@cchmc.org::f71083e1-97a1-40d2-8747-448f174445d2" providerId="AD" clId="Web-{299DFB61-213B-9EE4-F289-4D5AD57A0D15}" dt="2023-09-14T16:11:44.678" v="0"/>
          <pc:sldLayoutMkLst>
            <pc:docMk/>
            <pc:sldMasterMk cId="0" sldId="2147483662"/>
            <pc:sldLayoutMk cId="0" sldId="2147483671"/>
          </pc:sldLayoutMkLst>
        </pc:sldLayoutChg>
      </pc:sldMasterChg>
    </pc:docChg>
  </pc:docChgLst>
  <pc:docChgLst>
    <pc:chgData name="Bowen, Jimmy (He/Him/His)" userId="S::james.bowen@cchmc.org::f71083e1-97a1-40d2-8747-448f174445d2" providerId="AD" clId="Web-{CC8A610D-0C91-BAC1-8CF0-71DD84799F2E}"/>
    <pc:docChg chg="modSld">
      <pc:chgData name="Bowen, Jimmy (He/Him/His)" userId="S::james.bowen@cchmc.org::f71083e1-97a1-40d2-8747-448f174445d2" providerId="AD" clId="Web-{CC8A610D-0C91-BAC1-8CF0-71DD84799F2E}" dt="2023-06-30T14:02:14.150" v="1" actId="20577"/>
      <pc:docMkLst>
        <pc:docMk/>
      </pc:docMkLst>
      <pc:sldChg chg="modSp">
        <pc:chgData name="Bowen, Jimmy (He/Him/His)" userId="S::james.bowen@cchmc.org::f71083e1-97a1-40d2-8747-448f174445d2" providerId="AD" clId="Web-{CC8A610D-0C91-BAC1-8CF0-71DD84799F2E}" dt="2023-06-30T14:02:07.994" v="0" actId="20577"/>
        <pc:sldMkLst>
          <pc:docMk/>
          <pc:sldMk cId="0" sldId="256"/>
        </pc:sldMkLst>
        <pc:spChg chg="mod">
          <ac:chgData name="Bowen, Jimmy (He/Him/His)" userId="S::james.bowen@cchmc.org::f71083e1-97a1-40d2-8747-448f174445d2" providerId="AD" clId="Web-{CC8A610D-0C91-BAC1-8CF0-71DD84799F2E}" dt="2023-06-30T14:02:07.994" v="0" actId="20577"/>
          <ac:spMkLst>
            <pc:docMk/>
            <pc:sldMk cId="0" sldId="256"/>
            <ac:spMk id="222" creationId="{00000000-0000-0000-0000-000000000000}"/>
          </ac:spMkLst>
        </pc:spChg>
      </pc:sldChg>
      <pc:sldChg chg="modSp">
        <pc:chgData name="Bowen, Jimmy (He/Him/His)" userId="S::james.bowen@cchmc.org::f71083e1-97a1-40d2-8747-448f174445d2" providerId="AD" clId="Web-{CC8A610D-0C91-BAC1-8CF0-71DD84799F2E}" dt="2023-06-30T14:02:14.150" v="1" actId="20577"/>
        <pc:sldMkLst>
          <pc:docMk/>
          <pc:sldMk cId="0" sldId="258"/>
        </pc:sldMkLst>
        <pc:spChg chg="mod">
          <ac:chgData name="Bowen, Jimmy (He/Him/His)" userId="S::james.bowen@cchmc.org::f71083e1-97a1-40d2-8747-448f174445d2" providerId="AD" clId="Web-{CC8A610D-0C91-BAC1-8CF0-71DD84799F2E}" dt="2023-06-30T14:02:14.150" v="1" actId="20577"/>
          <ac:spMkLst>
            <pc:docMk/>
            <pc:sldMk cId="0" sldId="258"/>
            <ac:spMk id="4" creationId="{FF9567D7-FB74-8FB4-074B-52C5DAA84F4B}"/>
          </ac:spMkLst>
        </pc:spChg>
      </pc:sldChg>
    </pc:docChg>
  </pc:docChgLst>
  <pc:docChgLst>
    <pc:chgData name="Bowen, Jimmy (He/Him/His)" userId="S::james.bowen@cchmc.org::f71083e1-97a1-40d2-8747-448f174445d2" providerId="AD" clId="Web-{0EF5FD8E-1A22-2EA1-7960-B4CAE15F7D38}"/>
    <pc:docChg chg="modSld">
      <pc:chgData name="Bowen, Jimmy (He/Him/His)" userId="S::james.bowen@cchmc.org::f71083e1-97a1-40d2-8747-448f174445d2" providerId="AD" clId="Web-{0EF5FD8E-1A22-2EA1-7960-B4CAE15F7D38}" dt="2024-02-29T15:44:36.322" v="589" actId="20577"/>
      <pc:docMkLst>
        <pc:docMk/>
      </pc:docMkLst>
      <pc:sldChg chg="delSp modSp">
        <pc:chgData name="Bowen, Jimmy (He/Him/His)" userId="S::james.bowen@cchmc.org::f71083e1-97a1-40d2-8747-448f174445d2" providerId="AD" clId="Web-{0EF5FD8E-1A22-2EA1-7960-B4CAE15F7D38}" dt="2024-02-29T15:31:26.500" v="19" actId="1076"/>
        <pc:sldMkLst>
          <pc:docMk/>
          <pc:sldMk cId="0" sldId="256"/>
        </pc:sldMkLst>
        <pc:spChg chg="mod">
          <ac:chgData name="Bowen, Jimmy (He/Him/His)" userId="S::james.bowen@cchmc.org::f71083e1-97a1-40d2-8747-448f174445d2" providerId="AD" clId="Web-{0EF5FD8E-1A22-2EA1-7960-B4CAE15F7D38}" dt="2024-02-29T15:31:26.500" v="19" actId="1076"/>
          <ac:spMkLst>
            <pc:docMk/>
            <pc:sldMk cId="0" sldId="256"/>
            <ac:spMk id="222" creationId="{00000000-0000-0000-0000-000000000000}"/>
          </ac:spMkLst>
        </pc:spChg>
        <pc:grpChg chg="del">
          <ac:chgData name="Bowen, Jimmy (He/Him/His)" userId="S::james.bowen@cchmc.org::f71083e1-97a1-40d2-8747-448f174445d2" providerId="AD" clId="Web-{0EF5FD8E-1A22-2EA1-7960-B4CAE15F7D38}" dt="2024-02-29T15:31:23.469" v="18"/>
          <ac:grpSpMkLst>
            <pc:docMk/>
            <pc:sldMk cId="0" sldId="256"/>
            <ac:grpSpMk id="219" creationId="{00000000-0000-0000-0000-000000000000}"/>
          </ac:grpSpMkLst>
        </pc:grpChg>
      </pc:sldChg>
      <pc:sldChg chg="modSp modNotes">
        <pc:chgData name="Bowen, Jimmy (He/Him/His)" userId="S::james.bowen@cchmc.org::f71083e1-97a1-40d2-8747-448f174445d2" providerId="AD" clId="Web-{0EF5FD8E-1A22-2EA1-7960-B4CAE15F7D38}" dt="2024-02-29T15:43:23.804" v="565"/>
        <pc:sldMkLst>
          <pc:docMk/>
          <pc:sldMk cId="0" sldId="258"/>
        </pc:sldMkLst>
        <pc:spChg chg="mod">
          <ac:chgData name="Bowen, Jimmy (He/Him/His)" userId="S::james.bowen@cchmc.org::f71083e1-97a1-40d2-8747-448f174445d2" providerId="AD" clId="Web-{0EF5FD8E-1A22-2EA1-7960-B4CAE15F7D38}" dt="2024-02-29T15:32:56.534" v="158" actId="20577"/>
          <ac:spMkLst>
            <pc:docMk/>
            <pc:sldMk cId="0" sldId="258"/>
            <ac:spMk id="4" creationId="{FF9567D7-FB74-8FB4-074B-52C5DAA84F4B}"/>
          </ac:spMkLst>
        </pc:spChg>
      </pc:sldChg>
      <pc:sldChg chg="modSp">
        <pc:chgData name="Bowen, Jimmy (He/Him/His)" userId="S::james.bowen@cchmc.org::f71083e1-97a1-40d2-8747-448f174445d2" providerId="AD" clId="Web-{0EF5FD8E-1A22-2EA1-7960-B4CAE15F7D38}" dt="2024-02-29T15:29:02.683" v="1" actId="20577"/>
        <pc:sldMkLst>
          <pc:docMk/>
          <pc:sldMk cId="0" sldId="264"/>
        </pc:sldMkLst>
        <pc:spChg chg="mod">
          <ac:chgData name="Bowen, Jimmy (He/Him/His)" userId="S::james.bowen@cchmc.org::f71083e1-97a1-40d2-8747-448f174445d2" providerId="AD" clId="Web-{0EF5FD8E-1A22-2EA1-7960-B4CAE15F7D38}" dt="2024-02-29T15:29:02.683" v="1" actId="20577"/>
          <ac:spMkLst>
            <pc:docMk/>
            <pc:sldMk cId="0" sldId="264"/>
            <ac:spMk id="307" creationId="{00000000-0000-0000-0000-000000000000}"/>
          </ac:spMkLst>
        </pc:spChg>
      </pc:sldChg>
      <pc:sldChg chg="modSp">
        <pc:chgData name="Bowen, Jimmy (He/Him/His)" userId="S::james.bowen@cchmc.org::f71083e1-97a1-40d2-8747-448f174445d2" providerId="AD" clId="Web-{0EF5FD8E-1A22-2EA1-7960-B4CAE15F7D38}" dt="2024-02-29T15:44:09.868" v="585" actId="20577"/>
        <pc:sldMkLst>
          <pc:docMk/>
          <pc:sldMk cId="0" sldId="270"/>
        </pc:sldMkLst>
        <pc:spChg chg="mod">
          <ac:chgData name="Bowen, Jimmy (He/Him/His)" userId="S::james.bowen@cchmc.org::f71083e1-97a1-40d2-8747-448f174445d2" providerId="AD" clId="Web-{0EF5FD8E-1A22-2EA1-7960-B4CAE15F7D38}" dt="2024-02-29T15:44:09.868" v="585" actId="20577"/>
          <ac:spMkLst>
            <pc:docMk/>
            <pc:sldMk cId="0" sldId="270"/>
            <ac:spMk id="343" creationId="{00000000-0000-0000-0000-000000000000}"/>
          </ac:spMkLst>
        </pc:spChg>
      </pc:sldChg>
      <pc:sldChg chg="modSp">
        <pc:chgData name="Bowen, Jimmy (He/Him/His)" userId="S::james.bowen@cchmc.org::f71083e1-97a1-40d2-8747-448f174445d2" providerId="AD" clId="Web-{0EF5FD8E-1A22-2EA1-7960-B4CAE15F7D38}" dt="2024-02-29T15:44:36.322" v="589" actId="20577"/>
        <pc:sldMkLst>
          <pc:docMk/>
          <pc:sldMk cId="0" sldId="272"/>
        </pc:sldMkLst>
        <pc:spChg chg="mod">
          <ac:chgData name="Bowen, Jimmy (He/Him/His)" userId="S::james.bowen@cchmc.org::f71083e1-97a1-40d2-8747-448f174445d2" providerId="AD" clId="Web-{0EF5FD8E-1A22-2EA1-7960-B4CAE15F7D38}" dt="2024-02-29T15:44:36.322" v="589" actId="20577"/>
          <ac:spMkLst>
            <pc:docMk/>
            <pc:sldMk cId="0" sldId="272"/>
            <ac:spMk id="355" creationId="{00000000-0000-0000-0000-000000000000}"/>
          </ac:spMkLst>
        </pc:spChg>
      </pc:sldChg>
      <pc:sldChg chg="modSp">
        <pc:chgData name="Bowen, Jimmy (He/Him/His)" userId="S::james.bowen@cchmc.org::f71083e1-97a1-40d2-8747-448f174445d2" providerId="AD" clId="Web-{0EF5FD8E-1A22-2EA1-7960-B4CAE15F7D38}" dt="2024-02-29T15:43:34.398" v="574" actId="20577"/>
        <pc:sldMkLst>
          <pc:docMk/>
          <pc:sldMk cId="2016827136" sldId="299"/>
        </pc:sldMkLst>
        <pc:spChg chg="mod">
          <ac:chgData name="Bowen, Jimmy (He/Him/His)" userId="S::james.bowen@cchmc.org::f71083e1-97a1-40d2-8747-448f174445d2" providerId="AD" clId="Web-{0EF5FD8E-1A22-2EA1-7960-B4CAE15F7D38}" dt="2024-02-29T15:43:34.398" v="574" actId="20577"/>
          <ac:spMkLst>
            <pc:docMk/>
            <pc:sldMk cId="2016827136" sldId="299"/>
            <ac:spMk id="2" creationId="{FE7B6990-40BC-4427-BECE-8EE6BF1456DE}"/>
          </ac:spMkLst>
        </pc:spChg>
      </pc:sldChg>
      <pc:sldChg chg="modSp">
        <pc:chgData name="Bowen, Jimmy (He/Him/His)" userId="S::james.bowen@cchmc.org::f71083e1-97a1-40d2-8747-448f174445d2" providerId="AD" clId="Web-{0EF5FD8E-1A22-2EA1-7960-B4CAE15F7D38}" dt="2024-02-29T15:29:20.262" v="3" actId="20577"/>
        <pc:sldMkLst>
          <pc:docMk/>
          <pc:sldMk cId="3666191697" sldId="311"/>
        </pc:sldMkLst>
        <pc:spChg chg="mod">
          <ac:chgData name="Bowen, Jimmy (He/Him/His)" userId="S::james.bowen@cchmc.org::f71083e1-97a1-40d2-8747-448f174445d2" providerId="AD" clId="Web-{0EF5FD8E-1A22-2EA1-7960-B4CAE15F7D38}" dt="2024-02-29T15:29:20.262" v="3" actId="20577"/>
          <ac:spMkLst>
            <pc:docMk/>
            <pc:sldMk cId="3666191697" sldId="311"/>
            <ac:spMk id="2" creationId="{C8AE526A-2240-49E7-94CB-2BE749B44FCB}"/>
          </ac:spMkLst>
        </pc:spChg>
      </pc:sldChg>
      <pc:sldChg chg="modSp">
        <pc:chgData name="Bowen, Jimmy (He/Him/His)" userId="S::james.bowen@cchmc.org::f71083e1-97a1-40d2-8747-448f174445d2" providerId="AD" clId="Web-{0EF5FD8E-1A22-2EA1-7960-B4CAE15F7D38}" dt="2024-02-29T15:44:02.290" v="582" actId="20577"/>
        <pc:sldMkLst>
          <pc:docMk/>
          <pc:sldMk cId="4251026753" sldId="322"/>
        </pc:sldMkLst>
        <pc:spChg chg="mod">
          <ac:chgData name="Bowen, Jimmy (He/Him/His)" userId="S::james.bowen@cchmc.org::f71083e1-97a1-40d2-8747-448f174445d2" providerId="AD" clId="Web-{0EF5FD8E-1A22-2EA1-7960-B4CAE15F7D38}" dt="2024-02-29T15:44:02.290" v="582" actId="20577"/>
          <ac:spMkLst>
            <pc:docMk/>
            <pc:sldMk cId="4251026753" sldId="322"/>
            <ac:spMk id="2" creationId="{00000000-0000-0000-0000-000000000000}"/>
          </ac:spMkLst>
        </pc:spChg>
      </pc:sldChg>
      <pc:sldChg chg="modSp">
        <pc:chgData name="Bowen, Jimmy (He/Him/His)" userId="S::james.bowen@cchmc.org::f71083e1-97a1-40d2-8747-448f174445d2" providerId="AD" clId="Web-{0EF5FD8E-1A22-2EA1-7960-B4CAE15F7D38}" dt="2024-02-29T15:44:23.462" v="587" actId="20577"/>
        <pc:sldMkLst>
          <pc:docMk/>
          <pc:sldMk cId="3684799854" sldId="328"/>
        </pc:sldMkLst>
        <pc:spChg chg="mod">
          <ac:chgData name="Bowen, Jimmy (He/Him/His)" userId="S::james.bowen@cchmc.org::f71083e1-97a1-40d2-8747-448f174445d2" providerId="AD" clId="Web-{0EF5FD8E-1A22-2EA1-7960-B4CAE15F7D38}" dt="2024-02-29T15:44:23.462" v="587" actId="20577"/>
          <ac:spMkLst>
            <pc:docMk/>
            <pc:sldMk cId="3684799854" sldId="328"/>
            <ac:spMk id="2" creationId="{00000000-0000-0000-0000-000000000000}"/>
          </ac:spMkLst>
        </pc:spChg>
      </pc:sldChg>
      <pc:sldChg chg="modSp">
        <pc:chgData name="Bowen, Jimmy (He/Him/His)" userId="S::james.bowen@cchmc.org::f71083e1-97a1-40d2-8747-448f174445d2" providerId="AD" clId="Web-{0EF5FD8E-1A22-2EA1-7960-B4CAE15F7D38}" dt="2024-02-29T15:29:42.325" v="11" actId="20577"/>
        <pc:sldMkLst>
          <pc:docMk/>
          <pc:sldMk cId="3917206402" sldId="329"/>
        </pc:sldMkLst>
        <pc:spChg chg="mod">
          <ac:chgData name="Bowen, Jimmy (He/Him/His)" userId="S::james.bowen@cchmc.org::f71083e1-97a1-40d2-8747-448f174445d2" providerId="AD" clId="Web-{0EF5FD8E-1A22-2EA1-7960-B4CAE15F7D38}" dt="2024-02-29T15:29:42.325" v="11" actId="20577"/>
          <ac:spMkLst>
            <pc:docMk/>
            <pc:sldMk cId="3917206402" sldId="329"/>
            <ac:spMk id="2" creationId="{00000000-0000-0000-0000-000000000000}"/>
          </ac:spMkLst>
        </pc:spChg>
      </pc:sldChg>
      <pc:sldChg chg="modSp">
        <pc:chgData name="Bowen, Jimmy (He/Him/His)" userId="S::james.bowen@cchmc.org::f71083e1-97a1-40d2-8747-448f174445d2" providerId="AD" clId="Web-{0EF5FD8E-1A22-2EA1-7960-B4CAE15F7D38}" dt="2024-02-29T15:29:49.497" v="13" actId="20577"/>
        <pc:sldMkLst>
          <pc:docMk/>
          <pc:sldMk cId="1194644094" sldId="333"/>
        </pc:sldMkLst>
        <pc:spChg chg="mod">
          <ac:chgData name="Bowen, Jimmy (He/Him/His)" userId="S::james.bowen@cchmc.org::f71083e1-97a1-40d2-8747-448f174445d2" providerId="AD" clId="Web-{0EF5FD8E-1A22-2EA1-7960-B4CAE15F7D38}" dt="2024-02-29T15:29:49.497" v="13" actId="20577"/>
          <ac:spMkLst>
            <pc:docMk/>
            <pc:sldMk cId="1194644094" sldId="333"/>
            <ac:spMk id="3" creationId="{00000000-0000-0000-0000-000000000000}"/>
          </ac:spMkLst>
        </pc:spChg>
      </pc:sldChg>
      <pc:sldChg chg="modSp">
        <pc:chgData name="Bowen, Jimmy (He/Him/His)" userId="S::james.bowen@cchmc.org::f71083e1-97a1-40d2-8747-448f174445d2" providerId="AD" clId="Web-{0EF5FD8E-1A22-2EA1-7960-B4CAE15F7D38}" dt="2024-02-29T15:29:58.075" v="15" actId="20577"/>
        <pc:sldMkLst>
          <pc:docMk/>
          <pc:sldMk cId="1793284968" sldId="346"/>
        </pc:sldMkLst>
        <pc:spChg chg="mod">
          <ac:chgData name="Bowen, Jimmy (He/Him/His)" userId="S::james.bowen@cchmc.org::f71083e1-97a1-40d2-8747-448f174445d2" providerId="AD" clId="Web-{0EF5FD8E-1A22-2EA1-7960-B4CAE15F7D38}" dt="2024-02-29T15:29:58.075" v="15" actId="20577"/>
          <ac:spMkLst>
            <pc:docMk/>
            <pc:sldMk cId="1793284968" sldId="346"/>
            <ac:spMk id="367" creationId="{00000000-0000-0000-0000-000000000000}"/>
          </ac:spMkLst>
        </pc:spChg>
      </pc:sldChg>
      <pc:sldChg chg="modSp">
        <pc:chgData name="Bowen, Jimmy (He/Him/His)" userId="S::james.bowen@cchmc.org::f71083e1-97a1-40d2-8747-448f174445d2" providerId="AD" clId="Web-{0EF5FD8E-1A22-2EA1-7960-B4CAE15F7D38}" dt="2024-02-29T15:30:08.326" v="16" actId="20577"/>
        <pc:sldMkLst>
          <pc:docMk/>
          <pc:sldMk cId="1821428307" sldId="350"/>
        </pc:sldMkLst>
        <pc:spChg chg="mod">
          <ac:chgData name="Bowen, Jimmy (He/Him/His)" userId="S::james.bowen@cchmc.org::f71083e1-97a1-40d2-8747-448f174445d2" providerId="AD" clId="Web-{0EF5FD8E-1A22-2EA1-7960-B4CAE15F7D38}" dt="2024-02-29T15:30:08.326" v="16" actId="20577"/>
          <ac:spMkLst>
            <pc:docMk/>
            <pc:sldMk cId="1821428307" sldId="350"/>
            <ac:spMk id="385" creationId="{00000000-0000-0000-0000-000000000000}"/>
          </ac:spMkLst>
        </pc:spChg>
      </pc:sldChg>
    </pc:docChg>
  </pc:docChgLst>
  <pc:docChgLst>
    <pc:chgData name="Bowen, Jimmy (He/Him/His)" userId="S::james.bowen@cchmc.org::f71083e1-97a1-40d2-8747-448f174445d2" providerId="AD" clId="Web-{64801FD5-658D-F69D-9BA4-4DCE644722E8}"/>
    <pc:docChg chg="modSld">
      <pc:chgData name="Bowen, Jimmy (He/Him/His)" userId="S::james.bowen@cchmc.org::f71083e1-97a1-40d2-8747-448f174445d2" providerId="AD" clId="Web-{64801FD5-658D-F69D-9BA4-4DCE644722E8}" dt="2024-02-29T20:43:18.485" v="309"/>
      <pc:docMkLst>
        <pc:docMk/>
      </pc:docMkLst>
      <pc:sldChg chg="modSp">
        <pc:chgData name="Bowen, Jimmy (He/Him/His)" userId="S::james.bowen@cchmc.org::f71083e1-97a1-40d2-8747-448f174445d2" providerId="AD" clId="Web-{64801FD5-658D-F69D-9BA4-4DCE644722E8}" dt="2024-02-29T20:42:14.358" v="134" actId="1076"/>
        <pc:sldMkLst>
          <pc:docMk/>
          <pc:sldMk cId="0" sldId="269"/>
        </pc:sldMkLst>
        <pc:spChg chg="mod">
          <ac:chgData name="Bowen, Jimmy (He/Him/His)" userId="S::james.bowen@cchmc.org::f71083e1-97a1-40d2-8747-448f174445d2" providerId="AD" clId="Web-{64801FD5-658D-F69D-9BA4-4DCE644722E8}" dt="2024-02-29T20:42:14.358" v="134" actId="1076"/>
          <ac:spMkLst>
            <pc:docMk/>
            <pc:sldMk cId="0" sldId="269"/>
            <ac:spMk id="337" creationId="{00000000-0000-0000-0000-000000000000}"/>
          </ac:spMkLst>
        </pc:spChg>
      </pc:sldChg>
      <pc:sldChg chg="modNotes">
        <pc:chgData name="Bowen, Jimmy (He/Him/His)" userId="S::james.bowen@cchmc.org::f71083e1-97a1-40d2-8747-448f174445d2" providerId="AD" clId="Web-{64801FD5-658D-F69D-9BA4-4DCE644722E8}" dt="2024-02-29T20:41:42.544" v="78"/>
        <pc:sldMkLst>
          <pc:docMk/>
          <pc:sldMk cId="3117783798" sldId="309"/>
        </pc:sldMkLst>
      </pc:sldChg>
      <pc:sldChg chg="modNotes">
        <pc:chgData name="Bowen, Jimmy (He/Him/His)" userId="S::james.bowen@cchmc.org::f71083e1-97a1-40d2-8747-448f174445d2" providerId="AD" clId="Web-{64801FD5-658D-F69D-9BA4-4DCE644722E8}" dt="2024-02-29T20:41:54.966" v="129"/>
        <pc:sldMkLst>
          <pc:docMk/>
          <pc:sldMk cId="3666191697" sldId="311"/>
        </pc:sldMkLst>
      </pc:sldChg>
      <pc:sldChg chg="modNotes">
        <pc:chgData name="Bowen, Jimmy (He/Him/His)" userId="S::james.bowen@cchmc.org::f71083e1-97a1-40d2-8747-448f174445d2" providerId="AD" clId="Web-{64801FD5-658D-F69D-9BA4-4DCE644722E8}" dt="2024-02-29T20:43:18.485" v="309"/>
        <pc:sldMkLst>
          <pc:docMk/>
          <pc:sldMk cId="3248733232" sldId="332"/>
        </pc:sldMkLst>
      </pc:sldChg>
    </pc:docChg>
  </pc:docChgLst>
  <pc:docChgLst>
    <pc:chgData name="Bowen, Jimmy (He/Him/His)" userId="f71083e1-97a1-40d2-8747-448f174445d2" providerId="ADAL" clId="{F1C4E1E9-61CD-8B4E-884F-C5A25AFFEAC7}"/>
    <pc:docChg chg="custSel modSld">
      <pc:chgData name="Bowen, Jimmy (He/Him/His)" userId="f71083e1-97a1-40d2-8747-448f174445d2" providerId="ADAL" clId="{F1C4E1E9-61CD-8B4E-884F-C5A25AFFEAC7}" dt="2024-02-29T15:50:01.944" v="297" actId="20577"/>
      <pc:docMkLst>
        <pc:docMk/>
      </pc:docMkLst>
      <pc:sldChg chg="modSp mod">
        <pc:chgData name="Bowen, Jimmy (He/Him/His)" userId="f71083e1-97a1-40d2-8747-448f174445d2" providerId="ADAL" clId="{F1C4E1E9-61CD-8B4E-884F-C5A25AFFEAC7}" dt="2024-02-29T15:45:11.466" v="10" actId="20577"/>
        <pc:sldMkLst>
          <pc:docMk/>
          <pc:sldMk cId="0" sldId="260"/>
        </pc:sldMkLst>
        <pc:spChg chg="mod">
          <ac:chgData name="Bowen, Jimmy (He/Him/His)" userId="f71083e1-97a1-40d2-8747-448f174445d2" providerId="ADAL" clId="{F1C4E1E9-61CD-8B4E-884F-C5A25AFFEAC7}" dt="2024-02-29T15:45:11.466" v="10" actId="20577"/>
          <ac:spMkLst>
            <pc:docMk/>
            <pc:sldMk cId="0" sldId="260"/>
            <ac:spMk id="7" creationId="{10072C17-DD68-4595-A811-196E76134226}"/>
          </ac:spMkLst>
        </pc:spChg>
      </pc:sldChg>
      <pc:sldChg chg="modSp mod">
        <pc:chgData name="Bowen, Jimmy (He/Him/His)" userId="f71083e1-97a1-40d2-8747-448f174445d2" providerId="ADAL" clId="{F1C4E1E9-61CD-8B4E-884F-C5A25AFFEAC7}" dt="2024-02-29T15:46:25.807" v="37" actId="20577"/>
        <pc:sldMkLst>
          <pc:docMk/>
          <pc:sldMk cId="0" sldId="262"/>
        </pc:sldMkLst>
        <pc:spChg chg="mod">
          <ac:chgData name="Bowen, Jimmy (He/Him/His)" userId="f71083e1-97a1-40d2-8747-448f174445d2" providerId="ADAL" clId="{F1C4E1E9-61CD-8B4E-884F-C5A25AFFEAC7}" dt="2024-02-29T15:46:25.807" v="37" actId="20577"/>
          <ac:spMkLst>
            <pc:docMk/>
            <pc:sldMk cId="0" sldId="262"/>
            <ac:spMk id="8" creationId="{48739D61-6958-4220-B910-3D10742963E9}"/>
          </ac:spMkLst>
        </pc:spChg>
      </pc:sldChg>
      <pc:sldChg chg="modSp mod">
        <pc:chgData name="Bowen, Jimmy (He/Him/His)" userId="f71083e1-97a1-40d2-8747-448f174445d2" providerId="ADAL" clId="{F1C4E1E9-61CD-8B4E-884F-C5A25AFFEAC7}" dt="2024-02-29T15:46:44.398" v="74" actId="20577"/>
        <pc:sldMkLst>
          <pc:docMk/>
          <pc:sldMk cId="0" sldId="263"/>
        </pc:sldMkLst>
        <pc:spChg chg="mod">
          <ac:chgData name="Bowen, Jimmy (He/Him/His)" userId="f71083e1-97a1-40d2-8747-448f174445d2" providerId="ADAL" clId="{F1C4E1E9-61CD-8B4E-884F-C5A25AFFEAC7}" dt="2024-02-29T15:46:44.398" v="74" actId="20577"/>
          <ac:spMkLst>
            <pc:docMk/>
            <pc:sldMk cId="0" sldId="263"/>
            <ac:spMk id="4" creationId="{B900F8A2-A3CF-4882-9F6E-A4A4DBACF2DB}"/>
          </ac:spMkLst>
        </pc:spChg>
      </pc:sldChg>
      <pc:sldChg chg="modSp mod">
        <pc:chgData name="Bowen, Jimmy (He/Him/His)" userId="f71083e1-97a1-40d2-8747-448f174445d2" providerId="ADAL" clId="{F1C4E1E9-61CD-8B4E-884F-C5A25AFFEAC7}" dt="2024-02-29T15:47:08.085" v="79" actId="313"/>
        <pc:sldMkLst>
          <pc:docMk/>
          <pc:sldMk cId="0" sldId="267"/>
        </pc:sldMkLst>
        <pc:spChg chg="mod">
          <ac:chgData name="Bowen, Jimmy (He/Him/His)" userId="f71083e1-97a1-40d2-8747-448f174445d2" providerId="ADAL" clId="{F1C4E1E9-61CD-8B4E-884F-C5A25AFFEAC7}" dt="2024-02-29T15:47:08.085" v="79" actId="313"/>
          <ac:spMkLst>
            <pc:docMk/>
            <pc:sldMk cId="0" sldId="267"/>
            <ac:spMk id="325" creationId="{00000000-0000-0000-0000-000000000000}"/>
          </ac:spMkLst>
        </pc:spChg>
      </pc:sldChg>
      <pc:sldChg chg="modSp mod">
        <pc:chgData name="Bowen, Jimmy (He/Him/His)" userId="f71083e1-97a1-40d2-8747-448f174445d2" providerId="ADAL" clId="{F1C4E1E9-61CD-8B4E-884F-C5A25AFFEAC7}" dt="2024-02-29T15:47:27.467" v="87" actId="20577"/>
        <pc:sldMkLst>
          <pc:docMk/>
          <pc:sldMk cId="0" sldId="269"/>
        </pc:sldMkLst>
        <pc:spChg chg="mod">
          <ac:chgData name="Bowen, Jimmy (He/Him/His)" userId="f71083e1-97a1-40d2-8747-448f174445d2" providerId="ADAL" clId="{F1C4E1E9-61CD-8B4E-884F-C5A25AFFEAC7}" dt="2024-02-29T15:47:27.467" v="87" actId="20577"/>
          <ac:spMkLst>
            <pc:docMk/>
            <pc:sldMk cId="0" sldId="269"/>
            <ac:spMk id="337" creationId="{00000000-0000-0000-0000-000000000000}"/>
          </ac:spMkLst>
        </pc:spChg>
      </pc:sldChg>
      <pc:sldChg chg="modSp mod">
        <pc:chgData name="Bowen, Jimmy (He/Him/His)" userId="f71083e1-97a1-40d2-8747-448f174445d2" providerId="ADAL" clId="{F1C4E1E9-61CD-8B4E-884F-C5A25AFFEAC7}" dt="2024-02-29T15:48:45.505" v="153" actId="20577"/>
        <pc:sldMkLst>
          <pc:docMk/>
          <pc:sldMk cId="0" sldId="273"/>
        </pc:sldMkLst>
        <pc:spChg chg="mod">
          <ac:chgData name="Bowen, Jimmy (He/Him/His)" userId="f71083e1-97a1-40d2-8747-448f174445d2" providerId="ADAL" clId="{F1C4E1E9-61CD-8B4E-884F-C5A25AFFEAC7}" dt="2024-02-29T15:48:45.505" v="153" actId="20577"/>
          <ac:spMkLst>
            <pc:docMk/>
            <pc:sldMk cId="0" sldId="273"/>
            <ac:spMk id="361" creationId="{00000000-0000-0000-0000-000000000000}"/>
          </ac:spMkLst>
        </pc:spChg>
      </pc:sldChg>
      <pc:sldChg chg="modSp mod">
        <pc:chgData name="Bowen, Jimmy (He/Him/His)" userId="f71083e1-97a1-40d2-8747-448f174445d2" providerId="ADAL" clId="{F1C4E1E9-61CD-8B4E-884F-C5A25AFFEAC7}" dt="2024-02-29T15:49:33.564" v="276" actId="20577"/>
        <pc:sldMkLst>
          <pc:docMk/>
          <pc:sldMk cId="0" sldId="274"/>
        </pc:sldMkLst>
        <pc:spChg chg="mod">
          <ac:chgData name="Bowen, Jimmy (He/Him/His)" userId="f71083e1-97a1-40d2-8747-448f174445d2" providerId="ADAL" clId="{F1C4E1E9-61CD-8B4E-884F-C5A25AFFEAC7}" dt="2024-02-29T15:49:33.564" v="276" actId="20577"/>
          <ac:spMkLst>
            <pc:docMk/>
            <pc:sldMk cId="0" sldId="274"/>
            <ac:spMk id="367" creationId="{00000000-0000-0000-0000-000000000000}"/>
          </ac:spMkLst>
        </pc:spChg>
      </pc:sldChg>
      <pc:sldChg chg="modSp mod">
        <pc:chgData name="Bowen, Jimmy (He/Him/His)" userId="f71083e1-97a1-40d2-8747-448f174445d2" providerId="ADAL" clId="{F1C4E1E9-61CD-8B4E-884F-C5A25AFFEAC7}" dt="2024-02-29T15:49:51.178" v="278" actId="20577"/>
        <pc:sldMkLst>
          <pc:docMk/>
          <pc:sldMk cId="0" sldId="277"/>
        </pc:sldMkLst>
        <pc:spChg chg="mod">
          <ac:chgData name="Bowen, Jimmy (He/Him/His)" userId="f71083e1-97a1-40d2-8747-448f174445d2" providerId="ADAL" clId="{F1C4E1E9-61CD-8B4E-884F-C5A25AFFEAC7}" dt="2024-02-29T15:49:51.178" v="278" actId="20577"/>
          <ac:spMkLst>
            <pc:docMk/>
            <pc:sldMk cId="0" sldId="277"/>
            <ac:spMk id="385" creationId="{00000000-0000-0000-0000-000000000000}"/>
          </ac:spMkLst>
        </pc:spChg>
      </pc:sldChg>
      <pc:sldChg chg="modSp mod">
        <pc:chgData name="Bowen, Jimmy (He/Him/His)" userId="f71083e1-97a1-40d2-8747-448f174445d2" providerId="ADAL" clId="{F1C4E1E9-61CD-8B4E-884F-C5A25AFFEAC7}" dt="2024-02-29T15:45:26.534" v="33" actId="404"/>
        <pc:sldMkLst>
          <pc:docMk/>
          <pc:sldMk cId="2016827136" sldId="299"/>
        </pc:sldMkLst>
        <pc:spChg chg="mod">
          <ac:chgData name="Bowen, Jimmy (He/Him/His)" userId="f71083e1-97a1-40d2-8747-448f174445d2" providerId="ADAL" clId="{F1C4E1E9-61CD-8B4E-884F-C5A25AFFEAC7}" dt="2024-02-29T15:45:26.534" v="33" actId="404"/>
          <ac:spMkLst>
            <pc:docMk/>
            <pc:sldMk cId="2016827136" sldId="299"/>
            <ac:spMk id="2" creationId="{FE7B6990-40BC-4427-BECE-8EE6BF1456DE}"/>
          </ac:spMkLst>
        </pc:spChg>
      </pc:sldChg>
      <pc:sldChg chg="modSp mod">
        <pc:chgData name="Bowen, Jimmy (He/Him/His)" userId="f71083e1-97a1-40d2-8747-448f174445d2" providerId="ADAL" clId="{F1C4E1E9-61CD-8B4E-884F-C5A25AFFEAC7}" dt="2024-02-29T15:46:38.219" v="70" actId="20577"/>
        <pc:sldMkLst>
          <pc:docMk/>
          <pc:sldMk cId="3984489899" sldId="301"/>
        </pc:sldMkLst>
        <pc:spChg chg="mod">
          <ac:chgData name="Bowen, Jimmy (He/Him/His)" userId="f71083e1-97a1-40d2-8747-448f174445d2" providerId="ADAL" clId="{F1C4E1E9-61CD-8B4E-884F-C5A25AFFEAC7}" dt="2024-02-29T15:46:38.219" v="70" actId="20577"/>
          <ac:spMkLst>
            <pc:docMk/>
            <pc:sldMk cId="3984489899" sldId="301"/>
            <ac:spMk id="5" creationId="{3144D86E-A0AE-4AD5-982A-A95306848F2B}"/>
          </ac:spMkLst>
        </pc:spChg>
      </pc:sldChg>
      <pc:sldChg chg="modSp mod">
        <pc:chgData name="Bowen, Jimmy (He/Him/His)" userId="f71083e1-97a1-40d2-8747-448f174445d2" providerId="ADAL" clId="{F1C4E1E9-61CD-8B4E-884F-C5A25AFFEAC7}" dt="2024-02-29T15:47:34.393" v="90" actId="404"/>
        <pc:sldMkLst>
          <pc:docMk/>
          <pc:sldMk cId="4251026753" sldId="322"/>
        </pc:sldMkLst>
        <pc:spChg chg="mod">
          <ac:chgData name="Bowen, Jimmy (He/Him/His)" userId="f71083e1-97a1-40d2-8747-448f174445d2" providerId="ADAL" clId="{F1C4E1E9-61CD-8B4E-884F-C5A25AFFEAC7}" dt="2024-02-29T15:47:34.393" v="90" actId="404"/>
          <ac:spMkLst>
            <pc:docMk/>
            <pc:sldMk cId="4251026753" sldId="322"/>
            <ac:spMk id="2" creationId="{00000000-0000-0000-0000-000000000000}"/>
          </ac:spMkLst>
        </pc:spChg>
      </pc:sldChg>
      <pc:sldChg chg="modSp mod">
        <pc:chgData name="Bowen, Jimmy (He/Him/His)" userId="f71083e1-97a1-40d2-8747-448f174445d2" providerId="ADAL" clId="{F1C4E1E9-61CD-8B4E-884F-C5A25AFFEAC7}" dt="2024-02-29T15:47:51.352" v="118" actId="20577"/>
        <pc:sldMkLst>
          <pc:docMk/>
          <pc:sldMk cId="2064287918" sldId="323"/>
        </pc:sldMkLst>
        <pc:spChg chg="mod">
          <ac:chgData name="Bowen, Jimmy (He/Him/His)" userId="f71083e1-97a1-40d2-8747-448f174445d2" providerId="ADAL" clId="{F1C4E1E9-61CD-8B4E-884F-C5A25AFFEAC7}" dt="2024-02-29T15:47:51.352" v="118" actId="20577"/>
          <ac:spMkLst>
            <pc:docMk/>
            <pc:sldMk cId="2064287918" sldId="323"/>
            <ac:spMk id="2" creationId="{00000000-0000-0000-0000-000000000000}"/>
          </ac:spMkLst>
        </pc:spChg>
      </pc:sldChg>
      <pc:sldChg chg="modSp mod">
        <pc:chgData name="Bowen, Jimmy (He/Him/His)" userId="f71083e1-97a1-40d2-8747-448f174445d2" providerId="ADAL" clId="{F1C4E1E9-61CD-8B4E-884F-C5A25AFFEAC7}" dt="2024-02-29T15:49:03.554" v="226" actId="20577"/>
        <pc:sldMkLst>
          <pc:docMk/>
          <pc:sldMk cId="3248733232" sldId="332"/>
        </pc:sldMkLst>
        <pc:spChg chg="mod">
          <ac:chgData name="Bowen, Jimmy (He/Him/His)" userId="f71083e1-97a1-40d2-8747-448f174445d2" providerId="ADAL" clId="{F1C4E1E9-61CD-8B4E-884F-C5A25AFFEAC7}" dt="2024-02-29T15:49:03.554" v="226" actId="20577"/>
          <ac:spMkLst>
            <pc:docMk/>
            <pc:sldMk cId="3248733232" sldId="332"/>
            <ac:spMk id="2" creationId="{00000000-0000-0000-0000-000000000000}"/>
          </ac:spMkLst>
        </pc:spChg>
      </pc:sldChg>
      <pc:sldChg chg="modSp mod">
        <pc:chgData name="Bowen, Jimmy (He/Him/His)" userId="f71083e1-97a1-40d2-8747-448f174445d2" providerId="ADAL" clId="{F1C4E1E9-61CD-8B4E-884F-C5A25AFFEAC7}" dt="2024-02-29T15:49:24.347" v="275" actId="20577"/>
        <pc:sldMkLst>
          <pc:docMk/>
          <pc:sldMk cId="2212207395" sldId="334"/>
        </pc:sldMkLst>
        <pc:spChg chg="mod">
          <ac:chgData name="Bowen, Jimmy (He/Him/His)" userId="f71083e1-97a1-40d2-8747-448f174445d2" providerId="ADAL" clId="{F1C4E1E9-61CD-8B4E-884F-C5A25AFFEAC7}" dt="2024-02-29T15:49:24.347" v="275" actId="20577"/>
          <ac:spMkLst>
            <pc:docMk/>
            <pc:sldMk cId="2212207395" sldId="334"/>
            <ac:spMk id="2" creationId="{00000000-0000-0000-0000-000000000000}"/>
          </ac:spMkLst>
        </pc:spChg>
      </pc:sldChg>
      <pc:sldChg chg="modSp mod">
        <pc:chgData name="Bowen, Jimmy (He/Him/His)" userId="f71083e1-97a1-40d2-8747-448f174445d2" providerId="ADAL" clId="{F1C4E1E9-61CD-8B4E-884F-C5A25AFFEAC7}" dt="2024-02-29T15:50:01.944" v="297" actId="20577"/>
        <pc:sldMkLst>
          <pc:docMk/>
          <pc:sldMk cId="849508341" sldId="351"/>
        </pc:sldMkLst>
        <pc:spChg chg="mod">
          <ac:chgData name="Bowen, Jimmy (He/Him/His)" userId="f71083e1-97a1-40d2-8747-448f174445d2" providerId="ADAL" clId="{F1C4E1E9-61CD-8B4E-884F-C5A25AFFEAC7}" dt="2024-02-29T15:50:01.944" v="297" actId="20577"/>
          <ac:spMkLst>
            <pc:docMk/>
            <pc:sldMk cId="849508341" sldId="351"/>
            <ac:spMk id="4" creationId="{D5847CC6-7F94-3C5C-89B0-B0B7BF8CD5A8}"/>
          </ac:spMkLst>
        </pc:spChg>
      </pc:sldChg>
    </pc:docChg>
  </pc:docChgLst>
</pc:chgInfo>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065593D5-CB39-EE4E-81CE-E6F4051255CD}" type="doc">
      <dgm:prSet loTypeId="urn:microsoft.com/office/officeart/2005/8/layout/list1" loCatId="" qsTypeId="urn:microsoft.com/office/officeart/2005/8/quickstyle/simple1" qsCatId="simple" csTypeId="urn:microsoft.com/office/officeart/2005/8/colors/accent1_2" csCatId="accent1" phldr="1"/>
      <dgm:spPr/>
      <dgm:t>
        <a:bodyPr/>
        <a:lstStyle/>
        <a:p>
          <a:endParaRPr lang="en-US"/>
        </a:p>
      </dgm:t>
    </dgm:pt>
    <dgm:pt modelId="{753D38C4-5C28-7440-A04F-F38CD59A76C1}">
      <dgm:prSet phldrT="[Text]"/>
      <dgm:spPr/>
      <dgm:t>
        <a:bodyPr/>
        <a:lstStyle/>
        <a:p>
          <a:r>
            <a:rPr lang="en-US"/>
            <a:t>Historical Features</a:t>
          </a:r>
        </a:p>
      </dgm:t>
    </dgm:pt>
    <dgm:pt modelId="{C57EC333-2F76-EE4F-B351-9307651F9B75}" type="parTrans" cxnId="{4857C6C6-32B0-FC4C-9309-E576ACFA3C57}">
      <dgm:prSet/>
      <dgm:spPr/>
      <dgm:t>
        <a:bodyPr/>
        <a:lstStyle/>
        <a:p>
          <a:endParaRPr lang="en-US"/>
        </a:p>
      </dgm:t>
    </dgm:pt>
    <dgm:pt modelId="{0148F493-A722-C340-B3C1-6583AF8BC2AB}" type="sibTrans" cxnId="{4857C6C6-32B0-FC4C-9309-E576ACFA3C57}">
      <dgm:prSet/>
      <dgm:spPr/>
      <dgm:t>
        <a:bodyPr/>
        <a:lstStyle/>
        <a:p>
          <a:endParaRPr lang="en-US"/>
        </a:p>
      </dgm:t>
    </dgm:pt>
    <dgm:pt modelId="{2B358ABC-6771-FC4D-8DBD-E44611D35F75}">
      <dgm:prSet phldrT="[Text]"/>
      <dgm:spPr/>
      <dgm:t>
        <a:bodyPr/>
        <a:lstStyle/>
        <a:p>
          <a:r>
            <a:rPr lang="en-US"/>
            <a:t>Medical History</a:t>
          </a:r>
        </a:p>
      </dgm:t>
    </dgm:pt>
    <dgm:pt modelId="{416111DF-BA11-AC4F-871E-3D2CCB5D29A6}" type="parTrans" cxnId="{95B7DF20-8352-E74A-AC86-C2E502A54171}">
      <dgm:prSet/>
      <dgm:spPr/>
      <dgm:t>
        <a:bodyPr/>
        <a:lstStyle/>
        <a:p>
          <a:endParaRPr lang="en-US"/>
        </a:p>
      </dgm:t>
    </dgm:pt>
    <dgm:pt modelId="{D17EE93B-9C5A-6C4B-8EF9-08882571C3AB}" type="sibTrans" cxnId="{95B7DF20-8352-E74A-AC86-C2E502A54171}">
      <dgm:prSet/>
      <dgm:spPr/>
      <dgm:t>
        <a:bodyPr/>
        <a:lstStyle/>
        <a:p>
          <a:endParaRPr lang="en-US"/>
        </a:p>
      </dgm:t>
    </dgm:pt>
    <dgm:pt modelId="{5224AC12-035A-3A46-8D67-87A6B3741943}">
      <dgm:prSet phldrT="[Text]"/>
      <dgm:spPr/>
      <dgm:t>
        <a:bodyPr/>
        <a:lstStyle/>
        <a:p>
          <a:r>
            <a:rPr lang="en-US"/>
            <a:t>Family History</a:t>
          </a:r>
        </a:p>
      </dgm:t>
    </dgm:pt>
    <dgm:pt modelId="{7B11615C-F282-7647-A168-F2B5DEBBE201}" type="parTrans" cxnId="{784C8359-7A94-7741-967D-518F741059DB}">
      <dgm:prSet/>
      <dgm:spPr/>
      <dgm:t>
        <a:bodyPr/>
        <a:lstStyle/>
        <a:p>
          <a:endParaRPr lang="en-US"/>
        </a:p>
      </dgm:t>
    </dgm:pt>
    <dgm:pt modelId="{CBCFF7F1-C9B0-8C49-ADBB-FDFB8F2636AF}" type="sibTrans" cxnId="{784C8359-7A94-7741-967D-518F741059DB}">
      <dgm:prSet/>
      <dgm:spPr/>
      <dgm:t>
        <a:bodyPr/>
        <a:lstStyle/>
        <a:p>
          <a:endParaRPr lang="en-US"/>
        </a:p>
      </dgm:t>
    </dgm:pt>
    <dgm:pt modelId="{6FBC972D-22C9-0743-B338-CD58DE994851}">
      <dgm:prSet/>
      <dgm:spPr/>
      <dgm:t>
        <a:bodyPr/>
        <a:lstStyle/>
        <a:p>
          <a:r>
            <a:rPr lang="en-US"/>
            <a:t>Pain with exertion</a:t>
          </a:r>
        </a:p>
      </dgm:t>
    </dgm:pt>
    <dgm:pt modelId="{4553F766-018B-AE4B-98DD-135B9F069622}" type="parTrans" cxnId="{67648FFD-0FB2-CB4B-81E9-376875D7869B}">
      <dgm:prSet/>
      <dgm:spPr/>
      <dgm:t>
        <a:bodyPr/>
        <a:lstStyle/>
        <a:p>
          <a:endParaRPr lang="en-US"/>
        </a:p>
      </dgm:t>
    </dgm:pt>
    <dgm:pt modelId="{3A109926-8FB7-F943-8EE4-07C358BF3A9D}" type="sibTrans" cxnId="{67648FFD-0FB2-CB4B-81E9-376875D7869B}">
      <dgm:prSet/>
      <dgm:spPr/>
      <dgm:t>
        <a:bodyPr/>
        <a:lstStyle/>
        <a:p>
          <a:endParaRPr lang="en-US"/>
        </a:p>
      </dgm:t>
    </dgm:pt>
    <dgm:pt modelId="{88251638-6DF9-3044-AD64-31CEA6D32599}">
      <dgm:prSet/>
      <dgm:spPr/>
      <dgm:t>
        <a:bodyPr/>
        <a:lstStyle/>
        <a:p>
          <a:r>
            <a:rPr lang="en-US"/>
            <a:t>Exertional syncope</a:t>
          </a:r>
        </a:p>
      </dgm:t>
    </dgm:pt>
    <dgm:pt modelId="{7DF44A86-C2C4-6E4E-A8C5-D236ED5B371B}" type="parTrans" cxnId="{2C0AB877-FA45-2E4F-ADF2-969590913705}">
      <dgm:prSet/>
      <dgm:spPr/>
      <dgm:t>
        <a:bodyPr/>
        <a:lstStyle/>
        <a:p>
          <a:endParaRPr lang="en-US"/>
        </a:p>
      </dgm:t>
    </dgm:pt>
    <dgm:pt modelId="{660C4ADE-C8CA-9349-AA93-004C4D293725}" type="sibTrans" cxnId="{2C0AB877-FA45-2E4F-ADF2-969590913705}">
      <dgm:prSet/>
      <dgm:spPr/>
      <dgm:t>
        <a:bodyPr/>
        <a:lstStyle/>
        <a:p>
          <a:endParaRPr lang="en-US"/>
        </a:p>
      </dgm:t>
    </dgm:pt>
    <dgm:pt modelId="{72C67C60-C544-6544-A979-8070EFD62F87}">
      <dgm:prSet/>
      <dgm:spPr/>
      <dgm:t>
        <a:bodyPr/>
        <a:lstStyle/>
        <a:p>
          <a:r>
            <a:rPr lang="en-US"/>
            <a:t>Prolonged immobilization</a:t>
          </a:r>
        </a:p>
      </dgm:t>
    </dgm:pt>
    <dgm:pt modelId="{784A944E-6960-2844-969E-D2AD880D02AD}" type="parTrans" cxnId="{7D87015F-BCAA-354B-98CA-C4EF2943E838}">
      <dgm:prSet/>
      <dgm:spPr/>
      <dgm:t>
        <a:bodyPr/>
        <a:lstStyle/>
        <a:p>
          <a:endParaRPr lang="en-US"/>
        </a:p>
      </dgm:t>
    </dgm:pt>
    <dgm:pt modelId="{B50CE9A2-0571-D54E-A449-B8EBDE0F35A7}" type="sibTrans" cxnId="{7D87015F-BCAA-354B-98CA-C4EF2943E838}">
      <dgm:prSet/>
      <dgm:spPr/>
      <dgm:t>
        <a:bodyPr/>
        <a:lstStyle/>
        <a:p>
          <a:endParaRPr lang="en-US"/>
        </a:p>
      </dgm:t>
    </dgm:pt>
    <dgm:pt modelId="{2BF9C159-1672-474B-8D50-21F61CD18ED4}">
      <dgm:prSet/>
      <dgm:spPr/>
      <dgm:t>
        <a:bodyPr/>
        <a:lstStyle/>
        <a:p>
          <a:r>
            <a:rPr lang="en-US"/>
            <a:t>Sudden unexplained death (e.g., drownings, solo automobile accidents)</a:t>
          </a:r>
        </a:p>
      </dgm:t>
    </dgm:pt>
    <dgm:pt modelId="{CEFAA710-68B7-0549-A7C3-CE6814F85223}" type="parTrans" cxnId="{9A25DA3E-AAD9-2E49-806D-7305AA86F9B7}">
      <dgm:prSet/>
      <dgm:spPr/>
      <dgm:t>
        <a:bodyPr/>
        <a:lstStyle/>
        <a:p>
          <a:endParaRPr lang="en-US"/>
        </a:p>
      </dgm:t>
    </dgm:pt>
    <dgm:pt modelId="{50BB987E-465D-1245-9CE4-7497A5374312}" type="sibTrans" cxnId="{9A25DA3E-AAD9-2E49-806D-7305AA86F9B7}">
      <dgm:prSet/>
      <dgm:spPr/>
      <dgm:t>
        <a:bodyPr/>
        <a:lstStyle/>
        <a:p>
          <a:endParaRPr lang="en-US"/>
        </a:p>
      </dgm:t>
    </dgm:pt>
    <dgm:pt modelId="{215C7B51-9396-114B-A699-AF11CD6DDAA5}">
      <dgm:prSet/>
      <dgm:spPr/>
      <dgm:t>
        <a:bodyPr/>
        <a:lstStyle/>
        <a:p>
          <a:r>
            <a:rPr lang="en-US"/>
            <a:t>Cardiomyopathy</a:t>
          </a:r>
        </a:p>
      </dgm:t>
    </dgm:pt>
    <dgm:pt modelId="{EDA7A569-98E7-A64B-8584-504679AC4727}" type="parTrans" cxnId="{18324C22-5202-5C4D-B0E9-6404C7AE36C5}">
      <dgm:prSet/>
      <dgm:spPr/>
      <dgm:t>
        <a:bodyPr/>
        <a:lstStyle/>
        <a:p>
          <a:endParaRPr lang="en-US"/>
        </a:p>
      </dgm:t>
    </dgm:pt>
    <dgm:pt modelId="{58077352-BAD0-434F-84D5-9C46F6A51300}" type="sibTrans" cxnId="{18324C22-5202-5C4D-B0E9-6404C7AE36C5}">
      <dgm:prSet/>
      <dgm:spPr/>
      <dgm:t>
        <a:bodyPr/>
        <a:lstStyle/>
        <a:p>
          <a:endParaRPr lang="en-US"/>
        </a:p>
      </dgm:t>
    </dgm:pt>
    <dgm:pt modelId="{8AE6C0F6-0DC8-C84E-89A5-0526B5C08E25}">
      <dgm:prSet/>
      <dgm:spPr/>
      <dgm:t>
        <a:bodyPr/>
        <a:lstStyle/>
        <a:p>
          <a:r>
            <a:rPr lang="en-US"/>
            <a:t>Physical Examination</a:t>
          </a:r>
        </a:p>
      </dgm:t>
    </dgm:pt>
    <dgm:pt modelId="{A5C58C9A-C7A0-254C-80B4-9243C2A30362}" type="parTrans" cxnId="{DD03C186-B92A-A744-B817-52986D408B68}">
      <dgm:prSet/>
      <dgm:spPr/>
      <dgm:t>
        <a:bodyPr/>
        <a:lstStyle/>
        <a:p>
          <a:endParaRPr lang="en-US"/>
        </a:p>
      </dgm:t>
    </dgm:pt>
    <dgm:pt modelId="{1AA148AB-D92E-8543-B942-26D166A26E51}" type="sibTrans" cxnId="{DD03C186-B92A-A744-B817-52986D408B68}">
      <dgm:prSet/>
      <dgm:spPr/>
      <dgm:t>
        <a:bodyPr/>
        <a:lstStyle/>
        <a:p>
          <a:endParaRPr lang="en-US"/>
        </a:p>
      </dgm:t>
    </dgm:pt>
    <dgm:pt modelId="{10E9198D-1602-B240-87B1-3B043ACA2F89}">
      <dgm:prSet/>
      <dgm:spPr/>
      <dgm:t>
        <a:bodyPr/>
        <a:lstStyle/>
        <a:p>
          <a:r>
            <a:rPr lang="en-US"/>
            <a:t>Fever</a:t>
          </a:r>
        </a:p>
      </dgm:t>
    </dgm:pt>
    <dgm:pt modelId="{71D72F51-10D0-8C4A-ABE1-AE6108092D04}" type="parTrans" cxnId="{C645A3F8-B5C9-9347-AC0D-DFF13CEA1316}">
      <dgm:prSet/>
      <dgm:spPr/>
      <dgm:t>
        <a:bodyPr/>
        <a:lstStyle/>
        <a:p>
          <a:endParaRPr lang="en-US"/>
        </a:p>
      </dgm:t>
    </dgm:pt>
    <dgm:pt modelId="{57CA1E85-3266-7242-AAE0-89F50D59713A}" type="sibTrans" cxnId="{C645A3F8-B5C9-9347-AC0D-DFF13CEA1316}">
      <dgm:prSet/>
      <dgm:spPr/>
      <dgm:t>
        <a:bodyPr/>
        <a:lstStyle/>
        <a:p>
          <a:endParaRPr lang="en-US"/>
        </a:p>
      </dgm:t>
    </dgm:pt>
    <dgm:pt modelId="{74F7C97F-289C-E941-B11B-D8EDB9A6958A}">
      <dgm:prSet/>
      <dgm:spPr/>
      <dgm:t>
        <a:bodyPr/>
        <a:lstStyle/>
        <a:p>
          <a:r>
            <a:rPr lang="en-US"/>
            <a:t>Tachypnea</a:t>
          </a:r>
        </a:p>
      </dgm:t>
    </dgm:pt>
    <dgm:pt modelId="{338FDA69-3DF7-BE43-B8AC-3FD6DE2EF786}" type="parTrans" cxnId="{48614640-D2C8-A747-9A54-6319EB278823}">
      <dgm:prSet/>
      <dgm:spPr/>
      <dgm:t>
        <a:bodyPr/>
        <a:lstStyle/>
        <a:p>
          <a:endParaRPr lang="en-US"/>
        </a:p>
      </dgm:t>
    </dgm:pt>
    <dgm:pt modelId="{D1DAE20B-518B-AE43-806D-C354F08C0683}" type="sibTrans" cxnId="{48614640-D2C8-A747-9A54-6319EB278823}">
      <dgm:prSet/>
      <dgm:spPr/>
      <dgm:t>
        <a:bodyPr/>
        <a:lstStyle/>
        <a:p>
          <a:endParaRPr lang="en-US"/>
        </a:p>
      </dgm:t>
    </dgm:pt>
    <dgm:pt modelId="{FE250EF6-8B5A-C24F-AB2D-A4399D3FBA0C}">
      <dgm:prSet/>
      <dgm:spPr/>
      <dgm:t>
        <a:bodyPr/>
        <a:lstStyle/>
        <a:p>
          <a:r>
            <a:rPr lang="en-US"/>
            <a:t>Painful extremities</a:t>
          </a:r>
        </a:p>
      </dgm:t>
    </dgm:pt>
    <dgm:pt modelId="{769414A5-C3D4-6346-AB32-29B4595FEB9D}" type="parTrans" cxnId="{2A737665-552E-5540-BB37-8BA5EEC3DD93}">
      <dgm:prSet/>
      <dgm:spPr/>
      <dgm:t>
        <a:bodyPr/>
        <a:lstStyle/>
        <a:p>
          <a:endParaRPr lang="en-US"/>
        </a:p>
      </dgm:t>
    </dgm:pt>
    <dgm:pt modelId="{0A253D2D-EADB-5F4A-827A-7C1B19A7ECF2}" type="sibTrans" cxnId="{2A737665-552E-5540-BB37-8BA5EEC3DD93}">
      <dgm:prSet/>
      <dgm:spPr/>
      <dgm:t>
        <a:bodyPr/>
        <a:lstStyle/>
        <a:p>
          <a:endParaRPr lang="en-US"/>
        </a:p>
      </dgm:t>
    </dgm:pt>
    <dgm:pt modelId="{D7CA427C-05BC-4740-BE09-D7FB64B46DF8}">
      <dgm:prSet/>
      <dgm:spPr/>
      <dgm:t>
        <a:bodyPr/>
        <a:lstStyle/>
        <a:p>
          <a:r>
            <a:rPr lang="en-US"/>
            <a:t>Beck's Triad (distant heart sounds, distended jugular vein, hypotension). </a:t>
          </a:r>
        </a:p>
      </dgm:t>
    </dgm:pt>
    <dgm:pt modelId="{0D192824-BF6A-C741-9D4B-B2169BC79914}" type="parTrans" cxnId="{BEBE9B50-87F9-7740-B08B-2EB0CFB1E159}">
      <dgm:prSet/>
      <dgm:spPr/>
      <dgm:t>
        <a:bodyPr/>
        <a:lstStyle/>
        <a:p>
          <a:endParaRPr lang="en-US"/>
        </a:p>
      </dgm:t>
    </dgm:pt>
    <dgm:pt modelId="{D9704313-342F-394B-8726-120400D44730}" type="sibTrans" cxnId="{BEBE9B50-87F9-7740-B08B-2EB0CFB1E159}">
      <dgm:prSet/>
      <dgm:spPr/>
      <dgm:t>
        <a:bodyPr/>
        <a:lstStyle/>
        <a:p>
          <a:endParaRPr lang="en-US"/>
        </a:p>
      </dgm:t>
    </dgm:pt>
    <dgm:pt modelId="{00B96B96-109B-4645-80EE-09F4DB3DBD86}" type="pres">
      <dgm:prSet presAssocID="{065593D5-CB39-EE4E-81CE-E6F4051255CD}" presName="linear" presStyleCnt="0">
        <dgm:presLayoutVars>
          <dgm:dir/>
          <dgm:animLvl val="lvl"/>
          <dgm:resizeHandles val="exact"/>
        </dgm:presLayoutVars>
      </dgm:prSet>
      <dgm:spPr/>
    </dgm:pt>
    <dgm:pt modelId="{DF2ED52A-9DE1-E843-B18A-88DC2144D1B7}" type="pres">
      <dgm:prSet presAssocID="{753D38C4-5C28-7440-A04F-F38CD59A76C1}" presName="parentLin" presStyleCnt="0"/>
      <dgm:spPr/>
    </dgm:pt>
    <dgm:pt modelId="{0684872F-E6D7-2A4E-BC4C-26E8B67980AD}" type="pres">
      <dgm:prSet presAssocID="{753D38C4-5C28-7440-A04F-F38CD59A76C1}" presName="parentLeftMargin" presStyleLbl="node1" presStyleIdx="0" presStyleCnt="4"/>
      <dgm:spPr/>
    </dgm:pt>
    <dgm:pt modelId="{F32DBF2E-C2C9-DE46-9089-580B1E9C9E85}" type="pres">
      <dgm:prSet presAssocID="{753D38C4-5C28-7440-A04F-F38CD59A76C1}" presName="parentText" presStyleLbl="node1" presStyleIdx="0" presStyleCnt="4">
        <dgm:presLayoutVars>
          <dgm:chMax val="0"/>
          <dgm:bulletEnabled val="1"/>
        </dgm:presLayoutVars>
      </dgm:prSet>
      <dgm:spPr/>
    </dgm:pt>
    <dgm:pt modelId="{E4750376-8D57-9E45-99DB-0C5AE8B9885D}" type="pres">
      <dgm:prSet presAssocID="{753D38C4-5C28-7440-A04F-F38CD59A76C1}" presName="negativeSpace" presStyleCnt="0"/>
      <dgm:spPr/>
    </dgm:pt>
    <dgm:pt modelId="{96E1637D-3CEA-8F4D-8FE4-3F89A76FF91E}" type="pres">
      <dgm:prSet presAssocID="{753D38C4-5C28-7440-A04F-F38CD59A76C1}" presName="childText" presStyleLbl="conFgAcc1" presStyleIdx="0" presStyleCnt="4">
        <dgm:presLayoutVars>
          <dgm:bulletEnabled val="1"/>
        </dgm:presLayoutVars>
      </dgm:prSet>
      <dgm:spPr/>
    </dgm:pt>
    <dgm:pt modelId="{D1A39764-E92F-F64E-A9BE-2A5AE7834C98}" type="pres">
      <dgm:prSet presAssocID="{0148F493-A722-C340-B3C1-6583AF8BC2AB}" presName="spaceBetweenRectangles" presStyleCnt="0"/>
      <dgm:spPr/>
    </dgm:pt>
    <dgm:pt modelId="{22FCC2DC-4FA5-304F-9F41-07A616D900A4}" type="pres">
      <dgm:prSet presAssocID="{2B358ABC-6771-FC4D-8DBD-E44611D35F75}" presName="parentLin" presStyleCnt="0"/>
      <dgm:spPr/>
    </dgm:pt>
    <dgm:pt modelId="{19C1B89C-F86F-C743-AD03-46CC36086007}" type="pres">
      <dgm:prSet presAssocID="{2B358ABC-6771-FC4D-8DBD-E44611D35F75}" presName="parentLeftMargin" presStyleLbl="node1" presStyleIdx="0" presStyleCnt="4"/>
      <dgm:spPr/>
    </dgm:pt>
    <dgm:pt modelId="{56910AEB-68F4-7049-99DA-1C409D75FCCC}" type="pres">
      <dgm:prSet presAssocID="{2B358ABC-6771-FC4D-8DBD-E44611D35F75}" presName="parentText" presStyleLbl="node1" presStyleIdx="1" presStyleCnt="4">
        <dgm:presLayoutVars>
          <dgm:chMax val="0"/>
          <dgm:bulletEnabled val="1"/>
        </dgm:presLayoutVars>
      </dgm:prSet>
      <dgm:spPr/>
    </dgm:pt>
    <dgm:pt modelId="{459CF8C2-150B-DD4B-BE07-92E5C687F1D3}" type="pres">
      <dgm:prSet presAssocID="{2B358ABC-6771-FC4D-8DBD-E44611D35F75}" presName="negativeSpace" presStyleCnt="0"/>
      <dgm:spPr/>
    </dgm:pt>
    <dgm:pt modelId="{7AE54AB1-2EE0-3548-B888-28176027BB1E}" type="pres">
      <dgm:prSet presAssocID="{2B358ABC-6771-FC4D-8DBD-E44611D35F75}" presName="childText" presStyleLbl="conFgAcc1" presStyleIdx="1" presStyleCnt="4">
        <dgm:presLayoutVars>
          <dgm:bulletEnabled val="1"/>
        </dgm:presLayoutVars>
      </dgm:prSet>
      <dgm:spPr/>
    </dgm:pt>
    <dgm:pt modelId="{8F870B0B-426F-BE4C-A3CF-E6DCE35998B6}" type="pres">
      <dgm:prSet presAssocID="{D17EE93B-9C5A-6C4B-8EF9-08882571C3AB}" presName="spaceBetweenRectangles" presStyleCnt="0"/>
      <dgm:spPr/>
    </dgm:pt>
    <dgm:pt modelId="{DFAD58D2-A011-CD49-B1E7-04CAA717E9CA}" type="pres">
      <dgm:prSet presAssocID="{5224AC12-035A-3A46-8D67-87A6B3741943}" presName="parentLin" presStyleCnt="0"/>
      <dgm:spPr/>
    </dgm:pt>
    <dgm:pt modelId="{F81754D0-6CF2-DF46-AFAB-86A2C07A5AE0}" type="pres">
      <dgm:prSet presAssocID="{5224AC12-035A-3A46-8D67-87A6B3741943}" presName="parentLeftMargin" presStyleLbl="node1" presStyleIdx="1" presStyleCnt="4"/>
      <dgm:spPr/>
    </dgm:pt>
    <dgm:pt modelId="{87DC13FF-7803-9C48-9B20-BD3D12F55658}" type="pres">
      <dgm:prSet presAssocID="{5224AC12-035A-3A46-8D67-87A6B3741943}" presName="parentText" presStyleLbl="node1" presStyleIdx="2" presStyleCnt="4">
        <dgm:presLayoutVars>
          <dgm:chMax val="0"/>
          <dgm:bulletEnabled val="1"/>
        </dgm:presLayoutVars>
      </dgm:prSet>
      <dgm:spPr/>
    </dgm:pt>
    <dgm:pt modelId="{683D7CC9-5698-5645-9825-349360D407E4}" type="pres">
      <dgm:prSet presAssocID="{5224AC12-035A-3A46-8D67-87A6B3741943}" presName="negativeSpace" presStyleCnt="0"/>
      <dgm:spPr/>
    </dgm:pt>
    <dgm:pt modelId="{8ECF1FBB-C6FF-7D43-A224-BC7D0728D168}" type="pres">
      <dgm:prSet presAssocID="{5224AC12-035A-3A46-8D67-87A6B3741943}" presName="childText" presStyleLbl="conFgAcc1" presStyleIdx="2" presStyleCnt="4">
        <dgm:presLayoutVars>
          <dgm:bulletEnabled val="1"/>
        </dgm:presLayoutVars>
      </dgm:prSet>
      <dgm:spPr/>
    </dgm:pt>
    <dgm:pt modelId="{CB77DBA1-F16B-344F-9811-174105C0AA44}" type="pres">
      <dgm:prSet presAssocID="{CBCFF7F1-C9B0-8C49-ADBB-FDFB8F2636AF}" presName="spaceBetweenRectangles" presStyleCnt="0"/>
      <dgm:spPr/>
    </dgm:pt>
    <dgm:pt modelId="{4B4E93BD-A4E3-7741-A452-553193D30155}" type="pres">
      <dgm:prSet presAssocID="{8AE6C0F6-0DC8-C84E-89A5-0526B5C08E25}" presName="parentLin" presStyleCnt="0"/>
      <dgm:spPr/>
    </dgm:pt>
    <dgm:pt modelId="{161725ED-ED7D-0D49-A66B-D7328E3AFCD4}" type="pres">
      <dgm:prSet presAssocID="{8AE6C0F6-0DC8-C84E-89A5-0526B5C08E25}" presName="parentLeftMargin" presStyleLbl="node1" presStyleIdx="2" presStyleCnt="4"/>
      <dgm:spPr/>
    </dgm:pt>
    <dgm:pt modelId="{CDB6F1AD-1AF6-1B4D-AF61-7FEFBEA7CF1F}" type="pres">
      <dgm:prSet presAssocID="{8AE6C0F6-0DC8-C84E-89A5-0526B5C08E25}" presName="parentText" presStyleLbl="node1" presStyleIdx="3" presStyleCnt="4">
        <dgm:presLayoutVars>
          <dgm:chMax val="0"/>
          <dgm:bulletEnabled val="1"/>
        </dgm:presLayoutVars>
      </dgm:prSet>
      <dgm:spPr/>
    </dgm:pt>
    <dgm:pt modelId="{D826BCA8-2425-FF44-9A94-7C00C1873AC3}" type="pres">
      <dgm:prSet presAssocID="{8AE6C0F6-0DC8-C84E-89A5-0526B5C08E25}" presName="negativeSpace" presStyleCnt="0"/>
      <dgm:spPr/>
    </dgm:pt>
    <dgm:pt modelId="{7739CC37-79FF-394A-A43D-DEE7B0EF2A21}" type="pres">
      <dgm:prSet presAssocID="{8AE6C0F6-0DC8-C84E-89A5-0526B5C08E25}" presName="childText" presStyleLbl="conFgAcc1" presStyleIdx="3" presStyleCnt="4">
        <dgm:presLayoutVars>
          <dgm:bulletEnabled val="1"/>
        </dgm:presLayoutVars>
      </dgm:prSet>
      <dgm:spPr/>
    </dgm:pt>
  </dgm:ptLst>
  <dgm:cxnLst>
    <dgm:cxn modelId="{98800F18-3155-CC40-A77E-A2F8C5630B78}" type="presOf" srcId="{88251638-6DF9-3044-AD64-31CEA6D32599}" destId="{96E1637D-3CEA-8F4D-8FE4-3F89A76FF91E}" srcOrd="0" destOrd="1" presId="urn:microsoft.com/office/officeart/2005/8/layout/list1"/>
    <dgm:cxn modelId="{95B7DF20-8352-E74A-AC86-C2E502A54171}" srcId="{065593D5-CB39-EE4E-81CE-E6F4051255CD}" destId="{2B358ABC-6771-FC4D-8DBD-E44611D35F75}" srcOrd="1" destOrd="0" parTransId="{416111DF-BA11-AC4F-871E-3D2CCB5D29A6}" sibTransId="{D17EE93B-9C5A-6C4B-8EF9-08882571C3AB}"/>
    <dgm:cxn modelId="{18324C22-5202-5C4D-B0E9-6404C7AE36C5}" srcId="{5224AC12-035A-3A46-8D67-87A6B3741943}" destId="{215C7B51-9396-114B-A699-AF11CD6DDAA5}" srcOrd="1" destOrd="0" parTransId="{EDA7A569-98E7-A64B-8584-504679AC4727}" sibTransId="{58077352-BAD0-434F-84D5-9C46F6A51300}"/>
    <dgm:cxn modelId="{9A25DA3E-AAD9-2E49-806D-7305AA86F9B7}" srcId="{5224AC12-035A-3A46-8D67-87A6B3741943}" destId="{2BF9C159-1672-474B-8D50-21F61CD18ED4}" srcOrd="0" destOrd="0" parTransId="{CEFAA710-68B7-0549-A7C3-CE6814F85223}" sibTransId="{50BB987E-465D-1245-9CE4-7497A5374312}"/>
    <dgm:cxn modelId="{48614640-D2C8-A747-9A54-6319EB278823}" srcId="{8AE6C0F6-0DC8-C84E-89A5-0526B5C08E25}" destId="{74F7C97F-289C-E941-B11B-D8EDB9A6958A}" srcOrd="1" destOrd="0" parTransId="{338FDA69-3DF7-BE43-B8AC-3FD6DE2EF786}" sibTransId="{D1DAE20B-518B-AE43-806D-C354F08C0683}"/>
    <dgm:cxn modelId="{1B7D3C5E-D73E-DE42-AFB7-1647D0B1DCC2}" type="presOf" srcId="{2B358ABC-6771-FC4D-8DBD-E44611D35F75}" destId="{19C1B89C-F86F-C743-AD03-46CC36086007}" srcOrd="0" destOrd="0" presId="urn:microsoft.com/office/officeart/2005/8/layout/list1"/>
    <dgm:cxn modelId="{EBDCD55E-BBAC-F245-B2D1-7FCA257A8770}" type="presOf" srcId="{5224AC12-035A-3A46-8D67-87A6B3741943}" destId="{F81754D0-6CF2-DF46-AFAB-86A2C07A5AE0}" srcOrd="0" destOrd="0" presId="urn:microsoft.com/office/officeart/2005/8/layout/list1"/>
    <dgm:cxn modelId="{7D87015F-BCAA-354B-98CA-C4EF2943E838}" srcId="{2B358ABC-6771-FC4D-8DBD-E44611D35F75}" destId="{72C67C60-C544-6544-A979-8070EFD62F87}" srcOrd="0" destOrd="0" parTransId="{784A944E-6960-2844-969E-D2AD880D02AD}" sibTransId="{B50CE9A2-0571-D54E-A449-B8EBDE0F35A7}"/>
    <dgm:cxn modelId="{D925065F-4528-8143-81E7-9291D12E469E}" type="presOf" srcId="{065593D5-CB39-EE4E-81CE-E6F4051255CD}" destId="{00B96B96-109B-4645-80EE-09F4DB3DBD86}" srcOrd="0" destOrd="0" presId="urn:microsoft.com/office/officeart/2005/8/layout/list1"/>
    <dgm:cxn modelId="{4D626044-5C09-9248-A124-BC287BDB36F8}" type="presOf" srcId="{5224AC12-035A-3A46-8D67-87A6B3741943}" destId="{87DC13FF-7803-9C48-9B20-BD3D12F55658}" srcOrd="1" destOrd="0" presId="urn:microsoft.com/office/officeart/2005/8/layout/list1"/>
    <dgm:cxn modelId="{2A737665-552E-5540-BB37-8BA5EEC3DD93}" srcId="{8AE6C0F6-0DC8-C84E-89A5-0526B5C08E25}" destId="{FE250EF6-8B5A-C24F-AB2D-A4399D3FBA0C}" srcOrd="2" destOrd="0" parTransId="{769414A5-C3D4-6346-AB32-29B4595FEB9D}" sibTransId="{0A253D2D-EADB-5F4A-827A-7C1B19A7ECF2}"/>
    <dgm:cxn modelId="{E3B8F24A-77BF-9248-952F-980E3C87C120}" type="presOf" srcId="{10E9198D-1602-B240-87B1-3B043ACA2F89}" destId="{7739CC37-79FF-394A-A43D-DEE7B0EF2A21}" srcOrd="0" destOrd="0" presId="urn:microsoft.com/office/officeart/2005/8/layout/list1"/>
    <dgm:cxn modelId="{82E4084D-A3B6-3D47-8655-CB8EB1F9A97B}" type="presOf" srcId="{753D38C4-5C28-7440-A04F-F38CD59A76C1}" destId="{F32DBF2E-C2C9-DE46-9089-580B1E9C9E85}" srcOrd="1" destOrd="0" presId="urn:microsoft.com/office/officeart/2005/8/layout/list1"/>
    <dgm:cxn modelId="{5D43E64D-6084-094D-AD9A-CB339A6A8CAB}" type="presOf" srcId="{8AE6C0F6-0DC8-C84E-89A5-0526B5C08E25}" destId="{161725ED-ED7D-0D49-A66B-D7328E3AFCD4}" srcOrd="0" destOrd="0" presId="urn:microsoft.com/office/officeart/2005/8/layout/list1"/>
    <dgm:cxn modelId="{FC621D6E-1ED6-0147-A865-6FB54FE5F7E6}" type="presOf" srcId="{FE250EF6-8B5A-C24F-AB2D-A4399D3FBA0C}" destId="{7739CC37-79FF-394A-A43D-DEE7B0EF2A21}" srcOrd="0" destOrd="2" presId="urn:microsoft.com/office/officeart/2005/8/layout/list1"/>
    <dgm:cxn modelId="{BEBE9B50-87F9-7740-B08B-2EB0CFB1E159}" srcId="{8AE6C0F6-0DC8-C84E-89A5-0526B5C08E25}" destId="{D7CA427C-05BC-4740-BE09-D7FB64B46DF8}" srcOrd="3" destOrd="0" parTransId="{0D192824-BF6A-C741-9D4B-B2169BC79914}" sibTransId="{D9704313-342F-394B-8726-120400D44730}"/>
    <dgm:cxn modelId="{2C0AB877-FA45-2E4F-ADF2-969590913705}" srcId="{753D38C4-5C28-7440-A04F-F38CD59A76C1}" destId="{88251638-6DF9-3044-AD64-31CEA6D32599}" srcOrd="1" destOrd="0" parTransId="{7DF44A86-C2C4-6E4E-A8C5-D236ED5B371B}" sibTransId="{660C4ADE-C8CA-9349-AA93-004C4D293725}"/>
    <dgm:cxn modelId="{784C8359-7A94-7741-967D-518F741059DB}" srcId="{065593D5-CB39-EE4E-81CE-E6F4051255CD}" destId="{5224AC12-035A-3A46-8D67-87A6B3741943}" srcOrd="2" destOrd="0" parTransId="{7B11615C-F282-7647-A168-F2B5DEBBE201}" sibTransId="{CBCFF7F1-C9B0-8C49-ADBB-FDFB8F2636AF}"/>
    <dgm:cxn modelId="{2331377D-F7AE-5C4D-A6EE-559A09571BBC}" type="presOf" srcId="{6FBC972D-22C9-0743-B338-CD58DE994851}" destId="{96E1637D-3CEA-8F4D-8FE4-3F89A76FF91E}" srcOrd="0" destOrd="0" presId="urn:microsoft.com/office/officeart/2005/8/layout/list1"/>
    <dgm:cxn modelId="{3F86A085-1D59-8E46-B582-128FD8C60E71}" type="presOf" srcId="{2BF9C159-1672-474B-8D50-21F61CD18ED4}" destId="{8ECF1FBB-C6FF-7D43-A224-BC7D0728D168}" srcOrd="0" destOrd="0" presId="urn:microsoft.com/office/officeart/2005/8/layout/list1"/>
    <dgm:cxn modelId="{DD03C186-B92A-A744-B817-52986D408B68}" srcId="{065593D5-CB39-EE4E-81CE-E6F4051255CD}" destId="{8AE6C0F6-0DC8-C84E-89A5-0526B5C08E25}" srcOrd="3" destOrd="0" parTransId="{A5C58C9A-C7A0-254C-80B4-9243C2A30362}" sibTransId="{1AA148AB-D92E-8543-B942-26D166A26E51}"/>
    <dgm:cxn modelId="{BFFFC297-C279-6D4C-B1FC-1863EB8ACA13}" type="presOf" srcId="{D7CA427C-05BC-4740-BE09-D7FB64B46DF8}" destId="{7739CC37-79FF-394A-A43D-DEE7B0EF2A21}" srcOrd="0" destOrd="3" presId="urn:microsoft.com/office/officeart/2005/8/layout/list1"/>
    <dgm:cxn modelId="{E6D7AE9F-399E-D243-B547-3AAE169D373E}" type="presOf" srcId="{72C67C60-C544-6544-A979-8070EFD62F87}" destId="{7AE54AB1-2EE0-3548-B888-28176027BB1E}" srcOrd="0" destOrd="0" presId="urn:microsoft.com/office/officeart/2005/8/layout/list1"/>
    <dgm:cxn modelId="{9345EDBF-C4B4-894E-9BB7-22677B3C3243}" type="presOf" srcId="{8AE6C0F6-0DC8-C84E-89A5-0526B5C08E25}" destId="{CDB6F1AD-1AF6-1B4D-AF61-7FEFBEA7CF1F}" srcOrd="1" destOrd="0" presId="urn:microsoft.com/office/officeart/2005/8/layout/list1"/>
    <dgm:cxn modelId="{4857C6C6-32B0-FC4C-9309-E576ACFA3C57}" srcId="{065593D5-CB39-EE4E-81CE-E6F4051255CD}" destId="{753D38C4-5C28-7440-A04F-F38CD59A76C1}" srcOrd="0" destOrd="0" parTransId="{C57EC333-2F76-EE4F-B351-9307651F9B75}" sibTransId="{0148F493-A722-C340-B3C1-6583AF8BC2AB}"/>
    <dgm:cxn modelId="{DF40DAD2-435F-DF4A-BE7D-A42448C31FA5}" type="presOf" srcId="{74F7C97F-289C-E941-B11B-D8EDB9A6958A}" destId="{7739CC37-79FF-394A-A43D-DEE7B0EF2A21}" srcOrd="0" destOrd="1" presId="urn:microsoft.com/office/officeart/2005/8/layout/list1"/>
    <dgm:cxn modelId="{EB9191E1-5CC7-C04E-A64D-25343E5AD5F7}" type="presOf" srcId="{753D38C4-5C28-7440-A04F-F38CD59A76C1}" destId="{0684872F-E6D7-2A4E-BC4C-26E8B67980AD}" srcOrd="0" destOrd="0" presId="urn:microsoft.com/office/officeart/2005/8/layout/list1"/>
    <dgm:cxn modelId="{610637F4-107E-1844-AF2C-0CBF1791E684}" type="presOf" srcId="{215C7B51-9396-114B-A699-AF11CD6DDAA5}" destId="{8ECF1FBB-C6FF-7D43-A224-BC7D0728D168}" srcOrd="0" destOrd="1" presId="urn:microsoft.com/office/officeart/2005/8/layout/list1"/>
    <dgm:cxn modelId="{C645A3F8-B5C9-9347-AC0D-DFF13CEA1316}" srcId="{8AE6C0F6-0DC8-C84E-89A5-0526B5C08E25}" destId="{10E9198D-1602-B240-87B1-3B043ACA2F89}" srcOrd="0" destOrd="0" parTransId="{71D72F51-10D0-8C4A-ABE1-AE6108092D04}" sibTransId="{57CA1E85-3266-7242-AAE0-89F50D59713A}"/>
    <dgm:cxn modelId="{C9D62AFA-FC01-F846-A482-1F0086689907}" type="presOf" srcId="{2B358ABC-6771-FC4D-8DBD-E44611D35F75}" destId="{56910AEB-68F4-7049-99DA-1C409D75FCCC}" srcOrd="1" destOrd="0" presId="urn:microsoft.com/office/officeart/2005/8/layout/list1"/>
    <dgm:cxn modelId="{67648FFD-0FB2-CB4B-81E9-376875D7869B}" srcId="{753D38C4-5C28-7440-A04F-F38CD59A76C1}" destId="{6FBC972D-22C9-0743-B338-CD58DE994851}" srcOrd="0" destOrd="0" parTransId="{4553F766-018B-AE4B-98DD-135B9F069622}" sibTransId="{3A109926-8FB7-F943-8EE4-07C358BF3A9D}"/>
    <dgm:cxn modelId="{0BF4C950-38AB-E343-9C80-B3FA544A0FB3}" type="presParOf" srcId="{00B96B96-109B-4645-80EE-09F4DB3DBD86}" destId="{DF2ED52A-9DE1-E843-B18A-88DC2144D1B7}" srcOrd="0" destOrd="0" presId="urn:microsoft.com/office/officeart/2005/8/layout/list1"/>
    <dgm:cxn modelId="{2A9B430F-D2F9-924B-8A6F-897CF5863A98}" type="presParOf" srcId="{DF2ED52A-9DE1-E843-B18A-88DC2144D1B7}" destId="{0684872F-E6D7-2A4E-BC4C-26E8B67980AD}" srcOrd="0" destOrd="0" presId="urn:microsoft.com/office/officeart/2005/8/layout/list1"/>
    <dgm:cxn modelId="{C904D850-CBB5-3240-B4D0-97981F37088E}" type="presParOf" srcId="{DF2ED52A-9DE1-E843-B18A-88DC2144D1B7}" destId="{F32DBF2E-C2C9-DE46-9089-580B1E9C9E85}" srcOrd="1" destOrd="0" presId="urn:microsoft.com/office/officeart/2005/8/layout/list1"/>
    <dgm:cxn modelId="{A46F2BEF-5C47-F242-B29C-4DD932565199}" type="presParOf" srcId="{00B96B96-109B-4645-80EE-09F4DB3DBD86}" destId="{E4750376-8D57-9E45-99DB-0C5AE8B9885D}" srcOrd="1" destOrd="0" presId="urn:microsoft.com/office/officeart/2005/8/layout/list1"/>
    <dgm:cxn modelId="{A9F716F2-C3F9-2545-B72A-90664A829C3A}" type="presParOf" srcId="{00B96B96-109B-4645-80EE-09F4DB3DBD86}" destId="{96E1637D-3CEA-8F4D-8FE4-3F89A76FF91E}" srcOrd="2" destOrd="0" presId="urn:microsoft.com/office/officeart/2005/8/layout/list1"/>
    <dgm:cxn modelId="{2656AAE5-465C-6F47-BE92-BCA9BF008F8A}" type="presParOf" srcId="{00B96B96-109B-4645-80EE-09F4DB3DBD86}" destId="{D1A39764-E92F-F64E-A9BE-2A5AE7834C98}" srcOrd="3" destOrd="0" presId="urn:microsoft.com/office/officeart/2005/8/layout/list1"/>
    <dgm:cxn modelId="{FF00E6C1-358F-1042-940F-7DDF30163E84}" type="presParOf" srcId="{00B96B96-109B-4645-80EE-09F4DB3DBD86}" destId="{22FCC2DC-4FA5-304F-9F41-07A616D900A4}" srcOrd="4" destOrd="0" presId="urn:microsoft.com/office/officeart/2005/8/layout/list1"/>
    <dgm:cxn modelId="{F8986F06-E356-4E40-AD92-4AE8DDC85D94}" type="presParOf" srcId="{22FCC2DC-4FA5-304F-9F41-07A616D900A4}" destId="{19C1B89C-F86F-C743-AD03-46CC36086007}" srcOrd="0" destOrd="0" presId="urn:microsoft.com/office/officeart/2005/8/layout/list1"/>
    <dgm:cxn modelId="{8A3D55AD-B2D3-2042-A9CB-E11DDABC3247}" type="presParOf" srcId="{22FCC2DC-4FA5-304F-9F41-07A616D900A4}" destId="{56910AEB-68F4-7049-99DA-1C409D75FCCC}" srcOrd="1" destOrd="0" presId="urn:microsoft.com/office/officeart/2005/8/layout/list1"/>
    <dgm:cxn modelId="{B3B76926-5AE9-AE47-BD5C-95FDD7D8F2CD}" type="presParOf" srcId="{00B96B96-109B-4645-80EE-09F4DB3DBD86}" destId="{459CF8C2-150B-DD4B-BE07-92E5C687F1D3}" srcOrd="5" destOrd="0" presId="urn:microsoft.com/office/officeart/2005/8/layout/list1"/>
    <dgm:cxn modelId="{206FD0AB-C8C4-E044-A720-065453780D5F}" type="presParOf" srcId="{00B96B96-109B-4645-80EE-09F4DB3DBD86}" destId="{7AE54AB1-2EE0-3548-B888-28176027BB1E}" srcOrd="6" destOrd="0" presId="urn:microsoft.com/office/officeart/2005/8/layout/list1"/>
    <dgm:cxn modelId="{E465A8F6-4098-9742-BB61-F3990E1C0677}" type="presParOf" srcId="{00B96B96-109B-4645-80EE-09F4DB3DBD86}" destId="{8F870B0B-426F-BE4C-A3CF-E6DCE35998B6}" srcOrd="7" destOrd="0" presId="urn:microsoft.com/office/officeart/2005/8/layout/list1"/>
    <dgm:cxn modelId="{2C738EA9-E1DD-3940-8EAA-ACBB30186CE8}" type="presParOf" srcId="{00B96B96-109B-4645-80EE-09F4DB3DBD86}" destId="{DFAD58D2-A011-CD49-B1E7-04CAA717E9CA}" srcOrd="8" destOrd="0" presId="urn:microsoft.com/office/officeart/2005/8/layout/list1"/>
    <dgm:cxn modelId="{7D95FFE1-CBCD-A04E-81D8-215FF4609E6D}" type="presParOf" srcId="{DFAD58D2-A011-CD49-B1E7-04CAA717E9CA}" destId="{F81754D0-6CF2-DF46-AFAB-86A2C07A5AE0}" srcOrd="0" destOrd="0" presId="urn:microsoft.com/office/officeart/2005/8/layout/list1"/>
    <dgm:cxn modelId="{47854634-7F98-4447-9E30-62357A371591}" type="presParOf" srcId="{DFAD58D2-A011-CD49-B1E7-04CAA717E9CA}" destId="{87DC13FF-7803-9C48-9B20-BD3D12F55658}" srcOrd="1" destOrd="0" presId="urn:microsoft.com/office/officeart/2005/8/layout/list1"/>
    <dgm:cxn modelId="{FAC098E8-B52C-E942-93C7-9CBA62A4772F}" type="presParOf" srcId="{00B96B96-109B-4645-80EE-09F4DB3DBD86}" destId="{683D7CC9-5698-5645-9825-349360D407E4}" srcOrd="9" destOrd="0" presId="urn:microsoft.com/office/officeart/2005/8/layout/list1"/>
    <dgm:cxn modelId="{3B8FF81C-CA1D-7D4A-B03C-C415750274D2}" type="presParOf" srcId="{00B96B96-109B-4645-80EE-09F4DB3DBD86}" destId="{8ECF1FBB-C6FF-7D43-A224-BC7D0728D168}" srcOrd="10" destOrd="0" presId="urn:microsoft.com/office/officeart/2005/8/layout/list1"/>
    <dgm:cxn modelId="{D91DC3DD-4DA3-A04D-92D8-4D638BF253EF}" type="presParOf" srcId="{00B96B96-109B-4645-80EE-09F4DB3DBD86}" destId="{CB77DBA1-F16B-344F-9811-174105C0AA44}" srcOrd="11" destOrd="0" presId="urn:microsoft.com/office/officeart/2005/8/layout/list1"/>
    <dgm:cxn modelId="{E4FB9A68-17D9-A241-838C-947A057A2F5D}" type="presParOf" srcId="{00B96B96-109B-4645-80EE-09F4DB3DBD86}" destId="{4B4E93BD-A4E3-7741-A452-553193D30155}" srcOrd="12" destOrd="0" presId="urn:microsoft.com/office/officeart/2005/8/layout/list1"/>
    <dgm:cxn modelId="{3B07C4E3-6AF3-904E-B674-DECF289BD854}" type="presParOf" srcId="{4B4E93BD-A4E3-7741-A452-553193D30155}" destId="{161725ED-ED7D-0D49-A66B-D7328E3AFCD4}" srcOrd="0" destOrd="0" presId="urn:microsoft.com/office/officeart/2005/8/layout/list1"/>
    <dgm:cxn modelId="{E34D7B32-32E3-9240-B314-B34836ABC415}" type="presParOf" srcId="{4B4E93BD-A4E3-7741-A452-553193D30155}" destId="{CDB6F1AD-1AF6-1B4D-AF61-7FEFBEA7CF1F}" srcOrd="1" destOrd="0" presId="urn:microsoft.com/office/officeart/2005/8/layout/list1"/>
    <dgm:cxn modelId="{A4C21426-CA8E-0E4A-BAFD-164711F24478}" type="presParOf" srcId="{00B96B96-109B-4645-80EE-09F4DB3DBD86}" destId="{D826BCA8-2425-FF44-9A94-7C00C1873AC3}" srcOrd="13" destOrd="0" presId="urn:microsoft.com/office/officeart/2005/8/layout/list1"/>
    <dgm:cxn modelId="{3D42125C-AE97-6A4E-9FAE-748C7234B301}" type="presParOf" srcId="{00B96B96-109B-4645-80EE-09F4DB3DBD86}" destId="{7739CC37-79FF-394A-A43D-DEE7B0EF2A21}" srcOrd="14" destOrd="0" presId="urn:microsoft.com/office/officeart/2005/8/layout/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6E1637D-3CEA-8F4D-8FE4-3F89A76FF91E}">
      <dsp:nvSpPr>
        <dsp:cNvPr id="0" name=""/>
        <dsp:cNvSpPr/>
      </dsp:nvSpPr>
      <dsp:spPr>
        <a:xfrm>
          <a:off x="0" y="358147"/>
          <a:ext cx="5301006" cy="567000"/>
        </a:xfrm>
        <a:prstGeom prst="rect">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11417" tIns="208280" rIns="411417" bIns="71120" numCol="1" spcCol="1270" anchor="t" anchorCtr="0">
          <a:noAutofit/>
        </a:bodyPr>
        <a:lstStyle/>
        <a:p>
          <a:pPr marL="57150" lvl="1" indent="-57150" algn="l" defTabSz="444500">
            <a:lnSpc>
              <a:spcPct val="90000"/>
            </a:lnSpc>
            <a:spcBef>
              <a:spcPct val="0"/>
            </a:spcBef>
            <a:spcAft>
              <a:spcPct val="15000"/>
            </a:spcAft>
            <a:buChar char="•"/>
          </a:pPr>
          <a:r>
            <a:rPr lang="en-US" sz="1000" kern="1200"/>
            <a:t>Pain with exertion</a:t>
          </a:r>
        </a:p>
        <a:p>
          <a:pPr marL="57150" lvl="1" indent="-57150" algn="l" defTabSz="444500">
            <a:lnSpc>
              <a:spcPct val="90000"/>
            </a:lnSpc>
            <a:spcBef>
              <a:spcPct val="0"/>
            </a:spcBef>
            <a:spcAft>
              <a:spcPct val="15000"/>
            </a:spcAft>
            <a:buChar char="•"/>
          </a:pPr>
          <a:r>
            <a:rPr lang="en-US" sz="1000" kern="1200"/>
            <a:t>Exertional syncope</a:t>
          </a:r>
        </a:p>
      </dsp:txBody>
      <dsp:txXfrm>
        <a:off x="0" y="358147"/>
        <a:ext cx="5301006" cy="567000"/>
      </dsp:txXfrm>
    </dsp:sp>
    <dsp:sp modelId="{F32DBF2E-C2C9-DE46-9089-580B1E9C9E85}">
      <dsp:nvSpPr>
        <dsp:cNvPr id="0" name=""/>
        <dsp:cNvSpPr/>
      </dsp:nvSpPr>
      <dsp:spPr>
        <a:xfrm>
          <a:off x="265050" y="210547"/>
          <a:ext cx="3710704" cy="295200"/>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0256" tIns="0" rIns="140256" bIns="0" numCol="1" spcCol="1270" anchor="ctr" anchorCtr="0">
          <a:noAutofit/>
        </a:bodyPr>
        <a:lstStyle/>
        <a:p>
          <a:pPr marL="0" lvl="0" indent="0" algn="l" defTabSz="444500">
            <a:lnSpc>
              <a:spcPct val="90000"/>
            </a:lnSpc>
            <a:spcBef>
              <a:spcPct val="0"/>
            </a:spcBef>
            <a:spcAft>
              <a:spcPct val="35000"/>
            </a:spcAft>
            <a:buNone/>
          </a:pPr>
          <a:r>
            <a:rPr lang="en-US" sz="1000" kern="1200"/>
            <a:t>Historical Features</a:t>
          </a:r>
        </a:p>
      </dsp:txBody>
      <dsp:txXfrm>
        <a:off x="279460" y="224957"/>
        <a:ext cx="3681884" cy="266380"/>
      </dsp:txXfrm>
    </dsp:sp>
    <dsp:sp modelId="{7AE54AB1-2EE0-3548-B888-28176027BB1E}">
      <dsp:nvSpPr>
        <dsp:cNvPr id="0" name=""/>
        <dsp:cNvSpPr/>
      </dsp:nvSpPr>
      <dsp:spPr>
        <a:xfrm>
          <a:off x="0" y="1126747"/>
          <a:ext cx="5301006" cy="417375"/>
        </a:xfrm>
        <a:prstGeom prst="rect">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11417" tIns="208280" rIns="411417" bIns="71120" numCol="1" spcCol="1270" anchor="t" anchorCtr="0">
          <a:noAutofit/>
        </a:bodyPr>
        <a:lstStyle/>
        <a:p>
          <a:pPr marL="57150" lvl="1" indent="-57150" algn="l" defTabSz="444500">
            <a:lnSpc>
              <a:spcPct val="90000"/>
            </a:lnSpc>
            <a:spcBef>
              <a:spcPct val="0"/>
            </a:spcBef>
            <a:spcAft>
              <a:spcPct val="15000"/>
            </a:spcAft>
            <a:buChar char="•"/>
          </a:pPr>
          <a:r>
            <a:rPr lang="en-US" sz="1000" kern="1200"/>
            <a:t>Prolonged immobilization</a:t>
          </a:r>
        </a:p>
      </dsp:txBody>
      <dsp:txXfrm>
        <a:off x="0" y="1126747"/>
        <a:ext cx="5301006" cy="417375"/>
      </dsp:txXfrm>
    </dsp:sp>
    <dsp:sp modelId="{56910AEB-68F4-7049-99DA-1C409D75FCCC}">
      <dsp:nvSpPr>
        <dsp:cNvPr id="0" name=""/>
        <dsp:cNvSpPr/>
      </dsp:nvSpPr>
      <dsp:spPr>
        <a:xfrm>
          <a:off x="265050" y="979147"/>
          <a:ext cx="3710704" cy="295200"/>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0256" tIns="0" rIns="140256" bIns="0" numCol="1" spcCol="1270" anchor="ctr" anchorCtr="0">
          <a:noAutofit/>
        </a:bodyPr>
        <a:lstStyle/>
        <a:p>
          <a:pPr marL="0" lvl="0" indent="0" algn="l" defTabSz="444500">
            <a:lnSpc>
              <a:spcPct val="90000"/>
            </a:lnSpc>
            <a:spcBef>
              <a:spcPct val="0"/>
            </a:spcBef>
            <a:spcAft>
              <a:spcPct val="35000"/>
            </a:spcAft>
            <a:buNone/>
          </a:pPr>
          <a:r>
            <a:rPr lang="en-US" sz="1000" kern="1200"/>
            <a:t>Medical History</a:t>
          </a:r>
        </a:p>
      </dsp:txBody>
      <dsp:txXfrm>
        <a:off x="279460" y="993557"/>
        <a:ext cx="3681884" cy="266380"/>
      </dsp:txXfrm>
    </dsp:sp>
    <dsp:sp modelId="{8ECF1FBB-C6FF-7D43-A224-BC7D0728D168}">
      <dsp:nvSpPr>
        <dsp:cNvPr id="0" name=""/>
        <dsp:cNvSpPr/>
      </dsp:nvSpPr>
      <dsp:spPr>
        <a:xfrm>
          <a:off x="0" y="1745722"/>
          <a:ext cx="5301006" cy="567000"/>
        </a:xfrm>
        <a:prstGeom prst="rect">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11417" tIns="208280" rIns="411417" bIns="71120" numCol="1" spcCol="1270" anchor="t" anchorCtr="0">
          <a:noAutofit/>
        </a:bodyPr>
        <a:lstStyle/>
        <a:p>
          <a:pPr marL="57150" lvl="1" indent="-57150" algn="l" defTabSz="444500">
            <a:lnSpc>
              <a:spcPct val="90000"/>
            </a:lnSpc>
            <a:spcBef>
              <a:spcPct val="0"/>
            </a:spcBef>
            <a:spcAft>
              <a:spcPct val="15000"/>
            </a:spcAft>
            <a:buChar char="•"/>
          </a:pPr>
          <a:r>
            <a:rPr lang="en-US" sz="1000" kern="1200"/>
            <a:t>Sudden unexplained death (e.g., drownings, solo automobile accidents)</a:t>
          </a:r>
        </a:p>
        <a:p>
          <a:pPr marL="57150" lvl="1" indent="-57150" algn="l" defTabSz="444500">
            <a:lnSpc>
              <a:spcPct val="90000"/>
            </a:lnSpc>
            <a:spcBef>
              <a:spcPct val="0"/>
            </a:spcBef>
            <a:spcAft>
              <a:spcPct val="15000"/>
            </a:spcAft>
            <a:buChar char="•"/>
          </a:pPr>
          <a:r>
            <a:rPr lang="en-US" sz="1000" kern="1200"/>
            <a:t>Cardiomyopathy</a:t>
          </a:r>
        </a:p>
      </dsp:txBody>
      <dsp:txXfrm>
        <a:off x="0" y="1745722"/>
        <a:ext cx="5301006" cy="567000"/>
      </dsp:txXfrm>
    </dsp:sp>
    <dsp:sp modelId="{87DC13FF-7803-9C48-9B20-BD3D12F55658}">
      <dsp:nvSpPr>
        <dsp:cNvPr id="0" name=""/>
        <dsp:cNvSpPr/>
      </dsp:nvSpPr>
      <dsp:spPr>
        <a:xfrm>
          <a:off x="265050" y="1598122"/>
          <a:ext cx="3710704" cy="295200"/>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0256" tIns="0" rIns="140256" bIns="0" numCol="1" spcCol="1270" anchor="ctr" anchorCtr="0">
          <a:noAutofit/>
        </a:bodyPr>
        <a:lstStyle/>
        <a:p>
          <a:pPr marL="0" lvl="0" indent="0" algn="l" defTabSz="444500">
            <a:lnSpc>
              <a:spcPct val="90000"/>
            </a:lnSpc>
            <a:spcBef>
              <a:spcPct val="0"/>
            </a:spcBef>
            <a:spcAft>
              <a:spcPct val="35000"/>
            </a:spcAft>
            <a:buNone/>
          </a:pPr>
          <a:r>
            <a:rPr lang="en-US" sz="1000" kern="1200"/>
            <a:t>Family History</a:t>
          </a:r>
        </a:p>
      </dsp:txBody>
      <dsp:txXfrm>
        <a:off x="279460" y="1612532"/>
        <a:ext cx="3681884" cy="266380"/>
      </dsp:txXfrm>
    </dsp:sp>
    <dsp:sp modelId="{7739CC37-79FF-394A-A43D-DEE7B0EF2A21}">
      <dsp:nvSpPr>
        <dsp:cNvPr id="0" name=""/>
        <dsp:cNvSpPr/>
      </dsp:nvSpPr>
      <dsp:spPr>
        <a:xfrm>
          <a:off x="0" y="2514322"/>
          <a:ext cx="5301006" cy="882000"/>
        </a:xfrm>
        <a:prstGeom prst="rect">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11417" tIns="208280" rIns="411417" bIns="71120" numCol="1" spcCol="1270" anchor="t" anchorCtr="0">
          <a:noAutofit/>
        </a:bodyPr>
        <a:lstStyle/>
        <a:p>
          <a:pPr marL="57150" lvl="1" indent="-57150" algn="l" defTabSz="444500">
            <a:lnSpc>
              <a:spcPct val="90000"/>
            </a:lnSpc>
            <a:spcBef>
              <a:spcPct val="0"/>
            </a:spcBef>
            <a:spcAft>
              <a:spcPct val="15000"/>
            </a:spcAft>
            <a:buChar char="•"/>
          </a:pPr>
          <a:r>
            <a:rPr lang="en-US" sz="1000" kern="1200"/>
            <a:t>Fever</a:t>
          </a:r>
        </a:p>
        <a:p>
          <a:pPr marL="57150" lvl="1" indent="-57150" algn="l" defTabSz="444500">
            <a:lnSpc>
              <a:spcPct val="90000"/>
            </a:lnSpc>
            <a:spcBef>
              <a:spcPct val="0"/>
            </a:spcBef>
            <a:spcAft>
              <a:spcPct val="15000"/>
            </a:spcAft>
            <a:buChar char="•"/>
          </a:pPr>
          <a:r>
            <a:rPr lang="en-US" sz="1000" kern="1200"/>
            <a:t>Tachypnea</a:t>
          </a:r>
        </a:p>
        <a:p>
          <a:pPr marL="57150" lvl="1" indent="-57150" algn="l" defTabSz="444500">
            <a:lnSpc>
              <a:spcPct val="90000"/>
            </a:lnSpc>
            <a:spcBef>
              <a:spcPct val="0"/>
            </a:spcBef>
            <a:spcAft>
              <a:spcPct val="15000"/>
            </a:spcAft>
            <a:buChar char="•"/>
          </a:pPr>
          <a:r>
            <a:rPr lang="en-US" sz="1000" kern="1200"/>
            <a:t>Painful extremities</a:t>
          </a:r>
        </a:p>
        <a:p>
          <a:pPr marL="57150" lvl="1" indent="-57150" algn="l" defTabSz="444500">
            <a:lnSpc>
              <a:spcPct val="90000"/>
            </a:lnSpc>
            <a:spcBef>
              <a:spcPct val="0"/>
            </a:spcBef>
            <a:spcAft>
              <a:spcPct val="15000"/>
            </a:spcAft>
            <a:buChar char="•"/>
          </a:pPr>
          <a:r>
            <a:rPr lang="en-US" sz="1000" kern="1200"/>
            <a:t>Beck's Triad (distant heart sounds, distended jugular vein, hypotension). </a:t>
          </a:r>
        </a:p>
      </dsp:txBody>
      <dsp:txXfrm>
        <a:off x="0" y="2514322"/>
        <a:ext cx="5301006" cy="882000"/>
      </dsp:txXfrm>
    </dsp:sp>
    <dsp:sp modelId="{CDB6F1AD-1AF6-1B4D-AF61-7FEFBEA7CF1F}">
      <dsp:nvSpPr>
        <dsp:cNvPr id="0" name=""/>
        <dsp:cNvSpPr/>
      </dsp:nvSpPr>
      <dsp:spPr>
        <a:xfrm>
          <a:off x="265050" y="2366722"/>
          <a:ext cx="3710704" cy="295200"/>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0256" tIns="0" rIns="140256" bIns="0" numCol="1" spcCol="1270" anchor="ctr" anchorCtr="0">
          <a:noAutofit/>
        </a:bodyPr>
        <a:lstStyle/>
        <a:p>
          <a:pPr marL="0" lvl="0" indent="0" algn="l" defTabSz="444500">
            <a:lnSpc>
              <a:spcPct val="90000"/>
            </a:lnSpc>
            <a:spcBef>
              <a:spcPct val="0"/>
            </a:spcBef>
            <a:spcAft>
              <a:spcPct val="35000"/>
            </a:spcAft>
            <a:buNone/>
          </a:pPr>
          <a:r>
            <a:rPr lang="en-US" sz="1000" kern="1200"/>
            <a:t>Physical Examination</a:t>
          </a:r>
        </a:p>
      </dsp:txBody>
      <dsp:txXfrm>
        <a:off x="279460" y="2381132"/>
        <a:ext cx="3681884" cy="266380"/>
      </dsp:txXfrm>
    </dsp:sp>
  </dsp:spTree>
</dsp:drawing>
</file>

<file path=ppt/diagrams/layout1.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175" y="685800"/>
            <a:ext cx="60963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317500">
              <a:spcBef>
                <a:spcPts val="0"/>
              </a:spcBef>
              <a:spcAft>
                <a:spcPts val="0"/>
              </a:spcAft>
              <a:buSzPts val="1400"/>
              <a:buChar char="●"/>
              <a:defRPr sz="1100"/>
            </a:lvl1pPr>
            <a:lvl2pPr marL="914400" lvl="1" indent="-317500">
              <a:spcBef>
                <a:spcPts val="0"/>
              </a:spcBef>
              <a:spcAft>
                <a:spcPts val="0"/>
              </a:spcAft>
              <a:buSzPts val="1400"/>
              <a:buChar char="○"/>
              <a:defRPr sz="1100"/>
            </a:lvl2pPr>
            <a:lvl3pPr marL="1371600" lvl="2" indent="-317500">
              <a:spcBef>
                <a:spcPts val="0"/>
              </a:spcBef>
              <a:spcAft>
                <a:spcPts val="0"/>
              </a:spcAft>
              <a:buSzPts val="1400"/>
              <a:buChar char="■"/>
              <a:defRPr sz="1100"/>
            </a:lvl3pPr>
            <a:lvl4pPr marL="1828800" lvl="3" indent="-317500">
              <a:spcBef>
                <a:spcPts val="0"/>
              </a:spcBef>
              <a:spcAft>
                <a:spcPts val="0"/>
              </a:spcAft>
              <a:buSzPts val="1400"/>
              <a:buChar char="●"/>
              <a:defRPr sz="1100"/>
            </a:lvl4pPr>
            <a:lvl5pPr marL="2286000" lvl="4" indent="-317500">
              <a:spcBef>
                <a:spcPts val="0"/>
              </a:spcBef>
              <a:spcAft>
                <a:spcPts val="0"/>
              </a:spcAft>
              <a:buSzPts val="1400"/>
              <a:buChar char="○"/>
              <a:defRPr sz="1100"/>
            </a:lvl5pPr>
            <a:lvl6pPr marL="2743200" lvl="5" indent="-317500">
              <a:spcBef>
                <a:spcPts val="0"/>
              </a:spcBef>
              <a:spcAft>
                <a:spcPts val="0"/>
              </a:spcAft>
              <a:buSzPts val="1400"/>
              <a:buChar char="■"/>
              <a:defRPr sz="1100"/>
            </a:lvl6pPr>
            <a:lvl7pPr marL="3200400" lvl="6" indent="-317500">
              <a:spcBef>
                <a:spcPts val="0"/>
              </a:spcBef>
              <a:spcAft>
                <a:spcPts val="0"/>
              </a:spcAft>
              <a:buSzPts val="1400"/>
              <a:buChar char="●"/>
              <a:defRPr sz="1100"/>
            </a:lvl7pPr>
            <a:lvl8pPr marL="3657600" lvl="7" indent="-317500">
              <a:spcBef>
                <a:spcPts val="0"/>
              </a:spcBef>
              <a:spcAft>
                <a:spcPts val="0"/>
              </a:spcAft>
              <a:buSzPts val="1400"/>
              <a:buChar char="○"/>
              <a:defRPr sz="1100"/>
            </a:lvl8pPr>
            <a:lvl9pPr marL="4114800" lvl="8" indent="-317500">
              <a:spcBef>
                <a:spcPts val="0"/>
              </a:spcBef>
              <a:spcAft>
                <a:spcPts val="0"/>
              </a:spcAft>
              <a:buSzPts val="14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5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5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5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58.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59.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60.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61.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62.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63.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64.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65.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66.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67.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68.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6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5"/>
        <p:cNvGrpSpPr/>
        <p:nvPr/>
      </p:nvGrpSpPr>
      <p:grpSpPr>
        <a:xfrm>
          <a:off x="0" y="0"/>
          <a:ext cx="0" cy="0"/>
          <a:chOff x="0" y="0"/>
          <a:chExt cx="0" cy="0"/>
        </a:xfrm>
      </p:grpSpPr>
      <p:sp>
        <p:nvSpPr>
          <p:cNvPr id="216" name="Google Shape;216;g35f391192_0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7" name="Google Shape;217;g35f391192_0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a:t>Suggested timing for Session #5</a:t>
            </a:r>
            <a:endParaRPr lang="en-US" dirty="0"/>
          </a:p>
          <a:p>
            <a:pPr marL="0" indent="0">
              <a:buNone/>
            </a:pPr>
            <a:r>
              <a:rPr lang="en-US" dirty="0"/>
              <a:t>Review Curriculum (see below) - 10 minutes </a:t>
            </a:r>
          </a:p>
          <a:p>
            <a:pPr marL="0" indent="0">
              <a:buNone/>
            </a:pPr>
            <a:r>
              <a:rPr lang="en-US"/>
              <a:t>Review game – 50 minutes</a:t>
            </a:r>
            <a:endParaRPr lang="en-US" dirty="0"/>
          </a:p>
          <a:p>
            <a:pPr marL="0" indent="0">
              <a:buNone/>
            </a:pPr>
            <a:endParaRPr lang="en-US" dirty="0"/>
          </a:p>
          <a:p>
            <a:pPr marL="0" indent="0">
              <a:buNone/>
            </a:pPr>
            <a:r>
              <a:rPr lang="en-US"/>
              <a:t>Before beginning the game, the facilitator should remind the audience of the first four sessions – Illness Scripts Part 1 and 2, Script Concordance, and Pathophysiology. The facilitator should ask participants if they had any key take-aways from the previous sessions, and for examples of how they have applied clinical reasoning concepts to their everyday clinical practice.</a:t>
            </a:r>
          </a:p>
          <a:p>
            <a:pPr marL="0" indent="0">
              <a:buNone/>
            </a:pPr>
            <a:endParaRPr lang="en-US" dirty="0"/>
          </a:p>
          <a:p>
            <a:pPr marL="0" indent="0">
              <a:buNone/>
            </a:pPr>
            <a:r>
              <a:rPr lang="en-US" dirty="0"/>
              <a:t>Additional questions for discussion include:</a:t>
            </a:r>
          </a:p>
          <a:p>
            <a:pPr marL="171450" indent="-171450"/>
            <a:r>
              <a:rPr lang="en-US" dirty="0"/>
              <a:t>How has your assessment of other learners on the team changed following participation in the curriculum?</a:t>
            </a:r>
          </a:p>
          <a:p>
            <a:pPr marL="171450" indent="-171450"/>
            <a:r>
              <a:rPr lang="en-US"/>
              <a:t>How has your approach to goal-setting for strengthening clinical reasoning changed?</a:t>
            </a:r>
          </a:p>
          <a:p>
            <a:pPr marL="171450" indent="-171450"/>
            <a:r>
              <a:rPr lang="en-US" dirty="0"/>
              <a:t>If the participants took their In-Training Exam during the span of the curriculum (or other multiple-choice tests), the facilitator can ask if they noticed their approach to test-taking changed. </a:t>
            </a: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1"/>
        <p:cNvGrpSpPr/>
        <p:nvPr/>
      </p:nvGrpSpPr>
      <p:grpSpPr>
        <a:xfrm>
          <a:off x="0" y="0"/>
          <a:ext cx="0" cy="0"/>
          <a:chOff x="0" y="0"/>
          <a:chExt cx="0" cy="0"/>
        </a:xfrm>
      </p:grpSpPr>
      <p:sp>
        <p:nvSpPr>
          <p:cNvPr id="292" name="Google Shape;292;g7834a636a1_1_24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93" name="Google Shape;293;g7834a636a1_1_24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39700" indent="0">
              <a:buNone/>
            </a:pPr>
            <a:r>
              <a:rPr lang="en-US" dirty="0"/>
              <a:t>Facilitator can ask why differentiating between these two similar entities matters. The answer is that treatment differs – treatment for HUS is primarily supportive while treatment for TTP involves plasmapheresis </a:t>
            </a:r>
          </a:p>
        </p:txBody>
      </p:sp>
    </p:spTree>
    <p:extLst>
      <p:ext uri="{BB962C8B-B14F-4D97-AF65-F5344CB8AC3E}">
        <p14:creationId xmlns:p14="http://schemas.microsoft.com/office/powerpoint/2010/main" val="84922442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7"/>
        <p:cNvGrpSpPr/>
        <p:nvPr/>
      </p:nvGrpSpPr>
      <p:grpSpPr>
        <a:xfrm>
          <a:off x="0" y="0"/>
          <a:ext cx="0" cy="0"/>
          <a:chOff x="0" y="0"/>
          <a:chExt cx="0" cy="0"/>
        </a:xfrm>
      </p:grpSpPr>
      <p:sp>
        <p:nvSpPr>
          <p:cNvPr id="298" name="Google Shape;298;g7834a636a1_1_24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99" name="Google Shape;299;g7834a636a1_1_24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a:buNone/>
            </a:pPr>
            <a:r>
              <a:rPr lang="en-US" dirty="0">
                <a:latin typeface="Calibri"/>
                <a:cs typeface="Calibri"/>
              </a:rPr>
              <a:t>This is another example highlighting distinguishing features of similar presentations in a disease process. These features also matter as the management is different between the clinical processes!</a:t>
            </a:r>
          </a:p>
        </p:txBody>
      </p:sp>
    </p:spTree>
    <p:extLst>
      <p:ext uri="{BB962C8B-B14F-4D97-AF65-F5344CB8AC3E}">
        <p14:creationId xmlns:p14="http://schemas.microsoft.com/office/powerpoint/2010/main" val="2687289696"/>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3"/>
        <p:cNvGrpSpPr/>
        <p:nvPr/>
      </p:nvGrpSpPr>
      <p:grpSpPr>
        <a:xfrm>
          <a:off x="0" y="0"/>
          <a:ext cx="0" cy="0"/>
          <a:chOff x="0" y="0"/>
          <a:chExt cx="0" cy="0"/>
        </a:xfrm>
      </p:grpSpPr>
      <p:sp>
        <p:nvSpPr>
          <p:cNvPr id="304" name="Google Shape;304;g7834a636a1_1_26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5" name="Google Shape;305;g7834a636a1_1_26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a:buNone/>
            </a:pPr>
            <a:r>
              <a:rPr lang="en-US" dirty="0">
                <a:latin typeface="Calibri"/>
                <a:ea typeface="Calibri"/>
                <a:cs typeface="Calibri"/>
              </a:rPr>
              <a:t>An ABG obtained from a patient with diarrhea typically shows a metabolic acidosis without an anion gap. The body is "losing" bicarbonate through the stool.</a:t>
            </a:r>
          </a:p>
        </p:txBody>
      </p:sp>
    </p:spTree>
    <p:extLst>
      <p:ext uri="{BB962C8B-B14F-4D97-AF65-F5344CB8AC3E}">
        <p14:creationId xmlns:p14="http://schemas.microsoft.com/office/powerpoint/2010/main" val="538704995"/>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9"/>
        <p:cNvGrpSpPr/>
        <p:nvPr/>
      </p:nvGrpSpPr>
      <p:grpSpPr>
        <a:xfrm>
          <a:off x="0" y="0"/>
          <a:ext cx="0" cy="0"/>
          <a:chOff x="0" y="0"/>
          <a:chExt cx="0" cy="0"/>
        </a:xfrm>
      </p:grpSpPr>
      <p:sp>
        <p:nvSpPr>
          <p:cNvPr id="310" name="Google Shape;310;g7834a636a1_1_26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11" name="Google Shape;311;g7834a636a1_1_26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a:buNone/>
            </a:pPr>
            <a:r>
              <a:rPr lang="en-US" dirty="0">
                <a:latin typeface="Calibri"/>
                <a:ea typeface="Calibri"/>
                <a:cs typeface="Calibri"/>
              </a:rPr>
              <a:t>In patients with profuse vomiting, they are "losing" acid through their vomit, often causing a contraction alkalosis – metabolic alkalosis with decreased potassium (also lost in GI losses and exacerbated by metabolic alkalosis). Some providers would note that this constellation of alkalosis and hypokalemia are highly predictive of a dehydrated patient, and often seen in conjunction with hypertrophic pyloric stenosis. </a:t>
            </a:r>
          </a:p>
        </p:txBody>
      </p:sp>
    </p:spTree>
    <p:extLst>
      <p:ext uri="{BB962C8B-B14F-4D97-AF65-F5344CB8AC3E}">
        <p14:creationId xmlns:p14="http://schemas.microsoft.com/office/powerpoint/2010/main" val="4121356963"/>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5"/>
        <p:cNvGrpSpPr/>
        <p:nvPr/>
      </p:nvGrpSpPr>
      <p:grpSpPr>
        <a:xfrm>
          <a:off x="0" y="0"/>
          <a:ext cx="0" cy="0"/>
          <a:chOff x="0" y="0"/>
          <a:chExt cx="0" cy="0"/>
        </a:xfrm>
      </p:grpSpPr>
      <p:sp>
        <p:nvSpPr>
          <p:cNvPr id="316" name="Google Shape;316;g7834a636a1_1_27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17" name="Google Shape;317;g7834a636a1_1_27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a:buNone/>
            </a:pPr>
            <a:r>
              <a:rPr lang="en-US" dirty="0">
                <a:latin typeface="Calibri"/>
                <a:ea typeface="Calibri"/>
                <a:cs typeface="Calibri"/>
              </a:rPr>
              <a:t>Patients with DKA have a pseudohyponatremia due to the profound elevation in glucose. They will exhibit a +anion gap metabolic acidosis.</a:t>
            </a:r>
          </a:p>
          <a:p>
            <a:pPr>
              <a:buNone/>
            </a:pPr>
            <a:endParaRPr lang="en-US" dirty="0">
              <a:latin typeface="Calibri"/>
              <a:ea typeface="Calibri"/>
              <a:cs typeface="Calibri"/>
            </a:endParaRPr>
          </a:p>
          <a:p>
            <a:pPr>
              <a:buNone/>
            </a:pPr>
            <a:r>
              <a:rPr lang="en-US" dirty="0">
                <a:latin typeface="Calibri"/>
                <a:ea typeface="Calibri"/>
                <a:cs typeface="Calibri"/>
              </a:rPr>
              <a:t>Discussion question: Can anyone explain the pathophysiology behind this patient's hyperkalemia? </a:t>
            </a:r>
          </a:p>
          <a:p>
            <a:pPr>
              <a:buNone/>
            </a:pPr>
            <a:r>
              <a:rPr lang="en-US" dirty="0">
                <a:latin typeface="Calibri"/>
                <a:ea typeface="Calibri"/>
                <a:cs typeface="Calibri"/>
              </a:rPr>
              <a:t>Answer: In patients with DKA, there is a whole body hypokalemia due to osmotic diuresis, but there is often a measured peripheral hyperkalemia due to the body's attempt at regulating the acidosis. As the blood becomes more </a:t>
            </a:r>
            <a:r>
              <a:rPr lang="en-US" dirty="0" err="1">
                <a:latin typeface="Calibri"/>
                <a:ea typeface="Calibri"/>
                <a:cs typeface="Calibri"/>
              </a:rPr>
              <a:t>acidemic</a:t>
            </a:r>
            <a:r>
              <a:rPr lang="en-US" dirty="0">
                <a:latin typeface="Calibri"/>
                <a:ea typeface="Calibri"/>
                <a:cs typeface="Calibri"/>
              </a:rPr>
              <a:t>, more potassium will shift out of the cells and Hydrogen ions will shift into cells.</a:t>
            </a:r>
          </a:p>
        </p:txBody>
      </p:sp>
    </p:spTree>
    <p:extLst>
      <p:ext uri="{BB962C8B-B14F-4D97-AF65-F5344CB8AC3E}">
        <p14:creationId xmlns:p14="http://schemas.microsoft.com/office/powerpoint/2010/main" val="161685973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5"/>
        <p:cNvGrpSpPr/>
        <p:nvPr/>
      </p:nvGrpSpPr>
      <p:grpSpPr>
        <a:xfrm>
          <a:off x="0" y="0"/>
          <a:ext cx="0" cy="0"/>
          <a:chOff x="0" y="0"/>
          <a:chExt cx="0" cy="0"/>
        </a:xfrm>
      </p:grpSpPr>
      <p:sp>
        <p:nvSpPr>
          <p:cNvPr id="216" name="Google Shape;216;g35f391192_0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7" name="Google Shape;217;g35f391192_0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dirty="0"/>
              <a:t>Before beginning the game, the facilitator should remind the audience of the first four sessions – Illness Scripts Part 1 and 2, Script Concordance, and Pathophysiology. The facilitator should ask participants if they had any key take-aways from the previous sessions, and for examples of how they have applied clinical reasoning concepts to their everyday clinical practice.</a:t>
            </a:r>
          </a:p>
          <a:p>
            <a:pPr marL="0" indent="0">
              <a:buNone/>
            </a:pPr>
            <a:endParaRPr lang="en-US" dirty="0"/>
          </a:p>
          <a:p>
            <a:pPr marL="0" indent="0">
              <a:buNone/>
            </a:pPr>
            <a:r>
              <a:rPr lang="en-US" dirty="0"/>
              <a:t>Additional questions for discussion include:</a:t>
            </a:r>
          </a:p>
          <a:p>
            <a:pPr marL="171450" indent="-171450"/>
            <a:r>
              <a:rPr lang="en-US" dirty="0"/>
              <a:t>How has your assessment of other learners on the team changed following participation in the curriculum?</a:t>
            </a:r>
          </a:p>
          <a:p>
            <a:pPr marL="171450" indent="-171450"/>
            <a:r>
              <a:rPr lang="en-US"/>
              <a:t>How has your approach to goal-setting for strengthening clinical reasoning changed?</a:t>
            </a:r>
          </a:p>
          <a:p>
            <a:pPr marL="171450" indent="-171450"/>
            <a:r>
              <a:rPr lang="en-US" dirty="0"/>
              <a:t>If the participants took their In-Training Exam during the span of the curriculum (or other multiple-choice tests), the facilitator can ask if they noticed their approach to test-taking changed. </a:t>
            </a:r>
          </a:p>
        </p:txBody>
      </p:sp>
    </p:spTree>
    <p:extLst>
      <p:ext uri="{BB962C8B-B14F-4D97-AF65-F5344CB8AC3E}">
        <p14:creationId xmlns:p14="http://schemas.microsoft.com/office/powerpoint/2010/main" val="3850347746"/>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a:t>They are not adequately compensating for their acidosis based on the Winter’s Formula</a:t>
            </a:r>
          </a:p>
        </p:txBody>
      </p:sp>
    </p:spTree>
    <p:extLst>
      <p:ext uri="{BB962C8B-B14F-4D97-AF65-F5344CB8AC3E}">
        <p14:creationId xmlns:p14="http://schemas.microsoft.com/office/powerpoint/2010/main" val="2872729371"/>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1"/>
        <p:cNvGrpSpPr/>
        <p:nvPr/>
      </p:nvGrpSpPr>
      <p:grpSpPr>
        <a:xfrm>
          <a:off x="0" y="0"/>
          <a:ext cx="0" cy="0"/>
          <a:chOff x="0" y="0"/>
          <a:chExt cx="0" cy="0"/>
        </a:xfrm>
      </p:grpSpPr>
      <p:sp>
        <p:nvSpPr>
          <p:cNvPr id="322" name="Google Shape;322;g7834a636a1_1_27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23" name="Google Shape;323;g7834a636a1_1_27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a:buNone/>
            </a:pPr>
            <a:r>
              <a:rPr lang="en-US">
                <a:latin typeface="Calibri"/>
                <a:ea typeface="Calibri"/>
                <a:cs typeface="Calibri"/>
              </a:rPr>
              <a:t>A patient with poor ventilation (i.e. severe obstruction in an asthma exacerbation) will often have rising pCO2 levels and subsequent respiratory acidosis. They likely will NOT have compensated from a metabolic perspective given the</a:t>
            </a:r>
            <a:r>
              <a:rPr lang="en-US" dirty="0">
                <a:latin typeface="Calibri"/>
                <a:ea typeface="Calibri"/>
                <a:cs typeface="Calibri"/>
              </a:rPr>
              <a:t> acuity of the pathology.</a:t>
            </a:r>
            <a:endParaRPr lang="en-US">
              <a:latin typeface="Calibri"/>
              <a:ea typeface="Calibri"/>
              <a:cs typeface="Calibri"/>
            </a:endParaRPr>
          </a:p>
        </p:txBody>
      </p:sp>
    </p:spTree>
    <p:extLst>
      <p:ext uri="{BB962C8B-B14F-4D97-AF65-F5344CB8AC3E}">
        <p14:creationId xmlns:p14="http://schemas.microsoft.com/office/powerpoint/2010/main" val="2825463170"/>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7"/>
        <p:cNvGrpSpPr/>
        <p:nvPr/>
      </p:nvGrpSpPr>
      <p:grpSpPr>
        <a:xfrm>
          <a:off x="0" y="0"/>
          <a:ext cx="0" cy="0"/>
          <a:chOff x="0" y="0"/>
          <a:chExt cx="0" cy="0"/>
        </a:xfrm>
      </p:grpSpPr>
      <p:sp>
        <p:nvSpPr>
          <p:cNvPr id="328" name="Google Shape;328;g7834a636a1_1_28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29" name="Google Shape;329;g7834a636a1_1_28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a:buNone/>
            </a:pPr>
            <a:r>
              <a:rPr lang="en-US" dirty="0">
                <a:latin typeface="Calibri"/>
                <a:cs typeface="Calibri"/>
              </a:rPr>
              <a:t>Can ask the audience what they think caused this constellation of findings on the acidosis. Answer is revealed on next slides.</a:t>
            </a:r>
          </a:p>
        </p:txBody>
      </p:sp>
    </p:spTree>
    <p:extLst>
      <p:ext uri="{BB962C8B-B14F-4D97-AF65-F5344CB8AC3E}">
        <p14:creationId xmlns:p14="http://schemas.microsoft.com/office/powerpoint/2010/main" val="2655525031"/>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a:buNone/>
            </a:pPr>
            <a:r>
              <a:rPr lang="en-US" dirty="0">
                <a:latin typeface="Calibri"/>
                <a:cs typeface="Calibri"/>
              </a:rPr>
              <a:t>Salicylates cause a mixed metabolic acidosis and respiratory alkalosis. </a:t>
            </a:r>
          </a:p>
          <a:p>
            <a:pPr>
              <a:buNone/>
            </a:pPr>
            <a:endParaRPr lang="en-US" dirty="0">
              <a:latin typeface="Calibri"/>
              <a:cs typeface="Calibri"/>
            </a:endParaRPr>
          </a:p>
          <a:p>
            <a:pPr>
              <a:buNone/>
            </a:pPr>
            <a:r>
              <a:rPr lang="en-US" dirty="0">
                <a:latin typeface="Calibri"/>
                <a:cs typeface="Calibri"/>
              </a:rPr>
              <a:t>Discussion question: Facilitator can ask the audience what differences they may see in a patient with methanol intoxication or ethylene glycol intoxication. Answer, they may see an osmolar gap between the calculated serum osmolality and the measured serum osmolality.</a:t>
            </a:r>
          </a:p>
        </p:txBody>
      </p:sp>
    </p:spTree>
    <p:extLst>
      <p:ext uri="{BB962C8B-B14F-4D97-AF65-F5344CB8AC3E}">
        <p14:creationId xmlns:p14="http://schemas.microsoft.com/office/powerpoint/2010/main" val="1115848459"/>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3"/>
        <p:cNvGrpSpPr/>
        <p:nvPr/>
      </p:nvGrpSpPr>
      <p:grpSpPr>
        <a:xfrm>
          <a:off x="0" y="0"/>
          <a:ext cx="0" cy="0"/>
          <a:chOff x="0" y="0"/>
          <a:chExt cx="0" cy="0"/>
        </a:xfrm>
      </p:grpSpPr>
      <p:sp>
        <p:nvSpPr>
          <p:cNvPr id="334" name="Google Shape;334;g7834a636a1_1_29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35" name="Google Shape;335;g7834a636a1_1_29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39700" indent="0">
              <a:buNone/>
            </a:pPr>
            <a:r>
              <a:rPr lang="en-US" dirty="0"/>
              <a:t>First medication to administer is calcium gluconate (or calcium chloride) to stabilize the cardiac membrane</a:t>
            </a:r>
          </a:p>
        </p:txBody>
      </p:sp>
    </p:spTree>
    <p:extLst>
      <p:ext uri="{BB962C8B-B14F-4D97-AF65-F5344CB8AC3E}">
        <p14:creationId xmlns:p14="http://schemas.microsoft.com/office/powerpoint/2010/main" val="1460816496"/>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9"/>
        <p:cNvGrpSpPr/>
        <p:nvPr/>
      </p:nvGrpSpPr>
      <p:grpSpPr>
        <a:xfrm>
          <a:off x="0" y="0"/>
          <a:ext cx="0" cy="0"/>
          <a:chOff x="0" y="0"/>
          <a:chExt cx="0" cy="0"/>
        </a:xfrm>
      </p:grpSpPr>
      <p:sp>
        <p:nvSpPr>
          <p:cNvPr id="340" name="Google Shape;340;g7834a636a1_1_29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41" name="Google Shape;341;g7834a636a1_1_29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endParaRPr lang="en-US"/>
          </a:p>
        </p:txBody>
      </p:sp>
    </p:spTree>
    <p:extLst>
      <p:ext uri="{BB962C8B-B14F-4D97-AF65-F5344CB8AC3E}">
        <p14:creationId xmlns:p14="http://schemas.microsoft.com/office/powerpoint/2010/main" val="195560986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2"/>
        <p:cNvGrpSpPr/>
        <p:nvPr/>
      </p:nvGrpSpPr>
      <p:grpSpPr>
        <a:xfrm>
          <a:off x="0" y="0"/>
          <a:ext cx="0" cy="0"/>
          <a:chOff x="0" y="0"/>
          <a:chExt cx="0" cy="0"/>
        </a:xfrm>
      </p:grpSpPr>
      <p:sp>
        <p:nvSpPr>
          <p:cNvPr id="233" name="Google Shape;233;g7834a636a1_0_23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4" name="Google Shape;234;g7834a636a1_0_23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dirty="0"/>
              <a:t>Facilitator Instructions: Slide 2 is the "home" slide for the review game. Under each category, each of the five boxes ($200, $400, etc.) link to a question. Allow the teams to choose which question they want to attempt to answer, and click their choice to move to that question. Other slides in this PowerPoint have a link "Back to Panel" which will bring the facilitator back to slide 2.</a:t>
            </a:r>
          </a:p>
          <a:p>
            <a:pPr marL="0" indent="0">
              <a:buNone/>
            </a:pPr>
            <a:endParaRPr lang="en-US" dirty="0"/>
          </a:p>
          <a:p>
            <a:pPr marL="0" indent="0">
              <a:buNone/>
            </a:pPr>
            <a:r>
              <a:rPr lang="en-US" dirty="0"/>
              <a:t>When the facilitator clicks to a question, the participants will attempt to answer the question. Clicking the -&gt; Key will move the PowerPoint forward to reveal the answer, after which the facilitator should click "Back to Panel." Note: Clicking the cursor on the PowerPoint on any question or answer slide will return the PowerPoint to the slide 2.</a:t>
            </a:r>
          </a:p>
          <a:p>
            <a:pPr marL="0" indent="0">
              <a:buNone/>
            </a:pPr>
            <a:endParaRPr lang="en-US" dirty="0"/>
          </a:p>
          <a:p>
            <a:pPr marL="0" indent="0">
              <a:buNone/>
            </a:pPr>
            <a:r>
              <a:rPr lang="en-US" dirty="0"/>
              <a:t>Note: Some questions include discussion questions that the facilitator can ask the group. These are not meant for additional points, but more so to further highlight skills discussed in the curriculum.</a:t>
            </a:r>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5"/>
        <p:cNvGrpSpPr/>
        <p:nvPr/>
      </p:nvGrpSpPr>
      <p:grpSpPr>
        <a:xfrm>
          <a:off x="0" y="0"/>
          <a:ext cx="0" cy="0"/>
          <a:chOff x="0" y="0"/>
          <a:chExt cx="0" cy="0"/>
        </a:xfrm>
      </p:grpSpPr>
      <p:sp>
        <p:nvSpPr>
          <p:cNvPr id="346" name="Google Shape;346;g7834a636a1_1_30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47" name="Google Shape;347;g7834a636a1_1_30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1"/>
        <p:cNvGrpSpPr/>
        <p:nvPr/>
      </p:nvGrpSpPr>
      <p:grpSpPr>
        <a:xfrm>
          <a:off x="0" y="0"/>
          <a:ext cx="0" cy="0"/>
          <a:chOff x="0" y="0"/>
          <a:chExt cx="0" cy="0"/>
        </a:xfrm>
      </p:grpSpPr>
      <p:sp>
        <p:nvSpPr>
          <p:cNvPr id="352" name="Google Shape;352;g7834a636a1_1_30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53" name="Google Shape;353;g7834a636a1_1_30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endParaRPr lang="en-US"/>
          </a:p>
        </p:txBody>
      </p:sp>
    </p:spTree>
    <p:extLst>
      <p:ext uri="{BB962C8B-B14F-4D97-AF65-F5344CB8AC3E}">
        <p14:creationId xmlns:p14="http://schemas.microsoft.com/office/powerpoint/2010/main" val="1392042154"/>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7"/>
        <p:cNvGrpSpPr/>
        <p:nvPr/>
      </p:nvGrpSpPr>
      <p:grpSpPr>
        <a:xfrm>
          <a:off x="0" y="0"/>
          <a:ext cx="0" cy="0"/>
          <a:chOff x="0" y="0"/>
          <a:chExt cx="0" cy="0"/>
        </a:xfrm>
      </p:grpSpPr>
      <p:sp>
        <p:nvSpPr>
          <p:cNvPr id="358" name="Google Shape;358;g7834a636a1_1_3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59" name="Google Shape;359;g7834a636a1_1_3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a:buNone/>
            </a:pPr>
            <a:r>
              <a:rPr lang="en-US" dirty="0">
                <a:latin typeface="Calibri"/>
                <a:cs typeface="Calibri"/>
              </a:rPr>
              <a:t>Maneuvers to treat a "</a:t>
            </a:r>
            <a:r>
              <a:rPr lang="en-US" dirty="0" err="1">
                <a:latin typeface="Calibri"/>
                <a:cs typeface="Calibri"/>
              </a:rPr>
              <a:t>tet</a:t>
            </a:r>
            <a:r>
              <a:rPr lang="en-US" dirty="0">
                <a:latin typeface="Calibri"/>
                <a:cs typeface="Calibri"/>
              </a:rPr>
              <a:t>" spell increase SVR and decrease PVR, effectively forcing shunting of deoxygenated blood to the lungs and subsequently to the systemic vasculature, rather than allowing deoxygenated blood to go to the systemic vasculature.</a:t>
            </a:r>
          </a:p>
        </p:txBody>
      </p:sp>
    </p:spTree>
    <p:extLst>
      <p:ext uri="{BB962C8B-B14F-4D97-AF65-F5344CB8AC3E}">
        <p14:creationId xmlns:p14="http://schemas.microsoft.com/office/powerpoint/2010/main" val="4245743397"/>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3"/>
        <p:cNvGrpSpPr/>
        <p:nvPr/>
      </p:nvGrpSpPr>
      <p:grpSpPr>
        <a:xfrm>
          <a:off x="0" y="0"/>
          <a:ext cx="0" cy="0"/>
          <a:chOff x="0" y="0"/>
          <a:chExt cx="0" cy="0"/>
        </a:xfrm>
      </p:grpSpPr>
      <p:sp>
        <p:nvSpPr>
          <p:cNvPr id="364" name="Google Shape;364;g7834a636a1_1_32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65" name="Google Shape;365;g7834a636a1_1_32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3"/>
        <p:cNvGrpSpPr/>
        <p:nvPr/>
      </p:nvGrpSpPr>
      <p:grpSpPr>
        <a:xfrm>
          <a:off x="0" y="0"/>
          <a:ext cx="0" cy="0"/>
          <a:chOff x="0" y="0"/>
          <a:chExt cx="0" cy="0"/>
        </a:xfrm>
      </p:grpSpPr>
      <p:sp>
        <p:nvSpPr>
          <p:cNvPr id="364" name="Google Shape;364;g7834a636a1_1_32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65" name="Google Shape;365;g7834a636a1_1_32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extLst>
      <p:ext uri="{BB962C8B-B14F-4D97-AF65-F5344CB8AC3E}">
        <p14:creationId xmlns:p14="http://schemas.microsoft.com/office/powerpoint/2010/main" val="4032902534"/>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9"/>
        <p:cNvGrpSpPr/>
        <p:nvPr/>
      </p:nvGrpSpPr>
      <p:grpSpPr>
        <a:xfrm>
          <a:off x="0" y="0"/>
          <a:ext cx="0" cy="0"/>
          <a:chOff x="0" y="0"/>
          <a:chExt cx="0" cy="0"/>
        </a:xfrm>
      </p:grpSpPr>
      <p:sp>
        <p:nvSpPr>
          <p:cNvPr id="370" name="Google Shape;370;g7834a636a1_1_32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71" name="Google Shape;371;g7834a636a1_1_32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9"/>
        <p:cNvGrpSpPr/>
        <p:nvPr/>
      </p:nvGrpSpPr>
      <p:grpSpPr>
        <a:xfrm>
          <a:off x="0" y="0"/>
          <a:ext cx="0" cy="0"/>
          <a:chOff x="0" y="0"/>
          <a:chExt cx="0" cy="0"/>
        </a:xfrm>
      </p:grpSpPr>
      <p:sp>
        <p:nvSpPr>
          <p:cNvPr id="370" name="Google Shape;370;g7834a636a1_1_32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71" name="Google Shape;371;g7834a636a1_1_32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extLst>
      <p:ext uri="{BB962C8B-B14F-4D97-AF65-F5344CB8AC3E}">
        <p14:creationId xmlns:p14="http://schemas.microsoft.com/office/powerpoint/2010/main" val="2420254069"/>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5"/>
        <p:cNvGrpSpPr/>
        <p:nvPr/>
      </p:nvGrpSpPr>
      <p:grpSpPr>
        <a:xfrm>
          <a:off x="0" y="0"/>
          <a:ext cx="0" cy="0"/>
          <a:chOff x="0" y="0"/>
          <a:chExt cx="0" cy="0"/>
        </a:xfrm>
      </p:grpSpPr>
      <p:sp>
        <p:nvSpPr>
          <p:cNvPr id="376" name="Google Shape;376;g7834a636a1_1_33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77" name="Google Shape;377;g7834a636a1_1_33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3"/>
        <p:cNvGrpSpPr/>
        <p:nvPr/>
      </p:nvGrpSpPr>
      <p:grpSpPr>
        <a:xfrm>
          <a:off x="0" y="0"/>
          <a:ext cx="0" cy="0"/>
          <a:chOff x="0" y="0"/>
          <a:chExt cx="0" cy="0"/>
        </a:xfrm>
      </p:grpSpPr>
      <p:sp>
        <p:nvSpPr>
          <p:cNvPr id="274" name="Google Shape;274;g7834a636a1_0_29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75" name="Google Shape;275;g7834a636a1_0_29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800" b="0" i="0" u="none" strike="noStrike" dirty="0">
                <a:effectLst/>
              </a:rPr>
              <a:t>Each question in the CBC </a:t>
            </a:r>
            <a:r>
              <a:rPr lang="en-US" sz="1800" dirty="0"/>
              <a:t>category</a:t>
            </a:r>
            <a:r>
              <a:rPr lang="en-US" sz="1800" b="0" i="0" u="none" strike="noStrike" dirty="0">
                <a:effectLst/>
              </a:rPr>
              <a:t> involves the players being given part of- or all of a CBC.</a:t>
            </a:r>
          </a:p>
        </p:txBody>
      </p:sp>
    </p:spTree>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5"/>
        <p:cNvGrpSpPr/>
        <p:nvPr/>
      </p:nvGrpSpPr>
      <p:grpSpPr>
        <a:xfrm>
          <a:off x="0" y="0"/>
          <a:ext cx="0" cy="0"/>
          <a:chOff x="0" y="0"/>
          <a:chExt cx="0" cy="0"/>
        </a:xfrm>
      </p:grpSpPr>
      <p:sp>
        <p:nvSpPr>
          <p:cNvPr id="376" name="Google Shape;376;g7834a636a1_1_33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77" name="Google Shape;377;g7834a636a1_1_33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extLst>
      <p:ext uri="{BB962C8B-B14F-4D97-AF65-F5344CB8AC3E}">
        <p14:creationId xmlns:p14="http://schemas.microsoft.com/office/powerpoint/2010/main" val="3685524053"/>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1"/>
        <p:cNvGrpSpPr/>
        <p:nvPr/>
      </p:nvGrpSpPr>
      <p:grpSpPr>
        <a:xfrm>
          <a:off x="0" y="0"/>
          <a:ext cx="0" cy="0"/>
          <a:chOff x="0" y="0"/>
          <a:chExt cx="0" cy="0"/>
        </a:xfrm>
      </p:grpSpPr>
      <p:sp>
        <p:nvSpPr>
          <p:cNvPr id="382" name="Google Shape;382;g7834a636a1_1_33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83" name="Google Shape;383;g7834a636a1_1_33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1"/>
        <p:cNvGrpSpPr/>
        <p:nvPr/>
      </p:nvGrpSpPr>
      <p:grpSpPr>
        <a:xfrm>
          <a:off x="0" y="0"/>
          <a:ext cx="0" cy="0"/>
          <a:chOff x="0" y="0"/>
          <a:chExt cx="0" cy="0"/>
        </a:xfrm>
      </p:grpSpPr>
      <p:sp>
        <p:nvSpPr>
          <p:cNvPr id="382" name="Google Shape;382;g7834a636a1_1_33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83" name="Google Shape;383;g7834a636a1_1_33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extLst>
      <p:ext uri="{BB962C8B-B14F-4D97-AF65-F5344CB8AC3E}">
        <p14:creationId xmlns:p14="http://schemas.microsoft.com/office/powerpoint/2010/main" val="2493142435"/>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7"/>
        <p:cNvGrpSpPr/>
        <p:nvPr/>
      </p:nvGrpSpPr>
      <p:grpSpPr>
        <a:xfrm>
          <a:off x="0" y="0"/>
          <a:ext cx="0" cy="0"/>
          <a:chOff x="0" y="0"/>
          <a:chExt cx="0" cy="0"/>
        </a:xfrm>
      </p:grpSpPr>
      <p:sp>
        <p:nvSpPr>
          <p:cNvPr id="388" name="Google Shape;388;g7834a636a1_1_34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89" name="Google Shape;389;g7834a636a1_1_34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7"/>
        <p:cNvGrpSpPr/>
        <p:nvPr/>
      </p:nvGrpSpPr>
      <p:grpSpPr>
        <a:xfrm>
          <a:off x="0" y="0"/>
          <a:ext cx="0" cy="0"/>
          <a:chOff x="0" y="0"/>
          <a:chExt cx="0" cy="0"/>
        </a:xfrm>
      </p:grpSpPr>
      <p:sp>
        <p:nvSpPr>
          <p:cNvPr id="388" name="Google Shape;388;g7834a636a1_1_34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89" name="Google Shape;389;g7834a636a1_1_34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extLst>
      <p:ext uri="{BB962C8B-B14F-4D97-AF65-F5344CB8AC3E}">
        <p14:creationId xmlns:p14="http://schemas.microsoft.com/office/powerpoint/2010/main" val="1161894511"/>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53"/>
        <p:cNvGrpSpPr/>
        <p:nvPr/>
      </p:nvGrpSpPr>
      <p:grpSpPr>
        <a:xfrm>
          <a:off x="0" y="0"/>
          <a:ext cx="0" cy="0"/>
          <a:chOff x="0" y="0"/>
          <a:chExt cx="0" cy="0"/>
        </a:xfrm>
      </p:grpSpPr>
      <p:sp>
        <p:nvSpPr>
          <p:cNvPr id="454" name="Google Shape;454;g7834a636a1_1_89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55" name="Google Shape;455;g7834a636a1_1_89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51"/>
        <p:cNvGrpSpPr/>
        <p:nvPr/>
      </p:nvGrpSpPr>
      <p:grpSpPr>
        <a:xfrm>
          <a:off x="0" y="0"/>
          <a:ext cx="0" cy="0"/>
          <a:chOff x="0" y="0"/>
          <a:chExt cx="0" cy="0"/>
        </a:xfrm>
      </p:grpSpPr>
      <p:sp>
        <p:nvSpPr>
          <p:cNvPr id="652" name="Google Shape;652;g2794d772b92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53" name="Google Shape;653;g2794d772b92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39700" indent="0">
              <a:buNone/>
            </a:pPr>
            <a:r>
              <a:rPr lang="en-US"/>
              <a:t>In iron deficiency anemia, there are fewer RBCs created and they are smaller so the numerator and denominator are both small -&gt; &gt;13 </a:t>
            </a:r>
          </a:p>
          <a:p>
            <a:pPr marL="139700" indent="0">
              <a:buNone/>
            </a:pPr>
            <a:r>
              <a:rPr lang="en-US"/>
              <a:t>In Thalassemia, there is a normal amount of RBCs created but they’re fragile and small </a:t>
            </a:r>
          </a:p>
        </p:txBody>
      </p:sp>
    </p:spTree>
    <p:extLst>
      <p:ext uri="{BB962C8B-B14F-4D97-AF65-F5344CB8AC3E}">
        <p14:creationId xmlns:p14="http://schemas.microsoft.com/office/powerpoint/2010/main" val="41608599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9"/>
        <p:cNvGrpSpPr/>
        <p:nvPr/>
      </p:nvGrpSpPr>
      <p:grpSpPr>
        <a:xfrm>
          <a:off x="0" y="0"/>
          <a:ext cx="0" cy="0"/>
          <a:chOff x="0" y="0"/>
          <a:chExt cx="0" cy="0"/>
        </a:xfrm>
      </p:grpSpPr>
      <p:sp>
        <p:nvSpPr>
          <p:cNvPr id="280" name="Google Shape;280;g7834a636a1_1_23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81" name="Google Shape;281;g7834a636a1_1_23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a:buNone/>
            </a:pPr>
            <a:r>
              <a:rPr lang="en-US" dirty="0">
                <a:latin typeface="Calibri"/>
                <a:ea typeface="Calibri"/>
                <a:cs typeface="Calibri"/>
              </a:rPr>
              <a:t>The Mean Platelet Volume (MPV) can be a helpful clue in differentiating between </a:t>
            </a:r>
            <a:r>
              <a:rPr lang="en-US" dirty="0" err="1">
                <a:latin typeface="Calibri"/>
                <a:ea typeface="Calibri"/>
                <a:cs typeface="Calibri"/>
              </a:rPr>
              <a:t>Wiskott</a:t>
            </a:r>
            <a:r>
              <a:rPr lang="en-US" dirty="0">
                <a:latin typeface="Calibri"/>
                <a:ea typeface="Calibri"/>
                <a:cs typeface="Calibri"/>
              </a:rPr>
              <a:t>-Aldritch Syndrome and ITP. MPV is often elevated in ITP, and low or low-normal in WAS.</a:t>
            </a:r>
          </a:p>
          <a:p>
            <a:pPr>
              <a:buNone/>
            </a:pPr>
            <a:endParaRPr lang="en-US" dirty="0">
              <a:latin typeface="Calibri"/>
              <a:ea typeface="Calibri"/>
              <a:cs typeface="Calibri"/>
            </a:endParaRPr>
          </a:p>
          <a:p>
            <a:pPr>
              <a:buNone/>
            </a:pPr>
            <a:r>
              <a:rPr lang="en-US" dirty="0">
                <a:latin typeface="Calibri"/>
                <a:ea typeface="Calibri"/>
                <a:cs typeface="Calibri"/>
              </a:rPr>
              <a:t>Discussion question: In a patient with a </a:t>
            </a:r>
            <a:r>
              <a:rPr lang="en-US" dirty="0" err="1">
                <a:latin typeface="Calibri"/>
                <a:ea typeface="Calibri"/>
                <a:cs typeface="Calibri"/>
              </a:rPr>
              <a:t>petechiael</a:t>
            </a:r>
            <a:r>
              <a:rPr lang="en-US" dirty="0">
                <a:latin typeface="Calibri"/>
                <a:ea typeface="Calibri"/>
                <a:cs typeface="Calibri"/>
              </a:rPr>
              <a:t> rash, what clinical reasoning skill is exemplified by evaluating the MPV on your CBC to guide next steps?</a:t>
            </a:r>
          </a:p>
        </p:txBody>
      </p:sp>
    </p:spTree>
    <p:extLst>
      <p:ext uri="{BB962C8B-B14F-4D97-AF65-F5344CB8AC3E}">
        <p14:creationId xmlns:p14="http://schemas.microsoft.com/office/powerpoint/2010/main" val="147218414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5"/>
        <p:cNvGrpSpPr/>
        <p:nvPr/>
      </p:nvGrpSpPr>
      <p:grpSpPr>
        <a:xfrm>
          <a:off x="0" y="0"/>
          <a:ext cx="0" cy="0"/>
          <a:chOff x="0" y="0"/>
          <a:chExt cx="0" cy="0"/>
        </a:xfrm>
      </p:grpSpPr>
      <p:sp>
        <p:nvSpPr>
          <p:cNvPr id="286" name="Google Shape;286;g7834a636a1_1_23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87" name="Google Shape;287;g7834a636a1_1_23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a:buNone/>
            </a:pPr>
            <a:r>
              <a:rPr lang="en-US" dirty="0">
                <a:latin typeface="Calibri"/>
                <a:cs typeface="Calibri"/>
              </a:rPr>
              <a:t>Discussion question: These features include signs, symptoms, and laboratory findings consistent with acute leukemia, and make up a large component of an illness script for leukemia. Is there anything else you would consider including? This can vary from provider to provider.</a:t>
            </a:r>
          </a:p>
        </p:txBody>
      </p:sp>
    </p:spTree>
    <p:extLst>
      <p:ext uri="{BB962C8B-B14F-4D97-AF65-F5344CB8AC3E}">
        <p14:creationId xmlns:p14="http://schemas.microsoft.com/office/powerpoint/2010/main" val="1762780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type="title">
  <p:cSld name="TITLE">
    <p:spTree>
      <p:nvGrpSpPr>
        <p:cNvPr id="1" name="Shape 99"/>
        <p:cNvGrpSpPr/>
        <p:nvPr/>
      </p:nvGrpSpPr>
      <p:grpSpPr>
        <a:xfrm>
          <a:off x="0" y="0"/>
          <a:ext cx="0" cy="0"/>
          <a:chOff x="0" y="0"/>
          <a:chExt cx="0" cy="0"/>
        </a:xfrm>
      </p:grpSpPr>
      <p:sp>
        <p:nvSpPr>
          <p:cNvPr id="100" name="Google Shape;100;p2"/>
          <p:cNvSpPr txBox="1">
            <a:spLocks noGrp="1"/>
          </p:cNvSpPr>
          <p:nvPr>
            <p:ph type="ctrTitle"/>
          </p:nvPr>
        </p:nvSpPr>
        <p:spPr>
          <a:xfrm>
            <a:off x="685800" y="2694400"/>
            <a:ext cx="7772400" cy="607800"/>
          </a:xfrm>
          <a:prstGeom prst="rect">
            <a:avLst/>
          </a:prstGeom>
          <a:effectLst>
            <a:reflection stA="25000" endPos="60000" fadeDir="5400012" sy="-100000" algn="bl" rotWithShape="0"/>
          </a:effectLst>
        </p:spPr>
        <p:txBody>
          <a:bodyPr spcFirstLastPara="1" wrap="square" lIns="0" tIns="0" rIns="0" bIns="0" anchor="t" anchorCtr="0">
            <a:noAutofit/>
          </a:bodyPr>
          <a:lstStyle>
            <a:lvl1pPr lvl="0" algn="ctr" rtl="0">
              <a:spcBef>
                <a:spcPts val="0"/>
              </a:spcBef>
              <a:spcAft>
                <a:spcPts val="0"/>
              </a:spcAft>
              <a:buSzPts val="5500"/>
              <a:buNone/>
              <a:defRPr sz="5500"/>
            </a:lvl1pPr>
            <a:lvl2pPr lvl="1" algn="ctr" rtl="0">
              <a:spcBef>
                <a:spcPts val="0"/>
              </a:spcBef>
              <a:spcAft>
                <a:spcPts val="0"/>
              </a:spcAft>
              <a:buSzPts val="5500"/>
              <a:buNone/>
              <a:defRPr sz="5500"/>
            </a:lvl2pPr>
            <a:lvl3pPr lvl="2" algn="ctr" rtl="0">
              <a:spcBef>
                <a:spcPts val="0"/>
              </a:spcBef>
              <a:spcAft>
                <a:spcPts val="0"/>
              </a:spcAft>
              <a:buSzPts val="5500"/>
              <a:buNone/>
              <a:defRPr sz="5500"/>
            </a:lvl3pPr>
            <a:lvl4pPr lvl="3" algn="ctr" rtl="0">
              <a:spcBef>
                <a:spcPts val="0"/>
              </a:spcBef>
              <a:spcAft>
                <a:spcPts val="0"/>
              </a:spcAft>
              <a:buSzPts val="5500"/>
              <a:buNone/>
              <a:defRPr sz="5500"/>
            </a:lvl4pPr>
            <a:lvl5pPr lvl="4" algn="ctr" rtl="0">
              <a:spcBef>
                <a:spcPts val="0"/>
              </a:spcBef>
              <a:spcAft>
                <a:spcPts val="0"/>
              </a:spcAft>
              <a:buSzPts val="5500"/>
              <a:buNone/>
              <a:defRPr sz="5500"/>
            </a:lvl5pPr>
            <a:lvl6pPr lvl="5" algn="ctr" rtl="0">
              <a:spcBef>
                <a:spcPts val="0"/>
              </a:spcBef>
              <a:spcAft>
                <a:spcPts val="0"/>
              </a:spcAft>
              <a:buSzPts val="5500"/>
              <a:buNone/>
              <a:defRPr sz="5500"/>
            </a:lvl6pPr>
            <a:lvl7pPr lvl="6" algn="ctr" rtl="0">
              <a:spcBef>
                <a:spcPts val="0"/>
              </a:spcBef>
              <a:spcAft>
                <a:spcPts val="0"/>
              </a:spcAft>
              <a:buSzPts val="5500"/>
              <a:buNone/>
              <a:defRPr sz="5500"/>
            </a:lvl7pPr>
            <a:lvl8pPr lvl="7" algn="ctr" rtl="0">
              <a:spcBef>
                <a:spcPts val="0"/>
              </a:spcBef>
              <a:spcAft>
                <a:spcPts val="0"/>
              </a:spcAft>
              <a:buSzPts val="5500"/>
              <a:buNone/>
              <a:defRPr sz="5500"/>
            </a:lvl8pPr>
            <a:lvl9pPr lvl="8" algn="ctr" rtl="0">
              <a:spcBef>
                <a:spcPts val="0"/>
              </a:spcBef>
              <a:spcAft>
                <a:spcPts val="0"/>
              </a:spcAft>
              <a:buSzPts val="5500"/>
              <a:buNone/>
              <a:defRPr sz="5500"/>
            </a:lvl9pPr>
          </a:lstStyle>
          <a:p>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207"/>
        <p:cNvGrpSpPr/>
        <p:nvPr/>
      </p:nvGrpSpPr>
      <p:grpSpPr>
        <a:xfrm>
          <a:off x="0" y="0"/>
          <a:ext cx="0" cy="0"/>
          <a:chOff x="0" y="0"/>
          <a:chExt cx="0" cy="0"/>
        </a:xfrm>
      </p:grpSpPr>
      <p:grpSp>
        <p:nvGrpSpPr>
          <p:cNvPr id="208" name="Google Shape;208;p13"/>
          <p:cNvGrpSpPr/>
          <p:nvPr/>
        </p:nvGrpSpPr>
        <p:grpSpPr>
          <a:xfrm>
            <a:off x="695700" y="695700"/>
            <a:ext cx="7752600" cy="3752100"/>
            <a:chOff x="695700" y="695700"/>
            <a:chExt cx="7752600" cy="3752100"/>
          </a:xfrm>
        </p:grpSpPr>
        <p:sp>
          <p:nvSpPr>
            <p:cNvPr id="209" name="Google Shape;209;p13"/>
            <p:cNvSpPr/>
            <p:nvPr/>
          </p:nvSpPr>
          <p:spPr>
            <a:xfrm>
              <a:off x="695700" y="695700"/>
              <a:ext cx="7752600" cy="3752100"/>
            </a:xfrm>
            <a:prstGeom prst="rect">
              <a:avLst/>
            </a:prstGeom>
            <a:gradFill>
              <a:gsLst>
                <a:gs pos="0">
                  <a:schemeClr val="accent2"/>
                </a:gs>
                <a:gs pos="100000">
                  <a:schemeClr val="accent1"/>
                </a:gs>
              </a:gsLst>
              <a:lin ang="5400012" scaled="0"/>
            </a:gradFill>
            <a:ln>
              <a:noFill/>
            </a:ln>
            <a:effectLst>
              <a:outerShdw blurRad="300038" dist="19050" dir="5400000" algn="bl" rotWithShape="0">
                <a:schemeClr val="dk1">
                  <a:alpha val="50000"/>
                </a:scheme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10" name="Google Shape;210;p13"/>
            <p:cNvSpPr/>
            <p:nvPr/>
          </p:nvSpPr>
          <p:spPr>
            <a:xfrm>
              <a:off x="695700" y="695700"/>
              <a:ext cx="7752600" cy="3752100"/>
            </a:xfrm>
            <a:prstGeom prst="frame">
              <a:avLst>
                <a:gd name="adj1" fmla="val 204"/>
              </a:avLst>
            </a:prstGeom>
            <a:gradFill>
              <a:gsLst>
                <a:gs pos="0">
                  <a:schemeClr val="accent3"/>
                </a:gs>
                <a:gs pos="100000">
                  <a:schemeClr val="accent2"/>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211" name="Google Shape;211;p13"/>
          <p:cNvSpPr txBox="1">
            <a:spLocks noGrp="1"/>
          </p:cNvSpPr>
          <p:nvPr>
            <p:ph type="body" idx="1"/>
          </p:nvPr>
        </p:nvSpPr>
        <p:spPr>
          <a:xfrm>
            <a:off x="812975" y="4025300"/>
            <a:ext cx="7518000" cy="393600"/>
          </a:xfrm>
          <a:prstGeom prst="rect">
            <a:avLst/>
          </a:prstGeom>
        </p:spPr>
        <p:txBody>
          <a:bodyPr spcFirstLastPara="1" wrap="square" lIns="0" tIns="0" rIns="0" bIns="0" anchor="t" anchorCtr="0">
            <a:noAutofit/>
          </a:bodyPr>
          <a:lstStyle>
            <a:lvl1pPr marL="457200" lvl="0" indent="-228600" algn="ctr" rtl="0">
              <a:spcBef>
                <a:spcPts val="360"/>
              </a:spcBef>
              <a:spcAft>
                <a:spcPts val="0"/>
              </a:spcAft>
              <a:buSzPts val="1800"/>
              <a:buNone/>
              <a:defRPr sz="1800"/>
            </a:lvl1pPr>
          </a:lstStyle>
          <a:p>
            <a:endParaRPr/>
          </a:p>
        </p:txBody>
      </p:sp>
      <p:sp>
        <p:nvSpPr>
          <p:cNvPr id="212" name="Google Shape;212;p13"/>
          <p:cNvSpPr txBox="1">
            <a:spLocks noGrp="1"/>
          </p:cNvSpPr>
          <p:nvPr>
            <p:ph type="sldNum" idx="12"/>
          </p:nvPr>
        </p:nvSpPr>
        <p:spPr>
          <a:xfrm>
            <a:off x="4297650" y="4749851"/>
            <a:ext cx="548700" cy="393600"/>
          </a:xfrm>
          <a:prstGeom prst="rect">
            <a:avLst/>
          </a:prstGeom>
        </p:spPr>
        <p:txBody>
          <a:bodyPr spcFirstLastPara="1" wrap="square" lIns="0" tIns="0" rIns="0" bIns="0"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ct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213"/>
        <p:cNvGrpSpPr/>
        <p:nvPr/>
      </p:nvGrpSpPr>
      <p:grpSpPr>
        <a:xfrm>
          <a:off x="0" y="0"/>
          <a:ext cx="0" cy="0"/>
          <a:chOff x="0" y="0"/>
          <a:chExt cx="0" cy="0"/>
        </a:xfrm>
      </p:grpSpPr>
      <p:sp>
        <p:nvSpPr>
          <p:cNvPr id="214" name="Google Shape;214;p14"/>
          <p:cNvSpPr txBox="1">
            <a:spLocks noGrp="1"/>
          </p:cNvSpPr>
          <p:nvPr>
            <p:ph type="sldNum" idx="12"/>
          </p:nvPr>
        </p:nvSpPr>
        <p:spPr>
          <a:xfrm>
            <a:off x="4297650" y="4749851"/>
            <a:ext cx="548700" cy="393600"/>
          </a:xfrm>
          <a:prstGeom prst="rect">
            <a:avLst/>
          </a:prstGeom>
        </p:spPr>
        <p:txBody>
          <a:bodyPr spcFirstLastPara="1" wrap="square" lIns="0" tIns="0" rIns="0" bIns="0"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ct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Title" type="title">
  <p:cSld name="TITLE">
    <p:spTree>
      <p:nvGrpSpPr>
        <p:cNvPr id="1" name="Shape 99"/>
        <p:cNvGrpSpPr/>
        <p:nvPr/>
      </p:nvGrpSpPr>
      <p:grpSpPr>
        <a:xfrm>
          <a:off x="0" y="0"/>
          <a:ext cx="0" cy="0"/>
          <a:chOff x="0" y="0"/>
          <a:chExt cx="0" cy="0"/>
        </a:xfrm>
      </p:grpSpPr>
      <p:sp>
        <p:nvSpPr>
          <p:cNvPr id="100" name="Google Shape;100;p69"/>
          <p:cNvSpPr txBox="1">
            <a:spLocks noGrp="1"/>
          </p:cNvSpPr>
          <p:nvPr>
            <p:ph type="ctrTitle"/>
          </p:nvPr>
        </p:nvSpPr>
        <p:spPr>
          <a:xfrm>
            <a:off x="685800" y="2694400"/>
            <a:ext cx="7772400" cy="607800"/>
          </a:xfrm>
          <a:prstGeom prst="rect">
            <a:avLst/>
          </a:prstGeom>
          <a:noFill/>
          <a:ln>
            <a:noFill/>
          </a:ln>
          <a:effectLst>
            <a:reflection stA="25000" endPos="60000" fadeDir="5400012" sy="-100000" algn="bl" rotWithShape="0"/>
          </a:effectLst>
        </p:spPr>
        <p:txBody>
          <a:bodyPr spcFirstLastPara="1" wrap="square" lIns="0" tIns="0" rIns="0" bIns="0" anchor="t" anchorCtr="0">
            <a:noAutofit/>
          </a:bodyPr>
          <a:lstStyle>
            <a:lvl1pPr lvl="0" algn="ctr">
              <a:lnSpc>
                <a:spcPct val="90000"/>
              </a:lnSpc>
              <a:spcBef>
                <a:spcPts val="0"/>
              </a:spcBef>
              <a:spcAft>
                <a:spcPts val="0"/>
              </a:spcAft>
              <a:buSzPts val="5500"/>
              <a:buNone/>
              <a:defRPr sz="5500"/>
            </a:lvl1pPr>
            <a:lvl2pPr lvl="1" algn="ctr">
              <a:lnSpc>
                <a:spcPct val="90000"/>
              </a:lnSpc>
              <a:spcBef>
                <a:spcPts val="0"/>
              </a:spcBef>
              <a:spcAft>
                <a:spcPts val="0"/>
              </a:spcAft>
              <a:buSzPts val="5500"/>
              <a:buNone/>
              <a:defRPr sz="5500"/>
            </a:lvl2pPr>
            <a:lvl3pPr lvl="2" algn="ctr">
              <a:lnSpc>
                <a:spcPct val="90000"/>
              </a:lnSpc>
              <a:spcBef>
                <a:spcPts val="0"/>
              </a:spcBef>
              <a:spcAft>
                <a:spcPts val="0"/>
              </a:spcAft>
              <a:buSzPts val="5500"/>
              <a:buNone/>
              <a:defRPr sz="5500"/>
            </a:lvl3pPr>
            <a:lvl4pPr lvl="3" algn="ctr">
              <a:lnSpc>
                <a:spcPct val="90000"/>
              </a:lnSpc>
              <a:spcBef>
                <a:spcPts val="0"/>
              </a:spcBef>
              <a:spcAft>
                <a:spcPts val="0"/>
              </a:spcAft>
              <a:buSzPts val="5500"/>
              <a:buNone/>
              <a:defRPr sz="5500"/>
            </a:lvl4pPr>
            <a:lvl5pPr lvl="4" algn="ctr">
              <a:lnSpc>
                <a:spcPct val="90000"/>
              </a:lnSpc>
              <a:spcBef>
                <a:spcPts val="0"/>
              </a:spcBef>
              <a:spcAft>
                <a:spcPts val="0"/>
              </a:spcAft>
              <a:buSzPts val="5500"/>
              <a:buNone/>
              <a:defRPr sz="5500"/>
            </a:lvl5pPr>
            <a:lvl6pPr lvl="5" algn="ctr">
              <a:lnSpc>
                <a:spcPct val="90000"/>
              </a:lnSpc>
              <a:spcBef>
                <a:spcPts val="0"/>
              </a:spcBef>
              <a:spcAft>
                <a:spcPts val="0"/>
              </a:spcAft>
              <a:buSzPts val="5500"/>
              <a:buNone/>
              <a:defRPr sz="5500"/>
            </a:lvl6pPr>
            <a:lvl7pPr lvl="6" algn="ctr">
              <a:lnSpc>
                <a:spcPct val="90000"/>
              </a:lnSpc>
              <a:spcBef>
                <a:spcPts val="0"/>
              </a:spcBef>
              <a:spcAft>
                <a:spcPts val="0"/>
              </a:spcAft>
              <a:buSzPts val="5500"/>
              <a:buNone/>
              <a:defRPr sz="5500"/>
            </a:lvl7pPr>
            <a:lvl8pPr lvl="7" algn="ctr">
              <a:lnSpc>
                <a:spcPct val="90000"/>
              </a:lnSpc>
              <a:spcBef>
                <a:spcPts val="0"/>
              </a:spcBef>
              <a:spcAft>
                <a:spcPts val="0"/>
              </a:spcAft>
              <a:buSzPts val="5500"/>
              <a:buNone/>
              <a:defRPr sz="5500"/>
            </a:lvl8pPr>
            <a:lvl9pPr lvl="8" algn="ctr">
              <a:lnSpc>
                <a:spcPct val="90000"/>
              </a:lnSpc>
              <a:spcBef>
                <a:spcPts val="0"/>
              </a:spcBef>
              <a:spcAft>
                <a:spcPts val="0"/>
              </a:spcAft>
              <a:buSzPts val="5500"/>
              <a:buNone/>
              <a:defRPr sz="5500"/>
            </a:lvl9pPr>
          </a:lstStyle>
          <a:p>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JEOPARTY Panel">
  <p:cSld name="TITLE_ONLY_2">
    <p:spTree>
      <p:nvGrpSpPr>
        <p:cNvPr id="1" name="Shape 101"/>
        <p:cNvGrpSpPr/>
        <p:nvPr/>
      </p:nvGrpSpPr>
      <p:grpSpPr>
        <a:xfrm>
          <a:off x="0" y="0"/>
          <a:ext cx="0" cy="0"/>
          <a:chOff x="0" y="0"/>
          <a:chExt cx="0" cy="0"/>
        </a:xfrm>
      </p:grpSpPr>
      <p:sp>
        <p:nvSpPr>
          <p:cNvPr id="102" name="Google Shape;102;p70"/>
          <p:cNvSpPr/>
          <p:nvPr/>
        </p:nvSpPr>
        <p:spPr>
          <a:xfrm>
            <a:off x="485311" y="484852"/>
            <a:ext cx="8177442" cy="4183216"/>
          </a:xfrm>
          <a:prstGeom prst="rect">
            <a:avLst/>
          </a:prstGeom>
          <a:solidFill>
            <a:schemeClr val="dk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03" name="Google Shape;103;p70"/>
          <p:cNvSpPr txBox="1">
            <a:spLocks noGrp="1"/>
          </p:cNvSpPr>
          <p:nvPr>
            <p:ph type="title"/>
          </p:nvPr>
        </p:nvSpPr>
        <p:spPr>
          <a:xfrm>
            <a:off x="695700" y="0"/>
            <a:ext cx="7752600" cy="484800"/>
          </a:xfrm>
          <a:prstGeom prst="rect">
            <a:avLst/>
          </a:prstGeom>
          <a:noFill/>
          <a:ln>
            <a:noFill/>
          </a:ln>
          <a:effectLst>
            <a:outerShdw blurRad="28575" dist="38100" dir="2700000" algn="bl" rotWithShape="0">
              <a:schemeClr val="dk1">
                <a:alpha val="90980"/>
              </a:schemeClr>
            </a:outerShdw>
          </a:effectLst>
        </p:spPr>
        <p:txBody>
          <a:bodyPr spcFirstLastPara="1" wrap="square" lIns="0" tIns="0" rIns="0" bIns="0" anchor="ctr" anchorCtr="0">
            <a:noAutofit/>
          </a:bodyPr>
          <a:lstStyle>
            <a:lvl1pPr lvl="0" algn="ctr">
              <a:lnSpc>
                <a:spcPct val="90000"/>
              </a:lnSpc>
              <a:spcBef>
                <a:spcPts val="0"/>
              </a:spcBef>
              <a:spcAft>
                <a:spcPts val="0"/>
              </a:spcAft>
              <a:buClr>
                <a:schemeClr val="accent3"/>
              </a:buClr>
              <a:buSzPts val="1400"/>
              <a:buNone/>
              <a:defRPr sz="1400">
                <a:solidFill>
                  <a:schemeClr val="accent3"/>
                </a:solidFill>
              </a:defRPr>
            </a:lvl1pPr>
            <a:lvl2pPr lvl="1" algn="ctr">
              <a:lnSpc>
                <a:spcPct val="90000"/>
              </a:lnSpc>
              <a:spcBef>
                <a:spcPts val="0"/>
              </a:spcBef>
              <a:spcAft>
                <a:spcPts val="0"/>
              </a:spcAft>
              <a:buClr>
                <a:schemeClr val="accent3"/>
              </a:buClr>
              <a:buSzPts val="1400"/>
              <a:buNone/>
              <a:defRPr sz="1400">
                <a:solidFill>
                  <a:schemeClr val="accent3"/>
                </a:solidFill>
              </a:defRPr>
            </a:lvl2pPr>
            <a:lvl3pPr lvl="2" algn="ctr">
              <a:lnSpc>
                <a:spcPct val="90000"/>
              </a:lnSpc>
              <a:spcBef>
                <a:spcPts val="0"/>
              </a:spcBef>
              <a:spcAft>
                <a:spcPts val="0"/>
              </a:spcAft>
              <a:buClr>
                <a:schemeClr val="accent3"/>
              </a:buClr>
              <a:buSzPts val="1400"/>
              <a:buNone/>
              <a:defRPr sz="1400">
                <a:solidFill>
                  <a:schemeClr val="accent3"/>
                </a:solidFill>
              </a:defRPr>
            </a:lvl3pPr>
            <a:lvl4pPr lvl="3" algn="ctr">
              <a:lnSpc>
                <a:spcPct val="90000"/>
              </a:lnSpc>
              <a:spcBef>
                <a:spcPts val="0"/>
              </a:spcBef>
              <a:spcAft>
                <a:spcPts val="0"/>
              </a:spcAft>
              <a:buClr>
                <a:schemeClr val="accent3"/>
              </a:buClr>
              <a:buSzPts val="1400"/>
              <a:buNone/>
              <a:defRPr sz="1400">
                <a:solidFill>
                  <a:schemeClr val="accent3"/>
                </a:solidFill>
              </a:defRPr>
            </a:lvl4pPr>
            <a:lvl5pPr lvl="4" algn="ctr">
              <a:lnSpc>
                <a:spcPct val="90000"/>
              </a:lnSpc>
              <a:spcBef>
                <a:spcPts val="0"/>
              </a:spcBef>
              <a:spcAft>
                <a:spcPts val="0"/>
              </a:spcAft>
              <a:buClr>
                <a:schemeClr val="accent3"/>
              </a:buClr>
              <a:buSzPts val="1400"/>
              <a:buNone/>
              <a:defRPr sz="1400">
                <a:solidFill>
                  <a:schemeClr val="accent3"/>
                </a:solidFill>
              </a:defRPr>
            </a:lvl5pPr>
            <a:lvl6pPr lvl="5" algn="ctr">
              <a:lnSpc>
                <a:spcPct val="90000"/>
              </a:lnSpc>
              <a:spcBef>
                <a:spcPts val="0"/>
              </a:spcBef>
              <a:spcAft>
                <a:spcPts val="0"/>
              </a:spcAft>
              <a:buClr>
                <a:schemeClr val="accent3"/>
              </a:buClr>
              <a:buSzPts val="1400"/>
              <a:buNone/>
              <a:defRPr sz="1400">
                <a:solidFill>
                  <a:schemeClr val="accent3"/>
                </a:solidFill>
              </a:defRPr>
            </a:lvl6pPr>
            <a:lvl7pPr lvl="6" algn="ctr">
              <a:lnSpc>
                <a:spcPct val="90000"/>
              </a:lnSpc>
              <a:spcBef>
                <a:spcPts val="0"/>
              </a:spcBef>
              <a:spcAft>
                <a:spcPts val="0"/>
              </a:spcAft>
              <a:buClr>
                <a:schemeClr val="accent3"/>
              </a:buClr>
              <a:buSzPts val="1400"/>
              <a:buNone/>
              <a:defRPr sz="1400">
                <a:solidFill>
                  <a:schemeClr val="accent3"/>
                </a:solidFill>
              </a:defRPr>
            </a:lvl7pPr>
            <a:lvl8pPr lvl="7" algn="ctr">
              <a:lnSpc>
                <a:spcPct val="90000"/>
              </a:lnSpc>
              <a:spcBef>
                <a:spcPts val="0"/>
              </a:spcBef>
              <a:spcAft>
                <a:spcPts val="0"/>
              </a:spcAft>
              <a:buClr>
                <a:schemeClr val="accent3"/>
              </a:buClr>
              <a:buSzPts val="1400"/>
              <a:buNone/>
              <a:defRPr sz="1400">
                <a:solidFill>
                  <a:schemeClr val="accent3"/>
                </a:solidFill>
              </a:defRPr>
            </a:lvl8pPr>
            <a:lvl9pPr lvl="8" algn="ctr">
              <a:lnSpc>
                <a:spcPct val="90000"/>
              </a:lnSpc>
              <a:spcBef>
                <a:spcPts val="0"/>
              </a:spcBef>
              <a:spcAft>
                <a:spcPts val="0"/>
              </a:spcAft>
              <a:buClr>
                <a:schemeClr val="accent3"/>
              </a:buClr>
              <a:buSzPts val="1400"/>
              <a:buNone/>
              <a:defRPr sz="1400">
                <a:solidFill>
                  <a:schemeClr val="accent3"/>
                </a:solidFill>
              </a:defRPr>
            </a:lvl9pPr>
          </a:lstStyle>
          <a:p>
            <a:endParaRPr/>
          </a:p>
        </p:txBody>
      </p:sp>
      <p:grpSp>
        <p:nvGrpSpPr>
          <p:cNvPr id="104" name="Google Shape;104;p70"/>
          <p:cNvGrpSpPr/>
          <p:nvPr/>
        </p:nvGrpSpPr>
        <p:grpSpPr>
          <a:xfrm>
            <a:off x="572720" y="572673"/>
            <a:ext cx="1265739" cy="4018309"/>
            <a:chOff x="572700" y="572684"/>
            <a:chExt cx="1251349" cy="4018309"/>
          </a:xfrm>
        </p:grpSpPr>
        <p:sp>
          <p:nvSpPr>
            <p:cNvPr id="105" name="Google Shape;105;p70"/>
            <p:cNvSpPr/>
            <p:nvPr/>
          </p:nvSpPr>
          <p:spPr>
            <a:xfrm>
              <a:off x="572700" y="572684"/>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06" name="Google Shape;106;p70"/>
            <p:cNvSpPr/>
            <p:nvPr/>
          </p:nvSpPr>
          <p:spPr>
            <a:xfrm>
              <a:off x="572700" y="1317923"/>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07" name="Google Shape;107;p70"/>
            <p:cNvSpPr/>
            <p:nvPr/>
          </p:nvSpPr>
          <p:spPr>
            <a:xfrm>
              <a:off x="572700" y="1989598"/>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08" name="Google Shape;108;p70"/>
            <p:cNvSpPr/>
            <p:nvPr/>
          </p:nvSpPr>
          <p:spPr>
            <a:xfrm>
              <a:off x="572700" y="2661274"/>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09" name="Google Shape;109;p70"/>
            <p:cNvSpPr/>
            <p:nvPr/>
          </p:nvSpPr>
          <p:spPr>
            <a:xfrm>
              <a:off x="572700" y="3332949"/>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10" name="Google Shape;110;p70"/>
            <p:cNvSpPr/>
            <p:nvPr/>
          </p:nvSpPr>
          <p:spPr>
            <a:xfrm>
              <a:off x="572700" y="4004625"/>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111" name="Google Shape;111;p70"/>
          <p:cNvGrpSpPr/>
          <p:nvPr/>
        </p:nvGrpSpPr>
        <p:grpSpPr>
          <a:xfrm>
            <a:off x="1917802" y="572673"/>
            <a:ext cx="1265739" cy="4018309"/>
            <a:chOff x="1922099" y="572684"/>
            <a:chExt cx="1251349" cy="4018309"/>
          </a:xfrm>
        </p:grpSpPr>
        <p:sp>
          <p:nvSpPr>
            <p:cNvPr id="112" name="Google Shape;112;p70"/>
            <p:cNvSpPr/>
            <p:nvPr/>
          </p:nvSpPr>
          <p:spPr>
            <a:xfrm>
              <a:off x="1922099" y="572684"/>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13" name="Google Shape;113;p70"/>
            <p:cNvSpPr/>
            <p:nvPr/>
          </p:nvSpPr>
          <p:spPr>
            <a:xfrm>
              <a:off x="1922099" y="1317923"/>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14" name="Google Shape;114;p70"/>
            <p:cNvSpPr/>
            <p:nvPr/>
          </p:nvSpPr>
          <p:spPr>
            <a:xfrm>
              <a:off x="1922099" y="1989598"/>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15" name="Google Shape;115;p70"/>
            <p:cNvSpPr/>
            <p:nvPr/>
          </p:nvSpPr>
          <p:spPr>
            <a:xfrm>
              <a:off x="1922099" y="2661274"/>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16" name="Google Shape;116;p70"/>
            <p:cNvSpPr/>
            <p:nvPr/>
          </p:nvSpPr>
          <p:spPr>
            <a:xfrm>
              <a:off x="1922099" y="3332949"/>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17" name="Google Shape;117;p70"/>
            <p:cNvSpPr/>
            <p:nvPr/>
          </p:nvSpPr>
          <p:spPr>
            <a:xfrm>
              <a:off x="1922099" y="4004625"/>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118" name="Google Shape;118;p70"/>
          <p:cNvGrpSpPr/>
          <p:nvPr/>
        </p:nvGrpSpPr>
        <p:grpSpPr>
          <a:xfrm>
            <a:off x="3262884" y="572673"/>
            <a:ext cx="1265739" cy="4018309"/>
            <a:chOff x="3271498" y="572684"/>
            <a:chExt cx="1251349" cy="4018309"/>
          </a:xfrm>
        </p:grpSpPr>
        <p:sp>
          <p:nvSpPr>
            <p:cNvPr id="119" name="Google Shape;119;p70"/>
            <p:cNvSpPr/>
            <p:nvPr/>
          </p:nvSpPr>
          <p:spPr>
            <a:xfrm>
              <a:off x="3271498" y="572684"/>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20" name="Google Shape;120;p70"/>
            <p:cNvSpPr/>
            <p:nvPr/>
          </p:nvSpPr>
          <p:spPr>
            <a:xfrm>
              <a:off x="3271498" y="1317923"/>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21" name="Google Shape;121;p70"/>
            <p:cNvSpPr/>
            <p:nvPr/>
          </p:nvSpPr>
          <p:spPr>
            <a:xfrm>
              <a:off x="3271498" y="1989598"/>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22" name="Google Shape;122;p70"/>
            <p:cNvSpPr/>
            <p:nvPr/>
          </p:nvSpPr>
          <p:spPr>
            <a:xfrm>
              <a:off x="3271498" y="2661274"/>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23" name="Google Shape;123;p70"/>
            <p:cNvSpPr/>
            <p:nvPr/>
          </p:nvSpPr>
          <p:spPr>
            <a:xfrm>
              <a:off x="3271498" y="3332949"/>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24" name="Google Shape;124;p70"/>
            <p:cNvSpPr/>
            <p:nvPr/>
          </p:nvSpPr>
          <p:spPr>
            <a:xfrm>
              <a:off x="3271498" y="4004625"/>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125" name="Google Shape;125;p70"/>
          <p:cNvGrpSpPr/>
          <p:nvPr/>
        </p:nvGrpSpPr>
        <p:grpSpPr>
          <a:xfrm>
            <a:off x="4607967" y="572673"/>
            <a:ext cx="1265739" cy="4018309"/>
            <a:chOff x="4620897" y="572684"/>
            <a:chExt cx="1251349" cy="4018309"/>
          </a:xfrm>
        </p:grpSpPr>
        <p:sp>
          <p:nvSpPr>
            <p:cNvPr id="126" name="Google Shape;126;p70"/>
            <p:cNvSpPr/>
            <p:nvPr/>
          </p:nvSpPr>
          <p:spPr>
            <a:xfrm>
              <a:off x="4620897" y="572684"/>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27" name="Google Shape;127;p70"/>
            <p:cNvSpPr/>
            <p:nvPr/>
          </p:nvSpPr>
          <p:spPr>
            <a:xfrm>
              <a:off x="4620897" y="1317923"/>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28" name="Google Shape;128;p70"/>
            <p:cNvSpPr/>
            <p:nvPr/>
          </p:nvSpPr>
          <p:spPr>
            <a:xfrm>
              <a:off x="4620897" y="1989598"/>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29" name="Google Shape;129;p70"/>
            <p:cNvSpPr/>
            <p:nvPr/>
          </p:nvSpPr>
          <p:spPr>
            <a:xfrm>
              <a:off x="4620897" y="2661274"/>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30" name="Google Shape;130;p70"/>
            <p:cNvSpPr/>
            <p:nvPr/>
          </p:nvSpPr>
          <p:spPr>
            <a:xfrm>
              <a:off x="4620897" y="3332949"/>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31" name="Google Shape;131;p70"/>
            <p:cNvSpPr/>
            <p:nvPr/>
          </p:nvSpPr>
          <p:spPr>
            <a:xfrm>
              <a:off x="4620897" y="4004625"/>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132" name="Google Shape;132;p70"/>
          <p:cNvGrpSpPr/>
          <p:nvPr/>
        </p:nvGrpSpPr>
        <p:grpSpPr>
          <a:xfrm>
            <a:off x="5953049" y="572673"/>
            <a:ext cx="1265739" cy="4018309"/>
            <a:chOff x="5970296" y="572684"/>
            <a:chExt cx="1251349" cy="4018309"/>
          </a:xfrm>
        </p:grpSpPr>
        <p:sp>
          <p:nvSpPr>
            <p:cNvPr id="133" name="Google Shape;133;p70"/>
            <p:cNvSpPr/>
            <p:nvPr/>
          </p:nvSpPr>
          <p:spPr>
            <a:xfrm>
              <a:off x="5970296" y="572684"/>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34" name="Google Shape;134;p70"/>
            <p:cNvSpPr/>
            <p:nvPr/>
          </p:nvSpPr>
          <p:spPr>
            <a:xfrm>
              <a:off x="5970296" y="1317923"/>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35" name="Google Shape;135;p70"/>
            <p:cNvSpPr/>
            <p:nvPr/>
          </p:nvSpPr>
          <p:spPr>
            <a:xfrm>
              <a:off x="5970296" y="1989598"/>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36" name="Google Shape;136;p70"/>
            <p:cNvSpPr/>
            <p:nvPr/>
          </p:nvSpPr>
          <p:spPr>
            <a:xfrm>
              <a:off x="5970296" y="2661274"/>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37" name="Google Shape;137;p70"/>
            <p:cNvSpPr/>
            <p:nvPr/>
          </p:nvSpPr>
          <p:spPr>
            <a:xfrm>
              <a:off x="5970296" y="3332949"/>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38" name="Google Shape;138;p70"/>
            <p:cNvSpPr/>
            <p:nvPr/>
          </p:nvSpPr>
          <p:spPr>
            <a:xfrm>
              <a:off x="5970296" y="4004625"/>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139" name="Google Shape;139;p70"/>
          <p:cNvGrpSpPr/>
          <p:nvPr/>
        </p:nvGrpSpPr>
        <p:grpSpPr>
          <a:xfrm>
            <a:off x="7298131" y="572673"/>
            <a:ext cx="1265739" cy="4018309"/>
            <a:chOff x="7319696" y="572684"/>
            <a:chExt cx="1251349" cy="4018309"/>
          </a:xfrm>
        </p:grpSpPr>
        <p:sp>
          <p:nvSpPr>
            <p:cNvPr id="140" name="Google Shape;140;p70"/>
            <p:cNvSpPr/>
            <p:nvPr/>
          </p:nvSpPr>
          <p:spPr>
            <a:xfrm>
              <a:off x="7319696" y="572684"/>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41" name="Google Shape;141;p70"/>
            <p:cNvSpPr/>
            <p:nvPr/>
          </p:nvSpPr>
          <p:spPr>
            <a:xfrm>
              <a:off x="7319696" y="1317923"/>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42" name="Google Shape;142;p70"/>
            <p:cNvSpPr/>
            <p:nvPr/>
          </p:nvSpPr>
          <p:spPr>
            <a:xfrm>
              <a:off x="7319696" y="1989598"/>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43" name="Google Shape;143;p70"/>
            <p:cNvSpPr/>
            <p:nvPr/>
          </p:nvSpPr>
          <p:spPr>
            <a:xfrm>
              <a:off x="7319696" y="2661274"/>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44" name="Google Shape;144;p70"/>
            <p:cNvSpPr/>
            <p:nvPr/>
          </p:nvSpPr>
          <p:spPr>
            <a:xfrm>
              <a:off x="7319696" y="3332949"/>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45" name="Google Shape;145;p70"/>
            <p:cNvSpPr/>
            <p:nvPr/>
          </p:nvSpPr>
          <p:spPr>
            <a:xfrm>
              <a:off x="7319696" y="4004625"/>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matchingName="JEOPARTY Answer (with category info)">
  <p:cSld name="TITLE_ONLY_1_1_1">
    <p:spTree>
      <p:nvGrpSpPr>
        <p:cNvPr id="1" name="Shape 146"/>
        <p:cNvGrpSpPr/>
        <p:nvPr/>
      </p:nvGrpSpPr>
      <p:grpSpPr>
        <a:xfrm>
          <a:off x="0" y="0"/>
          <a:ext cx="0" cy="0"/>
          <a:chOff x="0" y="0"/>
          <a:chExt cx="0" cy="0"/>
        </a:xfrm>
      </p:grpSpPr>
      <p:grpSp>
        <p:nvGrpSpPr>
          <p:cNvPr id="147" name="Google Shape;147;p71"/>
          <p:cNvGrpSpPr/>
          <p:nvPr/>
        </p:nvGrpSpPr>
        <p:grpSpPr>
          <a:xfrm>
            <a:off x="485311" y="484852"/>
            <a:ext cx="8177442" cy="4183216"/>
            <a:chOff x="695700" y="695700"/>
            <a:chExt cx="7752600" cy="3752100"/>
          </a:xfrm>
        </p:grpSpPr>
        <p:sp>
          <p:nvSpPr>
            <p:cNvPr id="148" name="Google Shape;148;p71"/>
            <p:cNvSpPr/>
            <p:nvPr/>
          </p:nvSpPr>
          <p:spPr>
            <a:xfrm>
              <a:off x="695700" y="695700"/>
              <a:ext cx="7752600" cy="3752100"/>
            </a:xfrm>
            <a:prstGeom prst="rect">
              <a:avLst/>
            </a:prstGeom>
            <a:gradFill>
              <a:gsLst>
                <a:gs pos="0">
                  <a:schemeClr val="accent2"/>
                </a:gs>
                <a:gs pos="100000">
                  <a:schemeClr val="accent1"/>
                </a:gs>
              </a:gsLst>
              <a:lin ang="5400012" scaled="0"/>
            </a:gradFill>
            <a:ln>
              <a:noFill/>
            </a:ln>
            <a:effectLst>
              <a:outerShdw blurRad="300038" dist="19050" dir="5400000" algn="bl" rotWithShape="0">
                <a:schemeClr val="dk1">
                  <a:alpha val="49803"/>
                </a:schemeClr>
              </a:outerShdw>
            </a:effectLst>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49" name="Google Shape;149;p71"/>
            <p:cNvSpPr/>
            <p:nvPr/>
          </p:nvSpPr>
          <p:spPr>
            <a:xfrm>
              <a:off x="695700" y="695700"/>
              <a:ext cx="7752600" cy="3752100"/>
            </a:xfrm>
            <a:prstGeom prst="frame">
              <a:avLst>
                <a:gd name="adj1" fmla="val 194"/>
              </a:avLst>
            </a:prstGeom>
            <a:gradFill>
              <a:gsLst>
                <a:gs pos="0">
                  <a:schemeClr val="accent3"/>
                </a:gs>
                <a:gs pos="100000">
                  <a:schemeClr val="accent2"/>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sp>
        <p:nvSpPr>
          <p:cNvPr id="150" name="Google Shape;150;p71"/>
          <p:cNvSpPr txBox="1">
            <a:spLocks noGrp="1"/>
          </p:cNvSpPr>
          <p:nvPr>
            <p:ph type="title"/>
          </p:nvPr>
        </p:nvSpPr>
        <p:spPr>
          <a:xfrm>
            <a:off x="1032075" y="966325"/>
            <a:ext cx="7081800" cy="3188100"/>
          </a:xfrm>
          <a:prstGeom prst="rect">
            <a:avLst/>
          </a:prstGeom>
          <a:noFill/>
          <a:ln>
            <a:noFill/>
          </a:ln>
          <a:effectLst>
            <a:outerShdw blurRad="28575" dist="38100" dir="2700000" algn="bl" rotWithShape="0">
              <a:schemeClr val="dk1">
                <a:alpha val="90980"/>
              </a:schemeClr>
            </a:outerShdw>
          </a:effectLst>
        </p:spPr>
        <p:txBody>
          <a:bodyPr spcFirstLastPara="1" wrap="square" lIns="0" tIns="0" rIns="0" bIns="0" anchor="ctr" anchorCtr="0">
            <a:noAutofit/>
          </a:bodyPr>
          <a:lstStyle>
            <a:lvl1pPr lvl="0" algn="ctr">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1pPr>
            <a:lvl2pPr lvl="1" algn="ctr">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2pPr>
            <a:lvl3pPr lvl="2" algn="ctr">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3pPr>
            <a:lvl4pPr lvl="3" algn="ctr">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4pPr>
            <a:lvl5pPr lvl="4" algn="ctr">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5pPr>
            <a:lvl6pPr lvl="5" algn="ctr">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6pPr>
            <a:lvl7pPr lvl="6" algn="ctr">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7pPr>
            <a:lvl8pPr lvl="7" algn="ctr">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8pPr>
            <a:lvl9pPr lvl="8" algn="ctr">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9pPr>
          </a:lstStyle>
          <a:p>
            <a:endParaRPr/>
          </a:p>
        </p:txBody>
      </p:sp>
      <p:sp>
        <p:nvSpPr>
          <p:cNvPr id="151" name="Google Shape;151;p71"/>
          <p:cNvSpPr txBox="1">
            <a:spLocks noGrp="1"/>
          </p:cNvSpPr>
          <p:nvPr>
            <p:ph type="subTitle" idx="1"/>
          </p:nvPr>
        </p:nvSpPr>
        <p:spPr>
          <a:xfrm>
            <a:off x="1038650" y="640325"/>
            <a:ext cx="7079700" cy="444300"/>
          </a:xfrm>
          <a:prstGeom prst="rect">
            <a:avLst/>
          </a:prstGeom>
          <a:noFill/>
          <a:ln>
            <a:noFill/>
          </a:ln>
          <a:effectLst>
            <a:outerShdw blurRad="14288" dist="28575" dir="2700000" algn="bl" rotWithShape="0">
              <a:schemeClr val="dk1">
                <a:alpha val="90980"/>
              </a:schemeClr>
            </a:outerShdw>
          </a:effectLst>
        </p:spPr>
        <p:txBody>
          <a:bodyPr spcFirstLastPara="1" wrap="square" lIns="0" tIns="0" rIns="0" bIns="0" anchor="t" anchorCtr="0">
            <a:noAutofit/>
          </a:bodyPr>
          <a:lstStyle>
            <a:lvl1pPr lvl="0" algn="ctr">
              <a:lnSpc>
                <a:spcPct val="100000"/>
              </a:lnSpc>
              <a:spcBef>
                <a:spcPts val="600"/>
              </a:spcBef>
              <a:spcAft>
                <a:spcPts val="0"/>
              </a:spcAft>
              <a:buSzPts val="2400"/>
              <a:buNone/>
              <a:defRPr sz="2000" b="0">
                <a:latin typeface="Bebas Neue"/>
                <a:ea typeface="Bebas Neue"/>
                <a:cs typeface="Bebas Neue"/>
                <a:sym typeface="Bebas Neue"/>
              </a:defRPr>
            </a:lvl1pPr>
            <a:lvl2pPr lvl="1" algn="l">
              <a:lnSpc>
                <a:spcPct val="100000"/>
              </a:lnSpc>
              <a:spcBef>
                <a:spcPts val="600"/>
              </a:spcBef>
              <a:spcAft>
                <a:spcPts val="0"/>
              </a:spcAft>
              <a:buSzPts val="2400"/>
              <a:buNone/>
              <a:defRPr sz="2000"/>
            </a:lvl2pPr>
            <a:lvl3pPr lvl="2" algn="l">
              <a:lnSpc>
                <a:spcPct val="100000"/>
              </a:lnSpc>
              <a:spcBef>
                <a:spcPts val="600"/>
              </a:spcBef>
              <a:spcAft>
                <a:spcPts val="0"/>
              </a:spcAft>
              <a:buSzPts val="2400"/>
              <a:buNone/>
              <a:defRPr sz="2000"/>
            </a:lvl3pPr>
            <a:lvl4pPr lvl="3" algn="l">
              <a:lnSpc>
                <a:spcPct val="100000"/>
              </a:lnSpc>
              <a:spcBef>
                <a:spcPts val="600"/>
              </a:spcBef>
              <a:spcAft>
                <a:spcPts val="0"/>
              </a:spcAft>
              <a:buSzPts val="2400"/>
              <a:buNone/>
              <a:defRPr sz="2000"/>
            </a:lvl4pPr>
            <a:lvl5pPr lvl="4" algn="l">
              <a:lnSpc>
                <a:spcPct val="100000"/>
              </a:lnSpc>
              <a:spcBef>
                <a:spcPts val="600"/>
              </a:spcBef>
              <a:spcAft>
                <a:spcPts val="0"/>
              </a:spcAft>
              <a:buSzPts val="2400"/>
              <a:buNone/>
              <a:defRPr sz="2000"/>
            </a:lvl5pPr>
            <a:lvl6pPr lvl="5" algn="l">
              <a:lnSpc>
                <a:spcPct val="100000"/>
              </a:lnSpc>
              <a:spcBef>
                <a:spcPts val="600"/>
              </a:spcBef>
              <a:spcAft>
                <a:spcPts val="0"/>
              </a:spcAft>
              <a:buSzPts val="2400"/>
              <a:buNone/>
              <a:defRPr sz="2000"/>
            </a:lvl6pPr>
            <a:lvl7pPr lvl="6" algn="l">
              <a:lnSpc>
                <a:spcPct val="100000"/>
              </a:lnSpc>
              <a:spcBef>
                <a:spcPts val="600"/>
              </a:spcBef>
              <a:spcAft>
                <a:spcPts val="0"/>
              </a:spcAft>
              <a:buSzPts val="2400"/>
              <a:buNone/>
              <a:defRPr sz="2000"/>
            </a:lvl7pPr>
            <a:lvl8pPr lvl="7" algn="l">
              <a:lnSpc>
                <a:spcPct val="100000"/>
              </a:lnSpc>
              <a:spcBef>
                <a:spcPts val="600"/>
              </a:spcBef>
              <a:spcAft>
                <a:spcPts val="0"/>
              </a:spcAft>
              <a:buSzPts val="2400"/>
              <a:buNone/>
              <a:defRPr sz="2000"/>
            </a:lvl8pPr>
            <a:lvl9pPr lvl="8" algn="l">
              <a:lnSpc>
                <a:spcPct val="100000"/>
              </a:lnSpc>
              <a:spcBef>
                <a:spcPts val="600"/>
              </a:spcBef>
              <a:spcAft>
                <a:spcPts val="0"/>
              </a:spcAft>
              <a:buSzPts val="2400"/>
              <a:buNone/>
              <a:defRPr sz="2000"/>
            </a:lvl9pPr>
          </a:lstStyle>
          <a:p>
            <a:endParaRPr/>
          </a:p>
        </p:txBody>
      </p:sp>
      <p:sp>
        <p:nvSpPr>
          <p:cNvPr id="152" name="Google Shape;152;p71"/>
          <p:cNvSpPr txBox="1"/>
          <p:nvPr/>
        </p:nvSpPr>
        <p:spPr>
          <a:xfrm>
            <a:off x="3394800" y="4328600"/>
            <a:ext cx="2354400" cy="144600"/>
          </a:xfrm>
          <a:prstGeom prst="rect">
            <a:avLst/>
          </a:prstGeom>
          <a:noFill/>
          <a:ln>
            <a:noFill/>
          </a:ln>
        </p:spPr>
        <p:txBody>
          <a:bodyPr spcFirstLastPara="1" wrap="square" lIns="0" tIns="0" rIns="0" bIns="0" anchor="t" anchorCtr="0">
            <a:noAutofit/>
          </a:bodyPr>
          <a:lstStyle/>
          <a:p>
            <a:pPr marL="0" marR="0" lvl="0" indent="0" algn="ctr" rtl="0">
              <a:lnSpc>
                <a:spcPct val="100000"/>
              </a:lnSpc>
              <a:spcBef>
                <a:spcPts val="0"/>
              </a:spcBef>
              <a:spcAft>
                <a:spcPts val="0"/>
              </a:spcAft>
              <a:buClr>
                <a:srgbClr val="000000"/>
              </a:buClr>
              <a:buSzPts val="1000"/>
              <a:buFont typeface="Arial"/>
              <a:buNone/>
            </a:pPr>
            <a:r>
              <a:rPr lang="en-US" sz="1000" b="0" i="0" u="none" strike="noStrike" cap="none">
                <a:solidFill>
                  <a:srgbClr val="6D9EEB"/>
                </a:solidFill>
                <a:latin typeface="Della Respira"/>
                <a:ea typeface="Della Respira"/>
                <a:cs typeface="Della Respira"/>
                <a:sym typeface="Della Respira"/>
              </a:rPr>
              <a:t>⬅ BACK TO PANEL</a:t>
            </a:r>
            <a:endParaRPr sz="1000" b="0" i="0" u="none" strike="noStrike" cap="none">
              <a:solidFill>
                <a:srgbClr val="6D9EEB"/>
              </a:solidFill>
              <a:latin typeface="Della Respira"/>
              <a:ea typeface="Della Respira"/>
              <a:cs typeface="Della Respira"/>
              <a:sym typeface="Della Respira"/>
            </a:endParaRPr>
          </a:p>
        </p:txBody>
      </p:sp>
      <p:sp>
        <p:nvSpPr>
          <p:cNvPr id="153" name="Google Shape;153;p71">
            <a:hlinkClick r:id="" action="ppaction://noaction"/>
          </p:cNvPr>
          <p:cNvSpPr/>
          <p:nvPr/>
        </p:nvSpPr>
        <p:spPr>
          <a:xfrm>
            <a:off x="0" y="0"/>
            <a:ext cx="9144000" cy="5143500"/>
          </a:xfrm>
          <a:prstGeom prst="frame">
            <a:avLst>
              <a:gd name="adj1" fmla="val 19553"/>
            </a:avLst>
          </a:prstGeom>
          <a:no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154"/>
        <p:cNvGrpSpPr/>
        <p:nvPr/>
      </p:nvGrpSpPr>
      <p:grpSpPr>
        <a:xfrm>
          <a:off x="0" y="0"/>
          <a:ext cx="0" cy="0"/>
          <a:chOff x="0" y="0"/>
          <a:chExt cx="0" cy="0"/>
        </a:xfrm>
      </p:grpSpPr>
      <p:sp>
        <p:nvSpPr>
          <p:cNvPr id="155" name="Google Shape;155;p72"/>
          <p:cNvSpPr txBox="1">
            <a:spLocks noGrp="1"/>
          </p:cNvSpPr>
          <p:nvPr>
            <p:ph type="sldNum" idx="12"/>
          </p:nvPr>
        </p:nvSpPr>
        <p:spPr>
          <a:xfrm>
            <a:off x="4297650" y="4749851"/>
            <a:ext cx="548700" cy="393600"/>
          </a:xfrm>
          <a:prstGeom prst="rect">
            <a:avLst/>
          </a:prstGeom>
          <a:noFill/>
          <a:ln>
            <a:noFill/>
          </a:ln>
        </p:spPr>
        <p:txBody>
          <a:bodyPr spcFirstLastPara="1" wrap="square" lIns="0" tIns="0" rIns="0" bIns="0" anchor="ctr" anchorCtr="0">
            <a:noAutofit/>
          </a:bodyPr>
          <a:lstStyle>
            <a:lvl1pPr marL="0" marR="0" lvl="0"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1pPr>
            <a:lvl2pPr marL="0" marR="0" lvl="1"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2pPr>
            <a:lvl3pPr marL="0" marR="0" lvl="2"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3pPr>
            <a:lvl4pPr marL="0" marR="0" lvl="3"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4pPr>
            <a:lvl5pPr marL="0" marR="0" lvl="4"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5pPr>
            <a:lvl6pPr marL="0" marR="0" lvl="5"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6pPr>
            <a:lvl7pPr marL="0" marR="0" lvl="6"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7pPr>
            <a:lvl8pPr marL="0" marR="0" lvl="7"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8pPr>
            <a:lvl9pPr marL="0" marR="0" lvl="8"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matchingName="Subtitle">
  <p:cSld name="TITLE_1">
    <p:spTree>
      <p:nvGrpSpPr>
        <p:cNvPr id="1" name="Shape 156"/>
        <p:cNvGrpSpPr/>
        <p:nvPr/>
      </p:nvGrpSpPr>
      <p:grpSpPr>
        <a:xfrm>
          <a:off x="0" y="0"/>
          <a:ext cx="0" cy="0"/>
          <a:chOff x="0" y="0"/>
          <a:chExt cx="0" cy="0"/>
        </a:xfrm>
      </p:grpSpPr>
      <p:sp>
        <p:nvSpPr>
          <p:cNvPr id="157" name="Google Shape;157;p73"/>
          <p:cNvSpPr txBox="1">
            <a:spLocks noGrp="1"/>
          </p:cNvSpPr>
          <p:nvPr>
            <p:ph type="ctrTitle"/>
          </p:nvPr>
        </p:nvSpPr>
        <p:spPr>
          <a:xfrm>
            <a:off x="685800" y="2675275"/>
            <a:ext cx="7772400" cy="605700"/>
          </a:xfrm>
          <a:prstGeom prst="rect">
            <a:avLst/>
          </a:prstGeom>
          <a:noFill/>
          <a:ln>
            <a:noFill/>
          </a:ln>
          <a:effectLst>
            <a:reflection stA="35000" endPos="47000" fadeDir="5400012" sy="-100000" algn="bl" rotWithShape="0"/>
          </a:effectLst>
        </p:spPr>
        <p:txBody>
          <a:bodyPr spcFirstLastPara="1" wrap="square" lIns="0" tIns="0" rIns="0" bIns="0" anchor="t" anchorCtr="0">
            <a:noAutofit/>
          </a:bodyPr>
          <a:lstStyle>
            <a:lvl1pPr lvl="0" algn="ctr">
              <a:lnSpc>
                <a:spcPct val="90000"/>
              </a:lnSpc>
              <a:spcBef>
                <a:spcPts val="0"/>
              </a:spcBef>
              <a:spcAft>
                <a:spcPts val="0"/>
              </a:spcAft>
              <a:buSzPts val="5500"/>
              <a:buNone/>
              <a:defRPr sz="5500"/>
            </a:lvl1pPr>
            <a:lvl2pPr lvl="1" algn="ctr">
              <a:lnSpc>
                <a:spcPct val="90000"/>
              </a:lnSpc>
              <a:spcBef>
                <a:spcPts val="0"/>
              </a:spcBef>
              <a:spcAft>
                <a:spcPts val="0"/>
              </a:spcAft>
              <a:buSzPts val="5500"/>
              <a:buNone/>
              <a:defRPr sz="5500"/>
            </a:lvl2pPr>
            <a:lvl3pPr lvl="2" algn="ctr">
              <a:lnSpc>
                <a:spcPct val="90000"/>
              </a:lnSpc>
              <a:spcBef>
                <a:spcPts val="0"/>
              </a:spcBef>
              <a:spcAft>
                <a:spcPts val="0"/>
              </a:spcAft>
              <a:buSzPts val="5500"/>
              <a:buNone/>
              <a:defRPr sz="5500"/>
            </a:lvl3pPr>
            <a:lvl4pPr lvl="3" algn="ctr">
              <a:lnSpc>
                <a:spcPct val="90000"/>
              </a:lnSpc>
              <a:spcBef>
                <a:spcPts val="0"/>
              </a:spcBef>
              <a:spcAft>
                <a:spcPts val="0"/>
              </a:spcAft>
              <a:buSzPts val="5500"/>
              <a:buNone/>
              <a:defRPr sz="5500"/>
            </a:lvl4pPr>
            <a:lvl5pPr lvl="4" algn="ctr">
              <a:lnSpc>
                <a:spcPct val="90000"/>
              </a:lnSpc>
              <a:spcBef>
                <a:spcPts val="0"/>
              </a:spcBef>
              <a:spcAft>
                <a:spcPts val="0"/>
              </a:spcAft>
              <a:buSzPts val="5500"/>
              <a:buNone/>
              <a:defRPr sz="5500"/>
            </a:lvl5pPr>
            <a:lvl6pPr lvl="5" algn="ctr">
              <a:lnSpc>
                <a:spcPct val="90000"/>
              </a:lnSpc>
              <a:spcBef>
                <a:spcPts val="0"/>
              </a:spcBef>
              <a:spcAft>
                <a:spcPts val="0"/>
              </a:spcAft>
              <a:buSzPts val="5500"/>
              <a:buNone/>
              <a:defRPr sz="5500"/>
            </a:lvl6pPr>
            <a:lvl7pPr lvl="6" algn="ctr">
              <a:lnSpc>
                <a:spcPct val="90000"/>
              </a:lnSpc>
              <a:spcBef>
                <a:spcPts val="0"/>
              </a:spcBef>
              <a:spcAft>
                <a:spcPts val="0"/>
              </a:spcAft>
              <a:buSzPts val="5500"/>
              <a:buNone/>
              <a:defRPr sz="5500"/>
            </a:lvl7pPr>
            <a:lvl8pPr lvl="7" algn="ctr">
              <a:lnSpc>
                <a:spcPct val="90000"/>
              </a:lnSpc>
              <a:spcBef>
                <a:spcPts val="0"/>
              </a:spcBef>
              <a:spcAft>
                <a:spcPts val="0"/>
              </a:spcAft>
              <a:buSzPts val="5500"/>
              <a:buNone/>
              <a:defRPr sz="5500"/>
            </a:lvl8pPr>
            <a:lvl9pPr lvl="8" algn="ctr">
              <a:lnSpc>
                <a:spcPct val="90000"/>
              </a:lnSpc>
              <a:spcBef>
                <a:spcPts val="0"/>
              </a:spcBef>
              <a:spcAft>
                <a:spcPts val="0"/>
              </a:spcAft>
              <a:buSzPts val="5500"/>
              <a:buNone/>
              <a:defRPr sz="5500"/>
            </a:lvl9pPr>
          </a:lstStyle>
          <a:p>
            <a:endParaRPr/>
          </a:p>
        </p:txBody>
      </p:sp>
      <p:sp>
        <p:nvSpPr>
          <p:cNvPr id="158" name="Google Shape;158;p73"/>
          <p:cNvSpPr txBox="1">
            <a:spLocks noGrp="1"/>
          </p:cNvSpPr>
          <p:nvPr>
            <p:ph type="subTitle" idx="1"/>
          </p:nvPr>
        </p:nvSpPr>
        <p:spPr>
          <a:xfrm>
            <a:off x="685800" y="3381833"/>
            <a:ext cx="7772400" cy="403500"/>
          </a:xfrm>
          <a:prstGeom prst="rect">
            <a:avLst/>
          </a:prstGeom>
          <a:noFill/>
          <a:ln>
            <a:noFill/>
          </a:ln>
          <a:effectLst>
            <a:outerShdw blurRad="14288" dist="28575" dir="2700000" algn="bl" rotWithShape="0">
              <a:schemeClr val="dk1">
                <a:alpha val="90980"/>
              </a:schemeClr>
            </a:outerShdw>
          </a:effectLst>
        </p:spPr>
        <p:txBody>
          <a:bodyPr spcFirstLastPara="1" wrap="square" lIns="0" tIns="0" rIns="0" bIns="0" anchor="t" anchorCtr="0">
            <a:noAutofit/>
          </a:bodyPr>
          <a:lstStyle>
            <a:lvl1pPr lvl="0" algn="ctr">
              <a:lnSpc>
                <a:spcPct val="100000"/>
              </a:lnSpc>
              <a:spcBef>
                <a:spcPts val="0"/>
              </a:spcBef>
              <a:spcAft>
                <a:spcPts val="0"/>
              </a:spcAft>
              <a:buClr>
                <a:schemeClr val="accent6"/>
              </a:buClr>
              <a:buSzPts val="2400"/>
              <a:buNone/>
              <a:defRPr>
                <a:solidFill>
                  <a:schemeClr val="accent6"/>
                </a:solidFill>
              </a:defRPr>
            </a:lvl1pPr>
            <a:lvl2pPr lvl="1" algn="ctr">
              <a:lnSpc>
                <a:spcPct val="100000"/>
              </a:lnSpc>
              <a:spcBef>
                <a:spcPts val="0"/>
              </a:spcBef>
              <a:spcAft>
                <a:spcPts val="0"/>
              </a:spcAft>
              <a:buClr>
                <a:schemeClr val="accent6"/>
              </a:buClr>
              <a:buSzPts val="3000"/>
              <a:buNone/>
              <a:defRPr sz="3000">
                <a:solidFill>
                  <a:schemeClr val="accent6"/>
                </a:solidFill>
              </a:defRPr>
            </a:lvl2pPr>
            <a:lvl3pPr lvl="2" algn="ctr">
              <a:lnSpc>
                <a:spcPct val="100000"/>
              </a:lnSpc>
              <a:spcBef>
                <a:spcPts val="0"/>
              </a:spcBef>
              <a:spcAft>
                <a:spcPts val="0"/>
              </a:spcAft>
              <a:buClr>
                <a:schemeClr val="accent6"/>
              </a:buClr>
              <a:buSzPts val="3000"/>
              <a:buNone/>
              <a:defRPr sz="3000">
                <a:solidFill>
                  <a:schemeClr val="accent6"/>
                </a:solidFill>
              </a:defRPr>
            </a:lvl3pPr>
            <a:lvl4pPr lvl="3" algn="ctr">
              <a:lnSpc>
                <a:spcPct val="100000"/>
              </a:lnSpc>
              <a:spcBef>
                <a:spcPts val="0"/>
              </a:spcBef>
              <a:spcAft>
                <a:spcPts val="0"/>
              </a:spcAft>
              <a:buClr>
                <a:schemeClr val="accent6"/>
              </a:buClr>
              <a:buSzPts val="3000"/>
              <a:buNone/>
              <a:defRPr sz="3000">
                <a:solidFill>
                  <a:schemeClr val="accent6"/>
                </a:solidFill>
              </a:defRPr>
            </a:lvl4pPr>
            <a:lvl5pPr lvl="4" algn="ctr">
              <a:lnSpc>
                <a:spcPct val="100000"/>
              </a:lnSpc>
              <a:spcBef>
                <a:spcPts val="0"/>
              </a:spcBef>
              <a:spcAft>
                <a:spcPts val="0"/>
              </a:spcAft>
              <a:buClr>
                <a:schemeClr val="accent6"/>
              </a:buClr>
              <a:buSzPts val="3000"/>
              <a:buNone/>
              <a:defRPr sz="3000">
                <a:solidFill>
                  <a:schemeClr val="accent6"/>
                </a:solidFill>
              </a:defRPr>
            </a:lvl5pPr>
            <a:lvl6pPr lvl="5" algn="ctr">
              <a:lnSpc>
                <a:spcPct val="100000"/>
              </a:lnSpc>
              <a:spcBef>
                <a:spcPts val="0"/>
              </a:spcBef>
              <a:spcAft>
                <a:spcPts val="0"/>
              </a:spcAft>
              <a:buClr>
                <a:schemeClr val="accent6"/>
              </a:buClr>
              <a:buSzPts val="3000"/>
              <a:buNone/>
              <a:defRPr sz="3000">
                <a:solidFill>
                  <a:schemeClr val="accent6"/>
                </a:solidFill>
              </a:defRPr>
            </a:lvl6pPr>
            <a:lvl7pPr lvl="6" algn="ctr">
              <a:lnSpc>
                <a:spcPct val="100000"/>
              </a:lnSpc>
              <a:spcBef>
                <a:spcPts val="0"/>
              </a:spcBef>
              <a:spcAft>
                <a:spcPts val="0"/>
              </a:spcAft>
              <a:buClr>
                <a:schemeClr val="accent6"/>
              </a:buClr>
              <a:buSzPts val="3000"/>
              <a:buNone/>
              <a:defRPr sz="3000">
                <a:solidFill>
                  <a:schemeClr val="accent6"/>
                </a:solidFill>
              </a:defRPr>
            </a:lvl7pPr>
            <a:lvl8pPr lvl="7" algn="ctr">
              <a:lnSpc>
                <a:spcPct val="100000"/>
              </a:lnSpc>
              <a:spcBef>
                <a:spcPts val="0"/>
              </a:spcBef>
              <a:spcAft>
                <a:spcPts val="0"/>
              </a:spcAft>
              <a:buClr>
                <a:schemeClr val="accent6"/>
              </a:buClr>
              <a:buSzPts val="3000"/>
              <a:buNone/>
              <a:defRPr sz="3000">
                <a:solidFill>
                  <a:schemeClr val="accent6"/>
                </a:solidFill>
              </a:defRPr>
            </a:lvl8pPr>
            <a:lvl9pPr lvl="8" algn="ctr">
              <a:lnSpc>
                <a:spcPct val="100000"/>
              </a:lnSpc>
              <a:spcBef>
                <a:spcPts val="0"/>
              </a:spcBef>
              <a:spcAft>
                <a:spcPts val="0"/>
              </a:spcAft>
              <a:buClr>
                <a:schemeClr val="accent6"/>
              </a:buClr>
              <a:buSzPts val="3000"/>
              <a:buNone/>
              <a:defRPr sz="3000">
                <a:solidFill>
                  <a:schemeClr val="accent6"/>
                </a:solidFill>
              </a:defRPr>
            </a:lvl9pPr>
          </a:lstStyle>
          <a:p>
            <a:endParaRPr/>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matchingName="Quote">
  <p:cSld name="TITLE_1_1">
    <p:spTree>
      <p:nvGrpSpPr>
        <p:cNvPr id="1" name="Shape 159"/>
        <p:cNvGrpSpPr/>
        <p:nvPr/>
      </p:nvGrpSpPr>
      <p:grpSpPr>
        <a:xfrm>
          <a:off x="0" y="0"/>
          <a:ext cx="0" cy="0"/>
          <a:chOff x="0" y="0"/>
          <a:chExt cx="0" cy="0"/>
        </a:xfrm>
      </p:grpSpPr>
      <p:grpSp>
        <p:nvGrpSpPr>
          <p:cNvPr id="160" name="Google Shape;160;p74"/>
          <p:cNvGrpSpPr/>
          <p:nvPr/>
        </p:nvGrpSpPr>
        <p:grpSpPr>
          <a:xfrm>
            <a:off x="695700" y="695700"/>
            <a:ext cx="7752600" cy="3752100"/>
            <a:chOff x="695700" y="695700"/>
            <a:chExt cx="7752600" cy="3752100"/>
          </a:xfrm>
        </p:grpSpPr>
        <p:sp>
          <p:nvSpPr>
            <p:cNvPr id="161" name="Google Shape;161;p74"/>
            <p:cNvSpPr/>
            <p:nvPr/>
          </p:nvSpPr>
          <p:spPr>
            <a:xfrm>
              <a:off x="695700" y="695700"/>
              <a:ext cx="7752600" cy="3752100"/>
            </a:xfrm>
            <a:prstGeom prst="rect">
              <a:avLst/>
            </a:prstGeom>
            <a:gradFill>
              <a:gsLst>
                <a:gs pos="0">
                  <a:schemeClr val="accent2"/>
                </a:gs>
                <a:gs pos="100000">
                  <a:schemeClr val="accent1"/>
                </a:gs>
              </a:gsLst>
              <a:lin ang="5400012" scaled="0"/>
            </a:gradFill>
            <a:ln>
              <a:noFill/>
            </a:ln>
            <a:effectLst>
              <a:outerShdw blurRad="300038" dist="19050" dir="5400000" algn="bl" rotWithShape="0">
                <a:schemeClr val="dk1">
                  <a:alpha val="49803"/>
                </a:schemeClr>
              </a:outerShdw>
            </a:effectLst>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62" name="Google Shape;162;p74"/>
            <p:cNvSpPr/>
            <p:nvPr/>
          </p:nvSpPr>
          <p:spPr>
            <a:xfrm>
              <a:off x="695700" y="695700"/>
              <a:ext cx="7752600" cy="3752100"/>
            </a:xfrm>
            <a:prstGeom prst="frame">
              <a:avLst>
                <a:gd name="adj1" fmla="val 204"/>
              </a:avLst>
            </a:prstGeom>
            <a:gradFill>
              <a:gsLst>
                <a:gs pos="0">
                  <a:schemeClr val="accent3"/>
                </a:gs>
                <a:gs pos="100000">
                  <a:schemeClr val="accent2"/>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sp>
        <p:nvSpPr>
          <p:cNvPr id="163" name="Google Shape;163;p74"/>
          <p:cNvSpPr txBox="1">
            <a:spLocks noGrp="1"/>
          </p:cNvSpPr>
          <p:nvPr>
            <p:ph type="body" idx="1"/>
          </p:nvPr>
        </p:nvSpPr>
        <p:spPr>
          <a:xfrm>
            <a:off x="1387050" y="2161800"/>
            <a:ext cx="6369900" cy="819900"/>
          </a:xfrm>
          <a:prstGeom prst="rect">
            <a:avLst/>
          </a:prstGeom>
          <a:noFill/>
          <a:ln>
            <a:noFill/>
          </a:ln>
          <a:effectLst>
            <a:outerShdw blurRad="14288" dist="28575" dir="2700000" algn="bl" rotWithShape="0">
              <a:schemeClr val="dk1">
                <a:alpha val="90980"/>
              </a:schemeClr>
            </a:outerShdw>
          </a:effectLst>
        </p:spPr>
        <p:txBody>
          <a:bodyPr spcFirstLastPara="1" wrap="square" lIns="0" tIns="0" rIns="0" bIns="0" anchor="ctr" anchorCtr="0">
            <a:noAutofit/>
          </a:bodyPr>
          <a:lstStyle>
            <a:lvl1pPr marL="457200" lvl="0" indent="-419100" algn="ctr">
              <a:lnSpc>
                <a:spcPct val="100000"/>
              </a:lnSpc>
              <a:spcBef>
                <a:spcPts val="600"/>
              </a:spcBef>
              <a:spcAft>
                <a:spcPts val="0"/>
              </a:spcAft>
              <a:buSzPts val="3000"/>
              <a:buChar char="➢"/>
              <a:defRPr sz="3000"/>
            </a:lvl1pPr>
            <a:lvl2pPr marL="914400" lvl="1" indent="-419100" algn="ctr">
              <a:lnSpc>
                <a:spcPct val="100000"/>
              </a:lnSpc>
              <a:spcBef>
                <a:spcPts val="0"/>
              </a:spcBef>
              <a:spcAft>
                <a:spcPts val="0"/>
              </a:spcAft>
              <a:buSzPts val="3000"/>
              <a:buChar char="○"/>
              <a:defRPr sz="3000"/>
            </a:lvl2pPr>
            <a:lvl3pPr marL="1371600" lvl="2" indent="-419100" algn="ctr">
              <a:lnSpc>
                <a:spcPct val="100000"/>
              </a:lnSpc>
              <a:spcBef>
                <a:spcPts val="0"/>
              </a:spcBef>
              <a:spcAft>
                <a:spcPts val="0"/>
              </a:spcAft>
              <a:buSzPts val="3000"/>
              <a:buChar char="■"/>
              <a:defRPr sz="3000"/>
            </a:lvl3pPr>
            <a:lvl4pPr marL="1828800" lvl="3" indent="-419100" algn="ctr">
              <a:lnSpc>
                <a:spcPct val="100000"/>
              </a:lnSpc>
              <a:spcBef>
                <a:spcPts val="0"/>
              </a:spcBef>
              <a:spcAft>
                <a:spcPts val="0"/>
              </a:spcAft>
              <a:buSzPts val="3000"/>
              <a:buChar char="●"/>
              <a:defRPr sz="3000"/>
            </a:lvl4pPr>
            <a:lvl5pPr marL="2286000" lvl="4" indent="-419100" algn="ctr">
              <a:lnSpc>
                <a:spcPct val="100000"/>
              </a:lnSpc>
              <a:spcBef>
                <a:spcPts val="0"/>
              </a:spcBef>
              <a:spcAft>
                <a:spcPts val="0"/>
              </a:spcAft>
              <a:buSzPts val="3000"/>
              <a:buChar char="○"/>
              <a:defRPr sz="3000"/>
            </a:lvl5pPr>
            <a:lvl6pPr marL="2743200" lvl="5" indent="-419100" algn="ctr">
              <a:lnSpc>
                <a:spcPct val="100000"/>
              </a:lnSpc>
              <a:spcBef>
                <a:spcPts val="0"/>
              </a:spcBef>
              <a:spcAft>
                <a:spcPts val="0"/>
              </a:spcAft>
              <a:buSzPts val="3000"/>
              <a:buChar char="■"/>
              <a:defRPr sz="3000"/>
            </a:lvl6pPr>
            <a:lvl7pPr marL="3200400" lvl="6" indent="-419100" algn="ctr">
              <a:lnSpc>
                <a:spcPct val="100000"/>
              </a:lnSpc>
              <a:spcBef>
                <a:spcPts val="0"/>
              </a:spcBef>
              <a:spcAft>
                <a:spcPts val="0"/>
              </a:spcAft>
              <a:buSzPts val="3000"/>
              <a:buChar char="●"/>
              <a:defRPr sz="3000"/>
            </a:lvl7pPr>
            <a:lvl8pPr marL="3657600" lvl="7" indent="-419100" algn="ctr">
              <a:lnSpc>
                <a:spcPct val="100000"/>
              </a:lnSpc>
              <a:spcBef>
                <a:spcPts val="0"/>
              </a:spcBef>
              <a:spcAft>
                <a:spcPts val="0"/>
              </a:spcAft>
              <a:buSzPts val="3000"/>
              <a:buChar char="○"/>
              <a:defRPr sz="3000"/>
            </a:lvl8pPr>
            <a:lvl9pPr marL="4114800" lvl="8" indent="-419100" algn="ctr">
              <a:lnSpc>
                <a:spcPct val="100000"/>
              </a:lnSpc>
              <a:spcBef>
                <a:spcPts val="0"/>
              </a:spcBef>
              <a:spcAft>
                <a:spcPts val="0"/>
              </a:spcAft>
              <a:buSzPts val="3000"/>
              <a:buChar char="■"/>
              <a:defRPr sz="3000"/>
            </a:lvl9pPr>
          </a:lstStyle>
          <a:p>
            <a:endParaRPr/>
          </a:p>
        </p:txBody>
      </p:sp>
      <p:sp>
        <p:nvSpPr>
          <p:cNvPr id="164" name="Google Shape;164;p74"/>
          <p:cNvSpPr txBox="1"/>
          <p:nvPr/>
        </p:nvSpPr>
        <p:spPr>
          <a:xfrm>
            <a:off x="3593400" y="781369"/>
            <a:ext cx="1957200" cy="653700"/>
          </a:xfrm>
          <a:prstGeom prst="rect">
            <a:avLst/>
          </a:prstGeom>
          <a:noFill/>
          <a:ln>
            <a:noFill/>
          </a:ln>
        </p:spPr>
        <p:txBody>
          <a:bodyPr spcFirstLastPara="1" wrap="square" lIns="0" tIns="0" rIns="0" bIns="0" anchor="t" anchorCtr="0">
            <a:noAutofit/>
          </a:bodyPr>
          <a:lstStyle/>
          <a:p>
            <a:pPr marL="0" marR="0" lvl="0" indent="0" algn="ctr" rtl="0">
              <a:lnSpc>
                <a:spcPct val="100000"/>
              </a:lnSpc>
              <a:spcBef>
                <a:spcPts val="0"/>
              </a:spcBef>
              <a:spcAft>
                <a:spcPts val="0"/>
              </a:spcAft>
              <a:buClr>
                <a:srgbClr val="000000"/>
              </a:buClr>
              <a:buSzPts val="9600"/>
              <a:buFont typeface="Arial"/>
              <a:buNone/>
            </a:pPr>
            <a:r>
              <a:rPr lang="en-US" sz="9600" b="0" i="0" u="none" strike="noStrike" cap="none">
                <a:solidFill>
                  <a:schemeClr val="accent6"/>
                </a:solidFill>
                <a:latin typeface="Della Respira"/>
                <a:ea typeface="Della Respira"/>
                <a:cs typeface="Della Respira"/>
                <a:sym typeface="Della Respira"/>
              </a:rPr>
              <a:t>“</a:t>
            </a:r>
            <a:endParaRPr sz="9600" b="0" i="0" u="none" strike="noStrike" cap="none">
              <a:solidFill>
                <a:schemeClr val="accent6"/>
              </a:solidFill>
              <a:latin typeface="Della Respira"/>
              <a:ea typeface="Della Respira"/>
              <a:cs typeface="Della Respira"/>
              <a:sym typeface="Della Respira"/>
            </a:endParaRPr>
          </a:p>
        </p:txBody>
      </p:sp>
      <p:sp>
        <p:nvSpPr>
          <p:cNvPr id="165" name="Google Shape;165;p74"/>
          <p:cNvSpPr txBox="1">
            <a:spLocks noGrp="1"/>
          </p:cNvSpPr>
          <p:nvPr>
            <p:ph type="sldNum" idx="12"/>
          </p:nvPr>
        </p:nvSpPr>
        <p:spPr>
          <a:xfrm>
            <a:off x="4297650" y="4749851"/>
            <a:ext cx="548700" cy="393600"/>
          </a:xfrm>
          <a:prstGeom prst="rect">
            <a:avLst/>
          </a:prstGeom>
          <a:noFill/>
          <a:ln>
            <a:noFill/>
          </a:ln>
        </p:spPr>
        <p:txBody>
          <a:bodyPr spcFirstLastPara="1" wrap="square" lIns="0" tIns="0" rIns="0" bIns="0" anchor="ctr" anchorCtr="0">
            <a:noAutofit/>
          </a:bodyPr>
          <a:lstStyle>
            <a:lvl1pPr marL="0" marR="0" lvl="0"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1pPr>
            <a:lvl2pPr marL="0" marR="0" lvl="1"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2pPr>
            <a:lvl3pPr marL="0" marR="0" lvl="2"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3pPr>
            <a:lvl4pPr marL="0" marR="0" lvl="3"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4pPr>
            <a:lvl5pPr marL="0" marR="0" lvl="4"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5pPr>
            <a:lvl6pPr marL="0" marR="0" lvl="5"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6pPr>
            <a:lvl7pPr marL="0" marR="0" lvl="6"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7pPr>
            <a:lvl8pPr marL="0" marR="0" lvl="7"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8pPr>
            <a:lvl9pPr marL="0" marR="0" lvl="8"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matchingName="Title + 3 columns">
  <p:cSld name="TITLE_AND_TWO_COLUMNS_1">
    <p:spTree>
      <p:nvGrpSpPr>
        <p:cNvPr id="1" name="Shape 166"/>
        <p:cNvGrpSpPr/>
        <p:nvPr/>
      </p:nvGrpSpPr>
      <p:grpSpPr>
        <a:xfrm>
          <a:off x="0" y="0"/>
          <a:ext cx="0" cy="0"/>
          <a:chOff x="0" y="0"/>
          <a:chExt cx="0" cy="0"/>
        </a:xfrm>
      </p:grpSpPr>
      <p:grpSp>
        <p:nvGrpSpPr>
          <p:cNvPr id="167" name="Google Shape;167;p75"/>
          <p:cNvGrpSpPr/>
          <p:nvPr/>
        </p:nvGrpSpPr>
        <p:grpSpPr>
          <a:xfrm>
            <a:off x="695700" y="695700"/>
            <a:ext cx="7752600" cy="3752100"/>
            <a:chOff x="695700" y="695700"/>
            <a:chExt cx="7752600" cy="3752100"/>
          </a:xfrm>
        </p:grpSpPr>
        <p:sp>
          <p:nvSpPr>
            <p:cNvPr id="168" name="Google Shape;168;p75"/>
            <p:cNvSpPr/>
            <p:nvPr/>
          </p:nvSpPr>
          <p:spPr>
            <a:xfrm>
              <a:off x="695700" y="695700"/>
              <a:ext cx="7752600" cy="3752100"/>
            </a:xfrm>
            <a:prstGeom prst="rect">
              <a:avLst/>
            </a:prstGeom>
            <a:gradFill>
              <a:gsLst>
                <a:gs pos="0">
                  <a:schemeClr val="accent2"/>
                </a:gs>
                <a:gs pos="100000">
                  <a:schemeClr val="accent1"/>
                </a:gs>
              </a:gsLst>
              <a:lin ang="5400012" scaled="0"/>
            </a:gradFill>
            <a:ln>
              <a:noFill/>
            </a:ln>
            <a:effectLst>
              <a:outerShdw blurRad="300038" dist="19050" dir="5400000" algn="bl" rotWithShape="0">
                <a:schemeClr val="dk1">
                  <a:alpha val="49803"/>
                </a:schemeClr>
              </a:outerShdw>
            </a:effectLst>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69" name="Google Shape;169;p75"/>
            <p:cNvSpPr/>
            <p:nvPr/>
          </p:nvSpPr>
          <p:spPr>
            <a:xfrm>
              <a:off x="695700" y="695700"/>
              <a:ext cx="7752600" cy="3752100"/>
            </a:xfrm>
            <a:prstGeom prst="frame">
              <a:avLst>
                <a:gd name="adj1" fmla="val 204"/>
              </a:avLst>
            </a:prstGeom>
            <a:gradFill>
              <a:gsLst>
                <a:gs pos="0">
                  <a:schemeClr val="accent3"/>
                </a:gs>
                <a:gs pos="100000">
                  <a:schemeClr val="accent2"/>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sp>
        <p:nvSpPr>
          <p:cNvPr id="170" name="Google Shape;170;p75"/>
          <p:cNvSpPr txBox="1">
            <a:spLocks noGrp="1"/>
          </p:cNvSpPr>
          <p:nvPr>
            <p:ph type="title"/>
          </p:nvPr>
        </p:nvSpPr>
        <p:spPr>
          <a:xfrm>
            <a:off x="1022525" y="1008050"/>
            <a:ext cx="7098900" cy="357900"/>
          </a:xfrm>
          <a:prstGeom prst="rect">
            <a:avLst/>
          </a:prstGeom>
          <a:noFill/>
          <a:ln>
            <a:noFill/>
          </a:ln>
          <a:effectLst>
            <a:outerShdw blurRad="28575" dist="38100" dir="2700000" algn="bl" rotWithShape="0">
              <a:schemeClr val="dk1">
                <a:alpha val="90980"/>
              </a:schemeClr>
            </a:outerShdw>
          </a:effectLst>
        </p:spPr>
        <p:txBody>
          <a:bodyPr spcFirstLastPara="1" wrap="square" lIns="0" tIns="0" rIns="0" bIns="0" anchor="b" anchorCtr="0">
            <a:noAutofit/>
          </a:bodyPr>
          <a:lstStyle>
            <a:lvl1pPr lvl="0" algn="l">
              <a:lnSpc>
                <a:spcPct val="90000"/>
              </a:lnSpc>
              <a:spcBef>
                <a:spcPts val="0"/>
              </a:spcBef>
              <a:spcAft>
                <a:spcPts val="0"/>
              </a:spcAft>
              <a:buSzPts val="3200"/>
              <a:buNone/>
              <a:defRPr/>
            </a:lvl1pPr>
            <a:lvl2pPr lvl="1" algn="l">
              <a:lnSpc>
                <a:spcPct val="90000"/>
              </a:lnSpc>
              <a:spcBef>
                <a:spcPts val="0"/>
              </a:spcBef>
              <a:spcAft>
                <a:spcPts val="0"/>
              </a:spcAft>
              <a:buSzPts val="3200"/>
              <a:buNone/>
              <a:defRPr/>
            </a:lvl2pPr>
            <a:lvl3pPr lvl="2" algn="l">
              <a:lnSpc>
                <a:spcPct val="90000"/>
              </a:lnSpc>
              <a:spcBef>
                <a:spcPts val="0"/>
              </a:spcBef>
              <a:spcAft>
                <a:spcPts val="0"/>
              </a:spcAft>
              <a:buSzPts val="3200"/>
              <a:buNone/>
              <a:defRPr/>
            </a:lvl3pPr>
            <a:lvl4pPr lvl="3" algn="l">
              <a:lnSpc>
                <a:spcPct val="90000"/>
              </a:lnSpc>
              <a:spcBef>
                <a:spcPts val="0"/>
              </a:spcBef>
              <a:spcAft>
                <a:spcPts val="0"/>
              </a:spcAft>
              <a:buSzPts val="3200"/>
              <a:buNone/>
              <a:defRPr/>
            </a:lvl4pPr>
            <a:lvl5pPr lvl="4" algn="l">
              <a:lnSpc>
                <a:spcPct val="90000"/>
              </a:lnSpc>
              <a:spcBef>
                <a:spcPts val="0"/>
              </a:spcBef>
              <a:spcAft>
                <a:spcPts val="0"/>
              </a:spcAft>
              <a:buSzPts val="3200"/>
              <a:buNone/>
              <a:defRPr/>
            </a:lvl5pPr>
            <a:lvl6pPr lvl="5" algn="l">
              <a:lnSpc>
                <a:spcPct val="90000"/>
              </a:lnSpc>
              <a:spcBef>
                <a:spcPts val="0"/>
              </a:spcBef>
              <a:spcAft>
                <a:spcPts val="0"/>
              </a:spcAft>
              <a:buSzPts val="3200"/>
              <a:buNone/>
              <a:defRPr/>
            </a:lvl6pPr>
            <a:lvl7pPr lvl="6" algn="l">
              <a:lnSpc>
                <a:spcPct val="90000"/>
              </a:lnSpc>
              <a:spcBef>
                <a:spcPts val="0"/>
              </a:spcBef>
              <a:spcAft>
                <a:spcPts val="0"/>
              </a:spcAft>
              <a:buSzPts val="3200"/>
              <a:buNone/>
              <a:defRPr/>
            </a:lvl7pPr>
            <a:lvl8pPr lvl="7" algn="l">
              <a:lnSpc>
                <a:spcPct val="90000"/>
              </a:lnSpc>
              <a:spcBef>
                <a:spcPts val="0"/>
              </a:spcBef>
              <a:spcAft>
                <a:spcPts val="0"/>
              </a:spcAft>
              <a:buSzPts val="3200"/>
              <a:buNone/>
              <a:defRPr/>
            </a:lvl8pPr>
            <a:lvl9pPr lvl="8" algn="l">
              <a:lnSpc>
                <a:spcPct val="90000"/>
              </a:lnSpc>
              <a:spcBef>
                <a:spcPts val="0"/>
              </a:spcBef>
              <a:spcAft>
                <a:spcPts val="0"/>
              </a:spcAft>
              <a:buSzPts val="3200"/>
              <a:buNone/>
              <a:defRPr/>
            </a:lvl9pPr>
          </a:lstStyle>
          <a:p>
            <a:endParaRPr/>
          </a:p>
        </p:txBody>
      </p:sp>
      <p:sp>
        <p:nvSpPr>
          <p:cNvPr id="171" name="Google Shape;171;p75"/>
          <p:cNvSpPr txBox="1">
            <a:spLocks noGrp="1"/>
          </p:cNvSpPr>
          <p:nvPr>
            <p:ph type="body" idx="1"/>
          </p:nvPr>
        </p:nvSpPr>
        <p:spPr>
          <a:xfrm>
            <a:off x="1006512" y="1475825"/>
            <a:ext cx="2211300" cy="2756700"/>
          </a:xfrm>
          <a:prstGeom prst="rect">
            <a:avLst/>
          </a:prstGeom>
          <a:noFill/>
          <a:ln>
            <a:noFill/>
          </a:ln>
          <a:effectLst>
            <a:outerShdw blurRad="14288" dist="28575" dir="2700000" algn="bl" rotWithShape="0">
              <a:schemeClr val="dk1">
                <a:alpha val="90980"/>
              </a:schemeClr>
            </a:outerShdw>
          </a:effectLst>
        </p:spPr>
        <p:txBody>
          <a:bodyPr spcFirstLastPara="1" wrap="square" lIns="0" tIns="0" rIns="0" bIns="0" anchor="t" anchorCtr="0">
            <a:noAutofit/>
          </a:bodyPr>
          <a:lstStyle>
            <a:lvl1pPr marL="457200" lvl="0" indent="-342900" algn="l">
              <a:lnSpc>
                <a:spcPct val="100000"/>
              </a:lnSpc>
              <a:spcBef>
                <a:spcPts val="600"/>
              </a:spcBef>
              <a:spcAft>
                <a:spcPts val="0"/>
              </a:spcAft>
              <a:buSzPts val="1800"/>
              <a:buChar char="➢"/>
              <a:defRPr sz="1800"/>
            </a:lvl1pPr>
            <a:lvl2pPr marL="914400" lvl="1" indent="-342900" algn="l">
              <a:lnSpc>
                <a:spcPct val="100000"/>
              </a:lnSpc>
              <a:spcBef>
                <a:spcPts val="0"/>
              </a:spcBef>
              <a:spcAft>
                <a:spcPts val="0"/>
              </a:spcAft>
              <a:buSzPts val="1800"/>
              <a:buChar char="○"/>
              <a:defRPr sz="1800"/>
            </a:lvl2pPr>
            <a:lvl3pPr marL="1371600" lvl="2" indent="-342900" algn="l">
              <a:lnSpc>
                <a:spcPct val="100000"/>
              </a:lnSpc>
              <a:spcBef>
                <a:spcPts val="0"/>
              </a:spcBef>
              <a:spcAft>
                <a:spcPts val="0"/>
              </a:spcAft>
              <a:buSzPts val="1800"/>
              <a:buChar char="■"/>
              <a:defRPr sz="1800"/>
            </a:lvl3pPr>
            <a:lvl4pPr marL="1828800" lvl="3" indent="-342900" algn="l">
              <a:lnSpc>
                <a:spcPct val="100000"/>
              </a:lnSpc>
              <a:spcBef>
                <a:spcPts val="0"/>
              </a:spcBef>
              <a:spcAft>
                <a:spcPts val="0"/>
              </a:spcAft>
              <a:buSzPts val="1800"/>
              <a:buChar char="●"/>
              <a:defRPr sz="1800"/>
            </a:lvl4pPr>
            <a:lvl5pPr marL="2286000" lvl="4" indent="-342900" algn="l">
              <a:lnSpc>
                <a:spcPct val="100000"/>
              </a:lnSpc>
              <a:spcBef>
                <a:spcPts val="0"/>
              </a:spcBef>
              <a:spcAft>
                <a:spcPts val="0"/>
              </a:spcAft>
              <a:buSzPts val="1800"/>
              <a:buChar char="○"/>
              <a:defRPr sz="1800"/>
            </a:lvl5pPr>
            <a:lvl6pPr marL="2743200" lvl="5" indent="-342900" algn="l">
              <a:lnSpc>
                <a:spcPct val="100000"/>
              </a:lnSpc>
              <a:spcBef>
                <a:spcPts val="0"/>
              </a:spcBef>
              <a:spcAft>
                <a:spcPts val="0"/>
              </a:spcAft>
              <a:buSzPts val="1800"/>
              <a:buChar char="■"/>
              <a:defRPr sz="1800"/>
            </a:lvl6pPr>
            <a:lvl7pPr marL="3200400" lvl="6" indent="-342900" algn="l">
              <a:lnSpc>
                <a:spcPct val="100000"/>
              </a:lnSpc>
              <a:spcBef>
                <a:spcPts val="0"/>
              </a:spcBef>
              <a:spcAft>
                <a:spcPts val="0"/>
              </a:spcAft>
              <a:buSzPts val="1800"/>
              <a:buChar char="●"/>
              <a:defRPr sz="1800"/>
            </a:lvl7pPr>
            <a:lvl8pPr marL="3657600" lvl="7" indent="-342900" algn="l">
              <a:lnSpc>
                <a:spcPct val="100000"/>
              </a:lnSpc>
              <a:spcBef>
                <a:spcPts val="0"/>
              </a:spcBef>
              <a:spcAft>
                <a:spcPts val="0"/>
              </a:spcAft>
              <a:buSzPts val="1800"/>
              <a:buChar char="○"/>
              <a:defRPr sz="1800"/>
            </a:lvl8pPr>
            <a:lvl9pPr marL="4114800" lvl="8" indent="-342900" algn="l">
              <a:lnSpc>
                <a:spcPct val="100000"/>
              </a:lnSpc>
              <a:spcBef>
                <a:spcPts val="0"/>
              </a:spcBef>
              <a:spcAft>
                <a:spcPts val="0"/>
              </a:spcAft>
              <a:buSzPts val="1800"/>
              <a:buChar char="■"/>
              <a:defRPr sz="1800"/>
            </a:lvl9pPr>
          </a:lstStyle>
          <a:p>
            <a:endParaRPr/>
          </a:p>
        </p:txBody>
      </p:sp>
      <p:sp>
        <p:nvSpPr>
          <p:cNvPr id="172" name="Google Shape;172;p75"/>
          <p:cNvSpPr txBox="1">
            <a:spLocks noGrp="1"/>
          </p:cNvSpPr>
          <p:nvPr>
            <p:ph type="body" idx="2"/>
          </p:nvPr>
        </p:nvSpPr>
        <p:spPr>
          <a:xfrm>
            <a:off x="3450259" y="1475825"/>
            <a:ext cx="2211300" cy="2756700"/>
          </a:xfrm>
          <a:prstGeom prst="rect">
            <a:avLst/>
          </a:prstGeom>
          <a:noFill/>
          <a:ln>
            <a:noFill/>
          </a:ln>
          <a:effectLst>
            <a:outerShdw blurRad="14288" dist="28575" dir="2700000" algn="bl" rotWithShape="0">
              <a:schemeClr val="dk1">
                <a:alpha val="90980"/>
              </a:schemeClr>
            </a:outerShdw>
          </a:effectLst>
        </p:spPr>
        <p:txBody>
          <a:bodyPr spcFirstLastPara="1" wrap="square" lIns="0" tIns="0" rIns="0" bIns="0" anchor="t" anchorCtr="0">
            <a:noAutofit/>
          </a:bodyPr>
          <a:lstStyle>
            <a:lvl1pPr marL="457200" lvl="0" indent="-342900" algn="l">
              <a:lnSpc>
                <a:spcPct val="100000"/>
              </a:lnSpc>
              <a:spcBef>
                <a:spcPts val="600"/>
              </a:spcBef>
              <a:spcAft>
                <a:spcPts val="0"/>
              </a:spcAft>
              <a:buSzPts val="1800"/>
              <a:buChar char="➢"/>
              <a:defRPr sz="1800"/>
            </a:lvl1pPr>
            <a:lvl2pPr marL="914400" lvl="1" indent="-342900" algn="l">
              <a:lnSpc>
                <a:spcPct val="100000"/>
              </a:lnSpc>
              <a:spcBef>
                <a:spcPts val="0"/>
              </a:spcBef>
              <a:spcAft>
                <a:spcPts val="0"/>
              </a:spcAft>
              <a:buSzPts val="1800"/>
              <a:buChar char="○"/>
              <a:defRPr sz="1800"/>
            </a:lvl2pPr>
            <a:lvl3pPr marL="1371600" lvl="2" indent="-342900" algn="l">
              <a:lnSpc>
                <a:spcPct val="100000"/>
              </a:lnSpc>
              <a:spcBef>
                <a:spcPts val="0"/>
              </a:spcBef>
              <a:spcAft>
                <a:spcPts val="0"/>
              </a:spcAft>
              <a:buSzPts val="1800"/>
              <a:buChar char="■"/>
              <a:defRPr sz="1800"/>
            </a:lvl3pPr>
            <a:lvl4pPr marL="1828800" lvl="3" indent="-342900" algn="l">
              <a:lnSpc>
                <a:spcPct val="100000"/>
              </a:lnSpc>
              <a:spcBef>
                <a:spcPts val="0"/>
              </a:spcBef>
              <a:spcAft>
                <a:spcPts val="0"/>
              </a:spcAft>
              <a:buSzPts val="1800"/>
              <a:buChar char="●"/>
              <a:defRPr sz="1800"/>
            </a:lvl4pPr>
            <a:lvl5pPr marL="2286000" lvl="4" indent="-342900" algn="l">
              <a:lnSpc>
                <a:spcPct val="100000"/>
              </a:lnSpc>
              <a:spcBef>
                <a:spcPts val="0"/>
              </a:spcBef>
              <a:spcAft>
                <a:spcPts val="0"/>
              </a:spcAft>
              <a:buSzPts val="1800"/>
              <a:buChar char="○"/>
              <a:defRPr sz="1800"/>
            </a:lvl5pPr>
            <a:lvl6pPr marL="2743200" lvl="5" indent="-342900" algn="l">
              <a:lnSpc>
                <a:spcPct val="100000"/>
              </a:lnSpc>
              <a:spcBef>
                <a:spcPts val="0"/>
              </a:spcBef>
              <a:spcAft>
                <a:spcPts val="0"/>
              </a:spcAft>
              <a:buSzPts val="1800"/>
              <a:buChar char="■"/>
              <a:defRPr sz="1800"/>
            </a:lvl6pPr>
            <a:lvl7pPr marL="3200400" lvl="6" indent="-342900" algn="l">
              <a:lnSpc>
                <a:spcPct val="100000"/>
              </a:lnSpc>
              <a:spcBef>
                <a:spcPts val="0"/>
              </a:spcBef>
              <a:spcAft>
                <a:spcPts val="0"/>
              </a:spcAft>
              <a:buSzPts val="1800"/>
              <a:buChar char="●"/>
              <a:defRPr sz="1800"/>
            </a:lvl7pPr>
            <a:lvl8pPr marL="3657600" lvl="7" indent="-342900" algn="l">
              <a:lnSpc>
                <a:spcPct val="100000"/>
              </a:lnSpc>
              <a:spcBef>
                <a:spcPts val="0"/>
              </a:spcBef>
              <a:spcAft>
                <a:spcPts val="0"/>
              </a:spcAft>
              <a:buSzPts val="1800"/>
              <a:buChar char="○"/>
              <a:defRPr sz="1800"/>
            </a:lvl8pPr>
            <a:lvl9pPr marL="4114800" lvl="8" indent="-342900" algn="l">
              <a:lnSpc>
                <a:spcPct val="100000"/>
              </a:lnSpc>
              <a:spcBef>
                <a:spcPts val="0"/>
              </a:spcBef>
              <a:spcAft>
                <a:spcPts val="0"/>
              </a:spcAft>
              <a:buSzPts val="1800"/>
              <a:buChar char="■"/>
              <a:defRPr sz="1800"/>
            </a:lvl9pPr>
          </a:lstStyle>
          <a:p>
            <a:endParaRPr/>
          </a:p>
        </p:txBody>
      </p:sp>
      <p:sp>
        <p:nvSpPr>
          <p:cNvPr id="173" name="Google Shape;173;p75"/>
          <p:cNvSpPr txBox="1">
            <a:spLocks noGrp="1"/>
          </p:cNvSpPr>
          <p:nvPr>
            <p:ph type="body" idx="3"/>
          </p:nvPr>
        </p:nvSpPr>
        <p:spPr>
          <a:xfrm>
            <a:off x="5894006" y="1475825"/>
            <a:ext cx="2211300" cy="2756700"/>
          </a:xfrm>
          <a:prstGeom prst="rect">
            <a:avLst/>
          </a:prstGeom>
          <a:noFill/>
          <a:ln>
            <a:noFill/>
          </a:ln>
          <a:effectLst>
            <a:outerShdw blurRad="14288" dist="28575" dir="2700000" algn="bl" rotWithShape="0">
              <a:schemeClr val="dk1">
                <a:alpha val="90980"/>
              </a:schemeClr>
            </a:outerShdw>
          </a:effectLst>
        </p:spPr>
        <p:txBody>
          <a:bodyPr spcFirstLastPara="1" wrap="square" lIns="0" tIns="0" rIns="0" bIns="0" anchor="t" anchorCtr="0">
            <a:noAutofit/>
          </a:bodyPr>
          <a:lstStyle>
            <a:lvl1pPr marL="457200" lvl="0" indent="-342900" algn="l">
              <a:lnSpc>
                <a:spcPct val="100000"/>
              </a:lnSpc>
              <a:spcBef>
                <a:spcPts val="600"/>
              </a:spcBef>
              <a:spcAft>
                <a:spcPts val="0"/>
              </a:spcAft>
              <a:buSzPts val="1800"/>
              <a:buChar char="➢"/>
              <a:defRPr sz="1800"/>
            </a:lvl1pPr>
            <a:lvl2pPr marL="914400" lvl="1" indent="-342900" algn="l">
              <a:lnSpc>
                <a:spcPct val="100000"/>
              </a:lnSpc>
              <a:spcBef>
                <a:spcPts val="0"/>
              </a:spcBef>
              <a:spcAft>
                <a:spcPts val="0"/>
              </a:spcAft>
              <a:buSzPts val="1800"/>
              <a:buChar char="○"/>
              <a:defRPr sz="1800"/>
            </a:lvl2pPr>
            <a:lvl3pPr marL="1371600" lvl="2" indent="-342900" algn="l">
              <a:lnSpc>
                <a:spcPct val="100000"/>
              </a:lnSpc>
              <a:spcBef>
                <a:spcPts val="0"/>
              </a:spcBef>
              <a:spcAft>
                <a:spcPts val="0"/>
              </a:spcAft>
              <a:buSzPts val="1800"/>
              <a:buChar char="■"/>
              <a:defRPr sz="1800"/>
            </a:lvl3pPr>
            <a:lvl4pPr marL="1828800" lvl="3" indent="-342900" algn="l">
              <a:lnSpc>
                <a:spcPct val="100000"/>
              </a:lnSpc>
              <a:spcBef>
                <a:spcPts val="0"/>
              </a:spcBef>
              <a:spcAft>
                <a:spcPts val="0"/>
              </a:spcAft>
              <a:buSzPts val="1800"/>
              <a:buChar char="●"/>
              <a:defRPr sz="1800"/>
            </a:lvl4pPr>
            <a:lvl5pPr marL="2286000" lvl="4" indent="-342900" algn="l">
              <a:lnSpc>
                <a:spcPct val="100000"/>
              </a:lnSpc>
              <a:spcBef>
                <a:spcPts val="0"/>
              </a:spcBef>
              <a:spcAft>
                <a:spcPts val="0"/>
              </a:spcAft>
              <a:buSzPts val="1800"/>
              <a:buChar char="○"/>
              <a:defRPr sz="1800"/>
            </a:lvl5pPr>
            <a:lvl6pPr marL="2743200" lvl="5" indent="-342900" algn="l">
              <a:lnSpc>
                <a:spcPct val="100000"/>
              </a:lnSpc>
              <a:spcBef>
                <a:spcPts val="0"/>
              </a:spcBef>
              <a:spcAft>
                <a:spcPts val="0"/>
              </a:spcAft>
              <a:buSzPts val="1800"/>
              <a:buChar char="■"/>
              <a:defRPr sz="1800"/>
            </a:lvl6pPr>
            <a:lvl7pPr marL="3200400" lvl="6" indent="-342900" algn="l">
              <a:lnSpc>
                <a:spcPct val="100000"/>
              </a:lnSpc>
              <a:spcBef>
                <a:spcPts val="0"/>
              </a:spcBef>
              <a:spcAft>
                <a:spcPts val="0"/>
              </a:spcAft>
              <a:buSzPts val="1800"/>
              <a:buChar char="●"/>
              <a:defRPr sz="1800"/>
            </a:lvl7pPr>
            <a:lvl8pPr marL="3657600" lvl="7" indent="-342900" algn="l">
              <a:lnSpc>
                <a:spcPct val="100000"/>
              </a:lnSpc>
              <a:spcBef>
                <a:spcPts val="0"/>
              </a:spcBef>
              <a:spcAft>
                <a:spcPts val="0"/>
              </a:spcAft>
              <a:buSzPts val="1800"/>
              <a:buChar char="○"/>
              <a:defRPr sz="1800"/>
            </a:lvl8pPr>
            <a:lvl9pPr marL="4114800" lvl="8" indent="-342900" algn="l">
              <a:lnSpc>
                <a:spcPct val="100000"/>
              </a:lnSpc>
              <a:spcBef>
                <a:spcPts val="0"/>
              </a:spcBef>
              <a:spcAft>
                <a:spcPts val="0"/>
              </a:spcAft>
              <a:buSzPts val="1800"/>
              <a:buChar char="■"/>
              <a:defRPr sz="1800"/>
            </a:lvl9pPr>
          </a:lstStyle>
          <a:p>
            <a:endParaRPr/>
          </a:p>
        </p:txBody>
      </p:sp>
      <p:sp>
        <p:nvSpPr>
          <p:cNvPr id="174" name="Google Shape;174;p75"/>
          <p:cNvSpPr txBox="1">
            <a:spLocks noGrp="1"/>
          </p:cNvSpPr>
          <p:nvPr>
            <p:ph type="sldNum" idx="12"/>
          </p:nvPr>
        </p:nvSpPr>
        <p:spPr>
          <a:xfrm>
            <a:off x="4297650" y="4749851"/>
            <a:ext cx="548700" cy="393600"/>
          </a:xfrm>
          <a:prstGeom prst="rect">
            <a:avLst/>
          </a:prstGeom>
          <a:noFill/>
          <a:ln>
            <a:noFill/>
          </a:ln>
        </p:spPr>
        <p:txBody>
          <a:bodyPr spcFirstLastPara="1" wrap="square" lIns="0" tIns="0" rIns="0" bIns="0" anchor="ctr" anchorCtr="0">
            <a:noAutofit/>
          </a:bodyPr>
          <a:lstStyle>
            <a:lvl1pPr marL="0" marR="0" lvl="0"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1pPr>
            <a:lvl2pPr marL="0" marR="0" lvl="1"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2pPr>
            <a:lvl3pPr marL="0" marR="0" lvl="2"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3pPr>
            <a:lvl4pPr marL="0" marR="0" lvl="3"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4pPr>
            <a:lvl5pPr marL="0" marR="0" lvl="4"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5pPr>
            <a:lvl6pPr marL="0" marR="0" lvl="5"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6pPr>
            <a:lvl7pPr marL="0" marR="0" lvl="6"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7pPr>
            <a:lvl8pPr marL="0" marR="0" lvl="7"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8pPr>
            <a:lvl9pPr marL="0" marR="0" lvl="8"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175"/>
        <p:cNvGrpSpPr/>
        <p:nvPr/>
      </p:nvGrpSpPr>
      <p:grpSpPr>
        <a:xfrm>
          <a:off x="0" y="0"/>
          <a:ext cx="0" cy="0"/>
          <a:chOff x="0" y="0"/>
          <a:chExt cx="0" cy="0"/>
        </a:xfrm>
      </p:grpSpPr>
      <p:grpSp>
        <p:nvGrpSpPr>
          <p:cNvPr id="176" name="Google Shape;176;p76"/>
          <p:cNvGrpSpPr/>
          <p:nvPr/>
        </p:nvGrpSpPr>
        <p:grpSpPr>
          <a:xfrm>
            <a:off x="695700" y="695700"/>
            <a:ext cx="7752600" cy="3752100"/>
            <a:chOff x="695700" y="695700"/>
            <a:chExt cx="7752600" cy="3752100"/>
          </a:xfrm>
        </p:grpSpPr>
        <p:sp>
          <p:nvSpPr>
            <p:cNvPr id="177" name="Google Shape;177;p76"/>
            <p:cNvSpPr/>
            <p:nvPr/>
          </p:nvSpPr>
          <p:spPr>
            <a:xfrm>
              <a:off x="695700" y="695700"/>
              <a:ext cx="7752600" cy="3752100"/>
            </a:xfrm>
            <a:prstGeom prst="rect">
              <a:avLst/>
            </a:prstGeom>
            <a:gradFill>
              <a:gsLst>
                <a:gs pos="0">
                  <a:schemeClr val="accent2"/>
                </a:gs>
                <a:gs pos="100000">
                  <a:schemeClr val="accent1"/>
                </a:gs>
              </a:gsLst>
              <a:lin ang="5400012" scaled="0"/>
            </a:gradFill>
            <a:ln>
              <a:noFill/>
            </a:ln>
            <a:effectLst>
              <a:outerShdw blurRad="300038" dist="19050" dir="5400000" algn="bl" rotWithShape="0">
                <a:schemeClr val="dk1">
                  <a:alpha val="49803"/>
                </a:schemeClr>
              </a:outerShdw>
            </a:effectLst>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78" name="Google Shape;178;p76"/>
            <p:cNvSpPr/>
            <p:nvPr/>
          </p:nvSpPr>
          <p:spPr>
            <a:xfrm>
              <a:off x="695700" y="695700"/>
              <a:ext cx="7752600" cy="3752100"/>
            </a:xfrm>
            <a:prstGeom prst="frame">
              <a:avLst>
                <a:gd name="adj1" fmla="val 204"/>
              </a:avLst>
            </a:prstGeom>
            <a:gradFill>
              <a:gsLst>
                <a:gs pos="0">
                  <a:schemeClr val="accent3"/>
                </a:gs>
                <a:gs pos="100000">
                  <a:schemeClr val="accent2"/>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sp>
        <p:nvSpPr>
          <p:cNvPr id="179" name="Google Shape;179;p76"/>
          <p:cNvSpPr txBox="1">
            <a:spLocks noGrp="1"/>
          </p:cNvSpPr>
          <p:nvPr>
            <p:ph type="title"/>
          </p:nvPr>
        </p:nvSpPr>
        <p:spPr>
          <a:xfrm>
            <a:off x="1022525" y="1008050"/>
            <a:ext cx="7098900" cy="357900"/>
          </a:xfrm>
          <a:prstGeom prst="rect">
            <a:avLst/>
          </a:prstGeom>
          <a:noFill/>
          <a:ln>
            <a:noFill/>
          </a:ln>
          <a:effectLst>
            <a:outerShdw blurRad="28575" dist="38100" dir="2700000" algn="bl" rotWithShape="0">
              <a:schemeClr val="dk1">
                <a:alpha val="90980"/>
              </a:schemeClr>
            </a:outerShdw>
          </a:effectLst>
        </p:spPr>
        <p:txBody>
          <a:bodyPr spcFirstLastPara="1" wrap="square" lIns="0" tIns="0" rIns="0" bIns="0" anchor="b" anchorCtr="0">
            <a:noAutofit/>
          </a:bodyPr>
          <a:lstStyle>
            <a:lvl1pPr lvl="0" algn="l">
              <a:lnSpc>
                <a:spcPct val="90000"/>
              </a:lnSpc>
              <a:spcBef>
                <a:spcPts val="0"/>
              </a:spcBef>
              <a:spcAft>
                <a:spcPts val="0"/>
              </a:spcAft>
              <a:buSzPts val="3200"/>
              <a:buNone/>
              <a:defRPr/>
            </a:lvl1pPr>
            <a:lvl2pPr lvl="1" algn="l">
              <a:lnSpc>
                <a:spcPct val="90000"/>
              </a:lnSpc>
              <a:spcBef>
                <a:spcPts val="0"/>
              </a:spcBef>
              <a:spcAft>
                <a:spcPts val="0"/>
              </a:spcAft>
              <a:buSzPts val="3200"/>
              <a:buNone/>
              <a:defRPr/>
            </a:lvl2pPr>
            <a:lvl3pPr lvl="2" algn="l">
              <a:lnSpc>
                <a:spcPct val="90000"/>
              </a:lnSpc>
              <a:spcBef>
                <a:spcPts val="0"/>
              </a:spcBef>
              <a:spcAft>
                <a:spcPts val="0"/>
              </a:spcAft>
              <a:buSzPts val="3200"/>
              <a:buNone/>
              <a:defRPr/>
            </a:lvl3pPr>
            <a:lvl4pPr lvl="3" algn="l">
              <a:lnSpc>
                <a:spcPct val="90000"/>
              </a:lnSpc>
              <a:spcBef>
                <a:spcPts val="0"/>
              </a:spcBef>
              <a:spcAft>
                <a:spcPts val="0"/>
              </a:spcAft>
              <a:buSzPts val="3200"/>
              <a:buNone/>
              <a:defRPr/>
            </a:lvl4pPr>
            <a:lvl5pPr lvl="4" algn="l">
              <a:lnSpc>
                <a:spcPct val="90000"/>
              </a:lnSpc>
              <a:spcBef>
                <a:spcPts val="0"/>
              </a:spcBef>
              <a:spcAft>
                <a:spcPts val="0"/>
              </a:spcAft>
              <a:buSzPts val="3200"/>
              <a:buNone/>
              <a:defRPr/>
            </a:lvl5pPr>
            <a:lvl6pPr lvl="5" algn="l">
              <a:lnSpc>
                <a:spcPct val="90000"/>
              </a:lnSpc>
              <a:spcBef>
                <a:spcPts val="0"/>
              </a:spcBef>
              <a:spcAft>
                <a:spcPts val="0"/>
              </a:spcAft>
              <a:buSzPts val="3200"/>
              <a:buNone/>
              <a:defRPr/>
            </a:lvl6pPr>
            <a:lvl7pPr lvl="6" algn="l">
              <a:lnSpc>
                <a:spcPct val="90000"/>
              </a:lnSpc>
              <a:spcBef>
                <a:spcPts val="0"/>
              </a:spcBef>
              <a:spcAft>
                <a:spcPts val="0"/>
              </a:spcAft>
              <a:buSzPts val="3200"/>
              <a:buNone/>
              <a:defRPr/>
            </a:lvl7pPr>
            <a:lvl8pPr lvl="7" algn="l">
              <a:lnSpc>
                <a:spcPct val="90000"/>
              </a:lnSpc>
              <a:spcBef>
                <a:spcPts val="0"/>
              </a:spcBef>
              <a:spcAft>
                <a:spcPts val="0"/>
              </a:spcAft>
              <a:buSzPts val="3200"/>
              <a:buNone/>
              <a:defRPr/>
            </a:lvl8pPr>
            <a:lvl9pPr lvl="8" algn="l">
              <a:lnSpc>
                <a:spcPct val="90000"/>
              </a:lnSpc>
              <a:spcBef>
                <a:spcPts val="0"/>
              </a:spcBef>
              <a:spcAft>
                <a:spcPts val="0"/>
              </a:spcAft>
              <a:buSzPts val="3200"/>
              <a:buNone/>
              <a:defRPr/>
            </a:lvl9pPr>
          </a:lstStyle>
          <a:p>
            <a:endParaRPr/>
          </a:p>
        </p:txBody>
      </p:sp>
      <p:sp>
        <p:nvSpPr>
          <p:cNvPr id="180" name="Google Shape;180;p76"/>
          <p:cNvSpPr txBox="1">
            <a:spLocks noGrp="1"/>
          </p:cNvSpPr>
          <p:nvPr>
            <p:ph type="sldNum" idx="12"/>
          </p:nvPr>
        </p:nvSpPr>
        <p:spPr>
          <a:xfrm>
            <a:off x="4297650" y="4749851"/>
            <a:ext cx="548700" cy="393600"/>
          </a:xfrm>
          <a:prstGeom prst="rect">
            <a:avLst/>
          </a:prstGeom>
          <a:noFill/>
          <a:ln>
            <a:noFill/>
          </a:ln>
        </p:spPr>
        <p:txBody>
          <a:bodyPr spcFirstLastPara="1" wrap="square" lIns="0" tIns="0" rIns="0" bIns="0" anchor="ctr" anchorCtr="0">
            <a:noAutofit/>
          </a:bodyPr>
          <a:lstStyle>
            <a:lvl1pPr marL="0" marR="0" lvl="0"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1pPr>
            <a:lvl2pPr marL="0" marR="0" lvl="1"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2pPr>
            <a:lvl3pPr marL="0" marR="0" lvl="2"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3pPr>
            <a:lvl4pPr marL="0" marR="0" lvl="3"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4pPr>
            <a:lvl5pPr marL="0" marR="0" lvl="4"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5pPr>
            <a:lvl6pPr marL="0" marR="0" lvl="5"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6pPr>
            <a:lvl7pPr marL="0" marR="0" lvl="6"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7pPr>
            <a:lvl8pPr marL="0" marR="0" lvl="7"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8pPr>
            <a:lvl9pPr marL="0" marR="0" lvl="8"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ubtitle">
  <p:cSld name="TITLE_1">
    <p:spTree>
      <p:nvGrpSpPr>
        <p:cNvPr id="1" name="Shape 101"/>
        <p:cNvGrpSpPr/>
        <p:nvPr/>
      </p:nvGrpSpPr>
      <p:grpSpPr>
        <a:xfrm>
          <a:off x="0" y="0"/>
          <a:ext cx="0" cy="0"/>
          <a:chOff x="0" y="0"/>
          <a:chExt cx="0" cy="0"/>
        </a:xfrm>
      </p:grpSpPr>
      <p:sp>
        <p:nvSpPr>
          <p:cNvPr id="102" name="Google Shape;102;p3"/>
          <p:cNvSpPr txBox="1">
            <a:spLocks noGrp="1"/>
          </p:cNvSpPr>
          <p:nvPr>
            <p:ph type="ctrTitle"/>
          </p:nvPr>
        </p:nvSpPr>
        <p:spPr>
          <a:xfrm>
            <a:off x="685800" y="2675275"/>
            <a:ext cx="7772400" cy="605700"/>
          </a:xfrm>
          <a:prstGeom prst="rect">
            <a:avLst/>
          </a:prstGeom>
          <a:effectLst>
            <a:reflection stA="35000" endPos="47000" fadeDir="5400012" sy="-100000" algn="bl" rotWithShape="0"/>
          </a:effectLst>
        </p:spPr>
        <p:txBody>
          <a:bodyPr spcFirstLastPara="1" wrap="square" lIns="0" tIns="0" rIns="0" bIns="0" anchor="t" anchorCtr="0">
            <a:noAutofit/>
          </a:bodyPr>
          <a:lstStyle>
            <a:lvl1pPr lvl="0" algn="ctr" rtl="0">
              <a:spcBef>
                <a:spcPts val="0"/>
              </a:spcBef>
              <a:spcAft>
                <a:spcPts val="0"/>
              </a:spcAft>
              <a:buSzPts val="5500"/>
              <a:buNone/>
              <a:defRPr sz="5500"/>
            </a:lvl1pPr>
            <a:lvl2pPr lvl="1" algn="ctr" rtl="0">
              <a:spcBef>
                <a:spcPts val="0"/>
              </a:spcBef>
              <a:spcAft>
                <a:spcPts val="0"/>
              </a:spcAft>
              <a:buSzPts val="5500"/>
              <a:buNone/>
              <a:defRPr sz="5500"/>
            </a:lvl2pPr>
            <a:lvl3pPr lvl="2" algn="ctr" rtl="0">
              <a:spcBef>
                <a:spcPts val="0"/>
              </a:spcBef>
              <a:spcAft>
                <a:spcPts val="0"/>
              </a:spcAft>
              <a:buSzPts val="5500"/>
              <a:buNone/>
              <a:defRPr sz="5500"/>
            </a:lvl3pPr>
            <a:lvl4pPr lvl="3" algn="ctr" rtl="0">
              <a:spcBef>
                <a:spcPts val="0"/>
              </a:spcBef>
              <a:spcAft>
                <a:spcPts val="0"/>
              </a:spcAft>
              <a:buSzPts val="5500"/>
              <a:buNone/>
              <a:defRPr sz="5500"/>
            </a:lvl4pPr>
            <a:lvl5pPr lvl="4" algn="ctr" rtl="0">
              <a:spcBef>
                <a:spcPts val="0"/>
              </a:spcBef>
              <a:spcAft>
                <a:spcPts val="0"/>
              </a:spcAft>
              <a:buSzPts val="5500"/>
              <a:buNone/>
              <a:defRPr sz="5500"/>
            </a:lvl5pPr>
            <a:lvl6pPr lvl="5" algn="ctr" rtl="0">
              <a:spcBef>
                <a:spcPts val="0"/>
              </a:spcBef>
              <a:spcAft>
                <a:spcPts val="0"/>
              </a:spcAft>
              <a:buSzPts val="5500"/>
              <a:buNone/>
              <a:defRPr sz="5500"/>
            </a:lvl6pPr>
            <a:lvl7pPr lvl="6" algn="ctr" rtl="0">
              <a:spcBef>
                <a:spcPts val="0"/>
              </a:spcBef>
              <a:spcAft>
                <a:spcPts val="0"/>
              </a:spcAft>
              <a:buSzPts val="5500"/>
              <a:buNone/>
              <a:defRPr sz="5500"/>
            </a:lvl7pPr>
            <a:lvl8pPr lvl="7" algn="ctr" rtl="0">
              <a:spcBef>
                <a:spcPts val="0"/>
              </a:spcBef>
              <a:spcAft>
                <a:spcPts val="0"/>
              </a:spcAft>
              <a:buSzPts val="5500"/>
              <a:buNone/>
              <a:defRPr sz="5500"/>
            </a:lvl8pPr>
            <a:lvl9pPr lvl="8" algn="ctr" rtl="0">
              <a:spcBef>
                <a:spcPts val="0"/>
              </a:spcBef>
              <a:spcAft>
                <a:spcPts val="0"/>
              </a:spcAft>
              <a:buSzPts val="5500"/>
              <a:buNone/>
              <a:defRPr sz="5500"/>
            </a:lvl9pPr>
          </a:lstStyle>
          <a:p>
            <a:endParaRPr/>
          </a:p>
        </p:txBody>
      </p:sp>
      <p:sp>
        <p:nvSpPr>
          <p:cNvPr id="103" name="Google Shape;103;p3"/>
          <p:cNvSpPr txBox="1">
            <a:spLocks noGrp="1"/>
          </p:cNvSpPr>
          <p:nvPr>
            <p:ph type="subTitle" idx="1"/>
          </p:nvPr>
        </p:nvSpPr>
        <p:spPr>
          <a:xfrm>
            <a:off x="685800" y="3381833"/>
            <a:ext cx="7772400" cy="403500"/>
          </a:xfrm>
          <a:prstGeom prst="rect">
            <a:avLst/>
          </a:prstGeom>
        </p:spPr>
        <p:txBody>
          <a:bodyPr spcFirstLastPara="1" wrap="square" lIns="0" tIns="0" rIns="0" bIns="0" anchor="t" anchorCtr="0">
            <a:noAutofit/>
          </a:bodyPr>
          <a:lstStyle>
            <a:lvl1pPr lvl="0" algn="ctr" rtl="0">
              <a:spcBef>
                <a:spcPts val="0"/>
              </a:spcBef>
              <a:spcAft>
                <a:spcPts val="0"/>
              </a:spcAft>
              <a:buClr>
                <a:schemeClr val="accent6"/>
              </a:buClr>
              <a:buSzPts val="2400"/>
              <a:buNone/>
              <a:defRPr>
                <a:solidFill>
                  <a:schemeClr val="accent6"/>
                </a:solidFill>
              </a:defRPr>
            </a:lvl1pPr>
            <a:lvl2pPr lvl="1" algn="ctr" rtl="0">
              <a:spcBef>
                <a:spcPts val="0"/>
              </a:spcBef>
              <a:spcAft>
                <a:spcPts val="0"/>
              </a:spcAft>
              <a:buClr>
                <a:schemeClr val="accent6"/>
              </a:buClr>
              <a:buSzPts val="3000"/>
              <a:buNone/>
              <a:defRPr sz="3000">
                <a:solidFill>
                  <a:schemeClr val="accent6"/>
                </a:solidFill>
              </a:defRPr>
            </a:lvl2pPr>
            <a:lvl3pPr lvl="2" algn="ctr" rtl="0">
              <a:spcBef>
                <a:spcPts val="0"/>
              </a:spcBef>
              <a:spcAft>
                <a:spcPts val="0"/>
              </a:spcAft>
              <a:buClr>
                <a:schemeClr val="accent6"/>
              </a:buClr>
              <a:buSzPts val="3000"/>
              <a:buNone/>
              <a:defRPr sz="3000">
                <a:solidFill>
                  <a:schemeClr val="accent6"/>
                </a:solidFill>
              </a:defRPr>
            </a:lvl3pPr>
            <a:lvl4pPr lvl="3" algn="ctr" rtl="0">
              <a:spcBef>
                <a:spcPts val="0"/>
              </a:spcBef>
              <a:spcAft>
                <a:spcPts val="0"/>
              </a:spcAft>
              <a:buClr>
                <a:schemeClr val="accent6"/>
              </a:buClr>
              <a:buSzPts val="3000"/>
              <a:buNone/>
              <a:defRPr sz="3000">
                <a:solidFill>
                  <a:schemeClr val="accent6"/>
                </a:solidFill>
              </a:defRPr>
            </a:lvl4pPr>
            <a:lvl5pPr lvl="4" algn="ctr" rtl="0">
              <a:spcBef>
                <a:spcPts val="0"/>
              </a:spcBef>
              <a:spcAft>
                <a:spcPts val="0"/>
              </a:spcAft>
              <a:buClr>
                <a:schemeClr val="accent6"/>
              </a:buClr>
              <a:buSzPts val="3000"/>
              <a:buNone/>
              <a:defRPr sz="3000">
                <a:solidFill>
                  <a:schemeClr val="accent6"/>
                </a:solidFill>
              </a:defRPr>
            </a:lvl5pPr>
            <a:lvl6pPr lvl="5" algn="ctr" rtl="0">
              <a:spcBef>
                <a:spcPts val="0"/>
              </a:spcBef>
              <a:spcAft>
                <a:spcPts val="0"/>
              </a:spcAft>
              <a:buClr>
                <a:schemeClr val="accent6"/>
              </a:buClr>
              <a:buSzPts val="3000"/>
              <a:buNone/>
              <a:defRPr sz="3000">
                <a:solidFill>
                  <a:schemeClr val="accent6"/>
                </a:solidFill>
              </a:defRPr>
            </a:lvl6pPr>
            <a:lvl7pPr lvl="6" algn="ctr" rtl="0">
              <a:spcBef>
                <a:spcPts val="0"/>
              </a:spcBef>
              <a:spcAft>
                <a:spcPts val="0"/>
              </a:spcAft>
              <a:buClr>
                <a:schemeClr val="accent6"/>
              </a:buClr>
              <a:buSzPts val="3000"/>
              <a:buNone/>
              <a:defRPr sz="3000">
                <a:solidFill>
                  <a:schemeClr val="accent6"/>
                </a:solidFill>
              </a:defRPr>
            </a:lvl7pPr>
            <a:lvl8pPr lvl="7" algn="ctr" rtl="0">
              <a:spcBef>
                <a:spcPts val="0"/>
              </a:spcBef>
              <a:spcAft>
                <a:spcPts val="0"/>
              </a:spcAft>
              <a:buClr>
                <a:schemeClr val="accent6"/>
              </a:buClr>
              <a:buSzPts val="3000"/>
              <a:buNone/>
              <a:defRPr sz="3000">
                <a:solidFill>
                  <a:schemeClr val="accent6"/>
                </a:solidFill>
              </a:defRPr>
            </a:lvl8pPr>
            <a:lvl9pPr lvl="8" algn="ctr" rtl="0">
              <a:spcBef>
                <a:spcPts val="0"/>
              </a:spcBef>
              <a:spcAft>
                <a:spcPts val="0"/>
              </a:spcAft>
              <a:buClr>
                <a:schemeClr val="accent6"/>
              </a:buClr>
              <a:buSzPts val="3000"/>
              <a:buNone/>
              <a:defRPr sz="3000">
                <a:solidFill>
                  <a:schemeClr val="accent6"/>
                </a:solidFill>
              </a:defRPr>
            </a:lvl9pPr>
          </a:lstStyle>
          <a:p>
            <a:endParaRPr/>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matchingName="JEOPARTY Category">
  <p:cSld name="TITLE_ONLY_1">
    <p:spTree>
      <p:nvGrpSpPr>
        <p:cNvPr id="1" name="Shape 181"/>
        <p:cNvGrpSpPr/>
        <p:nvPr/>
      </p:nvGrpSpPr>
      <p:grpSpPr>
        <a:xfrm>
          <a:off x="0" y="0"/>
          <a:ext cx="0" cy="0"/>
          <a:chOff x="0" y="0"/>
          <a:chExt cx="0" cy="0"/>
        </a:xfrm>
      </p:grpSpPr>
      <p:grpSp>
        <p:nvGrpSpPr>
          <p:cNvPr id="182" name="Google Shape;182;p77"/>
          <p:cNvGrpSpPr/>
          <p:nvPr/>
        </p:nvGrpSpPr>
        <p:grpSpPr>
          <a:xfrm>
            <a:off x="485311" y="484852"/>
            <a:ext cx="8177442" cy="4183216"/>
            <a:chOff x="695700" y="695700"/>
            <a:chExt cx="7752600" cy="3752100"/>
          </a:xfrm>
        </p:grpSpPr>
        <p:sp>
          <p:nvSpPr>
            <p:cNvPr id="183" name="Google Shape;183;p77"/>
            <p:cNvSpPr/>
            <p:nvPr/>
          </p:nvSpPr>
          <p:spPr>
            <a:xfrm>
              <a:off x="695700" y="695700"/>
              <a:ext cx="7752600" cy="3752100"/>
            </a:xfrm>
            <a:prstGeom prst="rect">
              <a:avLst/>
            </a:prstGeom>
            <a:gradFill>
              <a:gsLst>
                <a:gs pos="0">
                  <a:schemeClr val="accent2"/>
                </a:gs>
                <a:gs pos="100000">
                  <a:schemeClr val="accent1"/>
                </a:gs>
              </a:gsLst>
              <a:lin ang="5400012" scaled="0"/>
            </a:gradFill>
            <a:ln>
              <a:noFill/>
            </a:ln>
            <a:effectLst>
              <a:outerShdw blurRad="300038" dist="19050" dir="5400000" algn="bl" rotWithShape="0">
                <a:schemeClr val="dk1">
                  <a:alpha val="49803"/>
                </a:schemeClr>
              </a:outerShdw>
            </a:effectLst>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84" name="Google Shape;184;p77"/>
            <p:cNvSpPr/>
            <p:nvPr/>
          </p:nvSpPr>
          <p:spPr>
            <a:xfrm>
              <a:off x="695700" y="695700"/>
              <a:ext cx="7752600" cy="3752100"/>
            </a:xfrm>
            <a:prstGeom prst="frame">
              <a:avLst>
                <a:gd name="adj1" fmla="val 194"/>
              </a:avLst>
            </a:prstGeom>
            <a:gradFill>
              <a:gsLst>
                <a:gs pos="0">
                  <a:schemeClr val="accent3"/>
                </a:gs>
                <a:gs pos="100000">
                  <a:schemeClr val="accent2"/>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sp>
        <p:nvSpPr>
          <p:cNvPr id="185" name="Google Shape;185;p77"/>
          <p:cNvSpPr txBox="1">
            <a:spLocks noGrp="1"/>
          </p:cNvSpPr>
          <p:nvPr>
            <p:ph type="title"/>
          </p:nvPr>
        </p:nvSpPr>
        <p:spPr>
          <a:xfrm>
            <a:off x="1517025" y="1499475"/>
            <a:ext cx="6111900" cy="687900"/>
          </a:xfrm>
          <a:prstGeom prst="rect">
            <a:avLst/>
          </a:prstGeom>
          <a:noFill/>
          <a:ln>
            <a:noFill/>
          </a:ln>
          <a:effectLst>
            <a:outerShdw blurRad="28575" dist="38100" dir="2700000" algn="bl" rotWithShape="0">
              <a:schemeClr val="dk1">
                <a:alpha val="90980"/>
              </a:schemeClr>
            </a:outerShdw>
          </a:effectLst>
        </p:spPr>
        <p:txBody>
          <a:bodyPr spcFirstLastPara="1" wrap="square" lIns="0" tIns="0" rIns="0" bIns="0" anchor="b" anchorCtr="0">
            <a:noAutofit/>
          </a:bodyPr>
          <a:lstStyle>
            <a:lvl1pPr lvl="0" algn="ctr">
              <a:lnSpc>
                <a:spcPct val="90000"/>
              </a:lnSpc>
              <a:spcBef>
                <a:spcPts val="0"/>
              </a:spcBef>
              <a:spcAft>
                <a:spcPts val="0"/>
              </a:spcAft>
              <a:buSzPts val="3600"/>
              <a:buFont typeface="Della Respira"/>
              <a:buNone/>
              <a:defRPr sz="3600" b="1">
                <a:latin typeface="Della Respira"/>
                <a:ea typeface="Della Respira"/>
                <a:cs typeface="Della Respira"/>
                <a:sym typeface="Della Respira"/>
              </a:defRPr>
            </a:lvl1pPr>
            <a:lvl2pPr lvl="1" algn="ctr">
              <a:lnSpc>
                <a:spcPct val="90000"/>
              </a:lnSpc>
              <a:spcBef>
                <a:spcPts val="0"/>
              </a:spcBef>
              <a:spcAft>
                <a:spcPts val="0"/>
              </a:spcAft>
              <a:buSzPts val="3600"/>
              <a:buFont typeface="Della Respira"/>
              <a:buNone/>
              <a:defRPr sz="3600" b="1">
                <a:latin typeface="Della Respira"/>
                <a:ea typeface="Della Respira"/>
                <a:cs typeface="Della Respira"/>
                <a:sym typeface="Della Respira"/>
              </a:defRPr>
            </a:lvl2pPr>
            <a:lvl3pPr lvl="2" algn="ctr">
              <a:lnSpc>
                <a:spcPct val="90000"/>
              </a:lnSpc>
              <a:spcBef>
                <a:spcPts val="0"/>
              </a:spcBef>
              <a:spcAft>
                <a:spcPts val="0"/>
              </a:spcAft>
              <a:buSzPts val="3600"/>
              <a:buFont typeface="Della Respira"/>
              <a:buNone/>
              <a:defRPr sz="3600" b="1">
                <a:latin typeface="Della Respira"/>
                <a:ea typeface="Della Respira"/>
                <a:cs typeface="Della Respira"/>
                <a:sym typeface="Della Respira"/>
              </a:defRPr>
            </a:lvl3pPr>
            <a:lvl4pPr lvl="3" algn="ctr">
              <a:lnSpc>
                <a:spcPct val="90000"/>
              </a:lnSpc>
              <a:spcBef>
                <a:spcPts val="0"/>
              </a:spcBef>
              <a:spcAft>
                <a:spcPts val="0"/>
              </a:spcAft>
              <a:buSzPts val="3600"/>
              <a:buFont typeface="Della Respira"/>
              <a:buNone/>
              <a:defRPr sz="3600" b="1">
                <a:latin typeface="Della Respira"/>
                <a:ea typeface="Della Respira"/>
                <a:cs typeface="Della Respira"/>
                <a:sym typeface="Della Respira"/>
              </a:defRPr>
            </a:lvl4pPr>
            <a:lvl5pPr lvl="4" algn="ctr">
              <a:lnSpc>
                <a:spcPct val="90000"/>
              </a:lnSpc>
              <a:spcBef>
                <a:spcPts val="0"/>
              </a:spcBef>
              <a:spcAft>
                <a:spcPts val="0"/>
              </a:spcAft>
              <a:buSzPts val="3600"/>
              <a:buFont typeface="Della Respira"/>
              <a:buNone/>
              <a:defRPr sz="3600" b="1">
                <a:latin typeface="Della Respira"/>
                <a:ea typeface="Della Respira"/>
                <a:cs typeface="Della Respira"/>
                <a:sym typeface="Della Respira"/>
              </a:defRPr>
            </a:lvl5pPr>
            <a:lvl6pPr lvl="5" algn="ctr">
              <a:lnSpc>
                <a:spcPct val="90000"/>
              </a:lnSpc>
              <a:spcBef>
                <a:spcPts val="0"/>
              </a:spcBef>
              <a:spcAft>
                <a:spcPts val="0"/>
              </a:spcAft>
              <a:buSzPts val="3600"/>
              <a:buFont typeface="Della Respira"/>
              <a:buNone/>
              <a:defRPr sz="3600" b="1">
                <a:latin typeface="Della Respira"/>
                <a:ea typeface="Della Respira"/>
                <a:cs typeface="Della Respira"/>
                <a:sym typeface="Della Respira"/>
              </a:defRPr>
            </a:lvl6pPr>
            <a:lvl7pPr lvl="6" algn="ctr">
              <a:lnSpc>
                <a:spcPct val="90000"/>
              </a:lnSpc>
              <a:spcBef>
                <a:spcPts val="0"/>
              </a:spcBef>
              <a:spcAft>
                <a:spcPts val="0"/>
              </a:spcAft>
              <a:buSzPts val="3600"/>
              <a:buFont typeface="Della Respira"/>
              <a:buNone/>
              <a:defRPr sz="3600" b="1">
                <a:latin typeface="Della Respira"/>
                <a:ea typeface="Della Respira"/>
                <a:cs typeface="Della Respira"/>
                <a:sym typeface="Della Respira"/>
              </a:defRPr>
            </a:lvl7pPr>
            <a:lvl8pPr lvl="7" algn="ctr">
              <a:lnSpc>
                <a:spcPct val="90000"/>
              </a:lnSpc>
              <a:spcBef>
                <a:spcPts val="0"/>
              </a:spcBef>
              <a:spcAft>
                <a:spcPts val="0"/>
              </a:spcAft>
              <a:buSzPts val="3600"/>
              <a:buFont typeface="Della Respira"/>
              <a:buNone/>
              <a:defRPr sz="3600" b="1">
                <a:latin typeface="Della Respira"/>
                <a:ea typeface="Della Respira"/>
                <a:cs typeface="Della Respira"/>
                <a:sym typeface="Della Respira"/>
              </a:defRPr>
            </a:lvl8pPr>
            <a:lvl9pPr lvl="8" algn="ctr">
              <a:lnSpc>
                <a:spcPct val="90000"/>
              </a:lnSpc>
              <a:spcBef>
                <a:spcPts val="0"/>
              </a:spcBef>
              <a:spcAft>
                <a:spcPts val="0"/>
              </a:spcAft>
              <a:buSzPts val="3600"/>
              <a:buFont typeface="Della Respira"/>
              <a:buNone/>
              <a:defRPr sz="3600" b="1">
                <a:latin typeface="Della Respira"/>
                <a:ea typeface="Della Respira"/>
                <a:cs typeface="Della Respira"/>
                <a:sym typeface="Della Respira"/>
              </a:defRPr>
            </a:lvl9pPr>
          </a:lstStyle>
          <a:p>
            <a:endParaRPr/>
          </a:p>
        </p:txBody>
      </p:sp>
      <p:sp>
        <p:nvSpPr>
          <p:cNvPr id="186" name="Google Shape;186;p77"/>
          <p:cNvSpPr txBox="1">
            <a:spLocks noGrp="1"/>
          </p:cNvSpPr>
          <p:nvPr>
            <p:ph type="subTitle" idx="1"/>
          </p:nvPr>
        </p:nvSpPr>
        <p:spPr>
          <a:xfrm>
            <a:off x="1517025" y="1998450"/>
            <a:ext cx="6123600" cy="1579800"/>
          </a:xfrm>
          <a:prstGeom prst="rect">
            <a:avLst/>
          </a:prstGeom>
          <a:noFill/>
          <a:ln>
            <a:noFill/>
          </a:ln>
          <a:effectLst>
            <a:outerShdw blurRad="14288" dist="28575" dir="2700000" algn="bl" rotWithShape="0">
              <a:schemeClr val="dk1">
                <a:alpha val="90980"/>
              </a:schemeClr>
            </a:outerShdw>
          </a:effectLst>
        </p:spPr>
        <p:txBody>
          <a:bodyPr spcFirstLastPara="1" wrap="square" lIns="0" tIns="0" rIns="0" bIns="0" anchor="t" anchorCtr="0">
            <a:noAutofit/>
          </a:bodyPr>
          <a:lstStyle>
            <a:lvl1pPr lvl="0" algn="ctr">
              <a:lnSpc>
                <a:spcPct val="100000"/>
              </a:lnSpc>
              <a:spcBef>
                <a:spcPts val="600"/>
              </a:spcBef>
              <a:spcAft>
                <a:spcPts val="0"/>
              </a:spcAft>
              <a:buSzPts val="2400"/>
              <a:buNone/>
              <a:defRPr sz="9600">
                <a:solidFill>
                  <a:srgbClr val="FFC319"/>
                </a:solidFill>
                <a:latin typeface="Bebas Neue"/>
                <a:ea typeface="Bebas Neue"/>
                <a:cs typeface="Bebas Neue"/>
                <a:sym typeface="Bebas Neue"/>
              </a:defRPr>
            </a:lvl1pPr>
            <a:lvl2pPr lvl="1" algn="ctr">
              <a:lnSpc>
                <a:spcPct val="100000"/>
              </a:lnSpc>
              <a:spcBef>
                <a:spcPts val="600"/>
              </a:spcBef>
              <a:spcAft>
                <a:spcPts val="0"/>
              </a:spcAft>
              <a:buSzPts val="2400"/>
              <a:buNone/>
              <a:defRPr sz="9600">
                <a:solidFill>
                  <a:srgbClr val="FFC319"/>
                </a:solidFill>
                <a:latin typeface="Bebas Neue"/>
                <a:ea typeface="Bebas Neue"/>
                <a:cs typeface="Bebas Neue"/>
                <a:sym typeface="Bebas Neue"/>
              </a:defRPr>
            </a:lvl2pPr>
            <a:lvl3pPr lvl="2" algn="ctr">
              <a:lnSpc>
                <a:spcPct val="100000"/>
              </a:lnSpc>
              <a:spcBef>
                <a:spcPts val="600"/>
              </a:spcBef>
              <a:spcAft>
                <a:spcPts val="0"/>
              </a:spcAft>
              <a:buSzPts val="2400"/>
              <a:buNone/>
              <a:defRPr sz="9600">
                <a:solidFill>
                  <a:srgbClr val="FFC319"/>
                </a:solidFill>
                <a:latin typeface="Bebas Neue"/>
                <a:ea typeface="Bebas Neue"/>
                <a:cs typeface="Bebas Neue"/>
                <a:sym typeface="Bebas Neue"/>
              </a:defRPr>
            </a:lvl3pPr>
            <a:lvl4pPr lvl="3" algn="ctr">
              <a:lnSpc>
                <a:spcPct val="100000"/>
              </a:lnSpc>
              <a:spcBef>
                <a:spcPts val="600"/>
              </a:spcBef>
              <a:spcAft>
                <a:spcPts val="0"/>
              </a:spcAft>
              <a:buSzPts val="2400"/>
              <a:buNone/>
              <a:defRPr sz="9600">
                <a:solidFill>
                  <a:srgbClr val="FFC319"/>
                </a:solidFill>
                <a:latin typeface="Bebas Neue"/>
                <a:ea typeface="Bebas Neue"/>
                <a:cs typeface="Bebas Neue"/>
                <a:sym typeface="Bebas Neue"/>
              </a:defRPr>
            </a:lvl4pPr>
            <a:lvl5pPr lvl="4" algn="ctr">
              <a:lnSpc>
                <a:spcPct val="100000"/>
              </a:lnSpc>
              <a:spcBef>
                <a:spcPts val="600"/>
              </a:spcBef>
              <a:spcAft>
                <a:spcPts val="0"/>
              </a:spcAft>
              <a:buSzPts val="2400"/>
              <a:buNone/>
              <a:defRPr sz="9600">
                <a:solidFill>
                  <a:srgbClr val="FFC319"/>
                </a:solidFill>
                <a:latin typeface="Bebas Neue"/>
                <a:ea typeface="Bebas Neue"/>
                <a:cs typeface="Bebas Neue"/>
                <a:sym typeface="Bebas Neue"/>
              </a:defRPr>
            </a:lvl5pPr>
            <a:lvl6pPr lvl="5" algn="ctr">
              <a:lnSpc>
                <a:spcPct val="100000"/>
              </a:lnSpc>
              <a:spcBef>
                <a:spcPts val="600"/>
              </a:spcBef>
              <a:spcAft>
                <a:spcPts val="0"/>
              </a:spcAft>
              <a:buSzPts val="2400"/>
              <a:buNone/>
              <a:defRPr sz="9600">
                <a:solidFill>
                  <a:srgbClr val="FFC319"/>
                </a:solidFill>
                <a:latin typeface="Bebas Neue"/>
                <a:ea typeface="Bebas Neue"/>
                <a:cs typeface="Bebas Neue"/>
                <a:sym typeface="Bebas Neue"/>
              </a:defRPr>
            </a:lvl6pPr>
            <a:lvl7pPr lvl="6" algn="ctr">
              <a:lnSpc>
                <a:spcPct val="100000"/>
              </a:lnSpc>
              <a:spcBef>
                <a:spcPts val="600"/>
              </a:spcBef>
              <a:spcAft>
                <a:spcPts val="0"/>
              </a:spcAft>
              <a:buSzPts val="2400"/>
              <a:buNone/>
              <a:defRPr sz="9600">
                <a:solidFill>
                  <a:srgbClr val="FFC319"/>
                </a:solidFill>
                <a:latin typeface="Bebas Neue"/>
                <a:ea typeface="Bebas Neue"/>
                <a:cs typeface="Bebas Neue"/>
                <a:sym typeface="Bebas Neue"/>
              </a:defRPr>
            </a:lvl7pPr>
            <a:lvl8pPr lvl="7" algn="ctr">
              <a:lnSpc>
                <a:spcPct val="100000"/>
              </a:lnSpc>
              <a:spcBef>
                <a:spcPts val="600"/>
              </a:spcBef>
              <a:spcAft>
                <a:spcPts val="0"/>
              </a:spcAft>
              <a:buSzPts val="2400"/>
              <a:buNone/>
              <a:defRPr sz="9600">
                <a:solidFill>
                  <a:srgbClr val="FFC319"/>
                </a:solidFill>
                <a:latin typeface="Bebas Neue"/>
                <a:ea typeface="Bebas Neue"/>
                <a:cs typeface="Bebas Neue"/>
                <a:sym typeface="Bebas Neue"/>
              </a:defRPr>
            </a:lvl8pPr>
            <a:lvl9pPr lvl="8" algn="ctr">
              <a:lnSpc>
                <a:spcPct val="100000"/>
              </a:lnSpc>
              <a:spcBef>
                <a:spcPts val="600"/>
              </a:spcBef>
              <a:spcAft>
                <a:spcPts val="0"/>
              </a:spcAft>
              <a:buSzPts val="2400"/>
              <a:buNone/>
              <a:defRPr sz="9600">
                <a:solidFill>
                  <a:srgbClr val="FFC319"/>
                </a:solidFill>
                <a:latin typeface="Bebas Neue"/>
                <a:ea typeface="Bebas Neue"/>
                <a:cs typeface="Bebas Neue"/>
                <a:sym typeface="Bebas Neue"/>
              </a:defRPr>
            </a:lvl9pPr>
          </a:lstStyle>
          <a:p>
            <a:endParaRPr/>
          </a:p>
        </p:txBody>
      </p:sp>
    </p:spTree>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matchingName="JEOPARTY Answer">
  <p:cSld name="TITLE_ONLY_1_1">
    <p:spTree>
      <p:nvGrpSpPr>
        <p:cNvPr id="1" name="Shape 187"/>
        <p:cNvGrpSpPr/>
        <p:nvPr/>
      </p:nvGrpSpPr>
      <p:grpSpPr>
        <a:xfrm>
          <a:off x="0" y="0"/>
          <a:ext cx="0" cy="0"/>
          <a:chOff x="0" y="0"/>
          <a:chExt cx="0" cy="0"/>
        </a:xfrm>
      </p:grpSpPr>
      <p:grpSp>
        <p:nvGrpSpPr>
          <p:cNvPr id="188" name="Google Shape;188;p78"/>
          <p:cNvGrpSpPr/>
          <p:nvPr/>
        </p:nvGrpSpPr>
        <p:grpSpPr>
          <a:xfrm>
            <a:off x="485311" y="484852"/>
            <a:ext cx="8177442" cy="4183216"/>
            <a:chOff x="695700" y="695700"/>
            <a:chExt cx="7752600" cy="3752100"/>
          </a:xfrm>
        </p:grpSpPr>
        <p:sp>
          <p:nvSpPr>
            <p:cNvPr id="189" name="Google Shape;189;p78"/>
            <p:cNvSpPr/>
            <p:nvPr/>
          </p:nvSpPr>
          <p:spPr>
            <a:xfrm>
              <a:off x="695700" y="695700"/>
              <a:ext cx="7752600" cy="3752100"/>
            </a:xfrm>
            <a:prstGeom prst="rect">
              <a:avLst/>
            </a:prstGeom>
            <a:gradFill>
              <a:gsLst>
                <a:gs pos="0">
                  <a:schemeClr val="accent2"/>
                </a:gs>
                <a:gs pos="100000">
                  <a:schemeClr val="accent1"/>
                </a:gs>
              </a:gsLst>
              <a:lin ang="5400012" scaled="0"/>
            </a:gradFill>
            <a:ln>
              <a:noFill/>
            </a:ln>
            <a:effectLst>
              <a:outerShdw blurRad="300038" dist="19050" dir="5400000" algn="bl" rotWithShape="0">
                <a:schemeClr val="dk1">
                  <a:alpha val="49803"/>
                </a:schemeClr>
              </a:outerShdw>
            </a:effectLst>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90" name="Google Shape;190;p78"/>
            <p:cNvSpPr/>
            <p:nvPr/>
          </p:nvSpPr>
          <p:spPr>
            <a:xfrm>
              <a:off x="695700" y="695700"/>
              <a:ext cx="7752600" cy="3752100"/>
            </a:xfrm>
            <a:prstGeom prst="frame">
              <a:avLst>
                <a:gd name="adj1" fmla="val 194"/>
              </a:avLst>
            </a:prstGeom>
            <a:gradFill>
              <a:gsLst>
                <a:gs pos="0">
                  <a:schemeClr val="accent3"/>
                </a:gs>
                <a:gs pos="100000">
                  <a:schemeClr val="accent2"/>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sp>
        <p:nvSpPr>
          <p:cNvPr id="191" name="Google Shape;191;p78"/>
          <p:cNvSpPr txBox="1">
            <a:spLocks noGrp="1"/>
          </p:cNvSpPr>
          <p:nvPr>
            <p:ph type="title"/>
          </p:nvPr>
        </p:nvSpPr>
        <p:spPr>
          <a:xfrm>
            <a:off x="1032075" y="998325"/>
            <a:ext cx="7081800" cy="3156300"/>
          </a:xfrm>
          <a:prstGeom prst="rect">
            <a:avLst/>
          </a:prstGeom>
          <a:noFill/>
          <a:ln>
            <a:noFill/>
          </a:ln>
          <a:effectLst>
            <a:outerShdw blurRad="28575" dist="38100" dir="2700000" algn="bl" rotWithShape="0">
              <a:schemeClr val="dk1">
                <a:alpha val="90980"/>
              </a:schemeClr>
            </a:outerShdw>
          </a:effectLst>
        </p:spPr>
        <p:txBody>
          <a:bodyPr spcFirstLastPara="1" wrap="square" lIns="0" tIns="0" rIns="0" bIns="0" anchor="ctr" anchorCtr="0">
            <a:noAutofit/>
          </a:bodyPr>
          <a:lstStyle>
            <a:lvl1pPr lvl="0" algn="ctr">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1pPr>
            <a:lvl2pPr lvl="1" algn="ctr">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2pPr>
            <a:lvl3pPr lvl="2" algn="ctr">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3pPr>
            <a:lvl4pPr lvl="3" algn="ctr">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4pPr>
            <a:lvl5pPr lvl="4" algn="ctr">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5pPr>
            <a:lvl6pPr lvl="5" algn="ctr">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6pPr>
            <a:lvl7pPr lvl="6" algn="ctr">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7pPr>
            <a:lvl8pPr lvl="7" algn="ctr">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8pPr>
            <a:lvl9pPr lvl="8" algn="ctr">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9pPr>
          </a:lstStyle>
          <a:p>
            <a:endParaRPr/>
          </a:p>
        </p:txBody>
      </p:sp>
      <p:sp>
        <p:nvSpPr>
          <p:cNvPr id="192" name="Google Shape;192;p78"/>
          <p:cNvSpPr txBox="1"/>
          <p:nvPr/>
        </p:nvSpPr>
        <p:spPr>
          <a:xfrm>
            <a:off x="3394800" y="4328600"/>
            <a:ext cx="2354400" cy="144600"/>
          </a:xfrm>
          <a:prstGeom prst="rect">
            <a:avLst/>
          </a:prstGeom>
          <a:noFill/>
          <a:ln>
            <a:noFill/>
          </a:ln>
        </p:spPr>
        <p:txBody>
          <a:bodyPr spcFirstLastPara="1" wrap="square" lIns="0" tIns="0" rIns="0" bIns="0" anchor="t" anchorCtr="0">
            <a:noAutofit/>
          </a:bodyPr>
          <a:lstStyle/>
          <a:p>
            <a:pPr marL="0" marR="0" lvl="0" indent="0" algn="ctr" rtl="0">
              <a:lnSpc>
                <a:spcPct val="100000"/>
              </a:lnSpc>
              <a:spcBef>
                <a:spcPts val="0"/>
              </a:spcBef>
              <a:spcAft>
                <a:spcPts val="0"/>
              </a:spcAft>
              <a:buClr>
                <a:srgbClr val="000000"/>
              </a:buClr>
              <a:buSzPts val="1000"/>
              <a:buFont typeface="Arial"/>
              <a:buNone/>
            </a:pPr>
            <a:r>
              <a:rPr lang="en-US" sz="1000" b="0" i="0" u="none" strike="noStrike" cap="none">
                <a:solidFill>
                  <a:srgbClr val="6D9EEB"/>
                </a:solidFill>
                <a:latin typeface="Della Respira"/>
                <a:ea typeface="Della Respira"/>
                <a:cs typeface="Della Respira"/>
                <a:sym typeface="Della Respira"/>
              </a:rPr>
              <a:t>⬅ BACK TO PANEL</a:t>
            </a:r>
            <a:endParaRPr sz="1000" b="0" i="0" u="none" strike="noStrike" cap="none">
              <a:solidFill>
                <a:srgbClr val="6D9EEB"/>
              </a:solidFill>
              <a:latin typeface="Della Respira"/>
              <a:ea typeface="Della Respira"/>
              <a:cs typeface="Della Respira"/>
              <a:sym typeface="Della Respira"/>
            </a:endParaRPr>
          </a:p>
        </p:txBody>
      </p:sp>
      <p:sp>
        <p:nvSpPr>
          <p:cNvPr id="193" name="Google Shape;193;p78">
            <a:hlinkClick r:id="" action="ppaction://noaction"/>
          </p:cNvPr>
          <p:cNvSpPr/>
          <p:nvPr/>
        </p:nvSpPr>
        <p:spPr>
          <a:xfrm>
            <a:off x="0" y="0"/>
            <a:ext cx="9144000" cy="5143500"/>
          </a:xfrm>
          <a:prstGeom prst="frame">
            <a:avLst>
              <a:gd name="adj1" fmla="val 19553"/>
            </a:avLst>
          </a:prstGeom>
          <a:no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Tree>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194"/>
        <p:cNvGrpSpPr/>
        <p:nvPr/>
      </p:nvGrpSpPr>
      <p:grpSpPr>
        <a:xfrm>
          <a:off x="0" y="0"/>
          <a:ext cx="0" cy="0"/>
          <a:chOff x="0" y="0"/>
          <a:chExt cx="0" cy="0"/>
        </a:xfrm>
      </p:grpSpPr>
      <p:grpSp>
        <p:nvGrpSpPr>
          <p:cNvPr id="195" name="Google Shape;195;p79"/>
          <p:cNvGrpSpPr/>
          <p:nvPr/>
        </p:nvGrpSpPr>
        <p:grpSpPr>
          <a:xfrm>
            <a:off x="695700" y="695700"/>
            <a:ext cx="7752600" cy="3752100"/>
            <a:chOff x="695700" y="695700"/>
            <a:chExt cx="7752600" cy="3752100"/>
          </a:xfrm>
        </p:grpSpPr>
        <p:sp>
          <p:nvSpPr>
            <p:cNvPr id="196" name="Google Shape;196;p79"/>
            <p:cNvSpPr/>
            <p:nvPr/>
          </p:nvSpPr>
          <p:spPr>
            <a:xfrm>
              <a:off x="695700" y="695700"/>
              <a:ext cx="7752600" cy="3752100"/>
            </a:xfrm>
            <a:prstGeom prst="rect">
              <a:avLst/>
            </a:prstGeom>
            <a:gradFill>
              <a:gsLst>
                <a:gs pos="0">
                  <a:schemeClr val="accent2"/>
                </a:gs>
                <a:gs pos="100000">
                  <a:schemeClr val="accent1"/>
                </a:gs>
              </a:gsLst>
              <a:lin ang="5400012" scaled="0"/>
            </a:gradFill>
            <a:ln>
              <a:noFill/>
            </a:ln>
            <a:effectLst>
              <a:outerShdw blurRad="300038" dist="19050" dir="5400000" algn="bl" rotWithShape="0">
                <a:schemeClr val="dk1">
                  <a:alpha val="49803"/>
                </a:schemeClr>
              </a:outerShdw>
            </a:effectLst>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97" name="Google Shape;197;p79"/>
            <p:cNvSpPr/>
            <p:nvPr/>
          </p:nvSpPr>
          <p:spPr>
            <a:xfrm>
              <a:off x="695700" y="695700"/>
              <a:ext cx="7752600" cy="3752100"/>
            </a:xfrm>
            <a:prstGeom prst="frame">
              <a:avLst>
                <a:gd name="adj1" fmla="val 204"/>
              </a:avLst>
            </a:prstGeom>
            <a:gradFill>
              <a:gsLst>
                <a:gs pos="0">
                  <a:schemeClr val="accent3"/>
                </a:gs>
                <a:gs pos="100000">
                  <a:schemeClr val="accent2"/>
                </a:gs>
              </a:gsLst>
              <a:lin ang="5400012" scaled="0"/>
            </a:gra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sp>
        <p:nvSpPr>
          <p:cNvPr id="198" name="Google Shape;198;p79"/>
          <p:cNvSpPr txBox="1">
            <a:spLocks noGrp="1"/>
          </p:cNvSpPr>
          <p:nvPr>
            <p:ph type="body" idx="1"/>
          </p:nvPr>
        </p:nvSpPr>
        <p:spPr>
          <a:xfrm>
            <a:off x="812975" y="4025300"/>
            <a:ext cx="7518000" cy="393600"/>
          </a:xfrm>
          <a:prstGeom prst="rect">
            <a:avLst/>
          </a:prstGeom>
          <a:noFill/>
          <a:ln>
            <a:noFill/>
          </a:ln>
          <a:effectLst>
            <a:outerShdw blurRad="14288" dist="28575" dir="2700000" algn="bl" rotWithShape="0">
              <a:schemeClr val="dk1">
                <a:alpha val="90980"/>
              </a:schemeClr>
            </a:outerShdw>
          </a:effectLst>
        </p:spPr>
        <p:txBody>
          <a:bodyPr spcFirstLastPara="1" wrap="square" lIns="0" tIns="0" rIns="0" bIns="0" anchor="t" anchorCtr="0">
            <a:noAutofit/>
          </a:bodyPr>
          <a:lstStyle>
            <a:lvl1pPr marL="457200" lvl="0" indent="-228600" algn="ctr">
              <a:lnSpc>
                <a:spcPct val="100000"/>
              </a:lnSpc>
              <a:spcBef>
                <a:spcPts val="360"/>
              </a:spcBef>
              <a:spcAft>
                <a:spcPts val="0"/>
              </a:spcAft>
              <a:buSzPts val="1800"/>
              <a:buNone/>
              <a:defRPr sz="1800"/>
            </a:lvl1pPr>
          </a:lstStyle>
          <a:p>
            <a:endParaRPr/>
          </a:p>
        </p:txBody>
      </p:sp>
      <p:sp>
        <p:nvSpPr>
          <p:cNvPr id="199" name="Google Shape;199;p79"/>
          <p:cNvSpPr txBox="1">
            <a:spLocks noGrp="1"/>
          </p:cNvSpPr>
          <p:nvPr>
            <p:ph type="sldNum" idx="12"/>
          </p:nvPr>
        </p:nvSpPr>
        <p:spPr>
          <a:xfrm>
            <a:off x="4297650" y="4749851"/>
            <a:ext cx="548700" cy="393600"/>
          </a:xfrm>
          <a:prstGeom prst="rect">
            <a:avLst/>
          </a:prstGeom>
          <a:noFill/>
          <a:ln>
            <a:noFill/>
          </a:ln>
        </p:spPr>
        <p:txBody>
          <a:bodyPr spcFirstLastPara="1" wrap="square" lIns="0" tIns="0" rIns="0" bIns="0" anchor="ctr" anchorCtr="0">
            <a:noAutofit/>
          </a:bodyPr>
          <a:lstStyle>
            <a:lvl1pPr marL="0" marR="0" lvl="0"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1pPr>
            <a:lvl2pPr marL="0" marR="0" lvl="1"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2pPr>
            <a:lvl3pPr marL="0" marR="0" lvl="2"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3pPr>
            <a:lvl4pPr marL="0" marR="0" lvl="3"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4pPr>
            <a:lvl5pPr marL="0" marR="0" lvl="4"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5pPr>
            <a:lvl6pPr marL="0" marR="0" lvl="5"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6pPr>
            <a:lvl7pPr marL="0" marR="0" lvl="6"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7pPr>
            <a:lvl8pPr marL="0" marR="0" lvl="7"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8pPr>
            <a:lvl9pPr marL="0" marR="0" lvl="8" indent="0" algn="ctr">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Quote">
  <p:cSld name="TITLE_1_1">
    <p:spTree>
      <p:nvGrpSpPr>
        <p:cNvPr id="1" name="Shape 104"/>
        <p:cNvGrpSpPr/>
        <p:nvPr/>
      </p:nvGrpSpPr>
      <p:grpSpPr>
        <a:xfrm>
          <a:off x="0" y="0"/>
          <a:ext cx="0" cy="0"/>
          <a:chOff x="0" y="0"/>
          <a:chExt cx="0" cy="0"/>
        </a:xfrm>
      </p:grpSpPr>
      <p:grpSp>
        <p:nvGrpSpPr>
          <p:cNvPr id="105" name="Google Shape;105;p4"/>
          <p:cNvGrpSpPr/>
          <p:nvPr/>
        </p:nvGrpSpPr>
        <p:grpSpPr>
          <a:xfrm>
            <a:off x="695700" y="695700"/>
            <a:ext cx="7752600" cy="3752100"/>
            <a:chOff x="695700" y="695700"/>
            <a:chExt cx="7752600" cy="3752100"/>
          </a:xfrm>
        </p:grpSpPr>
        <p:sp>
          <p:nvSpPr>
            <p:cNvPr id="106" name="Google Shape;106;p4"/>
            <p:cNvSpPr/>
            <p:nvPr/>
          </p:nvSpPr>
          <p:spPr>
            <a:xfrm>
              <a:off x="695700" y="695700"/>
              <a:ext cx="7752600" cy="3752100"/>
            </a:xfrm>
            <a:prstGeom prst="rect">
              <a:avLst/>
            </a:prstGeom>
            <a:gradFill>
              <a:gsLst>
                <a:gs pos="0">
                  <a:schemeClr val="accent2"/>
                </a:gs>
                <a:gs pos="100000">
                  <a:schemeClr val="accent1"/>
                </a:gs>
              </a:gsLst>
              <a:lin ang="5400012" scaled="0"/>
            </a:gradFill>
            <a:ln>
              <a:noFill/>
            </a:ln>
            <a:effectLst>
              <a:outerShdw blurRad="300038" dist="19050" dir="5400000" algn="bl" rotWithShape="0">
                <a:schemeClr val="dk1">
                  <a:alpha val="50000"/>
                </a:scheme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7" name="Google Shape;107;p4"/>
            <p:cNvSpPr/>
            <p:nvPr/>
          </p:nvSpPr>
          <p:spPr>
            <a:xfrm>
              <a:off x="695700" y="695700"/>
              <a:ext cx="7752600" cy="3752100"/>
            </a:xfrm>
            <a:prstGeom prst="frame">
              <a:avLst>
                <a:gd name="adj1" fmla="val 204"/>
              </a:avLst>
            </a:prstGeom>
            <a:gradFill>
              <a:gsLst>
                <a:gs pos="0">
                  <a:schemeClr val="accent3"/>
                </a:gs>
                <a:gs pos="100000">
                  <a:schemeClr val="accent2"/>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108" name="Google Shape;108;p4"/>
          <p:cNvSpPr txBox="1">
            <a:spLocks noGrp="1"/>
          </p:cNvSpPr>
          <p:nvPr>
            <p:ph type="body" idx="1"/>
          </p:nvPr>
        </p:nvSpPr>
        <p:spPr>
          <a:xfrm>
            <a:off x="1387050" y="2161800"/>
            <a:ext cx="6369900" cy="819900"/>
          </a:xfrm>
          <a:prstGeom prst="rect">
            <a:avLst/>
          </a:prstGeom>
        </p:spPr>
        <p:txBody>
          <a:bodyPr spcFirstLastPara="1" wrap="square" lIns="0" tIns="0" rIns="0" bIns="0" anchor="ctr" anchorCtr="0">
            <a:noAutofit/>
          </a:bodyPr>
          <a:lstStyle>
            <a:lvl1pPr marL="457200" lvl="0" indent="-419100" algn="ctr" rtl="0">
              <a:spcBef>
                <a:spcPts val="600"/>
              </a:spcBef>
              <a:spcAft>
                <a:spcPts val="0"/>
              </a:spcAft>
              <a:buSzPts val="3000"/>
              <a:buChar char="➢"/>
              <a:defRPr sz="3000"/>
            </a:lvl1pPr>
            <a:lvl2pPr marL="914400" lvl="1" indent="-419100" algn="ctr" rtl="0">
              <a:spcBef>
                <a:spcPts val="0"/>
              </a:spcBef>
              <a:spcAft>
                <a:spcPts val="0"/>
              </a:spcAft>
              <a:buSzPts val="3000"/>
              <a:buChar char="○"/>
              <a:defRPr sz="3000"/>
            </a:lvl2pPr>
            <a:lvl3pPr marL="1371600" lvl="2" indent="-419100" algn="ctr" rtl="0">
              <a:spcBef>
                <a:spcPts val="0"/>
              </a:spcBef>
              <a:spcAft>
                <a:spcPts val="0"/>
              </a:spcAft>
              <a:buSzPts val="3000"/>
              <a:buChar char="■"/>
              <a:defRPr sz="3000"/>
            </a:lvl3pPr>
            <a:lvl4pPr marL="1828800" lvl="3" indent="-419100" algn="ctr" rtl="0">
              <a:spcBef>
                <a:spcPts val="0"/>
              </a:spcBef>
              <a:spcAft>
                <a:spcPts val="0"/>
              </a:spcAft>
              <a:buSzPts val="3000"/>
              <a:buChar char="●"/>
              <a:defRPr sz="3000"/>
            </a:lvl4pPr>
            <a:lvl5pPr marL="2286000" lvl="4" indent="-419100" algn="ctr" rtl="0">
              <a:spcBef>
                <a:spcPts val="0"/>
              </a:spcBef>
              <a:spcAft>
                <a:spcPts val="0"/>
              </a:spcAft>
              <a:buSzPts val="3000"/>
              <a:buChar char="○"/>
              <a:defRPr sz="3000"/>
            </a:lvl5pPr>
            <a:lvl6pPr marL="2743200" lvl="5" indent="-419100" algn="ctr" rtl="0">
              <a:spcBef>
                <a:spcPts val="0"/>
              </a:spcBef>
              <a:spcAft>
                <a:spcPts val="0"/>
              </a:spcAft>
              <a:buSzPts val="3000"/>
              <a:buChar char="■"/>
              <a:defRPr sz="3000"/>
            </a:lvl6pPr>
            <a:lvl7pPr marL="3200400" lvl="6" indent="-419100" algn="ctr" rtl="0">
              <a:spcBef>
                <a:spcPts val="0"/>
              </a:spcBef>
              <a:spcAft>
                <a:spcPts val="0"/>
              </a:spcAft>
              <a:buSzPts val="3000"/>
              <a:buChar char="●"/>
              <a:defRPr sz="3000"/>
            </a:lvl7pPr>
            <a:lvl8pPr marL="3657600" lvl="7" indent="-419100" algn="ctr" rtl="0">
              <a:spcBef>
                <a:spcPts val="0"/>
              </a:spcBef>
              <a:spcAft>
                <a:spcPts val="0"/>
              </a:spcAft>
              <a:buSzPts val="3000"/>
              <a:buChar char="○"/>
              <a:defRPr sz="3000"/>
            </a:lvl8pPr>
            <a:lvl9pPr marL="4114800" lvl="8" indent="-419100" algn="ctr" rtl="0">
              <a:spcBef>
                <a:spcPts val="0"/>
              </a:spcBef>
              <a:spcAft>
                <a:spcPts val="0"/>
              </a:spcAft>
              <a:buSzPts val="3000"/>
              <a:buChar char="■"/>
              <a:defRPr sz="3000"/>
            </a:lvl9pPr>
          </a:lstStyle>
          <a:p>
            <a:endParaRPr/>
          </a:p>
        </p:txBody>
      </p:sp>
      <p:sp>
        <p:nvSpPr>
          <p:cNvPr id="109" name="Google Shape;109;p4"/>
          <p:cNvSpPr txBox="1"/>
          <p:nvPr/>
        </p:nvSpPr>
        <p:spPr>
          <a:xfrm>
            <a:off x="3593400" y="781369"/>
            <a:ext cx="1957200" cy="653700"/>
          </a:xfrm>
          <a:prstGeom prst="rect">
            <a:avLst/>
          </a:prstGeom>
          <a:noFill/>
          <a:ln>
            <a:noFill/>
          </a:ln>
        </p:spPr>
        <p:txBody>
          <a:bodyPr spcFirstLastPara="1" wrap="square" lIns="0" tIns="0" rIns="0" bIns="0" anchor="t" anchorCtr="0">
            <a:noAutofit/>
          </a:bodyPr>
          <a:lstStyle/>
          <a:p>
            <a:pPr marL="0" lvl="0" indent="0" algn="ctr" rtl="0">
              <a:spcBef>
                <a:spcPts val="0"/>
              </a:spcBef>
              <a:spcAft>
                <a:spcPts val="0"/>
              </a:spcAft>
              <a:buNone/>
            </a:pPr>
            <a:r>
              <a:rPr lang="en" sz="9600">
                <a:solidFill>
                  <a:schemeClr val="accent6"/>
                </a:solidFill>
                <a:latin typeface="Della Respira"/>
                <a:ea typeface="Della Respira"/>
                <a:cs typeface="Della Respira"/>
                <a:sym typeface="Della Respira"/>
              </a:rPr>
              <a:t>“</a:t>
            </a:r>
            <a:endParaRPr sz="9600">
              <a:solidFill>
                <a:schemeClr val="accent6"/>
              </a:solidFill>
              <a:latin typeface="Della Respira"/>
              <a:ea typeface="Della Respira"/>
              <a:cs typeface="Della Respira"/>
              <a:sym typeface="Della Respira"/>
            </a:endParaRPr>
          </a:p>
        </p:txBody>
      </p:sp>
      <p:sp>
        <p:nvSpPr>
          <p:cNvPr id="110" name="Google Shape;110;p4"/>
          <p:cNvSpPr txBox="1">
            <a:spLocks noGrp="1"/>
          </p:cNvSpPr>
          <p:nvPr>
            <p:ph type="sldNum" idx="12"/>
          </p:nvPr>
        </p:nvSpPr>
        <p:spPr>
          <a:xfrm>
            <a:off x="4297650" y="4749851"/>
            <a:ext cx="548700" cy="393600"/>
          </a:xfrm>
          <a:prstGeom prst="rect">
            <a:avLst/>
          </a:prstGeom>
        </p:spPr>
        <p:txBody>
          <a:bodyPr spcFirstLastPara="1" wrap="square" lIns="0" tIns="0" rIns="0" bIns="0"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ct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 3 columns">
  <p:cSld name="TITLE_AND_TWO_COLUMNS_1">
    <p:spTree>
      <p:nvGrpSpPr>
        <p:cNvPr id="1" name="Shape 126"/>
        <p:cNvGrpSpPr/>
        <p:nvPr/>
      </p:nvGrpSpPr>
      <p:grpSpPr>
        <a:xfrm>
          <a:off x="0" y="0"/>
          <a:ext cx="0" cy="0"/>
          <a:chOff x="0" y="0"/>
          <a:chExt cx="0" cy="0"/>
        </a:xfrm>
      </p:grpSpPr>
      <p:grpSp>
        <p:nvGrpSpPr>
          <p:cNvPr id="127" name="Google Shape;127;p7"/>
          <p:cNvGrpSpPr/>
          <p:nvPr/>
        </p:nvGrpSpPr>
        <p:grpSpPr>
          <a:xfrm>
            <a:off x="695700" y="695700"/>
            <a:ext cx="7752600" cy="3752100"/>
            <a:chOff x="695700" y="695700"/>
            <a:chExt cx="7752600" cy="3752100"/>
          </a:xfrm>
        </p:grpSpPr>
        <p:sp>
          <p:nvSpPr>
            <p:cNvPr id="128" name="Google Shape;128;p7"/>
            <p:cNvSpPr/>
            <p:nvPr/>
          </p:nvSpPr>
          <p:spPr>
            <a:xfrm>
              <a:off x="695700" y="695700"/>
              <a:ext cx="7752600" cy="3752100"/>
            </a:xfrm>
            <a:prstGeom prst="rect">
              <a:avLst/>
            </a:prstGeom>
            <a:gradFill>
              <a:gsLst>
                <a:gs pos="0">
                  <a:schemeClr val="accent2"/>
                </a:gs>
                <a:gs pos="100000">
                  <a:schemeClr val="accent1"/>
                </a:gs>
              </a:gsLst>
              <a:lin ang="5400012" scaled="0"/>
            </a:gradFill>
            <a:ln>
              <a:noFill/>
            </a:ln>
            <a:effectLst>
              <a:outerShdw blurRad="300038" dist="19050" dir="5400000" algn="bl" rotWithShape="0">
                <a:schemeClr val="dk1">
                  <a:alpha val="50000"/>
                </a:scheme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29" name="Google Shape;129;p7"/>
            <p:cNvSpPr/>
            <p:nvPr/>
          </p:nvSpPr>
          <p:spPr>
            <a:xfrm>
              <a:off x="695700" y="695700"/>
              <a:ext cx="7752600" cy="3752100"/>
            </a:xfrm>
            <a:prstGeom prst="frame">
              <a:avLst>
                <a:gd name="adj1" fmla="val 204"/>
              </a:avLst>
            </a:prstGeom>
            <a:gradFill>
              <a:gsLst>
                <a:gs pos="0">
                  <a:schemeClr val="accent3"/>
                </a:gs>
                <a:gs pos="100000">
                  <a:schemeClr val="accent2"/>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130" name="Google Shape;130;p7"/>
          <p:cNvSpPr txBox="1">
            <a:spLocks noGrp="1"/>
          </p:cNvSpPr>
          <p:nvPr>
            <p:ph type="title"/>
          </p:nvPr>
        </p:nvSpPr>
        <p:spPr>
          <a:xfrm>
            <a:off x="1022525" y="1008050"/>
            <a:ext cx="7098900" cy="357900"/>
          </a:xfrm>
          <a:prstGeom prst="rect">
            <a:avLst/>
          </a:prstGeom>
        </p:spPr>
        <p:txBody>
          <a:bodyPr spcFirstLastPara="1" wrap="square" lIns="0" tIns="0" rIns="0" bIns="0" anchor="b" anchorCtr="0">
            <a:noAutofit/>
          </a:bodyPr>
          <a:lstStyle>
            <a:lvl1pPr lvl="0" rtl="0">
              <a:spcBef>
                <a:spcPts val="0"/>
              </a:spcBef>
              <a:spcAft>
                <a:spcPts val="0"/>
              </a:spcAft>
              <a:buSzPts val="3200"/>
              <a:buNone/>
              <a:defRPr/>
            </a:lvl1pPr>
            <a:lvl2pPr lvl="1" rtl="0">
              <a:spcBef>
                <a:spcPts val="0"/>
              </a:spcBef>
              <a:spcAft>
                <a:spcPts val="0"/>
              </a:spcAft>
              <a:buSzPts val="3200"/>
              <a:buNone/>
              <a:defRPr/>
            </a:lvl2pPr>
            <a:lvl3pPr lvl="2" rtl="0">
              <a:spcBef>
                <a:spcPts val="0"/>
              </a:spcBef>
              <a:spcAft>
                <a:spcPts val="0"/>
              </a:spcAft>
              <a:buSzPts val="3200"/>
              <a:buNone/>
              <a:defRPr/>
            </a:lvl3pPr>
            <a:lvl4pPr lvl="3" rtl="0">
              <a:spcBef>
                <a:spcPts val="0"/>
              </a:spcBef>
              <a:spcAft>
                <a:spcPts val="0"/>
              </a:spcAft>
              <a:buSzPts val="3200"/>
              <a:buNone/>
              <a:defRPr/>
            </a:lvl4pPr>
            <a:lvl5pPr lvl="4" rtl="0">
              <a:spcBef>
                <a:spcPts val="0"/>
              </a:spcBef>
              <a:spcAft>
                <a:spcPts val="0"/>
              </a:spcAft>
              <a:buSzPts val="3200"/>
              <a:buNone/>
              <a:defRPr/>
            </a:lvl5pPr>
            <a:lvl6pPr lvl="5" rtl="0">
              <a:spcBef>
                <a:spcPts val="0"/>
              </a:spcBef>
              <a:spcAft>
                <a:spcPts val="0"/>
              </a:spcAft>
              <a:buSzPts val="3200"/>
              <a:buNone/>
              <a:defRPr/>
            </a:lvl6pPr>
            <a:lvl7pPr lvl="6" rtl="0">
              <a:spcBef>
                <a:spcPts val="0"/>
              </a:spcBef>
              <a:spcAft>
                <a:spcPts val="0"/>
              </a:spcAft>
              <a:buSzPts val="3200"/>
              <a:buNone/>
              <a:defRPr/>
            </a:lvl7pPr>
            <a:lvl8pPr lvl="7" rtl="0">
              <a:spcBef>
                <a:spcPts val="0"/>
              </a:spcBef>
              <a:spcAft>
                <a:spcPts val="0"/>
              </a:spcAft>
              <a:buSzPts val="3200"/>
              <a:buNone/>
              <a:defRPr/>
            </a:lvl8pPr>
            <a:lvl9pPr lvl="8" rtl="0">
              <a:spcBef>
                <a:spcPts val="0"/>
              </a:spcBef>
              <a:spcAft>
                <a:spcPts val="0"/>
              </a:spcAft>
              <a:buSzPts val="3200"/>
              <a:buNone/>
              <a:defRPr/>
            </a:lvl9pPr>
          </a:lstStyle>
          <a:p>
            <a:endParaRPr/>
          </a:p>
        </p:txBody>
      </p:sp>
      <p:sp>
        <p:nvSpPr>
          <p:cNvPr id="131" name="Google Shape;131;p7"/>
          <p:cNvSpPr txBox="1">
            <a:spLocks noGrp="1"/>
          </p:cNvSpPr>
          <p:nvPr>
            <p:ph type="body" idx="1"/>
          </p:nvPr>
        </p:nvSpPr>
        <p:spPr>
          <a:xfrm>
            <a:off x="1006512" y="1475825"/>
            <a:ext cx="2211300" cy="2756700"/>
          </a:xfrm>
          <a:prstGeom prst="rect">
            <a:avLst/>
          </a:prstGeom>
        </p:spPr>
        <p:txBody>
          <a:bodyPr spcFirstLastPara="1" wrap="square" lIns="0" tIns="0" rIns="0" bIns="0" anchor="t" anchorCtr="0">
            <a:noAutofit/>
          </a:bodyPr>
          <a:lstStyle>
            <a:lvl1pPr marL="457200" lvl="0" indent="-342900" rtl="0">
              <a:spcBef>
                <a:spcPts val="600"/>
              </a:spcBef>
              <a:spcAft>
                <a:spcPts val="0"/>
              </a:spcAft>
              <a:buSzPts val="1800"/>
              <a:buChar char="➢"/>
              <a:defRPr sz="1800"/>
            </a:lvl1pPr>
            <a:lvl2pPr marL="914400" lvl="1" indent="-342900" rtl="0">
              <a:spcBef>
                <a:spcPts val="0"/>
              </a:spcBef>
              <a:spcAft>
                <a:spcPts val="0"/>
              </a:spcAft>
              <a:buSzPts val="1800"/>
              <a:buChar char="○"/>
              <a:defRPr sz="1800"/>
            </a:lvl2pPr>
            <a:lvl3pPr marL="1371600" lvl="2" indent="-342900" rtl="0">
              <a:spcBef>
                <a:spcPts val="0"/>
              </a:spcBef>
              <a:spcAft>
                <a:spcPts val="0"/>
              </a:spcAft>
              <a:buSzPts val="1800"/>
              <a:buChar char="■"/>
              <a:defRPr sz="1800"/>
            </a:lvl3pPr>
            <a:lvl4pPr marL="1828800" lvl="3" indent="-342900" rtl="0">
              <a:spcBef>
                <a:spcPts val="0"/>
              </a:spcBef>
              <a:spcAft>
                <a:spcPts val="0"/>
              </a:spcAft>
              <a:buSzPts val="1800"/>
              <a:buChar char="●"/>
              <a:defRPr sz="1800"/>
            </a:lvl4pPr>
            <a:lvl5pPr marL="2286000" lvl="4" indent="-342900" rtl="0">
              <a:spcBef>
                <a:spcPts val="0"/>
              </a:spcBef>
              <a:spcAft>
                <a:spcPts val="0"/>
              </a:spcAft>
              <a:buSzPts val="1800"/>
              <a:buChar char="○"/>
              <a:defRPr sz="1800"/>
            </a:lvl5pPr>
            <a:lvl6pPr marL="2743200" lvl="5" indent="-342900" rtl="0">
              <a:spcBef>
                <a:spcPts val="0"/>
              </a:spcBef>
              <a:spcAft>
                <a:spcPts val="0"/>
              </a:spcAft>
              <a:buSzPts val="1800"/>
              <a:buChar char="■"/>
              <a:defRPr sz="1800"/>
            </a:lvl6pPr>
            <a:lvl7pPr marL="3200400" lvl="6" indent="-342900" rtl="0">
              <a:spcBef>
                <a:spcPts val="0"/>
              </a:spcBef>
              <a:spcAft>
                <a:spcPts val="0"/>
              </a:spcAft>
              <a:buSzPts val="1800"/>
              <a:buChar char="●"/>
              <a:defRPr sz="1800"/>
            </a:lvl7pPr>
            <a:lvl8pPr marL="3657600" lvl="7" indent="-342900" rtl="0">
              <a:spcBef>
                <a:spcPts val="0"/>
              </a:spcBef>
              <a:spcAft>
                <a:spcPts val="0"/>
              </a:spcAft>
              <a:buSzPts val="1800"/>
              <a:buChar char="○"/>
              <a:defRPr sz="1800"/>
            </a:lvl8pPr>
            <a:lvl9pPr marL="4114800" lvl="8" indent="-342900" rtl="0">
              <a:spcBef>
                <a:spcPts val="0"/>
              </a:spcBef>
              <a:spcAft>
                <a:spcPts val="0"/>
              </a:spcAft>
              <a:buSzPts val="1800"/>
              <a:buChar char="■"/>
              <a:defRPr sz="1800"/>
            </a:lvl9pPr>
          </a:lstStyle>
          <a:p>
            <a:endParaRPr/>
          </a:p>
        </p:txBody>
      </p:sp>
      <p:sp>
        <p:nvSpPr>
          <p:cNvPr id="132" name="Google Shape;132;p7"/>
          <p:cNvSpPr txBox="1">
            <a:spLocks noGrp="1"/>
          </p:cNvSpPr>
          <p:nvPr>
            <p:ph type="body" idx="2"/>
          </p:nvPr>
        </p:nvSpPr>
        <p:spPr>
          <a:xfrm>
            <a:off x="3450259" y="1475825"/>
            <a:ext cx="2211300" cy="2756700"/>
          </a:xfrm>
          <a:prstGeom prst="rect">
            <a:avLst/>
          </a:prstGeom>
        </p:spPr>
        <p:txBody>
          <a:bodyPr spcFirstLastPara="1" wrap="square" lIns="0" tIns="0" rIns="0" bIns="0" anchor="t" anchorCtr="0">
            <a:noAutofit/>
          </a:bodyPr>
          <a:lstStyle>
            <a:lvl1pPr marL="457200" lvl="0" indent="-342900" rtl="0">
              <a:spcBef>
                <a:spcPts val="600"/>
              </a:spcBef>
              <a:spcAft>
                <a:spcPts val="0"/>
              </a:spcAft>
              <a:buSzPts val="1800"/>
              <a:buChar char="➢"/>
              <a:defRPr sz="1800"/>
            </a:lvl1pPr>
            <a:lvl2pPr marL="914400" lvl="1" indent="-342900" rtl="0">
              <a:spcBef>
                <a:spcPts val="0"/>
              </a:spcBef>
              <a:spcAft>
                <a:spcPts val="0"/>
              </a:spcAft>
              <a:buSzPts val="1800"/>
              <a:buChar char="○"/>
              <a:defRPr sz="1800"/>
            </a:lvl2pPr>
            <a:lvl3pPr marL="1371600" lvl="2" indent="-342900" rtl="0">
              <a:spcBef>
                <a:spcPts val="0"/>
              </a:spcBef>
              <a:spcAft>
                <a:spcPts val="0"/>
              </a:spcAft>
              <a:buSzPts val="1800"/>
              <a:buChar char="■"/>
              <a:defRPr sz="1800"/>
            </a:lvl3pPr>
            <a:lvl4pPr marL="1828800" lvl="3" indent="-342900" rtl="0">
              <a:spcBef>
                <a:spcPts val="0"/>
              </a:spcBef>
              <a:spcAft>
                <a:spcPts val="0"/>
              </a:spcAft>
              <a:buSzPts val="1800"/>
              <a:buChar char="●"/>
              <a:defRPr sz="1800"/>
            </a:lvl4pPr>
            <a:lvl5pPr marL="2286000" lvl="4" indent="-342900" rtl="0">
              <a:spcBef>
                <a:spcPts val="0"/>
              </a:spcBef>
              <a:spcAft>
                <a:spcPts val="0"/>
              </a:spcAft>
              <a:buSzPts val="1800"/>
              <a:buChar char="○"/>
              <a:defRPr sz="1800"/>
            </a:lvl5pPr>
            <a:lvl6pPr marL="2743200" lvl="5" indent="-342900" rtl="0">
              <a:spcBef>
                <a:spcPts val="0"/>
              </a:spcBef>
              <a:spcAft>
                <a:spcPts val="0"/>
              </a:spcAft>
              <a:buSzPts val="1800"/>
              <a:buChar char="■"/>
              <a:defRPr sz="1800"/>
            </a:lvl6pPr>
            <a:lvl7pPr marL="3200400" lvl="6" indent="-342900" rtl="0">
              <a:spcBef>
                <a:spcPts val="0"/>
              </a:spcBef>
              <a:spcAft>
                <a:spcPts val="0"/>
              </a:spcAft>
              <a:buSzPts val="1800"/>
              <a:buChar char="●"/>
              <a:defRPr sz="1800"/>
            </a:lvl7pPr>
            <a:lvl8pPr marL="3657600" lvl="7" indent="-342900" rtl="0">
              <a:spcBef>
                <a:spcPts val="0"/>
              </a:spcBef>
              <a:spcAft>
                <a:spcPts val="0"/>
              </a:spcAft>
              <a:buSzPts val="1800"/>
              <a:buChar char="○"/>
              <a:defRPr sz="1800"/>
            </a:lvl8pPr>
            <a:lvl9pPr marL="4114800" lvl="8" indent="-342900" rtl="0">
              <a:spcBef>
                <a:spcPts val="0"/>
              </a:spcBef>
              <a:spcAft>
                <a:spcPts val="0"/>
              </a:spcAft>
              <a:buSzPts val="1800"/>
              <a:buChar char="■"/>
              <a:defRPr sz="1800"/>
            </a:lvl9pPr>
          </a:lstStyle>
          <a:p>
            <a:endParaRPr/>
          </a:p>
        </p:txBody>
      </p:sp>
      <p:sp>
        <p:nvSpPr>
          <p:cNvPr id="133" name="Google Shape;133;p7"/>
          <p:cNvSpPr txBox="1">
            <a:spLocks noGrp="1"/>
          </p:cNvSpPr>
          <p:nvPr>
            <p:ph type="body" idx="3"/>
          </p:nvPr>
        </p:nvSpPr>
        <p:spPr>
          <a:xfrm>
            <a:off x="5894006" y="1475825"/>
            <a:ext cx="2211300" cy="2756700"/>
          </a:xfrm>
          <a:prstGeom prst="rect">
            <a:avLst/>
          </a:prstGeom>
        </p:spPr>
        <p:txBody>
          <a:bodyPr spcFirstLastPara="1" wrap="square" lIns="0" tIns="0" rIns="0" bIns="0" anchor="t" anchorCtr="0">
            <a:noAutofit/>
          </a:bodyPr>
          <a:lstStyle>
            <a:lvl1pPr marL="457200" lvl="0" indent="-342900" rtl="0">
              <a:spcBef>
                <a:spcPts val="600"/>
              </a:spcBef>
              <a:spcAft>
                <a:spcPts val="0"/>
              </a:spcAft>
              <a:buSzPts val="1800"/>
              <a:buChar char="➢"/>
              <a:defRPr sz="1800"/>
            </a:lvl1pPr>
            <a:lvl2pPr marL="914400" lvl="1" indent="-342900" rtl="0">
              <a:spcBef>
                <a:spcPts val="0"/>
              </a:spcBef>
              <a:spcAft>
                <a:spcPts val="0"/>
              </a:spcAft>
              <a:buSzPts val="1800"/>
              <a:buChar char="○"/>
              <a:defRPr sz="1800"/>
            </a:lvl2pPr>
            <a:lvl3pPr marL="1371600" lvl="2" indent="-342900" rtl="0">
              <a:spcBef>
                <a:spcPts val="0"/>
              </a:spcBef>
              <a:spcAft>
                <a:spcPts val="0"/>
              </a:spcAft>
              <a:buSzPts val="1800"/>
              <a:buChar char="■"/>
              <a:defRPr sz="1800"/>
            </a:lvl3pPr>
            <a:lvl4pPr marL="1828800" lvl="3" indent="-342900" rtl="0">
              <a:spcBef>
                <a:spcPts val="0"/>
              </a:spcBef>
              <a:spcAft>
                <a:spcPts val="0"/>
              </a:spcAft>
              <a:buSzPts val="1800"/>
              <a:buChar char="●"/>
              <a:defRPr sz="1800"/>
            </a:lvl4pPr>
            <a:lvl5pPr marL="2286000" lvl="4" indent="-342900" rtl="0">
              <a:spcBef>
                <a:spcPts val="0"/>
              </a:spcBef>
              <a:spcAft>
                <a:spcPts val="0"/>
              </a:spcAft>
              <a:buSzPts val="1800"/>
              <a:buChar char="○"/>
              <a:defRPr sz="1800"/>
            </a:lvl5pPr>
            <a:lvl6pPr marL="2743200" lvl="5" indent="-342900" rtl="0">
              <a:spcBef>
                <a:spcPts val="0"/>
              </a:spcBef>
              <a:spcAft>
                <a:spcPts val="0"/>
              </a:spcAft>
              <a:buSzPts val="1800"/>
              <a:buChar char="■"/>
              <a:defRPr sz="1800"/>
            </a:lvl6pPr>
            <a:lvl7pPr marL="3200400" lvl="6" indent="-342900" rtl="0">
              <a:spcBef>
                <a:spcPts val="0"/>
              </a:spcBef>
              <a:spcAft>
                <a:spcPts val="0"/>
              </a:spcAft>
              <a:buSzPts val="1800"/>
              <a:buChar char="●"/>
              <a:defRPr sz="1800"/>
            </a:lvl7pPr>
            <a:lvl8pPr marL="3657600" lvl="7" indent="-342900" rtl="0">
              <a:spcBef>
                <a:spcPts val="0"/>
              </a:spcBef>
              <a:spcAft>
                <a:spcPts val="0"/>
              </a:spcAft>
              <a:buSzPts val="1800"/>
              <a:buChar char="○"/>
              <a:defRPr sz="1800"/>
            </a:lvl8pPr>
            <a:lvl9pPr marL="4114800" lvl="8" indent="-342900" rtl="0">
              <a:spcBef>
                <a:spcPts val="0"/>
              </a:spcBef>
              <a:spcAft>
                <a:spcPts val="0"/>
              </a:spcAft>
              <a:buSzPts val="1800"/>
              <a:buChar char="■"/>
              <a:defRPr sz="1800"/>
            </a:lvl9pPr>
          </a:lstStyle>
          <a:p>
            <a:endParaRPr/>
          </a:p>
        </p:txBody>
      </p:sp>
      <p:sp>
        <p:nvSpPr>
          <p:cNvPr id="134" name="Google Shape;134;p7"/>
          <p:cNvSpPr txBox="1">
            <a:spLocks noGrp="1"/>
          </p:cNvSpPr>
          <p:nvPr>
            <p:ph type="sldNum" idx="12"/>
          </p:nvPr>
        </p:nvSpPr>
        <p:spPr>
          <a:xfrm>
            <a:off x="4297650" y="4749851"/>
            <a:ext cx="548700" cy="393600"/>
          </a:xfrm>
          <a:prstGeom prst="rect">
            <a:avLst/>
          </a:prstGeom>
        </p:spPr>
        <p:txBody>
          <a:bodyPr spcFirstLastPara="1" wrap="square" lIns="0" tIns="0" rIns="0" bIns="0"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ct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135"/>
        <p:cNvGrpSpPr/>
        <p:nvPr/>
      </p:nvGrpSpPr>
      <p:grpSpPr>
        <a:xfrm>
          <a:off x="0" y="0"/>
          <a:ext cx="0" cy="0"/>
          <a:chOff x="0" y="0"/>
          <a:chExt cx="0" cy="0"/>
        </a:xfrm>
      </p:grpSpPr>
      <p:grpSp>
        <p:nvGrpSpPr>
          <p:cNvPr id="136" name="Google Shape;136;p8"/>
          <p:cNvGrpSpPr/>
          <p:nvPr/>
        </p:nvGrpSpPr>
        <p:grpSpPr>
          <a:xfrm>
            <a:off x="695700" y="695700"/>
            <a:ext cx="7752600" cy="3752100"/>
            <a:chOff x="695700" y="695700"/>
            <a:chExt cx="7752600" cy="3752100"/>
          </a:xfrm>
        </p:grpSpPr>
        <p:sp>
          <p:nvSpPr>
            <p:cNvPr id="137" name="Google Shape;137;p8"/>
            <p:cNvSpPr/>
            <p:nvPr/>
          </p:nvSpPr>
          <p:spPr>
            <a:xfrm>
              <a:off x="695700" y="695700"/>
              <a:ext cx="7752600" cy="3752100"/>
            </a:xfrm>
            <a:prstGeom prst="rect">
              <a:avLst/>
            </a:prstGeom>
            <a:gradFill>
              <a:gsLst>
                <a:gs pos="0">
                  <a:schemeClr val="accent2"/>
                </a:gs>
                <a:gs pos="100000">
                  <a:schemeClr val="accent1"/>
                </a:gs>
              </a:gsLst>
              <a:lin ang="5400012" scaled="0"/>
            </a:gradFill>
            <a:ln>
              <a:noFill/>
            </a:ln>
            <a:effectLst>
              <a:outerShdw blurRad="300038" dist="19050" dir="5400000" algn="bl" rotWithShape="0">
                <a:schemeClr val="dk1">
                  <a:alpha val="50000"/>
                </a:scheme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8" name="Google Shape;138;p8"/>
            <p:cNvSpPr/>
            <p:nvPr/>
          </p:nvSpPr>
          <p:spPr>
            <a:xfrm>
              <a:off x="695700" y="695700"/>
              <a:ext cx="7752600" cy="3752100"/>
            </a:xfrm>
            <a:prstGeom prst="frame">
              <a:avLst>
                <a:gd name="adj1" fmla="val 204"/>
              </a:avLst>
            </a:prstGeom>
            <a:gradFill>
              <a:gsLst>
                <a:gs pos="0">
                  <a:schemeClr val="accent3"/>
                </a:gs>
                <a:gs pos="100000">
                  <a:schemeClr val="accent2"/>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139" name="Google Shape;139;p8"/>
          <p:cNvSpPr txBox="1">
            <a:spLocks noGrp="1"/>
          </p:cNvSpPr>
          <p:nvPr>
            <p:ph type="title"/>
          </p:nvPr>
        </p:nvSpPr>
        <p:spPr>
          <a:xfrm>
            <a:off x="1022525" y="1008050"/>
            <a:ext cx="7098900" cy="357900"/>
          </a:xfrm>
          <a:prstGeom prst="rect">
            <a:avLst/>
          </a:prstGeom>
        </p:spPr>
        <p:txBody>
          <a:bodyPr spcFirstLastPara="1" wrap="square" lIns="0" tIns="0" rIns="0" bIns="0" anchor="b" anchorCtr="0">
            <a:noAutofit/>
          </a:bodyPr>
          <a:lstStyle>
            <a:lvl1pPr lvl="0" rtl="0">
              <a:spcBef>
                <a:spcPts val="0"/>
              </a:spcBef>
              <a:spcAft>
                <a:spcPts val="0"/>
              </a:spcAft>
              <a:buSzPts val="3200"/>
              <a:buNone/>
              <a:defRPr/>
            </a:lvl1pPr>
            <a:lvl2pPr lvl="1" rtl="0">
              <a:spcBef>
                <a:spcPts val="0"/>
              </a:spcBef>
              <a:spcAft>
                <a:spcPts val="0"/>
              </a:spcAft>
              <a:buSzPts val="3200"/>
              <a:buNone/>
              <a:defRPr/>
            </a:lvl2pPr>
            <a:lvl3pPr lvl="2" rtl="0">
              <a:spcBef>
                <a:spcPts val="0"/>
              </a:spcBef>
              <a:spcAft>
                <a:spcPts val="0"/>
              </a:spcAft>
              <a:buSzPts val="3200"/>
              <a:buNone/>
              <a:defRPr/>
            </a:lvl3pPr>
            <a:lvl4pPr lvl="3" rtl="0">
              <a:spcBef>
                <a:spcPts val="0"/>
              </a:spcBef>
              <a:spcAft>
                <a:spcPts val="0"/>
              </a:spcAft>
              <a:buSzPts val="3200"/>
              <a:buNone/>
              <a:defRPr/>
            </a:lvl4pPr>
            <a:lvl5pPr lvl="4" rtl="0">
              <a:spcBef>
                <a:spcPts val="0"/>
              </a:spcBef>
              <a:spcAft>
                <a:spcPts val="0"/>
              </a:spcAft>
              <a:buSzPts val="3200"/>
              <a:buNone/>
              <a:defRPr/>
            </a:lvl5pPr>
            <a:lvl6pPr lvl="5" rtl="0">
              <a:spcBef>
                <a:spcPts val="0"/>
              </a:spcBef>
              <a:spcAft>
                <a:spcPts val="0"/>
              </a:spcAft>
              <a:buSzPts val="3200"/>
              <a:buNone/>
              <a:defRPr/>
            </a:lvl6pPr>
            <a:lvl7pPr lvl="6" rtl="0">
              <a:spcBef>
                <a:spcPts val="0"/>
              </a:spcBef>
              <a:spcAft>
                <a:spcPts val="0"/>
              </a:spcAft>
              <a:buSzPts val="3200"/>
              <a:buNone/>
              <a:defRPr/>
            </a:lvl7pPr>
            <a:lvl8pPr lvl="7" rtl="0">
              <a:spcBef>
                <a:spcPts val="0"/>
              </a:spcBef>
              <a:spcAft>
                <a:spcPts val="0"/>
              </a:spcAft>
              <a:buSzPts val="3200"/>
              <a:buNone/>
              <a:defRPr/>
            </a:lvl8pPr>
            <a:lvl9pPr lvl="8" rtl="0">
              <a:spcBef>
                <a:spcPts val="0"/>
              </a:spcBef>
              <a:spcAft>
                <a:spcPts val="0"/>
              </a:spcAft>
              <a:buSzPts val="3200"/>
              <a:buNone/>
              <a:defRPr/>
            </a:lvl9pPr>
          </a:lstStyle>
          <a:p>
            <a:endParaRPr/>
          </a:p>
        </p:txBody>
      </p:sp>
      <p:sp>
        <p:nvSpPr>
          <p:cNvPr id="140" name="Google Shape;140;p8"/>
          <p:cNvSpPr txBox="1">
            <a:spLocks noGrp="1"/>
          </p:cNvSpPr>
          <p:nvPr>
            <p:ph type="sldNum" idx="12"/>
          </p:nvPr>
        </p:nvSpPr>
        <p:spPr>
          <a:xfrm>
            <a:off x="4297650" y="4749851"/>
            <a:ext cx="548700" cy="393600"/>
          </a:xfrm>
          <a:prstGeom prst="rect">
            <a:avLst/>
          </a:prstGeom>
        </p:spPr>
        <p:txBody>
          <a:bodyPr spcFirstLastPara="1" wrap="square" lIns="0" tIns="0" rIns="0" bIns="0"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ct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JEOPARTY Panel">
  <p:cSld name="TITLE_ONLY_2">
    <p:spTree>
      <p:nvGrpSpPr>
        <p:cNvPr id="1" name="Shape 141"/>
        <p:cNvGrpSpPr/>
        <p:nvPr/>
      </p:nvGrpSpPr>
      <p:grpSpPr>
        <a:xfrm>
          <a:off x="0" y="0"/>
          <a:ext cx="0" cy="0"/>
          <a:chOff x="0" y="0"/>
          <a:chExt cx="0" cy="0"/>
        </a:xfrm>
      </p:grpSpPr>
      <p:sp>
        <p:nvSpPr>
          <p:cNvPr id="142" name="Google Shape;142;p9"/>
          <p:cNvSpPr/>
          <p:nvPr/>
        </p:nvSpPr>
        <p:spPr>
          <a:xfrm>
            <a:off x="485311" y="484852"/>
            <a:ext cx="8177442" cy="4183216"/>
          </a:xfrm>
          <a:prstGeom prst="rect">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43" name="Google Shape;143;p9"/>
          <p:cNvSpPr txBox="1">
            <a:spLocks noGrp="1"/>
          </p:cNvSpPr>
          <p:nvPr>
            <p:ph type="title"/>
          </p:nvPr>
        </p:nvSpPr>
        <p:spPr>
          <a:xfrm>
            <a:off x="695700" y="0"/>
            <a:ext cx="7752600" cy="484800"/>
          </a:xfrm>
          <a:prstGeom prst="rect">
            <a:avLst/>
          </a:prstGeom>
        </p:spPr>
        <p:txBody>
          <a:bodyPr spcFirstLastPara="1" wrap="square" lIns="0" tIns="0" rIns="0" bIns="0" anchor="ctr" anchorCtr="0">
            <a:noAutofit/>
          </a:bodyPr>
          <a:lstStyle>
            <a:lvl1pPr lvl="0" algn="ctr" rtl="0">
              <a:spcBef>
                <a:spcPts val="0"/>
              </a:spcBef>
              <a:spcAft>
                <a:spcPts val="0"/>
              </a:spcAft>
              <a:buClr>
                <a:schemeClr val="accent3"/>
              </a:buClr>
              <a:buSzPts val="1400"/>
              <a:buNone/>
              <a:defRPr sz="1400">
                <a:solidFill>
                  <a:schemeClr val="accent3"/>
                </a:solidFill>
              </a:defRPr>
            </a:lvl1pPr>
            <a:lvl2pPr lvl="1" algn="ctr" rtl="0">
              <a:spcBef>
                <a:spcPts val="0"/>
              </a:spcBef>
              <a:spcAft>
                <a:spcPts val="0"/>
              </a:spcAft>
              <a:buClr>
                <a:schemeClr val="accent3"/>
              </a:buClr>
              <a:buSzPts val="1400"/>
              <a:buNone/>
              <a:defRPr sz="1400">
                <a:solidFill>
                  <a:schemeClr val="accent3"/>
                </a:solidFill>
              </a:defRPr>
            </a:lvl2pPr>
            <a:lvl3pPr lvl="2" algn="ctr" rtl="0">
              <a:spcBef>
                <a:spcPts val="0"/>
              </a:spcBef>
              <a:spcAft>
                <a:spcPts val="0"/>
              </a:spcAft>
              <a:buClr>
                <a:schemeClr val="accent3"/>
              </a:buClr>
              <a:buSzPts val="1400"/>
              <a:buNone/>
              <a:defRPr sz="1400">
                <a:solidFill>
                  <a:schemeClr val="accent3"/>
                </a:solidFill>
              </a:defRPr>
            </a:lvl3pPr>
            <a:lvl4pPr lvl="3" algn="ctr" rtl="0">
              <a:spcBef>
                <a:spcPts val="0"/>
              </a:spcBef>
              <a:spcAft>
                <a:spcPts val="0"/>
              </a:spcAft>
              <a:buClr>
                <a:schemeClr val="accent3"/>
              </a:buClr>
              <a:buSzPts val="1400"/>
              <a:buNone/>
              <a:defRPr sz="1400">
                <a:solidFill>
                  <a:schemeClr val="accent3"/>
                </a:solidFill>
              </a:defRPr>
            </a:lvl4pPr>
            <a:lvl5pPr lvl="4" algn="ctr" rtl="0">
              <a:spcBef>
                <a:spcPts val="0"/>
              </a:spcBef>
              <a:spcAft>
                <a:spcPts val="0"/>
              </a:spcAft>
              <a:buClr>
                <a:schemeClr val="accent3"/>
              </a:buClr>
              <a:buSzPts val="1400"/>
              <a:buNone/>
              <a:defRPr sz="1400">
                <a:solidFill>
                  <a:schemeClr val="accent3"/>
                </a:solidFill>
              </a:defRPr>
            </a:lvl5pPr>
            <a:lvl6pPr lvl="5" algn="ctr" rtl="0">
              <a:spcBef>
                <a:spcPts val="0"/>
              </a:spcBef>
              <a:spcAft>
                <a:spcPts val="0"/>
              </a:spcAft>
              <a:buClr>
                <a:schemeClr val="accent3"/>
              </a:buClr>
              <a:buSzPts val="1400"/>
              <a:buNone/>
              <a:defRPr sz="1400">
                <a:solidFill>
                  <a:schemeClr val="accent3"/>
                </a:solidFill>
              </a:defRPr>
            </a:lvl6pPr>
            <a:lvl7pPr lvl="6" algn="ctr" rtl="0">
              <a:spcBef>
                <a:spcPts val="0"/>
              </a:spcBef>
              <a:spcAft>
                <a:spcPts val="0"/>
              </a:spcAft>
              <a:buClr>
                <a:schemeClr val="accent3"/>
              </a:buClr>
              <a:buSzPts val="1400"/>
              <a:buNone/>
              <a:defRPr sz="1400">
                <a:solidFill>
                  <a:schemeClr val="accent3"/>
                </a:solidFill>
              </a:defRPr>
            </a:lvl7pPr>
            <a:lvl8pPr lvl="7" algn="ctr" rtl="0">
              <a:spcBef>
                <a:spcPts val="0"/>
              </a:spcBef>
              <a:spcAft>
                <a:spcPts val="0"/>
              </a:spcAft>
              <a:buClr>
                <a:schemeClr val="accent3"/>
              </a:buClr>
              <a:buSzPts val="1400"/>
              <a:buNone/>
              <a:defRPr sz="1400">
                <a:solidFill>
                  <a:schemeClr val="accent3"/>
                </a:solidFill>
              </a:defRPr>
            </a:lvl8pPr>
            <a:lvl9pPr lvl="8" algn="ctr" rtl="0">
              <a:spcBef>
                <a:spcPts val="0"/>
              </a:spcBef>
              <a:spcAft>
                <a:spcPts val="0"/>
              </a:spcAft>
              <a:buClr>
                <a:schemeClr val="accent3"/>
              </a:buClr>
              <a:buSzPts val="1400"/>
              <a:buNone/>
              <a:defRPr sz="1400">
                <a:solidFill>
                  <a:schemeClr val="accent3"/>
                </a:solidFill>
              </a:defRPr>
            </a:lvl9pPr>
          </a:lstStyle>
          <a:p>
            <a:endParaRPr/>
          </a:p>
        </p:txBody>
      </p:sp>
      <p:grpSp>
        <p:nvGrpSpPr>
          <p:cNvPr id="144" name="Google Shape;144;p9"/>
          <p:cNvGrpSpPr/>
          <p:nvPr/>
        </p:nvGrpSpPr>
        <p:grpSpPr>
          <a:xfrm>
            <a:off x="572720" y="572673"/>
            <a:ext cx="1265739" cy="4018309"/>
            <a:chOff x="572700" y="572684"/>
            <a:chExt cx="1251349" cy="4018309"/>
          </a:xfrm>
        </p:grpSpPr>
        <p:sp>
          <p:nvSpPr>
            <p:cNvPr id="145" name="Google Shape;145;p9"/>
            <p:cNvSpPr/>
            <p:nvPr/>
          </p:nvSpPr>
          <p:spPr>
            <a:xfrm>
              <a:off x="572700" y="572684"/>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46" name="Google Shape;146;p9"/>
            <p:cNvSpPr/>
            <p:nvPr/>
          </p:nvSpPr>
          <p:spPr>
            <a:xfrm>
              <a:off x="572700" y="1317923"/>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47" name="Google Shape;147;p9"/>
            <p:cNvSpPr/>
            <p:nvPr/>
          </p:nvSpPr>
          <p:spPr>
            <a:xfrm>
              <a:off x="572700" y="1989598"/>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48" name="Google Shape;148;p9"/>
            <p:cNvSpPr/>
            <p:nvPr/>
          </p:nvSpPr>
          <p:spPr>
            <a:xfrm>
              <a:off x="572700" y="2661274"/>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49" name="Google Shape;149;p9"/>
            <p:cNvSpPr/>
            <p:nvPr/>
          </p:nvSpPr>
          <p:spPr>
            <a:xfrm>
              <a:off x="572700" y="3332949"/>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50" name="Google Shape;150;p9"/>
            <p:cNvSpPr/>
            <p:nvPr/>
          </p:nvSpPr>
          <p:spPr>
            <a:xfrm>
              <a:off x="572700" y="4004625"/>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151" name="Google Shape;151;p9"/>
          <p:cNvGrpSpPr/>
          <p:nvPr/>
        </p:nvGrpSpPr>
        <p:grpSpPr>
          <a:xfrm>
            <a:off x="1917802" y="572673"/>
            <a:ext cx="1265739" cy="4018309"/>
            <a:chOff x="1922099" y="572684"/>
            <a:chExt cx="1251349" cy="4018309"/>
          </a:xfrm>
        </p:grpSpPr>
        <p:sp>
          <p:nvSpPr>
            <p:cNvPr id="152" name="Google Shape;152;p9"/>
            <p:cNvSpPr/>
            <p:nvPr/>
          </p:nvSpPr>
          <p:spPr>
            <a:xfrm>
              <a:off x="1922099" y="572684"/>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53" name="Google Shape;153;p9"/>
            <p:cNvSpPr/>
            <p:nvPr/>
          </p:nvSpPr>
          <p:spPr>
            <a:xfrm>
              <a:off x="1922099" y="1317923"/>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54" name="Google Shape;154;p9"/>
            <p:cNvSpPr/>
            <p:nvPr/>
          </p:nvSpPr>
          <p:spPr>
            <a:xfrm>
              <a:off x="1922099" y="1989598"/>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55" name="Google Shape;155;p9"/>
            <p:cNvSpPr/>
            <p:nvPr/>
          </p:nvSpPr>
          <p:spPr>
            <a:xfrm>
              <a:off x="1922099" y="2661274"/>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56" name="Google Shape;156;p9"/>
            <p:cNvSpPr/>
            <p:nvPr/>
          </p:nvSpPr>
          <p:spPr>
            <a:xfrm>
              <a:off x="1922099" y="3332949"/>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57" name="Google Shape;157;p9"/>
            <p:cNvSpPr/>
            <p:nvPr/>
          </p:nvSpPr>
          <p:spPr>
            <a:xfrm>
              <a:off x="1922099" y="4004625"/>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158" name="Google Shape;158;p9"/>
          <p:cNvGrpSpPr/>
          <p:nvPr/>
        </p:nvGrpSpPr>
        <p:grpSpPr>
          <a:xfrm>
            <a:off x="3262884" y="572673"/>
            <a:ext cx="1265739" cy="4018309"/>
            <a:chOff x="3271498" y="572684"/>
            <a:chExt cx="1251349" cy="4018309"/>
          </a:xfrm>
        </p:grpSpPr>
        <p:sp>
          <p:nvSpPr>
            <p:cNvPr id="159" name="Google Shape;159;p9"/>
            <p:cNvSpPr/>
            <p:nvPr/>
          </p:nvSpPr>
          <p:spPr>
            <a:xfrm>
              <a:off x="3271498" y="572684"/>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0" name="Google Shape;160;p9"/>
            <p:cNvSpPr/>
            <p:nvPr/>
          </p:nvSpPr>
          <p:spPr>
            <a:xfrm>
              <a:off x="3271498" y="1317923"/>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1" name="Google Shape;161;p9"/>
            <p:cNvSpPr/>
            <p:nvPr/>
          </p:nvSpPr>
          <p:spPr>
            <a:xfrm>
              <a:off x="3271498" y="1989598"/>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2" name="Google Shape;162;p9"/>
            <p:cNvSpPr/>
            <p:nvPr/>
          </p:nvSpPr>
          <p:spPr>
            <a:xfrm>
              <a:off x="3271498" y="2661274"/>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3" name="Google Shape;163;p9"/>
            <p:cNvSpPr/>
            <p:nvPr/>
          </p:nvSpPr>
          <p:spPr>
            <a:xfrm>
              <a:off x="3271498" y="3332949"/>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4" name="Google Shape;164;p9"/>
            <p:cNvSpPr/>
            <p:nvPr/>
          </p:nvSpPr>
          <p:spPr>
            <a:xfrm>
              <a:off x="3271498" y="4004625"/>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165" name="Google Shape;165;p9"/>
          <p:cNvGrpSpPr/>
          <p:nvPr/>
        </p:nvGrpSpPr>
        <p:grpSpPr>
          <a:xfrm>
            <a:off x="4607967" y="572673"/>
            <a:ext cx="1265739" cy="4018309"/>
            <a:chOff x="4620897" y="572684"/>
            <a:chExt cx="1251349" cy="4018309"/>
          </a:xfrm>
        </p:grpSpPr>
        <p:sp>
          <p:nvSpPr>
            <p:cNvPr id="166" name="Google Shape;166;p9"/>
            <p:cNvSpPr/>
            <p:nvPr/>
          </p:nvSpPr>
          <p:spPr>
            <a:xfrm>
              <a:off x="4620897" y="572684"/>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7" name="Google Shape;167;p9"/>
            <p:cNvSpPr/>
            <p:nvPr/>
          </p:nvSpPr>
          <p:spPr>
            <a:xfrm>
              <a:off x="4620897" y="1317923"/>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8" name="Google Shape;168;p9"/>
            <p:cNvSpPr/>
            <p:nvPr/>
          </p:nvSpPr>
          <p:spPr>
            <a:xfrm>
              <a:off x="4620897" y="1989598"/>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9" name="Google Shape;169;p9"/>
            <p:cNvSpPr/>
            <p:nvPr/>
          </p:nvSpPr>
          <p:spPr>
            <a:xfrm>
              <a:off x="4620897" y="2661274"/>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0" name="Google Shape;170;p9"/>
            <p:cNvSpPr/>
            <p:nvPr/>
          </p:nvSpPr>
          <p:spPr>
            <a:xfrm>
              <a:off x="4620897" y="3332949"/>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1" name="Google Shape;171;p9"/>
            <p:cNvSpPr/>
            <p:nvPr/>
          </p:nvSpPr>
          <p:spPr>
            <a:xfrm>
              <a:off x="4620897" y="4004625"/>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172" name="Google Shape;172;p9"/>
          <p:cNvGrpSpPr/>
          <p:nvPr/>
        </p:nvGrpSpPr>
        <p:grpSpPr>
          <a:xfrm>
            <a:off x="5953049" y="572673"/>
            <a:ext cx="1265739" cy="4018309"/>
            <a:chOff x="5970296" y="572684"/>
            <a:chExt cx="1251349" cy="4018309"/>
          </a:xfrm>
        </p:grpSpPr>
        <p:sp>
          <p:nvSpPr>
            <p:cNvPr id="173" name="Google Shape;173;p9"/>
            <p:cNvSpPr/>
            <p:nvPr/>
          </p:nvSpPr>
          <p:spPr>
            <a:xfrm>
              <a:off x="5970296" y="572684"/>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4" name="Google Shape;174;p9"/>
            <p:cNvSpPr/>
            <p:nvPr/>
          </p:nvSpPr>
          <p:spPr>
            <a:xfrm>
              <a:off x="5970296" y="1317923"/>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5" name="Google Shape;175;p9"/>
            <p:cNvSpPr/>
            <p:nvPr/>
          </p:nvSpPr>
          <p:spPr>
            <a:xfrm>
              <a:off x="5970296" y="1989598"/>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6" name="Google Shape;176;p9"/>
            <p:cNvSpPr/>
            <p:nvPr/>
          </p:nvSpPr>
          <p:spPr>
            <a:xfrm>
              <a:off x="5970296" y="2661274"/>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7" name="Google Shape;177;p9"/>
            <p:cNvSpPr/>
            <p:nvPr/>
          </p:nvSpPr>
          <p:spPr>
            <a:xfrm>
              <a:off x="5970296" y="3332949"/>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8" name="Google Shape;178;p9"/>
            <p:cNvSpPr/>
            <p:nvPr/>
          </p:nvSpPr>
          <p:spPr>
            <a:xfrm>
              <a:off x="5970296" y="4004625"/>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179" name="Google Shape;179;p9"/>
          <p:cNvGrpSpPr/>
          <p:nvPr/>
        </p:nvGrpSpPr>
        <p:grpSpPr>
          <a:xfrm>
            <a:off x="7298131" y="572673"/>
            <a:ext cx="1265739" cy="4018309"/>
            <a:chOff x="7319696" y="572684"/>
            <a:chExt cx="1251349" cy="4018309"/>
          </a:xfrm>
        </p:grpSpPr>
        <p:sp>
          <p:nvSpPr>
            <p:cNvPr id="180" name="Google Shape;180;p9"/>
            <p:cNvSpPr/>
            <p:nvPr/>
          </p:nvSpPr>
          <p:spPr>
            <a:xfrm>
              <a:off x="7319696" y="572684"/>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1" name="Google Shape;181;p9"/>
            <p:cNvSpPr/>
            <p:nvPr/>
          </p:nvSpPr>
          <p:spPr>
            <a:xfrm>
              <a:off x="7319696" y="1317923"/>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2" name="Google Shape;182;p9"/>
            <p:cNvSpPr/>
            <p:nvPr/>
          </p:nvSpPr>
          <p:spPr>
            <a:xfrm>
              <a:off x="7319696" y="1989598"/>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3" name="Google Shape;183;p9"/>
            <p:cNvSpPr/>
            <p:nvPr/>
          </p:nvSpPr>
          <p:spPr>
            <a:xfrm>
              <a:off x="7319696" y="2661274"/>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4" name="Google Shape;184;p9"/>
            <p:cNvSpPr/>
            <p:nvPr/>
          </p:nvSpPr>
          <p:spPr>
            <a:xfrm>
              <a:off x="7319696" y="3332949"/>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5" name="Google Shape;185;p9"/>
            <p:cNvSpPr/>
            <p:nvPr/>
          </p:nvSpPr>
          <p:spPr>
            <a:xfrm>
              <a:off x="7319696" y="4004625"/>
              <a:ext cx="1251349" cy="586368"/>
            </a:xfrm>
            <a:prstGeom prst="rect">
              <a:avLst/>
            </a:prstGeom>
            <a:gradFill>
              <a:gsLst>
                <a:gs pos="0">
                  <a:schemeClr val="accent2"/>
                </a:gs>
                <a:gs pos="100000">
                  <a:schemeClr val="accent1"/>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JEOPARTY Category">
  <p:cSld name="TITLE_ONLY_1">
    <p:spTree>
      <p:nvGrpSpPr>
        <p:cNvPr id="1" name="Shape 186"/>
        <p:cNvGrpSpPr/>
        <p:nvPr/>
      </p:nvGrpSpPr>
      <p:grpSpPr>
        <a:xfrm>
          <a:off x="0" y="0"/>
          <a:ext cx="0" cy="0"/>
          <a:chOff x="0" y="0"/>
          <a:chExt cx="0" cy="0"/>
        </a:xfrm>
      </p:grpSpPr>
      <p:grpSp>
        <p:nvGrpSpPr>
          <p:cNvPr id="187" name="Google Shape;187;p10"/>
          <p:cNvGrpSpPr/>
          <p:nvPr/>
        </p:nvGrpSpPr>
        <p:grpSpPr>
          <a:xfrm>
            <a:off x="485311" y="484852"/>
            <a:ext cx="8177442" cy="4183216"/>
            <a:chOff x="695700" y="695700"/>
            <a:chExt cx="7752600" cy="3752100"/>
          </a:xfrm>
        </p:grpSpPr>
        <p:sp>
          <p:nvSpPr>
            <p:cNvPr id="188" name="Google Shape;188;p10"/>
            <p:cNvSpPr/>
            <p:nvPr/>
          </p:nvSpPr>
          <p:spPr>
            <a:xfrm>
              <a:off x="695700" y="695700"/>
              <a:ext cx="7752600" cy="3752100"/>
            </a:xfrm>
            <a:prstGeom prst="rect">
              <a:avLst/>
            </a:prstGeom>
            <a:gradFill>
              <a:gsLst>
                <a:gs pos="0">
                  <a:schemeClr val="accent2"/>
                </a:gs>
                <a:gs pos="100000">
                  <a:schemeClr val="accent1"/>
                </a:gs>
              </a:gsLst>
              <a:lin ang="5400012" scaled="0"/>
            </a:gradFill>
            <a:ln>
              <a:noFill/>
            </a:ln>
            <a:effectLst>
              <a:outerShdw blurRad="300038" dist="19050" dir="5400000" algn="bl" rotWithShape="0">
                <a:schemeClr val="dk1">
                  <a:alpha val="50000"/>
                </a:scheme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9" name="Google Shape;189;p10"/>
            <p:cNvSpPr/>
            <p:nvPr/>
          </p:nvSpPr>
          <p:spPr>
            <a:xfrm>
              <a:off x="695700" y="695700"/>
              <a:ext cx="7752600" cy="3752100"/>
            </a:xfrm>
            <a:prstGeom prst="frame">
              <a:avLst>
                <a:gd name="adj1" fmla="val 194"/>
              </a:avLst>
            </a:prstGeom>
            <a:gradFill>
              <a:gsLst>
                <a:gs pos="0">
                  <a:schemeClr val="accent3"/>
                </a:gs>
                <a:gs pos="100000">
                  <a:schemeClr val="accent2"/>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190" name="Google Shape;190;p10"/>
          <p:cNvSpPr txBox="1">
            <a:spLocks noGrp="1"/>
          </p:cNvSpPr>
          <p:nvPr>
            <p:ph type="title"/>
          </p:nvPr>
        </p:nvSpPr>
        <p:spPr>
          <a:xfrm>
            <a:off x="1517025" y="1499475"/>
            <a:ext cx="6111900" cy="687900"/>
          </a:xfrm>
          <a:prstGeom prst="rect">
            <a:avLst/>
          </a:prstGeom>
        </p:spPr>
        <p:txBody>
          <a:bodyPr spcFirstLastPara="1" wrap="square" lIns="0" tIns="0" rIns="0" bIns="0" anchor="b" anchorCtr="0">
            <a:noAutofit/>
          </a:bodyPr>
          <a:lstStyle>
            <a:lvl1pPr lvl="0" algn="ctr" rtl="0">
              <a:spcBef>
                <a:spcPts val="0"/>
              </a:spcBef>
              <a:spcAft>
                <a:spcPts val="0"/>
              </a:spcAft>
              <a:buSzPts val="3600"/>
              <a:buFont typeface="Della Respira"/>
              <a:buNone/>
              <a:defRPr sz="3600" b="1">
                <a:latin typeface="Della Respira"/>
                <a:ea typeface="Della Respira"/>
                <a:cs typeface="Della Respira"/>
                <a:sym typeface="Della Respira"/>
              </a:defRPr>
            </a:lvl1pPr>
            <a:lvl2pPr lvl="1" algn="ctr" rtl="0">
              <a:spcBef>
                <a:spcPts val="0"/>
              </a:spcBef>
              <a:spcAft>
                <a:spcPts val="0"/>
              </a:spcAft>
              <a:buSzPts val="3600"/>
              <a:buFont typeface="Della Respira"/>
              <a:buNone/>
              <a:defRPr sz="3600" b="1">
                <a:latin typeface="Della Respira"/>
                <a:ea typeface="Della Respira"/>
                <a:cs typeface="Della Respira"/>
                <a:sym typeface="Della Respira"/>
              </a:defRPr>
            </a:lvl2pPr>
            <a:lvl3pPr lvl="2" algn="ctr" rtl="0">
              <a:spcBef>
                <a:spcPts val="0"/>
              </a:spcBef>
              <a:spcAft>
                <a:spcPts val="0"/>
              </a:spcAft>
              <a:buSzPts val="3600"/>
              <a:buFont typeface="Della Respira"/>
              <a:buNone/>
              <a:defRPr sz="3600" b="1">
                <a:latin typeface="Della Respira"/>
                <a:ea typeface="Della Respira"/>
                <a:cs typeface="Della Respira"/>
                <a:sym typeface="Della Respira"/>
              </a:defRPr>
            </a:lvl3pPr>
            <a:lvl4pPr lvl="3" algn="ctr" rtl="0">
              <a:spcBef>
                <a:spcPts val="0"/>
              </a:spcBef>
              <a:spcAft>
                <a:spcPts val="0"/>
              </a:spcAft>
              <a:buSzPts val="3600"/>
              <a:buFont typeface="Della Respira"/>
              <a:buNone/>
              <a:defRPr sz="3600" b="1">
                <a:latin typeface="Della Respira"/>
                <a:ea typeface="Della Respira"/>
                <a:cs typeface="Della Respira"/>
                <a:sym typeface="Della Respira"/>
              </a:defRPr>
            </a:lvl4pPr>
            <a:lvl5pPr lvl="4" algn="ctr" rtl="0">
              <a:spcBef>
                <a:spcPts val="0"/>
              </a:spcBef>
              <a:spcAft>
                <a:spcPts val="0"/>
              </a:spcAft>
              <a:buSzPts val="3600"/>
              <a:buFont typeface="Della Respira"/>
              <a:buNone/>
              <a:defRPr sz="3600" b="1">
                <a:latin typeface="Della Respira"/>
                <a:ea typeface="Della Respira"/>
                <a:cs typeface="Della Respira"/>
                <a:sym typeface="Della Respira"/>
              </a:defRPr>
            </a:lvl5pPr>
            <a:lvl6pPr lvl="5" algn="ctr" rtl="0">
              <a:spcBef>
                <a:spcPts val="0"/>
              </a:spcBef>
              <a:spcAft>
                <a:spcPts val="0"/>
              </a:spcAft>
              <a:buSzPts val="3600"/>
              <a:buFont typeface="Della Respira"/>
              <a:buNone/>
              <a:defRPr sz="3600" b="1">
                <a:latin typeface="Della Respira"/>
                <a:ea typeface="Della Respira"/>
                <a:cs typeface="Della Respira"/>
                <a:sym typeface="Della Respira"/>
              </a:defRPr>
            </a:lvl6pPr>
            <a:lvl7pPr lvl="6" algn="ctr" rtl="0">
              <a:spcBef>
                <a:spcPts val="0"/>
              </a:spcBef>
              <a:spcAft>
                <a:spcPts val="0"/>
              </a:spcAft>
              <a:buSzPts val="3600"/>
              <a:buFont typeface="Della Respira"/>
              <a:buNone/>
              <a:defRPr sz="3600" b="1">
                <a:latin typeface="Della Respira"/>
                <a:ea typeface="Della Respira"/>
                <a:cs typeface="Della Respira"/>
                <a:sym typeface="Della Respira"/>
              </a:defRPr>
            </a:lvl7pPr>
            <a:lvl8pPr lvl="7" algn="ctr" rtl="0">
              <a:spcBef>
                <a:spcPts val="0"/>
              </a:spcBef>
              <a:spcAft>
                <a:spcPts val="0"/>
              </a:spcAft>
              <a:buSzPts val="3600"/>
              <a:buFont typeface="Della Respira"/>
              <a:buNone/>
              <a:defRPr sz="3600" b="1">
                <a:latin typeface="Della Respira"/>
                <a:ea typeface="Della Respira"/>
                <a:cs typeface="Della Respira"/>
                <a:sym typeface="Della Respira"/>
              </a:defRPr>
            </a:lvl8pPr>
            <a:lvl9pPr lvl="8" algn="ctr" rtl="0">
              <a:spcBef>
                <a:spcPts val="0"/>
              </a:spcBef>
              <a:spcAft>
                <a:spcPts val="0"/>
              </a:spcAft>
              <a:buSzPts val="3600"/>
              <a:buFont typeface="Della Respira"/>
              <a:buNone/>
              <a:defRPr sz="3600" b="1">
                <a:latin typeface="Della Respira"/>
                <a:ea typeface="Della Respira"/>
                <a:cs typeface="Della Respira"/>
                <a:sym typeface="Della Respira"/>
              </a:defRPr>
            </a:lvl9pPr>
          </a:lstStyle>
          <a:p>
            <a:endParaRPr/>
          </a:p>
        </p:txBody>
      </p:sp>
      <p:sp>
        <p:nvSpPr>
          <p:cNvPr id="191" name="Google Shape;191;p10"/>
          <p:cNvSpPr txBox="1">
            <a:spLocks noGrp="1"/>
          </p:cNvSpPr>
          <p:nvPr>
            <p:ph type="subTitle" idx="1"/>
          </p:nvPr>
        </p:nvSpPr>
        <p:spPr>
          <a:xfrm>
            <a:off x="1517025" y="1998450"/>
            <a:ext cx="6123600" cy="1579800"/>
          </a:xfrm>
          <a:prstGeom prst="rect">
            <a:avLst/>
          </a:prstGeom>
        </p:spPr>
        <p:txBody>
          <a:bodyPr spcFirstLastPara="1" wrap="square" lIns="0" tIns="0" rIns="0" bIns="0" anchor="t" anchorCtr="0">
            <a:noAutofit/>
          </a:bodyPr>
          <a:lstStyle>
            <a:lvl1pPr lvl="0" algn="ctr">
              <a:spcBef>
                <a:spcPts val="600"/>
              </a:spcBef>
              <a:spcAft>
                <a:spcPts val="0"/>
              </a:spcAft>
              <a:buNone/>
              <a:defRPr sz="9600">
                <a:solidFill>
                  <a:srgbClr val="FFC319"/>
                </a:solidFill>
                <a:latin typeface="Bebas Neue"/>
                <a:ea typeface="Bebas Neue"/>
                <a:cs typeface="Bebas Neue"/>
                <a:sym typeface="Bebas Neue"/>
              </a:defRPr>
            </a:lvl1pPr>
            <a:lvl2pPr lvl="1" algn="ctr">
              <a:spcBef>
                <a:spcPts val="600"/>
              </a:spcBef>
              <a:spcAft>
                <a:spcPts val="0"/>
              </a:spcAft>
              <a:buNone/>
              <a:defRPr sz="9600">
                <a:solidFill>
                  <a:srgbClr val="FFC319"/>
                </a:solidFill>
                <a:latin typeface="Bebas Neue"/>
                <a:ea typeface="Bebas Neue"/>
                <a:cs typeface="Bebas Neue"/>
                <a:sym typeface="Bebas Neue"/>
              </a:defRPr>
            </a:lvl2pPr>
            <a:lvl3pPr lvl="2" algn="ctr">
              <a:spcBef>
                <a:spcPts val="600"/>
              </a:spcBef>
              <a:spcAft>
                <a:spcPts val="0"/>
              </a:spcAft>
              <a:buNone/>
              <a:defRPr sz="9600">
                <a:solidFill>
                  <a:srgbClr val="FFC319"/>
                </a:solidFill>
                <a:latin typeface="Bebas Neue"/>
                <a:ea typeface="Bebas Neue"/>
                <a:cs typeface="Bebas Neue"/>
                <a:sym typeface="Bebas Neue"/>
              </a:defRPr>
            </a:lvl3pPr>
            <a:lvl4pPr lvl="3" algn="ctr">
              <a:spcBef>
                <a:spcPts val="600"/>
              </a:spcBef>
              <a:spcAft>
                <a:spcPts val="0"/>
              </a:spcAft>
              <a:buNone/>
              <a:defRPr sz="9600">
                <a:solidFill>
                  <a:srgbClr val="FFC319"/>
                </a:solidFill>
                <a:latin typeface="Bebas Neue"/>
                <a:ea typeface="Bebas Neue"/>
                <a:cs typeface="Bebas Neue"/>
                <a:sym typeface="Bebas Neue"/>
              </a:defRPr>
            </a:lvl4pPr>
            <a:lvl5pPr lvl="4" algn="ctr">
              <a:spcBef>
                <a:spcPts val="600"/>
              </a:spcBef>
              <a:spcAft>
                <a:spcPts val="0"/>
              </a:spcAft>
              <a:buNone/>
              <a:defRPr sz="9600">
                <a:solidFill>
                  <a:srgbClr val="FFC319"/>
                </a:solidFill>
                <a:latin typeface="Bebas Neue"/>
                <a:ea typeface="Bebas Neue"/>
                <a:cs typeface="Bebas Neue"/>
                <a:sym typeface="Bebas Neue"/>
              </a:defRPr>
            </a:lvl5pPr>
            <a:lvl6pPr lvl="5" algn="ctr">
              <a:spcBef>
                <a:spcPts val="600"/>
              </a:spcBef>
              <a:spcAft>
                <a:spcPts val="0"/>
              </a:spcAft>
              <a:buNone/>
              <a:defRPr sz="9600">
                <a:solidFill>
                  <a:srgbClr val="FFC319"/>
                </a:solidFill>
                <a:latin typeface="Bebas Neue"/>
                <a:ea typeface="Bebas Neue"/>
                <a:cs typeface="Bebas Neue"/>
                <a:sym typeface="Bebas Neue"/>
              </a:defRPr>
            </a:lvl6pPr>
            <a:lvl7pPr lvl="6" algn="ctr">
              <a:spcBef>
                <a:spcPts val="600"/>
              </a:spcBef>
              <a:spcAft>
                <a:spcPts val="0"/>
              </a:spcAft>
              <a:buNone/>
              <a:defRPr sz="9600">
                <a:solidFill>
                  <a:srgbClr val="FFC319"/>
                </a:solidFill>
                <a:latin typeface="Bebas Neue"/>
                <a:ea typeface="Bebas Neue"/>
                <a:cs typeface="Bebas Neue"/>
                <a:sym typeface="Bebas Neue"/>
              </a:defRPr>
            </a:lvl7pPr>
            <a:lvl8pPr lvl="7" algn="ctr">
              <a:spcBef>
                <a:spcPts val="600"/>
              </a:spcBef>
              <a:spcAft>
                <a:spcPts val="0"/>
              </a:spcAft>
              <a:buNone/>
              <a:defRPr sz="9600">
                <a:solidFill>
                  <a:srgbClr val="FFC319"/>
                </a:solidFill>
                <a:latin typeface="Bebas Neue"/>
                <a:ea typeface="Bebas Neue"/>
                <a:cs typeface="Bebas Neue"/>
                <a:sym typeface="Bebas Neue"/>
              </a:defRPr>
            </a:lvl8pPr>
            <a:lvl9pPr lvl="8" algn="ctr">
              <a:spcBef>
                <a:spcPts val="600"/>
              </a:spcBef>
              <a:spcAft>
                <a:spcPts val="0"/>
              </a:spcAft>
              <a:buNone/>
              <a:defRPr sz="9600">
                <a:solidFill>
                  <a:srgbClr val="FFC319"/>
                </a:solidFill>
                <a:latin typeface="Bebas Neue"/>
                <a:ea typeface="Bebas Neue"/>
                <a:cs typeface="Bebas Neue"/>
                <a:sym typeface="Bebas Neue"/>
              </a:defRPr>
            </a:lvl9pPr>
          </a:lstStyle>
          <a:p>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JEOPARTY Answer">
  <p:cSld name="TITLE_ONLY_1_1">
    <p:spTree>
      <p:nvGrpSpPr>
        <p:cNvPr id="1" name="Shape 192"/>
        <p:cNvGrpSpPr/>
        <p:nvPr/>
      </p:nvGrpSpPr>
      <p:grpSpPr>
        <a:xfrm>
          <a:off x="0" y="0"/>
          <a:ext cx="0" cy="0"/>
          <a:chOff x="0" y="0"/>
          <a:chExt cx="0" cy="0"/>
        </a:xfrm>
      </p:grpSpPr>
      <p:grpSp>
        <p:nvGrpSpPr>
          <p:cNvPr id="193" name="Google Shape;193;p11"/>
          <p:cNvGrpSpPr/>
          <p:nvPr/>
        </p:nvGrpSpPr>
        <p:grpSpPr>
          <a:xfrm>
            <a:off x="485311" y="484852"/>
            <a:ext cx="8177442" cy="4183216"/>
            <a:chOff x="695700" y="695700"/>
            <a:chExt cx="7752600" cy="3752100"/>
          </a:xfrm>
        </p:grpSpPr>
        <p:sp>
          <p:nvSpPr>
            <p:cNvPr id="194" name="Google Shape;194;p11"/>
            <p:cNvSpPr/>
            <p:nvPr/>
          </p:nvSpPr>
          <p:spPr>
            <a:xfrm>
              <a:off x="695700" y="695700"/>
              <a:ext cx="7752600" cy="3752100"/>
            </a:xfrm>
            <a:prstGeom prst="rect">
              <a:avLst/>
            </a:prstGeom>
            <a:gradFill>
              <a:gsLst>
                <a:gs pos="0">
                  <a:schemeClr val="accent2"/>
                </a:gs>
                <a:gs pos="100000">
                  <a:schemeClr val="accent1"/>
                </a:gs>
              </a:gsLst>
              <a:lin ang="5400012" scaled="0"/>
            </a:gradFill>
            <a:ln>
              <a:noFill/>
            </a:ln>
            <a:effectLst>
              <a:outerShdw blurRad="300038" dist="19050" dir="5400000" algn="bl" rotWithShape="0">
                <a:schemeClr val="dk1">
                  <a:alpha val="50000"/>
                </a:scheme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95" name="Google Shape;195;p11"/>
            <p:cNvSpPr/>
            <p:nvPr/>
          </p:nvSpPr>
          <p:spPr>
            <a:xfrm>
              <a:off x="695700" y="695700"/>
              <a:ext cx="7752600" cy="3752100"/>
            </a:xfrm>
            <a:prstGeom prst="frame">
              <a:avLst>
                <a:gd name="adj1" fmla="val 194"/>
              </a:avLst>
            </a:prstGeom>
            <a:gradFill>
              <a:gsLst>
                <a:gs pos="0">
                  <a:schemeClr val="accent3"/>
                </a:gs>
                <a:gs pos="100000">
                  <a:schemeClr val="accent2"/>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196" name="Google Shape;196;p11"/>
          <p:cNvSpPr txBox="1">
            <a:spLocks noGrp="1"/>
          </p:cNvSpPr>
          <p:nvPr>
            <p:ph type="title"/>
          </p:nvPr>
        </p:nvSpPr>
        <p:spPr>
          <a:xfrm>
            <a:off x="1032075" y="998325"/>
            <a:ext cx="7081800" cy="3156300"/>
          </a:xfrm>
          <a:prstGeom prst="rect">
            <a:avLst/>
          </a:prstGeom>
        </p:spPr>
        <p:txBody>
          <a:bodyPr spcFirstLastPara="1" wrap="square" lIns="0" tIns="0" rIns="0" bIns="0" anchor="ctr" anchorCtr="0">
            <a:noAutofit/>
          </a:bodyPr>
          <a:lstStyle>
            <a:lvl1pPr lvl="0" algn="ctr" rtl="0">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1pPr>
            <a:lvl2pPr lvl="1" algn="ctr" rtl="0">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2pPr>
            <a:lvl3pPr lvl="2" algn="ctr" rtl="0">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3pPr>
            <a:lvl4pPr lvl="3" algn="ctr" rtl="0">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4pPr>
            <a:lvl5pPr lvl="4" algn="ctr" rtl="0">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5pPr>
            <a:lvl6pPr lvl="5" algn="ctr" rtl="0">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6pPr>
            <a:lvl7pPr lvl="6" algn="ctr" rtl="0">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7pPr>
            <a:lvl8pPr lvl="7" algn="ctr" rtl="0">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8pPr>
            <a:lvl9pPr lvl="8" algn="ctr" rtl="0">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9pPr>
          </a:lstStyle>
          <a:p>
            <a:endParaRPr/>
          </a:p>
        </p:txBody>
      </p:sp>
      <p:sp>
        <p:nvSpPr>
          <p:cNvPr id="197" name="Google Shape;197;p11"/>
          <p:cNvSpPr txBox="1"/>
          <p:nvPr/>
        </p:nvSpPr>
        <p:spPr>
          <a:xfrm>
            <a:off x="3394800" y="4328600"/>
            <a:ext cx="2354400" cy="144600"/>
          </a:xfrm>
          <a:prstGeom prst="rect">
            <a:avLst/>
          </a:prstGeom>
          <a:noFill/>
          <a:ln>
            <a:noFill/>
          </a:ln>
        </p:spPr>
        <p:txBody>
          <a:bodyPr spcFirstLastPara="1" wrap="square" lIns="0" tIns="0" rIns="0" bIns="0" anchor="t" anchorCtr="0">
            <a:noAutofit/>
          </a:bodyPr>
          <a:lstStyle/>
          <a:p>
            <a:pPr marL="0" lvl="0" indent="0" algn="ctr" rtl="0">
              <a:spcBef>
                <a:spcPts val="0"/>
              </a:spcBef>
              <a:spcAft>
                <a:spcPts val="0"/>
              </a:spcAft>
              <a:buNone/>
            </a:pPr>
            <a:r>
              <a:rPr lang="en" sz="1000">
                <a:solidFill>
                  <a:srgbClr val="6D9EEB"/>
                </a:solidFill>
                <a:latin typeface="Della Respira"/>
                <a:ea typeface="Della Respira"/>
                <a:cs typeface="Della Respira"/>
                <a:sym typeface="Della Respira"/>
              </a:rPr>
              <a:t>⬅ BACK TO PANEL</a:t>
            </a:r>
            <a:endParaRPr sz="1000">
              <a:solidFill>
                <a:srgbClr val="6D9EEB"/>
              </a:solidFill>
              <a:latin typeface="Della Respira"/>
              <a:ea typeface="Della Respira"/>
              <a:cs typeface="Della Respira"/>
              <a:sym typeface="Della Respira"/>
            </a:endParaRPr>
          </a:p>
        </p:txBody>
      </p:sp>
      <p:sp>
        <p:nvSpPr>
          <p:cNvPr id="198" name="Google Shape;198;p11">
            <a:hlinkClick r:id="rId2" action="ppaction://hlinksldjump"/>
          </p:cNvPr>
          <p:cNvSpPr/>
          <p:nvPr/>
        </p:nvSpPr>
        <p:spPr>
          <a:xfrm>
            <a:off x="0" y="0"/>
            <a:ext cx="9144000" cy="5143500"/>
          </a:xfrm>
          <a:prstGeom prst="frame">
            <a:avLst>
              <a:gd name="adj1" fmla="val 19553"/>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JEOPARTY Answer (with category info)">
  <p:cSld name="TITLE_ONLY_1_1_1">
    <p:spTree>
      <p:nvGrpSpPr>
        <p:cNvPr id="1" name="Shape 199"/>
        <p:cNvGrpSpPr/>
        <p:nvPr/>
      </p:nvGrpSpPr>
      <p:grpSpPr>
        <a:xfrm>
          <a:off x="0" y="0"/>
          <a:ext cx="0" cy="0"/>
          <a:chOff x="0" y="0"/>
          <a:chExt cx="0" cy="0"/>
        </a:xfrm>
      </p:grpSpPr>
      <p:grpSp>
        <p:nvGrpSpPr>
          <p:cNvPr id="200" name="Google Shape;200;p12"/>
          <p:cNvGrpSpPr/>
          <p:nvPr/>
        </p:nvGrpSpPr>
        <p:grpSpPr>
          <a:xfrm>
            <a:off x="485311" y="484852"/>
            <a:ext cx="8177442" cy="4183216"/>
            <a:chOff x="695700" y="695700"/>
            <a:chExt cx="7752600" cy="3752100"/>
          </a:xfrm>
        </p:grpSpPr>
        <p:sp>
          <p:nvSpPr>
            <p:cNvPr id="201" name="Google Shape;201;p12"/>
            <p:cNvSpPr/>
            <p:nvPr/>
          </p:nvSpPr>
          <p:spPr>
            <a:xfrm>
              <a:off x="695700" y="695700"/>
              <a:ext cx="7752600" cy="3752100"/>
            </a:xfrm>
            <a:prstGeom prst="rect">
              <a:avLst/>
            </a:prstGeom>
            <a:gradFill>
              <a:gsLst>
                <a:gs pos="0">
                  <a:schemeClr val="accent2"/>
                </a:gs>
                <a:gs pos="100000">
                  <a:schemeClr val="accent1"/>
                </a:gs>
              </a:gsLst>
              <a:lin ang="5400012" scaled="0"/>
            </a:gradFill>
            <a:ln>
              <a:noFill/>
            </a:ln>
            <a:effectLst>
              <a:outerShdw blurRad="300038" dist="19050" dir="5400000" algn="bl" rotWithShape="0">
                <a:schemeClr val="dk1">
                  <a:alpha val="50000"/>
                </a:scheme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02" name="Google Shape;202;p12"/>
            <p:cNvSpPr/>
            <p:nvPr/>
          </p:nvSpPr>
          <p:spPr>
            <a:xfrm>
              <a:off x="695700" y="695700"/>
              <a:ext cx="7752600" cy="3752100"/>
            </a:xfrm>
            <a:prstGeom prst="frame">
              <a:avLst>
                <a:gd name="adj1" fmla="val 194"/>
              </a:avLst>
            </a:prstGeom>
            <a:gradFill>
              <a:gsLst>
                <a:gs pos="0">
                  <a:schemeClr val="accent3"/>
                </a:gs>
                <a:gs pos="100000">
                  <a:schemeClr val="accent2"/>
                </a:gs>
              </a:gsLst>
              <a:lin ang="5400012"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203" name="Google Shape;203;p12"/>
          <p:cNvSpPr txBox="1">
            <a:spLocks noGrp="1"/>
          </p:cNvSpPr>
          <p:nvPr>
            <p:ph type="title"/>
          </p:nvPr>
        </p:nvSpPr>
        <p:spPr>
          <a:xfrm>
            <a:off x="1032075" y="966325"/>
            <a:ext cx="7081800" cy="3188100"/>
          </a:xfrm>
          <a:prstGeom prst="rect">
            <a:avLst/>
          </a:prstGeom>
        </p:spPr>
        <p:txBody>
          <a:bodyPr spcFirstLastPara="1" wrap="square" lIns="0" tIns="0" rIns="0" bIns="0" anchor="ctr" anchorCtr="0">
            <a:noAutofit/>
          </a:bodyPr>
          <a:lstStyle>
            <a:lvl1pPr lvl="0" algn="ctr" rtl="0">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1pPr>
            <a:lvl2pPr lvl="1" algn="ctr" rtl="0">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2pPr>
            <a:lvl3pPr lvl="2" algn="ctr" rtl="0">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3pPr>
            <a:lvl4pPr lvl="3" algn="ctr" rtl="0">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4pPr>
            <a:lvl5pPr lvl="4" algn="ctr" rtl="0">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5pPr>
            <a:lvl6pPr lvl="5" algn="ctr" rtl="0">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6pPr>
            <a:lvl7pPr lvl="6" algn="ctr" rtl="0">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7pPr>
            <a:lvl8pPr lvl="7" algn="ctr" rtl="0">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8pPr>
            <a:lvl9pPr lvl="8" algn="ctr" rtl="0">
              <a:lnSpc>
                <a:spcPct val="115000"/>
              </a:lnSpc>
              <a:spcBef>
                <a:spcPts val="0"/>
              </a:spcBef>
              <a:spcAft>
                <a:spcPts val="0"/>
              </a:spcAft>
              <a:buSzPts val="3400"/>
              <a:buFont typeface="Della Respira"/>
              <a:buNone/>
              <a:defRPr sz="3400" b="1">
                <a:latin typeface="Della Respira"/>
                <a:ea typeface="Della Respira"/>
                <a:cs typeface="Della Respira"/>
                <a:sym typeface="Della Respira"/>
              </a:defRPr>
            </a:lvl9pPr>
          </a:lstStyle>
          <a:p>
            <a:endParaRPr/>
          </a:p>
        </p:txBody>
      </p:sp>
      <p:sp>
        <p:nvSpPr>
          <p:cNvPr id="204" name="Google Shape;204;p12"/>
          <p:cNvSpPr txBox="1">
            <a:spLocks noGrp="1"/>
          </p:cNvSpPr>
          <p:nvPr>
            <p:ph type="subTitle" idx="1"/>
          </p:nvPr>
        </p:nvSpPr>
        <p:spPr>
          <a:xfrm>
            <a:off x="1038650" y="640325"/>
            <a:ext cx="7079700" cy="444300"/>
          </a:xfrm>
          <a:prstGeom prst="rect">
            <a:avLst/>
          </a:prstGeom>
        </p:spPr>
        <p:txBody>
          <a:bodyPr spcFirstLastPara="1" wrap="square" lIns="0" tIns="0" rIns="0" bIns="0" anchor="t" anchorCtr="0">
            <a:noAutofit/>
          </a:bodyPr>
          <a:lstStyle>
            <a:lvl1pPr lvl="0" algn="ctr">
              <a:spcBef>
                <a:spcPts val="600"/>
              </a:spcBef>
              <a:spcAft>
                <a:spcPts val="0"/>
              </a:spcAft>
              <a:buNone/>
              <a:defRPr sz="2000" b="0">
                <a:latin typeface="Bebas Neue"/>
                <a:ea typeface="Bebas Neue"/>
                <a:cs typeface="Bebas Neue"/>
                <a:sym typeface="Bebas Neue"/>
              </a:defRPr>
            </a:lvl1pPr>
            <a:lvl2pPr lvl="1">
              <a:spcBef>
                <a:spcPts val="600"/>
              </a:spcBef>
              <a:spcAft>
                <a:spcPts val="0"/>
              </a:spcAft>
              <a:buNone/>
              <a:defRPr sz="2000"/>
            </a:lvl2pPr>
            <a:lvl3pPr lvl="2">
              <a:spcBef>
                <a:spcPts val="600"/>
              </a:spcBef>
              <a:spcAft>
                <a:spcPts val="0"/>
              </a:spcAft>
              <a:buNone/>
              <a:defRPr sz="2000"/>
            </a:lvl3pPr>
            <a:lvl4pPr lvl="3">
              <a:spcBef>
                <a:spcPts val="600"/>
              </a:spcBef>
              <a:spcAft>
                <a:spcPts val="0"/>
              </a:spcAft>
              <a:buNone/>
              <a:defRPr sz="2000"/>
            </a:lvl4pPr>
            <a:lvl5pPr lvl="4">
              <a:spcBef>
                <a:spcPts val="600"/>
              </a:spcBef>
              <a:spcAft>
                <a:spcPts val="0"/>
              </a:spcAft>
              <a:buNone/>
              <a:defRPr sz="2000"/>
            </a:lvl5pPr>
            <a:lvl6pPr lvl="5">
              <a:spcBef>
                <a:spcPts val="600"/>
              </a:spcBef>
              <a:spcAft>
                <a:spcPts val="0"/>
              </a:spcAft>
              <a:buNone/>
              <a:defRPr sz="2000"/>
            </a:lvl6pPr>
            <a:lvl7pPr lvl="6">
              <a:spcBef>
                <a:spcPts val="600"/>
              </a:spcBef>
              <a:spcAft>
                <a:spcPts val="0"/>
              </a:spcAft>
              <a:buNone/>
              <a:defRPr sz="2000"/>
            </a:lvl7pPr>
            <a:lvl8pPr lvl="7">
              <a:spcBef>
                <a:spcPts val="600"/>
              </a:spcBef>
              <a:spcAft>
                <a:spcPts val="0"/>
              </a:spcAft>
              <a:buNone/>
              <a:defRPr sz="2000"/>
            </a:lvl8pPr>
            <a:lvl9pPr lvl="8">
              <a:spcBef>
                <a:spcPts val="600"/>
              </a:spcBef>
              <a:spcAft>
                <a:spcPts val="0"/>
              </a:spcAft>
              <a:buNone/>
              <a:defRPr sz="2000"/>
            </a:lvl9pPr>
          </a:lstStyle>
          <a:p>
            <a:endParaRPr/>
          </a:p>
        </p:txBody>
      </p:sp>
      <p:sp>
        <p:nvSpPr>
          <p:cNvPr id="205" name="Google Shape;205;p12"/>
          <p:cNvSpPr txBox="1"/>
          <p:nvPr/>
        </p:nvSpPr>
        <p:spPr>
          <a:xfrm>
            <a:off x="3394800" y="4328600"/>
            <a:ext cx="2354400" cy="144600"/>
          </a:xfrm>
          <a:prstGeom prst="rect">
            <a:avLst/>
          </a:prstGeom>
          <a:noFill/>
          <a:ln>
            <a:noFill/>
          </a:ln>
        </p:spPr>
        <p:txBody>
          <a:bodyPr spcFirstLastPara="1" wrap="square" lIns="0" tIns="0" rIns="0" bIns="0" anchor="t" anchorCtr="0">
            <a:noAutofit/>
          </a:bodyPr>
          <a:lstStyle/>
          <a:p>
            <a:pPr marL="0" lvl="0" indent="0" algn="ctr" rtl="0">
              <a:spcBef>
                <a:spcPts val="0"/>
              </a:spcBef>
              <a:spcAft>
                <a:spcPts val="0"/>
              </a:spcAft>
              <a:buNone/>
            </a:pPr>
            <a:r>
              <a:rPr lang="en" sz="1000">
                <a:solidFill>
                  <a:srgbClr val="6D9EEB"/>
                </a:solidFill>
                <a:latin typeface="Della Respira"/>
                <a:ea typeface="Della Respira"/>
                <a:cs typeface="Della Respira"/>
                <a:sym typeface="Della Respira"/>
              </a:rPr>
              <a:t>⬅ BACK TO PANEL</a:t>
            </a:r>
            <a:endParaRPr sz="1000">
              <a:solidFill>
                <a:srgbClr val="6D9EEB"/>
              </a:solidFill>
              <a:latin typeface="Della Respira"/>
              <a:ea typeface="Della Respira"/>
              <a:cs typeface="Della Respira"/>
              <a:sym typeface="Della Respira"/>
            </a:endParaRPr>
          </a:p>
        </p:txBody>
      </p:sp>
      <p:sp>
        <p:nvSpPr>
          <p:cNvPr id="206" name="Google Shape;206;p12">
            <a:hlinkClick r:id="rId2" action="ppaction://hlinksldjump"/>
          </p:cNvPr>
          <p:cNvSpPr/>
          <p:nvPr/>
        </p:nvSpPr>
        <p:spPr>
          <a:xfrm>
            <a:off x="0" y="0"/>
            <a:ext cx="9144000" cy="5143500"/>
          </a:xfrm>
          <a:prstGeom prst="frame">
            <a:avLst>
              <a:gd name="adj1" fmla="val 19553"/>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
    <p:bg>
      <p:bgPr>
        <a:gradFill>
          <a:gsLst>
            <a:gs pos="0">
              <a:schemeClr val="accent1"/>
            </a:gs>
            <a:gs pos="19000">
              <a:schemeClr val="accent2"/>
            </a:gs>
            <a:gs pos="39000">
              <a:schemeClr val="accent4"/>
            </a:gs>
            <a:gs pos="52999">
              <a:schemeClr val="accent5"/>
            </a:gs>
            <a:gs pos="63000">
              <a:schemeClr val="accent6"/>
            </a:gs>
            <a:gs pos="65000">
              <a:schemeClr val="accent5"/>
            </a:gs>
            <a:gs pos="71000">
              <a:schemeClr val="accent4"/>
            </a:gs>
            <a:gs pos="82000">
              <a:schemeClr val="accent2"/>
            </a:gs>
            <a:gs pos="95000">
              <a:schemeClr val="accent3"/>
            </a:gs>
            <a:gs pos="100000">
              <a:schemeClr val="accent3"/>
            </a:gs>
          </a:gsLst>
          <a:lin ang="5400012" scaled="0"/>
        </a:gradFill>
        <a:effectLst/>
      </p:bgPr>
    </p:bg>
    <p:spTree>
      <p:nvGrpSpPr>
        <p:cNvPr id="1" name="Shape 5"/>
        <p:cNvGrpSpPr/>
        <p:nvPr/>
      </p:nvGrpSpPr>
      <p:grpSpPr>
        <a:xfrm>
          <a:off x="0" y="0"/>
          <a:ext cx="0" cy="0"/>
          <a:chOff x="0" y="0"/>
          <a:chExt cx="0" cy="0"/>
        </a:xfrm>
      </p:grpSpPr>
      <p:grpSp>
        <p:nvGrpSpPr>
          <p:cNvPr id="6" name="Google Shape;6;p1"/>
          <p:cNvGrpSpPr/>
          <p:nvPr/>
        </p:nvGrpSpPr>
        <p:grpSpPr>
          <a:xfrm>
            <a:off x="-118224" y="-233576"/>
            <a:ext cx="9239574" cy="3010917"/>
            <a:chOff x="-118224" y="-233576"/>
            <a:chExt cx="9239574" cy="3010917"/>
          </a:xfrm>
        </p:grpSpPr>
        <p:grpSp>
          <p:nvGrpSpPr>
            <p:cNvPr id="7" name="Google Shape;7;p1"/>
            <p:cNvGrpSpPr/>
            <p:nvPr/>
          </p:nvGrpSpPr>
          <p:grpSpPr>
            <a:xfrm>
              <a:off x="1431407" y="-101026"/>
              <a:ext cx="1032685" cy="1032685"/>
              <a:chOff x="4937822" y="2270799"/>
              <a:chExt cx="2311809" cy="2311809"/>
            </a:xfrm>
          </p:grpSpPr>
          <p:sp>
            <p:nvSpPr>
              <p:cNvPr id="8" name="Google Shape;8;p1"/>
              <p:cNvSpPr/>
              <p:nvPr/>
            </p:nvSpPr>
            <p:spPr>
              <a:xfrm>
                <a:off x="4937822" y="2270799"/>
                <a:ext cx="2311809" cy="2311809"/>
              </a:xfrm>
              <a:custGeom>
                <a:avLst/>
                <a:gdLst/>
                <a:ahLst/>
                <a:cxnLst/>
                <a:rect l="l" t="t" r="r" b="b"/>
                <a:pathLst>
                  <a:path w="1875707" h="1875707" extrusionOk="0">
                    <a:moveTo>
                      <a:pt x="923567" y="903157"/>
                    </a:moveTo>
                    <a:lnTo>
                      <a:pt x="940085" y="0"/>
                    </a:lnTo>
                    <a:lnTo>
                      <a:pt x="952331" y="903252"/>
                    </a:lnTo>
                    <a:lnTo>
                      <a:pt x="1602596" y="276244"/>
                    </a:lnTo>
                    <a:lnTo>
                      <a:pt x="972551" y="923567"/>
                    </a:lnTo>
                    <a:lnTo>
                      <a:pt x="1875708" y="940085"/>
                    </a:lnTo>
                    <a:lnTo>
                      <a:pt x="972456" y="952331"/>
                    </a:lnTo>
                    <a:lnTo>
                      <a:pt x="1599464" y="1602596"/>
                    </a:lnTo>
                    <a:lnTo>
                      <a:pt x="952141" y="972551"/>
                    </a:lnTo>
                    <a:lnTo>
                      <a:pt x="935623" y="1875708"/>
                    </a:lnTo>
                    <a:lnTo>
                      <a:pt x="923472" y="972456"/>
                    </a:lnTo>
                    <a:lnTo>
                      <a:pt x="273112" y="1599464"/>
                    </a:lnTo>
                    <a:lnTo>
                      <a:pt x="903157" y="952141"/>
                    </a:lnTo>
                    <a:lnTo>
                      <a:pt x="0" y="935623"/>
                    </a:lnTo>
                    <a:lnTo>
                      <a:pt x="903252" y="923472"/>
                    </a:lnTo>
                    <a:lnTo>
                      <a:pt x="276244" y="273112"/>
                    </a:lnTo>
                    <a:lnTo>
                      <a:pt x="923567" y="903157"/>
                    </a:lnTo>
                    <a:close/>
                  </a:path>
                </a:pathLst>
              </a:custGeom>
              <a:gradFill>
                <a:gsLst>
                  <a:gs pos="0">
                    <a:srgbClr val="E3E8FB">
                      <a:alpha val="35294"/>
                    </a:srgbClr>
                  </a:gs>
                  <a:gs pos="100000">
                    <a:srgbClr val="E3E8FB">
                      <a:alpha val="0"/>
                    </a:srgbClr>
                  </a:gs>
                </a:gsLst>
                <a:path path="circle">
                  <a:fillToRect l="50000" t="50000" r="50000" b="50000"/>
                </a:path>
                <a:tileRect/>
              </a:gra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sp>
            <p:nvSpPr>
              <p:cNvPr id="9" name="Google Shape;9;p1"/>
              <p:cNvSpPr/>
              <p:nvPr/>
            </p:nvSpPr>
            <p:spPr>
              <a:xfrm>
                <a:off x="6046636" y="3379636"/>
                <a:ext cx="94929" cy="94929"/>
              </a:xfrm>
              <a:custGeom>
                <a:avLst/>
                <a:gdLst/>
                <a:ahLst/>
                <a:cxnLst/>
                <a:rect l="l" t="t" r="r" b="b"/>
                <a:pathLst>
                  <a:path w="94929" h="94929" extrusionOk="0">
                    <a:moveTo>
                      <a:pt x="94929" y="47465"/>
                    </a:moveTo>
                    <a:cubicBezTo>
                      <a:pt x="94929" y="73679"/>
                      <a:pt x="73679" y="94929"/>
                      <a:pt x="47465" y="94929"/>
                    </a:cubicBezTo>
                    <a:cubicBezTo>
                      <a:pt x="21251" y="94929"/>
                      <a:pt x="0" y="73679"/>
                      <a:pt x="0" y="47465"/>
                    </a:cubicBezTo>
                    <a:cubicBezTo>
                      <a:pt x="0" y="21251"/>
                      <a:pt x="21251" y="0"/>
                      <a:pt x="47465" y="0"/>
                    </a:cubicBezTo>
                    <a:cubicBezTo>
                      <a:pt x="73679" y="0"/>
                      <a:pt x="94929" y="21251"/>
                      <a:pt x="94929" y="47465"/>
                    </a:cubicBezTo>
                    <a:close/>
                  </a:path>
                </a:pathLst>
              </a:custGeom>
              <a:solidFill>
                <a:schemeClr val="lt1"/>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grpSp>
        <p:grpSp>
          <p:nvGrpSpPr>
            <p:cNvPr id="10" name="Google Shape;10;p1"/>
            <p:cNvGrpSpPr/>
            <p:nvPr/>
          </p:nvGrpSpPr>
          <p:grpSpPr>
            <a:xfrm>
              <a:off x="50307" y="-233576"/>
              <a:ext cx="1032685" cy="1032685"/>
              <a:chOff x="4937822" y="2270799"/>
              <a:chExt cx="2311809" cy="2311809"/>
            </a:xfrm>
          </p:grpSpPr>
          <p:sp>
            <p:nvSpPr>
              <p:cNvPr id="11" name="Google Shape;11;p1"/>
              <p:cNvSpPr/>
              <p:nvPr/>
            </p:nvSpPr>
            <p:spPr>
              <a:xfrm>
                <a:off x="4937822" y="2270799"/>
                <a:ext cx="2311809" cy="2311809"/>
              </a:xfrm>
              <a:custGeom>
                <a:avLst/>
                <a:gdLst/>
                <a:ahLst/>
                <a:cxnLst/>
                <a:rect l="l" t="t" r="r" b="b"/>
                <a:pathLst>
                  <a:path w="1875707" h="1875707" extrusionOk="0">
                    <a:moveTo>
                      <a:pt x="923567" y="903157"/>
                    </a:moveTo>
                    <a:lnTo>
                      <a:pt x="940085" y="0"/>
                    </a:lnTo>
                    <a:lnTo>
                      <a:pt x="952331" y="903252"/>
                    </a:lnTo>
                    <a:lnTo>
                      <a:pt x="1602596" y="276244"/>
                    </a:lnTo>
                    <a:lnTo>
                      <a:pt x="972551" y="923567"/>
                    </a:lnTo>
                    <a:lnTo>
                      <a:pt x="1875708" y="940085"/>
                    </a:lnTo>
                    <a:lnTo>
                      <a:pt x="972456" y="952331"/>
                    </a:lnTo>
                    <a:lnTo>
                      <a:pt x="1599464" y="1602596"/>
                    </a:lnTo>
                    <a:lnTo>
                      <a:pt x="952141" y="972551"/>
                    </a:lnTo>
                    <a:lnTo>
                      <a:pt x="935623" y="1875708"/>
                    </a:lnTo>
                    <a:lnTo>
                      <a:pt x="923472" y="972456"/>
                    </a:lnTo>
                    <a:lnTo>
                      <a:pt x="273112" y="1599464"/>
                    </a:lnTo>
                    <a:lnTo>
                      <a:pt x="903157" y="952141"/>
                    </a:lnTo>
                    <a:lnTo>
                      <a:pt x="0" y="935623"/>
                    </a:lnTo>
                    <a:lnTo>
                      <a:pt x="903252" y="923472"/>
                    </a:lnTo>
                    <a:lnTo>
                      <a:pt x="276244" y="273112"/>
                    </a:lnTo>
                    <a:lnTo>
                      <a:pt x="923567" y="903157"/>
                    </a:lnTo>
                    <a:close/>
                  </a:path>
                </a:pathLst>
              </a:custGeom>
              <a:gradFill>
                <a:gsLst>
                  <a:gs pos="0">
                    <a:srgbClr val="E569FF">
                      <a:alpha val="59215"/>
                    </a:srgbClr>
                  </a:gs>
                  <a:gs pos="100000">
                    <a:srgbClr val="E3E8FB">
                      <a:alpha val="0"/>
                    </a:srgbClr>
                  </a:gs>
                </a:gsLst>
                <a:path path="circle">
                  <a:fillToRect l="50000" t="50000" r="50000" b="50000"/>
                </a:path>
                <a:tileRect/>
              </a:gra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sp>
            <p:nvSpPr>
              <p:cNvPr id="12" name="Google Shape;12;p1"/>
              <p:cNvSpPr/>
              <p:nvPr/>
            </p:nvSpPr>
            <p:spPr>
              <a:xfrm>
                <a:off x="6046636" y="3379636"/>
                <a:ext cx="94929" cy="94929"/>
              </a:xfrm>
              <a:custGeom>
                <a:avLst/>
                <a:gdLst/>
                <a:ahLst/>
                <a:cxnLst/>
                <a:rect l="l" t="t" r="r" b="b"/>
                <a:pathLst>
                  <a:path w="94929" h="94929" extrusionOk="0">
                    <a:moveTo>
                      <a:pt x="94929" y="47465"/>
                    </a:moveTo>
                    <a:cubicBezTo>
                      <a:pt x="94929" y="73679"/>
                      <a:pt x="73679" y="94929"/>
                      <a:pt x="47465" y="94929"/>
                    </a:cubicBezTo>
                    <a:cubicBezTo>
                      <a:pt x="21251" y="94929"/>
                      <a:pt x="0" y="73679"/>
                      <a:pt x="0" y="47465"/>
                    </a:cubicBezTo>
                    <a:cubicBezTo>
                      <a:pt x="0" y="21251"/>
                      <a:pt x="21251" y="0"/>
                      <a:pt x="47465" y="0"/>
                    </a:cubicBezTo>
                    <a:cubicBezTo>
                      <a:pt x="73679" y="0"/>
                      <a:pt x="94929" y="21251"/>
                      <a:pt x="94929" y="47465"/>
                    </a:cubicBezTo>
                    <a:close/>
                  </a:path>
                </a:pathLst>
              </a:custGeom>
              <a:solidFill>
                <a:srgbClr val="E569FF"/>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grpSp>
        <p:grpSp>
          <p:nvGrpSpPr>
            <p:cNvPr id="13" name="Google Shape;13;p1"/>
            <p:cNvGrpSpPr/>
            <p:nvPr/>
          </p:nvGrpSpPr>
          <p:grpSpPr>
            <a:xfrm>
              <a:off x="7125382" y="371399"/>
              <a:ext cx="1032685" cy="1032685"/>
              <a:chOff x="4937822" y="2270799"/>
              <a:chExt cx="2311809" cy="2311809"/>
            </a:xfrm>
          </p:grpSpPr>
          <p:sp>
            <p:nvSpPr>
              <p:cNvPr id="14" name="Google Shape;14;p1"/>
              <p:cNvSpPr/>
              <p:nvPr/>
            </p:nvSpPr>
            <p:spPr>
              <a:xfrm>
                <a:off x="4937822" y="2270799"/>
                <a:ext cx="2311809" cy="2311809"/>
              </a:xfrm>
              <a:custGeom>
                <a:avLst/>
                <a:gdLst/>
                <a:ahLst/>
                <a:cxnLst/>
                <a:rect l="l" t="t" r="r" b="b"/>
                <a:pathLst>
                  <a:path w="1875707" h="1875707" extrusionOk="0">
                    <a:moveTo>
                      <a:pt x="923567" y="903157"/>
                    </a:moveTo>
                    <a:lnTo>
                      <a:pt x="940085" y="0"/>
                    </a:lnTo>
                    <a:lnTo>
                      <a:pt x="952331" y="903252"/>
                    </a:lnTo>
                    <a:lnTo>
                      <a:pt x="1602596" y="276244"/>
                    </a:lnTo>
                    <a:lnTo>
                      <a:pt x="972551" y="923567"/>
                    </a:lnTo>
                    <a:lnTo>
                      <a:pt x="1875708" y="940085"/>
                    </a:lnTo>
                    <a:lnTo>
                      <a:pt x="972456" y="952331"/>
                    </a:lnTo>
                    <a:lnTo>
                      <a:pt x="1599464" y="1602596"/>
                    </a:lnTo>
                    <a:lnTo>
                      <a:pt x="952141" y="972551"/>
                    </a:lnTo>
                    <a:lnTo>
                      <a:pt x="935623" y="1875708"/>
                    </a:lnTo>
                    <a:lnTo>
                      <a:pt x="923472" y="972456"/>
                    </a:lnTo>
                    <a:lnTo>
                      <a:pt x="273112" y="1599464"/>
                    </a:lnTo>
                    <a:lnTo>
                      <a:pt x="903157" y="952141"/>
                    </a:lnTo>
                    <a:lnTo>
                      <a:pt x="0" y="935623"/>
                    </a:lnTo>
                    <a:lnTo>
                      <a:pt x="903252" y="923472"/>
                    </a:lnTo>
                    <a:lnTo>
                      <a:pt x="276244" y="273112"/>
                    </a:lnTo>
                    <a:lnTo>
                      <a:pt x="923567" y="903157"/>
                    </a:lnTo>
                    <a:close/>
                  </a:path>
                </a:pathLst>
              </a:custGeom>
              <a:gradFill>
                <a:gsLst>
                  <a:gs pos="0">
                    <a:srgbClr val="E3E8FB">
                      <a:alpha val="35294"/>
                    </a:srgbClr>
                  </a:gs>
                  <a:gs pos="100000">
                    <a:srgbClr val="E3E8FB">
                      <a:alpha val="0"/>
                    </a:srgbClr>
                  </a:gs>
                </a:gsLst>
                <a:path path="circle">
                  <a:fillToRect l="50000" t="50000" r="50000" b="50000"/>
                </a:path>
                <a:tileRect/>
              </a:gra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sp>
            <p:nvSpPr>
              <p:cNvPr id="15" name="Google Shape;15;p1"/>
              <p:cNvSpPr/>
              <p:nvPr/>
            </p:nvSpPr>
            <p:spPr>
              <a:xfrm>
                <a:off x="6046636" y="3379636"/>
                <a:ext cx="94929" cy="94929"/>
              </a:xfrm>
              <a:custGeom>
                <a:avLst/>
                <a:gdLst/>
                <a:ahLst/>
                <a:cxnLst/>
                <a:rect l="l" t="t" r="r" b="b"/>
                <a:pathLst>
                  <a:path w="94929" h="94929" extrusionOk="0">
                    <a:moveTo>
                      <a:pt x="94929" y="47465"/>
                    </a:moveTo>
                    <a:cubicBezTo>
                      <a:pt x="94929" y="73679"/>
                      <a:pt x="73679" y="94929"/>
                      <a:pt x="47465" y="94929"/>
                    </a:cubicBezTo>
                    <a:cubicBezTo>
                      <a:pt x="21251" y="94929"/>
                      <a:pt x="0" y="73679"/>
                      <a:pt x="0" y="47465"/>
                    </a:cubicBezTo>
                    <a:cubicBezTo>
                      <a:pt x="0" y="21251"/>
                      <a:pt x="21251" y="0"/>
                      <a:pt x="47465" y="0"/>
                    </a:cubicBezTo>
                    <a:cubicBezTo>
                      <a:pt x="73679" y="0"/>
                      <a:pt x="94929" y="21251"/>
                      <a:pt x="94929" y="47465"/>
                    </a:cubicBezTo>
                    <a:close/>
                  </a:path>
                </a:pathLst>
              </a:custGeom>
              <a:solidFill>
                <a:schemeClr val="lt1"/>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grpSp>
        <p:grpSp>
          <p:nvGrpSpPr>
            <p:cNvPr id="16" name="Google Shape;16;p1"/>
            <p:cNvGrpSpPr/>
            <p:nvPr/>
          </p:nvGrpSpPr>
          <p:grpSpPr>
            <a:xfrm>
              <a:off x="-118224" y="419163"/>
              <a:ext cx="803354" cy="803354"/>
              <a:chOff x="4937822" y="2270799"/>
              <a:chExt cx="2311809" cy="2311809"/>
            </a:xfrm>
          </p:grpSpPr>
          <p:sp>
            <p:nvSpPr>
              <p:cNvPr id="17" name="Google Shape;17;p1"/>
              <p:cNvSpPr/>
              <p:nvPr/>
            </p:nvSpPr>
            <p:spPr>
              <a:xfrm>
                <a:off x="4937822" y="2270799"/>
                <a:ext cx="2311809" cy="2311809"/>
              </a:xfrm>
              <a:custGeom>
                <a:avLst/>
                <a:gdLst/>
                <a:ahLst/>
                <a:cxnLst/>
                <a:rect l="l" t="t" r="r" b="b"/>
                <a:pathLst>
                  <a:path w="1875707" h="1875707" extrusionOk="0">
                    <a:moveTo>
                      <a:pt x="923567" y="903157"/>
                    </a:moveTo>
                    <a:lnTo>
                      <a:pt x="940085" y="0"/>
                    </a:lnTo>
                    <a:lnTo>
                      <a:pt x="952331" y="903252"/>
                    </a:lnTo>
                    <a:lnTo>
                      <a:pt x="1602596" y="276244"/>
                    </a:lnTo>
                    <a:lnTo>
                      <a:pt x="972551" y="923567"/>
                    </a:lnTo>
                    <a:lnTo>
                      <a:pt x="1875708" y="940085"/>
                    </a:lnTo>
                    <a:lnTo>
                      <a:pt x="972456" y="952331"/>
                    </a:lnTo>
                    <a:lnTo>
                      <a:pt x="1599464" y="1602596"/>
                    </a:lnTo>
                    <a:lnTo>
                      <a:pt x="952141" y="972551"/>
                    </a:lnTo>
                    <a:lnTo>
                      <a:pt x="935623" y="1875708"/>
                    </a:lnTo>
                    <a:lnTo>
                      <a:pt x="923472" y="972456"/>
                    </a:lnTo>
                    <a:lnTo>
                      <a:pt x="273112" y="1599464"/>
                    </a:lnTo>
                    <a:lnTo>
                      <a:pt x="903157" y="952141"/>
                    </a:lnTo>
                    <a:lnTo>
                      <a:pt x="0" y="935623"/>
                    </a:lnTo>
                    <a:lnTo>
                      <a:pt x="903252" y="923472"/>
                    </a:lnTo>
                    <a:lnTo>
                      <a:pt x="276244" y="273112"/>
                    </a:lnTo>
                    <a:lnTo>
                      <a:pt x="923567" y="903157"/>
                    </a:lnTo>
                    <a:close/>
                  </a:path>
                </a:pathLst>
              </a:custGeom>
              <a:gradFill>
                <a:gsLst>
                  <a:gs pos="0">
                    <a:srgbClr val="E569FF">
                      <a:alpha val="59215"/>
                    </a:srgbClr>
                  </a:gs>
                  <a:gs pos="100000">
                    <a:srgbClr val="E3E8FB">
                      <a:alpha val="0"/>
                    </a:srgbClr>
                  </a:gs>
                </a:gsLst>
                <a:path path="circle">
                  <a:fillToRect l="50000" t="50000" r="50000" b="50000"/>
                </a:path>
                <a:tileRect/>
              </a:gra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sp>
            <p:nvSpPr>
              <p:cNvPr id="18" name="Google Shape;18;p1"/>
              <p:cNvSpPr/>
              <p:nvPr/>
            </p:nvSpPr>
            <p:spPr>
              <a:xfrm>
                <a:off x="6046636" y="3379636"/>
                <a:ext cx="94929" cy="94929"/>
              </a:xfrm>
              <a:custGeom>
                <a:avLst/>
                <a:gdLst/>
                <a:ahLst/>
                <a:cxnLst/>
                <a:rect l="l" t="t" r="r" b="b"/>
                <a:pathLst>
                  <a:path w="94929" h="94929" extrusionOk="0">
                    <a:moveTo>
                      <a:pt x="94929" y="47465"/>
                    </a:moveTo>
                    <a:cubicBezTo>
                      <a:pt x="94929" y="73679"/>
                      <a:pt x="73679" y="94929"/>
                      <a:pt x="47465" y="94929"/>
                    </a:cubicBezTo>
                    <a:cubicBezTo>
                      <a:pt x="21251" y="94929"/>
                      <a:pt x="0" y="73679"/>
                      <a:pt x="0" y="47465"/>
                    </a:cubicBezTo>
                    <a:cubicBezTo>
                      <a:pt x="0" y="21251"/>
                      <a:pt x="21251" y="0"/>
                      <a:pt x="47465" y="0"/>
                    </a:cubicBezTo>
                    <a:cubicBezTo>
                      <a:pt x="73679" y="0"/>
                      <a:pt x="94929" y="21251"/>
                      <a:pt x="94929" y="47465"/>
                    </a:cubicBezTo>
                    <a:close/>
                  </a:path>
                </a:pathLst>
              </a:custGeom>
              <a:solidFill>
                <a:srgbClr val="E569FF"/>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grpSp>
        <p:grpSp>
          <p:nvGrpSpPr>
            <p:cNvPr id="19" name="Google Shape;19;p1"/>
            <p:cNvGrpSpPr/>
            <p:nvPr/>
          </p:nvGrpSpPr>
          <p:grpSpPr>
            <a:xfrm>
              <a:off x="2717107" y="1008374"/>
              <a:ext cx="1032685" cy="1032685"/>
              <a:chOff x="4937822" y="2270799"/>
              <a:chExt cx="2311809" cy="2311809"/>
            </a:xfrm>
          </p:grpSpPr>
          <p:sp>
            <p:nvSpPr>
              <p:cNvPr id="20" name="Google Shape;20;p1"/>
              <p:cNvSpPr/>
              <p:nvPr/>
            </p:nvSpPr>
            <p:spPr>
              <a:xfrm>
                <a:off x="4937822" y="2270799"/>
                <a:ext cx="2311809" cy="2311809"/>
              </a:xfrm>
              <a:custGeom>
                <a:avLst/>
                <a:gdLst/>
                <a:ahLst/>
                <a:cxnLst/>
                <a:rect l="l" t="t" r="r" b="b"/>
                <a:pathLst>
                  <a:path w="1875707" h="1875707" extrusionOk="0">
                    <a:moveTo>
                      <a:pt x="923567" y="903157"/>
                    </a:moveTo>
                    <a:lnTo>
                      <a:pt x="940085" y="0"/>
                    </a:lnTo>
                    <a:lnTo>
                      <a:pt x="952331" y="903252"/>
                    </a:lnTo>
                    <a:lnTo>
                      <a:pt x="1602596" y="276244"/>
                    </a:lnTo>
                    <a:lnTo>
                      <a:pt x="972551" y="923567"/>
                    </a:lnTo>
                    <a:lnTo>
                      <a:pt x="1875708" y="940085"/>
                    </a:lnTo>
                    <a:lnTo>
                      <a:pt x="972456" y="952331"/>
                    </a:lnTo>
                    <a:lnTo>
                      <a:pt x="1599464" y="1602596"/>
                    </a:lnTo>
                    <a:lnTo>
                      <a:pt x="952141" y="972551"/>
                    </a:lnTo>
                    <a:lnTo>
                      <a:pt x="935623" y="1875708"/>
                    </a:lnTo>
                    <a:lnTo>
                      <a:pt x="923472" y="972456"/>
                    </a:lnTo>
                    <a:lnTo>
                      <a:pt x="273112" y="1599464"/>
                    </a:lnTo>
                    <a:lnTo>
                      <a:pt x="903157" y="952141"/>
                    </a:lnTo>
                    <a:lnTo>
                      <a:pt x="0" y="935623"/>
                    </a:lnTo>
                    <a:lnTo>
                      <a:pt x="903252" y="923472"/>
                    </a:lnTo>
                    <a:lnTo>
                      <a:pt x="276244" y="273112"/>
                    </a:lnTo>
                    <a:lnTo>
                      <a:pt x="923567" y="903157"/>
                    </a:lnTo>
                    <a:close/>
                  </a:path>
                </a:pathLst>
              </a:custGeom>
              <a:gradFill>
                <a:gsLst>
                  <a:gs pos="0">
                    <a:srgbClr val="E569FF">
                      <a:alpha val="59215"/>
                    </a:srgbClr>
                  </a:gs>
                  <a:gs pos="100000">
                    <a:srgbClr val="E3E8FB">
                      <a:alpha val="0"/>
                    </a:srgbClr>
                  </a:gs>
                </a:gsLst>
                <a:path path="circle">
                  <a:fillToRect l="50000" t="50000" r="50000" b="50000"/>
                </a:path>
                <a:tileRect/>
              </a:gra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sp>
            <p:nvSpPr>
              <p:cNvPr id="21" name="Google Shape;21;p1"/>
              <p:cNvSpPr/>
              <p:nvPr/>
            </p:nvSpPr>
            <p:spPr>
              <a:xfrm>
                <a:off x="6046636" y="3379636"/>
                <a:ext cx="94929" cy="94929"/>
              </a:xfrm>
              <a:custGeom>
                <a:avLst/>
                <a:gdLst/>
                <a:ahLst/>
                <a:cxnLst/>
                <a:rect l="l" t="t" r="r" b="b"/>
                <a:pathLst>
                  <a:path w="94929" h="94929" extrusionOk="0">
                    <a:moveTo>
                      <a:pt x="94929" y="47465"/>
                    </a:moveTo>
                    <a:cubicBezTo>
                      <a:pt x="94929" y="73679"/>
                      <a:pt x="73679" y="94929"/>
                      <a:pt x="47465" y="94929"/>
                    </a:cubicBezTo>
                    <a:cubicBezTo>
                      <a:pt x="21251" y="94929"/>
                      <a:pt x="0" y="73679"/>
                      <a:pt x="0" y="47465"/>
                    </a:cubicBezTo>
                    <a:cubicBezTo>
                      <a:pt x="0" y="21251"/>
                      <a:pt x="21251" y="0"/>
                      <a:pt x="47465" y="0"/>
                    </a:cubicBezTo>
                    <a:cubicBezTo>
                      <a:pt x="73679" y="0"/>
                      <a:pt x="94929" y="21251"/>
                      <a:pt x="94929" y="47465"/>
                    </a:cubicBezTo>
                    <a:close/>
                  </a:path>
                </a:pathLst>
              </a:custGeom>
              <a:solidFill>
                <a:srgbClr val="E569FF"/>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grpSp>
        <p:grpSp>
          <p:nvGrpSpPr>
            <p:cNvPr id="22" name="Google Shape;22;p1"/>
            <p:cNvGrpSpPr/>
            <p:nvPr/>
          </p:nvGrpSpPr>
          <p:grpSpPr>
            <a:xfrm>
              <a:off x="6613501" y="128288"/>
              <a:ext cx="803354" cy="803354"/>
              <a:chOff x="4937822" y="2270799"/>
              <a:chExt cx="2311809" cy="2311809"/>
            </a:xfrm>
          </p:grpSpPr>
          <p:sp>
            <p:nvSpPr>
              <p:cNvPr id="23" name="Google Shape;23;p1"/>
              <p:cNvSpPr/>
              <p:nvPr/>
            </p:nvSpPr>
            <p:spPr>
              <a:xfrm>
                <a:off x="4937822" y="2270799"/>
                <a:ext cx="2311809" cy="2311809"/>
              </a:xfrm>
              <a:custGeom>
                <a:avLst/>
                <a:gdLst/>
                <a:ahLst/>
                <a:cxnLst/>
                <a:rect l="l" t="t" r="r" b="b"/>
                <a:pathLst>
                  <a:path w="1875707" h="1875707" extrusionOk="0">
                    <a:moveTo>
                      <a:pt x="923567" y="903157"/>
                    </a:moveTo>
                    <a:lnTo>
                      <a:pt x="940085" y="0"/>
                    </a:lnTo>
                    <a:lnTo>
                      <a:pt x="952331" y="903252"/>
                    </a:lnTo>
                    <a:lnTo>
                      <a:pt x="1602596" y="276244"/>
                    </a:lnTo>
                    <a:lnTo>
                      <a:pt x="972551" y="923567"/>
                    </a:lnTo>
                    <a:lnTo>
                      <a:pt x="1875708" y="940085"/>
                    </a:lnTo>
                    <a:lnTo>
                      <a:pt x="972456" y="952331"/>
                    </a:lnTo>
                    <a:lnTo>
                      <a:pt x="1599464" y="1602596"/>
                    </a:lnTo>
                    <a:lnTo>
                      <a:pt x="952141" y="972551"/>
                    </a:lnTo>
                    <a:lnTo>
                      <a:pt x="935623" y="1875708"/>
                    </a:lnTo>
                    <a:lnTo>
                      <a:pt x="923472" y="972456"/>
                    </a:lnTo>
                    <a:lnTo>
                      <a:pt x="273112" y="1599464"/>
                    </a:lnTo>
                    <a:lnTo>
                      <a:pt x="903157" y="952141"/>
                    </a:lnTo>
                    <a:lnTo>
                      <a:pt x="0" y="935623"/>
                    </a:lnTo>
                    <a:lnTo>
                      <a:pt x="903252" y="923472"/>
                    </a:lnTo>
                    <a:lnTo>
                      <a:pt x="276244" y="273112"/>
                    </a:lnTo>
                    <a:lnTo>
                      <a:pt x="923567" y="903157"/>
                    </a:lnTo>
                    <a:close/>
                  </a:path>
                </a:pathLst>
              </a:custGeom>
              <a:gradFill>
                <a:gsLst>
                  <a:gs pos="0">
                    <a:srgbClr val="E569FF">
                      <a:alpha val="59215"/>
                    </a:srgbClr>
                  </a:gs>
                  <a:gs pos="100000">
                    <a:srgbClr val="E3E8FB">
                      <a:alpha val="0"/>
                    </a:srgbClr>
                  </a:gs>
                </a:gsLst>
                <a:path path="circle">
                  <a:fillToRect l="50000" t="50000" r="50000" b="50000"/>
                </a:path>
                <a:tileRect/>
              </a:gra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sp>
            <p:nvSpPr>
              <p:cNvPr id="24" name="Google Shape;24;p1"/>
              <p:cNvSpPr/>
              <p:nvPr/>
            </p:nvSpPr>
            <p:spPr>
              <a:xfrm>
                <a:off x="6046636" y="3379636"/>
                <a:ext cx="94929" cy="94929"/>
              </a:xfrm>
              <a:custGeom>
                <a:avLst/>
                <a:gdLst/>
                <a:ahLst/>
                <a:cxnLst/>
                <a:rect l="l" t="t" r="r" b="b"/>
                <a:pathLst>
                  <a:path w="94929" h="94929" extrusionOk="0">
                    <a:moveTo>
                      <a:pt x="94929" y="47465"/>
                    </a:moveTo>
                    <a:cubicBezTo>
                      <a:pt x="94929" y="73679"/>
                      <a:pt x="73679" y="94929"/>
                      <a:pt x="47465" y="94929"/>
                    </a:cubicBezTo>
                    <a:cubicBezTo>
                      <a:pt x="21251" y="94929"/>
                      <a:pt x="0" y="73679"/>
                      <a:pt x="0" y="47465"/>
                    </a:cubicBezTo>
                    <a:cubicBezTo>
                      <a:pt x="0" y="21251"/>
                      <a:pt x="21251" y="0"/>
                      <a:pt x="47465" y="0"/>
                    </a:cubicBezTo>
                    <a:cubicBezTo>
                      <a:pt x="73679" y="0"/>
                      <a:pt x="94929" y="21251"/>
                      <a:pt x="94929" y="47465"/>
                    </a:cubicBezTo>
                    <a:close/>
                  </a:path>
                </a:pathLst>
              </a:custGeom>
              <a:solidFill>
                <a:srgbClr val="E569FF"/>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grpSp>
        <p:grpSp>
          <p:nvGrpSpPr>
            <p:cNvPr id="25" name="Google Shape;25;p1"/>
            <p:cNvGrpSpPr/>
            <p:nvPr/>
          </p:nvGrpSpPr>
          <p:grpSpPr>
            <a:xfrm>
              <a:off x="3610901" y="-101034"/>
              <a:ext cx="733075" cy="733075"/>
              <a:chOff x="4937822" y="2270799"/>
              <a:chExt cx="2311809" cy="2311809"/>
            </a:xfrm>
          </p:grpSpPr>
          <p:sp>
            <p:nvSpPr>
              <p:cNvPr id="26" name="Google Shape;26;p1"/>
              <p:cNvSpPr/>
              <p:nvPr/>
            </p:nvSpPr>
            <p:spPr>
              <a:xfrm>
                <a:off x="4937822" y="2270799"/>
                <a:ext cx="2311809" cy="2311809"/>
              </a:xfrm>
              <a:custGeom>
                <a:avLst/>
                <a:gdLst/>
                <a:ahLst/>
                <a:cxnLst/>
                <a:rect l="l" t="t" r="r" b="b"/>
                <a:pathLst>
                  <a:path w="1875707" h="1875707" extrusionOk="0">
                    <a:moveTo>
                      <a:pt x="923567" y="903157"/>
                    </a:moveTo>
                    <a:lnTo>
                      <a:pt x="940085" y="0"/>
                    </a:lnTo>
                    <a:lnTo>
                      <a:pt x="952331" y="903252"/>
                    </a:lnTo>
                    <a:lnTo>
                      <a:pt x="1602596" y="276244"/>
                    </a:lnTo>
                    <a:lnTo>
                      <a:pt x="972551" y="923567"/>
                    </a:lnTo>
                    <a:lnTo>
                      <a:pt x="1875708" y="940085"/>
                    </a:lnTo>
                    <a:lnTo>
                      <a:pt x="972456" y="952331"/>
                    </a:lnTo>
                    <a:lnTo>
                      <a:pt x="1599464" y="1602596"/>
                    </a:lnTo>
                    <a:lnTo>
                      <a:pt x="952141" y="972551"/>
                    </a:lnTo>
                    <a:lnTo>
                      <a:pt x="935623" y="1875708"/>
                    </a:lnTo>
                    <a:lnTo>
                      <a:pt x="923472" y="972456"/>
                    </a:lnTo>
                    <a:lnTo>
                      <a:pt x="273112" y="1599464"/>
                    </a:lnTo>
                    <a:lnTo>
                      <a:pt x="903157" y="952141"/>
                    </a:lnTo>
                    <a:lnTo>
                      <a:pt x="0" y="935623"/>
                    </a:lnTo>
                    <a:lnTo>
                      <a:pt x="903252" y="923472"/>
                    </a:lnTo>
                    <a:lnTo>
                      <a:pt x="276244" y="273112"/>
                    </a:lnTo>
                    <a:lnTo>
                      <a:pt x="923567" y="903157"/>
                    </a:lnTo>
                    <a:close/>
                  </a:path>
                </a:pathLst>
              </a:custGeom>
              <a:gradFill>
                <a:gsLst>
                  <a:gs pos="0">
                    <a:srgbClr val="E3E8FB">
                      <a:alpha val="35294"/>
                    </a:srgbClr>
                  </a:gs>
                  <a:gs pos="100000">
                    <a:srgbClr val="E3E8FB">
                      <a:alpha val="0"/>
                    </a:srgbClr>
                  </a:gs>
                </a:gsLst>
                <a:path path="circle">
                  <a:fillToRect l="50000" t="50000" r="50000" b="50000"/>
                </a:path>
                <a:tileRect/>
              </a:gra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sp>
            <p:nvSpPr>
              <p:cNvPr id="27" name="Google Shape;27;p1"/>
              <p:cNvSpPr/>
              <p:nvPr/>
            </p:nvSpPr>
            <p:spPr>
              <a:xfrm>
                <a:off x="6046636" y="3379636"/>
                <a:ext cx="94929" cy="94929"/>
              </a:xfrm>
              <a:custGeom>
                <a:avLst/>
                <a:gdLst/>
                <a:ahLst/>
                <a:cxnLst/>
                <a:rect l="l" t="t" r="r" b="b"/>
                <a:pathLst>
                  <a:path w="94929" h="94929" extrusionOk="0">
                    <a:moveTo>
                      <a:pt x="94929" y="47465"/>
                    </a:moveTo>
                    <a:cubicBezTo>
                      <a:pt x="94929" y="73679"/>
                      <a:pt x="73679" y="94929"/>
                      <a:pt x="47465" y="94929"/>
                    </a:cubicBezTo>
                    <a:cubicBezTo>
                      <a:pt x="21251" y="94929"/>
                      <a:pt x="0" y="73679"/>
                      <a:pt x="0" y="47465"/>
                    </a:cubicBezTo>
                    <a:cubicBezTo>
                      <a:pt x="0" y="21251"/>
                      <a:pt x="21251" y="0"/>
                      <a:pt x="47465" y="0"/>
                    </a:cubicBezTo>
                    <a:cubicBezTo>
                      <a:pt x="73679" y="0"/>
                      <a:pt x="94929" y="21251"/>
                      <a:pt x="94929" y="47465"/>
                    </a:cubicBezTo>
                    <a:close/>
                  </a:path>
                </a:pathLst>
              </a:custGeom>
              <a:solidFill>
                <a:schemeClr val="lt1"/>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grpSp>
        <p:grpSp>
          <p:nvGrpSpPr>
            <p:cNvPr id="28" name="Google Shape;28;p1"/>
            <p:cNvGrpSpPr/>
            <p:nvPr/>
          </p:nvGrpSpPr>
          <p:grpSpPr>
            <a:xfrm>
              <a:off x="50301" y="1973988"/>
              <a:ext cx="803354" cy="803354"/>
              <a:chOff x="4937822" y="2270799"/>
              <a:chExt cx="2311809" cy="2311809"/>
            </a:xfrm>
          </p:grpSpPr>
          <p:sp>
            <p:nvSpPr>
              <p:cNvPr id="29" name="Google Shape;29;p1"/>
              <p:cNvSpPr/>
              <p:nvPr/>
            </p:nvSpPr>
            <p:spPr>
              <a:xfrm>
                <a:off x="4937822" y="2270799"/>
                <a:ext cx="2311809" cy="2311809"/>
              </a:xfrm>
              <a:custGeom>
                <a:avLst/>
                <a:gdLst/>
                <a:ahLst/>
                <a:cxnLst/>
                <a:rect l="l" t="t" r="r" b="b"/>
                <a:pathLst>
                  <a:path w="1875707" h="1875707" extrusionOk="0">
                    <a:moveTo>
                      <a:pt x="923567" y="903157"/>
                    </a:moveTo>
                    <a:lnTo>
                      <a:pt x="940085" y="0"/>
                    </a:lnTo>
                    <a:lnTo>
                      <a:pt x="952331" y="903252"/>
                    </a:lnTo>
                    <a:lnTo>
                      <a:pt x="1602596" y="276244"/>
                    </a:lnTo>
                    <a:lnTo>
                      <a:pt x="972551" y="923567"/>
                    </a:lnTo>
                    <a:lnTo>
                      <a:pt x="1875708" y="940085"/>
                    </a:lnTo>
                    <a:lnTo>
                      <a:pt x="972456" y="952331"/>
                    </a:lnTo>
                    <a:lnTo>
                      <a:pt x="1599464" y="1602596"/>
                    </a:lnTo>
                    <a:lnTo>
                      <a:pt x="952141" y="972551"/>
                    </a:lnTo>
                    <a:lnTo>
                      <a:pt x="935623" y="1875708"/>
                    </a:lnTo>
                    <a:lnTo>
                      <a:pt x="923472" y="972456"/>
                    </a:lnTo>
                    <a:lnTo>
                      <a:pt x="273112" y="1599464"/>
                    </a:lnTo>
                    <a:lnTo>
                      <a:pt x="903157" y="952141"/>
                    </a:lnTo>
                    <a:lnTo>
                      <a:pt x="0" y="935623"/>
                    </a:lnTo>
                    <a:lnTo>
                      <a:pt x="903252" y="923472"/>
                    </a:lnTo>
                    <a:lnTo>
                      <a:pt x="276244" y="273112"/>
                    </a:lnTo>
                    <a:lnTo>
                      <a:pt x="923567" y="903157"/>
                    </a:lnTo>
                    <a:close/>
                  </a:path>
                </a:pathLst>
              </a:custGeom>
              <a:gradFill>
                <a:gsLst>
                  <a:gs pos="0">
                    <a:srgbClr val="E569FF">
                      <a:alpha val="59215"/>
                    </a:srgbClr>
                  </a:gs>
                  <a:gs pos="100000">
                    <a:srgbClr val="E3E8FB">
                      <a:alpha val="0"/>
                    </a:srgbClr>
                  </a:gs>
                </a:gsLst>
                <a:path path="circle">
                  <a:fillToRect l="50000" t="50000" r="50000" b="50000"/>
                </a:path>
                <a:tileRect/>
              </a:gra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sp>
            <p:nvSpPr>
              <p:cNvPr id="30" name="Google Shape;30;p1"/>
              <p:cNvSpPr/>
              <p:nvPr/>
            </p:nvSpPr>
            <p:spPr>
              <a:xfrm>
                <a:off x="6046636" y="3379636"/>
                <a:ext cx="94929" cy="94929"/>
              </a:xfrm>
              <a:custGeom>
                <a:avLst/>
                <a:gdLst/>
                <a:ahLst/>
                <a:cxnLst/>
                <a:rect l="l" t="t" r="r" b="b"/>
                <a:pathLst>
                  <a:path w="94929" h="94929" extrusionOk="0">
                    <a:moveTo>
                      <a:pt x="94929" y="47465"/>
                    </a:moveTo>
                    <a:cubicBezTo>
                      <a:pt x="94929" y="73679"/>
                      <a:pt x="73679" y="94929"/>
                      <a:pt x="47465" y="94929"/>
                    </a:cubicBezTo>
                    <a:cubicBezTo>
                      <a:pt x="21251" y="94929"/>
                      <a:pt x="0" y="73679"/>
                      <a:pt x="0" y="47465"/>
                    </a:cubicBezTo>
                    <a:cubicBezTo>
                      <a:pt x="0" y="21251"/>
                      <a:pt x="21251" y="0"/>
                      <a:pt x="47465" y="0"/>
                    </a:cubicBezTo>
                    <a:cubicBezTo>
                      <a:pt x="73679" y="0"/>
                      <a:pt x="94929" y="21251"/>
                      <a:pt x="94929" y="47465"/>
                    </a:cubicBezTo>
                    <a:close/>
                  </a:path>
                </a:pathLst>
              </a:custGeom>
              <a:solidFill>
                <a:srgbClr val="E569FF"/>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grpSp>
        <p:sp>
          <p:nvSpPr>
            <p:cNvPr id="31" name="Google Shape;31;p1"/>
            <p:cNvSpPr/>
            <p:nvPr/>
          </p:nvSpPr>
          <p:spPr>
            <a:xfrm>
              <a:off x="4911450" y="7543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2" name="Google Shape;32;p1"/>
            <p:cNvSpPr/>
            <p:nvPr/>
          </p:nvSpPr>
          <p:spPr>
            <a:xfrm>
              <a:off x="5368650" y="5257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3" name="Google Shape;33;p1"/>
            <p:cNvSpPr/>
            <p:nvPr/>
          </p:nvSpPr>
          <p:spPr>
            <a:xfrm>
              <a:off x="5521050" y="11353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4" name="Google Shape;34;p1"/>
            <p:cNvSpPr/>
            <p:nvPr/>
          </p:nvSpPr>
          <p:spPr>
            <a:xfrm>
              <a:off x="6130650" y="10591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5" name="Google Shape;35;p1"/>
            <p:cNvSpPr/>
            <p:nvPr/>
          </p:nvSpPr>
          <p:spPr>
            <a:xfrm>
              <a:off x="5825850" y="14401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6" name="Google Shape;36;p1"/>
            <p:cNvSpPr/>
            <p:nvPr/>
          </p:nvSpPr>
          <p:spPr>
            <a:xfrm>
              <a:off x="4682850" y="13639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7" name="Google Shape;37;p1"/>
            <p:cNvSpPr/>
            <p:nvPr/>
          </p:nvSpPr>
          <p:spPr>
            <a:xfrm>
              <a:off x="4835250" y="2209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8" name="Google Shape;38;p1"/>
            <p:cNvSpPr/>
            <p:nvPr/>
          </p:nvSpPr>
          <p:spPr>
            <a:xfrm>
              <a:off x="3844650" y="9067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9" name="Google Shape;39;p1"/>
            <p:cNvSpPr/>
            <p:nvPr/>
          </p:nvSpPr>
          <p:spPr>
            <a:xfrm>
              <a:off x="3692250" y="9829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0" name="Google Shape;40;p1"/>
            <p:cNvSpPr/>
            <p:nvPr/>
          </p:nvSpPr>
          <p:spPr>
            <a:xfrm>
              <a:off x="4378050" y="9829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1" name="Google Shape;41;p1"/>
            <p:cNvSpPr/>
            <p:nvPr/>
          </p:nvSpPr>
          <p:spPr>
            <a:xfrm>
              <a:off x="3235050" y="5257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2" name="Google Shape;42;p1"/>
            <p:cNvSpPr/>
            <p:nvPr/>
          </p:nvSpPr>
          <p:spPr>
            <a:xfrm>
              <a:off x="2701650" y="8305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3" name="Google Shape;43;p1"/>
            <p:cNvSpPr/>
            <p:nvPr/>
          </p:nvSpPr>
          <p:spPr>
            <a:xfrm>
              <a:off x="1939650" y="11353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4" name="Google Shape;44;p1"/>
            <p:cNvSpPr/>
            <p:nvPr/>
          </p:nvSpPr>
          <p:spPr>
            <a:xfrm>
              <a:off x="2244450" y="12877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5" name="Google Shape;45;p1"/>
            <p:cNvSpPr/>
            <p:nvPr/>
          </p:nvSpPr>
          <p:spPr>
            <a:xfrm>
              <a:off x="2168250" y="14401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6" name="Google Shape;46;p1"/>
            <p:cNvSpPr/>
            <p:nvPr/>
          </p:nvSpPr>
          <p:spPr>
            <a:xfrm>
              <a:off x="1177650" y="5257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7" name="Google Shape;47;p1"/>
            <p:cNvSpPr/>
            <p:nvPr/>
          </p:nvSpPr>
          <p:spPr>
            <a:xfrm>
              <a:off x="1482450" y="7543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8" name="Google Shape;48;p1"/>
            <p:cNvSpPr/>
            <p:nvPr/>
          </p:nvSpPr>
          <p:spPr>
            <a:xfrm>
              <a:off x="1025250" y="9829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9" name="Google Shape;49;p1"/>
            <p:cNvSpPr/>
            <p:nvPr/>
          </p:nvSpPr>
          <p:spPr>
            <a:xfrm>
              <a:off x="1101450" y="10591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0" name="Google Shape;50;p1"/>
            <p:cNvSpPr/>
            <p:nvPr/>
          </p:nvSpPr>
          <p:spPr>
            <a:xfrm>
              <a:off x="1253850" y="18211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1" name="Google Shape;51;p1"/>
            <p:cNvSpPr/>
            <p:nvPr/>
          </p:nvSpPr>
          <p:spPr>
            <a:xfrm>
              <a:off x="415650" y="15163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2" name="Google Shape;52;p1"/>
            <p:cNvSpPr/>
            <p:nvPr/>
          </p:nvSpPr>
          <p:spPr>
            <a:xfrm>
              <a:off x="4225650" y="16687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3" name="Google Shape;53;p1"/>
            <p:cNvSpPr/>
            <p:nvPr/>
          </p:nvSpPr>
          <p:spPr>
            <a:xfrm>
              <a:off x="5978250" y="15163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4" name="Google Shape;54;p1"/>
            <p:cNvSpPr/>
            <p:nvPr/>
          </p:nvSpPr>
          <p:spPr>
            <a:xfrm>
              <a:off x="6587850" y="15163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5" name="Google Shape;55;p1"/>
            <p:cNvSpPr/>
            <p:nvPr/>
          </p:nvSpPr>
          <p:spPr>
            <a:xfrm>
              <a:off x="6587850" y="7543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6" name="Google Shape;56;p1"/>
            <p:cNvSpPr/>
            <p:nvPr/>
          </p:nvSpPr>
          <p:spPr>
            <a:xfrm>
              <a:off x="5978250" y="2971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7" name="Google Shape;57;p1"/>
            <p:cNvSpPr/>
            <p:nvPr/>
          </p:nvSpPr>
          <p:spPr>
            <a:xfrm>
              <a:off x="5902050" y="3733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8" name="Google Shape;58;p1"/>
            <p:cNvSpPr/>
            <p:nvPr/>
          </p:nvSpPr>
          <p:spPr>
            <a:xfrm>
              <a:off x="7426050" y="5257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9" name="Google Shape;59;p1"/>
            <p:cNvSpPr/>
            <p:nvPr/>
          </p:nvSpPr>
          <p:spPr>
            <a:xfrm>
              <a:off x="7578450" y="685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0" name="Google Shape;60;p1"/>
            <p:cNvSpPr/>
            <p:nvPr/>
          </p:nvSpPr>
          <p:spPr>
            <a:xfrm>
              <a:off x="7730850" y="13639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1" name="Google Shape;61;p1"/>
            <p:cNvSpPr/>
            <p:nvPr/>
          </p:nvSpPr>
          <p:spPr>
            <a:xfrm>
              <a:off x="7045050" y="11353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2" name="Google Shape;62;p1"/>
            <p:cNvSpPr/>
            <p:nvPr/>
          </p:nvSpPr>
          <p:spPr>
            <a:xfrm>
              <a:off x="8264250" y="12877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3" name="Google Shape;63;p1"/>
            <p:cNvSpPr/>
            <p:nvPr/>
          </p:nvSpPr>
          <p:spPr>
            <a:xfrm>
              <a:off x="8416650" y="14401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4" name="Google Shape;64;p1"/>
            <p:cNvSpPr/>
            <p:nvPr/>
          </p:nvSpPr>
          <p:spPr>
            <a:xfrm>
              <a:off x="8569050" y="18211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5" name="Google Shape;65;p1"/>
            <p:cNvSpPr/>
            <p:nvPr/>
          </p:nvSpPr>
          <p:spPr>
            <a:xfrm>
              <a:off x="8873850" y="11353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6" name="Google Shape;66;p1"/>
            <p:cNvSpPr/>
            <p:nvPr/>
          </p:nvSpPr>
          <p:spPr>
            <a:xfrm>
              <a:off x="8645250" y="6781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7" name="Google Shape;67;p1"/>
            <p:cNvSpPr/>
            <p:nvPr/>
          </p:nvSpPr>
          <p:spPr>
            <a:xfrm>
              <a:off x="8416650" y="8305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8" name="Google Shape;68;p1"/>
            <p:cNvSpPr/>
            <p:nvPr/>
          </p:nvSpPr>
          <p:spPr>
            <a:xfrm>
              <a:off x="8111850" y="3733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9" name="Google Shape;69;p1"/>
            <p:cNvSpPr/>
            <p:nvPr/>
          </p:nvSpPr>
          <p:spPr>
            <a:xfrm>
              <a:off x="8188050" y="2209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0" name="Google Shape;70;p1"/>
            <p:cNvSpPr/>
            <p:nvPr/>
          </p:nvSpPr>
          <p:spPr>
            <a:xfrm>
              <a:off x="8721450" y="2971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1" name="Google Shape;71;p1"/>
            <p:cNvSpPr/>
            <p:nvPr/>
          </p:nvSpPr>
          <p:spPr>
            <a:xfrm>
              <a:off x="9102450" y="3733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2" name="Google Shape;72;p1"/>
            <p:cNvSpPr/>
            <p:nvPr/>
          </p:nvSpPr>
          <p:spPr>
            <a:xfrm>
              <a:off x="8035650" y="754325"/>
              <a:ext cx="18900" cy="18900"/>
            </a:xfrm>
            <a:prstGeom prst="ellipse">
              <a:avLst/>
            </a:prstGeom>
            <a:solidFill>
              <a:srgbClr val="FFFFFF">
                <a:alpha val="55310"/>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3" name="Google Shape;73;p1"/>
            <p:cNvSpPr/>
            <p:nvPr/>
          </p:nvSpPr>
          <p:spPr>
            <a:xfrm>
              <a:off x="6968850" y="1059125"/>
              <a:ext cx="18900" cy="18900"/>
            </a:xfrm>
            <a:prstGeom prst="ellipse">
              <a:avLst/>
            </a:prstGeom>
            <a:solidFill>
              <a:srgbClr val="FFFFFF">
                <a:alpha val="29049"/>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4" name="Google Shape;74;p1"/>
            <p:cNvSpPr/>
            <p:nvPr/>
          </p:nvSpPr>
          <p:spPr>
            <a:xfrm>
              <a:off x="6359250" y="1287725"/>
              <a:ext cx="18900" cy="18900"/>
            </a:xfrm>
            <a:prstGeom prst="ellipse">
              <a:avLst/>
            </a:prstGeom>
            <a:solidFill>
              <a:srgbClr val="FFFFFF">
                <a:alpha val="29049"/>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5" name="Google Shape;75;p1"/>
            <p:cNvSpPr/>
            <p:nvPr/>
          </p:nvSpPr>
          <p:spPr>
            <a:xfrm>
              <a:off x="6359250" y="449525"/>
              <a:ext cx="18900" cy="18900"/>
            </a:xfrm>
            <a:prstGeom prst="ellipse">
              <a:avLst/>
            </a:prstGeom>
            <a:solidFill>
              <a:srgbClr val="FFFFFF">
                <a:alpha val="29049"/>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6" name="Google Shape;76;p1"/>
            <p:cNvSpPr/>
            <p:nvPr/>
          </p:nvSpPr>
          <p:spPr>
            <a:xfrm>
              <a:off x="6054450" y="678125"/>
              <a:ext cx="18900" cy="18900"/>
            </a:xfrm>
            <a:prstGeom prst="ellipse">
              <a:avLst/>
            </a:prstGeom>
            <a:solidFill>
              <a:srgbClr val="FFFFFF">
                <a:alpha val="29049"/>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7" name="Google Shape;77;p1"/>
            <p:cNvSpPr/>
            <p:nvPr/>
          </p:nvSpPr>
          <p:spPr>
            <a:xfrm>
              <a:off x="5292450" y="830525"/>
              <a:ext cx="18900" cy="18900"/>
            </a:xfrm>
            <a:prstGeom prst="ellipse">
              <a:avLst/>
            </a:prstGeom>
            <a:solidFill>
              <a:srgbClr val="FFFFFF">
                <a:alpha val="29049"/>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8" name="Google Shape;78;p1"/>
            <p:cNvSpPr/>
            <p:nvPr/>
          </p:nvSpPr>
          <p:spPr>
            <a:xfrm>
              <a:off x="4835250" y="1287725"/>
              <a:ext cx="18900" cy="18900"/>
            </a:xfrm>
            <a:prstGeom prst="ellipse">
              <a:avLst/>
            </a:prstGeom>
            <a:solidFill>
              <a:srgbClr val="FFFFFF">
                <a:alpha val="29049"/>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9" name="Google Shape;79;p1"/>
            <p:cNvSpPr/>
            <p:nvPr/>
          </p:nvSpPr>
          <p:spPr>
            <a:xfrm>
              <a:off x="4987650" y="449525"/>
              <a:ext cx="18900" cy="18900"/>
            </a:xfrm>
            <a:prstGeom prst="ellipse">
              <a:avLst/>
            </a:prstGeom>
            <a:solidFill>
              <a:srgbClr val="FFFFFF">
                <a:alpha val="29049"/>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0" name="Google Shape;80;p1"/>
            <p:cNvSpPr/>
            <p:nvPr/>
          </p:nvSpPr>
          <p:spPr>
            <a:xfrm>
              <a:off x="4301850" y="601925"/>
              <a:ext cx="18900" cy="18900"/>
            </a:xfrm>
            <a:prstGeom prst="ellipse">
              <a:avLst/>
            </a:prstGeom>
            <a:solidFill>
              <a:srgbClr val="FFFFFF">
                <a:alpha val="29049"/>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1" name="Google Shape;81;p1"/>
            <p:cNvSpPr/>
            <p:nvPr/>
          </p:nvSpPr>
          <p:spPr>
            <a:xfrm>
              <a:off x="4682850" y="144725"/>
              <a:ext cx="18900" cy="18900"/>
            </a:xfrm>
            <a:prstGeom prst="ellipse">
              <a:avLst/>
            </a:prstGeom>
            <a:solidFill>
              <a:srgbClr val="FFFFFF">
                <a:alpha val="29049"/>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2" name="Google Shape;82;p1"/>
            <p:cNvSpPr/>
            <p:nvPr/>
          </p:nvSpPr>
          <p:spPr>
            <a:xfrm>
              <a:off x="2701650" y="297125"/>
              <a:ext cx="18900" cy="18900"/>
            </a:xfrm>
            <a:prstGeom prst="ellipse">
              <a:avLst/>
            </a:prstGeom>
            <a:solidFill>
              <a:srgbClr val="FFFFFF">
                <a:alpha val="29049"/>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3" name="Google Shape;83;p1"/>
            <p:cNvSpPr/>
            <p:nvPr/>
          </p:nvSpPr>
          <p:spPr>
            <a:xfrm>
              <a:off x="2854050" y="906725"/>
              <a:ext cx="18900" cy="18900"/>
            </a:xfrm>
            <a:prstGeom prst="ellipse">
              <a:avLst/>
            </a:prstGeom>
            <a:solidFill>
              <a:srgbClr val="FFFFFF">
                <a:alpha val="29049"/>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4" name="Google Shape;84;p1"/>
            <p:cNvSpPr/>
            <p:nvPr/>
          </p:nvSpPr>
          <p:spPr>
            <a:xfrm>
              <a:off x="3311250" y="1211525"/>
              <a:ext cx="18900" cy="18900"/>
            </a:xfrm>
            <a:prstGeom prst="ellipse">
              <a:avLst/>
            </a:prstGeom>
            <a:solidFill>
              <a:srgbClr val="FFFFFF">
                <a:alpha val="29049"/>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5" name="Google Shape;85;p1"/>
            <p:cNvSpPr/>
            <p:nvPr/>
          </p:nvSpPr>
          <p:spPr>
            <a:xfrm>
              <a:off x="3387450" y="144725"/>
              <a:ext cx="18900" cy="18900"/>
            </a:xfrm>
            <a:prstGeom prst="ellipse">
              <a:avLst/>
            </a:prstGeom>
            <a:solidFill>
              <a:srgbClr val="FFFFFF">
                <a:alpha val="29049"/>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6" name="Google Shape;86;p1"/>
            <p:cNvSpPr/>
            <p:nvPr/>
          </p:nvSpPr>
          <p:spPr>
            <a:xfrm>
              <a:off x="1863450" y="220925"/>
              <a:ext cx="18900" cy="18900"/>
            </a:xfrm>
            <a:prstGeom prst="ellipse">
              <a:avLst/>
            </a:prstGeom>
            <a:solidFill>
              <a:srgbClr val="FFFFFF">
                <a:alpha val="29049"/>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7" name="Google Shape;87;p1"/>
            <p:cNvSpPr/>
            <p:nvPr/>
          </p:nvSpPr>
          <p:spPr>
            <a:xfrm>
              <a:off x="2092050" y="982925"/>
              <a:ext cx="18900" cy="18900"/>
            </a:xfrm>
            <a:prstGeom prst="ellipse">
              <a:avLst/>
            </a:prstGeom>
            <a:solidFill>
              <a:srgbClr val="FFFFFF">
                <a:alpha val="29049"/>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8" name="Google Shape;88;p1"/>
            <p:cNvSpPr/>
            <p:nvPr/>
          </p:nvSpPr>
          <p:spPr>
            <a:xfrm>
              <a:off x="2549250" y="1744925"/>
              <a:ext cx="18900" cy="18900"/>
            </a:xfrm>
            <a:prstGeom prst="ellipse">
              <a:avLst/>
            </a:prstGeom>
            <a:solidFill>
              <a:srgbClr val="FFFFFF">
                <a:alpha val="29049"/>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9" name="Google Shape;89;p1"/>
            <p:cNvSpPr/>
            <p:nvPr/>
          </p:nvSpPr>
          <p:spPr>
            <a:xfrm>
              <a:off x="1634850" y="1440125"/>
              <a:ext cx="18900" cy="18900"/>
            </a:xfrm>
            <a:prstGeom prst="ellipse">
              <a:avLst/>
            </a:prstGeom>
            <a:solidFill>
              <a:srgbClr val="FFFFFF">
                <a:alpha val="29049"/>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0" name="Google Shape;90;p1"/>
            <p:cNvSpPr/>
            <p:nvPr/>
          </p:nvSpPr>
          <p:spPr>
            <a:xfrm>
              <a:off x="949050" y="1135325"/>
              <a:ext cx="18900" cy="18900"/>
            </a:xfrm>
            <a:prstGeom prst="ellipse">
              <a:avLst/>
            </a:prstGeom>
            <a:solidFill>
              <a:srgbClr val="FFFFFF">
                <a:alpha val="29049"/>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1" name="Google Shape;91;p1"/>
            <p:cNvSpPr/>
            <p:nvPr/>
          </p:nvSpPr>
          <p:spPr>
            <a:xfrm>
              <a:off x="720450" y="601925"/>
              <a:ext cx="18900" cy="18900"/>
            </a:xfrm>
            <a:prstGeom prst="ellipse">
              <a:avLst/>
            </a:prstGeom>
            <a:solidFill>
              <a:srgbClr val="FFFFFF">
                <a:alpha val="29049"/>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2" name="Google Shape;92;p1"/>
            <p:cNvSpPr/>
            <p:nvPr/>
          </p:nvSpPr>
          <p:spPr>
            <a:xfrm>
              <a:off x="491850" y="1287725"/>
              <a:ext cx="18900" cy="18900"/>
            </a:xfrm>
            <a:prstGeom prst="ellipse">
              <a:avLst/>
            </a:prstGeom>
            <a:solidFill>
              <a:srgbClr val="FFFFFF">
                <a:alpha val="29049"/>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3" name="Google Shape;93;p1"/>
            <p:cNvSpPr/>
            <p:nvPr/>
          </p:nvSpPr>
          <p:spPr>
            <a:xfrm>
              <a:off x="796650" y="1592525"/>
              <a:ext cx="18900" cy="18900"/>
            </a:xfrm>
            <a:prstGeom prst="ellipse">
              <a:avLst/>
            </a:prstGeom>
            <a:solidFill>
              <a:srgbClr val="FFFFFF">
                <a:alpha val="29049"/>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4" name="Google Shape;94;p1"/>
            <p:cNvSpPr/>
            <p:nvPr/>
          </p:nvSpPr>
          <p:spPr>
            <a:xfrm>
              <a:off x="110850" y="1592525"/>
              <a:ext cx="18900" cy="18900"/>
            </a:xfrm>
            <a:prstGeom prst="ellipse">
              <a:avLst/>
            </a:prstGeom>
            <a:solidFill>
              <a:srgbClr val="FFFFFF">
                <a:alpha val="29049"/>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95" name="Google Shape;95;p1"/>
          <p:cNvSpPr/>
          <p:nvPr/>
        </p:nvSpPr>
        <p:spPr>
          <a:xfrm>
            <a:off x="-25" y="3000500"/>
            <a:ext cx="9144047" cy="2139958"/>
          </a:xfrm>
          <a:custGeom>
            <a:avLst/>
            <a:gdLst/>
            <a:ahLst/>
            <a:cxnLst/>
            <a:rect l="l" t="t" r="r" b="b"/>
            <a:pathLst>
              <a:path w="12192063" h="2641923" extrusionOk="0">
                <a:moveTo>
                  <a:pt x="12192063" y="451106"/>
                </a:moveTo>
                <a:lnTo>
                  <a:pt x="12192063" y="441541"/>
                </a:lnTo>
                <a:cubicBezTo>
                  <a:pt x="11982259" y="421143"/>
                  <a:pt x="11772456" y="403152"/>
                  <a:pt x="11562715" y="387568"/>
                </a:cubicBezTo>
                <a:cubicBezTo>
                  <a:pt x="11768709" y="376419"/>
                  <a:pt x="11977433" y="370232"/>
                  <a:pt x="12188888" y="369007"/>
                </a:cubicBezTo>
                <a:lnTo>
                  <a:pt x="12188888" y="359505"/>
                </a:lnTo>
                <a:cubicBezTo>
                  <a:pt x="11952097" y="360815"/>
                  <a:pt x="11718671" y="368395"/>
                  <a:pt x="11488610" y="382247"/>
                </a:cubicBezTo>
                <a:cubicBezTo>
                  <a:pt x="10787126" y="331949"/>
                  <a:pt x="10087610" y="308426"/>
                  <a:pt x="9390062" y="311678"/>
                </a:cubicBezTo>
                <a:cubicBezTo>
                  <a:pt x="10252075" y="193091"/>
                  <a:pt x="11189398" y="152675"/>
                  <a:pt x="12188698" y="191317"/>
                </a:cubicBezTo>
                <a:lnTo>
                  <a:pt x="12189079" y="181815"/>
                </a:lnTo>
                <a:cubicBezTo>
                  <a:pt x="11161840" y="141716"/>
                  <a:pt x="10200005" y="185426"/>
                  <a:pt x="9318117" y="311741"/>
                </a:cubicBezTo>
                <a:cubicBezTo>
                  <a:pt x="8591868" y="317062"/>
                  <a:pt x="7870317" y="351460"/>
                  <a:pt x="7157212" y="415061"/>
                </a:cubicBezTo>
                <a:cubicBezTo>
                  <a:pt x="6968617" y="431954"/>
                  <a:pt x="6780594" y="450810"/>
                  <a:pt x="6593142" y="471631"/>
                </a:cubicBezTo>
                <a:cubicBezTo>
                  <a:pt x="7049707" y="331118"/>
                  <a:pt x="7514971" y="220531"/>
                  <a:pt x="7986014" y="140576"/>
                </a:cubicBezTo>
                <a:lnTo>
                  <a:pt x="7984363" y="131200"/>
                </a:lnTo>
                <a:cubicBezTo>
                  <a:pt x="7497001" y="213886"/>
                  <a:pt x="7015798" y="329444"/>
                  <a:pt x="6544057" y="477079"/>
                </a:cubicBezTo>
                <a:cubicBezTo>
                  <a:pt x="6349321" y="499208"/>
                  <a:pt x="6155074" y="523492"/>
                  <a:pt x="5961317" y="549929"/>
                </a:cubicBezTo>
                <a:cubicBezTo>
                  <a:pt x="5671376" y="508499"/>
                  <a:pt x="5379276" y="473405"/>
                  <a:pt x="5085017" y="444645"/>
                </a:cubicBezTo>
                <a:cubicBezTo>
                  <a:pt x="5051870" y="441414"/>
                  <a:pt x="5018596" y="438310"/>
                  <a:pt x="4985449" y="435333"/>
                </a:cubicBezTo>
                <a:cubicBezTo>
                  <a:pt x="5201984" y="366199"/>
                  <a:pt x="5422945" y="305554"/>
                  <a:pt x="5648325" y="253398"/>
                </a:cubicBezTo>
                <a:cubicBezTo>
                  <a:pt x="6088126" y="215389"/>
                  <a:pt x="6489573" y="203290"/>
                  <a:pt x="6848475" y="216720"/>
                </a:cubicBezTo>
                <a:lnTo>
                  <a:pt x="6848857" y="207217"/>
                </a:lnTo>
                <a:cubicBezTo>
                  <a:pt x="6508115" y="194548"/>
                  <a:pt x="6128957" y="204937"/>
                  <a:pt x="5715127" y="238258"/>
                </a:cubicBezTo>
                <a:cubicBezTo>
                  <a:pt x="5883701" y="200798"/>
                  <a:pt x="6054363" y="168259"/>
                  <a:pt x="6227128" y="140639"/>
                </a:cubicBezTo>
                <a:lnTo>
                  <a:pt x="6225604" y="131263"/>
                </a:lnTo>
                <a:cubicBezTo>
                  <a:pt x="6030233" y="162431"/>
                  <a:pt x="5837384" y="199996"/>
                  <a:pt x="5647055" y="243959"/>
                </a:cubicBezTo>
                <a:cubicBezTo>
                  <a:pt x="5329047" y="271368"/>
                  <a:pt x="4991481" y="311952"/>
                  <a:pt x="4634357" y="365713"/>
                </a:cubicBezTo>
                <a:cubicBezTo>
                  <a:pt x="4575093" y="374582"/>
                  <a:pt x="4515466" y="383852"/>
                  <a:pt x="4455478" y="393523"/>
                </a:cubicBezTo>
                <a:cubicBezTo>
                  <a:pt x="4140517" y="372703"/>
                  <a:pt x="3823481" y="359062"/>
                  <a:pt x="3504375" y="352600"/>
                </a:cubicBezTo>
                <a:cubicBezTo>
                  <a:pt x="3837305" y="244197"/>
                  <a:pt x="4176059" y="154461"/>
                  <a:pt x="4519041" y="83816"/>
                </a:cubicBezTo>
                <a:lnTo>
                  <a:pt x="4517136" y="74567"/>
                </a:lnTo>
                <a:cubicBezTo>
                  <a:pt x="4164851" y="147083"/>
                  <a:pt x="3817042" y="239745"/>
                  <a:pt x="3475419" y="352094"/>
                </a:cubicBezTo>
                <a:cubicBezTo>
                  <a:pt x="3181033" y="346519"/>
                  <a:pt x="2885142" y="347047"/>
                  <a:pt x="2587752" y="353677"/>
                </a:cubicBezTo>
                <a:cubicBezTo>
                  <a:pt x="2806256" y="318646"/>
                  <a:pt x="3033586" y="285072"/>
                  <a:pt x="3267773" y="254918"/>
                </a:cubicBezTo>
                <a:lnTo>
                  <a:pt x="3266504" y="245543"/>
                </a:lnTo>
                <a:cubicBezTo>
                  <a:pt x="3007487" y="279117"/>
                  <a:pt x="2756789" y="316365"/>
                  <a:pt x="2517204" y="355451"/>
                </a:cubicBezTo>
                <a:cubicBezTo>
                  <a:pt x="2220405" y="363053"/>
                  <a:pt x="1922399" y="376693"/>
                  <a:pt x="1623187" y="396374"/>
                </a:cubicBezTo>
                <a:cubicBezTo>
                  <a:pt x="1883759" y="305486"/>
                  <a:pt x="2148891" y="228161"/>
                  <a:pt x="2417509" y="164711"/>
                </a:cubicBezTo>
                <a:cubicBezTo>
                  <a:pt x="2903665" y="51255"/>
                  <a:pt x="3361436" y="-436"/>
                  <a:pt x="3778314" y="11093"/>
                </a:cubicBezTo>
                <a:lnTo>
                  <a:pt x="3778314" y="1591"/>
                </a:lnTo>
                <a:cubicBezTo>
                  <a:pt x="3360928" y="-10002"/>
                  <a:pt x="2902014" y="41816"/>
                  <a:pt x="2415350" y="155526"/>
                </a:cubicBezTo>
                <a:cubicBezTo>
                  <a:pt x="2135054" y="221849"/>
                  <a:pt x="1858537" y="303157"/>
                  <a:pt x="1586992" y="399098"/>
                </a:cubicBezTo>
                <a:cubicBezTo>
                  <a:pt x="1060704" y="434488"/>
                  <a:pt x="531728" y="488714"/>
                  <a:pt x="64" y="561775"/>
                </a:cubicBezTo>
                <a:lnTo>
                  <a:pt x="64" y="571340"/>
                </a:lnTo>
                <a:cubicBezTo>
                  <a:pt x="520086" y="499757"/>
                  <a:pt x="1037927" y="446207"/>
                  <a:pt x="1553591" y="410690"/>
                </a:cubicBezTo>
                <a:cubicBezTo>
                  <a:pt x="1498810" y="430159"/>
                  <a:pt x="1443780" y="450262"/>
                  <a:pt x="1388491" y="470997"/>
                </a:cubicBezTo>
                <a:cubicBezTo>
                  <a:pt x="928922" y="501658"/>
                  <a:pt x="466111" y="546698"/>
                  <a:pt x="64" y="606118"/>
                </a:cubicBezTo>
                <a:lnTo>
                  <a:pt x="64" y="615684"/>
                </a:lnTo>
                <a:cubicBezTo>
                  <a:pt x="455316" y="557615"/>
                  <a:pt x="907796" y="513271"/>
                  <a:pt x="1357503" y="482653"/>
                </a:cubicBezTo>
                <a:cubicBezTo>
                  <a:pt x="1305687" y="502375"/>
                  <a:pt x="1253725" y="522647"/>
                  <a:pt x="1201611" y="543467"/>
                </a:cubicBezTo>
                <a:lnTo>
                  <a:pt x="1184783" y="550245"/>
                </a:lnTo>
                <a:cubicBezTo>
                  <a:pt x="794004" y="572206"/>
                  <a:pt x="399098" y="603542"/>
                  <a:pt x="64" y="644253"/>
                </a:cubicBezTo>
                <a:lnTo>
                  <a:pt x="64" y="653755"/>
                </a:lnTo>
                <a:cubicBezTo>
                  <a:pt x="389530" y="613889"/>
                  <a:pt x="775316" y="583102"/>
                  <a:pt x="1157415" y="561395"/>
                </a:cubicBezTo>
                <a:cubicBezTo>
                  <a:pt x="1093534" y="587325"/>
                  <a:pt x="1031602" y="613213"/>
                  <a:pt x="971614" y="639059"/>
                </a:cubicBezTo>
                <a:cubicBezTo>
                  <a:pt x="651701" y="648308"/>
                  <a:pt x="327851" y="662751"/>
                  <a:pt x="64" y="682389"/>
                </a:cubicBezTo>
                <a:lnTo>
                  <a:pt x="64" y="691891"/>
                </a:lnTo>
                <a:cubicBezTo>
                  <a:pt x="319723" y="672677"/>
                  <a:pt x="635718" y="658443"/>
                  <a:pt x="948055" y="649194"/>
                </a:cubicBezTo>
                <a:cubicBezTo>
                  <a:pt x="924433" y="659457"/>
                  <a:pt x="901148" y="669656"/>
                  <a:pt x="878205" y="679791"/>
                </a:cubicBezTo>
                <a:cubicBezTo>
                  <a:pt x="336614" y="805980"/>
                  <a:pt x="8636" y="902522"/>
                  <a:pt x="1905" y="904486"/>
                </a:cubicBezTo>
                <a:lnTo>
                  <a:pt x="4572" y="913608"/>
                </a:lnTo>
                <a:cubicBezTo>
                  <a:pt x="10922" y="911644"/>
                  <a:pt x="319723" y="820930"/>
                  <a:pt x="831787" y="700379"/>
                </a:cubicBezTo>
                <a:cubicBezTo>
                  <a:pt x="599631" y="804523"/>
                  <a:pt x="405067" y="901888"/>
                  <a:pt x="262446" y="977019"/>
                </a:cubicBezTo>
                <a:cubicBezTo>
                  <a:pt x="175154" y="972667"/>
                  <a:pt x="87694" y="968891"/>
                  <a:pt x="64" y="965680"/>
                </a:cubicBezTo>
                <a:lnTo>
                  <a:pt x="64" y="975182"/>
                </a:lnTo>
                <a:cubicBezTo>
                  <a:pt x="82190" y="978305"/>
                  <a:pt x="164168" y="981814"/>
                  <a:pt x="245999" y="985698"/>
                </a:cubicBezTo>
                <a:cubicBezTo>
                  <a:pt x="197612" y="1011353"/>
                  <a:pt x="155639" y="1034159"/>
                  <a:pt x="120650" y="1053480"/>
                </a:cubicBezTo>
                <a:cubicBezTo>
                  <a:pt x="80518" y="1051244"/>
                  <a:pt x="40301" y="1049128"/>
                  <a:pt x="0" y="1047145"/>
                </a:cubicBezTo>
                <a:lnTo>
                  <a:pt x="0" y="1056647"/>
                </a:lnTo>
                <a:cubicBezTo>
                  <a:pt x="35052" y="1058376"/>
                  <a:pt x="70041" y="1060195"/>
                  <a:pt x="104966" y="1062095"/>
                </a:cubicBezTo>
                <a:cubicBezTo>
                  <a:pt x="45593" y="1095099"/>
                  <a:pt x="9716" y="1116447"/>
                  <a:pt x="0" y="1122022"/>
                </a:cubicBezTo>
                <a:lnTo>
                  <a:pt x="0" y="1127596"/>
                </a:lnTo>
                <a:lnTo>
                  <a:pt x="2477" y="1131651"/>
                </a:lnTo>
                <a:cubicBezTo>
                  <a:pt x="3874" y="1130827"/>
                  <a:pt x="46228" y="1105488"/>
                  <a:pt x="123126" y="1063109"/>
                </a:cubicBezTo>
                <a:cubicBezTo>
                  <a:pt x="467254" y="1082195"/>
                  <a:pt x="808038" y="1109859"/>
                  <a:pt x="1145477" y="1146094"/>
                </a:cubicBezTo>
                <a:cubicBezTo>
                  <a:pt x="1051370" y="1172827"/>
                  <a:pt x="961943" y="1198609"/>
                  <a:pt x="877189" y="1223442"/>
                </a:cubicBezTo>
                <a:cubicBezTo>
                  <a:pt x="588772" y="1193035"/>
                  <a:pt x="296397" y="1168753"/>
                  <a:pt x="64" y="1150592"/>
                </a:cubicBezTo>
                <a:lnTo>
                  <a:pt x="64" y="1159967"/>
                </a:lnTo>
                <a:cubicBezTo>
                  <a:pt x="287930" y="1177749"/>
                  <a:pt x="572114" y="1201270"/>
                  <a:pt x="852614" y="1230537"/>
                </a:cubicBezTo>
                <a:cubicBezTo>
                  <a:pt x="711264" y="1272029"/>
                  <a:pt x="584264" y="1310291"/>
                  <a:pt x="474155" y="1343992"/>
                </a:cubicBezTo>
                <a:cubicBezTo>
                  <a:pt x="429916" y="1339431"/>
                  <a:pt x="385466" y="1334997"/>
                  <a:pt x="340805" y="1330689"/>
                </a:cubicBezTo>
                <a:cubicBezTo>
                  <a:pt x="227944" y="1294879"/>
                  <a:pt x="114364" y="1260183"/>
                  <a:pt x="64" y="1226609"/>
                </a:cubicBezTo>
                <a:lnTo>
                  <a:pt x="64" y="1236428"/>
                </a:lnTo>
                <a:cubicBezTo>
                  <a:pt x="98997" y="1265612"/>
                  <a:pt x="197464" y="1295550"/>
                  <a:pt x="295466" y="1326255"/>
                </a:cubicBezTo>
                <a:cubicBezTo>
                  <a:pt x="197591" y="1316924"/>
                  <a:pt x="99124" y="1308264"/>
                  <a:pt x="64" y="1300282"/>
                </a:cubicBezTo>
                <a:lnTo>
                  <a:pt x="64" y="1309721"/>
                </a:lnTo>
                <a:cubicBezTo>
                  <a:pt x="113856" y="1319014"/>
                  <a:pt x="226865" y="1329106"/>
                  <a:pt x="339090" y="1340001"/>
                </a:cubicBezTo>
                <a:cubicBezTo>
                  <a:pt x="363347" y="1347730"/>
                  <a:pt x="387541" y="1355395"/>
                  <a:pt x="411734" y="1363187"/>
                </a:cubicBezTo>
                <a:cubicBezTo>
                  <a:pt x="308356" y="1394861"/>
                  <a:pt x="222441" y="1422227"/>
                  <a:pt x="156401" y="1443385"/>
                </a:cubicBezTo>
                <a:cubicBezTo>
                  <a:pt x="104458" y="1425901"/>
                  <a:pt x="52345" y="1408689"/>
                  <a:pt x="64" y="1391756"/>
                </a:cubicBezTo>
                <a:lnTo>
                  <a:pt x="64" y="1401765"/>
                </a:lnTo>
                <a:cubicBezTo>
                  <a:pt x="47181" y="1417096"/>
                  <a:pt x="94191" y="1432597"/>
                  <a:pt x="141097" y="1448263"/>
                </a:cubicBezTo>
                <a:cubicBezTo>
                  <a:pt x="52642" y="1476642"/>
                  <a:pt x="3937" y="1492606"/>
                  <a:pt x="1714" y="1493683"/>
                </a:cubicBezTo>
                <a:lnTo>
                  <a:pt x="4763" y="1502678"/>
                </a:lnTo>
                <a:cubicBezTo>
                  <a:pt x="7049" y="1501918"/>
                  <a:pt x="60198" y="1484181"/>
                  <a:pt x="156337" y="1453394"/>
                </a:cubicBezTo>
                <a:cubicBezTo>
                  <a:pt x="233002" y="1479157"/>
                  <a:pt x="309202" y="1505466"/>
                  <a:pt x="384937" y="1532325"/>
                </a:cubicBezTo>
                <a:cubicBezTo>
                  <a:pt x="574421" y="1599303"/>
                  <a:pt x="754634" y="1666876"/>
                  <a:pt x="925576" y="1735038"/>
                </a:cubicBezTo>
                <a:cubicBezTo>
                  <a:pt x="871601" y="1779888"/>
                  <a:pt x="820312" y="1823896"/>
                  <a:pt x="771716" y="1867055"/>
                </a:cubicBezTo>
                <a:cubicBezTo>
                  <a:pt x="566230" y="1779508"/>
                  <a:pt x="342964" y="1690758"/>
                  <a:pt x="102362" y="1603338"/>
                </a:cubicBezTo>
                <a:cubicBezTo>
                  <a:pt x="68390" y="1590985"/>
                  <a:pt x="34227" y="1578886"/>
                  <a:pt x="64" y="1566723"/>
                </a:cubicBezTo>
                <a:lnTo>
                  <a:pt x="64" y="1576859"/>
                </a:lnTo>
                <a:cubicBezTo>
                  <a:pt x="32957" y="1588514"/>
                  <a:pt x="65850" y="1600171"/>
                  <a:pt x="98489" y="1612017"/>
                </a:cubicBezTo>
                <a:cubicBezTo>
                  <a:pt x="337693" y="1698930"/>
                  <a:pt x="559499" y="1787046"/>
                  <a:pt x="763842" y="1874086"/>
                </a:cubicBezTo>
                <a:lnTo>
                  <a:pt x="751777" y="1884792"/>
                </a:lnTo>
                <a:cubicBezTo>
                  <a:pt x="659702" y="1922123"/>
                  <a:pt x="575670" y="1957116"/>
                  <a:pt x="499682" y="1989759"/>
                </a:cubicBezTo>
                <a:cubicBezTo>
                  <a:pt x="345504" y="1923307"/>
                  <a:pt x="178943" y="1855652"/>
                  <a:pt x="64" y="1787996"/>
                </a:cubicBezTo>
                <a:lnTo>
                  <a:pt x="64" y="1798132"/>
                </a:lnTo>
                <a:cubicBezTo>
                  <a:pt x="174371" y="1864077"/>
                  <a:pt x="336614" y="1930085"/>
                  <a:pt x="487617" y="1994954"/>
                </a:cubicBezTo>
                <a:cubicBezTo>
                  <a:pt x="198374" y="2119115"/>
                  <a:pt x="31306" y="2203621"/>
                  <a:pt x="64" y="2219711"/>
                </a:cubicBezTo>
                <a:lnTo>
                  <a:pt x="64" y="2230417"/>
                </a:lnTo>
                <a:cubicBezTo>
                  <a:pt x="14034" y="2223132"/>
                  <a:pt x="186182" y="2134445"/>
                  <a:pt x="499618" y="2000085"/>
                </a:cubicBezTo>
                <a:cubicBezTo>
                  <a:pt x="528998" y="2012754"/>
                  <a:pt x="557932" y="2025424"/>
                  <a:pt x="586423" y="2038093"/>
                </a:cubicBezTo>
                <a:cubicBezTo>
                  <a:pt x="227203" y="2383465"/>
                  <a:pt x="58738" y="2632485"/>
                  <a:pt x="56452" y="2635906"/>
                </a:cubicBezTo>
                <a:lnTo>
                  <a:pt x="64326" y="2641227"/>
                </a:lnTo>
                <a:cubicBezTo>
                  <a:pt x="65151" y="2640023"/>
                  <a:pt x="145606" y="2520359"/>
                  <a:pt x="312420" y="2334181"/>
                </a:cubicBezTo>
                <a:cubicBezTo>
                  <a:pt x="383794" y="2254616"/>
                  <a:pt x="478219" y="2154907"/>
                  <a:pt x="595694" y="2042211"/>
                </a:cubicBezTo>
                <a:cubicBezTo>
                  <a:pt x="876999" y="2166816"/>
                  <a:pt x="1114362" y="2286226"/>
                  <a:pt x="1308608" y="2392207"/>
                </a:cubicBezTo>
                <a:cubicBezTo>
                  <a:pt x="1021461" y="2538350"/>
                  <a:pt x="872553" y="2633372"/>
                  <a:pt x="870458" y="2634576"/>
                </a:cubicBezTo>
                <a:lnTo>
                  <a:pt x="875094" y="2641734"/>
                </a:lnTo>
                <a:lnTo>
                  <a:pt x="876935" y="2641734"/>
                </a:lnTo>
                <a:cubicBezTo>
                  <a:pt x="891731" y="2632358"/>
                  <a:pt x="1041464" y="2538477"/>
                  <a:pt x="1318578" y="2397718"/>
                </a:cubicBezTo>
                <a:cubicBezTo>
                  <a:pt x="1428433" y="2457899"/>
                  <a:pt x="1524064" y="2513328"/>
                  <a:pt x="1606233" y="2563056"/>
                </a:cubicBezTo>
                <a:cubicBezTo>
                  <a:pt x="1627949" y="2576232"/>
                  <a:pt x="1648905" y="2589092"/>
                  <a:pt x="1669288" y="2601761"/>
                </a:cubicBezTo>
                <a:cubicBezTo>
                  <a:pt x="1652968" y="2623109"/>
                  <a:pt x="1644523" y="2634956"/>
                  <a:pt x="1643888" y="2635716"/>
                </a:cubicBezTo>
                <a:lnTo>
                  <a:pt x="1651635" y="2641164"/>
                </a:lnTo>
                <a:cubicBezTo>
                  <a:pt x="1651953" y="2640784"/>
                  <a:pt x="1660462" y="2628494"/>
                  <a:pt x="1677035" y="2606829"/>
                </a:cubicBezTo>
                <a:cubicBezTo>
                  <a:pt x="1696041" y="2618694"/>
                  <a:pt x="1714417" y="2630287"/>
                  <a:pt x="1732153" y="2641607"/>
                </a:cubicBezTo>
                <a:lnTo>
                  <a:pt x="1749806" y="2641607"/>
                </a:lnTo>
                <a:cubicBezTo>
                  <a:pt x="1728280" y="2627797"/>
                  <a:pt x="1706055" y="2613734"/>
                  <a:pt x="1682877" y="2599227"/>
                </a:cubicBezTo>
                <a:cubicBezTo>
                  <a:pt x="1714056" y="2558685"/>
                  <a:pt x="1768729" y="2490460"/>
                  <a:pt x="1847024" y="2402279"/>
                </a:cubicBezTo>
                <a:cubicBezTo>
                  <a:pt x="1929530" y="2448441"/>
                  <a:pt x="2004358" y="2491707"/>
                  <a:pt x="2071497" y="2532079"/>
                </a:cubicBezTo>
                <a:cubicBezTo>
                  <a:pt x="2135632" y="2570385"/>
                  <a:pt x="2194897" y="2606892"/>
                  <a:pt x="2249297" y="2641607"/>
                </a:cubicBezTo>
                <a:lnTo>
                  <a:pt x="2267014" y="2641607"/>
                </a:lnTo>
                <a:cubicBezTo>
                  <a:pt x="2209102" y="2604739"/>
                  <a:pt x="2145602" y="2565590"/>
                  <a:pt x="2076514" y="2524160"/>
                </a:cubicBezTo>
                <a:cubicBezTo>
                  <a:pt x="2009712" y="2484188"/>
                  <a:pt x="1935226" y="2440922"/>
                  <a:pt x="1853184" y="2395058"/>
                </a:cubicBezTo>
                <a:cubicBezTo>
                  <a:pt x="1873841" y="2371873"/>
                  <a:pt x="1896091" y="2347420"/>
                  <a:pt x="1919923" y="2321701"/>
                </a:cubicBezTo>
                <a:cubicBezTo>
                  <a:pt x="1948688" y="2290787"/>
                  <a:pt x="1980946" y="2256896"/>
                  <a:pt x="2016506" y="2220345"/>
                </a:cubicBezTo>
                <a:cubicBezTo>
                  <a:pt x="2233676" y="2328543"/>
                  <a:pt x="2418906" y="2428442"/>
                  <a:pt x="2570353" y="2514278"/>
                </a:cubicBezTo>
                <a:cubicBezTo>
                  <a:pt x="2589530" y="2525174"/>
                  <a:pt x="2608371" y="2535943"/>
                  <a:pt x="2626868" y="2546586"/>
                </a:cubicBezTo>
                <a:cubicBezTo>
                  <a:pt x="2520569" y="2601191"/>
                  <a:pt x="2465197" y="2633435"/>
                  <a:pt x="2464054" y="2634069"/>
                </a:cubicBezTo>
                <a:lnTo>
                  <a:pt x="2468309" y="2641354"/>
                </a:lnTo>
                <a:lnTo>
                  <a:pt x="2470468" y="2641354"/>
                </a:lnTo>
                <a:cubicBezTo>
                  <a:pt x="2480056" y="2635842"/>
                  <a:pt x="2536190" y="2603725"/>
                  <a:pt x="2636647" y="2552224"/>
                </a:cubicBezTo>
                <a:cubicBezTo>
                  <a:pt x="2690794" y="2583308"/>
                  <a:pt x="2741467" y="2613101"/>
                  <a:pt x="2788666" y="2641607"/>
                </a:cubicBezTo>
                <a:lnTo>
                  <a:pt x="2807081" y="2641607"/>
                </a:lnTo>
                <a:cubicBezTo>
                  <a:pt x="2757380" y="2611580"/>
                  <a:pt x="2704129" y="2580160"/>
                  <a:pt x="2647315" y="2547346"/>
                </a:cubicBezTo>
                <a:cubicBezTo>
                  <a:pt x="2720086" y="2510161"/>
                  <a:pt x="2814701" y="2463537"/>
                  <a:pt x="2930398" y="2410008"/>
                </a:cubicBezTo>
                <a:cubicBezTo>
                  <a:pt x="2991993" y="2442486"/>
                  <a:pt x="3049778" y="2473546"/>
                  <a:pt x="3103753" y="2503192"/>
                </a:cubicBezTo>
                <a:cubicBezTo>
                  <a:pt x="3132709" y="2519112"/>
                  <a:pt x="3160903" y="2534721"/>
                  <a:pt x="3188335" y="2550006"/>
                </a:cubicBezTo>
                <a:cubicBezTo>
                  <a:pt x="3145346" y="2603915"/>
                  <a:pt x="3124264" y="2634576"/>
                  <a:pt x="3123502" y="2635779"/>
                </a:cubicBezTo>
                <a:lnTo>
                  <a:pt x="3131376" y="2641100"/>
                </a:lnTo>
                <a:cubicBezTo>
                  <a:pt x="3131820" y="2640467"/>
                  <a:pt x="3153029" y="2609427"/>
                  <a:pt x="3196590" y="2554631"/>
                </a:cubicBezTo>
                <a:cubicBezTo>
                  <a:pt x="3250394" y="2584784"/>
                  <a:pt x="3301194" y="2613778"/>
                  <a:pt x="3348990" y="2641607"/>
                </a:cubicBezTo>
                <a:lnTo>
                  <a:pt x="3368040" y="2641607"/>
                </a:lnTo>
                <a:cubicBezTo>
                  <a:pt x="3316478" y="2611536"/>
                  <a:pt x="3261443" y="2580033"/>
                  <a:pt x="3202940" y="2547092"/>
                </a:cubicBezTo>
                <a:cubicBezTo>
                  <a:pt x="3244850" y="2494894"/>
                  <a:pt x="3305747" y="2422994"/>
                  <a:pt x="3387090" y="2336778"/>
                </a:cubicBezTo>
                <a:cubicBezTo>
                  <a:pt x="3442907" y="2277484"/>
                  <a:pt x="3512693" y="2206915"/>
                  <a:pt x="3596640" y="2128174"/>
                </a:cubicBezTo>
                <a:cubicBezTo>
                  <a:pt x="3686810" y="2093161"/>
                  <a:pt x="3783184" y="2056971"/>
                  <a:pt x="3885756" y="2019596"/>
                </a:cubicBezTo>
                <a:cubicBezTo>
                  <a:pt x="4023887" y="2061830"/>
                  <a:pt x="4159714" y="2105812"/>
                  <a:pt x="4293235" y="2151549"/>
                </a:cubicBezTo>
                <a:cubicBezTo>
                  <a:pt x="4470610" y="2212192"/>
                  <a:pt x="4636815" y="2273006"/>
                  <a:pt x="4791837" y="2333991"/>
                </a:cubicBezTo>
                <a:cubicBezTo>
                  <a:pt x="4778502" y="2348624"/>
                  <a:pt x="4765866" y="2362814"/>
                  <a:pt x="4753737" y="2376560"/>
                </a:cubicBezTo>
                <a:lnTo>
                  <a:pt x="4745673" y="2379728"/>
                </a:lnTo>
                <a:cubicBezTo>
                  <a:pt x="4369372" y="2528278"/>
                  <a:pt x="4162870" y="2633119"/>
                  <a:pt x="4160838" y="2634195"/>
                </a:cubicBezTo>
                <a:lnTo>
                  <a:pt x="4164648" y="2641607"/>
                </a:lnTo>
                <a:lnTo>
                  <a:pt x="4167251" y="2641607"/>
                </a:lnTo>
                <a:cubicBezTo>
                  <a:pt x="4189095" y="2630648"/>
                  <a:pt x="4389501" y="2530875"/>
                  <a:pt x="4740085" y="2392207"/>
                </a:cubicBezTo>
                <a:cubicBezTo>
                  <a:pt x="4610164" y="2540947"/>
                  <a:pt x="4553014" y="2634766"/>
                  <a:pt x="4552125" y="2635969"/>
                </a:cubicBezTo>
                <a:lnTo>
                  <a:pt x="4560253" y="2640910"/>
                </a:lnTo>
                <a:cubicBezTo>
                  <a:pt x="4561015" y="2639643"/>
                  <a:pt x="4621657" y="2540631"/>
                  <a:pt x="4758817" y="2384542"/>
                </a:cubicBezTo>
                <a:cubicBezTo>
                  <a:pt x="4784598" y="2374406"/>
                  <a:pt x="4811567" y="2363846"/>
                  <a:pt x="4839716" y="2352868"/>
                </a:cubicBezTo>
                <a:cubicBezTo>
                  <a:pt x="5090097" y="2452197"/>
                  <a:pt x="5310632" y="2549816"/>
                  <a:pt x="5502021" y="2641417"/>
                </a:cubicBezTo>
                <a:lnTo>
                  <a:pt x="5523992" y="2641417"/>
                </a:lnTo>
                <a:cubicBezTo>
                  <a:pt x="5330762" y="2548423"/>
                  <a:pt x="5107242" y="2449030"/>
                  <a:pt x="4852797" y="2347864"/>
                </a:cubicBezTo>
                <a:cubicBezTo>
                  <a:pt x="4939729" y="2314543"/>
                  <a:pt x="5037519" y="2278181"/>
                  <a:pt x="5145278" y="2240173"/>
                </a:cubicBezTo>
                <a:cubicBezTo>
                  <a:pt x="5467604" y="2368008"/>
                  <a:pt x="5748528" y="2494640"/>
                  <a:pt x="5987796" y="2611644"/>
                </a:cubicBezTo>
                <a:cubicBezTo>
                  <a:pt x="5975096" y="2626910"/>
                  <a:pt x="5968746" y="2635272"/>
                  <a:pt x="5968429" y="2635652"/>
                </a:cubicBezTo>
                <a:lnTo>
                  <a:pt x="5976049" y="2641354"/>
                </a:lnTo>
                <a:cubicBezTo>
                  <a:pt x="5976049" y="2641037"/>
                  <a:pt x="5983097" y="2632168"/>
                  <a:pt x="5996559" y="2616015"/>
                </a:cubicBezTo>
                <a:lnTo>
                  <a:pt x="6033707" y="2634322"/>
                </a:lnTo>
                <a:lnTo>
                  <a:pt x="6037263" y="2641734"/>
                </a:lnTo>
                <a:lnTo>
                  <a:pt x="6040184" y="2641734"/>
                </a:lnTo>
                <a:lnTo>
                  <a:pt x="6044565" y="2639707"/>
                </a:lnTo>
                <a:lnTo>
                  <a:pt x="6048629" y="2641734"/>
                </a:lnTo>
                <a:lnTo>
                  <a:pt x="6069902" y="2641734"/>
                </a:lnTo>
                <a:lnTo>
                  <a:pt x="6055614" y="2634576"/>
                </a:lnTo>
                <a:cubicBezTo>
                  <a:pt x="6117400" y="2606259"/>
                  <a:pt x="6209411" y="2567807"/>
                  <a:pt x="6328093" y="2522767"/>
                </a:cubicBezTo>
                <a:cubicBezTo>
                  <a:pt x="6416612" y="2563480"/>
                  <a:pt x="6500495" y="2603136"/>
                  <a:pt x="6579807" y="2641734"/>
                </a:cubicBezTo>
                <a:lnTo>
                  <a:pt x="6601524" y="2641734"/>
                </a:lnTo>
                <a:cubicBezTo>
                  <a:pt x="6519482" y="2601742"/>
                  <a:pt x="6432487" y="2560522"/>
                  <a:pt x="6340539" y="2518079"/>
                </a:cubicBezTo>
                <a:cubicBezTo>
                  <a:pt x="6426391" y="2485708"/>
                  <a:pt x="6525705" y="2450107"/>
                  <a:pt x="6637211" y="2412542"/>
                </a:cubicBezTo>
                <a:cubicBezTo>
                  <a:pt x="6821805" y="2492170"/>
                  <a:pt x="6990398" y="2569201"/>
                  <a:pt x="7142353" y="2641734"/>
                </a:cubicBezTo>
                <a:lnTo>
                  <a:pt x="7164388" y="2641734"/>
                </a:lnTo>
                <a:cubicBezTo>
                  <a:pt x="7010337" y="2567934"/>
                  <a:pt x="6838887" y="2489319"/>
                  <a:pt x="6650673" y="2407981"/>
                </a:cubicBezTo>
                <a:cubicBezTo>
                  <a:pt x="6927342" y="2315240"/>
                  <a:pt x="7277545" y="2210843"/>
                  <a:pt x="7682611" y="2114174"/>
                </a:cubicBezTo>
                <a:cubicBezTo>
                  <a:pt x="7880732" y="2066834"/>
                  <a:pt x="8082280" y="2023441"/>
                  <a:pt x="8287321" y="1983994"/>
                </a:cubicBezTo>
                <a:cubicBezTo>
                  <a:pt x="7784592" y="2341592"/>
                  <a:pt x="7471855" y="2630965"/>
                  <a:pt x="7467664" y="2635272"/>
                </a:cubicBezTo>
                <a:lnTo>
                  <a:pt x="7474014" y="2641924"/>
                </a:lnTo>
                <a:lnTo>
                  <a:pt x="7474585" y="2641924"/>
                </a:lnTo>
                <a:cubicBezTo>
                  <a:pt x="7486206" y="2631155"/>
                  <a:pt x="7803960" y="2338488"/>
                  <a:pt x="8309991" y="1979940"/>
                </a:cubicBezTo>
                <a:cubicBezTo>
                  <a:pt x="8517636" y="1940284"/>
                  <a:pt x="8728202" y="1904702"/>
                  <a:pt x="8941753" y="1873199"/>
                </a:cubicBezTo>
                <a:cubicBezTo>
                  <a:pt x="9204706" y="1987732"/>
                  <a:pt x="9423336" y="2096056"/>
                  <a:pt x="9598216" y="2189938"/>
                </a:cubicBezTo>
                <a:cubicBezTo>
                  <a:pt x="9326880" y="2387139"/>
                  <a:pt x="9130220" y="2557355"/>
                  <a:pt x="9048877" y="2635462"/>
                </a:cubicBezTo>
                <a:lnTo>
                  <a:pt x="9055227" y="2641797"/>
                </a:lnTo>
                <a:lnTo>
                  <a:pt x="9055735" y="2641797"/>
                </a:lnTo>
                <a:cubicBezTo>
                  <a:pt x="9137523" y="2563119"/>
                  <a:pt x="9335135" y="2392461"/>
                  <a:pt x="9607550" y="2194689"/>
                </a:cubicBezTo>
                <a:cubicBezTo>
                  <a:pt x="9659493" y="2222606"/>
                  <a:pt x="9707562" y="2249168"/>
                  <a:pt x="9751695" y="2274380"/>
                </a:cubicBezTo>
                <a:cubicBezTo>
                  <a:pt x="10121202" y="2484441"/>
                  <a:pt x="10301795" y="2633119"/>
                  <a:pt x="10312209" y="2641797"/>
                </a:cubicBezTo>
                <a:lnTo>
                  <a:pt x="10313162" y="2641797"/>
                </a:lnTo>
                <a:lnTo>
                  <a:pt x="10318877" y="2635019"/>
                </a:lnTo>
                <a:cubicBezTo>
                  <a:pt x="10317099" y="2633499"/>
                  <a:pt x="10136378" y="2482161"/>
                  <a:pt x="9756902" y="2266398"/>
                </a:cubicBezTo>
                <a:cubicBezTo>
                  <a:pt x="9713722" y="2241820"/>
                  <a:pt x="9666795" y="2215847"/>
                  <a:pt x="9616059" y="2188481"/>
                </a:cubicBezTo>
                <a:cubicBezTo>
                  <a:pt x="9686417" y="2137803"/>
                  <a:pt x="9761665" y="2084971"/>
                  <a:pt x="9841103" y="2031695"/>
                </a:cubicBezTo>
                <a:cubicBezTo>
                  <a:pt x="9984867" y="2103722"/>
                  <a:pt x="10110025" y="2170744"/>
                  <a:pt x="10216134" y="2230164"/>
                </a:cubicBezTo>
                <a:cubicBezTo>
                  <a:pt x="10501503" y="2390053"/>
                  <a:pt x="10693781" y="2519663"/>
                  <a:pt x="10792778" y="2590295"/>
                </a:cubicBezTo>
                <a:cubicBezTo>
                  <a:pt x="10765219" y="2618675"/>
                  <a:pt x="10750804" y="2635019"/>
                  <a:pt x="10750359" y="2635526"/>
                </a:cubicBezTo>
                <a:lnTo>
                  <a:pt x="10757598" y="2641861"/>
                </a:lnTo>
                <a:cubicBezTo>
                  <a:pt x="10757980" y="2641417"/>
                  <a:pt x="10772584" y="2624757"/>
                  <a:pt x="10800588" y="2595997"/>
                </a:cubicBezTo>
                <a:cubicBezTo>
                  <a:pt x="10831258" y="2617978"/>
                  <a:pt x="10851959" y="2633625"/>
                  <a:pt x="10862818" y="2641924"/>
                </a:cubicBezTo>
                <a:lnTo>
                  <a:pt x="10877169" y="2641924"/>
                </a:lnTo>
                <a:lnTo>
                  <a:pt x="10877613" y="2641354"/>
                </a:lnTo>
                <a:cubicBezTo>
                  <a:pt x="10876915" y="2640847"/>
                  <a:pt x="10853357" y="2622349"/>
                  <a:pt x="10807319" y="2589155"/>
                </a:cubicBezTo>
                <a:cubicBezTo>
                  <a:pt x="10853420" y="2542151"/>
                  <a:pt x="10931081" y="2467147"/>
                  <a:pt x="11037824" y="2377700"/>
                </a:cubicBezTo>
                <a:cubicBezTo>
                  <a:pt x="11279569" y="2517889"/>
                  <a:pt x="11421808" y="2615825"/>
                  <a:pt x="11458893" y="2641924"/>
                </a:cubicBezTo>
                <a:lnTo>
                  <a:pt x="11473879" y="2641924"/>
                </a:lnTo>
                <a:lnTo>
                  <a:pt x="11474323" y="2641227"/>
                </a:lnTo>
                <a:cubicBezTo>
                  <a:pt x="11472418" y="2639833"/>
                  <a:pt x="11326432" y="2534169"/>
                  <a:pt x="11045634" y="2371239"/>
                </a:cubicBezTo>
                <a:cubicBezTo>
                  <a:pt x="11071860" y="2349403"/>
                  <a:pt x="11099736" y="2326788"/>
                  <a:pt x="11129391" y="2303394"/>
                </a:cubicBezTo>
                <a:cubicBezTo>
                  <a:pt x="11174285" y="2268109"/>
                  <a:pt x="11225022" y="2229910"/>
                  <a:pt x="11281283" y="2189875"/>
                </a:cubicBezTo>
                <a:cubicBezTo>
                  <a:pt x="11775567" y="2444912"/>
                  <a:pt x="12045632" y="2628874"/>
                  <a:pt x="12064619" y="2641924"/>
                </a:cubicBezTo>
                <a:lnTo>
                  <a:pt x="12066207" y="2641924"/>
                </a:lnTo>
                <a:lnTo>
                  <a:pt x="12071159" y="2634892"/>
                </a:lnTo>
                <a:cubicBezTo>
                  <a:pt x="12068429" y="2632992"/>
                  <a:pt x="11798109" y="2446179"/>
                  <a:pt x="11290109" y="2183666"/>
                </a:cubicBezTo>
                <a:cubicBezTo>
                  <a:pt x="11556111" y="1995106"/>
                  <a:pt x="11843448" y="1838383"/>
                  <a:pt x="12146153" y="1716730"/>
                </a:cubicBezTo>
                <a:lnTo>
                  <a:pt x="12188634" y="1718631"/>
                </a:lnTo>
                <a:lnTo>
                  <a:pt x="12189143" y="1709128"/>
                </a:lnTo>
                <a:lnTo>
                  <a:pt x="12167933" y="1708178"/>
                </a:lnTo>
                <a:cubicBezTo>
                  <a:pt x="12175490" y="1705264"/>
                  <a:pt x="12182983" y="1702224"/>
                  <a:pt x="12190603" y="1699310"/>
                </a:cubicBezTo>
                <a:lnTo>
                  <a:pt x="12187174" y="1690441"/>
                </a:lnTo>
                <a:cubicBezTo>
                  <a:pt x="12172886" y="1695971"/>
                  <a:pt x="12158726" y="1701546"/>
                  <a:pt x="12144566" y="1707165"/>
                </a:cubicBezTo>
                <a:cubicBezTo>
                  <a:pt x="11545887" y="1680679"/>
                  <a:pt x="10946257" y="1684904"/>
                  <a:pt x="10348023" y="1719834"/>
                </a:cubicBezTo>
                <a:cubicBezTo>
                  <a:pt x="10535920" y="1613980"/>
                  <a:pt x="10726737" y="1517122"/>
                  <a:pt x="10918634" y="1429955"/>
                </a:cubicBezTo>
                <a:cubicBezTo>
                  <a:pt x="11010646" y="1388228"/>
                  <a:pt x="11102975" y="1348807"/>
                  <a:pt x="11195621" y="1311685"/>
                </a:cubicBezTo>
                <a:cubicBezTo>
                  <a:pt x="11527092" y="1320129"/>
                  <a:pt x="11858054" y="1337613"/>
                  <a:pt x="12188507" y="1364137"/>
                </a:cubicBezTo>
                <a:lnTo>
                  <a:pt x="12189270" y="1354635"/>
                </a:lnTo>
                <a:cubicBezTo>
                  <a:pt x="11866245" y="1328491"/>
                  <a:pt x="11542395" y="1311197"/>
                  <a:pt x="11217720" y="1302753"/>
                </a:cubicBezTo>
                <a:cubicBezTo>
                  <a:pt x="11464481" y="1204285"/>
                  <a:pt x="11717210" y="1121369"/>
                  <a:pt x="11974385" y="1054493"/>
                </a:cubicBezTo>
                <a:cubicBezTo>
                  <a:pt x="12045632" y="1060277"/>
                  <a:pt x="12116943" y="1066358"/>
                  <a:pt x="12188317" y="1072737"/>
                </a:cubicBezTo>
                <a:lnTo>
                  <a:pt x="12189206" y="1063235"/>
                </a:lnTo>
                <a:cubicBezTo>
                  <a:pt x="12126976" y="1057661"/>
                  <a:pt x="12064809" y="1052339"/>
                  <a:pt x="12002643" y="1047272"/>
                </a:cubicBezTo>
                <a:cubicBezTo>
                  <a:pt x="12065127" y="1031435"/>
                  <a:pt x="12127484" y="1016656"/>
                  <a:pt x="12189778" y="1002928"/>
                </a:cubicBezTo>
                <a:lnTo>
                  <a:pt x="12187745" y="993679"/>
                </a:lnTo>
                <a:cubicBezTo>
                  <a:pt x="12116498" y="1009263"/>
                  <a:pt x="12045124" y="1026322"/>
                  <a:pt x="11973560" y="1044864"/>
                </a:cubicBezTo>
                <a:cubicBezTo>
                  <a:pt x="11356848" y="995010"/>
                  <a:pt x="10743311" y="970811"/>
                  <a:pt x="10136251" y="972204"/>
                </a:cubicBezTo>
                <a:cubicBezTo>
                  <a:pt x="10247503" y="928621"/>
                  <a:pt x="10357866" y="888858"/>
                  <a:pt x="10467340" y="852921"/>
                </a:cubicBezTo>
                <a:cubicBezTo>
                  <a:pt x="10623677" y="801609"/>
                  <a:pt x="10777919" y="758260"/>
                  <a:pt x="10930065" y="722868"/>
                </a:cubicBezTo>
                <a:cubicBezTo>
                  <a:pt x="11346688" y="744831"/>
                  <a:pt x="11766106" y="776986"/>
                  <a:pt x="12188254" y="819346"/>
                </a:cubicBezTo>
                <a:lnTo>
                  <a:pt x="12189270" y="809844"/>
                </a:lnTo>
                <a:cubicBezTo>
                  <a:pt x="11778297" y="768668"/>
                  <a:pt x="11369802" y="736994"/>
                  <a:pt x="10963720" y="714823"/>
                </a:cubicBezTo>
                <a:cubicBezTo>
                  <a:pt x="11392408" y="618091"/>
                  <a:pt x="11802682" y="584960"/>
                  <a:pt x="12188444" y="616317"/>
                </a:cubicBezTo>
                <a:lnTo>
                  <a:pt x="12189206" y="606815"/>
                </a:lnTo>
                <a:cubicBezTo>
                  <a:pt x="11792839" y="574571"/>
                  <a:pt x="11370628" y="610299"/>
                  <a:pt x="10929239" y="712986"/>
                </a:cubicBezTo>
                <a:cubicBezTo>
                  <a:pt x="10463594" y="688407"/>
                  <a:pt x="10002139" y="676516"/>
                  <a:pt x="9544939" y="677321"/>
                </a:cubicBezTo>
                <a:cubicBezTo>
                  <a:pt x="10155619" y="528390"/>
                  <a:pt x="10806367" y="432925"/>
                  <a:pt x="11488674" y="392256"/>
                </a:cubicBezTo>
                <a:cubicBezTo>
                  <a:pt x="11723053" y="408769"/>
                  <a:pt x="11957495" y="428385"/>
                  <a:pt x="12192063" y="451106"/>
                </a:cubicBezTo>
                <a:close/>
                <a:moveTo>
                  <a:pt x="6546088" y="486771"/>
                </a:moveTo>
                <a:cubicBezTo>
                  <a:pt x="6749288" y="463712"/>
                  <a:pt x="6953377" y="443061"/>
                  <a:pt x="7158292" y="424817"/>
                </a:cubicBezTo>
                <a:cubicBezTo>
                  <a:pt x="7848346" y="363243"/>
                  <a:pt x="8545385" y="329035"/>
                  <a:pt x="9249410" y="322194"/>
                </a:cubicBezTo>
                <a:cubicBezTo>
                  <a:pt x="8978900" y="362483"/>
                  <a:pt x="8716073" y="410564"/>
                  <a:pt x="8460994" y="466436"/>
                </a:cubicBezTo>
                <a:cubicBezTo>
                  <a:pt x="8077327" y="549851"/>
                  <a:pt x="7698931" y="656042"/>
                  <a:pt x="7327964" y="784442"/>
                </a:cubicBezTo>
                <a:cubicBezTo>
                  <a:pt x="7315835" y="785645"/>
                  <a:pt x="7303770" y="786912"/>
                  <a:pt x="7291642" y="788053"/>
                </a:cubicBezTo>
                <a:cubicBezTo>
                  <a:pt x="6943345" y="712922"/>
                  <a:pt x="6590602" y="647275"/>
                  <a:pt x="6233414" y="591105"/>
                </a:cubicBezTo>
                <a:cubicBezTo>
                  <a:pt x="6336284" y="554827"/>
                  <a:pt x="6440488" y="520049"/>
                  <a:pt x="6546088" y="486771"/>
                </a:cubicBezTo>
                <a:close/>
                <a:moveTo>
                  <a:pt x="9814941" y="1759237"/>
                </a:moveTo>
                <a:cubicBezTo>
                  <a:pt x="9599041" y="1666496"/>
                  <a:pt x="9359836" y="1570270"/>
                  <a:pt x="9098597" y="1474172"/>
                </a:cubicBezTo>
                <a:cubicBezTo>
                  <a:pt x="9163241" y="1437050"/>
                  <a:pt x="9227757" y="1401151"/>
                  <a:pt x="9292209" y="1366481"/>
                </a:cubicBezTo>
                <a:lnTo>
                  <a:pt x="9326817" y="1363567"/>
                </a:lnTo>
                <a:cubicBezTo>
                  <a:pt x="9677273" y="1484371"/>
                  <a:pt x="9994392" y="1606759"/>
                  <a:pt x="10275507" y="1723952"/>
                </a:cubicBezTo>
                <a:cubicBezTo>
                  <a:pt x="10121138" y="1733537"/>
                  <a:pt x="9967595" y="1745300"/>
                  <a:pt x="9814941" y="1759237"/>
                </a:cubicBezTo>
                <a:close/>
                <a:moveTo>
                  <a:pt x="10295255" y="1731997"/>
                </a:moveTo>
                <a:lnTo>
                  <a:pt x="10301605" y="1734658"/>
                </a:lnTo>
                <a:cubicBezTo>
                  <a:pt x="10224008" y="1779001"/>
                  <a:pt x="10146982" y="1824865"/>
                  <a:pt x="10070529" y="1872249"/>
                </a:cubicBezTo>
                <a:cubicBezTo>
                  <a:pt x="9994773" y="1837832"/>
                  <a:pt x="9915652" y="1802883"/>
                  <a:pt x="9833229" y="1767408"/>
                </a:cubicBezTo>
                <a:cubicBezTo>
                  <a:pt x="9986391" y="1753428"/>
                  <a:pt x="10140379" y="1741626"/>
                  <a:pt x="10295255" y="1731997"/>
                </a:cubicBezTo>
                <a:close/>
                <a:moveTo>
                  <a:pt x="2138045" y="2013831"/>
                </a:moveTo>
                <a:cubicBezTo>
                  <a:pt x="1894205" y="1904176"/>
                  <a:pt x="1622933" y="1789834"/>
                  <a:pt x="1325944" y="1675428"/>
                </a:cubicBezTo>
                <a:cubicBezTo>
                  <a:pt x="1458024" y="1627619"/>
                  <a:pt x="1601641" y="1577619"/>
                  <a:pt x="1756791" y="1525420"/>
                </a:cubicBezTo>
                <a:cubicBezTo>
                  <a:pt x="2043729" y="1573311"/>
                  <a:pt x="2324208" y="1626821"/>
                  <a:pt x="2598230" y="1685943"/>
                </a:cubicBezTo>
                <a:cubicBezTo>
                  <a:pt x="2480501" y="1779571"/>
                  <a:pt x="2373884" y="1870602"/>
                  <a:pt x="2278380" y="1957008"/>
                </a:cubicBezTo>
                <a:cubicBezTo>
                  <a:pt x="2230203" y="1976184"/>
                  <a:pt x="2183429" y="1995124"/>
                  <a:pt x="2138045" y="2013831"/>
                </a:cubicBezTo>
                <a:close/>
                <a:moveTo>
                  <a:pt x="2258187" y="1975316"/>
                </a:moveTo>
                <a:cubicBezTo>
                  <a:pt x="2235073" y="1996430"/>
                  <a:pt x="2212613" y="2017208"/>
                  <a:pt x="2190814" y="2037650"/>
                </a:cubicBezTo>
                <a:lnTo>
                  <a:pt x="2149983" y="2019216"/>
                </a:lnTo>
                <a:cubicBezTo>
                  <a:pt x="2185245" y="2004690"/>
                  <a:pt x="2221313" y="1990057"/>
                  <a:pt x="2258187" y="1975316"/>
                </a:cubicBezTo>
                <a:close/>
                <a:moveTo>
                  <a:pt x="5040694" y="1641663"/>
                </a:moveTo>
                <a:cubicBezTo>
                  <a:pt x="4941716" y="1669112"/>
                  <a:pt x="4845495" y="1696712"/>
                  <a:pt x="4752023" y="1724459"/>
                </a:cubicBezTo>
                <a:cubicBezTo>
                  <a:pt x="4590396" y="1676866"/>
                  <a:pt x="4427411" y="1631464"/>
                  <a:pt x="4263073" y="1588261"/>
                </a:cubicBezTo>
                <a:cubicBezTo>
                  <a:pt x="4482465" y="1434440"/>
                  <a:pt x="4710157" y="1292750"/>
                  <a:pt x="4945126" y="1163831"/>
                </a:cubicBezTo>
                <a:cubicBezTo>
                  <a:pt x="5259026" y="1095752"/>
                  <a:pt x="5577923" y="1034792"/>
                  <a:pt x="5901817" y="980947"/>
                </a:cubicBezTo>
                <a:cubicBezTo>
                  <a:pt x="6115476" y="1020222"/>
                  <a:pt x="6325299" y="1062747"/>
                  <a:pt x="6531293" y="1108529"/>
                </a:cubicBezTo>
                <a:cubicBezTo>
                  <a:pt x="6388862" y="1175804"/>
                  <a:pt x="6250877" y="1246456"/>
                  <a:pt x="6117273" y="1320490"/>
                </a:cubicBezTo>
                <a:cubicBezTo>
                  <a:pt x="6059697" y="1352500"/>
                  <a:pt x="6003989" y="1384490"/>
                  <a:pt x="5950141" y="1416462"/>
                </a:cubicBezTo>
                <a:cubicBezTo>
                  <a:pt x="5642039" y="1484162"/>
                  <a:pt x="5338890" y="1559229"/>
                  <a:pt x="5040694" y="1641663"/>
                </a:cubicBezTo>
                <a:close/>
                <a:moveTo>
                  <a:pt x="5924614" y="1432046"/>
                </a:moveTo>
                <a:cubicBezTo>
                  <a:pt x="5696801" y="1568205"/>
                  <a:pt x="5478685" y="1719904"/>
                  <a:pt x="5271834" y="1886059"/>
                </a:cubicBezTo>
                <a:lnTo>
                  <a:pt x="5218494" y="1868765"/>
                </a:lnTo>
                <a:cubicBezTo>
                  <a:pt x="5069777" y="1820412"/>
                  <a:pt x="4919917" y="1773952"/>
                  <a:pt x="4768914" y="1729400"/>
                </a:cubicBezTo>
                <a:cubicBezTo>
                  <a:pt x="4857814" y="1703091"/>
                  <a:pt x="4949273" y="1676929"/>
                  <a:pt x="5043297" y="1650912"/>
                </a:cubicBezTo>
                <a:cubicBezTo>
                  <a:pt x="5332051" y="1570923"/>
                  <a:pt x="5625827" y="1497972"/>
                  <a:pt x="5924614" y="1432046"/>
                </a:cubicBezTo>
                <a:close/>
                <a:moveTo>
                  <a:pt x="2143379" y="1400372"/>
                </a:moveTo>
                <a:cubicBezTo>
                  <a:pt x="2225212" y="1374779"/>
                  <a:pt x="2309432" y="1349016"/>
                  <a:pt x="2396046" y="1323088"/>
                </a:cubicBezTo>
                <a:cubicBezTo>
                  <a:pt x="2580113" y="1355522"/>
                  <a:pt x="2762822" y="1390616"/>
                  <a:pt x="2944178" y="1428371"/>
                </a:cubicBezTo>
                <a:cubicBezTo>
                  <a:pt x="2896851" y="1461439"/>
                  <a:pt x="2850007" y="1495013"/>
                  <a:pt x="2803652" y="1529094"/>
                </a:cubicBezTo>
                <a:cubicBezTo>
                  <a:pt x="2586736" y="1482261"/>
                  <a:pt x="2366709" y="1439223"/>
                  <a:pt x="2143570" y="1399992"/>
                </a:cubicBezTo>
                <a:close/>
                <a:moveTo>
                  <a:pt x="2793492" y="1536633"/>
                </a:moveTo>
                <a:cubicBezTo>
                  <a:pt x="2776728" y="1548922"/>
                  <a:pt x="2759964" y="1561212"/>
                  <a:pt x="2743391" y="1573691"/>
                </a:cubicBezTo>
                <a:cubicBezTo>
                  <a:pt x="2696572" y="1608830"/>
                  <a:pt x="2651335" y="1643735"/>
                  <a:pt x="2607691" y="1678405"/>
                </a:cubicBezTo>
                <a:cubicBezTo>
                  <a:pt x="2336756" y="1619872"/>
                  <a:pt x="2059476" y="1566786"/>
                  <a:pt x="1775841" y="1519149"/>
                </a:cubicBezTo>
                <a:cubicBezTo>
                  <a:pt x="1886248" y="1482280"/>
                  <a:pt x="2002199" y="1444760"/>
                  <a:pt x="2123694" y="1406580"/>
                </a:cubicBezTo>
                <a:cubicBezTo>
                  <a:pt x="2350091" y="1445900"/>
                  <a:pt x="2573420" y="1489204"/>
                  <a:pt x="2793683" y="1536506"/>
                </a:cubicBezTo>
                <a:close/>
                <a:moveTo>
                  <a:pt x="3638614" y="549802"/>
                </a:moveTo>
                <a:cubicBezTo>
                  <a:pt x="3919665" y="564118"/>
                  <a:pt x="4197395" y="583925"/>
                  <a:pt x="4471797" y="609222"/>
                </a:cubicBezTo>
                <a:cubicBezTo>
                  <a:pt x="4371893" y="648878"/>
                  <a:pt x="4273125" y="690478"/>
                  <a:pt x="4175506" y="734017"/>
                </a:cubicBezTo>
                <a:cubicBezTo>
                  <a:pt x="3830276" y="701285"/>
                  <a:pt x="3477749" y="676054"/>
                  <a:pt x="3117914" y="658317"/>
                </a:cubicBezTo>
                <a:cubicBezTo>
                  <a:pt x="3294317" y="619759"/>
                  <a:pt x="3467881" y="583587"/>
                  <a:pt x="3638614" y="549802"/>
                </a:cubicBezTo>
                <a:close/>
                <a:moveTo>
                  <a:pt x="3081592" y="656479"/>
                </a:moveTo>
                <a:cubicBezTo>
                  <a:pt x="2968352" y="651032"/>
                  <a:pt x="2854408" y="646344"/>
                  <a:pt x="2739771" y="642416"/>
                </a:cubicBezTo>
                <a:cubicBezTo>
                  <a:pt x="2831338" y="602634"/>
                  <a:pt x="2924048" y="564266"/>
                  <a:pt x="3017901" y="527313"/>
                </a:cubicBezTo>
                <a:cubicBezTo>
                  <a:pt x="3213227" y="531537"/>
                  <a:pt x="3407092" y="538399"/>
                  <a:pt x="3599498" y="547901"/>
                </a:cubicBezTo>
                <a:cubicBezTo>
                  <a:pt x="3429870" y="581729"/>
                  <a:pt x="3257214" y="617922"/>
                  <a:pt x="3081528" y="656479"/>
                </a:cubicBezTo>
                <a:close/>
                <a:moveTo>
                  <a:pt x="6837236" y="972521"/>
                </a:moveTo>
                <a:cubicBezTo>
                  <a:pt x="6717856" y="945155"/>
                  <a:pt x="6597460" y="918973"/>
                  <a:pt x="6476111" y="893970"/>
                </a:cubicBezTo>
                <a:cubicBezTo>
                  <a:pt x="6606033" y="876106"/>
                  <a:pt x="6736588" y="859363"/>
                  <a:pt x="6867779" y="843735"/>
                </a:cubicBezTo>
                <a:cubicBezTo>
                  <a:pt x="6930327" y="857121"/>
                  <a:pt x="6992620" y="870804"/>
                  <a:pt x="7054723" y="884785"/>
                </a:cubicBezTo>
                <a:cubicBezTo>
                  <a:pt x="6981254" y="913247"/>
                  <a:pt x="6908737" y="942494"/>
                  <a:pt x="6837172" y="972521"/>
                </a:cubicBezTo>
                <a:close/>
                <a:moveTo>
                  <a:pt x="7071424" y="888522"/>
                </a:moveTo>
                <a:cubicBezTo>
                  <a:pt x="7350570" y="951616"/>
                  <a:pt x="7625906" y="1021109"/>
                  <a:pt x="7897369" y="1097000"/>
                </a:cubicBezTo>
                <a:cubicBezTo>
                  <a:pt x="7769543" y="1111316"/>
                  <a:pt x="7642225" y="1126817"/>
                  <a:pt x="7515416" y="1143497"/>
                </a:cubicBezTo>
                <a:cubicBezTo>
                  <a:pt x="7298309" y="1083525"/>
                  <a:pt x="7077520" y="1027741"/>
                  <a:pt x="6853047" y="976132"/>
                </a:cubicBezTo>
                <a:cubicBezTo>
                  <a:pt x="6924866" y="946188"/>
                  <a:pt x="6997637" y="916984"/>
                  <a:pt x="7071360" y="888522"/>
                </a:cubicBezTo>
                <a:close/>
                <a:moveTo>
                  <a:pt x="6822313" y="978793"/>
                </a:moveTo>
                <a:cubicBezTo>
                  <a:pt x="6728396" y="1018531"/>
                  <a:pt x="6636258" y="1059624"/>
                  <a:pt x="6545770" y="1102067"/>
                </a:cubicBezTo>
                <a:cubicBezTo>
                  <a:pt x="6344222" y="1057090"/>
                  <a:pt x="6138907" y="1015237"/>
                  <a:pt x="5929821" y="976512"/>
                </a:cubicBezTo>
                <a:cubicBezTo>
                  <a:pt x="6101188" y="948259"/>
                  <a:pt x="6273781" y="922052"/>
                  <a:pt x="6447600" y="897898"/>
                </a:cubicBezTo>
                <a:cubicBezTo>
                  <a:pt x="6573520" y="923617"/>
                  <a:pt x="6698425" y="950584"/>
                  <a:pt x="6822250" y="978793"/>
                </a:cubicBezTo>
                <a:close/>
                <a:moveTo>
                  <a:pt x="5902262" y="971444"/>
                </a:moveTo>
                <a:cubicBezTo>
                  <a:pt x="5761209" y="945516"/>
                  <a:pt x="5618525" y="921039"/>
                  <a:pt x="5474208" y="898024"/>
                </a:cubicBezTo>
                <a:cubicBezTo>
                  <a:pt x="5554263" y="861283"/>
                  <a:pt x="5635371" y="825491"/>
                  <a:pt x="5717540" y="790650"/>
                </a:cubicBezTo>
                <a:lnTo>
                  <a:pt x="5761228" y="772342"/>
                </a:lnTo>
                <a:cubicBezTo>
                  <a:pt x="5983523" y="808495"/>
                  <a:pt x="6202953" y="848442"/>
                  <a:pt x="6419533" y="892196"/>
                </a:cubicBezTo>
                <a:cubicBezTo>
                  <a:pt x="6245841" y="916604"/>
                  <a:pt x="6073394" y="943020"/>
                  <a:pt x="5902198" y="971444"/>
                </a:cubicBezTo>
                <a:close/>
                <a:moveTo>
                  <a:pt x="5874576" y="976069"/>
                </a:moveTo>
                <a:cubicBezTo>
                  <a:pt x="5570538" y="1027000"/>
                  <a:pt x="5270691" y="1084267"/>
                  <a:pt x="4975035" y="1147868"/>
                </a:cubicBezTo>
                <a:cubicBezTo>
                  <a:pt x="5131372" y="1062811"/>
                  <a:pt x="5292598" y="981916"/>
                  <a:pt x="5458714" y="905183"/>
                </a:cubicBezTo>
                <a:cubicBezTo>
                  <a:pt x="5598751" y="927481"/>
                  <a:pt x="5737352" y="951110"/>
                  <a:pt x="5874512" y="976069"/>
                </a:cubicBezTo>
                <a:close/>
                <a:moveTo>
                  <a:pt x="5713476" y="782035"/>
                </a:moveTo>
                <a:cubicBezTo>
                  <a:pt x="5626862" y="818650"/>
                  <a:pt x="5541474" y="856424"/>
                  <a:pt x="5457317" y="895364"/>
                </a:cubicBezTo>
                <a:cubicBezTo>
                  <a:pt x="5229651" y="859255"/>
                  <a:pt x="4998066" y="826714"/>
                  <a:pt x="4762564" y="797745"/>
                </a:cubicBezTo>
                <a:cubicBezTo>
                  <a:pt x="4714767" y="791835"/>
                  <a:pt x="4666787" y="786108"/>
                  <a:pt x="4618609" y="780578"/>
                </a:cubicBezTo>
                <a:cubicBezTo>
                  <a:pt x="4795393" y="746497"/>
                  <a:pt x="4973193" y="714272"/>
                  <a:pt x="5152009" y="683909"/>
                </a:cubicBezTo>
                <a:cubicBezTo>
                  <a:pt x="5351190" y="709248"/>
                  <a:pt x="5548332" y="737774"/>
                  <a:pt x="5743448" y="769492"/>
                </a:cubicBezTo>
                <a:cubicBezTo>
                  <a:pt x="5733479" y="773673"/>
                  <a:pt x="5723382" y="777790"/>
                  <a:pt x="5713413" y="782035"/>
                </a:cubicBezTo>
                <a:close/>
                <a:moveTo>
                  <a:pt x="4587304" y="777030"/>
                </a:moveTo>
                <a:cubicBezTo>
                  <a:pt x="4457637" y="762207"/>
                  <a:pt x="4326846" y="748460"/>
                  <a:pt x="4194937" y="735791"/>
                </a:cubicBezTo>
                <a:cubicBezTo>
                  <a:pt x="4293026" y="692334"/>
                  <a:pt x="4392340" y="650778"/>
                  <a:pt x="4492879" y="611122"/>
                </a:cubicBezTo>
                <a:cubicBezTo>
                  <a:pt x="4604893" y="621596"/>
                  <a:pt x="4716355" y="632914"/>
                  <a:pt x="4827270" y="645077"/>
                </a:cubicBezTo>
                <a:cubicBezTo>
                  <a:pt x="4925143" y="655928"/>
                  <a:pt x="5022514" y="667502"/>
                  <a:pt x="5119370" y="679791"/>
                </a:cubicBezTo>
                <a:cubicBezTo>
                  <a:pt x="4941189" y="710407"/>
                  <a:pt x="4763815" y="742822"/>
                  <a:pt x="4587240" y="777030"/>
                </a:cubicBezTo>
                <a:close/>
                <a:moveTo>
                  <a:pt x="4177094" y="743709"/>
                </a:moveTo>
                <a:cubicBezTo>
                  <a:pt x="4304557" y="755790"/>
                  <a:pt x="4430986" y="768922"/>
                  <a:pt x="4556379" y="783112"/>
                </a:cubicBezTo>
                <a:cubicBezTo>
                  <a:pt x="4279900" y="837166"/>
                  <a:pt x="4005917" y="895725"/>
                  <a:pt x="3734435" y="958775"/>
                </a:cubicBezTo>
                <a:cubicBezTo>
                  <a:pt x="3877945" y="883264"/>
                  <a:pt x="4024357" y="812080"/>
                  <a:pt x="4173665" y="745230"/>
                </a:cubicBezTo>
                <a:close/>
                <a:moveTo>
                  <a:pt x="4587685" y="786596"/>
                </a:moveTo>
                <a:cubicBezTo>
                  <a:pt x="4645724" y="793266"/>
                  <a:pt x="4703553" y="800108"/>
                  <a:pt x="4761167" y="807120"/>
                </a:cubicBezTo>
                <a:cubicBezTo>
                  <a:pt x="4991627" y="835373"/>
                  <a:pt x="5218576" y="867174"/>
                  <a:pt x="5442014" y="902522"/>
                </a:cubicBezTo>
                <a:cubicBezTo>
                  <a:pt x="5270310" y="982087"/>
                  <a:pt x="5103749" y="1066232"/>
                  <a:pt x="4942332" y="1154963"/>
                </a:cubicBezTo>
                <a:cubicBezTo>
                  <a:pt x="4546937" y="1240818"/>
                  <a:pt x="4160158" y="1337955"/>
                  <a:pt x="3781997" y="1446362"/>
                </a:cubicBezTo>
                <a:lnTo>
                  <a:pt x="3739579" y="1458588"/>
                </a:lnTo>
                <a:cubicBezTo>
                  <a:pt x="3533032" y="1410571"/>
                  <a:pt x="3324816" y="1365892"/>
                  <a:pt x="3114929" y="1324545"/>
                </a:cubicBezTo>
                <a:cubicBezTo>
                  <a:pt x="3303607" y="1200383"/>
                  <a:pt x="3499041" y="1084393"/>
                  <a:pt x="3701225" y="976576"/>
                </a:cubicBezTo>
                <a:cubicBezTo>
                  <a:pt x="3993534" y="907989"/>
                  <a:pt x="4289000" y="844667"/>
                  <a:pt x="4587621" y="786596"/>
                </a:cubicBezTo>
                <a:close/>
                <a:moveTo>
                  <a:pt x="4912741" y="1171180"/>
                </a:moveTo>
                <a:cubicBezTo>
                  <a:pt x="4685049" y="1297305"/>
                  <a:pt x="4464279" y="1435498"/>
                  <a:pt x="4251389" y="1585157"/>
                </a:cubicBezTo>
                <a:cubicBezTo>
                  <a:pt x="4088194" y="1542207"/>
                  <a:pt x="3923837" y="1501411"/>
                  <a:pt x="3758311" y="1462769"/>
                </a:cubicBezTo>
                <a:lnTo>
                  <a:pt x="3784473" y="1455231"/>
                </a:lnTo>
                <a:cubicBezTo>
                  <a:pt x="4151840" y="1350029"/>
                  <a:pt x="4527912" y="1255350"/>
                  <a:pt x="4912678" y="1171180"/>
                </a:cubicBezTo>
                <a:close/>
                <a:moveTo>
                  <a:pt x="3101277" y="1321694"/>
                </a:moveTo>
                <a:cubicBezTo>
                  <a:pt x="2958910" y="1293739"/>
                  <a:pt x="2815844" y="1267342"/>
                  <a:pt x="2672080" y="1242509"/>
                </a:cubicBezTo>
                <a:cubicBezTo>
                  <a:pt x="2874982" y="1184819"/>
                  <a:pt x="3088913" y="1127514"/>
                  <a:pt x="3313875" y="1070584"/>
                </a:cubicBezTo>
                <a:cubicBezTo>
                  <a:pt x="3430632" y="1041019"/>
                  <a:pt x="3547955" y="1012411"/>
                  <a:pt x="3665855" y="984747"/>
                </a:cubicBezTo>
                <a:cubicBezTo>
                  <a:pt x="3471628" y="1089227"/>
                  <a:pt x="3283439" y="1201542"/>
                  <a:pt x="3101277" y="1321694"/>
                </a:cubicBezTo>
                <a:close/>
                <a:moveTo>
                  <a:pt x="3089910" y="1329169"/>
                </a:moveTo>
                <a:cubicBezTo>
                  <a:pt x="3044527" y="1359196"/>
                  <a:pt x="2999594" y="1389729"/>
                  <a:pt x="2955100" y="1420770"/>
                </a:cubicBezTo>
                <a:cubicBezTo>
                  <a:pt x="2776963" y="1383648"/>
                  <a:pt x="2597487" y="1349016"/>
                  <a:pt x="2416683" y="1316880"/>
                </a:cubicBezTo>
                <a:cubicBezTo>
                  <a:pt x="2492883" y="1294157"/>
                  <a:pt x="2571033" y="1271377"/>
                  <a:pt x="2651125" y="1248527"/>
                </a:cubicBezTo>
                <a:cubicBezTo>
                  <a:pt x="2798064" y="1273740"/>
                  <a:pt x="2944324" y="1300618"/>
                  <a:pt x="3089910" y="1329169"/>
                </a:cubicBezTo>
                <a:close/>
                <a:moveTo>
                  <a:pt x="2395665" y="1313269"/>
                </a:moveTo>
                <a:cubicBezTo>
                  <a:pt x="2158937" y="1271586"/>
                  <a:pt x="1920094" y="1234337"/>
                  <a:pt x="1679131" y="1201523"/>
                </a:cubicBezTo>
                <a:cubicBezTo>
                  <a:pt x="1721466" y="1174873"/>
                  <a:pt x="1764201" y="1148565"/>
                  <a:pt x="1807337" y="1122592"/>
                </a:cubicBezTo>
                <a:cubicBezTo>
                  <a:pt x="2083435" y="1157687"/>
                  <a:pt x="2357438" y="1198438"/>
                  <a:pt x="2629345" y="1244853"/>
                </a:cubicBezTo>
                <a:cubicBezTo>
                  <a:pt x="2549671" y="1267658"/>
                  <a:pt x="2471782" y="1290464"/>
                  <a:pt x="2395665" y="1313269"/>
                </a:cubicBezTo>
                <a:close/>
                <a:moveTo>
                  <a:pt x="2957195" y="1430905"/>
                </a:moveTo>
                <a:cubicBezTo>
                  <a:pt x="3124918" y="1465956"/>
                  <a:pt x="3291351" y="1503267"/>
                  <a:pt x="3456496" y="1542841"/>
                </a:cubicBezTo>
                <a:cubicBezTo>
                  <a:pt x="3371831" y="1568940"/>
                  <a:pt x="3289173" y="1595122"/>
                  <a:pt x="3208528" y="1621392"/>
                </a:cubicBezTo>
                <a:cubicBezTo>
                  <a:pt x="3078944" y="1590098"/>
                  <a:pt x="2948178" y="1560154"/>
                  <a:pt x="2816225" y="1531565"/>
                </a:cubicBezTo>
                <a:cubicBezTo>
                  <a:pt x="2862707" y="1497484"/>
                  <a:pt x="2909697" y="1463929"/>
                  <a:pt x="2957195" y="1430905"/>
                </a:cubicBezTo>
                <a:close/>
                <a:moveTo>
                  <a:pt x="2967927" y="1423430"/>
                </a:moveTo>
                <a:cubicBezTo>
                  <a:pt x="3012631" y="1392472"/>
                  <a:pt x="3057735" y="1361920"/>
                  <a:pt x="3103245" y="1331766"/>
                </a:cubicBezTo>
                <a:cubicBezTo>
                  <a:pt x="3310681" y="1372518"/>
                  <a:pt x="3516522" y="1416506"/>
                  <a:pt x="3720783" y="1463719"/>
                </a:cubicBezTo>
                <a:cubicBezTo>
                  <a:pt x="3636753" y="1488089"/>
                  <a:pt x="3554584" y="1512624"/>
                  <a:pt x="3474276" y="1537329"/>
                </a:cubicBezTo>
                <a:cubicBezTo>
                  <a:pt x="3306845" y="1497040"/>
                  <a:pt x="3138062" y="1459076"/>
                  <a:pt x="2967927" y="1423430"/>
                </a:cubicBezTo>
                <a:close/>
                <a:moveTo>
                  <a:pt x="3739579" y="1468154"/>
                </a:moveTo>
                <a:cubicBezTo>
                  <a:pt x="3907898" y="1507303"/>
                  <a:pt x="4075113" y="1548688"/>
                  <a:pt x="4241229" y="1592315"/>
                </a:cubicBezTo>
                <a:cubicBezTo>
                  <a:pt x="4231069" y="1599474"/>
                  <a:pt x="4220718" y="1606632"/>
                  <a:pt x="4210558" y="1613917"/>
                </a:cubicBezTo>
                <a:cubicBezTo>
                  <a:pt x="4170763" y="1642341"/>
                  <a:pt x="4132155" y="1670613"/>
                  <a:pt x="4094734" y="1698740"/>
                </a:cubicBezTo>
                <a:cubicBezTo>
                  <a:pt x="3896151" y="1643165"/>
                  <a:pt x="3695427" y="1590814"/>
                  <a:pt x="3492564" y="1541701"/>
                </a:cubicBezTo>
                <a:cubicBezTo>
                  <a:pt x="3572999" y="1517039"/>
                  <a:pt x="3655333" y="1492524"/>
                  <a:pt x="3739579" y="1468154"/>
                </a:cubicBezTo>
                <a:close/>
                <a:moveTo>
                  <a:pt x="4216464" y="1621265"/>
                </a:moveTo>
                <a:cubicBezTo>
                  <a:pt x="4228592" y="1612587"/>
                  <a:pt x="4240911" y="1604098"/>
                  <a:pt x="4253167" y="1595419"/>
                </a:cubicBezTo>
                <a:cubicBezTo>
                  <a:pt x="4414965" y="1638071"/>
                  <a:pt x="4575639" y="1682732"/>
                  <a:pt x="4735195" y="1729400"/>
                </a:cubicBezTo>
                <a:cubicBezTo>
                  <a:pt x="4645197" y="1756215"/>
                  <a:pt x="4557859" y="1783036"/>
                  <a:pt x="4473194" y="1809852"/>
                </a:cubicBezTo>
                <a:cubicBezTo>
                  <a:pt x="4351700" y="1772603"/>
                  <a:pt x="4229354" y="1736704"/>
                  <a:pt x="4106164" y="1702160"/>
                </a:cubicBezTo>
                <a:cubicBezTo>
                  <a:pt x="4141851" y="1675428"/>
                  <a:pt x="4178617" y="1648460"/>
                  <a:pt x="4216464" y="1621265"/>
                </a:cubicBezTo>
                <a:close/>
                <a:moveTo>
                  <a:pt x="6122099" y="1328916"/>
                </a:moveTo>
                <a:cubicBezTo>
                  <a:pt x="6258878" y="1252898"/>
                  <a:pt x="6400419" y="1180618"/>
                  <a:pt x="6546723" y="1112076"/>
                </a:cubicBezTo>
                <a:cubicBezTo>
                  <a:pt x="6698615" y="1145860"/>
                  <a:pt x="6848285" y="1181550"/>
                  <a:pt x="6995669" y="1219134"/>
                </a:cubicBezTo>
                <a:cubicBezTo>
                  <a:pt x="6652324" y="1274037"/>
                  <a:pt x="6313824" y="1337702"/>
                  <a:pt x="5980240" y="1410127"/>
                </a:cubicBezTo>
                <a:cubicBezTo>
                  <a:pt x="6029960" y="1380987"/>
                  <a:pt x="6077458" y="1353748"/>
                  <a:pt x="6122162" y="1328916"/>
                </a:cubicBezTo>
                <a:close/>
                <a:moveTo>
                  <a:pt x="6560694" y="1105488"/>
                </a:moveTo>
                <a:cubicBezTo>
                  <a:pt x="6651371" y="1063254"/>
                  <a:pt x="6743827" y="1022249"/>
                  <a:pt x="6837998" y="982467"/>
                </a:cubicBezTo>
                <a:cubicBezTo>
                  <a:pt x="7059169" y="1033145"/>
                  <a:pt x="7276846" y="1087896"/>
                  <a:pt x="7490969" y="1146728"/>
                </a:cubicBezTo>
                <a:cubicBezTo>
                  <a:pt x="7332917" y="1167841"/>
                  <a:pt x="7175691" y="1190710"/>
                  <a:pt x="7019417" y="1215333"/>
                </a:cubicBezTo>
                <a:cubicBezTo>
                  <a:pt x="6868922" y="1176900"/>
                  <a:pt x="6716014" y="1140285"/>
                  <a:pt x="6560757" y="1105488"/>
                </a:cubicBezTo>
                <a:close/>
                <a:moveTo>
                  <a:pt x="7514654" y="1152936"/>
                </a:moveTo>
                <a:cubicBezTo>
                  <a:pt x="7634288" y="1186003"/>
                  <a:pt x="7752715" y="1220338"/>
                  <a:pt x="7869936" y="1255939"/>
                </a:cubicBezTo>
                <a:cubicBezTo>
                  <a:pt x="7784846" y="1296564"/>
                  <a:pt x="7701026" y="1338437"/>
                  <a:pt x="7618540" y="1381557"/>
                </a:cubicBezTo>
                <a:cubicBezTo>
                  <a:pt x="7430770" y="1324969"/>
                  <a:pt x="7238873" y="1271459"/>
                  <a:pt x="7042785" y="1221034"/>
                </a:cubicBezTo>
                <a:cubicBezTo>
                  <a:pt x="7199058" y="1196753"/>
                  <a:pt x="7356348" y="1174049"/>
                  <a:pt x="7514654" y="1152936"/>
                </a:cubicBezTo>
                <a:close/>
                <a:moveTo>
                  <a:pt x="7538847" y="1149768"/>
                </a:moveTo>
                <a:cubicBezTo>
                  <a:pt x="7665847" y="1133171"/>
                  <a:pt x="7793483" y="1117797"/>
                  <a:pt x="7921816" y="1103651"/>
                </a:cubicBezTo>
                <a:cubicBezTo>
                  <a:pt x="7979601" y="1119868"/>
                  <a:pt x="8037195" y="1136383"/>
                  <a:pt x="8094536" y="1153189"/>
                </a:cubicBezTo>
                <a:cubicBezTo>
                  <a:pt x="8023035" y="1184527"/>
                  <a:pt x="7952423" y="1216746"/>
                  <a:pt x="7882636" y="1249858"/>
                </a:cubicBezTo>
                <a:cubicBezTo>
                  <a:pt x="7769098" y="1215479"/>
                  <a:pt x="7654481" y="1182202"/>
                  <a:pt x="7538847" y="1150022"/>
                </a:cubicBezTo>
                <a:close/>
                <a:moveTo>
                  <a:pt x="8108696" y="1157370"/>
                </a:moveTo>
                <a:cubicBezTo>
                  <a:pt x="8240649" y="1196139"/>
                  <a:pt x="8371586" y="1236428"/>
                  <a:pt x="8501570" y="1278237"/>
                </a:cubicBezTo>
                <a:cubicBezTo>
                  <a:pt x="8624316" y="1317722"/>
                  <a:pt x="8743252" y="1357612"/>
                  <a:pt x="8858377" y="1397901"/>
                </a:cubicBezTo>
                <a:cubicBezTo>
                  <a:pt x="8729917" y="1411755"/>
                  <a:pt x="8601710" y="1427060"/>
                  <a:pt x="8473821" y="1443828"/>
                </a:cubicBezTo>
                <a:cubicBezTo>
                  <a:pt x="8391716" y="1414815"/>
                  <a:pt x="8307388" y="1385948"/>
                  <a:pt x="8220837" y="1357232"/>
                </a:cubicBezTo>
                <a:cubicBezTo>
                  <a:pt x="8113649" y="1321713"/>
                  <a:pt x="8005382" y="1287296"/>
                  <a:pt x="7896098" y="1253975"/>
                </a:cubicBezTo>
                <a:cubicBezTo>
                  <a:pt x="7966075" y="1221034"/>
                  <a:pt x="8037069" y="1188917"/>
                  <a:pt x="8109014" y="1157623"/>
                </a:cubicBezTo>
                <a:close/>
                <a:moveTo>
                  <a:pt x="8108061" y="1147234"/>
                </a:moveTo>
                <a:cubicBezTo>
                  <a:pt x="8054595" y="1131524"/>
                  <a:pt x="8000937" y="1116067"/>
                  <a:pt x="7947152" y="1100864"/>
                </a:cubicBezTo>
                <a:cubicBezTo>
                  <a:pt x="7997571" y="1095333"/>
                  <a:pt x="8048054" y="1089987"/>
                  <a:pt x="8098600" y="1084837"/>
                </a:cubicBezTo>
                <a:cubicBezTo>
                  <a:pt x="8166354" y="1077995"/>
                  <a:pt x="8234299" y="1071489"/>
                  <a:pt x="8302562" y="1065326"/>
                </a:cubicBezTo>
                <a:cubicBezTo>
                  <a:pt x="8237030" y="1092103"/>
                  <a:pt x="8172196" y="1119488"/>
                  <a:pt x="8108061" y="1147488"/>
                </a:cubicBezTo>
                <a:close/>
                <a:moveTo>
                  <a:pt x="8097647" y="1075398"/>
                </a:moveTo>
                <a:cubicBezTo>
                  <a:pt x="8039164" y="1081353"/>
                  <a:pt x="7980808" y="1087542"/>
                  <a:pt x="7922641" y="1093959"/>
                </a:cubicBezTo>
                <a:cubicBezTo>
                  <a:pt x="7648321" y="1016928"/>
                  <a:pt x="7369937" y="946314"/>
                  <a:pt x="7087489" y="882124"/>
                </a:cubicBezTo>
                <a:cubicBezTo>
                  <a:pt x="7160133" y="854333"/>
                  <a:pt x="7233730" y="827347"/>
                  <a:pt x="7308215" y="801166"/>
                </a:cubicBezTo>
                <a:cubicBezTo>
                  <a:pt x="7653338" y="875960"/>
                  <a:pt x="7993698" y="959997"/>
                  <a:pt x="8329358" y="1053290"/>
                </a:cubicBezTo>
                <a:cubicBezTo>
                  <a:pt x="8251952" y="1060594"/>
                  <a:pt x="8174736" y="1068050"/>
                  <a:pt x="8097647" y="1075651"/>
                </a:cubicBezTo>
                <a:close/>
                <a:moveTo>
                  <a:pt x="7070662" y="878387"/>
                </a:moveTo>
                <a:cubicBezTo>
                  <a:pt x="7012877" y="865337"/>
                  <a:pt x="6954965" y="852667"/>
                  <a:pt x="6896926" y="840378"/>
                </a:cubicBezTo>
                <a:cubicBezTo>
                  <a:pt x="7027291" y="825130"/>
                  <a:pt x="7158228" y="810966"/>
                  <a:pt x="7289673" y="797872"/>
                </a:cubicBezTo>
                <a:cubicBezTo>
                  <a:pt x="7215759" y="824015"/>
                  <a:pt x="7142734" y="850938"/>
                  <a:pt x="7070662" y="878640"/>
                </a:cubicBezTo>
                <a:close/>
                <a:moveTo>
                  <a:pt x="6868224" y="834043"/>
                </a:moveTo>
                <a:cubicBezTo>
                  <a:pt x="6585839" y="773736"/>
                  <a:pt x="6300108" y="719998"/>
                  <a:pt x="6010974" y="672823"/>
                </a:cubicBezTo>
                <a:cubicBezTo>
                  <a:pt x="6078284" y="647104"/>
                  <a:pt x="6146273" y="622061"/>
                  <a:pt x="6214936" y="597693"/>
                </a:cubicBezTo>
                <a:cubicBezTo>
                  <a:pt x="6567678" y="652850"/>
                  <a:pt x="6916483" y="717312"/>
                  <a:pt x="7261225" y="791093"/>
                </a:cubicBezTo>
                <a:cubicBezTo>
                  <a:pt x="7129590" y="804270"/>
                  <a:pt x="6998589" y="818605"/>
                  <a:pt x="6868224" y="834106"/>
                </a:cubicBezTo>
                <a:close/>
                <a:moveTo>
                  <a:pt x="6838950" y="837591"/>
                </a:moveTo>
                <a:cubicBezTo>
                  <a:pt x="6707950" y="853301"/>
                  <a:pt x="6577584" y="870196"/>
                  <a:pt x="6447917" y="888269"/>
                </a:cubicBezTo>
                <a:cubicBezTo>
                  <a:pt x="6227782" y="843336"/>
                  <a:pt x="6004389" y="802388"/>
                  <a:pt x="5777738" y="765438"/>
                </a:cubicBezTo>
                <a:cubicBezTo>
                  <a:pt x="5848731" y="736127"/>
                  <a:pt x="5920486" y="707538"/>
                  <a:pt x="5993003" y="679665"/>
                </a:cubicBezTo>
                <a:cubicBezTo>
                  <a:pt x="6278245" y="725991"/>
                  <a:pt x="6560249" y="778658"/>
                  <a:pt x="6839014" y="837654"/>
                </a:cubicBezTo>
                <a:close/>
                <a:moveTo>
                  <a:pt x="5760022" y="762524"/>
                </a:moveTo>
                <a:cubicBezTo>
                  <a:pt x="5569947" y="731737"/>
                  <a:pt x="5377923" y="703718"/>
                  <a:pt x="5183950" y="678461"/>
                </a:cubicBezTo>
                <a:cubicBezTo>
                  <a:pt x="5312728" y="656752"/>
                  <a:pt x="5441842" y="635999"/>
                  <a:pt x="5571300" y="616190"/>
                </a:cubicBezTo>
                <a:cubicBezTo>
                  <a:pt x="5706256" y="634941"/>
                  <a:pt x="5840559" y="655086"/>
                  <a:pt x="5974207" y="676624"/>
                </a:cubicBezTo>
                <a:cubicBezTo>
                  <a:pt x="5902071" y="704497"/>
                  <a:pt x="5830678" y="733130"/>
                  <a:pt x="5760022" y="762524"/>
                </a:cubicBezTo>
                <a:close/>
                <a:moveTo>
                  <a:pt x="5151755" y="674280"/>
                </a:moveTo>
                <a:cubicBezTo>
                  <a:pt x="5044612" y="660597"/>
                  <a:pt x="4936916" y="647737"/>
                  <a:pt x="4828667" y="635701"/>
                </a:cubicBezTo>
                <a:cubicBezTo>
                  <a:pt x="4723848" y="624088"/>
                  <a:pt x="4618482" y="613319"/>
                  <a:pt x="4512564" y="603394"/>
                </a:cubicBezTo>
                <a:cubicBezTo>
                  <a:pt x="4587113" y="574254"/>
                  <a:pt x="4662253" y="546191"/>
                  <a:pt x="4737989" y="519205"/>
                </a:cubicBezTo>
                <a:cubicBezTo>
                  <a:pt x="4793615" y="524399"/>
                  <a:pt x="4849114" y="529847"/>
                  <a:pt x="4904486" y="535549"/>
                </a:cubicBezTo>
                <a:cubicBezTo>
                  <a:pt x="5117256" y="557467"/>
                  <a:pt x="5328622" y="582806"/>
                  <a:pt x="5538597" y="611566"/>
                </a:cubicBezTo>
                <a:cubicBezTo>
                  <a:pt x="5409267" y="631584"/>
                  <a:pt x="5280324" y="652489"/>
                  <a:pt x="5151755" y="674280"/>
                </a:cubicBezTo>
                <a:close/>
                <a:moveTo>
                  <a:pt x="4491482" y="601810"/>
                </a:moveTo>
                <a:cubicBezTo>
                  <a:pt x="4223468" y="576471"/>
                  <a:pt x="3952050" y="556601"/>
                  <a:pt x="3677222" y="542200"/>
                </a:cubicBezTo>
                <a:cubicBezTo>
                  <a:pt x="3810953" y="515974"/>
                  <a:pt x="3942715" y="491269"/>
                  <a:pt x="4072509" y="468083"/>
                </a:cubicBezTo>
                <a:cubicBezTo>
                  <a:pt x="4288155" y="481217"/>
                  <a:pt x="4502468" y="497561"/>
                  <a:pt x="4715447" y="517114"/>
                </a:cubicBezTo>
                <a:cubicBezTo>
                  <a:pt x="4640218" y="544016"/>
                  <a:pt x="4565568" y="572248"/>
                  <a:pt x="4491482" y="601810"/>
                </a:cubicBezTo>
                <a:close/>
                <a:moveTo>
                  <a:pt x="3637852" y="540300"/>
                </a:moveTo>
                <a:cubicBezTo>
                  <a:pt x="3440411" y="530207"/>
                  <a:pt x="3241440" y="522879"/>
                  <a:pt x="3040952" y="518318"/>
                </a:cubicBezTo>
                <a:cubicBezTo>
                  <a:pt x="3113932" y="489896"/>
                  <a:pt x="3187529" y="462445"/>
                  <a:pt x="3261741" y="435966"/>
                </a:cubicBezTo>
                <a:cubicBezTo>
                  <a:pt x="3520269" y="440950"/>
                  <a:pt x="3777126" y="450853"/>
                  <a:pt x="4032314" y="465676"/>
                </a:cubicBezTo>
                <a:cubicBezTo>
                  <a:pt x="3902818" y="488861"/>
                  <a:pt x="3771329" y="513736"/>
                  <a:pt x="3637852" y="540300"/>
                </a:cubicBezTo>
                <a:close/>
                <a:moveTo>
                  <a:pt x="3016314" y="517748"/>
                </a:moveTo>
                <a:cubicBezTo>
                  <a:pt x="2556066" y="507655"/>
                  <a:pt x="2088280" y="511877"/>
                  <a:pt x="1612964" y="530417"/>
                </a:cubicBezTo>
                <a:cubicBezTo>
                  <a:pt x="1751565" y="502460"/>
                  <a:pt x="1896764" y="474524"/>
                  <a:pt x="2048574" y="446608"/>
                </a:cubicBezTo>
                <a:cubicBezTo>
                  <a:pt x="2447227" y="431828"/>
                  <a:pt x="2842724" y="428027"/>
                  <a:pt x="3235071" y="435206"/>
                </a:cubicBezTo>
                <a:cubicBezTo>
                  <a:pt x="3161494" y="461812"/>
                  <a:pt x="3088577" y="489326"/>
                  <a:pt x="3016314" y="517748"/>
                </a:cubicBezTo>
                <a:close/>
                <a:moveTo>
                  <a:pt x="2993581" y="526807"/>
                </a:moveTo>
                <a:cubicBezTo>
                  <a:pt x="2900445" y="563675"/>
                  <a:pt x="2808478" y="601980"/>
                  <a:pt x="2717673" y="641719"/>
                </a:cubicBezTo>
                <a:cubicBezTo>
                  <a:pt x="2197227" y="624235"/>
                  <a:pt x="1663637" y="622124"/>
                  <a:pt x="1116902" y="635385"/>
                </a:cubicBezTo>
                <a:cubicBezTo>
                  <a:pt x="1253046" y="605041"/>
                  <a:pt x="1399477" y="573684"/>
                  <a:pt x="1555052" y="542010"/>
                </a:cubicBezTo>
                <a:cubicBezTo>
                  <a:pt x="2041970" y="521908"/>
                  <a:pt x="2521414" y="516840"/>
                  <a:pt x="2993390" y="526807"/>
                </a:cubicBezTo>
                <a:close/>
                <a:moveTo>
                  <a:pt x="2719515" y="651285"/>
                </a:moveTo>
                <a:cubicBezTo>
                  <a:pt x="2828989" y="654959"/>
                  <a:pt x="2937891" y="659311"/>
                  <a:pt x="3046222" y="664335"/>
                </a:cubicBezTo>
                <a:cubicBezTo>
                  <a:pt x="2837307" y="710452"/>
                  <a:pt x="2624626" y="759863"/>
                  <a:pt x="2408174" y="812568"/>
                </a:cubicBezTo>
                <a:lnTo>
                  <a:pt x="2340928" y="829039"/>
                </a:lnTo>
                <a:cubicBezTo>
                  <a:pt x="2386775" y="806024"/>
                  <a:pt x="2432895" y="783384"/>
                  <a:pt x="2479294" y="761130"/>
                </a:cubicBezTo>
                <a:cubicBezTo>
                  <a:pt x="2558288" y="723375"/>
                  <a:pt x="2638298" y="686760"/>
                  <a:pt x="2719324" y="651285"/>
                </a:cubicBezTo>
                <a:close/>
                <a:moveTo>
                  <a:pt x="2410524" y="821817"/>
                </a:moveTo>
                <a:cubicBezTo>
                  <a:pt x="2638616" y="766280"/>
                  <a:pt x="2862625" y="714360"/>
                  <a:pt x="3082544" y="666045"/>
                </a:cubicBezTo>
                <a:cubicBezTo>
                  <a:pt x="3448387" y="683573"/>
                  <a:pt x="3806889" y="708912"/>
                  <a:pt x="4158044" y="742062"/>
                </a:cubicBezTo>
                <a:cubicBezTo>
                  <a:pt x="4001408" y="812296"/>
                  <a:pt x="3847973" y="887445"/>
                  <a:pt x="3697732" y="967517"/>
                </a:cubicBezTo>
                <a:cubicBezTo>
                  <a:pt x="3568319" y="997797"/>
                  <a:pt x="3439541" y="1029072"/>
                  <a:pt x="3311398" y="1061335"/>
                </a:cubicBezTo>
                <a:cubicBezTo>
                  <a:pt x="3079623" y="1119824"/>
                  <a:pt x="2859488" y="1178952"/>
                  <a:pt x="2650998" y="1238708"/>
                </a:cubicBezTo>
                <a:cubicBezTo>
                  <a:pt x="2376253" y="1191704"/>
                  <a:pt x="2099393" y="1150446"/>
                  <a:pt x="1820418" y="1114927"/>
                </a:cubicBezTo>
                <a:cubicBezTo>
                  <a:pt x="1976419" y="1021299"/>
                  <a:pt x="2137048" y="932504"/>
                  <a:pt x="2302320" y="848550"/>
                </a:cubicBezTo>
                <a:cubicBezTo>
                  <a:pt x="2338051" y="839510"/>
                  <a:pt x="2374056" y="830603"/>
                  <a:pt x="2410333" y="821817"/>
                </a:cubicBezTo>
                <a:close/>
                <a:moveTo>
                  <a:pt x="1805432" y="1112710"/>
                </a:moveTo>
                <a:cubicBezTo>
                  <a:pt x="1687278" y="1097760"/>
                  <a:pt x="1568749" y="1083804"/>
                  <a:pt x="1449832" y="1070837"/>
                </a:cubicBezTo>
                <a:cubicBezTo>
                  <a:pt x="1699514" y="1002295"/>
                  <a:pt x="1972691" y="930205"/>
                  <a:pt x="2262188" y="858242"/>
                </a:cubicBezTo>
                <a:cubicBezTo>
                  <a:pt x="2105768" y="938611"/>
                  <a:pt x="1953451" y="1023434"/>
                  <a:pt x="1805242" y="1112710"/>
                </a:cubicBezTo>
                <a:close/>
                <a:moveTo>
                  <a:pt x="1792351" y="1120692"/>
                </a:moveTo>
                <a:cubicBezTo>
                  <a:pt x="1749425" y="1146664"/>
                  <a:pt x="1706753" y="1172827"/>
                  <a:pt x="1664526" y="1199559"/>
                </a:cubicBezTo>
                <a:cubicBezTo>
                  <a:pt x="1527620" y="1180980"/>
                  <a:pt x="1390034" y="1163850"/>
                  <a:pt x="1251776" y="1148184"/>
                </a:cubicBezTo>
                <a:cubicBezTo>
                  <a:pt x="1232726" y="1146031"/>
                  <a:pt x="1213676" y="1144067"/>
                  <a:pt x="1194626" y="1141850"/>
                </a:cubicBezTo>
                <a:cubicBezTo>
                  <a:pt x="1268794" y="1120736"/>
                  <a:pt x="1345546" y="1099324"/>
                  <a:pt x="1424877" y="1077615"/>
                </a:cubicBezTo>
                <a:lnTo>
                  <a:pt x="1430401" y="1078185"/>
                </a:lnTo>
                <a:cubicBezTo>
                  <a:pt x="1551349" y="1091279"/>
                  <a:pt x="1671936" y="1105444"/>
                  <a:pt x="1792161" y="1120692"/>
                </a:cubicBezTo>
                <a:close/>
                <a:moveTo>
                  <a:pt x="1666748" y="1209378"/>
                </a:moveTo>
                <a:cubicBezTo>
                  <a:pt x="1905000" y="1241686"/>
                  <a:pt x="2141239" y="1278320"/>
                  <a:pt x="2375472" y="1319287"/>
                </a:cubicBezTo>
                <a:cubicBezTo>
                  <a:pt x="2289029" y="1345215"/>
                  <a:pt x="2204974" y="1370997"/>
                  <a:pt x="2123313" y="1396634"/>
                </a:cubicBezTo>
                <a:cubicBezTo>
                  <a:pt x="1925574" y="1362255"/>
                  <a:pt x="1725613" y="1330898"/>
                  <a:pt x="1523429" y="1302563"/>
                </a:cubicBezTo>
                <a:cubicBezTo>
                  <a:pt x="1570419" y="1271142"/>
                  <a:pt x="1618126" y="1240102"/>
                  <a:pt x="1666558" y="1209442"/>
                </a:cubicBezTo>
                <a:close/>
                <a:moveTo>
                  <a:pt x="2103565" y="1402842"/>
                </a:moveTo>
                <a:cubicBezTo>
                  <a:pt x="1982280" y="1440851"/>
                  <a:pt x="1866500" y="1478435"/>
                  <a:pt x="1756220" y="1515601"/>
                </a:cubicBezTo>
                <a:cubicBezTo>
                  <a:pt x="1610424" y="1491320"/>
                  <a:pt x="1463186" y="1468515"/>
                  <a:pt x="1314514" y="1447186"/>
                </a:cubicBezTo>
                <a:cubicBezTo>
                  <a:pt x="1379157" y="1400733"/>
                  <a:pt x="1444771" y="1355186"/>
                  <a:pt x="1511364" y="1310545"/>
                </a:cubicBezTo>
                <a:cubicBezTo>
                  <a:pt x="1710754" y="1338291"/>
                  <a:pt x="1908092" y="1369078"/>
                  <a:pt x="2103374" y="1402906"/>
                </a:cubicBezTo>
                <a:close/>
                <a:moveTo>
                  <a:pt x="1736789" y="1522126"/>
                </a:moveTo>
                <a:cubicBezTo>
                  <a:pt x="1584389" y="1573393"/>
                  <a:pt x="1442930" y="1622767"/>
                  <a:pt x="1312418" y="1670233"/>
                </a:cubicBezTo>
                <a:cubicBezTo>
                  <a:pt x="1247775" y="1645318"/>
                  <a:pt x="1181926" y="1620486"/>
                  <a:pt x="1114870" y="1595736"/>
                </a:cubicBezTo>
                <a:cubicBezTo>
                  <a:pt x="1176509" y="1548054"/>
                  <a:pt x="1239266" y="1501202"/>
                  <a:pt x="1303147" y="1455168"/>
                </a:cubicBezTo>
                <a:cubicBezTo>
                  <a:pt x="1449280" y="1476072"/>
                  <a:pt x="1593831" y="1498390"/>
                  <a:pt x="1736789" y="1522126"/>
                </a:cubicBezTo>
                <a:close/>
                <a:moveTo>
                  <a:pt x="1298639" y="1675174"/>
                </a:moveTo>
                <a:cubicBezTo>
                  <a:pt x="1206989" y="1708451"/>
                  <a:pt x="1121175" y="1740403"/>
                  <a:pt x="1041210" y="1771019"/>
                </a:cubicBezTo>
                <a:cubicBezTo>
                  <a:pt x="1009206" y="1758052"/>
                  <a:pt x="976865" y="1745047"/>
                  <a:pt x="944181" y="1731997"/>
                </a:cubicBezTo>
                <a:cubicBezTo>
                  <a:pt x="992905" y="1691708"/>
                  <a:pt x="1043857" y="1650830"/>
                  <a:pt x="1097026" y="1609356"/>
                </a:cubicBezTo>
                <a:lnTo>
                  <a:pt x="1105853" y="1602578"/>
                </a:lnTo>
                <a:cubicBezTo>
                  <a:pt x="1171340" y="1626732"/>
                  <a:pt x="1235647" y="1650931"/>
                  <a:pt x="1298766" y="1675174"/>
                </a:cubicBezTo>
                <a:close/>
                <a:moveTo>
                  <a:pt x="1847152" y="2137613"/>
                </a:moveTo>
                <a:cubicBezTo>
                  <a:pt x="1760157" y="2175919"/>
                  <a:pt x="1680655" y="2211983"/>
                  <a:pt x="1608646" y="2245810"/>
                </a:cubicBezTo>
                <a:lnTo>
                  <a:pt x="1591691" y="2253729"/>
                </a:lnTo>
                <a:cubicBezTo>
                  <a:pt x="1366838" y="2136409"/>
                  <a:pt x="1101154" y="2008130"/>
                  <a:pt x="795719" y="1877317"/>
                </a:cubicBezTo>
                <a:lnTo>
                  <a:pt x="861060" y="1851281"/>
                </a:lnTo>
                <a:cubicBezTo>
                  <a:pt x="917194" y="1829154"/>
                  <a:pt x="977328" y="1805797"/>
                  <a:pt x="1041464" y="1781218"/>
                </a:cubicBezTo>
                <a:cubicBezTo>
                  <a:pt x="1341374" y="1903099"/>
                  <a:pt x="1610614" y="2023903"/>
                  <a:pt x="1847279" y="2137549"/>
                </a:cubicBezTo>
                <a:close/>
                <a:moveTo>
                  <a:pt x="1054164" y="1776277"/>
                </a:moveTo>
                <a:cubicBezTo>
                  <a:pt x="1134345" y="1745743"/>
                  <a:pt x="1220362" y="1713772"/>
                  <a:pt x="1312228" y="1680369"/>
                </a:cubicBezTo>
                <a:cubicBezTo>
                  <a:pt x="1609725" y="1794711"/>
                  <a:pt x="1881505" y="1909054"/>
                  <a:pt x="2125917" y="2018836"/>
                </a:cubicBezTo>
                <a:cubicBezTo>
                  <a:pt x="2030413" y="2058156"/>
                  <a:pt x="1941341" y="2096056"/>
                  <a:pt x="1858709" y="2132545"/>
                </a:cubicBezTo>
                <a:cubicBezTo>
                  <a:pt x="1622616" y="2018899"/>
                  <a:pt x="1353884" y="1898221"/>
                  <a:pt x="1054164" y="1776277"/>
                </a:cubicBezTo>
                <a:close/>
                <a:moveTo>
                  <a:pt x="2609914" y="1688540"/>
                </a:moveTo>
                <a:cubicBezTo>
                  <a:pt x="2690730" y="1706025"/>
                  <a:pt x="2770969" y="1723996"/>
                  <a:pt x="2850642" y="1742449"/>
                </a:cubicBezTo>
                <a:cubicBezTo>
                  <a:pt x="2652141" y="1812132"/>
                  <a:pt x="2469642" y="1881118"/>
                  <a:pt x="2303272" y="1946999"/>
                </a:cubicBezTo>
                <a:cubicBezTo>
                  <a:pt x="2394966" y="1865154"/>
                  <a:pt x="2497201" y="1778178"/>
                  <a:pt x="2610231" y="1688540"/>
                </a:cubicBezTo>
                <a:close/>
                <a:moveTo>
                  <a:pt x="2619566" y="1680939"/>
                </a:moveTo>
                <a:cubicBezTo>
                  <a:pt x="2661431" y="1647871"/>
                  <a:pt x="2704700" y="1614531"/>
                  <a:pt x="2749360" y="1580913"/>
                </a:cubicBezTo>
                <a:cubicBezTo>
                  <a:pt x="2768029" y="1566850"/>
                  <a:pt x="2786888" y="1552976"/>
                  <a:pt x="2805748" y="1539103"/>
                </a:cubicBezTo>
                <a:cubicBezTo>
                  <a:pt x="2935288" y="1567021"/>
                  <a:pt x="3063685" y="1596325"/>
                  <a:pt x="3190939" y="1627030"/>
                </a:cubicBezTo>
                <a:cubicBezTo>
                  <a:pt x="3078925" y="1663645"/>
                  <a:pt x="2971083" y="1700152"/>
                  <a:pt x="2867406" y="1736558"/>
                </a:cubicBezTo>
                <a:cubicBezTo>
                  <a:pt x="2785663" y="1717509"/>
                  <a:pt x="2703151" y="1698974"/>
                  <a:pt x="2619883" y="1680939"/>
                </a:cubicBezTo>
                <a:close/>
                <a:moveTo>
                  <a:pt x="3208592" y="1631274"/>
                </a:moveTo>
                <a:cubicBezTo>
                  <a:pt x="3454127" y="1690694"/>
                  <a:pt x="3695275" y="1755100"/>
                  <a:pt x="3932047" y="1824485"/>
                </a:cubicBezTo>
                <a:cubicBezTo>
                  <a:pt x="3869608" y="1874529"/>
                  <a:pt x="3811060" y="1923307"/>
                  <a:pt x="3756406" y="1970818"/>
                </a:cubicBezTo>
                <a:cubicBezTo>
                  <a:pt x="3474847" y="1887408"/>
                  <a:pt x="3184271" y="1810675"/>
                  <a:pt x="2884678" y="1740612"/>
                </a:cubicBezTo>
                <a:cubicBezTo>
                  <a:pt x="2988647" y="1704333"/>
                  <a:pt x="3096724" y="1667889"/>
                  <a:pt x="3208909" y="1631274"/>
                </a:cubicBezTo>
                <a:close/>
                <a:moveTo>
                  <a:pt x="3225864" y="1625636"/>
                </a:moveTo>
                <a:cubicBezTo>
                  <a:pt x="3306553" y="1599493"/>
                  <a:pt x="3389357" y="1573355"/>
                  <a:pt x="3474276" y="1547212"/>
                </a:cubicBezTo>
                <a:cubicBezTo>
                  <a:pt x="3680098" y="1596876"/>
                  <a:pt x="3883704" y="1649791"/>
                  <a:pt x="4085082" y="1705961"/>
                </a:cubicBezTo>
                <a:cubicBezTo>
                  <a:pt x="4035127" y="1743545"/>
                  <a:pt x="3987248" y="1780648"/>
                  <a:pt x="3941445" y="1817263"/>
                </a:cubicBezTo>
                <a:cubicBezTo>
                  <a:pt x="3707467" y="1748512"/>
                  <a:pt x="3469050" y="1684632"/>
                  <a:pt x="3226181" y="1625636"/>
                </a:cubicBezTo>
                <a:close/>
                <a:moveTo>
                  <a:pt x="4096322" y="1709192"/>
                </a:moveTo>
                <a:cubicBezTo>
                  <a:pt x="4217353" y="1743229"/>
                  <a:pt x="4337577" y="1778494"/>
                  <a:pt x="4457002" y="1814983"/>
                </a:cubicBezTo>
                <a:cubicBezTo>
                  <a:pt x="4370134" y="1842602"/>
                  <a:pt x="4286168" y="1870051"/>
                  <a:pt x="4205097" y="1897335"/>
                </a:cubicBezTo>
                <a:cubicBezTo>
                  <a:pt x="4121487" y="1871064"/>
                  <a:pt x="4037222" y="1845408"/>
                  <a:pt x="3952304" y="1820367"/>
                </a:cubicBezTo>
                <a:cubicBezTo>
                  <a:pt x="3998278" y="1783961"/>
                  <a:pt x="4046391" y="1746903"/>
                  <a:pt x="4096639" y="1709192"/>
                </a:cubicBezTo>
                <a:close/>
                <a:moveTo>
                  <a:pt x="4472940" y="1819924"/>
                </a:moveTo>
                <a:cubicBezTo>
                  <a:pt x="4596003" y="1857679"/>
                  <a:pt x="4718177" y="1896720"/>
                  <a:pt x="4839462" y="1937054"/>
                </a:cubicBezTo>
                <a:cubicBezTo>
                  <a:pt x="4929588" y="1967080"/>
                  <a:pt x="5017624" y="1997297"/>
                  <a:pt x="5103559" y="2027704"/>
                </a:cubicBezTo>
                <a:cubicBezTo>
                  <a:pt x="5051533" y="2073777"/>
                  <a:pt x="5004308" y="2117468"/>
                  <a:pt x="4961890" y="2158771"/>
                </a:cubicBezTo>
                <a:cubicBezTo>
                  <a:pt x="4833239" y="2110075"/>
                  <a:pt x="4698683" y="2061513"/>
                  <a:pt x="4558221" y="2013071"/>
                </a:cubicBezTo>
                <a:cubicBezTo>
                  <a:pt x="4446969" y="1975062"/>
                  <a:pt x="4334510" y="1938112"/>
                  <a:pt x="4220845" y="1902212"/>
                </a:cubicBezTo>
                <a:cubicBezTo>
                  <a:pt x="4302081" y="1875017"/>
                  <a:pt x="4386218" y="1847588"/>
                  <a:pt x="4473258" y="1819924"/>
                </a:cubicBezTo>
                <a:close/>
                <a:moveTo>
                  <a:pt x="4842891" y="1928185"/>
                </a:moveTo>
                <a:cubicBezTo>
                  <a:pt x="4725842" y="1889163"/>
                  <a:pt x="4608049" y="1851388"/>
                  <a:pt x="4489514" y="1814856"/>
                </a:cubicBezTo>
                <a:cubicBezTo>
                  <a:pt x="4574432" y="1787996"/>
                  <a:pt x="4662024" y="1761156"/>
                  <a:pt x="4752277" y="1734341"/>
                </a:cubicBezTo>
                <a:cubicBezTo>
                  <a:pt x="4907852" y="1780160"/>
                  <a:pt x="5062220" y="1827887"/>
                  <a:pt x="5215382" y="1877507"/>
                </a:cubicBezTo>
                <a:lnTo>
                  <a:pt x="5263261" y="1893154"/>
                </a:lnTo>
                <a:cubicBezTo>
                  <a:pt x="5208861" y="1937117"/>
                  <a:pt x="5158486" y="1979668"/>
                  <a:pt x="5112131" y="2020799"/>
                </a:cubicBezTo>
                <a:cubicBezTo>
                  <a:pt x="5024628" y="1989677"/>
                  <a:pt x="4934985" y="1958801"/>
                  <a:pt x="4843209" y="1928185"/>
                </a:cubicBezTo>
                <a:close/>
                <a:moveTo>
                  <a:pt x="5273294" y="1896511"/>
                </a:moveTo>
                <a:cubicBezTo>
                  <a:pt x="5421884" y="1945371"/>
                  <a:pt x="5565267" y="1994637"/>
                  <a:pt x="5703443" y="2044301"/>
                </a:cubicBezTo>
                <a:cubicBezTo>
                  <a:pt x="5605272" y="2074791"/>
                  <a:pt x="5511800" y="2104799"/>
                  <a:pt x="5423027" y="2134319"/>
                </a:cubicBezTo>
                <a:cubicBezTo>
                  <a:pt x="5325663" y="2097533"/>
                  <a:pt x="5225288" y="2060753"/>
                  <a:pt x="5121910" y="2023967"/>
                </a:cubicBezTo>
                <a:cubicBezTo>
                  <a:pt x="5172285" y="1980086"/>
                  <a:pt x="5222856" y="1937643"/>
                  <a:pt x="5273612" y="1896638"/>
                </a:cubicBezTo>
                <a:close/>
                <a:moveTo>
                  <a:pt x="5718302" y="2049686"/>
                </a:moveTo>
                <a:cubicBezTo>
                  <a:pt x="5929376" y="2125703"/>
                  <a:pt x="6127941" y="2201720"/>
                  <a:pt x="6313488" y="2277104"/>
                </a:cubicBezTo>
                <a:lnTo>
                  <a:pt x="6307138" y="2283059"/>
                </a:lnTo>
                <a:cubicBezTo>
                  <a:pt x="6247003" y="2337982"/>
                  <a:pt x="6195251" y="2388216"/>
                  <a:pt x="6151499" y="2432560"/>
                </a:cubicBezTo>
                <a:cubicBezTo>
                  <a:pt x="5936361" y="2337538"/>
                  <a:pt x="5697919" y="2238652"/>
                  <a:pt x="5437315" y="2139703"/>
                </a:cubicBezTo>
                <a:cubicBezTo>
                  <a:pt x="5526297" y="2110310"/>
                  <a:pt x="5620068" y="2080346"/>
                  <a:pt x="5718620" y="2049813"/>
                </a:cubicBezTo>
                <a:close/>
                <a:moveTo>
                  <a:pt x="5733415" y="2044998"/>
                </a:moveTo>
                <a:cubicBezTo>
                  <a:pt x="5934139" y="1983171"/>
                  <a:pt x="6153912" y="1919950"/>
                  <a:pt x="6390958" y="1858122"/>
                </a:cubicBezTo>
                <a:cubicBezTo>
                  <a:pt x="6618224" y="1799000"/>
                  <a:pt x="6847904" y="1744331"/>
                  <a:pt x="7080123" y="1694115"/>
                </a:cubicBezTo>
                <a:cubicBezTo>
                  <a:pt x="6739383" y="1913298"/>
                  <a:pt x="6487224" y="2119622"/>
                  <a:pt x="6321298" y="2270009"/>
                </a:cubicBezTo>
                <a:cubicBezTo>
                  <a:pt x="6138228" y="2195829"/>
                  <a:pt x="5942140" y="2120319"/>
                  <a:pt x="5733733" y="2045125"/>
                </a:cubicBezTo>
                <a:close/>
                <a:moveTo>
                  <a:pt x="6388227" y="1849000"/>
                </a:moveTo>
                <a:cubicBezTo>
                  <a:pt x="6146864" y="1912221"/>
                  <a:pt x="5922899" y="1976456"/>
                  <a:pt x="5718874" y="2039804"/>
                </a:cubicBezTo>
                <a:cubicBezTo>
                  <a:pt x="5578793" y="1989379"/>
                  <a:pt x="5433314" y="1939290"/>
                  <a:pt x="5282438" y="1889543"/>
                </a:cubicBezTo>
                <a:cubicBezTo>
                  <a:pt x="5495290" y="1719442"/>
                  <a:pt x="5719756" y="1564328"/>
                  <a:pt x="5954205" y="1425331"/>
                </a:cubicBezTo>
                <a:cubicBezTo>
                  <a:pt x="6303410" y="1348807"/>
                  <a:pt x="6658357" y="1281975"/>
                  <a:pt x="7019036" y="1224835"/>
                </a:cubicBezTo>
                <a:cubicBezTo>
                  <a:pt x="7219125" y="1275938"/>
                  <a:pt x="7414895" y="1330290"/>
                  <a:pt x="7606475" y="1387892"/>
                </a:cubicBezTo>
                <a:cubicBezTo>
                  <a:pt x="7533195" y="1426452"/>
                  <a:pt x="7460996" y="1466000"/>
                  <a:pt x="7389876" y="1506543"/>
                </a:cubicBezTo>
                <a:cubicBezTo>
                  <a:pt x="7288276" y="1564442"/>
                  <a:pt x="7193026" y="1622342"/>
                  <a:pt x="7103301" y="1679418"/>
                </a:cubicBezTo>
                <a:cubicBezTo>
                  <a:pt x="6862636" y="1731028"/>
                  <a:pt x="6624383" y="1787597"/>
                  <a:pt x="6388545" y="1849127"/>
                </a:cubicBezTo>
                <a:close/>
                <a:moveTo>
                  <a:pt x="7394829" y="1514524"/>
                </a:moveTo>
                <a:cubicBezTo>
                  <a:pt x="7468426" y="1472588"/>
                  <a:pt x="7543229" y="1431710"/>
                  <a:pt x="7619175" y="1391883"/>
                </a:cubicBezTo>
                <a:cubicBezTo>
                  <a:pt x="7733158" y="1426262"/>
                  <a:pt x="7845552" y="1461756"/>
                  <a:pt x="7956423" y="1498371"/>
                </a:cubicBezTo>
                <a:lnTo>
                  <a:pt x="7999349" y="1512624"/>
                </a:lnTo>
                <a:cubicBezTo>
                  <a:pt x="7706995" y="1559077"/>
                  <a:pt x="7417182" y="1612796"/>
                  <a:pt x="7129844" y="1673781"/>
                </a:cubicBezTo>
                <a:cubicBezTo>
                  <a:pt x="7226364" y="1612967"/>
                  <a:pt x="7316089" y="1559755"/>
                  <a:pt x="7395146" y="1514651"/>
                </a:cubicBezTo>
                <a:close/>
                <a:moveTo>
                  <a:pt x="7959979" y="1489565"/>
                </a:moveTo>
                <a:cubicBezTo>
                  <a:pt x="7851902" y="1453837"/>
                  <a:pt x="7742238" y="1419186"/>
                  <a:pt x="7631049" y="1385612"/>
                </a:cubicBezTo>
                <a:cubicBezTo>
                  <a:pt x="7713663" y="1342535"/>
                  <a:pt x="7797610" y="1300726"/>
                  <a:pt x="7882890" y="1260183"/>
                </a:cubicBezTo>
                <a:cubicBezTo>
                  <a:pt x="7995285" y="1294391"/>
                  <a:pt x="8106601" y="1329720"/>
                  <a:pt x="8216773" y="1366164"/>
                </a:cubicBezTo>
                <a:cubicBezTo>
                  <a:pt x="8297228" y="1392814"/>
                  <a:pt x="8375777" y="1419648"/>
                  <a:pt x="8452421" y="1446679"/>
                </a:cubicBezTo>
                <a:cubicBezTo>
                  <a:pt x="8307642" y="1465810"/>
                  <a:pt x="8163307" y="1486715"/>
                  <a:pt x="8019415" y="1509393"/>
                </a:cubicBezTo>
                <a:close/>
                <a:moveTo>
                  <a:pt x="8472297" y="1453711"/>
                </a:moveTo>
                <a:cubicBezTo>
                  <a:pt x="8609965" y="1502406"/>
                  <a:pt x="8741346" y="1551266"/>
                  <a:pt x="8866505" y="1600297"/>
                </a:cubicBezTo>
                <a:cubicBezTo>
                  <a:pt x="8790686" y="1646750"/>
                  <a:pt x="8717217" y="1693102"/>
                  <a:pt x="8646096" y="1739345"/>
                </a:cubicBezTo>
                <a:cubicBezTo>
                  <a:pt x="8461248" y="1665482"/>
                  <a:pt x="8258746" y="1590288"/>
                  <a:pt x="8038846" y="1515918"/>
                </a:cubicBezTo>
                <a:cubicBezTo>
                  <a:pt x="8182991" y="1493537"/>
                  <a:pt x="8327645" y="1472842"/>
                  <a:pt x="8472805" y="1453837"/>
                </a:cubicBezTo>
                <a:close/>
                <a:moveTo>
                  <a:pt x="8493061" y="1450987"/>
                </a:moveTo>
                <a:cubicBezTo>
                  <a:pt x="8621332" y="1434345"/>
                  <a:pt x="8749919" y="1419123"/>
                  <a:pt x="8878760" y="1405313"/>
                </a:cubicBezTo>
                <a:cubicBezTo>
                  <a:pt x="8945753" y="1428796"/>
                  <a:pt x="9011412" y="1452336"/>
                  <a:pt x="9075610" y="1475946"/>
                </a:cubicBezTo>
                <a:cubicBezTo>
                  <a:pt x="9033955" y="1500018"/>
                  <a:pt x="8992235" y="1524514"/>
                  <a:pt x="8950452" y="1549429"/>
                </a:cubicBezTo>
                <a:cubicBezTo>
                  <a:pt x="8925623" y="1564252"/>
                  <a:pt x="8901049" y="1579031"/>
                  <a:pt x="8876602" y="1593772"/>
                </a:cubicBezTo>
                <a:cubicBezTo>
                  <a:pt x="8755126" y="1546388"/>
                  <a:pt x="8627428" y="1498833"/>
                  <a:pt x="8493570" y="1451113"/>
                </a:cubicBezTo>
                <a:close/>
                <a:moveTo>
                  <a:pt x="8900732" y="1402969"/>
                </a:moveTo>
                <a:lnTo>
                  <a:pt x="8926132" y="1400308"/>
                </a:lnTo>
                <a:cubicBezTo>
                  <a:pt x="9040050" y="1388399"/>
                  <a:pt x="9154160" y="1377649"/>
                  <a:pt x="9268523" y="1368064"/>
                </a:cubicBezTo>
                <a:cubicBezTo>
                  <a:pt x="9208198" y="1401050"/>
                  <a:pt x="9147683" y="1434915"/>
                  <a:pt x="9086913" y="1469674"/>
                </a:cubicBezTo>
                <a:cubicBezTo>
                  <a:pt x="9026271" y="1447502"/>
                  <a:pt x="8964358" y="1425312"/>
                  <a:pt x="8901240" y="1403096"/>
                </a:cubicBezTo>
                <a:close/>
                <a:moveTo>
                  <a:pt x="8955659" y="1557474"/>
                </a:moveTo>
                <a:cubicBezTo>
                  <a:pt x="8999665" y="1531166"/>
                  <a:pt x="9043543" y="1505402"/>
                  <a:pt x="9087421" y="1480190"/>
                </a:cubicBezTo>
                <a:cubicBezTo>
                  <a:pt x="9344850" y="1574768"/>
                  <a:pt x="9580944" y="1669473"/>
                  <a:pt x="9794557" y="1760947"/>
                </a:cubicBezTo>
                <a:cubicBezTo>
                  <a:pt x="9735058" y="1766477"/>
                  <a:pt x="9675812" y="1772286"/>
                  <a:pt x="9616757" y="1778368"/>
                </a:cubicBezTo>
                <a:cubicBezTo>
                  <a:pt x="9538271" y="1786559"/>
                  <a:pt x="9459976" y="1795281"/>
                  <a:pt x="9381807" y="1804530"/>
                </a:cubicBezTo>
                <a:cubicBezTo>
                  <a:pt x="9230233" y="1737255"/>
                  <a:pt x="9065514" y="1668079"/>
                  <a:pt x="8887968" y="1598460"/>
                </a:cubicBezTo>
                <a:cubicBezTo>
                  <a:pt x="8910510" y="1584859"/>
                  <a:pt x="8933244" y="1571240"/>
                  <a:pt x="8956167" y="1557601"/>
                </a:cubicBezTo>
                <a:close/>
                <a:moveTo>
                  <a:pt x="8875776" y="1215016"/>
                </a:moveTo>
                <a:cubicBezTo>
                  <a:pt x="9020746" y="1260456"/>
                  <a:pt x="9160891" y="1306408"/>
                  <a:pt x="9296209" y="1352861"/>
                </a:cubicBezTo>
                <a:lnTo>
                  <a:pt x="9288907" y="1356788"/>
                </a:lnTo>
                <a:cubicBezTo>
                  <a:pt x="9167241" y="1366924"/>
                  <a:pt x="9045829" y="1378282"/>
                  <a:pt x="8924607" y="1390870"/>
                </a:cubicBezTo>
                <a:lnTo>
                  <a:pt x="8880157" y="1395684"/>
                </a:lnTo>
                <a:cubicBezTo>
                  <a:pt x="8759254" y="1353241"/>
                  <a:pt x="8634095" y="1311159"/>
                  <a:pt x="8504745" y="1269432"/>
                </a:cubicBezTo>
                <a:cubicBezTo>
                  <a:pt x="8378127" y="1228680"/>
                  <a:pt x="8250555" y="1189380"/>
                  <a:pt x="8121968" y="1151542"/>
                </a:cubicBezTo>
                <a:cubicBezTo>
                  <a:pt x="8192262" y="1121008"/>
                  <a:pt x="8263383" y="1091298"/>
                  <a:pt x="8335328" y="1062412"/>
                </a:cubicBezTo>
                <a:lnTo>
                  <a:pt x="8354886" y="1060638"/>
                </a:lnTo>
                <a:cubicBezTo>
                  <a:pt x="8530272" y="1109751"/>
                  <a:pt x="8704072" y="1161253"/>
                  <a:pt x="8876284" y="1215143"/>
                </a:cubicBezTo>
                <a:close/>
                <a:moveTo>
                  <a:pt x="8382064" y="1058484"/>
                </a:moveTo>
                <a:cubicBezTo>
                  <a:pt x="8942197" y="1009789"/>
                  <a:pt x="9510205" y="984070"/>
                  <a:pt x="10085959" y="981327"/>
                </a:cubicBezTo>
                <a:cubicBezTo>
                  <a:pt x="9820021" y="1088555"/>
                  <a:pt x="9560306" y="1210582"/>
                  <a:pt x="9308084" y="1346843"/>
                </a:cubicBezTo>
                <a:cubicBezTo>
                  <a:pt x="9170289" y="1299586"/>
                  <a:pt x="9027414" y="1252708"/>
                  <a:pt x="8879522" y="1206211"/>
                </a:cubicBezTo>
                <a:cubicBezTo>
                  <a:pt x="8715184" y="1154646"/>
                  <a:pt x="8549386" y="1105406"/>
                  <a:pt x="8382064" y="1058484"/>
                </a:cubicBezTo>
                <a:close/>
                <a:moveTo>
                  <a:pt x="8345615" y="1048285"/>
                </a:moveTo>
                <a:cubicBezTo>
                  <a:pt x="8010525" y="954784"/>
                  <a:pt x="7670420" y="870487"/>
                  <a:pt x="7325296" y="795401"/>
                </a:cubicBezTo>
                <a:lnTo>
                  <a:pt x="7329995" y="793817"/>
                </a:lnTo>
                <a:cubicBezTo>
                  <a:pt x="8026718" y="726035"/>
                  <a:pt x="8740077" y="690497"/>
                  <a:pt x="9465691" y="686886"/>
                </a:cubicBezTo>
                <a:cubicBezTo>
                  <a:pt x="9415844" y="699556"/>
                  <a:pt x="9366250" y="712498"/>
                  <a:pt x="9316910" y="725718"/>
                </a:cubicBezTo>
                <a:cubicBezTo>
                  <a:pt x="8987155" y="814348"/>
                  <a:pt x="8662860" y="922052"/>
                  <a:pt x="8345678" y="1048285"/>
                </a:cubicBezTo>
                <a:close/>
                <a:moveTo>
                  <a:pt x="6496812" y="492409"/>
                </a:moveTo>
                <a:cubicBezTo>
                  <a:pt x="6401308" y="523112"/>
                  <a:pt x="6306966" y="554975"/>
                  <a:pt x="6213793" y="588001"/>
                </a:cubicBezTo>
                <a:cubicBezTo>
                  <a:pt x="6141149" y="576682"/>
                  <a:pt x="6068397" y="565745"/>
                  <a:pt x="5995543" y="555186"/>
                </a:cubicBezTo>
                <a:cubicBezTo>
                  <a:pt x="6162040" y="532719"/>
                  <a:pt x="6329128" y="511793"/>
                  <a:pt x="6496812" y="492409"/>
                </a:cubicBezTo>
                <a:close/>
                <a:moveTo>
                  <a:pt x="6194997" y="594652"/>
                </a:moveTo>
                <a:cubicBezTo>
                  <a:pt x="6126753" y="619020"/>
                  <a:pt x="6059024" y="644082"/>
                  <a:pt x="5991797" y="669846"/>
                </a:cubicBezTo>
                <a:cubicBezTo>
                  <a:pt x="5863317" y="649023"/>
                  <a:pt x="5734196" y="629472"/>
                  <a:pt x="5604447" y="611186"/>
                </a:cubicBezTo>
                <a:cubicBezTo>
                  <a:pt x="5722982" y="593279"/>
                  <a:pt x="5841810" y="576175"/>
                  <a:pt x="5960936" y="559874"/>
                </a:cubicBezTo>
                <a:cubicBezTo>
                  <a:pt x="6039250" y="570939"/>
                  <a:pt x="6117273" y="582532"/>
                  <a:pt x="6194997" y="594652"/>
                </a:cubicBezTo>
                <a:close/>
                <a:moveTo>
                  <a:pt x="5083747" y="454400"/>
                </a:moveTo>
                <a:cubicBezTo>
                  <a:pt x="5366785" y="482020"/>
                  <a:pt x="5647881" y="515531"/>
                  <a:pt x="5927027" y="554933"/>
                </a:cubicBezTo>
                <a:cubicBezTo>
                  <a:pt x="5808199" y="571361"/>
                  <a:pt x="5689664" y="588571"/>
                  <a:pt x="5571427" y="606561"/>
                </a:cubicBezTo>
                <a:cubicBezTo>
                  <a:pt x="5351291" y="576028"/>
                  <a:pt x="5129422" y="549211"/>
                  <a:pt x="4905820" y="526110"/>
                </a:cubicBezTo>
                <a:cubicBezTo>
                  <a:pt x="4857134" y="521126"/>
                  <a:pt x="4808455" y="516291"/>
                  <a:pt x="4759770" y="511603"/>
                </a:cubicBezTo>
                <a:cubicBezTo>
                  <a:pt x="4826953" y="487911"/>
                  <a:pt x="4894688" y="465043"/>
                  <a:pt x="4962970" y="442998"/>
                </a:cubicBezTo>
                <a:cubicBezTo>
                  <a:pt x="5002721" y="446735"/>
                  <a:pt x="5043170" y="450409"/>
                  <a:pt x="5083556" y="454400"/>
                </a:cubicBezTo>
                <a:close/>
                <a:moveTo>
                  <a:pt x="4635564" y="375089"/>
                </a:moveTo>
                <a:cubicBezTo>
                  <a:pt x="4967586" y="325128"/>
                  <a:pt x="5282965" y="286676"/>
                  <a:pt x="5581714" y="259733"/>
                </a:cubicBezTo>
                <a:cubicBezTo>
                  <a:pt x="5371230" y="309946"/>
                  <a:pt x="5164392" y="367888"/>
                  <a:pt x="4961192" y="433559"/>
                </a:cubicBezTo>
                <a:cubicBezTo>
                  <a:pt x="4807268" y="419496"/>
                  <a:pt x="4652753" y="407185"/>
                  <a:pt x="4497642" y="396627"/>
                </a:cubicBezTo>
                <a:cubicBezTo>
                  <a:pt x="4544041" y="389152"/>
                  <a:pt x="4590015" y="381973"/>
                  <a:pt x="4635564" y="375089"/>
                </a:cubicBezTo>
                <a:close/>
                <a:moveTo>
                  <a:pt x="4455668" y="403089"/>
                </a:moveTo>
                <a:cubicBezTo>
                  <a:pt x="4617085" y="413731"/>
                  <a:pt x="4777950" y="426295"/>
                  <a:pt x="4938268" y="440780"/>
                </a:cubicBezTo>
                <a:cubicBezTo>
                  <a:pt x="4870533" y="462910"/>
                  <a:pt x="4803312" y="485821"/>
                  <a:pt x="4736592" y="509513"/>
                </a:cubicBezTo>
                <a:cubicBezTo>
                  <a:pt x="4529754" y="490044"/>
                  <a:pt x="4321601" y="473869"/>
                  <a:pt x="4112133" y="460988"/>
                </a:cubicBezTo>
                <a:cubicBezTo>
                  <a:pt x="4228548" y="440421"/>
                  <a:pt x="4343146" y="421122"/>
                  <a:pt x="4455922" y="403089"/>
                </a:cubicBezTo>
                <a:close/>
                <a:moveTo>
                  <a:pt x="3476879" y="361659"/>
                </a:moveTo>
                <a:cubicBezTo>
                  <a:pt x="3790823" y="367614"/>
                  <a:pt x="4102970" y="380516"/>
                  <a:pt x="4413314" y="400365"/>
                </a:cubicBezTo>
                <a:cubicBezTo>
                  <a:pt x="4301300" y="418525"/>
                  <a:pt x="4187615" y="437909"/>
                  <a:pt x="4072255" y="458518"/>
                </a:cubicBezTo>
                <a:cubicBezTo>
                  <a:pt x="3812331" y="443018"/>
                  <a:pt x="3550603" y="432461"/>
                  <a:pt x="3287078" y="426844"/>
                </a:cubicBezTo>
                <a:cubicBezTo>
                  <a:pt x="3349771" y="404461"/>
                  <a:pt x="3413043" y="382733"/>
                  <a:pt x="3476879" y="361659"/>
                </a:cubicBezTo>
                <a:close/>
                <a:moveTo>
                  <a:pt x="2518029" y="364890"/>
                </a:moveTo>
                <a:cubicBezTo>
                  <a:pt x="2829604" y="356992"/>
                  <a:pt x="3139631" y="355725"/>
                  <a:pt x="3448114" y="361089"/>
                </a:cubicBezTo>
                <a:cubicBezTo>
                  <a:pt x="3385039" y="382205"/>
                  <a:pt x="3322384" y="403891"/>
                  <a:pt x="3260154" y="426147"/>
                </a:cubicBezTo>
                <a:cubicBezTo>
                  <a:pt x="2880932" y="418630"/>
                  <a:pt x="2498427" y="421438"/>
                  <a:pt x="2112645" y="434572"/>
                </a:cubicBezTo>
                <a:cubicBezTo>
                  <a:pt x="2243709" y="410923"/>
                  <a:pt x="2378856" y="387695"/>
                  <a:pt x="2518093" y="364890"/>
                </a:cubicBezTo>
                <a:close/>
                <a:moveTo>
                  <a:pt x="1588961" y="408220"/>
                </a:moveTo>
                <a:cubicBezTo>
                  <a:pt x="1876444" y="388751"/>
                  <a:pt x="2162893" y="374941"/>
                  <a:pt x="2448306" y="366790"/>
                </a:cubicBezTo>
                <a:cubicBezTo>
                  <a:pt x="2310511" y="389680"/>
                  <a:pt x="2176799" y="413118"/>
                  <a:pt x="2047177" y="437106"/>
                </a:cubicBezTo>
                <a:cubicBezTo>
                  <a:pt x="1839405" y="444624"/>
                  <a:pt x="1630851" y="455181"/>
                  <a:pt x="1421511" y="468780"/>
                </a:cubicBezTo>
                <a:cubicBezTo>
                  <a:pt x="1477474" y="447918"/>
                  <a:pt x="1533290" y="427731"/>
                  <a:pt x="1588961" y="408220"/>
                </a:cubicBezTo>
                <a:close/>
                <a:moveTo>
                  <a:pt x="1390714" y="480373"/>
                </a:moveTo>
                <a:cubicBezTo>
                  <a:pt x="1588370" y="467196"/>
                  <a:pt x="1785366" y="456638"/>
                  <a:pt x="1981708" y="448699"/>
                </a:cubicBezTo>
                <a:cubicBezTo>
                  <a:pt x="1832610" y="476529"/>
                  <a:pt x="1689907" y="504339"/>
                  <a:pt x="1553591" y="532128"/>
                </a:cubicBezTo>
                <a:cubicBezTo>
                  <a:pt x="1440771" y="536900"/>
                  <a:pt x="1327766" y="542411"/>
                  <a:pt x="1214565" y="548662"/>
                </a:cubicBezTo>
                <a:cubicBezTo>
                  <a:pt x="1273448" y="524970"/>
                  <a:pt x="1332167" y="502207"/>
                  <a:pt x="1390714" y="480373"/>
                </a:cubicBezTo>
                <a:close/>
                <a:moveTo>
                  <a:pt x="1186879" y="559747"/>
                </a:moveTo>
                <a:cubicBezTo>
                  <a:pt x="1289749" y="554004"/>
                  <a:pt x="1392320" y="548894"/>
                  <a:pt x="1494600" y="544417"/>
                </a:cubicBezTo>
                <a:cubicBezTo>
                  <a:pt x="1342835" y="576091"/>
                  <a:pt x="1200087" y="606688"/>
                  <a:pt x="1067562" y="636462"/>
                </a:cubicBezTo>
                <a:lnTo>
                  <a:pt x="997395" y="638362"/>
                </a:lnTo>
                <a:cubicBezTo>
                  <a:pt x="1058564" y="612263"/>
                  <a:pt x="1121728" y="586058"/>
                  <a:pt x="1186879" y="559747"/>
                </a:cubicBezTo>
                <a:close/>
                <a:moveTo>
                  <a:pt x="973709" y="648434"/>
                </a:moveTo>
                <a:lnTo>
                  <a:pt x="1019683" y="647167"/>
                </a:lnTo>
                <a:cubicBezTo>
                  <a:pt x="988651" y="654218"/>
                  <a:pt x="958196" y="661186"/>
                  <a:pt x="928306" y="668072"/>
                </a:cubicBezTo>
                <a:close/>
                <a:moveTo>
                  <a:pt x="881189" y="688787"/>
                </a:moveTo>
                <a:cubicBezTo>
                  <a:pt x="941134" y="674806"/>
                  <a:pt x="1003662" y="660489"/>
                  <a:pt x="1068769" y="645837"/>
                </a:cubicBezTo>
                <a:cubicBezTo>
                  <a:pt x="1624648" y="631605"/>
                  <a:pt x="2167528" y="633167"/>
                  <a:pt x="2697417" y="650525"/>
                </a:cubicBezTo>
                <a:cubicBezTo>
                  <a:pt x="2622442" y="683592"/>
                  <a:pt x="2548211" y="717629"/>
                  <a:pt x="2474722" y="752641"/>
                </a:cubicBezTo>
                <a:cubicBezTo>
                  <a:pt x="2415458" y="780894"/>
                  <a:pt x="2356866" y="809762"/>
                  <a:pt x="2298954" y="839238"/>
                </a:cubicBezTo>
                <a:cubicBezTo>
                  <a:pt x="1985899" y="916649"/>
                  <a:pt x="1691196" y="994440"/>
                  <a:pt x="1423988" y="1067986"/>
                </a:cubicBezTo>
                <a:cubicBezTo>
                  <a:pt x="1046461" y="1027399"/>
                  <a:pt x="665461" y="997372"/>
                  <a:pt x="280988" y="977906"/>
                </a:cubicBezTo>
                <a:cubicBezTo>
                  <a:pt x="431864" y="898975"/>
                  <a:pt x="636842" y="796795"/>
                  <a:pt x="881189" y="688850"/>
                </a:cubicBezTo>
                <a:close/>
                <a:moveTo>
                  <a:pt x="138557" y="1054493"/>
                </a:moveTo>
                <a:cubicBezTo>
                  <a:pt x="174181" y="1034855"/>
                  <a:pt x="216345" y="1012050"/>
                  <a:pt x="264541" y="986648"/>
                </a:cubicBezTo>
                <a:cubicBezTo>
                  <a:pt x="645839" y="1005779"/>
                  <a:pt x="1023938" y="1035235"/>
                  <a:pt x="1398842" y="1075018"/>
                </a:cubicBezTo>
                <a:cubicBezTo>
                  <a:pt x="1319848" y="1096809"/>
                  <a:pt x="1243374" y="1118202"/>
                  <a:pt x="1169416" y="1139189"/>
                </a:cubicBezTo>
                <a:cubicBezTo>
                  <a:pt x="829354" y="1102194"/>
                  <a:pt x="485732" y="1073960"/>
                  <a:pt x="138557" y="1054493"/>
                </a:cubicBezTo>
                <a:close/>
                <a:moveTo>
                  <a:pt x="1170178" y="1148818"/>
                </a:moveTo>
                <a:cubicBezTo>
                  <a:pt x="1196975" y="1151732"/>
                  <a:pt x="1223772" y="1154583"/>
                  <a:pt x="1250442" y="1157623"/>
                </a:cubicBezTo>
                <a:cubicBezTo>
                  <a:pt x="1384891" y="1172827"/>
                  <a:pt x="1518749" y="1189443"/>
                  <a:pt x="1652016" y="1207478"/>
                </a:cubicBezTo>
                <a:cubicBezTo>
                  <a:pt x="1603883" y="1238056"/>
                  <a:pt x="1556239" y="1269096"/>
                  <a:pt x="1509078" y="1300599"/>
                </a:cubicBezTo>
                <a:cubicBezTo>
                  <a:pt x="1397908" y="1285142"/>
                  <a:pt x="1286085" y="1270617"/>
                  <a:pt x="1173607" y="1257016"/>
                </a:cubicBezTo>
                <a:cubicBezTo>
                  <a:pt x="1083393" y="1246038"/>
                  <a:pt x="992740" y="1235731"/>
                  <a:pt x="901637" y="1226102"/>
                </a:cubicBezTo>
                <a:cubicBezTo>
                  <a:pt x="986409" y="1201333"/>
                  <a:pt x="1076135" y="1175487"/>
                  <a:pt x="1170178" y="1148818"/>
                </a:cubicBezTo>
                <a:close/>
                <a:moveTo>
                  <a:pt x="877697" y="1233070"/>
                </a:moveTo>
                <a:cubicBezTo>
                  <a:pt x="976249" y="1243459"/>
                  <a:pt x="1074357" y="1254564"/>
                  <a:pt x="1172020" y="1266391"/>
                </a:cubicBezTo>
                <a:cubicBezTo>
                  <a:pt x="1280941" y="1279568"/>
                  <a:pt x="1389272" y="1293631"/>
                  <a:pt x="1497013" y="1308581"/>
                </a:cubicBezTo>
                <a:cubicBezTo>
                  <a:pt x="1430547" y="1353178"/>
                  <a:pt x="1365104" y="1398725"/>
                  <a:pt x="1300671" y="1445222"/>
                </a:cubicBezTo>
                <a:cubicBezTo>
                  <a:pt x="1236110" y="1436055"/>
                  <a:pt x="1171258" y="1427105"/>
                  <a:pt x="1106107" y="1418362"/>
                </a:cubicBezTo>
                <a:cubicBezTo>
                  <a:pt x="906336" y="1391756"/>
                  <a:pt x="703771" y="1367792"/>
                  <a:pt x="498412" y="1346463"/>
                </a:cubicBezTo>
                <a:cubicBezTo>
                  <a:pt x="609283" y="1312635"/>
                  <a:pt x="736664" y="1274436"/>
                  <a:pt x="877697" y="1233070"/>
                </a:cubicBezTo>
                <a:close/>
                <a:moveTo>
                  <a:pt x="475107" y="1353431"/>
                </a:moveTo>
                <a:cubicBezTo>
                  <a:pt x="687705" y="1375349"/>
                  <a:pt x="897426" y="1400036"/>
                  <a:pt x="1104265" y="1427485"/>
                </a:cubicBezTo>
                <a:cubicBezTo>
                  <a:pt x="1166324" y="1435929"/>
                  <a:pt x="1228109" y="1444379"/>
                  <a:pt x="1289622" y="1452824"/>
                </a:cubicBezTo>
                <a:cubicBezTo>
                  <a:pt x="1226801" y="1498181"/>
                  <a:pt x="1165035" y="1544380"/>
                  <a:pt x="1104329" y="1591429"/>
                </a:cubicBezTo>
                <a:cubicBezTo>
                  <a:pt x="994264" y="1550842"/>
                  <a:pt x="881189" y="1510489"/>
                  <a:pt x="765112" y="1470371"/>
                </a:cubicBezTo>
                <a:cubicBezTo>
                  <a:pt x="658476" y="1433547"/>
                  <a:pt x="551223" y="1397648"/>
                  <a:pt x="443357" y="1362680"/>
                </a:cubicBezTo>
                <a:close/>
                <a:moveTo>
                  <a:pt x="384112" y="1344182"/>
                </a:moveTo>
                <a:lnTo>
                  <a:pt x="450914" y="1351151"/>
                </a:lnTo>
                <a:lnTo>
                  <a:pt x="427736" y="1358246"/>
                </a:lnTo>
                <a:close/>
                <a:moveTo>
                  <a:pt x="388874" y="1523330"/>
                </a:moveTo>
                <a:cubicBezTo>
                  <a:pt x="316908" y="1497991"/>
                  <a:pt x="244496" y="1472968"/>
                  <a:pt x="171641" y="1448263"/>
                </a:cubicBezTo>
                <a:cubicBezTo>
                  <a:pt x="238760" y="1427041"/>
                  <a:pt x="324866" y="1399992"/>
                  <a:pt x="427609" y="1368318"/>
                </a:cubicBezTo>
                <a:cubicBezTo>
                  <a:pt x="539539" y="1404426"/>
                  <a:pt x="650856" y="1441548"/>
                  <a:pt x="761556" y="1479683"/>
                </a:cubicBezTo>
                <a:cubicBezTo>
                  <a:pt x="875856" y="1519168"/>
                  <a:pt x="987152" y="1558868"/>
                  <a:pt x="1095439" y="1598777"/>
                </a:cubicBezTo>
                <a:lnTo>
                  <a:pt x="1090930" y="1602198"/>
                </a:lnTo>
                <a:cubicBezTo>
                  <a:pt x="1036365" y="1644767"/>
                  <a:pt x="984104" y="1686704"/>
                  <a:pt x="934149" y="1728006"/>
                </a:cubicBezTo>
                <a:cubicBezTo>
                  <a:pt x="761892" y="1659591"/>
                  <a:pt x="580136" y="1591429"/>
                  <a:pt x="388874" y="1523520"/>
                </a:cubicBezTo>
                <a:close/>
                <a:moveTo>
                  <a:pt x="935927" y="1738712"/>
                </a:moveTo>
                <a:cubicBezTo>
                  <a:pt x="967042" y="1751046"/>
                  <a:pt x="997839" y="1763399"/>
                  <a:pt x="1028319" y="1775770"/>
                </a:cubicBezTo>
                <a:cubicBezTo>
                  <a:pt x="967785" y="1798956"/>
                  <a:pt x="910762" y="1821172"/>
                  <a:pt x="857250" y="1842412"/>
                </a:cubicBezTo>
                <a:cubicBezTo>
                  <a:pt x="832104" y="1852377"/>
                  <a:pt x="807485" y="1862196"/>
                  <a:pt x="783400" y="1871869"/>
                </a:cubicBezTo>
                <a:lnTo>
                  <a:pt x="781431" y="1870982"/>
                </a:lnTo>
                <a:cubicBezTo>
                  <a:pt x="830072" y="1828077"/>
                  <a:pt x="881571" y="1784050"/>
                  <a:pt x="935927" y="1738902"/>
                </a:cubicBezTo>
                <a:close/>
                <a:moveTo>
                  <a:pt x="593852" y="2030872"/>
                </a:moveTo>
                <a:cubicBezTo>
                  <a:pt x="566885" y="2018962"/>
                  <a:pt x="539496" y="2006990"/>
                  <a:pt x="511683" y="1994954"/>
                </a:cubicBezTo>
                <a:cubicBezTo>
                  <a:pt x="578569" y="1966403"/>
                  <a:pt x="651637" y="1935932"/>
                  <a:pt x="730885" y="1903543"/>
                </a:cubicBezTo>
                <a:cubicBezTo>
                  <a:pt x="682415" y="1947208"/>
                  <a:pt x="636734" y="1989651"/>
                  <a:pt x="593852" y="2030872"/>
                </a:cubicBezTo>
                <a:close/>
                <a:moveTo>
                  <a:pt x="603123" y="2034989"/>
                </a:moveTo>
                <a:cubicBezTo>
                  <a:pt x="650621" y="1989588"/>
                  <a:pt x="701866" y="1942267"/>
                  <a:pt x="756857" y="1893027"/>
                </a:cubicBezTo>
                <a:lnTo>
                  <a:pt x="783273" y="1882321"/>
                </a:lnTo>
                <a:cubicBezTo>
                  <a:pt x="1089279" y="2013261"/>
                  <a:pt x="1355471" y="2141160"/>
                  <a:pt x="1581214" y="2258797"/>
                </a:cubicBezTo>
                <a:cubicBezTo>
                  <a:pt x="1484122" y="2304534"/>
                  <a:pt x="1396683" y="2347484"/>
                  <a:pt x="1319086" y="2386886"/>
                </a:cubicBezTo>
                <a:cubicBezTo>
                  <a:pt x="1124014" y="2280525"/>
                  <a:pt x="885889" y="2160164"/>
                  <a:pt x="603314" y="2034989"/>
                </a:cubicBezTo>
                <a:close/>
                <a:moveTo>
                  <a:pt x="1675067" y="2594223"/>
                </a:moveTo>
                <a:cubicBezTo>
                  <a:pt x="1654620" y="2581553"/>
                  <a:pt x="1633455" y="2568567"/>
                  <a:pt x="1611567" y="2555264"/>
                </a:cubicBezTo>
                <a:cubicBezTo>
                  <a:pt x="1530795" y="2506233"/>
                  <a:pt x="1436561" y="2451437"/>
                  <a:pt x="1328865" y="2392397"/>
                </a:cubicBezTo>
                <a:cubicBezTo>
                  <a:pt x="1406652" y="2352995"/>
                  <a:pt x="1494282" y="2310045"/>
                  <a:pt x="1591501" y="2264308"/>
                </a:cubicBezTo>
                <a:cubicBezTo>
                  <a:pt x="1680401" y="2310761"/>
                  <a:pt x="1762951" y="2355231"/>
                  <a:pt x="1839151" y="2397718"/>
                </a:cubicBezTo>
                <a:cubicBezTo>
                  <a:pt x="1760601" y="2486025"/>
                  <a:pt x="1706182" y="2553934"/>
                  <a:pt x="1675067" y="2594223"/>
                </a:cubicBezTo>
                <a:close/>
                <a:moveTo>
                  <a:pt x="1845564" y="2390497"/>
                </a:moveTo>
                <a:cubicBezTo>
                  <a:pt x="1770761" y="2348687"/>
                  <a:pt x="1689716" y="2304914"/>
                  <a:pt x="1602423" y="2259177"/>
                </a:cubicBezTo>
                <a:lnTo>
                  <a:pt x="1612773" y="2254362"/>
                </a:lnTo>
                <a:cubicBezTo>
                  <a:pt x="1686687" y="2219775"/>
                  <a:pt x="1768602" y="2182653"/>
                  <a:pt x="1858518" y="2142997"/>
                </a:cubicBezTo>
                <a:cubicBezTo>
                  <a:pt x="1910080" y="2167747"/>
                  <a:pt x="1960055" y="2192174"/>
                  <a:pt x="2008442" y="2216290"/>
                </a:cubicBezTo>
                <a:cubicBezTo>
                  <a:pt x="1946021" y="2280145"/>
                  <a:pt x="1891792" y="2338678"/>
                  <a:pt x="1845564" y="2390497"/>
                </a:cubicBezTo>
                <a:close/>
                <a:moveTo>
                  <a:pt x="2015427" y="2209195"/>
                </a:moveTo>
                <a:cubicBezTo>
                  <a:pt x="1968437" y="2185839"/>
                  <a:pt x="1919967" y="2162084"/>
                  <a:pt x="1870012" y="2137929"/>
                </a:cubicBezTo>
                <a:cubicBezTo>
                  <a:pt x="1952733" y="2101694"/>
                  <a:pt x="2042033" y="2063686"/>
                  <a:pt x="2137918" y="2023903"/>
                </a:cubicBezTo>
                <a:lnTo>
                  <a:pt x="2183321" y="2044428"/>
                </a:lnTo>
                <a:cubicBezTo>
                  <a:pt x="2122043" y="2102455"/>
                  <a:pt x="2066099" y="2157504"/>
                  <a:pt x="2015427" y="2209195"/>
                </a:cubicBezTo>
                <a:close/>
                <a:moveTo>
                  <a:pt x="2637727" y="2541644"/>
                </a:moveTo>
                <a:lnTo>
                  <a:pt x="2576132" y="2506486"/>
                </a:lnTo>
                <a:cubicBezTo>
                  <a:pt x="2425129" y="2420840"/>
                  <a:pt x="2240598" y="2321321"/>
                  <a:pt x="2024253" y="2213440"/>
                </a:cubicBezTo>
                <a:cubicBezTo>
                  <a:pt x="2073974" y="2162762"/>
                  <a:pt x="2130171" y="2107649"/>
                  <a:pt x="2192719" y="2048736"/>
                </a:cubicBezTo>
                <a:cubicBezTo>
                  <a:pt x="2474087" y="2176761"/>
                  <a:pt x="2717419" y="2297692"/>
                  <a:pt x="2919984" y="2404307"/>
                </a:cubicBezTo>
                <a:cubicBezTo>
                  <a:pt x="2804160" y="2457899"/>
                  <a:pt x="2709736" y="2504713"/>
                  <a:pt x="2637536" y="2541644"/>
                </a:cubicBezTo>
                <a:close/>
                <a:moveTo>
                  <a:pt x="3194558" y="2542531"/>
                </a:moveTo>
                <a:cubicBezTo>
                  <a:pt x="3166745" y="2526948"/>
                  <a:pt x="3138170" y="2511111"/>
                  <a:pt x="3108833" y="2495020"/>
                </a:cubicBezTo>
                <a:cubicBezTo>
                  <a:pt x="3056681" y="2466470"/>
                  <a:pt x="3000864" y="2436443"/>
                  <a:pt x="2941384" y="2404940"/>
                </a:cubicBezTo>
                <a:cubicBezTo>
                  <a:pt x="2999378" y="2378163"/>
                  <a:pt x="3062459" y="2349783"/>
                  <a:pt x="3130614" y="2319801"/>
                </a:cubicBezTo>
                <a:cubicBezTo>
                  <a:pt x="3253804" y="2265955"/>
                  <a:pt x="3401759" y="2204001"/>
                  <a:pt x="3573018" y="2137106"/>
                </a:cubicBezTo>
                <a:cubicBezTo>
                  <a:pt x="3388678" y="2312199"/>
                  <a:pt x="3264662" y="2455175"/>
                  <a:pt x="3194114" y="2542531"/>
                </a:cubicBezTo>
                <a:close/>
                <a:moveTo>
                  <a:pt x="3591751" y="2119749"/>
                </a:moveTo>
                <a:cubicBezTo>
                  <a:pt x="3411029" y="2190001"/>
                  <a:pt x="3255582" y="2254933"/>
                  <a:pt x="3127121" y="2311122"/>
                </a:cubicBezTo>
                <a:cubicBezTo>
                  <a:pt x="3056128" y="2342162"/>
                  <a:pt x="2990704" y="2371575"/>
                  <a:pt x="2930843" y="2399365"/>
                </a:cubicBezTo>
                <a:cubicBezTo>
                  <a:pt x="2727643" y="2292371"/>
                  <a:pt x="2483231" y="2170680"/>
                  <a:pt x="2200212" y="2041831"/>
                </a:cubicBezTo>
                <a:cubicBezTo>
                  <a:pt x="2226837" y="2016916"/>
                  <a:pt x="2254587" y="1991406"/>
                  <a:pt x="2283460" y="1965307"/>
                </a:cubicBezTo>
                <a:cubicBezTo>
                  <a:pt x="2459800" y="1894991"/>
                  <a:pt x="2655062" y="1821317"/>
                  <a:pt x="2868486" y="1746440"/>
                </a:cubicBezTo>
                <a:cubicBezTo>
                  <a:pt x="3170663" y="1816839"/>
                  <a:pt x="3463970" y="1894085"/>
                  <a:pt x="3748405" y="1978166"/>
                </a:cubicBezTo>
                <a:cubicBezTo>
                  <a:pt x="3692144" y="2027153"/>
                  <a:pt x="3639865" y="2074347"/>
                  <a:pt x="3591560" y="2119749"/>
                </a:cubicBezTo>
                <a:close/>
                <a:moveTo>
                  <a:pt x="3614928" y="2110753"/>
                </a:moveTo>
                <a:cubicBezTo>
                  <a:pt x="3659207" y="2069621"/>
                  <a:pt x="3707276" y="2026501"/>
                  <a:pt x="3759137" y="1981397"/>
                </a:cubicBezTo>
                <a:cubicBezTo>
                  <a:pt x="3796430" y="1992502"/>
                  <a:pt x="3833514" y="2003695"/>
                  <a:pt x="3870389" y="2014971"/>
                </a:cubicBezTo>
                <a:cubicBezTo>
                  <a:pt x="3780346" y="2047659"/>
                  <a:pt x="3695129" y="2079586"/>
                  <a:pt x="3614738" y="2110753"/>
                </a:cubicBezTo>
                <a:close/>
                <a:moveTo>
                  <a:pt x="3885184" y="2009397"/>
                </a:moveTo>
                <a:cubicBezTo>
                  <a:pt x="3846195" y="1997487"/>
                  <a:pt x="3807016" y="1985660"/>
                  <a:pt x="3767646" y="1973922"/>
                </a:cubicBezTo>
                <a:cubicBezTo>
                  <a:pt x="3822129" y="1926791"/>
                  <a:pt x="3880822" y="1878014"/>
                  <a:pt x="3943731" y="1827589"/>
                </a:cubicBezTo>
                <a:cubicBezTo>
                  <a:pt x="4026535" y="1851997"/>
                  <a:pt x="4108748" y="1876981"/>
                  <a:pt x="4190365" y="1902529"/>
                </a:cubicBezTo>
                <a:cubicBezTo>
                  <a:pt x="4083260" y="1938764"/>
                  <a:pt x="3981469" y="1974429"/>
                  <a:pt x="3884994" y="2009523"/>
                </a:cubicBezTo>
                <a:close/>
                <a:moveTo>
                  <a:pt x="4296728" y="2142427"/>
                </a:moveTo>
                <a:cubicBezTo>
                  <a:pt x="4166851" y="2097957"/>
                  <a:pt x="4034708" y="2055089"/>
                  <a:pt x="3900297" y="2013831"/>
                </a:cubicBezTo>
                <a:cubicBezTo>
                  <a:pt x="3996900" y="1978863"/>
                  <a:pt x="4098715" y="1943281"/>
                  <a:pt x="4205732" y="1907090"/>
                </a:cubicBezTo>
                <a:cubicBezTo>
                  <a:pt x="4323252" y="1944041"/>
                  <a:pt x="4439666" y="1982221"/>
                  <a:pt x="4554982" y="2021623"/>
                </a:cubicBezTo>
                <a:cubicBezTo>
                  <a:pt x="4694047" y="2069260"/>
                  <a:pt x="4827397" y="2117278"/>
                  <a:pt x="4955032" y="2165676"/>
                </a:cubicBezTo>
                <a:cubicBezTo>
                  <a:pt x="4935982" y="2183983"/>
                  <a:pt x="4918266" y="2201657"/>
                  <a:pt x="4901375" y="2218698"/>
                </a:cubicBezTo>
                <a:cubicBezTo>
                  <a:pt x="4863910" y="2256453"/>
                  <a:pt x="4829747" y="2292352"/>
                  <a:pt x="4798886" y="2326389"/>
                </a:cubicBezTo>
                <a:cubicBezTo>
                  <a:pt x="4642377" y="2265366"/>
                  <a:pt x="4474928" y="2204172"/>
                  <a:pt x="4296537" y="2142807"/>
                </a:cubicBezTo>
                <a:close/>
                <a:moveTo>
                  <a:pt x="4772978" y="2368515"/>
                </a:moveTo>
                <a:cubicBezTo>
                  <a:pt x="4782058" y="2358379"/>
                  <a:pt x="4791393" y="2347990"/>
                  <a:pt x="4801108" y="2337348"/>
                </a:cubicBezTo>
                <a:lnTo>
                  <a:pt x="4827016" y="2347547"/>
                </a:lnTo>
                <a:cubicBezTo>
                  <a:pt x="4808220" y="2355085"/>
                  <a:pt x="4790123" y="2362054"/>
                  <a:pt x="4772660" y="2369212"/>
                </a:cubicBezTo>
                <a:close/>
                <a:moveTo>
                  <a:pt x="4840097" y="2342479"/>
                </a:moveTo>
                <a:lnTo>
                  <a:pt x="4807966" y="2329810"/>
                </a:lnTo>
                <a:cubicBezTo>
                  <a:pt x="4838192" y="2296913"/>
                  <a:pt x="4871447" y="2262110"/>
                  <a:pt x="4907725" y="2225412"/>
                </a:cubicBezTo>
                <a:cubicBezTo>
                  <a:pt x="4926775" y="2206408"/>
                  <a:pt x="4945444" y="2187911"/>
                  <a:pt x="4964494" y="2169413"/>
                </a:cubicBezTo>
                <a:cubicBezTo>
                  <a:pt x="5021599" y="2191078"/>
                  <a:pt x="5077505" y="2212743"/>
                  <a:pt x="5132197" y="2234408"/>
                </a:cubicBezTo>
                <a:cubicBezTo>
                  <a:pt x="5023993" y="2273240"/>
                  <a:pt x="4926457" y="2309538"/>
                  <a:pt x="4839780" y="2342859"/>
                </a:cubicBezTo>
                <a:close/>
                <a:moveTo>
                  <a:pt x="4972050" y="2162128"/>
                </a:moveTo>
                <a:cubicBezTo>
                  <a:pt x="5018831" y="2117025"/>
                  <a:pt x="5066284" y="2073296"/>
                  <a:pt x="5114417" y="2030935"/>
                </a:cubicBezTo>
                <a:cubicBezTo>
                  <a:pt x="5215636" y="2066790"/>
                  <a:pt x="5313979" y="2102689"/>
                  <a:pt x="5409438" y="2138626"/>
                </a:cubicBezTo>
                <a:cubicBezTo>
                  <a:pt x="5315884" y="2169749"/>
                  <a:pt x="5228000" y="2199966"/>
                  <a:pt x="5145786" y="2229277"/>
                </a:cubicBezTo>
                <a:cubicBezTo>
                  <a:pt x="5088935" y="2207276"/>
                  <a:pt x="5030915" y="2185016"/>
                  <a:pt x="4971733" y="2162508"/>
                </a:cubicBezTo>
                <a:close/>
                <a:moveTo>
                  <a:pt x="5994400" y="2603662"/>
                </a:moveTo>
                <a:cubicBezTo>
                  <a:pt x="5757228" y="2487545"/>
                  <a:pt x="5478463" y="2361864"/>
                  <a:pt x="5159248" y="2234851"/>
                </a:cubicBezTo>
                <a:cubicBezTo>
                  <a:pt x="5241627" y="2205629"/>
                  <a:pt x="5329701" y="2175387"/>
                  <a:pt x="5423472" y="2144137"/>
                </a:cubicBezTo>
                <a:cubicBezTo>
                  <a:pt x="5686870" y="2243910"/>
                  <a:pt x="5927662" y="2343619"/>
                  <a:pt x="6144768" y="2439528"/>
                </a:cubicBezTo>
                <a:cubicBezTo>
                  <a:pt x="6071299" y="2514405"/>
                  <a:pt x="6021515" y="2571291"/>
                  <a:pt x="5994083" y="2604042"/>
                </a:cubicBezTo>
                <a:close/>
                <a:moveTo>
                  <a:pt x="6045200" y="2628621"/>
                </a:moveTo>
                <a:lnTo>
                  <a:pt x="6003354" y="2607969"/>
                </a:lnTo>
                <a:cubicBezTo>
                  <a:pt x="6031294" y="2574775"/>
                  <a:pt x="6081268" y="2517826"/>
                  <a:pt x="6154293" y="2443645"/>
                </a:cubicBezTo>
                <a:cubicBezTo>
                  <a:pt x="6209919" y="2468269"/>
                  <a:pt x="6263977" y="2492632"/>
                  <a:pt x="6316472" y="2516749"/>
                </a:cubicBezTo>
                <a:cubicBezTo>
                  <a:pt x="6196775" y="2562486"/>
                  <a:pt x="6105144" y="2601001"/>
                  <a:pt x="6044692" y="2628938"/>
                </a:cubicBezTo>
                <a:close/>
                <a:moveTo>
                  <a:pt x="6328474" y="2512378"/>
                </a:moveTo>
                <a:cubicBezTo>
                  <a:pt x="6274327" y="2487501"/>
                  <a:pt x="6218473" y="2462314"/>
                  <a:pt x="6160897" y="2436804"/>
                </a:cubicBezTo>
                <a:cubicBezTo>
                  <a:pt x="6204141" y="2393094"/>
                  <a:pt x="6255068" y="2343746"/>
                  <a:pt x="6314059" y="2289837"/>
                </a:cubicBezTo>
                <a:lnTo>
                  <a:pt x="6323584" y="2281222"/>
                </a:lnTo>
                <a:cubicBezTo>
                  <a:pt x="6427978" y="2323456"/>
                  <a:pt x="6528182" y="2365303"/>
                  <a:pt x="6624130" y="2406777"/>
                </a:cubicBezTo>
                <a:cubicBezTo>
                  <a:pt x="6512814" y="2444469"/>
                  <a:pt x="6413564" y="2480070"/>
                  <a:pt x="6328474" y="2512378"/>
                </a:cubicBezTo>
                <a:close/>
                <a:moveTo>
                  <a:pt x="8305864" y="1970691"/>
                </a:moveTo>
                <a:cubicBezTo>
                  <a:pt x="8093837" y="2011234"/>
                  <a:pt x="7885176" y="2055957"/>
                  <a:pt x="7680007" y="2104862"/>
                </a:cubicBezTo>
                <a:cubicBezTo>
                  <a:pt x="7269861" y="2202797"/>
                  <a:pt x="6915976" y="2308525"/>
                  <a:pt x="6637528" y="2402216"/>
                </a:cubicBezTo>
                <a:cubicBezTo>
                  <a:pt x="6539929" y="2359982"/>
                  <a:pt x="6437884" y="2317286"/>
                  <a:pt x="6331331" y="2274127"/>
                </a:cubicBezTo>
                <a:cubicBezTo>
                  <a:pt x="6592761" y="2037586"/>
                  <a:pt x="6869303" y="1840195"/>
                  <a:pt x="7107111" y="1688540"/>
                </a:cubicBezTo>
                <a:cubicBezTo>
                  <a:pt x="7407974" y="1624179"/>
                  <a:pt x="7711948" y="1567755"/>
                  <a:pt x="8019034" y="1519275"/>
                </a:cubicBezTo>
                <a:cubicBezTo>
                  <a:pt x="8243062" y="1594659"/>
                  <a:pt x="8448929" y="1670867"/>
                  <a:pt x="8636762" y="1745807"/>
                </a:cubicBezTo>
                <a:cubicBezTo>
                  <a:pt x="8519414" y="1822268"/>
                  <a:pt x="8408797" y="1897841"/>
                  <a:pt x="8305864" y="1970691"/>
                </a:cubicBezTo>
                <a:close/>
                <a:moveTo>
                  <a:pt x="8328407" y="1966447"/>
                </a:moveTo>
                <a:cubicBezTo>
                  <a:pt x="8427974" y="1896194"/>
                  <a:pt x="8534654" y="1823598"/>
                  <a:pt x="8647557" y="1750178"/>
                </a:cubicBezTo>
                <a:cubicBezTo>
                  <a:pt x="8744903" y="1789156"/>
                  <a:pt x="8837422" y="1827671"/>
                  <a:pt x="8924988" y="1865724"/>
                </a:cubicBezTo>
                <a:cubicBezTo>
                  <a:pt x="8723884" y="1895624"/>
                  <a:pt x="8525066" y="1929199"/>
                  <a:pt x="8328470" y="1966447"/>
                </a:cubicBezTo>
                <a:close/>
                <a:moveTo>
                  <a:pt x="8657336" y="1743843"/>
                </a:moveTo>
                <a:cubicBezTo>
                  <a:pt x="8728520" y="1697682"/>
                  <a:pt x="8802116" y="1651336"/>
                  <a:pt x="8878062" y="1604795"/>
                </a:cubicBezTo>
                <a:cubicBezTo>
                  <a:pt x="9052370" y="1673020"/>
                  <a:pt x="9214231" y="1740802"/>
                  <a:pt x="9363520" y="1806874"/>
                </a:cubicBezTo>
                <a:cubicBezTo>
                  <a:pt x="9222359" y="1823769"/>
                  <a:pt x="9082087" y="1842495"/>
                  <a:pt x="8942769" y="1863064"/>
                </a:cubicBezTo>
                <a:cubicBezTo>
                  <a:pt x="8852853" y="1823915"/>
                  <a:pt x="8757730" y="1784177"/>
                  <a:pt x="8657399" y="1743843"/>
                </a:cubicBezTo>
                <a:close/>
                <a:moveTo>
                  <a:pt x="9606534" y="2183286"/>
                </a:moveTo>
                <a:cubicBezTo>
                  <a:pt x="9433814" y="2090545"/>
                  <a:pt x="9218295" y="1983551"/>
                  <a:pt x="8959279" y="1870285"/>
                </a:cubicBezTo>
                <a:cubicBezTo>
                  <a:pt x="9098724" y="1849887"/>
                  <a:pt x="9239186" y="1831263"/>
                  <a:pt x="9380601" y="1814413"/>
                </a:cubicBezTo>
                <a:cubicBezTo>
                  <a:pt x="9546654" y="1888149"/>
                  <a:pt x="9696895" y="1959542"/>
                  <a:pt x="9831070" y="2026564"/>
                </a:cubicBezTo>
                <a:cubicBezTo>
                  <a:pt x="9751822" y="2079839"/>
                  <a:pt x="9676765" y="2132481"/>
                  <a:pt x="9606597" y="2183286"/>
                </a:cubicBezTo>
                <a:close/>
                <a:moveTo>
                  <a:pt x="9840150" y="2020483"/>
                </a:moveTo>
                <a:cubicBezTo>
                  <a:pt x="9708579" y="1954664"/>
                  <a:pt x="9561449" y="1884602"/>
                  <a:pt x="9399143" y="1812259"/>
                </a:cubicBezTo>
                <a:cubicBezTo>
                  <a:pt x="9471914" y="1803814"/>
                  <a:pt x="9544875" y="1795706"/>
                  <a:pt x="9618091" y="1787933"/>
                </a:cubicBezTo>
                <a:cubicBezTo>
                  <a:pt x="9682988" y="1781218"/>
                  <a:pt x="9748075" y="1774883"/>
                  <a:pt x="9813354" y="1768929"/>
                </a:cubicBezTo>
                <a:cubicBezTo>
                  <a:pt x="9899586" y="1805968"/>
                  <a:pt x="9982136" y="1842412"/>
                  <a:pt x="10061004" y="1878267"/>
                </a:cubicBezTo>
                <a:cubicBezTo>
                  <a:pt x="10014458" y="1907027"/>
                  <a:pt x="9968294" y="1936312"/>
                  <a:pt x="9922637" y="1966130"/>
                </a:cubicBezTo>
                <a:cubicBezTo>
                  <a:pt x="9894633" y="1984330"/>
                  <a:pt x="9867202" y="2002555"/>
                  <a:pt x="9840214" y="2020799"/>
                </a:cubicBezTo>
                <a:close/>
                <a:moveTo>
                  <a:pt x="10799000" y="2583200"/>
                </a:moveTo>
                <a:cubicBezTo>
                  <a:pt x="10700068" y="2512568"/>
                  <a:pt x="10507282" y="2382515"/>
                  <a:pt x="10220706" y="2222118"/>
                </a:cubicBezTo>
                <a:cubicBezTo>
                  <a:pt x="10115550" y="2163205"/>
                  <a:pt x="9991725" y="2096880"/>
                  <a:pt x="9849675" y="2025740"/>
                </a:cubicBezTo>
                <a:cubicBezTo>
                  <a:pt x="9875075" y="2008637"/>
                  <a:pt x="9901047" y="1991488"/>
                  <a:pt x="9927590" y="1974302"/>
                </a:cubicBezTo>
                <a:cubicBezTo>
                  <a:pt x="9975088" y="1943388"/>
                  <a:pt x="10022904" y="1913064"/>
                  <a:pt x="10070973" y="1883335"/>
                </a:cubicBezTo>
                <a:cubicBezTo>
                  <a:pt x="10326433" y="1999515"/>
                  <a:pt x="10541698" y="2107269"/>
                  <a:pt x="10714037" y="2198617"/>
                </a:cubicBezTo>
                <a:cubicBezTo>
                  <a:pt x="10832592" y="2261457"/>
                  <a:pt x="10937494" y="2319927"/>
                  <a:pt x="11028617" y="2372633"/>
                </a:cubicBezTo>
                <a:cubicBezTo>
                  <a:pt x="10922445" y="2461636"/>
                  <a:pt x="10845102" y="2536450"/>
                  <a:pt x="10799318" y="2583200"/>
                </a:cubicBezTo>
                <a:close/>
                <a:moveTo>
                  <a:pt x="11122850" y="2295792"/>
                </a:moveTo>
                <a:cubicBezTo>
                  <a:pt x="11092244" y="2319864"/>
                  <a:pt x="11063415" y="2343220"/>
                  <a:pt x="11036427" y="2365854"/>
                </a:cubicBezTo>
                <a:cubicBezTo>
                  <a:pt x="10944606" y="2312706"/>
                  <a:pt x="10838688" y="2253602"/>
                  <a:pt x="10718927" y="2190128"/>
                </a:cubicBezTo>
                <a:cubicBezTo>
                  <a:pt x="10547477" y="2099351"/>
                  <a:pt x="10334117" y="1992356"/>
                  <a:pt x="10080752" y="1877000"/>
                </a:cubicBezTo>
                <a:cubicBezTo>
                  <a:pt x="10157460" y="1829616"/>
                  <a:pt x="10234740" y="1783708"/>
                  <a:pt x="10312527" y="1739282"/>
                </a:cubicBezTo>
                <a:cubicBezTo>
                  <a:pt x="10694289" y="1899679"/>
                  <a:pt x="11007916" y="2049686"/>
                  <a:pt x="11246421" y="2171820"/>
                </a:cubicBezTo>
                <a:lnTo>
                  <a:pt x="11271313" y="2184490"/>
                </a:lnTo>
                <a:cubicBezTo>
                  <a:pt x="11216704" y="2223512"/>
                  <a:pt x="11167110" y="2261521"/>
                  <a:pt x="11123105" y="2295792"/>
                </a:cubicBezTo>
                <a:close/>
                <a:moveTo>
                  <a:pt x="12123103" y="1715400"/>
                </a:moveTo>
                <a:cubicBezTo>
                  <a:pt x="11825160" y="1836838"/>
                  <a:pt x="11542205" y="1992198"/>
                  <a:pt x="11280013" y="2178409"/>
                </a:cubicBezTo>
                <a:lnTo>
                  <a:pt x="11251120" y="2163585"/>
                </a:lnTo>
                <a:cubicBezTo>
                  <a:pt x="11013757" y="2042021"/>
                  <a:pt x="10702099" y="1892900"/>
                  <a:pt x="10322941" y="1733391"/>
                </a:cubicBezTo>
                <a:lnTo>
                  <a:pt x="10329291" y="1729843"/>
                </a:lnTo>
                <a:cubicBezTo>
                  <a:pt x="10926699" y="1694343"/>
                  <a:pt x="11525504" y="1689522"/>
                  <a:pt x="12123357" y="1715400"/>
                </a:cubicBezTo>
                <a:close/>
                <a:moveTo>
                  <a:pt x="10914253" y="1420833"/>
                </a:moveTo>
                <a:cubicBezTo>
                  <a:pt x="10716450" y="1510533"/>
                  <a:pt x="10519855" y="1610876"/>
                  <a:pt x="10326307" y="1720531"/>
                </a:cubicBezTo>
                <a:lnTo>
                  <a:pt x="10296652" y="1722368"/>
                </a:lnTo>
                <a:cubicBezTo>
                  <a:pt x="10016490" y="1605112"/>
                  <a:pt x="9700133" y="1482534"/>
                  <a:pt x="9350502" y="1361286"/>
                </a:cubicBezTo>
                <a:cubicBezTo>
                  <a:pt x="9956292" y="1313142"/>
                  <a:pt x="10564178" y="1296228"/>
                  <a:pt x="11171682" y="1310608"/>
                </a:cubicBezTo>
                <a:cubicBezTo>
                  <a:pt x="11085703" y="1345367"/>
                  <a:pt x="10999978" y="1382109"/>
                  <a:pt x="10914507" y="1420833"/>
                </a:cubicBezTo>
                <a:close/>
                <a:moveTo>
                  <a:pt x="11945620" y="1051579"/>
                </a:moveTo>
                <a:cubicBezTo>
                  <a:pt x="11690096" y="1119273"/>
                  <a:pt x="11439017" y="1202759"/>
                  <a:pt x="11193907" y="1301549"/>
                </a:cubicBezTo>
                <a:cubicBezTo>
                  <a:pt x="10571544" y="1286168"/>
                  <a:pt x="9948735" y="1303570"/>
                  <a:pt x="9328213" y="1353685"/>
                </a:cubicBezTo>
                <a:lnTo>
                  <a:pt x="9320594" y="1351087"/>
                </a:lnTo>
                <a:cubicBezTo>
                  <a:pt x="9577197" y="1212723"/>
                  <a:pt x="9841547" y="1089227"/>
                  <a:pt x="10112375" y="981200"/>
                </a:cubicBezTo>
                <a:cubicBezTo>
                  <a:pt x="10717847" y="979109"/>
                  <a:pt x="11330115" y="1002548"/>
                  <a:pt x="11945620" y="1051579"/>
                </a:cubicBezTo>
                <a:close/>
                <a:moveTo>
                  <a:pt x="10896219" y="720587"/>
                </a:moveTo>
                <a:cubicBezTo>
                  <a:pt x="10754106" y="754668"/>
                  <a:pt x="10610152" y="795591"/>
                  <a:pt x="10464419" y="843355"/>
                </a:cubicBezTo>
                <a:cubicBezTo>
                  <a:pt x="10347516" y="881744"/>
                  <a:pt x="10229469" y="924523"/>
                  <a:pt x="10110407" y="971698"/>
                </a:cubicBezTo>
                <a:cubicBezTo>
                  <a:pt x="9521761" y="973807"/>
                  <a:pt x="8940356" y="1000014"/>
                  <a:pt x="8366189" y="1050312"/>
                </a:cubicBezTo>
                <a:cubicBezTo>
                  <a:pt x="8677783" y="927133"/>
                  <a:pt x="8996172" y="821804"/>
                  <a:pt x="9319832" y="734841"/>
                </a:cubicBezTo>
                <a:cubicBezTo>
                  <a:pt x="9381299" y="718243"/>
                  <a:pt x="9443212" y="702216"/>
                  <a:pt x="9505506" y="686760"/>
                </a:cubicBezTo>
                <a:cubicBezTo>
                  <a:pt x="9964547" y="685030"/>
                  <a:pt x="10428160" y="696306"/>
                  <a:pt x="10896219" y="720587"/>
                </a:cubicBezTo>
                <a:close/>
                <a:moveTo>
                  <a:pt x="9504362" y="677258"/>
                </a:moveTo>
                <a:cubicBezTo>
                  <a:pt x="8778431" y="679665"/>
                  <a:pt x="8064818" y="714126"/>
                  <a:pt x="7367588" y="780704"/>
                </a:cubicBezTo>
                <a:cubicBezTo>
                  <a:pt x="7726553" y="658177"/>
                  <a:pt x="8092313" y="556334"/>
                  <a:pt x="8463026" y="475685"/>
                </a:cubicBezTo>
                <a:cubicBezTo>
                  <a:pt x="8738997" y="415125"/>
                  <a:pt x="9024239" y="363750"/>
                  <a:pt x="9318816" y="321560"/>
                </a:cubicBezTo>
                <a:cubicBezTo>
                  <a:pt x="10015093" y="316492"/>
                  <a:pt x="10714609" y="338115"/>
                  <a:pt x="11417363" y="386428"/>
                </a:cubicBezTo>
                <a:cubicBezTo>
                  <a:pt x="10745978" y="430771"/>
                  <a:pt x="10105581" y="528010"/>
                  <a:pt x="9504362" y="677258"/>
                </a:cubicBezTo>
                <a:close/>
              </a:path>
            </a:pathLst>
          </a:custGeom>
          <a:gradFill>
            <a:gsLst>
              <a:gs pos="0">
                <a:srgbClr val="E3E8FB">
                  <a:alpha val="0"/>
                </a:srgbClr>
              </a:gs>
              <a:gs pos="100000">
                <a:srgbClr val="E3E8FB">
                  <a:alpha val="59215"/>
                </a:srgbClr>
              </a:gs>
            </a:gsLst>
            <a:lin ang="5400012" scaled="0"/>
          </a:gra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sp>
        <p:nvSpPr>
          <p:cNvPr id="96" name="Google Shape;96;p1"/>
          <p:cNvSpPr txBox="1">
            <a:spLocks noGrp="1"/>
          </p:cNvSpPr>
          <p:nvPr>
            <p:ph type="title"/>
          </p:nvPr>
        </p:nvSpPr>
        <p:spPr>
          <a:xfrm>
            <a:off x="1022525" y="1008050"/>
            <a:ext cx="7098900" cy="357900"/>
          </a:xfrm>
          <a:prstGeom prst="rect">
            <a:avLst/>
          </a:prstGeom>
          <a:noFill/>
          <a:ln>
            <a:noFill/>
          </a:ln>
          <a:effectLst>
            <a:outerShdw blurRad="28575" dist="38100" dir="2700000" algn="bl" rotWithShape="0">
              <a:schemeClr val="dk1">
                <a:alpha val="91000"/>
              </a:schemeClr>
            </a:outerShdw>
          </a:effectLst>
        </p:spPr>
        <p:txBody>
          <a:bodyPr spcFirstLastPara="1" wrap="square" lIns="0" tIns="0" rIns="0" bIns="0" anchor="b" anchorCtr="0">
            <a:noAutofit/>
          </a:bodyPr>
          <a:lstStyle>
            <a:lvl1pPr lvl="0" rtl="0">
              <a:lnSpc>
                <a:spcPct val="90000"/>
              </a:lnSpc>
              <a:spcBef>
                <a:spcPts val="0"/>
              </a:spcBef>
              <a:spcAft>
                <a:spcPts val="0"/>
              </a:spcAft>
              <a:buClr>
                <a:schemeClr val="lt1"/>
              </a:buClr>
              <a:buSzPts val="3200"/>
              <a:buFont typeface="Bebas Neue"/>
              <a:buNone/>
              <a:defRPr sz="3200">
                <a:solidFill>
                  <a:schemeClr val="lt1"/>
                </a:solidFill>
                <a:latin typeface="Bebas Neue"/>
                <a:ea typeface="Bebas Neue"/>
                <a:cs typeface="Bebas Neue"/>
                <a:sym typeface="Bebas Neue"/>
              </a:defRPr>
            </a:lvl1pPr>
            <a:lvl2pPr lvl="1" rtl="0">
              <a:lnSpc>
                <a:spcPct val="90000"/>
              </a:lnSpc>
              <a:spcBef>
                <a:spcPts val="0"/>
              </a:spcBef>
              <a:spcAft>
                <a:spcPts val="0"/>
              </a:spcAft>
              <a:buClr>
                <a:schemeClr val="lt1"/>
              </a:buClr>
              <a:buSzPts val="3200"/>
              <a:buFont typeface="Bebas Neue"/>
              <a:buNone/>
              <a:defRPr sz="3200">
                <a:solidFill>
                  <a:schemeClr val="lt1"/>
                </a:solidFill>
                <a:latin typeface="Bebas Neue"/>
                <a:ea typeface="Bebas Neue"/>
                <a:cs typeface="Bebas Neue"/>
                <a:sym typeface="Bebas Neue"/>
              </a:defRPr>
            </a:lvl2pPr>
            <a:lvl3pPr lvl="2" rtl="0">
              <a:lnSpc>
                <a:spcPct val="90000"/>
              </a:lnSpc>
              <a:spcBef>
                <a:spcPts val="0"/>
              </a:spcBef>
              <a:spcAft>
                <a:spcPts val="0"/>
              </a:spcAft>
              <a:buClr>
                <a:schemeClr val="lt1"/>
              </a:buClr>
              <a:buSzPts val="3200"/>
              <a:buFont typeface="Bebas Neue"/>
              <a:buNone/>
              <a:defRPr sz="3200">
                <a:solidFill>
                  <a:schemeClr val="lt1"/>
                </a:solidFill>
                <a:latin typeface="Bebas Neue"/>
                <a:ea typeface="Bebas Neue"/>
                <a:cs typeface="Bebas Neue"/>
                <a:sym typeface="Bebas Neue"/>
              </a:defRPr>
            </a:lvl3pPr>
            <a:lvl4pPr lvl="3" rtl="0">
              <a:lnSpc>
                <a:spcPct val="90000"/>
              </a:lnSpc>
              <a:spcBef>
                <a:spcPts val="0"/>
              </a:spcBef>
              <a:spcAft>
                <a:spcPts val="0"/>
              </a:spcAft>
              <a:buClr>
                <a:schemeClr val="lt1"/>
              </a:buClr>
              <a:buSzPts val="3200"/>
              <a:buFont typeface="Bebas Neue"/>
              <a:buNone/>
              <a:defRPr sz="3200">
                <a:solidFill>
                  <a:schemeClr val="lt1"/>
                </a:solidFill>
                <a:latin typeface="Bebas Neue"/>
                <a:ea typeface="Bebas Neue"/>
                <a:cs typeface="Bebas Neue"/>
                <a:sym typeface="Bebas Neue"/>
              </a:defRPr>
            </a:lvl4pPr>
            <a:lvl5pPr lvl="4" rtl="0">
              <a:lnSpc>
                <a:spcPct val="90000"/>
              </a:lnSpc>
              <a:spcBef>
                <a:spcPts val="0"/>
              </a:spcBef>
              <a:spcAft>
                <a:spcPts val="0"/>
              </a:spcAft>
              <a:buClr>
                <a:schemeClr val="lt1"/>
              </a:buClr>
              <a:buSzPts val="3200"/>
              <a:buFont typeface="Bebas Neue"/>
              <a:buNone/>
              <a:defRPr sz="3200">
                <a:solidFill>
                  <a:schemeClr val="lt1"/>
                </a:solidFill>
                <a:latin typeface="Bebas Neue"/>
                <a:ea typeface="Bebas Neue"/>
                <a:cs typeface="Bebas Neue"/>
                <a:sym typeface="Bebas Neue"/>
              </a:defRPr>
            </a:lvl5pPr>
            <a:lvl6pPr lvl="5" rtl="0">
              <a:lnSpc>
                <a:spcPct val="90000"/>
              </a:lnSpc>
              <a:spcBef>
                <a:spcPts val="0"/>
              </a:spcBef>
              <a:spcAft>
                <a:spcPts val="0"/>
              </a:spcAft>
              <a:buClr>
                <a:schemeClr val="lt1"/>
              </a:buClr>
              <a:buSzPts val="3200"/>
              <a:buFont typeface="Bebas Neue"/>
              <a:buNone/>
              <a:defRPr sz="3200">
                <a:solidFill>
                  <a:schemeClr val="lt1"/>
                </a:solidFill>
                <a:latin typeface="Bebas Neue"/>
                <a:ea typeface="Bebas Neue"/>
                <a:cs typeface="Bebas Neue"/>
                <a:sym typeface="Bebas Neue"/>
              </a:defRPr>
            </a:lvl6pPr>
            <a:lvl7pPr lvl="6" rtl="0">
              <a:lnSpc>
                <a:spcPct val="90000"/>
              </a:lnSpc>
              <a:spcBef>
                <a:spcPts val="0"/>
              </a:spcBef>
              <a:spcAft>
                <a:spcPts val="0"/>
              </a:spcAft>
              <a:buClr>
                <a:schemeClr val="lt1"/>
              </a:buClr>
              <a:buSzPts val="3200"/>
              <a:buFont typeface="Bebas Neue"/>
              <a:buNone/>
              <a:defRPr sz="3200">
                <a:solidFill>
                  <a:schemeClr val="lt1"/>
                </a:solidFill>
                <a:latin typeface="Bebas Neue"/>
                <a:ea typeface="Bebas Neue"/>
                <a:cs typeface="Bebas Neue"/>
                <a:sym typeface="Bebas Neue"/>
              </a:defRPr>
            </a:lvl7pPr>
            <a:lvl8pPr lvl="7" rtl="0">
              <a:lnSpc>
                <a:spcPct val="90000"/>
              </a:lnSpc>
              <a:spcBef>
                <a:spcPts val="0"/>
              </a:spcBef>
              <a:spcAft>
                <a:spcPts val="0"/>
              </a:spcAft>
              <a:buClr>
                <a:schemeClr val="lt1"/>
              </a:buClr>
              <a:buSzPts val="3200"/>
              <a:buFont typeface="Bebas Neue"/>
              <a:buNone/>
              <a:defRPr sz="3200">
                <a:solidFill>
                  <a:schemeClr val="lt1"/>
                </a:solidFill>
                <a:latin typeface="Bebas Neue"/>
                <a:ea typeface="Bebas Neue"/>
                <a:cs typeface="Bebas Neue"/>
                <a:sym typeface="Bebas Neue"/>
              </a:defRPr>
            </a:lvl8pPr>
            <a:lvl9pPr lvl="8" rtl="0">
              <a:lnSpc>
                <a:spcPct val="90000"/>
              </a:lnSpc>
              <a:spcBef>
                <a:spcPts val="0"/>
              </a:spcBef>
              <a:spcAft>
                <a:spcPts val="0"/>
              </a:spcAft>
              <a:buClr>
                <a:schemeClr val="lt1"/>
              </a:buClr>
              <a:buSzPts val="3200"/>
              <a:buFont typeface="Bebas Neue"/>
              <a:buNone/>
              <a:defRPr sz="3200">
                <a:solidFill>
                  <a:schemeClr val="lt1"/>
                </a:solidFill>
                <a:latin typeface="Bebas Neue"/>
                <a:ea typeface="Bebas Neue"/>
                <a:cs typeface="Bebas Neue"/>
                <a:sym typeface="Bebas Neue"/>
              </a:defRPr>
            </a:lvl9pPr>
          </a:lstStyle>
          <a:p>
            <a:endParaRPr/>
          </a:p>
        </p:txBody>
      </p:sp>
      <p:sp>
        <p:nvSpPr>
          <p:cNvPr id="97" name="Google Shape;97;p1"/>
          <p:cNvSpPr txBox="1">
            <a:spLocks noGrp="1"/>
          </p:cNvSpPr>
          <p:nvPr>
            <p:ph type="body" idx="1"/>
          </p:nvPr>
        </p:nvSpPr>
        <p:spPr>
          <a:xfrm>
            <a:off x="1022525" y="1475820"/>
            <a:ext cx="7098900" cy="2739900"/>
          </a:xfrm>
          <a:prstGeom prst="rect">
            <a:avLst/>
          </a:prstGeom>
          <a:noFill/>
          <a:ln>
            <a:noFill/>
          </a:ln>
          <a:effectLst>
            <a:outerShdw blurRad="14288" dist="28575" dir="2700000" algn="bl" rotWithShape="0">
              <a:schemeClr val="dk1">
                <a:alpha val="91000"/>
              </a:schemeClr>
            </a:outerShdw>
          </a:effectLst>
        </p:spPr>
        <p:txBody>
          <a:bodyPr spcFirstLastPara="1" wrap="square" lIns="0" tIns="0" rIns="0" bIns="0" anchor="t" anchorCtr="0">
            <a:noAutofit/>
          </a:bodyPr>
          <a:lstStyle>
            <a:lvl1pPr marL="457200" lvl="0" indent="-381000" rtl="0">
              <a:spcBef>
                <a:spcPts val="600"/>
              </a:spcBef>
              <a:spcAft>
                <a:spcPts val="0"/>
              </a:spcAft>
              <a:buClr>
                <a:schemeClr val="lt1"/>
              </a:buClr>
              <a:buSzPts val="2400"/>
              <a:buFont typeface="Della Respira"/>
              <a:buChar char="➢"/>
              <a:defRPr sz="2400" b="1">
                <a:solidFill>
                  <a:schemeClr val="lt1"/>
                </a:solidFill>
                <a:latin typeface="Della Respira"/>
                <a:ea typeface="Della Respira"/>
                <a:cs typeface="Della Respira"/>
                <a:sym typeface="Della Respira"/>
              </a:defRPr>
            </a:lvl1pPr>
            <a:lvl2pPr marL="914400" lvl="1" indent="-381000" rtl="0">
              <a:spcBef>
                <a:spcPts val="0"/>
              </a:spcBef>
              <a:spcAft>
                <a:spcPts val="0"/>
              </a:spcAft>
              <a:buClr>
                <a:schemeClr val="lt1"/>
              </a:buClr>
              <a:buSzPts val="2400"/>
              <a:buFont typeface="Della Respira"/>
              <a:buChar char="○"/>
              <a:defRPr sz="2400" b="1">
                <a:solidFill>
                  <a:schemeClr val="lt1"/>
                </a:solidFill>
                <a:latin typeface="Della Respira"/>
                <a:ea typeface="Della Respira"/>
                <a:cs typeface="Della Respira"/>
                <a:sym typeface="Della Respira"/>
              </a:defRPr>
            </a:lvl2pPr>
            <a:lvl3pPr marL="1371600" lvl="2" indent="-381000" rtl="0">
              <a:spcBef>
                <a:spcPts val="0"/>
              </a:spcBef>
              <a:spcAft>
                <a:spcPts val="0"/>
              </a:spcAft>
              <a:buClr>
                <a:schemeClr val="lt1"/>
              </a:buClr>
              <a:buSzPts val="2400"/>
              <a:buFont typeface="Della Respira"/>
              <a:buChar char="■"/>
              <a:defRPr sz="2400" b="1">
                <a:solidFill>
                  <a:schemeClr val="lt1"/>
                </a:solidFill>
                <a:latin typeface="Della Respira"/>
                <a:ea typeface="Della Respira"/>
                <a:cs typeface="Della Respira"/>
                <a:sym typeface="Della Respira"/>
              </a:defRPr>
            </a:lvl3pPr>
            <a:lvl4pPr marL="1828800" lvl="3" indent="-381000" rtl="0">
              <a:spcBef>
                <a:spcPts val="0"/>
              </a:spcBef>
              <a:spcAft>
                <a:spcPts val="0"/>
              </a:spcAft>
              <a:buClr>
                <a:schemeClr val="lt1"/>
              </a:buClr>
              <a:buSzPts val="2400"/>
              <a:buFont typeface="Della Respira"/>
              <a:buChar char="●"/>
              <a:defRPr sz="2400" b="1">
                <a:solidFill>
                  <a:schemeClr val="lt1"/>
                </a:solidFill>
                <a:latin typeface="Della Respira"/>
                <a:ea typeface="Della Respira"/>
                <a:cs typeface="Della Respira"/>
                <a:sym typeface="Della Respira"/>
              </a:defRPr>
            </a:lvl4pPr>
            <a:lvl5pPr marL="2286000" lvl="4" indent="-381000" rtl="0">
              <a:spcBef>
                <a:spcPts val="0"/>
              </a:spcBef>
              <a:spcAft>
                <a:spcPts val="0"/>
              </a:spcAft>
              <a:buClr>
                <a:schemeClr val="lt1"/>
              </a:buClr>
              <a:buSzPts val="2400"/>
              <a:buFont typeface="Della Respira"/>
              <a:buChar char="○"/>
              <a:defRPr sz="2400" b="1">
                <a:solidFill>
                  <a:schemeClr val="lt1"/>
                </a:solidFill>
                <a:latin typeface="Della Respira"/>
                <a:ea typeface="Della Respira"/>
                <a:cs typeface="Della Respira"/>
                <a:sym typeface="Della Respira"/>
              </a:defRPr>
            </a:lvl5pPr>
            <a:lvl6pPr marL="2743200" lvl="5" indent="-381000" rtl="0">
              <a:spcBef>
                <a:spcPts val="0"/>
              </a:spcBef>
              <a:spcAft>
                <a:spcPts val="0"/>
              </a:spcAft>
              <a:buClr>
                <a:schemeClr val="lt1"/>
              </a:buClr>
              <a:buSzPts val="2400"/>
              <a:buFont typeface="Della Respira"/>
              <a:buChar char="■"/>
              <a:defRPr sz="2400" b="1">
                <a:solidFill>
                  <a:schemeClr val="lt1"/>
                </a:solidFill>
                <a:latin typeface="Della Respira"/>
                <a:ea typeface="Della Respira"/>
                <a:cs typeface="Della Respira"/>
                <a:sym typeface="Della Respira"/>
              </a:defRPr>
            </a:lvl6pPr>
            <a:lvl7pPr marL="3200400" lvl="6" indent="-381000" rtl="0">
              <a:spcBef>
                <a:spcPts val="0"/>
              </a:spcBef>
              <a:spcAft>
                <a:spcPts val="0"/>
              </a:spcAft>
              <a:buClr>
                <a:schemeClr val="lt1"/>
              </a:buClr>
              <a:buSzPts val="2400"/>
              <a:buFont typeface="Della Respira"/>
              <a:buChar char="●"/>
              <a:defRPr sz="2400" b="1">
                <a:solidFill>
                  <a:schemeClr val="lt1"/>
                </a:solidFill>
                <a:latin typeface="Della Respira"/>
                <a:ea typeface="Della Respira"/>
                <a:cs typeface="Della Respira"/>
                <a:sym typeface="Della Respira"/>
              </a:defRPr>
            </a:lvl7pPr>
            <a:lvl8pPr marL="3657600" lvl="7" indent="-381000" rtl="0">
              <a:spcBef>
                <a:spcPts val="0"/>
              </a:spcBef>
              <a:spcAft>
                <a:spcPts val="0"/>
              </a:spcAft>
              <a:buClr>
                <a:schemeClr val="lt1"/>
              </a:buClr>
              <a:buSzPts val="2400"/>
              <a:buFont typeface="Della Respira"/>
              <a:buChar char="○"/>
              <a:defRPr sz="2400" b="1">
                <a:solidFill>
                  <a:schemeClr val="lt1"/>
                </a:solidFill>
                <a:latin typeface="Della Respira"/>
                <a:ea typeface="Della Respira"/>
                <a:cs typeface="Della Respira"/>
                <a:sym typeface="Della Respira"/>
              </a:defRPr>
            </a:lvl8pPr>
            <a:lvl9pPr marL="4114800" lvl="8" indent="-381000" rtl="0">
              <a:spcBef>
                <a:spcPts val="0"/>
              </a:spcBef>
              <a:spcAft>
                <a:spcPts val="0"/>
              </a:spcAft>
              <a:buClr>
                <a:schemeClr val="lt1"/>
              </a:buClr>
              <a:buSzPts val="2400"/>
              <a:buFont typeface="Della Respira"/>
              <a:buChar char="■"/>
              <a:defRPr sz="2400" b="1">
                <a:solidFill>
                  <a:schemeClr val="lt1"/>
                </a:solidFill>
                <a:latin typeface="Della Respira"/>
                <a:ea typeface="Della Respira"/>
                <a:cs typeface="Della Respira"/>
                <a:sym typeface="Della Respira"/>
              </a:defRPr>
            </a:lvl9pPr>
          </a:lstStyle>
          <a:p>
            <a:endParaRPr/>
          </a:p>
        </p:txBody>
      </p:sp>
      <p:sp>
        <p:nvSpPr>
          <p:cNvPr id="98" name="Google Shape;98;p1"/>
          <p:cNvSpPr txBox="1">
            <a:spLocks noGrp="1"/>
          </p:cNvSpPr>
          <p:nvPr>
            <p:ph type="sldNum" idx="12"/>
          </p:nvPr>
        </p:nvSpPr>
        <p:spPr>
          <a:xfrm>
            <a:off x="4297650" y="4749851"/>
            <a:ext cx="548700" cy="393600"/>
          </a:xfrm>
          <a:prstGeom prst="rect">
            <a:avLst/>
          </a:prstGeom>
          <a:noFill/>
          <a:ln>
            <a:noFill/>
          </a:ln>
        </p:spPr>
        <p:txBody>
          <a:bodyPr spcFirstLastPara="1" wrap="square" lIns="0" tIns="0" rIns="0" bIns="0" anchor="ctr" anchorCtr="0">
            <a:noAutofit/>
          </a:bodyPr>
          <a:lstStyle>
            <a:lvl1pPr lvl="0" algn="ctr" rtl="0">
              <a:buNone/>
              <a:defRPr sz="1300">
                <a:solidFill>
                  <a:schemeClr val="lt1"/>
                </a:solidFill>
                <a:latin typeface="Della Respira"/>
                <a:ea typeface="Della Respira"/>
                <a:cs typeface="Della Respira"/>
                <a:sym typeface="Della Respira"/>
              </a:defRPr>
            </a:lvl1pPr>
            <a:lvl2pPr lvl="1" algn="ctr" rtl="0">
              <a:buNone/>
              <a:defRPr sz="1300">
                <a:solidFill>
                  <a:schemeClr val="lt1"/>
                </a:solidFill>
                <a:latin typeface="Della Respira"/>
                <a:ea typeface="Della Respira"/>
                <a:cs typeface="Della Respira"/>
                <a:sym typeface="Della Respira"/>
              </a:defRPr>
            </a:lvl2pPr>
            <a:lvl3pPr lvl="2" algn="ctr" rtl="0">
              <a:buNone/>
              <a:defRPr sz="1300">
                <a:solidFill>
                  <a:schemeClr val="lt1"/>
                </a:solidFill>
                <a:latin typeface="Della Respira"/>
                <a:ea typeface="Della Respira"/>
                <a:cs typeface="Della Respira"/>
                <a:sym typeface="Della Respira"/>
              </a:defRPr>
            </a:lvl3pPr>
            <a:lvl4pPr lvl="3" algn="ctr" rtl="0">
              <a:buNone/>
              <a:defRPr sz="1300">
                <a:solidFill>
                  <a:schemeClr val="lt1"/>
                </a:solidFill>
                <a:latin typeface="Della Respira"/>
                <a:ea typeface="Della Respira"/>
                <a:cs typeface="Della Respira"/>
                <a:sym typeface="Della Respira"/>
              </a:defRPr>
            </a:lvl4pPr>
            <a:lvl5pPr lvl="4" algn="ctr" rtl="0">
              <a:buNone/>
              <a:defRPr sz="1300">
                <a:solidFill>
                  <a:schemeClr val="lt1"/>
                </a:solidFill>
                <a:latin typeface="Della Respira"/>
                <a:ea typeface="Della Respira"/>
                <a:cs typeface="Della Respira"/>
                <a:sym typeface="Della Respira"/>
              </a:defRPr>
            </a:lvl5pPr>
            <a:lvl6pPr lvl="5" algn="ctr" rtl="0">
              <a:buNone/>
              <a:defRPr sz="1300">
                <a:solidFill>
                  <a:schemeClr val="lt1"/>
                </a:solidFill>
                <a:latin typeface="Della Respira"/>
                <a:ea typeface="Della Respira"/>
                <a:cs typeface="Della Respira"/>
                <a:sym typeface="Della Respira"/>
              </a:defRPr>
            </a:lvl6pPr>
            <a:lvl7pPr lvl="6" algn="ctr" rtl="0">
              <a:buNone/>
              <a:defRPr sz="1300">
                <a:solidFill>
                  <a:schemeClr val="lt1"/>
                </a:solidFill>
                <a:latin typeface="Della Respira"/>
                <a:ea typeface="Della Respira"/>
                <a:cs typeface="Della Respira"/>
                <a:sym typeface="Della Respira"/>
              </a:defRPr>
            </a:lvl7pPr>
            <a:lvl8pPr lvl="7" algn="ctr" rtl="0">
              <a:buNone/>
              <a:defRPr sz="1300">
                <a:solidFill>
                  <a:schemeClr val="lt1"/>
                </a:solidFill>
                <a:latin typeface="Della Respira"/>
                <a:ea typeface="Della Respira"/>
                <a:cs typeface="Della Respira"/>
                <a:sym typeface="Della Respira"/>
              </a:defRPr>
            </a:lvl8pPr>
            <a:lvl9pPr lvl="8" algn="ctr" rtl="0">
              <a:buNone/>
              <a:defRPr sz="1300">
                <a:solidFill>
                  <a:schemeClr val="lt1"/>
                </a:solidFill>
                <a:latin typeface="Della Respira"/>
                <a:ea typeface="Della Respira"/>
                <a:cs typeface="Della Respira"/>
                <a:sym typeface="Della Respira"/>
              </a:defRPr>
            </a:lvl9pPr>
          </a:lstStyle>
          <a:p>
            <a:pPr marL="0" lvl="0" indent="0" algn="ct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3" r:id="rId4"/>
    <p:sldLayoutId id="2147483654" r:id="rId5"/>
    <p:sldLayoutId id="2147483655" r:id="rId6"/>
    <p:sldLayoutId id="2147483656" r:id="rId7"/>
    <p:sldLayoutId id="2147483657" r:id="rId8"/>
    <p:sldLayoutId id="2147483658" r:id="rId9"/>
    <p:sldLayoutId id="2147483659" r:id="rId10"/>
    <p:sldLayoutId id="2147483660" r:id="rId11"/>
  </p:sldLayoutIdLst>
  <p:transition>
    <p:fade/>
  </p:transition>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name="simple-light">
    <p:bg>
      <p:bgPr>
        <a:gradFill>
          <a:gsLst>
            <a:gs pos="0">
              <a:schemeClr val="accent1"/>
            </a:gs>
            <a:gs pos="19000">
              <a:schemeClr val="accent2"/>
            </a:gs>
            <a:gs pos="39000">
              <a:schemeClr val="accent4"/>
            </a:gs>
            <a:gs pos="52999">
              <a:schemeClr val="accent5"/>
            </a:gs>
            <a:gs pos="63000">
              <a:schemeClr val="accent6"/>
            </a:gs>
            <a:gs pos="65000">
              <a:schemeClr val="accent5"/>
            </a:gs>
            <a:gs pos="71000">
              <a:schemeClr val="accent4"/>
            </a:gs>
            <a:gs pos="82000">
              <a:schemeClr val="accent2"/>
            </a:gs>
            <a:gs pos="95000">
              <a:schemeClr val="accent3"/>
            </a:gs>
            <a:gs pos="100000">
              <a:schemeClr val="accent3"/>
            </a:gs>
          </a:gsLst>
          <a:lin ang="5400012" scaled="0"/>
        </a:gradFill>
        <a:effectLst/>
      </p:bgPr>
    </p:bg>
    <p:spTree>
      <p:nvGrpSpPr>
        <p:cNvPr id="1" name="Shape 5"/>
        <p:cNvGrpSpPr/>
        <p:nvPr/>
      </p:nvGrpSpPr>
      <p:grpSpPr>
        <a:xfrm>
          <a:off x="0" y="0"/>
          <a:ext cx="0" cy="0"/>
          <a:chOff x="0" y="0"/>
          <a:chExt cx="0" cy="0"/>
        </a:xfrm>
      </p:grpSpPr>
      <p:grpSp>
        <p:nvGrpSpPr>
          <p:cNvPr id="6" name="Google Shape;6;p68"/>
          <p:cNvGrpSpPr/>
          <p:nvPr/>
        </p:nvGrpSpPr>
        <p:grpSpPr>
          <a:xfrm>
            <a:off x="-118224" y="-233576"/>
            <a:ext cx="9239574" cy="3010918"/>
            <a:chOff x="-118224" y="-233576"/>
            <a:chExt cx="9239574" cy="3010918"/>
          </a:xfrm>
        </p:grpSpPr>
        <p:grpSp>
          <p:nvGrpSpPr>
            <p:cNvPr id="7" name="Google Shape;7;p68"/>
            <p:cNvGrpSpPr/>
            <p:nvPr/>
          </p:nvGrpSpPr>
          <p:grpSpPr>
            <a:xfrm>
              <a:off x="1431407" y="-101026"/>
              <a:ext cx="1032685" cy="1032685"/>
              <a:chOff x="4937822" y="2270799"/>
              <a:chExt cx="2311809" cy="2311809"/>
            </a:xfrm>
          </p:grpSpPr>
          <p:sp>
            <p:nvSpPr>
              <p:cNvPr id="8" name="Google Shape;8;p68"/>
              <p:cNvSpPr/>
              <p:nvPr/>
            </p:nvSpPr>
            <p:spPr>
              <a:xfrm>
                <a:off x="4937822" y="2270799"/>
                <a:ext cx="2311809" cy="2311809"/>
              </a:xfrm>
              <a:custGeom>
                <a:avLst/>
                <a:gdLst/>
                <a:ahLst/>
                <a:cxnLst/>
                <a:rect l="l" t="t" r="r" b="b"/>
                <a:pathLst>
                  <a:path w="1875707" h="1875707" extrusionOk="0">
                    <a:moveTo>
                      <a:pt x="923567" y="903157"/>
                    </a:moveTo>
                    <a:lnTo>
                      <a:pt x="940085" y="0"/>
                    </a:lnTo>
                    <a:lnTo>
                      <a:pt x="952331" y="903252"/>
                    </a:lnTo>
                    <a:lnTo>
                      <a:pt x="1602596" y="276244"/>
                    </a:lnTo>
                    <a:lnTo>
                      <a:pt x="972551" y="923567"/>
                    </a:lnTo>
                    <a:lnTo>
                      <a:pt x="1875708" y="940085"/>
                    </a:lnTo>
                    <a:lnTo>
                      <a:pt x="972456" y="952331"/>
                    </a:lnTo>
                    <a:lnTo>
                      <a:pt x="1599464" y="1602596"/>
                    </a:lnTo>
                    <a:lnTo>
                      <a:pt x="952141" y="972551"/>
                    </a:lnTo>
                    <a:lnTo>
                      <a:pt x="935623" y="1875708"/>
                    </a:lnTo>
                    <a:lnTo>
                      <a:pt x="923472" y="972456"/>
                    </a:lnTo>
                    <a:lnTo>
                      <a:pt x="273112" y="1599464"/>
                    </a:lnTo>
                    <a:lnTo>
                      <a:pt x="903157" y="952141"/>
                    </a:lnTo>
                    <a:lnTo>
                      <a:pt x="0" y="935623"/>
                    </a:lnTo>
                    <a:lnTo>
                      <a:pt x="903252" y="923472"/>
                    </a:lnTo>
                    <a:lnTo>
                      <a:pt x="276244" y="273112"/>
                    </a:lnTo>
                    <a:lnTo>
                      <a:pt x="923567" y="903157"/>
                    </a:lnTo>
                    <a:close/>
                  </a:path>
                </a:pathLst>
              </a:custGeom>
              <a:gradFill>
                <a:gsLst>
                  <a:gs pos="0">
                    <a:srgbClr val="E3E8FB">
                      <a:alpha val="34901"/>
                    </a:srgbClr>
                  </a:gs>
                  <a:gs pos="100000">
                    <a:srgbClr val="E3E8FB">
                      <a:alpha val="0"/>
                    </a:srgbClr>
                  </a:gs>
                </a:gsLst>
                <a:path path="circle">
                  <a:fillToRect l="50000" t="50000" r="50000" b="50000"/>
                </a:path>
                <a:tileRect/>
              </a:gradFill>
              <a:ln>
                <a:noFill/>
              </a:ln>
            </p:spPr>
            <p:txBody>
              <a:bodyPr spcFirstLastPara="1" wrap="square" lIns="91425" tIns="45700" rIns="91425" bIns="45700" anchor="ctr" anchorCtr="0">
                <a:no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rgbClr val="000000"/>
                  </a:solidFill>
                  <a:latin typeface="Calibri"/>
                  <a:ea typeface="Calibri"/>
                  <a:cs typeface="Calibri"/>
                  <a:sym typeface="Calibri"/>
                </a:endParaRPr>
              </a:p>
            </p:txBody>
          </p:sp>
          <p:sp>
            <p:nvSpPr>
              <p:cNvPr id="9" name="Google Shape;9;p68"/>
              <p:cNvSpPr/>
              <p:nvPr/>
            </p:nvSpPr>
            <p:spPr>
              <a:xfrm>
                <a:off x="6046636" y="3379636"/>
                <a:ext cx="94929" cy="94929"/>
              </a:xfrm>
              <a:custGeom>
                <a:avLst/>
                <a:gdLst/>
                <a:ahLst/>
                <a:cxnLst/>
                <a:rect l="l" t="t" r="r" b="b"/>
                <a:pathLst>
                  <a:path w="94929" h="94929" extrusionOk="0">
                    <a:moveTo>
                      <a:pt x="94929" y="47465"/>
                    </a:moveTo>
                    <a:cubicBezTo>
                      <a:pt x="94929" y="73679"/>
                      <a:pt x="73679" y="94929"/>
                      <a:pt x="47465" y="94929"/>
                    </a:cubicBezTo>
                    <a:cubicBezTo>
                      <a:pt x="21251" y="94929"/>
                      <a:pt x="0" y="73679"/>
                      <a:pt x="0" y="47465"/>
                    </a:cubicBezTo>
                    <a:cubicBezTo>
                      <a:pt x="0" y="21251"/>
                      <a:pt x="21251" y="0"/>
                      <a:pt x="47465" y="0"/>
                    </a:cubicBezTo>
                    <a:cubicBezTo>
                      <a:pt x="73679" y="0"/>
                      <a:pt x="94929" y="21251"/>
                      <a:pt x="94929" y="47465"/>
                    </a:cubicBezTo>
                    <a:close/>
                  </a:path>
                </a:pathLst>
              </a:custGeom>
              <a:solidFill>
                <a:schemeClr val="lt1"/>
              </a:solidFill>
              <a:ln>
                <a:noFill/>
              </a:ln>
            </p:spPr>
            <p:txBody>
              <a:bodyPr spcFirstLastPara="1" wrap="square" lIns="91425" tIns="45700" rIns="91425" bIns="45700" anchor="ctr" anchorCtr="0">
                <a:no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rgbClr val="000000"/>
                  </a:solidFill>
                  <a:latin typeface="Calibri"/>
                  <a:ea typeface="Calibri"/>
                  <a:cs typeface="Calibri"/>
                  <a:sym typeface="Calibri"/>
                </a:endParaRPr>
              </a:p>
            </p:txBody>
          </p:sp>
        </p:grpSp>
        <p:grpSp>
          <p:nvGrpSpPr>
            <p:cNvPr id="10" name="Google Shape;10;p68"/>
            <p:cNvGrpSpPr/>
            <p:nvPr/>
          </p:nvGrpSpPr>
          <p:grpSpPr>
            <a:xfrm>
              <a:off x="50307" y="-233576"/>
              <a:ext cx="1032685" cy="1032685"/>
              <a:chOff x="4937822" y="2270799"/>
              <a:chExt cx="2311809" cy="2311809"/>
            </a:xfrm>
          </p:grpSpPr>
          <p:sp>
            <p:nvSpPr>
              <p:cNvPr id="11" name="Google Shape;11;p68"/>
              <p:cNvSpPr/>
              <p:nvPr/>
            </p:nvSpPr>
            <p:spPr>
              <a:xfrm>
                <a:off x="4937822" y="2270799"/>
                <a:ext cx="2311809" cy="2311809"/>
              </a:xfrm>
              <a:custGeom>
                <a:avLst/>
                <a:gdLst/>
                <a:ahLst/>
                <a:cxnLst/>
                <a:rect l="l" t="t" r="r" b="b"/>
                <a:pathLst>
                  <a:path w="1875707" h="1875707" extrusionOk="0">
                    <a:moveTo>
                      <a:pt x="923567" y="903157"/>
                    </a:moveTo>
                    <a:lnTo>
                      <a:pt x="940085" y="0"/>
                    </a:lnTo>
                    <a:lnTo>
                      <a:pt x="952331" y="903252"/>
                    </a:lnTo>
                    <a:lnTo>
                      <a:pt x="1602596" y="276244"/>
                    </a:lnTo>
                    <a:lnTo>
                      <a:pt x="972551" y="923567"/>
                    </a:lnTo>
                    <a:lnTo>
                      <a:pt x="1875708" y="940085"/>
                    </a:lnTo>
                    <a:lnTo>
                      <a:pt x="972456" y="952331"/>
                    </a:lnTo>
                    <a:lnTo>
                      <a:pt x="1599464" y="1602596"/>
                    </a:lnTo>
                    <a:lnTo>
                      <a:pt x="952141" y="972551"/>
                    </a:lnTo>
                    <a:lnTo>
                      <a:pt x="935623" y="1875708"/>
                    </a:lnTo>
                    <a:lnTo>
                      <a:pt x="923472" y="972456"/>
                    </a:lnTo>
                    <a:lnTo>
                      <a:pt x="273112" y="1599464"/>
                    </a:lnTo>
                    <a:lnTo>
                      <a:pt x="903157" y="952141"/>
                    </a:lnTo>
                    <a:lnTo>
                      <a:pt x="0" y="935623"/>
                    </a:lnTo>
                    <a:lnTo>
                      <a:pt x="903252" y="923472"/>
                    </a:lnTo>
                    <a:lnTo>
                      <a:pt x="276244" y="273112"/>
                    </a:lnTo>
                    <a:lnTo>
                      <a:pt x="923567" y="903157"/>
                    </a:lnTo>
                    <a:close/>
                  </a:path>
                </a:pathLst>
              </a:custGeom>
              <a:gradFill>
                <a:gsLst>
                  <a:gs pos="0">
                    <a:srgbClr val="E569FF">
                      <a:alpha val="58823"/>
                    </a:srgbClr>
                  </a:gs>
                  <a:gs pos="100000">
                    <a:srgbClr val="E3E8FB">
                      <a:alpha val="0"/>
                    </a:srgbClr>
                  </a:gs>
                </a:gsLst>
                <a:path path="circle">
                  <a:fillToRect l="50000" t="50000" r="50000" b="50000"/>
                </a:path>
                <a:tileRect/>
              </a:gradFill>
              <a:ln>
                <a:noFill/>
              </a:ln>
            </p:spPr>
            <p:txBody>
              <a:bodyPr spcFirstLastPara="1" wrap="square" lIns="91425" tIns="45700" rIns="91425" bIns="45700" anchor="ctr" anchorCtr="0">
                <a:no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rgbClr val="000000"/>
                  </a:solidFill>
                  <a:latin typeface="Calibri"/>
                  <a:ea typeface="Calibri"/>
                  <a:cs typeface="Calibri"/>
                  <a:sym typeface="Calibri"/>
                </a:endParaRPr>
              </a:p>
            </p:txBody>
          </p:sp>
          <p:sp>
            <p:nvSpPr>
              <p:cNvPr id="12" name="Google Shape;12;p68"/>
              <p:cNvSpPr/>
              <p:nvPr/>
            </p:nvSpPr>
            <p:spPr>
              <a:xfrm>
                <a:off x="6046636" y="3379636"/>
                <a:ext cx="94929" cy="94929"/>
              </a:xfrm>
              <a:custGeom>
                <a:avLst/>
                <a:gdLst/>
                <a:ahLst/>
                <a:cxnLst/>
                <a:rect l="l" t="t" r="r" b="b"/>
                <a:pathLst>
                  <a:path w="94929" h="94929" extrusionOk="0">
                    <a:moveTo>
                      <a:pt x="94929" y="47465"/>
                    </a:moveTo>
                    <a:cubicBezTo>
                      <a:pt x="94929" y="73679"/>
                      <a:pt x="73679" y="94929"/>
                      <a:pt x="47465" y="94929"/>
                    </a:cubicBezTo>
                    <a:cubicBezTo>
                      <a:pt x="21251" y="94929"/>
                      <a:pt x="0" y="73679"/>
                      <a:pt x="0" y="47465"/>
                    </a:cubicBezTo>
                    <a:cubicBezTo>
                      <a:pt x="0" y="21251"/>
                      <a:pt x="21251" y="0"/>
                      <a:pt x="47465" y="0"/>
                    </a:cubicBezTo>
                    <a:cubicBezTo>
                      <a:pt x="73679" y="0"/>
                      <a:pt x="94929" y="21251"/>
                      <a:pt x="94929" y="47465"/>
                    </a:cubicBezTo>
                    <a:close/>
                  </a:path>
                </a:pathLst>
              </a:custGeom>
              <a:solidFill>
                <a:srgbClr val="E569FF"/>
              </a:solidFill>
              <a:ln>
                <a:noFill/>
              </a:ln>
            </p:spPr>
            <p:txBody>
              <a:bodyPr spcFirstLastPara="1" wrap="square" lIns="91425" tIns="45700" rIns="91425" bIns="45700" anchor="ctr" anchorCtr="0">
                <a:no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rgbClr val="000000"/>
                  </a:solidFill>
                  <a:latin typeface="Calibri"/>
                  <a:ea typeface="Calibri"/>
                  <a:cs typeface="Calibri"/>
                  <a:sym typeface="Calibri"/>
                </a:endParaRPr>
              </a:p>
            </p:txBody>
          </p:sp>
        </p:grpSp>
        <p:grpSp>
          <p:nvGrpSpPr>
            <p:cNvPr id="13" name="Google Shape;13;p68"/>
            <p:cNvGrpSpPr/>
            <p:nvPr/>
          </p:nvGrpSpPr>
          <p:grpSpPr>
            <a:xfrm>
              <a:off x="7125382" y="371399"/>
              <a:ext cx="1032685" cy="1032685"/>
              <a:chOff x="4937822" y="2270799"/>
              <a:chExt cx="2311809" cy="2311809"/>
            </a:xfrm>
          </p:grpSpPr>
          <p:sp>
            <p:nvSpPr>
              <p:cNvPr id="14" name="Google Shape;14;p68"/>
              <p:cNvSpPr/>
              <p:nvPr/>
            </p:nvSpPr>
            <p:spPr>
              <a:xfrm>
                <a:off x="4937822" y="2270799"/>
                <a:ext cx="2311809" cy="2311809"/>
              </a:xfrm>
              <a:custGeom>
                <a:avLst/>
                <a:gdLst/>
                <a:ahLst/>
                <a:cxnLst/>
                <a:rect l="l" t="t" r="r" b="b"/>
                <a:pathLst>
                  <a:path w="1875707" h="1875707" extrusionOk="0">
                    <a:moveTo>
                      <a:pt x="923567" y="903157"/>
                    </a:moveTo>
                    <a:lnTo>
                      <a:pt x="940085" y="0"/>
                    </a:lnTo>
                    <a:lnTo>
                      <a:pt x="952331" y="903252"/>
                    </a:lnTo>
                    <a:lnTo>
                      <a:pt x="1602596" y="276244"/>
                    </a:lnTo>
                    <a:lnTo>
                      <a:pt x="972551" y="923567"/>
                    </a:lnTo>
                    <a:lnTo>
                      <a:pt x="1875708" y="940085"/>
                    </a:lnTo>
                    <a:lnTo>
                      <a:pt x="972456" y="952331"/>
                    </a:lnTo>
                    <a:lnTo>
                      <a:pt x="1599464" y="1602596"/>
                    </a:lnTo>
                    <a:lnTo>
                      <a:pt x="952141" y="972551"/>
                    </a:lnTo>
                    <a:lnTo>
                      <a:pt x="935623" y="1875708"/>
                    </a:lnTo>
                    <a:lnTo>
                      <a:pt x="923472" y="972456"/>
                    </a:lnTo>
                    <a:lnTo>
                      <a:pt x="273112" y="1599464"/>
                    </a:lnTo>
                    <a:lnTo>
                      <a:pt x="903157" y="952141"/>
                    </a:lnTo>
                    <a:lnTo>
                      <a:pt x="0" y="935623"/>
                    </a:lnTo>
                    <a:lnTo>
                      <a:pt x="903252" y="923472"/>
                    </a:lnTo>
                    <a:lnTo>
                      <a:pt x="276244" y="273112"/>
                    </a:lnTo>
                    <a:lnTo>
                      <a:pt x="923567" y="903157"/>
                    </a:lnTo>
                    <a:close/>
                  </a:path>
                </a:pathLst>
              </a:custGeom>
              <a:gradFill>
                <a:gsLst>
                  <a:gs pos="0">
                    <a:srgbClr val="E3E8FB">
                      <a:alpha val="34901"/>
                    </a:srgbClr>
                  </a:gs>
                  <a:gs pos="100000">
                    <a:srgbClr val="E3E8FB">
                      <a:alpha val="0"/>
                    </a:srgbClr>
                  </a:gs>
                </a:gsLst>
                <a:path path="circle">
                  <a:fillToRect l="50000" t="50000" r="50000" b="50000"/>
                </a:path>
                <a:tileRect/>
              </a:gradFill>
              <a:ln>
                <a:noFill/>
              </a:ln>
            </p:spPr>
            <p:txBody>
              <a:bodyPr spcFirstLastPara="1" wrap="square" lIns="91425" tIns="45700" rIns="91425" bIns="45700" anchor="ctr" anchorCtr="0">
                <a:no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rgbClr val="000000"/>
                  </a:solidFill>
                  <a:latin typeface="Calibri"/>
                  <a:ea typeface="Calibri"/>
                  <a:cs typeface="Calibri"/>
                  <a:sym typeface="Calibri"/>
                </a:endParaRPr>
              </a:p>
            </p:txBody>
          </p:sp>
          <p:sp>
            <p:nvSpPr>
              <p:cNvPr id="15" name="Google Shape;15;p68"/>
              <p:cNvSpPr/>
              <p:nvPr/>
            </p:nvSpPr>
            <p:spPr>
              <a:xfrm>
                <a:off x="6046636" y="3379636"/>
                <a:ext cx="94929" cy="94929"/>
              </a:xfrm>
              <a:custGeom>
                <a:avLst/>
                <a:gdLst/>
                <a:ahLst/>
                <a:cxnLst/>
                <a:rect l="l" t="t" r="r" b="b"/>
                <a:pathLst>
                  <a:path w="94929" h="94929" extrusionOk="0">
                    <a:moveTo>
                      <a:pt x="94929" y="47465"/>
                    </a:moveTo>
                    <a:cubicBezTo>
                      <a:pt x="94929" y="73679"/>
                      <a:pt x="73679" y="94929"/>
                      <a:pt x="47465" y="94929"/>
                    </a:cubicBezTo>
                    <a:cubicBezTo>
                      <a:pt x="21251" y="94929"/>
                      <a:pt x="0" y="73679"/>
                      <a:pt x="0" y="47465"/>
                    </a:cubicBezTo>
                    <a:cubicBezTo>
                      <a:pt x="0" y="21251"/>
                      <a:pt x="21251" y="0"/>
                      <a:pt x="47465" y="0"/>
                    </a:cubicBezTo>
                    <a:cubicBezTo>
                      <a:pt x="73679" y="0"/>
                      <a:pt x="94929" y="21251"/>
                      <a:pt x="94929" y="47465"/>
                    </a:cubicBezTo>
                    <a:close/>
                  </a:path>
                </a:pathLst>
              </a:custGeom>
              <a:solidFill>
                <a:schemeClr val="lt1"/>
              </a:solidFill>
              <a:ln>
                <a:noFill/>
              </a:ln>
            </p:spPr>
            <p:txBody>
              <a:bodyPr spcFirstLastPara="1" wrap="square" lIns="91425" tIns="45700" rIns="91425" bIns="45700" anchor="ctr" anchorCtr="0">
                <a:no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rgbClr val="000000"/>
                  </a:solidFill>
                  <a:latin typeface="Calibri"/>
                  <a:ea typeface="Calibri"/>
                  <a:cs typeface="Calibri"/>
                  <a:sym typeface="Calibri"/>
                </a:endParaRPr>
              </a:p>
            </p:txBody>
          </p:sp>
        </p:grpSp>
        <p:grpSp>
          <p:nvGrpSpPr>
            <p:cNvPr id="16" name="Google Shape;16;p68"/>
            <p:cNvGrpSpPr/>
            <p:nvPr/>
          </p:nvGrpSpPr>
          <p:grpSpPr>
            <a:xfrm>
              <a:off x="-118224" y="419163"/>
              <a:ext cx="803354" cy="803354"/>
              <a:chOff x="4937822" y="2270799"/>
              <a:chExt cx="2311809" cy="2311809"/>
            </a:xfrm>
          </p:grpSpPr>
          <p:sp>
            <p:nvSpPr>
              <p:cNvPr id="17" name="Google Shape;17;p68"/>
              <p:cNvSpPr/>
              <p:nvPr/>
            </p:nvSpPr>
            <p:spPr>
              <a:xfrm>
                <a:off x="4937822" y="2270799"/>
                <a:ext cx="2311809" cy="2311809"/>
              </a:xfrm>
              <a:custGeom>
                <a:avLst/>
                <a:gdLst/>
                <a:ahLst/>
                <a:cxnLst/>
                <a:rect l="l" t="t" r="r" b="b"/>
                <a:pathLst>
                  <a:path w="1875707" h="1875707" extrusionOk="0">
                    <a:moveTo>
                      <a:pt x="923567" y="903157"/>
                    </a:moveTo>
                    <a:lnTo>
                      <a:pt x="940085" y="0"/>
                    </a:lnTo>
                    <a:lnTo>
                      <a:pt x="952331" y="903252"/>
                    </a:lnTo>
                    <a:lnTo>
                      <a:pt x="1602596" y="276244"/>
                    </a:lnTo>
                    <a:lnTo>
                      <a:pt x="972551" y="923567"/>
                    </a:lnTo>
                    <a:lnTo>
                      <a:pt x="1875708" y="940085"/>
                    </a:lnTo>
                    <a:lnTo>
                      <a:pt x="972456" y="952331"/>
                    </a:lnTo>
                    <a:lnTo>
                      <a:pt x="1599464" y="1602596"/>
                    </a:lnTo>
                    <a:lnTo>
                      <a:pt x="952141" y="972551"/>
                    </a:lnTo>
                    <a:lnTo>
                      <a:pt x="935623" y="1875708"/>
                    </a:lnTo>
                    <a:lnTo>
                      <a:pt x="923472" y="972456"/>
                    </a:lnTo>
                    <a:lnTo>
                      <a:pt x="273112" y="1599464"/>
                    </a:lnTo>
                    <a:lnTo>
                      <a:pt x="903157" y="952141"/>
                    </a:lnTo>
                    <a:lnTo>
                      <a:pt x="0" y="935623"/>
                    </a:lnTo>
                    <a:lnTo>
                      <a:pt x="903252" y="923472"/>
                    </a:lnTo>
                    <a:lnTo>
                      <a:pt x="276244" y="273112"/>
                    </a:lnTo>
                    <a:lnTo>
                      <a:pt x="923567" y="903157"/>
                    </a:lnTo>
                    <a:close/>
                  </a:path>
                </a:pathLst>
              </a:custGeom>
              <a:gradFill>
                <a:gsLst>
                  <a:gs pos="0">
                    <a:srgbClr val="E569FF">
                      <a:alpha val="58823"/>
                    </a:srgbClr>
                  </a:gs>
                  <a:gs pos="100000">
                    <a:srgbClr val="E3E8FB">
                      <a:alpha val="0"/>
                    </a:srgbClr>
                  </a:gs>
                </a:gsLst>
                <a:path path="circle">
                  <a:fillToRect l="50000" t="50000" r="50000" b="50000"/>
                </a:path>
                <a:tileRect/>
              </a:gradFill>
              <a:ln>
                <a:noFill/>
              </a:ln>
            </p:spPr>
            <p:txBody>
              <a:bodyPr spcFirstLastPara="1" wrap="square" lIns="91425" tIns="45700" rIns="91425" bIns="45700" anchor="ctr" anchorCtr="0">
                <a:no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rgbClr val="000000"/>
                  </a:solidFill>
                  <a:latin typeface="Calibri"/>
                  <a:ea typeface="Calibri"/>
                  <a:cs typeface="Calibri"/>
                  <a:sym typeface="Calibri"/>
                </a:endParaRPr>
              </a:p>
            </p:txBody>
          </p:sp>
          <p:sp>
            <p:nvSpPr>
              <p:cNvPr id="18" name="Google Shape;18;p68"/>
              <p:cNvSpPr/>
              <p:nvPr/>
            </p:nvSpPr>
            <p:spPr>
              <a:xfrm>
                <a:off x="6046636" y="3379636"/>
                <a:ext cx="94929" cy="94929"/>
              </a:xfrm>
              <a:custGeom>
                <a:avLst/>
                <a:gdLst/>
                <a:ahLst/>
                <a:cxnLst/>
                <a:rect l="l" t="t" r="r" b="b"/>
                <a:pathLst>
                  <a:path w="94929" h="94929" extrusionOk="0">
                    <a:moveTo>
                      <a:pt x="94929" y="47465"/>
                    </a:moveTo>
                    <a:cubicBezTo>
                      <a:pt x="94929" y="73679"/>
                      <a:pt x="73679" y="94929"/>
                      <a:pt x="47465" y="94929"/>
                    </a:cubicBezTo>
                    <a:cubicBezTo>
                      <a:pt x="21251" y="94929"/>
                      <a:pt x="0" y="73679"/>
                      <a:pt x="0" y="47465"/>
                    </a:cubicBezTo>
                    <a:cubicBezTo>
                      <a:pt x="0" y="21251"/>
                      <a:pt x="21251" y="0"/>
                      <a:pt x="47465" y="0"/>
                    </a:cubicBezTo>
                    <a:cubicBezTo>
                      <a:pt x="73679" y="0"/>
                      <a:pt x="94929" y="21251"/>
                      <a:pt x="94929" y="47465"/>
                    </a:cubicBezTo>
                    <a:close/>
                  </a:path>
                </a:pathLst>
              </a:custGeom>
              <a:solidFill>
                <a:srgbClr val="E569FF"/>
              </a:solidFill>
              <a:ln>
                <a:noFill/>
              </a:ln>
            </p:spPr>
            <p:txBody>
              <a:bodyPr spcFirstLastPara="1" wrap="square" lIns="91425" tIns="45700" rIns="91425" bIns="45700" anchor="ctr" anchorCtr="0">
                <a:no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rgbClr val="000000"/>
                  </a:solidFill>
                  <a:latin typeface="Calibri"/>
                  <a:ea typeface="Calibri"/>
                  <a:cs typeface="Calibri"/>
                  <a:sym typeface="Calibri"/>
                </a:endParaRPr>
              </a:p>
            </p:txBody>
          </p:sp>
        </p:grpSp>
        <p:grpSp>
          <p:nvGrpSpPr>
            <p:cNvPr id="19" name="Google Shape;19;p68"/>
            <p:cNvGrpSpPr/>
            <p:nvPr/>
          </p:nvGrpSpPr>
          <p:grpSpPr>
            <a:xfrm>
              <a:off x="2717107" y="1008374"/>
              <a:ext cx="1032685" cy="1032685"/>
              <a:chOff x="4937822" y="2270799"/>
              <a:chExt cx="2311809" cy="2311809"/>
            </a:xfrm>
          </p:grpSpPr>
          <p:sp>
            <p:nvSpPr>
              <p:cNvPr id="20" name="Google Shape;20;p68"/>
              <p:cNvSpPr/>
              <p:nvPr/>
            </p:nvSpPr>
            <p:spPr>
              <a:xfrm>
                <a:off x="4937822" y="2270799"/>
                <a:ext cx="2311809" cy="2311809"/>
              </a:xfrm>
              <a:custGeom>
                <a:avLst/>
                <a:gdLst/>
                <a:ahLst/>
                <a:cxnLst/>
                <a:rect l="l" t="t" r="r" b="b"/>
                <a:pathLst>
                  <a:path w="1875707" h="1875707" extrusionOk="0">
                    <a:moveTo>
                      <a:pt x="923567" y="903157"/>
                    </a:moveTo>
                    <a:lnTo>
                      <a:pt x="940085" y="0"/>
                    </a:lnTo>
                    <a:lnTo>
                      <a:pt x="952331" y="903252"/>
                    </a:lnTo>
                    <a:lnTo>
                      <a:pt x="1602596" y="276244"/>
                    </a:lnTo>
                    <a:lnTo>
                      <a:pt x="972551" y="923567"/>
                    </a:lnTo>
                    <a:lnTo>
                      <a:pt x="1875708" y="940085"/>
                    </a:lnTo>
                    <a:lnTo>
                      <a:pt x="972456" y="952331"/>
                    </a:lnTo>
                    <a:lnTo>
                      <a:pt x="1599464" y="1602596"/>
                    </a:lnTo>
                    <a:lnTo>
                      <a:pt x="952141" y="972551"/>
                    </a:lnTo>
                    <a:lnTo>
                      <a:pt x="935623" y="1875708"/>
                    </a:lnTo>
                    <a:lnTo>
                      <a:pt x="923472" y="972456"/>
                    </a:lnTo>
                    <a:lnTo>
                      <a:pt x="273112" y="1599464"/>
                    </a:lnTo>
                    <a:lnTo>
                      <a:pt x="903157" y="952141"/>
                    </a:lnTo>
                    <a:lnTo>
                      <a:pt x="0" y="935623"/>
                    </a:lnTo>
                    <a:lnTo>
                      <a:pt x="903252" y="923472"/>
                    </a:lnTo>
                    <a:lnTo>
                      <a:pt x="276244" y="273112"/>
                    </a:lnTo>
                    <a:lnTo>
                      <a:pt x="923567" y="903157"/>
                    </a:lnTo>
                    <a:close/>
                  </a:path>
                </a:pathLst>
              </a:custGeom>
              <a:gradFill>
                <a:gsLst>
                  <a:gs pos="0">
                    <a:srgbClr val="E569FF">
                      <a:alpha val="58823"/>
                    </a:srgbClr>
                  </a:gs>
                  <a:gs pos="100000">
                    <a:srgbClr val="E3E8FB">
                      <a:alpha val="0"/>
                    </a:srgbClr>
                  </a:gs>
                </a:gsLst>
                <a:path path="circle">
                  <a:fillToRect l="50000" t="50000" r="50000" b="50000"/>
                </a:path>
                <a:tileRect/>
              </a:gradFill>
              <a:ln>
                <a:noFill/>
              </a:ln>
            </p:spPr>
            <p:txBody>
              <a:bodyPr spcFirstLastPara="1" wrap="square" lIns="91425" tIns="45700" rIns="91425" bIns="45700" anchor="ctr" anchorCtr="0">
                <a:no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rgbClr val="000000"/>
                  </a:solidFill>
                  <a:latin typeface="Calibri"/>
                  <a:ea typeface="Calibri"/>
                  <a:cs typeface="Calibri"/>
                  <a:sym typeface="Calibri"/>
                </a:endParaRPr>
              </a:p>
            </p:txBody>
          </p:sp>
          <p:sp>
            <p:nvSpPr>
              <p:cNvPr id="21" name="Google Shape;21;p68"/>
              <p:cNvSpPr/>
              <p:nvPr/>
            </p:nvSpPr>
            <p:spPr>
              <a:xfrm>
                <a:off x="6046636" y="3379636"/>
                <a:ext cx="94929" cy="94929"/>
              </a:xfrm>
              <a:custGeom>
                <a:avLst/>
                <a:gdLst/>
                <a:ahLst/>
                <a:cxnLst/>
                <a:rect l="l" t="t" r="r" b="b"/>
                <a:pathLst>
                  <a:path w="94929" h="94929" extrusionOk="0">
                    <a:moveTo>
                      <a:pt x="94929" y="47465"/>
                    </a:moveTo>
                    <a:cubicBezTo>
                      <a:pt x="94929" y="73679"/>
                      <a:pt x="73679" y="94929"/>
                      <a:pt x="47465" y="94929"/>
                    </a:cubicBezTo>
                    <a:cubicBezTo>
                      <a:pt x="21251" y="94929"/>
                      <a:pt x="0" y="73679"/>
                      <a:pt x="0" y="47465"/>
                    </a:cubicBezTo>
                    <a:cubicBezTo>
                      <a:pt x="0" y="21251"/>
                      <a:pt x="21251" y="0"/>
                      <a:pt x="47465" y="0"/>
                    </a:cubicBezTo>
                    <a:cubicBezTo>
                      <a:pt x="73679" y="0"/>
                      <a:pt x="94929" y="21251"/>
                      <a:pt x="94929" y="47465"/>
                    </a:cubicBezTo>
                    <a:close/>
                  </a:path>
                </a:pathLst>
              </a:custGeom>
              <a:solidFill>
                <a:srgbClr val="E569FF"/>
              </a:solidFill>
              <a:ln>
                <a:noFill/>
              </a:ln>
            </p:spPr>
            <p:txBody>
              <a:bodyPr spcFirstLastPara="1" wrap="square" lIns="91425" tIns="45700" rIns="91425" bIns="45700" anchor="ctr" anchorCtr="0">
                <a:no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rgbClr val="000000"/>
                  </a:solidFill>
                  <a:latin typeface="Calibri"/>
                  <a:ea typeface="Calibri"/>
                  <a:cs typeface="Calibri"/>
                  <a:sym typeface="Calibri"/>
                </a:endParaRPr>
              </a:p>
            </p:txBody>
          </p:sp>
        </p:grpSp>
        <p:grpSp>
          <p:nvGrpSpPr>
            <p:cNvPr id="22" name="Google Shape;22;p68"/>
            <p:cNvGrpSpPr/>
            <p:nvPr/>
          </p:nvGrpSpPr>
          <p:grpSpPr>
            <a:xfrm>
              <a:off x="6613501" y="128288"/>
              <a:ext cx="803354" cy="803354"/>
              <a:chOff x="4937822" y="2270799"/>
              <a:chExt cx="2311809" cy="2311809"/>
            </a:xfrm>
          </p:grpSpPr>
          <p:sp>
            <p:nvSpPr>
              <p:cNvPr id="23" name="Google Shape;23;p68"/>
              <p:cNvSpPr/>
              <p:nvPr/>
            </p:nvSpPr>
            <p:spPr>
              <a:xfrm>
                <a:off x="4937822" y="2270799"/>
                <a:ext cx="2311809" cy="2311809"/>
              </a:xfrm>
              <a:custGeom>
                <a:avLst/>
                <a:gdLst/>
                <a:ahLst/>
                <a:cxnLst/>
                <a:rect l="l" t="t" r="r" b="b"/>
                <a:pathLst>
                  <a:path w="1875707" h="1875707" extrusionOk="0">
                    <a:moveTo>
                      <a:pt x="923567" y="903157"/>
                    </a:moveTo>
                    <a:lnTo>
                      <a:pt x="940085" y="0"/>
                    </a:lnTo>
                    <a:lnTo>
                      <a:pt x="952331" y="903252"/>
                    </a:lnTo>
                    <a:lnTo>
                      <a:pt x="1602596" y="276244"/>
                    </a:lnTo>
                    <a:lnTo>
                      <a:pt x="972551" y="923567"/>
                    </a:lnTo>
                    <a:lnTo>
                      <a:pt x="1875708" y="940085"/>
                    </a:lnTo>
                    <a:lnTo>
                      <a:pt x="972456" y="952331"/>
                    </a:lnTo>
                    <a:lnTo>
                      <a:pt x="1599464" y="1602596"/>
                    </a:lnTo>
                    <a:lnTo>
                      <a:pt x="952141" y="972551"/>
                    </a:lnTo>
                    <a:lnTo>
                      <a:pt x="935623" y="1875708"/>
                    </a:lnTo>
                    <a:lnTo>
                      <a:pt x="923472" y="972456"/>
                    </a:lnTo>
                    <a:lnTo>
                      <a:pt x="273112" y="1599464"/>
                    </a:lnTo>
                    <a:lnTo>
                      <a:pt x="903157" y="952141"/>
                    </a:lnTo>
                    <a:lnTo>
                      <a:pt x="0" y="935623"/>
                    </a:lnTo>
                    <a:lnTo>
                      <a:pt x="903252" y="923472"/>
                    </a:lnTo>
                    <a:lnTo>
                      <a:pt x="276244" y="273112"/>
                    </a:lnTo>
                    <a:lnTo>
                      <a:pt x="923567" y="903157"/>
                    </a:lnTo>
                    <a:close/>
                  </a:path>
                </a:pathLst>
              </a:custGeom>
              <a:gradFill>
                <a:gsLst>
                  <a:gs pos="0">
                    <a:srgbClr val="E569FF">
                      <a:alpha val="58823"/>
                    </a:srgbClr>
                  </a:gs>
                  <a:gs pos="100000">
                    <a:srgbClr val="E3E8FB">
                      <a:alpha val="0"/>
                    </a:srgbClr>
                  </a:gs>
                </a:gsLst>
                <a:path path="circle">
                  <a:fillToRect l="50000" t="50000" r="50000" b="50000"/>
                </a:path>
                <a:tileRect/>
              </a:gradFill>
              <a:ln>
                <a:noFill/>
              </a:ln>
            </p:spPr>
            <p:txBody>
              <a:bodyPr spcFirstLastPara="1" wrap="square" lIns="91425" tIns="45700" rIns="91425" bIns="45700" anchor="ctr" anchorCtr="0">
                <a:no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rgbClr val="000000"/>
                  </a:solidFill>
                  <a:latin typeface="Calibri"/>
                  <a:ea typeface="Calibri"/>
                  <a:cs typeface="Calibri"/>
                  <a:sym typeface="Calibri"/>
                </a:endParaRPr>
              </a:p>
            </p:txBody>
          </p:sp>
          <p:sp>
            <p:nvSpPr>
              <p:cNvPr id="24" name="Google Shape;24;p68"/>
              <p:cNvSpPr/>
              <p:nvPr/>
            </p:nvSpPr>
            <p:spPr>
              <a:xfrm>
                <a:off x="6046636" y="3379636"/>
                <a:ext cx="94929" cy="94929"/>
              </a:xfrm>
              <a:custGeom>
                <a:avLst/>
                <a:gdLst/>
                <a:ahLst/>
                <a:cxnLst/>
                <a:rect l="l" t="t" r="r" b="b"/>
                <a:pathLst>
                  <a:path w="94929" h="94929" extrusionOk="0">
                    <a:moveTo>
                      <a:pt x="94929" y="47465"/>
                    </a:moveTo>
                    <a:cubicBezTo>
                      <a:pt x="94929" y="73679"/>
                      <a:pt x="73679" y="94929"/>
                      <a:pt x="47465" y="94929"/>
                    </a:cubicBezTo>
                    <a:cubicBezTo>
                      <a:pt x="21251" y="94929"/>
                      <a:pt x="0" y="73679"/>
                      <a:pt x="0" y="47465"/>
                    </a:cubicBezTo>
                    <a:cubicBezTo>
                      <a:pt x="0" y="21251"/>
                      <a:pt x="21251" y="0"/>
                      <a:pt x="47465" y="0"/>
                    </a:cubicBezTo>
                    <a:cubicBezTo>
                      <a:pt x="73679" y="0"/>
                      <a:pt x="94929" y="21251"/>
                      <a:pt x="94929" y="47465"/>
                    </a:cubicBezTo>
                    <a:close/>
                  </a:path>
                </a:pathLst>
              </a:custGeom>
              <a:solidFill>
                <a:srgbClr val="E569FF"/>
              </a:solidFill>
              <a:ln>
                <a:noFill/>
              </a:ln>
            </p:spPr>
            <p:txBody>
              <a:bodyPr spcFirstLastPara="1" wrap="square" lIns="91425" tIns="45700" rIns="91425" bIns="45700" anchor="ctr" anchorCtr="0">
                <a:no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rgbClr val="000000"/>
                  </a:solidFill>
                  <a:latin typeface="Calibri"/>
                  <a:ea typeface="Calibri"/>
                  <a:cs typeface="Calibri"/>
                  <a:sym typeface="Calibri"/>
                </a:endParaRPr>
              </a:p>
            </p:txBody>
          </p:sp>
        </p:grpSp>
        <p:grpSp>
          <p:nvGrpSpPr>
            <p:cNvPr id="25" name="Google Shape;25;p68"/>
            <p:cNvGrpSpPr/>
            <p:nvPr/>
          </p:nvGrpSpPr>
          <p:grpSpPr>
            <a:xfrm>
              <a:off x="3610901" y="-101034"/>
              <a:ext cx="733075" cy="733075"/>
              <a:chOff x="4937822" y="2270799"/>
              <a:chExt cx="2311809" cy="2311809"/>
            </a:xfrm>
          </p:grpSpPr>
          <p:sp>
            <p:nvSpPr>
              <p:cNvPr id="26" name="Google Shape;26;p68"/>
              <p:cNvSpPr/>
              <p:nvPr/>
            </p:nvSpPr>
            <p:spPr>
              <a:xfrm>
                <a:off x="4937822" y="2270799"/>
                <a:ext cx="2311809" cy="2311809"/>
              </a:xfrm>
              <a:custGeom>
                <a:avLst/>
                <a:gdLst/>
                <a:ahLst/>
                <a:cxnLst/>
                <a:rect l="l" t="t" r="r" b="b"/>
                <a:pathLst>
                  <a:path w="1875707" h="1875707" extrusionOk="0">
                    <a:moveTo>
                      <a:pt x="923567" y="903157"/>
                    </a:moveTo>
                    <a:lnTo>
                      <a:pt x="940085" y="0"/>
                    </a:lnTo>
                    <a:lnTo>
                      <a:pt x="952331" y="903252"/>
                    </a:lnTo>
                    <a:lnTo>
                      <a:pt x="1602596" y="276244"/>
                    </a:lnTo>
                    <a:lnTo>
                      <a:pt x="972551" y="923567"/>
                    </a:lnTo>
                    <a:lnTo>
                      <a:pt x="1875708" y="940085"/>
                    </a:lnTo>
                    <a:lnTo>
                      <a:pt x="972456" y="952331"/>
                    </a:lnTo>
                    <a:lnTo>
                      <a:pt x="1599464" y="1602596"/>
                    </a:lnTo>
                    <a:lnTo>
                      <a:pt x="952141" y="972551"/>
                    </a:lnTo>
                    <a:lnTo>
                      <a:pt x="935623" y="1875708"/>
                    </a:lnTo>
                    <a:lnTo>
                      <a:pt x="923472" y="972456"/>
                    </a:lnTo>
                    <a:lnTo>
                      <a:pt x="273112" y="1599464"/>
                    </a:lnTo>
                    <a:lnTo>
                      <a:pt x="903157" y="952141"/>
                    </a:lnTo>
                    <a:lnTo>
                      <a:pt x="0" y="935623"/>
                    </a:lnTo>
                    <a:lnTo>
                      <a:pt x="903252" y="923472"/>
                    </a:lnTo>
                    <a:lnTo>
                      <a:pt x="276244" y="273112"/>
                    </a:lnTo>
                    <a:lnTo>
                      <a:pt x="923567" y="903157"/>
                    </a:lnTo>
                    <a:close/>
                  </a:path>
                </a:pathLst>
              </a:custGeom>
              <a:gradFill>
                <a:gsLst>
                  <a:gs pos="0">
                    <a:srgbClr val="E3E8FB">
                      <a:alpha val="34901"/>
                    </a:srgbClr>
                  </a:gs>
                  <a:gs pos="100000">
                    <a:srgbClr val="E3E8FB">
                      <a:alpha val="0"/>
                    </a:srgbClr>
                  </a:gs>
                </a:gsLst>
                <a:path path="circle">
                  <a:fillToRect l="50000" t="50000" r="50000" b="50000"/>
                </a:path>
                <a:tileRect/>
              </a:gradFill>
              <a:ln>
                <a:noFill/>
              </a:ln>
            </p:spPr>
            <p:txBody>
              <a:bodyPr spcFirstLastPara="1" wrap="square" lIns="91425" tIns="45700" rIns="91425" bIns="45700" anchor="ctr" anchorCtr="0">
                <a:no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rgbClr val="000000"/>
                  </a:solidFill>
                  <a:latin typeface="Calibri"/>
                  <a:ea typeface="Calibri"/>
                  <a:cs typeface="Calibri"/>
                  <a:sym typeface="Calibri"/>
                </a:endParaRPr>
              </a:p>
            </p:txBody>
          </p:sp>
          <p:sp>
            <p:nvSpPr>
              <p:cNvPr id="27" name="Google Shape;27;p68"/>
              <p:cNvSpPr/>
              <p:nvPr/>
            </p:nvSpPr>
            <p:spPr>
              <a:xfrm>
                <a:off x="6046636" y="3379636"/>
                <a:ext cx="94929" cy="94929"/>
              </a:xfrm>
              <a:custGeom>
                <a:avLst/>
                <a:gdLst/>
                <a:ahLst/>
                <a:cxnLst/>
                <a:rect l="l" t="t" r="r" b="b"/>
                <a:pathLst>
                  <a:path w="94929" h="94929" extrusionOk="0">
                    <a:moveTo>
                      <a:pt x="94929" y="47465"/>
                    </a:moveTo>
                    <a:cubicBezTo>
                      <a:pt x="94929" y="73679"/>
                      <a:pt x="73679" y="94929"/>
                      <a:pt x="47465" y="94929"/>
                    </a:cubicBezTo>
                    <a:cubicBezTo>
                      <a:pt x="21251" y="94929"/>
                      <a:pt x="0" y="73679"/>
                      <a:pt x="0" y="47465"/>
                    </a:cubicBezTo>
                    <a:cubicBezTo>
                      <a:pt x="0" y="21251"/>
                      <a:pt x="21251" y="0"/>
                      <a:pt x="47465" y="0"/>
                    </a:cubicBezTo>
                    <a:cubicBezTo>
                      <a:pt x="73679" y="0"/>
                      <a:pt x="94929" y="21251"/>
                      <a:pt x="94929" y="47465"/>
                    </a:cubicBezTo>
                    <a:close/>
                  </a:path>
                </a:pathLst>
              </a:custGeom>
              <a:solidFill>
                <a:schemeClr val="lt1"/>
              </a:solidFill>
              <a:ln>
                <a:noFill/>
              </a:ln>
            </p:spPr>
            <p:txBody>
              <a:bodyPr spcFirstLastPara="1" wrap="square" lIns="91425" tIns="45700" rIns="91425" bIns="45700" anchor="ctr" anchorCtr="0">
                <a:no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rgbClr val="000000"/>
                  </a:solidFill>
                  <a:latin typeface="Calibri"/>
                  <a:ea typeface="Calibri"/>
                  <a:cs typeface="Calibri"/>
                  <a:sym typeface="Calibri"/>
                </a:endParaRPr>
              </a:p>
            </p:txBody>
          </p:sp>
        </p:grpSp>
        <p:grpSp>
          <p:nvGrpSpPr>
            <p:cNvPr id="28" name="Google Shape;28;p68"/>
            <p:cNvGrpSpPr/>
            <p:nvPr/>
          </p:nvGrpSpPr>
          <p:grpSpPr>
            <a:xfrm>
              <a:off x="50301" y="1973988"/>
              <a:ext cx="803354" cy="803354"/>
              <a:chOff x="4937822" y="2270799"/>
              <a:chExt cx="2311809" cy="2311809"/>
            </a:xfrm>
          </p:grpSpPr>
          <p:sp>
            <p:nvSpPr>
              <p:cNvPr id="29" name="Google Shape;29;p68"/>
              <p:cNvSpPr/>
              <p:nvPr/>
            </p:nvSpPr>
            <p:spPr>
              <a:xfrm>
                <a:off x="4937822" y="2270799"/>
                <a:ext cx="2311809" cy="2311809"/>
              </a:xfrm>
              <a:custGeom>
                <a:avLst/>
                <a:gdLst/>
                <a:ahLst/>
                <a:cxnLst/>
                <a:rect l="l" t="t" r="r" b="b"/>
                <a:pathLst>
                  <a:path w="1875707" h="1875707" extrusionOk="0">
                    <a:moveTo>
                      <a:pt x="923567" y="903157"/>
                    </a:moveTo>
                    <a:lnTo>
                      <a:pt x="940085" y="0"/>
                    </a:lnTo>
                    <a:lnTo>
                      <a:pt x="952331" y="903252"/>
                    </a:lnTo>
                    <a:lnTo>
                      <a:pt x="1602596" y="276244"/>
                    </a:lnTo>
                    <a:lnTo>
                      <a:pt x="972551" y="923567"/>
                    </a:lnTo>
                    <a:lnTo>
                      <a:pt x="1875708" y="940085"/>
                    </a:lnTo>
                    <a:lnTo>
                      <a:pt x="972456" y="952331"/>
                    </a:lnTo>
                    <a:lnTo>
                      <a:pt x="1599464" y="1602596"/>
                    </a:lnTo>
                    <a:lnTo>
                      <a:pt x="952141" y="972551"/>
                    </a:lnTo>
                    <a:lnTo>
                      <a:pt x="935623" y="1875708"/>
                    </a:lnTo>
                    <a:lnTo>
                      <a:pt x="923472" y="972456"/>
                    </a:lnTo>
                    <a:lnTo>
                      <a:pt x="273112" y="1599464"/>
                    </a:lnTo>
                    <a:lnTo>
                      <a:pt x="903157" y="952141"/>
                    </a:lnTo>
                    <a:lnTo>
                      <a:pt x="0" y="935623"/>
                    </a:lnTo>
                    <a:lnTo>
                      <a:pt x="903252" y="923472"/>
                    </a:lnTo>
                    <a:lnTo>
                      <a:pt x="276244" y="273112"/>
                    </a:lnTo>
                    <a:lnTo>
                      <a:pt x="923567" y="903157"/>
                    </a:lnTo>
                    <a:close/>
                  </a:path>
                </a:pathLst>
              </a:custGeom>
              <a:gradFill>
                <a:gsLst>
                  <a:gs pos="0">
                    <a:srgbClr val="E569FF">
                      <a:alpha val="58823"/>
                    </a:srgbClr>
                  </a:gs>
                  <a:gs pos="100000">
                    <a:srgbClr val="E3E8FB">
                      <a:alpha val="0"/>
                    </a:srgbClr>
                  </a:gs>
                </a:gsLst>
                <a:path path="circle">
                  <a:fillToRect l="50000" t="50000" r="50000" b="50000"/>
                </a:path>
                <a:tileRect/>
              </a:gradFill>
              <a:ln>
                <a:noFill/>
              </a:ln>
            </p:spPr>
            <p:txBody>
              <a:bodyPr spcFirstLastPara="1" wrap="square" lIns="91425" tIns="45700" rIns="91425" bIns="45700" anchor="ctr" anchorCtr="0">
                <a:no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rgbClr val="000000"/>
                  </a:solidFill>
                  <a:latin typeface="Calibri"/>
                  <a:ea typeface="Calibri"/>
                  <a:cs typeface="Calibri"/>
                  <a:sym typeface="Calibri"/>
                </a:endParaRPr>
              </a:p>
            </p:txBody>
          </p:sp>
          <p:sp>
            <p:nvSpPr>
              <p:cNvPr id="30" name="Google Shape;30;p68"/>
              <p:cNvSpPr/>
              <p:nvPr/>
            </p:nvSpPr>
            <p:spPr>
              <a:xfrm>
                <a:off x="6046636" y="3379636"/>
                <a:ext cx="94929" cy="94929"/>
              </a:xfrm>
              <a:custGeom>
                <a:avLst/>
                <a:gdLst/>
                <a:ahLst/>
                <a:cxnLst/>
                <a:rect l="l" t="t" r="r" b="b"/>
                <a:pathLst>
                  <a:path w="94929" h="94929" extrusionOk="0">
                    <a:moveTo>
                      <a:pt x="94929" y="47465"/>
                    </a:moveTo>
                    <a:cubicBezTo>
                      <a:pt x="94929" y="73679"/>
                      <a:pt x="73679" y="94929"/>
                      <a:pt x="47465" y="94929"/>
                    </a:cubicBezTo>
                    <a:cubicBezTo>
                      <a:pt x="21251" y="94929"/>
                      <a:pt x="0" y="73679"/>
                      <a:pt x="0" y="47465"/>
                    </a:cubicBezTo>
                    <a:cubicBezTo>
                      <a:pt x="0" y="21251"/>
                      <a:pt x="21251" y="0"/>
                      <a:pt x="47465" y="0"/>
                    </a:cubicBezTo>
                    <a:cubicBezTo>
                      <a:pt x="73679" y="0"/>
                      <a:pt x="94929" y="21251"/>
                      <a:pt x="94929" y="47465"/>
                    </a:cubicBezTo>
                    <a:close/>
                  </a:path>
                </a:pathLst>
              </a:custGeom>
              <a:solidFill>
                <a:srgbClr val="E569FF"/>
              </a:solidFill>
              <a:ln>
                <a:noFill/>
              </a:ln>
            </p:spPr>
            <p:txBody>
              <a:bodyPr spcFirstLastPara="1" wrap="square" lIns="91425" tIns="45700" rIns="91425" bIns="45700" anchor="ctr" anchorCtr="0">
                <a:no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rgbClr val="000000"/>
                  </a:solidFill>
                  <a:latin typeface="Calibri"/>
                  <a:ea typeface="Calibri"/>
                  <a:cs typeface="Calibri"/>
                  <a:sym typeface="Calibri"/>
                </a:endParaRPr>
              </a:p>
            </p:txBody>
          </p:sp>
        </p:grpSp>
        <p:sp>
          <p:nvSpPr>
            <p:cNvPr id="31" name="Google Shape;31;p68"/>
            <p:cNvSpPr/>
            <p:nvPr/>
          </p:nvSpPr>
          <p:spPr>
            <a:xfrm>
              <a:off x="4911450" y="7543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2" name="Google Shape;32;p68"/>
            <p:cNvSpPr/>
            <p:nvPr/>
          </p:nvSpPr>
          <p:spPr>
            <a:xfrm>
              <a:off x="5368650" y="5257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3" name="Google Shape;33;p68"/>
            <p:cNvSpPr/>
            <p:nvPr/>
          </p:nvSpPr>
          <p:spPr>
            <a:xfrm>
              <a:off x="5521050" y="11353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4" name="Google Shape;34;p68"/>
            <p:cNvSpPr/>
            <p:nvPr/>
          </p:nvSpPr>
          <p:spPr>
            <a:xfrm>
              <a:off x="6130650" y="10591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5" name="Google Shape;35;p68"/>
            <p:cNvSpPr/>
            <p:nvPr/>
          </p:nvSpPr>
          <p:spPr>
            <a:xfrm>
              <a:off x="5825850" y="14401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6" name="Google Shape;36;p68"/>
            <p:cNvSpPr/>
            <p:nvPr/>
          </p:nvSpPr>
          <p:spPr>
            <a:xfrm>
              <a:off x="4682850" y="13639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7" name="Google Shape;37;p68"/>
            <p:cNvSpPr/>
            <p:nvPr/>
          </p:nvSpPr>
          <p:spPr>
            <a:xfrm>
              <a:off x="4835250" y="2209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8" name="Google Shape;38;p68"/>
            <p:cNvSpPr/>
            <p:nvPr/>
          </p:nvSpPr>
          <p:spPr>
            <a:xfrm>
              <a:off x="3844650" y="9067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9" name="Google Shape;39;p68"/>
            <p:cNvSpPr/>
            <p:nvPr/>
          </p:nvSpPr>
          <p:spPr>
            <a:xfrm>
              <a:off x="3692250" y="9829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40" name="Google Shape;40;p68"/>
            <p:cNvSpPr/>
            <p:nvPr/>
          </p:nvSpPr>
          <p:spPr>
            <a:xfrm>
              <a:off x="4378050" y="9829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41" name="Google Shape;41;p68"/>
            <p:cNvSpPr/>
            <p:nvPr/>
          </p:nvSpPr>
          <p:spPr>
            <a:xfrm>
              <a:off x="3235050" y="5257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42" name="Google Shape;42;p68"/>
            <p:cNvSpPr/>
            <p:nvPr/>
          </p:nvSpPr>
          <p:spPr>
            <a:xfrm>
              <a:off x="2701650" y="8305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43" name="Google Shape;43;p68"/>
            <p:cNvSpPr/>
            <p:nvPr/>
          </p:nvSpPr>
          <p:spPr>
            <a:xfrm>
              <a:off x="1939650" y="11353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44" name="Google Shape;44;p68"/>
            <p:cNvSpPr/>
            <p:nvPr/>
          </p:nvSpPr>
          <p:spPr>
            <a:xfrm>
              <a:off x="2244450" y="12877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45" name="Google Shape;45;p68"/>
            <p:cNvSpPr/>
            <p:nvPr/>
          </p:nvSpPr>
          <p:spPr>
            <a:xfrm>
              <a:off x="2168250" y="14401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46" name="Google Shape;46;p68"/>
            <p:cNvSpPr/>
            <p:nvPr/>
          </p:nvSpPr>
          <p:spPr>
            <a:xfrm>
              <a:off x="1177650" y="5257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47" name="Google Shape;47;p68"/>
            <p:cNvSpPr/>
            <p:nvPr/>
          </p:nvSpPr>
          <p:spPr>
            <a:xfrm>
              <a:off x="1482450" y="7543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48" name="Google Shape;48;p68"/>
            <p:cNvSpPr/>
            <p:nvPr/>
          </p:nvSpPr>
          <p:spPr>
            <a:xfrm>
              <a:off x="1025250" y="9829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49" name="Google Shape;49;p68"/>
            <p:cNvSpPr/>
            <p:nvPr/>
          </p:nvSpPr>
          <p:spPr>
            <a:xfrm>
              <a:off x="1101450" y="10591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50" name="Google Shape;50;p68"/>
            <p:cNvSpPr/>
            <p:nvPr/>
          </p:nvSpPr>
          <p:spPr>
            <a:xfrm>
              <a:off x="1253850" y="18211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51" name="Google Shape;51;p68"/>
            <p:cNvSpPr/>
            <p:nvPr/>
          </p:nvSpPr>
          <p:spPr>
            <a:xfrm>
              <a:off x="415650" y="15163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52" name="Google Shape;52;p68"/>
            <p:cNvSpPr/>
            <p:nvPr/>
          </p:nvSpPr>
          <p:spPr>
            <a:xfrm>
              <a:off x="4225650" y="16687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53" name="Google Shape;53;p68"/>
            <p:cNvSpPr/>
            <p:nvPr/>
          </p:nvSpPr>
          <p:spPr>
            <a:xfrm>
              <a:off x="5978250" y="15163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54" name="Google Shape;54;p68"/>
            <p:cNvSpPr/>
            <p:nvPr/>
          </p:nvSpPr>
          <p:spPr>
            <a:xfrm>
              <a:off x="6587850" y="15163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55" name="Google Shape;55;p68"/>
            <p:cNvSpPr/>
            <p:nvPr/>
          </p:nvSpPr>
          <p:spPr>
            <a:xfrm>
              <a:off x="6587850" y="7543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56" name="Google Shape;56;p68"/>
            <p:cNvSpPr/>
            <p:nvPr/>
          </p:nvSpPr>
          <p:spPr>
            <a:xfrm>
              <a:off x="5978250" y="2971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57" name="Google Shape;57;p68"/>
            <p:cNvSpPr/>
            <p:nvPr/>
          </p:nvSpPr>
          <p:spPr>
            <a:xfrm>
              <a:off x="5902050" y="3733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58" name="Google Shape;58;p68"/>
            <p:cNvSpPr/>
            <p:nvPr/>
          </p:nvSpPr>
          <p:spPr>
            <a:xfrm>
              <a:off x="7426050" y="5257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59" name="Google Shape;59;p68"/>
            <p:cNvSpPr/>
            <p:nvPr/>
          </p:nvSpPr>
          <p:spPr>
            <a:xfrm>
              <a:off x="7578450" y="685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60" name="Google Shape;60;p68"/>
            <p:cNvSpPr/>
            <p:nvPr/>
          </p:nvSpPr>
          <p:spPr>
            <a:xfrm>
              <a:off x="7730850" y="13639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61" name="Google Shape;61;p68"/>
            <p:cNvSpPr/>
            <p:nvPr/>
          </p:nvSpPr>
          <p:spPr>
            <a:xfrm>
              <a:off x="7045050" y="11353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62" name="Google Shape;62;p68"/>
            <p:cNvSpPr/>
            <p:nvPr/>
          </p:nvSpPr>
          <p:spPr>
            <a:xfrm>
              <a:off x="8264250" y="12877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63" name="Google Shape;63;p68"/>
            <p:cNvSpPr/>
            <p:nvPr/>
          </p:nvSpPr>
          <p:spPr>
            <a:xfrm>
              <a:off x="8416650" y="14401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64" name="Google Shape;64;p68"/>
            <p:cNvSpPr/>
            <p:nvPr/>
          </p:nvSpPr>
          <p:spPr>
            <a:xfrm>
              <a:off x="8569050" y="18211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65" name="Google Shape;65;p68"/>
            <p:cNvSpPr/>
            <p:nvPr/>
          </p:nvSpPr>
          <p:spPr>
            <a:xfrm>
              <a:off x="8873850" y="11353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66" name="Google Shape;66;p68"/>
            <p:cNvSpPr/>
            <p:nvPr/>
          </p:nvSpPr>
          <p:spPr>
            <a:xfrm>
              <a:off x="8645250" y="6781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67" name="Google Shape;67;p68"/>
            <p:cNvSpPr/>
            <p:nvPr/>
          </p:nvSpPr>
          <p:spPr>
            <a:xfrm>
              <a:off x="8416650" y="8305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68" name="Google Shape;68;p68"/>
            <p:cNvSpPr/>
            <p:nvPr/>
          </p:nvSpPr>
          <p:spPr>
            <a:xfrm>
              <a:off x="8111850" y="3733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69" name="Google Shape;69;p68"/>
            <p:cNvSpPr/>
            <p:nvPr/>
          </p:nvSpPr>
          <p:spPr>
            <a:xfrm>
              <a:off x="8188050" y="2209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70" name="Google Shape;70;p68"/>
            <p:cNvSpPr/>
            <p:nvPr/>
          </p:nvSpPr>
          <p:spPr>
            <a:xfrm>
              <a:off x="8721450" y="2971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71" name="Google Shape;71;p68"/>
            <p:cNvSpPr/>
            <p:nvPr/>
          </p:nvSpPr>
          <p:spPr>
            <a:xfrm>
              <a:off x="9102450" y="373325"/>
              <a:ext cx="18900" cy="18900"/>
            </a:xfrm>
            <a:prstGeom prst="ellipse">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72" name="Google Shape;72;p68"/>
            <p:cNvSpPr/>
            <p:nvPr/>
          </p:nvSpPr>
          <p:spPr>
            <a:xfrm>
              <a:off x="8035650" y="754325"/>
              <a:ext cx="18900" cy="18900"/>
            </a:xfrm>
            <a:prstGeom prst="ellipse">
              <a:avLst/>
            </a:prstGeom>
            <a:solidFill>
              <a:srgbClr val="FFFFFF">
                <a:alpha val="55294"/>
              </a:srgbClr>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73" name="Google Shape;73;p68"/>
            <p:cNvSpPr/>
            <p:nvPr/>
          </p:nvSpPr>
          <p:spPr>
            <a:xfrm>
              <a:off x="6968850" y="1059125"/>
              <a:ext cx="18900" cy="18900"/>
            </a:xfrm>
            <a:prstGeom prst="ellipse">
              <a:avLst/>
            </a:prstGeom>
            <a:solidFill>
              <a:srgbClr val="FFFFFF">
                <a:alpha val="29019"/>
              </a:srgbClr>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74" name="Google Shape;74;p68"/>
            <p:cNvSpPr/>
            <p:nvPr/>
          </p:nvSpPr>
          <p:spPr>
            <a:xfrm>
              <a:off x="6359250" y="1287725"/>
              <a:ext cx="18900" cy="18900"/>
            </a:xfrm>
            <a:prstGeom prst="ellipse">
              <a:avLst/>
            </a:prstGeom>
            <a:solidFill>
              <a:srgbClr val="FFFFFF">
                <a:alpha val="29019"/>
              </a:srgbClr>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75" name="Google Shape;75;p68"/>
            <p:cNvSpPr/>
            <p:nvPr/>
          </p:nvSpPr>
          <p:spPr>
            <a:xfrm>
              <a:off x="6359250" y="449525"/>
              <a:ext cx="18900" cy="18900"/>
            </a:xfrm>
            <a:prstGeom prst="ellipse">
              <a:avLst/>
            </a:prstGeom>
            <a:solidFill>
              <a:srgbClr val="FFFFFF">
                <a:alpha val="29019"/>
              </a:srgbClr>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76" name="Google Shape;76;p68"/>
            <p:cNvSpPr/>
            <p:nvPr/>
          </p:nvSpPr>
          <p:spPr>
            <a:xfrm>
              <a:off x="6054450" y="678125"/>
              <a:ext cx="18900" cy="18900"/>
            </a:xfrm>
            <a:prstGeom prst="ellipse">
              <a:avLst/>
            </a:prstGeom>
            <a:solidFill>
              <a:srgbClr val="FFFFFF">
                <a:alpha val="29019"/>
              </a:srgbClr>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77" name="Google Shape;77;p68"/>
            <p:cNvSpPr/>
            <p:nvPr/>
          </p:nvSpPr>
          <p:spPr>
            <a:xfrm>
              <a:off x="5292450" y="830525"/>
              <a:ext cx="18900" cy="18900"/>
            </a:xfrm>
            <a:prstGeom prst="ellipse">
              <a:avLst/>
            </a:prstGeom>
            <a:solidFill>
              <a:srgbClr val="FFFFFF">
                <a:alpha val="29019"/>
              </a:srgbClr>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78" name="Google Shape;78;p68"/>
            <p:cNvSpPr/>
            <p:nvPr/>
          </p:nvSpPr>
          <p:spPr>
            <a:xfrm>
              <a:off x="4835250" y="1287725"/>
              <a:ext cx="18900" cy="18900"/>
            </a:xfrm>
            <a:prstGeom prst="ellipse">
              <a:avLst/>
            </a:prstGeom>
            <a:solidFill>
              <a:srgbClr val="FFFFFF">
                <a:alpha val="29019"/>
              </a:srgbClr>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79" name="Google Shape;79;p68"/>
            <p:cNvSpPr/>
            <p:nvPr/>
          </p:nvSpPr>
          <p:spPr>
            <a:xfrm>
              <a:off x="4987650" y="449525"/>
              <a:ext cx="18900" cy="18900"/>
            </a:xfrm>
            <a:prstGeom prst="ellipse">
              <a:avLst/>
            </a:prstGeom>
            <a:solidFill>
              <a:srgbClr val="FFFFFF">
                <a:alpha val="29019"/>
              </a:srgbClr>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80" name="Google Shape;80;p68"/>
            <p:cNvSpPr/>
            <p:nvPr/>
          </p:nvSpPr>
          <p:spPr>
            <a:xfrm>
              <a:off x="4301850" y="601925"/>
              <a:ext cx="18900" cy="18900"/>
            </a:xfrm>
            <a:prstGeom prst="ellipse">
              <a:avLst/>
            </a:prstGeom>
            <a:solidFill>
              <a:srgbClr val="FFFFFF">
                <a:alpha val="29019"/>
              </a:srgbClr>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81" name="Google Shape;81;p68"/>
            <p:cNvSpPr/>
            <p:nvPr/>
          </p:nvSpPr>
          <p:spPr>
            <a:xfrm>
              <a:off x="4682850" y="144725"/>
              <a:ext cx="18900" cy="18900"/>
            </a:xfrm>
            <a:prstGeom prst="ellipse">
              <a:avLst/>
            </a:prstGeom>
            <a:solidFill>
              <a:srgbClr val="FFFFFF">
                <a:alpha val="29019"/>
              </a:srgbClr>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82" name="Google Shape;82;p68"/>
            <p:cNvSpPr/>
            <p:nvPr/>
          </p:nvSpPr>
          <p:spPr>
            <a:xfrm>
              <a:off x="2701650" y="297125"/>
              <a:ext cx="18900" cy="18900"/>
            </a:xfrm>
            <a:prstGeom prst="ellipse">
              <a:avLst/>
            </a:prstGeom>
            <a:solidFill>
              <a:srgbClr val="FFFFFF">
                <a:alpha val="29019"/>
              </a:srgbClr>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83" name="Google Shape;83;p68"/>
            <p:cNvSpPr/>
            <p:nvPr/>
          </p:nvSpPr>
          <p:spPr>
            <a:xfrm>
              <a:off x="2854050" y="906725"/>
              <a:ext cx="18900" cy="18900"/>
            </a:xfrm>
            <a:prstGeom prst="ellipse">
              <a:avLst/>
            </a:prstGeom>
            <a:solidFill>
              <a:srgbClr val="FFFFFF">
                <a:alpha val="29019"/>
              </a:srgbClr>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84" name="Google Shape;84;p68"/>
            <p:cNvSpPr/>
            <p:nvPr/>
          </p:nvSpPr>
          <p:spPr>
            <a:xfrm>
              <a:off x="3311250" y="1211525"/>
              <a:ext cx="18900" cy="18900"/>
            </a:xfrm>
            <a:prstGeom prst="ellipse">
              <a:avLst/>
            </a:prstGeom>
            <a:solidFill>
              <a:srgbClr val="FFFFFF">
                <a:alpha val="29019"/>
              </a:srgbClr>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85" name="Google Shape;85;p68"/>
            <p:cNvSpPr/>
            <p:nvPr/>
          </p:nvSpPr>
          <p:spPr>
            <a:xfrm>
              <a:off x="3387450" y="144725"/>
              <a:ext cx="18900" cy="18900"/>
            </a:xfrm>
            <a:prstGeom prst="ellipse">
              <a:avLst/>
            </a:prstGeom>
            <a:solidFill>
              <a:srgbClr val="FFFFFF">
                <a:alpha val="29019"/>
              </a:srgbClr>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86" name="Google Shape;86;p68"/>
            <p:cNvSpPr/>
            <p:nvPr/>
          </p:nvSpPr>
          <p:spPr>
            <a:xfrm>
              <a:off x="1863450" y="220925"/>
              <a:ext cx="18900" cy="18900"/>
            </a:xfrm>
            <a:prstGeom prst="ellipse">
              <a:avLst/>
            </a:prstGeom>
            <a:solidFill>
              <a:srgbClr val="FFFFFF">
                <a:alpha val="29019"/>
              </a:srgbClr>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87" name="Google Shape;87;p68"/>
            <p:cNvSpPr/>
            <p:nvPr/>
          </p:nvSpPr>
          <p:spPr>
            <a:xfrm>
              <a:off x="2092050" y="982925"/>
              <a:ext cx="18900" cy="18900"/>
            </a:xfrm>
            <a:prstGeom prst="ellipse">
              <a:avLst/>
            </a:prstGeom>
            <a:solidFill>
              <a:srgbClr val="FFFFFF">
                <a:alpha val="29019"/>
              </a:srgbClr>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88" name="Google Shape;88;p68"/>
            <p:cNvSpPr/>
            <p:nvPr/>
          </p:nvSpPr>
          <p:spPr>
            <a:xfrm>
              <a:off x="2549250" y="1744925"/>
              <a:ext cx="18900" cy="18900"/>
            </a:xfrm>
            <a:prstGeom prst="ellipse">
              <a:avLst/>
            </a:prstGeom>
            <a:solidFill>
              <a:srgbClr val="FFFFFF">
                <a:alpha val="29019"/>
              </a:srgbClr>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89" name="Google Shape;89;p68"/>
            <p:cNvSpPr/>
            <p:nvPr/>
          </p:nvSpPr>
          <p:spPr>
            <a:xfrm>
              <a:off x="1634850" y="1440125"/>
              <a:ext cx="18900" cy="18900"/>
            </a:xfrm>
            <a:prstGeom prst="ellipse">
              <a:avLst/>
            </a:prstGeom>
            <a:solidFill>
              <a:srgbClr val="FFFFFF">
                <a:alpha val="29019"/>
              </a:srgbClr>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90" name="Google Shape;90;p68"/>
            <p:cNvSpPr/>
            <p:nvPr/>
          </p:nvSpPr>
          <p:spPr>
            <a:xfrm>
              <a:off x="949050" y="1135325"/>
              <a:ext cx="18900" cy="18900"/>
            </a:xfrm>
            <a:prstGeom prst="ellipse">
              <a:avLst/>
            </a:prstGeom>
            <a:solidFill>
              <a:srgbClr val="FFFFFF">
                <a:alpha val="29019"/>
              </a:srgbClr>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91" name="Google Shape;91;p68"/>
            <p:cNvSpPr/>
            <p:nvPr/>
          </p:nvSpPr>
          <p:spPr>
            <a:xfrm>
              <a:off x="720450" y="601925"/>
              <a:ext cx="18900" cy="18900"/>
            </a:xfrm>
            <a:prstGeom prst="ellipse">
              <a:avLst/>
            </a:prstGeom>
            <a:solidFill>
              <a:srgbClr val="FFFFFF">
                <a:alpha val="29019"/>
              </a:srgbClr>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92" name="Google Shape;92;p68"/>
            <p:cNvSpPr/>
            <p:nvPr/>
          </p:nvSpPr>
          <p:spPr>
            <a:xfrm>
              <a:off x="491850" y="1287725"/>
              <a:ext cx="18900" cy="18900"/>
            </a:xfrm>
            <a:prstGeom prst="ellipse">
              <a:avLst/>
            </a:prstGeom>
            <a:solidFill>
              <a:srgbClr val="FFFFFF">
                <a:alpha val="29019"/>
              </a:srgbClr>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93" name="Google Shape;93;p68"/>
            <p:cNvSpPr/>
            <p:nvPr/>
          </p:nvSpPr>
          <p:spPr>
            <a:xfrm>
              <a:off x="796650" y="1592525"/>
              <a:ext cx="18900" cy="18900"/>
            </a:xfrm>
            <a:prstGeom prst="ellipse">
              <a:avLst/>
            </a:prstGeom>
            <a:solidFill>
              <a:srgbClr val="FFFFFF">
                <a:alpha val="29019"/>
              </a:srgbClr>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94" name="Google Shape;94;p68"/>
            <p:cNvSpPr/>
            <p:nvPr/>
          </p:nvSpPr>
          <p:spPr>
            <a:xfrm>
              <a:off x="110850" y="1592525"/>
              <a:ext cx="18900" cy="18900"/>
            </a:xfrm>
            <a:prstGeom prst="ellipse">
              <a:avLst/>
            </a:prstGeom>
            <a:solidFill>
              <a:srgbClr val="FFFFFF">
                <a:alpha val="29019"/>
              </a:srgbClr>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sp>
        <p:nvSpPr>
          <p:cNvPr id="95" name="Google Shape;95;p68"/>
          <p:cNvSpPr/>
          <p:nvPr/>
        </p:nvSpPr>
        <p:spPr>
          <a:xfrm>
            <a:off x="-25" y="3000500"/>
            <a:ext cx="9144047" cy="2139958"/>
          </a:xfrm>
          <a:custGeom>
            <a:avLst/>
            <a:gdLst/>
            <a:ahLst/>
            <a:cxnLst/>
            <a:rect l="l" t="t" r="r" b="b"/>
            <a:pathLst>
              <a:path w="12192063" h="2641923" extrusionOk="0">
                <a:moveTo>
                  <a:pt x="12192063" y="451106"/>
                </a:moveTo>
                <a:lnTo>
                  <a:pt x="12192063" y="441541"/>
                </a:lnTo>
                <a:cubicBezTo>
                  <a:pt x="11982259" y="421143"/>
                  <a:pt x="11772456" y="403152"/>
                  <a:pt x="11562715" y="387568"/>
                </a:cubicBezTo>
                <a:cubicBezTo>
                  <a:pt x="11768709" y="376419"/>
                  <a:pt x="11977433" y="370232"/>
                  <a:pt x="12188888" y="369007"/>
                </a:cubicBezTo>
                <a:lnTo>
                  <a:pt x="12188888" y="359505"/>
                </a:lnTo>
                <a:cubicBezTo>
                  <a:pt x="11952097" y="360815"/>
                  <a:pt x="11718671" y="368395"/>
                  <a:pt x="11488610" y="382247"/>
                </a:cubicBezTo>
                <a:cubicBezTo>
                  <a:pt x="10787126" y="331949"/>
                  <a:pt x="10087610" y="308426"/>
                  <a:pt x="9390062" y="311678"/>
                </a:cubicBezTo>
                <a:cubicBezTo>
                  <a:pt x="10252075" y="193091"/>
                  <a:pt x="11189398" y="152675"/>
                  <a:pt x="12188698" y="191317"/>
                </a:cubicBezTo>
                <a:lnTo>
                  <a:pt x="12189079" y="181815"/>
                </a:lnTo>
                <a:cubicBezTo>
                  <a:pt x="11161840" y="141716"/>
                  <a:pt x="10200005" y="185426"/>
                  <a:pt x="9318117" y="311741"/>
                </a:cubicBezTo>
                <a:cubicBezTo>
                  <a:pt x="8591868" y="317062"/>
                  <a:pt x="7870317" y="351460"/>
                  <a:pt x="7157212" y="415061"/>
                </a:cubicBezTo>
                <a:cubicBezTo>
                  <a:pt x="6968617" y="431954"/>
                  <a:pt x="6780594" y="450810"/>
                  <a:pt x="6593142" y="471631"/>
                </a:cubicBezTo>
                <a:cubicBezTo>
                  <a:pt x="7049707" y="331118"/>
                  <a:pt x="7514971" y="220531"/>
                  <a:pt x="7986014" y="140576"/>
                </a:cubicBezTo>
                <a:lnTo>
                  <a:pt x="7984363" y="131200"/>
                </a:lnTo>
                <a:cubicBezTo>
                  <a:pt x="7497001" y="213886"/>
                  <a:pt x="7015798" y="329444"/>
                  <a:pt x="6544057" y="477079"/>
                </a:cubicBezTo>
                <a:cubicBezTo>
                  <a:pt x="6349321" y="499208"/>
                  <a:pt x="6155074" y="523492"/>
                  <a:pt x="5961317" y="549929"/>
                </a:cubicBezTo>
                <a:cubicBezTo>
                  <a:pt x="5671376" y="508499"/>
                  <a:pt x="5379276" y="473405"/>
                  <a:pt x="5085017" y="444645"/>
                </a:cubicBezTo>
                <a:cubicBezTo>
                  <a:pt x="5051870" y="441414"/>
                  <a:pt x="5018596" y="438310"/>
                  <a:pt x="4985449" y="435333"/>
                </a:cubicBezTo>
                <a:cubicBezTo>
                  <a:pt x="5201984" y="366199"/>
                  <a:pt x="5422945" y="305554"/>
                  <a:pt x="5648325" y="253398"/>
                </a:cubicBezTo>
                <a:cubicBezTo>
                  <a:pt x="6088126" y="215389"/>
                  <a:pt x="6489573" y="203290"/>
                  <a:pt x="6848475" y="216720"/>
                </a:cubicBezTo>
                <a:lnTo>
                  <a:pt x="6848857" y="207217"/>
                </a:lnTo>
                <a:cubicBezTo>
                  <a:pt x="6508115" y="194548"/>
                  <a:pt x="6128957" y="204937"/>
                  <a:pt x="5715127" y="238258"/>
                </a:cubicBezTo>
                <a:cubicBezTo>
                  <a:pt x="5883701" y="200798"/>
                  <a:pt x="6054363" y="168259"/>
                  <a:pt x="6227128" y="140639"/>
                </a:cubicBezTo>
                <a:lnTo>
                  <a:pt x="6225604" y="131263"/>
                </a:lnTo>
                <a:cubicBezTo>
                  <a:pt x="6030233" y="162431"/>
                  <a:pt x="5837384" y="199996"/>
                  <a:pt x="5647055" y="243959"/>
                </a:cubicBezTo>
                <a:cubicBezTo>
                  <a:pt x="5329047" y="271368"/>
                  <a:pt x="4991481" y="311952"/>
                  <a:pt x="4634357" y="365713"/>
                </a:cubicBezTo>
                <a:cubicBezTo>
                  <a:pt x="4575093" y="374582"/>
                  <a:pt x="4515466" y="383852"/>
                  <a:pt x="4455478" y="393523"/>
                </a:cubicBezTo>
                <a:cubicBezTo>
                  <a:pt x="4140517" y="372703"/>
                  <a:pt x="3823481" y="359062"/>
                  <a:pt x="3504375" y="352600"/>
                </a:cubicBezTo>
                <a:cubicBezTo>
                  <a:pt x="3837305" y="244197"/>
                  <a:pt x="4176059" y="154461"/>
                  <a:pt x="4519041" y="83816"/>
                </a:cubicBezTo>
                <a:lnTo>
                  <a:pt x="4517136" y="74567"/>
                </a:lnTo>
                <a:cubicBezTo>
                  <a:pt x="4164851" y="147083"/>
                  <a:pt x="3817042" y="239745"/>
                  <a:pt x="3475419" y="352094"/>
                </a:cubicBezTo>
                <a:cubicBezTo>
                  <a:pt x="3181033" y="346519"/>
                  <a:pt x="2885142" y="347047"/>
                  <a:pt x="2587752" y="353677"/>
                </a:cubicBezTo>
                <a:cubicBezTo>
                  <a:pt x="2806256" y="318646"/>
                  <a:pt x="3033586" y="285072"/>
                  <a:pt x="3267773" y="254918"/>
                </a:cubicBezTo>
                <a:lnTo>
                  <a:pt x="3266504" y="245543"/>
                </a:lnTo>
                <a:cubicBezTo>
                  <a:pt x="3007487" y="279117"/>
                  <a:pt x="2756789" y="316365"/>
                  <a:pt x="2517204" y="355451"/>
                </a:cubicBezTo>
                <a:cubicBezTo>
                  <a:pt x="2220405" y="363053"/>
                  <a:pt x="1922399" y="376693"/>
                  <a:pt x="1623187" y="396374"/>
                </a:cubicBezTo>
                <a:cubicBezTo>
                  <a:pt x="1883759" y="305486"/>
                  <a:pt x="2148891" y="228161"/>
                  <a:pt x="2417509" y="164711"/>
                </a:cubicBezTo>
                <a:cubicBezTo>
                  <a:pt x="2903665" y="51255"/>
                  <a:pt x="3361436" y="-436"/>
                  <a:pt x="3778314" y="11093"/>
                </a:cubicBezTo>
                <a:lnTo>
                  <a:pt x="3778314" y="1591"/>
                </a:lnTo>
                <a:cubicBezTo>
                  <a:pt x="3360928" y="-10002"/>
                  <a:pt x="2902014" y="41816"/>
                  <a:pt x="2415350" y="155526"/>
                </a:cubicBezTo>
                <a:cubicBezTo>
                  <a:pt x="2135054" y="221849"/>
                  <a:pt x="1858537" y="303157"/>
                  <a:pt x="1586992" y="399098"/>
                </a:cubicBezTo>
                <a:cubicBezTo>
                  <a:pt x="1060704" y="434488"/>
                  <a:pt x="531728" y="488714"/>
                  <a:pt x="64" y="561775"/>
                </a:cubicBezTo>
                <a:lnTo>
                  <a:pt x="64" y="571340"/>
                </a:lnTo>
                <a:cubicBezTo>
                  <a:pt x="520086" y="499757"/>
                  <a:pt x="1037927" y="446207"/>
                  <a:pt x="1553591" y="410690"/>
                </a:cubicBezTo>
                <a:cubicBezTo>
                  <a:pt x="1498810" y="430159"/>
                  <a:pt x="1443780" y="450262"/>
                  <a:pt x="1388491" y="470997"/>
                </a:cubicBezTo>
                <a:cubicBezTo>
                  <a:pt x="928922" y="501658"/>
                  <a:pt x="466111" y="546698"/>
                  <a:pt x="64" y="606118"/>
                </a:cubicBezTo>
                <a:lnTo>
                  <a:pt x="64" y="615684"/>
                </a:lnTo>
                <a:cubicBezTo>
                  <a:pt x="455316" y="557615"/>
                  <a:pt x="907796" y="513271"/>
                  <a:pt x="1357503" y="482653"/>
                </a:cubicBezTo>
                <a:cubicBezTo>
                  <a:pt x="1305687" y="502375"/>
                  <a:pt x="1253725" y="522647"/>
                  <a:pt x="1201611" y="543467"/>
                </a:cubicBezTo>
                <a:lnTo>
                  <a:pt x="1184783" y="550245"/>
                </a:lnTo>
                <a:cubicBezTo>
                  <a:pt x="794004" y="572206"/>
                  <a:pt x="399098" y="603542"/>
                  <a:pt x="64" y="644253"/>
                </a:cubicBezTo>
                <a:lnTo>
                  <a:pt x="64" y="653755"/>
                </a:lnTo>
                <a:cubicBezTo>
                  <a:pt x="389530" y="613889"/>
                  <a:pt x="775316" y="583102"/>
                  <a:pt x="1157415" y="561395"/>
                </a:cubicBezTo>
                <a:cubicBezTo>
                  <a:pt x="1093534" y="587325"/>
                  <a:pt x="1031602" y="613213"/>
                  <a:pt x="971614" y="639059"/>
                </a:cubicBezTo>
                <a:cubicBezTo>
                  <a:pt x="651701" y="648308"/>
                  <a:pt x="327851" y="662751"/>
                  <a:pt x="64" y="682389"/>
                </a:cubicBezTo>
                <a:lnTo>
                  <a:pt x="64" y="691891"/>
                </a:lnTo>
                <a:cubicBezTo>
                  <a:pt x="319723" y="672677"/>
                  <a:pt x="635718" y="658443"/>
                  <a:pt x="948055" y="649194"/>
                </a:cubicBezTo>
                <a:cubicBezTo>
                  <a:pt x="924433" y="659457"/>
                  <a:pt x="901148" y="669656"/>
                  <a:pt x="878205" y="679791"/>
                </a:cubicBezTo>
                <a:cubicBezTo>
                  <a:pt x="336614" y="805980"/>
                  <a:pt x="8636" y="902522"/>
                  <a:pt x="1905" y="904486"/>
                </a:cubicBezTo>
                <a:lnTo>
                  <a:pt x="4572" y="913608"/>
                </a:lnTo>
                <a:cubicBezTo>
                  <a:pt x="10922" y="911644"/>
                  <a:pt x="319723" y="820930"/>
                  <a:pt x="831787" y="700379"/>
                </a:cubicBezTo>
                <a:cubicBezTo>
                  <a:pt x="599631" y="804523"/>
                  <a:pt x="405067" y="901888"/>
                  <a:pt x="262446" y="977019"/>
                </a:cubicBezTo>
                <a:cubicBezTo>
                  <a:pt x="175154" y="972667"/>
                  <a:pt x="87694" y="968891"/>
                  <a:pt x="64" y="965680"/>
                </a:cubicBezTo>
                <a:lnTo>
                  <a:pt x="64" y="975182"/>
                </a:lnTo>
                <a:cubicBezTo>
                  <a:pt x="82190" y="978305"/>
                  <a:pt x="164168" y="981814"/>
                  <a:pt x="245999" y="985698"/>
                </a:cubicBezTo>
                <a:cubicBezTo>
                  <a:pt x="197612" y="1011353"/>
                  <a:pt x="155639" y="1034159"/>
                  <a:pt x="120650" y="1053480"/>
                </a:cubicBezTo>
                <a:cubicBezTo>
                  <a:pt x="80518" y="1051244"/>
                  <a:pt x="40301" y="1049128"/>
                  <a:pt x="0" y="1047145"/>
                </a:cubicBezTo>
                <a:lnTo>
                  <a:pt x="0" y="1056647"/>
                </a:lnTo>
                <a:cubicBezTo>
                  <a:pt x="35052" y="1058376"/>
                  <a:pt x="70041" y="1060195"/>
                  <a:pt x="104966" y="1062095"/>
                </a:cubicBezTo>
                <a:cubicBezTo>
                  <a:pt x="45593" y="1095099"/>
                  <a:pt x="9716" y="1116447"/>
                  <a:pt x="0" y="1122022"/>
                </a:cubicBezTo>
                <a:lnTo>
                  <a:pt x="0" y="1127596"/>
                </a:lnTo>
                <a:lnTo>
                  <a:pt x="2477" y="1131651"/>
                </a:lnTo>
                <a:cubicBezTo>
                  <a:pt x="3874" y="1130827"/>
                  <a:pt x="46228" y="1105488"/>
                  <a:pt x="123126" y="1063109"/>
                </a:cubicBezTo>
                <a:cubicBezTo>
                  <a:pt x="467254" y="1082195"/>
                  <a:pt x="808038" y="1109859"/>
                  <a:pt x="1145477" y="1146094"/>
                </a:cubicBezTo>
                <a:cubicBezTo>
                  <a:pt x="1051370" y="1172827"/>
                  <a:pt x="961943" y="1198609"/>
                  <a:pt x="877189" y="1223442"/>
                </a:cubicBezTo>
                <a:cubicBezTo>
                  <a:pt x="588772" y="1193035"/>
                  <a:pt x="296397" y="1168753"/>
                  <a:pt x="64" y="1150592"/>
                </a:cubicBezTo>
                <a:lnTo>
                  <a:pt x="64" y="1159967"/>
                </a:lnTo>
                <a:cubicBezTo>
                  <a:pt x="287930" y="1177749"/>
                  <a:pt x="572114" y="1201270"/>
                  <a:pt x="852614" y="1230537"/>
                </a:cubicBezTo>
                <a:cubicBezTo>
                  <a:pt x="711264" y="1272029"/>
                  <a:pt x="584264" y="1310291"/>
                  <a:pt x="474155" y="1343992"/>
                </a:cubicBezTo>
                <a:cubicBezTo>
                  <a:pt x="429916" y="1339431"/>
                  <a:pt x="385466" y="1334997"/>
                  <a:pt x="340805" y="1330689"/>
                </a:cubicBezTo>
                <a:cubicBezTo>
                  <a:pt x="227944" y="1294879"/>
                  <a:pt x="114364" y="1260183"/>
                  <a:pt x="64" y="1226609"/>
                </a:cubicBezTo>
                <a:lnTo>
                  <a:pt x="64" y="1236428"/>
                </a:lnTo>
                <a:cubicBezTo>
                  <a:pt x="98997" y="1265612"/>
                  <a:pt x="197464" y="1295550"/>
                  <a:pt x="295466" y="1326255"/>
                </a:cubicBezTo>
                <a:cubicBezTo>
                  <a:pt x="197591" y="1316924"/>
                  <a:pt x="99124" y="1308264"/>
                  <a:pt x="64" y="1300282"/>
                </a:cubicBezTo>
                <a:lnTo>
                  <a:pt x="64" y="1309721"/>
                </a:lnTo>
                <a:cubicBezTo>
                  <a:pt x="113856" y="1319014"/>
                  <a:pt x="226865" y="1329106"/>
                  <a:pt x="339090" y="1340001"/>
                </a:cubicBezTo>
                <a:cubicBezTo>
                  <a:pt x="363347" y="1347730"/>
                  <a:pt x="387541" y="1355395"/>
                  <a:pt x="411734" y="1363187"/>
                </a:cubicBezTo>
                <a:cubicBezTo>
                  <a:pt x="308356" y="1394861"/>
                  <a:pt x="222441" y="1422227"/>
                  <a:pt x="156401" y="1443385"/>
                </a:cubicBezTo>
                <a:cubicBezTo>
                  <a:pt x="104458" y="1425901"/>
                  <a:pt x="52345" y="1408689"/>
                  <a:pt x="64" y="1391756"/>
                </a:cubicBezTo>
                <a:lnTo>
                  <a:pt x="64" y="1401765"/>
                </a:lnTo>
                <a:cubicBezTo>
                  <a:pt x="47181" y="1417096"/>
                  <a:pt x="94191" y="1432597"/>
                  <a:pt x="141097" y="1448263"/>
                </a:cubicBezTo>
                <a:cubicBezTo>
                  <a:pt x="52642" y="1476642"/>
                  <a:pt x="3937" y="1492606"/>
                  <a:pt x="1714" y="1493683"/>
                </a:cubicBezTo>
                <a:lnTo>
                  <a:pt x="4763" y="1502678"/>
                </a:lnTo>
                <a:cubicBezTo>
                  <a:pt x="7049" y="1501918"/>
                  <a:pt x="60198" y="1484181"/>
                  <a:pt x="156337" y="1453394"/>
                </a:cubicBezTo>
                <a:cubicBezTo>
                  <a:pt x="233002" y="1479157"/>
                  <a:pt x="309202" y="1505466"/>
                  <a:pt x="384937" y="1532325"/>
                </a:cubicBezTo>
                <a:cubicBezTo>
                  <a:pt x="574421" y="1599303"/>
                  <a:pt x="754634" y="1666876"/>
                  <a:pt x="925576" y="1735038"/>
                </a:cubicBezTo>
                <a:cubicBezTo>
                  <a:pt x="871601" y="1779888"/>
                  <a:pt x="820312" y="1823896"/>
                  <a:pt x="771716" y="1867055"/>
                </a:cubicBezTo>
                <a:cubicBezTo>
                  <a:pt x="566230" y="1779508"/>
                  <a:pt x="342964" y="1690758"/>
                  <a:pt x="102362" y="1603338"/>
                </a:cubicBezTo>
                <a:cubicBezTo>
                  <a:pt x="68390" y="1590985"/>
                  <a:pt x="34227" y="1578886"/>
                  <a:pt x="64" y="1566723"/>
                </a:cubicBezTo>
                <a:lnTo>
                  <a:pt x="64" y="1576859"/>
                </a:lnTo>
                <a:cubicBezTo>
                  <a:pt x="32957" y="1588514"/>
                  <a:pt x="65850" y="1600171"/>
                  <a:pt x="98489" y="1612017"/>
                </a:cubicBezTo>
                <a:cubicBezTo>
                  <a:pt x="337693" y="1698930"/>
                  <a:pt x="559499" y="1787046"/>
                  <a:pt x="763842" y="1874086"/>
                </a:cubicBezTo>
                <a:lnTo>
                  <a:pt x="751777" y="1884792"/>
                </a:lnTo>
                <a:cubicBezTo>
                  <a:pt x="659702" y="1922123"/>
                  <a:pt x="575670" y="1957116"/>
                  <a:pt x="499682" y="1989759"/>
                </a:cubicBezTo>
                <a:cubicBezTo>
                  <a:pt x="345504" y="1923307"/>
                  <a:pt x="178943" y="1855652"/>
                  <a:pt x="64" y="1787996"/>
                </a:cubicBezTo>
                <a:lnTo>
                  <a:pt x="64" y="1798132"/>
                </a:lnTo>
                <a:cubicBezTo>
                  <a:pt x="174371" y="1864077"/>
                  <a:pt x="336614" y="1930085"/>
                  <a:pt x="487617" y="1994954"/>
                </a:cubicBezTo>
                <a:cubicBezTo>
                  <a:pt x="198374" y="2119115"/>
                  <a:pt x="31306" y="2203621"/>
                  <a:pt x="64" y="2219711"/>
                </a:cubicBezTo>
                <a:lnTo>
                  <a:pt x="64" y="2230417"/>
                </a:lnTo>
                <a:cubicBezTo>
                  <a:pt x="14034" y="2223132"/>
                  <a:pt x="186182" y="2134445"/>
                  <a:pt x="499618" y="2000085"/>
                </a:cubicBezTo>
                <a:cubicBezTo>
                  <a:pt x="528998" y="2012754"/>
                  <a:pt x="557932" y="2025424"/>
                  <a:pt x="586423" y="2038093"/>
                </a:cubicBezTo>
                <a:cubicBezTo>
                  <a:pt x="227203" y="2383465"/>
                  <a:pt x="58738" y="2632485"/>
                  <a:pt x="56452" y="2635906"/>
                </a:cubicBezTo>
                <a:lnTo>
                  <a:pt x="64326" y="2641227"/>
                </a:lnTo>
                <a:cubicBezTo>
                  <a:pt x="65151" y="2640023"/>
                  <a:pt x="145606" y="2520359"/>
                  <a:pt x="312420" y="2334181"/>
                </a:cubicBezTo>
                <a:cubicBezTo>
                  <a:pt x="383794" y="2254616"/>
                  <a:pt x="478219" y="2154907"/>
                  <a:pt x="595694" y="2042211"/>
                </a:cubicBezTo>
                <a:cubicBezTo>
                  <a:pt x="876999" y="2166816"/>
                  <a:pt x="1114362" y="2286226"/>
                  <a:pt x="1308608" y="2392207"/>
                </a:cubicBezTo>
                <a:cubicBezTo>
                  <a:pt x="1021461" y="2538350"/>
                  <a:pt x="872553" y="2633372"/>
                  <a:pt x="870458" y="2634576"/>
                </a:cubicBezTo>
                <a:lnTo>
                  <a:pt x="875094" y="2641734"/>
                </a:lnTo>
                <a:lnTo>
                  <a:pt x="876935" y="2641734"/>
                </a:lnTo>
                <a:cubicBezTo>
                  <a:pt x="891731" y="2632358"/>
                  <a:pt x="1041464" y="2538477"/>
                  <a:pt x="1318578" y="2397718"/>
                </a:cubicBezTo>
                <a:cubicBezTo>
                  <a:pt x="1428433" y="2457899"/>
                  <a:pt x="1524064" y="2513328"/>
                  <a:pt x="1606233" y="2563056"/>
                </a:cubicBezTo>
                <a:cubicBezTo>
                  <a:pt x="1627949" y="2576232"/>
                  <a:pt x="1648905" y="2589092"/>
                  <a:pt x="1669288" y="2601761"/>
                </a:cubicBezTo>
                <a:cubicBezTo>
                  <a:pt x="1652968" y="2623109"/>
                  <a:pt x="1644523" y="2634956"/>
                  <a:pt x="1643888" y="2635716"/>
                </a:cubicBezTo>
                <a:lnTo>
                  <a:pt x="1651635" y="2641164"/>
                </a:lnTo>
                <a:cubicBezTo>
                  <a:pt x="1651953" y="2640784"/>
                  <a:pt x="1660462" y="2628494"/>
                  <a:pt x="1677035" y="2606829"/>
                </a:cubicBezTo>
                <a:cubicBezTo>
                  <a:pt x="1696041" y="2618694"/>
                  <a:pt x="1714417" y="2630287"/>
                  <a:pt x="1732153" y="2641607"/>
                </a:cubicBezTo>
                <a:lnTo>
                  <a:pt x="1749806" y="2641607"/>
                </a:lnTo>
                <a:cubicBezTo>
                  <a:pt x="1728280" y="2627797"/>
                  <a:pt x="1706055" y="2613734"/>
                  <a:pt x="1682877" y="2599227"/>
                </a:cubicBezTo>
                <a:cubicBezTo>
                  <a:pt x="1714056" y="2558685"/>
                  <a:pt x="1768729" y="2490460"/>
                  <a:pt x="1847024" y="2402279"/>
                </a:cubicBezTo>
                <a:cubicBezTo>
                  <a:pt x="1929530" y="2448441"/>
                  <a:pt x="2004358" y="2491707"/>
                  <a:pt x="2071497" y="2532079"/>
                </a:cubicBezTo>
                <a:cubicBezTo>
                  <a:pt x="2135632" y="2570385"/>
                  <a:pt x="2194897" y="2606892"/>
                  <a:pt x="2249297" y="2641607"/>
                </a:cubicBezTo>
                <a:lnTo>
                  <a:pt x="2267014" y="2641607"/>
                </a:lnTo>
                <a:cubicBezTo>
                  <a:pt x="2209102" y="2604739"/>
                  <a:pt x="2145602" y="2565590"/>
                  <a:pt x="2076514" y="2524160"/>
                </a:cubicBezTo>
                <a:cubicBezTo>
                  <a:pt x="2009712" y="2484188"/>
                  <a:pt x="1935226" y="2440922"/>
                  <a:pt x="1853184" y="2395058"/>
                </a:cubicBezTo>
                <a:cubicBezTo>
                  <a:pt x="1873841" y="2371873"/>
                  <a:pt x="1896091" y="2347420"/>
                  <a:pt x="1919923" y="2321701"/>
                </a:cubicBezTo>
                <a:cubicBezTo>
                  <a:pt x="1948688" y="2290787"/>
                  <a:pt x="1980946" y="2256896"/>
                  <a:pt x="2016506" y="2220345"/>
                </a:cubicBezTo>
                <a:cubicBezTo>
                  <a:pt x="2233676" y="2328543"/>
                  <a:pt x="2418906" y="2428442"/>
                  <a:pt x="2570353" y="2514278"/>
                </a:cubicBezTo>
                <a:cubicBezTo>
                  <a:pt x="2589530" y="2525174"/>
                  <a:pt x="2608371" y="2535943"/>
                  <a:pt x="2626868" y="2546586"/>
                </a:cubicBezTo>
                <a:cubicBezTo>
                  <a:pt x="2520569" y="2601191"/>
                  <a:pt x="2465197" y="2633435"/>
                  <a:pt x="2464054" y="2634069"/>
                </a:cubicBezTo>
                <a:lnTo>
                  <a:pt x="2468309" y="2641354"/>
                </a:lnTo>
                <a:lnTo>
                  <a:pt x="2470468" y="2641354"/>
                </a:lnTo>
                <a:cubicBezTo>
                  <a:pt x="2480056" y="2635842"/>
                  <a:pt x="2536190" y="2603725"/>
                  <a:pt x="2636647" y="2552224"/>
                </a:cubicBezTo>
                <a:cubicBezTo>
                  <a:pt x="2690794" y="2583308"/>
                  <a:pt x="2741467" y="2613101"/>
                  <a:pt x="2788666" y="2641607"/>
                </a:cubicBezTo>
                <a:lnTo>
                  <a:pt x="2807081" y="2641607"/>
                </a:lnTo>
                <a:cubicBezTo>
                  <a:pt x="2757380" y="2611580"/>
                  <a:pt x="2704129" y="2580160"/>
                  <a:pt x="2647315" y="2547346"/>
                </a:cubicBezTo>
                <a:cubicBezTo>
                  <a:pt x="2720086" y="2510161"/>
                  <a:pt x="2814701" y="2463537"/>
                  <a:pt x="2930398" y="2410008"/>
                </a:cubicBezTo>
                <a:cubicBezTo>
                  <a:pt x="2991993" y="2442486"/>
                  <a:pt x="3049778" y="2473546"/>
                  <a:pt x="3103753" y="2503192"/>
                </a:cubicBezTo>
                <a:cubicBezTo>
                  <a:pt x="3132709" y="2519112"/>
                  <a:pt x="3160903" y="2534721"/>
                  <a:pt x="3188335" y="2550006"/>
                </a:cubicBezTo>
                <a:cubicBezTo>
                  <a:pt x="3145346" y="2603915"/>
                  <a:pt x="3124264" y="2634576"/>
                  <a:pt x="3123502" y="2635779"/>
                </a:cubicBezTo>
                <a:lnTo>
                  <a:pt x="3131376" y="2641100"/>
                </a:lnTo>
                <a:cubicBezTo>
                  <a:pt x="3131820" y="2640467"/>
                  <a:pt x="3153029" y="2609427"/>
                  <a:pt x="3196590" y="2554631"/>
                </a:cubicBezTo>
                <a:cubicBezTo>
                  <a:pt x="3250394" y="2584784"/>
                  <a:pt x="3301194" y="2613778"/>
                  <a:pt x="3348990" y="2641607"/>
                </a:cubicBezTo>
                <a:lnTo>
                  <a:pt x="3368040" y="2641607"/>
                </a:lnTo>
                <a:cubicBezTo>
                  <a:pt x="3316478" y="2611536"/>
                  <a:pt x="3261443" y="2580033"/>
                  <a:pt x="3202940" y="2547092"/>
                </a:cubicBezTo>
                <a:cubicBezTo>
                  <a:pt x="3244850" y="2494894"/>
                  <a:pt x="3305747" y="2422994"/>
                  <a:pt x="3387090" y="2336778"/>
                </a:cubicBezTo>
                <a:cubicBezTo>
                  <a:pt x="3442907" y="2277484"/>
                  <a:pt x="3512693" y="2206915"/>
                  <a:pt x="3596640" y="2128174"/>
                </a:cubicBezTo>
                <a:cubicBezTo>
                  <a:pt x="3686810" y="2093161"/>
                  <a:pt x="3783184" y="2056971"/>
                  <a:pt x="3885756" y="2019596"/>
                </a:cubicBezTo>
                <a:cubicBezTo>
                  <a:pt x="4023887" y="2061830"/>
                  <a:pt x="4159714" y="2105812"/>
                  <a:pt x="4293235" y="2151549"/>
                </a:cubicBezTo>
                <a:cubicBezTo>
                  <a:pt x="4470610" y="2212192"/>
                  <a:pt x="4636815" y="2273006"/>
                  <a:pt x="4791837" y="2333991"/>
                </a:cubicBezTo>
                <a:cubicBezTo>
                  <a:pt x="4778502" y="2348624"/>
                  <a:pt x="4765866" y="2362814"/>
                  <a:pt x="4753737" y="2376560"/>
                </a:cubicBezTo>
                <a:lnTo>
                  <a:pt x="4745673" y="2379728"/>
                </a:lnTo>
                <a:cubicBezTo>
                  <a:pt x="4369372" y="2528278"/>
                  <a:pt x="4162870" y="2633119"/>
                  <a:pt x="4160838" y="2634195"/>
                </a:cubicBezTo>
                <a:lnTo>
                  <a:pt x="4164648" y="2641607"/>
                </a:lnTo>
                <a:lnTo>
                  <a:pt x="4167251" y="2641607"/>
                </a:lnTo>
                <a:cubicBezTo>
                  <a:pt x="4189095" y="2630648"/>
                  <a:pt x="4389501" y="2530875"/>
                  <a:pt x="4740085" y="2392207"/>
                </a:cubicBezTo>
                <a:cubicBezTo>
                  <a:pt x="4610164" y="2540947"/>
                  <a:pt x="4553014" y="2634766"/>
                  <a:pt x="4552125" y="2635969"/>
                </a:cubicBezTo>
                <a:lnTo>
                  <a:pt x="4560253" y="2640910"/>
                </a:lnTo>
                <a:cubicBezTo>
                  <a:pt x="4561015" y="2639643"/>
                  <a:pt x="4621657" y="2540631"/>
                  <a:pt x="4758817" y="2384542"/>
                </a:cubicBezTo>
                <a:cubicBezTo>
                  <a:pt x="4784598" y="2374406"/>
                  <a:pt x="4811567" y="2363846"/>
                  <a:pt x="4839716" y="2352868"/>
                </a:cubicBezTo>
                <a:cubicBezTo>
                  <a:pt x="5090097" y="2452197"/>
                  <a:pt x="5310632" y="2549816"/>
                  <a:pt x="5502021" y="2641417"/>
                </a:cubicBezTo>
                <a:lnTo>
                  <a:pt x="5523992" y="2641417"/>
                </a:lnTo>
                <a:cubicBezTo>
                  <a:pt x="5330762" y="2548423"/>
                  <a:pt x="5107242" y="2449030"/>
                  <a:pt x="4852797" y="2347864"/>
                </a:cubicBezTo>
                <a:cubicBezTo>
                  <a:pt x="4939729" y="2314543"/>
                  <a:pt x="5037519" y="2278181"/>
                  <a:pt x="5145278" y="2240173"/>
                </a:cubicBezTo>
                <a:cubicBezTo>
                  <a:pt x="5467604" y="2368008"/>
                  <a:pt x="5748528" y="2494640"/>
                  <a:pt x="5987796" y="2611644"/>
                </a:cubicBezTo>
                <a:cubicBezTo>
                  <a:pt x="5975096" y="2626910"/>
                  <a:pt x="5968746" y="2635272"/>
                  <a:pt x="5968429" y="2635652"/>
                </a:cubicBezTo>
                <a:lnTo>
                  <a:pt x="5976049" y="2641354"/>
                </a:lnTo>
                <a:cubicBezTo>
                  <a:pt x="5976049" y="2641037"/>
                  <a:pt x="5983097" y="2632168"/>
                  <a:pt x="5996559" y="2616015"/>
                </a:cubicBezTo>
                <a:lnTo>
                  <a:pt x="6033707" y="2634322"/>
                </a:lnTo>
                <a:lnTo>
                  <a:pt x="6037263" y="2641734"/>
                </a:lnTo>
                <a:lnTo>
                  <a:pt x="6040184" y="2641734"/>
                </a:lnTo>
                <a:lnTo>
                  <a:pt x="6044565" y="2639707"/>
                </a:lnTo>
                <a:lnTo>
                  <a:pt x="6048629" y="2641734"/>
                </a:lnTo>
                <a:lnTo>
                  <a:pt x="6069902" y="2641734"/>
                </a:lnTo>
                <a:lnTo>
                  <a:pt x="6055614" y="2634576"/>
                </a:lnTo>
                <a:cubicBezTo>
                  <a:pt x="6117400" y="2606259"/>
                  <a:pt x="6209411" y="2567807"/>
                  <a:pt x="6328093" y="2522767"/>
                </a:cubicBezTo>
                <a:cubicBezTo>
                  <a:pt x="6416612" y="2563480"/>
                  <a:pt x="6500495" y="2603136"/>
                  <a:pt x="6579807" y="2641734"/>
                </a:cubicBezTo>
                <a:lnTo>
                  <a:pt x="6601524" y="2641734"/>
                </a:lnTo>
                <a:cubicBezTo>
                  <a:pt x="6519482" y="2601742"/>
                  <a:pt x="6432487" y="2560522"/>
                  <a:pt x="6340539" y="2518079"/>
                </a:cubicBezTo>
                <a:cubicBezTo>
                  <a:pt x="6426391" y="2485708"/>
                  <a:pt x="6525705" y="2450107"/>
                  <a:pt x="6637211" y="2412542"/>
                </a:cubicBezTo>
                <a:cubicBezTo>
                  <a:pt x="6821805" y="2492170"/>
                  <a:pt x="6990398" y="2569201"/>
                  <a:pt x="7142353" y="2641734"/>
                </a:cubicBezTo>
                <a:lnTo>
                  <a:pt x="7164388" y="2641734"/>
                </a:lnTo>
                <a:cubicBezTo>
                  <a:pt x="7010337" y="2567934"/>
                  <a:pt x="6838887" y="2489319"/>
                  <a:pt x="6650673" y="2407981"/>
                </a:cubicBezTo>
                <a:cubicBezTo>
                  <a:pt x="6927342" y="2315240"/>
                  <a:pt x="7277545" y="2210843"/>
                  <a:pt x="7682611" y="2114174"/>
                </a:cubicBezTo>
                <a:cubicBezTo>
                  <a:pt x="7880732" y="2066834"/>
                  <a:pt x="8082280" y="2023441"/>
                  <a:pt x="8287321" y="1983994"/>
                </a:cubicBezTo>
                <a:cubicBezTo>
                  <a:pt x="7784592" y="2341592"/>
                  <a:pt x="7471855" y="2630965"/>
                  <a:pt x="7467664" y="2635272"/>
                </a:cubicBezTo>
                <a:lnTo>
                  <a:pt x="7474014" y="2641924"/>
                </a:lnTo>
                <a:lnTo>
                  <a:pt x="7474585" y="2641924"/>
                </a:lnTo>
                <a:cubicBezTo>
                  <a:pt x="7486206" y="2631155"/>
                  <a:pt x="7803960" y="2338488"/>
                  <a:pt x="8309991" y="1979940"/>
                </a:cubicBezTo>
                <a:cubicBezTo>
                  <a:pt x="8517636" y="1940284"/>
                  <a:pt x="8728202" y="1904702"/>
                  <a:pt x="8941753" y="1873199"/>
                </a:cubicBezTo>
                <a:cubicBezTo>
                  <a:pt x="9204706" y="1987732"/>
                  <a:pt x="9423336" y="2096056"/>
                  <a:pt x="9598216" y="2189938"/>
                </a:cubicBezTo>
                <a:cubicBezTo>
                  <a:pt x="9326880" y="2387139"/>
                  <a:pt x="9130220" y="2557355"/>
                  <a:pt x="9048877" y="2635462"/>
                </a:cubicBezTo>
                <a:lnTo>
                  <a:pt x="9055227" y="2641797"/>
                </a:lnTo>
                <a:lnTo>
                  <a:pt x="9055735" y="2641797"/>
                </a:lnTo>
                <a:cubicBezTo>
                  <a:pt x="9137523" y="2563119"/>
                  <a:pt x="9335135" y="2392461"/>
                  <a:pt x="9607550" y="2194689"/>
                </a:cubicBezTo>
                <a:cubicBezTo>
                  <a:pt x="9659493" y="2222606"/>
                  <a:pt x="9707562" y="2249168"/>
                  <a:pt x="9751695" y="2274380"/>
                </a:cubicBezTo>
                <a:cubicBezTo>
                  <a:pt x="10121202" y="2484441"/>
                  <a:pt x="10301795" y="2633119"/>
                  <a:pt x="10312209" y="2641797"/>
                </a:cubicBezTo>
                <a:lnTo>
                  <a:pt x="10313162" y="2641797"/>
                </a:lnTo>
                <a:lnTo>
                  <a:pt x="10318877" y="2635019"/>
                </a:lnTo>
                <a:cubicBezTo>
                  <a:pt x="10317099" y="2633499"/>
                  <a:pt x="10136378" y="2482161"/>
                  <a:pt x="9756902" y="2266398"/>
                </a:cubicBezTo>
                <a:cubicBezTo>
                  <a:pt x="9713722" y="2241820"/>
                  <a:pt x="9666795" y="2215847"/>
                  <a:pt x="9616059" y="2188481"/>
                </a:cubicBezTo>
                <a:cubicBezTo>
                  <a:pt x="9686417" y="2137803"/>
                  <a:pt x="9761665" y="2084971"/>
                  <a:pt x="9841103" y="2031695"/>
                </a:cubicBezTo>
                <a:cubicBezTo>
                  <a:pt x="9984867" y="2103722"/>
                  <a:pt x="10110025" y="2170744"/>
                  <a:pt x="10216134" y="2230164"/>
                </a:cubicBezTo>
                <a:cubicBezTo>
                  <a:pt x="10501503" y="2390053"/>
                  <a:pt x="10693781" y="2519663"/>
                  <a:pt x="10792778" y="2590295"/>
                </a:cubicBezTo>
                <a:cubicBezTo>
                  <a:pt x="10765219" y="2618675"/>
                  <a:pt x="10750804" y="2635019"/>
                  <a:pt x="10750359" y="2635526"/>
                </a:cubicBezTo>
                <a:lnTo>
                  <a:pt x="10757598" y="2641861"/>
                </a:lnTo>
                <a:cubicBezTo>
                  <a:pt x="10757980" y="2641417"/>
                  <a:pt x="10772584" y="2624757"/>
                  <a:pt x="10800588" y="2595997"/>
                </a:cubicBezTo>
                <a:cubicBezTo>
                  <a:pt x="10831258" y="2617978"/>
                  <a:pt x="10851959" y="2633625"/>
                  <a:pt x="10862818" y="2641924"/>
                </a:cubicBezTo>
                <a:lnTo>
                  <a:pt x="10877169" y="2641924"/>
                </a:lnTo>
                <a:lnTo>
                  <a:pt x="10877613" y="2641354"/>
                </a:lnTo>
                <a:cubicBezTo>
                  <a:pt x="10876915" y="2640847"/>
                  <a:pt x="10853357" y="2622349"/>
                  <a:pt x="10807319" y="2589155"/>
                </a:cubicBezTo>
                <a:cubicBezTo>
                  <a:pt x="10853420" y="2542151"/>
                  <a:pt x="10931081" y="2467147"/>
                  <a:pt x="11037824" y="2377700"/>
                </a:cubicBezTo>
                <a:cubicBezTo>
                  <a:pt x="11279569" y="2517889"/>
                  <a:pt x="11421808" y="2615825"/>
                  <a:pt x="11458893" y="2641924"/>
                </a:cubicBezTo>
                <a:lnTo>
                  <a:pt x="11473879" y="2641924"/>
                </a:lnTo>
                <a:lnTo>
                  <a:pt x="11474323" y="2641227"/>
                </a:lnTo>
                <a:cubicBezTo>
                  <a:pt x="11472418" y="2639833"/>
                  <a:pt x="11326432" y="2534169"/>
                  <a:pt x="11045634" y="2371239"/>
                </a:cubicBezTo>
                <a:cubicBezTo>
                  <a:pt x="11071860" y="2349403"/>
                  <a:pt x="11099736" y="2326788"/>
                  <a:pt x="11129391" y="2303394"/>
                </a:cubicBezTo>
                <a:cubicBezTo>
                  <a:pt x="11174285" y="2268109"/>
                  <a:pt x="11225022" y="2229910"/>
                  <a:pt x="11281283" y="2189875"/>
                </a:cubicBezTo>
                <a:cubicBezTo>
                  <a:pt x="11775567" y="2444912"/>
                  <a:pt x="12045632" y="2628874"/>
                  <a:pt x="12064619" y="2641924"/>
                </a:cubicBezTo>
                <a:lnTo>
                  <a:pt x="12066207" y="2641924"/>
                </a:lnTo>
                <a:lnTo>
                  <a:pt x="12071159" y="2634892"/>
                </a:lnTo>
                <a:cubicBezTo>
                  <a:pt x="12068429" y="2632992"/>
                  <a:pt x="11798109" y="2446179"/>
                  <a:pt x="11290109" y="2183666"/>
                </a:cubicBezTo>
                <a:cubicBezTo>
                  <a:pt x="11556111" y="1995106"/>
                  <a:pt x="11843448" y="1838383"/>
                  <a:pt x="12146153" y="1716730"/>
                </a:cubicBezTo>
                <a:lnTo>
                  <a:pt x="12188634" y="1718631"/>
                </a:lnTo>
                <a:lnTo>
                  <a:pt x="12189143" y="1709128"/>
                </a:lnTo>
                <a:lnTo>
                  <a:pt x="12167933" y="1708178"/>
                </a:lnTo>
                <a:cubicBezTo>
                  <a:pt x="12175490" y="1705264"/>
                  <a:pt x="12182983" y="1702224"/>
                  <a:pt x="12190603" y="1699310"/>
                </a:cubicBezTo>
                <a:lnTo>
                  <a:pt x="12187174" y="1690441"/>
                </a:lnTo>
                <a:cubicBezTo>
                  <a:pt x="12172886" y="1695971"/>
                  <a:pt x="12158726" y="1701546"/>
                  <a:pt x="12144566" y="1707165"/>
                </a:cubicBezTo>
                <a:cubicBezTo>
                  <a:pt x="11545887" y="1680679"/>
                  <a:pt x="10946257" y="1684904"/>
                  <a:pt x="10348023" y="1719834"/>
                </a:cubicBezTo>
                <a:cubicBezTo>
                  <a:pt x="10535920" y="1613980"/>
                  <a:pt x="10726737" y="1517122"/>
                  <a:pt x="10918634" y="1429955"/>
                </a:cubicBezTo>
                <a:cubicBezTo>
                  <a:pt x="11010646" y="1388228"/>
                  <a:pt x="11102975" y="1348807"/>
                  <a:pt x="11195621" y="1311685"/>
                </a:cubicBezTo>
                <a:cubicBezTo>
                  <a:pt x="11527092" y="1320129"/>
                  <a:pt x="11858054" y="1337613"/>
                  <a:pt x="12188507" y="1364137"/>
                </a:cubicBezTo>
                <a:lnTo>
                  <a:pt x="12189270" y="1354635"/>
                </a:lnTo>
                <a:cubicBezTo>
                  <a:pt x="11866245" y="1328491"/>
                  <a:pt x="11542395" y="1311197"/>
                  <a:pt x="11217720" y="1302753"/>
                </a:cubicBezTo>
                <a:cubicBezTo>
                  <a:pt x="11464481" y="1204285"/>
                  <a:pt x="11717210" y="1121369"/>
                  <a:pt x="11974385" y="1054493"/>
                </a:cubicBezTo>
                <a:cubicBezTo>
                  <a:pt x="12045632" y="1060277"/>
                  <a:pt x="12116943" y="1066358"/>
                  <a:pt x="12188317" y="1072737"/>
                </a:cubicBezTo>
                <a:lnTo>
                  <a:pt x="12189206" y="1063235"/>
                </a:lnTo>
                <a:cubicBezTo>
                  <a:pt x="12126976" y="1057661"/>
                  <a:pt x="12064809" y="1052339"/>
                  <a:pt x="12002643" y="1047272"/>
                </a:cubicBezTo>
                <a:cubicBezTo>
                  <a:pt x="12065127" y="1031435"/>
                  <a:pt x="12127484" y="1016656"/>
                  <a:pt x="12189778" y="1002928"/>
                </a:cubicBezTo>
                <a:lnTo>
                  <a:pt x="12187745" y="993679"/>
                </a:lnTo>
                <a:cubicBezTo>
                  <a:pt x="12116498" y="1009263"/>
                  <a:pt x="12045124" y="1026322"/>
                  <a:pt x="11973560" y="1044864"/>
                </a:cubicBezTo>
                <a:cubicBezTo>
                  <a:pt x="11356848" y="995010"/>
                  <a:pt x="10743311" y="970811"/>
                  <a:pt x="10136251" y="972204"/>
                </a:cubicBezTo>
                <a:cubicBezTo>
                  <a:pt x="10247503" y="928621"/>
                  <a:pt x="10357866" y="888858"/>
                  <a:pt x="10467340" y="852921"/>
                </a:cubicBezTo>
                <a:cubicBezTo>
                  <a:pt x="10623677" y="801609"/>
                  <a:pt x="10777919" y="758260"/>
                  <a:pt x="10930065" y="722868"/>
                </a:cubicBezTo>
                <a:cubicBezTo>
                  <a:pt x="11346688" y="744831"/>
                  <a:pt x="11766106" y="776986"/>
                  <a:pt x="12188254" y="819346"/>
                </a:cubicBezTo>
                <a:lnTo>
                  <a:pt x="12189270" y="809844"/>
                </a:lnTo>
                <a:cubicBezTo>
                  <a:pt x="11778297" y="768668"/>
                  <a:pt x="11369802" y="736994"/>
                  <a:pt x="10963720" y="714823"/>
                </a:cubicBezTo>
                <a:cubicBezTo>
                  <a:pt x="11392408" y="618091"/>
                  <a:pt x="11802682" y="584960"/>
                  <a:pt x="12188444" y="616317"/>
                </a:cubicBezTo>
                <a:lnTo>
                  <a:pt x="12189206" y="606815"/>
                </a:lnTo>
                <a:cubicBezTo>
                  <a:pt x="11792839" y="574571"/>
                  <a:pt x="11370628" y="610299"/>
                  <a:pt x="10929239" y="712986"/>
                </a:cubicBezTo>
                <a:cubicBezTo>
                  <a:pt x="10463594" y="688407"/>
                  <a:pt x="10002139" y="676516"/>
                  <a:pt x="9544939" y="677321"/>
                </a:cubicBezTo>
                <a:cubicBezTo>
                  <a:pt x="10155619" y="528390"/>
                  <a:pt x="10806367" y="432925"/>
                  <a:pt x="11488674" y="392256"/>
                </a:cubicBezTo>
                <a:cubicBezTo>
                  <a:pt x="11723053" y="408769"/>
                  <a:pt x="11957495" y="428385"/>
                  <a:pt x="12192063" y="451106"/>
                </a:cubicBezTo>
                <a:close/>
                <a:moveTo>
                  <a:pt x="6546088" y="486771"/>
                </a:moveTo>
                <a:cubicBezTo>
                  <a:pt x="6749288" y="463712"/>
                  <a:pt x="6953377" y="443061"/>
                  <a:pt x="7158292" y="424817"/>
                </a:cubicBezTo>
                <a:cubicBezTo>
                  <a:pt x="7848346" y="363243"/>
                  <a:pt x="8545385" y="329035"/>
                  <a:pt x="9249410" y="322194"/>
                </a:cubicBezTo>
                <a:cubicBezTo>
                  <a:pt x="8978900" y="362483"/>
                  <a:pt x="8716073" y="410564"/>
                  <a:pt x="8460994" y="466436"/>
                </a:cubicBezTo>
                <a:cubicBezTo>
                  <a:pt x="8077327" y="549851"/>
                  <a:pt x="7698931" y="656042"/>
                  <a:pt x="7327964" y="784442"/>
                </a:cubicBezTo>
                <a:cubicBezTo>
                  <a:pt x="7315835" y="785645"/>
                  <a:pt x="7303770" y="786912"/>
                  <a:pt x="7291642" y="788053"/>
                </a:cubicBezTo>
                <a:cubicBezTo>
                  <a:pt x="6943345" y="712922"/>
                  <a:pt x="6590602" y="647275"/>
                  <a:pt x="6233414" y="591105"/>
                </a:cubicBezTo>
                <a:cubicBezTo>
                  <a:pt x="6336284" y="554827"/>
                  <a:pt x="6440488" y="520049"/>
                  <a:pt x="6546088" y="486771"/>
                </a:cubicBezTo>
                <a:close/>
                <a:moveTo>
                  <a:pt x="9814941" y="1759237"/>
                </a:moveTo>
                <a:cubicBezTo>
                  <a:pt x="9599041" y="1666496"/>
                  <a:pt x="9359836" y="1570270"/>
                  <a:pt x="9098597" y="1474172"/>
                </a:cubicBezTo>
                <a:cubicBezTo>
                  <a:pt x="9163241" y="1437050"/>
                  <a:pt x="9227757" y="1401151"/>
                  <a:pt x="9292209" y="1366481"/>
                </a:cubicBezTo>
                <a:lnTo>
                  <a:pt x="9326817" y="1363567"/>
                </a:lnTo>
                <a:cubicBezTo>
                  <a:pt x="9677273" y="1484371"/>
                  <a:pt x="9994392" y="1606759"/>
                  <a:pt x="10275507" y="1723952"/>
                </a:cubicBezTo>
                <a:cubicBezTo>
                  <a:pt x="10121138" y="1733537"/>
                  <a:pt x="9967595" y="1745300"/>
                  <a:pt x="9814941" y="1759237"/>
                </a:cubicBezTo>
                <a:close/>
                <a:moveTo>
                  <a:pt x="10295255" y="1731997"/>
                </a:moveTo>
                <a:lnTo>
                  <a:pt x="10301605" y="1734658"/>
                </a:lnTo>
                <a:cubicBezTo>
                  <a:pt x="10224008" y="1779001"/>
                  <a:pt x="10146982" y="1824865"/>
                  <a:pt x="10070529" y="1872249"/>
                </a:cubicBezTo>
                <a:cubicBezTo>
                  <a:pt x="9994773" y="1837832"/>
                  <a:pt x="9915652" y="1802883"/>
                  <a:pt x="9833229" y="1767408"/>
                </a:cubicBezTo>
                <a:cubicBezTo>
                  <a:pt x="9986391" y="1753428"/>
                  <a:pt x="10140379" y="1741626"/>
                  <a:pt x="10295255" y="1731997"/>
                </a:cubicBezTo>
                <a:close/>
                <a:moveTo>
                  <a:pt x="2138045" y="2013831"/>
                </a:moveTo>
                <a:cubicBezTo>
                  <a:pt x="1894205" y="1904176"/>
                  <a:pt x="1622933" y="1789834"/>
                  <a:pt x="1325944" y="1675428"/>
                </a:cubicBezTo>
                <a:cubicBezTo>
                  <a:pt x="1458024" y="1627619"/>
                  <a:pt x="1601641" y="1577619"/>
                  <a:pt x="1756791" y="1525420"/>
                </a:cubicBezTo>
                <a:cubicBezTo>
                  <a:pt x="2043729" y="1573311"/>
                  <a:pt x="2324208" y="1626821"/>
                  <a:pt x="2598230" y="1685943"/>
                </a:cubicBezTo>
                <a:cubicBezTo>
                  <a:pt x="2480501" y="1779571"/>
                  <a:pt x="2373884" y="1870602"/>
                  <a:pt x="2278380" y="1957008"/>
                </a:cubicBezTo>
                <a:cubicBezTo>
                  <a:pt x="2230203" y="1976184"/>
                  <a:pt x="2183429" y="1995124"/>
                  <a:pt x="2138045" y="2013831"/>
                </a:cubicBezTo>
                <a:close/>
                <a:moveTo>
                  <a:pt x="2258187" y="1975316"/>
                </a:moveTo>
                <a:cubicBezTo>
                  <a:pt x="2235073" y="1996430"/>
                  <a:pt x="2212613" y="2017208"/>
                  <a:pt x="2190814" y="2037650"/>
                </a:cubicBezTo>
                <a:lnTo>
                  <a:pt x="2149983" y="2019216"/>
                </a:lnTo>
                <a:cubicBezTo>
                  <a:pt x="2185245" y="2004690"/>
                  <a:pt x="2221313" y="1990057"/>
                  <a:pt x="2258187" y="1975316"/>
                </a:cubicBezTo>
                <a:close/>
                <a:moveTo>
                  <a:pt x="5040694" y="1641663"/>
                </a:moveTo>
                <a:cubicBezTo>
                  <a:pt x="4941716" y="1669112"/>
                  <a:pt x="4845495" y="1696712"/>
                  <a:pt x="4752023" y="1724459"/>
                </a:cubicBezTo>
                <a:cubicBezTo>
                  <a:pt x="4590396" y="1676866"/>
                  <a:pt x="4427411" y="1631464"/>
                  <a:pt x="4263073" y="1588261"/>
                </a:cubicBezTo>
                <a:cubicBezTo>
                  <a:pt x="4482465" y="1434440"/>
                  <a:pt x="4710157" y="1292750"/>
                  <a:pt x="4945126" y="1163831"/>
                </a:cubicBezTo>
                <a:cubicBezTo>
                  <a:pt x="5259026" y="1095752"/>
                  <a:pt x="5577923" y="1034792"/>
                  <a:pt x="5901817" y="980947"/>
                </a:cubicBezTo>
                <a:cubicBezTo>
                  <a:pt x="6115476" y="1020222"/>
                  <a:pt x="6325299" y="1062747"/>
                  <a:pt x="6531293" y="1108529"/>
                </a:cubicBezTo>
                <a:cubicBezTo>
                  <a:pt x="6388862" y="1175804"/>
                  <a:pt x="6250877" y="1246456"/>
                  <a:pt x="6117273" y="1320490"/>
                </a:cubicBezTo>
                <a:cubicBezTo>
                  <a:pt x="6059697" y="1352500"/>
                  <a:pt x="6003989" y="1384490"/>
                  <a:pt x="5950141" y="1416462"/>
                </a:cubicBezTo>
                <a:cubicBezTo>
                  <a:pt x="5642039" y="1484162"/>
                  <a:pt x="5338890" y="1559229"/>
                  <a:pt x="5040694" y="1641663"/>
                </a:cubicBezTo>
                <a:close/>
                <a:moveTo>
                  <a:pt x="5924614" y="1432046"/>
                </a:moveTo>
                <a:cubicBezTo>
                  <a:pt x="5696801" y="1568205"/>
                  <a:pt x="5478685" y="1719904"/>
                  <a:pt x="5271834" y="1886059"/>
                </a:cubicBezTo>
                <a:lnTo>
                  <a:pt x="5218494" y="1868765"/>
                </a:lnTo>
                <a:cubicBezTo>
                  <a:pt x="5069777" y="1820412"/>
                  <a:pt x="4919917" y="1773952"/>
                  <a:pt x="4768914" y="1729400"/>
                </a:cubicBezTo>
                <a:cubicBezTo>
                  <a:pt x="4857814" y="1703091"/>
                  <a:pt x="4949273" y="1676929"/>
                  <a:pt x="5043297" y="1650912"/>
                </a:cubicBezTo>
                <a:cubicBezTo>
                  <a:pt x="5332051" y="1570923"/>
                  <a:pt x="5625827" y="1497972"/>
                  <a:pt x="5924614" y="1432046"/>
                </a:cubicBezTo>
                <a:close/>
                <a:moveTo>
                  <a:pt x="2143379" y="1400372"/>
                </a:moveTo>
                <a:cubicBezTo>
                  <a:pt x="2225212" y="1374779"/>
                  <a:pt x="2309432" y="1349016"/>
                  <a:pt x="2396046" y="1323088"/>
                </a:cubicBezTo>
                <a:cubicBezTo>
                  <a:pt x="2580113" y="1355522"/>
                  <a:pt x="2762822" y="1390616"/>
                  <a:pt x="2944178" y="1428371"/>
                </a:cubicBezTo>
                <a:cubicBezTo>
                  <a:pt x="2896851" y="1461439"/>
                  <a:pt x="2850007" y="1495013"/>
                  <a:pt x="2803652" y="1529094"/>
                </a:cubicBezTo>
                <a:cubicBezTo>
                  <a:pt x="2586736" y="1482261"/>
                  <a:pt x="2366709" y="1439223"/>
                  <a:pt x="2143570" y="1399992"/>
                </a:cubicBezTo>
                <a:close/>
                <a:moveTo>
                  <a:pt x="2793492" y="1536633"/>
                </a:moveTo>
                <a:cubicBezTo>
                  <a:pt x="2776728" y="1548922"/>
                  <a:pt x="2759964" y="1561212"/>
                  <a:pt x="2743391" y="1573691"/>
                </a:cubicBezTo>
                <a:cubicBezTo>
                  <a:pt x="2696572" y="1608830"/>
                  <a:pt x="2651335" y="1643735"/>
                  <a:pt x="2607691" y="1678405"/>
                </a:cubicBezTo>
                <a:cubicBezTo>
                  <a:pt x="2336756" y="1619872"/>
                  <a:pt x="2059476" y="1566786"/>
                  <a:pt x="1775841" y="1519149"/>
                </a:cubicBezTo>
                <a:cubicBezTo>
                  <a:pt x="1886248" y="1482280"/>
                  <a:pt x="2002199" y="1444760"/>
                  <a:pt x="2123694" y="1406580"/>
                </a:cubicBezTo>
                <a:cubicBezTo>
                  <a:pt x="2350091" y="1445900"/>
                  <a:pt x="2573420" y="1489204"/>
                  <a:pt x="2793683" y="1536506"/>
                </a:cubicBezTo>
                <a:close/>
                <a:moveTo>
                  <a:pt x="3638614" y="549802"/>
                </a:moveTo>
                <a:cubicBezTo>
                  <a:pt x="3919665" y="564118"/>
                  <a:pt x="4197395" y="583925"/>
                  <a:pt x="4471797" y="609222"/>
                </a:cubicBezTo>
                <a:cubicBezTo>
                  <a:pt x="4371893" y="648878"/>
                  <a:pt x="4273125" y="690478"/>
                  <a:pt x="4175506" y="734017"/>
                </a:cubicBezTo>
                <a:cubicBezTo>
                  <a:pt x="3830276" y="701285"/>
                  <a:pt x="3477749" y="676054"/>
                  <a:pt x="3117914" y="658317"/>
                </a:cubicBezTo>
                <a:cubicBezTo>
                  <a:pt x="3294317" y="619759"/>
                  <a:pt x="3467881" y="583587"/>
                  <a:pt x="3638614" y="549802"/>
                </a:cubicBezTo>
                <a:close/>
                <a:moveTo>
                  <a:pt x="3081592" y="656479"/>
                </a:moveTo>
                <a:cubicBezTo>
                  <a:pt x="2968352" y="651032"/>
                  <a:pt x="2854408" y="646344"/>
                  <a:pt x="2739771" y="642416"/>
                </a:cubicBezTo>
                <a:cubicBezTo>
                  <a:pt x="2831338" y="602634"/>
                  <a:pt x="2924048" y="564266"/>
                  <a:pt x="3017901" y="527313"/>
                </a:cubicBezTo>
                <a:cubicBezTo>
                  <a:pt x="3213227" y="531537"/>
                  <a:pt x="3407092" y="538399"/>
                  <a:pt x="3599498" y="547901"/>
                </a:cubicBezTo>
                <a:cubicBezTo>
                  <a:pt x="3429870" y="581729"/>
                  <a:pt x="3257214" y="617922"/>
                  <a:pt x="3081528" y="656479"/>
                </a:cubicBezTo>
                <a:close/>
                <a:moveTo>
                  <a:pt x="6837236" y="972521"/>
                </a:moveTo>
                <a:cubicBezTo>
                  <a:pt x="6717856" y="945155"/>
                  <a:pt x="6597460" y="918973"/>
                  <a:pt x="6476111" y="893970"/>
                </a:cubicBezTo>
                <a:cubicBezTo>
                  <a:pt x="6606033" y="876106"/>
                  <a:pt x="6736588" y="859363"/>
                  <a:pt x="6867779" y="843735"/>
                </a:cubicBezTo>
                <a:cubicBezTo>
                  <a:pt x="6930327" y="857121"/>
                  <a:pt x="6992620" y="870804"/>
                  <a:pt x="7054723" y="884785"/>
                </a:cubicBezTo>
                <a:cubicBezTo>
                  <a:pt x="6981254" y="913247"/>
                  <a:pt x="6908737" y="942494"/>
                  <a:pt x="6837172" y="972521"/>
                </a:cubicBezTo>
                <a:close/>
                <a:moveTo>
                  <a:pt x="7071424" y="888522"/>
                </a:moveTo>
                <a:cubicBezTo>
                  <a:pt x="7350570" y="951616"/>
                  <a:pt x="7625906" y="1021109"/>
                  <a:pt x="7897369" y="1097000"/>
                </a:cubicBezTo>
                <a:cubicBezTo>
                  <a:pt x="7769543" y="1111316"/>
                  <a:pt x="7642225" y="1126817"/>
                  <a:pt x="7515416" y="1143497"/>
                </a:cubicBezTo>
                <a:cubicBezTo>
                  <a:pt x="7298309" y="1083525"/>
                  <a:pt x="7077520" y="1027741"/>
                  <a:pt x="6853047" y="976132"/>
                </a:cubicBezTo>
                <a:cubicBezTo>
                  <a:pt x="6924866" y="946188"/>
                  <a:pt x="6997637" y="916984"/>
                  <a:pt x="7071360" y="888522"/>
                </a:cubicBezTo>
                <a:close/>
                <a:moveTo>
                  <a:pt x="6822313" y="978793"/>
                </a:moveTo>
                <a:cubicBezTo>
                  <a:pt x="6728396" y="1018531"/>
                  <a:pt x="6636258" y="1059624"/>
                  <a:pt x="6545770" y="1102067"/>
                </a:cubicBezTo>
                <a:cubicBezTo>
                  <a:pt x="6344222" y="1057090"/>
                  <a:pt x="6138907" y="1015237"/>
                  <a:pt x="5929821" y="976512"/>
                </a:cubicBezTo>
                <a:cubicBezTo>
                  <a:pt x="6101188" y="948259"/>
                  <a:pt x="6273781" y="922052"/>
                  <a:pt x="6447600" y="897898"/>
                </a:cubicBezTo>
                <a:cubicBezTo>
                  <a:pt x="6573520" y="923617"/>
                  <a:pt x="6698425" y="950584"/>
                  <a:pt x="6822250" y="978793"/>
                </a:cubicBezTo>
                <a:close/>
                <a:moveTo>
                  <a:pt x="5902262" y="971444"/>
                </a:moveTo>
                <a:cubicBezTo>
                  <a:pt x="5761209" y="945516"/>
                  <a:pt x="5618525" y="921039"/>
                  <a:pt x="5474208" y="898024"/>
                </a:cubicBezTo>
                <a:cubicBezTo>
                  <a:pt x="5554263" y="861283"/>
                  <a:pt x="5635371" y="825491"/>
                  <a:pt x="5717540" y="790650"/>
                </a:cubicBezTo>
                <a:lnTo>
                  <a:pt x="5761228" y="772342"/>
                </a:lnTo>
                <a:cubicBezTo>
                  <a:pt x="5983523" y="808495"/>
                  <a:pt x="6202953" y="848442"/>
                  <a:pt x="6419533" y="892196"/>
                </a:cubicBezTo>
                <a:cubicBezTo>
                  <a:pt x="6245841" y="916604"/>
                  <a:pt x="6073394" y="943020"/>
                  <a:pt x="5902198" y="971444"/>
                </a:cubicBezTo>
                <a:close/>
                <a:moveTo>
                  <a:pt x="5874576" y="976069"/>
                </a:moveTo>
                <a:cubicBezTo>
                  <a:pt x="5570538" y="1027000"/>
                  <a:pt x="5270691" y="1084267"/>
                  <a:pt x="4975035" y="1147868"/>
                </a:cubicBezTo>
                <a:cubicBezTo>
                  <a:pt x="5131372" y="1062811"/>
                  <a:pt x="5292598" y="981916"/>
                  <a:pt x="5458714" y="905183"/>
                </a:cubicBezTo>
                <a:cubicBezTo>
                  <a:pt x="5598751" y="927481"/>
                  <a:pt x="5737352" y="951110"/>
                  <a:pt x="5874512" y="976069"/>
                </a:cubicBezTo>
                <a:close/>
                <a:moveTo>
                  <a:pt x="5713476" y="782035"/>
                </a:moveTo>
                <a:cubicBezTo>
                  <a:pt x="5626862" y="818650"/>
                  <a:pt x="5541474" y="856424"/>
                  <a:pt x="5457317" y="895364"/>
                </a:cubicBezTo>
                <a:cubicBezTo>
                  <a:pt x="5229651" y="859255"/>
                  <a:pt x="4998066" y="826714"/>
                  <a:pt x="4762564" y="797745"/>
                </a:cubicBezTo>
                <a:cubicBezTo>
                  <a:pt x="4714767" y="791835"/>
                  <a:pt x="4666787" y="786108"/>
                  <a:pt x="4618609" y="780578"/>
                </a:cubicBezTo>
                <a:cubicBezTo>
                  <a:pt x="4795393" y="746497"/>
                  <a:pt x="4973193" y="714272"/>
                  <a:pt x="5152009" y="683909"/>
                </a:cubicBezTo>
                <a:cubicBezTo>
                  <a:pt x="5351190" y="709248"/>
                  <a:pt x="5548332" y="737774"/>
                  <a:pt x="5743448" y="769492"/>
                </a:cubicBezTo>
                <a:cubicBezTo>
                  <a:pt x="5733479" y="773673"/>
                  <a:pt x="5723382" y="777790"/>
                  <a:pt x="5713413" y="782035"/>
                </a:cubicBezTo>
                <a:close/>
                <a:moveTo>
                  <a:pt x="4587304" y="777030"/>
                </a:moveTo>
                <a:cubicBezTo>
                  <a:pt x="4457637" y="762207"/>
                  <a:pt x="4326846" y="748460"/>
                  <a:pt x="4194937" y="735791"/>
                </a:cubicBezTo>
                <a:cubicBezTo>
                  <a:pt x="4293026" y="692334"/>
                  <a:pt x="4392340" y="650778"/>
                  <a:pt x="4492879" y="611122"/>
                </a:cubicBezTo>
                <a:cubicBezTo>
                  <a:pt x="4604893" y="621596"/>
                  <a:pt x="4716355" y="632914"/>
                  <a:pt x="4827270" y="645077"/>
                </a:cubicBezTo>
                <a:cubicBezTo>
                  <a:pt x="4925143" y="655928"/>
                  <a:pt x="5022514" y="667502"/>
                  <a:pt x="5119370" y="679791"/>
                </a:cubicBezTo>
                <a:cubicBezTo>
                  <a:pt x="4941189" y="710407"/>
                  <a:pt x="4763815" y="742822"/>
                  <a:pt x="4587240" y="777030"/>
                </a:cubicBezTo>
                <a:close/>
                <a:moveTo>
                  <a:pt x="4177094" y="743709"/>
                </a:moveTo>
                <a:cubicBezTo>
                  <a:pt x="4304557" y="755790"/>
                  <a:pt x="4430986" y="768922"/>
                  <a:pt x="4556379" y="783112"/>
                </a:cubicBezTo>
                <a:cubicBezTo>
                  <a:pt x="4279900" y="837166"/>
                  <a:pt x="4005917" y="895725"/>
                  <a:pt x="3734435" y="958775"/>
                </a:cubicBezTo>
                <a:cubicBezTo>
                  <a:pt x="3877945" y="883264"/>
                  <a:pt x="4024357" y="812080"/>
                  <a:pt x="4173665" y="745230"/>
                </a:cubicBezTo>
                <a:close/>
                <a:moveTo>
                  <a:pt x="4587685" y="786596"/>
                </a:moveTo>
                <a:cubicBezTo>
                  <a:pt x="4645724" y="793266"/>
                  <a:pt x="4703553" y="800108"/>
                  <a:pt x="4761167" y="807120"/>
                </a:cubicBezTo>
                <a:cubicBezTo>
                  <a:pt x="4991627" y="835373"/>
                  <a:pt x="5218576" y="867174"/>
                  <a:pt x="5442014" y="902522"/>
                </a:cubicBezTo>
                <a:cubicBezTo>
                  <a:pt x="5270310" y="982087"/>
                  <a:pt x="5103749" y="1066232"/>
                  <a:pt x="4942332" y="1154963"/>
                </a:cubicBezTo>
                <a:cubicBezTo>
                  <a:pt x="4546937" y="1240818"/>
                  <a:pt x="4160158" y="1337955"/>
                  <a:pt x="3781997" y="1446362"/>
                </a:cubicBezTo>
                <a:lnTo>
                  <a:pt x="3739579" y="1458588"/>
                </a:lnTo>
                <a:cubicBezTo>
                  <a:pt x="3533032" y="1410571"/>
                  <a:pt x="3324816" y="1365892"/>
                  <a:pt x="3114929" y="1324545"/>
                </a:cubicBezTo>
                <a:cubicBezTo>
                  <a:pt x="3303607" y="1200383"/>
                  <a:pt x="3499041" y="1084393"/>
                  <a:pt x="3701225" y="976576"/>
                </a:cubicBezTo>
                <a:cubicBezTo>
                  <a:pt x="3993534" y="907989"/>
                  <a:pt x="4289000" y="844667"/>
                  <a:pt x="4587621" y="786596"/>
                </a:cubicBezTo>
                <a:close/>
                <a:moveTo>
                  <a:pt x="4912741" y="1171180"/>
                </a:moveTo>
                <a:cubicBezTo>
                  <a:pt x="4685049" y="1297305"/>
                  <a:pt x="4464279" y="1435498"/>
                  <a:pt x="4251389" y="1585157"/>
                </a:cubicBezTo>
                <a:cubicBezTo>
                  <a:pt x="4088194" y="1542207"/>
                  <a:pt x="3923837" y="1501411"/>
                  <a:pt x="3758311" y="1462769"/>
                </a:cubicBezTo>
                <a:lnTo>
                  <a:pt x="3784473" y="1455231"/>
                </a:lnTo>
                <a:cubicBezTo>
                  <a:pt x="4151840" y="1350029"/>
                  <a:pt x="4527912" y="1255350"/>
                  <a:pt x="4912678" y="1171180"/>
                </a:cubicBezTo>
                <a:close/>
                <a:moveTo>
                  <a:pt x="3101277" y="1321694"/>
                </a:moveTo>
                <a:cubicBezTo>
                  <a:pt x="2958910" y="1293739"/>
                  <a:pt x="2815844" y="1267342"/>
                  <a:pt x="2672080" y="1242509"/>
                </a:cubicBezTo>
                <a:cubicBezTo>
                  <a:pt x="2874982" y="1184819"/>
                  <a:pt x="3088913" y="1127514"/>
                  <a:pt x="3313875" y="1070584"/>
                </a:cubicBezTo>
                <a:cubicBezTo>
                  <a:pt x="3430632" y="1041019"/>
                  <a:pt x="3547955" y="1012411"/>
                  <a:pt x="3665855" y="984747"/>
                </a:cubicBezTo>
                <a:cubicBezTo>
                  <a:pt x="3471628" y="1089227"/>
                  <a:pt x="3283439" y="1201542"/>
                  <a:pt x="3101277" y="1321694"/>
                </a:cubicBezTo>
                <a:close/>
                <a:moveTo>
                  <a:pt x="3089910" y="1329169"/>
                </a:moveTo>
                <a:cubicBezTo>
                  <a:pt x="3044527" y="1359196"/>
                  <a:pt x="2999594" y="1389729"/>
                  <a:pt x="2955100" y="1420770"/>
                </a:cubicBezTo>
                <a:cubicBezTo>
                  <a:pt x="2776963" y="1383648"/>
                  <a:pt x="2597487" y="1349016"/>
                  <a:pt x="2416683" y="1316880"/>
                </a:cubicBezTo>
                <a:cubicBezTo>
                  <a:pt x="2492883" y="1294157"/>
                  <a:pt x="2571033" y="1271377"/>
                  <a:pt x="2651125" y="1248527"/>
                </a:cubicBezTo>
                <a:cubicBezTo>
                  <a:pt x="2798064" y="1273740"/>
                  <a:pt x="2944324" y="1300618"/>
                  <a:pt x="3089910" y="1329169"/>
                </a:cubicBezTo>
                <a:close/>
                <a:moveTo>
                  <a:pt x="2395665" y="1313269"/>
                </a:moveTo>
                <a:cubicBezTo>
                  <a:pt x="2158937" y="1271586"/>
                  <a:pt x="1920094" y="1234337"/>
                  <a:pt x="1679131" y="1201523"/>
                </a:cubicBezTo>
                <a:cubicBezTo>
                  <a:pt x="1721466" y="1174873"/>
                  <a:pt x="1764201" y="1148565"/>
                  <a:pt x="1807337" y="1122592"/>
                </a:cubicBezTo>
                <a:cubicBezTo>
                  <a:pt x="2083435" y="1157687"/>
                  <a:pt x="2357438" y="1198438"/>
                  <a:pt x="2629345" y="1244853"/>
                </a:cubicBezTo>
                <a:cubicBezTo>
                  <a:pt x="2549671" y="1267658"/>
                  <a:pt x="2471782" y="1290464"/>
                  <a:pt x="2395665" y="1313269"/>
                </a:cubicBezTo>
                <a:close/>
                <a:moveTo>
                  <a:pt x="2957195" y="1430905"/>
                </a:moveTo>
                <a:cubicBezTo>
                  <a:pt x="3124918" y="1465956"/>
                  <a:pt x="3291351" y="1503267"/>
                  <a:pt x="3456496" y="1542841"/>
                </a:cubicBezTo>
                <a:cubicBezTo>
                  <a:pt x="3371831" y="1568940"/>
                  <a:pt x="3289173" y="1595122"/>
                  <a:pt x="3208528" y="1621392"/>
                </a:cubicBezTo>
                <a:cubicBezTo>
                  <a:pt x="3078944" y="1590098"/>
                  <a:pt x="2948178" y="1560154"/>
                  <a:pt x="2816225" y="1531565"/>
                </a:cubicBezTo>
                <a:cubicBezTo>
                  <a:pt x="2862707" y="1497484"/>
                  <a:pt x="2909697" y="1463929"/>
                  <a:pt x="2957195" y="1430905"/>
                </a:cubicBezTo>
                <a:close/>
                <a:moveTo>
                  <a:pt x="2967927" y="1423430"/>
                </a:moveTo>
                <a:cubicBezTo>
                  <a:pt x="3012631" y="1392472"/>
                  <a:pt x="3057735" y="1361920"/>
                  <a:pt x="3103245" y="1331766"/>
                </a:cubicBezTo>
                <a:cubicBezTo>
                  <a:pt x="3310681" y="1372518"/>
                  <a:pt x="3516522" y="1416506"/>
                  <a:pt x="3720783" y="1463719"/>
                </a:cubicBezTo>
                <a:cubicBezTo>
                  <a:pt x="3636753" y="1488089"/>
                  <a:pt x="3554584" y="1512624"/>
                  <a:pt x="3474276" y="1537329"/>
                </a:cubicBezTo>
                <a:cubicBezTo>
                  <a:pt x="3306845" y="1497040"/>
                  <a:pt x="3138062" y="1459076"/>
                  <a:pt x="2967927" y="1423430"/>
                </a:cubicBezTo>
                <a:close/>
                <a:moveTo>
                  <a:pt x="3739579" y="1468154"/>
                </a:moveTo>
                <a:cubicBezTo>
                  <a:pt x="3907898" y="1507303"/>
                  <a:pt x="4075113" y="1548688"/>
                  <a:pt x="4241229" y="1592315"/>
                </a:cubicBezTo>
                <a:cubicBezTo>
                  <a:pt x="4231069" y="1599474"/>
                  <a:pt x="4220718" y="1606632"/>
                  <a:pt x="4210558" y="1613917"/>
                </a:cubicBezTo>
                <a:cubicBezTo>
                  <a:pt x="4170763" y="1642341"/>
                  <a:pt x="4132155" y="1670613"/>
                  <a:pt x="4094734" y="1698740"/>
                </a:cubicBezTo>
                <a:cubicBezTo>
                  <a:pt x="3896151" y="1643165"/>
                  <a:pt x="3695427" y="1590814"/>
                  <a:pt x="3492564" y="1541701"/>
                </a:cubicBezTo>
                <a:cubicBezTo>
                  <a:pt x="3572999" y="1517039"/>
                  <a:pt x="3655333" y="1492524"/>
                  <a:pt x="3739579" y="1468154"/>
                </a:cubicBezTo>
                <a:close/>
                <a:moveTo>
                  <a:pt x="4216464" y="1621265"/>
                </a:moveTo>
                <a:cubicBezTo>
                  <a:pt x="4228592" y="1612587"/>
                  <a:pt x="4240911" y="1604098"/>
                  <a:pt x="4253167" y="1595419"/>
                </a:cubicBezTo>
                <a:cubicBezTo>
                  <a:pt x="4414965" y="1638071"/>
                  <a:pt x="4575639" y="1682732"/>
                  <a:pt x="4735195" y="1729400"/>
                </a:cubicBezTo>
                <a:cubicBezTo>
                  <a:pt x="4645197" y="1756215"/>
                  <a:pt x="4557859" y="1783036"/>
                  <a:pt x="4473194" y="1809852"/>
                </a:cubicBezTo>
                <a:cubicBezTo>
                  <a:pt x="4351700" y="1772603"/>
                  <a:pt x="4229354" y="1736704"/>
                  <a:pt x="4106164" y="1702160"/>
                </a:cubicBezTo>
                <a:cubicBezTo>
                  <a:pt x="4141851" y="1675428"/>
                  <a:pt x="4178617" y="1648460"/>
                  <a:pt x="4216464" y="1621265"/>
                </a:cubicBezTo>
                <a:close/>
                <a:moveTo>
                  <a:pt x="6122099" y="1328916"/>
                </a:moveTo>
                <a:cubicBezTo>
                  <a:pt x="6258878" y="1252898"/>
                  <a:pt x="6400419" y="1180618"/>
                  <a:pt x="6546723" y="1112076"/>
                </a:cubicBezTo>
                <a:cubicBezTo>
                  <a:pt x="6698615" y="1145860"/>
                  <a:pt x="6848285" y="1181550"/>
                  <a:pt x="6995669" y="1219134"/>
                </a:cubicBezTo>
                <a:cubicBezTo>
                  <a:pt x="6652324" y="1274037"/>
                  <a:pt x="6313824" y="1337702"/>
                  <a:pt x="5980240" y="1410127"/>
                </a:cubicBezTo>
                <a:cubicBezTo>
                  <a:pt x="6029960" y="1380987"/>
                  <a:pt x="6077458" y="1353748"/>
                  <a:pt x="6122162" y="1328916"/>
                </a:cubicBezTo>
                <a:close/>
                <a:moveTo>
                  <a:pt x="6560694" y="1105488"/>
                </a:moveTo>
                <a:cubicBezTo>
                  <a:pt x="6651371" y="1063254"/>
                  <a:pt x="6743827" y="1022249"/>
                  <a:pt x="6837998" y="982467"/>
                </a:cubicBezTo>
                <a:cubicBezTo>
                  <a:pt x="7059169" y="1033145"/>
                  <a:pt x="7276846" y="1087896"/>
                  <a:pt x="7490969" y="1146728"/>
                </a:cubicBezTo>
                <a:cubicBezTo>
                  <a:pt x="7332917" y="1167841"/>
                  <a:pt x="7175691" y="1190710"/>
                  <a:pt x="7019417" y="1215333"/>
                </a:cubicBezTo>
                <a:cubicBezTo>
                  <a:pt x="6868922" y="1176900"/>
                  <a:pt x="6716014" y="1140285"/>
                  <a:pt x="6560757" y="1105488"/>
                </a:cubicBezTo>
                <a:close/>
                <a:moveTo>
                  <a:pt x="7514654" y="1152936"/>
                </a:moveTo>
                <a:cubicBezTo>
                  <a:pt x="7634288" y="1186003"/>
                  <a:pt x="7752715" y="1220338"/>
                  <a:pt x="7869936" y="1255939"/>
                </a:cubicBezTo>
                <a:cubicBezTo>
                  <a:pt x="7784846" y="1296564"/>
                  <a:pt x="7701026" y="1338437"/>
                  <a:pt x="7618540" y="1381557"/>
                </a:cubicBezTo>
                <a:cubicBezTo>
                  <a:pt x="7430770" y="1324969"/>
                  <a:pt x="7238873" y="1271459"/>
                  <a:pt x="7042785" y="1221034"/>
                </a:cubicBezTo>
                <a:cubicBezTo>
                  <a:pt x="7199058" y="1196753"/>
                  <a:pt x="7356348" y="1174049"/>
                  <a:pt x="7514654" y="1152936"/>
                </a:cubicBezTo>
                <a:close/>
                <a:moveTo>
                  <a:pt x="7538847" y="1149768"/>
                </a:moveTo>
                <a:cubicBezTo>
                  <a:pt x="7665847" y="1133171"/>
                  <a:pt x="7793483" y="1117797"/>
                  <a:pt x="7921816" y="1103651"/>
                </a:cubicBezTo>
                <a:cubicBezTo>
                  <a:pt x="7979601" y="1119868"/>
                  <a:pt x="8037195" y="1136383"/>
                  <a:pt x="8094536" y="1153189"/>
                </a:cubicBezTo>
                <a:cubicBezTo>
                  <a:pt x="8023035" y="1184527"/>
                  <a:pt x="7952423" y="1216746"/>
                  <a:pt x="7882636" y="1249858"/>
                </a:cubicBezTo>
                <a:cubicBezTo>
                  <a:pt x="7769098" y="1215479"/>
                  <a:pt x="7654481" y="1182202"/>
                  <a:pt x="7538847" y="1150022"/>
                </a:cubicBezTo>
                <a:close/>
                <a:moveTo>
                  <a:pt x="8108696" y="1157370"/>
                </a:moveTo>
                <a:cubicBezTo>
                  <a:pt x="8240649" y="1196139"/>
                  <a:pt x="8371586" y="1236428"/>
                  <a:pt x="8501570" y="1278237"/>
                </a:cubicBezTo>
                <a:cubicBezTo>
                  <a:pt x="8624316" y="1317722"/>
                  <a:pt x="8743252" y="1357612"/>
                  <a:pt x="8858377" y="1397901"/>
                </a:cubicBezTo>
                <a:cubicBezTo>
                  <a:pt x="8729917" y="1411755"/>
                  <a:pt x="8601710" y="1427060"/>
                  <a:pt x="8473821" y="1443828"/>
                </a:cubicBezTo>
                <a:cubicBezTo>
                  <a:pt x="8391716" y="1414815"/>
                  <a:pt x="8307388" y="1385948"/>
                  <a:pt x="8220837" y="1357232"/>
                </a:cubicBezTo>
                <a:cubicBezTo>
                  <a:pt x="8113649" y="1321713"/>
                  <a:pt x="8005382" y="1287296"/>
                  <a:pt x="7896098" y="1253975"/>
                </a:cubicBezTo>
                <a:cubicBezTo>
                  <a:pt x="7966075" y="1221034"/>
                  <a:pt x="8037069" y="1188917"/>
                  <a:pt x="8109014" y="1157623"/>
                </a:cubicBezTo>
                <a:close/>
                <a:moveTo>
                  <a:pt x="8108061" y="1147234"/>
                </a:moveTo>
                <a:cubicBezTo>
                  <a:pt x="8054595" y="1131524"/>
                  <a:pt x="8000937" y="1116067"/>
                  <a:pt x="7947152" y="1100864"/>
                </a:cubicBezTo>
                <a:cubicBezTo>
                  <a:pt x="7997571" y="1095333"/>
                  <a:pt x="8048054" y="1089987"/>
                  <a:pt x="8098600" y="1084837"/>
                </a:cubicBezTo>
                <a:cubicBezTo>
                  <a:pt x="8166354" y="1077995"/>
                  <a:pt x="8234299" y="1071489"/>
                  <a:pt x="8302562" y="1065326"/>
                </a:cubicBezTo>
                <a:cubicBezTo>
                  <a:pt x="8237030" y="1092103"/>
                  <a:pt x="8172196" y="1119488"/>
                  <a:pt x="8108061" y="1147488"/>
                </a:cubicBezTo>
                <a:close/>
                <a:moveTo>
                  <a:pt x="8097647" y="1075398"/>
                </a:moveTo>
                <a:cubicBezTo>
                  <a:pt x="8039164" y="1081353"/>
                  <a:pt x="7980808" y="1087542"/>
                  <a:pt x="7922641" y="1093959"/>
                </a:cubicBezTo>
                <a:cubicBezTo>
                  <a:pt x="7648321" y="1016928"/>
                  <a:pt x="7369937" y="946314"/>
                  <a:pt x="7087489" y="882124"/>
                </a:cubicBezTo>
                <a:cubicBezTo>
                  <a:pt x="7160133" y="854333"/>
                  <a:pt x="7233730" y="827347"/>
                  <a:pt x="7308215" y="801166"/>
                </a:cubicBezTo>
                <a:cubicBezTo>
                  <a:pt x="7653338" y="875960"/>
                  <a:pt x="7993698" y="959997"/>
                  <a:pt x="8329358" y="1053290"/>
                </a:cubicBezTo>
                <a:cubicBezTo>
                  <a:pt x="8251952" y="1060594"/>
                  <a:pt x="8174736" y="1068050"/>
                  <a:pt x="8097647" y="1075651"/>
                </a:cubicBezTo>
                <a:close/>
                <a:moveTo>
                  <a:pt x="7070662" y="878387"/>
                </a:moveTo>
                <a:cubicBezTo>
                  <a:pt x="7012877" y="865337"/>
                  <a:pt x="6954965" y="852667"/>
                  <a:pt x="6896926" y="840378"/>
                </a:cubicBezTo>
                <a:cubicBezTo>
                  <a:pt x="7027291" y="825130"/>
                  <a:pt x="7158228" y="810966"/>
                  <a:pt x="7289673" y="797872"/>
                </a:cubicBezTo>
                <a:cubicBezTo>
                  <a:pt x="7215759" y="824015"/>
                  <a:pt x="7142734" y="850938"/>
                  <a:pt x="7070662" y="878640"/>
                </a:cubicBezTo>
                <a:close/>
                <a:moveTo>
                  <a:pt x="6868224" y="834043"/>
                </a:moveTo>
                <a:cubicBezTo>
                  <a:pt x="6585839" y="773736"/>
                  <a:pt x="6300108" y="719998"/>
                  <a:pt x="6010974" y="672823"/>
                </a:cubicBezTo>
                <a:cubicBezTo>
                  <a:pt x="6078284" y="647104"/>
                  <a:pt x="6146273" y="622061"/>
                  <a:pt x="6214936" y="597693"/>
                </a:cubicBezTo>
                <a:cubicBezTo>
                  <a:pt x="6567678" y="652850"/>
                  <a:pt x="6916483" y="717312"/>
                  <a:pt x="7261225" y="791093"/>
                </a:cubicBezTo>
                <a:cubicBezTo>
                  <a:pt x="7129590" y="804270"/>
                  <a:pt x="6998589" y="818605"/>
                  <a:pt x="6868224" y="834106"/>
                </a:cubicBezTo>
                <a:close/>
                <a:moveTo>
                  <a:pt x="6838950" y="837591"/>
                </a:moveTo>
                <a:cubicBezTo>
                  <a:pt x="6707950" y="853301"/>
                  <a:pt x="6577584" y="870196"/>
                  <a:pt x="6447917" y="888269"/>
                </a:cubicBezTo>
                <a:cubicBezTo>
                  <a:pt x="6227782" y="843336"/>
                  <a:pt x="6004389" y="802388"/>
                  <a:pt x="5777738" y="765438"/>
                </a:cubicBezTo>
                <a:cubicBezTo>
                  <a:pt x="5848731" y="736127"/>
                  <a:pt x="5920486" y="707538"/>
                  <a:pt x="5993003" y="679665"/>
                </a:cubicBezTo>
                <a:cubicBezTo>
                  <a:pt x="6278245" y="725991"/>
                  <a:pt x="6560249" y="778658"/>
                  <a:pt x="6839014" y="837654"/>
                </a:cubicBezTo>
                <a:close/>
                <a:moveTo>
                  <a:pt x="5760022" y="762524"/>
                </a:moveTo>
                <a:cubicBezTo>
                  <a:pt x="5569947" y="731737"/>
                  <a:pt x="5377923" y="703718"/>
                  <a:pt x="5183950" y="678461"/>
                </a:cubicBezTo>
                <a:cubicBezTo>
                  <a:pt x="5312728" y="656752"/>
                  <a:pt x="5441842" y="635999"/>
                  <a:pt x="5571300" y="616190"/>
                </a:cubicBezTo>
                <a:cubicBezTo>
                  <a:pt x="5706256" y="634941"/>
                  <a:pt x="5840559" y="655086"/>
                  <a:pt x="5974207" y="676624"/>
                </a:cubicBezTo>
                <a:cubicBezTo>
                  <a:pt x="5902071" y="704497"/>
                  <a:pt x="5830678" y="733130"/>
                  <a:pt x="5760022" y="762524"/>
                </a:cubicBezTo>
                <a:close/>
                <a:moveTo>
                  <a:pt x="5151755" y="674280"/>
                </a:moveTo>
                <a:cubicBezTo>
                  <a:pt x="5044612" y="660597"/>
                  <a:pt x="4936916" y="647737"/>
                  <a:pt x="4828667" y="635701"/>
                </a:cubicBezTo>
                <a:cubicBezTo>
                  <a:pt x="4723848" y="624088"/>
                  <a:pt x="4618482" y="613319"/>
                  <a:pt x="4512564" y="603394"/>
                </a:cubicBezTo>
                <a:cubicBezTo>
                  <a:pt x="4587113" y="574254"/>
                  <a:pt x="4662253" y="546191"/>
                  <a:pt x="4737989" y="519205"/>
                </a:cubicBezTo>
                <a:cubicBezTo>
                  <a:pt x="4793615" y="524399"/>
                  <a:pt x="4849114" y="529847"/>
                  <a:pt x="4904486" y="535549"/>
                </a:cubicBezTo>
                <a:cubicBezTo>
                  <a:pt x="5117256" y="557467"/>
                  <a:pt x="5328622" y="582806"/>
                  <a:pt x="5538597" y="611566"/>
                </a:cubicBezTo>
                <a:cubicBezTo>
                  <a:pt x="5409267" y="631584"/>
                  <a:pt x="5280324" y="652489"/>
                  <a:pt x="5151755" y="674280"/>
                </a:cubicBezTo>
                <a:close/>
                <a:moveTo>
                  <a:pt x="4491482" y="601810"/>
                </a:moveTo>
                <a:cubicBezTo>
                  <a:pt x="4223468" y="576471"/>
                  <a:pt x="3952050" y="556601"/>
                  <a:pt x="3677222" y="542200"/>
                </a:cubicBezTo>
                <a:cubicBezTo>
                  <a:pt x="3810953" y="515974"/>
                  <a:pt x="3942715" y="491269"/>
                  <a:pt x="4072509" y="468083"/>
                </a:cubicBezTo>
                <a:cubicBezTo>
                  <a:pt x="4288155" y="481217"/>
                  <a:pt x="4502468" y="497561"/>
                  <a:pt x="4715447" y="517114"/>
                </a:cubicBezTo>
                <a:cubicBezTo>
                  <a:pt x="4640218" y="544016"/>
                  <a:pt x="4565568" y="572248"/>
                  <a:pt x="4491482" y="601810"/>
                </a:cubicBezTo>
                <a:close/>
                <a:moveTo>
                  <a:pt x="3637852" y="540300"/>
                </a:moveTo>
                <a:cubicBezTo>
                  <a:pt x="3440411" y="530207"/>
                  <a:pt x="3241440" y="522879"/>
                  <a:pt x="3040952" y="518318"/>
                </a:cubicBezTo>
                <a:cubicBezTo>
                  <a:pt x="3113932" y="489896"/>
                  <a:pt x="3187529" y="462445"/>
                  <a:pt x="3261741" y="435966"/>
                </a:cubicBezTo>
                <a:cubicBezTo>
                  <a:pt x="3520269" y="440950"/>
                  <a:pt x="3777126" y="450853"/>
                  <a:pt x="4032314" y="465676"/>
                </a:cubicBezTo>
                <a:cubicBezTo>
                  <a:pt x="3902818" y="488861"/>
                  <a:pt x="3771329" y="513736"/>
                  <a:pt x="3637852" y="540300"/>
                </a:cubicBezTo>
                <a:close/>
                <a:moveTo>
                  <a:pt x="3016314" y="517748"/>
                </a:moveTo>
                <a:cubicBezTo>
                  <a:pt x="2556066" y="507655"/>
                  <a:pt x="2088280" y="511877"/>
                  <a:pt x="1612964" y="530417"/>
                </a:cubicBezTo>
                <a:cubicBezTo>
                  <a:pt x="1751565" y="502460"/>
                  <a:pt x="1896764" y="474524"/>
                  <a:pt x="2048574" y="446608"/>
                </a:cubicBezTo>
                <a:cubicBezTo>
                  <a:pt x="2447227" y="431828"/>
                  <a:pt x="2842724" y="428027"/>
                  <a:pt x="3235071" y="435206"/>
                </a:cubicBezTo>
                <a:cubicBezTo>
                  <a:pt x="3161494" y="461812"/>
                  <a:pt x="3088577" y="489326"/>
                  <a:pt x="3016314" y="517748"/>
                </a:cubicBezTo>
                <a:close/>
                <a:moveTo>
                  <a:pt x="2993581" y="526807"/>
                </a:moveTo>
                <a:cubicBezTo>
                  <a:pt x="2900445" y="563675"/>
                  <a:pt x="2808478" y="601980"/>
                  <a:pt x="2717673" y="641719"/>
                </a:cubicBezTo>
                <a:cubicBezTo>
                  <a:pt x="2197227" y="624235"/>
                  <a:pt x="1663637" y="622124"/>
                  <a:pt x="1116902" y="635385"/>
                </a:cubicBezTo>
                <a:cubicBezTo>
                  <a:pt x="1253046" y="605041"/>
                  <a:pt x="1399477" y="573684"/>
                  <a:pt x="1555052" y="542010"/>
                </a:cubicBezTo>
                <a:cubicBezTo>
                  <a:pt x="2041970" y="521908"/>
                  <a:pt x="2521414" y="516840"/>
                  <a:pt x="2993390" y="526807"/>
                </a:cubicBezTo>
                <a:close/>
                <a:moveTo>
                  <a:pt x="2719515" y="651285"/>
                </a:moveTo>
                <a:cubicBezTo>
                  <a:pt x="2828989" y="654959"/>
                  <a:pt x="2937891" y="659311"/>
                  <a:pt x="3046222" y="664335"/>
                </a:cubicBezTo>
                <a:cubicBezTo>
                  <a:pt x="2837307" y="710452"/>
                  <a:pt x="2624626" y="759863"/>
                  <a:pt x="2408174" y="812568"/>
                </a:cubicBezTo>
                <a:lnTo>
                  <a:pt x="2340928" y="829039"/>
                </a:lnTo>
                <a:cubicBezTo>
                  <a:pt x="2386775" y="806024"/>
                  <a:pt x="2432895" y="783384"/>
                  <a:pt x="2479294" y="761130"/>
                </a:cubicBezTo>
                <a:cubicBezTo>
                  <a:pt x="2558288" y="723375"/>
                  <a:pt x="2638298" y="686760"/>
                  <a:pt x="2719324" y="651285"/>
                </a:cubicBezTo>
                <a:close/>
                <a:moveTo>
                  <a:pt x="2410524" y="821817"/>
                </a:moveTo>
                <a:cubicBezTo>
                  <a:pt x="2638616" y="766280"/>
                  <a:pt x="2862625" y="714360"/>
                  <a:pt x="3082544" y="666045"/>
                </a:cubicBezTo>
                <a:cubicBezTo>
                  <a:pt x="3448387" y="683573"/>
                  <a:pt x="3806889" y="708912"/>
                  <a:pt x="4158044" y="742062"/>
                </a:cubicBezTo>
                <a:cubicBezTo>
                  <a:pt x="4001408" y="812296"/>
                  <a:pt x="3847973" y="887445"/>
                  <a:pt x="3697732" y="967517"/>
                </a:cubicBezTo>
                <a:cubicBezTo>
                  <a:pt x="3568319" y="997797"/>
                  <a:pt x="3439541" y="1029072"/>
                  <a:pt x="3311398" y="1061335"/>
                </a:cubicBezTo>
                <a:cubicBezTo>
                  <a:pt x="3079623" y="1119824"/>
                  <a:pt x="2859488" y="1178952"/>
                  <a:pt x="2650998" y="1238708"/>
                </a:cubicBezTo>
                <a:cubicBezTo>
                  <a:pt x="2376253" y="1191704"/>
                  <a:pt x="2099393" y="1150446"/>
                  <a:pt x="1820418" y="1114927"/>
                </a:cubicBezTo>
                <a:cubicBezTo>
                  <a:pt x="1976419" y="1021299"/>
                  <a:pt x="2137048" y="932504"/>
                  <a:pt x="2302320" y="848550"/>
                </a:cubicBezTo>
                <a:cubicBezTo>
                  <a:pt x="2338051" y="839510"/>
                  <a:pt x="2374056" y="830603"/>
                  <a:pt x="2410333" y="821817"/>
                </a:cubicBezTo>
                <a:close/>
                <a:moveTo>
                  <a:pt x="1805432" y="1112710"/>
                </a:moveTo>
                <a:cubicBezTo>
                  <a:pt x="1687278" y="1097760"/>
                  <a:pt x="1568749" y="1083804"/>
                  <a:pt x="1449832" y="1070837"/>
                </a:cubicBezTo>
                <a:cubicBezTo>
                  <a:pt x="1699514" y="1002295"/>
                  <a:pt x="1972691" y="930205"/>
                  <a:pt x="2262188" y="858242"/>
                </a:cubicBezTo>
                <a:cubicBezTo>
                  <a:pt x="2105768" y="938611"/>
                  <a:pt x="1953451" y="1023434"/>
                  <a:pt x="1805242" y="1112710"/>
                </a:cubicBezTo>
                <a:close/>
                <a:moveTo>
                  <a:pt x="1792351" y="1120692"/>
                </a:moveTo>
                <a:cubicBezTo>
                  <a:pt x="1749425" y="1146664"/>
                  <a:pt x="1706753" y="1172827"/>
                  <a:pt x="1664526" y="1199559"/>
                </a:cubicBezTo>
                <a:cubicBezTo>
                  <a:pt x="1527620" y="1180980"/>
                  <a:pt x="1390034" y="1163850"/>
                  <a:pt x="1251776" y="1148184"/>
                </a:cubicBezTo>
                <a:cubicBezTo>
                  <a:pt x="1232726" y="1146031"/>
                  <a:pt x="1213676" y="1144067"/>
                  <a:pt x="1194626" y="1141850"/>
                </a:cubicBezTo>
                <a:cubicBezTo>
                  <a:pt x="1268794" y="1120736"/>
                  <a:pt x="1345546" y="1099324"/>
                  <a:pt x="1424877" y="1077615"/>
                </a:cubicBezTo>
                <a:lnTo>
                  <a:pt x="1430401" y="1078185"/>
                </a:lnTo>
                <a:cubicBezTo>
                  <a:pt x="1551349" y="1091279"/>
                  <a:pt x="1671936" y="1105444"/>
                  <a:pt x="1792161" y="1120692"/>
                </a:cubicBezTo>
                <a:close/>
                <a:moveTo>
                  <a:pt x="1666748" y="1209378"/>
                </a:moveTo>
                <a:cubicBezTo>
                  <a:pt x="1905000" y="1241686"/>
                  <a:pt x="2141239" y="1278320"/>
                  <a:pt x="2375472" y="1319287"/>
                </a:cubicBezTo>
                <a:cubicBezTo>
                  <a:pt x="2289029" y="1345215"/>
                  <a:pt x="2204974" y="1370997"/>
                  <a:pt x="2123313" y="1396634"/>
                </a:cubicBezTo>
                <a:cubicBezTo>
                  <a:pt x="1925574" y="1362255"/>
                  <a:pt x="1725613" y="1330898"/>
                  <a:pt x="1523429" y="1302563"/>
                </a:cubicBezTo>
                <a:cubicBezTo>
                  <a:pt x="1570419" y="1271142"/>
                  <a:pt x="1618126" y="1240102"/>
                  <a:pt x="1666558" y="1209442"/>
                </a:cubicBezTo>
                <a:close/>
                <a:moveTo>
                  <a:pt x="2103565" y="1402842"/>
                </a:moveTo>
                <a:cubicBezTo>
                  <a:pt x="1982280" y="1440851"/>
                  <a:pt x="1866500" y="1478435"/>
                  <a:pt x="1756220" y="1515601"/>
                </a:cubicBezTo>
                <a:cubicBezTo>
                  <a:pt x="1610424" y="1491320"/>
                  <a:pt x="1463186" y="1468515"/>
                  <a:pt x="1314514" y="1447186"/>
                </a:cubicBezTo>
                <a:cubicBezTo>
                  <a:pt x="1379157" y="1400733"/>
                  <a:pt x="1444771" y="1355186"/>
                  <a:pt x="1511364" y="1310545"/>
                </a:cubicBezTo>
                <a:cubicBezTo>
                  <a:pt x="1710754" y="1338291"/>
                  <a:pt x="1908092" y="1369078"/>
                  <a:pt x="2103374" y="1402906"/>
                </a:cubicBezTo>
                <a:close/>
                <a:moveTo>
                  <a:pt x="1736789" y="1522126"/>
                </a:moveTo>
                <a:cubicBezTo>
                  <a:pt x="1584389" y="1573393"/>
                  <a:pt x="1442930" y="1622767"/>
                  <a:pt x="1312418" y="1670233"/>
                </a:cubicBezTo>
                <a:cubicBezTo>
                  <a:pt x="1247775" y="1645318"/>
                  <a:pt x="1181926" y="1620486"/>
                  <a:pt x="1114870" y="1595736"/>
                </a:cubicBezTo>
                <a:cubicBezTo>
                  <a:pt x="1176509" y="1548054"/>
                  <a:pt x="1239266" y="1501202"/>
                  <a:pt x="1303147" y="1455168"/>
                </a:cubicBezTo>
                <a:cubicBezTo>
                  <a:pt x="1449280" y="1476072"/>
                  <a:pt x="1593831" y="1498390"/>
                  <a:pt x="1736789" y="1522126"/>
                </a:cubicBezTo>
                <a:close/>
                <a:moveTo>
                  <a:pt x="1298639" y="1675174"/>
                </a:moveTo>
                <a:cubicBezTo>
                  <a:pt x="1206989" y="1708451"/>
                  <a:pt x="1121175" y="1740403"/>
                  <a:pt x="1041210" y="1771019"/>
                </a:cubicBezTo>
                <a:cubicBezTo>
                  <a:pt x="1009206" y="1758052"/>
                  <a:pt x="976865" y="1745047"/>
                  <a:pt x="944181" y="1731997"/>
                </a:cubicBezTo>
                <a:cubicBezTo>
                  <a:pt x="992905" y="1691708"/>
                  <a:pt x="1043857" y="1650830"/>
                  <a:pt x="1097026" y="1609356"/>
                </a:cubicBezTo>
                <a:lnTo>
                  <a:pt x="1105853" y="1602578"/>
                </a:lnTo>
                <a:cubicBezTo>
                  <a:pt x="1171340" y="1626732"/>
                  <a:pt x="1235647" y="1650931"/>
                  <a:pt x="1298766" y="1675174"/>
                </a:cubicBezTo>
                <a:close/>
                <a:moveTo>
                  <a:pt x="1847152" y="2137613"/>
                </a:moveTo>
                <a:cubicBezTo>
                  <a:pt x="1760157" y="2175919"/>
                  <a:pt x="1680655" y="2211983"/>
                  <a:pt x="1608646" y="2245810"/>
                </a:cubicBezTo>
                <a:lnTo>
                  <a:pt x="1591691" y="2253729"/>
                </a:lnTo>
                <a:cubicBezTo>
                  <a:pt x="1366838" y="2136409"/>
                  <a:pt x="1101154" y="2008130"/>
                  <a:pt x="795719" y="1877317"/>
                </a:cubicBezTo>
                <a:lnTo>
                  <a:pt x="861060" y="1851281"/>
                </a:lnTo>
                <a:cubicBezTo>
                  <a:pt x="917194" y="1829154"/>
                  <a:pt x="977328" y="1805797"/>
                  <a:pt x="1041464" y="1781218"/>
                </a:cubicBezTo>
                <a:cubicBezTo>
                  <a:pt x="1341374" y="1903099"/>
                  <a:pt x="1610614" y="2023903"/>
                  <a:pt x="1847279" y="2137549"/>
                </a:cubicBezTo>
                <a:close/>
                <a:moveTo>
                  <a:pt x="1054164" y="1776277"/>
                </a:moveTo>
                <a:cubicBezTo>
                  <a:pt x="1134345" y="1745743"/>
                  <a:pt x="1220362" y="1713772"/>
                  <a:pt x="1312228" y="1680369"/>
                </a:cubicBezTo>
                <a:cubicBezTo>
                  <a:pt x="1609725" y="1794711"/>
                  <a:pt x="1881505" y="1909054"/>
                  <a:pt x="2125917" y="2018836"/>
                </a:cubicBezTo>
                <a:cubicBezTo>
                  <a:pt x="2030413" y="2058156"/>
                  <a:pt x="1941341" y="2096056"/>
                  <a:pt x="1858709" y="2132545"/>
                </a:cubicBezTo>
                <a:cubicBezTo>
                  <a:pt x="1622616" y="2018899"/>
                  <a:pt x="1353884" y="1898221"/>
                  <a:pt x="1054164" y="1776277"/>
                </a:cubicBezTo>
                <a:close/>
                <a:moveTo>
                  <a:pt x="2609914" y="1688540"/>
                </a:moveTo>
                <a:cubicBezTo>
                  <a:pt x="2690730" y="1706025"/>
                  <a:pt x="2770969" y="1723996"/>
                  <a:pt x="2850642" y="1742449"/>
                </a:cubicBezTo>
                <a:cubicBezTo>
                  <a:pt x="2652141" y="1812132"/>
                  <a:pt x="2469642" y="1881118"/>
                  <a:pt x="2303272" y="1946999"/>
                </a:cubicBezTo>
                <a:cubicBezTo>
                  <a:pt x="2394966" y="1865154"/>
                  <a:pt x="2497201" y="1778178"/>
                  <a:pt x="2610231" y="1688540"/>
                </a:cubicBezTo>
                <a:close/>
                <a:moveTo>
                  <a:pt x="2619566" y="1680939"/>
                </a:moveTo>
                <a:cubicBezTo>
                  <a:pt x="2661431" y="1647871"/>
                  <a:pt x="2704700" y="1614531"/>
                  <a:pt x="2749360" y="1580913"/>
                </a:cubicBezTo>
                <a:cubicBezTo>
                  <a:pt x="2768029" y="1566850"/>
                  <a:pt x="2786888" y="1552976"/>
                  <a:pt x="2805748" y="1539103"/>
                </a:cubicBezTo>
                <a:cubicBezTo>
                  <a:pt x="2935288" y="1567021"/>
                  <a:pt x="3063685" y="1596325"/>
                  <a:pt x="3190939" y="1627030"/>
                </a:cubicBezTo>
                <a:cubicBezTo>
                  <a:pt x="3078925" y="1663645"/>
                  <a:pt x="2971083" y="1700152"/>
                  <a:pt x="2867406" y="1736558"/>
                </a:cubicBezTo>
                <a:cubicBezTo>
                  <a:pt x="2785663" y="1717509"/>
                  <a:pt x="2703151" y="1698974"/>
                  <a:pt x="2619883" y="1680939"/>
                </a:cubicBezTo>
                <a:close/>
                <a:moveTo>
                  <a:pt x="3208592" y="1631274"/>
                </a:moveTo>
                <a:cubicBezTo>
                  <a:pt x="3454127" y="1690694"/>
                  <a:pt x="3695275" y="1755100"/>
                  <a:pt x="3932047" y="1824485"/>
                </a:cubicBezTo>
                <a:cubicBezTo>
                  <a:pt x="3869608" y="1874529"/>
                  <a:pt x="3811060" y="1923307"/>
                  <a:pt x="3756406" y="1970818"/>
                </a:cubicBezTo>
                <a:cubicBezTo>
                  <a:pt x="3474847" y="1887408"/>
                  <a:pt x="3184271" y="1810675"/>
                  <a:pt x="2884678" y="1740612"/>
                </a:cubicBezTo>
                <a:cubicBezTo>
                  <a:pt x="2988647" y="1704333"/>
                  <a:pt x="3096724" y="1667889"/>
                  <a:pt x="3208909" y="1631274"/>
                </a:cubicBezTo>
                <a:close/>
                <a:moveTo>
                  <a:pt x="3225864" y="1625636"/>
                </a:moveTo>
                <a:cubicBezTo>
                  <a:pt x="3306553" y="1599493"/>
                  <a:pt x="3389357" y="1573355"/>
                  <a:pt x="3474276" y="1547212"/>
                </a:cubicBezTo>
                <a:cubicBezTo>
                  <a:pt x="3680098" y="1596876"/>
                  <a:pt x="3883704" y="1649791"/>
                  <a:pt x="4085082" y="1705961"/>
                </a:cubicBezTo>
                <a:cubicBezTo>
                  <a:pt x="4035127" y="1743545"/>
                  <a:pt x="3987248" y="1780648"/>
                  <a:pt x="3941445" y="1817263"/>
                </a:cubicBezTo>
                <a:cubicBezTo>
                  <a:pt x="3707467" y="1748512"/>
                  <a:pt x="3469050" y="1684632"/>
                  <a:pt x="3226181" y="1625636"/>
                </a:cubicBezTo>
                <a:close/>
                <a:moveTo>
                  <a:pt x="4096322" y="1709192"/>
                </a:moveTo>
                <a:cubicBezTo>
                  <a:pt x="4217353" y="1743229"/>
                  <a:pt x="4337577" y="1778494"/>
                  <a:pt x="4457002" y="1814983"/>
                </a:cubicBezTo>
                <a:cubicBezTo>
                  <a:pt x="4370134" y="1842602"/>
                  <a:pt x="4286168" y="1870051"/>
                  <a:pt x="4205097" y="1897335"/>
                </a:cubicBezTo>
                <a:cubicBezTo>
                  <a:pt x="4121487" y="1871064"/>
                  <a:pt x="4037222" y="1845408"/>
                  <a:pt x="3952304" y="1820367"/>
                </a:cubicBezTo>
                <a:cubicBezTo>
                  <a:pt x="3998278" y="1783961"/>
                  <a:pt x="4046391" y="1746903"/>
                  <a:pt x="4096639" y="1709192"/>
                </a:cubicBezTo>
                <a:close/>
                <a:moveTo>
                  <a:pt x="4472940" y="1819924"/>
                </a:moveTo>
                <a:cubicBezTo>
                  <a:pt x="4596003" y="1857679"/>
                  <a:pt x="4718177" y="1896720"/>
                  <a:pt x="4839462" y="1937054"/>
                </a:cubicBezTo>
                <a:cubicBezTo>
                  <a:pt x="4929588" y="1967080"/>
                  <a:pt x="5017624" y="1997297"/>
                  <a:pt x="5103559" y="2027704"/>
                </a:cubicBezTo>
                <a:cubicBezTo>
                  <a:pt x="5051533" y="2073777"/>
                  <a:pt x="5004308" y="2117468"/>
                  <a:pt x="4961890" y="2158771"/>
                </a:cubicBezTo>
                <a:cubicBezTo>
                  <a:pt x="4833239" y="2110075"/>
                  <a:pt x="4698683" y="2061513"/>
                  <a:pt x="4558221" y="2013071"/>
                </a:cubicBezTo>
                <a:cubicBezTo>
                  <a:pt x="4446969" y="1975062"/>
                  <a:pt x="4334510" y="1938112"/>
                  <a:pt x="4220845" y="1902212"/>
                </a:cubicBezTo>
                <a:cubicBezTo>
                  <a:pt x="4302081" y="1875017"/>
                  <a:pt x="4386218" y="1847588"/>
                  <a:pt x="4473258" y="1819924"/>
                </a:cubicBezTo>
                <a:close/>
                <a:moveTo>
                  <a:pt x="4842891" y="1928185"/>
                </a:moveTo>
                <a:cubicBezTo>
                  <a:pt x="4725842" y="1889163"/>
                  <a:pt x="4608049" y="1851388"/>
                  <a:pt x="4489514" y="1814856"/>
                </a:cubicBezTo>
                <a:cubicBezTo>
                  <a:pt x="4574432" y="1787996"/>
                  <a:pt x="4662024" y="1761156"/>
                  <a:pt x="4752277" y="1734341"/>
                </a:cubicBezTo>
                <a:cubicBezTo>
                  <a:pt x="4907852" y="1780160"/>
                  <a:pt x="5062220" y="1827887"/>
                  <a:pt x="5215382" y="1877507"/>
                </a:cubicBezTo>
                <a:lnTo>
                  <a:pt x="5263261" y="1893154"/>
                </a:lnTo>
                <a:cubicBezTo>
                  <a:pt x="5208861" y="1937117"/>
                  <a:pt x="5158486" y="1979668"/>
                  <a:pt x="5112131" y="2020799"/>
                </a:cubicBezTo>
                <a:cubicBezTo>
                  <a:pt x="5024628" y="1989677"/>
                  <a:pt x="4934985" y="1958801"/>
                  <a:pt x="4843209" y="1928185"/>
                </a:cubicBezTo>
                <a:close/>
                <a:moveTo>
                  <a:pt x="5273294" y="1896511"/>
                </a:moveTo>
                <a:cubicBezTo>
                  <a:pt x="5421884" y="1945371"/>
                  <a:pt x="5565267" y="1994637"/>
                  <a:pt x="5703443" y="2044301"/>
                </a:cubicBezTo>
                <a:cubicBezTo>
                  <a:pt x="5605272" y="2074791"/>
                  <a:pt x="5511800" y="2104799"/>
                  <a:pt x="5423027" y="2134319"/>
                </a:cubicBezTo>
                <a:cubicBezTo>
                  <a:pt x="5325663" y="2097533"/>
                  <a:pt x="5225288" y="2060753"/>
                  <a:pt x="5121910" y="2023967"/>
                </a:cubicBezTo>
                <a:cubicBezTo>
                  <a:pt x="5172285" y="1980086"/>
                  <a:pt x="5222856" y="1937643"/>
                  <a:pt x="5273612" y="1896638"/>
                </a:cubicBezTo>
                <a:close/>
                <a:moveTo>
                  <a:pt x="5718302" y="2049686"/>
                </a:moveTo>
                <a:cubicBezTo>
                  <a:pt x="5929376" y="2125703"/>
                  <a:pt x="6127941" y="2201720"/>
                  <a:pt x="6313488" y="2277104"/>
                </a:cubicBezTo>
                <a:lnTo>
                  <a:pt x="6307138" y="2283059"/>
                </a:lnTo>
                <a:cubicBezTo>
                  <a:pt x="6247003" y="2337982"/>
                  <a:pt x="6195251" y="2388216"/>
                  <a:pt x="6151499" y="2432560"/>
                </a:cubicBezTo>
                <a:cubicBezTo>
                  <a:pt x="5936361" y="2337538"/>
                  <a:pt x="5697919" y="2238652"/>
                  <a:pt x="5437315" y="2139703"/>
                </a:cubicBezTo>
                <a:cubicBezTo>
                  <a:pt x="5526297" y="2110310"/>
                  <a:pt x="5620068" y="2080346"/>
                  <a:pt x="5718620" y="2049813"/>
                </a:cubicBezTo>
                <a:close/>
                <a:moveTo>
                  <a:pt x="5733415" y="2044998"/>
                </a:moveTo>
                <a:cubicBezTo>
                  <a:pt x="5934139" y="1983171"/>
                  <a:pt x="6153912" y="1919950"/>
                  <a:pt x="6390958" y="1858122"/>
                </a:cubicBezTo>
                <a:cubicBezTo>
                  <a:pt x="6618224" y="1799000"/>
                  <a:pt x="6847904" y="1744331"/>
                  <a:pt x="7080123" y="1694115"/>
                </a:cubicBezTo>
                <a:cubicBezTo>
                  <a:pt x="6739383" y="1913298"/>
                  <a:pt x="6487224" y="2119622"/>
                  <a:pt x="6321298" y="2270009"/>
                </a:cubicBezTo>
                <a:cubicBezTo>
                  <a:pt x="6138228" y="2195829"/>
                  <a:pt x="5942140" y="2120319"/>
                  <a:pt x="5733733" y="2045125"/>
                </a:cubicBezTo>
                <a:close/>
                <a:moveTo>
                  <a:pt x="6388227" y="1849000"/>
                </a:moveTo>
                <a:cubicBezTo>
                  <a:pt x="6146864" y="1912221"/>
                  <a:pt x="5922899" y="1976456"/>
                  <a:pt x="5718874" y="2039804"/>
                </a:cubicBezTo>
                <a:cubicBezTo>
                  <a:pt x="5578793" y="1989379"/>
                  <a:pt x="5433314" y="1939290"/>
                  <a:pt x="5282438" y="1889543"/>
                </a:cubicBezTo>
                <a:cubicBezTo>
                  <a:pt x="5495290" y="1719442"/>
                  <a:pt x="5719756" y="1564328"/>
                  <a:pt x="5954205" y="1425331"/>
                </a:cubicBezTo>
                <a:cubicBezTo>
                  <a:pt x="6303410" y="1348807"/>
                  <a:pt x="6658357" y="1281975"/>
                  <a:pt x="7019036" y="1224835"/>
                </a:cubicBezTo>
                <a:cubicBezTo>
                  <a:pt x="7219125" y="1275938"/>
                  <a:pt x="7414895" y="1330290"/>
                  <a:pt x="7606475" y="1387892"/>
                </a:cubicBezTo>
                <a:cubicBezTo>
                  <a:pt x="7533195" y="1426452"/>
                  <a:pt x="7460996" y="1466000"/>
                  <a:pt x="7389876" y="1506543"/>
                </a:cubicBezTo>
                <a:cubicBezTo>
                  <a:pt x="7288276" y="1564442"/>
                  <a:pt x="7193026" y="1622342"/>
                  <a:pt x="7103301" y="1679418"/>
                </a:cubicBezTo>
                <a:cubicBezTo>
                  <a:pt x="6862636" y="1731028"/>
                  <a:pt x="6624383" y="1787597"/>
                  <a:pt x="6388545" y="1849127"/>
                </a:cubicBezTo>
                <a:close/>
                <a:moveTo>
                  <a:pt x="7394829" y="1514524"/>
                </a:moveTo>
                <a:cubicBezTo>
                  <a:pt x="7468426" y="1472588"/>
                  <a:pt x="7543229" y="1431710"/>
                  <a:pt x="7619175" y="1391883"/>
                </a:cubicBezTo>
                <a:cubicBezTo>
                  <a:pt x="7733158" y="1426262"/>
                  <a:pt x="7845552" y="1461756"/>
                  <a:pt x="7956423" y="1498371"/>
                </a:cubicBezTo>
                <a:lnTo>
                  <a:pt x="7999349" y="1512624"/>
                </a:lnTo>
                <a:cubicBezTo>
                  <a:pt x="7706995" y="1559077"/>
                  <a:pt x="7417182" y="1612796"/>
                  <a:pt x="7129844" y="1673781"/>
                </a:cubicBezTo>
                <a:cubicBezTo>
                  <a:pt x="7226364" y="1612967"/>
                  <a:pt x="7316089" y="1559755"/>
                  <a:pt x="7395146" y="1514651"/>
                </a:cubicBezTo>
                <a:close/>
                <a:moveTo>
                  <a:pt x="7959979" y="1489565"/>
                </a:moveTo>
                <a:cubicBezTo>
                  <a:pt x="7851902" y="1453837"/>
                  <a:pt x="7742238" y="1419186"/>
                  <a:pt x="7631049" y="1385612"/>
                </a:cubicBezTo>
                <a:cubicBezTo>
                  <a:pt x="7713663" y="1342535"/>
                  <a:pt x="7797610" y="1300726"/>
                  <a:pt x="7882890" y="1260183"/>
                </a:cubicBezTo>
                <a:cubicBezTo>
                  <a:pt x="7995285" y="1294391"/>
                  <a:pt x="8106601" y="1329720"/>
                  <a:pt x="8216773" y="1366164"/>
                </a:cubicBezTo>
                <a:cubicBezTo>
                  <a:pt x="8297228" y="1392814"/>
                  <a:pt x="8375777" y="1419648"/>
                  <a:pt x="8452421" y="1446679"/>
                </a:cubicBezTo>
                <a:cubicBezTo>
                  <a:pt x="8307642" y="1465810"/>
                  <a:pt x="8163307" y="1486715"/>
                  <a:pt x="8019415" y="1509393"/>
                </a:cubicBezTo>
                <a:close/>
                <a:moveTo>
                  <a:pt x="8472297" y="1453711"/>
                </a:moveTo>
                <a:cubicBezTo>
                  <a:pt x="8609965" y="1502406"/>
                  <a:pt x="8741346" y="1551266"/>
                  <a:pt x="8866505" y="1600297"/>
                </a:cubicBezTo>
                <a:cubicBezTo>
                  <a:pt x="8790686" y="1646750"/>
                  <a:pt x="8717217" y="1693102"/>
                  <a:pt x="8646096" y="1739345"/>
                </a:cubicBezTo>
                <a:cubicBezTo>
                  <a:pt x="8461248" y="1665482"/>
                  <a:pt x="8258746" y="1590288"/>
                  <a:pt x="8038846" y="1515918"/>
                </a:cubicBezTo>
                <a:cubicBezTo>
                  <a:pt x="8182991" y="1493537"/>
                  <a:pt x="8327645" y="1472842"/>
                  <a:pt x="8472805" y="1453837"/>
                </a:cubicBezTo>
                <a:close/>
                <a:moveTo>
                  <a:pt x="8493061" y="1450987"/>
                </a:moveTo>
                <a:cubicBezTo>
                  <a:pt x="8621332" y="1434345"/>
                  <a:pt x="8749919" y="1419123"/>
                  <a:pt x="8878760" y="1405313"/>
                </a:cubicBezTo>
                <a:cubicBezTo>
                  <a:pt x="8945753" y="1428796"/>
                  <a:pt x="9011412" y="1452336"/>
                  <a:pt x="9075610" y="1475946"/>
                </a:cubicBezTo>
                <a:cubicBezTo>
                  <a:pt x="9033955" y="1500018"/>
                  <a:pt x="8992235" y="1524514"/>
                  <a:pt x="8950452" y="1549429"/>
                </a:cubicBezTo>
                <a:cubicBezTo>
                  <a:pt x="8925623" y="1564252"/>
                  <a:pt x="8901049" y="1579031"/>
                  <a:pt x="8876602" y="1593772"/>
                </a:cubicBezTo>
                <a:cubicBezTo>
                  <a:pt x="8755126" y="1546388"/>
                  <a:pt x="8627428" y="1498833"/>
                  <a:pt x="8493570" y="1451113"/>
                </a:cubicBezTo>
                <a:close/>
                <a:moveTo>
                  <a:pt x="8900732" y="1402969"/>
                </a:moveTo>
                <a:lnTo>
                  <a:pt x="8926132" y="1400308"/>
                </a:lnTo>
                <a:cubicBezTo>
                  <a:pt x="9040050" y="1388399"/>
                  <a:pt x="9154160" y="1377649"/>
                  <a:pt x="9268523" y="1368064"/>
                </a:cubicBezTo>
                <a:cubicBezTo>
                  <a:pt x="9208198" y="1401050"/>
                  <a:pt x="9147683" y="1434915"/>
                  <a:pt x="9086913" y="1469674"/>
                </a:cubicBezTo>
                <a:cubicBezTo>
                  <a:pt x="9026271" y="1447502"/>
                  <a:pt x="8964358" y="1425312"/>
                  <a:pt x="8901240" y="1403096"/>
                </a:cubicBezTo>
                <a:close/>
                <a:moveTo>
                  <a:pt x="8955659" y="1557474"/>
                </a:moveTo>
                <a:cubicBezTo>
                  <a:pt x="8999665" y="1531166"/>
                  <a:pt x="9043543" y="1505402"/>
                  <a:pt x="9087421" y="1480190"/>
                </a:cubicBezTo>
                <a:cubicBezTo>
                  <a:pt x="9344850" y="1574768"/>
                  <a:pt x="9580944" y="1669473"/>
                  <a:pt x="9794557" y="1760947"/>
                </a:cubicBezTo>
                <a:cubicBezTo>
                  <a:pt x="9735058" y="1766477"/>
                  <a:pt x="9675812" y="1772286"/>
                  <a:pt x="9616757" y="1778368"/>
                </a:cubicBezTo>
                <a:cubicBezTo>
                  <a:pt x="9538271" y="1786559"/>
                  <a:pt x="9459976" y="1795281"/>
                  <a:pt x="9381807" y="1804530"/>
                </a:cubicBezTo>
                <a:cubicBezTo>
                  <a:pt x="9230233" y="1737255"/>
                  <a:pt x="9065514" y="1668079"/>
                  <a:pt x="8887968" y="1598460"/>
                </a:cubicBezTo>
                <a:cubicBezTo>
                  <a:pt x="8910510" y="1584859"/>
                  <a:pt x="8933244" y="1571240"/>
                  <a:pt x="8956167" y="1557601"/>
                </a:cubicBezTo>
                <a:close/>
                <a:moveTo>
                  <a:pt x="8875776" y="1215016"/>
                </a:moveTo>
                <a:cubicBezTo>
                  <a:pt x="9020746" y="1260456"/>
                  <a:pt x="9160891" y="1306408"/>
                  <a:pt x="9296209" y="1352861"/>
                </a:cubicBezTo>
                <a:lnTo>
                  <a:pt x="9288907" y="1356788"/>
                </a:lnTo>
                <a:cubicBezTo>
                  <a:pt x="9167241" y="1366924"/>
                  <a:pt x="9045829" y="1378282"/>
                  <a:pt x="8924607" y="1390870"/>
                </a:cubicBezTo>
                <a:lnTo>
                  <a:pt x="8880157" y="1395684"/>
                </a:lnTo>
                <a:cubicBezTo>
                  <a:pt x="8759254" y="1353241"/>
                  <a:pt x="8634095" y="1311159"/>
                  <a:pt x="8504745" y="1269432"/>
                </a:cubicBezTo>
                <a:cubicBezTo>
                  <a:pt x="8378127" y="1228680"/>
                  <a:pt x="8250555" y="1189380"/>
                  <a:pt x="8121968" y="1151542"/>
                </a:cubicBezTo>
                <a:cubicBezTo>
                  <a:pt x="8192262" y="1121008"/>
                  <a:pt x="8263383" y="1091298"/>
                  <a:pt x="8335328" y="1062412"/>
                </a:cubicBezTo>
                <a:lnTo>
                  <a:pt x="8354886" y="1060638"/>
                </a:lnTo>
                <a:cubicBezTo>
                  <a:pt x="8530272" y="1109751"/>
                  <a:pt x="8704072" y="1161253"/>
                  <a:pt x="8876284" y="1215143"/>
                </a:cubicBezTo>
                <a:close/>
                <a:moveTo>
                  <a:pt x="8382064" y="1058484"/>
                </a:moveTo>
                <a:cubicBezTo>
                  <a:pt x="8942197" y="1009789"/>
                  <a:pt x="9510205" y="984070"/>
                  <a:pt x="10085959" y="981327"/>
                </a:cubicBezTo>
                <a:cubicBezTo>
                  <a:pt x="9820021" y="1088555"/>
                  <a:pt x="9560306" y="1210582"/>
                  <a:pt x="9308084" y="1346843"/>
                </a:cubicBezTo>
                <a:cubicBezTo>
                  <a:pt x="9170289" y="1299586"/>
                  <a:pt x="9027414" y="1252708"/>
                  <a:pt x="8879522" y="1206211"/>
                </a:cubicBezTo>
                <a:cubicBezTo>
                  <a:pt x="8715184" y="1154646"/>
                  <a:pt x="8549386" y="1105406"/>
                  <a:pt x="8382064" y="1058484"/>
                </a:cubicBezTo>
                <a:close/>
                <a:moveTo>
                  <a:pt x="8345615" y="1048285"/>
                </a:moveTo>
                <a:cubicBezTo>
                  <a:pt x="8010525" y="954784"/>
                  <a:pt x="7670420" y="870487"/>
                  <a:pt x="7325296" y="795401"/>
                </a:cubicBezTo>
                <a:lnTo>
                  <a:pt x="7329995" y="793817"/>
                </a:lnTo>
                <a:cubicBezTo>
                  <a:pt x="8026718" y="726035"/>
                  <a:pt x="8740077" y="690497"/>
                  <a:pt x="9465691" y="686886"/>
                </a:cubicBezTo>
                <a:cubicBezTo>
                  <a:pt x="9415844" y="699556"/>
                  <a:pt x="9366250" y="712498"/>
                  <a:pt x="9316910" y="725718"/>
                </a:cubicBezTo>
                <a:cubicBezTo>
                  <a:pt x="8987155" y="814348"/>
                  <a:pt x="8662860" y="922052"/>
                  <a:pt x="8345678" y="1048285"/>
                </a:cubicBezTo>
                <a:close/>
                <a:moveTo>
                  <a:pt x="6496812" y="492409"/>
                </a:moveTo>
                <a:cubicBezTo>
                  <a:pt x="6401308" y="523112"/>
                  <a:pt x="6306966" y="554975"/>
                  <a:pt x="6213793" y="588001"/>
                </a:cubicBezTo>
                <a:cubicBezTo>
                  <a:pt x="6141149" y="576682"/>
                  <a:pt x="6068397" y="565745"/>
                  <a:pt x="5995543" y="555186"/>
                </a:cubicBezTo>
                <a:cubicBezTo>
                  <a:pt x="6162040" y="532719"/>
                  <a:pt x="6329128" y="511793"/>
                  <a:pt x="6496812" y="492409"/>
                </a:cubicBezTo>
                <a:close/>
                <a:moveTo>
                  <a:pt x="6194997" y="594652"/>
                </a:moveTo>
                <a:cubicBezTo>
                  <a:pt x="6126753" y="619020"/>
                  <a:pt x="6059024" y="644082"/>
                  <a:pt x="5991797" y="669846"/>
                </a:cubicBezTo>
                <a:cubicBezTo>
                  <a:pt x="5863317" y="649023"/>
                  <a:pt x="5734196" y="629472"/>
                  <a:pt x="5604447" y="611186"/>
                </a:cubicBezTo>
                <a:cubicBezTo>
                  <a:pt x="5722982" y="593279"/>
                  <a:pt x="5841810" y="576175"/>
                  <a:pt x="5960936" y="559874"/>
                </a:cubicBezTo>
                <a:cubicBezTo>
                  <a:pt x="6039250" y="570939"/>
                  <a:pt x="6117273" y="582532"/>
                  <a:pt x="6194997" y="594652"/>
                </a:cubicBezTo>
                <a:close/>
                <a:moveTo>
                  <a:pt x="5083747" y="454400"/>
                </a:moveTo>
                <a:cubicBezTo>
                  <a:pt x="5366785" y="482020"/>
                  <a:pt x="5647881" y="515531"/>
                  <a:pt x="5927027" y="554933"/>
                </a:cubicBezTo>
                <a:cubicBezTo>
                  <a:pt x="5808199" y="571361"/>
                  <a:pt x="5689664" y="588571"/>
                  <a:pt x="5571427" y="606561"/>
                </a:cubicBezTo>
                <a:cubicBezTo>
                  <a:pt x="5351291" y="576028"/>
                  <a:pt x="5129422" y="549211"/>
                  <a:pt x="4905820" y="526110"/>
                </a:cubicBezTo>
                <a:cubicBezTo>
                  <a:pt x="4857134" y="521126"/>
                  <a:pt x="4808455" y="516291"/>
                  <a:pt x="4759770" y="511603"/>
                </a:cubicBezTo>
                <a:cubicBezTo>
                  <a:pt x="4826953" y="487911"/>
                  <a:pt x="4894688" y="465043"/>
                  <a:pt x="4962970" y="442998"/>
                </a:cubicBezTo>
                <a:cubicBezTo>
                  <a:pt x="5002721" y="446735"/>
                  <a:pt x="5043170" y="450409"/>
                  <a:pt x="5083556" y="454400"/>
                </a:cubicBezTo>
                <a:close/>
                <a:moveTo>
                  <a:pt x="4635564" y="375089"/>
                </a:moveTo>
                <a:cubicBezTo>
                  <a:pt x="4967586" y="325128"/>
                  <a:pt x="5282965" y="286676"/>
                  <a:pt x="5581714" y="259733"/>
                </a:cubicBezTo>
                <a:cubicBezTo>
                  <a:pt x="5371230" y="309946"/>
                  <a:pt x="5164392" y="367888"/>
                  <a:pt x="4961192" y="433559"/>
                </a:cubicBezTo>
                <a:cubicBezTo>
                  <a:pt x="4807268" y="419496"/>
                  <a:pt x="4652753" y="407185"/>
                  <a:pt x="4497642" y="396627"/>
                </a:cubicBezTo>
                <a:cubicBezTo>
                  <a:pt x="4544041" y="389152"/>
                  <a:pt x="4590015" y="381973"/>
                  <a:pt x="4635564" y="375089"/>
                </a:cubicBezTo>
                <a:close/>
                <a:moveTo>
                  <a:pt x="4455668" y="403089"/>
                </a:moveTo>
                <a:cubicBezTo>
                  <a:pt x="4617085" y="413731"/>
                  <a:pt x="4777950" y="426295"/>
                  <a:pt x="4938268" y="440780"/>
                </a:cubicBezTo>
                <a:cubicBezTo>
                  <a:pt x="4870533" y="462910"/>
                  <a:pt x="4803312" y="485821"/>
                  <a:pt x="4736592" y="509513"/>
                </a:cubicBezTo>
                <a:cubicBezTo>
                  <a:pt x="4529754" y="490044"/>
                  <a:pt x="4321601" y="473869"/>
                  <a:pt x="4112133" y="460988"/>
                </a:cubicBezTo>
                <a:cubicBezTo>
                  <a:pt x="4228548" y="440421"/>
                  <a:pt x="4343146" y="421122"/>
                  <a:pt x="4455922" y="403089"/>
                </a:cubicBezTo>
                <a:close/>
                <a:moveTo>
                  <a:pt x="3476879" y="361659"/>
                </a:moveTo>
                <a:cubicBezTo>
                  <a:pt x="3790823" y="367614"/>
                  <a:pt x="4102970" y="380516"/>
                  <a:pt x="4413314" y="400365"/>
                </a:cubicBezTo>
                <a:cubicBezTo>
                  <a:pt x="4301300" y="418525"/>
                  <a:pt x="4187615" y="437909"/>
                  <a:pt x="4072255" y="458518"/>
                </a:cubicBezTo>
                <a:cubicBezTo>
                  <a:pt x="3812331" y="443018"/>
                  <a:pt x="3550603" y="432461"/>
                  <a:pt x="3287078" y="426844"/>
                </a:cubicBezTo>
                <a:cubicBezTo>
                  <a:pt x="3349771" y="404461"/>
                  <a:pt x="3413043" y="382733"/>
                  <a:pt x="3476879" y="361659"/>
                </a:cubicBezTo>
                <a:close/>
                <a:moveTo>
                  <a:pt x="2518029" y="364890"/>
                </a:moveTo>
                <a:cubicBezTo>
                  <a:pt x="2829604" y="356992"/>
                  <a:pt x="3139631" y="355725"/>
                  <a:pt x="3448114" y="361089"/>
                </a:cubicBezTo>
                <a:cubicBezTo>
                  <a:pt x="3385039" y="382205"/>
                  <a:pt x="3322384" y="403891"/>
                  <a:pt x="3260154" y="426147"/>
                </a:cubicBezTo>
                <a:cubicBezTo>
                  <a:pt x="2880932" y="418630"/>
                  <a:pt x="2498427" y="421438"/>
                  <a:pt x="2112645" y="434572"/>
                </a:cubicBezTo>
                <a:cubicBezTo>
                  <a:pt x="2243709" y="410923"/>
                  <a:pt x="2378856" y="387695"/>
                  <a:pt x="2518093" y="364890"/>
                </a:cubicBezTo>
                <a:close/>
                <a:moveTo>
                  <a:pt x="1588961" y="408220"/>
                </a:moveTo>
                <a:cubicBezTo>
                  <a:pt x="1876444" y="388751"/>
                  <a:pt x="2162893" y="374941"/>
                  <a:pt x="2448306" y="366790"/>
                </a:cubicBezTo>
                <a:cubicBezTo>
                  <a:pt x="2310511" y="389680"/>
                  <a:pt x="2176799" y="413118"/>
                  <a:pt x="2047177" y="437106"/>
                </a:cubicBezTo>
                <a:cubicBezTo>
                  <a:pt x="1839405" y="444624"/>
                  <a:pt x="1630851" y="455181"/>
                  <a:pt x="1421511" y="468780"/>
                </a:cubicBezTo>
                <a:cubicBezTo>
                  <a:pt x="1477474" y="447918"/>
                  <a:pt x="1533290" y="427731"/>
                  <a:pt x="1588961" y="408220"/>
                </a:cubicBezTo>
                <a:close/>
                <a:moveTo>
                  <a:pt x="1390714" y="480373"/>
                </a:moveTo>
                <a:cubicBezTo>
                  <a:pt x="1588370" y="467196"/>
                  <a:pt x="1785366" y="456638"/>
                  <a:pt x="1981708" y="448699"/>
                </a:cubicBezTo>
                <a:cubicBezTo>
                  <a:pt x="1832610" y="476529"/>
                  <a:pt x="1689907" y="504339"/>
                  <a:pt x="1553591" y="532128"/>
                </a:cubicBezTo>
                <a:cubicBezTo>
                  <a:pt x="1440771" y="536900"/>
                  <a:pt x="1327766" y="542411"/>
                  <a:pt x="1214565" y="548662"/>
                </a:cubicBezTo>
                <a:cubicBezTo>
                  <a:pt x="1273448" y="524970"/>
                  <a:pt x="1332167" y="502207"/>
                  <a:pt x="1390714" y="480373"/>
                </a:cubicBezTo>
                <a:close/>
                <a:moveTo>
                  <a:pt x="1186879" y="559747"/>
                </a:moveTo>
                <a:cubicBezTo>
                  <a:pt x="1289749" y="554004"/>
                  <a:pt x="1392320" y="548894"/>
                  <a:pt x="1494600" y="544417"/>
                </a:cubicBezTo>
                <a:cubicBezTo>
                  <a:pt x="1342835" y="576091"/>
                  <a:pt x="1200087" y="606688"/>
                  <a:pt x="1067562" y="636462"/>
                </a:cubicBezTo>
                <a:lnTo>
                  <a:pt x="997395" y="638362"/>
                </a:lnTo>
                <a:cubicBezTo>
                  <a:pt x="1058564" y="612263"/>
                  <a:pt x="1121728" y="586058"/>
                  <a:pt x="1186879" y="559747"/>
                </a:cubicBezTo>
                <a:close/>
                <a:moveTo>
                  <a:pt x="973709" y="648434"/>
                </a:moveTo>
                <a:lnTo>
                  <a:pt x="1019683" y="647167"/>
                </a:lnTo>
                <a:cubicBezTo>
                  <a:pt x="988651" y="654218"/>
                  <a:pt x="958196" y="661186"/>
                  <a:pt x="928306" y="668072"/>
                </a:cubicBezTo>
                <a:close/>
                <a:moveTo>
                  <a:pt x="881189" y="688787"/>
                </a:moveTo>
                <a:cubicBezTo>
                  <a:pt x="941134" y="674806"/>
                  <a:pt x="1003662" y="660489"/>
                  <a:pt x="1068769" y="645837"/>
                </a:cubicBezTo>
                <a:cubicBezTo>
                  <a:pt x="1624648" y="631605"/>
                  <a:pt x="2167528" y="633167"/>
                  <a:pt x="2697417" y="650525"/>
                </a:cubicBezTo>
                <a:cubicBezTo>
                  <a:pt x="2622442" y="683592"/>
                  <a:pt x="2548211" y="717629"/>
                  <a:pt x="2474722" y="752641"/>
                </a:cubicBezTo>
                <a:cubicBezTo>
                  <a:pt x="2415458" y="780894"/>
                  <a:pt x="2356866" y="809762"/>
                  <a:pt x="2298954" y="839238"/>
                </a:cubicBezTo>
                <a:cubicBezTo>
                  <a:pt x="1985899" y="916649"/>
                  <a:pt x="1691196" y="994440"/>
                  <a:pt x="1423988" y="1067986"/>
                </a:cubicBezTo>
                <a:cubicBezTo>
                  <a:pt x="1046461" y="1027399"/>
                  <a:pt x="665461" y="997372"/>
                  <a:pt x="280988" y="977906"/>
                </a:cubicBezTo>
                <a:cubicBezTo>
                  <a:pt x="431864" y="898975"/>
                  <a:pt x="636842" y="796795"/>
                  <a:pt x="881189" y="688850"/>
                </a:cubicBezTo>
                <a:close/>
                <a:moveTo>
                  <a:pt x="138557" y="1054493"/>
                </a:moveTo>
                <a:cubicBezTo>
                  <a:pt x="174181" y="1034855"/>
                  <a:pt x="216345" y="1012050"/>
                  <a:pt x="264541" y="986648"/>
                </a:cubicBezTo>
                <a:cubicBezTo>
                  <a:pt x="645839" y="1005779"/>
                  <a:pt x="1023938" y="1035235"/>
                  <a:pt x="1398842" y="1075018"/>
                </a:cubicBezTo>
                <a:cubicBezTo>
                  <a:pt x="1319848" y="1096809"/>
                  <a:pt x="1243374" y="1118202"/>
                  <a:pt x="1169416" y="1139189"/>
                </a:cubicBezTo>
                <a:cubicBezTo>
                  <a:pt x="829354" y="1102194"/>
                  <a:pt x="485732" y="1073960"/>
                  <a:pt x="138557" y="1054493"/>
                </a:cubicBezTo>
                <a:close/>
                <a:moveTo>
                  <a:pt x="1170178" y="1148818"/>
                </a:moveTo>
                <a:cubicBezTo>
                  <a:pt x="1196975" y="1151732"/>
                  <a:pt x="1223772" y="1154583"/>
                  <a:pt x="1250442" y="1157623"/>
                </a:cubicBezTo>
                <a:cubicBezTo>
                  <a:pt x="1384891" y="1172827"/>
                  <a:pt x="1518749" y="1189443"/>
                  <a:pt x="1652016" y="1207478"/>
                </a:cubicBezTo>
                <a:cubicBezTo>
                  <a:pt x="1603883" y="1238056"/>
                  <a:pt x="1556239" y="1269096"/>
                  <a:pt x="1509078" y="1300599"/>
                </a:cubicBezTo>
                <a:cubicBezTo>
                  <a:pt x="1397908" y="1285142"/>
                  <a:pt x="1286085" y="1270617"/>
                  <a:pt x="1173607" y="1257016"/>
                </a:cubicBezTo>
                <a:cubicBezTo>
                  <a:pt x="1083393" y="1246038"/>
                  <a:pt x="992740" y="1235731"/>
                  <a:pt x="901637" y="1226102"/>
                </a:cubicBezTo>
                <a:cubicBezTo>
                  <a:pt x="986409" y="1201333"/>
                  <a:pt x="1076135" y="1175487"/>
                  <a:pt x="1170178" y="1148818"/>
                </a:cubicBezTo>
                <a:close/>
                <a:moveTo>
                  <a:pt x="877697" y="1233070"/>
                </a:moveTo>
                <a:cubicBezTo>
                  <a:pt x="976249" y="1243459"/>
                  <a:pt x="1074357" y="1254564"/>
                  <a:pt x="1172020" y="1266391"/>
                </a:cubicBezTo>
                <a:cubicBezTo>
                  <a:pt x="1280941" y="1279568"/>
                  <a:pt x="1389272" y="1293631"/>
                  <a:pt x="1497013" y="1308581"/>
                </a:cubicBezTo>
                <a:cubicBezTo>
                  <a:pt x="1430547" y="1353178"/>
                  <a:pt x="1365104" y="1398725"/>
                  <a:pt x="1300671" y="1445222"/>
                </a:cubicBezTo>
                <a:cubicBezTo>
                  <a:pt x="1236110" y="1436055"/>
                  <a:pt x="1171258" y="1427105"/>
                  <a:pt x="1106107" y="1418362"/>
                </a:cubicBezTo>
                <a:cubicBezTo>
                  <a:pt x="906336" y="1391756"/>
                  <a:pt x="703771" y="1367792"/>
                  <a:pt x="498412" y="1346463"/>
                </a:cubicBezTo>
                <a:cubicBezTo>
                  <a:pt x="609283" y="1312635"/>
                  <a:pt x="736664" y="1274436"/>
                  <a:pt x="877697" y="1233070"/>
                </a:cubicBezTo>
                <a:close/>
                <a:moveTo>
                  <a:pt x="475107" y="1353431"/>
                </a:moveTo>
                <a:cubicBezTo>
                  <a:pt x="687705" y="1375349"/>
                  <a:pt x="897426" y="1400036"/>
                  <a:pt x="1104265" y="1427485"/>
                </a:cubicBezTo>
                <a:cubicBezTo>
                  <a:pt x="1166324" y="1435929"/>
                  <a:pt x="1228109" y="1444379"/>
                  <a:pt x="1289622" y="1452824"/>
                </a:cubicBezTo>
                <a:cubicBezTo>
                  <a:pt x="1226801" y="1498181"/>
                  <a:pt x="1165035" y="1544380"/>
                  <a:pt x="1104329" y="1591429"/>
                </a:cubicBezTo>
                <a:cubicBezTo>
                  <a:pt x="994264" y="1550842"/>
                  <a:pt x="881189" y="1510489"/>
                  <a:pt x="765112" y="1470371"/>
                </a:cubicBezTo>
                <a:cubicBezTo>
                  <a:pt x="658476" y="1433547"/>
                  <a:pt x="551223" y="1397648"/>
                  <a:pt x="443357" y="1362680"/>
                </a:cubicBezTo>
                <a:close/>
                <a:moveTo>
                  <a:pt x="384112" y="1344182"/>
                </a:moveTo>
                <a:lnTo>
                  <a:pt x="450914" y="1351151"/>
                </a:lnTo>
                <a:lnTo>
                  <a:pt x="427736" y="1358246"/>
                </a:lnTo>
                <a:close/>
                <a:moveTo>
                  <a:pt x="388874" y="1523330"/>
                </a:moveTo>
                <a:cubicBezTo>
                  <a:pt x="316908" y="1497991"/>
                  <a:pt x="244496" y="1472968"/>
                  <a:pt x="171641" y="1448263"/>
                </a:cubicBezTo>
                <a:cubicBezTo>
                  <a:pt x="238760" y="1427041"/>
                  <a:pt x="324866" y="1399992"/>
                  <a:pt x="427609" y="1368318"/>
                </a:cubicBezTo>
                <a:cubicBezTo>
                  <a:pt x="539539" y="1404426"/>
                  <a:pt x="650856" y="1441548"/>
                  <a:pt x="761556" y="1479683"/>
                </a:cubicBezTo>
                <a:cubicBezTo>
                  <a:pt x="875856" y="1519168"/>
                  <a:pt x="987152" y="1558868"/>
                  <a:pt x="1095439" y="1598777"/>
                </a:cubicBezTo>
                <a:lnTo>
                  <a:pt x="1090930" y="1602198"/>
                </a:lnTo>
                <a:cubicBezTo>
                  <a:pt x="1036365" y="1644767"/>
                  <a:pt x="984104" y="1686704"/>
                  <a:pt x="934149" y="1728006"/>
                </a:cubicBezTo>
                <a:cubicBezTo>
                  <a:pt x="761892" y="1659591"/>
                  <a:pt x="580136" y="1591429"/>
                  <a:pt x="388874" y="1523520"/>
                </a:cubicBezTo>
                <a:close/>
                <a:moveTo>
                  <a:pt x="935927" y="1738712"/>
                </a:moveTo>
                <a:cubicBezTo>
                  <a:pt x="967042" y="1751046"/>
                  <a:pt x="997839" y="1763399"/>
                  <a:pt x="1028319" y="1775770"/>
                </a:cubicBezTo>
                <a:cubicBezTo>
                  <a:pt x="967785" y="1798956"/>
                  <a:pt x="910762" y="1821172"/>
                  <a:pt x="857250" y="1842412"/>
                </a:cubicBezTo>
                <a:cubicBezTo>
                  <a:pt x="832104" y="1852377"/>
                  <a:pt x="807485" y="1862196"/>
                  <a:pt x="783400" y="1871869"/>
                </a:cubicBezTo>
                <a:lnTo>
                  <a:pt x="781431" y="1870982"/>
                </a:lnTo>
                <a:cubicBezTo>
                  <a:pt x="830072" y="1828077"/>
                  <a:pt x="881571" y="1784050"/>
                  <a:pt x="935927" y="1738902"/>
                </a:cubicBezTo>
                <a:close/>
                <a:moveTo>
                  <a:pt x="593852" y="2030872"/>
                </a:moveTo>
                <a:cubicBezTo>
                  <a:pt x="566885" y="2018962"/>
                  <a:pt x="539496" y="2006990"/>
                  <a:pt x="511683" y="1994954"/>
                </a:cubicBezTo>
                <a:cubicBezTo>
                  <a:pt x="578569" y="1966403"/>
                  <a:pt x="651637" y="1935932"/>
                  <a:pt x="730885" y="1903543"/>
                </a:cubicBezTo>
                <a:cubicBezTo>
                  <a:pt x="682415" y="1947208"/>
                  <a:pt x="636734" y="1989651"/>
                  <a:pt x="593852" y="2030872"/>
                </a:cubicBezTo>
                <a:close/>
                <a:moveTo>
                  <a:pt x="603123" y="2034989"/>
                </a:moveTo>
                <a:cubicBezTo>
                  <a:pt x="650621" y="1989588"/>
                  <a:pt x="701866" y="1942267"/>
                  <a:pt x="756857" y="1893027"/>
                </a:cubicBezTo>
                <a:lnTo>
                  <a:pt x="783273" y="1882321"/>
                </a:lnTo>
                <a:cubicBezTo>
                  <a:pt x="1089279" y="2013261"/>
                  <a:pt x="1355471" y="2141160"/>
                  <a:pt x="1581214" y="2258797"/>
                </a:cubicBezTo>
                <a:cubicBezTo>
                  <a:pt x="1484122" y="2304534"/>
                  <a:pt x="1396683" y="2347484"/>
                  <a:pt x="1319086" y="2386886"/>
                </a:cubicBezTo>
                <a:cubicBezTo>
                  <a:pt x="1124014" y="2280525"/>
                  <a:pt x="885889" y="2160164"/>
                  <a:pt x="603314" y="2034989"/>
                </a:cubicBezTo>
                <a:close/>
                <a:moveTo>
                  <a:pt x="1675067" y="2594223"/>
                </a:moveTo>
                <a:cubicBezTo>
                  <a:pt x="1654620" y="2581553"/>
                  <a:pt x="1633455" y="2568567"/>
                  <a:pt x="1611567" y="2555264"/>
                </a:cubicBezTo>
                <a:cubicBezTo>
                  <a:pt x="1530795" y="2506233"/>
                  <a:pt x="1436561" y="2451437"/>
                  <a:pt x="1328865" y="2392397"/>
                </a:cubicBezTo>
                <a:cubicBezTo>
                  <a:pt x="1406652" y="2352995"/>
                  <a:pt x="1494282" y="2310045"/>
                  <a:pt x="1591501" y="2264308"/>
                </a:cubicBezTo>
                <a:cubicBezTo>
                  <a:pt x="1680401" y="2310761"/>
                  <a:pt x="1762951" y="2355231"/>
                  <a:pt x="1839151" y="2397718"/>
                </a:cubicBezTo>
                <a:cubicBezTo>
                  <a:pt x="1760601" y="2486025"/>
                  <a:pt x="1706182" y="2553934"/>
                  <a:pt x="1675067" y="2594223"/>
                </a:cubicBezTo>
                <a:close/>
                <a:moveTo>
                  <a:pt x="1845564" y="2390497"/>
                </a:moveTo>
                <a:cubicBezTo>
                  <a:pt x="1770761" y="2348687"/>
                  <a:pt x="1689716" y="2304914"/>
                  <a:pt x="1602423" y="2259177"/>
                </a:cubicBezTo>
                <a:lnTo>
                  <a:pt x="1612773" y="2254362"/>
                </a:lnTo>
                <a:cubicBezTo>
                  <a:pt x="1686687" y="2219775"/>
                  <a:pt x="1768602" y="2182653"/>
                  <a:pt x="1858518" y="2142997"/>
                </a:cubicBezTo>
                <a:cubicBezTo>
                  <a:pt x="1910080" y="2167747"/>
                  <a:pt x="1960055" y="2192174"/>
                  <a:pt x="2008442" y="2216290"/>
                </a:cubicBezTo>
                <a:cubicBezTo>
                  <a:pt x="1946021" y="2280145"/>
                  <a:pt x="1891792" y="2338678"/>
                  <a:pt x="1845564" y="2390497"/>
                </a:cubicBezTo>
                <a:close/>
                <a:moveTo>
                  <a:pt x="2015427" y="2209195"/>
                </a:moveTo>
                <a:cubicBezTo>
                  <a:pt x="1968437" y="2185839"/>
                  <a:pt x="1919967" y="2162084"/>
                  <a:pt x="1870012" y="2137929"/>
                </a:cubicBezTo>
                <a:cubicBezTo>
                  <a:pt x="1952733" y="2101694"/>
                  <a:pt x="2042033" y="2063686"/>
                  <a:pt x="2137918" y="2023903"/>
                </a:cubicBezTo>
                <a:lnTo>
                  <a:pt x="2183321" y="2044428"/>
                </a:lnTo>
                <a:cubicBezTo>
                  <a:pt x="2122043" y="2102455"/>
                  <a:pt x="2066099" y="2157504"/>
                  <a:pt x="2015427" y="2209195"/>
                </a:cubicBezTo>
                <a:close/>
                <a:moveTo>
                  <a:pt x="2637727" y="2541644"/>
                </a:moveTo>
                <a:lnTo>
                  <a:pt x="2576132" y="2506486"/>
                </a:lnTo>
                <a:cubicBezTo>
                  <a:pt x="2425129" y="2420840"/>
                  <a:pt x="2240598" y="2321321"/>
                  <a:pt x="2024253" y="2213440"/>
                </a:cubicBezTo>
                <a:cubicBezTo>
                  <a:pt x="2073974" y="2162762"/>
                  <a:pt x="2130171" y="2107649"/>
                  <a:pt x="2192719" y="2048736"/>
                </a:cubicBezTo>
                <a:cubicBezTo>
                  <a:pt x="2474087" y="2176761"/>
                  <a:pt x="2717419" y="2297692"/>
                  <a:pt x="2919984" y="2404307"/>
                </a:cubicBezTo>
                <a:cubicBezTo>
                  <a:pt x="2804160" y="2457899"/>
                  <a:pt x="2709736" y="2504713"/>
                  <a:pt x="2637536" y="2541644"/>
                </a:cubicBezTo>
                <a:close/>
                <a:moveTo>
                  <a:pt x="3194558" y="2542531"/>
                </a:moveTo>
                <a:cubicBezTo>
                  <a:pt x="3166745" y="2526948"/>
                  <a:pt x="3138170" y="2511111"/>
                  <a:pt x="3108833" y="2495020"/>
                </a:cubicBezTo>
                <a:cubicBezTo>
                  <a:pt x="3056681" y="2466470"/>
                  <a:pt x="3000864" y="2436443"/>
                  <a:pt x="2941384" y="2404940"/>
                </a:cubicBezTo>
                <a:cubicBezTo>
                  <a:pt x="2999378" y="2378163"/>
                  <a:pt x="3062459" y="2349783"/>
                  <a:pt x="3130614" y="2319801"/>
                </a:cubicBezTo>
                <a:cubicBezTo>
                  <a:pt x="3253804" y="2265955"/>
                  <a:pt x="3401759" y="2204001"/>
                  <a:pt x="3573018" y="2137106"/>
                </a:cubicBezTo>
                <a:cubicBezTo>
                  <a:pt x="3388678" y="2312199"/>
                  <a:pt x="3264662" y="2455175"/>
                  <a:pt x="3194114" y="2542531"/>
                </a:cubicBezTo>
                <a:close/>
                <a:moveTo>
                  <a:pt x="3591751" y="2119749"/>
                </a:moveTo>
                <a:cubicBezTo>
                  <a:pt x="3411029" y="2190001"/>
                  <a:pt x="3255582" y="2254933"/>
                  <a:pt x="3127121" y="2311122"/>
                </a:cubicBezTo>
                <a:cubicBezTo>
                  <a:pt x="3056128" y="2342162"/>
                  <a:pt x="2990704" y="2371575"/>
                  <a:pt x="2930843" y="2399365"/>
                </a:cubicBezTo>
                <a:cubicBezTo>
                  <a:pt x="2727643" y="2292371"/>
                  <a:pt x="2483231" y="2170680"/>
                  <a:pt x="2200212" y="2041831"/>
                </a:cubicBezTo>
                <a:cubicBezTo>
                  <a:pt x="2226837" y="2016916"/>
                  <a:pt x="2254587" y="1991406"/>
                  <a:pt x="2283460" y="1965307"/>
                </a:cubicBezTo>
                <a:cubicBezTo>
                  <a:pt x="2459800" y="1894991"/>
                  <a:pt x="2655062" y="1821317"/>
                  <a:pt x="2868486" y="1746440"/>
                </a:cubicBezTo>
                <a:cubicBezTo>
                  <a:pt x="3170663" y="1816839"/>
                  <a:pt x="3463970" y="1894085"/>
                  <a:pt x="3748405" y="1978166"/>
                </a:cubicBezTo>
                <a:cubicBezTo>
                  <a:pt x="3692144" y="2027153"/>
                  <a:pt x="3639865" y="2074347"/>
                  <a:pt x="3591560" y="2119749"/>
                </a:cubicBezTo>
                <a:close/>
                <a:moveTo>
                  <a:pt x="3614928" y="2110753"/>
                </a:moveTo>
                <a:cubicBezTo>
                  <a:pt x="3659207" y="2069621"/>
                  <a:pt x="3707276" y="2026501"/>
                  <a:pt x="3759137" y="1981397"/>
                </a:cubicBezTo>
                <a:cubicBezTo>
                  <a:pt x="3796430" y="1992502"/>
                  <a:pt x="3833514" y="2003695"/>
                  <a:pt x="3870389" y="2014971"/>
                </a:cubicBezTo>
                <a:cubicBezTo>
                  <a:pt x="3780346" y="2047659"/>
                  <a:pt x="3695129" y="2079586"/>
                  <a:pt x="3614738" y="2110753"/>
                </a:cubicBezTo>
                <a:close/>
                <a:moveTo>
                  <a:pt x="3885184" y="2009397"/>
                </a:moveTo>
                <a:cubicBezTo>
                  <a:pt x="3846195" y="1997487"/>
                  <a:pt x="3807016" y="1985660"/>
                  <a:pt x="3767646" y="1973922"/>
                </a:cubicBezTo>
                <a:cubicBezTo>
                  <a:pt x="3822129" y="1926791"/>
                  <a:pt x="3880822" y="1878014"/>
                  <a:pt x="3943731" y="1827589"/>
                </a:cubicBezTo>
                <a:cubicBezTo>
                  <a:pt x="4026535" y="1851997"/>
                  <a:pt x="4108748" y="1876981"/>
                  <a:pt x="4190365" y="1902529"/>
                </a:cubicBezTo>
                <a:cubicBezTo>
                  <a:pt x="4083260" y="1938764"/>
                  <a:pt x="3981469" y="1974429"/>
                  <a:pt x="3884994" y="2009523"/>
                </a:cubicBezTo>
                <a:close/>
                <a:moveTo>
                  <a:pt x="4296728" y="2142427"/>
                </a:moveTo>
                <a:cubicBezTo>
                  <a:pt x="4166851" y="2097957"/>
                  <a:pt x="4034708" y="2055089"/>
                  <a:pt x="3900297" y="2013831"/>
                </a:cubicBezTo>
                <a:cubicBezTo>
                  <a:pt x="3996900" y="1978863"/>
                  <a:pt x="4098715" y="1943281"/>
                  <a:pt x="4205732" y="1907090"/>
                </a:cubicBezTo>
                <a:cubicBezTo>
                  <a:pt x="4323252" y="1944041"/>
                  <a:pt x="4439666" y="1982221"/>
                  <a:pt x="4554982" y="2021623"/>
                </a:cubicBezTo>
                <a:cubicBezTo>
                  <a:pt x="4694047" y="2069260"/>
                  <a:pt x="4827397" y="2117278"/>
                  <a:pt x="4955032" y="2165676"/>
                </a:cubicBezTo>
                <a:cubicBezTo>
                  <a:pt x="4935982" y="2183983"/>
                  <a:pt x="4918266" y="2201657"/>
                  <a:pt x="4901375" y="2218698"/>
                </a:cubicBezTo>
                <a:cubicBezTo>
                  <a:pt x="4863910" y="2256453"/>
                  <a:pt x="4829747" y="2292352"/>
                  <a:pt x="4798886" y="2326389"/>
                </a:cubicBezTo>
                <a:cubicBezTo>
                  <a:pt x="4642377" y="2265366"/>
                  <a:pt x="4474928" y="2204172"/>
                  <a:pt x="4296537" y="2142807"/>
                </a:cubicBezTo>
                <a:close/>
                <a:moveTo>
                  <a:pt x="4772978" y="2368515"/>
                </a:moveTo>
                <a:cubicBezTo>
                  <a:pt x="4782058" y="2358379"/>
                  <a:pt x="4791393" y="2347990"/>
                  <a:pt x="4801108" y="2337348"/>
                </a:cubicBezTo>
                <a:lnTo>
                  <a:pt x="4827016" y="2347547"/>
                </a:lnTo>
                <a:cubicBezTo>
                  <a:pt x="4808220" y="2355085"/>
                  <a:pt x="4790123" y="2362054"/>
                  <a:pt x="4772660" y="2369212"/>
                </a:cubicBezTo>
                <a:close/>
                <a:moveTo>
                  <a:pt x="4840097" y="2342479"/>
                </a:moveTo>
                <a:lnTo>
                  <a:pt x="4807966" y="2329810"/>
                </a:lnTo>
                <a:cubicBezTo>
                  <a:pt x="4838192" y="2296913"/>
                  <a:pt x="4871447" y="2262110"/>
                  <a:pt x="4907725" y="2225412"/>
                </a:cubicBezTo>
                <a:cubicBezTo>
                  <a:pt x="4926775" y="2206408"/>
                  <a:pt x="4945444" y="2187911"/>
                  <a:pt x="4964494" y="2169413"/>
                </a:cubicBezTo>
                <a:cubicBezTo>
                  <a:pt x="5021599" y="2191078"/>
                  <a:pt x="5077505" y="2212743"/>
                  <a:pt x="5132197" y="2234408"/>
                </a:cubicBezTo>
                <a:cubicBezTo>
                  <a:pt x="5023993" y="2273240"/>
                  <a:pt x="4926457" y="2309538"/>
                  <a:pt x="4839780" y="2342859"/>
                </a:cubicBezTo>
                <a:close/>
                <a:moveTo>
                  <a:pt x="4972050" y="2162128"/>
                </a:moveTo>
                <a:cubicBezTo>
                  <a:pt x="5018831" y="2117025"/>
                  <a:pt x="5066284" y="2073296"/>
                  <a:pt x="5114417" y="2030935"/>
                </a:cubicBezTo>
                <a:cubicBezTo>
                  <a:pt x="5215636" y="2066790"/>
                  <a:pt x="5313979" y="2102689"/>
                  <a:pt x="5409438" y="2138626"/>
                </a:cubicBezTo>
                <a:cubicBezTo>
                  <a:pt x="5315884" y="2169749"/>
                  <a:pt x="5228000" y="2199966"/>
                  <a:pt x="5145786" y="2229277"/>
                </a:cubicBezTo>
                <a:cubicBezTo>
                  <a:pt x="5088935" y="2207276"/>
                  <a:pt x="5030915" y="2185016"/>
                  <a:pt x="4971733" y="2162508"/>
                </a:cubicBezTo>
                <a:close/>
                <a:moveTo>
                  <a:pt x="5994400" y="2603662"/>
                </a:moveTo>
                <a:cubicBezTo>
                  <a:pt x="5757228" y="2487545"/>
                  <a:pt x="5478463" y="2361864"/>
                  <a:pt x="5159248" y="2234851"/>
                </a:cubicBezTo>
                <a:cubicBezTo>
                  <a:pt x="5241627" y="2205629"/>
                  <a:pt x="5329701" y="2175387"/>
                  <a:pt x="5423472" y="2144137"/>
                </a:cubicBezTo>
                <a:cubicBezTo>
                  <a:pt x="5686870" y="2243910"/>
                  <a:pt x="5927662" y="2343619"/>
                  <a:pt x="6144768" y="2439528"/>
                </a:cubicBezTo>
                <a:cubicBezTo>
                  <a:pt x="6071299" y="2514405"/>
                  <a:pt x="6021515" y="2571291"/>
                  <a:pt x="5994083" y="2604042"/>
                </a:cubicBezTo>
                <a:close/>
                <a:moveTo>
                  <a:pt x="6045200" y="2628621"/>
                </a:moveTo>
                <a:lnTo>
                  <a:pt x="6003354" y="2607969"/>
                </a:lnTo>
                <a:cubicBezTo>
                  <a:pt x="6031294" y="2574775"/>
                  <a:pt x="6081268" y="2517826"/>
                  <a:pt x="6154293" y="2443645"/>
                </a:cubicBezTo>
                <a:cubicBezTo>
                  <a:pt x="6209919" y="2468269"/>
                  <a:pt x="6263977" y="2492632"/>
                  <a:pt x="6316472" y="2516749"/>
                </a:cubicBezTo>
                <a:cubicBezTo>
                  <a:pt x="6196775" y="2562486"/>
                  <a:pt x="6105144" y="2601001"/>
                  <a:pt x="6044692" y="2628938"/>
                </a:cubicBezTo>
                <a:close/>
                <a:moveTo>
                  <a:pt x="6328474" y="2512378"/>
                </a:moveTo>
                <a:cubicBezTo>
                  <a:pt x="6274327" y="2487501"/>
                  <a:pt x="6218473" y="2462314"/>
                  <a:pt x="6160897" y="2436804"/>
                </a:cubicBezTo>
                <a:cubicBezTo>
                  <a:pt x="6204141" y="2393094"/>
                  <a:pt x="6255068" y="2343746"/>
                  <a:pt x="6314059" y="2289837"/>
                </a:cubicBezTo>
                <a:lnTo>
                  <a:pt x="6323584" y="2281222"/>
                </a:lnTo>
                <a:cubicBezTo>
                  <a:pt x="6427978" y="2323456"/>
                  <a:pt x="6528182" y="2365303"/>
                  <a:pt x="6624130" y="2406777"/>
                </a:cubicBezTo>
                <a:cubicBezTo>
                  <a:pt x="6512814" y="2444469"/>
                  <a:pt x="6413564" y="2480070"/>
                  <a:pt x="6328474" y="2512378"/>
                </a:cubicBezTo>
                <a:close/>
                <a:moveTo>
                  <a:pt x="8305864" y="1970691"/>
                </a:moveTo>
                <a:cubicBezTo>
                  <a:pt x="8093837" y="2011234"/>
                  <a:pt x="7885176" y="2055957"/>
                  <a:pt x="7680007" y="2104862"/>
                </a:cubicBezTo>
                <a:cubicBezTo>
                  <a:pt x="7269861" y="2202797"/>
                  <a:pt x="6915976" y="2308525"/>
                  <a:pt x="6637528" y="2402216"/>
                </a:cubicBezTo>
                <a:cubicBezTo>
                  <a:pt x="6539929" y="2359982"/>
                  <a:pt x="6437884" y="2317286"/>
                  <a:pt x="6331331" y="2274127"/>
                </a:cubicBezTo>
                <a:cubicBezTo>
                  <a:pt x="6592761" y="2037586"/>
                  <a:pt x="6869303" y="1840195"/>
                  <a:pt x="7107111" y="1688540"/>
                </a:cubicBezTo>
                <a:cubicBezTo>
                  <a:pt x="7407974" y="1624179"/>
                  <a:pt x="7711948" y="1567755"/>
                  <a:pt x="8019034" y="1519275"/>
                </a:cubicBezTo>
                <a:cubicBezTo>
                  <a:pt x="8243062" y="1594659"/>
                  <a:pt x="8448929" y="1670867"/>
                  <a:pt x="8636762" y="1745807"/>
                </a:cubicBezTo>
                <a:cubicBezTo>
                  <a:pt x="8519414" y="1822268"/>
                  <a:pt x="8408797" y="1897841"/>
                  <a:pt x="8305864" y="1970691"/>
                </a:cubicBezTo>
                <a:close/>
                <a:moveTo>
                  <a:pt x="8328407" y="1966447"/>
                </a:moveTo>
                <a:cubicBezTo>
                  <a:pt x="8427974" y="1896194"/>
                  <a:pt x="8534654" y="1823598"/>
                  <a:pt x="8647557" y="1750178"/>
                </a:cubicBezTo>
                <a:cubicBezTo>
                  <a:pt x="8744903" y="1789156"/>
                  <a:pt x="8837422" y="1827671"/>
                  <a:pt x="8924988" y="1865724"/>
                </a:cubicBezTo>
                <a:cubicBezTo>
                  <a:pt x="8723884" y="1895624"/>
                  <a:pt x="8525066" y="1929199"/>
                  <a:pt x="8328470" y="1966447"/>
                </a:cubicBezTo>
                <a:close/>
                <a:moveTo>
                  <a:pt x="8657336" y="1743843"/>
                </a:moveTo>
                <a:cubicBezTo>
                  <a:pt x="8728520" y="1697682"/>
                  <a:pt x="8802116" y="1651336"/>
                  <a:pt x="8878062" y="1604795"/>
                </a:cubicBezTo>
                <a:cubicBezTo>
                  <a:pt x="9052370" y="1673020"/>
                  <a:pt x="9214231" y="1740802"/>
                  <a:pt x="9363520" y="1806874"/>
                </a:cubicBezTo>
                <a:cubicBezTo>
                  <a:pt x="9222359" y="1823769"/>
                  <a:pt x="9082087" y="1842495"/>
                  <a:pt x="8942769" y="1863064"/>
                </a:cubicBezTo>
                <a:cubicBezTo>
                  <a:pt x="8852853" y="1823915"/>
                  <a:pt x="8757730" y="1784177"/>
                  <a:pt x="8657399" y="1743843"/>
                </a:cubicBezTo>
                <a:close/>
                <a:moveTo>
                  <a:pt x="9606534" y="2183286"/>
                </a:moveTo>
                <a:cubicBezTo>
                  <a:pt x="9433814" y="2090545"/>
                  <a:pt x="9218295" y="1983551"/>
                  <a:pt x="8959279" y="1870285"/>
                </a:cubicBezTo>
                <a:cubicBezTo>
                  <a:pt x="9098724" y="1849887"/>
                  <a:pt x="9239186" y="1831263"/>
                  <a:pt x="9380601" y="1814413"/>
                </a:cubicBezTo>
                <a:cubicBezTo>
                  <a:pt x="9546654" y="1888149"/>
                  <a:pt x="9696895" y="1959542"/>
                  <a:pt x="9831070" y="2026564"/>
                </a:cubicBezTo>
                <a:cubicBezTo>
                  <a:pt x="9751822" y="2079839"/>
                  <a:pt x="9676765" y="2132481"/>
                  <a:pt x="9606597" y="2183286"/>
                </a:cubicBezTo>
                <a:close/>
                <a:moveTo>
                  <a:pt x="9840150" y="2020483"/>
                </a:moveTo>
                <a:cubicBezTo>
                  <a:pt x="9708579" y="1954664"/>
                  <a:pt x="9561449" y="1884602"/>
                  <a:pt x="9399143" y="1812259"/>
                </a:cubicBezTo>
                <a:cubicBezTo>
                  <a:pt x="9471914" y="1803814"/>
                  <a:pt x="9544875" y="1795706"/>
                  <a:pt x="9618091" y="1787933"/>
                </a:cubicBezTo>
                <a:cubicBezTo>
                  <a:pt x="9682988" y="1781218"/>
                  <a:pt x="9748075" y="1774883"/>
                  <a:pt x="9813354" y="1768929"/>
                </a:cubicBezTo>
                <a:cubicBezTo>
                  <a:pt x="9899586" y="1805968"/>
                  <a:pt x="9982136" y="1842412"/>
                  <a:pt x="10061004" y="1878267"/>
                </a:cubicBezTo>
                <a:cubicBezTo>
                  <a:pt x="10014458" y="1907027"/>
                  <a:pt x="9968294" y="1936312"/>
                  <a:pt x="9922637" y="1966130"/>
                </a:cubicBezTo>
                <a:cubicBezTo>
                  <a:pt x="9894633" y="1984330"/>
                  <a:pt x="9867202" y="2002555"/>
                  <a:pt x="9840214" y="2020799"/>
                </a:cubicBezTo>
                <a:close/>
                <a:moveTo>
                  <a:pt x="10799000" y="2583200"/>
                </a:moveTo>
                <a:cubicBezTo>
                  <a:pt x="10700068" y="2512568"/>
                  <a:pt x="10507282" y="2382515"/>
                  <a:pt x="10220706" y="2222118"/>
                </a:cubicBezTo>
                <a:cubicBezTo>
                  <a:pt x="10115550" y="2163205"/>
                  <a:pt x="9991725" y="2096880"/>
                  <a:pt x="9849675" y="2025740"/>
                </a:cubicBezTo>
                <a:cubicBezTo>
                  <a:pt x="9875075" y="2008637"/>
                  <a:pt x="9901047" y="1991488"/>
                  <a:pt x="9927590" y="1974302"/>
                </a:cubicBezTo>
                <a:cubicBezTo>
                  <a:pt x="9975088" y="1943388"/>
                  <a:pt x="10022904" y="1913064"/>
                  <a:pt x="10070973" y="1883335"/>
                </a:cubicBezTo>
                <a:cubicBezTo>
                  <a:pt x="10326433" y="1999515"/>
                  <a:pt x="10541698" y="2107269"/>
                  <a:pt x="10714037" y="2198617"/>
                </a:cubicBezTo>
                <a:cubicBezTo>
                  <a:pt x="10832592" y="2261457"/>
                  <a:pt x="10937494" y="2319927"/>
                  <a:pt x="11028617" y="2372633"/>
                </a:cubicBezTo>
                <a:cubicBezTo>
                  <a:pt x="10922445" y="2461636"/>
                  <a:pt x="10845102" y="2536450"/>
                  <a:pt x="10799318" y="2583200"/>
                </a:cubicBezTo>
                <a:close/>
                <a:moveTo>
                  <a:pt x="11122850" y="2295792"/>
                </a:moveTo>
                <a:cubicBezTo>
                  <a:pt x="11092244" y="2319864"/>
                  <a:pt x="11063415" y="2343220"/>
                  <a:pt x="11036427" y="2365854"/>
                </a:cubicBezTo>
                <a:cubicBezTo>
                  <a:pt x="10944606" y="2312706"/>
                  <a:pt x="10838688" y="2253602"/>
                  <a:pt x="10718927" y="2190128"/>
                </a:cubicBezTo>
                <a:cubicBezTo>
                  <a:pt x="10547477" y="2099351"/>
                  <a:pt x="10334117" y="1992356"/>
                  <a:pt x="10080752" y="1877000"/>
                </a:cubicBezTo>
                <a:cubicBezTo>
                  <a:pt x="10157460" y="1829616"/>
                  <a:pt x="10234740" y="1783708"/>
                  <a:pt x="10312527" y="1739282"/>
                </a:cubicBezTo>
                <a:cubicBezTo>
                  <a:pt x="10694289" y="1899679"/>
                  <a:pt x="11007916" y="2049686"/>
                  <a:pt x="11246421" y="2171820"/>
                </a:cubicBezTo>
                <a:lnTo>
                  <a:pt x="11271313" y="2184490"/>
                </a:lnTo>
                <a:cubicBezTo>
                  <a:pt x="11216704" y="2223512"/>
                  <a:pt x="11167110" y="2261521"/>
                  <a:pt x="11123105" y="2295792"/>
                </a:cubicBezTo>
                <a:close/>
                <a:moveTo>
                  <a:pt x="12123103" y="1715400"/>
                </a:moveTo>
                <a:cubicBezTo>
                  <a:pt x="11825160" y="1836838"/>
                  <a:pt x="11542205" y="1992198"/>
                  <a:pt x="11280013" y="2178409"/>
                </a:cubicBezTo>
                <a:lnTo>
                  <a:pt x="11251120" y="2163585"/>
                </a:lnTo>
                <a:cubicBezTo>
                  <a:pt x="11013757" y="2042021"/>
                  <a:pt x="10702099" y="1892900"/>
                  <a:pt x="10322941" y="1733391"/>
                </a:cubicBezTo>
                <a:lnTo>
                  <a:pt x="10329291" y="1729843"/>
                </a:lnTo>
                <a:cubicBezTo>
                  <a:pt x="10926699" y="1694343"/>
                  <a:pt x="11525504" y="1689522"/>
                  <a:pt x="12123357" y="1715400"/>
                </a:cubicBezTo>
                <a:close/>
                <a:moveTo>
                  <a:pt x="10914253" y="1420833"/>
                </a:moveTo>
                <a:cubicBezTo>
                  <a:pt x="10716450" y="1510533"/>
                  <a:pt x="10519855" y="1610876"/>
                  <a:pt x="10326307" y="1720531"/>
                </a:cubicBezTo>
                <a:lnTo>
                  <a:pt x="10296652" y="1722368"/>
                </a:lnTo>
                <a:cubicBezTo>
                  <a:pt x="10016490" y="1605112"/>
                  <a:pt x="9700133" y="1482534"/>
                  <a:pt x="9350502" y="1361286"/>
                </a:cubicBezTo>
                <a:cubicBezTo>
                  <a:pt x="9956292" y="1313142"/>
                  <a:pt x="10564178" y="1296228"/>
                  <a:pt x="11171682" y="1310608"/>
                </a:cubicBezTo>
                <a:cubicBezTo>
                  <a:pt x="11085703" y="1345367"/>
                  <a:pt x="10999978" y="1382109"/>
                  <a:pt x="10914507" y="1420833"/>
                </a:cubicBezTo>
                <a:close/>
                <a:moveTo>
                  <a:pt x="11945620" y="1051579"/>
                </a:moveTo>
                <a:cubicBezTo>
                  <a:pt x="11690096" y="1119273"/>
                  <a:pt x="11439017" y="1202759"/>
                  <a:pt x="11193907" y="1301549"/>
                </a:cubicBezTo>
                <a:cubicBezTo>
                  <a:pt x="10571544" y="1286168"/>
                  <a:pt x="9948735" y="1303570"/>
                  <a:pt x="9328213" y="1353685"/>
                </a:cubicBezTo>
                <a:lnTo>
                  <a:pt x="9320594" y="1351087"/>
                </a:lnTo>
                <a:cubicBezTo>
                  <a:pt x="9577197" y="1212723"/>
                  <a:pt x="9841547" y="1089227"/>
                  <a:pt x="10112375" y="981200"/>
                </a:cubicBezTo>
                <a:cubicBezTo>
                  <a:pt x="10717847" y="979109"/>
                  <a:pt x="11330115" y="1002548"/>
                  <a:pt x="11945620" y="1051579"/>
                </a:cubicBezTo>
                <a:close/>
                <a:moveTo>
                  <a:pt x="10896219" y="720587"/>
                </a:moveTo>
                <a:cubicBezTo>
                  <a:pt x="10754106" y="754668"/>
                  <a:pt x="10610152" y="795591"/>
                  <a:pt x="10464419" y="843355"/>
                </a:cubicBezTo>
                <a:cubicBezTo>
                  <a:pt x="10347516" y="881744"/>
                  <a:pt x="10229469" y="924523"/>
                  <a:pt x="10110407" y="971698"/>
                </a:cubicBezTo>
                <a:cubicBezTo>
                  <a:pt x="9521761" y="973807"/>
                  <a:pt x="8940356" y="1000014"/>
                  <a:pt x="8366189" y="1050312"/>
                </a:cubicBezTo>
                <a:cubicBezTo>
                  <a:pt x="8677783" y="927133"/>
                  <a:pt x="8996172" y="821804"/>
                  <a:pt x="9319832" y="734841"/>
                </a:cubicBezTo>
                <a:cubicBezTo>
                  <a:pt x="9381299" y="718243"/>
                  <a:pt x="9443212" y="702216"/>
                  <a:pt x="9505506" y="686760"/>
                </a:cubicBezTo>
                <a:cubicBezTo>
                  <a:pt x="9964547" y="685030"/>
                  <a:pt x="10428160" y="696306"/>
                  <a:pt x="10896219" y="720587"/>
                </a:cubicBezTo>
                <a:close/>
                <a:moveTo>
                  <a:pt x="9504362" y="677258"/>
                </a:moveTo>
                <a:cubicBezTo>
                  <a:pt x="8778431" y="679665"/>
                  <a:pt x="8064818" y="714126"/>
                  <a:pt x="7367588" y="780704"/>
                </a:cubicBezTo>
                <a:cubicBezTo>
                  <a:pt x="7726553" y="658177"/>
                  <a:pt x="8092313" y="556334"/>
                  <a:pt x="8463026" y="475685"/>
                </a:cubicBezTo>
                <a:cubicBezTo>
                  <a:pt x="8738997" y="415125"/>
                  <a:pt x="9024239" y="363750"/>
                  <a:pt x="9318816" y="321560"/>
                </a:cubicBezTo>
                <a:cubicBezTo>
                  <a:pt x="10015093" y="316492"/>
                  <a:pt x="10714609" y="338115"/>
                  <a:pt x="11417363" y="386428"/>
                </a:cubicBezTo>
                <a:cubicBezTo>
                  <a:pt x="10745978" y="430771"/>
                  <a:pt x="10105581" y="528010"/>
                  <a:pt x="9504362" y="677258"/>
                </a:cubicBezTo>
                <a:close/>
              </a:path>
            </a:pathLst>
          </a:custGeom>
          <a:gradFill>
            <a:gsLst>
              <a:gs pos="0">
                <a:srgbClr val="E3E8FB">
                  <a:alpha val="0"/>
                </a:srgbClr>
              </a:gs>
              <a:gs pos="100000">
                <a:srgbClr val="E3E8FB">
                  <a:alpha val="58823"/>
                </a:srgbClr>
              </a:gs>
            </a:gsLst>
            <a:lin ang="5400012" scaled="0"/>
          </a:gradFill>
          <a:ln>
            <a:noFill/>
          </a:ln>
        </p:spPr>
        <p:txBody>
          <a:bodyPr spcFirstLastPara="1" wrap="square" lIns="91425" tIns="45700" rIns="91425" bIns="45700" anchor="ctr" anchorCtr="0">
            <a:no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rgbClr val="000000"/>
              </a:solidFill>
              <a:latin typeface="Calibri"/>
              <a:ea typeface="Calibri"/>
              <a:cs typeface="Calibri"/>
              <a:sym typeface="Calibri"/>
            </a:endParaRPr>
          </a:p>
        </p:txBody>
      </p:sp>
      <p:sp>
        <p:nvSpPr>
          <p:cNvPr id="96" name="Google Shape;96;p68"/>
          <p:cNvSpPr txBox="1">
            <a:spLocks noGrp="1"/>
          </p:cNvSpPr>
          <p:nvPr>
            <p:ph type="title"/>
          </p:nvPr>
        </p:nvSpPr>
        <p:spPr>
          <a:xfrm>
            <a:off x="1022525" y="1008050"/>
            <a:ext cx="7098900" cy="357900"/>
          </a:xfrm>
          <a:prstGeom prst="rect">
            <a:avLst/>
          </a:prstGeom>
          <a:noFill/>
          <a:ln>
            <a:noFill/>
          </a:ln>
          <a:effectLst>
            <a:outerShdw blurRad="28575" dist="38100" dir="2700000" algn="bl" rotWithShape="0">
              <a:schemeClr val="dk1">
                <a:alpha val="90980"/>
              </a:schemeClr>
            </a:outerShdw>
          </a:effectLst>
        </p:spPr>
        <p:txBody>
          <a:bodyPr spcFirstLastPara="1" wrap="square" lIns="0" tIns="0" rIns="0" bIns="0" anchor="b" anchorCtr="0">
            <a:noAutofit/>
          </a:bodyPr>
          <a:lstStyle>
            <a:lvl1pPr marR="0" lvl="0" algn="l" rtl="0">
              <a:lnSpc>
                <a:spcPct val="90000"/>
              </a:lnSpc>
              <a:spcBef>
                <a:spcPts val="0"/>
              </a:spcBef>
              <a:spcAft>
                <a:spcPts val="0"/>
              </a:spcAft>
              <a:buClr>
                <a:schemeClr val="lt1"/>
              </a:buClr>
              <a:buSzPts val="3200"/>
              <a:buFont typeface="Bebas Neue"/>
              <a:buNone/>
              <a:defRPr sz="3200" b="0" i="0" u="none" strike="noStrike" cap="none">
                <a:solidFill>
                  <a:schemeClr val="lt1"/>
                </a:solidFill>
                <a:latin typeface="Bebas Neue"/>
                <a:ea typeface="Bebas Neue"/>
                <a:cs typeface="Bebas Neue"/>
                <a:sym typeface="Bebas Neue"/>
              </a:defRPr>
            </a:lvl1pPr>
            <a:lvl2pPr marR="0" lvl="1" algn="l" rtl="0">
              <a:lnSpc>
                <a:spcPct val="90000"/>
              </a:lnSpc>
              <a:spcBef>
                <a:spcPts val="0"/>
              </a:spcBef>
              <a:spcAft>
                <a:spcPts val="0"/>
              </a:spcAft>
              <a:buClr>
                <a:schemeClr val="lt1"/>
              </a:buClr>
              <a:buSzPts val="3200"/>
              <a:buFont typeface="Bebas Neue"/>
              <a:buNone/>
              <a:defRPr sz="3200" b="0" i="0" u="none" strike="noStrike" cap="none">
                <a:solidFill>
                  <a:schemeClr val="lt1"/>
                </a:solidFill>
                <a:latin typeface="Bebas Neue"/>
                <a:ea typeface="Bebas Neue"/>
                <a:cs typeface="Bebas Neue"/>
                <a:sym typeface="Bebas Neue"/>
              </a:defRPr>
            </a:lvl2pPr>
            <a:lvl3pPr marR="0" lvl="2" algn="l" rtl="0">
              <a:lnSpc>
                <a:spcPct val="90000"/>
              </a:lnSpc>
              <a:spcBef>
                <a:spcPts val="0"/>
              </a:spcBef>
              <a:spcAft>
                <a:spcPts val="0"/>
              </a:spcAft>
              <a:buClr>
                <a:schemeClr val="lt1"/>
              </a:buClr>
              <a:buSzPts val="3200"/>
              <a:buFont typeface="Bebas Neue"/>
              <a:buNone/>
              <a:defRPr sz="3200" b="0" i="0" u="none" strike="noStrike" cap="none">
                <a:solidFill>
                  <a:schemeClr val="lt1"/>
                </a:solidFill>
                <a:latin typeface="Bebas Neue"/>
                <a:ea typeface="Bebas Neue"/>
                <a:cs typeface="Bebas Neue"/>
                <a:sym typeface="Bebas Neue"/>
              </a:defRPr>
            </a:lvl3pPr>
            <a:lvl4pPr marR="0" lvl="3" algn="l" rtl="0">
              <a:lnSpc>
                <a:spcPct val="90000"/>
              </a:lnSpc>
              <a:spcBef>
                <a:spcPts val="0"/>
              </a:spcBef>
              <a:spcAft>
                <a:spcPts val="0"/>
              </a:spcAft>
              <a:buClr>
                <a:schemeClr val="lt1"/>
              </a:buClr>
              <a:buSzPts val="3200"/>
              <a:buFont typeface="Bebas Neue"/>
              <a:buNone/>
              <a:defRPr sz="3200" b="0" i="0" u="none" strike="noStrike" cap="none">
                <a:solidFill>
                  <a:schemeClr val="lt1"/>
                </a:solidFill>
                <a:latin typeface="Bebas Neue"/>
                <a:ea typeface="Bebas Neue"/>
                <a:cs typeface="Bebas Neue"/>
                <a:sym typeface="Bebas Neue"/>
              </a:defRPr>
            </a:lvl4pPr>
            <a:lvl5pPr marR="0" lvl="4" algn="l" rtl="0">
              <a:lnSpc>
                <a:spcPct val="90000"/>
              </a:lnSpc>
              <a:spcBef>
                <a:spcPts val="0"/>
              </a:spcBef>
              <a:spcAft>
                <a:spcPts val="0"/>
              </a:spcAft>
              <a:buClr>
                <a:schemeClr val="lt1"/>
              </a:buClr>
              <a:buSzPts val="3200"/>
              <a:buFont typeface="Bebas Neue"/>
              <a:buNone/>
              <a:defRPr sz="3200" b="0" i="0" u="none" strike="noStrike" cap="none">
                <a:solidFill>
                  <a:schemeClr val="lt1"/>
                </a:solidFill>
                <a:latin typeface="Bebas Neue"/>
                <a:ea typeface="Bebas Neue"/>
                <a:cs typeface="Bebas Neue"/>
                <a:sym typeface="Bebas Neue"/>
              </a:defRPr>
            </a:lvl5pPr>
            <a:lvl6pPr marR="0" lvl="5" algn="l" rtl="0">
              <a:lnSpc>
                <a:spcPct val="90000"/>
              </a:lnSpc>
              <a:spcBef>
                <a:spcPts val="0"/>
              </a:spcBef>
              <a:spcAft>
                <a:spcPts val="0"/>
              </a:spcAft>
              <a:buClr>
                <a:schemeClr val="lt1"/>
              </a:buClr>
              <a:buSzPts val="3200"/>
              <a:buFont typeface="Bebas Neue"/>
              <a:buNone/>
              <a:defRPr sz="3200" b="0" i="0" u="none" strike="noStrike" cap="none">
                <a:solidFill>
                  <a:schemeClr val="lt1"/>
                </a:solidFill>
                <a:latin typeface="Bebas Neue"/>
                <a:ea typeface="Bebas Neue"/>
                <a:cs typeface="Bebas Neue"/>
                <a:sym typeface="Bebas Neue"/>
              </a:defRPr>
            </a:lvl6pPr>
            <a:lvl7pPr marR="0" lvl="6" algn="l" rtl="0">
              <a:lnSpc>
                <a:spcPct val="90000"/>
              </a:lnSpc>
              <a:spcBef>
                <a:spcPts val="0"/>
              </a:spcBef>
              <a:spcAft>
                <a:spcPts val="0"/>
              </a:spcAft>
              <a:buClr>
                <a:schemeClr val="lt1"/>
              </a:buClr>
              <a:buSzPts val="3200"/>
              <a:buFont typeface="Bebas Neue"/>
              <a:buNone/>
              <a:defRPr sz="3200" b="0" i="0" u="none" strike="noStrike" cap="none">
                <a:solidFill>
                  <a:schemeClr val="lt1"/>
                </a:solidFill>
                <a:latin typeface="Bebas Neue"/>
                <a:ea typeface="Bebas Neue"/>
                <a:cs typeface="Bebas Neue"/>
                <a:sym typeface="Bebas Neue"/>
              </a:defRPr>
            </a:lvl7pPr>
            <a:lvl8pPr marR="0" lvl="7" algn="l" rtl="0">
              <a:lnSpc>
                <a:spcPct val="90000"/>
              </a:lnSpc>
              <a:spcBef>
                <a:spcPts val="0"/>
              </a:spcBef>
              <a:spcAft>
                <a:spcPts val="0"/>
              </a:spcAft>
              <a:buClr>
                <a:schemeClr val="lt1"/>
              </a:buClr>
              <a:buSzPts val="3200"/>
              <a:buFont typeface="Bebas Neue"/>
              <a:buNone/>
              <a:defRPr sz="3200" b="0" i="0" u="none" strike="noStrike" cap="none">
                <a:solidFill>
                  <a:schemeClr val="lt1"/>
                </a:solidFill>
                <a:latin typeface="Bebas Neue"/>
                <a:ea typeface="Bebas Neue"/>
                <a:cs typeface="Bebas Neue"/>
                <a:sym typeface="Bebas Neue"/>
              </a:defRPr>
            </a:lvl8pPr>
            <a:lvl9pPr marR="0" lvl="8" algn="l" rtl="0">
              <a:lnSpc>
                <a:spcPct val="90000"/>
              </a:lnSpc>
              <a:spcBef>
                <a:spcPts val="0"/>
              </a:spcBef>
              <a:spcAft>
                <a:spcPts val="0"/>
              </a:spcAft>
              <a:buClr>
                <a:schemeClr val="lt1"/>
              </a:buClr>
              <a:buSzPts val="3200"/>
              <a:buFont typeface="Bebas Neue"/>
              <a:buNone/>
              <a:defRPr sz="3200" b="0" i="0" u="none" strike="noStrike" cap="none">
                <a:solidFill>
                  <a:schemeClr val="lt1"/>
                </a:solidFill>
                <a:latin typeface="Bebas Neue"/>
                <a:ea typeface="Bebas Neue"/>
                <a:cs typeface="Bebas Neue"/>
                <a:sym typeface="Bebas Neue"/>
              </a:defRPr>
            </a:lvl9pPr>
          </a:lstStyle>
          <a:p>
            <a:endParaRPr/>
          </a:p>
        </p:txBody>
      </p:sp>
      <p:sp>
        <p:nvSpPr>
          <p:cNvPr id="97" name="Google Shape;97;p68"/>
          <p:cNvSpPr txBox="1">
            <a:spLocks noGrp="1"/>
          </p:cNvSpPr>
          <p:nvPr>
            <p:ph type="body" idx="1"/>
          </p:nvPr>
        </p:nvSpPr>
        <p:spPr>
          <a:xfrm>
            <a:off x="1022525" y="1475820"/>
            <a:ext cx="7098900" cy="2739900"/>
          </a:xfrm>
          <a:prstGeom prst="rect">
            <a:avLst/>
          </a:prstGeom>
          <a:noFill/>
          <a:ln>
            <a:noFill/>
          </a:ln>
          <a:effectLst>
            <a:outerShdw blurRad="14288" dist="28575" dir="2700000" algn="bl" rotWithShape="0">
              <a:schemeClr val="dk1">
                <a:alpha val="90980"/>
              </a:schemeClr>
            </a:outerShdw>
          </a:effectLst>
        </p:spPr>
        <p:txBody>
          <a:bodyPr spcFirstLastPara="1" wrap="square" lIns="0" tIns="0" rIns="0" bIns="0" anchor="t" anchorCtr="0">
            <a:noAutofit/>
          </a:bodyPr>
          <a:lstStyle>
            <a:lvl1pPr marL="457200" marR="0" lvl="0" indent="-381000" algn="l" rtl="0">
              <a:lnSpc>
                <a:spcPct val="100000"/>
              </a:lnSpc>
              <a:spcBef>
                <a:spcPts val="600"/>
              </a:spcBef>
              <a:spcAft>
                <a:spcPts val="0"/>
              </a:spcAft>
              <a:buClr>
                <a:schemeClr val="lt1"/>
              </a:buClr>
              <a:buSzPts val="2400"/>
              <a:buFont typeface="Della Respira"/>
              <a:buChar char="➢"/>
              <a:defRPr sz="2400" b="1" i="0" u="none" strike="noStrike" cap="none">
                <a:solidFill>
                  <a:schemeClr val="lt1"/>
                </a:solidFill>
                <a:latin typeface="Della Respira"/>
                <a:ea typeface="Della Respira"/>
                <a:cs typeface="Della Respira"/>
                <a:sym typeface="Della Respira"/>
              </a:defRPr>
            </a:lvl1pPr>
            <a:lvl2pPr marL="914400" marR="0" lvl="1" indent="-381000" algn="l" rtl="0">
              <a:lnSpc>
                <a:spcPct val="100000"/>
              </a:lnSpc>
              <a:spcBef>
                <a:spcPts val="0"/>
              </a:spcBef>
              <a:spcAft>
                <a:spcPts val="0"/>
              </a:spcAft>
              <a:buClr>
                <a:schemeClr val="lt1"/>
              </a:buClr>
              <a:buSzPts val="2400"/>
              <a:buFont typeface="Della Respira"/>
              <a:buChar char="○"/>
              <a:defRPr sz="2400" b="1" i="0" u="none" strike="noStrike" cap="none">
                <a:solidFill>
                  <a:schemeClr val="lt1"/>
                </a:solidFill>
                <a:latin typeface="Della Respira"/>
                <a:ea typeface="Della Respira"/>
                <a:cs typeface="Della Respira"/>
                <a:sym typeface="Della Respira"/>
              </a:defRPr>
            </a:lvl2pPr>
            <a:lvl3pPr marL="1371600" marR="0" lvl="2" indent="-381000" algn="l" rtl="0">
              <a:lnSpc>
                <a:spcPct val="100000"/>
              </a:lnSpc>
              <a:spcBef>
                <a:spcPts val="0"/>
              </a:spcBef>
              <a:spcAft>
                <a:spcPts val="0"/>
              </a:spcAft>
              <a:buClr>
                <a:schemeClr val="lt1"/>
              </a:buClr>
              <a:buSzPts val="2400"/>
              <a:buFont typeface="Della Respira"/>
              <a:buChar char="■"/>
              <a:defRPr sz="2400" b="1" i="0" u="none" strike="noStrike" cap="none">
                <a:solidFill>
                  <a:schemeClr val="lt1"/>
                </a:solidFill>
                <a:latin typeface="Della Respira"/>
                <a:ea typeface="Della Respira"/>
                <a:cs typeface="Della Respira"/>
                <a:sym typeface="Della Respira"/>
              </a:defRPr>
            </a:lvl3pPr>
            <a:lvl4pPr marL="1828800" marR="0" lvl="3" indent="-381000" algn="l" rtl="0">
              <a:lnSpc>
                <a:spcPct val="100000"/>
              </a:lnSpc>
              <a:spcBef>
                <a:spcPts val="0"/>
              </a:spcBef>
              <a:spcAft>
                <a:spcPts val="0"/>
              </a:spcAft>
              <a:buClr>
                <a:schemeClr val="lt1"/>
              </a:buClr>
              <a:buSzPts val="2400"/>
              <a:buFont typeface="Della Respira"/>
              <a:buChar char="●"/>
              <a:defRPr sz="2400" b="1" i="0" u="none" strike="noStrike" cap="none">
                <a:solidFill>
                  <a:schemeClr val="lt1"/>
                </a:solidFill>
                <a:latin typeface="Della Respira"/>
                <a:ea typeface="Della Respira"/>
                <a:cs typeface="Della Respira"/>
                <a:sym typeface="Della Respira"/>
              </a:defRPr>
            </a:lvl4pPr>
            <a:lvl5pPr marL="2286000" marR="0" lvl="4" indent="-381000" algn="l" rtl="0">
              <a:lnSpc>
                <a:spcPct val="100000"/>
              </a:lnSpc>
              <a:spcBef>
                <a:spcPts val="0"/>
              </a:spcBef>
              <a:spcAft>
                <a:spcPts val="0"/>
              </a:spcAft>
              <a:buClr>
                <a:schemeClr val="lt1"/>
              </a:buClr>
              <a:buSzPts val="2400"/>
              <a:buFont typeface="Della Respira"/>
              <a:buChar char="○"/>
              <a:defRPr sz="2400" b="1" i="0" u="none" strike="noStrike" cap="none">
                <a:solidFill>
                  <a:schemeClr val="lt1"/>
                </a:solidFill>
                <a:latin typeface="Della Respira"/>
                <a:ea typeface="Della Respira"/>
                <a:cs typeface="Della Respira"/>
                <a:sym typeface="Della Respira"/>
              </a:defRPr>
            </a:lvl5pPr>
            <a:lvl6pPr marL="2743200" marR="0" lvl="5" indent="-381000" algn="l" rtl="0">
              <a:lnSpc>
                <a:spcPct val="100000"/>
              </a:lnSpc>
              <a:spcBef>
                <a:spcPts val="0"/>
              </a:spcBef>
              <a:spcAft>
                <a:spcPts val="0"/>
              </a:spcAft>
              <a:buClr>
                <a:schemeClr val="lt1"/>
              </a:buClr>
              <a:buSzPts val="2400"/>
              <a:buFont typeface="Della Respira"/>
              <a:buChar char="■"/>
              <a:defRPr sz="2400" b="1" i="0" u="none" strike="noStrike" cap="none">
                <a:solidFill>
                  <a:schemeClr val="lt1"/>
                </a:solidFill>
                <a:latin typeface="Della Respira"/>
                <a:ea typeface="Della Respira"/>
                <a:cs typeface="Della Respira"/>
                <a:sym typeface="Della Respira"/>
              </a:defRPr>
            </a:lvl6pPr>
            <a:lvl7pPr marL="3200400" marR="0" lvl="6" indent="-381000" algn="l" rtl="0">
              <a:lnSpc>
                <a:spcPct val="100000"/>
              </a:lnSpc>
              <a:spcBef>
                <a:spcPts val="0"/>
              </a:spcBef>
              <a:spcAft>
                <a:spcPts val="0"/>
              </a:spcAft>
              <a:buClr>
                <a:schemeClr val="lt1"/>
              </a:buClr>
              <a:buSzPts val="2400"/>
              <a:buFont typeface="Della Respira"/>
              <a:buChar char="●"/>
              <a:defRPr sz="2400" b="1" i="0" u="none" strike="noStrike" cap="none">
                <a:solidFill>
                  <a:schemeClr val="lt1"/>
                </a:solidFill>
                <a:latin typeface="Della Respira"/>
                <a:ea typeface="Della Respira"/>
                <a:cs typeface="Della Respira"/>
                <a:sym typeface="Della Respira"/>
              </a:defRPr>
            </a:lvl7pPr>
            <a:lvl8pPr marL="3657600" marR="0" lvl="7" indent="-381000" algn="l" rtl="0">
              <a:lnSpc>
                <a:spcPct val="100000"/>
              </a:lnSpc>
              <a:spcBef>
                <a:spcPts val="0"/>
              </a:spcBef>
              <a:spcAft>
                <a:spcPts val="0"/>
              </a:spcAft>
              <a:buClr>
                <a:schemeClr val="lt1"/>
              </a:buClr>
              <a:buSzPts val="2400"/>
              <a:buFont typeface="Della Respira"/>
              <a:buChar char="○"/>
              <a:defRPr sz="2400" b="1" i="0" u="none" strike="noStrike" cap="none">
                <a:solidFill>
                  <a:schemeClr val="lt1"/>
                </a:solidFill>
                <a:latin typeface="Della Respira"/>
                <a:ea typeface="Della Respira"/>
                <a:cs typeface="Della Respira"/>
                <a:sym typeface="Della Respira"/>
              </a:defRPr>
            </a:lvl8pPr>
            <a:lvl9pPr marL="4114800" marR="0" lvl="8" indent="-381000" algn="l" rtl="0">
              <a:lnSpc>
                <a:spcPct val="100000"/>
              </a:lnSpc>
              <a:spcBef>
                <a:spcPts val="0"/>
              </a:spcBef>
              <a:spcAft>
                <a:spcPts val="0"/>
              </a:spcAft>
              <a:buClr>
                <a:schemeClr val="lt1"/>
              </a:buClr>
              <a:buSzPts val="2400"/>
              <a:buFont typeface="Della Respira"/>
              <a:buChar char="■"/>
              <a:defRPr sz="2400" b="1" i="0" u="none" strike="noStrike" cap="none">
                <a:solidFill>
                  <a:schemeClr val="lt1"/>
                </a:solidFill>
                <a:latin typeface="Della Respira"/>
                <a:ea typeface="Della Respira"/>
                <a:cs typeface="Della Respira"/>
                <a:sym typeface="Della Respira"/>
              </a:defRPr>
            </a:lvl9pPr>
          </a:lstStyle>
          <a:p>
            <a:endParaRPr/>
          </a:p>
        </p:txBody>
      </p:sp>
      <p:sp>
        <p:nvSpPr>
          <p:cNvPr id="98" name="Google Shape;98;p68"/>
          <p:cNvSpPr txBox="1">
            <a:spLocks noGrp="1"/>
          </p:cNvSpPr>
          <p:nvPr>
            <p:ph type="sldNum" idx="12"/>
          </p:nvPr>
        </p:nvSpPr>
        <p:spPr>
          <a:xfrm>
            <a:off x="4297650" y="4749851"/>
            <a:ext cx="548700" cy="393600"/>
          </a:xfrm>
          <a:prstGeom prst="rect">
            <a:avLst/>
          </a:prstGeom>
          <a:noFill/>
          <a:ln>
            <a:noFill/>
          </a:ln>
        </p:spPr>
        <p:txBody>
          <a:bodyPr spcFirstLastPara="1" wrap="square" lIns="0" tIns="0" rIns="0" bIns="0" anchor="ctr" anchorCtr="0">
            <a:noAutofit/>
          </a:bodyPr>
          <a:lstStyle>
            <a:lvl1pPr marL="0" marR="0" lvl="0" indent="0" algn="ctr" rtl="0">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1pPr>
            <a:lvl2pPr marL="0" marR="0" lvl="1" indent="0" algn="ctr" rtl="0">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2pPr>
            <a:lvl3pPr marL="0" marR="0" lvl="2" indent="0" algn="ctr" rtl="0">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3pPr>
            <a:lvl4pPr marL="0" marR="0" lvl="3" indent="0" algn="ctr" rtl="0">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4pPr>
            <a:lvl5pPr marL="0" marR="0" lvl="4" indent="0" algn="ctr" rtl="0">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5pPr>
            <a:lvl6pPr marL="0" marR="0" lvl="5" indent="0" algn="ctr" rtl="0">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6pPr>
            <a:lvl7pPr marL="0" marR="0" lvl="6" indent="0" algn="ctr" rtl="0">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7pPr>
            <a:lvl8pPr marL="0" marR="0" lvl="7" indent="0" algn="ctr" rtl="0">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8pPr>
            <a:lvl9pPr marL="0" marR="0" lvl="8" indent="0" algn="ctr" rtl="0">
              <a:lnSpc>
                <a:spcPct val="100000"/>
              </a:lnSpc>
              <a:spcBef>
                <a:spcPts val="0"/>
              </a:spcBef>
              <a:spcAft>
                <a:spcPts val="0"/>
              </a:spcAft>
              <a:buClr>
                <a:srgbClr val="000000"/>
              </a:buClr>
              <a:buSzPts val="1300"/>
              <a:buFont typeface="Arial"/>
              <a:buNone/>
              <a:defRPr sz="1300" b="0" i="0" u="none" strike="noStrike" cap="none">
                <a:solidFill>
                  <a:schemeClr val="lt1"/>
                </a:solidFill>
                <a:latin typeface="Della Respira"/>
                <a:ea typeface="Della Respira"/>
                <a:cs typeface="Della Respira"/>
                <a:sym typeface="Della Respira"/>
              </a:defRPr>
            </a:lvl9pPr>
          </a:lstStyle>
          <a:p>
            <a:pPr marL="0" lvl="0" indent="0" algn="ct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63" r:id="rId1"/>
    <p:sldLayoutId id="2147483664" r:id="rId2"/>
    <p:sldLayoutId id="2147483651" r:id="rId3"/>
    <p:sldLayoutId id="2147483652" r:id="rId4"/>
    <p:sldLayoutId id="2147483665" r:id="rId5"/>
    <p:sldLayoutId id="2147483666" r:id="rId6"/>
    <p:sldLayoutId id="2147483667" r:id="rId7"/>
    <p:sldLayoutId id="2147483668" r:id="rId8"/>
    <p:sldLayoutId id="2147483669" r:id="rId9"/>
    <p:sldLayoutId id="2147483670" r:id="rId10"/>
    <p:sldLayoutId id="2147483671" r:id="rId11"/>
  </p:sldLayoutIdLst>
  <p:transition>
    <p:fade/>
  </p:transition>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9.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9.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9.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9.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9.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9.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9.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9.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9.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9.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9.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9.xml"/></Relationships>
</file>

<file path=ppt/slides/_rels/slide3.xml.rels><?xml version="1.0" encoding="UTF-8" standalone="yes"?>
<Relationships xmlns="http://schemas.openxmlformats.org/package/2006/relationships"><Relationship Id="rId8" Type="http://schemas.openxmlformats.org/officeDocument/2006/relationships/slide" Target="slide14.xml"/><Relationship Id="rId13" Type="http://schemas.openxmlformats.org/officeDocument/2006/relationships/slide" Target="slide38.xml"/><Relationship Id="rId18" Type="http://schemas.openxmlformats.org/officeDocument/2006/relationships/slide" Target="slide58.xml"/><Relationship Id="rId3" Type="http://schemas.openxmlformats.org/officeDocument/2006/relationships/slide" Target="slide4.xml"/><Relationship Id="rId21" Type="http://schemas.openxmlformats.org/officeDocument/2006/relationships/slide" Target="slide64.xml"/><Relationship Id="rId7" Type="http://schemas.openxmlformats.org/officeDocument/2006/relationships/slide" Target="slide12.xml"/><Relationship Id="rId12" Type="http://schemas.openxmlformats.org/officeDocument/2006/relationships/slide" Target="slide33.xml"/><Relationship Id="rId17" Type="http://schemas.openxmlformats.org/officeDocument/2006/relationships/slide" Target="slide53.xml"/><Relationship Id="rId2" Type="http://schemas.openxmlformats.org/officeDocument/2006/relationships/notesSlide" Target="../notesSlides/notesSlide3.xml"/><Relationship Id="rId16" Type="http://schemas.openxmlformats.org/officeDocument/2006/relationships/slide" Target="slide50.xml"/><Relationship Id="rId20" Type="http://schemas.openxmlformats.org/officeDocument/2006/relationships/slide" Target="slide62.xml"/><Relationship Id="rId1" Type="http://schemas.openxmlformats.org/officeDocument/2006/relationships/slideLayout" Target="../slideLayouts/slideLayout6.xml"/><Relationship Id="rId6" Type="http://schemas.openxmlformats.org/officeDocument/2006/relationships/slide" Target="slide10.xml"/><Relationship Id="rId11" Type="http://schemas.openxmlformats.org/officeDocument/2006/relationships/slide" Target="slide29.xml"/><Relationship Id="rId5" Type="http://schemas.openxmlformats.org/officeDocument/2006/relationships/slide" Target="slide8.xml"/><Relationship Id="rId15" Type="http://schemas.openxmlformats.org/officeDocument/2006/relationships/slide" Target="slide46.xml"/><Relationship Id="rId10" Type="http://schemas.openxmlformats.org/officeDocument/2006/relationships/slide" Target="slide24.xml"/><Relationship Id="rId19" Type="http://schemas.openxmlformats.org/officeDocument/2006/relationships/slide" Target="slide60.xml"/><Relationship Id="rId4" Type="http://schemas.openxmlformats.org/officeDocument/2006/relationships/slide" Target="slide6.xml"/><Relationship Id="rId9" Type="http://schemas.openxmlformats.org/officeDocument/2006/relationships/slide" Target="slide20.xml"/><Relationship Id="rId14" Type="http://schemas.openxmlformats.org/officeDocument/2006/relationships/slide" Target="slide40.xml"/><Relationship Id="rId22" Type="http://schemas.openxmlformats.org/officeDocument/2006/relationships/slide" Target="slide66.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9.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9.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9.xml"/></Relationships>
</file>

<file path=ppt/slides/_rels/slide36.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9.xml"/></Relationships>
</file>

<file path=ppt/slides/_rels/slide38.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6.xml"/><Relationship Id="rId1" Type="http://schemas.openxmlformats.org/officeDocument/2006/relationships/slideLayout" Target="../slideLayouts/slideLayout9.xml"/><Relationship Id="rId4" Type="http://schemas.openxmlformats.org/officeDocument/2006/relationships/hyperlink" Target="https://litfl.com/hyperkalaemia-ecg-library/" TargetMode="Externa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9.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9.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9.xml"/></Relationships>
</file>

<file path=ppt/slides/_rels/slide41.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42.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29.xml"/><Relationship Id="rId1" Type="http://schemas.openxmlformats.org/officeDocument/2006/relationships/slideLayout" Target="../slideLayouts/slideLayout9.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4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9.xml"/></Relationships>
</file>

<file path=ppt/slides/_rels/slide44.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45.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9.xml"/></Relationships>
</file>

<file path=ppt/slides/_rels/slide4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0.xml"/><Relationship Id="rId1" Type="http://schemas.openxmlformats.org/officeDocument/2006/relationships/slideLayout" Target="../slideLayouts/slideLayout9.xml"/><Relationship Id="rId4" Type="http://schemas.openxmlformats.org/officeDocument/2006/relationships/hyperlink" Target="https://litfl.com/av-block-3rd-degree-complete-heart-block/" TargetMode="External"/></Relationships>
</file>

<file path=ppt/slides/_rels/slide47.xml.rels><?xml version="1.0" encoding="UTF-8" standalone="yes"?>
<Relationships xmlns="http://schemas.openxmlformats.org/package/2006/relationships"><Relationship Id="rId3" Type="http://schemas.openxmlformats.org/officeDocument/2006/relationships/hyperlink" Target="https://litfl.com/av-block-3rd-degree-complete-heart-block/" TargetMode="External"/><Relationship Id="rId2" Type="http://schemas.openxmlformats.org/officeDocument/2006/relationships/image" Target="../media/image3.png"/><Relationship Id="rId1" Type="http://schemas.openxmlformats.org/officeDocument/2006/relationships/slideLayout" Target="../slideLayouts/slideLayout9.xml"/></Relationships>
</file>

<file path=ppt/slides/_rels/slide48.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49.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9.xml"/></Relationships>
</file>

<file path=ppt/slides/_rels/slide50.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9.xml"/></Relationships>
</file>

<file path=ppt/slides/_rels/slide51.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5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9.xml"/></Relationships>
</file>

<file path=ppt/slides/_rels/slide5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9.xml"/></Relationships>
</file>

<file path=ppt/slides/_rels/slide5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9.xml"/></Relationships>
</file>

<file path=ppt/slides/_rels/slide55.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56.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57.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58.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9.xml"/></Relationships>
</file>

<file path=ppt/slides/_rels/slide59.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9.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9.xml"/></Relationships>
</file>

<file path=ppt/slides/_rels/slide60.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9.xml"/></Relationships>
</file>

<file path=ppt/slides/_rels/slide61.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9.xml"/></Relationships>
</file>

<file path=ppt/slides/_rels/slide62.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9.xml"/></Relationships>
</file>

<file path=ppt/slides/_rels/slide63.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9.xml"/></Relationships>
</file>

<file path=ppt/slides/_rels/slide64.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9.xml"/></Relationships>
</file>

<file path=ppt/slides/_rels/slide65.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9.xml"/></Relationships>
</file>

<file path=ppt/slides/_rels/slide66.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9.xml"/></Relationships>
</file>

<file path=ppt/slides/_rels/slide67.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9.xml"/></Relationships>
</file>

<file path=ppt/slides/_rels/slide68.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11.xml"/></Relationships>
</file>

<file path=ppt/slides/_rels/slide69.xml.rels><?xml version="1.0" encoding="UTF-8" standalone="yes"?>
<Relationships xmlns="http://schemas.openxmlformats.org/package/2006/relationships"><Relationship Id="rId3" Type="http://schemas.openxmlformats.org/officeDocument/2006/relationships/hyperlink" Target="https://www.ncbi.nlm.nih.gov/books/NBK430685/" TargetMode="External"/><Relationship Id="rId2" Type="http://schemas.openxmlformats.org/officeDocument/2006/relationships/notesSlide" Target="../notesSlides/notesSlide46.xml"/><Relationship Id="rId1" Type="http://schemas.openxmlformats.org/officeDocument/2006/relationships/slideLayout" Target="../slideLayouts/slideLayout14.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9.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9.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9.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218"/>
        <p:cNvGrpSpPr/>
        <p:nvPr/>
      </p:nvGrpSpPr>
      <p:grpSpPr>
        <a:xfrm>
          <a:off x="0" y="0"/>
          <a:ext cx="0" cy="0"/>
          <a:chOff x="0" y="0"/>
          <a:chExt cx="0" cy="0"/>
        </a:xfrm>
      </p:grpSpPr>
      <p:sp>
        <p:nvSpPr>
          <p:cNvPr id="222" name="Google Shape;222;p15"/>
          <p:cNvSpPr txBox="1">
            <a:spLocks noGrp="1"/>
          </p:cNvSpPr>
          <p:nvPr>
            <p:ph type="ctrTitle"/>
          </p:nvPr>
        </p:nvSpPr>
        <p:spPr>
          <a:xfrm>
            <a:off x="685800" y="2032845"/>
            <a:ext cx="7772400" cy="607800"/>
          </a:xfrm>
          <a:prstGeom prst="rect">
            <a:avLst/>
          </a:prstGeom>
        </p:spPr>
        <p:txBody>
          <a:bodyPr spcFirstLastPara="1" wrap="square" lIns="0" tIns="0" rIns="0" bIns="0" anchor="t" anchorCtr="0">
            <a:noAutofit/>
          </a:bodyPr>
          <a:lstStyle/>
          <a:p>
            <a:r>
              <a:rPr lang="en" dirty="0"/>
              <a:t> Clinical Reasoning Review Game</a:t>
            </a:r>
            <a:endParaRPr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294"/>
        <p:cNvGrpSpPr/>
        <p:nvPr/>
      </p:nvGrpSpPr>
      <p:grpSpPr>
        <a:xfrm>
          <a:off x="0" y="0"/>
          <a:ext cx="0" cy="0"/>
          <a:chOff x="0" y="0"/>
          <a:chExt cx="0" cy="0"/>
        </a:xfrm>
      </p:grpSpPr>
      <p:sp>
        <p:nvSpPr>
          <p:cNvPr id="296" name="Google Shape;296;p21"/>
          <p:cNvSpPr txBox="1">
            <a:spLocks noGrp="1"/>
          </p:cNvSpPr>
          <p:nvPr>
            <p:ph type="subTitle" idx="1"/>
          </p:nvPr>
        </p:nvSpPr>
        <p:spPr>
          <a:xfrm>
            <a:off x="1038650" y="640325"/>
            <a:ext cx="7079700" cy="444300"/>
          </a:xfrm>
          <a:prstGeom prst="rect">
            <a:avLst/>
          </a:prstGeom>
        </p:spPr>
        <p:txBody>
          <a:bodyPr spcFirstLastPara="1" wrap="square" lIns="0" tIns="0" rIns="0" bIns="0" anchor="t" anchorCtr="0">
            <a:noAutofit/>
          </a:bodyPr>
          <a:lstStyle/>
          <a:p>
            <a:pPr marL="0" indent="0"/>
            <a:r>
              <a:rPr lang="en-US">
                <a:solidFill>
                  <a:schemeClr val="lt1"/>
                </a:solidFill>
                <a:latin typeface="Bebas Neue"/>
                <a:ea typeface="Bebas Neue"/>
                <a:cs typeface="Bebas Neue"/>
                <a:sym typeface="Bebas Neue"/>
              </a:rPr>
              <a:t>To </a:t>
            </a:r>
            <a:r>
              <a:rPr lang="en-US" err="1">
                <a:solidFill>
                  <a:schemeClr val="lt1"/>
                </a:solidFill>
                <a:latin typeface="Bebas Neue"/>
                <a:ea typeface="Bebas Neue"/>
                <a:cs typeface="Bebas Neue"/>
                <a:sym typeface="Bebas Neue"/>
              </a:rPr>
              <a:t>cbc</a:t>
            </a:r>
            <a:r>
              <a:rPr lang="en-US">
                <a:solidFill>
                  <a:schemeClr val="lt1"/>
                </a:solidFill>
                <a:latin typeface="Bebas Neue"/>
                <a:ea typeface="Bebas Neue"/>
                <a:cs typeface="Bebas Neue"/>
                <a:sym typeface="Bebas Neue"/>
              </a:rPr>
              <a:t> or not to </a:t>
            </a:r>
            <a:r>
              <a:rPr lang="en-US" err="1">
                <a:solidFill>
                  <a:schemeClr val="lt1"/>
                </a:solidFill>
                <a:latin typeface="Bebas Neue"/>
                <a:ea typeface="Bebas Neue"/>
                <a:cs typeface="Bebas Neue"/>
                <a:sym typeface="Bebas Neue"/>
              </a:rPr>
              <a:t>cbc</a:t>
            </a:r>
            <a:endParaRPr lang="en-US">
              <a:solidFill>
                <a:schemeClr val="lt1"/>
              </a:solidFill>
              <a:latin typeface="Bebas Neue"/>
              <a:ea typeface="Bebas Neue"/>
              <a:cs typeface="Bebas Neue"/>
              <a:sym typeface="Bebas Neue"/>
            </a:endParaRPr>
          </a:p>
          <a:p>
            <a:pPr marL="0" lvl="0" indent="0" algn="ctr" rtl="0">
              <a:spcBef>
                <a:spcPts val="600"/>
              </a:spcBef>
              <a:spcAft>
                <a:spcPts val="0"/>
              </a:spcAft>
              <a:buNone/>
            </a:pPr>
            <a:r>
              <a:rPr lang="en">
                <a:solidFill>
                  <a:srgbClr val="FFC319"/>
                </a:solidFill>
              </a:rPr>
              <a:t>$800</a:t>
            </a:r>
            <a:endParaRPr>
              <a:solidFill>
                <a:srgbClr val="FFC319"/>
              </a:solidFill>
            </a:endParaRPr>
          </a:p>
        </p:txBody>
      </p:sp>
      <p:graphicFrame>
        <p:nvGraphicFramePr>
          <p:cNvPr id="7" name="Table 6">
            <a:extLst>
              <a:ext uri="{FF2B5EF4-FFF2-40B4-BE49-F238E27FC236}">
                <a16:creationId xmlns:a16="http://schemas.microsoft.com/office/drawing/2014/main" id="{DCD1BECD-7EA5-4F8F-98A4-BCFEEB6559B7}"/>
              </a:ext>
            </a:extLst>
          </p:cNvPr>
          <p:cNvGraphicFramePr>
            <a:graphicFrameLocks noGrp="1"/>
          </p:cNvGraphicFramePr>
          <p:nvPr>
            <p:extLst>
              <p:ext uri="{D42A27DB-BD31-4B8C-83A1-F6EECF244321}">
                <p14:modId xmlns:p14="http://schemas.microsoft.com/office/powerpoint/2010/main" val="902346880"/>
              </p:ext>
            </p:extLst>
          </p:nvPr>
        </p:nvGraphicFramePr>
        <p:xfrm>
          <a:off x="1274618" y="1969155"/>
          <a:ext cx="2871145" cy="1205190"/>
        </p:xfrm>
        <a:graphic>
          <a:graphicData uri="http://schemas.openxmlformats.org/drawingml/2006/table">
            <a:tbl>
              <a:tblPr firstRow="1" bandRow="1"/>
              <a:tblGrid>
                <a:gridCol w="706605">
                  <a:extLst>
                    <a:ext uri="{9D8B030D-6E8A-4147-A177-3AD203B41FA5}">
                      <a16:colId xmlns:a16="http://schemas.microsoft.com/office/drawing/2014/main" val="824425484"/>
                    </a:ext>
                  </a:extLst>
                </a:gridCol>
                <a:gridCol w="429331">
                  <a:extLst>
                    <a:ext uri="{9D8B030D-6E8A-4147-A177-3AD203B41FA5}">
                      <a16:colId xmlns:a16="http://schemas.microsoft.com/office/drawing/2014/main" val="610143289"/>
                    </a:ext>
                  </a:extLst>
                </a:gridCol>
                <a:gridCol w="688716">
                  <a:extLst>
                    <a:ext uri="{9D8B030D-6E8A-4147-A177-3AD203B41FA5}">
                      <a16:colId xmlns:a16="http://schemas.microsoft.com/office/drawing/2014/main" val="3542840054"/>
                    </a:ext>
                  </a:extLst>
                </a:gridCol>
                <a:gridCol w="429330">
                  <a:extLst>
                    <a:ext uri="{9D8B030D-6E8A-4147-A177-3AD203B41FA5}">
                      <a16:colId xmlns:a16="http://schemas.microsoft.com/office/drawing/2014/main" val="3916601039"/>
                    </a:ext>
                  </a:extLst>
                </a:gridCol>
                <a:gridCol w="617163">
                  <a:extLst>
                    <a:ext uri="{9D8B030D-6E8A-4147-A177-3AD203B41FA5}">
                      <a16:colId xmlns:a16="http://schemas.microsoft.com/office/drawing/2014/main" val="4033324111"/>
                    </a:ext>
                  </a:extLst>
                </a:gridCol>
              </a:tblGrid>
              <a:tr h="602595">
                <a:tc rowSpan="2">
                  <a:txBody>
                    <a:bodyPr/>
                    <a:lstStyle>
                      <a:lvl1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1pPr>
                      <a:lvl2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2pPr>
                      <a:lvl3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3pPr>
                      <a:lvl4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4pPr>
                      <a:lvl5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5pPr>
                      <a:lvl6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6pPr>
                      <a:lvl7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7pPr>
                      <a:lvl8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8pPr>
                      <a:lvl9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9pPr>
                    </a:lstStyle>
                    <a:p>
                      <a:endParaRPr lang="en-US" sz="1200" b="0">
                        <a:solidFill>
                          <a:schemeClr val="tx1"/>
                        </a:solidFill>
                      </a:endParaRPr>
                    </a:p>
                    <a:p>
                      <a:endParaRPr lang="en-US" sz="1200"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ap="flat" cmpd="sng" algn="ctr">
                      <a:noFill/>
                      <a:prstDash val="solid"/>
                      <a:round/>
                      <a:headEnd type="none" w="med" len="med"/>
                      <a:tailEnd type="none" w="med" len="med"/>
                    </a:lnTlToBr>
                    <a:lnBlToTr w="12700" cmpd="sng">
                      <a:noFill/>
                      <a:prstDash val="solid"/>
                    </a:lnBlToTr>
                    <a:solidFill>
                      <a:sysClr val="window" lastClr="FFFFFF"/>
                    </a:solidFill>
                  </a:tcPr>
                </a:tc>
                <a:tc>
                  <a:txBody>
                    <a:bodyPr/>
                    <a:lstStyle>
                      <a:lvl1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1pPr>
                      <a:lvl2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2pPr>
                      <a:lvl3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3pPr>
                      <a:lvl4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4pPr>
                      <a:lvl5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5pPr>
                      <a:lvl6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6pPr>
                      <a:lvl7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7pPr>
                      <a:lvl8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8pPr>
                      <a:lvl9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9pPr>
                    </a:lstStyle>
                    <a:p>
                      <a:endParaRPr lang="en-US" sz="1200"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ap="flat" cmpd="sng" algn="ctr">
                      <a:solidFill>
                        <a:sysClr val="windowText" lastClr="000000"/>
                      </a:solidFill>
                      <a:prstDash val="solid"/>
                      <a:round/>
                      <a:headEnd type="none" w="med" len="med"/>
                      <a:tailEnd type="none" w="med" len="med"/>
                    </a:lnTlToBr>
                    <a:lnBlToTr w="12700" cmpd="sng">
                      <a:noFill/>
                      <a:prstDash val="solid"/>
                    </a:lnBlToTr>
                    <a:solidFill>
                      <a:sysClr val="window" lastClr="FFFFFF"/>
                    </a:solidFill>
                  </a:tcPr>
                </a:tc>
                <a:tc>
                  <a:txBody>
                    <a:bodyPr/>
                    <a:lstStyle>
                      <a:lvl1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1pPr>
                      <a:lvl2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2pPr>
                      <a:lvl3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3pPr>
                      <a:lvl4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4pPr>
                      <a:lvl5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5pPr>
                      <a:lvl6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6pPr>
                      <a:lvl7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7pPr>
                      <a:lvl8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8pPr>
                      <a:lvl9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9pPr>
                    </a:lstStyle>
                    <a:p>
                      <a:pPr algn="ctr"/>
                      <a:endParaRPr lang="en-US" sz="1200" b="0">
                        <a:solidFill>
                          <a:schemeClr val="tx1"/>
                        </a:solidFill>
                      </a:endParaRPr>
                    </a:p>
                    <a:p>
                      <a:pPr algn="ctr"/>
                      <a:r>
                        <a:rPr lang="en-US" sz="1800" b="0">
                          <a:solidFill>
                            <a:schemeClr val="tx1"/>
                          </a:solidFill>
                        </a:rPr>
                        <a:t>5.7</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solidFill>
                      <a:sysClr val="window" lastClr="FFFFFF"/>
                    </a:solidFill>
                  </a:tcPr>
                </a:tc>
                <a:tc>
                  <a:txBody>
                    <a:bodyPr/>
                    <a:lstStyle>
                      <a:lvl1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1pPr>
                      <a:lvl2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2pPr>
                      <a:lvl3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3pPr>
                      <a:lvl4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4pPr>
                      <a:lvl5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5pPr>
                      <a:lvl6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6pPr>
                      <a:lvl7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7pPr>
                      <a:lvl8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8pPr>
                      <a:lvl9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9pPr>
                    </a:lstStyle>
                    <a:p>
                      <a:endParaRPr lang="en-US" sz="1400"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ap="flat" cmpd="sng" algn="ctr">
                      <a:solidFill>
                        <a:sysClr val="windowText" lastClr="000000"/>
                      </a:solidFill>
                      <a:prstDash val="solid"/>
                      <a:round/>
                      <a:headEnd type="none" w="med" len="med"/>
                      <a:tailEnd type="none" w="med" len="med"/>
                    </a:lnBlToTr>
                    <a:solidFill>
                      <a:sysClr val="window" lastClr="FFFFFF"/>
                    </a:solidFill>
                  </a:tcPr>
                </a:tc>
                <a:tc rowSpan="2">
                  <a:txBody>
                    <a:bodyPr/>
                    <a:lstStyle>
                      <a:lvl1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1pPr>
                      <a:lvl2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2pPr>
                      <a:lvl3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3pPr>
                      <a:lvl4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4pPr>
                      <a:lvl5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5pPr>
                      <a:lvl6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6pPr>
                      <a:lvl7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7pPr>
                      <a:lvl8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8pPr>
                      <a:lvl9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9pPr>
                    </a:lstStyle>
                    <a:p>
                      <a:endParaRPr lang="en-US" sz="1600" b="0">
                        <a:solidFill>
                          <a:schemeClr val="tx1"/>
                        </a:solidFill>
                      </a:endParaRPr>
                    </a:p>
                    <a:p>
                      <a:endParaRPr lang="en-US" sz="1600" b="0">
                        <a:solidFill>
                          <a:schemeClr val="tx1"/>
                        </a:solidFill>
                      </a:endParaRPr>
                    </a:p>
                    <a:p>
                      <a:r>
                        <a:rPr lang="en-US" sz="1600" b="0">
                          <a:solidFill>
                            <a:schemeClr val="tx1"/>
                          </a:solidFill>
                        </a:rPr>
                        <a:t>42</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ap="flat" cmpd="sng" algn="ctr">
                      <a:noFill/>
                      <a:prstDash val="solid"/>
                      <a:round/>
                      <a:headEnd type="none" w="med" len="med"/>
                      <a:tailEnd type="none" w="med" len="med"/>
                    </a:lnBlToTr>
                    <a:solidFill>
                      <a:sysClr val="window" lastClr="FFFFFF"/>
                    </a:solidFill>
                  </a:tcPr>
                </a:tc>
                <a:extLst>
                  <a:ext uri="{0D108BD9-81ED-4DB2-BD59-A6C34878D82A}">
                    <a16:rowId xmlns:a16="http://schemas.microsoft.com/office/drawing/2014/main" val="727745014"/>
                  </a:ext>
                </a:extLst>
              </a:tr>
              <a:tr h="602595">
                <a:tc vMerge="1">
                  <a:txBody>
                    <a:bodyPr/>
                    <a:lstStyle/>
                    <a:p>
                      <a:endParaRPr lang="en-US"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ap="flat" cmpd="sng" algn="ctr">
                      <a:noFill/>
                      <a:prstDash val="solid"/>
                      <a:round/>
                      <a:headEnd type="none" w="med" len="med"/>
                      <a:tailEnd type="none" w="med" len="med"/>
                    </a:lnBlToTr>
                    <a:solidFill>
                      <a:schemeClr val="bg1"/>
                    </a:solidFill>
                  </a:tcPr>
                </a:tc>
                <a:tc>
                  <a:txBody>
                    <a:bodyPr/>
                    <a:lstStyle>
                      <a:lvl1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1pPr>
                      <a:lvl2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2pPr>
                      <a:lvl3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3pPr>
                      <a:lvl4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4pPr>
                      <a:lvl5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5pPr>
                      <a:lvl6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6pPr>
                      <a:lvl7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7pPr>
                      <a:lvl8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8pPr>
                      <a:lvl9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9pPr>
                    </a:lstStyle>
                    <a:p>
                      <a:endParaRPr lang="en-US" sz="1200"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ap="flat" cmpd="sng" algn="ctr">
                      <a:solidFill>
                        <a:sysClr val="windowText" lastClr="000000"/>
                      </a:solidFill>
                      <a:prstDash val="solid"/>
                      <a:round/>
                      <a:headEnd type="none" w="med" len="med"/>
                      <a:tailEnd type="none" w="med" len="med"/>
                    </a:lnBlToTr>
                    <a:solidFill>
                      <a:sysClr val="window" lastClr="FFFFFF"/>
                    </a:solidFill>
                  </a:tcPr>
                </a:tc>
                <a:tc>
                  <a:txBody>
                    <a:bodyPr/>
                    <a:lstStyle>
                      <a:lvl1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1pPr>
                      <a:lvl2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2pPr>
                      <a:lvl3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3pPr>
                      <a:lvl4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4pPr>
                      <a:lvl5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5pPr>
                      <a:lvl6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6pPr>
                      <a:lvl7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7pPr>
                      <a:lvl8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8pPr>
                      <a:lvl9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9pPr>
                    </a:lstStyle>
                    <a:p>
                      <a:endParaRPr lang="en-US" sz="1200"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ysClr val="windowText" lastClr="000000"/>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ysClr val="window" lastClr="FFFFFF"/>
                    </a:solidFill>
                  </a:tcPr>
                </a:tc>
                <a:tc>
                  <a:txBody>
                    <a:bodyPr/>
                    <a:lstStyle>
                      <a:lvl1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1pPr>
                      <a:lvl2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2pPr>
                      <a:lvl3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3pPr>
                      <a:lvl4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4pPr>
                      <a:lvl5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5pPr>
                      <a:lvl6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6pPr>
                      <a:lvl7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7pPr>
                      <a:lvl8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8pPr>
                      <a:lvl9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9pPr>
                    </a:lstStyle>
                    <a:p>
                      <a:endParaRPr lang="en-US" sz="1600"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ap="flat" cmpd="sng" algn="ctr">
                      <a:solidFill>
                        <a:sysClr val="windowText" lastClr="000000"/>
                      </a:solidFill>
                      <a:prstDash val="solid"/>
                      <a:round/>
                      <a:headEnd type="none" w="med" len="med"/>
                      <a:tailEnd type="none" w="med" len="med"/>
                    </a:lnTlToBr>
                    <a:lnBlToTr w="12700" cap="flat" cmpd="sng" algn="ctr">
                      <a:noFill/>
                      <a:prstDash val="solid"/>
                      <a:round/>
                      <a:headEnd type="none" w="med" len="med"/>
                      <a:tailEnd type="none" w="med" len="med"/>
                    </a:lnBlToTr>
                    <a:solidFill>
                      <a:sysClr val="window" lastClr="FFFFFF"/>
                    </a:solidFill>
                  </a:tcPr>
                </a:tc>
                <a:tc vMerge="1">
                  <a:txBody>
                    <a:bodyPr/>
                    <a:lstStyle/>
                    <a:p>
                      <a:endParaRPr lang="en-US"/>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ap="flat" cmpd="sng" algn="ctr">
                      <a:noFill/>
                      <a:prstDash val="solid"/>
                      <a:round/>
                      <a:headEnd type="none" w="med" len="med"/>
                      <a:tailEnd type="none" w="med" len="med"/>
                    </a:lnTlToBr>
                    <a:lnBlToTr w="12700" cap="flat" cmpd="sng" algn="ctr">
                      <a:noFill/>
                      <a:prstDash val="solid"/>
                      <a:round/>
                      <a:headEnd type="none" w="med" len="med"/>
                      <a:tailEnd type="none" w="med" len="med"/>
                    </a:lnBlToTr>
                    <a:solidFill>
                      <a:schemeClr val="bg1"/>
                    </a:solidFill>
                  </a:tcPr>
                </a:tc>
                <a:extLst>
                  <a:ext uri="{0D108BD9-81ED-4DB2-BD59-A6C34878D82A}">
                    <a16:rowId xmlns:a16="http://schemas.microsoft.com/office/drawing/2014/main" val="2515014331"/>
                  </a:ext>
                </a:extLst>
              </a:tr>
            </a:tbl>
          </a:graphicData>
        </a:graphic>
      </p:graphicFrame>
      <p:sp>
        <p:nvSpPr>
          <p:cNvPr id="8" name="TextBox 7">
            <a:extLst>
              <a:ext uri="{FF2B5EF4-FFF2-40B4-BE49-F238E27FC236}">
                <a16:creationId xmlns:a16="http://schemas.microsoft.com/office/drawing/2014/main" id="{48739D61-6958-4220-B910-3D10742963E9}"/>
              </a:ext>
            </a:extLst>
          </p:cNvPr>
          <p:cNvSpPr txBox="1"/>
          <p:nvPr/>
        </p:nvSpPr>
        <p:spPr>
          <a:xfrm>
            <a:off x="4572000" y="2013840"/>
            <a:ext cx="3516406" cy="1815882"/>
          </a:xfrm>
          <a:prstGeom prst="rect">
            <a:avLst/>
          </a:prstGeom>
          <a:solidFill>
            <a:schemeClr val="bg1"/>
          </a:solidFill>
        </p:spPr>
        <p:txBody>
          <a:bodyPr wrap="square" rtlCol="0">
            <a:spAutoFit/>
          </a:bodyPr>
          <a:lstStyle/>
          <a:p>
            <a:r>
              <a:rPr lang="en-US" dirty="0"/>
              <a:t>This is a 5-year-old patient who presents with epistaxis. Peripheral smear shows presence of schistocytes.</a:t>
            </a:r>
          </a:p>
          <a:p>
            <a:endParaRPr lang="en-US" dirty="0"/>
          </a:p>
          <a:p>
            <a:r>
              <a:rPr lang="en-US" dirty="0"/>
              <a:t>What are two possible diagnoses for this patient, and what historical, exam, or lab findings would help you differentiate the two?</a:t>
            </a: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a:extLst>
              <a:ext uri="{FF2B5EF4-FFF2-40B4-BE49-F238E27FC236}">
                <a16:creationId xmlns:a16="http://schemas.microsoft.com/office/drawing/2014/main" id="{465816D3-7512-4CAA-9648-1C87DDD5716B}"/>
              </a:ext>
            </a:extLst>
          </p:cNvPr>
          <p:cNvSpPr>
            <a:spLocks noGrp="1"/>
          </p:cNvSpPr>
          <p:nvPr>
            <p:ph type="subTitle" idx="1"/>
          </p:nvPr>
        </p:nvSpPr>
        <p:spPr/>
        <p:txBody>
          <a:bodyPr/>
          <a:lstStyle/>
          <a:p>
            <a:r>
              <a:rPr lang="en-US"/>
              <a:t>Microangiopathic hemolytic anemia</a:t>
            </a:r>
          </a:p>
        </p:txBody>
      </p:sp>
      <p:sp>
        <p:nvSpPr>
          <p:cNvPr id="4" name="TextBox 3">
            <a:extLst>
              <a:ext uri="{FF2B5EF4-FFF2-40B4-BE49-F238E27FC236}">
                <a16:creationId xmlns:a16="http://schemas.microsoft.com/office/drawing/2014/main" id="{D8CDBE8B-96B9-4231-8CB0-165E65E214C6}"/>
              </a:ext>
            </a:extLst>
          </p:cNvPr>
          <p:cNvSpPr txBox="1"/>
          <p:nvPr/>
        </p:nvSpPr>
        <p:spPr>
          <a:xfrm>
            <a:off x="1038650" y="1321907"/>
            <a:ext cx="3293205" cy="1815882"/>
          </a:xfrm>
          <a:prstGeom prst="rect">
            <a:avLst/>
          </a:prstGeom>
          <a:solidFill>
            <a:schemeClr val="bg1"/>
          </a:solidFill>
        </p:spPr>
        <p:txBody>
          <a:bodyPr wrap="square" rtlCol="0">
            <a:spAutoFit/>
          </a:bodyPr>
          <a:lstStyle/>
          <a:p>
            <a:pPr algn="ctr"/>
            <a:r>
              <a:rPr lang="en-US"/>
              <a:t>Hemolytic-Uremic Syndrome</a:t>
            </a:r>
          </a:p>
          <a:p>
            <a:pPr algn="ctr"/>
            <a:endParaRPr lang="en-US"/>
          </a:p>
          <a:p>
            <a:pPr marL="285750" indent="-285750" algn="ctr">
              <a:buFont typeface="Arial" panose="020B0604020202020204" pitchFamily="34" charset="0"/>
              <a:buChar char="•"/>
            </a:pPr>
            <a:r>
              <a:rPr lang="en-US"/>
              <a:t>History of bloody diarrhea</a:t>
            </a:r>
          </a:p>
          <a:p>
            <a:pPr marL="285750" indent="-285750" algn="ctr">
              <a:buFont typeface="Arial" panose="020B0604020202020204" pitchFamily="34" charset="0"/>
              <a:buChar char="•"/>
            </a:pPr>
            <a:r>
              <a:rPr lang="en-US"/>
              <a:t>Stool culture positive for Shiga Toxin or </a:t>
            </a:r>
            <a:r>
              <a:rPr lang="en-US" i="1"/>
              <a:t>E. coli O157:H7</a:t>
            </a:r>
          </a:p>
          <a:p>
            <a:pPr marL="285750" indent="-285750" algn="ctr">
              <a:buFont typeface="Arial" panose="020B0604020202020204" pitchFamily="34" charset="0"/>
              <a:buChar char="•"/>
            </a:pPr>
            <a:r>
              <a:rPr lang="en-US"/>
              <a:t>Acute Kidney Injury, HTN</a:t>
            </a:r>
          </a:p>
          <a:p>
            <a:pPr marL="285750" lvl="1" indent="-285750" algn="ctr">
              <a:buFont typeface="Arial" panose="020B0604020202020204" pitchFamily="34" charset="0"/>
              <a:buChar char="•"/>
            </a:pPr>
            <a:r>
              <a:rPr lang="en-US"/>
              <a:t>May see edema, albuminuria</a:t>
            </a:r>
          </a:p>
          <a:p>
            <a:pPr marL="285750" indent="-285750" algn="ctr">
              <a:buFont typeface="Arial" panose="020B0604020202020204" pitchFamily="34" charset="0"/>
              <a:buChar char="•"/>
            </a:pPr>
            <a:r>
              <a:rPr lang="en-US"/>
              <a:t>Neurologic Symptoms (e.g. stroke)</a:t>
            </a:r>
          </a:p>
        </p:txBody>
      </p:sp>
      <p:sp>
        <p:nvSpPr>
          <p:cNvPr id="5" name="TextBox 4">
            <a:extLst>
              <a:ext uri="{FF2B5EF4-FFF2-40B4-BE49-F238E27FC236}">
                <a16:creationId xmlns:a16="http://schemas.microsoft.com/office/drawing/2014/main" id="{3144D86E-A0AE-4AD5-982A-A95306848F2B}"/>
              </a:ext>
            </a:extLst>
          </p:cNvPr>
          <p:cNvSpPr txBox="1"/>
          <p:nvPr/>
        </p:nvSpPr>
        <p:spPr>
          <a:xfrm>
            <a:off x="4484255" y="1321907"/>
            <a:ext cx="3293205" cy="1815882"/>
          </a:xfrm>
          <a:prstGeom prst="rect">
            <a:avLst/>
          </a:prstGeom>
          <a:solidFill>
            <a:schemeClr val="bg1"/>
          </a:solidFill>
        </p:spPr>
        <p:txBody>
          <a:bodyPr wrap="square" lIns="91440" tIns="45720" rIns="91440" bIns="45720" rtlCol="0" anchor="t">
            <a:spAutoFit/>
          </a:bodyPr>
          <a:lstStyle/>
          <a:p>
            <a:pPr algn="ctr"/>
            <a:r>
              <a:rPr lang="en-US" dirty="0"/>
              <a:t>Thrombotic Thrombocytopenic Purpura</a:t>
            </a:r>
          </a:p>
          <a:p>
            <a:pPr algn="ctr"/>
            <a:endParaRPr lang="en-US" dirty="0"/>
          </a:p>
          <a:p>
            <a:pPr marL="285750" indent="-285750" algn="ctr">
              <a:buFont typeface="Arial" panose="020B0604020202020204" pitchFamily="34" charset="0"/>
              <a:buChar char="•"/>
            </a:pPr>
            <a:r>
              <a:rPr lang="en-US" dirty="0"/>
              <a:t>Presence of fever</a:t>
            </a:r>
          </a:p>
          <a:p>
            <a:pPr marL="285750" indent="-285750" algn="ctr">
              <a:buFont typeface="Arial" panose="020B0604020202020204" pitchFamily="34" charset="0"/>
              <a:buChar char="•"/>
            </a:pPr>
            <a:r>
              <a:rPr lang="en-US" dirty="0"/>
              <a:t>Acute kidney injury, hypertension</a:t>
            </a:r>
          </a:p>
          <a:p>
            <a:pPr marL="285750" indent="-285750" algn="ctr">
              <a:buFont typeface="Arial" panose="020B0604020202020204" pitchFamily="34" charset="0"/>
              <a:buChar char="•"/>
            </a:pPr>
            <a:r>
              <a:rPr lang="en-US" dirty="0"/>
              <a:t>Neurologic symptoms (</a:t>
            </a:r>
            <a:r>
              <a:rPr lang="en-US"/>
              <a:t>e.g.,</a:t>
            </a:r>
            <a:r>
              <a:rPr lang="en-US" dirty="0"/>
              <a:t> altered mental status)</a:t>
            </a:r>
          </a:p>
          <a:p>
            <a:pPr marL="285750" indent="-285750" algn="ctr">
              <a:buFont typeface="Arial" panose="020B0604020202020204" pitchFamily="34" charset="0"/>
              <a:buChar char="•"/>
            </a:pPr>
            <a:r>
              <a:rPr lang="en-US" dirty="0"/>
              <a:t>Decreased ADAMTS13 Level</a:t>
            </a:r>
          </a:p>
          <a:p>
            <a:pPr marL="285750" indent="-285750" algn="ctr">
              <a:buFont typeface="Arial" panose="020B0604020202020204" pitchFamily="34" charset="0"/>
              <a:buChar char="•"/>
            </a:pPr>
            <a:endParaRPr lang="en-US" dirty="0"/>
          </a:p>
        </p:txBody>
      </p:sp>
      <p:sp>
        <p:nvSpPr>
          <p:cNvPr id="6" name="TextBox 5">
            <a:extLst>
              <a:ext uri="{FF2B5EF4-FFF2-40B4-BE49-F238E27FC236}">
                <a16:creationId xmlns:a16="http://schemas.microsoft.com/office/drawing/2014/main" id="{38344698-1CFC-4FBE-8AE7-619E47DD1B29}"/>
              </a:ext>
            </a:extLst>
          </p:cNvPr>
          <p:cNvSpPr txBox="1"/>
          <p:nvPr/>
        </p:nvSpPr>
        <p:spPr>
          <a:xfrm>
            <a:off x="1038651" y="3186545"/>
            <a:ext cx="6738810" cy="307777"/>
          </a:xfrm>
          <a:prstGeom prst="rect">
            <a:avLst/>
          </a:prstGeom>
          <a:solidFill>
            <a:schemeClr val="bg1"/>
          </a:solidFill>
        </p:spPr>
        <p:txBody>
          <a:bodyPr wrap="square" rtlCol="0">
            <a:spAutoFit/>
          </a:bodyPr>
          <a:lstStyle/>
          <a:p>
            <a:pPr algn="ctr"/>
            <a:r>
              <a:rPr lang="en-US"/>
              <a:t>Why is it important to differentiate between the two?</a:t>
            </a:r>
          </a:p>
        </p:txBody>
      </p:sp>
    </p:spTree>
    <p:extLst>
      <p:ext uri="{BB962C8B-B14F-4D97-AF65-F5344CB8AC3E}">
        <p14:creationId xmlns:p14="http://schemas.microsoft.com/office/powerpoint/2010/main" val="398448989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300"/>
        <p:cNvGrpSpPr/>
        <p:nvPr/>
      </p:nvGrpSpPr>
      <p:grpSpPr>
        <a:xfrm>
          <a:off x="0" y="0"/>
          <a:ext cx="0" cy="0"/>
          <a:chOff x="0" y="0"/>
          <a:chExt cx="0" cy="0"/>
        </a:xfrm>
      </p:grpSpPr>
      <p:sp>
        <p:nvSpPr>
          <p:cNvPr id="302" name="Google Shape;302;p22"/>
          <p:cNvSpPr txBox="1">
            <a:spLocks noGrp="1"/>
          </p:cNvSpPr>
          <p:nvPr>
            <p:ph type="subTitle" idx="1"/>
          </p:nvPr>
        </p:nvSpPr>
        <p:spPr>
          <a:xfrm>
            <a:off x="1038650" y="640325"/>
            <a:ext cx="7079700" cy="444300"/>
          </a:xfrm>
          <a:prstGeom prst="rect">
            <a:avLst/>
          </a:prstGeom>
        </p:spPr>
        <p:txBody>
          <a:bodyPr spcFirstLastPara="1" wrap="square" lIns="0" tIns="0" rIns="0" bIns="0" anchor="t" anchorCtr="0">
            <a:noAutofit/>
          </a:bodyPr>
          <a:lstStyle/>
          <a:p>
            <a:pPr marL="0" indent="0"/>
            <a:r>
              <a:rPr lang="en-US">
                <a:solidFill>
                  <a:schemeClr val="lt1"/>
                </a:solidFill>
                <a:latin typeface="Bebas Neue"/>
                <a:ea typeface="Bebas Neue"/>
                <a:cs typeface="Bebas Neue"/>
                <a:sym typeface="Bebas Neue"/>
              </a:rPr>
              <a:t>To </a:t>
            </a:r>
            <a:r>
              <a:rPr lang="en-US" err="1">
                <a:solidFill>
                  <a:schemeClr val="lt1"/>
                </a:solidFill>
                <a:latin typeface="Bebas Neue"/>
                <a:ea typeface="Bebas Neue"/>
                <a:cs typeface="Bebas Neue"/>
                <a:sym typeface="Bebas Neue"/>
              </a:rPr>
              <a:t>cbc</a:t>
            </a:r>
            <a:r>
              <a:rPr lang="en-US">
                <a:solidFill>
                  <a:schemeClr val="lt1"/>
                </a:solidFill>
                <a:latin typeface="Bebas Neue"/>
                <a:ea typeface="Bebas Neue"/>
                <a:cs typeface="Bebas Neue"/>
                <a:sym typeface="Bebas Neue"/>
              </a:rPr>
              <a:t> or not to </a:t>
            </a:r>
            <a:r>
              <a:rPr lang="en-US" err="1">
                <a:solidFill>
                  <a:schemeClr val="lt1"/>
                </a:solidFill>
                <a:latin typeface="Bebas Neue"/>
                <a:ea typeface="Bebas Neue"/>
                <a:cs typeface="Bebas Neue"/>
                <a:sym typeface="Bebas Neue"/>
              </a:rPr>
              <a:t>cbc</a:t>
            </a:r>
            <a:endParaRPr lang="en-US">
              <a:solidFill>
                <a:schemeClr val="lt1"/>
              </a:solidFill>
              <a:latin typeface="Bebas Neue"/>
              <a:ea typeface="Bebas Neue"/>
              <a:cs typeface="Bebas Neue"/>
              <a:sym typeface="Bebas Neue"/>
            </a:endParaRPr>
          </a:p>
          <a:p>
            <a:pPr marL="0" lvl="0" indent="0" algn="ctr" rtl="0">
              <a:spcBef>
                <a:spcPts val="600"/>
              </a:spcBef>
              <a:spcAft>
                <a:spcPts val="0"/>
              </a:spcAft>
              <a:buNone/>
            </a:pPr>
            <a:r>
              <a:rPr lang="en"/>
              <a:t>· </a:t>
            </a:r>
            <a:r>
              <a:rPr lang="en">
                <a:solidFill>
                  <a:srgbClr val="FFC319"/>
                </a:solidFill>
              </a:rPr>
              <a:t>$1000</a:t>
            </a:r>
            <a:endParaRPr>
              <a:solidFill>
                <a:srgbClr val="FFC319"/>
              </a:solidFill>
            </a:endParaRPr>
          </a:p>
        </p:txBody>
      </p:sp>
      <p:graphicFrame>
        <p:nvGraphicFramePr>
          <p:cNvPr id="6" name="Table 5">
            <a:extLst>
              <a:ext uri="{FF2B5EF4-FFF2-40B4-BE49-F238E27FC236}">
                <a16:creationId xmlns:a16="http://schemas.microsoft.com/office/drawing/2014/main" id="{D2E3B8A4-34B4-4663-8D49-9BEBAA46486D}"/>
              </a:ext>
            </a:extLst>
          </p:cNvPr>
          <p:cNvGraphicFramePr>
            <a:graphicFrameLocks noGrp="1"/>
          </p:cNvGraphicFramePr>
          <p:nvPr>
            <p:extLst>
              <p:ext uri="{D42A27DB-BD31-4B8C-83A1-F6EECF244321}">
                <p14:modId xmlns:p14="http://schemas.microsoft.com/office/powerpoint/2010/main" val="3198127074"/>
              </p:ext>
            </p:extLst>
          </p:nvPr>
        </p:nvGraphicFramePr>
        <p:xfrm>
          <a:off x="1331399" y="2115439"/>
          <a:ext cx="3240601" cy="1306790"/>
        </p:xfrm>
        <a:graphic>
          <a:graphicData uri="http://schemas.openxmlformats.org/drawingml/2006/table">
            <a:tbl>
              <a:tblPr firstRow="1" bandRow="1">
                <a:tableStyleId>{5C22544A-7EE6-4342-B048-85BDC9FD1C3A}</a:tableStyleId>
              </a:tblPr>
              <a:tblGrid>
                <a:gridCol w="797530">
                  <a:extLst>
                    <a:ext uri="{9D8B030D-6E8A-4147-A177-3AD203B41FA5}">
                      <a16:colId xmlns:a16="http://schemas.microsoft.com/office/drawing/2014/main" val="824425484"/>
                    </a:ext>
                  </a:extLst>
                </a:gridCol>
                <a:gridCol w="484577">
                  <a:extLst>
                    <a:ext uri="{9D8B030D-6E8A-4147-A177-3AD203B41FA5}">
                      <a16:colId xmlns:a16="http://schemas.microsoft.com/office/drawing/2014/main" val="610143289"/>
                    </a:ext>
                  </a:extLst>
                </a:gridCol>
                <a:gridCol w="777339">
                  <a:extLst>
                    <a:ext uri="{9D8B030D-6E8A-4147-A177-3AD203B41FA5}">
                      <a16:colId xmlns:a16="http://schemas.microsoft.com/office/drawing/2014/main" val="3542840054"/>
                    </a:ext>
                  </a:extLst>
                </a:gridCol>
                <a:gridCol w="484576">
                  <a:extLst>
                    <a:ext uri="{9D8B030D-6E8A-4147-A177-3AD203B41FA5}">
                      <a16:colId xmlns:a16="http://schemas.microsoft.com/office/drawing/2014/main" val="3916601039"/>
                    </a:ext>
                  </a:extLst>
                </a:gridCol>
                <a:gridCol w="696579">
                  <a:extLst>
                    <a:ext uri="{9D8B030D-6E8A-4147-A177-3AD203B41FA5}">
                      <a16:colId xmlns:a16="http://schemas.microsoft.com/office/drawing/2014/main" val="4033324111"/>
                    </a:ext>
                  </a:extLst>
                </a:gridCol>
              </a:tblGrid>
              <a:tr h="653395">
                <a:tc rowSpan="2">
                  <a:txBody>
                    <a:bodyPr/>
                    <a:lstStyle/>
                    <a:p>
                      <a:endParaRPr lang="en-US" sz="1200" b="0">
                        <a:solidFill>
                          <a:schemeClr val="tx1"/>
                        </a:solidFill>
                      </a:endParaRPr>
                    </a:p>
                    <a:p>
                      <a:endParaRPr lang="en-US" sz="1200"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ap="flat" cmpd="sng" algn="ctr">
                      <a:noFill/>
                      <a:prstDash val="solid"/>
                      <a:round/>
                      <a:headEnd type="none" w="med" len="med"/>
                      <a:tailEnd type="none" w="med" len="med"/>
                    </a:lnTlToBr>
                    <a:lnBlToTr w="12700" cmpd="sng">
                      <a:noFill/>
                      <a:prstDash val="solid"/>
                    </a:lnBlToTr>
                    <a:solidFill>
                      <a:schemeClr val="bg1"/>
                    </a:solidFill>
                  </a:tcPr>
                </a:tc>
                <a:tc>
                  <a:txBody>
                    <a:bodyPr/>
                    <a:lstStyle/>
                    <a:p>
                      <a:endParaRPr lang="en-US" sz="1200"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ap="flat" cmpd="sng" algn="ctr">
                      <a:solidFill>
                        <a:schemeClr val="tx1"/>
                      </a:solidFill>
                      <a:prstDash val="solid"/>
                      <a:round/>
                      <a:headEnd type="none" w="med" len="med"/>
                      <a:tailEnd type="none" w="med" len="med"/>
                    </a:lnTlToBr>
                    <a:lnBlToTr w="12700" cmpd="sng">
                      <a:noFill/>
                      <a:prstDash val="solid"/>
                    </a:lnBlToTr>
                    <a:solidFill>
                      <a:schemeClr val="bg1"/>
                    </a:solidFill>
                  </a:tcPr>
                </a:tc>
                <a:tc>
                  <a:txBody>
                    <a:bodyPr/>
                    <a:lstStyle/>
                    <a:p>
                      <a:pPr algn="ctr"/>
                      <a:endParaRPr lang="en-US" sz="1200" b="0">
                        <a:solidFill>
                          <a:schemeClr val="tx1"/>
                        </a:solidFill>
                      </a:endParaRPr>
                    </a:p>
                    <a:p>
                      <a:pPr algn="ctr"/>
                      <a:r>
                        <a:rPr lang="en-US" sz="1800" b="0">
                          <a:solidFill>
                            <a:schemeClr val="tx1"/>
                          </a:solidFill>
                        </a:rPr>
                        <a:t>4.7</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1200"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ap="flat" cmpd="sng" algn="ctr">
                      <a:solidFill>
                        <a:schemeClr val="tx1"/>
                      </a:solidFill>
                      <a:prstDash val="solid"/>
                      <a:round/>
                      <a:headEnd type="none" w="med" len="med"/>
                      <a:tailEnd type="none" w="med" len="med"/>
                    </a:lnBlToTr>
                    <a:solidFill>
                      <a:schemeClr val="bg1"/>
                    </a:solidFill>
                  </a:tcPr>
                </a:tc>
                <a:tc rowSpan="2">
                  <a:txBody>
                    <a:bodyPr/>
                    <a:lstStyle/>
                    <a:p>
                      <a:endParaRPr lang="en-US" sz="1200" b="0">
                        <a:solidFill>
                          <a:schemeClr val="tx1"/>
                        </a:solidFill>
                      </a:endParaRPr>
                    </a:p>
                    <a:p>
                      <a:endParaRPr lang="en-US" sz="1200"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ap="flat" cmpd="sng" algn="ctr">
                      <a:noFill/>
                      <a:prstDash val="solid"/>
                      <a:round/>
                      <a:headEnd type="none" w="med" len="med"/>
                      <a:tailEnd type="none" w="med" len="med"/>
                    </a:lnBlToTr>
                    <a:solidFill>
                      <a:schemeClr val="bg1"/>
                    </a:solidFill>
                  </a:tcPr>
                </a:tc>
                <a:extLst>
                  <a:ext uri="{0D108BD9-81ED-4DB2-BD59-A6C34878D82A}">
                    <a16:rowId xmlns:a16="http://schemas.microsoft.com/office/drawing/2014/main" val="727745014"/>
                  </a:ext>
                </a:extLst>
              </a:tr>
              <a:tr h="653395">
                <a:tc vMerge="1">
                  <a:txBody>
                    <a:bodyPr/>
                    <a:lstStyle/>
                    <a:p>
                      <a:endParaRPr lang="en-US"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ap="flat" cmpd="sng" algn="ctr">
                      <a:noFill/>
                      <a:prstDash val="solid"/>
                      <a:round/>
                      <a:headEnd type="none" w="med" len="med"/>
                      <a:tailEnd type="none" w="med" len="med"/>
                    </a:lnBlToTr>
                    <a:solidFill>
                      <a:schemeClr val="bg1"/>
                    </a:solidFill>
                  </a:tcPr>
                </a:tc>
                <a:tc>
                  <a:txBody>
                    <a:bodyPr/>
                    <a:lstStyle/>
                    <a:p>
                      <a:endParaRPr lang="en-US" sz="1200"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ap="flat" cmpd="sng" algn="ctr">
                      <a:solidFill>
                        <a:schemeClr val="tx1"/>
                      </a:solidFill>
                      <a:prstDash val="solid"/>
                      <a:round/>
                      <a:headEnd type="none" w="med" len="med"/>
                      <a:tailEnd type="none" w="med" len="med"/>
                    </a:lnBlToTr>
                    <a:solidFill>
                      <a:schemeClr val="bg1"/>
                    </a:solidFill>
                  </a:tcPr>
                </a:tc>
                <a:tc>
                  <a:txBody>
                    <a:bodyPr/>
                    <a:lstStyle/>
                    <a:p>
                      <a:endParaRPr lang="en-US" sz="1200"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1200"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ap="flat" cmpd="sng" algn="ctr">
                      <a:solidFill>
                        <a:schemeClr val="tx1"/>
                      </a:solidFill>
                      <a:prstDash val="solid"/>
                      <a:round/>
                      <a:headEnd type="none" w="med" len="med"/>
                      <a:tailEnd type="none" w="med" len="med"/>
                    </a:lnTlToBr>
                    <a:lnBlToTr w="12700" cap="flat" cmpd="sng" algn="ctr">
                      <a:noFill/>
                      <a:prstDash val="solid"/>
                      <a:round/>
                      <a:headEnd type="none" w="med" len="med"/>
                      <a:tailEnd type="none" w="med" len="med"/>
                    </a:lnBlToTr>
                    <a:solidFill>
                      <a:schemeClr val="bg1"/>
                    </a:solidFill>
                  </a:tcPr>
                </a:tc>
                <a:tc vMerge="1">
                  <a:txBody>
                    <a:bodyPr/>
                    <a:lstStyle/>
                    <a:p>
                      <a:endParaRPr lang="en-US"/>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ap="flat" cmpd="sng" algn="ctr">
                      <a:noFill/>
                      <a:prstDash val="solid"/>
                      <a:round/>
                      <a:headEnd type="none" w="med" len="med"/>
                      <a:tailEnd type="none" w="med" len="med"/>
                    </a:lnTlToBr>
                    <a:lnBlToTr w="12700" cap="flat" cmpd="sng" algn="ctr">
                      <a:noFill/>
                      <a:prstDash val="solid"/>
                      <a:round/>
                      <a:headEnd type="none" w="med" len="med"/>
                      <a:tailEnd type="none" w="med" len="med"/>
                    </a:lnBlToTr>
                    <a:solidFill>
                      <a:schemeClr val="bg1"/>
                    </a:solidFill>
                  </a:tcPr>
                </a:tc>
                <a:extLst>
                  <a:ext uri="{0D108BD9-81ED-4DB2-BD59-A6C34878D82A}">
                    <a16:rowId xmlns:a16="http://schemas.microsoft.com/office/drawing/2014/main" val="2515014331"/>
                  </a:ext>
                </a:extLst>
              </a:tr>
            </a:tbl>
          </a:graphicData>
        </a:graphic>
      </p:graphicFrame>
      <p:sp>
        <p:nvSpPr>
          <p:cNvPr id="4" name="TextBox 3">
            <a:extLst>
              <a:ext uri="{FF2B5EF4-FFF2-40B4-BE49-F238E27FC236}">
                <a16:creationId xmlns:a16="http://schemas.microsoft.com/office/drawing/2014/main" id="{B900F8A2-A3CF-4882-9F6E-A4A4DBACF2DB}"/>
              </a:ext>
            </a:extLst>
          </p:cNvPr>
          <p:cNvSpPr txBox="1"/>
          <p:nvPr/>
        </p:nvSpPr>
        <p:spPr>
          <a:xfrm>
            <a:off x="4913745" y="2115439"/>
            <a:ext cx="3094182" cy="1815882"/>
          </a:xfrm>
          <a:prstGeom prst="rect">
            <a:avLst/>
          </a:prstGeom>
          <a:solidFill>
            <a:schemeClr val="bg1"/>
          </a:solidFill>
        </p:spPr>
        <p:txBody>
          <a:bodyPr wrap="square" rtlCol="0">
            <a:spAutoFit/>
          </a:bodyPr>
          <a:lstStyle/>
          <a:p>
            <a:r>
              <a:rPr lang="en-US" dirty="0"/>
              <a:t>This hemoglobin was obtained on a 7-year-old patient with </a:t>
            </a:r>
            <a:r>
              <a:rPr lang="en-US" dirty="0" err="1"/>
              <a:t>HgbSS</a:t>
            </a:r>
            <a:r>
              <a:rPr lang="en-US" dirty="0"/>
              <a:t> Disease. </a:t>
            </a:r>
          </a:p>
          <a:p>
            <a:endParaRPr lang="en-US" dirty="0"/>
          </a:p>
          <a:p>
            <a:r>
              <a:rPr lang="en-US" dirty="0"/>
              <a:t>What are three etiologies of acute anemia in a patient with </a:t>
            </a:r>
            <a:r>
              <a:rPr lang="en-US" dirty="0" err="1"/>
              <a:t>HgbSS</a:t>
            </a:r>
            <a:r>
              <a:rPr lang="en-US" dirty="0"/>
              <a:t>? How would you differentiate between these using clinical reasoning skills?</a:t>
            </a: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a:extLst>
              <a:ext uri="{FF2B5EF4-FFF2-40B4-BE49-F238E27FC236}">
                <a16:creationId xmlns:a16="http://schemas.microsoft.com/office/drawing/2014/main" id="{C0320584-81F6-4442-8A34-EA286FCB7F11}"/>
              </a:ext>
            </a:extLst>
          </p:cNvPr>
          <p:cNvSpPr>
            <a:spLocks noGrp="1"/>
          </p:cNvSpPr>
          <p:nvPr>
            <p:ph type="subTitle" idx="1"/>
          </p:nvPr>
        </p:nvSpPr>
        <p:spPr/>
        <p:txBody>
          <a:bodyPr/>
          <a:lstStyle/>
          <a:p>
            <a:r>
              <a:rPr lang="en-US"/>
              <a:t>Acute anemia in Hgb ss</a:t>
            </a:r>
          </a:p>
        </p:txBody>
      </p:sp>
      <p:sp>
        <p:nvSpPr>
          <p:cNvPr id="4" name="TextBox 3">
            <a:extLst>
              <a:ext uri="{FF2B5EF4-FFF2-40B4-BE49-F238E27FC236}">
                <a16:creationId xmlns:a16="http://schemas.microsoft.com/office/drawing/2014/main" id="{5D6DF9E8-182A-41AB-9BF7-031A3A4BA22C}"/>
              </a:ext>
            </a:extLst>
          </p:cNvPr>
          <p:cNvSpPr txBox="1"/>
          <p:nvPr/>
        </p:nvSpPr>
        <p:spPr>
          <a:xfrm>
            <a:off x="789268" y="1402199"/>
            <a:ext cx="2392218" cy="2339102"/>
          </a:xfrm>
          <a:prstGeom prst="rect">
            <a:avLst/>
          </a:prstGeom>
          <a:solidFill>
            <a:schemeClr val="bg1"/>
          </a:solidFill>
        </p:spPr>
        <p:txBody>
          <a:bodyPr wrap="square" rtlCol="0">
            <a:spAutoFit/>
          </a:bodyPr>
          <a:lstStyle/>
          <a:p>
            <a:pPr algn="ctr"/>
            <a:r>
              <a:rPr lang="en-US" sz="1800"/>
              <a:t>Aplastic Crisis</a:t>
            </a:r>
          </a:p>
          <a:p>
            <a:pPr marL="285750" indent="-285750" algn="ctr">
              <a:buFont typeface="Arial" panose="020B0604020202020204" pitchFamily="34" charset="0"/>
              <a:buChar char="•"/>
            </a:pPr>
            <a:r>
              <a:rPr lang="en-US" sz="1600"/>
              <a:t>Decreased reticulocyte count</a:t>
            </a:r>
          </a:p>
          <a:p>
            <a:pPr marL="285750" indent="-285750" algn="ctr">
              <a:buFont typeface="Arial" panose="020B0604020202020204" pitchFamily="34" charset="0"/>
              <a:buChar char="•"/>
            </a:pPr>
            <a:r>
              <a:rPr lang="en-US" sz="1600"/>
              <a:t>Recent infection with Parvovirus B19 (e.g. positive sick contacts, arthralgias, Fifth Disease rash)</a:t>
            </a:r>
          </a:p>
          <a:p>
            <a:pPr marL="285750" indent="-285750" algn="ctr">
              <a:buFont typeface="Arial" panose="020B0604020202020204" pitchFamily="34" charset="0"/>
              <a:buChar char="•"/>
            </a:pPr>
            <a:r>
              <a:rPr lang="en-US" sz="1600"/>
              <a:t>Baseline Bilirubin</a:t>
            </a:r>
          </a:p>
        </p:txBody>
      </p:sp>
      <p:sp>
        <p:nvSpPr>
          <p:cNvPr id="5" name="TextBox 4">
            <a:extLst>
              <a:ext uri="{FF2B5EF4-FFF2-40B4-BE49-F238E27FC236}">
                <a16:creationId xmlns:a16="http://schemas.microsoft.com/office/drawing/2014/main" id="{55374428-396C-4076-BF42-C1AF4C9BE7DA}"/>
              </a:ext>
            </a:extLst>
          </p:cNvPr>
          <p:cNvSpPr txBox="1"/>
          <p:nvPr/>
        </p:nvSpPr>
        <p:spPr>
          <a:xfrm>
            <a:off x="5975514" y="1402199"/>
            <a:ext cx="2392218" cy="2369880"/>
          </a:xfrm>
          <a:prstGeom prst="rect">
            <a:avLst/>
          </a:prstGeom>
          <a:solidFill>
            <a:schemeClr val="bg1"/>
          </a:solidFill>
        </p:spPr>
        <p:txBody>
          <a:bodyPr wrap="square" rtlCol="0">
            <a:spAutoFit/>
          </a:bodyPr>
          <a:lstStyle/>
          <a:p>
            <a:pPr algn="ctr"/>
            <a:r>
              <a:rPr lang="en-US" sz="1800"/>
              <a:t>Splenic Sequestration</a:t>
            </a:r>
          </a:p>
          <a:p>
            <a:pPr marL="285750" indent="-285750" algn="ctr">
              <a:buFont typeface="Arial" panose="020B0604020202020204" pitchFamily="34" charset="0"/>
              <a:buChar char="•"/>
            </a:pPr>
            <a:r>
              <a:rPr lang="en-US" sz="1600"/>
              <a:t>Acute-onset abdominal pain</a:t>
            </a:r>
          </a:p>
          <a:p>
            <a:pPr marL="285750" indent="-285750" algn="ctr">
              <a:buFont typeface="Arial" panose="020B0604020202020204" pitchFamily="34" charset="0"/>
              <a:buChar char="•"/>
            </a:pPr>
            <a:r>
              <a:rPr lang="en-US" sz="1600"/>
              <a:t>Splenomegaly</a:t>
            </a:r>
          </a:p>
          <a:p>
            <a:pPr marL="285750" indent="-285750" algn="ctr">
              <a:buFont typeface="Arial" panose="020B0604020202020204" pitchFamily="34" charset="0"/>
              <a:buChar char="•"/>
            </a:pPr>
            <a:r>
              <a:rPr lang="en-US" sz="1600"/>
              <a:t>Increased reticulocyte count</a:t>
            </a:r>
          </a:p>
          <a:p>
            <a:pPr marL="285750" indent="-285750" algn="ctr">
              <a:buFont typeface="Arial" panose="020B0604020202020204" pitchFamily="34" charset="0"/>
              <a:buChar char="•"/>
            </a:pPr>
            <a:r>
              <a:rPr lang="en-US" sz="1600"/>
              <a:t>Thrombocytopenia</a:t>
            </a:r>
          </a:p>
          <a:p>
            <a:pPr marL="285750" indent="-285750" algn="ctr">
              <a:buFont typeface="Arial" panose="020B0604020202020204" pitchFamily="34" charset="0"/>
              <a:buChar char="•"/>
            </a:pPr>
            <a:r>
              <a:rPr lang="en-US" sz="1600"/>
              <a:t>Baseline bilirubin</a:t>
            </a:r>
          </a:p>
        </p:txBody>
      </p:sp>
      <p:sp>
        <p:nvSpPr>
          <p:cNvPr id="6" name="TextBox 5">
            <a:extLst>
              <a:ext uri="{FF2B5EF4-FFF2-40B4-BE49-F238E27FC236}">
                <a16:creationId xmlns:a16="http://schemas.microsoft.com/office/drawing/2014/main" id="{4BE2217C-A0C4-4283-964A-CD5C26A4EFEB}"/>
              </a:ext>
            </a:extLst>
          </p:cNvPr>
          <p:cNvSpPr txBox="1"/>
          <p:nvPr/>
        </p:nvSpPr>
        <p:spPr>
          <a:xfrm>
            <a:off x="3382391" y="1402199"/>
            <a:ext cx="2392218" cy="2831544"/>
          </a:xfrm>
          <a:prstGeom prst="rect">
            <a:avLst/>
          </a:prstGeom>
          <a:solidFill>
            <a:schemeClr val="bg1"/>
          </a:solidFill>
        </p:spPr>
        <p:txBody>
          <a:bodyPr wrap="square" rtlCol="0">
            <a:spAutoFit/>
          </a:bodyPr>
          <a:lstStyle/>
          <a:p>
            <a:pPr algn="ctr"/>
            <a:r>
              <a:rPr lang="en-US" sz="1800"/>
              <a:t>Vaso-Occlusive Episode</a:t>
            </a:r>
          </a:p>
          <a:p>
            <a:pPr marL="285750" indent="-285750" algn="ctr">
              <a:buFont typeface="Arial" panose="020B0604020202020204" pitchFamily="34" charset="0"/>
              <a:buChar char="•"/>
            </a:pPr>
            <a:r>
              <a:rPr lang="en-US" sz="1600"/>
              <a:t>Pain typical of past VOE</a:t>
            </a:r>
          </a:p>
          <a:p>
            <a:pPr marL="285750" indent="-285750" algn="ctr">
              <a:buFont typeface="Arial" panose="020B0604020202020204" pitchFamily="34" charset="0"/>
              <a:buChar char="•"/>
            </a:pPr>
            <a:r>
              <a:rPr lang="en-US" sz="1600"/>
              <a:t>Increased reticulocyte count</a:t>
            </a:r>
          </a:p>
          <a:p>
            <a:pPr marL="285750" indent="-285750" algn="ctr">
              <a:buFont typeface="Arial" panose="020B0604020202020204" pitchFamily="34" charset="0"/>
              <a:buChar char="•"/>
            </a:pPr>
            <a:r>
              <a:rPr lang="en-US" sz="1600"/>
              <a:t>Possible increase in MCV (</a:t>
            </a:r>
            <a:r>
              <a:rPr lang="en-US" sz="1600" i="1" err="1"/>
              <a:t>reticulocytosis</a:t>
            </a:r>
            <a:r>
              <a:rPr lang="en-US" sz="1600"/>
              <a:t>)</a:t>
            </a:r>
          </a:p>
          <a:p>
            <a:pPr marL="285750" indent="-285750" algn="ctr">
              <a:buFont typeface="Arial" panose="020B0604020202020204" pitchFamily="34" charset="0"/>
              <a:buChar char="•"/>
            </a:pPr>
            <a:r>
              <a:rPr lang="en-US" sz="1600"/>
              <a:t>Increased bilirubin</a:t>
            </a:r>
          </a:p>
          <a:p>
            <a:pPr marL="285750" indent="-285750" algn="ctr">
              <a:buFont typeface="Arial" panose="020B0604020202020204" pitchFamily="34" charset="0"/>
              <a:buChar char="•"/>
            </a:pPr>
            <a:r>
              <a:rPr lang="en-US" sz="1600"/>
              <a:t>Increased </a:t>
            </a:r>
            <a:r>
              <a:rPr lang="en-US" sz="1600" err="1"/>
              <a:t>HgbS</a:t>
            </a:r>
            <a:r>
              <a:rPr lang="en-US" sz="1600"/>
              <a:t>% </a:t>
            </a:r>
          </a:p>
          <a:p>
            <a:endParaRPr lang="en-US"/>
          </a:p>
        </p:txBody>
      </p:sp>
    </p:spTree>
    <p:extLst>
      <p:ext uri="{BB962C8B-B14F-4D97-AF65-F5344CB8AC3E}">
        <p14:creationId xmlns:p14="http://schemas.microsoft.com/office/powerpoint/2010/main" val="71101622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306"/>
        <p:cNvGrpSpPr/>
        <p:nvPr/>
      </p:nvGrpSpPr>
      <p:grpSpPr>
        <a:xfrm>
          <a:off x="0" y="0"/>
          <a:ext cx="0" cy="0"/>
          <a:chOff x="0" y="0"/>
          <a:chExt cx="0" cy="0"/>
        </a:xfrm>
      </p:grpSpPr>
      <p:sp>
        <p:nvSpPr>
          <p:cNvPr id="307" name="Google Shape;307;p23"/>
          <p:cNvSpPr txBox="1">
            <a:spLocks noGrp="1"/>
          </p:cNvSpPr>
          <p:nvPr>
            <p:ph type="title"/>
          </p:nvPr>
        </p:nvSpPr>
        <p:spPr>
          <a:xfrm>
            <a:off x="1032075" y="966325"/>
            <a:ext cx="7081800" cy="3188100"/>
          </a:xfrm>
          <a:prstGeom prst="rect">
            <a:avLst/>
          </a:prstGeom>
        </p:spPr>
        <p:txBody>
          <a:bodyPr spcFirstLastPara="1" wrap="square" lIns="0" tIns="0" rIns="0" bIns="0" anchor="ctr" anchorCtr="0">
            <a:noAutofit/>
          </a:bodyPr>
          <a:lstStyle/>
          <a:p>
            <a:pPr marL="0" lvl="0" indent="0" algn="ctr" rtl="0">
              <a:spcBef>
                <a:spcPts val="0"/>
              </a:spcBef>
              <a:spcAft>
                <a:spcPts val="0"/>
              </a:spcAft>
              <a:buNone/>
            </a:pPr>
            <a:r>
              <a:rPr lang="en-US" dirty="0"/>
              <a:t>T</a:t>
            </a:r>
            <a:r>
              <a:rPr lang="en" dirty="0"/>
              <a:t>his is the ABG of a </a:t>
            </a:r>
            <a:r>
              <a:rPr lang="en-US" dirty="0"/>
              <a:t>2-year-old</a:t>
            </a:r>
            <a:r>
              <a:rPr lang="en" dirty="0"/>
              <a:t> male who presents with moderate dehydration after 4 days of diarrhea and poor PO with other sick contacts at home</a:t>
            </a:r>
            <a:endParaRPr dirty="0"/>
          </a:p>
        </p:txBody>
      </p:sp>
      <p:sp>
        <p:nvSpPr>
          <p:cNvPr id="308" name="Google Shape;308;p23"/>
          <p:cNvSpPr txBox="1">
            <a:spLocks noGrp="1"/>
          </p:cNvSpPr>
          <p:nvPr>
            <p:ph type="subTitle" idx="1"/>
          </p:nvPr>
        </p:nvSpPr>
        <p:spPr>
          <a:xfrm>
            <a:off x="1038650" y="640325"/>
            <a:ext cx="7079700" cy="444300"/>
          </a:xfrm>
          <a:prstGeom prst="rect">
            <a:avLst/>
          </a:prstGeom>
        </p:spPr>
        <p:txBody>
          <a:bodyPr spcFirstLastPara="1" wrap="square" lIns="0" tIns="0" rIns="0" bIns="0" anchor="t" anchorCtr="0">
            <a:noAutofit/>
          </a:bodyPr>
          <a:lstStyle/>
          <a:p>
            <a:pPr marL="0" lvl="0" indent="0" algn="ctr" rtl="0">
              <a:spcBef>
                <a:spcPts val="600"/>
              </a:spcBef>
              <a:spcAft>
                <a:spcPts val="0"/>
              </a:spcAft>
              <a:buNone/>
            </a:pPr>
            <a:r>
              <a:rPr lang="en"/>
              <a:t>CATEGORY 2 · </a:t>
            </a:r>
            <a:r>
              <a:rPr lang="en">
                <a:solidFill>
                  <a:srgbClr val="FFC319"/>
                </a:solidFill>
              </a:rPr>
              <a:t>$200</a:t>
            </a:r>
            <a:endParaRPr>
              <a:solidFill>
                <a:srgbClr val="FFC319"/>
              </a:solidFill>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4">
            <a:extLst>
              <a:ext uri="{FF2B5EF4-FFF2-40B4-BE49-F238E27FC236}">
                <a16:creationId xmlns:a16="http://schemas.microsoft.com/office/drawing/2014/main" id="{3215665E-1D94-4A7C-B02C-7C8AC9980C0D}"/>
              </a:ext>
            </a:extLst>
          </p:cNvPr>
          <p:cNvGraphicFramePr>
            <a:graphicFrameLocks noGrp="1"/>
          </p:cNvGraphicFramePr>
          <p:nvPr>
            <p:extLst>
              <p:ext uri="{D42A27DB-BD31-4B8C-83A1-F6EECF244321}">
                <p14:modId xmlns:p14="http://schemas.microsoft.com/office/powerpoint/2010/main" val="3996389126"/>
              </p:ext>
            </p:extLst>
          </p:nvPr>
        </p:nvGraphicFramePr>
        <p:xfrm>
          <a:off x="866774" y="836445"/>
          <a:ext cx="7362828" cy="2527050"/>
        </p:xfrm>
        <a:graphic>
          <a:graphicData uri="http://schemas.openxmlformats.org/drawingml/2006/table">
            <a:tbl>
              <a:tblPr firstRow="1" bandRow="1">
                <a:tableStyleId>{5C22544A-7EE6-4342-B048-85BDC9FD1C3A}</a:tableStyleId>
              </a:tblPr>
              <a:tblGrid>
                <a:gridCol w="1227138">
                  <a:extLst>
                    <a:ext uri="{9D8B030D-6E8A-4147-A177-3AD203B41FA5}">
                      <a16:colId xmlns:a16="http://schemas.microsoft.com/office/drawing/2014/main" val="2956672230"/>
                    </a:ext>
                  </a:extLst>
                </a:gridCol>
                <a:gridCol w="1227138">
                  <a:extLst>
                    <a:ext uri="{9D8B030D-6E8A-4147-A177-3AD203B41FA5}">
                      <a16:colId xmlns:a16="http://schemas.microsoft.com/office/drawing/2014/main" val="3366791402"/>
                    </a:ext>
                  </a:extLst>
                </a:gridCol>
                <a:gridCol w="1227138">
                  <a:extLst>
                    <a:ext uri="{9D8B030D-6E8A-4147-A177-3AD203B41FA5}">
                      <a16:colId xmlns:a16="http://schemas.microsoft.com/office/drawing/2014/main" val="1166372328"/>
                    </a:ext>
                  </a:extLst>
                </a:gridCol>
                <a:gridCol w="1227138">
                  <a:extLst>
                    <a:ext uri="{9D8B030D-6E8A-4147-A177-3AD203B41FA5}">
                      <a16:colId xmlns:a16="http://schemas.microsoft.com/office/drawing/2014/main" val="3425385262"/>
                    </a:ext>
                  </a:extLst>
                </a:gridCol>
                <a:gridCol w="1227138">
                  <a:extLst>
                    <a:ext uri="{9D8B030D-6E8A-4147-A177-3AD203B41FA5}">
                      <a16:colId xmlns:a16="http://schemas.microsoft.com/office/drawing/2014/main" val="1561456660"/>
                    </a:ext>
                  </a:extLst>
                </a:gridCol>
                <a:gridCol w="1227138">
                  <a:extLst>
                    <a:ext uri="{9D8B030D-6E8A-4147-A177-3AD203B41FA5}">
                      <a16:colId xmlns:a16="http://schemas.microsoft.com/office/drawing/2014/main" val="3670303674"/>
                    </a:ext>
                  </a:extLst>
                </a:gridCol>
              </a:tblGrid>
              <a:tr h="505410">
                <a:tc>
                  <a:txBody>
                    <a:bodyPr/>
                    <a:lstStyle/>
                    <a:p>
                      <a:pPr algn="ctr"/>
                      <a:r>
                        <a:rPr lang="en-US"/>
                        <a:t>pH</a:t>
                      </a:r>
                    </a:p>
                  </a:txBody>
                  <a:tcPr/>
                </a:tc>
                <a:tc>
                  <a:txBody>
                    <a:bodyPr/>
                    <a:lstStyle/>
                    <a:p>
                      <a:pPr algn="ctr"/>
                      <a:r>
                        <a:rPr lang="en-US"/>
                        <a:t>pCO2</a:t>
                      </a:r>
                    </a:p>
                  </a:txBody>
                  <a:tcPr/>
                </a:tc>
                <a:tc>
                  <a:txBody>
                    <a:bodyPr/>
                    <a:lstStyle/>
                    <a:p>
                      <a:pPr algn="ctr"/>
                      <a:r>
                        <a:rPr lang="en-US"/>
                        <a:t>HCO3-</a:t>
                      </a:r>
                    </a:p>
                  </a:txBody>
                  <a:tcPr/>
                </a:tc>
                <a:tc>
                  <a:txBody>
                    <a:bodyPr/>
                    <a:lstStyle/>
                    <a:p>
                      <a:pPr algn="ctr"/>
                      <a:r>
                        <a:rPr lang="en-US"/>
                        <a:t>Na+</a:t>
                      </a:r>
                    </a:p>
                  </a:txBody>
                  <a:tcPr/>
                </a:tc>
                <a:tc>
                  <a:txBody>
                    <a:bodyPr/>
                    <a:lstStyle/>
                    <a:p>
                      <a:pPr algn="ctr"/>
                      <a:r>
                        <a:rPr lang="en-US"/>
                        <a:t>K+</a:t>
                      </a:r>
                    </a:p>
                  </a:txBody>
                  <a:tcPr/>
                </a:tc>
                <a:tc>
                  <a:txBody>
                    <a:bodyPr/>
                    <a:lstStyle/>
                    <a:p>
                      <a:pPr algn="ctr"/>
                      <a:r>
                        <a:rPr lang="en-US"/>
                        <a:t>Cl-</a:t>
                      </a:r>
                    </a:p>
                  </a:txBody>
                  <a:tcPr/>
                </a:tc>
                <a:extLst>
                  <a:ext uri="{0D108BD9-81ED-4DB2-BD59-A6C34878D82A}">
                    <a16:rowId xmlns:a16="http://schemas.microsoft.com/office/drawing/2014/main" val="3925621980"/>
                  </a:ext>
                </a:extLst>
              </a:tr>
              <a:tr h="505410">
                <a:tc>
                  <a:txBody>
                    <a:bodyPr/>
                    <a:lstStyle/>
                    <a:p>
                      <a:r>
                        <a:rPr lang="en-US"/>
                        <a:t>7.25</a:t>
                      </a:r>
                    </a:p>
                  </a:txBody>
                  <a:tcPr/>
                </a:tc>
                <a:tc>
                  <a:txBody>
                    <a:bodyPr/>
                    <a:lstStyle/>
                    <a:p>
                      <a:r>
                        <a:rPr lang="en-US"/>
                        <a:t>36</a:t>
                      </a:r>
                    </a:p>
                  </a:txBody>
                  <a:tcPr/>
                </a:tc>
                <a:tc>
                  <a:txBody>
                    <a:bodyPr/>
                    <a:lstStyle/>
                    <a:p>
                      <a:r>
                        <a:rPr lang="en-US"/>
                        <a:t>28</a:t>
                      </a:r>
                    </a:p>
                  </a:txBody>
                  <a:tcPr/>
                </a:tc>
                <a:tc>
                  <a:txBody>
                    <a:bodyPr/>
                    <a:lstStyle/>
                    <a:p>
                      <a:r>
                        <a:rPr lang="en-US"/>
                        <a:t>137</a:t>
                      </a:r>
                    </a:p>
                  </a:txBody>
                  <a:tcPr/>
                </a:tc>
                <a:tc>
                  <a:txBody>
                    <a:bodyPr/>
                    <a:lstStyle/>
                    <a:p>
                      <a:r>
                        <a:rPr lang="en-US"/>
                        <a:t>4.6</a:t>
                      </a:r>
                    </a:p>
                  </a:txBody>
                  <a:tcPr/>
                </a:tc>
                <a:tc>
                  <a:txBody>
                    <a:bodyPr/>
                    <a:lstStyle/>
                    <a:p>
                      <a:r>
                        <a:rPr lang="en-US"/>
                        <a:t>110</a:t>
                      </a:r>
                    </a:p>
                  </a:txBody>
                  <a:tcPr/>
                </a:tc>
                <a:extLst>
                  <a:ext uri="{0D108BD9-81ED-4DB2-BD59-A6C34878D82A}">
                    <a16:rowId xmlns:a16="http://schemas.microsoft.com/office/drawing/2014/main" val="1549369976"/>
                  </a:ext>
                </a:extLst>
              </a:tr>
              <a:tr h="505410">
                <a:tc>
                  <a:txBody>
                    <a:bodyPr/>
                    <a:lstStyle/>
                    <a:p>
                      <a:r>
                        <a:rPr lang="en-US"/>
                        <a:t>7.25</a:t>
                      </a:r>
                    </a:p>
                  </a:txBody>
                  <a:tcPr/>
                </a:tc>
                <a:tc>
                  <a:txBody>
                    <a:bodyPr/>
                    <a:lstStyle/>
                    <a:p>
                      <a:r>
                        <a:rPr lang="en-US"/>
                        <a:t>36</a:t>
                      </a:r>
                    </a:p>
                  </a:txBody>
                  <a:tcPr/>
                </a:tc>
                <a:tc>
                  <a:txBody>
                    <a:bodyPr/>
                    <a:lstStyle/>
                    <a:p>
                      <a:r>
                        <a:rPr lang="en-US"/>
                        <a:t>22</a:t>
                      </a:r>
                    </a:p>
                  </a:txBody>
                  <a:tcPr/>
                </a:tc>
                <a:tc>
                  <a:txBody>
                    <a:bodyPr/>
                    <a:lstStyle/>
                    <a:p>
                      <a:r>
                        <a:rPr lang="en-US"/>
                        <a:t>135</a:t>
                      </a:r>
                    </a:p>
                  </a:txBody>
                  <a:tcPr/>
                </a:tc>
                <a:tc>
                  <a:txBody>
                    <a:bodyPr/>
                    <a:lstStyle/>
                    <a:p>
                      <a:r>
                        <a:rPr lang="en-US"/>
                        <a:t>4.5</a:t>
                      </a:r>
                    </a:p>
                  </a:txBody>
                  <a:tcPr/>
                </a:tc>
                <a:tc>
                  <a:txBody>
                    <a:bodyPr/>
                    <a:lstStyle/>
                    <a:p>
                      <a:r>
                        <a:rPr lang="en-US"/>
                        <a:t>105</a:t>
                      </a:r>
                    </a:p>
                  </a:txBody>
                  <a:tcPr/>
                </a:tc>
                <a:extLst>
                  <a:ext uri="{0D108BD9-81ED-4DB2-BD59-A6C34878D82A}">
                    <a16:rowId xmlns:a16="http://schemas.microsoft.com/office/drawing/2014/main" val="3365227491"/>
                  </a:ext>
                </a:extLst>
              </a:tr>
              <a:tr h="505410">
                <a:tc>
                  <a:txBody>
                    <a:bodyPr/>
                    <a:lstStyle/>
                    <a:p>
                      <a:r>
                        <a:rPr lang="en-US"/>
                        <a:t>7.40</a:t>
                      </a:r>
                    </a:p>
                  </a:txBody>
                  <a:tcPr/>
                </a:tc>
                <a:tc>
                  <a:txBody>
                    <a:bodyPr/>
                    <a:lstStyle/>
                    <a:p>
                      <a:r>
                        <a:rPr lang="en-US"/>
                        <a:t>38</a:t>
                      </a:r>
                    </a:p>
                  </a:txBody>
                  <a:tcPr/>
                </a:tc>
                <a:tc>
                  <a:txBody>
                    <a:bodyPr/>
                    <a:lstStyle/>
                    <a:p>
                      <a:r>
                        <a:rPr lang="en-US"/>
                        <a:t>28</a:t>
                      </a:r>
                    </a:p>
                  </a:txBody>
                  <a:tcPr/>
                </a:tc>
                <a:tc>
                  <a:txBody>
                    <a:bodyPr/>
                    <a:lstStyle/>
                    <a:p>
                      <a:r>
                        <a:rPr lang="en-US"/>
                        <a:t>140</a:t>
                      </a:r>
                    </a:p>
                  </a:txBody>
                  <a:tcPr/>
                </a:tc>
                <a:tc>
                  <a:txBody>
                    <a:bodyPr/>
                    <a:lstStyle/>
                    <a:p>
                      <a:r>
                        <a:rPr lang="en-US"/>
                        <a:t>4.5</a:t>
                      </a:r>
                    </a:p>
                  </a:txBody>
                  <a:tcPr/>
                </a:tc>
                <a:tc>
                  <a:txBody>
                    <a:bodyPr/>
                    <a:lstStyle/>
                    <a:p>
                      <a:r>
                        <a:rPr lang="en-US"/>
                        <a:t>105</a:t>
                      </a:r>
                    </a:p>
                  </a:txBody>
                  <a:tcPr/>
                </a:tc>
                <a:extLst>
                  <a:ext uri="{0D108BD9-81ED-4DB2-BD59-A6C34878D82A}">
                    <a16:rowId xmlns:a16="http://schemas.microsoft.com/office/drawing/2014/main" val="2197128974"/>
                  </a:ext>
                </a:extLst>
              </a:tr>
              <a:tr h="505410">
                <a:tc>
                  <a:txBody>
                    <a:bodyPr/>
                    <a:lstStyle/>
                    <a:p>
                      <a:r>
                        <a:rPr lang="en-US"/>
                        <a:t>7.30</a:t>
                      </a:r>
                    </a:p>
                  </a:txBody>
                  <a:tcPr/>
                </a:tc>
                <a:tc>
                  <a:txBody>
                    <a:bodyPr/>
                    <a:lstStyle/>
                    <a:p>
                      <a:r>
                        <a:rPr lang="en-US"/>
                        <a:t>40</a:t>
                      </a:r>
                    </a:p>
                  </a:txBody>
                  <a:tcPr/>
                </a:tc>
                <a:tc>
                  <a:txBody>
                    <a:bodyPr/>
                    <a:lstStyle/>
                    <a:p>
                      <a:r>
                        <a:rPr lang="en-US"/>
                        <a:t>22</a:t>
                      </a:r>
                    </a:p>
                  </a:txBody>
                  <a:tcPr/>
                </a:tc>
                <a:tc>
                  <a:txBody>
                    <a:bodyPr/>
                    <a:lstStyle/>
                    <a:p>
                      <a:r>
                        <a:rPr lang="en-US"/>
                        <a:t>138</a:t>
                      </a:r>
                    </a:p>
                  </a:txBody>
                  <a:tcPr/>
                </a:tc>
                <a:tc>
                  <a:txBody>
                    <a:bodyPr/>
                    <a:lstStyle/>
                    <a:p>
                      <a:r>
                        <a:rPr lang="en-US"/>
                        <a:t>4.2</a:t>
                      </a:r>
                    </a:p>
                  </a:txBody>
                  <a:tcPr/>
                </a:tc>
                <a:tc>
                  <a:txBody>
                    <a:bodyPr/>
                    <a:lstStyle/>
                    <a:p>
                      <a:r>
                        <a:rPr lang="en-US"/>
                        <a:t>110</a:t>
                      </a:r>
                    </a:p>
                  </a:txBody>
                  <a:tcPr/>
                </a:tc>
                <a:extLst>
                  <a:ext uri="{0D108BD9-81ED-4DB2-BD59-A6C34878D82A}">
                    <a16:rowId xmlns:a16="http://schemas.microsoft.com/office/drawing/2014/main" val="2772863870"/>
                  </a:ext>
                </a:extLst>
              </a:tr>
            </a:tbl>
          </a:graphicData>
        </a:graphic>
      </p:graphicFrame>
    </p:spTree>
    <p:extLst>
      <p:ext uri="{BB962C8B-B14F-4D97-AF65-F5344CB8AC3E}">
        <p14:creationId xmlns:p14="http://schemas.microsoft.com/office/powerpoint/2010/main" val="291276668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a:extLst>
              <a:ext uri="{FF2B5EF4-FFF2-40B4-BE49-F238E27FC236}">
                <a16:creationId xmlns:a16="http://schemas.microsoft.com/office/drawing/2014/main" id="{F414C4A7-1F96-4EBE-B806-DC30D2FDB556}"/>
              </a:ext>
            </a:extLst>
          </p:cNvPr>
          <p:cNvSpPr>
            <a:spLocks noGrp="1"/>
          </p:cNvSpPr>
          <p:nvPr>
            <p:ph type="subTitle" idx="1"/>
          </p:nvPr>
        </p:nvSpPr>
        <p:spPr/>
        <p:txBody>
          <a:bodyPr/>
          <a:lstStyle/>
          <a:p>
            <a:endParaRPr lang="en-US"/>
          </a:p>
        </p:txBody>
      </p:sp>
      <p:graphicFrame>
        <p:nvGraphicFramePr>
          <p:cNvPr id="4" name="Table 4">
            <a:extLst>
              <a:ext uri="{FF2B5EF4-FFF2-40B4-BE49-F238E27FC236}">
                <a16:creationId xmlns:a16="http://schemas.microsoft.com/office/drawing/2014/main" id="{69D351DF-D364-4B2B-8146-6516691F808F}"/>
              </a:ext>
            </a:extLst>
          </p:cNvPr>
          <p:cNvGraphicFramePr>
            <a:graphicFrameLocks noGrp="1"/>
          </p:cNvGraphicFramePr>
          <p:nvPr>
            <p:extLst>
              <p:ext uri="{D42A27DB-BD31-4B8C-83A1-F6EECF244321}">
                <p14:modId xmlns:p14="http://schemas.microsoft.com/office/powerpoint/2010/main" val="3196742557"/>
              </p:ext>
            </p:extLst>
          </p:nvPr>
        </p:nvGraphicFramePr>
        <p:xfrm>
          <a:off x="852928" y="544451"/>
          <a:ext cx="7362828" cy="2527050"/>
        </p:xfrm>
        <a:graphic>
          <a:graphicData uri="http://schemas.openxmlformats.org/drawingml/2006/table">
            <a:tbl>
              <a:tblPr firstRow="1" bandRow="1">
                <a:tableStyleId>{5C22544A-7EE6-4342-B048-85BDC9FD1C3A}</a:tableStyleId>
              </a:tblPr>
              <a:tblGrid>
                <a:gridCol w="1227138">
                  <a:extLst>
                    <a:ext uri="{9D8B030D-6E8A-4147-A177-3AD203B41FA5}">
                      <a16:colId xmlns:a16="http://schemas.microsoft.com/office/drawing/2014/main" val="2956672230"/>
                    </a:ext>
                  </a:extLst>
                </a:gridCol>
                <a:gridCol w="1227138">
                  <a:extLst>
                    <a:ext uri="{9D8B030D-6E8A-4147-A177-3AD203B41FA5}">
                      <a16:colId xmlns:a16="http://schemas.microsoft.com/office/drawing/2014/main" val="3366791402"/>
                    </a:ext>
                  </a:extLst>
                </a:gridCol>
                <a:gridCol w="1227138">
                  <a:extLst>
                    <a:ext uri="{9D8B030D-6E8A-4147-A177-3AD203B41FA5}">
                      <a16:colId xmlns:a16="http://schemas.microsoft.com/office/drawing/2014/main" val="1166372328"/>
                    </a:ext>
                  </a:extLst>
                </a:gridCol>
                <a:gridCol w="1227138">
                  <a:extLst>
                    <a:ext uri="{9D8B030D-6E8A-4147-A177-3AD203B41FA5}">
                      <a16:colId xmlns:a16="http://schemas.microsoft.com/office/drawing/2014/main" val="3425385262"/>
                    </a:ext>
                  </a:extLst>
                </a:gridCol>
                <a:gridCol w="1227138">
                  <a:extLst>
                    <a:ext uri="{9D8B030D-6E8A-4147-A177-3AD203B41FA5}">
                      <a16:colId xmlns:a16="http://schemas.microsoft.com/office/drawing/2014/main" val="1561456660"/>
                    </a:ext>
                  </a:extLst>
                </a:gridCol>
                <a:gridCol w="1227138">
                  <a:extLst>
                    <a:ext uri="{9D8B030D-6E8A-4147-A177-3AD203B41FA5}">
                      <a16:colId xmlns:a16="http://schemas.microsoft.com/office/drawing/2014/main" val="3670303674"/>
                    </a:ext>
                  </a:extLst>
                </a:gridCol>
              </a:tblGrid>
              <a:tr h="505410">
                <a:tc>
                  <a:txBody>
                    <a:bodyPr/>
                    <a:lstStyle/>
                    <a:p>
                      <a:pPr algn="ctr"/>
                      <a:r>
                        <a:rPr lang="en-US"/>
                        <a:t>pH</a:t>
                      </a:r>
                    </a:p>
                  </a:txBody>
                  <a:tcPr/>
                </a:tc>
                <a:tc>
                  <a:txBody>
                    <a:bodyPr/>
                    <a:lstStyle/>
                    <a:p>
                      <a:pPr algn="ctr"/>
                      <a:r>
                        <a:rPr lang="en-US"/>
                        <a:t>pCO2</a:t>
                      </a:r>
                    </a:p>
                  </a:txBody>
                  <a:tcPr/>
                </a:tc>
                <a:tc>
                  <a:txBody>
                    <a:bodyPr/>
                    <a:lstStyle/>
                    <a:p>
                      <a:pPr algn="ctr"/>
                      <a:r>
                        <a:rPr lang="en-US"/>
                        <a:t>HCO3-</a:t>
                      </a:r>
                    </a:p>
                  </a:txBody>
                  <a:tcPr/>
                </a:tc>
                <a:tc>
                  <a:txBody>
                    <a:bodyPr/>
                    <a:lstStyle/>
                    <a:p>
                      <a:pPr algn="ctr"/>
                      <a:r>
                        <a:rPr lang="en-US"/>
                        <a:t>Na+</a:t>
                      </a:r>
                    </a:p>
                  </a:txBody>
                  <a:tcPr/>
                </a:tc>
                <a:tc>
                  <a:txBody>
                    <a:bodyPr/>
                    <a:lstStyle/>
                    <a:p>
                      <a:pPr algn="ctr"/>
                      <a:r>
                        <a:rPr lang="en-US"/>
                        <a:t>K+</a:t>
                      </a:r>
                    </a:p>
                  </a:txBody>
                  <a:tcPr/>
                </a:tc>
                <a:tc>
                  <a:txBody>
                    <a:bodyPr/>
                    <a:lstStyle/>
                    <a:p>
                      <a:pPr algn="ctr"/>
                      <a:r>
                        <a:rPr lang="en-US"/>
                        <a:t>Cl-</a:t>
                      </a:r>
                    </a:p>
                  </a:txBody>
                  <a:tcPr/>
                </a:tc>
                <a:extLst>
                  <a:ext uri="{0D108BD9-81ED-4DB2-BD59-A6C34878D82A}">
                    <a16:rowId xmlns:a16="http://schemas.microsoft.com/office/drawing/2014/main" val="3925621980"/>
                  </a:ext>
                </a:extLst>
              </a:tr>
              <a:tr h="505410">
                <a:tc>
                  <a:txBody>
                    <a:bodyPr/>
                    <a:lstStyle/>
                    <a:p>
                      <a:r>
                        <a:rPr lang="en-US"/>
                        <a:t>7.25</a:t>
                      </a:r>
                    </a:p>
                  </a:txBody>
                  <a:tcPr/>
                </a:tc>
                <a:tc>
                  <a:txBody>
                    <a:bodyPr/>
                    <a:lstStyle/>
                    <a:p>
                      <a:r>
                        <a:rPr lang="en-US"/>
                        <a:t>36</a:t>
                      </a:r>
                    </a:p>
                  </a:txBody>
                  <a:tcPr/>
                </a:tc>
                <a:tc>
                  <a:txBody>
                    <a:bodyPr/>
                    <a:lstStyle/>
                    <a:p>
                      <a:r>
                        <a:rPr lang="en-US"/>
                        <a:t>28</a:t>
                      </a:r>
                    </a:p>
                  </a:txBody>
                  <a:tcPr/>
                </a:tc>
                <a:tc>
                  <a:txBody>
                    <a:bodyPr/>
                    <a:lstStyle/>
                    <a:p>
                      <a:r>
                        <a:rPr lang="en-US"/>
                        <a:t>137</a:t>
                      </a:r>
                    </a:p>
                  </a:txBody>
                  <a:tcPr/>
                </a:tc>
                <a:tc>
                  <a:txBody>
                    <a:bodyPr/>
                    <a:lstStyle/>
                    <a:p>
                      <a:r>
                        <a:rPr lang="en-US"/>
                        <a:t>4.6</a:t>
                      </a:r>
                    </a:p>
                  </a:txBody>
                  <a:tcPr/>
                </a:tc>
                <a:tc>
                  <a:txBody>
                    <a:bodyPr/>
                    <a:lstStyle/>
                    <a:p>
                      <a:r>
                        <a:rPr lang="en-US"/>
                        <a:t>110</a:t>
                      </a:r>
                    </a:p>
                  </a:txBody>
                  <a:tcPr/>
                </a:tc>
                <a:extLst>
                  <a:ext uri="{0D108BD9-81ED-4DB2-BD59-A6C34878D82A}">
                    <a16:rowId xmlns:a16="http://schemas.microsoft.com/office/drawing/2014/main" val="1549369976"/>
                  </a:ext>
                </a:extLst>
              </a:tr>
              <a:tr h="505410">
                <a:tc>
                  <a:txBody>
                    <a:bodyPr/>
                    <a:lstStyle/>
                    <a:p>
                      <a:r>
                        <a:rPr lang="en-US" b="1">
                          <a:solidFill>
                            <a:schemeClr val="tx1"/>
                          </a:solidFill>
                          <a:highlight>
                            <a:srgbClr val="FFFF00"/>
                          </a:highlight>
                        </a:rPr>
                        <a:t>7.25</a:t>
                      </a:r>
                    </a:p>
                  </a:txBody>
                  <a:tcPr/>
                </a:tc>
                <a:tc>
                  <a:txBody>
                    <a:bodyPr/>
                    <a:lstStyle/>
                    <a:p>
                      <a:r>
                        <a:rPr lang="en-US" b="1">
                          <a:solidFill>
                            <a:schemeClr val="tx1"/>
                          </a:solidFill>
                          <a:highlight>
                            <a:srgbClr val="FFFF00"/>
                          </a:highlight>
                        </a:rPr>
                        <a:t>36</a:t>
                      </a:r>
                    </a:p>
                  </a:txBody>
                  <a:tcPr/>
                </a:tc>
                <a:tc>
                  <a:txBody>
                    <a:bodyPr/>
                    <a:lstStyle/>
                    <a:p>
                      <a:r>
                        <a:rPr lang="en-US" b="1">
                          <a:solidFill>
                            <a:schemeClr val="tx1"/>
                          </a:solidFill>
                          <a:highlight>
                            <a:srgbClr val="FFFF00"/>
                          </a:highlight>
                        </a:rPr>
                        <a:t>22</a:t>
                      </a:r>
                    </a:p>
                  </a:txBody>
                  <a:tcPr/>
                </a:tc>
                <a:tc>
                  <a:txBody>
                    <a:bodyPr/>
                    <a:lstStyle/>
                    <a:p>
                      <a:r>
                        <a:rPr lang="en-US" b="1">
                          <a:solidFill>
                            <a:schemeClr val="tx1"/>
                          </a:solidFill>
                          <a:highlight>
                            <a:srgbClr val="FFFF00"/>
                          </a:highlight>
                        </a:rPr>
                        <a:t>135</a:t>
                      </a:r>
                    </a:p>
                  </a:txBody>
                  <a:tcPr/>
                </a:tc>
                <a:tc>
                  <a:txBody>
                    <a:bodyPr/>
                    <a:lstStyle/>
                    <a:p>
                      <a:r>
                        <a:rPr lang="en-US" b="1">
                          <a:solidFill>
                            <a:schemeClr val="tx1"/>
                          </a:solidFill>
                          <a:highlight>
                            <a:srgbClr val="FFFF00"/>
                          </a:highlight>
                        </a:rPr>
                        <a:t>4.5</a:t>
                      </a:r>
                    </a:p>
                  </a:txBody>
                  <a:tcPr/>
                </a:tc>
                <a:tc>
                  <a:txBody>
                    <a:bodyPr/>
                    <a:lstStyle/>
                    <a:p>
                      <a:r>
                        <a:rPr lang="en-US" b="1">
                          <a:solidFill>
                            <a:schemeClr val="tx1"/>
                          </a:solidFill>
                          <a:highlight>
                            <a:srgbClr val="FFFF00"/>
                          </a:highlight>
                        </a:rPr>
                        <a:t>105</a:t>
                      </a:r>
                    </a:p>
                  </a:txBody>
                  <a:tcPr/>
                </a:tc>
                <a:extLst>
                  <a:ext uri="{0D108BD9-81ED-4DB2-BD59-A6C34878D82A}">
                    <a16:rowId xmlns:a16="http://schemas.microsoft.com/office/drawing/2014/main" val="3365227491"/>
                  </a:ext>
                </a:extLst>
              </a:tr>
              <a:tr h="505410">
                <a:tc>
                  <a:txBody>
                    <a:bodyPr/>
                    <a:lstStyle/>
                    <a:p>
                      <a:r>
                        <a:rPr lang="en-US"/>
                        <a:t>7.40</a:t>
                      </a:r>
                    </a:p>
                  </a:txBody>
                  <a:tcPr/>
                </a:tc>
                <a:tc>
                  <a:txBody>
                    <a:bodyPr/>
                    <a:lstStyle/>
                    <a:p>
                      <a:r>
                        <a:rPr lang="en-US"/>
                        <a:t>38</a:t>
                      </a:r>
                    </a:p>
                  </a:txBody>
                  <a:tcPr/>
                </a:tc>
                <a:tc>
                  <a:txBody>
                    <a:bodyPr/>
                    <a:lstStyle/>
                    <a:p>
                      <a:r>
                        <a:rPr lang="en-US"/>
                        <a:t>28</a:t>
                      </a:r>
                    </a:p>
                  </a:txBody>
                  <a:tcPr/>
                </a:tc>
                <a:tc>
                  <a:txBody>
                    <a:bodyPr/>
                    <a:lstStyle/>
                    <a:p>
                      <a:r>
                        <a:rPr lang="en-US"/>
                        <a:t>140</a:t>
                      </a:r>
                    </a:p>
                  </a:txBody>
                  <a:tcPr/>
                </a:tc>
                <a:tc>
                  <a:txBody>
                    <a:bodyPr/>
                    <a:lstStyle/>
                    <a:p>
                      <a:r>
                        <a:rPr lang="en-US"/>
                        <a:t>4.5</a:t>
                      </a:r>
                    </a:p>
                  </a:txBody>
                  <a:tcPr/>
                </a:tc>
                <a:tc>
                  <a:txBody>
                    <a:bodyPr/>
                    <a:lstStyle/>
                    <a:p>
                      <a:r>
                        <a:rPr lang="en-US"/>
                        <a:t>105</a:t>
                      </a:r>
                    </a:p>
                  </a:txBody>
                  <a:tcPr/>
                </a:tc>
                <a:extLst>
                  <a:ext uri="{0D108BD9-81ED-4DB2-BD59-A6C34878D82A}">
                    <a16:rowId xmlns:a16="http://schemas.microsoft.com/office/drawing/2014/main" val="2197128974"/>
                  </a:ext>
                </a:extLst>
              </a:tr>
              <a:tr h="505410">
                <a:tc>
                  <a:txBody>
                    <a:bodyPr/>
                    <a:lstStyle/>
                    <a:p>
                      <a:r>
                        <a:rPr lang="en-US"/>
                        <a:t>7.30</a:t>
                      </a:r>
                    </a:p>
                  </a:txBody>
                  <a:tcPr/>
                </a:tc>
                <a:tc>
                  <a:txBody>
                    <a:bodyPr/>
                    <a:lstStyle/>
                    <a:p>
                      <a:r>
                        <a:rPr lang="en-US"/>
                        <a:t>40</a:t>
                      </a:r>
                    </a:p>
                  </a:txBody>
                  <a:tcPr/>
                </a:tc>
                <a:tc>
                  <a:txBody>
                    <a:bodyPr/>
                    <a:lstStyle/>
                    <a:p>
                      <a:r>
                        <a:rPr lang="en-US"/>
                        <a:t>22</a:t>
                      </a:r>
                    </a:p>
                  </a:txBody>
                  <a:tcPr/>
                </a:tc>
                <a:tc>
                  <a:txBody>
                    <a:bodyPr/>
                    <a:lstStyle/>
                    <a:p>
                      <a:r>
                        <a:rPr lang="en-US"/>
                        <a:t>138</a:t>
                      </a:r>
                    </a:p>
                  </a:txBody>
                  <a:tcPr/>
                </a:tc>
                <a:tc>
                  <a:txBody>
                    <a:bodyPr/>
                    <a:lstStyle/>
                    <a:p>
                      <a:r>
                        <a:rPr lang="en-US"/>
                        <a:t>4.2</a:t>
                      </a:r>
                    </a:p>
                  </a:txBody>
                  <a:tcPr/>
                </a:tc>
                <a:tc>
                  <a:txBody>
                    <a:bodyPr/>
                    <a:lstStyle/>
                    <a:p>
                      <a:r>
                        <a:rPr lang="en-US"/>
                        <a:t>110</a:t>
                      </a:r>
                    </a:p>
                  </a:txBody>
                  <a:tcPr/>
                </a:tc>
                <a:extLst>
                  <a:ext uri="{0D108BD9-81ED-4DB2-BD59-A6C34878D82A}">
                    <a16:rowId xmlns:a16="http://schemas.microsoft.com/office/drawing/2014/main" val="2772863870"/>
                  </a:ext>
                </a:extLst>
              </a:tr>
            </a:tbl>
          </a:graphicData>
        </a:graphic>
      </p:graphicFrame>
      <p:sp>
        <p:nvSpPr>
          <p:cNvPr id="5" name="TextBox 4">
            <a:extLst>
              <a:ext uri="{FF2B5EF4-FFF2-40B4-BE49-F238E27FC236}">
                <a16:creationId xmlns:a16="http://schemas.microsoft.com/office/drawing/2014/main" id="{98F07DB8-71A0-4A1A-998A-AFB49C6B0FC8}"/>
              </a:ext>
            </a:extLst>
          </p:cNvPr>
          <p:cNvSpPr txBox="1"/>
          <p:nvPr/>
        </p:nvSpPr>
        <p:spPr>
          <a:xfrm>
            <a:off x="852928" y="3153062"/>
            <a:ext cx="6769634" cy="738664"/>
          </a:xfrm>
          <a:prstGeom prst="rect">
            <a:avLst/>
          </a:prstGeom>
          <a:noFill/>
        </p:spPr>
        <p:txBody>
          <a:bodyPr wrap="square" rtlCol="0">
            <a:spAutoFit/>
          </a:bodyPr>
          <a:lstStyle/>
          <a:p>
            <a:pPr marL="342900" indent="-342900">
              <a:buAutoNum type="arabicPeriod"/>
            </a:pPr>
            <a:r>
              <a:rPr lang="en-US">
                <a:solidFill>
                  <a:schemeClr val="bg1"/>
                </a:solidFill>
              </a:rPr>
              <a:t>Acidosis (GI losses)</a:t>
            </a:r>
          </a:p>
          <a:p>
            <a:pPr marL="342900" indent="-342900">
              <a:buAutoNum type="arabicPeriod"/>
            </a:pPr>
            <a:r>
              <a:rPr lang="en-US">
                <a:solidFill>
                  <a:schemeClr val="bg1"/>
                </a:solidFill>
              </a:rPr>
              <a:t>HCO3 : low (base deficit) + low pH = metabolic acidosis</a:t>
            </a:r>
          </a:p>
          <a:p>
            <a:pPr marL="342900" indent="-342900">
              <a:buAutoNum type="arabicPeriod"/>
            </a:pPr>
            <a:r>
              <a:rPr lang="en-US">
                <a:solidFill>
                  <a:schemeClr val="bg1"/>
                </a:solidFill>
              </a:rPr>
              <a:t>Is there an anion gap?</a:t>
            </a:r>
          </a:p>
        </p:txBody>
      </p:sp>
    </p:spTree>
    <p:extLst>
      <p:ext uri="{BB962C8B-B14F-4D97-AF65-F5344CB8AC3E}">
        <p14:creationId xmlns:p14="http://schemas.microsoft.com/office/powerpoint/2010/main" val="367507811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14E6901-3474-4B86-A321-D08394743DD7}"/>
              </a:ext>
            </a:extLst>
          </p:cNvPr>
          <p:cNvSpPr>
            <a:spLocks noGrp="1"/>
          </p:cNvSpPr>
          <p:nvPr>
            <p:ph type="title"/>
          </p:nvPr>
        </p:nvSpPr>
        <p:spPr/>
        <p:txBody>
          <a:bodyPr/>
          <a:lstStyle/>
          <a:p>
            <a:r>
              <a:rPr lang="en-US"/>
              <a:t>(Na</a:t>
            </a:r>
            <a:r>
              <a:rPr lang="en-US" baseline="30000"/>
              <a:t>+</a:t>
            </a:r>
            <a:r>
              <a:rPr lang="en-US"/>
              <a:t>+K</a:t>
            </a:r>
            <a:r>
              <a:rPr lang="en-US" baseline="30000"/>
              <a:t>+</a:t>
            </a:r>
            <a:r>
              <a:rPr lang="en-US"/>
              <a:t>)-(HCO3</a:t>
            </a:r>
            <a:r>
              <a:rPr lang="en-US" baseline="30000"/>
              <a:t>-</a:t>
            </a:r>
            <a:r>
              <a:rPr lang="en-US"/>
              <a:t>+Cl</a:t>
            </a:r>
            <a:r>
              <a:rPr lang="en-US" baseline="30000"/>
              <a:t>-</a:t>
            </a:r>
            <a:r>
              <a:rPr lang="en-US"/>
              <a:t>)</a:t>
            </a:r>
            <a:br>
              <a:rPr lang="en-US"/>
            </a:br>
            <a:r>
              <a:rPr lang="en-US"/>
              <a:t>(135+4.5)-(22+105) = 12</a:t>
            </a:r>
          </a:p>
        </p:txBody>
      </p:sp>
      <p:sp>
        <p:nvSpPr>
          <p:cNvPr id="3" name="Subtitle 2">
            <a:extLst>
              <a:ext uri="{FF2B5EF4-FFF2-40B4-BE49-F238E27FC236}">
                <a16:creationId xmlns:a16="http://schemas.microsoft.com/office/drawing/2014/main" id="{AC58139C-68EF-4729-A677-1A02CC16D7D1}"/>
              </a:ext>
            </a:extLst>
          </p:cNvPr>
          <p:cNvSpPr>
            <a:spLocks noGrp="1"/>
          </p:cNvSpPr>
          <p:nvPr>
            <p:ph type="subTitle" idx="1"/>
          </p:nvPr>
        </p:nvSpPr>
        <p:spPr/>
        <p:txBody>
          <a:bodyPr/>
          <a:lstStyle/>
          <a:p>
            <a:r>
              <a:rPr lang="en-US"/>
              <a:t>Anion gap calculation</a:t>
            </a:r>
          </a:p>
        </p:txBody>
      </p:sp>
    </p:spTree>
    <p:extLst>
      <p:ext uri="{BB962C8B-B14F-4D97-AF65-F5344CB8AC3E}">
        <p14:creationId xmlns:p14="http://schemas.microsoft.com/office/powerpoint/2010/main" val="3803157728"/>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A3A6BB-9EC9-4FAC-9D55-2D92E740BE9B}"/>
              </a:ext>
            </a:extLst>
          </p:cNvPr>
          <p:cNvSpPr>
            <a:spLocks noGrp="1"/>
          </p:cNvSpPr>
          <p:nvPr>
            <p:ph type="title"/>
          </p:nvPr>
        </p:nvSpPr>
        <p:spPr/>
        <p:txBody>
          <a:bodyPr/>
          <a:lstStyle/>
          <a:p>
            <a:r>
              <a:rPr lang="en-US"/>
              <a:t>8-12 (without K+)</a:t>
            </a:r>
            <a:br>
              <a:rPr lang="en-US"/>
            </a:br>
            <a:r>
              <a:rPr lang="en-US"/>
              <a:t>12-16 (with K+ included)</a:t>
            </a:r>
          </a:p>
        </p:txBody>
      </p:sp>
      <p:sp>
        <p:nvSpPr>
          <p:cNvPr id="3" name="Subtitle 2">
            <a:extLst>
              <a:ext uri="{FF2B5EF4-FFF2-40B4-BE49-F238E27FC236}">
                <a16:creationId xmlns:a16="http://schemas.microsoft.com/office/drawing/2014/main" id="{E4D5ADB6-2361-4183-B686-7FB442E62ADC}"/>
              </a:ext>
            </a:extLst>
          </p:cNvPr>
          <p:cNvSpPr>
            <a:spLocks noGrp="1"/>
          </p:cNvSpPr>
          <p:nvPr>
            <p:ph type="subTitle" idx="1"/>
          </p:nvPr>
        </p:nvSpPr>
        <p:spPr/>
        <p:txBody>
          <a:bodyPr/>
          <a:lstStyle/>
          <a:p>
            <a:r>
              <a:rPr lang="en-US"/>
              <a:t>Normal anion gap</a:t>
            </a:r>
          </a:p>
        </p:txBody>
      </p:sp>
    </p:spTree>
    <p:extLst>
      <p:ext uri="{BB962C8B-B14F-4D97-AF65-F5344CB8AC3E}">
        <p14:creationId xmlns:p14="http://schemas.microsoft.com/office/powerpoint/2010/main" val="223003277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7A981CC-B161-4EB1-A546-F99B1472ADD5}"/>
              </a:ext>
            </a:extLst>
          </p:cNvPr>
          <p:cNvSpPr>
            <a:spLocks noGrp="1"/>
          </p:cNvSpPr>
          <p:nvPr>
            <p:ph type="title"/>
          </p:nvPr>
        </p:nvSpPr>
        <p:spPr/>
        <p:txBody>
          <a:bodyPr/>
          <a:lstStyle/>
          <a:p>
            <a:pPr marL="457200" indent="-457200" algn="l">
              <a:buFont typeface="Arial" panose="020B0604020202020204" pitchFamily="34" charset="0"/>
              <a:buChar char="•"/>
            </a:pPr>
            <a:br>
              <a:rPr lang="en-US"/>
            </a:br>
            <a:endParaRPr lang="en-US"/>
          </a:p>
        </p:txBody>
      </p:sp>
      <p:sp>
        <p:nvSpPr>
          <p:cNvPr id="3" name="Subtitle 2">
            <a:extLst>
              <a:ext uri="{FF2B5EF4-FFF2-40B4-BE49-F238E27FC236}">
                <a16:creationId xmlns:a16="http://schemas.microsoft.com/office/drawing/2014/main" id="{7E7F4B69-B101-415E-8871-EC8BD48B0807}"/>
              </a:ext>
            </a:extLst>
          </p:cNvPr>
          <p:cNvSpPr>
            <a:spLocks noGrp="1"/>
          </p:cNvSpPr>
          <p:nvPr>
            <p:ph type="subTitle" idx="1"/>
          </p:nvPr>
        </p:nvSpPr>
        <p:spPr/>
        <p:txBody>
          <a:bodyPr/>
          <a:lstStyle/>
          <a:p>
            <a:r>
              <a:rPr lang="en-US"/>
              <a:t>Common causes of normal anion gap metabolic acidosis</a:t>
            </a:r>
          </a:p>
        </p:txBody>
      </p:sp>
      <p:graphicFrame>
        <p:nvGraphicFramePr>
          <p:cNvPr id="4" name="Table 4">
            <a:extLst>
              <a:ext uri="{FF2B5EF4-FFF2-40B4-BE49-F238E27FC236}">
                <a16:creationId xmlns:a16="http://schemas.microsoft.com/office/drawing/2014/main" id="{71396ECA-E9D6-4A02-9AEB-EB220199E11E}"/>
              </a:ext>
            </a:extLst>
          </p:cNvPr>
          <p:cNvGraphicFramePr>
            <a:graphicFrameLocks noGrp="1"/>
          </p:cNvGraphicFramePr>
          <p:nvPr>
            <p:extLst>
              <p:ext uri="{D42A27DB-BD31-4B8C-83A1-F6EECF244321}">
                <p14:modId xmlns:p14="http://schemas.microsoft.com/office/powerpoint/2010/main" val="2706028440"/>
              </p:ext>
            </p:extLst>
          </p:nvPr>
        </p:nvGraphicFramePr>
        <p:xfrm>
          <a:off x="1530500" y="1381125"/>
          <a:ext cx="6096000" cy="1094105"/>
        </p:xfrm>
        <a:graphic>
          <a:graphicData uri="http://schemas.openxmlformats.org/drawingml/2006/table">
            <a:tbl>
              <a:tblPr firstRow="1" bandRow="1">
                <a:tableStyleId>{5C22544A-7EE6-4342-B048-85BDC9FD1C3A}</a:tableStyleId>
              </a:tblPr>
              <a:tblGrid>
                <a:gridCol w="3048000">
                  <a:extLst>
                    <a:ext uri="{9D8B030D-6E8A-4147-A177-3AD203B41FA5}">
                      <a16:colId xmlns:a16="http://schemas.microsoft.com/office/drawing/2014/main" val="2783055389"/>
                    </a:ext>
                  </a:extLst>
                </a:gridCol>
                <a:gridCol w="3048000">
                  <a:extLst>
                    <a:ext uri="{9D8B030D-6E8A-4147-A177-3AD203B41FA5}">
                      <a16:colId xmlns:a16="http://schemas.microsoft.com/office/drawing/2014/main" val="3047645058"/>
                    </a:ext>
                  </a:extLst>
                </a:gridCol>
              </a:tblGrid>
              <a:tr h="352425">
                <a:tc>
                  <a:txBody>
                    <a:bodyPr/>
                    <a:lstStyle/>
                    <a:p>
                      <a:r>
                        <a:rPr lang="en-US"/>
                        <a:t>Loss of bicarbonate</a:t>
                      </a:r>
                    </a:p>
                  </a:txBody>
                  <a:tcPr/>
                </a:tc>
                <a:tc>
                  <a:txBody>
                    <a:bodyPr/>
                    <a:lstStyle/>
                    <a:p>
                      <a:r>
                        <a:rPr lang="en-US"/>
                        <a:t>Diminished acid secretion</a:t>
                      </a:r>
                    </a:p>
                  </a:txBody>
                  <a:tcPr/>
                </a:tc>
                <a:extLst>
                  <a:ext uri="{0D108BD9-81ED-4DB2-BD59-A6C34878D82A}">
                    <a16:rowId xmlns:a16="http://schemas.microsoft.com/office/drawing/2014/main" val="4174407451"/>
                  </a:ext>
                </a:extLst>
              </a:tr>
              <a:tr h="370840">
                <a:tc>
                  <a:txBody>
                    <a:bodyPr/>
                    <a:lstStyle/>
                    <a:p>
                      <a:r>
                        <a:rPr lang="en-US"/>
                        <a:t>GI losses (diarrhea)</a:t>
                      </a:r>
                    </a:p>
                  </a:txBody>
                  <a:tcPr/>
                </a:tc>
                <a:tc>
                  <a:txBody>
                    <a:bodyPr/>
                    <a:lstStyle/>
                    <a:p>
                      <a:r>
                        <a:rPr lang="en-US"/>
                        <a:t>RTA</a:t>
                      </a:r>
                    </a:p>
                  </a:txBody>
                  <a:tcPr/>
                </a:tc>
                <a:extLst>
                  <a:ext uri="{0D108BD9-81ED-4DB2-BD59-A6C34878D82A}">
                    <a16:rowId xmlns:a16="http://schemas.microsoft.com/office/drawing/2014/main" val="551634856"/>
                  </a:ext>
                </a:extLst>
              </a:tr>
              <a:tr h="370840">
                <a:tc>
                  <a:txBody>
                    <a:bodyPr/>
                    <a:lstStyle/>
                    <a:p>
                      <a:r>
                        <a:rPr lang="en-US"/>
                        <a:t>Renal losses </a:t>
                      </a:r>
                    </a:p>
                  </a:txBody>
                  <a:tcPr/>
                </a:tc>
                <a:tc>
                  <a:txBody>
                    <a:bodyPr/>
                    <a:lstStyle/>
                    <a:p>
                      <a:endParaRPr lang="en-US"/>
                    </a:p>
                  </a:txBody>
                  <a:tcPr/>
                </a:tc>
                <a:extLst>
                  <a:ext uri="{0D108BD9-81ED-4DB2-BD59-A6C34878D82A}">
                    <a16:rowId xmlns:a16="http://schemas.microsoft.com/office/drawing/2014/main" val="1440963831"/>
                  </a:ext>
                </a:extLst>
              </a:tr>
            </a:tbl>
          </a:graphicData>
        </a:graphic>
      </p:graphicFrame>
    </p:spTree>
    <p:extLst>
      <p:ext uri="{BB962C8B-B14F-4D97-AF65-F5344CB8AC3E}">
        <p14:creationId xmlns:p14="http://schemas.microsoft.com/office/powerpoint/2010/main" val="11218546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218"/>
        <p:cNvGrpSpPr/>
        <p:nvPr/>
      </p:nvGrpSpPr>
      <p:grpSpPr>
        <a:xfrm>
          <a:off x="0" y="0"/>
          <a:ext cx="0" cy="0"/>
          <a:chOff x="0" y="0"/>
          <a:chExt cx="0" cy="0"/>
        </a:xfrm>
      </p:grpSpPr>
      <p:sp>
        <p:nvSpPr>
          <p:cNvPr id="222" name="Google Shape;222;p15"/>
          <p:cNvSpPr txBox="1">
            <a:spLocks noGrp="1"/>
          </p:cNvSpPr>
          <p:nvPr>
            <p:ph type="ctrTitle"/>
          </p:nvPr>
        </p:nvSpPr>
        <p:spPr>
          <a:xfrm>
            <a:off x="685800" y="2032845"/>
            <a:ext cx="7772400" cy="607800"/>
          </a:xfrm>
          <a:prstGeom prst="rect">
            <a:avLst/>
          </a:prstGeom>
        </p:spPr>
        <p:txBody>
          <a:bodyPr spcFirstLastPara="1" wrap="square" lIns="0" tIns="0" rIns="0" bIns="0" anchor="t" anchorCtr="0">
            <a:noAutofit/>
          </a:bodyPr>
          <a:lstStyle/>
          <a:p>
            <a:r>
              <a:rPr lang="en" dirty="0"/>
              <a:t>Let's Recap!</a:t>
            </a:r>
          </a:p>
        </p:txBody>
      </p:sp>
    </p:spTree>
    <p:extLst>
      <p:ext uri="{BB962C8B-B14F-4D97-AF65-F5344CB8AC3E}">
        <p14:creationId xmlns:p14="http://schemas.microsoft.com/office/powerpoint/2010/main" val="3496686093"/>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312"/>
        <p:cNvGrpSpPr/>
        <p:nvPr/>
      </p:nvGrpSpPr>
      <p:grpSpPr>
        <a:xfrm>
          <a:off x="0" y="0"/>
          <a:ext cx="0" cy="0"/>
          <a:chOff x="0" y="0"/>
          <a:chExt cx="0" cy="0"/>
        </a:xfrm>
      </p:grpSpPr>
      <p:sp>
        <p:nvSpPr>
          <p:cNvPr id="313" name="Google Shape;313;p24"/>
          <p:cNvSpPr txBox="1">
            <a:spLocks noGrp="1"/>
          </p:cNvSpPr>
          <p:nvPr>
            <p:ph type="title"/>
          </p:nvPr>
        </p:nvSpPr>
        <p:spPr>
          <a:xfrm>
            <a:off x="1032075" y="966325"/>
            <a:ext cx="7081800" cy="3188100"/>
          </a:xfrm>
          <a:prstGeom prst="rect">
            <a:avLst/>
          </a:prstGeom>
        </p:spPr>
        <p:txBody>
          <a:bodyPr spcFirstLastPara="1" wrap="square" lIns="0" tIns="0" rIns="0" bIns="0" anchor="ctr" anchorCtr="0">
            <a:noAutofit/>
          </a:bodyPr>
          <a:lstStyle/>
          <a:p>
            <a:pPr marL="0" lvl="0" indent="0" algn="ctr" rtl="0">
              <a:spcBef>
                <a:spcPts val="0"/>
              </a:spcBef>
              <a:spcAft>
                <a:spcPts val="0"/>
              </a:spcAft>
              <a:buNone/>
            </a:pPr>
            <a:r>
              <a:rPr lang="en-US"/>
              <a:t>T</a:t>
            </a:r>
            <a:r>
              <a:rPr lang="en"/>
              <a:t>his is the ABG of a </a:t>
            </a:r>
            <a:r>
              <a:rPr lang="en-US"/>
              <a:t>2-week-old, first-born</a:t>
            </a:r>
            <a:r>
              <a:rPr lang="en"/>
              <a:t> male presenting with projectile vomiting after every feed</a:t>
            </a:r>
            <a:endParaRPr/>
          </a:p>
        </p:txBody>
      </p:sp>
      <p:sp>
        <p:nvSpPr>
          <p:cNvPr id="314" name="Google Shape;314;p24"/>
          <p:cNvSpPr txBox="1">
            <a:spLocks noGrp="1"/>
          </p:cNvSpPr>
          <p:nvPr>
            <p:ph type="subTitle" idx="1"/>
          </p:nvPr>
        </p:nvSpPr>
        <p:spPr>
          <a:xfrm>
            <a:off x="1038650" y="640325"/>
            <a:ext cx="7079700" cy="444300"/>
          </a:xfrm>
          <a:prstGeom prst="rect">
            <a:avLst/>
          </a:prstGeom>
        </p:spPr>
        <p:txBody>
          <a:bodyPr spcFirstLastPara="1" wrap="square" lIns="0" tIns="0" rIns="0" bIns="0" anchor="t" anchorCtr="0">
            <a:noAutofit/>
          </a:bodyPr>
          <a:lstStyle/>
          <a:p>
            <a:pPr marL="0" lvl="0" indent="0" algn="ctr" rtl="0">
              <a:spcBef>
                <a:spcPts val="600"/>
              </a:spcBef>
              <a:spcAft>
                <a:spcPts val="0"/>
              </a:spcAft>
              <a:buNone/>
            </a:pPr>
            <a:r>
              <a:rPr lang="en"/>
              <a:t>CATEGORY 2 · </a:t>
            </a:r>
            <a:r>
              <a:rPr lang="en">
                <a:solidFill>
                  <a:srgbClr val="FFC319"/>
                </a:solidFill>
              </a:rPr>
              <a:t>$400</a:t>
            </a:r>
            <a:endParaRPr>
              <a:solidFill>
                <a:srgbClr val="FFC319"/>
              </a:solidFill>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488381-3BA6-4308-8626-C2F4EBE1E386}"/>
              </a:ext>
            </a:extLst>
          </p:cNvPr>
          <p:cNvSpPr>
            <a:spLocks noGrp="1"/>
          </p:cNvSpPr>
          <p:nvPr>
            <p:ph type="title"/>
          </p:nvPr>
        </p:nvSpPr>
        <p:spPr/>
        <p:txBody>
          <a:bodyPr/>
          <a:lstStyle/>
          <a:p>
            <a:endParaRPr lang="en-US"/>
          </a:p>
        </p:txBody>
      </p:sp>
      <p:sp>
        <p:nvSpPr>
          <p:cNvPr id="3" name="Subtitle 2">
            <a:extLst>
              <a:ext uri="{FF2B5EF4-FFF2-40B4-BE49-F238E27FC236}">
                <a16:creationId xmlns:a16="http://schemas.microsoft.com/office/drawing/2014/main" id="{6BF6477A-2AE8-40AD-AA44-ED96C6C3E643}"/>
              </a:ext>
            </a:extLst>
          </p:cNvPr>
          <p:cNvSpPr>
            <a:spLocks noGrp="1"/>
          </p:cNvSpPr>
          <p:nvPr>
            <p:ph type="subTitle" idx="1"/>
          </p:nvPr>
        </p:nvSpPr>
        <p:spPr/>
        <p:txBody>
          <a:bodyPr/>
          <a:lstStyle/>
          <a:p>
            <a:endParaRPr lang="en-US"/>
          </a:p>
        </p:txBody>
      </p:sp>
      <p:graphicFrame>
        <p:nvGraphicFramePr>
          <p:cNvPr id="4" name="Table 4">
            <a:extLst>
              <a:ext uri="{FF2B5EF4-FFF2-40B4-BE49-F238E27FC236}">
                <a16:creationId xmlns:a16="http://schemas.microsoft.com/office/drawing/2014/main" id="{488082D4-788F-4EDD-AFA8-CF2BB36B241E}"/>
              </a:ext>
            </a:extLst>
          </p:cNvPr>
          <p:cNvGraphicFramePr>
            <a:graphicFrameLocks noGrp="1"/>
          </p:cNvGraphicFramePr>
          <p:nvPr>
            <p:extLst>
              <p:ext uri="{D42A27DB-BD31-4B8C-83A1-F6EECF244321}">
                <p14:modId xmlns:p14="http://schemas.microsoft.com/office/powerpoint/2010/main" val="525605270"/>
              </p:ext>
            </p:extLst>
          </p:nvPr>
        </p:nvGraphicFramePr>
        <p:xfrm>
          <a:off x="897086" y="945520"/>
          <a:ext cx="7362828" cy="2527050"/>
        </p:xfrm>
        <a:graphic>
          <a:graphicData uri="http://schemas.openxmlformats.org/drawingml/2006/table">
            <a:tbl>
              <a:tblPr firstRow="1" bandRow="1">
                <a:tableStyleId>{5C22544A-7EE6-4342-B048-85BDC9FD1C3A}</a:tableStyleId>
              </a:tblPr>
              <a:tblGrid>
                <a:gridCol w="1227138">
                  <a:extLst>
                    <a:ext uri="{9D8B030D-6E8A-4147-A177-3AD203B41FA5}">
                      <a16:colId xmlns:a16="http://schemas.microsoft.com/office/drawing/2014/main" val="2956672230"/>
                    </a:ext>
                  </a:extLst>
                </a:gridCol>
                <a:gridCol w="1227138">
                  <a:extLst>
                    <a:ext uri="{9D8B030D-6E8A-4147-A177-3AD203B41FA5}">
                      <a16:colId xmlns:a16="http://schemas.microsoft.com/office/drawing/2014/main" val="3366791402"/>
                    </a:ext>
                  </a:extLst>
                </a:gridCol>
                <a:gridCol w="1227138">
                  <a:extLst>
                    <a:ext uri="{9D8B030D-6E8A-4147-A177-3AD203B41FA5}">
                      <a16:colId xmlns:a16="http://schemas.microsoft.com/office/drawing/2014/main" val="1166372328"/>
                    </a:ext>
                  </a:extLst>
                </a:gridCol>
                <a:gridCol w="1227138">
                  <a:extLst>
                    <a:ext uri="{9D8B030D-6E8A-4147-A177-3AD203B41FA5}">
                      <a16:colId xmlns:a16="http://schemas.microsoft.com/office/drawing/2014/main" val="3425385262"/>
                    </a:ext>
                  </a:extLst>
                </a:gridCol>
                <a:gridCol w="1227138">
                  <a:extLst>
                    <a:ext uri="{9D8B030D-6E8A-4147-A177-3AD203B41FA5}">
                      <a16:colId xmlns:a16="http://schemas.microsoft.com/office/drawing/2014/main" val="1561456660"/>
                    </a:ext>
                  </a:extLst>
                </a:gridCol>
                <a:gridCol w="1227138">
                  <a:extLst>
                    <a:ext uri="{9D8B030D-6E8A-4147-A177-3AD203B41FA5}">
                      <a16:colId xmlns:a16="http://schemas.microsoft.com/office/drawing/2014/main" val="3670303674"/>
                    </a:ext>
                  </a:extLst>
                </a:gridCol>
              </a:tblGrid>
              <a:tr h="505410">
                <a:tc>
                  <a:txBody>
                    <a:bodyPr/>
                    <a:lstStyle/>
                    <a:p>
                      <a:pPr algn="ctr"/>
                      <a:r>
                        <a:rPr lang="en-US"/>
                        <a:t>pH</a:t>
                      </a:r>
                    </a:p>
                  </a:txBody>
                  <a:tcPr/>
                </a:tc>
                <a:tc>
                  <a:txBody>
                    <a:bodyPr/>
                    <a:lstStyle/>
                    <a:p>
                      <a:pPr algn="ctr"/>
                      <a:r>
                        <a:rPr lang="en-US"/>
                        <a:t>pCO2</a:t>
                      </a:r>
                    </a:p>
                  </a:txBody>
                  <a:tcPr/>
                </a:tc>
                <a:tc>
                  <a:txBody>
                    <a:bodyPr/>
                    <a:lstStyle/>
                    <a:p>
                      <a:pPr algn="ctr"/>
                      <a:r>
                        <a:rPr lang="en-US"/>
                        <a:t>HCO3-</a:t>
                      </a:r>
                    </a:p>
                  </a:txBody>
                  <a:tcPr/>
                </a:tc>
                <a:tc>
                  <a:txBody>
                    <a:bodyPr/>
                    <a:lstStyle/>
                    <a:p>
                      <a:pPr algn="ctr"/>
                      <a:r>
                        <a:rPr lang="en-US"/>
                        <a:t>Na+</a:t>
                      </a:r>
                    </a:p>
                  </a:txBody>
                  <a:tcPr/>
                </a:tc>
                <a:tc>
                  <a:txBody>
                    <a:bodyPr/>
                    <a:lstStyle/>
                    <a:p>
                      <a:pPr algn="ctr"/>
                      <a:r>
                        <a:rPr lang="en-US"/>
                        <a:t>K+</a:t>
                      </a:r>
                    </a:p>
                  </a:txBody>
                  <a:tcPr/>
                </a:tc>
                <a:tc>
                  <a:txBody>
                    <a:bodyPr/>
                    <a:lstStyle/>
                    <a:p>
                      <a:pPr algn="ctr"/>
                      <a:r>
                        <a:rPr lang="en-US"/>
                        <a:t>Cl-</a:t>
                      </a:r>
                    </a:p>
                  </a:txBody>
                  <a:tcPr/>
                </a:tc>
                <a:extLst>
                  <a:ext uri="{0D108BD9-81ED-4DB2-BD59-A6C34878D82A}">
                    <a16:rowId xmlns:a16="http://schemas.microsoft.com/office/drawing/2014/main" val="3925621980"/>
                  </a:ext>
                </a:extLst>
              </a:tr>
              <a:tr h="505410">
                <a:tc>
                  <a:txBody>
                    <a:bodyPr/>
                    <a:lstStyle/>
                    <a:p>
                      <a:r>
                        <a:rPr lang="en-US"/>
                        <a:t>7.35</a:t>
                      </a:r>
                    </a:p>
                  </a:txBody>
                  <a:tcPr/>
                </a:tc>
                <a:tc>
                  <a:txBody>
                    <a:bodyPr/>
                    <a:lstStyle/>
                    <a:p>
                      <a:r>
                        <a:rPr lang="en-US"/>
                        <a:t>35</a:t>
                      </a:r>
                    </a:p>
                  </a:txBody>
                  <a:tcPr/>
                </a:tc>
                <a:tc>
                  <a:txBody>
                    <a:bodyPr/>
                    <a:lstStyle/>
                    <a:p>
                      <a:r>
                        <a:rPr lang="en-US"/>
                        <a:t>26</a:t>
                      </a:r>
                    </a:p>
                  </a:txBody>
                  <a:tcPr/>
                </a:tc>
                <a:tc>
                  <a:txBody>
                    <a:bodyPr/>
                    <a:lstStyle/>
                    <a:p>
                      <a:r>
                        <a:rPr lang="en-US"/>
                        <a:t>142</a:t>
                      </a:r>
                    </a:p>
                  </a:txBody>
                  <a:tcPr/>
                </a:tc>
                <a:tc>
                  <a:txBody>
                    <a:bodyPr/>
                    <a:lstStyle/>
                    <a:p>
                      <a:r>
                        <a:rPr lang="en-US"/>
                        <a:t>4.0</a:t>
                      </a:r>
                    </a:p>
                  </a:txBody>
                  <a:tcPr/>
                </a:tc>
                <a:tc>
                  <a:txBody>
                    <a:bodyPr/>
                    <a:lstStyle/>
                    <a:p>
                      <a:r>
                        <a:rPr lang="en-US"/>
                        <a:t>95</a:t>
                      </a:r>
                    </a:p>
                  </a:txBody>
                  <a:tcPr/>
                </a:tc>
                <a:extLst>
                  <a:ext uri="{0D108BD9-81ED-4DB2-BD59-A6C34878D82A}">
                    <a16:rowId xmlns:a16="http://schemas.microsoft.com/office/drawing/2014/main" val="1549369976"/>
                  </a:ext>
                </a:extLst>
              </a:tr>
              <a:tr h="505410">
                <a:tc>
                  <a:txBody>
                    <a:bodyPr/>
                    <a:lstStyle/>
                    <a:p>
                      <a:r>
                        <a:rPr lang="en-US"/>
                        <a:t>7.40</a:t>
                      </a:r>
                    </a:p>
                  </a:txBody>
                  <a:tcPr/>
                </a:tc>
                <a:tc>
                  <a:txBody>
                    <a:bodyPr/>
                    <a:lstStyle/>
                    <a:p>
                      <a:r>
                        <a:rPr lang="en-US"/>
                        <a:t>40</a:t>
                      </a:r>
                    </a:p>
                  </a:txBody>
                  <a:tcPr/>
                </a:tc>
                <a:tc>
                  <a:txBody>
                    <a:bodyPr/>
                    <a:lstStyle/>
                    <a:p>
                      <a:r>
                        <a:rPr lang="en-US"/>
                        <a:t>22</a:t>
                      </a:r>
                    </a:p>
                  </a:txBody>
                  <a:tcPr/>
                </a:tc>
                <a:tc>
                  <a:txBody>
                    <a:bodyPr/>
                    <a:lstStyle/>
                    <a:p>
                      <a:r>
                        <a:rPr lang="en-US"/>
                        <a:t>142</a:t>
                      </a:r>
                    </a:p>
                  </a:txBody>
                  <a:tcPr/>
                </a:tc>
                <a:tc>
                  <a:txBody>
                    <a:bodyPr/>
                    <a:lstStyle/>
                    <a:p>
                      <a:r>
                        <a:rPr lang="en-US"/>
                        <a:t>4.0</a:t>
                      </a:r>
                    </a:p>
                  </a:txBody>
                  <a:tcPr/>
                </a:tc>
                <a:tc>
                  <a:txBody>
                    <a:bodyPr/>
                    <a:lstStyle/>
                    <a:p>
                      <a:r>
                        <a:rPr lang="en-US"/>
                        <a:t>110</a:t>
                      </a:r>
                    </a:p>
                  </a:txBody>
                  <a:tcPr/>
                </a:tc>
                <a:extLst>
                  <a:ext uri="{0D108BD9-81ED-4DB2-BD59-A6C34878D82A}">
                    <a16:rowId xmlns:a16="http://schemas.microsoft.com/office/drawing/2014/main" val="3365227491"/>
                  </a:ext>
                </a:extLst>
              </a:tr>
              <a:tr h="505410">
                <a:tc>
                  <a:txBody>
                    <a:bodyPr/>
                    <a:lstStyle/>
                    <a:p>
                      <a:r>
                        <a:rPr lang="en-US"/>
                        <a:t>7.50</a:t>
                      </a:r>
                    </a:p>
                  </a:txBody>
                  <a:tcPr/>
                </a:tc>
                <a:tc>
                  <a:txBody>
                    <a:bodyPr/>
                    <a:lstStyle/>
                    <a:p>
                      <a:r>
                        <a:rPr lang="en-US"/>
                        <a:t>27</a:t>
                      </a:r>
                    </a:p>
                  </a:txBody>
                  <a:tcPr/>
                </a:tc>
                <a:tc>
                  <a:txBody>
                    <a:bodyPr/>
                    <a:lstStyle/>
                    <a:p>
                      <a:r>
                        <a:rPr lang="en-US"/>
                        <a:t>24</a:t>
                      </a:r>
                    </a:p>
                  </a:txBody>
                  <a:tcPr/>
                </a:tc>
                <a:tc>
                  <a:txBody>
                    <a:bodyPr/>
                    <a:lstStyle/>
                    <a:p>
                      <a:r>
                        <a:rPr lang="en-US"/>
                        <a:t>140</a:t>
                      </a:r>
                    </a:p>
                  </a:txBody>
                  <a:tcPr/>
                </a:tc>
                <a:tc>
                  <a:txBody>
                    <a:bodyPr/>
                    <a:lstStyle/>
                    <a:p>
                      <a:r>
                        <a:rPr lang="en-US"/>
                        <a:t>3.2</a:t>
                      </a:r>
                    </a:p>
                  </a:txBody>
                  <a:tcPr/>
                </a:tc>
                <a:tc>
                  <a:txBody>
                    <a:bodyPr/>
                    <a:lstStyle/>
                    <a:p>
                      <a:r>
                        <a:rPr lang="en-US"/>
                        <a:t>90</a:t>
                      </a:r>
                    </a:p>
                  </a:txBody>
                  <a:tcPr/>
                </a:tc>
                <a:extLst>
                  <a:ext uri="{0D108BD9-81ED-4DB2-BD59-A6C34878D82A}">
                    <a16:rowId xmlns:a16="http://schemas.microsoft.com/office/drawing/2014/main" val="2197128974"/>
                  </a:ext>
                </a:extLst>
              </a:tr>
              <a:tr h="505410">
                <a:tc>
                  <a:txBody>
                    <a:bodyPr/>
                    <a:lstStyle/>
                    <a:p>
                      <a:r>
                        <a:rPr lang="en-US"/>
                        <a:t>7.58</a:t>
                      </a:r>
                    </a:p>
                  </a:txBody>
                  <a:tcPr/>
                </a:tc>
                <a:tc>
                  <a:txBody>
                    <a:bodyPr/>
                    <a:lstStyle/>
                    <a:p>
                      <a:r>
                        <a:rPr lang="en-US"/>
                        <a:t>42</a:t>
                      </a:r>
                    </a:p>
                  </a:txBody>
                  <a:tcPr/>
                </a:tc>
                <a:tc>
                  <a:txBody>
                    <a:bodyPr/>
                    <a:lstStyle/>
                    <a:p>
                      <a:r>
                        <a:rPr lang="en-US"/>
                        <a:t>38</a:t>
                      </a:r>
                    </a:p>
                  </a:txBody>
                  <a:tcPr/>
                </a:tc>
                <a:tc>
                  <a:txBody>
                    <a:bodyPr/>
                    <a:lstStyle/>
                    <a:p>
                      <a:r>
                        <a:rPr lang="en-US"/>
                        <a:t>137</a:t>
                      </a:r>
                    </a:p>
                  </a:txBody>
                  <a:tcPr/>
                </a:tc>
                <a:tc>
                  <a:txBody>
                    <a:bodyPr/>
                    <a:lstStyle/>
                    <a:p>
                      <a:r>
                        <a:rPr lang="en-US"/>
                        <a:t>3.1</a:t>
                      </a:r>
                    </a:p>
                  </a:txBody>
                  <a:tcPr/>
                </a:tc>
                <a:tc>
                  <a:txBody>
                    <a:bodyPr/>
                    <a:lstStyle/>
                    <a:p>
                      <a:r>
                        <a:rPr lang="en-US"/>
                        <a:t>85</a:t>
                      </a:r>
                    </a:p>
                  </a:txBody>
                  <a:tcPr/>
                </a:tc>
                <a:extLst>
                  <a:ext uri="{0D108BD9-81ED-4DB2-BD59-A6C34878D82A}">
                    <a16:rowId xmlns:a16="http://schemas.microsoft.com/office/drawing/2014/main" val="2170261752"/>
                  </a:ext>
                </a:extLst>
              </a:tr>
            </a:tbl>
          </a:graphicData>
        </a:graphic>
      </p:graphicFrame>
    </p:spTree>
    <p:extLst>
      <p:ext uri="{BB962C8B-B14F-4D97-AF65-F5344CB8AC3E}">
        <p14:creationId xmlns:p14="http://schemas.microsoft.com/office/powerpoint/2010/main" val="3293218741"/>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4">
            <a:extLst>
              <a:ext uri="{FF2B5EF4-FFF2-40B4-BE49-F238E27FC236}">
                <a16:creationId xmlns:a16="http://schemas.microsoft.com/office/drawing/2014/main" id="{A4D1ECFC-4B8A-437C-AECC-42E95DBA4B3E}"/>
              </a:ext>
            </a:extLst>
          </p:cNvPr>
          <p:cNvGraphicFramePr>
            <a:graphicFrameLocks noGrp="1"/>
          </p:cNvGraphicFramePr>
          <p:nvPr>
            <p:extLst>
              <p:ext uri="{D42A27DB-BD31-4B8C-83A1-F6EECF244321}">
                <p14:modId xmlns:p14="http://schemas.microsoft.com/office/powerpoint/2010/main" val="1325105110"/>
              </p:ext>
            </p:extLst>
          </p:nvPr>
        </p:nvGraphicFramePr>
        <p:xfrm>
          <a:off x="890586" y="207853"/>
          <a:ext cx="7362828" cy="2527050"/>
        </p:xfrm>
        <a:graphic>
          <a:graphicData uri="http://schemas.openxmlformats.org/drawingml/2006/table">
            <a:tbl>
              <a:tblPr firstRow="1" bandRow="1">
                <a:tableStyleId>{5C22544A-7EE6-4342-B048-85BDC9FD1C3A}</a:tableStyleId>
              </a:tblPr>
              <a:tblGrid>
                <a:gridCol w="1227138">
                  <a:extLst>
                    <a:ext uri="{9D8B030D-6E8A-4147-A177-3AD203B41FA5}">
                      <a16:colId xmlns:a16="http://schemas.microsoft.com/office/drawing/2014/main" val="2956672230"/>
                    </a:ext>
                  </a:extLst>
                </a:gridCol>
                <a:gridCol w="1227138">
                  <a:extLst>
                    <a:ext uri="{9D8B030D-6E8A-4147-A177-3AD203B41FA5}">
                      <a16:colId xmlns:a16="http://schemas.microsoft.com/office/drawing/2014/main" val="3366791402"/>
                    </a:ext>
                  </a:extLst>
                </a:gridCol>
                <a:gridCol w="1227138">
                  <a:extLst>
                    <a:ext uri="{9D8B030D-6E8A-4147-A177-3AD203B41FA5}">
                      <a16:colId xmlns:a16="http://schemas.microsoft.com/office/drawing/2014/main" val="1166372328"/>
                    </a:ext>
                  </a:extLst>
                </a:gridCol>
                <a:gridCol w="1227138">
                  <a:extLst>
                    <a:ext uri="{9D8B030D-6E8A-4147-A177-3AD203B41FA5}">
                      <a16:colId xmlns:a16="http://schemas.microsoft.com/office/drawing/2014/main" val="3425385262"/>
                    </a:ext>
                  </a:extLst>
                </a:gridCol>
                <a:gridCol w="1227138">
                  <a:extLst>
                    <a:ext uri="{9D8B030D-6E8A-4147-A177-3AD203B41FA5}">
                      <a16:colId xmlns:a16="http://schemas.microsoft.com/office/drawing/2014/main" val="1561456660"/>
                    </a:ext>
                  </a:extLst>
                </a:gridCol>
                <a:gridCol w="1227138">
                  <a:extLst>
                    <a:ext uri="{9D8B030D-6E8A-4147-A177-3AD203B41FA5}">
                      <a16:colId xmlns:a16="http://schemas.microsoft.com/office/drawing/2014/main" val="3670303674"/>
                    </a:ext>
                  </a:extLst>
                </a:gridCol>
              </a:tblGrid>
              <a:tr h="505410">
                <a:tc>
                  <a:txBody>
                    <a:bodyPr/>
                    <a:lstStyle/>
                    <a:p>
                      <a:pPr algn="ctr"/>
                      <a:r>
                        <a:rPr lang="en-US"/>
                        <a:t>pH</a:t>
                      </a:r>
                    </a:p>
                  </a:txBody>
                  <a:tcPr/>
                </a:tc>
                <a:tc>
                  <a:txBody>
                    <a:bodyPr/>
                    <a:lstStyle/>
                    <a:p>
                      <a:pPr algn="ctr"/>
                      <a:r>
                        <a:rPr lang="en-US"/>
                        <a:t>pCO2</a:t>
                      </a:r>
                    </a:p>
                  </a:txBody>
                  <a:tcPr/>
                </a:tc>
                <a:tc>
                  <a:txBody>
                    <a:bodyPr/>
                    <a:lstStyle/>
                    <a:p>
                      <a:pPr algn="ctr"/>
                      <a:r>
                        <a:rPr lang="en-US"/>
                        <a:t>HCO3-</a:t>
                      </a:r>
                    </a:p>
                  </a:txBody>
                  <a:tcPr/>
                </a:tc>
                <a:tc>
                  <a:txBody>
                    <a:bodyPr/>
                    <a:lstStyle/>
                    <a:p>
                      <a:pPr algn="ctr"/>
                      <a:r>
                        <a:rPr lang="en-US"/>
                        <a:t>Na+</a:t>
                      </a:r>
                    </a:p>
                  </a:txBody>
                  <a:tcPr/>
                </a:tc>
                <a:tc>
                  <a:txBody>
                    <a:bodyPr/>
                    <a:lstStyle/>
                    <a:p>
                      <a:pPr algn="ctr"/>
                      <a:r>
                        <a:rPr lang="en-US"/>
                        <a:t>K+</a:t>
                      </a:r>
                    </a:p>
                  </a:txBody>
                  <a:tcPr/>
                </a:tc>
                <a:tc>
                  <a:txBody>
                    <a:bodyPr/>
                    <a:lstStyle/>
                    <a:p>
                      <a:pPr algn="ctr"/>
                      <a:r>
                        <a:rPr lang="en-US"/>
                        <a:t>Cl-</a:t>
                      </a:r>
                    </a:p>
                  </a:txBody>
                  <a:tcPr/>
                </a:tc>
                <a:extLst>
                  <a:ext uri="{0D108BD9-81ED-4DB2-BD59-A6C34878D82A}">
                    <a16:rowId xmlns:a16="http://schemas.microsoft.com/office/drawing/2014/main" val="3925621980"/>
                  </a:ext>
                </a:extLst>
              </a:tr>
              <a:tr h="505410">
                <a:tc>
                  <a:txBody>
                    <a:bodyPr/>
                    <a:lstStyle/>
                    <a:p>
                      <a:r>
                        <a:rPr lang="en-US"/>
                        <a:t>7.35</a:t>
                      </a:r>
                    </a:p>
                  </a:txBody>
                  <a:tcPr/>
                </a:tc>
                <a:tc>
                  <a:txBody>
                    <a:bodyPr/>
                    <a:lstStyle/>
                    <a:p>
                      <a:r>
                        <a:rPr lang="en-US"/>
                        <a:t>35</a:t>
                      </a:r>
                    </a:p>
                  </a:txBody>
                  <a:tcPr/>
                </a:tc>
                <a:tc>
                  <a:txBody>
                    <a:bodyPr/>
                    <a:lstStyle/>
                    <a:p>
                      <a:r>
                        <a:rPr lang="en-US"/>
                        <a:t>26</a:t>
                      </a:r>
                    </a:p>
                  </a:txBody>
                  <a:tcPr/>
                </a:tc>
                <a:tc>
                  <a:txBody>
                    <a:bodyPr/>
                    <a:lstStyle/>
                    <a:p>
                      <a:r>
                        <a:rPr lang="en-US"/>
                        <a:t>142</a:t>
                      </a:r>
                    </a:p>
                  </a:txBody>
                  <a:tcPr/>
                </a:tc>
                <a:tc>
                  <a:txBody>
                    <a:bodyPr/>
                    <a:lstStyle/>
                    <a:p>
                      <a:r>
                        <a:rPr lang="en-US"/>
                        <a:t>4.0</a:t>
                      </a:r>
                    </a:p>
                  </a:txBody>
                  <a:tcPr/>
                </a:tc>
                <a:tc>
                  <a:txBody>
                    <a:bodyPr/>
                    <a:lstStyle/>
                    <a:p>
                      <a:r>
                        <a:rPr lang="en-US"/>
                        <a:t>95</a:t>
                      </a:r>
                    </a:p>
                  </a:txBody>
                  <a:tcPr/>
                </a:tc>
                <a:extLst>
                  <a:ext uri="{0D108BD9-81ED-4DB2-BD59-A6C34878D82A}">
                    <a16:rowId xmlns:a16="http://schemas.microsoft.com/office/drawing/2014/main" val="1549369976"/>
                  </a:ext>
                </a:extLst>
              </a:tr>
              <a:tr h="505410">
                <a:tc>
                  <a:txBody>
                    <a:bodyPr/>
                    <a:lstStyle/>
                    <a:p>
                      <a:r>
                        <a:rPr lang="en-US"/>
                        <a:t>7.40</a:t>
                      </a:r>
                    </a:p>
                  </a:txBody>
                  <a:tcPr/>
                </a:tc>
                <a:tc>
                  <a:txBody>
                    <a:bodyPr/>
                    <a:lstStyle/>
                    <a:p>
                      <a:r>
                        <a:rPr lang="en-US"/>
                        <a:t>40</a:t>
                      </a:r>
                    </a:p>
                  </a:txBody>
                  <a:tcPr/>
                </a:tc>
                <a:tc>
                  <a:txBody>
                    <a:bodyPr/>
                    <a:lstStyle/>
                    <a:p>
                      <a:r>
                        <a:rPr lang="en-US"/>
                        <a:t>22</a:t>
                      </a:r>
                    </a:p>
                  </a:txBody>
                  <a:tcPr/>
                </a:tc>
                <a:tc>
                  <a:txBody>
                    <a:bodyPr/>
                    <a:lstStyle/>
                    <a:p>
                      <a:r>
                        <a:rPr lang="en-US"/>
                        <a:t>142</a:t>
                      </a:r>
                    </a:p>
                  </a:txBody>
                  <a:tcPr/>
                </a:tc>
                <a:tc>
                  <a:txBody>
                    <a:bodyPr/>
                    <a:lstStyle/>
                    <a:p>
                      <a:r>
                        <a:rPr lang="en-US"/>
                        <a:t>4.0</a:t>
                      </a:r>
                    </a:p>
                  </a:txBody>
                  <a:tcPr/>
                </a:tc>
                <a:tc>
                  <a:txBody>
                    <a:bodyPr/>
                    <a:lstStyle/>
                    <a:p>
                      <a:r>
                        <a:rPr lang="en-US"/>
                        <a:t>110</a:t>
                      </a:r>
                    </a:p>
                  </a:txBody>
                  <a:tcPr/>
                </a:tc>
                <a:extLst>
                  <a:ext uri="{0D108BD9-81ED-4DB2-BD59-A6C34878D82A}">
                    <a16:rowId xmlns:a16="http://schemas.microsoft.com/office/drawing/2014/main" val="3365227491"/>
                  </a:ext>
                </a:extLst>
              </a:tr>
              <a:tr h="505410">
                <a:tc>
                  <a:txBody>
                    <a:bodyPr/>
                    <a:lstStyle/>
                    <a:p>
                      <a:r>
                        <a:rPr lang="en-US"/>
                        <a:t>7.50</a:t>
                      </a:r>
                    </a:p>
                  </a:txBody>
                  <a:tcPr/>
                </a:tc>
                <a:tc>
                  <a:txBody>
                    <a:bodyPr/>
                    <a:lstStyle/>
                    <a:p>
                      <a:r>
                        <a:rPr lang="en-US"/>
                        <a:t>27</a:t>
                      </a:r>
                    </a:p>
                  </a:txBody>
                  <a:tcPr/>
                </a:tc>
                <a:tc>
                  <a:txBody>
                    <a:bodyPr/>
                    <a:lstStyle/>
                    <a:p>
                      <a:r>
                        <a:rPr lang="en-US"/>
                        <a:t>24</a:t>
                      </a:r>
                    </a:p>
                  </a:txBody>
                  <a:tcPr/>
                </a:tc>
                <a:tc>
                  <a:txBody>
                    <a:bodyPr/>
                    <a:lstStyle/>
                    <a:p>
                      <a:r>
                        <a:rPr lang="en-US"/>
                        <a:t>140</a:t>
                      </a:r>
                    </a:p>
                  </a:txBody>
                  <a:tcPr/>
                </a:tc>
                <a:tc>
                  <a:txBody>
                    <a:bodyPr/>
                    <a:lstStyle/>
                    <a:p>
                      <a:r>
                        <a:rPr lang="en-US"/>
                        <a:t>3.2</a:t>
                      </a:r>
                    </a:p>
                  </a:txBody>
                  <a:tcPr/>
                </a:tc>
                <a:tc>
                  <a:txBody>
                    <a:bodyPr/>
                    <a:lstStyle/>
                    <a:p>
                      <a:r>
                        <a:rPr lang="en-US"/>
                        <a:t>90</a:t>
                      </a:r>
                    </a:p>
                  </a:txBody>
                  <a:tcPr/>
                </a:tc>
                <a:extLst>
                  <a:ext uri="{0D108BD9-81ED-4DB2-BD59-A6C34878D82A}">
                    <a16:rowId xmlns:a16="http://schemas.microsoft.com/office/drawing/2014/main" val="2197128974"/>
                  </a:ext>
                </a:extLst>
              </a:tr>
              <a:tr h="505410">
                <a:tc>
                  <a:txBody>
                    <a:bodyPr/>
                    <a:lstStyle/>
                    <a:p>
                      <a:r>
                        <a:rPr lang="en-US" b="1">
                          <a:highlight>
                            <a:srgbClr val="FFFF00"/>
                          </a:highlight>
                        </a:rPr>
                        <a:t>7.58</a:t>
                      </a:r>
                    </a:p>
                  </a:txBody>
                  <a:tcPr/>
                </a:tc>
                <a:tc>
                  <a:txBody>
                    <a:bodyPr/>
                    <a:lstStyle/>
                    <a:p>
                      <a:r>
                        <a:rPr lang="en-US" b="1">
                          <a:highlight>
                            <a:srgbClr val="FFFF00"/>
                          </a:highlight>
                        </a:rPr>
                        <a:t>42</a:t>
                      </a:r>
                    </a:p>
                  </a:txBody>
                  <a:tcPr/>
                </a:tc>
                <a:tc>
                  <a:txBody>
                    <a:bodyPr/>
                    <a:lstStyle/>
                    <a:p>
                      <a:r>
                        <a:rPr lang="en-US" b="1">
                          <a:highlight>
                            <a:srgbClr val="FFFF00"/>
                          </a:highlight>
                        </a:rPr>
                        <a:t>38</a:t>
                      </a:r>
                    </a:p>
                  </a:txBody>
                  <a:tcPr/>
                </a:tc>
                <a:tc>
                  <a:txBody>
                    <a:bodyPr/>
                    <a:lstStyle/>
                    <a:p>
                      <a:r>
                        <a:rPr lang="en-US" b="1">
                          <a:highlight>
                            <a:srgbClr val="FFFF00"/>
                          </a:highlight>
                        </a:rPr>
                        <a:t>137</a:t>
                      </a:r>
                    </a:p>
                  </a:txBody>
                  <a:tcPr/>
                </a:tc>
                <a:tc>
                  <a:txBody>
                    <a:bodyPr/>
                    <a:lstStyle/>
                    <a:p>
                      <a:r>
                        <a:rPr lang="en-US" b="1">
                          <a:highlight>
                            <a:srgbClr val="FFFF00"/>
                          </a:highlight>
                        </a:rPr>
                        <a:t>3.1</a:t>
                      </a:r>
                    </a:p>
                  </a:txBody>
                  <a:tcPr/>
                </a:tc>
                <a:tc>
                  <a:txBody>
                    <a:bodyPr/>
                    <a:lstStyle/>
                    <a:p>
                      <a:r>
                        <a:rPr lang="en-US" b="1">
                          <a:highlight>
                            <a:srgbClr val="FFFF00"/>
                          </a:highlight>
                        </a:rPr>
                        <a:t>85</a:t>
                      </a:r>
                    </a:p>
                  </a:txBody>
                  <a:tcPr/>
                </a:tc>
                <a:extLst>
                  <a:ext uri="{0D108BD9-81ED-4DB2-BD59-A6C34878D82A}">
                    <a16:rowId xmlns:a16="http://schemas.microsoft.com/office/drawing/2014/main" val="2170261752"/>
                  </a:ext>
                </a:extLst>
              </a:tr>
            </a:tbl>
          </a:graphicData>
        </a:graphic>
      </p:graphicFrame>
      <p:sp>
        <p:nvSpPr>
          <p:cNvPr id="6" name="TextBox 5">
            <a:extLst>
              <a:ext uri="{FF2B5EF4-FFF2-40B4-BE49-F238E27FC236}">
                <a16:creationId xmlns:a16="http://schemas.microsoft.com/office/drawing/2014/main" id="{284BF5C0-F621-46D1-871F-9EA444193063}"/>
              </a:ext>
            </a:extLst>
          </p:cNvPr>
          <p:cNvSpPr txBox="1"/>
          <p:nvPr/>
        </p:nvSpPr>
        <p:spPr>
          <a:xfrm>
            <a:off x="852928" y="2999381"/>
            <a:ext cx="6769634" cy="1169551"/>
          </a:xfrm>
          <a:prstGeom prst="rect">
            <a:avLst/>
          </a:prstGeom>
          <a:noFill/>
        </p:spPr>
        <p:txBody>
          <a:bodyPr wrap="square" rtlCol="0">
            <a:spAutoFit/>
          </a:bodyPr>
          <a:lstStyle/>
          <a:p>
            <a:pPr marL="342900" indent="-342900">
              <a:buAutoNum type="arabicPeriod"/>
            </a:pPr>
            <a:r>
              <a:rPr lang="en-US">
                <a:solidFill>
                  <a:schemeClr val="bg1"/>
                </a:solidFill>
              </a:rPr>
              <a:t>pH: high (alkalosis)</a:t>
            </a:r>
          </a:p>
          <a:p>
            <a:pPr marL="342900" indent="-342900">
              <a:buAutoNum type="arabicPeriod"/>
            </a:pPr>
            <a:r>
              <a:rPr lang="en-US">
                <a:solidFill>
                  <a:schemeClr val="bg1"/>
                </a:solidFill>
              </a:rPr>
              <a:t>pCO2: normal</a:t>
            </a:r>
          </a:p>
          <a:p>
            <a:pPr marL="342900" indent="-342900">
              <a:buAutoNum type="arabicPeriod"/>
            </a:pPr>
            <a:r>
              <a:rPr lang="en-US">
                <a:solidFill>
                  <a:schemeClr val="bg1"/>
                </a:solidFill>
              </a:rPr>
              <a:t>HCO3 : high (base excess) + high pH = metabolic alkalosis – loss of H+ from vomiting</a:t>
            </a:r>
          </a:p>
          <a:p>
            <a:pPr marL="342900" indent="-342900">
              <a:buAutoNum type="arabicPeriod"/>
            </a:pPr>
            <a:r>
              <a:rPr lang="en-US">
                <a:solidFill>
                  <a:schemeClr val="bg1"/>
                </a:solidFill>
              </a:rPr>
              <a:t>Other electrolyte disturbances?</a:t>
            </a:r>
          </a:p>
        </p:txBody>
      </p:sp>
    </p:spTree>
    <p:extLst>
      <p:ext uri="{BB962C8B-B14F-4D97-AF65-F5344CB8AC3E}">
        <p14:creationId xmlns:p14="http://schemas.microsoft.com/office/powerpoint/2010/main" val="1079207296"/>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C98A8E-FDED-407A-841B-6AD578FD6D42}"/>
              </a:ext>
            </a:extLst>
          </p:cNvPr>
          <p:cNvSpPr>
            <a:spLocks noGrp="1"/>
          </p:cNvSpPr>
          <p:nvPr>
            <p:ph type="title"/>
          </p:nvPr>
        </p:nvSpPr>
        <p:spPr/>
        <p:txBody>
          <a:bodyPr/>
          <a:lstStyle/>
          <a:p>
            <a:r>
              <a:rPr lang="en-US"/>
              <a:t>Electrolyte abnormalities – loss of hydrogen and chloride ions from vomiting gastric contents</a:t>
            </a:r>
          </a:p>
        </p:txBody>
      </p:sp>
      <p:sp>
        <p:nvSpPr>
          <p:cNvPr id="3" name="Subtitle 2">
            <a:extLst>
              <a:ext uri="{FF2B5EF4-FFF2-40B4-BE49-F238E27FC236}">
                <a16:creationId xmlns:a16="http://schemas.microsoft.com/office/drawing/2014/main" id="{FFFC6D88-B835-4D64-90F6-270FD2F54B43}"/>
              </a:ext>
            </a:extLst>
          </p:cNvPr>
          <p:cNvSpPr>
            <a:spLocks noGrp="1"/>
          </p:cNvSpPr>
          <p:nvPr>
            <p:ph type="subTitle" idx="1"/>
          </p:nvPr>
        </p:nvSpPr>
        <p:spPr/>
        <p:txBody>
          <a:bodyPr/>
          <a:lstStyle/>
          <a:p>
            <a:endParaRPr lang="en-US"/>
          </a:p>
        </p:txBody>
      </p:sp>
    </p:spTree>
    <p:extLst>
      <p:ext uri="{BB962C8B-B14F-4D97-AF65-F5344CB8AC3E}">
        <p14:creationId xmlns:p14="http://schemas.microsoft.com/office/powerpoint/2010/main" val="3935565634"/>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318"/>
        <p:cNvGrpSpPr/>
        <p:nvPr/>
      </p:nvGrpSpPr>
      <p:grpSpPr>
        <a:xfrm>
          <a:off x="0" y="0"/>
          <a:ext cx="0" cy="0"/>
          <a:chOff x="0" y="0"/>
          <a:chExt cx="0" cy="0"/>
        </a:xfrm>
      </p:grpSpPr>
      <p:sp>
        <p:nvSpPr>
          <p:cNvPr id="319" name="Google Shape;319;p25"/>
          <p:cNvSpPr txBox="1">
            <a:spLocks noGrp="1"/>
          </p:cNvSpPr>
          <p:nvPr>
            <p:ph type="title"/>
          </p:nvPr>
        </p:nvSpPr>
        <p:spPr>
          <a:xfrm>
            <a:off x="1032075" y="966325"/>
            <a:ext cx="7081800" cy="3188100"/>
          </a:xfrm>
          <a:prstGeom prst="rect">
            <a:avLst/>
          </a:prstGeom>
        </p:spPr>
        <p:txBody>
          <a:bodyPr spcFirstLastPara="1" wrap="square" lIns="0" tIns="0" rIns="0" bIns="0" anchor="ctr" anchorCtr="0">
            <a:noAutofit/>
          </a:bodyPr>
          <a:lstStyle/>
          <a:p>
            <a:pPr marL="0" lvl="0" indent="0" algn="ctr" rtl="0">
              <a:spcBef>
                <a:spcPts val="0"/>
              </a:spcBef>
              <a:spcAft>
                <a:spcPts val="0"/>
              </a:spcAft>
              <a:buNone/>
            </a:pPr>
            <a:r>
              <a:rPr lang="en"/>
              <a:t>ABG for a patient with history of poorly controlled diabetes and new-onset DKA</a:t>
            </a:r>
            <a:endParaRPr/>
          </a:p>
        </p:txBody>
      </p:sp>
      <p:sp>
        <p:nvSpPr>
          <p:cNvPr id="320" name="Google Shape;320;p25"/>
          <p:cNvSpPr txBox="1">
            <a:spLocks noGrp="1"/>
          </p:cNvSpPr>
          <p:nvPr>
            <p:ph type="subTitle" idx="1"/>
          </p:nvPr>
        </p:nvSpPr>
        <p:spPr>
          <a:xfrm>
            <a:off x="1038650" y="640325"/>
            <a:ext cx="7079700" cy="444300"/>
          </a:xfrm>
          <a:prstGeom prst="rect">
            <a:avLst/>
          </a:prstGeom>
        </p:spPr>
        <p:txBody>
          <a:bodyPr spcFirstLastPara="1" wrap="square" lIns="0" tIns="0" rIns="0" bIns="0" anchor="t" anchorCtr="0">
            <a:noAutofit/>
          </a:bodyPr>
          <a:lstStyle/>
          <a:p>
            <a:pPr marL="0" lvl="0" indent="0" algn="ctr" rtl="0">
              <a:spcBef>
                <a:spcPts val="600"/>
              </a:spcBef>
              <a:spcAft>
                <a:spcPts val="0"/>
              </a:spcAft>
              <a:buNone/>
            </a:pPr>
            <a:r>
              <a:rPr lang="en"/>
              <a:t>CATEGORY 2 · </a:t>
            </a:r>
            <a:r>
              <a:rPr lang="en">
                <a:solidFill>
                  <a:srgbClr val="FFC319"/>
                </a:solidFill>
              </a:rPr>
              <a:t>$600</a:t>
            </a:r>
            <a:endParaRPr>
              <a:solidFill>
                <a:srgbClr val="FFC319"/>
              </a:solidFill>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1E2B69-BA2F-4DF5-A8FD-51D6B16F31A0}"/>
              </a:ext>
            </a:extLst>
          </p:cNvPr>
          <p:cNvSpPr>
            <a:spLocks noGrp="1"/>
          </p:cNvSpPr>
          <p:nvPr>
            <p:ph type="title"/>
          </p:nvPr>
        </p:nvSpPr>
        <p:spPr/>
        <p:txBody>
          <a:bodyPr/>
          <a:lstStyle/>
          <a:p>
            <a:endParaRPr lang="en-US"/>
          </a:p>
        </p:txBody>
      </p:sp>
      <p:sp>
        <p:nvSpPr>
          <p:cNvPr id="3" name="Subtitle 2">
            <a:extLst>
              <a:ext uri="{FF2B5EF4-FFF2-40B4-BE49-F238E27FC236}">
                <a16:creationId xmlns:a16="http://schemas.microsoft.com/office/drawing/2014/main" id="{8E597D12-C434-4573-84C8-761A3DC6E9E5}"/>
              </a:ext>
            </a:extLst>
          </p:cNvPr>
          <p:cNvSpPr>
            <a:spLocks noGrp="1"/>
          </p:cNvSpPr>
          <p:nvPr>
            <p:ph type="subTitle" idx="1"/>
          </p:nvPr>
        </p:nvSpPr>
        <p:spPr/>
        <p:txBody>
          <a:bodyPr/>
          <a:lstStyle/>
          <a:p>
            <a:endParaRPr lang="en-US"/>
          </a:p>
        </p:txBody>
      </p:sp>
      <p:graphicFrame>
        <p:nvGraphicFramePr>
          <p:cNvPr id="4" name="Table 4">
            <a:extLst>
              <a:ext uri="{FF2B5EF4-FFF2-40B4-BE49-F238E27FC236}">
                <a16:creationId xmlns:a16="http://schemas.microsoft.com/office/drawing/2014/main" id="{9654722D-3FFA-419E-B273-B04979206034}"/>
              </a:ext>
            </a:extLst>
          </p:cNvPr>
          <p:cNvGraphicFramePr>
            <a:graphicFrameLocks noGrp="1"/>
          </p:cNvGraphicFramePr>
          <p:nvPr>
            <p:extLst>
              <p:ext uri="{D42A27DB-BD31-4B8C-83A1-F6EECF244321}">
                <p14:modId xmlns:p14="http://schemas.microsoft.com/office/powerpoint/2010/main" val="851035194"/>
              </p:ext>
            </p:extLst>
          </p:nvPr>
        </p:nvGraphicFramePr>
        <p:xfrm>
          <a:off x="897086" y="945520"/>
          <a:ext cx="7362828" cy="2527050"/>
        </p:xfrm>
        <a:graphic>
          <a:graphicData uri="http://schemas.openxmlformats.org/drawingml/2006/table">
            <a:tbl>
              <a:tblPr firstRow="1" bandRow="1">
                <a:tableStyleId>{5C22544A-7EE6-4342-B048-85BDC9FD1C3A}</a:tableStyleId>
              </a:tblPr>
              <a:tblGrid>
                <a:gridCol w="1227138">
                  <a:extLst>
                    <a:ext uri="{9D8B030D-6E8A-4147-A177-3AD203B41FA5}">
                      <a16:colId xmlns:a16="http://schemas.microsoft.com/office/drawing/2014/main" val="2956672230"/>
                    </a:ext>
                  </a:extLst>
                </a:gridCol>
                <a:gridCol w="1227138">
                  <a:extLst>
                    <a:ext uri="{9D8B030D-6E8A-4147-A177-3AD203B41FA5}">
                      <a16:colId xmlns:a16="http://schemas.microsoft.com/office/drawing/2014/main" val="3366791402"/>
                    </a:ext>
                  </a:extLst>
                </a:gridCol>
                <a:gridCol w="1227138">
                  <a:extLst>
                    <a:ext uri="{9D8B030D-6E8A-4147-A177-3AD203B41FA5}">
                      <a16:colId xmlns:a16="http://schemas.microsoft.com/office/drawing/2014/main" val="1166372328"/>
                    </a:ext>
                  </a:extLst>
                </a:gridCol>
                <a:gridCol w="1227138">
                  <a:extLst>
                    <a:ext uri="{9D8B030D-6E8A-4147-A177-3AD203B41FA5}">
                      <a16:colId xmlns:a16="http://schemas.microsoft.com/office/drawing/2014/main" val="3425385262"/>
                    </a:ext>
                  </a:extLst>
                </a:gridCol>
                <a:gridCol w="1227138">
                  <a:extLst>
                    <a:ext uri="{9D8B030D-6E8A-4147-A177-3AD203B41FA5}">
                      <a16:colId xmlns:a16="http://schemas.microsoft.com/office/drawing/2014/main" val="1561456660"/>
                    </a:ext>
                  </a:extLst>
                </a:gridCol>
                <a:gridCol w="1227138">
                  <a:extLst>
                    <a:ext uri="{9D8B030D-6E8A-4147-A177-3AD203B41FA5}">
                      <a16:colId xmlns:a16="http://schemas.microsoft.com/office/drawing/2014/main" val="3670303674"/>
                    </a:ext>
                  </a:extLst>
                </a:gridCol>
              </a:tblGrid>
              <a:tr h="505410">
                <a:tc>
                  <a:txBody>
                    <a:bodyPr/>
                    <a:lstStyle/>
                    <a:p>
                      <a:pPr algn="ctr"/>
                      <a:r>
                        <a:rPr lang="en-US"/>
                        <a:t>pH</a:t>
                      </a:r>
                    </a:p>
                  </a:txBody>
                  <a:tcPr/>
                </a:tc>
                <a:tc>
                  <a:txBody>
                    <a:bodyPr/>
                    <a:lstStyle/>
                    <a:p>
                      <a:pPr algn="ctr"/>
                      <a:r>
                        <a:rPr lang="en-US"/>
                        <a:t>pCO2</a:t>
                      </a:r>
                    </a:p>
                  </a:txBody>
                  <a:tcPr/>
                </a:tc>
                <a:tc>
                  <a:txBody>
                    <a:bodyPr/>
                    <a:lstStyle/>
                    <a:p>
                      <a:pPr algn="ctr"/>
                      <a:r>
                        <a:rPr lang="en-US"/>
                        <a:t>HCO3-</a:t>
                      </a:r>
                    </a:p>
                  </a:txBody>
                  <a:tcPr/>
                </a:tc>
                <a:tc>
                  <a:txBody>
                    <a:bodyPr/>
                    <a:lstStyle/>
                    <a:p>
                      <a:pPr algn="ctr"/>
                      <a:r>
                        <a:rPr lang="en-US"/>
                        <a:t>Na+</a:t>
                      </a:r>
                    </a:p>
                  </a:txBody>
                  <a:tcPr/>
                </a:tc>
                <a:tc>
                  <a:txBody>
                    <a:bodyPr/>
                    <a:lstStyle/>
                    <a:p>
                      <a:pPr algn="ctr"/>
                      <a:r>
                        <a:rPr lang="en-US"/>
                        <a:t>K+</a:t>
                      </a:r>
                    </a:p>
                  </a:txBody>
                  <a:tcPr/>
                </a:tc>
                <a:tc>
                  <a:txBody>
                    <a:bodyPr/>
                    <a:lstStyle/>
                    <a:p>
                      <a:pPr algn="ctr"/>
                      <a:r>
                        <a:rPr lang="en-US"/>
                        <a:t>Cl-</a:t>
                      </a:r>
                    </a:p>
                  </a:txBody>
                  <a:tcPr/>
                </a:tc>
                <a:extLst>
                  <a:ext uri="{0D108BD9-81ED-4DB2-BD59-A6C34878D82A}">
                    <a16:rowId xmlns:a16="http://schemas.microsoft.com/office/drawing/2014/main" val="3925621980"/>
                  </a:ext>
                </a:extLst>
              </a:tr>
              <a:tr h="505410">
                <a:tc>
                  <a:txBody>
                    <a:bodyPr/>
                    <a:lstStyle/>
                    <a:p>
                      <a:r>
                        <a:rPr lang="en-US"/>
                        <a:t>7.40</a:t>
                      </a:r>
                    </a:p>
                  </a:txBody>
                  <a:tcPr/>
                </a:tc>
                <a:tc>
                  <a:txBody>
                    <a:bodyPr/>
                    <a:lstStyle/>
                    <a:p>
                      <a:r>
                        <a:rPr lang="en-US"/>
                        <a:t>38</a:t>
                      </a:r>
                    </a:p>
                  </a:txBody>
                  <a:tcPr/>
                </a:tc>
                <a:tc>
                  <a:txBody>
                    <a:bodyPr/>
                    <a:lstStyle/>
                    <a:p>
                      <a:r>
                        <a:rPr lang="en-US"/>
                        <a:t>12</a:t>
                      </a:r>
                    </a:p>
                  </a:txBody>
                  <a:tcPr/>
                </a:tc>
                <a:tc>
                  <a:txBody>
                    <a:bodyPr/>
                    <a:lstStyle/>
                    <a:p>
                      <a:r>
                        <a:rPr lang="en-US"/>
                        <a:t>140</a:t>
                      </a:r>
                    </a:p>
                  </a:txBody>
                  <a:tcPr/>
                </a:tc>
                <a:tc>
                  <a:txBody>
                    <a:bodyPr/>
                    <a:lstStyle/>
                    <a:p>
                      <a:r>
                        <a:rPr lang="en-US"/>
                        <a:t>5.2</a:t>
                      </a:r>
                    </a:p>
                  </a:txBody>
                  <a:tcPr/>
                </a:tc>
                <a:tc>
                  <a:txBody>
                    <a:bodyPr/>
                    <a:lstStyle/>
                    <a:p>
                      <a:r>
                        <a:rPr lang="en-US"/>
                        <a:t>100</a:t>
                      </a:r>
                    </a:p>
                  </a:txBody>
                  <a:tcPr/>
                </a:tc>
                <a:extLst>
                  <a:ext uri="{0D108BD9-81ED-4DB2-BD59-A6C34878D82A}">
                    <a16:rowId xmlns:a16="http://schemas.microsoft.com/office/drawing/2014/main" val="1549369976"/>
                  </a:ext>
                </a:extLst>
              </a:tr>
              <a:tr h="505410">
                <a:tc>
                  <a:txBody>
                    <a:bodyPr/>
                    <a:lstStyle/>
                    <a:p>
                      <a:r>
                        <a:rPr lang="en-US"/>
                        <a:t>7.29</a:t>
                      </a:r>
                    </a:p>
                  </a:txBody>
                  <a:tcPr/>
                </a:tc>
                <a:tc>
                  <a:txBody>
                    <a:bodyPr/>
                    <a:lstStyle/>
                    <a:p>
                      <a:r>
                        <a:rPr lang="en-US"/>
                        <a:t>25</a:t>
                      </a:r>
                    </a:p>
                  </a:txBody>
                  <a:tcPr/>
                </a:tc>
                <a:tc>
                  <a:txBody>
                    <a:bodyPr/>
                    <a:lstStyle/>
                    <a:p>
                      <a:r>
                        <a:rPr lang="en-US"/>
                        <a:t>24</a:t>
                      </a:r>
                    </a:p>
                  </a:txBody>
                  <a:tcPr/>
                </a:tc>
                <a:tc>
                  <a:txBody>
                    <a:bodyPr/>
                    <a:lstStyle/>
                    <a:p>
                      <a:r>
                        <a:rPr lang="en-US"/>
                        <a:t>135</a:t>
                      </a:r>
                    </a:p>
                  </a:txBody>
                  <a:tcPr/>
                </a:tc>
                <a:tc>
                  <a:txBody>
                    <a:bodyPr/>
                    <a:lstStyle/>
                    <a:p>
                      <a:r>
                        <a:rPr lang="en-US"/>
                        <a:t>5.0</a:t>
                      </a:r>
                    </a:p>
                  </a:txBody>
                  <a:tcPr/>
                </a:tc>
                <a:tc>
                  <a:txBody>
                    <a:bodyPr/>
                    <a:lstStyle/>
                    <a:p>
                      <a:r>
                        <a:rPr lang="en-US"/>
                        <a:t>100</a:t>
                      </a:r>
                    </a:p>
                  </a:txBody>
                  <a:tcPr/>
                </a:tc>
                <a:extLst>
                  <a:ext uri="{0D108BD9-81ED-4DB2-BD59-A6C34878D82A}">
                    <a16:rowId xmlns:a16="http://schemas.microsoft.com/office/drawing/2014/main" val="3365227491"/>
                  </a:ext>
                </a:extLst>
              </a:tr>
              <a:tr h="505410">
                <a:tc>
                  <a:txBody>
                    <a:bodyPr/>
                    <a:lstStyle/>
                    <a:p>
                      <a:r>
                        <a:rPr lang="en-US" b="0"/>
                        <a:t>7.29</a:t>
                      </a:r>
                    </a:p>
                  </a:txBody>
                  <a:tcPr/>
                </a:tc>
                <a:tc>
                  <a:txBody>
                    <a:bodyPr/>
                    <a:lstStyle/>
                    <a:p>
                      <a:r>
                        <a:rPr lang="en-US" b="0"/>
                        <a:t>38</a:t>
                      </a:r>
                    </a:p>
                  </a:txBody>
                  <a:tcPr/>
                </a:tc>
                <a:tc>
                  <a:txBody>
                    <a:bodyPr/>
                    <a:lstStyle/>
                    <a:p>
                      <a:r>
                        <a:rPr lang="en-US" b="0"/>
                        <a:t>12</a:t>
                      </a:r>
                    </a:p>
                  </a:txBody>
                  <a:tcPr/>
                </a:tc>
                <a:tc>
                  <a:txBody>
                    <a:bodyPr/>
                    <a:lstStyle/>
                    <a:p>
                      <a:r>
                        <a:rPr lang="en-US" b="0"/>
                        <a:t>144</a:t>
                      </a:r>
                    </a:p>
                  </a:txBody>
                  <a:tcPr/>
                </a:tc>
                <a:tc>
                  <a:txBody>
                    <a:bodyPr/>
                    <a:lstStyle/>
                    <a:p>
                      <a:r>
                        <a:rPr lang="en-US" b="0"/>
                        <a:t>5.7</a:t>
                      </a:r>
                    </a:p>
                  </a:txBody>
                  <a:tcPr/>
                </a:tc>
                <a:tc>
                  <a:txBody>
                    <a:bodyPr/>
                    <a:lstStyle/>
                    <a:p>
                      <a:r>
                        <a:rPr lang="en-US" b="0"/>
                        <a:t>98</a:t>
                      </a:r>
                    </a:p>
                  </a:txBody>
                  <a:tcPr/>
                </a:tc>
                <a:extLst>
                  <a:ext uri="{0D108BD9-81ED-4DB2-BD59-A6C34878D82A}">
                    <a16:rowId xmlns:a16="http://schemas.microsoft.com/office/drawing/2014/main" val="2197128974"/>
                  </a:ext>
                </a:extLst>
              </a:tr>
              <a:tr h="505410">
                <a:tc>
                  <a:txBody>
                    <a:bodyPr/>
                    <a:lstStyle/>
                    <a:p>
                      <a:r>
                        <a:rPr lang="en-US"/>
                        <a:t>7.35</a:t>
                      </a:r>
                    </a:p>
                  </a:txBody>
                  <a:tcPr/>
                </a:tc>
                <a:tc>
                  <a:txBody>
                    <a:bodyPr/>
                    <a:lstStyle/>
                    <a:p>
                      <a:r>
                        <a:rPr lang="en-US"/>
                        <a:t>35</a:t>
                      </a:r>
                    </a:p>
                  </a:txBody>
                  <a:tcPr/>
                </a:tc>
                <a:tc>
                  <a:txBody>
                    <a:bodyPr/>
                    <a:lstStyle/>
                    <a:p>
                      <a:r>
                        <a:rPr lang="en-US"/>
                        <a:t>22</a:t>
                      </a:r>
                    </a:p>
                  </a:txBody>
                  <a:tcPr/>
                </a:tc>
                <a:tc>
                  <a:txBody>
                    <a:bodyPr/>
                    <a:lstStyle/>
                    <a:p>
                      <a:r>
                        <a:rPr lang="en-US"/>
                        <a:t>140</a:t>
                      </a:r>
                    </a:p>
                  </a:txBody>
                  <a:tcPr/>
                </a:tc>
                <a:tc>
                  <a:txBody>
                    <a:bodyPr/>
                    <a:lstStyle/>
                    <a:p>
                      <a:r>
                        <a:rPr lang="en-US"/>
                        <a:t>4.5</a:t>
                      </a:r>
                    </a:p>
                  </a:txBody>
                  <a:tcPr/>
                </a:tc>
                <a:tc>
                  <a:txBody>
                    <a:bodyPr/>
                    <a:lstStyle/>
                    <a:p>
                      <a:r>
                        <a:rPr lang="en-US"/>
                        <a:t>105</a:t>
                      </a:r>
                    </a:p>
                  </a:txBody>
                  <a:tcPr/>
                </a:tc>
                <a:extLst>
                  <a:ext uri="{0D108BD9-81ED-4DB2-BD59-A6C34878D82A}">
                    <a16:rowId xmlns:a16="http://schemas.microsoft.com/office/drawing/2014/main" val="3581344390"/>
                  </a:ext>
                </a:extLst>
              </a:tr>
            </a:tbl>
          </a:graphicData>
        </a:graphic>
      </p:graphicFrame>
    </p:spTree>
    <p:extLst>
      <p:ext uri="{BB962C8B-B14F-4D97-AF65-F5344CB8AC3E}">
        <p14:creationId xmlns:p14="http://schemas.microsoft.com/office/powerpoint/2010/main" val="1945550964"/>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4">
            <a:extLst>
              <a:ext uri="{FF2B5EF4-FFF2-40B4-BE49-F238E27FC236}">
                <a16:creationId xmlns:a16="http://schemas.microsoft.com/office/drawing/2014/main" id="{15C7176D-C596-4087-8FF0-2504C9684D69}"/>
              </a:ext>
            </a:extLst>
          </p:cNvPr>
          <p:cNvGraphicFramePr>
            <a:graphicFrameLocks noGrp="1"/>
          </p:cNvGraphicFramePr>
          <p:nvPr>
            <p:extLst>
              <p:ext uri="{D42A27DB-BD31-4B8C-83A1-F6EECF244321}">
                <p14:modId xmlns:p14="http://schemas.microsoft.com/office/powerpoint/2010/main" val="2448725507"/>
              </p:ext>
            </p:extLst>
          </p:nvPr>
        </p:nvGraphicFramePr>
        <p:xfrm>
          <a:off x="890586" y="376902"/>
          <a:ext cx="7362828" cy="2527050"/>
        </p:xfrm>
        <a:graphic>
          <a:graphicData uri="http://schemas.openxmlformats.org/drawingml/2006/table">
            <a:tbl>
              <a:tblPr firstRow="1" bandRow="1">
                <a:tableStyleId>{5C22544A-7EE6-4342-B048-85BDC9FD1C3A}</a:tableStyleId>
              </a:tblPr>
              <a:tblGrid>
                <a:gridCol w="1227138">
                  <a:extLst>
                    <a:ext uri="{9D8B030D-6E8A-4147-A177-3AD203B41FA5}">
                      <a16:colId xmlns:a16="http://schemas.microsoft.com/office/drawing/2014/main" val="2956672230"/>
                    </a:ext>
                  </a:extLst>
                </a:gridCol>
                <a:gridCol w="1227138">
                  <a:extLst>
                    <a:ext uri="{9D8B030D-6E8A-4147-A177-3AD203B41FA5}">
                      <a16:colId xmlns:a16="http://schemas.microsoft.com/office/drawing/2014/main" val="3366791402"/>
                    </a:ext>
                  </a:extLst>
                </a:gridCol>
                <a:gridCol w="1227138">
                  <a:extLst>
                    <a:ext uri="{9D8B030D-6E8A-4147-A177-3AD203B41FA5}">
                      <a16:colId xmlns:a16="http://schemas.microsoft.com/office/drawing/2014/main" val="1166372328"/>
                    </a:ext>
                  </a:extLst>
                </a:gridCol>
                <a:gridCol w="1227138">
                  <a:extLst>
                    <a:ext uri="{9D8B030D-6E8A-4147-A177-3AD203B41FA5}">
                      <a16:colId xmlns:a16="http://schemas.microsoft.com/office/drawing/2014/main" val="3425385262"/>
                    </a:ext>
                  </a:extLst>
                </a:gridCol>
                <a:gridCol w="1227138">
                  <a:extLst>
                    <a:ext uri="{9D8B030D-6E8A-4147-A177-3AD203B41FA5}">
                      <a16:colId xmlns:a16="http://schemas.microsoft.com/office/drawing/2014/main" val="1561456660"/>
                    </a:ext>
                  </a:extLst>
                </a:gridCol>
                <a:gridCol w="1227138">
                  <a:extLst>
                    <a:ext uri="{9D8B030D-6E8A-4147-A177-3AD203B41FA5}">
                      <a16:colId xmlns:a16="http://schemas.microsoft.com/office/drawing/2014/main" val="3670303674"/>
                    </a:ext>
                  </a:extLst>
                </a:gridCol>
              </a:tblGrid>
              <a:tr h="505410">
                <a:tc>
                  <a:txBody>
                    <a:bodyPr/>
                    <a:lstStyle/>
                    <a:p>
                      <a:pPr algn="ctr"/>
                      <a:r>
                        <a:rPr lang="en-US"/>
                        <a:t>pH</a:t>
                      </a:r>
                    </a:p>
                  </a:txBody>
                  <a:tcPr/>
                </a:tc>
                <a:tc>
                  <a:txBody>
                    <a:bodyPr/>
                    <a:lstStyle/>
                    <a:p>
                      <a:pPr algn="ctr"/>
                      <a:r>
                        <a:rPr lang="en-US"/>
                        <a:t>pCO2</a:t>
                      </a:r>
                    </a:p>
                  </a:txBody>
                  <a:tcPr/>
                </a:tc>
                <a:tc>
                  <a:txBody>
                    <a:bodyPr/>
                    <a:lstStyle/>
                    <a:p>
                      <a:pPr algn="ctr"/>
                      <a:r>
                        <a:rPr lang="en-US"/>
                        <a:t>HCO3-</a:t>
                      </a:r>
                    </a:p>
                  </a:txBody>
                  <a:tcPr/>
                </a:tc>
                <a:tc>
                  <a:txBody>
                    <a:bodyPr/>
                    <a:lstStyle/>
                    <a:p>
                      <a:pPr algn="ctr"/>
                      <a:r>
                        <a:rPr lang="en-US"/>
                        <a:t>Na+</a:t>
                      </a:r>
                    </a:p>
                  </a:txBody>
                  <a:tcPr/>
                </a:tc>
                <a:tc>
                  <a:txBody>
                    <a:bodyPr/>
                    <a:lstStyle/>
                    <a:p>
                      <a:pPr algn="ctr"/>
                      <a:r>
                        <a:rPr lang="en-US"/>
                        <a:t>K+</a:t>
                      </a:r>
                    </a:p>
                  </a:txBody>
                  <a:tcPr/>
                </a:tc>
                <a:tc>
                  <a:txBody>
                    <a:bodyPr/>
                    <a:lstStyle/>
                    <a:p>
                      <a:pPr algn="ctr"/>
                      <a:r>
                        <a:rPr lang="en-US"/>
                        <a:t>Cl-</a:t>
                      </a:r>
                    </a:p>
                  </a:txBody>
                  <a:tcPr/>
                </a:tc>
                <a:extLst>
                  <a:ext uri="{0D108BD9-81ED-4DB2-BD59-A6C34878D82A}">
                    <a16:rowId xmlns:a16="http://schemas.microsoft.com/office/drawing/2014/main" val="3925621980"/>
                  </a:ext>
                </a:extLst>
              </a:tr>
              <a:tr h="505410">
                <a:tc>
                  <a:txBody>
                    <a:bodyPr/>
                    <a:lstStyle/>
                    <a:p>
                      <a:r>
                        <a:rPr lang="en-US"/>
                        <a:t>7.40</a:t>
                      </a:r>
                    </a:p>
                  </a:txBody>
                  <a:tcPr/>
                </a:tc>
                <a:tc>
                  <a:txBody>
                    <a:bodyPr/>
                    <a:lstStyle/>
                    <a:p>
                      <a:r>
                        <a:rPr lang="en-US"/>
                        <a:t>38</a:t>
                      </a:r>
                    </a:p>
                  </a:txBody>
                  <a:tcPr/>
                </a:tc>
                <a:tc>
                  <a:txBody>
                    <a:bodyPr/>
                    <a:lstStyle/>
                    <a:p>
                      <a:r>
                        <a:rPr lang="en-US"/>
                        <a:t>12</a:t>
                      </a:r>
                    </a:p>
                  </a:txBody>
                  <a:tcPr/>
                </a:tc>
                <a:tc>
                  <a:txBody>
                    <a:bodyPr/>
                    <a:lstStyle/>
                    <a:p>
                      <a:r>
                        <a:rPr lang="en-US"/>
                        <a:t>131</a:t>
                      </a:r>
                    </a:p>
                  </a:txBody>
                  <a:tcPr/>
                </a:tc>
                <a:tc>
                  <a:txBody>
                    <a:bodyPr/>
                    <a:lstStyle/>
                    <a:p>
                      <a:r>
                        <a:rPr lang="en-US"/>
                        <a:t>5.2</a:t>
                      </a:r>
                    </a:p>
                  </a:txBody>
                  <a:tcPr/>
                </a:tc>
                <a:tc>
                  <a:txBody>
                    <a:bodyPr/>
                    <a:lstStyle/>
                    <a:p>
                      <a:r>
                        <a:rPr lang="en-US"/>
                        <a:t>100</a:t>
                      </a:r>
                    </a:p>
                  </a:txBody>
                  <a:tcPr/>
                </a:tc>
                <a:extLst>
                  <a:ext uri="{0D108BD9-81ED-4DB2-BD59-A6C34878D82A}">
                    <a16:rowId xmlns:a16="http://schemas.microsoft.com/office/drawing/2014/main" val="1549369976"/>
                  </a:ext>
                </a:extLst>
              </a:tr>
              <a:tr h="505410">
                <a:tc>
                  <a:txBody>
                    <a:bodyPr/>
                    <a:lstStyle/>
                    <a:p>
                      <a:r>
                        <a:rPr lang="en-US"/>
                        <a:t>7.29</a:t>
                      </a:r>
                    </a:p>
                  </a:txBody>
                  <a:tcPr/>
                </a:tc>
                <a:tc>
                  <a:txBody>
                    <a:bodyPr/>
                    <a:lstStyle/>
                    <a:p>
                      <a:r>
                        <a:rPr lang="en-US"/>
                        <a:t>25</a:t>
                      </a:r>
                    </a:p>
                  </a:txBody>
                  <a:tcPr/>
                </a:tc>
                <a:tc>
                  <a:txBody>
                    <a:bodyPr/>
                    <a:lstStyle/>
                    <a:p>
                      <a:r>
                        <a:rPr lang="en-US"/>
                        <a:t>24</a:t>
                      </a:r>
                    </a:p>
                  </a:txBody>
                  <a:tcPr/>
                </a:tc>
                <a:tc>
                  <a:txBody>
                    <a:bodyPr/>
                    <a:lstStyle/>
                    <a:p>
                      <a:r>
                        <a:rPr lang="en-US"/>
                        <a:t>130</a:t>
                      </a:r>
                    </a:p>
                  </a:txBody>
                  <a:tcPr/>
                </a:tc>
                <a:tc>
                  <a:txBody>
                    <a:bodyPr/>
                    <a:lstStyle/>
                    <a:p>
                      <a:r>
                        <a:rPr lang="en-US"/>
                        <a:t>5.0</a:t>
                      </a:r>
                    </a:p>
                  </a:txBody>
                  <a:tcPr/>
                </a:tc>
                <a:tc>
                  <a:txBody>
                    <a:bodyPr/>
                    <a:lstStyle/>
                    <a:p>
                      <a:r>
                        <a:rPr lang="en-US"/>
                        <a:t>100</a:t>
                      </a:r>
                    </a:p>
                  </a:txBody>
                  <a:tcPr/>
                </a:tc>
                <a:extLst>
                  <a:ext uri="{0D108BD9-81ED-4DB2-BD59-A6C34878D82A}">
                    <a16:rowId xmlns:a16="http://schemas.microsoft.com/office/drawing/2014/main" val="3365227491"/>
                  </a:ext>
                </a:extLst>
              </a:tr>
              <a:tr h="505410">
                <a:tc>
                  <a:txBody>
                    <a:bodyPr/>
                    <a:lstStyle/>
                    <a:p>
                      <a:r>
                        <a:rPr lang="en-US" b="1">
                          <a:highlight>
                            <a:srgbClr val="FFFF00"/>
                          </a:highlight>
                        </a:rPr>
                        <a:t>7.29</a:t>
                      </a:r>
                    </a:p>
                  </a:txBody>
                  <a:tcPr/>
                </a:tc>
                <a:tc>
                  <a:txBody>
                    <a:bodyPr/>
                    <a:lstStyle/>
                    <a:p>
                      <a:r>
                        <a:rPr lang="en-US" b="1">
                          <a:highlight>
                            <a:srgbClr val="FFFF00"/>
                          </a:highlight>
                        </a:rPr>
                        <a:t>38</a:t>
                      </a:r>
                    </a:p>
                  </a:txBody>
                  <a:tcPr/>
                </a:tc>
                <a:tc>
                  <a:txBody>
                    <a:bodyPr/>
                    <a:lstStyle/>
                    <a:p>
                      <a:r>
                        <a:rPr lang="en-US" b="1">
                          <a:highlight>
                            <a:srgbClr val="FFFF00"/>
                          </a:highlight>
                        </a:rPr>
                        <a:t>12</a:t>
                      </a:r>
                    </a:p>
                  </a:txBody>
                  <a:tcPr/>
                </a:tc>
                <a:tc>
                  <a:txBody>
                    <a:bodyPr/>
                    <a:lstStyle/>
                    <a:p>
                      <a:r>
                        <a:rPr lang="en-US" b="1">
                          <a:highlight>
                            <a:srgbClr val="FFFF00"/>
                          </a:highlight>
                        </a:rPr>
                        <a:t>128</a:t>
                      </a:r>
                    </a:p>
                  </a:txBody>
                  <a:tcPr/>
                </a:tc>
                <a:tc>
                  <a:txBody>
                    <a:bodyPr/>
                    <a:lstStyle/>
                    <a:p>
                      <a:r>
                        <a:rPr lang="en-US" b="1">
                          <a:highlight>
                            <a:srgbClr val="FFFF00"/>
                          </a:highlight>
                        </a:rPr>
                        <a:t>5.7</a:t>
                      </a:r>
                    </a:p>
                  </a:txBody>
                  <a:tcPr/>
                </a:tc>
                <a:tc>
                  <a:txBody>
                    <a:bodyPr/>
                    <a:lstStyle/>
                    <a:p>
                      <a:r>
                        <a:rPr lang="en-US" b="1">
                          <a:highlight>
                            <a:srgbClr val="FFFF00"/>
                          </a:highlight>
                        </a:rPr>
                        <a:t>98</a:t>
                      </a:r>
                    </a:p>
                  </a:txBody>
                  <a:tcPr/>
                </a:tc>
                <a:extLst>
                  <a:ext uri="{0D108BD9-81ED-4DB2-BD59-A6C34878D82A}">
                    <a16:rowId xmlns:a16="http://schemas.microsoft.com/office/drawing/2014/main" val="2197128974"/>
                  </a:ext>
                </a:extLst>
              </a:tr>
              <a:tr h="505410">
                <a:tc>
                  <a:txBody>
                    <a:bodyPr/>
                    <a:lstStyle/>
                    <a:p>
                      <a:r>
                        <a:rPr lang="en-US"/>
                        <a:t>7.35</a:t>
                      </a:r>
                    </a:p>
                  </a:txBody>
                  <a:tcPr/>
                </a:tc>
                <a:tc>
                  <a:txBody>
                    <a:bodyPr/>
                    <a:lstStyle/>
                    <a:p>
                      <a:r>
                        <a:rPr lang="en-US"/>
                        <a:t>35</a:t>
                      </a:r>
                    </a:p>
                  </a:txBody>
                  <a:tcPr/>
                </a:tc>
                <a:tc>
                  <a:txBody>
                    <a:bodyPr/>
                    <a:lstStyle/>
                    <a:p>
                      <a:r>
                        <a:rPr lang="en-US"/>
                        <a:t>22</a:t>
                      </a:r>
                    </a:p>
                  </a:txBody>
                  <a:tcPr/>
                </a:tc>
                <a:tc>
                  <a:txBody>
                    <a:bodyPr/>
                    <a:lstStyle/>
                    <a:p>
                      <a:r>
                        <a:rPr lang="en-US"/>
                        <a:t>129</a:t>
                      </a:r>
                    </a:p>
                  </a:txBody>
                  <a:tcPr/>
                </a:tc>
                <a:tc>
                  <a:txBody>
                    <a:bodyPr/>
                    <a:lstStyle/>
                    <a:p>
                      <a:r>
                        <a:rPr lang="en-US"/>
                        <a:t>4.5</a:t>
                      </a:r>
                    </a:p>
                  </a:txBody>
                  <a:tcPr/>
                </a:tc>
                <a:tc>
                  <a:txBody>
                    <a:bodyPr/>
                    <a:lstStyle/>
                    <a:p>
                      <a:r>
                        <a:rPr lang="en-US"/>
                        <a:t>105</a:t>
                      </a:r>
                    </a:p>
                  </a:txBody>
                  <a:tcPr/>
                </a:tc>
                <a:extLst>
                  <a:ext uri="{0D108BD9-81ED-4DB2-BD59-A6C34878D82A}">
                    <a16:rowId xmlns:a16="http://schemas.microsoft.com/office/drawing/2014/main" val="3581344390"/>
                  </a:ext>
                </a:extLst>
              </a:tr>
            </a:tbl>
          </a:graphicData>
        </a:graphic>
      </p:graphicFrame>
      <p:sp>
        <p:nvSpPr>
          <p:cNvPr id="5" name="TextBox 4">
            <a:extLst>
              <a:ext uri="{FF2B5EF4-FFF2-40B4-BE49-F238E27FC236}">
                <a16:creationId xmlns:a16="http://schemas.microsoft.com/office/drawing/2014/main" id="{1658F5AE-33D1-411E-B798-271F7ADD1466}"/>
              </a:ext>
            </a:extLst>
          </p:cNvPr>
          <p:cNvSpPr txBox="1"/>
          <p:nvPr/>
        </p:nvSpPr>
        <p:spPr>
          <a:xfrm>
            <a:off x="852928" y="3153062"/>
            <a:ext cx="6769634" cy="954107"/>
          </a:xfrm>
          <a:prstGeom prst="rect">
            <a:avLst/>
          </a:prstGeom>
          <a:noFill/>
        </p:spPr>
        <p:txBody>
          <a:bodyPr wrap="square" rtlCol="0">
            <a:spAutoFit/>
          </a:bodyPr>
          <a:lstStyle/>
          <a:p>
            <a:pPr marL="342900" indent="-342900">
              <a:buAutoNum type="arabicPeriod"/>
            </a:pPr>
            <a:r>
              <a:rPr lang="en-US">
                <a:solidFill>
                  <a:schemeClr val="bg1"/>
                </a:solidFill>
              </a:rPr>
              <a:t>pH: low (acidosis)</a:t>
            </a:r>
          </a:p>
          <a:p>
            <a:pPr marL="342900" indent="-342900">
              <a:buAutoNum type="arabicPeriod"/>
            </a:pPr>
            <a:r>
              <a:rPr lang="en-US">
                <a:solidFill>
                  <a:schemeClr val="bg1"/>
                </a:solidFill>
              </a:rPr>
              <a:t>pCO2: normal</a:t>
            </a:r>
          </a:p>
          <a:p>
            <a:pPr marL="342900" indent="-342900">
              <a:buAutoNum type="arabicPeriod"/>
            </a:pPr>
            <a:r>
              <a:rPr lang="en-US">
                <a:solidFill>
                  <a:schemeClr val="bg1"/>
                </a:solidFill>
              </a:rPr>
              <a:t>HCO3 : low (base deficit) + low pH = metabolic acidosis</a:t>
            </a:r>
          </a:p>
          <a:p>
            <a:pPr marL="342900" indent="-342900">
              <a:buAutoNum type="arabicPeriod"/>
            </a:pPr>
            <a:r>
              <a:rPr lang="en-US">
                <a:solidFill>
                  <a:schemeClr val="bg1"/>
                </a:solidFill>
              </a:rPr>
              <a:t>Is there an anion gap? – yes (40)</a:t>
            </a:r>
          </a:p>
        </p:txBody>
      </p:sp>
    </p:spTree>
    <p:extLst>
      <p:ext uri="{BB962C8B-B14F-4D97-AF65-F5344CB8AC3E}">
        <p14:creationId xmlns:p14="http://schemas.microsoft.com/office/powerpoint/2010/main" val="3909737988"/>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28FA62-8A59-4A45-BA75-AFC09365BF9D}"/>
              </a:ext>
            </a:extLst>
          </p:cNvPr>
          <p:cNvSpPr>
            <a:spLocks noGrp="1"/>
          </p:cNvSpPr>
          <p:nvPr>
            <p:ph type="title"/>
          </p:nvPr>
        </p:nvSpPr>
        <p:spPr/>
        <p:txBody>
          <a:bodyPr/>
          <a:lstStyle/>
          <a:p>
            <a:r>
              <a:rPr lang="en-US"/>
              <a:t>Is this patient adequately compensating?</a:t>
            </a:r>
            <a:br>
              <a:rPr lang="en-US"/>
            </a:br>
            <a:endParaRPr lang="en-US"/>
          </a:p>
        </p:txBody>
      </p:sp>
      <p:sp>
        <p:nvSpPr>
          <p:cNvPr id="3" name="Subtitle 2">
            <a:extLst>
              <a:ext uri="{FF2B5EF4-FFF2-40B4-BE49-F238E27FC236}">
                <a16:creationId xmlns:a16="http://schemas.microsoft.com/office/drawing/2014/main" id="{E7589A73-6422-4B71-AB62-AB05B000F643}"/>
              </a:ext>
            </a:extLst>
          </p:cNvPr>
          <p:cNvSpPr>
            <a:spLocks noGrp="1"/>
          </p:cNvSpPr>
          <p:nvPr>
            <p:ph type="subTitle" idx="1"/>
          </p:nvPr>
        </p:nvSpPr>
        <p:spPr/>
        <p:txBody>
          <a:bodyPr/>
          <a:lstStyle/>
          <a:p>
            <a:endParaRPr lang="en-US"/>
          </a:p>
        </p:txBody>
      </p:sp>
    </p:spTree>
    <p:extLst>
      <p:ext uri="{BB962C8B-B14F-4D97-AF65-F5344CB8AC3E}">
        <p14:creationId xmlns:p14="http://schemas.microsoft.com/office/powerpoint/2010/main" val="3749927469"/>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BB49B5-DB52-4600-9976-2938F171F141}"/>
              </a:ext>
            </a:extLst>
          </p:cNvPr>
          <p:cNvSpPr>
            <a:spLocks noGrp="1"/>
          </p:cNvSpPr>
          <p:nvPr>
            <p:ph type="title"/>
          </p:nvPr>
        </p:nvSpPr>
        <p:spPr/>
        <p:txBody>
          <a:bodyPr/>
          <a:lstStyle/>
          <a:p>
            <a:r>
              <a:rPr lang="en-US" sz="3200"/>
              <a:t>Expected CO2 = (Bicarb x 1.5) + 8 +/- 2</a:t>
            </a:r>
            <a:br>
              <a:rPr lang="en-US" sz="3200"/>
            </a:br>
            <a:r>
              <a:rPr lang="en-US" sz="3200"/>
              <a:t>=(12x1.5)+8 +/-2</a:t>
            </a:r>
            <a:br>
              <a:rPr lang="en-US" sz="3200"/>
            </a:br>
            <a:r>
              <a:rPr lang="en-US" sz="3200"/>
              <a:t>= 24-28</a:t>
            </a:r>
          </a:p>
        </p:txBody>
      </p:sp>
      <p:sp>
        <p:nvSpPr>
          <p:cNvPr id="3" name="Subtitle 2">
            <a:extLst>
              <a:ext uri="{FF2B5EF4-FFF2-40B4-BE49-F238E27FC236}">
                <a16:creationId xmlns:a16="http://schemas.microsoft.com/office/drawing/2014/main" id="{E243C276-92AA-4DD2-9B26-28E6F8C870B0}"/>
              </a:ext>
            </a:extLst>
          </p:cNvPr>
          <p:cNvSpPr>
            <a:spLocks noGrp="1"/>
          </p:cNvSpPr>
          <p:nvPr>
            <p:ph type="subTitle" idx="1"/>
          </p:nvPr>
        </p:nvSpPr>
        <p:spPr/>
        <p:txBody>
          <a:bodyPr/>
          <a:lstStyle/>
          <a:p>
            <a:r>
              <a:rPr lang="en-US"/>
              <a:t>Winter’s formula</a:t>
            </a:r>
          </a:p>
        </p:txBody>
      </p:sp>
    </p:spTree>
    <p:extLst>
      <p:ext uri="{BB962C8B-B14F-4D97-AF65-F5344CB8AC3E}">
        <p14:creationId xmlns:p14="http://schemas.microsoft.com/office/powerpoint/2010/main" val="1125905568"/>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324"/>
        <p:cNvGrpSpPr/>
        <p:nvPr/>
      </p:nvGrpSpPr>
      <p:grpSpPr>
        <a:xfrm>
          <a:off x="0" y="0"/>
          <a:ext cx="0" cy="0"/>
          <a:chOff x="0" y="0"/>
          <a:chExt cx="0" cy="0"/>
        </a:xfrm>
      </p:grpSpPr>
      <p:sp>
        <p:nvSpPr>
          <p:cNvPr id="325" name="Google Shape;325;p26"/>
          <p:cNvSpPr txBox="1">
            <a:spLocks noGrp="1"/>
          </p:cNvSpPr>
          <p:nvPr>
            <p:ph type="title"/>
          </p:nvPr>
        </p:nvSpPr>
        <p:spPr>
          <a:xfrm>
            <a:off x="1032075" y="966325"/>
            <a:ext cx="7081800" cy="3188100"/>
          </a:xfrm>
          <a:prstGeom prst="rect">
            <a:avLst/>
          </a:prstGeom>
        </p:spPr>
        <p:txBody>
          <a:bodyPr spcFirstLastPara="1" wrap="square" lIns="0" tIns="0" rIns="0" bIns="0" anchor="ctr" anchorCtr="0">
            <a:noAutofit/>
          </a:bodyPr>
          <a:lstStyle/>
          <a:p>
            <a:pPr marL="0" lvl="0" indent="0" algn="ctr" rtl="0">
              <a:spcBef>
                <a:spcPts val="0"/>
              </a:spcBef>
              <a:spcAft>
                <a:spcPts val="0"/>
              </a:spcAft>
              <a:buNone/>
            </a:pPr>
            <a:r>
              <a:rPr lang="en" dirty="0"/>
              <a:t>This is the ABG of a 12-year-old boy with poorly-controlled asthma presenting with an asthma exacerbation in the setting of viral illness</a:t>
            </a:r>
            <a:endParaRPr dirty="0"/>
          </a:p>
        </p:txBody>
      </p:sp>
      <p:sp>
        <p:nvSpPr>
          <p:cNvPr id="326" name="Google Shape;326;p26"/>
          <p:cNvSpPr txBox="1">
            <a:spLocks noGrp="1"/>
          </p:cNvSpPr>
          <p:nvPr>
            <p:ph type="subTitle" idx="1"/>
          </p:nvPr>
        </p:nvSpPr>
        <p:spPr>
          <a:xfrm>
            <a:off x="1038650" y="640325"/>
            <a:ext cx="7079700" cy="444300"/>
          </a:xfrm>
          <a:prstGeom prst="rect">
            <a:avLst/>
          </a:prstGeom>
        </p:spPr>
        <p:txBody>
          <a:bodyPr spcFirstLastPara="1" wrap="square" lIns="0" tIns="0" rIns="0" bIns="0" anchor="t" anchorCtr="0">
            <a:noAutofit/>
          </a:bodyPr>
          <a:lstStyle/>
          <a:p>
            <a:pPr marL="0" lvl="0" indent="0" algn="ctr" rtl="0">
              <a:spcBef>
                <a:spcPts val="600"/>
              </a:spcBef>
              <a:spcAft>
                <a:spcPts val="0"/>
              </a:spcAft>
              <a:buNone/>
            </a:pPr>
            <a:r>
              <a:rPr lang="en"/>
              <a:t>CATEGORY 2 · </a:t>
            </a:r>
            <a:r>
              <a:rPr lang="en">
                <a:solidFill>
                  <a:srgbClr val="FFC319"/>
                </a:solidFill>
              </a:rPr>
              <a:t>$800</a:t>
            </a:r>
            <a:endParaRPr>
              <a:solidFill>
                <a:srgbClr val="FFC319"/>
              </a:solidFill>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235"/>
        <p:cNvGrpSpPr/>
        <p:nvPr/>
      </p:nvGrpSpPr>
      <p:grpSpPr>
        <a:xfrm>
          <a:off x="0" y="0"/>
          <a:ext cx="0" cy="0"/>
          <a:chOff x="0" y="0"/>
          <a:chExt cx="0" cy="0"/>
        </a:xfrm>
      </p:grpSpPr>
      <p:sp>
        <p:nvSpPr>
          <p:cNvPr id="237" name="Google Shape;237;p17"/>
          <p:cNvSpPr txBox="1"/>
          <p:nvPr/>
        </p:nvSpPr>
        <p:spPr>
          <a:xfrm>
            <a:off x="572725" y="572675"/>
            <a:ext cx="1265700" cy="584100"/>
          </a:xfrm>
          <a:prstGeom prst="rect">
            <a:avLst/>
          </a:prstGeom>
          <a:noFill/>
          <a:ln>
            <a:noFill/>
          </a:ln>
          <a:effectLst>
            <a:outerShdw dist="28575" dir="2700000" algn="bl" rotWithShape="0">
              <a:schemeClr val="dk1">
                <a:alpha val="76000"/>
              </a:schemeClr>
            </a:outerShdw>
          </a:effectLst>
        </p:spPr>
        <p:txBody>
          <a:bodyPr spcFirstLastPara="1" wrap="square" lIns="0" tIns="0" rIns="0" bIns="0" anchor="ctr" anchorCtr="0">
            <a:noAutofit/>
          </a:bodyPr>
          <a:lstStyle/>
          <a:p>
            <a:pPr marL="0" lvl="0" indent="0" algn="ctr" rtl="0">
              <a:spcBef>
                <a:spcPts val="0"/>
              </a:spcBef>
              <a:spcAft>
                <a:spcPts val="0"/>
              </a:spcAft>
              <a:buNone/>
            </a:pPr>
            <a:r>
              <a:rPr lang="en-US">
                <a:solidFill>
                  <a:schemeClr val="lt1"/>
                </a:solidFill>
                <a:latin typeface="Bebas Neue"/>
                <a:ea typeface="Bebas Neue"/>
                <a:cs typeface="Bebas Neue"/>
                <a:sym typeface="Bebas Neue"/>
              </a:rPr>
              <a:t>To CBC or not to CBC</a:t>
            </a:r>
            <a:endParaRPr>
              <a:solidFill>
                <a:schemeClr val="lt1"/>
              </a:solidFill>
              <a:latin typeface="Bebas Neue"/>
              <a:ea typeface="Bebas Neue"/>
              <a:cs typeface="Bebas Neue"/>
              <a:sym typeface="Bebas Neue"/>
            </a:endParaRPr>
          </a:p>
        </p:txBody>
      </p:sp>
      <p:sp>
        <p:nvSpPr>
          <p:cNvPr id="238" name="Google Shape;238;p17"/>
          <p:cNvSpPr txBox="1"/>
          <p:nvPr/>
        </p:nvSpPr>
        <p:spPr>
          <a:xfrm>
            <a:off x="1917800" y="572675"/>
            <a:ext cx="1265700" cy="584100"/>
          </a:xfrm>
          <a:prstGeom prst="rect">
            <a:avLst/>
          </a:prstGeom>
          <a:noFill/>
          <a:ln>
            <a:noFill/>
          </a:ln>
          <a:effectLst>
            <a:outerShdw dist="28575" dir="2700000" algn="bl" rotWithShape="0">
              <a:schemeClr val="dk1">
                <a:alpha val="76000"/>
              </a:schemeClr>
            </a:outerShdw>
          </a:effectLst>
        </p:spPr>
        <p:txBody>
          <a:bodyPr spcFirstLastPara="1" wrap="square" lIns="0" tIns="0" rIns="0" bIns="0" anchor="ctr" anchorCtr="0">
            <a:noAutofit/>
          </a:bodyPr>
          <a:lstStyle/>
          <a:p>
            <a:pPr marL="0" lvl="0" indent="0" algn="ctr" rtl="0">
              <a:spcBef>
                <a:spcPts val="0"/>
              </a:spcBef>
              <a:spcAft>
                <a:spcPts val="0"/>
              </a:spcAft>
              <a:buNone/>
            </a:pPr>
            <a:r>
              <a:rPr lang="en-US">
                <a:solidFill>
                  <a:schemeClr val="lt1"/>
                </a:solidFill>
                <a:latin typeface="Bebas Neue"/>
                <a:ea typeface="Bebas Neue"/>
                <a:cs typeface="Bebas Neue"/>
                <a:sym typeface="Bebas Neue"/>
              </a:rPr>
              <a:t>The ABCs of ABGs</a:t>
            </a:r>
            <a:endParaRPr>
              <a:solidFill>
                <a:schemeClr val="lt1"/>
              </a:solidFill>
              <a:latin typeface="Bebas Neue"/>
              <a:ea typeface="Bebas Neue"/>
              <a:cs typeface="Bebas Neue"/>
              <a:sym typeface="Bebas Neue"/>
            </a:endParaRPr>
          </a:p>
        </p:txBody>
      </p:sp>
      <p:sp>
        <p:nvSpPr>
          <p:cNvPr id="239" name="Google Shape;239;p17"/>
          <p:cNvSpPr txBox="1"/>
          <p:nvPr/>
        </p:nvSpPr>
        <p:spPr>
          <a:xfrm>
            <a:off x="3262888" y="572675"/>
            <a:ext cx="1265700" cy="584100"/>
          </a:xfrm>
          <a:prstGeom prst="rect">
            <a:avLst/>
          </a:prstGeom>
          <a:noFill/>
          <a:ln>
            <a:noFill/>
          </a:ln>
          <a:effectLst>
            <a:outerShdw dist="28575" dir="2700000" algn="bl" rotWithShape="0">
              <a:schemeClr val="dk1">
                <a:alpha val="76000"/>
              </a:schemeClr>
            </a:outerShdw>
          </a:effectLst>
        </p:spPr>
        <p:txBody>
          <a:bodyPr spcFirstLastPara="1" wrap="square" lIns="0" tIns="0" rIns="0" bIns="0" anchor="ctr" anchorCtr="0">
            <a:noAutofit/>
          </a:bodyPr>
          <a:lstStyle/>
          <a:p>
            <a:pPr marL="0" lvl="0" indent="0" algn="ctr" rtl="0">
              <a:spcBef>
                <a:spcPts val="0"/>
              </a:spcBef>
              <a:spcAft>
                <a:spcPts val="0"/>
              </a:spcAft>
              <a:buNone/>
            </a:pPr>
            <a:r>
              <a:rPr lang="en">
                <a:solidFill>
                  <a:schemeClr val="lt1"/>
                </a:solidFill>
                <a:latin typeface="Bebas Neue"/>
                <a:ea typeface="Bebas Neue"/>
                <a:cs typeface="Bebas Neue"/>
                <a:sym typeface="Bebas Neue"/>
              </a:rPr>
              <a:t>“It’s Not the Heart”</a:t>
            </a:r>
            <a:endParaRPr>
              <a:solidFill>
                <a:schemeClr val="lt1"/>
              </a:solidFill>
              <a:latin typeface="Bebas Neue"/>
              <a:ea typeface="Bebas Neue"/>
              <a:cs typeface="Bebas Neue"/>
              <a:sym typeface="Bebas Neue"/>
            </a:endParaRPr>
          </a:p>
        </p:txBody>
      </p:sp>
      <p:sp>
        <p:nvSpPr>
          <p:cNvPr id="240" name="Google Shape;240;p17"/>
          <p:cNvSpPr txBox="1"/>
          <p:nvPr/>
        </p:nvSpPr>
        <p:spPr>
          <a:xfrm>
            <a:off x="4607963" y="572675"/>
            <a:ext cx="1265700" cy="584100"/>
          </a:xfrm>
          <a:prstGeom prst="rect">
            <a:avLst/>
          </a:prstGeom>
          <a:noFill/>
          <a:ln>
            <a:noFill/>
          </a:ln>
          <a:effectLst>
            <a:outerShdw dist="28575" dir="2700000" algn="bl" rotWithShape="0">
              <a:schemeClr val="dk1">
                <a:alpha val="76000"/>
              </a:schemeClr>
            </a:outerShdw>
          </a:effectLst>
        </p:spPr>
        <p:txBody>
          <a:bodyPr spcFirstLastPara="1" wrap="square" lIns="0" tIns="0" rIns="0" bIns="0" anchor="ctr" anchorCtr="0">
            <a:noAutofit/>
          </a:bodyPr>
          <a:lstStyle/>
          <a:p>
            <a:pPr marL="0" lvl="0" indent="0" algn="ctr" rtl="0">
              <a:spcBef>
                <a:spcPts val="0"/>
              </a:spcBef>
              <a:spcAft>
                <a:spcPts val="0"/>
              </a:spcAft>
              <a:buNone/>
            </a:pPr>
            <a:r>
              <a:rPr lang="en">
                <a:solidFill>
                  <a:schemeClr val="lt1"/>
                </a:solidFill>
                <a:latin typeface="Bebas Neue"/>
                <a:ea typeface="Bebas Neue"/>
                <a:cs typeface="Bebas Neue"/>
                <a:sym typeface="Bebas Neue"/>
              </a:rPr>
              <a:t>Tachycardia Conundrum</a:t>
            </a:r>
          </a:p>
        </p:txBody>
      </p:sp>
      <p:sp>
        <p:nvSpPr>
          <p:cNvPr id="243" name="Google Shape;243;p17">
            <a:hlinkClick r:id="rId3" action="ppaction://hlinksldjump"/>
          </p:cNvPr>
          <p:cNvSpPr txBox="1"/>
          <p:nvPr/>
        </p:nvSpPr>
        <p:spPr>
          <a:xfrm>
            <a:off x="576450" y="1317345"/>
            <a:ext cx="1265700" cy="584100"/>
          </a:xfrm>
          <a:prstGeom prst="rect">
            <a:avLst/>
          </a:prstGeom>
          <a:noFill/>
          <a:ln>
            <a:noFill/>
          </a:ln>
          <a:effectLst>
            <a:outerShdw dist="38100" dir="2700000" algn="bl" rotWithShape="0">
              <a:schemeClr val="dk1">
                <a:alpha val="90000"/>
              </a:schemeClr>
            </a:outerShdw>
          </a:effectLst>
        </p:spPr>
        <p:txBody>
          <a:bodyPr spcFirstLastPara="1" wrap="square" lIns="0" tIns="0" rIns="0" bIns="0" anchor="ctr" anchorCtr="0">
            <a:noAutofit/>
          </a:bodyPr>
          <a:lstStyle/>
          <a:p>
            <a:pPr marL="0" lvl="0" indent="0" algn="ctr" rtl="0">
              <a:spcBef>
                <a:spcPts val="0"/>
              </a:spcBef>
              <a:spcAft>
                <a:spcPts val="0"/>
              </a:spcAft>
              <a:buNone/>
            </a:pPr>
            <a:r>
              <a:rPr lang="en" sz="2900">
                <a:solidFill>
                  <a:srgbClr val="FFC319"/>
                </a:solidFill>
                <a:latin typeface="Bebas Neue"/>
                <a:ea typeface="Bebas Neue"/>
                <a:cs typeface="Bebas Neue"/>
                <a:sym typeface="Bebas Neue"/>
              </a:rPr>
              <a:t>$200</a:t>
            </a:r>
            <a:endParaRPr sz="2900">
              <a:solidFill>
                <a:srgbClr val="FFC319"/>
              </a:solidFill>
              <a:latin typeface="Bebas Neue"/>
              <a:ea typeface="Bebas Neue"/>
              <a:cs typeface="Bebas Neue"/>
              <a:sym typeface="Bebas Neue"/>
            </a:endParaRPr>
          </a:p>
        </p:txBody>
      </p:sp>
      <p:sp>
        <p:nvSpPr>
          <p:cNvPr id="244" name="Google Shape;244;p17">
            <a:hlinkClick r:id="rId4" action="ppaction://hlinksldjump"/>
          </p:cNvPr>
          <p:cNvSpPr txBox="1"/>
          <p:nvPr/>
        </p:nvSpPr>
        <p:spPr>
          <a:xfrm>
            <a:off x="576450" y="1989197"/>
            <a:ext cx="1265700" cy="584100"/>
          </a:xfrm>
          <a:prstGeom prst="rect">
            <a:avLst/>
          </a:prstGeom>
          <a:noFill/>
          <a:ln>
            <a:noFill/>
          </a:ln>
          <a:effectLst>
            <a:outerShdw dist="38100" dir="2700000" algn="bl" rotWithShape="0">
              <a:schemeClr val="dk1">
                <a:alpha val="90000"/>
              </a:schemeClr>
            </a:outerShdw>
          </a:effectLst>
        </p:spPr>
        <p:txBody>
          <a:bodyPr spcFirstLastPara="1" wrap="square" lIns="0" tIns="0" rIns="0" bIns="0" anchor="ctr" anchorCtr="0">
            <a:noAutofit/>
          </a:bodyPr>
          <a:lstStyle/>
          <a:p>
            <a:pPr marL="0" lvl="0" indent="0" algn="ctr" rtl="0">
              <a:spcBef>
                <a:spcPts val="0"/>
              </a:spcBef>
              <a:spcAft>
                <a:spcPts val="0"/>
              </a:spcAft>
              <a:buNone/>
            </a:pPr>
            <a:r>
              <a:rPr lang="en" sz="2900">
                <a:solidFill>
                  <a:srgbClr val="FFC319"/>
                </a:solidFill>
                <a:latin typeface="Bebas Neue"/>
                <a:ea typeface="Bebas Neue"/>
                <a:cs typeface="Bebas Neue"/>
                <a:sym typeface="Bebas Neue"/>
              </a:rPr>
              <a:t>$400</a:t>
            </a:r>
            <a:endParaRPr sz="2900">
              <a:solidFill>
                <a:srgbClr val="FFC319"/>
              </a:solidFill>
              <a:latin typeface="Bebas Neue"/>
              <a:ea typeface="Bebas Neue"/>
              <a:cs typeface="Bebas Neue"/>
              <a:sym typeface="Bebas Neue"/>
            </a:endParaRPr>
          </a:p>
        </p:txBody>
      </p:sp>
      <p:sp>
        <p:nvSpPr>
          <p:cNvPr id="245" name="Google Shape;245;p17">
            <a:hlinkClick r:id="rId5" action="ppaction://hlinksldjump"/>
          </p:cNvPr>
          <p:cNvSpPr txBox="1"/>
          <p:nvPr/>
        </p:nvSpPr>
        <p:spPr>
          <a:xfrm>
            <a:off x="576450" y="2661049"/>
            <a:ext cx="1265700" cy="584100"/>
          </a:xfrm>
          <a:prstGeom prst="rect">
            <a:avLst/>
          </a:prstGeom>
          <a:noFill/>
          <a:ln>
            <a:noFill/>
          </a:ln>
          <a:effectLst>
            <a:outerShdw dist="38100" dir="2700000" algn="bl" rotWithShape="0">
              <a:schemeClr val="dk1">
                <a:alpha val="90000"/>
              </a:schemeClr>
            </a:outerShdw>
          </a:effectLst>
        </p:spPr>
        <p:txBody>
          <a:bodyPr spcFirstLastPara="1" wrap="square" lIns="0" tIns="0" rIns="0" bIns="0" anchor="ctr" anchorCtr="0">
            <a:noAutofit/>
          </a:bodyPr>
          <a:lstStyle/>
          <a:p>
            <a:pPr marL="0" lvl="0" indent="0" algn="ctr" rtl="0">
              <a:spcBef>
                <a:spcPts val="0"/>
              </a:spcBef>
              <a:spcAft>
                <a:spcPts val="0"/>
              </a:spcAft>
              <a:buNone/>
            </a:pPr>
            <a:r>
              <a:rPr lang="en" sz="2900">
                <a:solidFill>
                  <a:srgbClr val="FFC319"/>
                </a:solidFill>
                <a:latin typeface="Bebas Neue"/>
                <a:ea typeface="Bebas Neue"/>
                <a:cs typeface="Bebas Neue"/>
                <a:sym typeface="Bebas Neue"/>
              </a:rPr>
              <a:t>$600</a:t>
            </a:r>
            <a:endParaRPr sz="2900">
              <a:solidFill>
                <a:srgbClr val="FFC319"/>
              </a:solidFill>
              <a:latin typeface="Bebas Neue"/>
              <a:ea typeface="Bebas Neue"/>
              <a:cs typeface="Bebas Neue"/>
              <a:sym typeface="Bebas Neue"/>
            </a:endParaRPr>
          </a:p>
        </p:txBody>
      </p:sp>
      <p:sp>
        <p:nvSpPr>
          <p:cNvPr id="246" name="Google Shape;246;p17">
            <a:hlinkClick r:id="rId6" action="ppaction://hlinksldjump"/>
          </p:cNvPr>
          <p:cNvSpPr txBox="1"/>
          <p:nvPr/>
        </p:nvSpPr>
        <p:spPr>
          <a:xfrm>
            <a:off x="576450" y="3332902"/>
            <a:ext cx="1265700" cy="584100"/>
          </a:xfrm>
          <a:prstGeom prst="rect">
            <a:avLst/>
          </a:prstGeom>
          <a:noFill/>
          <a:ln>
            <a:noFill/>
          </a:ln>
          <a:effectLst>
            <a:outerShdw dist="38100" dir="2700000" algn="bl" rotWithShape="0">
              <a:schemeClr val="dk1">
                <a:alpha val="90000"/>
              </a:schemeClr>
            </a:outerShdw>
          </a:effectLst>
        </p:spPr>
        <p:txBody>
          <a:bodyPr spcFirstLastPara="1" wrap="square" lIns="0" tIns="0" rIns="0" bIns="0" anchor="ctr" anchorCtr="0">
            <a:noAutofit/>
          </a:bodyPr>
          <a:lstStyle/>
          <a:p>
            <a:pPr marL="0" lvl="0" indent="0" algn="ctr" rtl="0">
              <a:spcBef>
                <a:spcPts val="0"/>
              </a:spcBef>
              <a:spcAft>
                <a:spcPts val="0"/>
              </a:spcAft>
              <a:buNone/>
            </a:pPr>
            <a:r>
              <a:rPr lang="en" sz="2900">
                <a:solidFill>
                  <a:srgbClr val="FFC319"/>
                </a:solidFill>
                <a:latin typeface="Bebas Neue"/>
                <a:ea typeface="Bebas Neue"/>
                <a:cs typeface="Bebas Neue"/>
                <a:sym typeface="Bebas Neue"/>
              </a:rPr>
              <a:t>$800</a:t>
            </a:r>
            <a:endParaRPr sz="2900">
              <a:solidFill>
                <a:srgbClr val="FFC319"/>
              </a:solidFill>
              <a:latin typeface="Bebas Neue"/>
              <a:ea typeface="Bebas Neue"/>
              <a:cs typeface="Bebas Neue"/>
              <a:sym typeface="Bebas Neue"/>
            </a:endParaRPr>
          </a:p>
        </p:txBody>
      </p:sp>
      <p:sp>
        <p:nvSpPr>
          <p:cNvPr id="247" name="Google Shape;247;p17">
            <a:hlinkClick r:id="rId7" action="ppaction://hlinksldjump"/>
          </p:cNvPr>
          <p:cNvSpPr txBox="1"/>
          <p:nvPr/>
        </p:nvSpPr>
        <p:spPr>
          <a:xfrm>
            <a:off x="576450" y="4004754"/>
            <a:ext cx="1265700" cy="584100"/>
          </a:xfrm>
          <a:prstGeom prst="rect">
            <a:avLst/>
          </a:prstGeom>
          <a:noFill/>
          <a:ln>
            <a:noFill/>
          </a:ln>
          <a:effectLst>
            <a:outerShdw dist="38100" dir="2700000" algn="bl" rotWithShape="0">
              <a:schemeClr val="dk1">
                <a:alpha val="90000"/>
              </a:schemeClr>
            </a:outerShdw>
          </a:effectLst>
        </p:spPr>
        <p:txBody>
          <a:bodyPr spcFirstLastPara="1" wrap="square" lIns="0" tIns="0" rIns="0" bIns="0" anchor="ctr" anchorCtr="0">
            <a:noAutofit/>
          </a:bodyPr>
          <a:lstStyle/>
          <a:p>
            <a:pPr marL="0" lvl="0" indent="0" algn="ctr" rtl="0">
              <a:spcBef>
                <a:spcPts val="0"/>
              </a:spcBef>
              <a:spcAft>
                <a:spcPts val="0"/>
              </a:spcAft>
              <a:buNone/>
            </a:pPr>
            <a:r>
              <a:rPr lang="en" sz="2900">
                <a:solidFill>
                  <a:srgbClr val="FFC319"/>
                </a:solidFill>
                <a:latin typeface="Bebas Neue"/>
                <a:ea typeface="Bebas Neue"/>
                <a:cs typeface="Bebas Neue"/>
                <a:sym typeface="Bebas Neue"/>
              </a:rPr>
              <a:t>$1000</a:t>
            </a:r>
            <a:endParaRPr sz="2900">
              <a:solidFill>
                <a:srgbClr val="FFC319"/>
              </a:solidFill>
              <a:latin typeface="Bebas Neue"/>
              <a:ea typeface="Bebas Neue"/>
              <a:cs typeface="Bebas Neue"/>
              <a:sym typeface="Bebas Neue"/>
            </a:endParaRPr>
          </a:p>
        </p:txBody>
      </p:sp>
      <p:sp>
        <p:nvSpPr>
          <p:cNvPr id="248" name="Google Shape;248;p17">
            <a:hlinkClick r:id="rId8" action="ppaction://hlinksldjump"/>
          </p:cNvPr>
          <p:cNvSpPr txBox="1"/>
          <p:nvPr/>
        </p:nvSpPr>
        <p:spPr>
          <a:xfrm>
            <a:off x="1919663" y="1317345"/>
            <a:ext cx="1265700" cy="584100"/>
          </a:xfrm>
          <a:prstGeom prst="rect">
            <a:avLst/>
          </a:prstGeom>
          <a:noFill/>
          <a:ln>
            <a:noFill/>
          </a:ln>
          <a:effectLst>
            <a:outerShdw dist="38100" dir="2700000" algn="bl" rotWithShape="0">
              <a:schemeClr val="dk1">
                <a:alpha val="90000"/>
              </a:schemeClr>
            </a:outerShdw>
          </a:effectLst>
        </p:spPr>
        <p:txBody>
          <a:bodyPr spcFirstLastPara="1" wrap="square" lIns="0" tIns="0" rIns="0" bIns="0" anchor="ctr" anchorCtr="0">
            <a:noAutofit/>
          </a:bodyPr>
          <a:lstStyle/>
          <a:p>
            <a:pPr marL="0" lvl="0" indent="0" algn="ctr" rtl="0">
              <a:spcBef>
                <a:spcPts val="0"/>
              </a:spcBef>
              <a:spcAft>
                <a:spcPts val="0"/>
              </a:spcAft>
              <a:buNone/>
            </a:pPr>
            <a:r>
              <a:rPr lang="en" sz="2900">
                <a:solidFill>
                  <a:srgbClr val="FFC319"/>
                </a:solidFill>
                <a:latin typeface="Bebas Neue"/>
                <a:ea typeface="Bebas Neue"/>
                <a:cs typeface="Bebas Neue"/>
                <a:sym typeface="Bebas Neue"/>
              </a:rPr>
              <a:t>$200</a:t>
            </a:r>
            <a:endParaRPr sz="2900">
              <a:solidFill>
                <a:srgbClr val="FFC319"/>
              </a:solidFill>
              <a:latin typeface="Bebas Neue"/>
              <a:ea typeface="Bebas Neue"/>
              <a:cs typeface="Bebas Neue"/>
              <a:sym typeface="Bebas Neue"/>
            </a:endParaRPr>
          </a:p>
        </p:txBody>
      </p:sp>
      <p:sp>
        <p:nvSpPr>
          <p:cNvPr id="249" name="Google Shape;249;p17">
            <a:hlinkClick r:id="rId9" action="ppaction://hlinksldjump"/>
          </p:cNvPr>
          <p:cNvSpPr txBox="1"/>
          <p:nvPr/>
        </p:nvSpPr>
        <p:spPr>
          <a:xfrm>
            <a:off x="1919663" y="1989197"/>
            <a:ext cx="1265700" cy="584100"/>
          </a:xfrm>
          <a:prstGeom prst="rect">
            <a:avLst/>
          </a:prstGeom>
          <a:noFill/>
          <a:ln>
            <a:noFill/>
          </a:ln>
          <a:effectLst>
            <a:outerShdw dist="38100" dir="2700000" algn="bl" rotWithShape="0">
              <a:schemeClr val="dk1">
                <a:alpha val="90000"/>
              </a:schemeClr>
            </a:outerShdw>
          </a:effectLst>
        </p:spPr>
        <p:txBody>
          <a:bodyPr spcFirstLastPara="1" wrap="square" lIns="0" tIns="0" rIns="0" bIns="0" anchor="ctr" anchorCtr="0">
            <a:noAutofit/>
          </a:bodyPr>
          <a:lstStyle/>
          <a:p>
            <a:pPr marL="0" lvl="0" indent="0" algn="ctr" rtl="0">
              <a:spcBef>
                <a:spcPts val="0"/>
              </a:spcBef>
              <a:spcAft>
                <a:spcPts val="0"/>
              </a:spcAft>
              <a:buNone/>
            </a:pPr>
            <a:r>
              <a:rPr lang="en" sz="2900">
                <a:solidFill>
                  <a:srgbClr val="FFC319"/>
                </a:solidFill>
                <a:latin typeface="Bebas Neue"/>
                <a:ea typeface="Bebas Neue"/>
                <a:cs typeface="Bebas Neue"/>
                <a:sym typeface="Bebas Neue"/>
              </a:rPr>
              <a:t>$400</a:t>
            </a:r>
            <a:endParaRPr sz="2900">
              <a:solidFill>
                <a:srgbClr val="FFC319"/>
              </a:solidFill>
              <a:latin typeface="Bebas Neue"/>
              <a:ea typeface="Bebas Neue"/>
              <a:cs typeface="Bebas Neue"/>
              <a:sym typeface="Bebas Neue"/>
            </a:endParaRPr>
          </a:p>
        </p:txBody>
      </p:sp>
      <p:sp>
        <p:nvSpPr>
          <p:cNvPr id="250" name="Google Shape;250;p17">
            <a:hlinkClick r:id="rId10" action="ppaction://hlinksldjump"/>
          </p:cNvPr>
          <p:cNvSpPr txBox="1"/>
          <p:nvPr/>
        </p:nvSpPr>
        <p:spPr>
          <a:xfrm>
            <a:off x="1919663" y="2661049"/>
            <a:ext cx="1265700" cy="584100"/>
          </a:xfrm>
          <a:prstGeom prst="rect">
            <a:avLst/>
          </a:prstGeom>
          <a:noFill/>
          <a:ln>
            <a:noFill/>
          </a:ln>
          <a:effectLst>
            <a:outerShdw dist="38100" dir="2700000" algn="bl" rotWithShape="0">
              <a:schemeClr val="dk1">
                <a:alpha val="90000"/>
              </a:schemeClr>
            </a:outerShdw>
          </a:effectLst>
        </p:spPr>
        <p:txBody>
          <a:bodyPr spcFirstLastPara="1" wrap="square" lIns="0" tIns="0" rIns="0" bIns="0" anchor="ctr" anchorCtr="0">
            <a:noAutofit/>
          </a:bodyPr>
          <a:lstStyle/>
          <a:p>
            <a:pPr marL="0" lvl="0" indent="0" algn="ctr" rtl="0">
              <a:spcBef>
                <a:spcPts val="0"/>
              </a:spcBef>
              <a:spcAft>
                <a:spcPts val="0"/>
              </a:spcAft>
              <a:buNone/>
            </a:pPr>
            <a:r>
              <a:rPr lang="en" sz="2900">
                <a:solidFill>
                  <a:srgbClr val="FFC319"/>
                </a:solidFill>
                <a:latin typeface="Bebas Neue"/>
                <a:ea typeface="Bebas Neue"/>
                <a:cs typeface="Bebas Neue"/>
                <a:sym typeface="Bebas Neue"/>
              </a:rPr>
              <a:t>$600</a:t>
            </a:r>
            <a:endParaRPr sz="2900">
              <a:solidFill>
                <a:srgbClr val="FFC319"/>
              </a:solidFill>
              <a:latin typeface="Bebas Neue"/>
              <a:ea typeface="Bebas Neue"/>
              <a:cs typeface="Bebas Neue"/>
              <a:sym typeface="Bebas Neue"/>
            </a:endParaRPr>
          </a:p>
        </p:txBody>
      </p:sp>
      <p:sp>
        <p:nvSpPr>
          <p:cNvPr id="251" name="Google Shape;251;p17">
            <a:hlinkClick r:id="rId11" action="ppaction://hlinksldjump"/>
          </p:cNvPr>
          <p:cNvSpPr txBox="1"/>
          <p:nvPr/>
        </p:nvSpPr>
        <p:spPr>
          <a:xfrm>
            <a:off x="1919663" y="3332902"/>
            <a:ext cx="1265700" cy="584100"/>
          </a:xfrm>
          <a:prstGeom prst="rect">
            <a:avLst/>
          </a:prstGeom>
          <a:noFill/>
          <a:ln>
            <a:noFill/>
          </a:ln>
          <a:effectLst>
            <a:outerShdw dist="38100" dir="2700000" algn="bl" rotWithShape="0">
              <a:schemeClr val="dk1">
                <a:alpha val="90000"/>
              </a:schemeClr>
            </a:outerShdw>
          </a:effectLst>
        </p:spPr>
        <p:txBody>
          <a:bodyPr spcFirstLastPara="1" wrap="square" lIns="0" tIns="0" rIns="0" bIns="0" anchor="ctr" anchorCtr="0">
            <a:noAutofit/>
          </a:bodyPr>
          <a:lstStyle/>
          <a:p>
            <a:pPr marL="0" lvl="0" indent="0" algn="ctr" rtl="0">
              <a:spcBef>
                <a:spcPts val="0"/>
              </a:spcBef>
              <a:spcAft>
                <a:spcPts val="0"/>
              </a:spcAft>
              <a:buNone/>
            </a:pPr>
            <a:r>
              <a:rPr lang="en" sz="2900">
                <a:solidFill>
                  <a:srgbClr val="FFC319"/>
                </a:solidFill>
                <a:latin typeface="Bebas Neue"/>
                <a:ea typeface="Bebas Neue"/>
                <a:cs typeface="Bebas Neue"/>
                <a:sym typeface="Bebas Neue"/>
              </a:rPr>
              <a:t>$800</a:t>
            </a:r>
            <a:endParaRPr sz="2900">
              <a:solidFill>
                <a:srgbClr val="FFC319"/>
              </a:solidFill>
              <a:latin typeface="Bebas Neue"/>
              <a:ea typeface="Bebas Neue"/>
              <a:cs typeface="Bebas Neue"/>
              <a:sym typeface="Bebas Neue"/>
            </a:endParaRPr>
          </a:p>
        </p:txBody>
      </p:sp>
      <p:sp>
        <p:nvSpPr>
          <p:cNvPr id="252" name="Google Shape;252;p17">
            <a:hlinkClick r:id="rId12" action="ppaction://hlinksldjump"/>
          </p:cNvPr>
          <p:cNvSpPr txBox="1"/>
          <p:nvPr/>
        </p:nvSpPr>
        <p:spPr>
          <a:xfrm>
            <a:off x="1919663" y="4004754"/>
            <a:ext cx="1265700" cy="584100"/>
          </a:xfrm>
          <a:prstGeom prst="rect">
            <a:avLst/>
          </a:prstGeom>
          <a:noFill/>
          <a:ln>
            <a:noFill/>
          </a:ln>
          <a:effectLst>
            <a:outerShdw dist="38100" dir="2700000" algn="bl" rotWithShape="0">
              <a:schemeClr val="dk1">
                <a:alpha val="90000"/>
              </a:schemeClr>
            </a:outerShdw>
          </a:effectLst>
        </p:spPr>
        <p:txBody>
          <a:bodyPr spcFirstLastPara="1" wrap="square" lIns="0" tIns="0" rIns="0" bIns="0" anchor="ctr" anchorCtr="0">
            <a:noAutofit/>
          </a:bodyPr>
          <a:lstStyle/>
          <a:p>
            <a:pPr marL="0" lvl="0" indent="0" algn="ctr" rtl="0">
              <a:spcBef>
                <a:spcPts val="0"/>
              </a:spcBef>
              <a:spcAft>
                <a:spcPts val="0"/>
              </a:spcAft>
              <a:buNone/>
            </a:pPr>
            <a:r>
              <a:rPr lang="en" sz="2900">
                <a:solidFill>
                  <a:srgbClr val="FFC319"/>
                </a:solidFill>
                <a:latin typeface="Bebas Neue"/>
                <a:ea typeface="Bebas Neue"/>
                <a:cs typeface="Bebas Neue"/>
                <a:sym typeface="Bebas Neue"/>
              </a:rPr>
              <a:t>$1000</a:t>
            </a:r>
            <a:endParaRPr sz="2900">
              <a:solidFill>
                <a:srgbClr val="FFC319"/>
              </a:solidFill>
              <a:latin typeface="Bebas Neue"/>
              <a:ea typeface="Bebas Neue"/>
              <a:cs typeface="Bebas Neue"/>
              <a:sym typeface="Bebas Neue"/>
            </a:endParaRPr>
          </a:p>
        </p:txBody>
      </p:sp>
      <p:sp>
        <p:nvSpPr>
          <p:cNvPr id="253" name="Google Shape;253;p17">
            <a:hlinkClick r:id="rId13" action="ppaction://hlinksldjump"/>
          </p:cNvPr>
          <p:cNvSpPr txBox="1"/>
          <p:nvPr/>
        </p:nvSpPr>
        <p:spPr>
          <a:xfrm>
            <a:off x="3262881" y="1317558"/>
            <a:ext cx="1265700" cy="584100"/>
          </a:xfrm>
          <a:prstGeom prst="rect">
            <a:avLst/>
          </a:prstGeom>
          <a:noFill/>
          <a:ln>
            <a:noFill/>
          </a:ln>
          <a:effectLst>
            <a:outerShdw dist="38100" dir="2700000" algn="bl" rotWithShape="0">
              <a:schemeClr val="dk1">
                <a:alpha val="90000"/>
              </a:schemeClr>
            </a:outerShdw>
          </a:effectLst>
        </p:spPr>
        <p:txBody>
          <a:bodyPr spcFirstLastPara="1" wrap="square" lIns="0" tIns="0" rIns="0" bIns="0" anchor="ctr" anchorCtr="0">
            <a:noAutofit/>
          </a:bodyPr>
          <a:lstStyle/>
          <a:p>
            <a:pPr marL="0" lvl="0" indent="0" algn="ctr" rtl="0">
              <a:spcBef>
                <a:spcPts val="0"/>
              </a:spcBef>
              <a:spcAft>
                <a:spcPts val="0"/>
              </a:spcAft>
              <a:buNone/>
            </a:pPr>
            <a:r>
              <a:rPr lang="en" sz="2900">
                <a:solidFill>
                  <a:srgbClr val="FFC319"/>
                </a:solidFill>
                <a:latin typeface="Bebas Neue"/>
                <a:ea typeface="Bebas Neue"/>
                <a:cs typeface="Bebas Neue"/>
                <a:sym typeface="Bebas Neue"/>
              </a:rPr>
              <a:t>$200</a:t>
            </a:r>
            <a:endParaRPr sz="2900">
              <a:solidFill>
                <a:srgbClr val="FFC319"/>
              </a:solidFill>
              <a:latin typeface="Bebas Neue"/>
              <a:ea typeface="Bebas Neue"/>
              <a:cs typeface="Bebas Neue"/>
              <a:sym typeface="Bebas Neue"/>
            </a:endParaRPr>
          </a:p>
        </p:txBody>
      </p:sp>
      <p:sp>
        <p:nvSpPr>
          <p:cNvPr id="254" name="Google Shape;254;p17">
            <a:hlinkClick r:id="rId14" action="ppaction://hlinksldjump"/>
          </p:cNvPr>
          <p:cNvSpPr txBox="1"/>
          <p:nvPr/>
        </p:nvSpPr>
        <p:spPr>
          <a:xfrm>
            <a:off x="3262881" y="1989410"/>
            <a:ext cx="1265700" cy="584100"/>
          </a:xfrm>
          <a:prstGeom prst="rect">
            <a:avLst/>
          </a:prstGeom>
          <a:noFill/>
          <a:ln>
            <a:noFill/>
          </a:ln>
          <a:effectLst>
            <a:outerShdw dist="38100" dir="2700000" algn="bl" rotWithShape="0">
              <a:schemeClr val="dk1">
                <a:alpha val="90000"/>
              </a:schemeClr>
            </a:outerShdw>
          </a:effectLst>
        </p:spPr>
        <p:txBody>
          <a:bodyPr spcFirstLastPara="1" wrap="square" lIns="0" tIns="0" rIns="0" bIns="0" anchor="ctr" anchorCtr="0">
            <a:noAutofit/>
          </a:bodyPr>
          <a:lstStyle/>
          <a:p>
            <a:pPr marL="0" lvl="0" indent="0" algn="ctr" rtl="0">
              <a:spcBef>
                <a:spcPts val="0"/>
              </a:spcBef>
              <a:spcAft>
                <a:spcPts val="0"/>
              </a:spcAft>
              <a:buNone/>
            </a:pPr>
            <a:r>
              <a:rPr lang="en" sz="2900">
                <a:solidFill>
                  <a:srgbClr val="FFC319"/>
                </a:solidFill>
                <a:latin typeface="Bebas Neue"/>
                <a:ea typeface="Bebas Neue"/>
                <a:cs typeface="Bebas Neue"/>
                <a:sym typeface="Bebas Neue"/>
              </a:rPr>
              <a:t>$400</a:t>
            </a:r>
            <a:endParaRPr sz="2900">
              <a:solidFill>
                <a:srgbClr val="FFC319"/>
              </a:solidFill>
              <a:latin typeface="Bebas Neue"/>
              <a:ea typeface="Bebas Neue"/>
              <a:cs typeface="Bebas Neue"/>
              <a:sym typeface="Bebas Neue"/>
            </a:endParaRPr>
          </a:p>
        </p:txBody>
      </p:sp>
      <p:sp>
        <p:nvSpPr>
          <p:cNvPr id="255" name="Google Shape;255;p17">
            <a:hlinkClick r:id="rId15" action="ppaction://hlinksldjump"/>
          </p:cNvPr>
          <p:cNvSpPr txBox="1"/>
          <p:nvPr/>
        </p:nvSpPr>
        <p:spPr>
          <a:xfrm>
            <a:off x="3262881" y="2661262"/>
            <a:ext cx="1265700" cy="584100"/>
          </a:xfrm>
          <a:prstGeom prst="rect">
            <a:avLst/>
          </a:prstGeom>
          <a:noFill/>
          <a:ln>
            <a:noFill/>
          </a:ln>
          <a:effectLst>
            <a:outerShdw dist="38100" dir="2700000" algn="bl" rotWithShape="0">
              <a:schemeClr val="dk1">
                <a:alpha val="90000"/>
              </a:schemeClr>
            </a:outerShdw>
          </a:effectLst>
        </p:spPr>
        <p:txBody>
          <a:bodyPr spcFirstLastPara="1" wrap="square" lIns="0" tIns="0" rIns="0" bIns="0" anchor="ctr" anchorCtr="0">
            <a:noAutofit/>
          </a:bodyPr>
          <a:lstStyle/>
          <a:p>
            <a:pPr marL="0" lvl="0" indent="0" algn="ctr" rtl="0">
              <a:spcBef>
                <a:spcPts val="0"/>
              </a:spcBef>
              <a:spcAft>
                <a:spcPts val="0"/>
              </a:spcAft>
              <a:buNone/>
            </a:pPr>
            <a:r>
              <a:rPr lang="en" sz="2900">
                <a:solidFill>
                  <a:srgbClr val="FFC319"/>
                </a:solidFill>
                <a:latin typeface="Bebas Neue"/>
                <a:ea typeface="Bebas Neue"/>
                <a:cs typeface="Bebas Neue"/>
                <a:sym typeface="Bebas Neue"/>
              </a:rPr>
              <a:t>$600</a:t>
            </a:r>
            <a:endParaRPr sz="2900">
              <a:solidFill>
                <a:srgbClr val="FFC319"/>
              </a:solidFill>
              <a:latin typeface="Bebas Neue"/>
              <a:ea typeface="Bebas Neue"/>
              <a:cs typeface="Bebas Neue"/>
              <a:sym typeface="Bebas Neue"/>
            </a:endParaRPr>
          </a:p>
        </p:txBody>
      </p:sp>
      <p:sp>
        <p:nvSpPr>
          <p:cNvPr id="256" name="Google Shape;256;p17">
            <a:hlinkClick r:id="rId16" action="ppaction://hlinksldjump"/>
          </p:cNvPr>
          <p:cNvSpPr txBox="1"/>
          <p:nvPr/>
        </p:nvSpPr>
        <p:spPr>
          <a:xfrm>
            <a:off x="3262881" y="3333114"/>
            <a:ext cx="1265700" cy="584100"/>
          </a:xfrm>
          <a:prstGeom prst="rect">
            <a:avLst/>
          </a:prstGeom>
          <a:noFill/>
          <a:ln>
            <a:noFill/>
          </a:ln>
          <a:effectLst>
            <a:outerShdw dist="38100" dir="2700000" algn="bl" rotWithShape="0">
              <a:schemeClr val="dk1">
                <a:alpha val="90000"/>
              </a:schemeClr>
            </a:outerShdw>
          </a:effectLst>
        </p:spPr>
        <p:txBody>
          <a:bodyPr spcFirstLastPara="1" wrap="square" lIns="0" tIns="0" rIns="0" bIns="0" anchor="ctr" anchorCtr="0">
            <a:noAutofit/>
          </a:bodyPr>
          <a:lstStyle/>
          <a:p>
            <a:pPr marL="0" lvl="0" indent="0" algn="ctr" rtl="0">
              <a:spcBef>
                <a:spcPts val="0"/>
              </a:spcBef>
              <a:spcAft>
                <a:spcPts val="0"/>
              </a:spcAft>
              <a:buNone/>
            </a:pPr>
            <a:r>
              <a:rPr lang="en" sz="2900">
                <a:solidFill>
                  <a:srgbClr val="FFC319"/>
                </a:solidFill>
                <a:latin typeface="Bebas Neue"/>
                <a:ea typeface="Bebas Neue"/>
                <a:cs typeface="Bebas Neue"/>
                <a:sym typeface="Bebas Neue"/>
              </a:rPr>
              <a:t>$800</a:t>
            </a:r>
            <a:endParaRPr sz="2900">
              <a:solidFill>
                <a:srgbClr val="FFC319"/>
              </a:solidFill>
              <a:latin typeface="Bebas Neue"/>
              <a:ea typeface="Bebas Neue"/>
              <a:cs typeface="Bebas Neue"/>
              <a:sym typeface="Bebas Neue"/>
            </a:endParaRPr>
          </a:p>
        </p:txBody>
      </p:sp>
      <p:sp>
        <p:nvSpPr>
          <p:cNvPr id="257" name="Google Shape;257;p17">
            <a:hlinkClick r:id="rId17" action="ppaction://hlinksldjump"/>
          </p:cNvPr>
          <p:cNvSpPr txBox="1"/>
          <p:nvPr/>
        </p:nvSpPr>
        <p:spPr>
          <a:xfrm>
            <a:off x="3262881" y="4004966"/>
            <a:ext cx="1265700" cy="584100"/>
          </a:xfrm>
          <a:prstGeom prst="rect">
            <a:avLst/>
          </a:prstGeom>
          <a:noFill/>
          <a:ln>
            <a:noFill/>
          </a:ln>
          <a:effectLst>
            <a:outerShdw dist="38100" dir="2700000" algn="bl" rotWithShape="0">
              <a:schemeClr val="dk1">
                <a:alpha val="90000"/>
              </a:schemeClr>
            </a:outerShdw>
          </a:effectLst>
        </p:spPr>
        <p:txBody>
          <a:bodyPr spcFirstLastPara="1" wrap="square" lIns="0" tIns="0" rIns="0" bIns="0" anchor="ctr" anchorCtr="0">
            <a:noAutofit/>
          </a:bodyPr>
          <a:lstStyle/>
          <a:p>
            <a:pPr marL="0" lvl="0" indent="0" algn="ctr" rtl="0">
              <a:spcBef>
                <a:spcPts val="0"/>
              </a:spcBef>
              <a:spcAft>
                <a:spcPts val="0"/>
              </a:spcAft>
              <a:buNone/>
            </a:pPr>
            <a:r>
              <a:rPr lang="en" sz="2900">
                <a:solidFill>
                  <a:srgbClr val="FFC319"/>
                </a:solidFill>
                <a:latin typeface="Bebas Neue"/>
                <a:ea typeface="Bebas Neue"/>
                <a:cs typeface="Bebas Neue"/>
                <a:sym typeface="Bebas Neue"/>
              </a:rPr>
              <a:t>$1000</a:t>
            </a:r>
            <a:endParaRPr sz="2900">
              <a:solidFill>
                <a:srgbClr val="FFC319"/>
              </a:solidFill>
              <a:latin typeface="Bebas Neue"/>
              <a:ea typeface="Bebas Neue"/>
              <a:cs typeface="Bebas Neue"/>
              <a:sym typeface="Bebas Neue"/>
            </a:endParaRPr>
          </a:p>
        </p:txBody>
      </p:sp>
      <p:sp>
        <p:nvSpPr>
          <p:cNvPr id="258" name="Google Shape;258;p17">
            <a:hlinkClick r:id="rId18" action="ppaction://hlinksldjump"/>
          </p:cNvPr>
          <p:cNvSpPr txBox="1"/>
          <p:nvPr/>
        </p:nvSpPr>
        <p:spPr>
          <a:xfrm>
            <a:off x="4607975" y="1317558"/>
            <a:ext cx="1265700" cy="584100"/>
          </a:xfrm>
          <a:prstGeom prst="rect">
            <a:avLst/>
          </a:prstGeom>
          <a:noFill/>
          <a:ln>
            <a:noFill/>
          </a:ln>
          <a:effectLst>
            <a:outerShdw dist="38100" dir="2700000" algn="bl" rotWithShape="0">
              <a:schemeClr val="dk1">
                <a:alpha val="90000"/>
              </a:schemeClr>
            </a:outerShdw>
          </a:effectLst>
        </p:spPr>
        <p:txBody>
          <a:bodyPr spcFirstLastPara="1" wrap="square" lIns="0" tIns="0" rIns="0" bIns="0" anchor="ctr" anchorCtr="0">
            <a:noAutofit/>
          </a:bodyPr>
          <a:lstStyle/>
          <a:p>
            <a:pPr marL="0" lvl="0" indent="0" algn="ctr" rtl="0">
              <a:spcBef>
                <a:spcPts val="0"/>
              </a:spcBef>
              <a:spcAft>
                <a:spcPts val="0"/>
              </a:spcAft>
              <a:buNone/>
            </a:pPr>
            <a:r>
              <a:rPr lang="en" sz="2900">
                <a:solidFill>
                  <a:srgbClr val="FFC319"/>
                </a:solidFill>
                <a:latin typeface="Bebas Neue"/>
                <a:ea typeface="Bebas Neue"/>
                <a:cs typeface="Bebas Neue"/>
                <a:sym typeface="Bebas Neue"/>
              </a:rPr>
              <a:t>$200</a:t>
            </a:r>
            <a:endParaRPr sz="2900">
              <a:solidFill>
                <a:srgbClr val="FFC319"/>
              </a:solidFill>
              <a:latin typeface="Bebas Neue"/>
              <a:ea typeface="Bebas Neue"/>
              <a:cs typeface="Bebas Neue"/>
              <a:sym typeface="Bebas Neue"/>
            </a:endParaRPr>
          </a:p>
        </p:txBody>
      </p:sp>
      <p:sp>
        <p:nvSpPr>
          <p:cNvPr id="259" name="Google Shape;259;p17">
            <a:hlinkClick r:id="rId19" action="ppaction://hlinksldjump"/>
          </p:cNvPr>
          <p:cNvSpPr txBox="1"/>
          <p:nvPr/>
        </p:nvSpPr>
        <p:spPr>
          <a:xfrm>
            <a:off x="4607975" y="1989410"/>
            <a:ext cx="1265700" cy="584100"/>
          </a:xfrm>
          <a:prstGeom prst="rect">
            <a:avLst/>
          </a:prstGeom>
          <a:noFill/>
          <a:ln>
            <a:noFill/>
          </a:ln>
          <a:effectLst>
            <a:outerShdw dist="38100" dir="2700000" algn="bl" rotWithShape="0">
              <a:schemeClr val="dk1">
                <a:alpha val="90000"/>
              </a:schemeClr>
            </a:outerShdw>
          </a:effectLst>
        </p:spPr>
        <p:txBody>
          <a:bodyPr spcFirstLastPara="1" wrap="square" lIns="0" tIns="0" rIns="0" bIns="0" anchor="ctr" anchorCtr="0">
            <a:noAutofit/>
          </a:bodyPr>
          <a:lstStyle/>
          <a:p>
            <a:pPr marL="0" lvl="0" indent="0" algn="ctr" rtl="0">
              <a:spcBef>
                <a:spcPts val="0"/>
              </a:spcBef>
              <a:spcAft>
                <a:spcPts val="0"/>
              </a:spcAft>
              <a:buNone/>
            </a:pPr>
            <a:r>
              <a:rPr lang="en" sz="2900">
                <a:solidFill>
                  <a:srgbClr val="FFC319"/>
                </a:solidFill>
                <a:latin typeface="Bebas Neue"/>
                <a:ea typeface="Bebas Neue"/>
                <a:cs typeface="Bebas Neue"/>
                <a:sym typeface="Bebas Neue"/>
              </a:rPr>
              <a:t>$400</a:t>
            </a:r>
            <a:endParaRPr sz="2900">
              <a:solidFill>
                <a:srgbClr val="FFC319"/>
              </a:solidFill>
              <a:latin typeface="Bebas Neue"/>
              <a:ea typeface="Bebas Neue"/>
              <a:cs typeface="Bebas Neue"/>
              <a:sym typeface="Bebas Neue"/>
            </a:endParaRPr>
          </a:p>
        </p:txBody>
      </p:sp>
      <p:sp>
        <p:nvSpPr>
          <p:cNvPr id="260" name="Google Shape;260;p17">
            <a:hlinkClick r:id="rId20" action="ppaction://hlinksldjump"/>
          </p:cNvPr>
          <p:cNvSpPr txBox="1"/>
          <p:nvPr/>
        </p:nvSpPr>
        <p:spPr>
          <a:xfrm>
            <a:off x="4607975" y="2661262"/>
            <a:ext cx="1265700" cy="584100"/>
          </a:xfrm>
          <a:prstGeom prst="rect">
            <a:avLst/>
          </a:prstGeom>
          <a:noFill/>
          <a:ln>
            <a:noFill/>
          </a:ln>
          <a:effectLst>
            <a:outerShdw dist="38100" dir="2700000" algn="bl" rotWithShape="0">
              <a:schemeClr val="dk1">
                <a:alpha val="90000"/>
              </a:schemeClr>
            </a:outerShdw>
          </a:effectLst>
        </p:spPr>
        <p:txBody>
          <a:bodyPr spcFirstLastPara="1" wrap="square" lIns="0" tIns="0" rIns="0" bIns="0" anchor="ctr" anchorCtr="0">
            <a:noAutofit/>
          </a:bodyPr>
          <a:lstStyle/>
          <a:p>
            <a:pPr marL="0" lvl="0" indent="0" algn="ctr" rtl="0">
              <a:spcBef>
                <a:spcPts val="0"/>
              </a:spcBef>
              <a:spcAft>
                <a:spcPts val="0"/>
              </a:spcAft>
              <a:buNone/>
            </a:pPr>
            <a:r>
              <a:rPr lang="en" sz="2900">
                <a:solidFill>
                  <a:srgbClr val="FFC319"/>
                </a:solidFill>
                <a:latin typeface="Bebas Neue"/>
                <a:ea typeface="Bebas Neue"/>
                <a:cs typeface="Bebas Neue"/>
                <a:sym typeface="Bebas Neue"/>
              </a:rPr>
              <a:t>$600</a:t>
            </a:r>
            <a:endParaRPr sz="2900">
              <a:solidFill>
                <a:srgbClr val="FFC319"/>
              </a:solidFill>
              <a:latin typeface="Bebas Neue"/>
              <a:ea typeface="Bebas Neue"/>
              <a:cs typeface="Bebas Neue"/>
              <a:sym typeface="Bebas Neue"/>
            </a:endParaRPr>
          </a:p>
        </p:txBody>
      </p:sp>
      <p:sp>
        <p:nvSpPr>
          <p:cNvPr id="261" name="Google Shape;261;p17">
            <a:hlinkClick r:id="rId21" action="ppaction://hlinksldjump"/>
          </p:cNvPr>
          <p:cNvSpPr txBox="1"/>
          <p:nvPr/>
        </p:nvSpPr>
        <p:spPr>
          <a:xfrm>
            <a:off x="4607975" y="3333114"/>
            <a:ext cx="1265700" cy="584100"/>
          </a:xfrm>
          <a:prstGeom prst="rect">
            <a:avLst/>
          </a:prstGeom>
          <a:noFill/>
          <a:ln>
            <a:noFill/>
          </a:ln>
          <a:effectLst>
            <a:outerShdw dist="38100" dir="2700000" algn="bl" rotWithShape="0">
              <a:schemeClr val="dk1">
                <a:alpha val="90000"/>
              </a:schemeClr>
            </a:outerShdw>
          </a:effectLst>
        </p:spPr>
        <p:txBody>
          <a:bodyPr spcFirstLastPara="1" wrap="square" lIns="0" tIns="0" rIns="0" bIns="0" anchor="ctr" anchorCtr="0">
            <a:noAutofit/>
          </a:bodyPr>
          <a:lstStyle/>
          <a:p>
            <a:pPr marL="0" lvl="0" indent="0" algn="ctr" rtl="0">
              <a:spcBef>
                <a:spcPts val="0"/>
              </a:spcBef>
              <a:spcAft>
                <a:spcPts val="0"/>
              </a:spcAft>
              <a:buNone/>
            </a:pPr>
            <a:r>
              <a:rPr lang="en" sz="2900">
                <a:solidFill>
                  <a:srgbClr val="FFC319"/>
                </a:solidFill>
                <a:latin typeface="Bebas Neue"/>
                <a:ea typeface="Bebas Neue"/>
                <a:cs typeface="Bebas Neue"/>
                <a:sym typeface="Bebas Neue"/>
              </a:rPr>
              <a:t>$800</a:t>
            </a:r>
            <a:endParaRPr sz="2900">
              <a:solidFill>
                <a:srgbClr val="FFC319"/>
              </a:solidFill>
              <a:latin typeface="Bebas Neue"/>
              <a:ea typeface="Bebas Neue"/>
              <a:cs typeface="Bebas Neue"/>
              <a:sym typeface="Bebas Neue"/>
            </a:endParaRPr>
          </a:p>
        </p:txBody>
      </p:sp>
      <p:sp>
        <p:nvSpPr>
          <p:cNvPr id="262" name="Google Shape;262;p17">
            <a:hlinkClick r:id="rId22" action="ppaction://hlinksldjump"/>
          </p:cNvPr>
          <p:cNvSpPr txBox="1"/>
          <p:nvPr/>
        </p:nvSpPr>
        <p:spPr>
          <a:xfrm>
            <a:off x="4607975" y="4004966"/>
            <a:ext cx="1265700" cy="584100"/>
          </a:xfrm>
          <a:prstGeom prst="rect">
            <a:avLst/>
          </a:prstGeom>
          <a:noFill/>
          <a:ln>
            <a:noFill/>
          </a:ln>
          <a:effectLst>
            <a:outerShdw dist="38100" dir="2700000" algn="bl" rotWithShape="0">
              <a:schemeClr val="dk1">
                <a:alpha val="90000"/>
              </a:schemeClr>
            </a:outerShdw>
          </a:effectLst>
        </p:spPr>
        <p:txBody>
          <a:bodyPr spcFirstLastPara="1" wrap="square" lIns="0" tIns="0" rIns="0" bIns="0" anchor="ctr" anchorCtr="0">
            <a:noAutofit/>
          </a:bodyPr>
          <a:lstStyle/>
          <a:p>
            <a:pPr marL="0" lvl="0" indent="0" algn="ctr" rtl="0">
              <a:spcBef>
                <a:spcPts val="0"/>
              </a:spcBef>
              <a:spcAft>
                <a:spcPts val="0"/>
              </a:spcAft>
              <a:buNone/>
            </a:pPr>
            <a:r>
              <a:rPr lang="en" sz="2900">
                <a:solidFill>
                  <a:srgbClr val="FFC319"/>
                </a:solidFill>
                <a:latin typeface="Bebas Neue"/>
                <a:ea typeface="Bebas Neue"/>
                <a:cs typeface="Bebas Neue"/>
                <a:sym typeface="Bebas Neue"/>
              </a:rPr>
              <a:t>$1000</a:t>
            </a:r>
            <a:endParaRPr sz="2900">
              <a:solidFill>
                <a:srgbClr val="FFC319"/>
              </a:solidFill>
              <a:latin typeface="Bebas Neue"/>
              <a:ea typeface="Bebas Neue"/>
              <a:cs typeface="Bebas Neue"/>
              <a:sym typeface="Bebas Neue"/>
            </a:endParaRPr>
          </a:p>
        </p:txBody>
      </p:sp>
      <p:sp>
        <p:nvSpPr>
          <p:cNvPr id="4" name="TextBox 3">
            <a:extLst>
              <a:ext uri="{FF2B5EF4-FFF2-40B4-BE49-F238E27FC236}">
                <a16:creationId xmlns:a16="http://schemas.microsoft.com/office/drawing/2014/main" id="{FF9567D7-FB74-8FB4-074B-52C5DAA84F4B}"/>
              </a:ext>
            </a:extLst>
          </p:cNvPr>
          <p:cNvSpPr txBox="1"/>
          <p:nvPr/>
        </p:nvSpPr>
        <p:spPr>
          <a:xfrm>
            <a:off x="5949312" y="478869"/>
            <a:ext cx="3045402" cy="4185761"/>
          </a:xfrm>
          <a:prstGeom prst="rect">
            <a:avLst/>
          </a:prstGeom>
          <a:solidFill>
            <a:schemeClr val="bg1"/>
          </a:solidFill>
        </p:spPr>
        <p:txBody>
          <a:bodyPr wrap="square" lIns="91440" tIns="45720" rIns="91440" bIns="45720" rtlCol="0" anchor="t">
            <a:spAutoFit/>
          </a:bodyPr>
          <a:lstStyle/>
          <a:p>
            <a:pPr algn="ctr"/>
            <a:r>
              <a:rPr lang="en-US" dirty="0"/>
              <a:t>Review Game rules</a:t>
            </a:r>
          </a:p>
          <a:p>
            <a:pPr algn="ctr"/>
            <a:endParaRPr lang="en-US"/>
          </a:p>
          <a:p>
            <a:pPr marL="285750" indent="-285750" algn="ctr">
              <a:buFont typeface="Arial" panose="020B0604020202020204" pitchFamily="34" charset="0"/>
              <a:buChar char="•"/>
            </a:pPr>
            <a:r>
              <a:rPr lang="en-US" dirty="0"/>
              <a:t>Split up until 2 teams</a:t>
            </a:r>
          </a:p>
          <a:p>
            <a:pPr marL="285750" indent="-285750" algn="ctr">
              <a:buFont typeface="Arial" panose="020B0604020202020204" pitchFamily="34" charset="0"/>
              <a:buChar char="•"/>
            </a:pPr>
            <a:r>
              <a:rPr lang="en-US" dirty="0"/>
              <a:t>The team that picks the question is allowed 1 minute to answer. If they answer incorrectly or fail to answer, the other team may “steal” for points</a:t>
            </a:r>
          </a:p>
          <a:p>
            <a:pPr marL="285750" indent="-285750" algn="ctr">
              <a:buFont typeface="Arial" panose="020B0604020202020204" pitchFamily="34" charset="0"/>
              <a:buChar char="•"/>
            </a:pPr>
            <a:r>
              <a:rPr lang="en-US" dirty="0"/>
              <a:t>In some questions, there are multiple correct answers</a:t>
            </a:r>
          </a:p>
          <a:p>
            <a:pPr marL="285750" indent="-285750" algn="ctr">
              <a:buFont typeface="Arial" panose="020B0604020202020204" pitchFamily="34" charset="0"/>
              <a:buChar char="•"/>
            </a:pPr>
            <a:r>
              <a:rPr lang="en-US" dirty="0"/>
              <a:t>In the case of an answer dispute, the facilitate may decide how to allot points.</a:t>
            </a:r>
          </a:p>
          <a:p>
            <a:pPr marL="285750" indent="-285750" algn="ctr">
              <a:buFont typeface="Arial" panose="020B0604020202020204" pitchFamily="34" charset="0"/>
              <a:buChar char="•"/>
            </a:pPr>
            <a:endParaRPr lang="en-US"/>
          </a:p>
          <a:p>
            <a:pPr marL="285750" indent="-285750" algn="ctr">
              <a:buFont typeface="Arial" panose="020B0604020202020204" pitchFamily="34" charset="0"/>
              <a:buChar char="•"/>
            </a:pPr>
            <a:endParaRPr lang="en-US"/>
          </a:p>
          <a:p>
            <a:pPr algn="ctr"/>
            <a:r>
              <a:rPr lang="en-US" dirty="0"/>
              <a:t>This is all for fun and should be a great way to re-emphasize clinical reasoning skills.</a:t>
            </a:r>
          </a:p>
          <a:p>
            <a:pPr algn="ctr"/>
            <a:endParaRPr lang="en-US"/>
          </a:p>
        </p:txBody>
      </p:sp>
    </p:spTree>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243"/>
                    </p:tgtEl>
                  </p:cond>
                </p:stCondLst>
                <p:endSync evt="end" delay="0">
                  <p:rtn val="all"/>
                </p:endSync>
                <p:childTnLst>
                  <p:par>
                    <p:cTn id="3" fill="hold">
                      <p:stCondLst>
                        <p:cond delay="0"/>
                      </p:stCondLst>
                      <p:childTnLst>
                        <p:par>
                          <p:cTn id="4" fill="hold">
                            <p:stCondLst>
                              <p:cond delay="0"/>
                            </p:stCondLst>
                            <p:childTnLst>
                              <p:par>
                                <p:cTn id="5" presetID="10" presetClass="exit" presetSubtype="0" fill="hold" grpId="0" nodeType="clickEffect">
                                  <p:stCondLst>
                                    <p:cond delay="0"/>
                                  </p:stCondLst>
                                  <p:childTnLst>
                                    <p:animEffect transition="out" filter="fade">
                                      <p:cBhvr>
                                        <p:cTn id="6" dur="500"/>
                                        <p:tgtEl>
                                          <p:spTgt spid="243"/>
                                        </p:tgtEl>
                                      </p:cBhvr>
                                    </p:animEffect>
                                    <p:set>
                                      <p:cBhvr>
                                        <p:cTn id="7" dur="1" fill="hold">
                                          <p:stCondLst>
                                            <p:cond delay="499"/>
                                          </p:stCondLst>
                                        </p:cTn>
                                        <p:tgtEl>
                                          <p:spTgt spid="243"/>
                                        </p:tgtEl>
                                        <p:attrNameLst>
                                          <p:attrName>style.visibility</p:attrName>
                                        </p:attrNameLst>
                                      </p:cBhvr>
                                      <p:to>
                                        <p:strVal val="hidden"/>
                                      </p:to>
                                    </p:set>
                                  </p:childTnLst>
                                  <p:subTnLst>
                                    <p:set>
                                      <p:cBhvr override="childStyle">
                                        <p:cTn dur="1" fill="hold" display="0" masterRel="sameClick" afterEffect="1">
                                          <p:stCondLst>
                                            <p:cond evt="end" delay="0">
                                              <p:tn val="5"/>
                                            </p:cond>
                                          </p:stCondLst>
                                        </p:cTn>
                                        <p:tgtEl>
                                          <p:spTgt spid="243"/>
                                        </p:tgtEl>
                                        <p:attrNameLst>
                                          <p:attrName>style.visibility</p:attrName>
                                        </p:attrNameLst>
                                      </p:cBhvr>
                                      <p:to>
                                        <p:strVal val="hidden"/>
                                      </p:to>
                                    </p:set>
                                  </p:subTnLst>
                                </p:cTn>
                              </p:par>
                            </p:childTnLst>
                          </p:cTn>
                        </p:par>
                      </p:childTnLst>
                    </p:cTn>
                  </p:par>
                </p:childTnLst>
              </p:cTn>
              <p:nextCondLst>
                <p:cond evt="onClick" delay="0">
                  <p:tgtEl>
                    <p:spTgt spid="243"/>
                  </p:tgtEl>
                </p:cond>
              </p:nextCondLst>
            </p:seq>
            <p:seq concurrent="1" nextAc="seek">
              <p:cTn id="8" restart="whenNotActive" fill="hold" evtFilter="cancelBubble" nodeType="interactiveSeq">
                <p:stCondLst>
                  <p:cond evt="onClick" delay="0">
                    <p:tgtEl>
                      <p:spTgt spid="244"/>
                    </p:tgtEl>
                  </p:cond>
                </p:stCondLst>
                <p:endSync evt="end" delay="0">
                  <p:rtn val="all"/>
                </p:endSync>
                <p:childTnLst>
                  <p:par>
                    <p:cTn id="9" fill="hold">
                      <p:stCondLst>
                        <p:cond delay="0"/>
                      </p:stCondLst>
                      <p:childTnLst>
                        <p:par>
                          <p:cTn id="10" fill="hold">
                            <p:stCondLst>
                              <p:cond delay="0"/>
                            </p:stCondLst>
                            <p:childTnLst>
                              <p:par>
                                <p:cTn id="11" presetID="10" presetClass="exit" presetSubtype="0" fill="hold" grpId="0" nodeType="clickEffect">
                                  <p:stCondLst>
                                    <p:cond delay="0"/>
                                  </p:stCondLst>
                                  <p:childTnLst>
                                    <p:animEffect transition="out" filter="fade">
                                      <p:cBhvr>
                                        <p:cTn id="12" dur="500"/>
                                        <p:tgtEl>
                                          <p:spTgt spid="244"/>
                                        </p:tgtEl>
                                      </p:cBhvr>
                                    </p:animEffect>
                                    <p:set>
                                      <p:cBhvr>
                                        <p:cTn id="13" dur="1" fill="hold">
                                          <p:stCondLst>
                                            <p:cond delay="499"/>
                                          </p:stCondLst>
                                        </p:cTn>
                                        <p:tgtEl>
                                          <p:spTgt spid="244"/>
                                        </p:tgtEl>
                                        <p:attrNameLst>
                                          <p:attrName>style.visibility</p:attrName>
                                        </p:attrNameLst>
                                      </p:cBhvr>
                                      <p:to>
                                        <p:strVal val="hidden"/>
                                      </p:to>
                                    </p:set>
                                  </p:childTnLst>
                                  <p:subTnLst>
                                    <p:set>
                                      <p:cBhvr override="childStyle">
                                        <p:cTn dur="1" fill="hold" display="0" masterRel="sameClick" afterEffect="1">
                                          <p:stCondLst>
                                            <p:cond evt="end" delay="0">
                                              <p:tn val="11"/>
                                            </p:cond>
                                          </p:stCondLst>
                                        </p:cTn>
                                        <p:tgtEl>
                                          <p:spTgt spid="244"/>
                                        </p:tgtEl>
                                        <p:attrNameLst>
                                          <p:attrName>style.visibility</p:attrName>
                                        </p:attrNameLst>
                                      </p:cBhvr>
                                      <p:to>
                                        <p:strVal val="hidden"/>
                                      </p:to>
                                    </p:set>
                                  </p:subTnLst>
                                </p:cTn>
                              </p:par>
                            </p:childTnLst>
                          </p:cTn>
                        </p:par>
                      </p:childTnLst>
                    </p:cTn>
                  </p:par>
                </p:childTnLst>
              </p:cTn>
              <p:nextCondLst>
                <p:cond evt="onClick" delay="0">
                  <p:tgtEl>
                    <p:spTgt spid="244"/>
                  </p:tgtEl>
                </p:cond>
              </p:nextCondLst>
            </p:seq>
            <p:seq concurrent="1" nextAc="seek">
              <p:cTn id="14" restart="whenNotActive" fill="hold" evtFilter="cancelBubble" nodeType="interactiveSeq">
                <p:stCondLst>
                  <p:cond evt="onClick" delay="0">
                    <p:tgtEl>
                      <p:spTgt spid="245"/>
                    </p:tgtEl>
                  </p:cond>
                </p:stCondLst>
                <p:endSync evt="end" delay="0">
                  <p:rtn val="all"/>
                </p:endSync>
                <p:childTnLst>
                  <p:par>
                    <p:cTn id="15" fill="hold">
                      <p:stCondLst>
                        <p:cond delay="0"/>
                      </p:stCondLst>
                      <p:childTnLst>
                        <p:par>
                          <p:cTn id="16" fill="hold">
                            <p:stCondLst>
                              <p:cond delay="0"/>
                            </p:stCondLst>
                            <p:childTnLst>
                              <p:par>
                                <p:cTn id="17" presetID="10" presetClass="exit" presetSubtype="0" fill="hold" grpId="0" nodeType="clickEffect">
                                  <p:stCondLst>
                                    <p:cond delay="0"/>
                                  </p:stCondLst>
                                  <p:childTnLst>
                                    <p:animEffect transition="out" filter="fade">
                                      <p:cBhvr>
                                        <p:cTn id="18" dur="500"/>
                                        <p:tgtEl>
                                          <p:spTgt spid="245"/>
                                        </p:tgtEl>
                                      </p:cBhvr>
                                    </p:animEffect>
                                    <p:set>
                                      <p:cBhvr>
                                        <p:cTn id="19" dur="1" fill="hold">
                                          <p:stCondLst>
                                            <p:cond delay="499"/>
                                          </p:stCondLst>
                                        </p:cTn>
                                        <p:tgtEl>
                                          <p:spTgt spid="245"/>
                                        </p:tgtEl>
                                        <p:attrNameLst>
                                          <p:attrName>style.visibility</p:attrName>
                                        </p:attrNameLst>
                                      </p:cBhvr>
                                      <p:to>
                                        <p:strVal val="hidden"/>
                                      </p:to>
                                    </p:set>
                                  </p:childTnLst>
                                  <p:subTnLst>
                                    <p:set>
                                      <p:cBhvr override="childStyle">
                                        <p:cTn dur="1" fill="hold" display="0" masterRel="sameClick" afterEffect="1">
                                          <p:stCondLst>
                                            <p:cond evt="end" delay="0">
                                              <p:tn val="17"/>
                                            </p:cond>
                                          </p:stCondLst>
                                        </p:cTn>
                                        <p:tgtEl>
                                          <p:spTgt spid="245"/>
                                        </p:tgtEl>
                                        <p:attrNameLst>
                                          <p:attrName>style.visibility</p:attrName>
                                        </p:attrNameLst>
                                      </p:cBhvr>
                                      <p:to>
                                        <p:strVal val="hidden"/>
                                      </p:to>
                                    </p:set>
                                  </p:subTnLst>
                                </p:cTn>
                              </p:par>
                            </p:childTnLst>
                          </p:cTn>
                        </p:par>
                      </p:childTnLst>
                    </p:cTn>
                  </p:par>
                </p:childTnLst>
              </p:cTn>
              <p:nextCondLst>
                <p:cond evt="onClick" delay="0">
                  <p:tgtEl>
                    <p:spTgt spid="245"/>
                  </p:tgtEl>
                </p:cond>
              </p:nextCondLst>
            </p:seq>
            <p:seq concurrent="1" nextAc="seek">
              <p:cTn id="20" restart="whenNotActive" fill="hold" evtFilter="cancelBubble" nodeType="interactiveSeq">
                <p:stCondLst>
                  <p:cond evt="onClick" delay="0">
                    <p:tgtEl>
                      <p:spTgt spid="246"/>
                    </p:tgtEl>
                  </p:cond>
                </p:stCondLst>
                <p:endSync evt="end" delay="0">
                  <p:rtn val="all"/>
                </p:endSync>
                <p:childTnLst>
                  <p:par>
                    <p:cTn id="21" fill="hold">
                      <p:stCondLst>
                        <p:cond delay="0"/>
                      </p:stCondLst>
                      <p:childTnLst>
                        <p:par>
                          <p:cTn id="22" fill="hold">
                            <p:stCondLst>
                              <p:cond delay="0"/>
                            </p:stCondLst>
                            <p:childTnLst>
                              <p:par>
                                <p:cTn id="23" presetID="10" presetClass="exit" presetSubtype="0" fill="hold" grpId="0" nodeType="clickEffect">
                                  <p:stCondLst>
                                    <p:cond delay="0"/>
                                  </p:stCondLst>
                                  <p:childTnLst>
                                    <p:animEffect transition="out" filter="fade">
                                      <p:cBhvr>
                                        <p:cTn id="24" dur="500"/>
                                        <p:tgtEl>
                                          <p:spTgt spid="246"/>
                                        </p:tgtEl>
                                      </p:cBhvr>
                                    </p:animEffect>
                                    <p:set>
                                      <p:cBhvr>
                                        <p:cTn id="25" dur="1" fill="hold">
                                          <p:stCondLst>
                                            <p:cond delay="499"/>
                                          </p:stCondLst>
                                        </p:cTn>
                                        <p:tgtEl>
                                          <p:spTgt spid="246"/>
                                        </p:tgtEl>
                                        <p:attrNameLst>
                                          <p:attrName>style.visibility</p:attrName>
                                        </p:attrNameLst>
                                      </p:cBhvr>
                                      <p:to>
                                        <p:strVal val="hidden"/>
                                      </p:to>
                                    </p:set>
                                  </p:childTnLst>
                                  <p:subTnLst>
                                    <p:set>
                                      <p:cBhvr override="childStyle">
                                        <p:cTn dur="1" fill="hold" display="0" masterRel="sameClick" afterEffect="1">
                                          <p:stCondLst>
                                            <p:cond evt="end" delay="0">
                                              <p:tn val="23"/>
                                            </p:cond>
                                          </p:stCondLst>
                                        </p:cTn>
                                        <p:tgtEl>
                                          <p:spTgt spid="246"/>
                                        </p:tgtEl>
                                        <p:attrNameLst>
                                          <p:attrName>style.visibility</p:attrName>
                                        </p:attrNameLst>
                                      </p:cBhvr>
                                      <p:to>
                                        <p:strVal val="hidden"/>
                                      </p:to>
                                    </p:set>
                                  </p:subTnLst>
                                </p:cTn>
                              </p:par>
                            </p:childTnLst>
                          </p:cTn>
                        </p:par>
                      </p:childTnLst>
                    </p:cTn>
                  </p:par>
                </p:childTnLst>
              </p:cTn>
              <p:nextCondLst>
                <p:cond evt="onClick" delay="0">
                  <p:tgtEl>
                    <p:spTgt spid="246"/>
                  </p:tgtEl>
                </p:cond>
              </p:nextCondLst>
            </p:seq>
            <p:seq concurrent="1" nextAc="seek">
              <p:cTn id="26" restart="whenNotActive" fill="hold" evtFilter="cancelBubble" nodeType="interactiveSeq">
                <p:stCondLst>
                  <p:cond evt="onClick" delay="0">
                    <p:tgtEl>
                      <p:spTgt spid="247"/>
                    </p:tgtEl>
                  </p:cond>
                </p:stCondLst>
                <p:endSync evt="end" delay="0">
                  <p:rtn val="all"/>
                </p:endSync>
                <p:childTnLst>
                  <p:par>
                    <p:cTn id="27" fill="hold">
                      <p:stCondLst>
                        <p:cond delay="0"/>
                      </p:stCondLst>
                      <p:childTnLst>
                        <p:par>
                          <p:cTn id="28" fill="hold">
                            <p:stCondLst>
                              <p:cond delay="0"/>
                            </p:stCondLst>
                            <p:childTnLst>
                              <p:par>
                                <p:cTn id="29" presetID="10" presetClass="exit" presetSubtype="0" fill="hold" grpId="0" nodeType="clickEffect">
                                  <p:stCondLst>
                                    <p:cond delay="0"/>
                                  </p:stCondLst>
                                  <p:childTnLst>
                                    <p:animEffect transition="out" filter="fade">
                                      <p:cBhvr>
                                        <p:cTn id="30" dur="500"/>
                                        <p:tgtEl>
                                          <p:spTgt spid="247"/>
                                        </p:tgtEl>
                                      </p:cBhvr>
                                    </p:animEffect>
                                    <p:set>
                                      <p:cBhvr>
                                        <p:cTn id="31" dur="1" fill="hold">
                                          <p:stCondLst>
                                            <p:cond delay="499"/>
                                          </p:stCondLst>
                                        </p:cTn>
                                        <p:tgtEl>
                                          <p:spTgt spid="247"/>
                                        </p:tgtEl>
                                        <p:attrNameLst>
                                          <p:attrName>style.visibility</p:attrName>
                                        </p:attrNameLst>
                                      </p:cBhvr>
                                      <p:to>
                                        <p:strVal val="hidden"/>
                                      </p:to>
                                    </p:set>
                                  </p:childTnLst>
                                  <p:subTnLst>
                                    <p:set>
                                      <p:cBhvr override="childStyle">
                                        <p:cTn dur="1" fill="hold" display="0" masterRel="sameClick" afterEffect="1">
                                          <p:stCondLst>
                                            <p:cond evt="end" delay="0">
                                              <p:tn val="29"/>
                                            </p:cond>
                                          </p:stCondLst>
                                        </p:cTn>
                                        <p:tgtEl>
                                          <p:spTgt spid="247"/>
                                        </p:tgtEl>
                                        <p:attrNameLst>
                                          <p:attrName>style.visibility</p:attrName>
                                        </p:attrNameLst>
                                      </p:cBhvr>
                                      <p:to>
                                        <p:strVal val="hidden"/>
                                      </p:to>
                                    </p:set>
                                  </p:subTnLst>
                                </p:cTn>
                              </p:par>
                            </p:childTnLst>
                          </p:cTn>
                        </p:par>
                      </p:childTnLst>
                    </p:cTn>
                  </p:par>
                </p:childTnLst>
              </p:cTn>
              <p:nextCondLst>
                <p:cond evt="onClick" delay="0">
                  <p:tgtEl>
                    <p:spTgt spid="247"/>
                  </p:tgtEl>
                </p:cond>
              </p:nextCondLst>
            </p:seq>
            <p:seq concurrent="1" nextAc="seek">
              <p:cTn id="32" restart="whenNotActive" fill="hold" evtFilter="cancelBubble" nodeType="interactiveSeq">
                <p:stCondLst>
                  <p:cond evt="onClick" delay="0">
                    <p:tgtEl>
                      <p:spTgt spid="248"/>
                    </p:tgtEl>
                  </p:cond>
                </p:stCondLst>
                <p:endSync evt="end" delay="0">
                  <p:rtn val="all"/>
                </p:endSync>
                <p:childTnLst>
                  <p:par>
                    <p:cTn id="33" fill="hold">
                      <p:stCondLst>
                        <p:cond delay="0"/>
                      </p:stCondLst>
                      <p:childTnLst>
                        <p:par>
                          <p:cTn id="34" fill="hold">
                            <p:stCondLst>
                              <p:cond delay="0"/>
                            </p:stCondLst>
                            <p:childTnLst>
                              <p:par>
                                <p:cTn id="35" presetID="10" presetClass="exit" presetSubtype="0" fill="hold" grpId="0" nodeType="clickEffect">
                                  <p:stCondLst>
                                    <p:cond delay="0"/>
                                  </p:stCondLst>
                                  <p:childTnLst>
                                    <p:animEffect transition="out" filter="fade">
                                      <p:cBhvr>
                                        <p:cTn id="36" dur="500"/>
                                        <p:tgtEl>
                                          <p:spTgt spid="248"/>
                                        </p:tgtEl>
                                      </p:cBhvr>
                                    </p:animEffect>
                                    <p:set>
                                      <p:cBhvr>
                                        <p:cTn id="37" dur="1" fill="hold">
                                          <p:stCondLst>
                                            <p:cond delay="499"/>
                                          </p:stCondLst>
                                        </p:cTn>
                                        <p:tgtEl>
                                          <p:spTgt spid="248"/>
                                        </p:tgtEl>
                                        <p:attrNameLst>
                                          <p:attrName>style.visibility</p:attrName>
                                        </p:attrNameLst>
                                      </p:cBhvr>
                                      <p:to>
                                        <p:strVal val="hidden"/>
                                      </p:to>
                                    </p:set>
                                  </p:childTnLst>
                                  <p:subTnLst>
                                    <p:set>
                                      <p:cBhvr override="childStyle">
                                        <p:cTn dur="1" fill="hold" display="0" masterRel="sameClick" afterEffect="1">
                                          <p:stCondLst>
                                            <p:cond evt="end" delay="0">
                                              <p:tn val="35"/>
                                            </p:cond>
                                          </p:stCondLst>
                                        </p:cTn>
                                        <p:tgtEl>
                                          <p:spTgt spid="248"/>
                                        </p:tgtEl>
                                        <p:attrNameLst>
                                          <p:attrName>style.visibility</p:attrName>
                                        </p:attrNameLst>
                                      </p:cBhvr>
                                      <p:to>
                                        <p:strVal val="hidden"/>
                                      </p:to>
                                    </p:set>
                                  </p:subTnLst>
                                </p:cTn>
                              </p:par>
                            </p:childTnLst>
                          </p:cTn>
                        </p:par>
                      </p:childTnLst>
                    </p:cTn>
                  </p:par>
                </p:childTnLst>
              </p:cTn>
              <p:nextCondLst>
                <p:cond evt="onClick" delay="0">
                  <p:tgtEl>
                    <p:spTgt spid="248"/>
                  </p:tgtEl>
                </p:cond>
              </p:nextCondLst>
            </p:seq>
            <p:seq concurrent="1" nextAc="seek">
              <p:cTn id="38" restart="whenNotActive" fill="hold" evtFilter="cancelBubble" nodeType="interactiveSeq">
                <p:stCondLst>
                  <p:cond evt="onClick" delay="0">
                    <p:tgtEl>
                      <p:spTgt spid="249"/>
                    </p:tgtEl>
                  </p:cond>
                </p:stCondLst>
                <p:endSync evt="end" delay="0">
                  <p:rtn val="all"/>
                </p:endSync>
                <p:childTnLst>
                  <p:par>
                    <p:cTn id="39" fill="hold">
                      <p:stCondLst>
                        <p:cond delay="0"/>
                      </p:stCondLst>
                      <p:childTnLst>
                        <p:par>
                          <p:cTn id="40" fill="hold">
                            <p:stCondLst>
                              <p:cond delay="0"/>
                            </p:stCondLst>
                            <p:childTnLst>
                              <p:par>
                                <p:cTn id="41" presetID="10" presetClass="exit" presetSubtype="0" fill="hold" grpId="0" nodeType="clickEffect">
                                  <p:stCondLst>
                                    <p:cond delay="0"/>
                                  </p:stCondLst>
                                  <p:childTnLst>
                                    <p:animEffect transition="out" filter="fade">
                                      <p:cBhvr>
                                        <p:cTn id="42" dur="500"/>
                                        <p:tgtEl>
                                          <p:spTgt spid="249"/>
                                        </p:tgtEl>
                                      </p:cBhvr>
                                    </p:animEffect>
                                    <p:set>
                                      <p:cBhvr>
                                        <p:cTn id="43" dur="1" fill="hold">
                                          <p:stCondLst>
                                            <p:cond delay="499"/>
                                          </p:stCondLst>
                                        </p:cTn>
                                        <p:tgtEl>
                                          <p:spTgt spid="249"/>
                                        </p:tgtEl>
                                        <p:attrNameLst>
                                          <p:attrName>style.visibility</p:attrName>
                                        </p:attrNameLst>
                                      </p:cBhvr>
                                      <p:to>
                                        <p:strVal val="hidden"/>
                                      </p:to>
                                    </p:set>
                                  </p:childTnLst>
                                  <p:subTnLst>
                                    <p:set>
                                      <p:cBhvr override="childStyle">
                                        <p:cTn dur="1" fill="hold" display="0" masterRel="sameClick" afterEffect="1">
                                          <p:stCondLst>
                                            <p:cond evt="end" delay="0">
                                              <p:tn val="41"/>
                                            </p:cond>
                                          </p:stCondLst>
                                        </p:cTn>
                                        <p:tgtEl>
                                          <p:spTgt spid="249"/>
                                        </p:tgtEl>
                                        <p:attrNameLst>
                                          <p:attrName>style.visibility</p:attrName>
                                        </p:attrNameLst>
                                      </p:cBhvr>
                                      <p:to>
                                        <p:strVal val="hidden"/>
                                      </p:to>
                                    </p:set>
                                  </p:subTnLst>
                                </p:cTn>
                              </p:par>
                            </p:childTnLst>
                          </p:cTn>
                        </p:par>
                      </p:childTnLst>
                    </p:cTn>
                  </p:par>
                </p:childTnLst>
              </p:cTn>
              <p:nextCondLst>
                <p:cond evt="onClick" delay="0">
                  <p:tgtEl>
                    <p:spTgt spid="249"/>
                  </p:tgtEl>
                </p:cond>
              </p:nextCondLst>
            </p:seq>
            <p:seq concurrent="1" nextAc="seek">
              <p:cTn id="44" restart="whenNotActive" fill="hold" evtFilter="cancelBubble" nodeType="interactiveSeq">
                <p:stCondLst>
                  <p:cond evt="onClick" delay="0">
                    <p:tgtEl>
                      <p:spTgt spid="250"/>
                    </p:tgtEl>
                  </p:cond>
                </p:stCondLst>
                <p:endSync evt="end" delay="0">
                  <p:rtn val="all"/>
                </p:endSync>
                <p:childTnLst>
                  <p:par>
                    <p:cTn id="45" fill="hold">
                      <p:stCondLst>
                        <p:cond delay="0"/>
                      </p:stCondLst>
                      <p:childTnLst>
                        <p:par>
                          <p:cTn id="46" fill="hold">
                            <p:stCondLst>
                              <p:cond delay="0"/>
                            </p:stCondLst>
                            <p:childTnLst>
                              <p:par>
                                <p:cTn id="47" presetID="10" presetClass="exit" presetSubtype="0" fill="hold" grpId="0" nodeType="clickEffect">
                                  <p:stCondLst>
                                    <p:cond delay="0"/>
                                  </p:stCondLst>
                                  <p:childTnLst>
                                    <p:animEffect transition="out" filter="fade">
                                      <p:cBhvr>
                                        <p:cTn id="48" dur="500"/>
                                        <p:tgtEl>
                                          <p:spTgt spid="250"/>
                                        </p:tgtEl>
                                      </p:cBhvr>
                                    </p:animEffect>
                                    <p:set>
                                      <p:cBhvr>
                                        <p:cTn id="49" dur="1" fill="hold">
                                          <p:stCondLst>
                                            <p:cond delay="499"/>
                                          </p:stCondLst>
                                        </p:cTn>
                                        <p:tgtEl>
                                          <p:spTgt spid="250"/>
                                        </p:tgtEl>
                                        <p:attrNameLst>
                                          <p:attrName>style.visibility</p:attrName>
                                        </p:attrNameLst>
                                      </p:cBhvr>
                                      <p:to>
                                        <p:strVal val="hidden"/>
                                      </p:to>
                                    </p:set>
                                  </p:childTnLst>
                                  <p:subTnLst>
                                    <p:set>
                                      <p:cBhvr override="childStyle">
                                        <p:cTn dur="1" fill="hold" display="0" masterRel="sameClick" afterEffect="1">
                                          <p:stCondLst>
                                            <p:cond evt="end" delay="0">
                                              <p:tn val="47"/>
                                            </p:cond>
                                          </p:stCondLst>
                                        </p:cTn>
                                        <p:tgtEl>
                                          <p:spTgt spid="250"/>
                                        </p:tgtEl>
                                        <p:attrNameLst>
                                          <p:attrName>style.visibility</p:attrName>
                                        </p:attrNameLst>
                                      </p:cBhvr>
                                      <p:to>
                                        <p:strVal val="hidden"/>
                                      </p:to>
                                    </p:set>
                                  </p:subTnLst>
                                </p:cTn>
                              </p:par>
                            </p:childTnLst>
                          </p:cTn>
                        </p:par>
                      </p:childTnLst>
                    </p:cTn>
                  </p:par>
                </p:childTnLst>
              </p:cTn>
              <p:nextCondLst>
                <p:cond evt="onClick" delay="0">
                  <p:tgtEl>
                    <p:spTgt spid="250"/>
                  </p:tgtEl>
                </p:cond>
              </p:nextCondLst>
            </p:seq>
            <p:seq concurrent="1" nextAc="seek">
              <p:cTn id="50" restart="whenNotActive" fill="hold" evtFilter="cancelBubble" nodeType="interactiveSeq">
                <p:stCondLst>
                  <p:cond evt="onClick" delay="0">
                    <p:tgtEl>
                      <p:spTgt spid="251"/>
                    </p:tgtEl>
                  </p:cond>
                </p:stCondLst>
                <p:endSync evt="end" delay="0">
                  <p:rtn val="all"/>
                </p:endSync>
                <p:childTnLst>
                  <p:par>
                    <p:cTn id="51" fill="hold">
                      <p:stCondLst>
                        <p:cond delay="0"/>
                      </p:stCondLst>
                      <p:childTnLst>
                        <p:par>
                          <p:cTn id="52" fill="hold">
                            <p:stCondLst>
                              <p:cond delay="0"/>
                            </p:stCondLst>
                            <p:childTnLst>
                              <p:par>
                                <p:cTn id="53" presetID="10" presetClass="exit" presetSubtype="0" fill="hold" grpId="0" nodeType="clickEffect">
                                  <p:stCondLst>
                                    <p:cond delay="0"/>
                                  </p:stCondLst>
                                  <p:childTnLst>
                                    <p:animEffect transition="out" filter="fade">
                                      <p:cBhvr>
                                        <p:cTn id="54" dur="500"/>
                                        <p:tgtEl>
                                          <p:spTgt spid="251"/>
                                        </p:tgtEl>
                                      </p:cBhvr>
                                    </p:animEffect>
                                    <p:set>
                                      <p:cBhvr>
                                        <p:cTn id="55" dur="1" fill="hold">
                                          <p:stCondLst>
                                            <p:cond delay="499"/>
                                          </p:stCondLst>
                                        </p:cTn>
                                        <p:tgtEl>
                                          <p:spTgt spid="251"/>
                                        </p:tgtEl>
                                        <p:attrNameLst>
                                          <p:attrName>style.visibility</p:attrName>
                                        </p:attrNameLst>
                                      </p:cBhvr>
                                      <p:to>
                                        <p:strVal val="hidden"/>
                                      </p:to>
                                    </p:set>
                                  </p:childTnLst>
                                  <p:subTnLst>
                                    <p:set>
                                      <p:cBhvr override="childStyle">
                                        <p:cTn dur="1" fill="hold" display="0" masterRel="sameClick" afterEffect="1">
                                          <p:stCondLst>
                                            <p:cond evt="end" delay="0">
                                              <p:tn val="53"/>
                                            </p:cond>
                                          </p:stCondLst>
                                        </p:cTn>
                                        <p:tgtEl>
                                          <p:spTgt spid="251"/>
                                        </p:tgtEl>
                                        <p:attrNameLst>
                                          <p:attrName>style.visibility</p:attrName>
                                        </p:attrNameLst>
                                      </p:cBhvr>
                                      <p:to>
                                        <p:strVal val="hidden"/>
                                      </p:to>
                                    </p:set>
                                  </p:subTnLst>
                                </p:cTn>
                              </p:par>
                            </p:childTnLst>
                          </p:cTn>
                        </p:par>
                      </p:childTnLst>
                    </p:cTn>
                  </p:par>
                </p:childTnLst>
              </p:cTn>
              <p:nextCondLst>
                <p:cond evt="onClick" delay="0">
                  <p:tgtEl>
                    <p:spTgt spid="251"/>
                  </p:tgtEl>
                </p:cond>
              </p:nextCondLst>
            </p:seq>
            <p:seq concurrent="1" nextAc="seek">
              <p:cTn id="56" restart="whenNotActive" fill="hold" evtFilter="cancelBubble" nodeType="interactiveSeq">
                <p:stCondLst>
                  <p:cond evt="onClick" delay="0">
                    <p:tgtEl>
                      <p:spTgt spid="252"/>
                    </p:tgtEl>
                  </p:cond>
                </p:stCondLst>
                <p:endSync evt="end" delay="0">
                  <p:rtn val="all"/>
                </p:endSync>
                <p:childTnLst>
                  <p:par>
                    <p:cTn id="57" fill="hold">
                      <p:stCondLst>
                        <p:cond delay="0"/>
                      </p:stCondLst>
                      <p:childTnLst>
                        <p:par>
                          <p:cTn id="58" fill="hold">
                            <p:stCondLst>
                              <p:cond delay="0"/>
                            </p:stCondLst>
                            <p:childTnLst>
                              <p:par>
                                <p:cTn id="59" presetID="10" presetClass="exit" presetSubtype="0" fill="hold" grpId="0" nodeType="clickEffect">
                                  <p:stCondLst>
                                    <p:cond delay="0"/>
                                  </p:stCondLst>
                                  <p:childTnLst>
                                    <p:animEffect transition="out" filter="fade">
                                      <p:cBhvr>
                                        <p:cTn id="60" dur="500"/>
                                        <p:tgtEl>
                                          <p:spTgt spid="252"/>
                                        </p:tgtEl>
                                      </p:cBhvr>
                                    </p:animEffect>
                                    <p:set>
                                      <p:cBhvr>
                                        <p:cTn id="61" dur="1" fill="hold">
                                          <p:stCondLst>
                                            <p:cond delay="499"/>
                                          </p:stCondLst>
                                        </p:cTn>
                                        <p:tgtEl>
                                          <p:spTgt spid="252"/>
                                        </p:tgtEl>
                                        <p:attrNameLst>
                                          <p:attrName>style.visibility</p:attrName>
                                        </p:attrNameLst>
                                      </p:cBhvr>
                                      <p:to>
                                        <p:strVal val="hidden"/>
                                      </p:to>
                                    </p:set>
                                  </p:childTnLst>
                                  <p:subTnLst>
                                    <p:set>
                                      <p:cBhvr override="childStyle">
                                        <p:cTn dur="1" fill="hold" display="0" masterRel="sameClick" afterEffect="1">
                                          <p:stCondLst>
                                            <p:cond evt="end" delay="0">
                                              <p:tn val="59"/>
                                            </p:cond>
                                          </p:stCondLst>
                                        </p:cTn>
                                        <p:tgtEl>
                                          <p:spTgt spid="252"/>
                                        </p:tgtEl>
                                        <p:attrNameLst>
                                          <p:attrName>style.visibility</p:attrName>
                                        </p:attrNameLst>
                                      </p:cBhvr>
                                      <p:to>
                                        <p:strVal val="hidden"/>
                                      </p:to>
                                    </p:set>
                                  </p:subTnLst>
                                </p:cTn>
                              </p:par>
                            </p:childTnLst>
                          </p:cTn>
                        </p:par>
                      </p:childTnLst>
                    </p:cTn>
                  </p:par>
                </p:childTnLst>
              </p:cTn>
              <p:nextCondLst>
                <p:cond evt="onClick" delay="0">
                  <p:tgtEl>
                    <p:spTgt spid="252"/>
                  </p:tgtEl>
                </p:cond>
              </p:nextCondLst>
            </p:seq>
            <p:seq concurrent="1" nextAc="seek">
              <p:cTn id="62" restart="whenNotActive" fill="hold" evtFilter="cancelBubble" nodeType="interactiveSeq">
                <p:stCondLst>
                  <p:cond evt="onClick" delay="0">
                    <p:tgtEl>
                      <p:spTgt spid="253"/>
                    </p:tgtEl>
                  </p:cond>
                </p:stCondLst>
                <p:endSync evt="end" delay="0">
                  <p:rtn val="all"/>
                </p:endSync>
                <p:childTnLst>
                  <p:par>
                    <p:cTn id="63" fill="hold">
                      <p:stCondLst>
                        <p:cond delay="0"/>
                      </p:stCondLst>
                      <p:childTnLst>
                        <p:par>
                          <p:cTn id="64" fill="hold">
                            <p:stCondLst>
                              <p:cond delay="0"/>
                            </p:stCondLst>
                            <p:childTnLst>
                              <p:par>
                                <p:cTn id="65" presetID="10" presetClass="exit" presetSubtype="0" fill="hold" grpId="0" nodeType="clickEffect">
                                  <p:stCondLst>
                                    <p:cond delay="0"/>
                                  </p:stCondLst>
                                  <p:childTnLst>
                                    <p:animEffect transition="out" filter="fade">
                                      <p:cBhvr>
                                        <p:cTn id="66" dur="500"/>
                                        <p:tgtEl>
                                          <p:spTgt spid="253"/>
                                        </p:tgtEl>
                                      </p:cBhvr>
                                    </p:animEffect>
                                    <p:set>
                                      <p:cBhvr>
                                        <p:cTn id="67" dur="1" fill="hold">
                                          <p:stCondLst>
                                            <p:cond delay="499"/>
                                          </p:stCondLst>
                                        </p:cTn>
                                        <p:tgtEl>
                                          <p:spTgt spid="253"/>
                                        </p:tgtEl>
                                        <p:attrNameLst>
                                          <p:attrName>style.visibility</p:attrName>
                                        </p:attrNameLst>
                                      </p:cBhvr>
                                      <p:to>
                                        <p:strVal val="hidden"/>
                                      </p:to>
                                    </p:set>
                                  </p:childTnLst>
                                  <p:subTnLst>
                                    <p:set>
                                      <p:cBhvr override="childStyle">
                                        <p:cTn dur="1" fill="hold" display="0" masterRel="sameClick" afterEffect="1">
                                          <p:stCondLst>
                                            <p:cond evt="end" delay="0">
                                              <p:tn val="65"/>
                                            </p:cond>
                                          </p:stCondLst>
                                        </p:cTn>
                                        <p:tgtEl>
                                          <p:spTgt spid="253"/>
                                        </p:tgtEl>
                                        <p:attrNameLst>
                                          <p:attrName>style.visibility</p:attrName>
                                        </p:attrNameLst>
                                      </p:cBhvr>
                                      <p:to>
                                        <p:strVal val="hidden"/>
                                      </p:to>
                                    </p:set>
                                  </p:subTnLst>
                                </p:cTn>
                              </p:par>
                            </p:childTnLst>
                          </p:cTn>
                        </p:par>
                      </p:childTnLst>
                    </p:cTn>
                  </p:par>
                </p:childTnLst>
              </p:cTn>
              <p:nextCondLst>
                <p:cond evt="onClick" delay="0">
                  <p:tgtEl>
                    <p:spTgt spid="253"/>
                  </p:tgtEl>
                </p:cond>
              </p:nextCondLst>
            </p:seq>
            <p:seq concurrent="1" nextAc="seek">
              <p:cTn id="68" restart="whenNotActive" fill="hold" evtFilter="cancelBubble" nodeType="interactiveSeq">
                <p:stCondLst>
                  <p:cond evt="onClick" delay="0">
                    <p:tgtEl>
                      <p:spTgt spid="254"/>
                    </p:tgtEl>
                  </p:cond>
                </p:stCondLst>
                <p:endSync evt="end" delay="0">
                  <p:rtn val="all"/>
                </p:endSync>
                <p:childTnLst>
                  <p:par>
                    <p:cTn id="69" fill="hold">
                      <p:stCondLst>
                        <p:cond delay="0"/>
                      </p:stCondLst>
                      <p:childTnLst>
                        <p:par>
                          <p:cTn id="70" fill="hold">
                            <p:stCondLst>
                              <p:cond delay="0"/>
                            </p:stCondLst>
                            <p:childTnLst>
                              <p:par>
                                <p:cTn id="71" presetID="10" presetClass="exit" presetSubtype="0" fill="hold" grpId="0" nodeType="clickEffect">
                                  <p:stCondLst>
                                    <p:cond delay="0"/>
                                  </p:stCondLst>
                                  <p:childTnLst>
                                    <p:animEffect transition="out" filter="fade">
                                      <p:cBhvr>
                                        <p:cTn id="72" dur="500"/>
                                        <p:tgtEl>
                                          <p:spTgt spid="254"/>
                                        </p:tgtEl>
                                      </p:cBhvr>
                                    </p:animEffect>
                                    <p:set>
                                      <p:cBhvr>
                                        <p:cTn id="73" dur="1" fill="hold">
                                          <p:stCondLst>
                                            <p:cond delay="499"/>
                                          </p:stCondLst>
                                        </p:cTn>
                                        <p:tgtEl>
                                          <p:spTgt spid="254"/>
                                        </p:tgtEl>
                                        <p:attrNameLst>
                                          <p:attrName>style.visibility</p:attrName>
                                        </p:attrNameLst>
                                      </p:cBhvr>
                                      <p:to>
                                        <p:strVal val="hidden"/>
                                      </p:to>
                                    </p:set>
                                  </p:childTnLst>
                                  <p:subTnLst>
                                    <p:set>
                                      <p:cBhvr override="childStyle">
                                        <p:cTn dur="1" fill="hold" display="0" masterRel="sameClick" afterEffect="1">
                                          <p:stCondLst>
                                            <p:cond evt="end" delay="0">
                                              <p:tn val="71"/>
                                            </p:cond>
                                          </p:stCondLst>
                                        </p:cTn>
                                        <p:tgtEl>
                                          <p:spTgt spid="254"/>
                                        </p:tgtEl>
                                        <p:attrNameLst>
                                          <p:attrName>style.visibility</p:attrName>
                                        </p:attrNameLst>
                                      </p:cBhvr>
                                      <p:to>
                                        <p:strVal val="hidden"/>
                                      </p:to>
                                    </p:set>
                                  </p:subTnLst>
                                </p:cTn>
                              </p:par>
                            </p:childTnLst>
                          </p:cTn>
                        </p:par>
                      </p:childTnLst>
                    </p:cTn>
                  </p:par>
                </p:childTnLst>
              </p:cTn>
              <p:nextCondLst>
                <p:cond evt="onClick" delay="0">
                  <p:tgtEl>
                    <p:spTgt spid="254"/>
                  </p:tgtEl>
                </p:cond>
              </p:nextCondLst>
            </p:seq>
            <p:seq concurrent="1" nextAc="seek">
              <p:cTn id="74" restart="whenNotActive" fill="hold" evtFilter="cancelBubble" nodeType="interactiveSeq">
                <p:stCondLst>
                  <p:cond evt="onClick" delay="0">
                    <p:tgtEl>
                      <p:spTgt spid="255"/>
                    </p:tgtEl>
                  </p:cond>
                </p:stCondLst>
                <p:endSync evt="end" delay="0">
                  <p:rtn val="all"/>
                </p:endSync>
                <p:childTnLst>
                  <p:par>
                    <p:cTn id="75" fill="hold">
                      <p:stCondLst>
                        <p:cond delay="0"/>
                      </p:stCondLst>
                      <p:childTnLst>
                        <p:par>
                          <p:cTn id="76" fill="hold">
                            <p:stCondLst>
                              <p:cond delay="0"/>
                            </p:stCondLst>
                            <p:childTnLst>
                              <p:par>
                                <p:cTn id="77" presetID="10" presetClass="exit" presetSubtype="0" fill="hold" grpId="0" nodeType="clickEffect">
                                  <p:stCondLst>
                                    <p:cond delay="0"/>
                                  </p:stCondLst>
                                  <p:childTnLst>
                                    <p:animEffect transition="out" filter="fade">
                                      <p:cBhvr>
                                        <p:cTn id="78" dur="500"/>
                                        <p:tgtEl>
                                          <p:spTgt spid="255"/>
                                        </p:tgtEl>
                                      </p:cBhvr>
                                    </p:animEffect>
                                    <p:set>
                                      <p:cBhvr>
                                        <p:cTn id="79" dur="1" fill="hold">
                                          <p:stCondLst>
                                            <p:cond delay="499"/>
                                          </p:stCondLst>
                                        </p:cTn>
                                        <p:tgtEl>
                                          <p:spTgt spid="255"/>
                                        </p:tgtEl>
                                        <p:attrNameLst>
                                          <p:attrName>style.visibility</p:attrName>
                                        </p:attrNameLst>
                                      </p:cBhvr>
                                      <p:to>
                                        <p:strVal val="hidden"/>
                                      </p:to>
                                    </p:set>
                                  </p:childTnLst>
                                  <p:subTnLst>
                                    <p:set>
                                      <p:cBhvr override="childStyle">
                                        <p:cTn dur="1" fill="hold" display="0" masterRel="sameClick" afterEffect="1">
                                          <p:stCondLst>
                                            <p:cond evt="end" delay="0">
                                              <p:tn val="77"/>
                                            </p:cond>
                                          </p:stCondLst>
                                        </p:cTn>
                                        <p:tgtEl>
                                          <p:spTgt spid="255"/>
                                        </p:tgtEl>
                                        <p:attrNameLst>
                                          <p:attrName>style.visibility</p:attrName>
                                        </p:attrNameLst>
                                      </p:cBhvr>
                                      <p:to>
                                        <p:strVal val="hidden"/>
                                      </p:to>
                                    </p:set>
                                  </p:subTnLst>
                                </p:cTn>
                              </p:par>
                            </p:childTnLst>
                          </p:cTn>
                        </p:par>
                      </p:childTnLst>
                    </p:cTn>
                  </p:par>
                </p:childTnLst>
              </p:cTn>
              <p:nextCondLst>
                <p:cond evt="onClick" delay="0">
                  <p:tgtEl>
                    <p:spTgt spid="255"/>
                  </p:tgtEl>
                </p:cond>
              </p:nextCondLst>
            </p:seq>
            <p:seq concurrent="1" nextAc="seek">
              <p:cTn id="80" restart="whenNotActive" fill="hold" evtFilter="cancelBubble" nodeType="interactiveSeq">
                <p:stCondLst>
                  <p:cond evt="onClick" delay="0">
                    <p:tgtEl>
                      <p:spTgt spid="256"/>
                    </p:tgtEl>
                  </p:cond>
                </p:stCondLst>
                <p:endSync evt="end" delay="0">
                  <p:rtn val="all"/>
                </p:endSync>
                <p:childTnLst>
                  <p:par>
                    <p:cTn id="81" fill="hold">
                      <p:stCondLst>
                        <p:cond delay="0"/>
                      </p:stCondLst>
                      <p:childTnLst>
                        <p:par>
                          <p:cTn id="82" fill="hold">
                            <p:stCondLst>
                              <p:cond delay="0"/>
                            </p:stCondLst>
                            <p:childTnLst>
                              <p:par>
                                <p:cTn id="83" presetID="10" presetClass="exit" presetSubtype="0" fill="hold" grpId="0" nodeType="clickEffect">
                                  <p:stCondLst>
                                    <p:cond delay="0"/>
                                  </p:stCondLst>
                                  <p:childTnLst>
                                    <p:animEffect transition="out" filter="fade">
                                      <p:cBhvr>
                                        <p:cTn id="84" dur="500"/>
                                        <p:tgtEl>
                                          <p:spTgt spid="256"/>
                                        </p:tgtEl>
                                      </p:cBhvr>
                                    </p:animEffect>
                                    <p:set>
                                      <p:cBhvr>
                                        <p:cTn id="85" dur="1" fill="hold">
                                          <p:stCondLst>
                                            <p:cond delay="499"/>
                                          </p:stCondLst>
                                        </p:cTn>
                                        <p:tgtEl>
                                          <p:spTgt spid="256"/>
                                        </p:tgtEl>
                                        <p:attrNameLst>
                                          <p:attrName>style.visibility</p:attrName>
                                        </p:attrNameLst>
                                      </p:cBhvr>
                                      <p:to>
                                        <p:strVal val="hidden"/>
                                      </p:to>
                                    </p:set>
                                  </p:childTnLst>
                                  <p:subTnLst>
                                    <p:set>
                                      <p:cBhvr override="childStyle">
                                        <p:cTn dur="1" fill="hold" display="0" masterRel="sameClick" afterEffect="1">
                                          <p:stCondLst>
                                            <p:cond evt="end" delay="0">
                                              <p:tn val="83"/>
                                            </p:cond>
                                          </p:stCondLst>
                                        </p:cTn>
                                        <p:tgtEl>
                                          <p:spTgt spid="256"/>
                                        </p:tgtEl>
                                        <p:attrNameLst>
                                          <p:attrName>style.visibility</p:attrName>
                                        </p:attrNameLst>
                                      </p:cBhvr>
                                      <p:to>
                                        <p:strVal val="hidden"/>
                                      </p:to>
                                    </p:set>
                                  </p:subTnLst>
                                </p:cTn>
                              </p:par>
                            </p:childTnLst>
                          </p:cTn>
                        </p:par>
                      </p:childTnLst>
                    </p:cTn>
                  </p:par>
                </p:childTnLst>
              </p:cTn>
              <p:nextCondLst>
                <p:cond evt="onClick" delay="0">
                  <p:tgtEl>
                    <p:spTgt spid="256"/>
                  </p:tgtEl>
                </p:cond>
              </p:nextCondLst>
            </p:seq>
            <p:seq concurrent="1" nextAc="seek">
              <p:cTn id="86" restart="whenNotActive" fill="hold" evtFilter="cancelBubble" nodeType="interactiveSeq">
                <p:stCondLst>
                  <p:cond evt="onClick" delay="0">
                    <p:tgtEl>
                      <p:spTgt spid="257"/>
                    </p:tgtEl>
                  </p:cond>
                </p:stCondLst>
                <p:endSync evt="end" delay="0">
                  <p:rtn val="all"/>
                </p:endSync>
                <p:childTnLst>
                  <p:par>
                    <p:cTn id="87" fill="hold">
                      <p:stCondLst>
                        <p:cond delay="0"/>
                      </p:stCondLst>
                      <p:childTnLst>
                        <p:par>
                          <p:cTn id="88" fill="hold">
                            <p:stCondLst>
                              <p:cond delay="0"/>
                            </p:stCondLst>
                            <p:childTnLst>
                              <p:par>
                                <p:cTn id="89" presetID="10" presetClass="exit" presetSubtype="0" fill="hold" grpId="0" nodeType="clickEffect">
                                  <p:stCondLst>
                                    <p:cond delay="0"/>
                                  </p:stCondLst>
                                  <p:childTnLst>
                                    <p:animEffect transition="out" filter="fade">
                                      <p:cBhvr>
                                        <p:cTn id="90" dur="500"/>
                                        <p:tgtEl>
                                          <p:spTgt spid="257"/>
                                        </p:tgtEl>
                                      </p:cBhvr>
                                    </p:animEffect>
                                    <p:set>
                                      <p:cBhvr>
                                        <p:cTn id="91" dur="1" fill="hold">
                                          <p:stCondLst>
                                            <p:cond delay="499"/>
                                          </p:stCondLst>
                                        </p:cTn>
                                        <p:tgtEl>
                                          <p:spTgt spid="257"/>
                                        </p:tgtEl>
                                        <p:attrNameLst>
                                          <p:attrName>style.visibility</p:attrName>
                                        </p:attrNameLst>
                                      </p:cBhvr>
                                      <p:to>
                                        <p:strVal val="hidden"/>
                                      </p:to>
                                    </p:set>
                                  </p:childTnLst>
                                  <p:subTnLst>
                                    <p:set>
                                      <p:cBhvr override="childStyle">
                                        <p:cTn dur="1" fill="hold" display="0" masterRel="sameClick" afterEffect="1">
                                          <p:stCondLst>
                                            <p:cond evt="end" delay="0">
                                              <p:tn val="89"/>
                                            </p:cond>
                                          </p:stCondLst>
                                        </p:cTn>
                                        <p:tgtEl>
                                          <p:spTgt spid="257"/>
                                        </p:tgtEl>
                                        <p:attrNameLst>
                                          <p:attrName>style.visibility</p:attrName>
                                        </p:attrNameLst>
                                      </p:cBhvr>
                                      <p:to>
                                        <p:strVal val="hidden"/>
                                      </p:to>
                                    </p:set>
                                  </p:subTnLst>
                                </p:cTn>
                              </p:par>
                            </p:childTnLst>
                          </p:cTn>
                        </p:par>
                      </p:childTnLst>
                    </p:cTn>
                  </p:par>
                </p:childTnLst>
              </p:cTn>
              <p:nextCondLst>
                <p:cond evt="onClick" delay="0">
                  <p:tgtEl>
                    <p:spTgt spid="257"/>
                  </p:tgtEl>
                </p:cond>
              </p:nextCondLst>
            </p:seq>
            <p:seq concurrent="1" nextAc="seek">
              <p:cTn id="92" restart="whenNotActive" fill="hold" evtFilter="cancelBubble" nodeType="interactiveSeq">
                <p:stCondLst>
                  <p:cond evt="onClick" delay="0">
                    <p:tgtEl>
                      <p:spTgt spid="258"/>
                    </p:tgtEl>
                  </p:cond>
                </p:stCondLst>
                <p:endSync evt="end" delay="0">
                  <p:rtn val="all"/>
                </p:endSync>
                <p:childTnLst>
                  <p:par>
                    <p:cTn id="93" fill="hold">
                      <p:stCondLst>
                        <p:cond delay="0"/>
                      </p:stCondLst>
                      <p:childTnLst>
                        <p:par>
                          <p:cTn id="94" fill="hold">
                            <p:stCondLst>
                              <p:cond delay="0"/>
                            </p:stCondLst>
                            <p:childTnLst>
                              <p:par>
                                <p:cTn id="95" presetID="10" presetClass="exit" presetSubtype="0" fill="hold" grpId="0" nodeType="clickEffect">
                                  <p:stCondLst>
                                    <p:cond delay="0"/>
                                  </p:stCondLst>
                                  <p:childTnLst>
                                    <p:animEffect transition="out" filter="fade">
                                      <p:cBhvr>
                                        <p:cTn id="96" dur="500"/>
                                        <p:tgtEl>
                                          <p:spTgt spid="258"/>
                                        </p:tgtEl>
                                      </p:cBhvr>
                                    </p:animEffect>
                                    <p:set>
                                      <p:cBhvr>
                                        <p:cTn id="97" dur="1" fill="hold">
                                          <p:stCondLst>
                                            <p:cond delay="499"/>
                                          </p:stCondLst>
                                        </p:cTn>
                                        <p:tgtEl>
                                          <p:spTgt spid="258"/>
                                        </p:tgtEl>
                                        <p:attrNameLst>
                                          <p:attrName>style.visibility</p:attrName>
                                        </p:attrNameLst>
                                      </p:cBhvr>
                                      <p:to>
                                        <p:strVal val="hidden"/>
                                      </p:to>
                                    </p:set>
                                  </p:childTnLst>
                                  <p:subTnLst>
                                    <p:set>
                                      <p:cBhvr override="childStyle">
                                        <p:cTn dur="1" fill="hold" display="0" masterRel="sameClick" afterEffect="1">
                                          <p:stCondLst>
                                            <p:cond evt="end" delay="0">
                                              <p:tn val="95"/>
                                            </p:cond>
                                          </p:stCondLst>
                                        </p:cTn>
                                        <p:tgtEl>
                                          <p:spTgt spid="258"/>
                                        </p:tgtEl>
                                        <p:attrNameLst>
                                          <p:attrName>style.visibility</p:attrName>
                                        </p:attrNameLst>
                                      </p:cBhvr>
                                      <p:to>
                                        <p:strVal val="hidden"/>
                                      </p:to>
                                    </p:set>
                                  </p:subTnLst>
                                </p:cTn>
                              </p:par>
                            </p:childTnLst>
                          </p:cTn>
                        </p:par>
                      </p:childTnLst>
                    </p:cTn>
                  </p:par>
                </p:childTnLst>
              </p:cTn>
              <p:nextCondLst>
                <p:cond evt="onClick" delay="0">
                  <p:tgtEl>
                    <p:spTgt spid="258"/>
                  </p:tgtEl>
                </p:cond>
              </p:nextCondLst>
            </p:seq>
            <p:seq concurrent="1" nextAc="seek">
              <p:cTn id="98" restart="whenNotActive" fill="hold" evtFilter="cancelBubble" nodeType="interactiveSeq">
                <p:stCondLst>
                  <p:cond evt="onClick" delay="0">
                    <p:tgtEl>
                      <p:spTgt spid="259"/>
                    </p:tgtEl>
                  </p:cond>
                </p:stCondLst>
                <p:endSync evt="end" delay="0">
                  <p:rtn val="all"/>
                </p:endSync>
                <p:childTnLst>
                  <p:par>
                    <p:cTn id="99" fill="hold">
                      <p:stCondLst>
                        <p:cond delay="0"/>
                      </p:stCondLst>
                      <p:childTnLst>
                        <p:par>
                          <p:cTn id="100" fill="hold">
                            <p:stCondLst>
                              <p:cond delay="0"/>
                            </p:stCondLst>
                            <p:childTnLst>
                              <p:par>
                                <p:cTn id="101" presetID="10" presetClass="exit" presetSubtype="0" fill="hold" grpId="0" nodeType="clickEffect">
                                  <p:stCondLst>
                                    <p:cond delay="0"/>
                                  </p:stCondLst>
                                  <p:childTnLst>
                                    <p:animEffect transition="out" filter="fade">
                                      <p:cBhvr>
                                        <p:cTn id="102" dur="500"/>
                                        <p:tgtEl>
                                          <p:spTgt spid="259"/>
                                        </p:tgtEl>
                                      </p:cBhvr>
                                    </p:animEffect>
                                    <p:set>
                                      <p:cBhvr>
                                        <p:cTn id="103" dur="1" fill="hold">
                                          <p:stCondLst>
                                            <p:cond delay="499"/>
                                          </p:stCondLst>
                                        </p:cTn>
                                        <p:tgtEl>
                                          <p:spTgt spid="259"/>
                                        </p:tgtEl>
                                        <p:attrNameLst>
                                          <p:attrName>style.visibility</p:attrName>
                                        </p:attrNameLst>
                                      </p:cBhvr>
                                      <p:to>
                                        <p:strVal val="hidden"/>
                                      </p:to>
                                    </p:set>
                                  </p:childTnLst>
                                  <p:subTnLst>
                                    <p:set>
                                      <p:cBhvr override="childStyle">
                                        <p:cTn dur="1" fill="hold" display="0" masterRel="sameClick" afterEffect="1">
                                          <p:stCondLst>
                                            <p:cond evt="end" delay="0">
                                              <p:tn val="101"/>
                                            </p:cond>
                                          </p:stCondLst>
                                        </p:cTn>
                                        <p:tgtEl>
                                          <p:spTgt spid="259"/>
                                        </p:tgtEl>
                                        <p:attrNameLst>
                                          <p:attrName>style.visibility</p:attrName>
                                        </p:attrNameLst>
                                      </p:cBhvr>
                                      <p:to>
                                        <p:strVal val="hidden"/>
                                      </p:to>
                                    </p:set>
                                  </p:subTnLst>
                                </p:cTn>
                              </p:par>
                            </p:childTnLst>
                          </p:cTn>
                        </p:par>
                      </p:childTnLst>
                    </p:cTn>
                  </p:par>
                </p:childTnLst>
              </p:cTn>
              <p:nextCondLst>
                <p:cond evt="onClick" delay="0">
                  <p:tgtEl>
                    <p:spTgt spid="259"/>
                  </p:tgtEl>
                </p:cond>
              </p:nextCondLst>
            </p:seq>
            <p:seq concurrent="1" nextAc="seek">
              <p:cTn id="104" restart="whenNotActive" fill="hold" evtFilter="cancelBubble" nodeType="interactiveSeq">
                <p:stCondLst>
                  <p:cond evt="onClick" delay="0">
                    <p:tgtEl>
                      <p:spTgt spid="260"/>
                    </p:tgtEl>
                  </p:cond>
                </p:stCondLst>
                <p:endSync evt="end" delay="0">
                  <p:rtn val="all"/>
                </p:endSync>
                <p:childTnLst>
                  <p:par>
                    <p:cTn id="105" fill="hold">
                      <p:stCondLst>
                        <p:cond delay="0"/>
                      </p:stCondLst>
                      <p:childTnLst>
                        <p:par>
                          <p:cTn id="106" fill="hold">
                            <p:stCondLst>
                              <p:cond delay="0"/>
                            </p:stCondLst>
                            <p:childTnLst>
                              <p:par>
                                <p:cTn id="107" presetID="10" presetClass="exit" presetSubtype="0" fill="hold" grpId="0" nodeType="clickEffect">
                                  <p:stCondLst>
                                    <p:cond delay="0"/>
                                  </p:stCondLst>
                                  <p:childTnLst>
                                    <p:animEffect transition="out" filter="fade">
                                      <p:cBhvr>
                                        <p:cTn id="108" dur="500"/>
                                        <p:tgtEl>
                                          <p:spTgt spid="260"/>
                                        </p:tgtEl>
                                      </p:cBhvr>
                                    </p:animEffect>
                                    <p:set>
                                      <p:cBhvr>
                                        <p:cTn id="109" dur="1" fill="hold">
                                          <p:stCondLst>
                                            <p:cond delay="499"/>
                                          </p:stCondLst>
                                        </p:cTn>
                                        <p:tgtEl>
                                          <p:spTgt spid="260"/>
                                        </p:tgtEl>
                                        <p:attrNameLst>
                                          <p:attrName>style.visibility</p:attrName>
                                        </p:attrNameLst>
                                      </p:cBhvr>
                                      <p:to>
                                        <p:strVal val="hidden"/>
                                      </p:to>
                                    </p:set>
                                  </p:childTnLst>
                                  <p:subTnLst>
                                    <p:set>
                                      <p:cBhvr override="childStyle">
                                        <p:cTn dur="1" fill="hold" display="0" masterRel="sameClick" afterEffect="1">
                                          <p:stCondLst>
                                            <p:cond evt="end" delay="0">
                                              <p:tn val="107"/>
                                            </p:cond>
                                          </p:stCondLst>
                                        </p:cTn>
                                        <p:tgtEl>
                                          <p:spTgt spid="260"/>
                                        </p:tgtEl>
                                        <p:attrNameLst>
                                          <p:attrName>style.visibility</p:attrName>
                                        </p:attrNameLst>
                                      </p:cBhvr>
                                      <p:to>
                                        <p:strVal val="hidden"/>
                                      </p:to>
                                    </p:set>
                                  </p:subTnLst>
                                </p:cTn>
                              </p:par>
                            </p:childTnLst>
                          </p:cTn>
                        </p:par>
                      </p:childTnLst>
                    </p:cTn>
                  </p:par>
                </p:childTnLst>
              </p:cTn>
              <p:nextCondLst>
                <p:cond evt="onClick" delay="0">
                  <p:tgtEl>
                    <p:spTgt spid="260"/>
                  </p:tgtEl>
                </p:cond>
              </p:nextCondLst>
            </p:seq>
            <p:seq concurrent="1" nextAc="seek">
              <p:cTn id="110" restart="whenNotActive" fill="hold" evtFilter="cancelBubble" nodeType="interactiveSeq">
                <p:stCondLst>
                  <p:cond evt="onClick" delay="0">
                    <p:tgtEl>
                      <p:spTgt spid="261"/>
                    </p:tgtEl>
                  </p:cond>
                </p:stCondLst>
                <p:endSync evt="end" delay="0">
                  <p:rtn val="all"/>
                </p:endSync>
                <p:childTnLst>
                  <p:par>
                    <p:cTn id="111" fill="hold">
                      <p:stCondLst>
                        <p:cond delay="0"/>
                      </p:stCondLst>
                      <p:childTnLst>
                        <p:par>
                          <p:cTn id="112" fill="hold">
                            <p:stCondLst>
                              <p:cond delay="0"/>
                            </p:stCondLst>
                            <p:childTnLst>
                              <p:par>
                                <p:cTn id="113" presetID="10" presetClass="exit" presetSubtype="0" fill="hold" grpId="0" nodeType="clickEffect">
                                  <p:stCondLst>
                                    <p:cond delay="0"/>
                                  </p:stCondLst>
                                  <p:childTnLst>
                                    <p:animEffect transition="out" filter="fade">
                                      <p:cBhvr>
                                        <p:cTn id="114" dur="500"/>
                                        <p:tgtEl>
                                          <p:spTgt spid="261"/>
                                        </p:tgtEl>
                                      </p:cBhvr>
                                    </p:animEffect>
                                    <p:set>
                                      <p:cBhvr>
                                        <p:cTn id="115" dur="1" fill="hold">
                                          <p:stCondLst>
                                            <p:cond delay="499"/>
                                          </p:stCondLst>
                                        </p:cTn>
                                        <p:tgtEl>
                                          <p:spTgt spid="261"/>
                                        </p:tgtEl>
                                        <p:attrNameLst>
                                          <p:attrName>style.visibility</p:attrName>
                                        </p:attrNameLst>
                                      </p:cBhvr>
                                      <p:to>
                                        <p:strVal val="hidden"/>
                                      </p:to>
                                    </p:set>
                                  </p:childTnLst>
                                  <p:subTnLst>
                                    <p:set>
                                      <p:cBhvr override="childStyle">
                                        <p:cTn dur="1" fill="hold" display="0" masterRel="sameClick" afterEffect="1">
                                          <p:stCondLst>
                                            <p:cond evt="end" delay="0">
                                              <p:tn val="113"/>
                                            </p:cond>
                                          </p:stCondLst>
                                        </p:cTn>
                                        <p:tgtEl>
                                          <p:spTgt spid="261"/>
                                        </p:tgtEl>
                                        <p:attrNameLst>
                                          <p:attrName>style.visibility</p:attrName>
                                        </p:attrNameLst>
                                      </p:cBhvr>
                                      <p:to>
                                        <p:strVal val="hidden"/>
                                      </p:to>
                                    </p:set>
                                  </p:subTnLst>
                                </p:cTn>
                              </p:par>
                            </p:childTnLst>
                          </p:cTn>
                        </p:par>
                      </p:childTnLst>
                    </p:cTn>
                  </p:par>
                </p:childTnLst>
              </p:cTn>
              <p:nextCondLst>
                <p:cond evt="onClick" delay="0">
                  <p:tgtEl>
                    <p:spTgt spid="261"/>
                  </p:tgtEl>
                </p:cond>
              </p:nextCondLst>
            </p:seq>
            <p:seq concurrent="1" nextAc="seek">
              <p:cTn id="116" restart="whenNotActive" fill="hold" evtFilter="cancelBubble" nodeType="interactiveSeq">
                <p:stCondLst>
                  <p:cond evt="onClick" delay="0">
                    <p:tgtEl>
                      <p:spTgt spid="262"/>
                    </p:tgtEl>
                  </p:cond>
                </p:stCondLst>
                <p:endSync evt="end" delay="0">
                  <p:rtn val="all"/>
                </p:endSync>
                <p:childTnLst>
                  <p:par>
                    <p:cTn id="117" fill="hold">
                      <p:stCondLst>
                        <p:cond delay="0"/>
                      </p:stCondLst>
                      <p:childTnLst>
                        <p:par>
                          <p:cTn id="118" fill="hold">
                            <p:stCondLst>
                              <p:cond delay="0"/>
                            </p:stCondLst>
                            <p:childTnLst>
                              <p:par>
                                <p:cTn id="119" presetID="10" presetClass="exit" presetSubtype="0" fill="hold" grpId="0" nodeType="clickEffect">
                                  <p:stCondLst>
                                    <p:cond delay="0"/>
                                  </p:stCondLst>
                                  <p:childTnLst>
                                    <p:animEffect transition="out" filter="fade">
                                      <p:cBhvr>
                                        <p:cTn id="120" dur="500"/>
                                        <p:tgtEl>
                                          <p:spTgt spid="262"/>
                                        </p:tgtEl>
                                      </p:cBhvr>
                                    </p:animEffect>
                                    <p:set>
                                      <p:cBhvr>
                                        <p:cTn id="121" dur="1" fill="hold">
                                          <p:stCondLst>
                                            <p:cond delay="499"/>
                                          </p:stCondLst>
                                        </p:cTn>
                                        <p:tgtEl>
                                          <p:spTgt spid="262"/>
                                        </p:tgtEl>
                                        <p:attrNameLst>
                                          <p:attrName>style.visibility</p:attrName>
                                        </p:attrNameLst>
                                      </p:cBhvr>
                                      <p:to>
                                        <p:strVal val="hidden"/>
                                      </p:to>
                                    </p:set>
                                  </p:childTnLst>
                                  <p:subTnLst>
                                    <p:set>
                                      <p:cBhvr override="childStyle">
                                        <p:cTn dur="1" fill="hold" display="0" masterRel="sameClick" afterEffect="1">
                                          <p:stCondLst>
                                            <p:cond evt="end" delay="0">
                                              <p:tn val="119"/>
                                            </p:cond>
                                          </p:stCondLst>
                                        </p:cTn>
                                        <p:tgtEl>
                                          <p:spTgt spid="262"/>
                                        </p:tgtEl>
                                        <p:attrNameLst>
                                          <p:attrName>style.visibility</p:attrName>
                                        </p:attrNameLst>
                                      </p:cBhvr>
                                      <p:to>
                                        <p:strVal val="hidden"/>
                                      </p:to>
                                    </p:set>
                                  </p:subTnLst>
                                </p:cTn>
                              </p:par>
                            </p:childTnLst>
                          </p:cTn>
                        </p:par>
                      </p:childTnLst>
                    </p:cTn>
                  </p:par>
                </p:childTnLst>
              </p:cTn>
              <p:nextCondLst>
                <p:cond evt="onClick" delay="0">
                  <p:tgtEl>
                    <p:spTgt spid="262"/>
                  </p:tgtEl>
                </p:cond>
              </p:nextCondLst>
            </p:seq>
          </p:childTnLst>
        </p:cTn>
      </p:par>
    </p:tnLst>
    <p:bldLst>
      <p:bldP spid="243" grpId="0"/>
      <p:bldP spid="244" grpId="0"/>
      <p:bldP spid="245" grpId="0"/>
      <p:bldP spid="246" grpId="0"/>
      <p:bldP spid="247" grpId="0"/>
      <p:bldP spid="248" grpId="0"/>
      <p:bldP spid="249" grpId="0"/>
      <p:bldP spid="250" grpId="0"/>
      <p:bldP spid="251" grpId="0"/>
      <p:bldP spid="252" grpId="0"/>
      <p:bldP spid="253" grpId="0"/>
      <p:bldP spid="254" grpId="0"/>
      <p:bldP spid="255" grpId="0"/>
      <p:bldP spid="256" grpId="0"/>
      <p:bldP spid="257" grpId="0"/>
      <p:bldP spid="258" grpId="0"/>
      <p:bldP spid="259" grpId="0"/>
      <p:bldP spid="260" grpId="0"/>
      <p:bldP spid="261" grpId="0"/>
      <p:bldP spid="262" grpId="0"/>
    </p:bld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591EE6-8BD1-4862-AEF1-9ED6CB99B92D}"/>
              </a:ext>
            </a:extLst>
          </p:cNvPr>
          <p:cNvSpPr>
            <a:spLocks noGrp="1"/>
          </p:cNvSpPr>
          <p:nvPr>
            <p:ph type="title"/>
          </p:nvPr>
        </p:nvSpPr>
        <p:spPr/>
        <p:txBody>
          <a:bodyPr/>
          <a:lstStyle/>
          <a:p>
            <a:endParaRPr lang="en-US"/>
          </a:p>
        </p:txBody>
      </p:sp>
      <p:sp>
        <p:nvSpPr>
          <p:cNvPr id="3" name="Subtitle 2">
            <a:extLst>
              <a:ext uri="{FF2B5EF4-FFF2-40B4-BE49-F238E27FC236}">
                <a16:creationId xmlns:a16="http://schemas.microsoft.com/office/drawing/2014/main" id="{F75479F5-0EE8-4D8D-B5E1-4B758B968743}"/>
              </a:ext>
            </a:extLst>
          </p:cNvPr>
          <p:cNvSpPr>
            <a:spLocks noGrp="1"/>
          </p:cNvSpPr>
          <p:nvPr>
            <p:ph type="subTitle" idx="1"/>
          </p:nvPr>
        </p:nvSpPr>
        <p:spPr/>
        <p:txBody>
          <a:bodyPr/>
          <a:lstStyle/>
          <a:p>
            <a:endParaRPr lang="en-US"/>
          </a:p>
        </p:txBody>
      </p:sp>
      <p:graphicFrame>
        <p:nvGraphicFramePr>
          <p:cNvPr id="4" name="Table 4">
            <a:extLst>
              <a:ext uri="{FF2B5EF4-FFF2-40B4-BE49-F238E27FC236}">
                <a16:creationId xmlns:a16="http://schemas.microsoft.com/office/drawing/2014/main" id="{2B64071D-04FB-4255-BEC0-AE4E7291A5F0}"/>
              </a:ext>
            </a:extLst>
          </p:cNvPr>
          <p:cNvGraphicFramePr>
            <a:graphicFrameLocks noGrp="1"/>
          </p:cNvGraphicFramePr>
          <p:nvPr>
            <p:extLst>
              <p:ext uri="{D42A27DB-BD31-4B8C-83A1-F6EECF244321}">
                <p14:modId xmlns:p14="http://schemas.microsoft.com/office/powerpoint/2010/main" val="812617919"/>
              </p:ext>
            </p:extLst>
          </p:nvPr>
        </p:nvGraphicFramePr>
        <p:xfrm>
          <a:off x="897086" y="945520"/>
          <a:ext cx="7362828" cy="2527050"/>
        </p:xfrm>
        <a:graphic>
          <a:graphicData uri="http://schemas.openxmlformats.org/drawingml/2006/table">
            <a:tbl>
              <a:tblPr firstRow="1" bandRow="1">
                <a:tableStyleId>{5C22544A-7EE6-4342-B048-85BDC9FD1C3A}</a:tableStyleId>
              </a:tblPr>
              <a:tblGrid>
                <a:gridCol w="1227138">
                  <a:extLst>
                    <a:ext uri="{9D8B030D-6E8A-4147-A177-3AD203B41FA5}">
                      <a16:colId xmlns:a16="http://schemas.microsoft.com/office/drawing/2014/main" val="2956672230"/>
                    </a:ext>
                  </a:extLst>
                </a:gridCol>
                <a:gridCol w="1227138">
                  <a:extLst>
                    <a:ext uri="{9D8B030D-6E8A-4147-A177-3AD203B41FA5}">
                      <a16:colId xmlns:a16="http://schemas.microsoft.com/office/drawing/2014/main" val="3366791402"/>
                    </a:ext>
                  </a:extLst>
                </a:gridCol>
                <a:gridCol w="1227138">
                  <a:extLst>
                    <a:ext uri="{9D8B030D-6E8A-4147-A177-3AD203B41FA5}">
                      <a16:colId xmlns:a16="http://schemas.microsoft.com/office/drawing/2014/main" val="1166372328"/>
                    </a:ext>
                  </a:extLst>
                </a:gridCol>
                <a:gridCol w="1227138">
                  <a:extLst>
                    <a:ext uri="{9D8B030D-6E8A-4147-A177-3AD203B41FA5}">
                      <a16:colId xmlns:a16="http://schemas.microsoft.com/office/drawing/2014/main" val="3425385262"/>
                    </a:ext>
                  </a:extLst>
                </a:gridCol>
                <a:gridCol w="1227138">
                  <a:extLst>
                    <a:ext uri="{9D8B030D-6E8A-4147-A177-3AD203B41FA5}">
                      <a16:colId xmlns:a16="http://schemas.microsoft.com/office/drawing/2014/main" val="1561456660"/>
                    </a:ext>
                  </a:extLst>
                </a:gridCol>
                <a:gridCol w="1227138">
                  <a:extLst>
                    <a:ext uri="{9D8B030D-6E8A-4147-A177-3AD203B41FA5}">
                      <a16:colId xmlns:a16="http://schemas.microsoft.com/office/drawing/2014/main" val="3670303674"/>
                    </a:ext>
                  </a:extLst>
                </a:gridCol>
              </a:tblGrid>
              <a:tr h="505410">
                <a:tc>
                  <a:txBody>
                    <a:bodyPr/>
                    <a:lstStyle/>
                    <a:p>
                      <a:pPr algn="ctr"/>
                      <a:r>
                        <a:rPr lang="en-US"/>
                        <a:t>pH</a:t>
                      </a:r>
                    </a:p>
                  </a:txBody>
                  <a:tcPr/>
                </a:tc>
                <a:tc>
                  <a:txBody>
                    <a:bodyPr/>
                    <a:lstStyle/>
                    <a:p>
                      <a:pPr algn="ctr"/>
                      <a:r>
                        <a:rPr lang="en-US"/>
                        <a:t>pCO2</a:t>
                      </a:r>
                    </a:p>
                  </a:txBody>
                  <a:tcPr/>
                </a:tc>
                <a:tc>
                  <a:txBody>
                    <a:bodyPr/>
                    <a:lstStyle/>
                    <a:p>
                      <a:pPr algn="ctr"/>
                      <a:r>
                        <a:rPr lang="en-US"/>
                        <a:t>HCO3-</a:t>
                      </a:r>
                    </a:p>
                  </a:txBody>
                  <a:tcPr/>
                </a:tc>
                <a:tc>
                  <a:txBody>
                    <a:bodyPr/>
                    <a:lstStyle/>
                    <a:p>
                      <a:pPr algn="ctr"/>
                      <a:r>
                        <a:rPr lang="en-US"/>
                        <a:t>Na+</a:t>
                      </a:r>
                    </a:p>
                  </a:txBody>
                  <a:tcPr/>
                </a:tc>
                <a:tc>
                  <a:txBody>
                    <a:bodyPr/>
                    <a:lstStyle/>
                    <a:p>
                      <a:pPr algn="ctr"/>
                      <a:r>
                        <a:rPr lang="en-US"/>
                        <a:t>K+</a:t>
                      </a:r>
                    </a:p>
                  </a:txBody>
                  <a:tcPr/>
                </a:tc>
                <a:tc>
                  <a:txBody>
                    <a:bodyPr/>
                    <a:lstStyle/>
                    <a:p>
                      <a:pPr algn="ctr"/>
                      <a:r>
                        <a:rPr lang="en-US"/>
                        <a:t>Cl-</a:t>
                      </a:r>
                    </a:p>
                  </a:txBody>
                  <a:tcPr/>
                </a:tc>
                <a:extLst>
                  <a:ext uri="{0D108BD9-81ED-4DB2-BD59-A6C34878D82A}">
                    <a16:rowId xmlns:a16="http://schemas.microsoft.com/office/drawing/2014/main" val="3925621980"/>
                  </a:ext>
                </a:extLst>
              </a:tr>
              <a:tr h="505410">
                <a:tc>
                  <a:txBody>
                    <a:bodyPr/>
                    <a:lstStyle/>
                    <a:p>
                      <a:r>
                        <a:rPr lang="en-US"/>
                        <a:t>7.06</a:t>
                      </a:r>
                    </a:p>
                  </a:txBody>
                  <a:tcPr/>
                </a:tc>
                <a:tc>
                  <a:txBody>
                    <a:bodyPr/>
                    <a:lstStyle/>
                    <a:p>
                      <a:r>
                        <a:rPr lang="en-US"/>
                        <a:t>86</a:t>
                      </a:r>
                    </a:p>
                  </a:txBody>
                  <a:tcPr/>
                </a:tc>
                <a:tc>
                  <a:txBody>
                    <a:bodyPr/>
                    <a:lstStyle/>
                    <a:p>
                      <a:r>
                        <a:rPr lang="en-US"/>
                        <a:t>14</a:t>
                      </a:r>
                    </a:p>
                  </a:txBody>
                  <a:tcPr/>
                </a:tc>
                <a:tc>
                  <a:txBody>
                    <a:bodyPr/>
                    <a:lstStyle/>
                    <a:p>
                      <a:r>
                        <a:rPr lang="en-US"/>
                        <a:t>137</a:t>
                      </a:r>
                    </a:p>
                  </a:txBody>
                  <a:tcPr/>
                </a:tc>
                <a:tc>
                  <a:txBody>
                    <a:bodyPr/>
                    <a:lstStyle/>
                    <a:p>
                      <a:r>
                        <a:rPr lang="en-US"/>
                        <a:t>3.8</a:t>
                      </a:r>
                    </a:p>
                  </a:txBody>
                  <a:tcPr/>
                </a:tc>
                <a:tc>
                  <a:txBody>
                    <a:bodyPr/>
                    <a:lstStyle/>
                    <a:p>
                      <a:r>
                        <a:rPr lang="en-US"/>
                        <a:t>105</a:t>
                      </a:r>
                    </a:p>
                  </a:txBody>
                  <a:tcPr/>
                </a:tc>
                <a:extLst>
                  <a:ext uri="{0D108BD9-81ED-4DB2-BD59-A6C34878D82A}">
                    <a16:rowId xmlns:a16="http://schemas.microsoft.com/office/drawing/2014/main" val="3939055279"/>
                  </a:ext>
                </a:extLst>
              </a:tr>
              <a:tr h="505410">
                <a:tc>
                  <a:txBody>
                    <a:bodyPr/>
                    <a:lstStyle/>
                    <a:p>
                      <a:r>
                        <a:rPr lang="en-US"/>
                        <a:t>7.1</a:t>
                      </a:r>
                    </a:p>
                  </a:txBody>
                  <a:tcPr/>
                </a:tc>
                <a:tc>
                  <a:txBody>
                    <a:bodyPr/>
                    <a:lstStyle/>
                    <a:p>
                      <a:r>
                        <a:rPr lang="en-US"/>
                        <a:t>42</a:t>
                      </a:r>
                    </a:p>
                  </a:txBody>
                  <a:tcPr/>
                </a:tc>
                <a:tc>
                  <a:txBody>
                    <a:bodyPr/>
                    <a:lstStyle/>
                    <a:p>
                      <a:r>
                        <a:rPr lang="en-US"/>
                        <a:t>22</a:t>
                      </a:r>
                    </a:p>
                  </a:txBody>
                  <a:tcPr/>
                </a:tc>
                <a:tc>
                  <a:txBody>
                    <a:bodyPr/>
                    <a:lstStyle/>
                    <a:p>
                      <a:r>
                        <a:rPr lang="en-US"/>
                        <a:t>135</a:t>
                      </a:r>
                    </a:p>
                  </a:txBody>
                  <a:tcPr/>
                </a:tc>
                <a:tc>
                  <a:txBody>
                    <a:bodyPr/>
                    <a:lstStyle/>
                    <a:p>
                      <a:r>
                        <a:rPr lang="en-US"/>
                        <a:t>4.0</a:t>
                      </a:r>
                    </a:p>
                  </a:txBody>
                  <a:tcPr/>
                </a:tc>
                <a:tc>
                  <a:txBody>
                    <a:bodyPr/>
                    <a:lstStyle/>
                    <a:p>
                      <a:r>
                        <a:rPr lang="en-US"/>
                        <a:t>110</a:t>
                      </a:r>
                    </a:p>
                  </a:txBody>
                  <a:tcPr/>
                </a:tc>
                <a:extLst>
                  <a:ext uri="{0D108BD9-81ED-4DB2-BD59-A6C34878D82A}">
                    <a16:rowId xmlns:a16="http://schemas.microsoft.com/office/drawing/2014/main" val="1549369976"/>
                  </a:ext>
                </a:extLst>
              </a:tr>
              <a:tr h="505410">
                <a:tc>
                  <a:txBody>
                    <a:bodyPr/>
                    <a:lstStyle/>
                    <a:p>
                      <a:r>
                        <a:rPr lang="en-US"/>
                        <a:t>7.35</a:t>
                      </a:r>
                    </a:p>
                  </a:txBody>
                  <a:tcPr/>
                </a:tc>
                <a:tc>
                  <a:txBody>
                    <a:bodyPr/>
                    <a:lstStyle/>
                    <a:p>
                      <a:r>
                        <a:rPr lang="en-US"/>
                        <a:t>35</a:t>
                      </a:r>
                    </a:p>
                  </a:txBody>
                  <a:tcPr/>
                </a:tc>
                <a:tc>
                  <a:txBody>
                    <a:bodyPr/>
                    <a:lstStyle/>
                    <a:p>
                      <a:r>
                        <a:rPr lang="en-US"/>
                        <a:t>24</a:t>
                      </a:r>
                    </a:p>
                  </a:txBody>
                  <a:tcPr/>
                </a:tc>
                <a:tc>
                  <a:txBody>
                    <a:bodyPr/>
                    <a:lstStyle/>
                    <a:p>
                      <a:r>
                        <a:rPr lang="en-US"/>
                        <a:t>140</a:t>
                      </a:r>
                    </a:p>
                  </a:txBody>
                  <a:tcPr/>
                </a:tc>
                <a:tc>
                  <a:txBody>
                    <a:bodyPr/>
                    <a:lstStyle/>
                    <a:p>
                      <a:r>
                        <a:rPr lang="en-US"/>
                        <a:t>3.5</a:t>
                      </a:r>
                    </a:p>
                  </a:txBody>
                  <a:tcPr/>
                </a:tc>
                <a:tc>
                  <a:txBody>
                    <a:bodyPr/>
                    <a:lstStyle/>
                    <a:p>
                      <a:r>
                        <a:rPr lang="en-US"/>
                        <a:t>100</a:t>
                      </a:r>
                    </a:p>
                  </a:txBody>
                  <a:tcPr/>
                </a:tc>
                <a:extLst>
                  <a:ext uri="{0D108BD9-81ED-4DB2-BD59-A6C34878D82A}">
                    <a16:rowId xmlns:a16="http://schemas.microsoft.com/office/drawing/2014/main" val="3365227491"/>
                  </a:ext>
                </a:extLst>
              </a:tr>
              <a:tr h="505410">
                <a:tc>
                  <a:txBody>
                    <a:bodyPr/>
                    <a:lstStyle/>
                    <a:p>
                      <a:r>
                        <a:rPr lang="en-US"/>
                        <a:t>7.20</a:t>
                      </a:r>
                    </a:p>
                  </a:txBody>
                  <a:tcPr/>
                </a:tc>
                <a:tc>
                  <a:txBody>
                    <a:bodyPr/>
                    <a:lstStyle/>
                    <a:p>
                      <a:r>
                        <a:rPr lang="en-US"/>
                        <a:t>45</a:t>
                      </a:r>
                    </a:p>
                  </a:txBody>
                  <a:tcPr/>
                </a:tc>
                <a:tc>
                  <a:txBody>
                    <a:bodyPr/>
                    <a:lstStyle/>
                    <a:p>
                      <a:r>
                        <a:rPr lang="en-US"/>
                        <a:t>26</a:t>
                      </a:r>
                    </a:p>
                  </a:txBody>
                  <a:tcPr/>
                </a:tc>
                <a:tc>
                  <a:txBody>
                    <a:bodyPr/>
                    <a:lstStyle/>
                    <a:p>
                      <a:r>
                        <a:rPr lang="en-US"/>
                        <a:t>137</a:t>
                      </a:r>
                    </a:p>
                  </a:txBody>
                  <a:tcPr/>
                </a:tc>
                <a:tc>
                  <a:txBody>
                    <a:bodyPr/>
                    <a:lstStyle/>
                    <a:p>
                      <a:r>
                        <a:rPr lang="en-US"/>
                        <a:t>3.8</a:t>
                      </a:r>
                    </a:p>
                  </a:txBody>
                  <a:tcPr/>
                </a:tc>
                <a:tc>
                  <a:txBody>
                    <a:bodyPr/>
                    <a:lstStyle/>
                    <a:p>
                      <a:r>
                        <a:rPr lang="en-US"/>
                        <a:t>105</a:t>
                      </a:r>
                    </a:p>
                  </a:txBody>
                  <a:tcPr/>
                </a:tc>
                <a:extLst>
                  <a:ext uri="{0D108BD9-81ED-4DB2-BD59-A6C34878D82A}">
                    <a16:rowId xmlns:a16="http://schemas.microsoft.com/office/drawing/2014/main" val="2197128974"/>
                  </a:ext>
                </a:extLst>
              </a:tr>
            </a:tbl>
          </a:graphicData>
        </a:graphic>
      </p:graphicFrame>
    </p:spTree>
    <p:extLst>
      <p:ext uri="{BB962C8B-B14F-4D97-AF65-F5344CB8AC3E}">
        <p14:creationId xmlns:p14="http://schemas.microsoft.com/office/powerpoint/2010/main" val="1722234689"/>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4">
            <a:extLst>
              <a:ext uri="{FF2B5EF4-FFF2-40B4-BE49-F238E27FC236}">
                <a16:creationId xmlns:a16="http://schemas.microsoft.com/office/drawing/2014/main" id="{C4E0E685-9834-45EF-9AE2-C5BFDE27322F}"/>
              </a:ext>
            </a:extLst>
          </p:cNvPr>
          <p:cNvGraphicFramePr>
            <a:graphicFrameLocks noGrp="1"/>
          </p:cNvGraphicFramePr>
          <p:nvPr>
            <p:extLst>
              <p:ext uri="{D42A27DB-BD31-4B8C-83A1-F6EECF244321}">
                <p14:modId xmlns:p14="http://schemas.microsoft.com/office/powerpoint/2010/main" val="3882712"/>
              </p:ext>
            </p:extLst>
          </p:nvPr>
        </p:nvGraphicFramePr>
        <p:xfrm>
          <a:off x="897086" y="430690"/>
          <a:ext cx="7362828" cy="2527050"/>
        </p:xfrm>
        <a:graphic>
          <a:graphicData uri="http://schemas.openxmlformats.org/drawingml/2006/table">
            <a:tbl>
              <a:tblPr firstRow="1" bandRow="1">
                <a:tableStyleId>{5C22544A-7EE6-4342-B048-85BDC9FD1C3A}</a:tableStyleId>
              </a:tblPr>
              <a:tblGrid>
                <a:gridCol w="1227138">
                  <a:extLst>
                    <a:ext uri="{9D8B030D-6E8A-4147-A177-3AD203B41FA5}">
                      <a16:colId xmlns:a16="http://schemas.microsoft.com/office/drawing/2014/main" val="2956672230"/>
                    </a:ext>
                  </a:extLst>
                </a:gridCol>
                <a:gridCol w="1227138">
                  <a:extLst>
                    <a:ext uri="{9D8B030D-6E8A-4147-A177-3AD203B41FA5}">
                      <a16:colId xmlns:a16="http://schemas.microsoft.com/office/drawing/2014/main" val="3366791402"/>
                    </a:ext>
                  </a:extLst>
                </a:gridCol>
                <a:gridCol w="1227138">
                  <a:extLst>
                    <a:ext uri="{9D8B030D-6E8A-4147-A177-3AD203B41FA5}">
                      <a16:colId xmlns:a16="http://schemas.microsoft.com/office/drawing/2014/main" val="1166372328"/>
                    </a:ext>
                  </a:extLst>
                </a:gridCol>
                <a:gridCol w="1227138">
                  <a:extLst>
                    <a:ext uri="{9D8B030D-6E8A-4147-A177-3AD203B41FA5}">
                      <a16:colId xmlns:a16="http://schemas.microsoft.com/office/drawing/2014/main" val="3425385262"/>
                    </a:ext>
                  </a:extLst>
                </a:gridCol>
                <a:gridCol w="1227138">
                  <a:extLst>
                    <a:ext uri="{9D8B030D-6E8A-4147-A177-3AD203B41FA5}">
                      <a16:colId xmlns:a16="http://schemas.microsoft.com/office/drawing/2014/main" val="1561456660"/>
                    </a:ext>
                  </a:extLst>
                </a:gridCol>
                <a:gridCol w="1227138">
                  <a:extLst>
                    <a:ext uri="{9D8B030D-6E8A-4147-A177-3AD203B41FA5}">
                      <a16:colId xmlns:a16="http://schemas.microsoft.com/office/drawing/2014/main" val="3670303674"/>
                    </a:ext>
                  </a:extLst>
                </a:gridCol>
              </a:tblGrid>
              <a:tr h="505410">
                <a:tc>
                  <a:txBody>
                    <a:bodyPr/>
                    <a:lstStyle/>
                    <a:p>
                      <a:pPr algn="ctr"/>
                      <a:r>
                        <a:rPr lang="en-US"/>
                        <a:t>pH</a:t>
                      </a:r>
                    </a:p>
                  </a:txBody>
                  <a:tcPr/>
                </a:tc>
                <a:tc>
                  <a:txBody>
                    <a:bodyPr/>
                    <a:lstStyle/>
                    <a:p>
                      <a:pPr algn="ctr"/>
                      <a:r>
                        <a:rPr lang="en-US"/>
                        <a:t>pCO2</a:t>
                      </a:r>
                    </a:p>
                  </a:txBody>
                  <a:tcPr/>
                </a:tc>
                <a:tc>
                  <a:txBody>
                    <a:bodyPr/>
                    <a:lstStyle/>
                    <a:p>
                      <a:pPr algn="ctr"/>
                      <a:r>
                        <a:rPr lang="en-US"/>
                        <a:t>HCO3-</a:t>
                      </a:r>
                    </a:p>
                  </a:txBody>
                  <a:tcPr/>
                </a:tc>
                <a:tc>
                  <a:txBody>
                    <a:bodyPr/>
                    <a:lstStyle/>
                    <a:p>
                      <a:pPr algn="ctr"/>
                      <a:r>
                        <a:rPr lang="en-US"/>
                        <a:t>Na+</a:t>
                      </a:r>
                    </a:p>
                  </a:txBody>
                  <a:tcPr/>
                </a:tc>
                <a:tc>
                  <a:txBody>
                    <a:bodyPr/>
                    <a:lstStyle/>
                    <a:p>
                      <a:pPr algn="ctr"/>
                      <a:r>
                        <a:rPr lang="en-US"/>
                        <a:t>K+</a:t>
                      </a:r>
                    </a:p>
                  </a:txBody>
                  <a:tcPr/>
                </a:tc>
                <a:tc>
                  <a:txBody>
                    <a:bodyPr/>
                    <a:lstStyle/>
                    <a:p>
                      <a:pPr algn="ctr"/>
                      <a:r>
                        <a:rPr lang="en-US"/>
                        <a:t>Cl-</a:t>
                      </a:r>
                    </a:p>
                  </a:txBody>
                  <a:tcPr/>
                </a:tc>
                <a:extLst>
                  <a:ext uri="{0D108BD9-81ED-4DB2-BD59-A6C34878D82A}">
                    <a16:rowId xmlns:a16="http://schemas.microsoft.com/office/drawing/2014/main" val="3925621980"/>
                  </a:ext>
                </a:extLst>
              </a:tr>
              <a:tr h="505410">
                <a:tc>
                  <a:txBody>
                    <a:bodyPr/>
                    <a:lstStyle/>
                    <a:p>
                      <a:r>
                        <a:rPr lang="en-US" b="1">
                          <a:solidFill>
                            <a:schemeClr val="tx1"/>
                          </a:solidFill>
                          <a:highlight>
                            <a:srgbClr val="FFFF00"/>
                          </a:highlight>
                        </a:rPr>
                        <a:t>7.06</a:t>
                      </a:r>
                    </a:p>
                  </a:txBody>
                  <a:tcPr/>
                </a:tc>
                <a:tc>
                  <a:txBody>
                    <a:bodyPr/>
                    <a:lstStyle/>
                    <a:p>
                      <a:r>
                        <a:rPr lang="en-US" b="1">
                          <a:solidFill>
                            <a:schemeClr val="tx1"/>
                          </a:solidFill>
                          <a:highlight>
                            <a:srgbClr val="FFFF00"/>
                          </a:highlight>
                        </a:rPr>
                        <a:t>86</a:t>
                      </a:r>
                    </a:p>
                  </a:txBody>
                  <a:tcPr/>
                </a:tc>
                <a:tc>
                  <a:txBody>
                    <a:bodyPr/>
                    <a:lstStyle/>
                    <a:p>
                      <a:r>
                        <a:rPr lang="en-US" b="1">
                          <a:solidFill>
                            <a:schemeClr val="tx1"/>
                          </a:solidFill>
                          <a:highlight>
                            <a:srgbClr val="FFFF00"/>
                          </a:highlight>
                        </a:rPr>
                        <a:t>14</a:t>
                      </a:r>
                    </a:p>
                  </a:txBody>
                  <a:tcPr/>
                </a:tc>
                <a:tc>
                  <a:txBody>
                    <a:bodyPr/>
                    <a:lstStyle/>
                    <a:p>
                      <a:r>
                        <a:rPr lang="en-US" b="1">
                          <a:solidFill>
                            <a:schemeClr val="tx1"/>
                          </a:solidFill>
                          <a:highlight>
                            <a:srgbClr val="FFFF00"/>
                          </a:highlight>
                        </a:rPr>
                        <a:t>137</a:t>
                      </a:r>
                    </a:p>
                  </a:txBody>
                  <a:tcPr/>
                </a:tc>
                <a:tc>
                  <a:txBody>
                    <a:bodyPr/>
                    <a:lstStyle/>
                    <a:p>
                      <a:r>
                        <a:rPr lang="en-US" b="1">
                          <a:solidFill>
                            <a:schemeClr val="tx1"/>
                          </a:solidFill>
                          <a:highlight>
                            <a:srgbClr val="FFFF00"/>
                          </a:highlight>
                        </a:rPr>
                        <a:t>3.8</a:t>
                      </a:r>
                    </a:p>
                  </a:txBody>
                  <a:tcPr/>
                </a:tc>
                <a:tc>
                  <a:txBody>
                    <a:bodyPr/>
                    <a:lstStyle/>
                    <a:p>
                      <a:r>
                        <a:rPr lang="en-US" b="1">
                          <a:solidFill>
                            <a:schemeClr val="tx1"/>
                          </a:solidFill>
                          <a:highlight>
                            <a:srgbClr val="FFFF00"/>
                          </a:highlight>
                        </a:rPr>
                        <a:t>105</a:t>
                      </a:r>
                    </a:p>
                  </a:txBody>
                  <a:tcPr/>
                </a:tc>
                <a:extLst>
                  <a:ext uri="{0D108BD9-81ED-4DB2-BD59-A6C34878D82A}">
                    <a16:rowId xmlns:a16="http://schemas.microsoft.com/office/drawing/2014/main" val="3939055279"/>
                  </a:ext>
                </a:extLst>
              </a:tr>
              <a:tr h="505410">
                <a:tc>
                  <a:txBody>
                    <a:bodyPr/>
                    <a:lstStyle/>
                    <a:p>
                      <a:r>
                        <a:rPr lang="en-US"/>
                        <a:t>7.1</a:t>
                      </a:r>
                    </a:p>
                  </a:txBody>
                  <a:tcPr/>
                </a:tc>
                <a:tc>
                  <a:txBody>
                    <a:bodyPr/>
                    <a:lstStyle/>
                    <a:p>
                      <a:r>
                        <a:rPr lang="en-US"/>
                        <a:t>42</a:t>
                      </a:r>
                    </a:p>
                  </a:txBody>
                  <a:tcPr/>
                </a:tc>
                <a:tc>
                  <a:txBody>
                    <a:bodyPr/>
                    <a:lstStyle/>
                    <a:p>
                      <a:r>
                        <a:rPr lang="en-US"/>
                        <a:t>22</a:t>
                      </a:r>
                    </a:p>
                  </a:txBody>
                  <a:tcPr/>
                </a:tc>
                <a:tc>
                  <a:txBody>
                    <a:bodyPr/>
                    <a:lstStyle/>
                    <a:p>
                      <a:r>
                        <a:rPr lang="en-US"/>
                        <a:t>135</a:t>
                      </a:r>
                    </a:p>
                  </a:txBody>
                  <a:tcPr/>
                </a:tc>
                <a:tc>
                  <a:txBody>
                    <a:bodyPr/>
                    <a:lstStyle/>
                    <a:p>
                      <a:r>
                        <a:rPr lang="en-US"/>
                        <a:t>4.0</a:t>
                      </a:r>
                    </a:p>
                  </a:txBody>
                  <a:tcPr/>
                </a:tc>
                <a:tc>
                  <a:txBody>
                    <a:bodyPr/>
                    <a:lstStyle/>
                    <a:p>
                      <a:r>
                        <a:rPr lang="en-US"/>
                        <a:t>110</a:t>
                      </a:r>
                    </a:p>
                  </a:txBody>
                  <a:tcPr/>
                </a:tc>
                <a:extLst>
                  <a:ext uri="{0D108BD9-81ED-4DB2-BD59-A6C34878D82A}">
                    <a16:rowId xmlns:a16="http://schemas.microsoft.com/office/drawing/2014/main" val="1549369976"/>
                  </a:ext>
                </a:extLst>
              </a:tr>
              <a:tr h="505410">
                <a:tc>
                  <a:txBody>
                    <a:bodyPr/>
                    <a:lstStyle/>
                    <a:p>
                      <a:r>
                        <a:rPr lang="en-US"/>
                        <a:t>7.35</a:t>
                      </a:r>
                    </a:p>
                  </a:txBody>
                  <a:tcPr/>
                </a:tc>
                <a:tc>
                  <a:txBody>
                    <a:bodyPr/>
                    <a:lstStyle/>
                    <a:p>
                      <a:r>
                        <a:rPr lang="en-US"/>
                        <a:t>35</a:t>
                      </a:r>
                    </a:p>
                  </a:txBody>
                  <a:tcPr/>
                </a:tc>
                <a:tc>
                  <a:txBody>
                    <a:bodyPr/>
                    <a:lstStyle/>
                    <a:p>
                      <a:r>
                        <a:rPr lang="en-US"/>
                        <a:t>24</a:t>
                      </a:r>
                    </a:p>
                  </a:txBody>
                  <a:tcPr/>
                </a:tc>
                <a:tc>
                  <a:txBody>
                    <a:bodyPr/>
                    <a:lstStyle/>
                    <a:p>
                      <a:r>
                        <a:rPr lang="en-US"/>
                        <a:t>140</a:t>
                      </a:r>
                    </a:p>
                  </a:txBody>
                  <a:tcPr/>
                </a:tc>
                <a:tc>
                  <a:txBody>
                    <a:bodyPr/>
                    <a:lstStyle/>
                    <a:p>
                      <a:r>
                        <a:rPr lang="en-US"/>
                        <a:t>3.5</a:t>
                      </a:r>
                    </a:p>
                  </a:txBody>
                  <a:tcPr/>
                </a:tc>
                <a:tc>
                  <a:txBody>
                    <a:bodyPr/>
                    <a:lstStyle/>
                    <a:p>
                      <a:r>
                        <a:rPr lang="en-US"/>
                        <a:t>100</a:t>
                      </a:r>
                    </a:p>
                  </a:txBody>
                  <a:tcPr/>
                </a:tc>
                <a:extLst>
                  <a:ext uri="{0D108BD9-81ED-4DB2-BD59-A6C34878D82A}">
                    <a16:rowId xmlns:a16="http://schemas.microsoft.com/office/drawing/2014/main" val="3365227491"/>
                  </a:ext>
                </a:extLst>
              </a:tr>
              <a:tr h="505410">
                <a:tc>
                  <a:txBody>
                    <a:bodyPr/>
                    <a:lstStyle/>
                    <a:p>
                      <a:r>
                        <a:rPr lang="en-US"/>
                        <a:t>7.20</a:t>
                      </a:r>
                    </a:p>
                  </a:txBody>
                  <a:tcPr/>
                </a:tc>
                <a:tc>
                  <a:txBody>
                    <a:bodyPr/>
                    <a:lstStyle/>
                    <a:p>
                      <a:r>
                        <a:rPr lang="en-US"/>
                        <a:t>45</a:t>
                      </a:r>
                    </a:p>
                  </a:txBody>
                  <a:tcPr/>
                </a:tc>
                <a:tc>
                  <a:txBody>
                    <a:bodyPr/>
                    <a:lstStyle/>
                    <a:p>
                      <a:r>
                        <a:rPr lang="en-US"/>
                        <a:t>26</a:t>
                      </a:r>
                    </a:p>
                  </a:txBody>
                  <a:tcPr/>
                </a:tc>
                <a:tc>
                  <a:txBody>
                    <a:bodyPr/>
                    <a:lstStyle/>
                    <a:p>
                      <a:r>
                        <a:rPr lang="en-US"/>
                        <a:t>137</a:t>
                      </a:r>
                    </a:p>
                  </a:txBody>
                  <a:tcPr/>
                </a:tc>
                <a:tc>
                  <a:txBody>
                    <a:bodyPr/>
                    <a:lstStyle/>
                    <a:p>
                      <a:r>
                        <a:rPr lang="en-US"/>
                        <a:t>3.8</a:t>
                      </a:r>
                    </a:p>
                  </a:txBody>
                  <a:tcPr/>
                </a:tc>
                <a:tc>
                  <a:txBody>
                    <a:bodyPr/>
                    <a:lstStyle/>
                    <a:p>
                      <a:r>
                        <a:rPr lang="en-US"/>
                        <a:t>105</a:t>
                      </a:r>
                    </a:p>
                  </a:txBody>
                  <a:tcPr/>
                </a:tc>
                <a:extLst>
                  <a:ext uri="{0D108BD9-81ED-4DB2-BD59-A6C34878D82A}">
                    <a16:rowId xmlns:a16="http://schemas.microsoft.com/office/drawing/2014/main" val="2197128974"/>
                  </a:ext>
                </a:extLst>
              </a:tr>
            </a:tbl>
          </a:graphicData>
        </a:graphic>
      </p:graphicFrame>
      <p:sp>
        <p:nvSpPr>
          <p:cNvPr id="5" name="TextBox 4">
            <a:extLst>
              <a:ext uri="{FF2B5EF4-FFF2-40B4-BE49-F238E27FC236}">
                <a16:creationId xmlns:a16="http://schemas.microsoft.com/office/drawing/2014/main" id="{D08605A7-1795-432E-AB37-430163A6A686}"/>
              </a:ext>
            </a:extLst>
          </p:cNvPr>
          <p:cNvSpPr txBox="1"/>
          <p:nvPr/>
        </p:nvSpPr>
        <p:spPr>
          <a:xfrm>
            <a:off x="852928" y="3153062"/>
            <a:ext cx="6769634" cy="738664"/>
          </a:xfrm>
          <a:prstGeom prst="rect">
            <a:avLst/>
          </a:prstGeom>
          <a:noFill/>
        </p:spPr>
        <p:txBody>
          <a:bodyPr wrap="square" rtlCol="0">
            <a:spAutoFit/>
          </a:bodyPr>
          <a:lstStyle/>
          <a:p>
            <a:pPr marL="342900" indent="-342900">
              <a:buAutoNum type="arabicPeriod"/>
            </a:pPr>
            <a:r>
              <a:rPr lang="en-US">
                <a:solidFill>
                  <a:schemeClr val="bg1"/>
                </a:solidFill>
              </a:rPr>
              <a:t>pH: low (acidosis)</a:t>
            </a:r>
          </a:p>
          <a:p>
            <a:pPr marL="342900" indent="-342900">
              <a:buAutoNum type="arabicPeriod"/>
            </a:pPr>
            <a:r>
              <a:rPr lang="en-US">
                <a:solidFill>
                  <a:schemeClr val="bg1"/>
                </a:solidFill>
              </a:rPr>
              <a:t>pCO2: high – hypercarbia (primary respiratory acidosis)</a:t>
            </a:r>
          </a:p>
          <a:p>
            <a:pPr marL="342900" indent="-342900">
              <a:buAutoNum type="arabicPeriod"/>
            </a:pPr>
            <a:r>
              <a:rPr lang="en-US">
                <a:solidFill>
                  <a:schemeClr val="bg1"/>
                </a:solidFill>
              </a:rPr>
              <a:t>HCO3 : low</a:t>
            </a:r>
          </a:p>
        </p:txBody>
      </p:sp>
    </p:spTree>
    <p:extLst>
      <p:ext uri="{BB962C8B-B14F-4D97-AF65-F5344CB8AC3E}">
        <p14:creationId xmlns:p14="http://schemas.microsoft.com/office/powerpoint/2010/main" val="1798559321"/>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a:extLst>
              <a:ext uri="{FF2B5EF4-FFF2-40B4-BE49-F238E27FC236}">
                <a16:creationId xmlns:a16="http://schemas.microsoft.com/office/drawing/2014/main" id="{3E4F02D9-E099-466C-933C-BCED028FAACD}"/>
              </a:ext>
            </a:extLst>
          </p:cNvPr>
          <p:cNvSpPr>
            <a:spLocks noGrp="1"/>
          </p:cNvSpPr>
          <p:nvPr>
            <p:ph type="subTitle" idx="1"/>
          </p:nvPr>
        </p:nvSpPr>
        <p:spPr/>
        <p:txBody>
          <a:bodyPr/>
          <a:lstStyle/>
          <a:p>
            <a:r>
              <a:rPr lang="en-US"/>
              <a:t>ABGs in asthma Exacerbations</a:t>
            </a:r>
          </a:p>
        </p:txBody>
      </p:sp>
      <p:graphicFrame>
        <p:nvGraphicFramePr>
          <p:cNvPr id="4" name="Table 4">
            <a:extLst>
              <a:ext uri="{FF2B5EF4-FFF2-40B4-BE49-F238E27FC236}">
                <a16:creationId xmlns:a16="http://schemas.microsoft.com/office/drawing/2014/main" id="{6A501834-1E0B-40EB-8943-DC755D6CB4A0}"/>
              </a:ext>
            </a:extLst>
          </p:cNvPr>
          <p:cNvGraphicFramePr>
            <a:graphicFrameLocks noGrp="1"/>
          </p:cNvGraphicFramePr>
          <p:nvPr>
            <p:extLst>
              <p:ext uri="{D42A27DB-BD31-4B8C-83A1-F6EECF244321}">
                <p14:modId xmlns:p14="http://schemas.microsoft.com/office/powerpoint/2010/main" val="3534496265"/>
              </p:ext>
            </p:extLst>
          </p:nvPr>
        </p:nvGraphicFramePr>
        <p:xfrm>
          <a:off x="711749" y="1411850"/>
          <a:ext cx="7546426" cy="2455301"/>
        </p:xfrm>
        <a:graphic>
          <a:graphicData uri="http://schemas.openxmlformats.org/drawingml/2006/table">
            <a:tbl>
              <a:tblPr firstRow="1" bandRow="1">
                <a:tableStyleId>{5C22544A-7EE6-4342-B048-85BDC9FD1C3A}</a:tableStyleId>
              </a:tblPr>
              <a:tblGrid>
                <a:gridCol w="1431376">
                  <a:extLst>
                    <a:ext uri="{9D8B030D-6E8A-4147-A177-3AD203B41FA5}">
                      <a16:colId xmlns:a16="http://schemas.microsoft.com/office/drawing/2014/main" val="892130774"/>
                    </a:ext>
                  </a:extLst>
                </a:gridCol>
                <a:gridCol w="1852572">
                  <a:extLst>
                    <a:ext uri="{9D8B030D-6E8A-4147-A177-3AD203B41FA5}">
                      <a16:colId xmlns:a16="http://schemas.microsoft.com/office/drawing/2014/main" val="942401746"/>
                    </a:ext>
                  </a:extLst>
                </a:gridCol>
                <a:gridCol w="1967113">
                  <a:extLst>
                    <a:ext uri="{9D8B030D-6E8A-4147-A177-3AD203B41FA5}">
                      <a16:colId xmlns:a16="http://schemas.microsoft.com/office/drawing/2014/main" val="1248992128"/>
                    </a:ext>
                  </a:extLst>
                </a:gridCol>
                <a:gridCol w="2295365">
                  <a:extLst>
                    <a:ext uri="{9D8B030D-6E8A-4147-A177-3AD203B41FA5}">
                      <a16:colId xmlns:a16="http://schemas.microsoft.com/office/drawing/2014/main" val="1992672152"/>
                    </a:ext>
                  </a:extLst>
                </a:gridCol>
              </a:tblGrid>
              <a:tr h="418517">
                <a:tc>
                  <a:txBody>
                    <a:bodyPr/>
                    <a:lstStyle/>
                    <a:p>
                      <a:pPr algn="ctr"/>
                      <a:endParaRPr lang="en-US"/>
                    </a:p>
                  </a:txBody>
                  <a:tcPr/>
                </a:tc>
                <a:tc>
                  <a:txBody>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a:t>Mild</a:t>
                      </a:r>
                    </a:p>
                  </a:txBody>
                  <a:tcPr/>
                </a:tc>
                <a:tc>
                  <a:txBody>
                    <a:bodyPr/>
                    <a:lstStyle/>
                    <a:p>
                      <a:pPr algn="ctr"/>
                      <a:r>
                        <a:rPr lang="en-US"/>
                        <a:t>Moderate</a:t>
                      </a:r>
                    </a:p>
                  </a:txBody>
                  <a:tcPr/>
                </a:tc>
                <a:tc>
                  <a:txBody>
                    <a:bodyPr/>
                    <a:lstStyle/>
                    <a:p>
                      <a:pPr algn="ctr"/>
                      <a:r>
                        <a:rPr lang="en-US"/>
                        <a:t>Severe</a:t>
                      </a:r>
                    </a:p>
                  </a:txBody>
                  <a:tcPr/>
                </a:tc>
                <a:extLst>
                  <a:ext uri="{0D108BD9-81ED-4DB2-BD59-A6C34878D82A}">
                    <a16:rowId xmlns:a16="http://schemas.microsoft.com/office/drawing/2014/main" val="2351828031"/>
                  </a:ext>
                </a:extLst>
              </a:tr>
              <a:tr h="509196">
                <a:tc>
                  <a:txBody>
                    <a:bodyPr/>
                    <a:lstStyle/>
                    <a:p>
                      <a:r>
                        <a:rPr lang="en-US"/>
                        <a:t>pH</a:t>
                      </a:r>
                    </a:p>
                  </a:txBody>
                  <a:tcPr/>
                </a:tc>
                <a:tc>
                  <a:txBody>
                    <a:bodyPr/>
                    <a:lstStyle/>
                    <a:p>
                      <a:endParaRPr lang="en-US"/>
                    </a:p>
                  </a:txBody>
                  <a:tcPr/>
                </a:tc>
                <a:tc>
                  <a:txBody>
                    <a:bodyPr/>
                    <a:lstStyle/>
                    <a:p>
                      <a:endParaRPr lang="en-US"/>
                    </a:p>
                  </a:txBody>
                  <a:tcPr/>
                </a:tc>
                <a:tc>
                  <a:txBody>
                    <a:bodyPr/>
                    <a:lstStyle/>
                    <a:p>
                      <a:endParaRPr lang="en-US"/>
                    </a:p>
                  </a:txBody>
                  <a:tcPr/>
                </a:tc>
                <a:extLst>
                  <a:ext uri="{0D108BD9-81ED-4DB2-BD59-A6C34878D82A}">
                    <a16:rowId xmlns:a16="http://schemas.microsoft.com/office/drawing/2014/main" val="666738570"/>
                  </a:ext>
                </a:extLst>
              </a:tr>
              <a:tr h="509196">
                <a:tc>
                  <a:txBody>
                    <a:bodyPr/>
                    <a:lstStyle/>
                    <a:p>
                      <a:r>
                        <a:rPr lang="en-US"/>
                        <a:t>PaO2</a:t>
                      </a:r>
                    </a:p>
                  </a:txBody>
                  <a:tcPr/>
                </a:tc>
                <a:tc>
                  <a:txBody>
                    <a:bodyPr/>
                    <a:lstStyle/>
                    <a:p>
                      <a:endParaRPr lang="en-US"/>
                    </a:p>
                  </a:txBody>
                  <a:tcPr/>
                </a:tc>
                <a:tc>
                  <a:txBody>
                    <a:bodyPr/>
                    <a:lstStyle/>
                    <a:p>
                      <a:endParaRPr lang="en-US"/>
                    </a:p>
                  </a:txBody>
                  <a:tcPr/>
                </a:tc>
                <a:tc>
                  <a:txBody>
                    <a:bodyPr/>
                    <a:lstStyle/>
                    <a:p>
                      <a:endParaRPr lang="en-US"/>
                    </a:p>
                  </a:txBody>
                  <a:tcPr/>
                </a:tc>
                <a:extLst>
                  <a:ext uri="{0D108BD9-81ED-4DB2-BD59-A6C34878D82A}">
                    <a16:rowId xmlns:a16="http://schemas.microsoft.com/office/drawing/2014/main" val="1805733169"/>
                  </a:ext>
                </a:extLst>
              </a:tr>
              <a:tr h="509196">
                <a:tc>
                  <a:txBody>
                    <a:bodyPr/>
                    <a:lstStyle/>
                    <a:p>
                      <a:r>
                        <a:rPr lang="en-US"/>
                        <a:t>PaCO2</a:t>
                      </a:r>
                    </a:p>
                  </a:txBody>
                  <a:tcPr/>
                </a:tc>
                <a:tc>
                  <a:txBody>
                    <a:bodyPr/>
                    <a:lstStyle/>
                    <a:p>
                      <a:endParaRPr lang="en-US"/>
                    </a:p>
                  </a:txBody>
                  <a:tcPr/>
                </a:tc>
                <a:tc>
                  <a:txBody>
                    <a:bodyPr/>
                    <a:lstStyle/>
                    <a:p>
                      <a:endParaRPr lang="en-US"/>
                    </a:p>
                  </a:txBody>
                  <a:tcPr/>
                </a:tc>
                <a:tc>
                  <a:txBody>
                    <a:bodyPr/>
                    <a:lstStyle/>
                    <a:p>
                      <a:endParaRPr lang="en-US"/>
                    </a:p>
                  </a:txBody>
                  <a:tcPr/>
                </a:tc>
                <a:extLst>
                  <a:ext uri="{0D108BD9-81ED-4DB2-BD59-A6C34878D82A}">
                    <a16:rowId xmlns:a16="http://schemas.microsoft.com/office/drawing/2014/main" val="450300719"/>
                  </a:ext>
                </a:extLst>
              </a:tr>
              <a:tr h="509196">
                <a:tc>
                  <a:txBody>
                    <a:bodyPr/>
                    <a:lstStyle/>
                    <a:p>
                      <a:r>
                        <a:rPr lang="en-US"/>
                        <a:t>HCO3</a:t>
                      </a:r>
                    </a:p>
                  </a:txBody>
                  <a:tcPr/>
                </a:tc>
                <a:tc>
                  <a:txBody>
                    <a:bodyPr/>
                    <a:lstStyle/>
                    <a:p>
                      <a:endParaRPr lang="en-US"/>
                    </a:p>
                  </a:txBody>
                  <a:tcPr/>
                </a:tc>
                <a:tc>
                  <a:txBody>
                    <a:bodyPr/>
                    <a:lstStyle/>
                    <a:p>
                      <a:endParaRPr lang="en-US"/>
                    </a:p>
                  </a:txBody>
                  <a:tcPr/>
                </a:tc>
                <a:tc>
                  <a:txBody>
                    <a:bodyPr/>
                    <a:lstStyle/>
                    <a:p>
                      <a:endParaRPr lang="en-US"/>
                    </a:p>
                  </a:txBody>
                  <a:tcPr/>
                </a:tc>
                <a:extLst>
                  <a:ext uri="{0D108BD9-81ED-4DB2-BD59-A6C34878D82A}">
                    <a16:rowId xmlns:a16="http://schemas.microsoft.com/office/drawing/2014/main" val="435336150"/>
                  </a:ext>
                </a:extLst>
              </a:tr>
            </a:tbl>
          </a:graphicData>
        </a:graphic>
      </p:graphicFrame>
      <p:cxnSp>
        <p:nvCxnSpPr>
          <p:cNvPr id="6" name="Straight Arrow Connector 5">
            <a:extLst>
              <a:ext uri="{FF2B5EF4-FFF2-40B4-BE49-F238E27FC236}">
                <a16:creationId xmlns:a16="http://schemas.microsoft.com/office/drawing/2014/main" id="{AD9D1581-E099-49B4-80C3-BDF06F85D4C7}"/>
              </a:ext>
            </a:extLst>
          </p:cNvPr>
          <p:cNvCxnSpPr/>
          <p:nvPr/>
        </p:nvCxnSpPr>
        <p:spPr>
          <a:xfrm>
            <a:off x="7158638" y="2395537"/>
            <a:ext cx="0" cy="314325"/>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7" name="Straight Arrow Connector 6">
            <a:extLst>
              <a:ext uri="{FF2B5EF4-FFF2-40B4-BE49-F238E27FC236}">
                <a16:creationId xmlns:a16="http://schemas.microsoft.com/office/drawing/2014/main" id="{6B4D21C3-481F-4D76-8441-5689C181C2E2}"/>
              </a:ext>
            </a:extLst>
          </p:cNvPr>
          <p:cNvCxnSpPr/>
          <p:nvPr/>
        </p:nvCxnSpPr>
        <p:spPr>
          <a:xfrm>
            <a:off x="7034813" y="1952624"/>
            <a:ext cx="0" cy="314325"/>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8" name="Straight Arrow Connector 7">
            <a:extLst>
              <a:ext uri="{FF2B5EF4-FFF2-40B4-BE49-F238E27FC236}">
                <a16:creationId xmlns:a16="http://schemas.microsoft.com/office/drawing/2014/main" id="{32166715-A1BE-47FA-8F2C-8B81ABA06330}"/>
              </a:ext>
            </a:extLst>
          </p:cNvPr>
          <p:cNvCxnSpPr/>
          <p:nvPr/>
        </p:nvCxnSpPr>
        <p:spPr>
          <a:xfrm>
            <a:off x="6930038" y="2395537"/>
            <a:ext cx="0" cy="314325"/>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9" name="Straight Arrow Connector 8">
            <a:extLst>
              <a:ext uri="{FF2B5EF4-FFF2-40B4-BE49-F238E27FC236}">
                <a16:creationId xmlns:a16="http://schemas.microsoft.com/office/drawing/2014/main" id="{7FE66D21-5A27-4579-8126-F9635873AA65}"/>
              </a:ext>
            </a:extLst>
          </p:cNvPr>
          <p:cNvCxnSpPr/>
          <p:nvPr/>
        </p:nvCxnSpPr>
        <p:spPr>
          <a:xfrm>
            <a:off x="4918661" y="2400300"/>
            <a:ext cx="0" cy="314325"/>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0" name="Straight Arrow Connector 9">
            <a:extLst>
              <a:ext uri="{FF2B5EF4-FFF2-40B4-BE49-F238E27FC236}">
                <a16:creationId xmlns:a16="http://schemas.microsoft.com/office/drawing/2014/main" id="{1E98889F-1811-43FE-BBAF-D313D6C01E97}"/>
              </a:ext>
            </a:extLst>
          </p:cNvPr>
          <p:cNvCxnSpPr/>
          <p:nvPr/>
        </p:nvCxnSpPr>
        <p:spPr>
          <a:xfrm>
            <a:off x="2990850" y="2933700"/>
            <a:ext cx="0" cy="314325"/>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2" name="Straight Arrow Connector 11">
            <a:extLst>
              <a:ext uri="{FF2B5EF4-FFF2-40B4-BE49-F238E27FC236}">
                <a16:creationId xmlns:a16="http://schemas.microsoft.com/office/drawing/2014/main" id="{BCD8E668-B0BF-4297-84B7-849940F987DD}"/>
              </a:ext>
            </a:extLst>
          </p:cNvPr>
          <p:cNvCxnSpPr>
            <a:cxnSpLocks/>
          </p:cNvCxnSpPr>
          <p:nvPr/>
        </p:nvCxnSpPr>
        <p:spPr>
          <a:xfrm>
            <a:off x="2800350" y="3629025"/>
            <a:ext cx="409575"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4" name="Straight Arrow Connector 13">
            <a:extLst>
              <a:ext uri="{FF2B5EF4-FFF2-40B4-BE49-F238E27FC236}">
                <a16:creationId xmlns:a16="http://schemas.microsoft.com/office/drawing/2014/main" id="{77AD2118-A40A-4792-AB0D-029F8DBDF0B6}"/>
              </a:ext>
            </a:extLst>
          </p:cNvPr>
          <p:cNvCxnSpPr>
            <a:cxnSpLocks/>
          </p:cNvCxnSpPr>
          <p:nvPr/>
        </p:nvCxnSpPr>
        <p:spPr>
          <a:xfrm>
            <a:off x="4713873" y="3629025"/>
            <a:ext cx="409575"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5" name="Straight Arrow Connector 14">
            <a:extLst>
              <a:ext uri="{FF2B5EF4-FFF2-40B4-BE49-F238E27FC236}">
                <a16:creationId xmlns:a16="http://schemas.microsoft.com/office/drawing/2014/main" id="{A1CB3F66-DE92-4400-9922-C7A1E574FE99}"/>
              </a:ext>
            </a:extLst>
          </p:cNvPr>
          <p:cNvCxnSpPr/>
          <p:nvPr/>
        </p:nvCxnSpPr>
        <p:spPr>
          <a:xfrm>
            <a:off x="7061547" y="3471862"/>
            <a:ext cx="0" cy="314325"/>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7" name="Straight Arrow Connector 16">
            <a:extLst>
              <a:ext uri="{FF2B5EF4-FFF2-40B4-BE49-F238E27FC236}">
                <a16:creationId xmlns:a16="http://schemas.microsoft.com/office/drawing/2014/main" id="{E28E5C0F-2BE5-4409-A13A-05517FBFE977}"/>
              </a:ext>
            </a:extLst>
          </p:cNvPr>
          <p:cNvCxnSpPr/>
          <p:nvPr/>
        </p:nvCxnSpPr>
        <p:spPr>
          <a:xfrm flipV="1">
            <a:off x="2990850" y="1957387"/>
            <a:ext cx="0" cy="314325"/>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8" name="Straight Arrow Connector 17">
            <a:extLst>
              <a:ext uri="{FF2B5EF4-FFF2-40B4-BE49-F238E27FC236}">
                <a16:creationId xmlns:a16="http://schemas.microsoft.com/office/drawing/2014/main" id="{5C119A4D-5155-4C75-AB07-FCF6637C0CC9}"/>
              </a:ext>
            </a:extLst>
          </p:cNvPr>
          <p:cNvCxnSpPr/>
          <p:nvPr/>
        </p:nvCxnSpPr>
        <p:spPr>
          <a:xfrm flipV="1">
            <a:off x="7082438" y="2928937"/>
            <a:ext cx="0" cy="314325"/>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9" name="Straight Arrow Connector 18">
            <a:extLst>
              <a:ext uri="{FF2B5EF4-FFF2-40B4-BE49-F238E27FC236}">
                <a16:creationId xmlns:a16="http://schemas.microsoft.com/office/drawing/2014/main" id="{03EAB633-C97F-4169-AB48-90C9479A7A00}"/>
              </a:ext>
            </a:extLst>
          </p:cNvPr>
          <p:cNvCxnSpPr>
            <a:cxnSpLocks/>
          </p:cNvCxnSpPr>
          <p:nvPr/>
        </p:nvCxnSpPr>
        <p:spPr>
          <a:xfrm>
            <a:off x="4685298" y="2047875"/>
            <a:ext cx="409575"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20" name="Straight Arrow Connector 19">
            <a:extLst>
              <a:ext uri="{FF2B5EF4-FFF2-40B4-BE49-F238E27FC236}">
                <a16:creationId xmlns:a16="http://schemas.microsoft.com/office/drawing/2014/main" id="{49E41EFB-9044-43E8-AC4A-84D3B15DE929}"/>
              </a:ext>
            </a:extLst>
          </p:cNvPr>
          <p:cNvCxnSpPr>
            <a:cxnSpLocks/>
          </p:cNvCxnSpPr>
          <p:nvPr/>
        </p:nvCxnSpPr>
        <p:spPr>
          <a:xfrm>
            <a:off x="4685298" y="3086100"/>
            <a:ext cx="409575"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21" name="Straight Arrow Connector 20">
            <a:extLst>
              <a:ext uri="{FF2B5EF4-FFF2-40B4-BE49-F238E27FC236}">
                <a16:creationId xmlns:a16="http://schemas.microsoft.com/office/drawing/2014/main" id="{53C2C7B5-DED1-41E7-9598-2CD1DDE4205A}"/>
              </a:ext>
            </a:extLst>
          </p:cNvPr>
          <p:cNvCxnSpPr>
            <a:cxnSpLocks/>
          </p:cNvCxnSpPr>
          <p:nvPr/>
        </p:nvCxnSpPr>
        <p:spPr>
          <a:xfrm>
            <a:off x="2800350" y="2571750"/>
            <a:ext cx="409575"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24945547"/>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330"/>
        <p:cNvGrpSpPr/>
        <p:nvPr/>
      </p:nvGrpSpPr>
      <p:grpSpPr>
        <a:xfrm>
          <a:off x="0" y="0"/>
          <a:ext cx="0" cy="0"/>
          <a:chOff x="0" y="0"/>
          <a:chExt cx="0" cy="0"/>
        </a:xfrm>
      </p:grpSpPr>
      <p:sp>
        <p:nvSpPr>
          <p:cNvPr id="331" name="Google Shape;331;p27"/>
          <p:cNvSpPr txBox="1">
            <a:spLocks noGrp="1"/>
          </p:cNvSpPr>
          <p:nvPr>
            <p:ph type="title"/>
          </p:nvPr>
        </p:nvSpPr>
        <p:spPr>
          <a:xfrm>
            <a:off x="1032075" y="966325"/>
            <a:ext cx="7081800" cy="3188100"/>
          </a:xfrm>
          <a:prstGeom prst="rect">
            <a:avLst/>
          </a:prstGeom>
        </p:spPr>
        <p:txBody>
          <a:bodyPr spcFirstLastPara="1" wrap="square" lIns="0" tIns="0" rIns="0" bIns="0" anchor="ctr" anchorCtr="0">
            <a:noAutofit/>
          </a:bodyPr>
          <a:lstStyle/>
          <a:p>
            <a:pPr marL="0" lvl="0" indent="0" algn="ctr" rtl="0">
              <a:spcBef>
                <a:spcPts val="0"/>
              </a:spcBef>
              <a:spcAft>
                <a:spcPts val="0"/>
              </a:spcAft>
              <a:buNone/>
            </a:pPr>
            <a:r>
              <a:rPr lang="en"/>
              <a:t>This is the ABG of a 14-year-old female presenting with tachypnea and tachycardia with reported tinnitus and vertigo after an unknown ingestion</a:t>
            </a:r>
            <a:endParaRPr/>
          </a:p>
        </p:txBody>
      </p:sp>
      <p:sp>
        <p:nvSpPr>
          <p:cNvPr id="332" name="Google Shape;332;p27"/>
          <p:cNvSpPr txBox="1">
            <a:spLocks noGrp="1"/>
          </p:cNvSpPr>
          <p:nvPr>
            <p:ph type="subTitle" idx="1"/>
          </p:nvPr>
        </p:nvSpPr>
        <p:spPr>
          <a:xfrm>
            <a:off x="1038650" y="640325"/>
            <a:ext cx="7079700" cy="444300"/>
          </a:xfrm>
          <a:prstGeom prst="rect">
            <a:avLst/>
          </a:prstGeom>
        </p:spPr>
        <p:txBody>
          <a:bodyPr spcFirstLastPara="1" wrap="square" lIns="0" tIns="0" rIns="0" bIns="0" anchor="t" anchorCtr="0">
            <a:noAutofit/>
          </a:bodyPr>
          <a:lstStyle/>
          <a:p>
            <a:pPr marL="0" lvl="0" indent="0" algn="ctr" rtl="0">
              <a:spcBef>
                <a:spcPts val="600"/>
              </a:spcBef>
              <a:spcAft>
                <a:spcPts val="0"/>
              </a:spcAft>
              <a:buNone/>
            </a:pPr>
            <a:r>
              <a:rPr lang="en"/>
              <a:t>CATEGORY 2 · </a:t>
            </a:r>
            <a:r>
              <a:rPr lang="en">
                <a:solidFill>
                  <a:srgbClr val="FFC319"/>
                </a:solidFill>
              </a:rPr>
              <a:t>$1000</a:t>
            </a:r>
            <a:endParaRPr>
              <a:solidFill>
                <a:srgbClr val="FFC319"/>
              </a:solidFill>
            </a:endParaRPr>
          </a:p>
        </p:txBody>
      </p:sp>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4">
            <a:extLst>
              <a:ext uri="{FF2B5EF4-FFF2-40B4-BE49-F238E27FC236}">
                <a16:creationId xmlns:a16="http://schemas.microsoft.com/office/drawing/2014/main" id="{11491989-8829-49A2-8871-482CCB5D3D0E}"/>
              </a:ext>
            </a:extLst>
          </p:cNvPr>
          <p:cNvGraphicFramePr>
            <a:graphicFrameLocks noGrp="1"/>
          </p:cNvGraphicFramePr>
          <p:nvPr>
            <p:extLst>
              <p:ext uri="{D42A27DB-BD31-4B8C-83A1-F6EECF244321}">
                <p14:modId xmlns:p14="http://schemas.microsoft.com/office/powerpoint/2010/main" val="3958732734"/>
              </p:ext>
            </p:extLst>
          </p:nvPr>
        </p:nvGraphicFramePr>
        <p:xfrm>
          <a:off x="820245" y="1083833"/>
          <a:ext cx="7362828" cy="2527050"/>
        </p:xfrm>
        <a:graphic>
          <a:graphicData uri="http://schemas.openxmlformats.org/drawingml/2006/table">
            <a:tbl>
              <a:tblPr firstRow="1" bandRow="1">
                <a:tableStyleId>{5C22544A-7EE6-4342-B048-85BDC9FD1C3A}</a:tableStyleId>
              </a:tblPr>
              <a:tblGrid>
                <a:gridCol w="1227138">
                  <a:extLst>
                    <a:ext uri="{9D8B030D-6E8A-4147-A177-3AD203B41FA5}">
                      <a16:colId xmlns:a16="http://schemas.microsoft.com/office/drawing/2014/main" val="2956672230"/>
                    </a:ext>
                  </a:extLst>
                </a:gridCol>
                <a:gridCol w="1227138">
                  <a:extLst>
                    <a:ext uri="{9D8B030D-6E8A-4147-A177-3AD203B41FA5}">
                      <a16:colId xmlns:a16="http://schemas.microsoft.com/office/drawing/2014/main" val="3366791402"/>
                    </a:ext>
                  </a:extLst>
                </a:gridCol>
                <a:gridCol w="1227138">
                  <a:extLst>
                    <a:ext uri="{9D8B030D-6E8A-4147-A177-3AD203B41FA5}">
                      <a16:colId xmlns:a16="http://schemas.microsoft.com/office/drawing/2014/main" val="1166372328"/>
                    </a:ext>
                  </a:extLst>
                </a:gridCol>
                <a:gridCol w="1227138">
                  <a:extLst>
                    <a:ext uri="{9D8B030D-6E8A-4147-A177-3AD203B41FA5}">
                      <a16:colId xmlns:a16="http://schemas.microsoft.com/office/drawing/2014/main" val="3425385262"/>
                    </a:ext>
                  </a:extLst>
                </a:gridCol>
                <a:gridCol w="1227138">
                  <a:extLst>
                    <a:ext uri="{9D8B030D-6E8A-4147-A177-3AD203B41FA5}">
                      <a16:colId xmlns:a16="http://schemas.microsoft.com/office/drawing/2014/main" val="1561456660"/>
                    </a:ext>
                  </a:extLst>
                </a:gridCol>
                <a:gridCol w="1227138">
                  <a:extLst>
                    <a:ext uri="{9D8B030D-6E8A-4147-A177-3AD203B41FA5}">
                      <a16:colId xmlns:a16="http://schemas.microsoft.com/office/drawing/2014/main" val="3670303674"/>
                    </a:ext>
                  </a:extLst>
                </a:gridCol>
              </a:tblGrid>
              <a:tr h="505410">
                <a:tc>
                  <a:txBody>
                    <a:bodyPr/>
                    <a:lstStyle/>
                    <a:p>
                      <a:pPr algn="ctr"/>
                      <a:r>
                        <a:rPr lang="en-US"/>
                        <a:t>pH</a:t>
                      </a:r>
                    </a:p>
                  </a:txBody>
                  <a:tcPr/>
                </a:tc>
                <a:tc>
                  <a:txBody>
                    <a:bodyPr/>
                    <a:lstStyle/>
                    <a:p>
                      <a:pPr algn="ctr"/>
                      <a:r>
                        <a:rPr lang="en-US"/>
                        <a:t>pCO2</a:t>
                      </a:r>
                    </a:p>
                  </a:txBody>
                  <a:tcPr/>
                </a:tc>
                <a:tc>
                  <a:txBody>
                    <a:bodyPr/>
                    <a:lstStyle/>
                    <a:p>
                      <a:pPr algn="ctr"/>
                      <a:r>
                        <a:rPr lang="en-US"/>
                        <a:t>HCO3-</a:t>
                      </a:r>
                    </a:p>
                  </a:txBody>
                  <a:tcPr/>
                </a:tc>
                <a:tc>
                  <a:txBody>
                    <a:bodyPr/>
                    <a:lstStyle/>
                    <a:p>
                      <a:pPr algn="ctr"/>
                      <a:r>
                        <a:rPr lang="en-US"/>
                        <a:t>Na+</a:t>
                      </a:r>
                    </a:p>
                  </a:txBody>
                  <a:tcPr/>
                </a:tc>
                <a:tc>
                  <a:txBody>
                    <a:bodyPr/>
                    <a:lstStyle/>
                    <a:p>
                      <a:pPr algn="ctr"/>
                      <a:r>
                        <a:rPr lang="en-US"/>
                        <a:t>K+</a:t>
                      </a:r>
                    </a:p>
                  </a:txBody>
                  <a:tcPr/>
                </a:tc>
                <a:tc>
                  <a:txBody>
                    <a:bodyPr/>
                    <a:lstStyle/>
                    <a:p>
                      <a:pPr algn="ctr"/>
                      <a:r>
                        <a:rPr lang="en-US"/>
                        <a:t>Cl-</a:t>
                      </a:r>
                    </a:p>
                  </a:txBody>
                  <a:tcPr/>
                </a:tc>
                <a:extLst>
                  <a:ext uri="{0D108BD9-81ED-4DB2-BD59-A6C34878D82A}">
                    <a16:rowId xmlns:a16="http://schemas.microsoft.com/office/drawing/2014/main" val="3925621980"/>
                  </a:ext>
                </a:extLst>
              </a:tr>
              <a:tr h="505410">
                <a:tc>
                  <a:txBody>
                    <a:bodyPr/>
                    <a:lstStyle/>
                    <a:p>
                      <a:r>
                        <a:rPr lang="en-US"/>
                        <a:t>7.29</a:t>
                      </a:r>
                    </a:p>
                  </a:txBody>
                  <a:tcPr/>
                </a:tc>
                <a:tc>
                  <a:txBody>
                    <a:bodyPr/>
                    <a:lstStyle/>
                    <a:p>
                      <a:r>
                        <a:rPr lang="en-US"/>
                        <a:t>35</a:t>
                      </a:r>
                    </a:p>
                  </a:txBody>
                  <a:tcPr/>
                </a:tc>
                <a:tc>
                  <a:txBody>
                    <a:bodyPr/>
                    <a:lstStyle/>
                    <a:p>
                      <a:r>
                        <a:rPr lang="en-US"/>
                        <a:t>24</a:t>
                      </a:r>
                    </a:p>
                  </a:txBody>
                  <a:tcPr/>
                </a:tc>
                <a:tc>
                  <a:txBody>
                    <a:bodyPr/>
                    <a:lstStyle/>
                    <a:p>
                      <a:r>
                        <a:rPr lang="en-US"/>
                        <a:t>140</a:t>
                      </a:r>
                    </a:p>
                  </a:txBody>
                  <a:tcPr/>
                </a:tc>
                <a:tc>
                  <a:txBody>
                    <a:bodyPr/>
                    <a:lstStyle/>
                    <a:p>
                      <a:r>
                        <a:rPr lang="en-US"/>
                        <a:t>4.2</a:t>
                      </a:r>
                    </a:p>
                  </a:txBody>
                  <a:tcPr/>
                </a:tc>
                <a:tc>
                  <a:txBody>
                    <a:bodyPr/>
                    <a:lstStyle/>
                    <a:p>
                      <a:r>
                        <a:rPr lang="en-US"/>
                        <a:t>110</a:t>
                      </a:r>
                    </a:p>
                  </a:txBody>
                  <a:tcPr/>
                </a:tc>
                <a:extLst>
                  <a:ext uri="{0D108BD9-81ED-4DB2-BD59-A6C34878D82A}">
                    <a16:rowId xmlns:a16="http://schemas.microsoft.com/office/drawing/2014/main" val="1549369976"/>
                  </a:ext>
                </a:extLst>
              </a:tr>
              <a:tr h="505410">
                <a:tc>
                  <a:txBody>
                    <a:bodyPr/>
                    <a:lstStyle/>
                    <a:p>
                      <a:r>
                        <a:rPr lang="en-US" b="0"/>
                        <a:t>7.29</a:t>
                      </a:r>
                    </a:p>
                  </a:txBody>
                  <a:tcPr/>
                </a:tc>
                <a:tc>
                  <a:txBody>
                    <a:bodyPr/>
                    <a:lstStyle/>
                    <a:p>
                      <a:r>
                        <a:rPr lang="en-US" b="0"/>
                        <a:t>30</a:t>
                      </a:r>
                    </a:p>
                  </a:txBody>
                  <a:tcPr/>
                </a:tc>
                <a:tc>
                  <a:txBody>
                    <a:bodyPr/>
                    <a:lstStyle/>
                    <a:p>
                      <a:r>
                        <a:rPr lang="en-US" b="0"/>
                        <a:t>14</a:t>
                      </a:r>
                    </a:p>
                  </a:txBody>
                  <a:tcPr/>
                </a:tc>
                <a:tc>
                  <a:txBody>
                    <a:bodyPr/>
                    <a:lstStyle/>
                    <a:p>
                      <a:r>
                        <a:rPr lang="en-US" b="0"/>
                        <a:t>140</a:t>
                      </a:r>
                    </a:p>
                  </a:txBody>
                  <a:tcPr/>
                </a:tc>
                <a:tc>
                  <a:txBody>
                    <a:bodyPr/>
                    <a:lstStyle/>
                    <a:p>
                      <a:r>
                        <a:rPr lang="en-US" b="0"/>
                        <a:t>4.2</a:t>
                      </a:r>
                    </a:p>
                  </a:txBody>
                  <a:tcPr/>
                </a:tc>
                <a:tc>
                  <a:txBody>
                    <a:bodyPr/>
                    <a:lstStyle/>
                    <a:p>
                      <a:r>
                        <a:rPr lang="en-US" b="0"/>
                        <a:t>110</a:t>
                      </a:r>
                    </a:p>
                  </a:txBody>
                  <a:tcPr/>
                </a:tc>
                <a:extLst>
                  <a:ext uri="{0D108BD9-81ED-4DB2-BD59-A6C34878D82A}">
                    <a16:rowId xmlns:a16="http://schemas.microsoft.com/office/drawing/2014/main" val="3365227491"/>
                  </a:ext>
                </a:extLst>
              </a:tr>
              <a:tr h="505410">
                <a:tc>
                  <a:txBody>
                    <a:bodyPr/>
                    <a:lstStyle/>
                    <a:p>
                      <a:r>
                        <a:rPr lang="en-US"/>
                        <a:t>7.35</a:t>
                      </a:r>
                    </a:p>
                  </a:txBody>
                  <a:tcPr/>
                </a:tc>
                <a:tc>
                  <a:txBody>
                    <a:bodyPr/>
                    <a:lstStyle/>
                    <a:p>
                      <a:r>
                        <a:rPr lang="en-US"/>
                        <a:t>40</a:t>
                      </a:r>
                    </a:p>
                  </a:txBody>
                  <a:tcPr/>
                </a:tc>
                <a:tc>
                  <a:txBody>
                    <a:bodyPr/>
                    <a:lstStyle/>
                    <a:p>
                      <a:r>
                        <a:rPr lang="en-US"/>
                        <a:t>24</a:t>
                      </a:r>
                    </a:p>
                  </a:txBody>
                  <a:tcPr/>
                </a:tc>
                <a:tc>
                  <a:txBody>
                    <a:bodyPr/>
                    <a:lstStyle/>
                    <a:p>
                      <a:r>
                        <a:rPr lang="en-US"/>
                        <a:t>140</a:t>
                      </a:r>
                    </a:p>
                  </a:txBody>
                  <a:tcPr/>
                </a:tc>
                <a:tc>
                  <a:txBody>
                    <a:bodyPr/>
                    <a:lstStyle/>
                    <a:p>
                      <a:r>
                        <a:rPr lang="en-US"/>
                        <a:t>4.2</a:t>
                      </a:r>
                    </a:p>
                  </a:txBody>
                  <a:tcPr/>
                </a:tc>
                <a:tc>
                  <a:txBody>
                    <a:bodyPr/>
                    <a:lstStyle/>
                    <a:p>
                      <a:r>
                        <a:rPr lang="en-US"/>
                        <a:t>110</a:t>
                      </a:r>
                    </a:p>
                  </a:txBody>
                  <a:tcPr/>
                </a:tc>
                <a:extLst>
                  <a:ext uri="{0D108BD9-81ED-4DB2-BD59-A6C34878D82A}">
                    <a16:rowId xmlns:a16="http://schemas.microsoft.com/office/drawing/2014/main" val="2197128974"/>
                  </a:ext>
                </a:extLst>
              </a:tr>
              <a:tr h="505410">
                <a:tc>
                  <a:txBody>
                    <a:bodyPr/>
                    <a:lstStyle/>
                    <a:p>
                      <a:r>
                        <a:rPr lang="en-US"/>
                        <a:t>7.40</a:t>
                      </a:r>
                    </a:p>
                  </a:txBody>
                  <a:tcPr/>
                </a:tc>
                <a:tc>
                  <a:txBody>
                    <a:bodyPr/>
                    <a:lstStyle/>
                    <a:p>
                      <a:r>
                        <a:rPr lang="en-US"/>
                        <a:t>35</a:t>
                      </a:r>
                    </a:p>
                  </a:txBody>
                  <a:tcPr/>
                </a:tc>
                <a:tc>
                  <a:txBody>
                    <a:bodyPr/>
                    <a:lstStyle/>
                    <a:p>
                      <a:r>
                        <a:rPr lang="en-US"/>
                        <a:t>24</a:t>
                      </a:r>
                    </a:p>
                  </a:txBody>
                  <a:tcPr/>
                </a:tc>
                <a:tc>
                  <a:txBody>
                    <a:bodyPr/>
                    <a:lstStyle/>
                    <a:p>
                      <a:r>
                        <a:rPr lang="en-US"/>
                        <a:t>140</a:t>
                      </a:r>
                    </a:p>
                  </a:txBody>
                  <a:tcPr/>
                </a:tc>
                <a:tc>
                  <a:txBody>
                    <a:bodyPr/>
                    <a:lstStyle/>
                    <a:p>
                      <a:r>
                        <a:rPr lang="en-US"/>
                        <a:t>4.2</a:t>
                      </a:r>
                    </a:p>
                  </a:txBody>
                  <a:tcPr/>
                </a:tc>
                <a:tc>
                  <a:txBody>
                    <a:bodyPr/>
                    <a:lstStyle/>
                    <a:p>
                      <a:r>
                        <a:rPr lang="en-US"/>
                        <a:t>110</a:t>
                      </a:r>
                    </a:p>
                  </a:txBody>
                  <a:tcPr/>
                </a:tc>
                <a:extLst>
                  <a:ext uri="{0D108BD9-81ED-4DB2-BD59-A6C34878D82A}">
                    <a16:rowId xmlns:a16="http://schemas.microsoft.com/office/drawing/2014/main" val="463883610"/>
                  </a:ext>
                </a:extLst>
              </a:tr>
            </a:tbl>
          </a:graphicData>
        </a:graphic>
      </p:graphicFrame>
    </p:spTree>
    <p:extLst>
      <p:ext uri="{BB962C8B-B14F-4D97-AF65-F5344CB8AC3E}">
        <p14:creationId xmlns:p14="http://schemas.microsoft.com/office/powerpoint/2010/main" val="799443949"/>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4">
            <a:extLst>
              <a:ext uri="{FF2B5EF4-FFF2-40B4-BE49-F238E27FC236}">
                <a16:creationId xmlns:a16="http://schemas.microsoft.com/office/drawing/2014/main" id="{11491989-8829-49A2-8871-482CCB5D3D0E}"/>
              </a:ext>
            </a:extLst>
          </p:cNvPr>
          <p:cNvGraphicFramePr>
            <a:graphicFrameLocks noGrp="1"/>
          </p:cNvGraphicFramePr>
          <p:nvPr>
            <p:extLst>
              <p:ext uri="{D42A27DB-BD31-4B8C-83A1-F6EECF244321}">
                <p14:modId xmlns:p14="http://schemas.microsoft.com/office/powerpoint/2010/main" val="2332507471"/>
              </p:ext>
            </p:extLst>
          </p:nvPr>
        </p:nvGraphicFramePr>
        <p:xfrm>
          <a:off x="897086" y="315429"/>
          <a:ext cx="7362828" cy="2527050"/>
        </p:xfrm>
        <a:graphic>
          <a:graphicData uri="http://schemas.openxmlformats.org/drawingml/2006/table">
            <a:tbl>
              <a:tblPr firstRow="1" bandRow="1">
                <a:tableStyleId>{5C22544A-7EE6-4342-B048-85BDC9FD1C3A}</a:tableStyleId>
              </a:tblPr>
              <a:tblGrid>
                <a:gridCol w="1227138">
                  <a:extLst>
                    <a:ext uri="{9D8B030D-6E8A-4147-A177-3AD203B41FA5}">
                      <a16:colId xmlns:a16="http://schemas.microsoft.com/office/drawing/2014/main" val="2956672230"/>
                    </a:ext>
                  </a:extLst>
                </a:gridCol>
                <a:gridCol w="1227138">
                  <a:extLst>
                    <a:ext uri="{9D8B030D-6E8A-4147-A177-3AD203B41FA5}">
                      <a16:colId xmlns:a16="http://schemas.microsoft.com/office/drawing/2014/main" val="3366791402"/>
                    </a:ext>
                  </a:extLst>
                </a:gridCol>
                <a:gridCol w="1227138">
                  <a:extLst>
                    <a:ext uri="{9D8B030D-6E8A-4147-A177-3AD203B41FA5}">
                      <a16:colId xmlns:a16="http://schemas.microsoft.com/office/drawing/2014/main" val="1166372328"/>
                    </a:ext>
                  </a:extLst>
                </a:gridCol>
                <a:gridCol w="1227138">
                  <a:extLst>
                    <a:ext uri="{9D8B030D-6E8A-4147-A177-3AD203B41FA5}">
                      <a16:colId xmlns:a16="http://schemas.microsoft.com/office/drawing/2014/main" val="3425385262"/>
                    </a:ext>
                  </a:extLst>
                </a:gridCol>
                <a:gridCol w="1227138">
                  <a:extLst>
                    <a:ext uri="{9D8B030D-6E8A-4147-A177-3AD203B41FA5}">
                      <a16:colId xmlns:a16="http://schemas.microsoft.com/office/drawing/2014/main" val="1561456660"/>
                    </a:ext>
                  </a:extLst>
                </a:gridCol>
                <a:gridCol w="1227138">
                  <a:extLst>
                    <a:ext uri="{9D8B030D-6E8A-4147-A177-3AD203B41FA5}">
                      <a16:colId xmlns:a16="http://schemas.microsoft.com/office/drawing/2014/main" val="3670303674"/>
                    </a:ext>
                  </a:extLst>
                </a:gridCol>
              </a:tblGrid>
              <a:tr h="505410">
                <a:tc>
                  <a:txBody>
                    <a:bodyPr/>
                    <a:lstStyle/>
                    <a:p>
                      <a:pPr algn="ctr"/>
                      <a:r>
                        <a:rPr lang="en-US"/>
                        <a:t>pH</a:t>
                      </a:r>
                    </a:p>
                  </a:txBody>
                  <a:tcPr/>
                </a:tc>
                <a:tc>
                  <a:txBody>
                    <a:bodyPr/>
                    <a:lstStyle/>
                    <a:p>
                      <a:pPr algn="ctr"/>
                      <a:r>
                        <a:rPr lang="en-US"/>
                        <a:t>pCO2</a:t>
                      </a:r>
                    </a:p>
                  </a:txBody>
                  <a:tcPr/>
                </a:tc>
                <a:tc>
                  <a:txBody>
                    <a:bodyPr/>
                    <a:lstStyle/>
                    <a:p>
                      <a:pPr algn="ctr"/>
                      <a:r>
                        <a:rPr lang="en-US"/>
                        <a:t>HCO3-</a:t>
                      </a:r>
                    </a:p>
                  </a:txBody>
                  <a:tcPr/>
                </a:tc>
                <a:tc>
                  <a:txBody>
                    <a:bodyPr/>
                    <a:lstStyle/>
                    <a:p>
                      <a:pPr algn="ctr"/>
                      <a:r>
                        <a:rPr lang="en-US"/>
                        <a:t>Na+</a:t>
                      </a:r>
                    </a:p>
                  </a:txBody>
                  <a:tcPr/>
                </a:tc>
                <a:tc>
                  <a:txBody>
                    <a:bodyPr/>
                    <a:lstStyle/>
                    <a:p>
                      <a:pPr algn="ctr"/>
                      <a:r>
                        <a:rPr lang="en-US"/>
                        <a:t>K+</a:t>
                      </a:r>
                    </a:p>
                  </a:txBody>
                  <a:tcPr/>
                </a:tc>
                <a:tc>
                  <a:txBody>
                    <a:bodyPr/>
                    <a:lstStyle/>
                    <a:p>
                      <a:pPr algn="ctr"/>
                      <a:r>
                        <a:rPr lang="en-US"/>
                        <a:t>Cl-</a:t>
                      </a:r>
                    </a:p>
                  </a:txBody>
                  <a:tcPr/>
                </a:tc>
                <a:extLst>
                  <a:ext uri="{0D108BD9-81ED-4DB2-BD59-A6C34878D82A}">
                    <a16:rowId xmlns:a16="http://schemas.microsoft.com/office/drawing/2014/main" val="3925621980"/>
                  </a:ext>
                </a:extLst>
              </a:tr>
              <a:tr h="505410">
                <a:tc>
                  <a:txBody>
                    <a:bodyPr/>
                    <a:lstStyle/>
                    <a:p>
                      <a:r>
                        <a:rPr lang="en-US"/>
                        <a:t>7.29</a:t>
                      </a:r>
                    </a:p>
                  </a:txBody>
                  <a:tcPr/>
                </a:tc>
                <a:tc>
                  <a:txBody>
                    <a:bodyPr/>
                    <a:lstStyle/>
                    <a:p>
                      <a:r>
                        <a:rPr lang="en-US"/>
                        <a:t>35</a:t>
                      </a:r>
                    </a:p>
                  </a:txBody>
                  <a:tcPr/>
                </a:tc>
                <a:tc>
                  <a:txBody>
                    <a:bodyPr/>
                    <a:lstStyle/>
                    <a:p>
                      <a:r>
                        <a:rPr lang="en-US"/>
                        <a:t>24</a:t>
                      </a:r>
                    </a:p>
                  </a:txBody>
                  <a:tcPr/>
                </a:tc>
                <a:tc>
                  <a:txBody>
                    <a:bodyPr/>
                    <a:lstStyle/>
                    <a:p>
                      <a:r>
                        <a:rPr lang="en-US"/>
                        <a:t>140</a:t>
                      </a:r>
                    </a:p>
                  </a:txBody>
                  <a:tcPr/>
                </a:tc>
                <a:tc>
                  <a:txBody>
                    <a:bodyPr/>
                    <a:lstStyle/>
                    <a:p>
                      <a:r>
                        <a:rPr lang="en-US"/>
                        <a:t>4.5</a:t>
                      </a:r>
                    </a:p>
                  </a:txBody>
                  <a:tcPr/>
                </a:tc>
                <a:tc>
                  <a:txBody>
                    <a:bodyPr/>
                    <a:lstStyle/>
                    <a:p>
                      <a:r>
                        <a:rPr lang="en-US"/>
                        <a:t>110</a:t>
                      </a:r>
                    </a:p>
                  </a:txBody>
                  <a:tcPr/>
                </a:tc>
                <a:extLst>
                  <a:ext uri="{0D108BD9-81ED-4DB2-BD59-A6C34878D82A}">
                    <a16:rowId xmlns:a16="http://schemas.microsoft.com/office/drawing/2014/main" val="1549369976"/>
                  </a:ext>
                </a:extLst>
              </a:tr>
              <a:tr h="505410">
                <a:tc>
                  <a:txBody>
                    <a:bodyPr/>
                    <a:lstStyle/>
                    <a:p>
                      <a:r>
                        <a:rPr lang="en-US" b="1">
                          <a:highlight>
                            <a:srgbClr val="FFFF00"/>
                          </a:highlight>
                        </a:rPr>
                        <a:t>7.29</a:t>
                      </a:r>
                    </a:p>
                  </a:txBody>
                  <a:tcPr/>
                </a:tc>
                <a:tc>
                  <a:txBody>
                    <a:bodyPr/>
                    <a:lstStyle/>
                    <a:p>
                      <a:r>
                        <a:rPr lang="en-US" b="1">
                          <a:highlight>
                            <a:srgbClr val="FFFF00"/>
                          </a:highlight>
                        </a:rPr>
                        <a:t>30</a:t>
                      </a:r>
                    </a:p>
                  </a:txBody>
                  <a:tcPr/>
                </a:tc>
                <a:tc>
                  <a:txBody>
                    <a:bodyPr/>
                    <a:lstStyle/>
                    <a:p>
                      <a:r>
                        <a:rPr lang="en-US" b="1">
                          <a:highlight>
                            <a:srgbClr val="FFFF00"/>
                          </a:highlight>
                        </a:rPr>
                        <a:t>14</a:t>
                      </a:r>
                    </a:p>
                  </a:txBody>
                  <a:tcPr/>
                </a:tc>
                <a:tc>
                  <a:txBody>
                    <a:bodyPr/>
                    <a:lstStyle/>
                    <a:p>
                      <a:r>
                        <a:rPr lang="en-US" b="1">
                          <a:highlight>
                            <a:srgbClr val="FFFF00"/>
                          </a:highlight>
                        </a:rPr>
                        <a:t>140</a:t>
                      </a:r>
                    </a:p>
                  </a:txBody>
                  <a:tcPr/>
                </a:tc>
                <a:tc>
                  <a:txBody>
                    <a:bodyPr/>
                    <a:lstStyle/>
                    <a:p>
                      <a:r>
                        <a:rPr lang="en-US" b="1">
                          <a:highlight>
                            <a:srgbClr val="FFFF00"/>
                          </a:highlight>
                        </a:rPr>
                        <a:t>3.8</a:t>
                      </a:r>
                    </a:p>
                  </a:txBody>
                  <a:tcPr/>
                </a:tc>
                <a:tc>
                  <a:txBody>
                    <a:bodyPr/>
                    <a:lstStyle/>
                    <a:p>
                      <a:r>
                        <a:rPr lang="en-US" b="1">
                          <a:highlight>
                            <a:srgbClr val="FFFF00"/>
                          </a:highlight>
                        </a:rPr>
                        <a:t>110</a:t>
                      </a:r>
                    </a:p>
                  </a:txBody>
                  <a:tcPr/>
                </a:tc>
                <a:extLst>
                  <a:ext uri="{0D108BD9-81ED-4DB2-BD59-A6C34878D82A}">
                    <a16:rowId xmlns:a16="http://schemas.microsoft.com/office/drawing/2014/main" val="3365227491"/>
                  </a:ext>
                </a:extLst>
              </a:tr>
              <a:tr h="505410">
                <a:tc>
                  <a:txBody>
                    <a:bodyPr/>
                    <a:lstStyle/>
                    <a:p>
                      <a:r>
                        <a:rPr lang="en-US"/>
                        <a:t>7.35</a:t>
                      </a:r>
                    </a:p>
                  </a:txBody>
                  <a:tcPr/>
                </a:tc>
                <a:tc>
                  <a:txBody>
                    <a:bodyPr/>
                    <a:lstStyle/>
                    <a:p>
                      <a:r>
                        <a:rPr lang="en-US"/>
                        <a:t>40</a:t>
                      </a:r>
                    </a:p>
                  </a:txBody>
                  <a:tcPr/>
                </a:tc>
                <a:tc>
                  <a:txBody>
                    <a:bodyPr/>
                    <a:lstStyle/>
                    <a:p>
                      <a:r>
                        <a:rPr lang="en-US"/>
                        <a:t>24</a:t>
                      </a:r>
                    </a:p>
                  </a:txBody>
                  <a:tcPr/>
                </a:tc>
                <a:tc>
                  <a:txBody>
                    <a:bodyPr/>
                    <a:lstStyle/>
                    <a:p>
                      <a:r>
                        <a:rPr lang="en-US"/>
                        <a:t>140</a:t>
                      </a:r>
                    </a:p>
                  </a:txBody>
                  <a:tcPr/>
                </a:tc>
                <a:tc>
                  <a:txBody>
                    <a:bodyPr/>
                    <a:lstStyle/>
                    <a:p>
                      <a:r>
                        <a:rPr lang="en-US"/>
                        <a:t>3.8</a:t>
                      </a:r>
                    </a:p>
                  </a:txBody>
                  <a:tcPr/>
                </a:tc>
                <a:tc>
                  <a:txBody>
                    <a:bodyPr/>
                    <a:lstStyle/>
                    <a:p>
                      <a:r>
                        <a:rPr lang="en-US"/>
                        <a:t>110</a:t>
                      </a:r>
                    </a:p>
                  </a:txBody>
                  <a:tcPr/>
                </a:tc>
                <a:extLst>
                  <a:ext uri="{0D108BD9-81ED-4DB2-BD59-A6C34878D82A}">
                    <a16:rowId xmlns:a16="http://schemas.microsoft.com/office/drawing/2014/main" val="2197128974"/>
                  </a:ext>
                </a:extLst>
              </a:tr>
              <a:tr h="505410">
                <a:tc>
                  <a:txBody>
                    <a:bodyPr/>
                    <a:lstStyle/>
                    <a:p>
                      <a:r>
                        <a:rPr lang="en-US"/>
                        <a:t>7.40</a:t>
                      </a:r>
                    </a:p>
                  </a:txBody>
                  <a:tcPr/>
                </a:tc>
                <a:tc>
                  <a:txBody>
                    <a:bodyPr/>
                    <a:lstStyle/>
                    <a:p>
                      <a:r>
                        <a:rPr lang="en-US"/>
                        <a:t>35</a:t>
                      </a:r>
                    </a:p>
                  </a:txBody>
                  <a:tcPr/>
                </a:tc>
                <a:tc>
                  <a:txBody>
                    <a:bodyPr/>
                    <a:lstStyle/>
                    <a:p>
                      <a:r>
                        <a:rPr lang="en-US"/>
                        <a:t>24</a:t>
                      </a:r>
                    </a:p>
                  </a:txBody>
                  <a:tcPr/>
                </a:tc>
                <a:tc>
                  <a:txBody>
                    <a:bodyPr/>
                    <a:lstStyle/>
                    <a:p>
                      <a:r>
                        <a:rPr lang="en-US"/>
                        <a:t>140</a:t>
                      </a:r>
                    </a:p>
                  </a:txBody>
                  <a:tcPr/>
                </a:tc>
                <a:tc>
                  <a:txBody>
                    <a:bodyPr/>
                    <a:lstStyle/>
                    <a:p>
                      <a:r>
                        <a:rPr lang="en-US"/>
                        <a:t>4.2</a:t>
                      </a:r>
                    </a:p>
                  </a:txBody>
                  <a:tcPr/>
                </a:tc>
                <a:tc>
                  <a:txBody>
                    <a:bodyPr/>
                    <a:lstStyle/>
                    <a:p>
                      <a:r>
                        <a:rPr lang="en-US"/>
                        <a:t>110</a:t>
                      </a:r>
                    </a:p>
                  </a:txBody>
                  <a:tcPr/>
                </a:tc>
                <a:extLst>
                  <a:ext uri="{0D108BD9-81ED-4DB2-BD59-A6C34878D82A}">
                    <a16:rowId xmlns:a16="http://schemas.microsoft.com/office/drawing/2014/main" val="463883610"/>
                  </a:ext>
                </a:extLst>
              </a:tr>
            </a:tbl>
          </a:graphicData>
        </a:graphic>
      </p:graphicFrame>
      <p:sp>
        <p:nvSpPr>
          <p:cNvPr id="5" name="TextBox 4">
            <a:extLst>
              <a:ext uri="{FF2B5EF4-FFF2-40B4-BE49-F238E27FC236}">
                <a16:creationId xmlns:a16="http://schemas.microsoft.com/office/drawing/2014/main" id="{D1C8E11B-4594-438C-9421-9C528973B73F}"/>
              </a:ext>
            </a:extLst>
          </p:cNvPr>
          <p:cNvSpPr txBox="1"/>
          <p:nvPr/>
        </p:nvSpPr>
        <p:spPr>
          <a:xfrm>
            <a:off x="983556" y="3030117"/>
            <a:ext cx="6769634" cy="954107"/>
          </a:xfrm>
          <a:prstGeom prst="rect">
            <a:avLst/>
          </a:prstGeom>
          <a:noFill/>
        </p:spPr>
        <p:txBody>
          <a:bodyPr wrap="square" rtlCol="0">
            <a:spAutoFit/>
          </a:bodyPr>
          <a:lstStyle/>
          <a:p>
            <a:pPr marL="342900" indent="-342900">
              <a:buAutoNum type="arabicPeriod"/>
            </a:pPr>
            <a:r>
              <a:rPr lang="en-US">
                <a:solidFill>
                  <a:schemeClr val="bg1"/>
                </a:solidFill>
              </a:rPr>
              <a:t>pH: Acidosis </a:t>
            </a:r>
          </a:p>
          <a:p>
            <a:pPr marL="342900" indent="-342900">
              <a:buAutoNum type="arabicPeriod"/>
            </a:pPr>
            <a:r>
              <a:rPr lang="en-US">
                <a:solidFill>
                  <a:schemeClr val="bg1"/>
                </a:solidFill>
              </a:rPr>
              <a:t>pCO2: low (alkalosis)</a:t>
            </a:r>
          </a:p>
          <a:p>
            <a:pPr marL="342900" indent="-342900">
              <a:buAutoNum type="arabicPeriod"/>
            </a:pPr>
            <a:r>
              <a:rPr lang="en-US">
                <a:solidFill>
                  <a:schemeClr val="bg1"/>
                </a:solidFill>
              </a:rPr>
              <a:t>HCO3 : low (base deficit) + low pH = metabolic acidosis</a:t>
            </a:r>
          </a:p>
          <a:p>
            <a:pPr marL="342900" indent="-342900">
              <a:buAutoNum type="arabicPeriod"/>
            </a:pPr>
            <a:r>
              <a:rPr lang="en-US">
                <a:solidFill>
                  <a:schemeClr val="bg1"/>
                </a:solidFill>
              </a:rPr>
              <a:t>Is there an anion gap?</a:t>
            </a:r>
          </a:p>
        </p:txBody>
      </p:sp>
    </p:spTree>
    <p:extLst>
      <p:ext uri="{BB962C8B-B14F-4D97-AF65-F5344CB8AC3E}">
        <p14:creationId xmlns:p14="http://schemas.microsoft.com/office/powerpoint/2010/main" val="3117783798"/>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6F1F157-B747-43D9-81E5-23B220AFE547}"/>
              </a:ext>
            </a:extLst>
          </p:cNvPr>
          <p:cNvSpPr>
            <a:spLocks noGrp="1"/>
          </p:cNvSpPr>
          <p:nvPr>
            <p:ph type="title"/>
          </p:nvPr>
        </p:nvSpPr>
        <p:spPr/>
        <p:txBody>
          <a:bodyPr/>
          <a:lstStyle/>
          <a:p>
            <a:r>
              <a:rPr lang="en-US"/>
              <a:t>(Na</a:t>
            </a:r>
            <a:r>
              <a:rPr lang="en-US" baseline="30000"/>
              <a:t>+</a:t>
            </a:r>
            <a:r>
              <a:rPr lang="en-US"/>
              <a:t>+K</a:t>
            </a:r>
            <a:r>
              <a:rPr lang="en-US" baseline="30000"/>
              <a:t>+</a:t>
            </a:r>
            <a:r>
              <a:rPr lang="en-US"/>
              <a:t>)-(HCO3</a:t>
            </a:r>
            <a:r>
              <a:rPr lang="en-US" baseline="30000"/>
              <a:t>-</a:t>
            </a:r>
            <a:r>
              <a:rPr lang="en-US"/>
              <a:t>+Cl</a:t>
            </a:r>
            <a:r>
              <a:rPr lang="en-US" baseline="30000"/>
              <a:t>-</a:t>
            </a:r>
            <a:r>
              <a:rPr lang="en-US"/>
              <a:t>)</a:t>
            </a:r>
            <a:br>
              <a:rPr lang="en-US"/>
            </a:br>
            <a:r>
              <a:rPr lang="en-US"/>
              <a:t>(140+4.2)-(14+110) = 20.2</a:t>
            </a:r>
          </a:p>
        </p:txBody>
      </p:sp>
      <p:sp>
        <p:nvSpPr>
          <p:cNvPr id="3" name="Subtitle 2">
            <a:extLst>
              <a:ext uri="{FF2B5EF4-FFF2-40B4-BE49-F238E27FC236}">
                <a16:creationId xmlns:a16="http://schemas.microsoft.com/office/drawing/2014/main" id="{DB322116-4825-4676-A24E-5D2F451B99B3}"/>
              </a:ext>
            </a:extLst>
          </p:cNvPr>
          <p:cNvSpPr>
            <a:spLocks noGrp="1"/>
          </p:cNvSpPr>
          <p:nvPr>
            <p:ph type="subTitle" idx="1"/>
          </p:nvPr>
        </p:nvSpPr>
        <p:spPr/>
        <p:txBody>
          <a:bodyPr/>
          <a:lstStyle/>
          <a:p>
            <a:r>
              <a:rPr lang="en-US"/>
              <a:t>Back to the anion gap</a:t>
            </a:r>
          </a:p>
        </p:txBody>
      </p:sp>
    </p:spTree>
    <p:extLst>
      <p:ext uri="{BB962C8B-B14F-4D97-AF65-F5344CB8AC3E}">
        <p14:creationId xmlns:p14="http://schemas.microsoft.com/office/powerpoint/2010/main" val="1536761277"/>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8AE526A-2240-49E7-94CB-2BE749B44FCB}"/>
              </a:ext>
            </a:extLst>
          </p:cNvPr>
          <p:cNvSpPr>
            <a:spLocks noGrp="1"/>
          </p:cNvSpPr>
          <p:nvPr>
            <p:ph type="title"/>
          </p:nvPr>
        </p:nvSpPr>
        <p:spPr/>
        <p:txBody>
          <a:bodyPr/>
          <a:lstStyle/>
          <a:p>
            <a:r>
              <a:rPr lang="en-US" sz="2000" dirty="0"/>
              <a:t>M: Methanol</a:t>
            </a:r>
            <a:br>
              <a:rPr lang="en-US" sz="2000" dirty="0"/>
            </a:br>
            <a:r>
              <a:rPr lang="en-US" sz="2000" dirty="0"/>
              <a:t>U: Uremia</a:t>
            </a:r>
            <a:br>
              <a:rPr lang="en-US" sz="2000" dirty="0"/>
            </a:br>
            <a:r>
              <a:rPr lang="en-US" sz="2000" dirty="0"/>
              <a:t>D: DKA</a:t>
            </a:r>
            <a:br>
              <a:rPr lang="en-US" sz="2000" dirty="0"/>
            </a:br>
            <a:r>
              <a:rPr lang="en-US" sz="2000" dirty="0"/>
              <a:t>P: Paracetamol/Propylene glycol</a:t>
            </a:r>
            <a:br>
              <a:rPr lang="en-US" sz="2000" dirty="0"/>
            </a:br>
            <a:r>
              <a:rPr lang="en-US" sz="2000" dirty="0"/>
              <a:t>I: Iron/Isoniazid</a:t>
            </a:r>
            <a:br>
              <a:rPr lang="en-US" sz="2000" dirty="0"/>
            </a:br>
            <a:r>
              <a:rPr lang="en-US" sz="2000" dirty="0"/>
              <a:t>L: Lactic acidosis</a:t>
            </a:r>
            <a:br>
              <a:rPr lang="en-US" sz="2000" dirty="0"/>
            </a:br>
            <a:r>
              <a:rPr lang="en-US" sz="2000" dirty="0"/>
              <a:t>E: Ethylene glycol</a:t>
            </a:r>
            <a:br>
              <a:rPr lang="en-US" sz="2000" dirty="0"/>
            </a:br>
            <a:r>
              <a:rPr lang="en-US" sz="2000" dirty="0">
                <a:solidFill>
                  <a:srgbClr val="FF0000"/>
                </a:solidFill>
              </a:rPr>
              <a:t>S: Salicylates</a:t>
            </a:r>
          </a:p>
        </p:txBody>
      </p:sp>
      <p:sp>
        <p:nvSpPr>
          <p:cNvPr id="3" name="Subtitle 2">
            <a:extLst>
              <a:ext uri="{FF2B5EF4-FFF2-40B4-BE49-F238E27FC236}">
                <a16:creationId xmlns:a16="http://schemas.microsoft.com/office/drawing/2014/main" id="{D53F1F2E-8C59-4567-974E-43E05CF9B688}"/>
              </a:ext>
            </a:extLst>
          </p:cNvPr>
          <p:cNvSpPr>
            <a:spLocks noGrp="1"/>
          </p:cNvSpPr>
          <p:nvPr>
            <p:ph type="subTitle" idx="1"/>
          </p:nvPr>
        </p:nvSpPr>
        <p:spPr/>
        <p:txBody>
          <a:bodyPr/>
          <a:lstStyle/>
          <a:p>
            <a:r>
              <a:rPr lang="en-US"/>
              <a:t>Causes of elevated anion gap metabolic acidosis</a:t>
            </a:r>
          </a:p>
        </p:txBody>
      </p:sp>
    </p:spTree>
    <p:extLst>
      <p:ext uri="{BB962C8B-B14F-4D97-AF65-F5344CB8AC3E}">
        <p14:creationId xmlns:p14="http://schemas.microsoft.com/office/powerpoint/2010/main" val="3666191697"/>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Shape 336"/>
        <p:cNvGrpSpPr/>
        <p:nvPr/>
      </p:nvGrpSpPr>
      <p:grpSpPr>
        <a:xfrm>
          <a:off x="0" y="0"/>
          <a:ext cx="0" cy="0"/>
          <a:chOff x="0" y="0"/>
          <a:chExt cx="0" cy="0"/>
        </a:xfrm>
      </p:grpSpPr>
      <p:sp>
        <p:nvSpPr>
          <p:cNvPr id="337" name="Google Shape;337;p28"/>
          <p:cNvSpPr txBox="1">
            <a:spLocks noGrp="1"/>
          </p:cNvSpPr>
          <p:nvPr>
            <p:ph type="title"/>
          </p:nvPr>
        </p:nvSpPr>
        <p:spPr>
          <a:xfrm>
            <a:off x="6146713" y="1287823"/>
            <a:ext cx="2423910" cy="2790264"/>
          </a:xfrm>
          <a:prstGeom prst="rect">
            <a:avLst/>
          </a:prstGeom>
        </p:spPr>
        <p:txBody>
          <a:bodyPr spcFirstLastPara="1" wrap="square" lIns="0" tIns="0" rIns="0" bIns="0" anchor="ctr" anchorCtr="0">
            <a:noAutofit/>
          </a:bodyPr>
          <a:lstStyle/>
          <a:p>
            <a:pPr lvl="0"/>
            <a:r>
              <a:rPr lang="en-US" sz="1600" dirty="0"/>
              <a:t>1. Identify the cause of the abnormality seen here. </a:t>
            </a:r>
            <a:br>
              <a:rPr lang="en-US" sz="1600" dirty="0"/>
            </a:br>
            <a:r>
              <a:rPr lang="en-US" sz="1600" dirty="0"/>
              <a:t>2. Provide a differential including 4+ diagnoses in which you may see this. </a:t>
            </a:r>
            <a:endParaRPr sz="1600" dirty="0"/>
          </a:p>
        </p:txBody>
      </p:sp>
      <p:sp>
        <p:nvSpPr>
          <p:cNvPr id="338" name="Google Shape;338;p28"/>
          <p:cNvSpPr txBox="1">
            <a:spLocks noGrp="1"/>
          </p:cNvSpPr>
          <p:nvPr>
            <p:ph type="subTitle" idx="1"/>
          </p:nvPr>
        </p:nvSpPr>
        <p:spPr>
          <a:xfrm>
            <a:off x="1038650" y="640325"/>
            <a:ext cx="7079700" cy="444300"/>
          </a:xfrm>
          <a:prstGeom prst="rect">
            <a:avLst/>
          </a:prstGeom>
        </p:spPr>
        <p:txBody>
          <a:bodyPr spcFirstLastPara="1" wrap="square" lIns="0" tIns="0" rIns="0" bIns="0" anchor="t" anchorCtr="0">
            <a:noAutofit/>
          </a:bodyPr>
          <a:lstStyle/>
          <a:p>
            <a:pPr marL="0" lvl="0" indent="0" algn="ctr" rtl="0">
              <a:spcBef>
                <a:spcPts val="600"/>
              </a:spcBef>
              <a:spcAft>
                <a:spcPts val="0"/>
              </a:spcAft>
              <a:buNone/>
            </a:pPr>
            <a:r>
              <a:rPr lang="en"/>
              <a:t>It’s not the heart· </a:t>
            </a:r>
            <a:r>
              <a:rPr lang="en">
                <a:solidFill>
                  <a:srgbClr val="FFC319"/>
                </a:solidFill>
              </a:rPr>
              <a:t>$200</a:t>
            </a:r>
            <a:endParaRPr>
              <a:solidFill>
                <a:srgbClr val="FFC319"/>
              </a:solidFill>
            </a:endParaRPr>
          </a:p>
        </p:txBody>
      </p:sp>
      <p:pic>
        <p:nvPicPr>
          <p:cNvPr id="4" name="Picture 3" descr="Diagram&#10;&#10;Description automatically generated"/>
          <p:cNvPicPr/>
          <p:nvPr/>
        </p:nvPicPr>
        <p:blipFill>
          <a:blip r:embed="rId3">
            <a:extLst>
              <a:ext uri="{28A0092B-C50C-407E-A947-70E740481C1C}">
                <a14:useLocalDpi xmlns:a14="http://schemas.microsoft.com/office/drawing/2010/main" val="0"/>
              </a:ext>
            </a:extLst>
          </a:blip>
          <a:stretch>
            <a:fillRect/>
          </a:stretch>
        </p:blipFill>
        <p:spPr>
          <a:xfrm>
            <a:off x="168008" y="1084625"/>
            <a:ext cx="5825168" cy="3080285"/>
          </a:xfrm>
          <a:prstGeom prst="rect">
            <a:avLst/>
          </a:prstGeom>
        </p:spPr>
      </p:pic>
      <p:sp>
        <p:nvSpPr>
          <p:cNvPr id="3" name="TextBox 2">
            <a:extLst>
              <a:ext uri="{FF2B5EF4-FFF2-40B4-BE49-F238E27FC236}">
                <a16:creationId xmlns:a16="http://schemas.microsoft.com/office/drawing/2014/main" id="{9C7F7E2F-059A-E3B4-F8C7-C92F9E3C1B73}"/>
              </a:ext>
            </a:extLst>
          </p:cNvPr>
          <p:cNvSpPr txBox="1"/>
          <p:nvPr/>
        </p:nvSpPr>
        <p:spPr>
          <a:xfrm>
            <a:off x="0" y="4635669"/>
            <a:ext cx="4633274" cy="507831"/>
          </a:xfrm>
          <a:prstGeom prst="rect">
            <a:avLst/>
          </a:prstGeom>
          <a:noFill/>
        </p:spPr>
        <p:txBody>
          <a:bodyPr wrap="square">
            <a:spAutoFit/>
          </a:bodyPr>
          <a:lstStyle/>
          <a:p>
            <a:r>
              <a:rPr lang="en-US" sz="900" b="1">
                <a:solidFill>
                  <a:schemeClr val="bg1"/>
                </a:solidFill>
                <a:effectLst/>
                <a:latin typeface="Calibri" panose="020F0502020204030204" pitchFamily="34" charset="0"/>
                <a:cs typeface="Calibri" panose="020F0502020204030204" pitchFamily="34" charset="0"/>
              </a:rPr>
              <a:t>Image by </a:t>
            </a:r>
            <a:r>
              <a:rPr lang="en-US" sz="900" b="1" err="1">
                <a:solidFill>
                  <a:schemeClr val="bg1"/>
                </a:solidFill>
                <a:effectLst/>
                <a:latin typeface="Calibri" panose="020F0502020204030204" pitchFamily="34" charset="0"/>
                <a:cs typeface="Calibri" panose="020F0502020204030204" pitchFamily="34" charset="0"/>
              </a:rPr>
              <a:t>LifeInTheFastLane</a:t>
            </a:r>
            <a:r>
              <a:rPr lang="en-US" sz="900" b="1">
                <a:solidFill>
                  <a:schemeClr val="bg1"/>
                </a:solidFill>
                <a:effectLst/>
                <a:latin typeface="Calibri" panose="020F0502020204030204" pitchFamily="34" charset="0"/>
                <a:cs typeface="Calibri" panose="020F0502020204030204" pitchFamily="34" charset="0"/>
              </a:rPr>
              <a:t>, retrieved from </a:t>
            </a:r>
            <a:r>
              <a:rPr lang="en-US" sz="900" b="1">
                <a:solidFill>
                  <a:schemeClr val="bg1"/>
                </a:solidFill>
                <a:effectLst/>
                <a:latin typeface="Calibri" panose="020F0502020204030204" pitchFamily="34" charset="0"/>
                <a:cs typeface="Calibri" panose="020F0502020204030204" pitchFamily="34" charset="0"/>
                <a:hlinkClick r:id="rId4">
                  <a:extLst>
                    <a:ext uri="{A12FA001-AC4F-418D-AE19-62706E023703}">
                      <ahyp:hlinkClr xmlns:ahyp="http://schemas.microsoft.com/office/drawing/2018/hyperlinkcolor" val="tx"/>
                    </a:ext>
                  </a:extLst>
                </a:hlinkClick>
              </a:rPr>
              <a:t>https://litfl.com/hyperkalaemia-ecg-library/</a:t>
            </a:r>
            <a:r>
              <a:rPr lang="en-US" sz="900" b="1">
                <a:solidFill>
                  <a:schemeClr val="bg1"/>
                </a:solidFill>
                <a:effectLst/>
                <a:latin typeface="Calibri" panose="020F0502020204030204" pitchFamily="34" charset="0"/>
                <a:cs typeface="Calibri" panose="020F0502020204030204" pitchFamily="34" charset="0"/>
              </a:rPr>
              <a:t> on 05-01-2022. Creative Commons License associated: https://</a:t>
            </a:r>
            <a:r>
              <a:rPr lang="en-US" sz="900" b="1" err="1">
                <a:solidFill>
                  <a:schemeClr val="bg1"/>
                </a:solidFill>
                <a:effectLst/>
                <a:latin typeface="Calibri" panose="020F0502020204030204" pitchFamily="34" charset="0"/>
                <a:cs typeface="Calibri" panose="020F0502020204030204" pitchFamily="34" charset="0"/>
              </a:rPr>
              <a:t>creativecommons.org</a:t>
            </a:r>
            <a:r>
              <a:rPr lang="en-US" sz="900" b="1">
                <a:solidFill>
                  <a:schemeClr val="bg1"/>
                </a:solidFill>
                <a:effectLst/>
                <a:latin typeface="Calibri" panose="020F0502020204030204" pitchFamily="34" charset="0"/>
                <a:cs typeface="Calibri" panose="020F0502020204030204" pitchFamily="34" charset="0"/>
              </a:rPr>
              <a:t>/licenses/by-</a:t>
            </a:r>
            <a:r>
              <a:rPr lang="en-US" sz="900" b="1" err="1">
                <a:solidFill>
                  <a:schemeClr val="bg1"/>
                </a:solidFill>
                <a:effectLst/>
                <a:latin typeface="Calibri" panose="020F0502020204030204" pitchFamily="34" charset="0"/>
                <a:cs typeface="Calibri" panose="020F0502020204030204" pitchFamily="34" charset="0"/>
              </a:rPr>
              <a:t>nc</a:t>
            </a:r>
            <a:r>
              <a:rPr lang="en-US" sz="900" b="1">
                <a:solidFill>
                  <a:schemeClr val="bg1"/>
                </a:solidFill>
                <a:effectLst/>
                <a:latin typeface="Calibri" panose="020F0502020204030204" pitchFamily="34" charset="0"/>
                <a:cs typeface="Calibri" panose="020F0502020204030204" pitchFamily="34" charset="0"/>
              </a:rPr>
              <a:t>-</a:t>
            </a:r>
            <a:r>
              <a:rPr lang="en-US" sz="900" b="1" err="1">
                <a:solidFill>
                  <a:schemeClr val="bg1"/>
                </a:solidFill>
                <a:effectLst/>
                <a:latin typeface="Calibri" panose="020F0502020204030204" pitchFamily="34" charset="0"/>
                <a:cs typeface="Calibri" panose="020F0502020204030204" pitchFamily="34" charset="0"/>
              </a:rPr>
              <a:t>sa</a:t>
            </a:r>
            <a:r>
              <a:rPr lang="en-US" sz="900" b="1">
                <a:solidFill>
                  <a:schemeClr val="bg1"/>
                </a:solidFill>
                <a:effectLst/>
                <a:latin typeface="Calibri" panose="020F0502020204030204" pitchFamily="34" charset="0"/>
                <a:cs typeface="Calibri" panose="020F0502020204030204" pitchFamily="34" charset="0"/>
              </a:rPr>
              <a:t>/4.0/</a:t>
            </a:r>
            <a:endParaRPr lang="en-US" sz="900">
              <a:solidFill>
                <a:schemeClr val="bg1"/>
              </a:solidFill>
              <a:effectLst/>
              <a:latin typeface="Calibri" panose="020F0502020204030204" pitchFamily="34" charset="0"/>
              <a:cs typeface="Calibri" panose="020F0502020204030204" pitchFamily="34" charset="0"/>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p:bldLst>
  </p:timing>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2400" dirty="0"/>
              <a:t>Answer: 1) Hyperkalemia</a:t>
            </a:r>
            <a:r>
              <a:rPr lang="en-US" sz="2400" dirty="0">
                <a:sym typeface="Wingdings" panose="05000000000000000000" pitchFamily="2" charset="2"/>
              </a:rPr>
              <a:t> peaked T waves</a:t>
            </a:r>
            <a:br>
              <a:rPr lang="en-US" sz="2400" dirty="0"/>
            </a:br>
            <a:r>
              <a:rPr lang="en-US" sz="2400" dirty="0">
                <a:sym typeface="Wingdings" panose="05000000000000000000" pitchFamily="2" charset="2"/>
              </a:rPr>
              <a:t>2) Renal failure, DKA, Adrenal Insufficiency, Congenital Adrenal Hyperplasia, Rhabdomyolysis</a:t>
            </a:r>
            <a:br>
              <a:rPr lang="en-US" sz="2400" dirty="0"/>
            </a:br>
            <a:r>
              <a:rPr lang="en-US" sz="2400" dirty="0">
                <a:sym typeface="Wingdings" panose="05000000000000000000" pitchFamily="2" charset="2"/>
              </a:rPr>
              <a:t>3) Bonus Question – What is the first treatment medication to administer?</a:t>
            </a:r>
            <a:endParaRPr lang="en-US" sz="2400" dirty="0"/>
          </a:p>
        </p:txBody>
      </p:sp>
    </p:spTree>
    <p:extLst>
      <p:ext uri="{BB962C8B-B14F-4D97-AF65-F5344CB8AC3E}">
        <p14:creationId xmlns:p14="http://schemas.microsoft.com/office/powerpoint/2010/main" val="425102675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276"/>
        <p:cNvGrpSpPr/>
        <p:nvPr/>
      </p:nvGrpSpPr>
      <p:grpSpPr>
        <a:xfrm>
          <a:off x="0" y="0"/>
          <a:ext cx="0" cy="0"/>
          <a:chOff x="0" y="0"/>
          <a:chExt cx="0" cy="0"/>
        </a:xfrm>
      </p:grpSpPr>
      <p:sp>
        <p:nvSpPr>
          <p:cNvPr id="277" name="Google Shape;277;p18"/>
          <p:cNvSpPr txBox="1">
            <a:spLocks noGrp="1"/>
          </p:cNvSpPr>
          <p:nvPr>
            <p:ph type="title"/>
          </p:nvPr>
        </p:nvSpPr>
        <p:spPr>
          <a:xfrm>
            <a:off x="1032075" y="966325"/>
            <a:ext cx="7081800" cy="3188100"/>
          </a:xfrm>
          <a:prstGeom prst="rect">
            <a:avLst/>
          </a:prstGeom>
        </p:spPr>
        <p:txBody>
          <a:bodyPr spcFirstLastPara="1" wrap="square" lIns="0" tIns="0" rIns="0" bIns="0" anchor="ctr" anchorCtr="0">
            <a:noAutofit/>
          </a:bodyPr>
          <a:lstStyle/>
          <a:p>
            <a:br>
              <a:rPr lang="en-US" sz="1800" b="0" i="0" u="none" strike="noStrike">
                <a:effectLst/>
                <a:latin typeface="Arial" panose="020B0604020202020204" pitchFamily="34" charset="0"/>
              </a:rPr>
            </a:br>
            <a:endParaRPr lang="en-US"/>
          </a:p>
        </p:txBody>
      </p:sp>
      <p:sp>
        <p:nvSpPr>
          <p:cNvPr id="278" name="Google Shape;278;p18"/>
          <p:cNvSpPr txBox="1">
            <a:spLocks noGrp="1"/>
          </p:cNvSpPr>
          <p:nvPr>
            <p:ph type="subTitle" idx="1"/>
          </p:nvPr>
        </p:nvSpPr>
        <p:spPr>
          <a:xfrm>
            <a:off x="712694" y="640325"/>
            <a:ext cx="7405656" cy="444300"/>
          </a:xfrm>
          <a:prstGeom prst="rect">
            <a:avLst/>
          </a:prstGeom>
        </p:spPr>
        <p:txBody>
          <a:bodyPr spcFirstLastPara="1" wrap="square" lIns="0" tIns="0" rIns="0" bIns="0" anchor="t" anchorCtr="0">
            <a:noAutofit/>
          </a:bodyPr>
          <a:lstStyle/>
          <a:p>
            <a:pPr marL="0" indent="0"/>
            <a:r>
              <a:rPr lang="en-US">
                <a:solidFill>
                  <a:schemeClr val="lt1"/>
                </a:solidFill>
                <a:latin typeface="Bebas Neue"/>
                <a:ea typeface="Bebas Neue"/>
                <a:cs typeface="Bebas Neue"/>
                <a:sym typeface="Bebas Neue"/>
              </a:rPr>
              <a:t>To </a:t>
            </a:r>
            <a:r>
              <a:rPr lang="en-US" err="1">
                <a:solidFill>
                  <a:schemeClr val="lt1"/>
                </a:solidFill>
                <a:latin typeface="Bebas Neue"/>
                <a:ea typeface="Bebas Neue"/>
                <a:cs typeface="Bebas Neue"/>
                <a:sym typeface="Bebas Neue"/>
              </a:rPr>
              <a:t>cbc</a:t>
            </a:r>
            <a:r>
              <a:rPr lang="en-US">
                <a:solidFill>
                  <a:schemeClr val="lt1"/>
                </a:solidFill>
                <a:latin typeface="Bebas Neue"/>
                <a:ea typeface="Bebas Neue"/>
                <a:cs typeface="Bebas Neue"/>
                <a:sym typeface="Bebas Neue"/>
              </a:rPr>
              <a:t> or not to </a:t>
            </a:r>
            <a:r>
              <a:rPr lang="en-US" err="1">
                <a:solidFill>
                  <a:schemeClr val="lt1"/>
                </a:solidFill>
                <a:latin typeface="Bebas Neue"/>
                <a:ea typeface="Bebas Neue"/>
                <a:cs typeface="Bebas Neue"/>
                <a:sym typeface="Bebas Neue"/>
              </a:rPr>
              <a:t>cbc</a:t>
            </a:r>
            <a:endParaRPr lang="en-US">
              <a:solidFill>
                <a:schemeClr val="lt1"/>
              </a:solidFill>
              <a:latin typeface="Bebas Neue"/>
              <a:ea typeface="Bebas Neue"/>
              <a:cs typeface="Bebas Neue"/>
              <a:sym typeface="Bebas Neue"/>
            </a:endParaRPr>
          </a:p>
          <a:p>
            <a:pPr marL="0" lvl="0" indent="0" algn="ctr" rtl="0">
              <a:spcBef>
                <a:spcPts val="600"/>
              </a:spcBef>
              <a:spcAft>
                <a:spcPts val="0"/>
              </a:spcAft>
              <a:buNone/>
            </a:pPr>
            <a:r>
              <a:rPr lang="en"/>
              <a:t>· </a:t>
            </a:r>
            <a:r>
              <a:rPr lang="en">
                <a:solidFill>
                  <a:srgbClr val="FFC319"/>
                </a:solidFill>
              </a:rPr>
              <a:t>$200</a:t>
            </a:r>
            <a:endParaRPr>
              <a:solidFill>
                <a:srgbClr val="FFC319"/>
              </a:solidFill>
            </a:endParaRPr>
          </a:p>
        </p:txBody>
      </p:sp>
      <p:graphicFrame>
        <p:nvGraphicFramePr>
          <p:cNvPr id="4" name="Table 3">
            <a:extLst>
              <a:ext uri="{FF2B5EF4-FFF2-40B4-BE49-F238E27FC236}">
                <a16:creationId xmlns:a16="http://schemas.microsoft.com/office/drawing/2014/main" id="{BD4F7E9F-B461-4A78-89F8-3DD4D43DA580}"/>
              </a:ext>
            </a:extLst>
          </p:cNvPr>
          <p:cNvGraphicFramePr>
            <a:graphicFrameLocks noGrp="1"/>
          </p:cNvGraphicFramePr>
          <p:nvPr>
            <p:extLst>
              <p:ext uri="{D42A27DB-BD31-4B8C-83A1-F6EECF244321}">
                <p14:modId xmlns:p14="http://schemas.microsoft.com/office/powerpoint/2010/main" val="2129456290"/>
              </p:ext>
            </p:extLst>
          </p:nvPr>
        </p:nvGraphicFramePr>
        <p:xfrm>
          <a:off x="947609" y="1823374"/>
          <a:ext cx="2918420" cy="1592302"/>
        </p:xfrm>
        <a:graphic>
          <a:graphicData uri="http://schemas.openxmlformats.org/drawingml/2006/table">
            <a:tbl>
              <a:tblPr firstRow="1" bandRow="1">
                <a:tableStyleId>{5C22544A-7EE6-4342-B048-85BDC9FD1C3A}</a:tableStyleId>
              </a:tblPr>
              <a:tblGrid>
                <a:gridCol w="718240">
                  <a:extLst>
                    <a:ext uri="{9D8B030D-6E8A-4147-A177-3AD203B41FA5}">
                      <a16:colId xmlns:a16="http://schemas.microsoft.com/office/drawing/2014/main" val="824425484"/>
                    </a:ext>
                  </a:extLst>
                </a:gridCol>
                <a:gridCol w="436400">
                  <a:extLst>
                    <a:ext uri="{9D8B030D-6E8A-4147-A177-3AD203B41FA5}">
                      <a16:colId xmlns:a16="http://schemas.microsoft.com/office/drawing/2014/main" val="610143289"/>
                    </a:ext>
                  </a:extLst>
                </a:gridCol>
                <a:gridCol w="700056">
                  <a:extLst>
                    <a:ext uri="{9D8B030D-6E8A-4147-A177-3AD203B41FA5}">
                      <a16:colId xmlns:a16="http://schemas.microsoft.com/office/drawing/2014/main" val="3542840054"/>
                    </a:ext>
                  </a:extLst>
                </a:gridCol>
                <a:gridCol w="436399">
                  <a:extLst>
                    <a:ext uri="{9D8B030D-6E8A-4147-A177-3AD203B41FA5}">
                      <a16:colId xmlns:a16="http://schemas.microsoft.com/office/drawing/2014/main" val="3916601039"/>
                    </a:ext>
                  </a:extLst>
                </a:gridCol>
                <a:gridCol w="627325">
                  <a:extLst>
                    <a:ext uri="{9D8B030D-6E8A-4147-A177-3AD203B41FA5}">
                      <a16:colId xmlns:a16="http://schemas.microsoft.com/office/drawing/2014/main" val="4033324111"/>
                    </a:ext>
                  </a:extLst>
                </a:gridCol>
              </a:tblGrid>
              <a:tr h="796151">
                <a:tc rowSpan="2">
                  <a:txBody>
                    <a:bodyPr/>
                    <a:lstStyle/>
                    <a:p>
                      <a:endParaRPr lang="en-US" sz="1200" b="0">
                        <a:solidFill>
                          <a:schemeClr val="tx1"/>
                        </a:solidFill>
                      </a:endParaRPr>
                    </a:p>
                    <a:p>
                      <a:endParaRPr lang="en-US" sz="1200"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ap="flat" cmpd="sng" algn="ctr">
                      <a:noFill/>
                      <a:prstDash val="solid"/>
                      <a:round/>
                      <a:headEnd type="none" w="med" len="med"/>
                      <a:tailEnd type="none" w="med" len="med"/>
                    </a:lnTlToBr>
                    <a:lnBlToTr w="12700" cmpd="sng">
                      <a:noFill/>
                      <a:prstDash val="solid"/>
                    </a:lnBlToTr>
                    <a:solidFill>
                      <a:schemeClr val="bg1"/>
                    </a:solidFill>
                  </a:tcPr>
                </a:tc>
                <a:tc>
                  <a:txBody>
                    <a:bodyPr/>
                    <a:lstStyle/>
                    <a:p>
                      <a:endParaRPr lang="en-US" sz="1200"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ap="flat" cmpd="sng" algn="ctr">
                      <a:solidFill>
                        <a:schemeClr val="tx1"/>
                      </a:solidFill>
                      <a:prstDash val="solid"/>
                      <a:round/>
                      <a:headEnd type="none" w="med" len="med"/>
                      <a:tailEnd type="none" w="med" len="med"/>
                    </a:lnTlToBr>
                    <a:lnBlToTr w="12700" cmpd="sng">
                      <a:noFill/>
                      <a:prstDash val="solid"/>
                    </a:lnBlToTr>
                    <a:solidFill>
                      <a:schemeClr val="bg1"/>
                    </a:solidFill>
                  </a:tcPr>
                </a:tc>
                <a:tc>
                  <a:txBody>
                    <a:bodyPr/>
                    <a:lstStyle/>
                    <a:p>
                      <a:pPr algn="ctr"/>
                      <a:endParaRPr lang="en-US" sz="1200" b="0">
                        <a:solidFill>
                          <a:schemeClr val="tx1"/>
                        </a:solidFill>
                      </a:endParaRPr>
                    </a:p>
                    <a:p>
                      <a:pPr algn="ctr"/>
                      <a:r>
                        <a:rPr lang="en-US" sz="1800" b="0">
                          <a:solidFill>
                            <a:schemeClr val="tx1"/>
                          </a:solidFill>
                        </a:rPr>
                        <a:t>9.7</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1200"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ap="flat" cmpd="sng" algn="ctr">
                      <a:solidFill>
                        <a:schemeClr val="tx1"/>
                      </a:solidFill>
                      <a:prstDash val="solid"/>
                      <a:round/>
                      <a:headEnd type="none" w="med" len="med"/>
                      <a:tailEnd type="none" w="med" len="med"/>
                    </a:lnBlToTr>
                    <a:solidFill>
                      <a:schemeClr val="bg1"/>
                    </a:solidFill>
                  </a:tcPr>
                </a:tc>
                <a:tc rowSpan="2">
                  <a:txBody>
                    <a:bodyPr/>
                    <a:lstStyle/>
                    <a:p>
                      <a:endParaRPr lang="en-US" sz="1200" b="0">
                        <a:solidFill>
                          <a:schemeClr val="tx1"/>
                        </a:solidFill>
                      </a:endParaRPr>
                    </a:p>
                    <a:p>
                      <a:endParaRPr lang="en-US" sz="1200"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ap="flat" cmpd="sng" algn="ctr">
                      <a:noFill/>
                      <a:prstDash val="solid"/>
                      <a:round/>
                      <a:headEnd type="none" w="med" len="med"/>
                      <a:tailEnd type="none" w="med" len="med"/>
                    </a:lnBlToTr>
                    <a:solidFill>
                      <a:schemeClr val="bg1"/>
                    </a:solidFill>
                  </a:tcPr>
                </a:tc>
                <a:extLst>
                  <a:ext uri="{0D108BD9-81ED-4DB2-BD59-A6C34878D82A}">
                    <a16:rowId xmlns:a16="http://schemas.microsoft.com/office/drawing/2014/main" val="727745014"/>
                  </a:ext>
                </a:extLst>
              </a:tr>
              <a:tr h="796151">
                <a:tc vMerge="1">
                  <a:txBody>
                    <a:bodyPr/>
                    <a:lstStyle/>
                    <a:p>
                      <a:endParaRPr lang="en-US"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ap="flat" cmpd="sng" algn="ctr">
                      <a:noFill/>
                      <a:prstDash val="solid"/>
                      <a:round/>
                      <a:headEnd type="none" w="med" len="med"/>
                      <a:tailEnd type="none" w="med" len="med"/>
                    </a:lnBlToTr>
                    <a:solidFill>
                      <a:schemeClr val="bg1"/>
                    </a:solidFill>
                  </a:tcPr>
                </a:tc>
                <a:tc>
                  <a:txBody>
                    <a:bodyPr/>
                    <a:lstStyle/>
                    <a:p>
                      <a:endParaRPr lang="en-US" sz="1200"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ap="flat" cmpd="sng" algn="ctr">
                      <a:solidFill>
                        <a:schemeClr val="tx1"/>
                      </a:solidFill>
                      <a:prstDash val="solid"/>
                      <a:round/>
                      <a:headEnd type="none" w="med" len="med"/>
                      <a:tailEnd type="none" w="med" len="med"/>
                    </a:lnBlToTr>
                    <a:solidFill>
                      <a:schemeClr val="bg1"/>
                    </a:solidFill>
                  </a:tcPr>
                </a:tc>
                <a:tc>
                  <a:txBody>
                    <a:bodyPr/>
                    <a:lstStyle/>
                    <a:p>
                      <a:endParaRPr lang="en-US" sz="1200"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1200"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ap="flat" cmpd="sng" algn="ctr">
                      <a:solidFill>
                        <a:schemeClr val="tx1"/>
                      </a:solidFill>
                      <a:prstDash val="solid"/>
                      <a:round/>
                      <a:headEnd type="none" w="med" len="med"/>
                      <a:tailEnd type="none" w="med" len="med"/>
                    </a:lnTlToBr>
                    <a:lnBlToTr w="12700" cap="flat" cmpd="sng" algn="ctr">
                      <a:noFill/>
                      <a:prstDash val="solid"/>
                      <a:round/>
                      <a:headEnd type="none" w="med" len="med"/>
                      <a:tailEnd type="none" w="med" len="med"/>
                    </a:lnBlToTr>
                    <a:solidFill>
                      <a:schemeClr val="bg1"/>
                    </a:solidFill>
                  </a:tcPr>
                </a:tc>
                <a:tc vMerge="1">
                  <a:txBody>
                    <a:bodyPr/>
                    <a:lstStyle/>
                    <a:p>
                      <a:endParaRPr lang="en-US"/>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ap="flat" cmpd="sng" algn="ctr">
                      <a:noFill/>
                      <a:prstDash val="solid"/>
                      <a:round/>
                      <a:headEnd type="none" w="med" len="med"/>
                      <a:tailEnd type="none" w="med" len="med"/>
                    </a:lnTlToBr>
                    <a:lnBlToTr w="12700" cap="flat" cmpd="sng" algn="ctr">
                      <a:noFill/>
                      <a:prstDash val="solid"/>
                      <a:round/>
                      <a:headEnd type="none" w="med" len="med"/>
                      <a:tailEnd type="none" w="med" len="med"/>
                    </a:lnBlToTr>
                    <a:solidFill>
                      <a:schemeClr val="bg1"/>
                    </a:solidFill>
                  </a:tcPr>
                </a:tc>
                <a:extLst>
                  <a:ext uri="{0D108BD9-81ED-4DB2-BD59-A6C34878D82A}">
                    <a16:rowId xmlns:a16="http://schemas.microsoft.com/office/drawing/2014/main" val="2515014331"/>
                  </a:ext>
                </a:extLst>
              </a:tr>
            </a:tbl>
          </a:graphicData>
        </a:graphic>
      </p:graphicFrame>
      <p:sp>
        <p:nvSpPr>
          <p:cNvPr id="2" name="TextBox 1">
            <a:extLst>
              <a:ext uri="{FF2B5EF4-FFF2-40B4-BE49-F238E27FC236}">
                <a16:creationId xmlns:a16="http://schemas.microsoft.com/office/drawing/2014/main" id="{98142A2B-8791-4EC8-8032-D2A7E83D2F54}"/>
              </a:ext>
            </a:extLst>
          </p:cNvPr>
          <p:cNvSpPr txBox="1"/>
          <p:nvPr/>
        </p:nvSpPr>
        <p:spPr>
          <a:xfrm>
            <a:off x="4047565" y="1823375"/>
            <a:ext cx="3516406" cy="954107"/>
          </a:xfrm>
          <a:prstGeom prst="rect">
            <a:avLst/>
          </a:prstGeom>
          <a:solidFill>
            <a:schemeClr val="bg1"/>
          </a:solidFill>
        </p:spPr>
        <p:txBody>
          <a:bodyPr wrap="square" rtlCol="0">
            <a:spAutoFit/>
          </a:bodyPr>
          <a:lstStyle/>
          <a:p>
            <a:r>
              <a:rPr lang="en-US"/>
              <a:t>MCV 78</a:t>
            </a:r>
          </a:p>
          <a:p>
            <a:r>
              <a:rPr lang="en-US"/>
              <a:t>MCHC Normal</a:t>
            </a:r>
          </a:p>
          <a:p>
            <a:r>
              <a:rPr lang="en-US"/>
              <a:t>RBC 4.7</a:t>
            </a:r>
          </a:p>
          <a:p>
            <a:r>
              <a:rPr lang="en-US"/>
              <a:t>RDW 15.1 (upper limit of normal 15)</a:t>
            </a:r>
          </a:p>
        </p:txBody>
      </p:sp>
      <p:sp>
        <p:nvSpPr>
          <p:cNvPr id="3" name="TextBox 2">
            <a:extLst>
              <a:ext uri="{FF2B5EF4-FFF2-40B4-BE49-F238E27FC236}">
                <a16:creationId xmlns:a16="http://schemas.microsoft.com/office/drawing/2014/main" id="{722F260A-BA2B-4E49-9408-3EB3D52F8925}"/>
              </a:ext>
            </a:extLst>
          </p:cNvPr>
          <p:cNvSpPr txBox="1"/>
          <p:nvPr/>
        </p:nvSpPr>
        <p:spPr>
          <a:xfrm>
            <a:off x="4047565" y="2892056"/>
            <a:ext cx="3629142" cy="738664"/>
          </a:xfrm>
          <a:prstGeom prst="rect">
            <a:avLst/>
          </a:prstGeom>
          <a:solidFill>
            <a:schemeClr val="bg1"/>
          </a:solidFill>
        </p:spPr>
        <p:txBody>
          <a:bodyPr wrap="square" rtlCol="0">
            <a:spAutoFit/>
          </a:bodyPr>
          <a:lstStyle/>
          <a:p>
            <a:r>
              <a:rPr lang="en-US"/>
              <a:t>Does this constellation of labs suggest a diagnosis of Iron-Deficiency Anemia or Thalassemia and why?</a:t>
            </a:r>
          </a:p>
        </p:txBody>
      </p:sp>
    </p:spTree>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Shape 342"/>
        <p:cNvGrpSpPr/>
        <p:nvPr/>
      </p:nvGrpSpPr>
      <p:grpSpPr>
        <a:xfrm>
          <a:off x="0" y="0"/>
          <a:ext cx="0" cy="0"/>
          <a:chOff x="0" y="0"/>
          <a:chExt cx="0" cy="0"/>
        </a:xfrm>
      </p:grpSpPr>
      <p:sp>
        <p:nvSpPr>
          <p:cNvPr id="343" name="Google Shape;343;p29"/>
          <p:cNvSpPr txBox="1">
            <a:spLocks noGrp="1"/>
          </p:cNvSpPr>
          <p:nvPr>
            <p:ph type="title"/>
          </p:nvPr>
        </p:nvSpPr>
        <p:spPr>
          <a:xfrm>
            <a:off x="1032075" y="1208696"/>
            <a:ext cx="7081800" cy="3188100"/>
          </a:xfrm>
          <a:prstGeom prst="rect">
            <a:avLst/>
          </a:prstGeom>
        </p:spPr>
        <p:txBody>
          <a:bodyPr spcFirstLastPara="1" wrap="square" lIns="0" tIns="0" rIns="0" bIns="0" anchor="ctr" anchorCtr="0">
            <a:noAutofit/>
          </a:bodyPr>
          <a:lstStyle/>
          <a:p>
            <a:r>
              <a:rPr lang="en-US" dirty="0"/>
              <a:t>A </a:t>
            </a:r>
            <a:r>
              <a:rPr lang="en-US"/>
              <a:t>17-year-old</a:t>
            </a:r>
            <a:r>
              <a:rPr lang="en-US" dirty="0"/>
              <a:t> girl presents with chest pain. Please take a moment to build a mini illness script of factors consistent with “non-cardiac” chest pain etiologies vs cardiac. </a:t>
            </a:r>
            <a:br>
              <a:rPr lang="en-US" dirty="0"/>
            </a:br>
            <a:endParaRPr/>
          </a:p>
        </p:txBody>
      </p:sp>
      <p:sp>
        <p:nvSpPr>
          <p:cNvPr id="344" name="Google Shape;344;p29"/>
          <p:cNvSpPr txBox="1">
            <a:spLocks noGrp="1"/>
          </p:cNvSpPr>
          <p:nvPr>
            <p:ph type="subTitle" idx="1"/>
          </p:nvPr>
        </p:nvSpPr>
        <p:spPr>
          <a:xfrm>
            <a:off x="1038650" y="640325"/>
            <a:ext cx="7079700" cy="444300"/>
          </a:xfrm>
          <a:prstGeom prst="rect">
            <a:avLst/>
          </a:prstGeom>
        </p:spPr>
        <p:txBody>
          <a:bodyPr spcFirstLastPara="1" wrap="square" lIns="0" tIns="0" rIns="0" bIns="0" anchor="t" anchorCtr="0">
            <a:noAutofit/>
          </a:bodyPr>
          <a:lstStyle/>
          <a:p>
            <a:pPr marL="0" lvl="0" indent="0" algn="ctr" rtl="0">
              <a:spcBef>
                <a:spcPts val="600"/>
              </a:spcBef>
              <a:spcAft>
                <a:spcPts val="0"/>
              </a:spcAft>
              <a:buNone/>
            </a:pPr>
            <a:r>
              <a:rPr lang="en"/>
              <a:t>IT’s NOT THE HEART· </a:t>
            </a:r>
            <a:r>
              <a:rPr lang="en">
                <a:solidFill>
                  <a:srgbClr val="FFC319"/>
                </a:solidFill>
              </a:rPr>
              <a:t>$400</a:t>
            </a:r>
            <a:endParaRPr>
              <a:solidFill>
                <a:srgbClr val="FFC319"/>
              </a:solidFill>
            </a:endParaRPr>
          </a:p>
        </p:txBody>
      </p:sp>
    </p:spTree>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85CF4B3-EEA5-4C00-913C-5F9EA4D07130}"/>
              </a:ext>
            </a:extLst>
          </p:cNvPr>
          <p:cNvSpPr>
            <a:spLocks noGrp="1"/>
          </p:cNvSpPr>
          <p:nvPr>
            <p:ph type="title"/>
          </p:nvPr>
        </p:nvSpPr>
        <p:spPr/>
        <p:txBody>
          <a:bodyPr/>
          <a:lstStyle/>
          <a:p>
            <a:r>
              <a:rPr lang="en-US" sz="2800"/>
              <a:t>Example features of non-cardiac causes of chest pain – non-exertional, reproducible on exam (tenderness to palpation), pleuritic </a:t>
            </a:r>
            <a:br>
              <a:rPr lang="en-US" sz="2800"/>
            </a:br>
            <a:r>
              <a:rPr lang="en-US" sz="2800"/>
              <a:t>Features of cardiac chest pain – “crushing” substernal, radiating to left arm, exertional, resolves with rest</a:t>
            </a:r>
          </a:p>
        </p:txBody>
      </p:sp>
      <p:sp>
        <p:nvSpPr>
          <p:cNvPr id="3" name="Subtitle 2">
            <a:extLst>
              <a:ext uri="{FF2B5EF4-FFF2-40B4-BE49-F238E27FC236}">
                <a16:creationId xmlns:a16="http://schemas.microsoft.com/office/drawing/2014/main" id="{41F30623-9015-F769-4F93-2C2B2665761B}"/>
              </a:ext>
            </a:extLst>
          </p:cNvPr>
          <p:cNvSpPr>
            <a:spLocks noGrp="1"/>
          </p:cNvSpPr>
          <p:nvPr>
            <p:ph type="subTitle" idx="1"/>
          </p:nvPr>
        </p:nvSpPr>
        <p:spPr/>
        <p:txBody>
          <a:bodyPr/>
          <a:lstStyle/>
          <a:p>
            <a:endParaRPr lang="en-US"/>
          </a:p>
        </p:txBody>
      </p:sp>
    </p:spTree>
    <p:extLst>
      <p:ext uri="{BB962C8B-B14F-4D97-AF65-F5344CB8AC3E}">
        <p14:creationId xmlns:p14="http://schemas.microsoft.com/office/powerpoint/2010/main" val="673569381"/>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32075" y="966325"/>
            <a:ext cx="1871381" cy="3238030"/>
          </a:xfrm>
        </p:spPr>
        <p:txBody>
          <a:bodyPr/>
          <a:lstStyle/>
          <a:p>
            <a:r>
              <a:rPr lang="en-US" sz="2000" b="0"/>
              <a:t>(What were some descriptors on your non cardiac list?)</a:t>
            </a:r>
            <a:br>
              <a:rPr lang="en-US" sz="2000" b="0"/>
            </a:br>
            <a:br>
              <a:rPr lang="en-US" sz="2000" b="0"/>
            </a:br>
            <a:r>
              <a:rPr lang="en-US" sz="2000" b="0"/>
              <a:t>Here are some examples:</a:t>
            </a:r>
          </a:p>
        </p:txBody>
      </p:sp>
      <p:sp>
        <p:nvSpPr>
          <p:cNvPr id="3" name="Subtitle 2"/>
          <p:cNvSpPr>
            <a:spLocks noGrp="1"/>
          </p:cNvSpPr>
          <p:nvPr>
            <p:ph type="subTitle" idx="1"/>
          </p:nvPr>
        </p:nvSpPr>
        <p:spPr>
          <a:xfrm>
            <a:off x="-988453" y="522025"/>
            <a:ext cx="7079700" cy="444300"/>
          </a:xfrm>
        </p:spPr>
        <p:txBody>
          <a:bodyPr/>
          <a:lstStyle/>
          <a:p>
            <a:r>
              <a:rPr lang="en-US"/>
              <a:t>CHEST PAIN CONTINUED: </a:t>
            </a:r>
          </a:p>
        </p:txBody>
      </p:sp>
      <p:graphicFrame>
        <p:nvGraphicFramePr>
          <p:cNvPr id="5" name="Diagram 4">
            <a:extLst>
              <a:ext uri="{FF2B5EF4-FFF2-40B4-BE49-F238E27FC236}">
                <a16:creationId xmlns:a16="http://schemas.microsoft.com/office/drawing/2014/main" id="{AB19B883-158D-CC85-C8F1-1D378F32F225}"/>
              </a:ext>
            </a:extLst>
          </p:cNvPr>
          <p:cNvGraphicFramePr/>
          <p:nvPr>
            <p:extLst>
              <p:ext uri="{D42A27DB-BD31-4B8C-83A1-F6EECF244321}">
                <p14:modId xmlns:p14="http://schemas.microsoft.com/office/powerpoint/2010/main" val="1637441443"/>
              </p:ext>
            </p:extLst>
          </p:nvPr>
        </p:nvGraphicFramePr>
        <p:xfrm>
          <a:off x="3101419" y="768315"/>
          <a:ext cx="5301006" cy="360687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7" name="TextBox 6">
            <a:extLst>
              <a:ext uri="{FF2B5EF4-FFF2-40B4-BE49-F238E27FC236}">
                <a16:creationId xmlns:a16="http://schemas.microsoft.com/office/drawing/2014/main" id="{6FAA4B1D-01DF-D178-3D85-221DE47E3437}"/>
              </a:ext>
            </a:extLst>
          </p:cNvPr>
          <p:cNvSpPr txBox="1"/>
          <p:nvPr/>
        </p:nvSpPr>
        <p:spPr>
          <a:xfrm>
            <a:off x="0" y="4681835"/>
            <a:ext cx="5066906" cy="461665"/>
          </a:xfrm>
          <a:prstGeom prst="rect">
            <a:avLst/>
          </a:prstGeom>
          <a:noFill/>
        </p:spPr>
        <p:txBody>
          <a:bodyPr wrap="square">
            <a:spAutoFit/>
          </a:bodyPr>
          <a:lstStyle/>
          <a:p>
            <a:r>
              <a:rPr lang="en-US" sz="800" err="1">
                <a:solidFill>
                  <a:schemeClr val="bg1"/>
                </a:solidFill>
              </a:rPr>
              <a:t>Zitelli</a:t>
            </a:r>
            <a:r>
              <a:rPr lang="en-US" sz="800">
                <a:solidFill>
                  <a:schemeClr val="bg1"/>
                </a:solidFill>
              </a:rPr>
              <a:t> BJ McIntire SC </a:t>
            </a:r>
            <a:r>
              <a:rPr lang="en-US" sz="800" err="1">
                <a:solidFill>
                  <a:schemeClr val="bg1"/>
                </a:solidFill>
              </a:rPr>
              <a:t>Nowalk</a:t>
            </a:r>
            <a:r>
              <a:rPr lang="en-US" sz="800">
                <a:solidFill>
                  <a:schemeClr val="bg1"/>
                </a:solidFill>
              </a:rPr>
              <a:t> AJ. </a:t>
            </a:r>
            <a:r>
              <a:rPr lang="en-US" sz="800" err="1">
                <a:solidFill>
                  <a:schemeClr val="bg1"/>
                </a:solidFill>
              </a:rPr>
              <a:t>Zitelli</a:t>
            </a:r>
            <a:r>
              <a:rPr lang="en-US" sz="800">
                <a:solidFill>
                  <a:schemeClr val="bg1"/>
                </a:solidFill>
              </a:rPr>
              <a:t> and Davis' Atlas of Pediatric Physical Diagnosis. Sixth ed. Philadelphia PA: Saunders/Elsevier; 2012. http://</a:t>
            </a:r>
            <a:r>
              <a:rPr lang="en-US" sz="800" err="1">
                <a:solidFill>
                  <a:schemeClr val="bg1"/>
                </a:solidFill>
              </a:rPr>
              <a:t>www.clinicalkey.com</a:t>
            </a:r>
            <a:r>
              <a:rPr lang="en-US" sz="800">
                <a:solidFill>
                  <a:schemeClr val="bg1"/>
                </a:solidFill>
              </a:rPr>
              <a:t>/dura/browse/</a:t>
            </a:r>
            <a:r>
              <a:rPr lang="en-US" sz="800" err="1">
                <a:solidFill>
                  <a:schemeClr val="bg1"/>
                </a:solidFill>
              </a:rPr>
              <a:t>bookChapter</a:t>
            </a:r>
            <a:r>
              <a:rPr lang="en-US" sz="800">
                <a:solidFill>
                  <a:schemeClr val="bg1"/>
                </a:solidFill>
              </a:rPr>
              <a:t>/3-s2.0-C20090425819.</a:t>
            </a:r>
          </a:p>
        </p:txBody>
      </p:sp>
    </p:spTree>
    <p:extLst>
      <p:ext uri="{BB962C8B-B14F-4D97-AF65-F5344CB8AC3E}">
        <p14:creationId xmlns:p14="http://schemas.microsoft.com/office/powerpoint/2010/main" val="1307015233"/>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54109" y="660478"/>
            <a:ext cx="7081800" cy="1058685"/>
          </a:xfrm>
        </p:spPr>
        <p:txBody>
          <a:bodyPr/>
          <a:lstStyle/>
          <a:p>
            <a:r>
              <a:rPr lang="en-US" sz="1800" dirty="0"/>
              <a:t>She has a recent diagnosis of Systemic Lupus Erythematosus in the last 6 months. Her EKG is shown: what is the dx?</a:t>
            </a:r>
          </a:p>
        </p:txBody>
      </p:sp>
      <p:pic>
        <p:nvPicPr>
          <p:cNvPr id="4" name="Picture 3" descr="A picture containing text, document&#10;&#10;Description automatically generated"/>
          <p:cNvPicPr/>
          <p:nvPr/>
        </p:nvPicPr>
        <p:blipFill>
          <a:blip r:embed="rId2">
            <a:extLst>
              <a:ext uri="{28A0092B-C50C-407E-A947-70E740481C1C}">
                <a14:useLocalDpi xmlns:a14="http://schemas.microsoft.com/office/drawing/2010/main" val="0"/>
              </a:ext>
            </a:extLst>
          </a:blip>
          <a:stretch>
            <a:fillRect/>
          </a:stretch>
        </p:blipFill>
        <p:spPr>
          <a:xfrm>
            <a:off x="1380180" y="1608463"/>
            <a:ext cx="6429657" cy="2874559"/>
          </a:xfrm>
          <a:prstGeom prst="rect">
            <a:avLst/>
          </a:prstGeom>
        </p:spPr>
      </p:pic>
      <p:sp>
        <p:nvSpPr>
          <p:cNvPr id="5" name="TextBox 4">
            <a:extLst>
              <a:ext uri="{FF2B5EF4-FFF2-40B4-BE49-F238E27FC236}">
                <a16:creationId xmlns:a16="http://schemas.microsoft.com/office/drawing/2014/main" id="{AA0A404C-8241-B2A7-79B6-F8C6984C450C}"/>
              </a:ext>
            </a:extLst>
          </p:cNvPr>
          <p:cNvSpPr txBox="1"/>
          <p:nvPr/>
        </p:nvSpPr>
        <p:spPr>
          <a:xfrm>
            <a:off x="120192" y="4804946"/>
            <a:ext cx="4633274" cy="338554"/>
          </a:xfrm>
          <a:prstGeom prst="rect">
            <a:avLst/>
          </a:prstGeom>
          <a:noFill/>
        </p:spPr>
        <p:txBody>
          <a:bodyPr wrap="square">
            <a:spAutoFit/>
          </a:bodyPr>
          <a:lstStyle/>
          <a:p>
            <a:r>
              <a:rPr lang="en-US" sz="800" b="1">
                <a:solidFill>
                  <a:schemeClr val="bg1"/>
                </a:solidFill>
                <a:effectLst/>
                <a:latin typeface="Calibri" panose="020F0502020204030204" pitchFamily="34" charset="0"/>
                <a:cs typeface="Calibri" panose="020F0502020204030204" pitchFamily="34" charset="0"/>
              </a:rPr>
              <a:t>Image by </a:t>
            </a:r>
            <a:r>
              <a:rPr lang="en-US" sz="800" b="1" err="1">
                <a:solidFill>
                  <a:schemeClr val="bg1"/>
                </a:solidFill>
                <a:effectLst/>
                <a:latin typeface="Calibri" panose="020F0502020204030204" pitchFamily="34" charset="0"/>
                <a:cs typeface="Calibri" panose="020F0502020204030204" pitchFamily="34" charset="0"/>
              </a:rPr>
              <a:t>LifeInTheFastLane</a:t>
            </a:r>
            <a:r>
              <a:rPr lang="en-US" sz="800" b="1">
                <a:solidFill>
                  <a:schemeClr val="bg1"/>
                </a:solidFill>
                <a:effectLst/>
                <a:latin typeface="Calibri" panose="020F0502020204030204" pitchFamily="34" charset="0"/>
                <a:cs typeface="Calibri" panose="020F0502020204030204" pitchFamily="34" charset="0"/>
              </a:rPr>
              <a:t>, retrieved from </a:t>
            </a:r>
            <a:r>
              <a:rPr lang="en-US" sz="800" b="1" u="sng">
                <a:solidFill>
                  <a:schemeClr val="bg1"/>
                </a:solidFill>
                <a:effectLst/>
                <a:latin typeface="Calibri" panose="020F0502020204030204" pitchFamily="34" charset="0"/>
                <a:cs typeface="Calibri" panose="020F0502020204030204" pitchFamily="34" charset="0"/>
              </a:rPr>
              <a:t>https://</a:t>
            </a:r>
            <a:r>
              <a:rPr lang="en-US" sz="800" b="1" u="sng" err="1">
                <a:solidFill>
                  <a:schemeClr val="bg1"/>
                </a:solidFill>
                <a:effectLst/>
                <a:latin typeface="Calibri" panose="020F0502020204030204" pitchFamily="34" charset="0"/>
                <a:cs typeface="Calibri" panose="020F0502020204030204" pitchFamily="34" charset="0"/>
              </a:rPr>
              <a:t>litfl.com</a:t>
            </a:r>
            <a:r>
              <a:rPr lang="en-US" sz="800" b="1" u="sng">
                <a:solidFill>
                  <a:schemeClr val="bg1"/>
                </a:solidFill>
                <a:effectLst/>
                <a:latin typeface="Calibri" panose="020F0502020204030204" pitchFamily="34" charset="0"/>
                <a:cs typeface="Calibri" panose="020F0502020204030204" pitchFamily="34" charset="0"/>
              </a:rPr>
              <a:t>/pericarditis-</a:t>
            </a:r>
            <a:r>
              <a:rPr lang="en-US" sz="800" b="1" u="sng" err="1">
                <a:solidFill>
                  <a:schemeClr val="bg1"/>
                </a:solidFill>
                <a:effectLst/>
                <a:latin typeface="Calibri" panose="020F0502020204030204" pitchFamily="34" charset="0"/>
                <a:cs typeface="Calibri" panose="020F0502020204030204" pitchFamily="34" charset="0"/>
              </a:rPr>
              <a:t>ecg</a:t>
            </a:r>
            <a:r>
              <a:rPr lang="en-US" sz="800" b="1" u="sng">
                <a:solidFill>
                  <a:schemeClr val="bg1"/>
                </a:solidFill>
                <a:effectLst/>
                <a:latin typeface="Calibri" panose="020F0502020204030204" pitchFamily="34" charset="0"/>
                <a:cs typeface="Calibri" panose="020F0502020204030204" pitchFamily="34" charset="0"/>
              </a:rPr>
              <a:t>-library/</a:t>
            </a:r>
            <a:r>
              <a:rPr lang="en-US" sz="800" b="1">
                <a:solidFill>
                  <a:schemeClr val="bg1"/>
                </a:solidFill>
                <a:effectLst/>
                <a:latin typeface="Calibri" panose="020F0502020204030204" pitchFamily="34" charset="0"/>
                <a:cs typeface="Calibri" panose="020F0502020204030204" pitchFamily="34" charset="0"/>
              </a:rPr>
              <a:t> on 05-01-2022. Creative Commons License associated: https://</a:t>
            </a:r>
            <a:r>
              <a:rPr lang="en-US" sz="800" b="1" err="1">
                <a:solidFill>
                  <a:schemeClr val="bg1"/>
                </a:solidFill>
                <a:effectLst/>
                <a:latin typeface="Calibri" panose="020F0502020204030204" pitchFamily="34" charset="0"/>
                <a:cs typeface="Calibri" panose="020F0502020204030204" pitchFamily="34" charset="0"/>
              </a:rPr>
              <a:t>creativecommons.org</a:t>
            </a:r>
            <a:r>
              <a:rPr lang="en-US" sz="800" b="1">
                <a:solidFill>
                  <a:schemeClr val="bg1"/>
                </a:solidFill>
                <a:effectLst/>
                <a:latin typeface="Calibri" panose="020F0502020204030204" pitchFamily="34" charset="0"/>
                <a:cs typeface="Calibri" panose="020F0502020204030204" pitchFamily="34" charset="0"/>
              </a:rPr>
              <a:t>/licenses/by-</a:t>
            </a:r>
            <a:r>
              <a:rPr lang="en-US" sz="800" b="1" err="1">
                <a:solidFill>
                  <a:schemeClr val="bg1"/>
                </a:solidFill>
                <a:effectLst/>
                <a:latin typeface="Calibri" panose="020F0502020204030204" pitchFamily="34" charset="0"/>
                <a:cs typeface="Calibri" panose="020F0502020204030204" pitchFamily="34" charset="0"/>
              </a:rPr>
              <a:t>nc</a:t>
            </a:r>
            <a:r>
              <a:rPr lang="en-US" sz="800" b="1">
                <a:solidFill>
                  <a:schemeClr val="bg1"/>
                </a:solidFill>
                <a:effectLst/>
                <a:latin typeface="Calibri" panose="020F0502020204030204" pitchFamily="34" charset="0"/>
                <a:cs typeface="Calibri" panose="020F0502020204030204" pitchFamily="34" charset="0"/>
              </a:rPr>
              <a:t>-</a:t>
            </a:r>
            <a:r>
              <a:rPr lang="en-US" sz="800" b="1" err="1">
                <a:solidFill>
                  <a:schemeClr val="bg1"/>
                </a:solidFill>
                <a:effectLst/>
                <a:latin typeface="Calibri" panose="020F0502020204030204" pitchFamily="34" charset="0"/>
                <a:cs typeface="Calibri" panose="020F0502020204030204" pitchFamily="34" charset="0"/>
              </a:rPr>
              <a:t>sa</a:t>
            </a:r>
            <a:r>
              <a:rPr lang="en-US" sz="800" b="1">
                <a:solidFill>
                  <a:schemeClr val="bg1"/>
                </a:solidFill>
                <a:effectLst/>
                <a:latin typeface="Calibri" panose="020F0502020204030204" pitchFamily="34" charset="0"/>
                <a:cs typeface="Calibri" panose="020F0502020204030204" pitchFamily="34" charset="0"/>
              </a:rPr>
              <a:t>/4.0/</a:t>
            </a:r>
            <a:endParaRPr lang="en-US" sz="800">
              <a:solidFill>
                <a:schemeClr val="bg1"/>
              </a:solidFill>
              <a:effectLst/>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06428791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Pericarditis. </a:t>
            </a:r>
          </a:p>
        </p:txBody>
      </p:sp>
      <p:sp>
        <p:nvSpPr>
          <p:cNvPr id="3" name="Subtitle 2"/>
          <p:cNvSpPr>
            <a:spLocks noGrp="1"/>
          </p:cNvSpPr>
          <p:nvPr>
            <p:ph type="subTitle" idx="1"/>
          </p:nvPr>
        </p:nvSpPr>
        <p:spPr/>
        <p:txBody>
          <a:bodyPr/>
          <a:lstStyle/>
          <a:p>
            <a:r>
              <a:rPr lang="en-US"/>
              <a:t>Answer: </a:t>
            </a:r>
          </a:p>
        </p:txBody>
      </p:sp>
    </p:spTree>
    <p:extLst>
      <p:ext uri="{BB962C8B-B14F-4D97-AF65-F5344CB8AC3E}">
        <p14:creationId xmlns:p14="http://schemas.microsoft.com/office/powerpoint/2010/main" val="2756704831"/>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325794" y="3641706"/>
            <a:ext cx="6505412" cy="950610"/>
          </a:xfrm>
        </p:spPr>
        <p:txBody>
          <a:bodyPr/>
          <a:lstStyle/>
          <a:p>
            <a:r>
              <a:rPr lang="en-US" sz="1800"/>
              <a:t>ST elevation in V2-V6, II/III/</a:t>
            </a:r>
            <a:r>
              <a:rPr lang="en-US" sz="1800" err="1"/>
              <a:t>aVL</a:t>
            </a:r>
            <a:r>
              <a:rPr lang="en-US" sz="1800"/>
              <a:t>, PR depression in these leads as well ; reciprocal changes in AVR – consistent with pericarditis</a:t>
            </a:r>
          </a:p>
        </p:txBody>
      </p:sp>
      <p:sp>
        <p:nvSpPr>
          <p:cNvPr id="3" name="Subtitle 2"/>
          <p:cNvSpPr>
            <a:spLocks noGrp="1"/>
          </p:cNvSpPr>
          <p:nvPr>
            <p:ph type="subTitle" idx="1"/>
          </p:nvPr>
        </p:nvSpPr>
        <p:spPr/>
        <p:txBody>
          <a:bodyPr/>
          <a:lstStyle/>
          <a:p>
            <a:endParaRPr lang="en-US"/>
          </a:p>
        </p:txBody>
      </p:sp>
      <p:pic>
        <p:nvPicPr>
          <p:cNvPr id="4" name="Picture 3" descr="A picture containing text, document&#10;&#10;Description automatically generated"/>
          <p:cNvPicPr/>
          <p:nvPr/>
        </p:nvPicPr>
        <p:blipFill>
          <a:blip r:embed="rId2">
            <a:extLst>
              <a:ext uri="{28A0092B-C50C-407E-A947-70E740481C1C}">
                <a14:useLocalDpi xmlns:a14="http://schemas.microsoft.com/office/drawing/2010/main" val="0"/>
              </a:ext>
            </a:extLst>
          </a:blip>
          <a:stretch>
            <a:fillRect/>
          </a:stretch>
        </p:blipFill>
        <p:spPr>
          <a:xfrm>
            <a:off x="1508877" y="749216"/>
            <a:ext cx="6139246" cy="2892490"/>
          </a:xfrm>
          <a:prstGeom prst="rect">
            <a:avLst/>
          </a:prstGeom>
        </p:spPr>
      </p:pic>
      <p:sp>
        <p:nvSpPr>
          <p:cNvPr id="5" name="TextBox 4">
            <a:extLst>
              <a:ext uri="{FF2B5EF4-FFF2-40B4-BE49-F238E27FC236}">
                <a16:creationId xmlns:a16="http://schemas.microsoft.com/office/drawing/2014/main" id="{4864A121-40A5-1C7B-AE08-306D0307E2F4}"/>
              </a:ext>
            </a:extLst>
          </p:cNvPr>
          <p:cNvSpPr txBox="1"/>
          <p:nvPr/>
        </p:nvSpPr>
        <p:spPr>
          <a:xfrm>
            <a:off x="120192" y="4804946"/>
            <a:ext cx="4633274" cy="338554"/>
          </a:xfrm>
          <a:prstGeom prst="rect">
            <a:avLst/>
          </a:prstGeom>
          <a:noFill/>
        </p:spPr>
        <p:txBody>
          <a:bodyPr wrap="square">
            <a:spAutoFit/>
          </a:bodyPr>
          <a:lstStyle/>
          <a:p>
            <a:r>
              <a:rPr lang="en-US" sz="800" b="1">
                <a:solidFill>
                  <a:schemeClr val="bg1"/>
                </a:solidFill>
                <a:effectLst/>
                <a:latin typeface="Calibri" panose="020F0502020204030204" pitchFamily="34" charset="0"/>
                <a:cs typeface="Calibri" panose="020F0502020204030204" pitchFamily="34" charset="0"/>
              </a:rPr>
              <a:t>Image by </a:t>
            </a:r>
            <a:r>
              <a:rPr lang="en-US" sz="800" b="1" err="1">
                <a:solidFill>
                  <a:schemeClr val="bg1"/>
                </a:solidFill>
                <a:effectLst/>
                <a:latin typeface="Calibri" panose="020F0502020204030204" pitchFamily="34" charset="0"/>
                <a:cs typeface="Calibri" panose="020F0502020204030204" pitchFamily="34" charset="0"/>
              </a:rPr>
              <a:t>LifeInTheFastLane</a:t>
            </a:r>
            <a:r>
              <a:rPr lang="en-US" sz="800" b="1">
                <a:solidFill>
                  <a:schemeClr val="bg1"/>
                </a:solidFill>
                <a:effectLst/>
                <a:latin typeface="Calibri" panose="020F0502020204030204" pitchFamily="34" charset="0"/>
                <a:cs typeface="Calibri" panose="020F0502020204030204" pitchFamily="34" charset="0"/>
              </a:rPr>
              <a:t>, retrieved from </a:t>
            </a:r>
            <a:r>
              <a:rPr lang="en-US" sz="800" b="1" u="sng">
                <a:solidFill>
                  <a:schemeClr val="bg1"/>
                </a:solidFill>
                <a:effectLst/>
                <a:latin typeface="Calibri" panose="020F0502020204030204" pitchFamily="34" charset="0"/>
                <a:cs typeface="Calibri" panose="020F0502020204030204" pitchFamily="34" charset="0"/>
              </a:rPr>
              <a:t>https://</a:t>
            </a:r>
            <a:r>
              <a:rPr lang="en-US" sz="800" b="1" u="sng" err="1">
                <a:solidFill>
                  <a:schemeClr val="bg1"/>
                </a:solidFill>
                <a:effectLst/>
                <a:latin typeface="Calibri" panose="020F0502020204030204" pitchFamily="34" charset="0"/>
                <a:cs typeface="Calibri" panose="020F0502020204030204" pitchFamily="34" charset="0"/>
              </a:rPr>
              <a:t>litfl.com</a:t>
            </a:r>
            <a:r>
              <a:rPr lang="en-US" sz="800" b="1" u="sng">
                <a:solidFill>
                  <a:schemeClr val="bg1"/>
                </a:solidFill>
                <a:effectLst/>
                <a:latin typeface="Calibri" panose="020F0502020204030204" pitchFamily="34" charset="0"/>
                <a:cs typeface="Calibri" panose="020F0502020204030204" pitchFamily="34" charset="0"/>
              </a:rPr>
              <a:t>/pericarditis-</a:t>
            </a:r>
            <a:r>
              <a:rPr lang="en-US" sz="800" b="1" u="sng" err="1">
                <a:solidFill>
                  <a:schemeClr val="bg1"/>
                </a:solidFill>
                <a:effectLst/>
                <a:latin typeface="Calibri" panose="020F0502020204030204" pitchFamily="34" charset="0"/>
                <a:cs typeface="Calibri" panose="020F0502020204030204" pitchFamily="34" charset="0"/>
              </a:rPr>
              <a:t>ecg</a:t>
            </a:r>
            <a:r>
              <a:rPr lang="en-US" sz="800" b="1" u="sng">
                <a:solidFill>
                  <a:schemeClr val="bg1"/>
                </a:solidFill>
                <a:effectLst/>
                <a:latin typeface="Calibri" panose="020F0502020204030204" pitchFamily="34" charset="0"/>
                <a:cs typeface="Calibri" panose="020F0502020204030204" pitchFamily="34" charset="0"/>
              </a:rPr>
              <a:t>-library/</a:t>
            </a:r>
            <a:r>
              <a:rPr lang="en-US" sz="800" b="1">
                <a:solidFill>
                  <a:schemeClr val="bg1"/>
                </a:solidFill>
                <a:effectLst/>
                <a:latin typeface="Calibri" panose="020F0502020204030204" pitchFamily="34" charset="0"/>
                <a:cs typeface="Calibri" panose="020F0502020204030204" pitchFamily="34" charset="0"/>
              </a:rPr>
              <a:t> on 05-01-2022. Creative Commons License associated: https://</a:t>
            </a:r>
            <a:r>
              <a:rPr lang="en-US" sz="800" b="1" err="1">
                <a:solidFill>
                  <a:schemeClr val="bg1"/>
                </a:solidFill>
                <a:effectLst/>
                <a:latin typeface="Calibri" panose="020F0502020204030204" pitchFamily="34" charset="0"/>
                <a:cs typeface="Calibri" panose="020F0502020204030204" pitchFamily="34" charset="0"/>
              </a:rPr>
              <a:t>creativecommons.org</a:t>
            </a:r>
            <a:r>
              <a:rPr lang="en-US" sz="800" b="1">
                <a:solidFill>
                  <a:schemeClr val="bg1"/>
                </a:solidFill>
                <a:effectLst/>
                <a:latin typeface="Calibri" panose="020F0502020204030204" pitchFamily="34" charset="0"/>
                <a:cs typeface="Calibri" panose="020F0502020204030204" pitchFamily="34" charset="0"/>
              </a:rPr>
              <a:t>/licenses/by-</a:t>
            </a:r>
            <a:r>
              <a:rPr lang="en-US" sz="800" b="1" err="1">
                <a:solidFill>
                  <a:schemeClr val="bg1"/>
                </a:solidFill>
                <a:effectLst/>
                <a:latin typeface="Calibri" panose="020F0502020204030204" pitchFamily="34" charset="0"/>
                <a:cs typeface="Calibri" panose="020F0502020204030204" pitchFamily="34" charset="0"/>
              </a:rPr>
              <a:t>nc</a:t>
            </a:r>
            <a:r>
              <a:rPr lang="en-US" sz="800" b="1">
                <a:solidFill>
                  <a:schemeClr val="bg1"/>
                </a:solidFill>
                <a:effectLst/>
                <a:latin typeface="Calibri" panose="020F0502020204030204" pitchFamily="34" charset="0"/>
                <a:cs typeface="Calibri" panose="020F0502020204030204" pitchFamily="34" charset="0"/>
              </a:rPr>
              <a:t>-</a:t>
            </a:r>
            <a:r>
              <a:rPr lang="en-US" sz="800" b="1" err="1">
                <a:solidFill>
                  <a:schemeClr val="bg1"/>
                </a:solidFill>
                <a:effectLst/>
                <a:latin typeface="Calibri" panose="020F0502020204030204" pitchFamily="34" charset="0"/>
                <a:cs typeface="Calibri" panose="020F0502020204030204" pitchFamily="34" charset="0"/>
              </a:rPr>
              <a:t>sa</a:t>
            </a:r>
            <a:r>
              <a:rPr lang="en-US" sz="800" b="1">
                <a:solidFill>
                  <a:schemeClr val="bg1"/>
                </a:solidFill>
                <a:effectLst/>
                <a:latin typeface="Calibri" panose="020F0502020204030204" pitchFamily="34" charset="0"/>
                <a:cs typeface="Calibri" panose="020F0502020204030204" pitchFamily="34" charset="0"/>
              </a:rPr>
              <a:t>/4.0/</a:t>
            </a:r>
            <a:endParaRPr lang="en-US" sz="800">
              <a:solidFill>
                <a:schemeClr val="bg1"/>
              </a:solidFill>
              <a:effectLst/>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48767094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Shape 348"/>
        <p:cNvGrpSpPr/>
        <p:nvPr/>
      </p:nvGrpSpPr>
      <p:grpSpPr>
        <a:xfrm>
          <a:off x="0" y="0"/>
          <a:ext cx="0" cy="0"/>
          <a:chOff x="0" y="0"/>
          <a:chExt cx="0" cy="0"/>
        </a:xfrm>
      </p:grpSpPr>
      <p:sp>
        <p:nvSpPr>
          <p:cNvPr id="349" name="Google Shape;349;p30"/>
          <p:cNvSpPr txBox="1">
            <a:spLocks noGrp="1"/>
          </p:cNvSpPr>
          <p:nvPr>
            <p:ph type="title"/>
          </p:nvPr>
        </p:nvSpPr>
        <p:spPr>
          <a:xfrm>
            <a:off x="6257581" y="2060154"/>
            <a:ext cx="2445744" cy="1403366"/>
          </a:xfrm>
          <a:prstGeom prst="rect">
            <a:avLst/>
          </a:prstGeom>
        </p:spPr>
        <p:txBody>
          <a:bodyPr spcFirstLastPara="1" wrap="square" lIns="0" tIns="0" rIns="0" bIns="0" anchor="ctr" anchorCtr="0">
            <a:noAutofit/>
          </a:bodyPr>
          <a:lstStyle/>
          <a:p>
            <a:pPr marL="0" lvl="0" indent="0" algn="ctr" rtl="0">
              <a:spcBef>
                <a:spcPts val="0"/>
              </a:spcBef>
              <a:spcAft>
                <a:spcPts val="0"/>
              </a:spcAft>
              <a:buNone/>
            </a:pPr>
            <a:r>
              <a:rPr lang="en-US" sz="1600"/>
              <a:t>You are on cardiology consults and are asked to see a previously healthy baby admitted for spell rule out after their EKG showed this. </a:t>
            </a:r>
            <a:br>
              <a:rPr lang="en-US" sz="1600"/>
            </a:br>
            <a:br>
              <a:rPr lang="en-US" sz="1600"/>
            </a:br>
            <a:r>
              <a:rPr lang="en-US" sz="1600"/>
              <a:t>What is the diagnosis? What is the most likely underlying pathophysiology for this patient? </a:t>
            </a:r>
            <a:endParaRPr sz="1600"/>
          </a:p>
        </p:txBody>
      </p:sp>
      <p:sp>
        <p:nvSpPr>
          <p:cNvPr id="350" name="Google Shape;350;p30"/>
          <p:cNvSpPr txBox="1">
            <a:spLocks noGrp="1"/>
          </p:cNvSpPr>
          <p:nvPr>
            <p:ph type="subTitle" idx="1"/>
          </p:nvPr>
        </p:nvSpPr>
        <p:spPr>
          <a:xfrm>
            <a:off x="1038650" y="640325"/>
            <a:ext cx="7079700" cy="444300"/>
          </a:xfrm>
          <a:prstGeom prst="rect">
            <a:avLst/>
          </a:prstGeom>
        </p:spPr>
        <p:txBody>
          <a:bodyPr spcFirstLastPara="1" wrap="square" lIns="0" tIns="0" rIns="0" bIns="0" anchor="t" anchorCtr="0">
            <a:noAutofit/>
          </a:bodyPr>
          <a:lstStyle/>
          <a:p>
            <a:pPr marL="0" lvl="0" indent="0" algn="ctr" rtl="0">
              <a:spcBef>
                <a:spcPts val="600"/>
              </a:spcBef>
              <a:spcAft>
                <a:spcPts val="0"/>
              </a:spcAft>
              <a:buNone/>
            </a:pPr>
            <a:r>
              <a:rPr lang="en"/>
              <a:t>IT’s NOT THE HEART · </a:t>
            </a:r>
            <a:r>
              <a:rPr lang="en">
                <a:solidFill>
                  <a:srgbClr val="FFC319"/>
                </a:solidFill>
              </a:rPr>
              <a:t>$600</a:t>
            </a:r>
            <a:endParaRPr>
              <a:solidFill>
                <a:srgbClr val="FFC319"/>
              </a:solidFill>
            </a:endParaRPr>
          </a:p>
        </p:txBody>
      </p:sp>
      <p:pic>
        <p:nvPicPr>
          <p:cNvPr id="4" name="Picture 3" descr="A picture containing diagram&#10;&#10;Description automatically generated"/>
          <p:cNvPicPr/>
          <p:nvPr/>
        </p:nvPicPr>
        <p:blipFill>
          <a:blip r:embed="rId3">
            <a:extLst>
              <a:ext uri="{28A0092B-C50C-407E-A947-70E740481C1C}">
                <a14:useLocalDpi xmlns:a14="http://schemas.microsoft.com/office/drawing/2010/main" val="0"/>
              </a:ext>
            </a:extLst>
          </a:blip>
          <a:stretch>
            <a:fillRect/>
          </a:stretch>
        </p:blipFill>
        <p:spPr>
          <a:xfrm>
            <a:off x="167297" y="1084625"/>
            <a:ext cx="6180463" cy="3205099"/>
          </a:xfrm>
          <a:prstGeom prst="rect">
            <a:avLst/>
          </a:prstGeom>
        </p:spPr>
      </p:pic>
      <p:sp>
        <p:nvSpPr>
          <p:cNvPr id="3" name="TextBox 2">
            <a:extLst>
              <a:ext uri="{FF2B5EF4-FFF2-40B4-BE49-F238E27FC236}">
                <a16:creationId xmlns:a16="http://schemas.microsoft.com/office/drawing/2014/main" id="{27CE6577-218A-1328-0BDD-335F6745BDF2}"/>
              </a:ext>
            </a:extLst>
          </p:cNvPr>
          <p:cNvSpPr txBox="1"/>
          <p:nvPr/>
        </p:nvSpPr>
        <p:spPr>
          <a:xfrm>
            <a:off x="0" y="4566419"/>
            <a:ext cx="4633274" cy="507831"/>
          </a:xfrm>
          <a:prstGeom prst="rect">
            <a:avLst/>
          </a:prstGeom>
          <a:noFill/>
        </p:spPr>
        <p:txBody>
          <a:bodyPr wrap="square">
            <a:spAutoFit/>
          </a:bodyPr>
          <a:lstStyle/>
          <a:p>
            <a:r>
              <a:rPr lang="en-US" sz="900" b="1">
                <a:solidFill>
                  <a:schemeClr val="bg1"/>
                </a:solidFill>
                <a:effectLst/>
                <a:latin typeface="Calibri" panose="020F0502020204030204" pitchFamily="34" charset="0"/>
                <a:cs typeface="Calibri" panose="020F0502020204030204" pitchFamily="34" charset="0"/>
              </a:rPr>
              <a:t>Image by </a:t>
            </a:r>
            <a:r>
              <a:rPr lang="en-US" sz="900" b="1" err="1">
                <a:solidFill>
                  <a:schemeClr val="bg1"/>
                </a:solidFill>
                <a:effectLst/>
                <a:latin typeface="Calibri" panose="020F0502020204030204" pitchFamily="34" charset="0"/>
                <a:cs typeface="Calibri" panose="020F0502020204030204" pitchFamily="34" charset="0"/>
              </a:rPr>
              <a:t>LifeInTheFastLane</a:t>
            </a:r>
            <a:r>
              <a:rPr lang="en-US" sz="900" b="1">
                <a:solidFill>
                  <a:schemeClr val="bg1"/>
                </a:solidFill>
                <a:effectLst/>
                <a:latin typeface="Calibri" panose="020F0502020204030204" pitchFamily="34" charset="0"/>
                <a:cs typeface="Calibri" panose="020F0502020204030204" pitchFamily="34" charset="0"/>
              </a:rPr>
              <a:t>, retrieved from </a:t>
            </a:r>
            <a:r>
              <a:rPr lang="en-US" sz="900">
                <a:solidFill>
                  <a:schemeClr val="bg1"/>
                </a:solidFill>
                <a:effectLst/>
                <a:latin typeface="Calibri" panose="020F0502020204030204" pitchFamily="34" charset="0"/>
                <a:cs typeface="Calibri" panose="020F0502020204030204" pitchFamily="34" charset="0"/>
                <a:hlinkClick r:id="rId4">
                  <a:extLst>
                    <a:ext uri="{A12FA001-AC4F-418D-AE19-62706E023703}">
                      <ahyp:hlinkClr xmlns:ahyp="http://schemas.microsoft.com/office/drawing/2018/hyperlinkcolor" val="tx"/>
                    </a:ext>
                  </a:extLst>
                </a:hlinkClick>
              </a:rPr>
              <a:t>https://litfl.com/av-block-3rd-degree-complete-heart-block/</a:t>
            </a:r>
            <a:r>
              <a:rPr lang="en-US" sz="900" b="1">
                <a:solidFill>
                  <a:schemeClr val="bg1"/>
                </a:solidFill>
                <a:effectLst/>
                <a:latin typeface="Calibri" panose="020F0502020204030204" pitchFamily="34" charset="0"/>
                <a:cs typeface="Calibri" panose="020F0502020204030204" pitchFamily="34" charset="0"/>
              </a:rPr>
              <a:t> on 05-01-2022. Creative Commons License associated: https://</a:t>
            </a:r>
            <a:r>
              <a:rPr lang="en-US" sz="900" b="1" err="1">
                <a:solidFill>
                  <a:schemeClr val="bg1"/>
                </a:solidFill>
                <a:effectLst/>
                <a:latin typeface="Calibri" panose="020F0502020204030204" pitchFamily="34" charset="0"/>
                <a:cs typeface="Calibri" panose="020F0502020204030204" pitchFamily="34" charset="0"/>
              </a:rPr>
              <a:t>creativecommons.org</a:t>
            </a:r>
            <a:r>
              <a:rPr lang="en-US" sz="900" b="1">
                <a:solidFill>
                  <a:schemeClr val="bg1"/>
                </a:solidFill>
                <a:effectLst/>
                <a:latin typeface="Calibri" panose="020F0502020204030204" pitchFamily="34" charset="0"/>
                <a:cs typeface="Calibri" panose="020F0502020204030204" pitchFamily="34" charset="0"/>
              </a:rPr>
              <a:t>/licenses/by-</a:t>
            </a:r>
            <a:r>
              <a:rPr lang="en-US" sz="900" b="1" err="1">
                <a:solidFill>
                  <a:schemeClr val="bg1"/>
                </a:solidFill>
                <a:effectLst/>
                <a:latin typeface="Calibri" panose="020F0502020204030204" pitchFamily="34" charset="0"/>
                <a:cs typeface="Calibri" panose="020F0502020204030204" pitchFamily="34" charset="0"/>
              </a:rPr>
              <a:t>nc</a:t>
            </a:r>
            <a:r>
              <a:rPr lang="en-US" sz="900" b="1">
                <a:solidFill>
                  <a:schemeClr val="bg1"/>
                </a:solidFill>
                <a:effectLst/>
                <a:latin typeface="Calibri" panose="020F0502020204030204" pitchFamily="34" charset="0"/>
                <a:cs typeface="Calibri" panose="020F0502020204030204" pitchFamily="34" charset="0"/>
              </a:rPr>
              <a:t>-</a:t>
            </a:r>
            <a:r>
              <a:rPr lang="en-US" sz="900" b="1" err="1">
                <a:solidFill>
                  <a:schemeClr val="bg1"/>
                </a:solidFill>
                <a:effectLst/>
                <a:latin typeface="Calibri" panose="020F0502020204030204" pitchFamily="34" charset="0"/>
                <a:cs typeface="Calibri" panose="020F0502020204030204" pitchFamily="34" charset="0"/>
              </a:rPr>
              <a:t>sa</a:t>
            </a:r>
            <a:r>
              <a:rPr lang="en-US" sz="900" b="1">
                <a:solidFill>
                  <a:schemeClr val="bg1"/>
                </a:solidFill>
                <a:effectLst/>
                <a:latin typeface="Calibri" panose="020F0502020204030204" pitchFamily="34" charset="0"/>
                <a:cs typeface="Calibri" panose="020F0502020204030204" pitchFamily="34" charset="0"/>
              </a:rPr>
              <a:t>/4.0/</a:t>
            </a:r>
            <a:endParaRPr lang="en-US" sz="900">
              <a:solidFill>
                <a:schemeClr val="bg1"/>
              </a:solidFill>
              <a:effectLst/>
              <a:latin typeface="Calibri" panose="020F0502020204030204" pitchFamily="34" charset="0"/>
              <a:cs typeface="Calibri" panose="020F0502020204030204" pitchFamily="34" charset="0"/>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p:bldLst>
  </p:timing>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sp>
        <p:nvSpPr>
          <p:cNvPr id="3" name="Subtitle 2"/>
          <p:cNvSpPr>
            <a:spLocks noGrp="1"/>
          </p:cNvSpPr>
          <p:nvPr>
            <p:ph type="subTitle" idx="1"/>
          </p:nvPr>
        </p:nvSpPr>
        <p:spPr>
          <a:xfrm>
            <a:off x="1038650" y="522025"/>
            <a:ext cx="7079700" cy="444300"/>
          </a:xfrm>
        </p:spPr>
        <p:txBody>
          <a:bodyPr/>
          <a:lstStyle/>
          <a:p>
            <a:r>
              <a:rPr lang="en-US"/>
              <a:t>Answer: Complete (3</a:t>
            </a:r>
            <a:r>
              <a:rPr lang="en-US" baseline="30000"/>
              <a:t>rd</a:t>
            </a:r>
            <a:r>
              <a:rPr lang="en-US"/>
              <a:t> degree) heart block,  </a:t>
            </a:r>
          </a:p>
        </p:txBody>
      </p:sp>
      <p:pic>
        <p:nvPicPr>
          <p:cNvPr id="4" name="Picture 3" descr="A picture containing diagram&#10;&#10;Description automatically generated"/>
          <p:cNvPicPr/>
          <p:nvPr/>
        </p:nvPicPr>
        <p:blipFill>
          <a:blip r:embed="rId2">
            <a:extLst>
              <a:ext uri="{28A0092B-C50C-407E-A947-70E740481C1C}">
                <a14:useLocalDpi xmlns:a14="http://schemas.microsoft.com/office/drawing/2010/main" val="0"/>
              </a:ext>
            </a:extLst>
          </a:blip>
          <a:stretch>
            <a:fillRect/>
          </a:stretch>
        </p:blipFill>
        <p:spPr>
          <a:xfrm>
            <a:off x="1482743" y="966325"/>
            <a:ext cx="6180463" cy="3205099"/>
          </a:xfrm>
          <a:prstGeom prst="rect">
            <a:avLst/>
          </a:prstGeom>
        </p:spPr>
      </p:pic>
      <p:sp>
        <p:nvSpPr>
          <p:cNvPr id="5" name="Oval 4"/>
          <p:cNvSpPr/>
          <p:nvPr/>
        </p:nvSpPr>
        <p:spPr>
          <a:xfrm>
            <a:off x="2500828" y="1228846"/>
            <a:ext cx="154238" cy="363557"/>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Oval 5"/>
          <p:cNvSpPr/>
          <p:nvPr/>
        </p:nvSpPr>
        <p:spPr>
          <a:xfrm>
            <a:off x="4999821" y="2500248"/>
            <a:ext cx="154238" cy="363557"/>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66E0AEF5-0623-EC8A-D4B8-0CE04155D91B}"/>
              </a:ext>
            </a:extLst>
          </p:cNvPr>
          <p:cNvSpPr txBox="1"/>
          <p:nvPr/>
        </p:nvSpPr>
        <p:spPr>
          <a:xfrm>
            <a:off x="0" y="4566419"/>
            <a:ext cx="4633274" cy="507831"/>
          </a:xfrm>
          <a:prstGeom prst="rect">
            <a:avLst/>
          </a:prstGeom>
          <a:noFill/>
        </p:spPr>
        <p:txBody>
          <a:bodyPr wrap="square">
            <a:spAutoFit/>
          </a:bodyPr>
          <a:lstStyle/>
          <a:p>
            <a:r>
              <a:rPr lang="en-US" sz="900" b="1">
                <a:solidFill>
                  <a:schemeClr val="bg1"/>
                </a:solidFill>
                <a:effectLst/>
                <a:latin typeface="Calibri" panose="020F0502020204030204" pitchFamily="34" charset="0"/>
                <a:cs typeface="Calibri" panose="020F0502020204030204" pitchFamily="34" charset="0"/>
              </a:rPr>
              <a:t>Image by </a:t>
            </a:r>
            <a:r>
              <a:rPr lang="en-US" sz="900" b="1" err="1">
                <a:solidFill>
                  <a:schemeClr val="bg1"/>
                </a:solidFill>
                <a:effectLst/>
                <a:latin typeface="Calibri" panose="020F0502020204030204" pitchFamily="34" charset="0"/>
                <a:cs typeface="Calibri" panose="020F0502020204030204" pitchFamily="34" charset="0"/>
              </a:rPr>
              <a:t>LifeInTheFastLane</a:t>
            </a:r>
            <a:r>
              <a:rPr lang="en-US" sz="900" b="1">
                <a:solidFill>
                  <a:schemeClr val="bg1"/>
                </a:solidFill>
                <a:effectLst/>
                <a:latin typeface="Calibri" panose="020F0502020204030204" pitchFamily="34" charset="0"/>
                <a:cs typeface="Calibri" panose="020F0502020204030204" pitchFamily="34" charset="0"/>
              </a:rPr>
              <a:t>, retrieved from </a:t>
            </a:r>
            <a:r>
              <a:rPr lang="en-US" sz="900">
                <a:solidFill>
                  <a:schemeClr val="bg1"/>
                </a:solidFill>
                <a:effectLst/>
                <a:latin typeface="Calibri" panose="020F0502020204030204" pitchFamily="34" charset="0"/>
                <a:cs typeface="Calibri" panose="020F0502020204030204" pitchFamily="34" charset="0"/>
                <a:hlinkClick r:id="rId3">
                  <a:extLst>
                    <a:ext uri="{A12FA001-AC4F-418D-AE19-62706E023703}">
                      <ahyp:hlinkClr xmlns:ahyp="http://schemas.microsoft.com/office/drawing/2018/hyperlinkcolor" val="tx"/>
                    </a:ext>
                  </a:extLst>
                </a:hlinkClick>
              </a:rPr>
              <a:t>https://litfl.com/av-block-3rd-degree-complete-heart-block/</a:t>
            </a:r>
            <a:r>
              <a:rPr lang="en-US" sz="900" b="1">
                <a:solidFill>
                  <a:schemeClr val="bg1"/>
                </a:solidFill>
                <a:effectLst/>
                <a:latin typeface="Calibri" panose="020F0502020204030204" pitchFamily="34" charset="0"/>
                <a:cs typeface="Calibri" panose="020F0502020204030204" pitchFamily="34" charset="0"/>
              </a:rPr>
              <a:t> on 05-01-2022. Creative Commons License associated: https://</a:t>
            </a:r>
            <a:r>
              <a:rPr lang="en-US" sz="900" b="1" err="1">
                <a:solidFill>
                  <a:schemeClr val="bg1"/>
                </a:solidFill>
                <a:effectLst/>
                <a:latin typeface="Calibri" panose="020F0502020204030204" pitchFamily="34" charset="0"/>
                <a:cs typeface="Calibri" panose="020F0502020204030204" pitchFamily="34" charset="0"/>
              </a:rPr>
              <a:t>creativecommons.org</a:t>
            </a:r>
            <a:r>
              <a:rPr lang="en-US" sz="900" b="1">
                <a:solidFill>
                  <a:schemeClr val="bg1"/>
                </a:solidFill>
                <a:effectLst/>
                <a:latin typeface="Calibri" panose="020F0502020204030204" pitchFamily="34" charset="0"/>
                <a:cs typeface="Calibri" panose="020F0502020204030204" pitchFamily="34" charset="0"/>
              </a:rPr>
              <a:t>/licenses/by-</a:t>
            </a:r>
            <a:r>
              <a:rPr lang="en-US" sz="900" b="1" err="1">
                <a:solidFill>
                  <a:schemeClr val="bg1"/>
                </a:solidFill>
                <a:effectLst/>
                <a:latin typeface="Calibri" panose="020F0502020204030204" pitchFamily="34" charset="0"/>
                <a:cs typeface="Calibri" panose="020F0502020204030204" pitchFamily="34" charset="0"/>
              </a:rPr>
              <a:t>nc</a:t>
            </a:r>
            <a:r>
              <a:rPr lang="en-US" sz="900" b="1">
                <a:solidFill>
                  <a:schemeClr val="bg1"/>
                </a:solidFill>
                <a:effectLst/>
                <a:latin typeface="Calibri" panose="020F0502020204030204" pitchFamily="34" charset="0"/>
                <a:cs typeface="Calibri" panose="020F0502020204030204" pitchFamily="34" charset="0"/>
              </a:rPr>
              <a:t>-</a:t>
            </a:r>
            <a:r>
              <a:rPr lang="en-US" sz="900" b="1" err="1">
                <a:solidFill>
                  <a:schemeClr val="bg1"/>
                </a:solidFill>
                <a:effectLst/>
                <a:latin typeface="Calibri" panose="020F0502020204030204" pitchFamily="34" charset="0"/>
                <a:cs typeface="Calibri" panose="020F0502020204030204" pitchFamily="34" charset="0"/>
              </a:rPr>
              <a:t>sa</a:t>
            </a:r>
            <a:r>
              <a:rPr lang="en-US" sz="900" b="1">
                <a:solidFill>
                  <a:schemeClr val="bg1"/>
                </a:solidFill>
                <a:effectLst/>
                <a:latin typeface="Calibri" panose="020F0502020204030204" pitchFamily="34" charset="0"/>
                <a:cs typeface="Calibri" panose="020F0502020204030204" pitchFamily="34" charset="0"/>
              </a:rPr>
              <a:t>/4.0/</a:t>
            </a:r>
            <a:endParaRPr lang="en-US" sz="900">
              <a:solidFill>
                <a:schemeClr val="bg1"/>
              </a:solidFill>
              <a:effectLst/>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21836819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p:bldLst>
  </p:timing>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Third degree heart block: complete dissociation between atria and ventricular contraction, i.e. able to “march out” P waves and QRS as separate entities</a:t>
            </a:r>
          </a:p>
        </p:txBody>
      </p:sp>
      <p:sp>
        <p:nvSpPr>
          <p:cNvPr id="3" name="Subtitle 2"/>
          <p:cNvSpPr>
            <a:spLocks noGrp="1"/>
          </p:cNvSpPr>
          <p:nvPr>
            <p:ph type="subTitle" idx="1"/>
          </p:nvPr>
        </p:nvSpPr>
        <p:spPr/>
        <p:txBody>
          <a:bodyPr/>
          <a:lstStyle/>
          <a:p>
            <a:r>
              <a:rPr lang="en-US"/>
              <a:t>Complete Heart Block </a:t>
            </a:r>
          </a:p>
        </p:txBody>
      </p:sp>
    </p:spTree>
    <p:extLst>
      <p:ext uri="{BB962C8B-B14F-4D97-AF65-F5344CB8AC3E}">
        <p14:creationId xmlns:p14="http://schemas.microsoft.com/office/powerpoint/2010/main" val="3684799854"/>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200" dirty="0"/>
              <a:t>Congenital heart block, likely due to neonatal lupus (</a:t>
            </a:r>
            <a:r>
              <a:rPr lang="en-US" sz="3200" dirty="0" err="1"/>
              <a:t>mAb</a:t>
            </a:r>
            <a:r>
              <a:rPr lang="en-US" sz="3200" dirty="0"/>
              <a:t> SS-A and SS-B crossing the placenta). Other causes include myocarditis, Lyme Disease (carditis), post operative/ablation (acute or chronic)</a:t>
            </a:r>
          </a:p>
        </p:txBody>
      </p:sp>
      <p:sp>
        <p:nvSpPr>
          <p:cNvPr id="3" name="Subtitle 2"/>
          <p:cNvSpPr>
            <a:spLocks noGrp="1"/>
          </p:cNvSpPr>
          <p:nvPr>
            <p:ph type="subTitle" idx="1"/>
          </p:nvPr>
        </p:nvSpPr>
        <p:spPr/>
        <p:txBody>
          <a:bodyPr/>
          <a:lstStyle/>
          <a:p>
            <a:r>
              <a:rPr lang="en-US"/>
              <a:t>What is the most likely underlying pathophysiology for this baby’s heart block?</a:t>
            </a:r>
          </a:p>
        </p:txBody>
      </p:sp>
    </p:spTree>
    <p:extLst>
      <p:ext uri="{BB962C8B-B14F-4D97-AF65-F5344CB8AC3E}">
        <p14:creationId xmlns:p14="http://schemas.microsoft.com/office/powerpoint/2010/main" val="391720640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D5B93B-D6E9-46A1-8E71-B42472829E2E}"/>
              </a:ext>
            </a:extLst>
          </p:cNvPr>
          <p:cNvSpPr>
            <a:spLocks noGrp="1"/>
          </p:cNvSpPr>
          <p:nvPr>
            <p:ph type="title"/>
          </p:nvPr>
        </p:nvSpPr>
        <p:spPr/>
        <p:txBody>
          <a:bodyPr/>
          <a:lstStyle/>
          <a:p>
            <a:pPr marL="457200" indent="-457200" algn="l">
              <a:buFont typeface="Arial" panose="020B0604020202020204" pitchFamily="34" charset="0"/>
              <a:buChar char="•"/>
            </a:pPr>
            <a:r>
              <a:rPr lang="en-US" dirty="0"/>
              <a:t>Mentzer Index</a:t>
            </a:r>
            <a:br>
              <a:rPr lang="en-US" dirty="0"/>
            </a:br>
            <a:r>
              <a:rPr lang="en-US" dirty="0"/>
              <a:t>	MCV / RBC # </a:t>
            </a:r>
            <a:br>
              <a:rPr lang="en-US" dirty="0"/>
            </a:br>
            <a:r>
              <a:rPr lang="en-US" dirty="0"/>
              <a:t>	&gt;13 Suggests Iron-deficiency anemia</a:t>
            </a:r>
            <a:br>
              <a:rPr lang="en-US" dirty="0"/>
            </a:br>
            <a:r>
              <a:rPr lang="en-US" dirty="0"/>
              <a:t>	&lt;13 Suggests Thalassemia</a:t>
            </a:r>
          </a:p>
        </p:txBody>
      </p:sp>
      <p:sp>
        <p:nvSpPr>
          <p:cNvPr id="3" name="Subtitle 2">
            <a:extLst>
              <a:ext uri="{FF2B5EF4-FFF2-40B4-BE49-F238E27FC236}">
                <a16:creationId xmlns:a16="http://schemas.microsoft.com/office/drawing/2014/main" id="{B4B8B1A7-461C-4F50-B85C-FBEDE863A9DC}"/>
              </a:ext>
            </a:extLst>
          </p:cNvPr>
          <p:cNvSpPr>
            <a:spLocks noGrp="1"/>
          </p:cNvSpPr>
          <p:nvPr>
            <p:ph type="subTitle" idx="1"/>
          </p:nvPr>
        </p:nvSpPr>
        <p:spPr/>
        <p:txBody>
          <a:bodyPr/>
          <a:lstStyle/>
          <a:p>
            <a:r>
              <a:rPr lang="en-US"/>
              <a:t>Answer – Iron-Deficiency Anemia</a:t>
            </a:r>
          </a:p>
        </p:txBody>
      </p:sp>
    </p:spTree>
    <p:extLst>
      <p:ext uri="{BB962C8B-B14F-4D97-AF65-F5344CB8AC3E}">
        <p14:creationId xmlns:p14="http://schemas.microsoft.com/office/powerpoint/2010/main" val="668808694"/>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Shape 354"/>
        <p:cNvGrpSpPr/>
        <p:nvPr/>
      </p:nvGrpSpPr>
      <p:grpSpPr>
        <a:xfrm>
          <a:off x="0" y="0"/>
          <a:ext cx="0" cy="0"/>
          <a:chOff x="0" y="0"/>
          <a:chExt cx="0" cy="0"/>
        </a:xfrm>
      </p:grpSpPr>
      <p:sp>
        <p:nvSpPr>
          <p:cNvPr id="355" name="Google Shape;355;p31"/>
          <p:cNvSpPr txBox="1">
            <a:spLocks noGrp="1"/>
          </p:cNvSpPr>
          <p:nvPr>
            <p:ph type="title"/>
          </p:nvPr>
        </p:nvSpPr>
        <p:spPr>
          <a:xfrm>
            <a:off x="741900" y="1103500"/>
            <a:ext cx="7673200" cy="3188100"/>
          </a:xfrm>
          <a:prstGeom prst="rect">
            <a:avLst/>
          </a:prstGeom>
        </p:spPr>
        <p:txBody>
          <a:bodyPr spcFirstLastPara="1" wrap="square" lIns="0" tIns="0" rIns="0" bIns="0" anchor="ctr" anchorCtr="0">
            <a:noAutofit/>
          </a:bodyPr>
          <a:lstStyle/>
          <a:p>
            <a:r>
              <a:rPr lang="en-US" sz="1600"/>
              <a:t>A 5-year-old patient with history of </a:t>
            </a:r>
            <a:r>
              <a:rPr lang="en-US" sz="1600" dirty="0" err="1"/>
              <a:t>secundum</a:t>
            </a:r>
            <a:r>
              <a:rPr lang="en-US" sz="1600" dirty="0"/>
              <a:t> type atrial septal defect s/p surgical patch closure 4 weeks ago who presents to the emergency department after a week of progressive exercise intolerance, fatigue, fussiness, and fevers. Examination is notable for an ill appearing child with vital signs notable for a fever to 39.3C, HR 160, BP 82/40, RR 50. On exam, the patient’s cardiac examination is notable for muffled heart sounds. Exam is also notable for hepatomegaly and poor perfusion. You are concerned about how this child looks and have called the cardiology team for a STAT ECHO and gave additional temporizing recommendations for you to start before they get down there. </a:t>
            </a:r>
            <a:br>
              <a:rPr lang="en-US" sz="1600" dirty="0"/>
            </a:br>
            <a:r>
              <a:rPr lang="en-US" sz="1600" dirty="0"/>
              <a:t>What is the mechanism of action of their temporizing measure?</a:t>
            </a:r>
            <a:br>
              <a:rPr lang="en-US" sz="1600" dirty="0"/>
            </a:br>
            <a:endParaRPr sz="1600"/>
          </a:p>
        </p:txBody>
      </p:sp>
      <p:sp>
        <p:nvSpPr>
          <p:cNvPr id="356" name="Google Shape;356;p31"/>
          <p:cNvSpPr txBox="1">
            <a:spLocks noGrp="1"/>
          </p:cNvSpPr>
          <p:nvPr>
            <p:ph type="subTitle" idx="1"/>
          </p:nvPr>
        </p:nvSpPr>
        <p:spPr>
          <a:xfrm>
            <a:off x="1038650" y="640325"/>
            <a:ext cx="7079700" cy="444300"/>
          </a:xfrm>
          <a:prstGeom prst="rect">
            <a:avLst/>
          </a:prstGeom>
        </p:spPr>
        <p:txBody>
          <a:bodyPr spcFirstLastPara="1" wrap="square" lIns="0" tIns="0" rIns="0" bIns="0" anchor="t" anchorCtr="0">
            <a:noAutofit/>
          </a:bodyPr>
          <a:lstStyle/>
          <a:p>
            <a:pPr marL="0" lvl="0" indent="0" algn="ctr" rtl="0">
              <a:spcBef>
                <a:spcPts val="600"/>
              </a:spcBef>
              <a:spcAft>
                <a:spcPts val="0"/>
              </a:spcAft>
              <a:buNone/>
            </a:pPr>
            <a:r>
              <a:rPr lang="en"/>
              <a:t>It’s Not the heart· </a:t>
            </a:r>
            <a:r>
              <a:rPr lang="en">
                <a:solidFill>
                  <a:srgbClr val="FFC319"/>
                </a:solidFill>
              </a:rPr>
              <a:t>$800</a:t>
            </a:r>
            <a:endParaRPr>
              <a:solidFill>
                <a:srgbClr val="FFC319"/>
              </a:solidFill>
            </a:endParaRPr>
          </a:p>
        </p:txBody>
      </p:sp>
    </p:spTree>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Rapid infusion of saline bolus to increase preload and prevent chamber collapse. </a:t>
            </a:r>
          </a:p>
        </p:txBody>
      </p:sp>
      <p:sp>
        <p:nvSpPr>
          <p:cNvPr id="3" name="Subtitle 2"/>
          <p:cNvSpPr>
            <a:spLocks noGrp="1"/>
          </p:cNvSpPr>
          <p:nvPr>
            <p:ph type="subTitle" idx="1"/>
          </p:nvPr>
        </p:nvSpPr>
        <p:spPr/>
        <p:txBody>
          <a:bodyPr/>
          <a:lstStyle/>
          <a:p>
            <a:endParaRPr lang="en-US"/>
          </a:p>
        </p:txBody>
      </p:sp>
    </p:spTree>
    <p:extLst>
      <p:ext uri="{BB962C8B-B14F-4D97-AF65-F5344CB8AC3E}">
        <p14:creationId xmlns:p14="http://schemas.microsoft.com/office/powerpoint/2010/main" val="3598964838"/>
      </p:ext>
    </p:extLst>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923827" y="1191638"/>
            <a:ext cx="7713397" cy="3188100"/>
          </a:xfrm>
        </p:spPr>
        <p:txBody>
          <a:bodyPr/>
          <a:lstStyle/>
          <a:p>
            <a:r>
              <a:rPr lang="en-US" sz="2400"/>
              <a:t>Normally, the pericardial sac is filled with a very small amount of fluid. </a:t>
            </a:r>
            <a:br>
              <a:rPr lang="en-US" sz="2400"/>
            </a:br>
            <a:r>
              <a:rPr lang="en-US" sz="2400"/>
              <a:t>In tamponade physiology, excess fluid builds up in the pericardial sac and compresses the heart, reducing cardiac output. If tamponade physiology, drainage is ultimate treatment.</a:t>
            </a:r>
          </a:p>
        </p:txBody>
      </p:sp>
      <p:sp>
        <p:nvSpPr>
          <p:cNvPr id="3" name="Subtitle 2"/>
          <p:cNvSpPr>
            <a:spLocks noGrp="1"/>
          </p:cNvSpPr>
          <p:nvPr>
            <p:ph type="subTitle" idx="1"/>
          </p:nvPr>
        </p:nvSpPr>
        <p:spPr/>
        <p:txBody>
          <a:bodyPr/>
          <a:lstStyle/>
          <a:p>
            <a:endParaRPr lang="en-US"/>
          </a:p>
        </p:txBody>
      </p:sp>
    </p:spTree>
    <p:extLst>
      <p:ext uri="{BB962C8B-B14F-4D97-AF65-F5344CB8AC3E}">
        <p14:creationId xmlns:p14="http://schemas.microsoft.com/office/powerpoint/2010/main" val="2740533997"/>
      </p:ext>
    </p:extLst>
  </p:cSld>
  <p:clrMapOvr>
    <a:masterClrMapping/>
  </p:clrMapOvr>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Shape 360"/>
        <p:cNvGrpSpPr/>
        <p:nvPr/>
      </p:nvGrpSpPr>
      <p:grpSpPr>
        <a:xfrm>
          <a:off x="0" y="0"/>
          <a:ext cx="0" cy="0"/>
          <a:chOff x="0" y="0"/>
          <a:chExt cx="0" cy="0"/>
        </a:xfrm>
      </p:grpSpPr>
      <p:sp>
        <p:nvSpPr>
          <p:cNvPr id="361" name="Google Shape;361;p32"/>
          <p:cNvSpPr txBox="1">
            <a:spLocks noGrp="1"/>
          </p:cNvSpPr>
          <p:nvPr>
            <p:ph type="title"/>
          </p:nvPr>
        </p:nvSpPr>
        <p:spPr>
          <a:xfrm>
            <a:off x="638978" y="966325"/>
            <a:ext cx="7910111" cy="3188100"/>
          </a:xfrm>
          <a:prstGeom prst="rect">
            <a:avLst/>
          </a:prstGeom>
        </p:spPr>
        <p:txBody>
          <a:bodyPr spcFirstLastPara="1" wrap="square" lIns="0" tIns="0" rIns="0" bIns="0" anchor="ctr" anchorCtr="0">
            <a:noAutofit/>
          </a:bodyPr>
          <a:lstStyle/>
          <a:p>
            <a:pPr lvl="0"/>
            <a:r>
              <a:rPr lang="en-US" sz="1600" dirty="0"/>
              <a:t>You are admitting a 4-week-old male with presumed bronchiolitis after episodes of cyanosis at home. After further discussion with the parents, you learn that this baby has had multiple episodes of cyanosis since birth. The baby looks well on your initial exam aside from some mild tachypnea and crackles and a systolic murmur (HR 140s and hard to further characterize), so you place on continuous pulse ox before leaving the room. You are called to the bedside due to the baby having a pulse ox reading of 78% and appearing cyanotic. You go to the room and the baby is alert but extremely fussy and with true cyanosis and an SpO2 of 78% with good waveform.  You have difficulty appreciating a murmur. </a:t>
            </a:r>
            <a:br>
              <a:rPr lang="en-US" sz="1600" dirty="0"/>
            </a:br>
            <a:br>
              <a:rPr lang="en-US" sz="1600" dirty="0"/>
            </a:br>
            <a:r>
              <a:rPr lang="en-US" sz="1600" dirty="0"/>
              <a:t>What does this baby have and what is the mechanism of action of your next steps?</a:t>
            </a:r>
            <a:endParaRPr sz="1600" dirty="0"/>
          </a:p>
        </p:txBody>
      </p:sp>
      <p:sp>
        <p:nvSpPr>
          <p:cNvPr id="362" name="Google Shape;362;p32"/>
          <p:cNvSpPr txBox="1">
            <a:spLocks noGrp="1"/>
          </p:cNvSpPr>
          <p:nvPr>
            <p:ph type="subTitle" idx="1"/>
          </p:nvPr>
        </p:nvSpPr>
        <p:spPr>
          <a:xfrm>
            <a:off x="1038650" y="640325"/>
            <a:ext cx="7079700" cy="444300"/>
          </a:xfrm>
          <a:prstGeom prst="rect">
            <a:avLst/>
          </a:prstGeom>
        </p:spPr>
        <p:txBody>
          <a:bodyPr spcFirstLastPara="1" wrap="square" lIns="0" tIns="0" rIns="0" bIns="0" anchor="t" anchorCtr="0">
            <a:noAutofit/>
          </a:bodyPr>
          <a:lstStyle/>
          <a:p>
            <a:pPr marL="0" lvl="0" indent="0" algn="ctr" rtl="0">
              <a:spcBef>
                <a:spcPts val="600"/>
              </a:spcBef>
              <a:spcAft>
                <a:spcPts val="0"/>
              </a:spcAft>
              <a:buNone/>
            </a:pPr>
            <a:r>
              <a:rPr lang="en"/>
              <a:t>It’s Not The heart · </a:t>
            </a:r>
            <a:r>
              <a:rPr lang="en">
                <a:solidFill>
                  <a:srgbClr val="FFC319"/>
                </a:solidFill>
              </a:rPr>
              <a:t>$1000</a:t>
            </a:r>
            <a:endParaRPr>
              <a:solidFill>
                <a:srgbClr val="FFC319"/>
              </a:solidFill>
            </a:endParaRPr>
          </a:p>
        </p:txBody>
      </p:sp>
    </p:spTree>
  </p:cSld>
  <p:clrMapOvr>
    <a:masterClrMapping/>
  </p:clrMapOvr>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etralogy of Fallot with “Tet Spell”: treatment aimed at decreasing pulmonary vascular resistance (PVR) and increasing systemic vascular resistance (SVR)</a:t>
            </a:r>
          </a:p>
        </p:txBody>
      </p:sp>
      <p:sp>
        <p:nvSpPr>
          <p:cNvPr id="3" name="Subtitle 2"/>
          <p:cNvSpPr>
            <a:spLocks noGrp="1"/>
          </p:cNvSpPr>
          <p:nvPr>
            <p:ph type="subTitle" idx="1"/>
          </p:nvPr>
        </p:nvSpPr>
        <p:spPr/>
        <p:txBody>
          <a:bodyPr/>
          <a:lstStyle/>
          <a:p>
            <a:r>
              <a:rPr lang="en-US"/>
              <a:t>Answer: </a:t>
            </a:r>
          </a:p>
        </p:txBody>
      </p:sp>
    </p:spTree>
    <p:extLst>
      <p:ext uri="{BB962C8B-B14F-4D97-AF65-F5344CB8AC3E}">
        <p14:creationId xmlns:p14="http://schemas.microsoft.com/office/powerpoint/2010/main" val="3248733232"/>
      </p:ext>
    </p:extLst>
  </p:cSld>
  <p:clrMapOvr>
    <a:masterClrMapping/>
  </p:clrMapOvr>
</p:sld>
</file>

<file path=ppt/slides/slide5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2000"/>
              <a:t>Hallmark of 4 abnormalities—all a reflection of anterior malalignment of the septum, resulting in </a:t>
            </a:r>
            <a:r>
              <a:rPr lang="en-US" sz="2000" err="1"/>
              <a:t>malaligned</a:t>
            </a:r>
            <a:r>
              <a:rPr lang="en-US" sz="2000"/>
              <a:t> VSD (1) with overriding aorta (2) which causes right ventricular outflow tract obstruction (3). This obstruction results in right ventricular hypertrophy (4).</a:t>
            </a:r>
          </a:p>
        </p:txBody>
      </p:sp>
      <p:sp>
        <p:nvSpPr>
          <p:cNvPr id="3" name="Subtitle 2"/>
          <p:cNvSpPr>
            <a:spLocks noGrp="1"/>
          </p:cNvSpPr>
          <p:nvPr>
            <p:ph type="subTitle" idx="1"/>
          </p:nvPr>
        </p:nvSpPr>
        <p:spPr/>
        <p:txBody>
          <a:bodyPr/>
          <a:lstStyle/>
          <a:p>
            <a:r>
              <a:rPr lang="en-US" dirty="0"/>
              <a:t>Tetralogy of Fallot</a:t>
            </a:r>
          </a:p>
        </p:txBody>
      </p:sp>
    </p:spTree>
    <p:extLst>
      <p:ext uri="{BB962C8B-B14F-4D97-AF65-F5344CB8AC3E}">
        <p14:creationId xmlns:p14="http://schemas.microsoft.com/office/powerpoint/2010/main" val="1194644094"/>
      </p:ext>
    </p:extLst>
  </p:cSld>
  <p:clrMapOvr>
    <a:masterClrMapping/>
  </p:clrMapOvr>
</p:sld>
</file>

<file path=ppt/slides/slide5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2000" dirty="0"/>
              <a:t>Tet spell pathophysiology: Not perfectly understood but PVR&gt;&gt;SVR, and with pre-existing right ventricular outflow tract obstruction, decreased flow to the lungs, causing cyanosis. These are often exacerbated by fussiness, crying or defecating (all of these can transiently decrease arterial O2 saturation.) </a:t>
            </a:r>
            <a:br>
              <a:rPr lang="en-US" sz="2000" dirty="0"/>
            </a:br>
            <a:endParaRPr lang="en-US" sz="2000" dirty="0"/>
          </a:p>
        </p:txBody>
      </p:sp>
      <p:sp>
        <p:nvSpPr>
          <p:cNvPr id="3" name="Subtitle 2"/>
          <p:cNvSpPr>
            <a:spLocks noGrp="1"/>
          </p:cNvSpPr>
          <p:nvPr>
            <p:ph type="subTitle" idx="1"/>
          </p:nvPr>
        </p:nvSpPr>
        <p:spPr/>
        <p:txBody>
          <a:bodyPr/>
          <a:lstStyle/>
          <a:p>
            <a:r>
              <a:rPr lang="en-US"/>
              <a:t>TOF Continued</a:t>
            </a:r>
          </a:p>
        </p:txBody>
      </p:sp>
    </p:spTree>
    <p:extLst>
      <p:ext uri="{BB962C8B-B14F-4D97-AF65-F5344CB8AC3E}">
        <p14:creationId xmlns:p14="http://schemas.microsoft.com/office/powerpoint/2010/main" val="2212207395"/>
      </p:ext>
    </p:extLst>
  </p:cSld>
  <p:clrMapOvr>
    <a:masterClrMapping/>
  </p:clrMapOvr>
</p:sld>
</file>

<file path=ppt/slides/slide5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83894" y="1208696"/>
            <a:ext cx="7910111" cy="3188100"/>
          </a:xfrm>
        </p:spPr>
        <p:txBody>
          <a:bodyPr/>
          <a:lstStyle/>
          <a:p>
            <a:br>
              <a:rPr lang="en-US" sz="2000"/>
            </a:br>
            <a:r>
              <a:rPr lang="en-US" sz="2000"/>
              <a:t>*Positioning: knee chest (if not further aggravating patient) increases SVR</a:t>
            </a:r>
            <a:br>
              <a:rPr lang="en-US" sz="2000"/>
            </a:br>
            <a:r>
              <a:rPr lang="en-US" sz="2000"/>
              <a:t>*Supplemental O2 (increase in arterial O2 will increase SVR and decrease PVR) </a:t>
            </a:r>
            <a:br>
              <a:rPr lang="en-US" sz="2000"/>
            </a:br>
            <a:r>
              <a:rPr lang="en-US" sz="2000"/>
              <a:t>*Bolus: increase preload and decrease degree of RVOT</a:t>
            </a:r>
            <a:br>
              <a:rPr lang="en-US" sz="2000"/>
            </a:br>
            <a:r>
              <a:rPr lang="en-US" sz="2000"/>
              <a:t>*Morphine: mechanism not fully understood</a:t>
            </a:r>
            <a:br>
              <a:rPr lang="en-US" sz="2000"/>
            </a:br>
            <a:r>
              <a:rPr lang="en-US" sz="2000"/>
              <a:t>*Meds: B-blockers (improve RVOT), phenylephrine- increases SVR </a:t>
            </a:r>
            <a:br>
              <a:rPr lang="en-US" sz="2000"/>
            </a:br>
            <a:br>
              <a:rPr lang="en-US" sz="2000"/>
            </a:br>
            <a:endParaRPr lang="en-US" sz="2000"/>
          </a:p>
        </p:txBody>
      </p:sp>
      <p:sp>
        <p:nvSpPr>
          <p:cNvPr id="3" name="Subtitle 2"/>
          <p:cNvSpPr>
            <a:spLocks noGrp="1"/>
          </p:cNvSpPr>
          <p:nvPr>
            <p:ph type="subTitle" idx="1"/>
          </p:nvPr>
        </p:nvSpPr>
        <p:spPr/>
        <p:txBody>
          <a:bodyPr/>
          <a:lstStyle/>
          <a:p>
            <a:r>
              <a:rPr lang="en-US" sz="2800"/>
              <a:t>TET SPELL MANAGEMENT</a:t>
            </a:r>
            <a:r>
              <a:rPr lang="en-US" sz="2800">
                <a:sym typeface="Wingdings" panose="05000000000000000000" pitchFamily="2" charset="2"/>
              </a:rPr>
              <a:t> INCREASE SVR, DECREASE PVR</a:t>
            </a:r>
            <a:r>
              <a:rPr lang="en-US" sz="2800"/>
              <a:t> </a:t>
            </a:r>
          </a:p>
        </p:txBody>
      </p:sp>
    </p:spTree>
    <p:extLst>
      <p:ext uri="{BB962C8B-B14F-4D97-AF65-F5344CB8AC3E}">
        <p14:creationId xmlns:p14="http://schemas.microsoft.com/office/powerpoint/2010/main" val="2235986008"/>
      </p:ext>
    </p:extLst>
  </p:cSld>
  <p:clrMapOvr>
    <a:masterClrMapping/>
  </p:clrMapOvr>
</p:sld>
</file>

<file path=ppt/slides/slide58.xml><?xml version="1.0" encoding="utf-8"?>
<p:sld xmlns:a="http://schemas.openxmlformats.org/drawingml/2006/main" xmlns:r="http://schemas.openxmlformats.org/officeDocument/2006/relationships" xmlns:p="http://schemas.openxmlformats.org/presentationml/2006/main">
  <p:cSld>
    <p:spTree>
      <p:nvGrpSpPr>
        <p:cNvPr id="1" name="Shape 366"/>
        <p:cNvGrpSpPr/>
        <p:nvPr/>
      </p:nvGrpSpPr>
      <p:grpSpPr>
        <a:xfrm>
          <a:off x="0" y="0"/>
          <a:ext cx="0" cy="0"/>
          <a:chOff x="0" y="0"/>
          <a:chExt cx="0" cy="0"/>
        </a:xfrm>
      </p:grpSpPr>
      <p:sp>
        <p:nvSpPr>
          <p:cNvPr id="367" name="Google Shape;367;p33"/>
          <p:cNvSpPr txBox="1">
            <a:spLocks noGrp="1"/>
          </p:cNvSpPr>
          <p:nvPr>
            <p:ph type="title"/>
          </p:nvPr>
        </p:nvSpPr>
        <p:spPr>
          <a:xfrm>
            <a:off x="2877916" y="1624612"/>
            <a:ext cx="3912431" cy="1721818"/>
          </a:xfrm>
          <a:prstGeom prst="rect">
            <a:avLst/>
          </a:prstGeom>
        </p:spPr>
        <p:txBody>
          <a:bodyPr spcFirstLastPara="1" wrap="square" lIns="0" tIns="0" rIns="0" bIns="0" anchor="ctr" anchorCtr="0">
            <a:noAutofit/>
          </a:bodyPr>
          <a:lstStyle/>
          <a:p>
            <a:pPr marL="0" lvl="0" indent="0" algn="ctr" rtl="0">
              <a:spcBef>
                <a:spcPts val="0"/>
              </a:spcBef>
              <a:spcAft>
                <a:spcPts val="0"/>
              </a:spcAft>
              <a:buNone/>
            </a:pPr>
            <a:r>
              <a:rPr lang="en-US" sz="2000" dirty="0"/>
              <a:t>Name three drugs that may cause tachycardia (in either therapeutic or supratherapeutic doses)</a:t>
            </a:r>
            <a:endParaRPr sz="2000" dirty="0"/>
          </a:p>
        </p:txBody>
      </p:sp>
      <p:sp>
        <p:nvSpPr>
          <p:cNvPr id="368" name="Google Shape;368;p33"/>
          <p:cNvSpPr txBox="1">
            <a:spLocks noGrp="1"/>
          </p:cNvSpPr>
          <p:nvPr>
            <p:ph type="subTitle" idx="1"/>
          </p:nvPr>
        </p:nvSpPr>
        <p:spPr>
          <a:xfrm>
            <a:off x="1038650" y="640325"/>
            <a:ext cx="7079700" cy="444300"/>
          </a:xfrm>
          <a:prstGeom prst="rect">
            <a:avLst/>
          </a:prstGeom>
        </p:spPr>
        <p:txBody>
          <a:bodyPr spcFirstLastPara="1" wrap="square" lIns="0" tIns="0" rIns="0" bIns="0" anchor="t" anchorCtr="0">
            <a:noAutofit/>
          </a:bodyPr>
          <a:lstStyle/>
          <a:p>
            <a:pPr marL="0" lvl="0" indent="0" algn="ctr" rtl="0">
              <a:spcBef>
                <a:spcPts val="600"/>
              </a:spcBef>
              <a:spcAft>
                <a:spcPts val="0"/>
              </a:spcAft>
              <a:buNone/>
            </a:pPr>
            <a:r>
              <a:rPr lang="en"/>
              <a:t>Tachycardia Conundrum· </a:t>
            </a:r>
            <a:r>
              <a:rPr lang="en">
                <a:solidFill>
                  <a:srgbClr val="FFC319"/>
                </a:solidFill>
              </a:rPr>
              <a:t>$200</a:t>
            </a:r>
            <a:endParaRPr>
              <a:solidFill>
                <a:srgbClr val="FFC319"/>
              </a:solidFill>
            </a:endParaRPr>
          </a:p>
        </p:txBody>
      </p:sp>
    </p:spTree>
  </p:cSld>
  <p:clrMapOvr>
    <a:masterClrMapping/>
  </p:clrMapOvr>
</p:sld>
</file>

<file path=ppt/slides/slide59.xml><?xml version="1.0" encoding="utf-8"?>
<p:sld xmlns:a="http://schemas.openxmlformats.org/drawingml/2006/main" xmlns:r="http://schemas.openxmlformats.org/officeDocument/2006/relationships" xmlns:p="http://schemas.openxmlformats.org/presentationml/2006/main">
  <p:cSld>
    <p:spTree>
      <p:nvGrpSpPr>
        <p:cNvPr id="1" name="Shape 366"/>
        <p:cNvGrpSpPr/>
        <p:nvPr/>
      </p:nvGrpSpPr>
      <p:grpSpPr>
        <a:xfrm>
          <a:off x="0" y="0"/>
          <a:ext cx="0" cy="0"/>
          <a:chOff x="0" y="0"/>
          <a:chExt cx="0" cy="0"/>
        </a:xfrm>
      </p:grpSpPr>
      <p:sp>
        <p:nvSpPr>
          <p:cNvPr id="367" name="Google Shape;367;p33"/>
          <p:cNvSpPr txBox="1">
            <a:spLocks noGrp="1"/>
          </p:cNvSpPr>
          <p:nvPr>
            <p:ph type="title"/>
          </p:nvPr>
        </p:nvSpPr>
        <p:spPr>
          <a:xfrm>
            <a:off x="2877916" y="1624612"/>
            <a:ext cx="3912431" cy="1721818"/>
          </a:xfrm>
          <a:prstGeom prst="rect">
            <a:avLst/>
          </a:prstGeom>
        </p:spPr>
        <p:txBody>
          <a:bodyPr spcFirstLastPara="1" wrap="square" lIns="0" tIns="0" rIns="0" bIns="0" anchor="ctr" anchorCtr="0">
            <a:noAutofit/>
          </a:bodyPr>
          <a:lstStyle/>
          <a:p>
            <a:r>
              <a:rPr lang="en-US" sz="2000" dirty="0"/>
              <a:t>Anticholinergic Toxicity (e.g. diphenhydramine intoxication)</a:t>
            </a:r>
            <a:br>
              <a:rPr lang="en-US" sz="2000" dirty="0"/>
            </a:br>
            <a:r>
              <a:rPr lang="en-US" sz="2000" dirty="0"/>
              <a:t>TCAs, MAOIs, or SSRIs (Serotonin Syndrome)</a:t>
            </a:r>
            <a:br>
              <a:rPr lang="en-US" sz="2000" dirty="0"/>
            </a:br>
            <a:r>
              <a:rPr lang="en-US" sz="2000" dirty="0"/>
              <a:t>Amphetamines</a:t>
            </a:r>
            <a:endParaRPr sz="2000" dirty="0"/>
          </a:p>
        </p:txBody>
      </p:sp>
      <p:sp>
        <p:nvSpPr>
          <p:cNvPr id="368" name="Google Shape;368;p33"/>
          <p:cNvSpPr txBox="1">
            <a:spLocks noGrp="1"/>
          </p:cNvSpPr>
          <p:nvPr>
            <p:ph type="subTitle" idx="1"/>
          </p:nvPr>
        </p:nvSpPr>
        <p:spPr>
          <a:xfrm>
            <a:off x="1038650" y="640325"/>
            <a:ext cx="7079700" cy="444300"/>
          </a:xfrm>
          <a:prstGeom prst="rect">
            <a:avLst/>
          </a:prstGeom>
        </p:spPr>
        <p:txBody>
          <a:bodyPr spcFirstLastPara="1" wrap="square" lIns="0" tIns="0" rIns="0" bIns="0" anchor="t" anchorCtr="0">
            <a:noAutofit/>
          </a:bodyPr>
          <a:lstStyle/>
          <a:p>
            <a:pPr marL="0" lvl="0" indent="0" algn="ctr" rtl="0">
              <a:spcBef>
                <a:spcPts val="600"/>
              </a:spcBef>
              <a:spcAft>
                <a:spcPts val="0"/>
              </a:spcAft>
              <a:buNone/>
            </a:pPr>
            <a:r>
              <a:rPr lang="en"/>
              <a:t>Tachycardia Conundrum· </a:t>
            </a:r>
            <a:r>
              <a:rPr lang="en">
                <a:solidFill>
                  <a:srgbClr val="FFC319"/>
                </a:solidFill>
              </a:rPr>
              <a:t>$200</a:t>
            </a:r>
            <a:endParaRPr>
              <a:solidFill>
                <a:srgbClr val="FFC319"/>
              </a:solidFill>
            </a:endParaRPr>
          </a:p>
        </p:txBody>
      </p:sp>
    </p:spTree>
    <p:extLst>
      <p:ext uri="{BB962C8B-B14F-4D97-AF65-F5344CB8AC3E}">
        <p14:creationId xmlns:p14="http://schemas.microsoft.com/office/powerpoint/2010/main" val="179328496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282"/>
        <p:cNvGrpSpPr/>
        <p:nvPr/>
      </p:nvGrpSpPr>
      <p:grpSpPr>
        <a:xfrm>
          <a:off x="0" y="0"/>
          <a:ext cx="0" cy="0"/>
          <a:chOff x="0" y="0"/>
          <a:chExt cx="0" cy="0"/>
        </a:xfrm>
      </p:grpSpPr>
      <p:sp>
        <p:nvSpPr>
          <p:cNvPr id="284" name="Google Shape;284;p19"/>
          <p:cNvSpPr txBox="1">
            <a:spLocks noGrp="1"/>
          </p:cNvSpPr>
          <p:nvPr>
            <p:ph type="subTitle" idx="1"/>
          </p:nvPr>
        </p:nvSpPr>
        <p:spPr>
          <a:xfrm>
            <a:off x="1038650" y="640325"/>
            <a:ext cx="7079700" cy="444300"/>
          </a:xfrm>
          <a:prstGeom prst="rect">
            <a:avLst/>
          </a:prstGeom>
        </p:spPr>
        <p:txBody>
          <a:bodyPr spcFirstLastPara="1" wrap="square" lIns="0" tIns="0" rIns="0" bIns="0" anchor="t" anchorCtr="0">
            <a:noAutofit/>
          </a:bodyPr>
          <a:lstStyle/>
          <a:p>
            <a:pPr marL="0" indent="0"/>
            <a:r>
              <a:rPr lang="en-US">
                <a:solidFill>
                  <a:schemeClr val="lt1"/>
                </a:solidFill>
                <a:latin typeface="Bebas Neue"/>
                <a:ea typeface="Bebas Neue"/>
                <a:cs typeface="Bebas Neue"/>
                <a:sym typeface="Bebas Neue"/>
              </a:rPr>
              <a:t>To </a:t>
            </a:r>
            <a:r>
              <a:rPr lang="en-US" err="1">
                <a:solidFill>
                  <a:schemeClr val="lt1"/>
                </a:solidFill>
                <a:latin typeface="Bebas Neue"/>
                <a:ea typeface="Bebas Neue"/>
                <a:cs typeface="Bebas Neue"/>
                <a:sym typeface="Bebas Neue"/>
              </a:rPr>
              <a:t>cbc</a:t>
            </a:r>
            <a:r>
              <a:rPr lang="en-US">
                <a:solidFill>
                  <a:schemeClr val="lt1"/>
                </a:solidFill>
                <a:latin typeface="Bebas Neue"/>
                <a:ea typeface="Bebas Neue"/>
                <a:cs typeface="Bebas Neue"/>
                <a:sym typeface="Bebas Neue"/>
              </a:rPr>
              <a:t> or not to </a:t>
            </a:r>
            <a:r>
              <a:rPr lang="en-US" err="1">
                <a:solidFill>
                  <a:schemeClr val="lt1"/>
                </a:solidFill>
                <a:latin typeface="Bebas Neue"/>
                <a:ea typeface="Bebas Neue"/>
                <a:cs typeface="Bebas Neue"/>
                <a:sym typeface="Bebas Neue"/>
              </a:rPr>
              <a:t>cbc</a:t>
            </a:r>
            <a:endParaRPr lang="en-US">
              <a:solidFill>
                <a:schemeClr val="lt1"/>
              </a:solidFill>
              <a:latin typeface="Bebas Neue"/>
              <a:ea typeface="Bebas Neue"/>
              <a:cs typeface="Bebas Neue"/>
              <a:sym typeface="Bebas Neue"/>
            </a:endParaRPr>
          </a:p>
          <a:p>
            <a:pPr marL="0" lvl="0" indent="0" algn="ctr" rtl="0">
              <a:spcBef>
                <a:spcPts val="600"/>
              </a:spcBef>
              <a:spcAft>
                <a:spcPts val="0"/>
              </a:spcAft>
              <a:buNone/>
            </a:pPr>
            <a:r>
              <a:rPr lang="en"/>
              <a:t>· </a:t>
            </a:r>
            <a:r>
              <a:rPr lang="en">
                <a:solidFill>
                  <a:srgbClr val="FFC319"/>
                </a:solidFill>
              </a:rPr>
              <a:t>$400</a:t>
            </a:r>
            <a:endParaRPr>
              <a:solidFill>
                <a:srgbClr val="FFC319"/>
              </a:solidFill>
            </a:endParaRPr>
          </a:p>
        </p:txBody>
      </p:sp>
      <p:graphicFrame>
        <p:nvGraphicFramePr>
          <p:cNvPr id="6" name="Table 5">
            <a:extLst>
              <a:ext uri="{FF2B5EF4-FFF2-40B4-BE49-F238E27FC236}">
                <a16:creationId xmlns:a16="http://schemas.microsoft.com/office/drawing/2014/main" id="{495A53B3-2251-4A1C-9313-1390291369AC}"/>
              </a:ext>
            </a:extLst>
          </p:cNvPr>
          <p:cNvGraphicFramePr>
            <a:graphicFrameLocks noGrp="1"/>
          </p:cNvGraphicFramePr>
          <p:nvPr>
            <p:extLst>
              <p:ext uri="{D42A27DB-BD31-4B8C-83A1-F6EECF244321}">
                <p14:modId xmlns:p14="http://schemas.microsoft.com/office/powerpoint/2010/main" val="2149670775"/>
              </p:ext>
            </p:extLst>
          </p:nvPr>
        </p:nvGraphicFramePr>
        <p:xfrm>
          <a:off x="1145309" y="2013840"/>
          <a:ext cx="3120529" cy="1482280"/>
        </p:xfrm>
        <a:graphic>
          <a:graphicData uri="http://schemas.openxmlformats.org/drawingml/2006/table">
            <a:tbl>
              <a:tblPr firstRow="1" bandRow="1"/>
              <a:tblGrid>
                <a:gridCol w="767980">
                  <a:extLst>
                    <a:ext uri="{9D8B030D-6E8A-4147-A177-3AD203B41FA5}">
                      <a16:colId xmlns:a16="http://schemas.microsoft.com/office/drawing/2014/main" val="824425484"/>
                    </a:ext>
                  </a:extLst>
                </a:gridCol>
                <a:gridCol w="466622">
                  <a:extLst>
                    <a:ext uri="{9D8B030D-6E8A-4147-A177-3AD203B41FA5}">
                      <a16:colId xmlns:a16="http://schemas.microsoft.com/office/drawing/2014/main" val="610143289"/>
                    </a:ext>
                  </a:extLst>
                </a:gridCol>
                <a:gridCol w="748537">
                  <a:extLst>
                    <a:ext uri="{9D8B030D-6E8A-4147-A177-3AD203B41FA5}">
                      <a16:colId xmlns:a16="http://schemas.microsoft.com/office/drawing/2014/main" val="3542840054"/>
                    </a:ext>
                  </a:extLst>
                </a:gridCol>
                <a:gridCol w="466621">
                  <a:extLst>
                    <a:ext uri="{9D8B030D-6E8A-4147-A177-3AD203B41FA5}">
                      <a16:colId xmlns:a16="http://schemas.microsoft.com/office/drawing/2014/main" val="3916601039"/>
                    </a:ext>
                  </a:extLst>
                </a:gridCol>
                <a:gridCol w="670769">
                  <a:extLst>
                    <a:ext uri="{9D8B030D-6E8A-4147-A177-3AD203B41FA5}">
                      <a16:colId xmlns:a16="http://schemas.microsoft.com/office/drawing/2014/main" val="4033324111"/>
                    </a:ext>
                  </a:extLst>
                </a:gridCol>
              </a:tblGrid>
              <a:tr h="741140">
                <a:tc rowSpan="2">
                  <a:txBody>
                    <a:bodyPr/>
                    <a:lstStyle>
                      <a:lvl1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1pPr>
                      <a:lvl2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2pPr>
                      <a:lvl3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3pPr>
                      <a:lvl4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4pPr>
                      <a:lvl5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5pPr>
                      <a:lvl6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6pPr>
                      <a:lvl7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7pPr>
                      <a:lvl8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8pPr>
                      <a:lvl9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9pPr>
                    </a:lstStyle>
                    <a:p>
                      <a:endParaRPr lang="en-US" sz="1200" b="0">
                        <a:solidFill>
                          <a:schemeClr val="tx1"/>
                        </a:solidFill>
                      </a:endParaRPr>
                    </a:p>
                    <a:p>
                      <a:r>
                        <a:rPr lang="en-US" sz="2400" b="0">
                          <a:solidFill>
                            <a:schemeClr val="tx1"/>
                          </a:solidFill>
                        </a:rPr>
                        <a:t>7.2</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ap="flat" cmpd="sng" algn="ctr">
                      <a:noFill/>
                      <a:prstDash val="solid"/>
                      <a:round/>
                      <a:headEnd type="none" w="med" len="med"/>
                      <a:tailEnd type="none" w="med" len="med"/>
                    </a:lnTlToBr>
                    <a:lnBlToTr w="12700" cmpd="sng">
                      <a:noFill/>
                      <a:prstDash val="solid"/>
                    </a:lnBlToTr>
                    <a:solidFill>
                      <a:sysClr val="window" lastClr="FFFFFF"/>
                    </a:solidFill>
                  </a:tcPr>
                </a:tc>
                <a:tc>
                  <a:txBody>
                    <a:bodyPr/>
                    <a:lstStyle>
                      <a:lvl1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1pPr>
                      <a:lvl2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2pPr>
                      <a:lvl3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3pPr>
                      <a:lvl4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4pPr>
                      <a:lvl5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5pPr>
                      <a:lvl6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6pPr>
                      <a:lvl7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7pPr>
                      <a:lvl8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8pPr>
                      <a:lvl9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9pPr>
                    </a:lstStyle>
                    <a:p>
                      <a:endParaRPr lang="en-US" sz="1200"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ap="flat" cmpd="sng" algn="ctr">
                      <a:solidFill>
                        <a:sysClr val="windowText" lastClr="000000"/>
                      </a:solidFill>
                      <a:prstDash val="solid"/>
                      <a:round/>
                      <a:headEnd type="none" w="med" len="med"/>
                      <a:tailEnd type="none" w="med" len="med"/>
                    </a:lnTlToBr>
                    <a:lnBlToTr w="12700" cmpd="sng">
                      <a:noFill/>
                      <a:prstDash val="solid"/>
                    </a:lnBlToTr>
                    <a:solidFill>
                      <a:sysClr val="window" lastClr="FFFFFF"/>
                    </a:solidFill>
                  </a:tcPr>
                </a:tc>
                <a:tc>
                  <a:txBody>
                    <a:bodyPr/>
                    <a:lstStyle>
                      <a:lvl1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1pPr>
                      <a:lvl2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2pPr>
                      <a:lvl3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3pPr>
                      <a:lvl4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4pPr>
                      <a:lvl5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5pPr>
                      <a:lvl6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6pPr>
                      <a:lvl7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7pPr>
                      <a:lvl8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8pPr>
                      <a:lvl9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9pPr>
                    </a:lstStyle>
                    <a:p>
                      <a:pPr algn="ctr"/>
                      <a:r>
                        <a:rPr lang="en-US" sz="2000" b="0">
                          <a:solidFill>
                            <a:schemeClr val="tx1"/>
                          </a:solidFill>
                        </a:rPr>
                        <a:t>12.4</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solidFill>
                      <a:sysClr val="window" lastClr="FFFFFF"/>
                    </a:solidFill>
                  </a:tcPr>
                </a:tc>
                <a:tc>
                  <a:txBody>
                    <a:bodyPr/>
                    <a:lstStyle>
                      <a:lvl1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1pPr>
                      <a:lvl2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2pPr>
                      <a:lvl3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3pPr>
                      <a:lvl4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4pPr>
                      <a:lvl5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5pPr>
                      <a:lvl6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6pPr>
                      <a:lvl7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7pPr>
                      <a:lvl8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8pPr>
                      <a:lvl9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9pPr>
                    </a:lstStyle>
                    <a:p>
                      <a:endParaRPr lang="en-US" sz="1200"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ap="flat" cmpd="sng" algn="ctr">
                      <a:solidFill>
                        <a:sysClr val="windowText" lastClr="000000"/>
                      </a:solidFill>
                      <a:prstDash val="solid"/>
                      <a:round/>
                      <a:headEnd type="none" w="med" len="med"/>
                      <a:tailEnd type="none" w="med" len="med"/>
                    </a:lnBlToTr>
                    <a:solidFill>
                      <a:sysClr val="window" lastClr="FFFFFF"/>
                    </a:solidFill>
                  </a:tcPr>
                </a:tc>
                <a:tc rowSpan="2">
                  <a:txBody>
                    <a:bodyPr/>
                    <a:lstStyle>
                      <a:lvl1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1pPr>
                      <a:lvl2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2pPr>
                      <a:lvl3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3pPr>
                      <a:lvl4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4pPr>
                      <a:lvl5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5pPr>
                      <a:lvl6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6pPr>
                      <a:lvl7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7pPr>
                      <a:lvl8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8pPr>
                      <a:lvl9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9pPr>
                    </a:lstStyle>
                    <a:p>
                      <a:endParaRPr lang="en-US" sz="1200" b="0">
                        <a:solidFill>
                          <a:schemeClr val="tx1"/>
                        </a:solidFill>
                      </a:endParaRPr>
                    </a:p>
                    <a:p>
                      <a:endParaRPr lang="en-US" sz="1200" b="0">
                        <a:solidFill>
                          <a:schemeClr val="tx1"/>
                        </a:solidFill>
                      </a:endParaRPr>
                    </a:p>
                    <a:p>
                      <a:endParaRPr lang="en-US" sz="1200" b="0">
                        <a:solidFill>
                          <a:schemeClr val="tx1"/>
                        </a:solidFill>
                      </a:endParaRPr>
                    </a:p>
                    <a:p>
                      <a:r>
                        <a:rPr lang="en-US" sz="2000" b="0">
                          <a:solidFill>
                            <a:schemeClr val="tx1"/>
                          </a:solidFill>
                        </a:rPr>
                        <a:t>56</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ap="flat" cmpd="sng" algn="ctr">
                      <a:noFill/>
                      <a:prstDash val="solid"/>
                      <a:round/>
                      <a:headEnd type="none" w="med" len="med"/>
                      <a:tailEnd type="none" w="med" len="med"/>
                    </a:lnBlToTr>
                    <a:solidFill>
                      <a:sysClr val="window" lastClr="FFFFFF"/>
                    </a:solidFill>
                  </a:tcPr>
                </a:tc>
                <a:extLst>
                  <a:ext uri="{0D108BD9-81ED-4DB2-BD59-A6C34878D82A}">
                    <a16:rowId xmlns:a16="http://schemas.microsoft.com/office/drawing/2014/main" val="727745014"/>
                  </a:ext>
                </a:extLst>
              </a:tr>
              <a:tr h="741140">
                <a:tc vMerge="1">
                  <a:txBody>
                    <a:bodyPr/>
                    <a:lstStyle/>
                    <a:p>
                      <a:endParaRPr lang="en-US"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ap="flat" cmpd="sng" algn="ctr">
                      <a:noFill/>
                      <a:prstDash val="solid"/>
                      <a:round/>
                      <a:headEnd type="none" w="med" len="med"/>
                      <a:tailEnd type="none" w="med" len="med"/>
                    </a:lnBlToTr>
                    <a:solidFill>
                      <a:schemeClr val="bg1"/>
                    </a:solidFill>
                  </a:tcPr>
                </a:tc>
                <a:tc>
                  <a:txBody>
                    <a:bodyPr/>
                    <a:lstStyle>
                      <a:lvl1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1pPr>
                      <a:lvl2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2pPr>
                      <a:lvl3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3pPr>
                      <a:lvl4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4pPr>
                      <a:lvl5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5pPr>
                      <a:lvl6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6pPr>
                      <a:lvl7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7pPr>
                      <a:lvl8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8pPr>
                      <a:lvl9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9pPr>
                    </a:lstStyle>
                    <a:p>
                      <a:endParaRPr lang="en-US" sz="1200"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ap="flat" cmpd="sng" algn="ctr">
                      <a:solidFill>
                        <a:sysClr val="windowText" lastClr="000000"/>
                      </a:solidFill>
                      <a:prstDash val="solid"/>
                      <a:round/>
                      <a:headEnd type="none" w="med" len="med"/>
                      <a:tailEnd type="none" w="med" len="med"/>
                    </a:lnBlToTr>
                    <a:solidFill>
                      <a:sysClr val="window" lastClr="FFFFFF"/>
                    </a:solidFill>
                  </a:tcPr>
                </a:tc>
                <a:tc>
                  <a:txBody>
                    <a:bodyPr/>
                    <a:lstStyle>
                      <a:lvl1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1pPr>
                      <a:lvl2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2pPr>
                      <a:lvl3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3pPr>
                      <a:lvl4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4pPr>
                      <a:lvl5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5pPr>
                      <a:lvl6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6pPr>
                      <a:lvl7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7pPr>
                      <a:lvl8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8pPr>
                      <a:lvl9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9pPr>
                    </a:lstStyle>
                    <a:p>
                      <a:endParaRPr lang="en-US" sz="1200"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ysClr val="windowText" lastClr="000000"/>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ysClr val="window" lastClr="FFFFFF"/>
                    </a:solidFill>
                  </a:tcPr>
                </a:tc>
                <a:tc>
                  <a:txBody>
                    <a:bodyPr/>
                    <a:lstStyle>
                      <a:lvl1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1pPr>
                      <a:lvl2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2pPr>
                      <a:lvl3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3pPr>
                      <a:lvl4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4pPr>
                      <a:lvl5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5pPr>
                      <a:lvl6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6pPr>
                      <a:lvl7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7pPr>
                      <a:lvl8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8pPr>
                      <a:lvl9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9pPr>
                    </a:lstStyle>
                    <a:p>
                      <a:endParaRPr lang="en-US" sz="1200"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ap="flat" cmpd="sng" algn="ctr">
                      <a:solidFill>
                        <a:sysClr val="windowText" lastClr="000000"/>
                      </a:solidFill>
                      <a:prstDash val="solid"/>
                      <a:round/>
                      <a:headEnd type="none" w="med" len="med"/>
                      <a:tailEnd type="none" w="med" len="med"/>
                    </a:lnTlToBr>
                    <a:lnBlToTr w="12700" cap="flat" cmpd="sng" algn="ctr">
                      <a:noFill/>
                      <a:prstDash val="solid"/>
                      <a:round/>
                      <a:headEnd type="none" w="med" len="med"/>
                      <a:tailEnd type="none" w="med" len="med"/>
                    </a:lnBlToTr>
                    <a:solidFill>
                      <a:sysClr val="window" lastClr="FFFFFF"/>
                    </a:solidFill>
                  </a:tcPr>
                </a:tc>
                <a:tc vMerge="1">
                  <a:txBody>
                    <a:bodyPr/>
                    <a:lstStyle/>
                    <a:p>
                      <a:endParaRPr lang="en-US"/>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ap="flat" cmpd="sng" algn="ctr">
                      <a:noFill/>
                      <a:prstDash val="solid"/>
                      <a:round/>
                      <a:headEnd type="none" w="med" len="med"/>
                      <a:tailEnd type="none" w="med" len="med"/>
                    </a:lnTlToBr>
                    <a:lnBlToTr w="12700" cap="flat" cmpd="sng" algn="ctr">
                      <a:noFill/>
                      <a:prstDash val="solid"/>
                      <a:round/>
                      <a:headEnd type="none" w="med" len="med"/>
                      <a:tailEnd type="none" w="med" len="med"/>
                    </a:lnBlToTr>
                    <a:solidFill>
                      <a:schemeClr val="bg1"/>
                    </a:solidFill>
                  </a:tcPr>
                </a:tc>
                <a:extLst>
                  <a:ext uri="{0D108BD9-81ED-4DB2-BD59-A6C34878D82A}">
                    <a16:rowId xmlns:a16="http://schemas.microsoft.com/office/drawing/2014/main" val="2515014331"/>
                  </a:ext>
                </a:extLst>
              </a:tr>
            </a:tbl>
          </a:graphicData>
        </a:graphic>
      </p:graphicFrame>
      <p:sp>
        <p:nvSpPr>
          <p:cNvPr id="7" name="TextBox 6">
            <a:extLst>
              <a:ext uri="{FF2B5EF4-FFF2-40B4-BE49-F238E27FC236}">
                <a16:creationId xmlns:a16="http://schemas.microsoft.com/office/drawing/2014/main" id="{10072C17-DD68-4595-A811-196E76134226}"/>
              </a:ext>
            </a:extLst>
          </p:cNvPr>
          <p:cNvSpPr txBox="1"/>
          <p:nvPr/>
        </p:nvSpPr>
        <p:spPr>
          <a:xfrm>
            <a:off x="4572000" y="2013840"/>
            <a:ext cx="3516406" cy="523220"/>
          </a:xfrm>
          <a:prstGeom prst="rect">
            <a:avLst/>
          </a:prstGeom>
          <a:solidFill>
            <a:schemeClr val="bg1"/>
          </a:solidFill>
        </p:spPr>
        <p:txBody>
          <a:bodyPr wrap="square" rtlCol="0">
            <a:spAutoFit/>
          </a:bodyPr>
          <a:lstStyle/>
          <a:p>
            <a:r>
              <a:rPr lang="en-US" dirty="0"/>
              <a:t>This patient is a 2-year-old male with a history of eczema and a recent viral URI</a:t>
            </a:r>
          </a:p>
        </p:txBody>
      </p:sp>
      <p:sp>
        <p:nvSpPr>
          <p:cNvPr id="9" name="TextBox 8">
            <a:extLst>
              <a:ext uri="{FF2B5EF4-FFF2-40B4-BE49-F238E27FC236}">
                <a16:creationId xmlns:a16="http://schemas.microsoft.com/office/drawing/2014/main" id="{7E84D48B-FC6D-4590-BBB2-A037C7F96B5E}"/>
              </a:ext>
            </a:extLst>
          </p:cNvPr>
          <p:cNvSpPr txBox="1"/>
          <p:nvPr/>
        </p:nvSpPr>
        <p:spPr>
          <a:xfrm>
            <a:off x="4572000" y="2703627"/>
            <a:ext cx="3516406" cy="1169551"/>
          </a:xfrm>
          <a:prstGeom prst="rect">
            <a:avLst/>
          </a:prstGeom>
          <a:solidFill>
            <a:schemeClr val="bg1"/>
          </a:solidFill>
        </p:spPr>
        <p:txBody>
          <a:bodyPr wrap="square" rtlCol="0">
            <a:spAutoFit/>
          </a:bodyPr>
          <a:lstStyle/>
          <a:p>
            <a:r>
              <a:rPr lang="en-US"/>
              <a:t>What are one possible acquired diagnosis and one possible genetic diagnosis?</a:t>
            </a:r>
          </a:p>
          <a:p>
            <a:endParaRPr lang="en-US"/>
          </a:p>
          <a:p>
            <a:r>
              <a:rPr lang="en-US"/>
              <a:t>Is there any laboratory information that would make one diagnosis more likely?</a:t>
            </a:r>
          </a:p>
        </p:txBody>
      </p:sp>
    </p:spTree>
  </p:cSld>
  <p:clrMapOvr>
    <a:masterClrMapping/>
  </p:clrMapOvr>
</p:sld>
</file>

<file path=ppt/slides/slide60.xml><?xml version="1.0" encoding="utf-8"?>
<p:sld xmlns:a="http://schemas.openxmlformats.org/drawingml/2006/main" xmlns:r="http://schemas.openxmlformats.org/officeDocument/2006/relationships" xmlns:p="http://schemas.openxmlformats.org/presentationml/2006/main">
  <p:cSld>
    <p:spTree>
      <p:nvGrpSpPr>
        <p:cNvPr id="1" name="Shape 372"/>
        <p:cNvGrpSpPr/>
        <p:nvPr/>
      </p:nvGrpSpPr>
      <p:grpSpPr>
        <a:xfrm>
          <a:off x="0" y="0"/>
          <a:ext cx="0" cy="0"/>
          <a:chOff x="0" y="0"/>
          <a:chExt cx="0" cy="0"/>
        </a:xfrm>
      </p:grpSpPr>
      <p:sp>
        <p:nvSpPr>
          <p:cNvPr id="373" name="Google Shape;373;p34"/>
          <p:cNvSpPr txBox="1">
            <a:spLocks noGrp="1"/>
          </p:cNvSpPr>
          <p:nvPr>
            <p:ph type="title"/>
          </p:nvPr>
        </p:nvSpPr>
        <p:spPr>
          <a:xfrm>
            <a:off x="2738953" y="1866481"/>
            <a:ext cx="4311884" cy="1594050"/>
          </a:xfrm>
          <a:prstGeom prst="rect">
            <a:avLst/>
          </a:prstGeom>
        </p:spPr>
        <p:txBody>
          <a:bodyPr spcFirstLastPara="1" wrap="square" lIns="0" tIns="0" rIns="0" bIns="0" anchor="ctr" anchorCtr="0">
            <a:noAutofit/>
          </a:bodyPr>
          <a:lstStyle/>
          <a:p>
            <a:pPr marL="0" lvl="0" indent="0" algn="ctr" rtl="0">
              <a:spcBef>
                <a:spcPts val="0"/>
              </a:spcBef>
              <a:spcAft>
                <a:spcPts val="0"/>
              </a:spcAft>
              <a:buNone/>
            </a:pPr>
            <a:r>
              <a:rPr lang="en-US"/>
              <a:t>Name 3 Cardiac etiologies for pathologic tachycardia and how you diagnose them  </a:t>
            </a:r>
            <a:endParaRPr/>
          </a:p>
        </p:txBody>
      </p:sp>
      <p:sp>
        <p:nvSpPr>
          <p:cNvPr id="374" name="Google Shape;374;p34"/>
          <p:cNvSpPr txBox="1">
            <a:spLocks noGrp="1"/>
          </p:cNvSpPr>
          <p:nvPr>
            <p:ph type="subTitle" idx="1"/>
          </p:nvPr>
        </p:nvSpPr>
        <p:spPr>
          <a:xfrm>
            <a:off x="1038650" y="640325"/>
            <a:ext cx="7079700" cy="444300"/>
          </a:xfrm>
          <a:prstGeom prst="rect">
            <a:avLst/>
          </a:prstGeom>
        </p:spPr>
        <p:txBody>
          <a:bodyPr spcFirstLastPara="1" wrap="square" lIns="0" tIns="0" rIns="0" bIns="0" anchor="t" anchorCtr="0">
            <a:noAutofit/>
          </a:bodyPr>
          <a:lstStyle/>
          <a:p>
            <a:pPr marL="0" lvl="0" indent="0" algn="ctr" rtl="0">
              <a:spcBef>
                <a:spcPts val="600"/>
              </a:spcBef>
              <a:spcAft>
                <a:spcPts val="0"/>
              </a:spcAft>
              <a:buNone/>
            </a:pPr>
            <a:r>
              <a:rPr lang="en"/>
              <a:t>Tachycardia Conundrum · </a:t>
            </a:r>
            <a:r>
              <a:rPr lang="en">
                <a:solidFill>
                  <a:srgbClr val="FFC319"/>
                </a:solidFill>
              </a:rPr>
              <a:t>$400</a:t>
            </a:r>
            <a:endParaRPr>
              <a:solidFill>
                <a:srgbClr val="FFC319"/>
              </a:solidFill>
            </a:endParaRPr>
          </a:p>
        </p:txBody>
      </p:sp>
    </p:spTree>
  </p:cSld>
  <p:clrMapOvr>
    <a:masterClrMapping/>
  </p:clrMapOvr>
</p:sld>
</file>

<file path=ppt/slides/slide61.xml><?xml version="1.0" encoding="utf-8"?>
<p:sld xmlns:a="http://schemas.openxmlformats.org/drawingml/2006/main" xmlns:r="http://schemas.openxmlformats.org/officeDocument/2006/relationships" xmlns:p="http://schemas.openxmlformats.org/presentationml/2006/main">
  <p:cSld>
    <p:spTree>
      <p:nvGrpSpPr>
        <p:cNvPr id="1" name="Shape 372"/>
        <p:cNvGrpSpPr/>
        <p:nvPr/>
      </p:nvGrpSpPr>
      <p:grpSpPr>
        <a:xfrm>
          <a:off x="0" y="0"/>
          <a:ext cx="0" cy="0"/>
          <a:chOff x="0" y="0"/>
          <a:chExt cx="0" cy="0"/>
        </a:xfrm>
      </p:grpSpPr>
      <p:sp>
        <p:nvSpPr>
          <p:cNvPr id="373" name="Google Shape;373;p34"/>
          <p:cNvSpPr txBox="1">
            <a:spLocks noGrp="1"/>
          </p:cNvSpPr>
          <p:nvPr>
            <p:ph type="title"/>
          </p:nvPr>
        </p:nvSpPr>
        <p:spPr>
          <a:xfrm>
            <a:off x="2738953" y="1866481"/>
            <a:ext cx="4311884" cy="1594050"/>
          </a:xfrm>
          <a:prstGeom prst="rect">
            <a:avLst/>
          </a:prstGeom>
        </p:spPr>
        <p:txBody>
          <a:bodyPr spcFirstLastPara="1" wrap="square" lIns="0" tIns="0" rIns="0" bIns="0" anchor="ctr" anchorCtr="0">
            <a:noAutofit/>
          </a:bodyPr>
          <a:lstStyle/>
          <a:p>
            <a:pPr lvl="0"/>
            <a:br>
              <a:rPr lang="en-US"/>
            </a:br>
            <a:r>
              <a:rPr lang="en-US" sz="1800"/>
              <a:t>Arrhythmia – example of SVT (lack of P-waves, may resolve with vagal maneuvers)</a:t>
            </a:r>
            <a:br>
              <a:rPr lang="en-US" sz="1800"/>
            </a:br>
            <a:r>
              <a:rPr lang="en-US" sz="1800"/>
              <a:t>Myocarditis – may see EKG changes or signs of volume overload (pulmonary crackles, hepatomegaly)</a:t>
            </a:r>
            <a:br>
              <a:rPr lang="en-US" sz="1800"/>
            </a:br>
            <a:r>
              <a:rPr lang="en-US" sz="1800"/>
              <a:t>Cardiac Tamponade – Beck’s Triad (distant heart sounds, pulsus paradoxus, hypotension)</a:t>
            </a:r>
            <a:endParaRPr/>
          </a:p>
        </p:txBody>
      </p:sp>
      <p:sp>
        <p:nvSpPr>
          <p:cNvPr id="374" name="Google Shape;374;p34"/>
          <p:cNvSpPr txBox="1">
            <a:spLocks noGrp="1"/>
          </p:cNvSpPr>
          <p:nvPr>
            <p:ph type="subTitle" idx="1"/>
          </p:nvPr>
        </p:nvSpPr>
        <p:spPr>
          <a:xfrm>
            <a:off x="1038650" y="640325"/>
            <a:ext cx="7079700" cy="444300"/>
          </a:xfrm>
          <a:prstGeom prst="rect">
            <a:avLst/>
          </a:prstGeom>
        </p:spPr>
        <p:txBody>
          <a:bodyPr spcFirstLastPara="1" wrap="square" lIns="0" tIns="0" rIns="0" bIns="0" anchor="t" anchorCtr="0">
            <a:noAutofit/>
          </a:bodyPr>
          <a:lstStyle/>
          <a:p>
            <a:pPr marL="0" lvl="0" indent="0" algn="ctr" rtl="0">
              <a:spcBef>
                <a:spcPts val="600"/>
              </a:spcBef>
              <a:spcAft>
                <a:spcPts val="0"/>
              </a:spcAft>
              <a:buNone/>
            </a:pPr>
            <a:r>
              <a:rPr lang="en"/>
              <a:t>Tachycardia Conundrum · </a:t>
            </a:r>
            <a:r>
              <a:rPr lang="en">
                <a:solidFill>
                  <a:srgbClr val="FFC319"/>
                </a:solidFill>
              </a:rPr>
              <a:t>$400</a:t>
            </a:r>
            <a:endParaRPr>
              <a:solidFill>
                <a:srgbClr val="FFC319"/>
              </a:solidFill>
            </a:endParaRPr>
          </a:p>
        </p:txBody>
      </p:sp>
    </p:spTree>
    <p:extLst>
      <p:ext uri="{BB962C8B-B14F-4D97-AF65-F5344CB8AC3E}">
        <p14:creationId xmlns:p14="http://schemas.microsoft.com/office/powerpoint/2010/main" val="942353908"/>
      </p:ext>
    </p:extLst>
  </p:cSld>
  <p:clrMapOvr>
    <a:masterClrMapping/>
  </p:clrMapOvr>
</p:sld>
</file>

<file path=ppt/slides/slide62.xml><?xml version="1.0" encoding="utf-8"?>
<p:sld xmlns:a="http://schemas.openxmlformats.org/drawingml/2006/main" xmlns:r="http://schemas.openxmlformats.org/officeDocument/2006/relationships" xmlns:p="http://schemas.openxmlformats.org/presentationml/2006/main">
  <p:cSld>
    <p:spTree>
      <p:nvGrpSpPr>
        <p:cNvPr id="1" name="Shape 378"/>
        <p:cNvGrpSpPr/>
        <p:nvPr/>
      </p:nvGrpSpPr>
      <p:grpSpPr>
        <a:xfrm>
          <a:off x="0" y="0"/>
          <a:ext cx="0" cy="0"/>
          <a:chOff x="0" y="0"/>
          <a:chExt cx="0" cy="0"/>
        </a:xfrm>
      </p:grpSpPr>
      <p:sp>
        <p:nvSpPr>
          <p:cNvPr id="379" name="Google Shape;379;p35"/>
          <p:cNvSpPr txBox="1">
            <a:spLocks noGrp="1"/>
          </p:cNvSpPr>
          <p:nvPr>
            <p:ph type="title"/>
          </p:nvPr>
        </p:nvSpPr>
        <p:spPr>
          <a:xfrm>
            <a:off x="718457" y="1627303"/>
            <a:ext cx="7660433" cy="1888893"/>
          </a:xfrm>
          <a:prstGeom prst="rect">
            <a:avLst/>
          </a:prstGeom>
        </p:spPr>
        <p:txBody>
          <a:bodyPr spcFirstLastPara="1" wrap="square" lIns="0" tIns="0" rIns="0" bIns="0" anchor="ctr" anchorCtr="0">
            <a:noAutofit/>
          </a:bodyPr>
          <a:lstStyle/>
          <a:p>
            <a:pPr marL="0" lvl="0" indent="0" algn="ctr" rtl="0">
              <a:spcBef>
                <a:spcPts val="0"/>
              </a:spcBef>
              <a:spcAft>
                <a:spcPts val="0"/>
              </a:spcAft>
              <a:buNone/>
            </a:pPr>
            <a:r>
              <a:rPr lang="en-US"/>
              <a:t>Name 3 metabolic causes of tachycardia that may be diagnosed via BMP</a:t>
            </a:r>
            <a:endParaRPr/>
          </a:p>
        </p:txBody>
      </p:sp>
      <p:sp>
        <p:nvSpPr>
          <p:cNvPr id="380" name="Google Shape;380;p35"/>
          <p:cNvSpPr txBox="1">
            <a:spLocks noGrp="1"/>
          </p:cNvSpPr>
          <p:nvPr>
            <p:ph type="subTitle" idx="1"/>
          </p:nvPr>
        </p:nvSpPr>
        <p:spPr>
          <a:xfrm>
            <a:off x="1038650" y="640325"/>
            <a:ext cx="7079700" cy="444300"/>
          </a:xfrm>
          <a:prstGeom prst="rect">
            <a:avLst/>
          </a:prstGeom>
        </p:spPr>
        <p:txBody>
          <a:bodyPr spcFirstLastPara="1" wrap="square" lIns="0" tIns="0" rIns="0" bIns="0" anchor="t" anchorCtr="0">
            <a:noAutofit/>
          </a:bodyPr>
          <a:lstStyle/>
          <a:p>
            <a:pPr marL="0" lvl="0" indent="0" algn="ctr" rtl="0">
              <a:spcBef>
                <a:spcPts val="600"/>
              </a:spcBef>
              <a:spcAft>
                <a:spcPts val="0"/>
              </a:spcAft>
              <a:buNone/>
            </a:pPr>
            <a:r>
              <a:rPr lang="en"/>
              <a:t>Tachycardia Conundrum· </a:t>
            </a:r>
            <a:r>
              <a:rPr lang="en">
                <a:solidFill>
                  <a:srgbClr val="FFC319"/>
                </a:solidFill>
              </a:rPr>
              <a:t>$600</a:t>
            </a:r>
            <a:endParaRPr>
              <a:solidFill>
                <a:srgbClr val="FFC319"/>
              </a:solidFill>
            </a:endParaRPr>
          </a:p>
        </p:txBody>
      </p:sp>
    </p:spTree>
  </p:cSld>
  <p:clrMapOvr>
    <a:masterClrMapping/>
  </p:clrMapOvr>
</p:sld>
</file>

<file path=ppt/slides/slide63.xml><?xml version="1.0" encoding="utf-8"?>
<p:sld xmlns:a="http://schemas.openxmlformats.org/drawingml/2006/main" xmlns:r="http://schemas.openxmlformats.org/officeDocument/2006/relationships" xmlns:p="http://schemas.openxmlformats.org/presentationml/2006/main">
  <p:cSld>
    <p:spTree>
      <p:nvGrpSpPr>
        <p:cNvPr id="1" name="Shape 378"/>
        <p:cNvGrpSpPr/>
        <p:nvPr/>
      </p:nvGrpSpPr>
      <p:grpSpPr>
        <a:xfrm>
          <a:off x="0" y="0"/>
          <a:ext cx="0" cy="0"/>
          <a:chOff x="0" y="0"/>
          <a:chExt cx="0" cy="0"/>
        </a:xfrm>
      </p:grpSpPr>
      <p:sp>
        <p:nvSpPr>
          <p:cNvPr id="379" name="Google Shape;379;p35"/>
          <p:cNvSpPr txBox="1">
            <a:spLocks noGrp="1"/>
          </p:cNvSpPr>
          <p:nvPr>
            <p:ph type="title"/>
          </p:nvPr>
        </p:nvSpPr>
        <p:spPr>
          <a:xfrm>
            <a:off x="718457" y="1627303"/>
            <a:ext cx="7660433" cy="1888893"/>
          </a:xfrm>
          <a:prstGeom prst="rect">
            <a:avLst/>
          </a:prstGeom>
        </p:spPr>
        <p:txBody>
          <a:bodyPr spcFirstLastPara="1" wrap="square" lIns="0" tIns="0" rIns="0" bIns="0" anchor="ctr" anchorCtr="0">
            <a:noAutofit/>
          </a:bodyPr>
          <a:lstStyle/>
          <a:p>
            <a:pPr marL="0" lvl="0" indent="0" algn="ctr" rtl="0">
              <a:spcBef>
                <a:spcPts val="0"/>
              </a:spcBef>
              <a:spcAft>
                <a:spcPts val="0"/>
              </a:spcAft>
              <a:buNone/>
            </a:pPr>
            <a:r>
              <a:rPr lang="en-US"/>
              <a:t>Hypoglycemia – this is an issue of substrate deficiency.</a:t>
            </a:r>
            <a:br>
              <a:rPr lang="en-US"/>
            </a:br>
            <a:r>
              <a:rPr lang="en-US"/>
              <a:t>Hyperkalemia</a:t>
            </a:r>
            <a:br>
              <a:rPr lang="en-US"/>
            </a:br>
            <a:r>
              <a:rPr lang="en-US"/>
              <a:t>Hypocalcemia (may precipitate arrhythmia)</a:t>
            </a:r>
            <a:endParaRPr/>
          </a:p>
        </p:txBody>
      </p:sp>
      <p:sp>
        <p:nvSpPr>
          <p:cNvPr id="380" name="Google Shape;380;p35"/>
          <p:cNvSpPr txBox="1">
            <a:spLocks noGrp="1"/>
          </p:cNvSpPr>
          <p:nvPr>
            <p:ph type="subTitle" idx="1"/>
          </p:nvPr>
        </p:nvSpPr>
        <p:spPr>
          <a:xfrm>
            <a:off x="1038650" y="640325"/>
            <a:ext cx="7079700" cy="444300"/>
          </a:xfrm>
          <a:prstGeom prst="rect">
            <a:avLst/>
          </a:prstGeom>
        </p:spPr>
        <p:txBody>
          <a:bodyPr spcFirstLastPara="1" wrap="square" lIns="0" tIns="0" rIns="0" bIns="0" anchor="t" anchorCtr="0">
            <a:noAutofit/>
          </a:bodyPr>
          <a:lstStyle/>
          <a:p>
            <a:pPr marL="0" lvl="0" indent="0" algn="ctr" rtl="0">
              <a:spcBef>
                <a:spcPts val="600"/>
              </a:spcBef>
              <a:spcAft>
                <a:spcPts val="0"/>
              </a:spcAft>
              <a:buNone/>
            </a:pPr>
            <a:r>
              <a:rPr lang="en"/>
              <a:t>Tachycardia Conundrum· </a:t>
            </a:r>
            <a:r>
              <a:rPr lang="en">
                <a:solidFill>
                  <a:srgbClr val="FFC319"/>
                </a:solidFill>
              </a:rPr>
              <a:t>$600</a:t>
            </a:r>
            <a:endParaRPr>
              <a:solidFill>
                <a:srgbClr val="FFC319"/>
              </a:solidFill>
            </a:endParaRPr>
          </a:p>
        </p:txBody>
      </p:sp>
    </p:spTree>
    <p:extLst>
      <p:ext uri="{BB962C8B-B14F-4D97-AF65-F5344CB8AC3E}">
        <p14:creationId xmlns:p14="http://schemas.microsoft.com/office/powerpoint/2010/main" val="2236388295"/>
      </p:ext>
    </p:extLst>
  </p:cSld>
  <p:clrMapOvr>
    <a:masterClrMapping/>
  </p:clrMapOvr>
</p:sld>
</file>

<file path=ppt/slides/slide64.xml><?xml version="1.0" encoding="utf-8"?>
<p:sld xmlns:a="http://schemas.openxmlformats.org/drawingml/2006/main" xmlns:r="http://schemas.openxmlformats.org/officeDocument/2006/relationships" xmlns:p="http://schemas.openxmlformats.org/presentationml/2006/main">
  <p:cSld>
    <p:spTree>
      <p:nvGrpSpPr>
        <p:cNvPr id="1" name="Shape 384"/>
        <p:cNvGrpSpPr/>
        <p:nvPr/>
      </p:nvGrpSpPr>
      <p:grpSpPr>
        <a:xfrm>
          <a:off x="0" y="0"/>
          <a:ext cx="0" cy="0"/>
          <a:chOff x="0" y="0"/>
          <a:chExt cx="0" cy="0"/>
        </a:xfrm>
      </p:grpSpPr>
      <p:sp>
        <p:nvSpPr>
          <p:cNvPr id="385" name="Google Shape;385;p36"/>
          <p:cNvSpPr txBox="1">
            <a:spLocks noGrp="1"/>
          </p:cNvSpPr>
          <p:nvPr>
            <p:ph type="title"/>
          </p:nvPr>
        </p:nvSpPr>
        <p:spPr>
          <a:xfrm>
            <a:off x="1255624" y="1316455"/>
            <a:ext cx="6380501" cy="2729955"/>
          </a:xfrm>
          <a:prstGeom prst="rect">
            <a:avLst/>
          </a:prstGeom>
        </p:spPr>
        <p:txBody>
          <a:bodyPr spcFirstLastPara="1" wrap="square" lIns="0" tIns="0" rIns="0" bIns="0" anchor="ctr" anchorCtr="0">
            <a:noAutofit/>
          </a:bodyPr>
          <a:lstStyle/>
          <a:p>
            <a:pPr marL="0" lvl="0" indent="0" algn="ctr" rtl="0">
              <a:spcBef>
                <a:spcPts val="0"/>
              </a:spcBef>
              <a:spcAft>
                <a:spcPts val="0"/>
              </a:spcAft>
              <a:buNone/>
            </a:pPr>
            <a:r>
              <a:rPr lang="en-US" dirty="0"/>
              <a:t>Name the diagnosis: A 17-year-old female w/ a PMH of PCOS presents with tachycardia following a flight home from college</a:t>
            </a:r>
            <a:endParaRPr dirty="0"/>
          </a:p>
        </p:txBody>
      </p:sp>
      <p:sp>
        <p:nvSpPr>
          <p:cNvPr id="386" name="Google Shape;386;p36"/>
          <p:cNvSpPr txBox="1">
            <a:spLocks noGrp="1"/>
          </p:cNvSpPr>
          <p:nvPr>
            <p:ph type="subTitle" idx="1"/>
          </p:nvPr>
        </p:nvSpPr>
        <p:spPr>
          <a:xfrm>
            <a:off x="1038650" y="640325"/>
            <a:ext cx="7079700" cy="444300"/>
          </a:xfrm>
          <a:prstGeom prst="rect">
            <a:avLst/>
          </a:prstGeom>
        </p:spPr>
        <p:txBody>
          <a:bodyPr spcFirstLastPara="1" wrap="square" lIns="0" tIns="0" rIns="0" bIns="0" anchor="t" anchorCtr="0">
            <a:noAutofit/>
          </a:bodyPr>
          <a:lstStyle/>
          <a:p>
            <a:pPr marL="0" lvl="0" indent="0" algn="ctr" rtl="0">
              <a:spcBef>
                <a:spcPts val="600"/>
              </a:spcBef>
              <a:spcAft>
                <a:spcPts val="0"/>
              </a:spcAft>
              <a:buNone/>
            </a:pPr>
            <a:r>
              <a:rPr lang="en"/>
              <a:t>Tachycardia Conundrum· </a:t>
            </a:r>
            <a:r>
              <a:rPr lang="en">
                <a:solidFill>
                  <a:srgbClr val="FFC319"/>
                </a:solidFill>
              </a:rPr>
              <a:t>$800</a:t>
            </a:r>
            <a:endParaRPr>
              <a:solidFill>
                <a:srgbClr val="FFC319"/>
              </a:solidFill>
            </a:endParaRPr>
          </a:p>
        </p:txBody>
      </p:sp>
    </p:spTree>
  </p:cSld>
  <p:clrMapOvr>
    <a:masterClrMapping/>
  </p:clrMapOvr>
</p:sld>
</file>

<file path=ppt/slides/slide65.xml><?xml version="1.0" encoding="utf-8"?>
<p:sld xmlns:a="http://schemas.openxmlformats.org/drawingml/2006/main" xmlns:r="http://schemas.openxmlformats.org/officeDocument/2006/relationships" xmlns:p="http://schemas.openxmlformats.org/presentationml/2006/main">
  <p:cSld>
    <p:spTree>
      <p:nvGrpSpPr>
        <p:cNvPr id="1" name="Shape 384"/>
        <p:cNvGrpSpPr/>
        <p:nvPr/>
      </p:nvGrpSpPr>
      <p:grpSpPr>
        <a:xfrm>
          <a:off x="0" y="0"/>
          <a:ext cx="0" cy="0"/>
          <a:chOff x="0" y="0"/>
          <a:chExt cx="0" cy="0"/>
        </a:xfrm>
      </p:grpSpPr>
      <p:sp>
        <p:nvSpPr>
          <p:cNvPr id="385" name="Google Shape;385;p36"/>
          <p:cNvSpPr txBox="1">
            <a:spLocks noGrp="1"/>
          </p:cNvSpPr>
          <p:nvPr>
            <p:ph type="title"/>
          </p:nvPr>
        </p:nvSpPr>
        <p:spPr>
          <a:xfrm>
            <a:off x="1255624" y="1316455"/>
            <a:ext cx="6380501" cy="2729955"/>
          </a:xfrm>
          <a:prstGeom prst="rect">
            <a:avLst/>
          </a:prstGeom>
        </p:spPr>
        <p:txBody>
          <a:bodyPr spcFirstLastPara="1" wrap="square" lIns="0" tIns="0" rIns="0" bIns="0" anchor="ctr" anchorCtr="0">
            <a:noAutofit/>
          </a:bodyPr>
          <a:lstStyle/>
          <a:p>
            <a:pPr marL="0" lvl="0" indent="0" algn="ctr" rtl="0">
              <a:spcBef>
                <a:spcPts val="0"/>
              </a:spcBef>
              <a:spcAft>
                <a:spcPts val="0"/>
              </a:spcAft>
              <a:buNone/>
            </a:pPr>
            <a:r>
              <a:rPr lang="en-US" dirty="0"/>
              <a:t>Answer – Pulmonary Embolism</a:t>
            </a:r>
            <a:br>
              <a:rPr lang="en-US" dirty="0"/>
            </a:br>
            <a:r>
              <a:rPr lang="en-US" sz="1800" dirty="0"/>
              <a:t>PE may present with isolated tachycardia or with symptoms including dyspnea, chest pain, hypoxemia, or hypotension. This patient had risk factors including immobilization and oral contraceptive use (for her PCOS). PE is a no-miss diagnosis.</a:t>
            </a:r>
            <a:br>
              <a:rPr lang="en-US" sz="1800" dirty="0"/>
            </a:br>
            <a:br>
              <a:rPr lang="en-US" sz="1800" dirty="0"/>
            </a:br>
            <a:r>
              <a:rPr lang="en-US" sz="1800" dirty="0"/>
              <a:t>Your illness script for PE should be activated any patient with unexplained, isolated tachycardia!</a:t>
            </a:r>
            <a:endParaRPr dirty="0"/>
          </a:p>
        </p:txBody>
      </p:sp>
      <p:sp>
        <p:nvSpPr>
          <p:cNvPr id="386" name="Google Shape;386;p36"/>
          <p:cNvSpPr txBox="1">
            <a:spLocks noGrp="1"/>
          </p:cNvSpPr>
          <p:nvPr>
            <p:ph type="subTitle" idx="1"/>
          </p:nvPr>
        </p:nvSpPr>
        <p:spPr>
          <a:xfrm>
            <a:off x="1038650" y="640325"/>
            <a:ext cx="7079700" cy="444300"/>
          </a:xfrm>
          <a:prstGeom prst="rect">
            <a:avLst/>
          </a:prstGeom>
        </p:spPr>
        <p:txBody>
          <a:bodyPr spcFirstLastPara="1" wrap="square" lIns="0" tIns="0" rIns="0" bIns="0" anchor="t" anchorCtr="0">
            <a:noAutofit/>
          </a:bodyPr>
          <a:lstStyle/>
          <a:p>
            <a:pPr marL="0" lvl="0" indent="0" algn="ctr" rtl="0">
              <a:spcBef>
                <a:spcPts val="600"/>
              </a:spcBef>
              <a:spcAft>
                <a:spcPts val="0"/>
              </a:spcAft>
              <a:buNone/>
            </a:pPr>
            <a:r>
              <a:rPr lang="en"/>
              <a:t>Tachycardia Conundrum· </a:t>
            </a:r>
            <a:r>
              <a:rPr lang="en">
                <a:solidFill>
                  <a:srgbClr val="FFC319"/>
                </a:solidFill>
              </a:rPr>
              <a:t>$800</a:t>
            </a:r>
            <a:endParaRPr>
              <a:solidFill>
                <a:srgbClr val="FFC319"/>
              </a:solidFill>
            </a:endParaRPr>
          </a:p>
        </p:txBody>
      </p:sp>
    </p:spTree>
    <p:extLst>
      <p:ext uri="{BB962C8B-B14F-4D97-AF65-F5344CB8AC3E}">
        <p14:creationId xmlns:p14="http://schemas.microsoft.com/office/powerpoint/2010/main" val="1821428307"/>
      </p:ext>
    </p:extLst>
  </p:cSld>
  <p:clrMapOvr>
    <a:masterClrMapping/>
  </p:clrMapOvr>
</p:sld>
</file>

<file path=ppt/slides/slide66.xml><?xml version="1.0" encoding="utf-8"?>
<p:sld xmlns:a="http://schemas.openxmlformats.org/drawingml/2006/main" xmlns:r="http://schemas.openxmlformats.org/officeDocument/2006/relationships" xmlns:p="http://schemas.openxmlformats.org/presentationml/2006/main">
  <p:cSld>
    <p:spTree>
      <p:nvGrpSpPr>
        <p:cNvPr id="1" name="Shape 390"/>
        <p:cNvGrpSpPr/>
        <p:nvPr/>
      </p:nvGrpSpPr>
      <p:grpSpPr>
        <a:xfrm>
          <a:off x="0" y="0"/>
          <a:ext cx="0" cy="0"/>
          <a:chOff x="0" y="0"/>
          <a:chExt cx="0" cy="0"/>
        </a:xfrm>
      </p:grpSpPr>
      <p:sp>
        <p:nvSpPr>
          <p:cNvPr id="392" name="Google Shape;392;p37"/>
          <p:cNvSpPr txBox="1">
            <a:spLocks noGrp="1"/>
          </p:cNvSpPr>
          <p:nvPr>
            <p:ph type="subTitle" idx="1"/>
          </p:nvPr>
        </p:nvSpPr>
        <p:spPr>
          <a:xfrm>
            <a:off x="1038650" y="640325"/>
            <a:ext cx="7079700" cy="444300"/>
          </a:xfrm>
          <a:prstGeom prst="rect">
            <a:avLst/>
          </a:prstGeom>
        </p:spPr>
        <p:txBody>
          <a:bodyPr spcFirstLastPara="1" wrap="square" lIns="0" tIns="0" rIns="0" bIns="0" anchor="t" anchorCtr="0">
            <a:noAutofit/>
          </a:bodyPr>
          <a:lstStyle/>
          <a:p>
            <a:pPr marL="0" lvl="0" indent="0" algn="ctr" rtl="0">
              <a:spcBef>
                <a:spcPts val="600"/>
              </a:spcBef>
              <a:spcAft>
                <a:spcPts val="0"/>
              </a:spcAft>
              <a:buNone/>
            </a:pPr>
            <a:r>
              <a:rPr lang="en"/>
              <a:t>Tachycardia Conundrum· </a:t>
            </a:r>
            <a:r>
              <a:rPr lang="en">
                <a:solidFill>
                  <a:srgbClr val="FFC319"/>
                </a:solidFill>
              </a:rPr>
              <a:t>$1000</a:t>
            </a:r>
            <a:endParaRPr>
              <a:solidFill>
                <a:srgbClr val="FFC319"/>
              </a:solidFill>
            </a:endParaRPr>
          </a:p>
        </p:txBody>
      </p:sp>
      <p:sp>
        <p:nvSpPr>
          <p:cNvPr id="4" name="Title 3">
            <a:extLst>
              <a:ext uri="{FF2B5EF4-FFF2-40B4-BE49-F238E27FC236}">
                <a16:creationId xmlns:a16="http://schemas.microsoft.com/office/drawing/2014/main" id="{D5847CC6-7F94-3C5C-89B0-B0B7BF8CD5A8}"/>
              </a:ext>
            </a:extLst>
          </p:cNvPr>
          <p:cNvSpPr>
            <a:spLocks noGrp="1"/>
          </p:cNvSpPr>
          <p:nvPr>
            <p:ph type="title"/>
          </p:nvPr>
        </p:nvSpPr>
        <p:spPr>
          <a:xfrm>
            <a:off x="957431" y="1101272"/>
            <a:ext cx="7081800" cy="3188100"/>
          </a:xfrm>
        </p:spPr>
        <p:txBody>
          <a:bodyPr/>
          <a:lstStyle/>
          <a:p>
            <a:r>
              <a:rPr lang="en-US"/>
              <a:t>Pathophysiology: Why is tachycardia often the first sign of shock?</a:t>
            </a:r>
          </a:p>
        </p:txBody>
      </p:sp>
    </p:spTree>
  </p:cSld>
  <p:clrMapOvr>
    <a:masterClrMapping/>
  </p:clrMapOvr>
</p:sld>
</file>

<file path=ppt/slides/slide67.xml><?xml version="1.0" encoding="utf-8"?>
<p:sld xmlns:a="http://schemas.openxmlformats.org/drawingml/2006/main" xmlns:r="http://schemas.openxmlformats.org/officeDocument/2006/relationships" xmlns:p="http://schemas.openxmlformats.org/presentationml/2006/main">
  <p:cSld>
    <p:spTree>
      <p:nvGrpSpPr>
        <p:cNvPr id="1" name="Shape 390"/>
        <p:cNvGrpSpPr/>
        <p:nvPr/>
      </p:nvGrpSpPr>
      <p:grpSpPr>
        <a:xfrm>
          <a:off x="0" y="0"/>
          <a:ext cx="0" cy="0"/>
          <a:chOff x="0" y="0"/>
          <a:chExt cx="0" cy="0"/>
        </a:xfrm>
      </p:grpSpPr>
      <p:sp>
        <p:nvSpPr>
          <p:cNvPr id="392" name="Google Shape;392;p37"/>
          <p:cNvSpPr txBox="1">
            <a:spLocks noGrp="1"/>
          </p:cNvSpPr>
          <p:nvPr>
            <p:ph type="subTitle" idx="1"/>
          </p:nvPr>
        </p:nvSpPr>
        <p:spPr>
          <a:xfrm>
            <a:off x="1038650" y="640325"/>
            <a:ext cx="7079700" cy="444300"/>
          </a:xfrm>
          <a:prstGeom prst="rect">
            <a:avLst/>
          </a:prstGeom>
        </p:spPr>
        <p:txBody>
          <a:bodyPr spcFirstLastPara="1" wrap="square" lIns="0" tIns="0" rIns="0" bIns="0" anchor="t" anchorCtr="0">
            <a:noAutofit/>
          </a:bodyPr>
          <a:lstStyle/>
          <a:p>
            <a:pPr marL="0" lvl="0" indent="0" algn="ctr" rtl="0">
              <a:spcBef>
                <a:spcPts val="600"/>
              </a:spcBef>
              <a:spcAft>
                <a:spcPts val="0"/>
              </a:spcAft>
              <a:buNone/>
            </a:pPr>
            <a:r>
              <a:rPr lang="en"/>
              <a:t>Tachycardia Conundrum· </a:t>
            </a:r>
            <a:r>
              <a:rPr lang="en">
                <a:solidFill>
                  <a:srgbClr val="FFC319"/>
                </a:solidFill>
              </a:rPr>
              <a:t>$1000</a:t>
            </a:r>
            <a:endParaRPr>
              <a:solidFill>
                <a:srgbClr val="FFC319"/>
              </a:solidFill>
            </a:endParaRPr>
          </a:p>
        </p:txBody>
      </p:sp>
      <p:sp>
        <p:nvSpPr>
          <p:cNvPr id="4" name="Title 3">
            <a:extLst>
              <a:ext uri="{FF2B5EF4-FFF2-40B4-BE49-F238E27FC236}">
                <a16:creationId xmlns:a16="http://schemas.microsoft.com/office/drawing/2014/main" id="{D5847CC6-7F94-3C5C-89B0-B0B7BF8CD5A8}"/>
              </a:ext>
            </a:extLst>
          </p:cNvPr>
          <p:cNvSpPr>
            <a:spLocks noGrp="1"/>
          </p:cNvSpPr>
          <p:nvPr>
            <p:ph type="title"/>
          </p:nvPr>
        </p:nvSpPr>
        <p:spPr>
          <a:xfrm>
            <a:off x="957431" y="1101272"/>
            <a:ext cx="7081800" cy="3188100"/>
          </a:xfrm>
        </p:spPr>
        <p:txBody>
          <a:bodyPr/>
          <a:lstStyle/>
          <a:p>
            <a:r>
              <a:rPr lang="en-US" sz="2000" dirty="0"/>
              <a:t>The definition of shock is inadequate cardiac output to meet metabolic demands. It can be due to decreased volume, increased metabolic demands, or inadequate cardiac output (CO) due to cardiac etiologies – in all of these cases, tachycardia occurs to attempt to increase CO and meet these metabolic demands! </a:t>
            </a:r>
          </a:p>
        </p:txBody>
      </p:sp>
    </p:spTree>
    <p:extLst>
      <p:ext uri="{BB962C8B-B14F-4D97-AF65-F5344CB8AC3E}">
        <p14:creationId xmlns:p14="http://schemas.microsoft.com/office/powerpoint/2010/main" val="849508341"/>
      </p:ext>
    </p:extLst>
  </p:cSld>
  <p:clrMapOvr>
    <a:masterClrMapping/>
  </p:clrMapOvr>
</p:sld>
</file>

<file path=ppt/slides/slide68.xml><?xml version="1.0" encoding="utf-8"?>
<p:sld xmlns:a="http://schemas.openxmlformats.org/drawingml/2006/main" xmlns:r="http://schemas.openxmlformats.org/officeDocument/2006/relationships" xmlns:p="http://schemas.openxmlformats.org/presentationml/2006/main">
  <p:cSld>
    <p:spTree>
      <p:nvGrpSpPr>
        <p:cNvPr id="1" name="Shape 456"/>
        <p:cNvGrpSpPr/>
        <p:nvPr/>
      </p:nvGrpSpPr>
      <p:grpSpPr>
        <a:xfrm>
          <a:off x="0" y="0"/>
          <a:ext cx="0" cy="0"/>
          <a:chOff x="0" y="0"/>
          <a:chExt cx="0" cy="0"/>
        </a:xfrm>
      </p:grpSpPr>
      <p:sp>
        <p:nvSpPr>
          <p:cNvPr id="457" name="Google Shape;457;p48"/>
          <p:cNvSpPr/>
          <p:nvPr/>
        </p:nvSpPr>
        <p:spPr>
          <a:xfrm>
            <a:off x="2428664" y="2024965"/>
            <a:ext cx="4286664" cy="1243434"/>
          </a:xfrm>
          <a:prstGeom prst="rect">
            <a:avLst/>
          </a:prstGeom>
        </p:spPr>
        <p:txBody>
          <a:bodyPr>
            <a:prstTxWarp prst="textPlain">
              <a:avLst/>
            </a:prstTxWarp>
          </a:bodyPr>
          <a:lstStyle/>
          <a:p>
            <a:pPr lvl="0" algn="ctr"/>
            <a:r>
              <a:rPr b="1" i="0">
                <a:ln>
                  <a:noFill/>
                </a:ln>
                <a:gradFill>
                  <a:gsLst>
                    <a:gs pos="0">
                      <a:schemeClr val="lt1"/>
                    </a:gs>
                    <a:gs pos="3000">
                      <a:schemeClr val="dk2"/>
                    </a:gs>
                    <a:gs pos="68000">
                      <a:schemeClr val="dk2"/>
                    </a:gs>
                    <a:gs pos="100000">
                      <a:schemeClr val="lt2"/>
                    </a:gs>
                  </a:gsLst>
                  <a:lin ang="5400012" scaled="0"/>
                </a:gradFill>
                <a:latin typeface="Bebas Neue"/>
              </a:rPr>
              <a:t>Winner!</a:t>
            </a:r>
          </a:p>
        </p:txBody>
      </p:sp>
    </p:spTree>
  </p:cSld>
  <p:clrMapOvr>
    <a:masterClrMapping/>
  </p:clrMapOvr>
</p:sld>
</file>

<file path=ppt/slides/slide69.xml><?xml version="1.0" encoding="utf-8"?>
<p:sld xmlns:a="http://schemas.openxmlformats.org/drawingml/2006/main" xmlns:r="http://schemas.openxmlformats.org/officeDocument/2006/relationships" xmlns:p="http://schemas.openxmlformats.org/presentationml/2006/main">
  <p:cSld>
    <p:spTree>
      <p:nvGrpSpPr>
        <p:cNvPr id="1" name="Shape 654"/>
        <p:cNvGrpSpPr/>
        <p:nvPr/>
      </p:nvGrpSpPr>
      <p:grpSpPr>
        <a:xfrm>
          <a:off x="0" y="0"/>
          <a:ext cx="0" cy="0"/>
          <a:chOff x="0" y="0"/>
          <a:chExt cx="0" cy="0"/>
        </a:xfrm>
      </p:grpSpPr>
      <p:sp>
        <p:nvSpPr>
          <p:cNvPr id="655" name="Google Shape;655;g2794d772b92_0_0"/>
          <p:cNvSpPr txBox="1">
            <a:spLocks noGrp="1"/>
          </p:cNvSpPr>
          <p:nvPr>
            <p:ph type="title"/>
          </p:nvPr>
        </p:nvSpPr>
        <p:spPr>
          <a:xfrm>
            <a:off x="1032075" y="966325"/>
            <a:ext cx="7081800" cy="3188100"/>
          </a:xfrm>
          <a:prstGeom prst="rect">
            <a:avLst/>
          </a:prstGeom>
        </p:spPr>
        <p:txBody>
          <a:bodyPr spcFirstLastPara="1" wrap="square" lIns="0" tIns="0" rIns="0" bIns="0" anchor="ctr" anchorCtr="0">
            <a:noAutofit/>
          </a:bodyPr>
          <a:lstStyle/>
          <a:p>
            <a:pPr marL="457200" lvl="0" indent="-368300" algn="l" rtl="0">
              <a:spcBef>
                <a:spcPts val="0"/>
              </a:spcBef>
              <a:spcAft>
                <a:spcPts val="0"/>
              </a:spcAft>
              <a:buSzPts val="2200"/>
              <a:buFont typeface="Calibri"/>
              <a:buChar char="●"/>
            </a:pPr>
            <a:r>
              <a:rPr lang="en-US" sz="2200" b="0">
                <a:latin typeface="Calibri"/>
                <a:ea typeface="Calibri"/>
                <a:cs typeface="Calibri"/>
                <a:sym typeface="Calibri"/>
              </a:rPr>
              <a:t>StatPearls [Internet]. Treasure Island (FL): StatPearls Publishing; 2023 Jan-. Available from: </a:t>
            </a:r>
            <a:r>
              <a:rPr lang="en-US" sz="2200" b="0" u="sng">
                <a:latin typeface="Calibri"/>
                <a:ea typeface="Calibri"/>
                <a:cs typeface="Calibri"/>
                <a:sym typeface="Calibri"/>
                <a:hlinkClick r:id="rId3"/>
              </a:rPr>
              <a:t>https://www.ncbi.nlm.nih.gov/books/NBK430685/</a:t>
            </a:r>
            <a:endParaRPr sz="2200" b="0">
              <a:latin typeface="Calibri"/>
              <a:ea typeface="Calibri"/>
              <a:cs typeface="Calibri"/>
              <a:sym typeface="Calibri"/>
            </a:endParaRPr>
          </a:p>
          <a:p>
            <a:pPr marL="457200" lvl="0" indent="-368300" algn="l" rtl="0">
              <a:spcBef>
                <a:spcPts val="0"/>
              </a:spcBef>
              <a:spcAft>
                <a:spcPts val="0"/>
              </a:spcAft>
              <a:buSzPts val="2200"/>
              <a:buFont typeface="Calibri"/>
              <a:buChar char="●"/>
            </a:pPr>
            <a:r>
              <a:rPr lang="en-US" sz="2200" b="0">
                <a:latin typeface="Calibri"/>
                <a:ea typeface="Calibri"/>
                <a:cs typeface="Calibri"/>
                <a:sym typeface="Calibri"/>
              </a:rPr>
              <a:t>Zitelli BJ McIntire SC Nowalk AJ. </a:t>
            </a:r>
            <a:r>
              <a:rPr lang="en-US" sz="2200" b="0" i="1">
                <a:latin typeface="Calibri"/>
                <a:ea typeface="Calibri"/>
                <a:cs typeface="Calibri"/>
                <a:sym typeface="Calibri"/>
              </a:rPr>
              <a:t>Zitelli and Davis' Atlas of Pediatric Physical Diagnosis</a:t>
            </a:r>
            <a:r>
              <a:rPr lang="en-US" sz="2200" b="0">
                <a:latin typeface="Calibri"/>
                <a:ea typeface="Calibri"/>
                <a:cs typeface="Calibri"/>
                <a:sym typeface="Calibri"/>
              </a:rPr>
              <a:t>. Sixth ed. Philadelphia PA: Saunders/Elsevier; 2012. http://www.clinicalkey.com/dura/browse/bookChapter/3-s2.0-C20090425819. Accessed August 29 2023.</a:t>
            </a:r>
            <a:endParaRPr sz="2200" b="0">
              <a:latin typeface="Calibri"/>
              <a:ea typeface="Calibri"/>
              <a:cs typeface="Calibri"/>
              <a:sym typeface="Calibri"/>
            </a:endParaRPr>
          </a:p>
        </p:txBody>
      </p:sp>
      <p:sp>
        <p:nvSpPr>
          <p:cNvPr id="656" name="Google Shape;656;g2794d772b92_0_0"/>
          <p:cNvSpPr txBox="1">
            <a:spLocks noGrp="1"/>
          </p:cNvSpPr>
          <p:nvPr>
            <p:ph type="subTitle" idx="1"/>
          </p:nvPr>
        </p:nvSpPr>
        <p:spPr>
          <a:xfrm>
            <a:off x="1038650" y="640325"/>
            <a:ext cx="7079700" cy="444300"/>
          </a:xfrm>
          <a:prstGeom prst="rect">
            <a:avLst/>
          </a:prstGeom>
        </p:spPr>
        <p:txBody>
          <a:bodyPr spcFirstLastPara="1" wrap="square" lIns="0" tIns="0" rIns="0" bIns="0" anchor="t" anchorCtr="0">
            <a:noAutofit/>
          </a:bodyPr>
          <a:lstStyle/>
          <a:p>
            <a:pPr marL="0" lvl="0" indent="0" algn="ctr" rtl="0">
              <a:spcBef>
                <a:spcPts val="600"/>
              </a:spcBef>
              <a:spcAft>
                <a:spcPts val="0"/>
              </a:spcAft>
              <a:buNone/>
            </a:pPr>
            <a:r>
              <a:rPr lang="en-US"/>
              <a:t>References</a:t>
            </a:r>
            <a:endParaRPr/>
          </a:p>
        </p:txBody>
      </p:sp>
    </p:spTree>
    <p:extLst>
      <p:ext uri="{BB962C8B-B14F-4D97-AF65-F5344CB8AC3E}">
        <p14:creationId xmlns:p14="http://schemas.microsoft.com/office/powerpoint/2010/main" val="280479918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7B6990-40BC-4427-BECE-8EE6BF1456DE}"/>
              </a:ext>
            </a:extLst>
          </p:cNvPr>
          <p:cNvSpPr>
            <a:spLocks noGrp="1"/>
          </p:cNvSpPr>
          <p:nvPr>
            <p:ph type="title"/>
          </p:nvPr>
        </p:nvSpPr>
        <p:spPr/>
        <p:txBody>
          <a:bodyPr/>
          <a:lstStyle/>
          <a:p>
            <a:r>
              <a:rPr lang="en-US" sz="2800" dirty="0"/>
              <a:t>Answer: Wiskott-Aldritch Syndrome vs. Immune Thrombocytopenia</a:t>
            </a:r>
            <a:br>
              <a:rPr lang="en-US" sz="2800" dirty="0"/>
            </a:br>
            <a:br>
              <a:rPr lang="en-US" sz="2800" dirty="0"/>
            </a:br>
            <a:r>
              <a:rPr lang="en-US" sz="2800" dirty="0"/>
              <a:t>Differentiating factor: Mean Platelet Volume!</a:t>
            </a:r>
            <a:br>
              <a:rPr lang="en-US" sz="2800" dirty="0"/>
            </a:br>
            <a:r>
              <a:rPr lang="en-US" sz="2800" dirty="0"/>
              <a:t>WAS is a </a:t>
            </a:r>
            <a:r>
              <a:rPr lang="en-US" sz="2800" err="1"/>
              <a:t>microthrombocytopenia</a:t>
            </a:r>
            <a:br>
              <a:rPr lang="en-US" sz="2800" dirty="0"/>
            </a:br>
            <a:r>
              <a:rPr lang="en-US" sz="2800" dirty="0"/>
              <a:t>ITP is a macrothrombocytopenia</a:t>
            </a:r>
          </a:p>
        </p:txBody>
      </p:sp>
    </p:spTree>
    <p:extLst>
      <p:ext uri="{BB962C8B-B14F-4D97-AF65-F5344CB8AC3E}">
        <p14:creationId xmlns:p14="http://schemas.microsoft.com/office/powerpoint/2010/main" val="201682713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288"/>
        <p:cNvGrpSpPr/>
        <p:nvPr/>
      </p:nvGrpSpPr>
      <p:grpSpPr>
        <a:xfrm>
          <a:off x="0" y="0"/>
          <a:ext cx="0" cy="0"/>
          <a:chOff x="0" y="0"/>
          <a:chExt cx="0" cy="0"/>
        </a:xfrm>
      </p:grpSpPr>
      <p:sp>
        <p:nvSpPr>
          <p:cNvPr id="290" name="Google Shape;290;p20"/>
          <p:cNvSpPr txBox="1">
            <a:spLocks noGrp="1"/>
          </p:cNvSpPr>
          <p:nvPr>
            <p:ph type="subTitle" idx="1"/>
          </p:nvPr>
        </p:nvSpPr>
        <p:spPr>
          <a:xfrm>
            <a:off x="1038649" y="640325"/>
            <a:ext cx="7329495" cy="444300"/>
          </a:xfrm>
          <a:prstGeom prst="rect">
            <a:avLst/>
          </a:prstGeom>
        </p:spPr>
        <p:txBody>
          <a:bodyPr spcFirstLastPara="1" wrap="square" lIns="0" tIns="0" rIns="0" bIns="0" anchor="t" anchorCtr="0">
            <a:noAutofit/>
          </a:bodyPr>
          <a:lstStyle/>
          <a:p>
            <a:pPr marL="0" indent="0"/>
            <a:r>
              <a:rPr lang="en-US">
                <a:solidFill>
                  <a:schemeClr val="lt1"/>
                </a:solidFill>
                <a:latin typeface="Bebas Neue"/>
                <a:ea typeface="Bebas Neue"/>
                <a:cs typeface="Bebas Neue"/>
                <a:sym typeface="Bebas Neue"/>
              </a:rPr>
              <a:t>To </a:t>
            </a:r>
            <a:r>
              <a:rPr lang="en-US" err="1">
                <a:solidFill>
                  <a:schemeClr val="lt1"/>
                </a:solidFill>
                <a:latin typeface="Bebas Neue"/>
                <a:ea typeface="Bebas Neue"/>
                <a:cs typeface="Bebas Neue"/>
                <a:sym typeface="Bebas Neue"/>
              </a:rPr>
              <a:t>cbc</a:t>
            </a:r>
            <a:r>
              <a:rPr lang="en-US">
                <a:solidFill>
                  <a:schemeClr val="lt1"/>
                </a:solidFill>
                <a:latin typeface="Bebas Neue"/>
                <a:ea typeface="Bebas Neue"/>
                <a:cs typeface="Bebas Neue"/>
                <a:sym typeface="Bebas Neue"/>
              </a:rPr>
              <a:t> or not to </a:t>
            </a:r>
            <a:r>
              <a:rPr lang="en-US" err="1">
                <a:solidFill>
                  <a:schemeClr val="lt1"/>
                </a:solidFill>
                <a:latin typeface="Bebas Neue"/>
                <a:ea typeface="Bebas Neue"/>
                <a:cs typeface="Bebas Neue"/>
                <a:sym typeface="Bebas Neue"/>
              </a:rPr>
              <a:t>cbc</a:t>
            </a:r>
            <a:endParaRPr lang="en-US">
              <a:solidFill>
                <a:schemeClr val="lt1"/>
              </a:solidFill>
              <a:latin typeface="Bebas Neue"/>
              <a:ea typeface="Bebas Neue"/>
              <a:cs typeface="Bebas Neue"/>
              <a:sym typeface="Bebas Neue"/>
            </a:endParaRPr>
          </a:p>
          <a:p>
            <a:pPr marL="0" lvl="0" indent="0" algn="ctr" rtl="0">
              <a:spcBef>
                <a:spcPts val="600"/>
              </a:spcBef>
              <a:spcAft>
                <a:spcPts val="0"/>
              </a:spcAft>
              <a:buNone/>
            </a:pPr>
            <a:r>
              <a:rPr lang="en"/>
              <a:t>· </a:t>
            </a:r>
            <a:r>
              <a:rPr lang="en">
                <a:solidFill>
                  <a:srgbClr val="FFC319"/>
                </a:solidFill>
              </a:rPr>
              <a:t>$600</a:t>
            </a:r>
            <a:endParaRPr>
              <a:solidFill>
                <a:srgbClr val="FFC319"/>
              </a:solidFill>
            </a:endParaRPr>
          </a:p>
        </p:txBody>
      </p:sp>
      <p:graphicFrame>
        <p:nvGraphicFramePr>
          <p:cNvPr id="6" name="Table 5">
            <a:extLst>
              <a:ext uri="{FF2B5EF4-FFF2-40B4-BE49-F238E27FC236}">
                <a16:creationId xmlns:a16="http://schemas.microsoft.com/office/drawing/2014/main" id="{91C0079E-C59D-4F0A-84EE-A7B3A4EB78D2}"/>
              </a:ext>
            </a:extLst>
          </p:cNvPr>
          <p:cNvGraphicFramePr>
            <a:graphicFrameLocks noGrp="1"/>
          </p:cNvGraphicFramePr>
          <p:nvPr>
            <p:extLst>
              <p:ext uri="{D42A27DB-BD31-4B8C-83A1-F6EECF244321}">
                <p14:modId xmlns:p14="http://schemas.microsoft.com/office/powerpoint/2010/main" val="19518423"/>
              </p:ext>
            </p:extLst>
          </p:nvPr>
        </p:nvGraphicFramePr>
        <p:xfrm>
          <a:off x="1357745" y="2013840"/>
          <a:ext cx="2937165" cy="1093837"/>
        </p:xfrm>
        <a:graphic>
          <a:graphicData uri="http://schemas.openxmlformats.org/drawingml/2006/table">
            <a:tbl>
              <a:tblPr firstRow="1" bandRow="1"/>
              <a:tblGrid>
                <a:gridCol w="722853">
                  <a:extLst>
                    <a:ext uri="{9D8B030D-6E8A-4147-A177-3AD203B41FA5}">
                      <a16:colId xmlns:a16="http://schemas.microsoft.com/office/drawing/2014/main" val="824425484"/>
                    </a:ext>
                  </a:extLst>
                </a:gridCol>
                <a:gridCol w="439204">
                  <a:extLst>
                    <a:ext uri="{9D8B030D-6E8A-4147-A177-3AD203B41FA5}">
                      <a16:colId xmlns:a16="http://schemas.microsoft.com/office/drawing/2014/main" val="610143289"/>
                    </a:ext>
                  </a:extLst>
                </a:gridCol>
                <a:gridCol w="704552">
                  <a:extLst>
                    <a:ext uri="{9D8B030D-6E8A-4147-A177-3AD203B41FA5}">
                      <a16:colId xmlns:a16="http://schemas.microsoft.com/office/drawing/2014/main" val="3542840054"/>
                    </a:ext>
                  </a:extLst>
                </a:gridCol>
                <a:gridCol w="439202">
                  <a:extLst>
                    <a:ext uri="{9D8B030D-6E8A-4147-A177-3AD203B41FA5}">
                      <a16:colId xmlns:a16="http://schemas.microsoft.com/office/drawing/2014/main" val="3916601039"/>
                    </a:ext>
                  </a:extLst>
                </a:gridCol>
                <a:gridCol w="631354">
                  <a:extLst>
                    <a:ext uri="{9D8B030D-6E8A-4147-A177-3AD203B41FA5}">
                      <a16:colId xmlns:a16="http://schemas.microsoft.com/office/drawing/2014/main" val="4033324111"/>
                    </a:ext>
                  </a:extLst>
                </a:gridCol>
              </a:tblGrid>
              <a:tr h="446495">
                <a:tc rowSpan="2">
                  <a:txBody>
                    <a:bodyPr/>
                    <a:lstStyle>
                      <a:lvl1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1pPr>
                      <a:lvl2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2pPr>
                      <a:lvl3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3pPr>
                      <a:lvl4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4pPr>
                      <a:lvl5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5pPr>
                      <a:lvl6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6pPr>
                      <a:lvl7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7pPr>
                      <a:lvl8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8pPr>
                      <a:lvl9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9pPr>
                    </a:lstStyle>
                    <a:p>
                      <a:endParaRPr lang="en-US" sz="1400" b="0">
                        <a:solidFill>
                          <a:schemeClr val="tx1"/>
                        </a:solidFill>
                      </a:endParaRPr>
                    </a:p>
                    <a:p>
                      <a:endParaRPr lang="en-US" sz="1400" b="0">
                        <a:solidFill>
                          <a:schemeClr val="tx1"/>
                        </a:solidFill>
                      </a:endParaRPr>
                    </a:p>
                    <a:p>
                      <a:r>
                        <a:rPr lang="en-US" sz="1800" b="0">
                          <a:solidFill>
                            <a:schemeClr val="tx1"/>
                          </a:solidFill>
                        </a:rPr>
                        <a:t>1.7</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ap="flat" cmpd="sng" algn="ctr">
                      <a:noFill/>
                      <a:prstDash val="solid"/>
                      <a:round/>
                      <a:headEnd type="none" w="med" len="med"/>
                      <a:tailEnd type="none" w="med" len="med"/>
                    </a:lnTlToBr>
                    <a:lnBlToTr w="12700" cmpd="sng">
                      <a:noFill/>
                      <a:prstDash val="solid"/>
                    </a:lnBlToTr>
                    <a:solidFill>
                      <a:sysClr val="window" lastClr="FFFFFF"/>
                    </a:solidFill>
                  </a:tcPr>
                </a:tc>
                <a:tc>
                  <a:txBody>
                    <a:bodyPr/>
                    <a:lstStyle>
                      <a:lvl1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1pPr>
                      <a:lvl2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2pPr>
                      <a:lvl3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3pPr>
                      <a:lvl4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4pPr>
                      <a:lvl5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5pPr>
                      <a:lvl6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6pPr>
                      <a:lvl7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7pPr>
                      <a:lvl8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8pPr>
                      <a:lvl9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9pPr>
                    </a:lstStyle>
                    <a:p>
                      <a:endParaRPr lang="en-US" sz="1200"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ap="flat" cmpd="sng" algn="ctr">
                      <a:solidFill>
                        <a:sysClr val="windowText" lastClr="000000"/>
                      </a:solidFill>
                      <a:prstDash val="solid"/>
                      <a:round/>
                      <a:headEnd type="none" w="med" len="med"/>
                      <a:tailEnd type="none" w="med" len="med"/>
                    </a:lnTlToBr>
                    <a:lnBlToTr w="12700" cmpd="sng">
                      <a:noFill/>
                      <a:prstDash val="solid"/>
                    </a:lnBlToTr>
                    <a:solidFill>
                      <a:sysClr val="window" lastClr="FFFFFF"/>
                    </a:solidFill>
                  </a:tcPr>
                </a:tc>
                <a:tc>
                  <a:txBody>
                    <a:bodyPr/>
                    <a:lstStyle>
                      <a:lvl1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1pPr>
                      <a:lvl2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2pPr>
                      <a:lvl3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3pPr>
                      <a:lvl4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4pPr>
                      <a:lvl5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5pPr>
                      <a:lvl6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6pPr>
                      <a:lvl7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7pPr>
                      <a:lvl8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8pPr>
                      <a:lvl9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9pPr>
                    </a:lstStyle>
                    <a:p>
                      <a:pPr algn="ctr"/>
                      <a:r>
                        <a:rPr lang="en-US" sz="1600" b="0">
                          <a:solidFill>
                            <a:schemeClr val="tx1"/>
                          </a:solidFill>
                        </a:rPr>
                        <a:t>5.6</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solidFill>
                      <a:sysClr val="window" lastClr="FFFFFF"/>
                    </a:solidFill>
                  </a:tcPr>
                </a:tc>
                <a:tc>
                  <a:txBody>
                    <a:bodyPr/>
                    <a:lstStyle>
                      <a:lvl1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1pPr>
                      <a:lvl2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2pPr>
                      <a:lvl3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3pPr>
                      <a:lvl4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4pPr>
                      <a:lvl5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5pPr>
                      <a:lvl6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6pPr>
                      <a:lvl7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7pPr>
                      <a:lvl8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8pPr>
                      <a:lvl9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9pPr>
                    </a:lstStyle>
                    <a:p>
                      <a:endParaRPr lang="en-US" sz="1200"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ap="flat" cmpd="sng" algn="ctr">
                      <a:solidFill>
                        <a:sysClr val="windowText" lastClr="000000"/>
                      </a:solidFill>
                      <a:prstDash val="solid"/>
                      <a:round/>
                      <a:headEnd type="none" w="med" len="med"/>
                      <a:tailEnd type="none" w="med" len="med"/>
                    </a:lnBlToTr>
                    <a:solidFill>
                      <a:sysClr val="window" lastClr="FFFFFF"/>
                    </a:solidFill>
                  </a:tcPr>
                </a:tc>
                <a:tc rowSpan="2">
                  <a:txBody>
                    <a:bodyPr/>
                    <a:lstStyle>
                      <a:lvl1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1pPr>
                      <a:lvl2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2pPr>
                      <a:lvl3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3pPr>
                      <a:lvl4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4pPr>
                      <a:lvl5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5pPr>
                      <a:lvl6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6pPr>
                      <a:lvl7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7pPr>
                      <a:lvl8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8pPr>
                      <a:lvl9pPr marR="0" algn="l" rtl="0">
                        <a:lnSpc>
                          <a:spcPct val="100000"/>
                        </a:lnSpc>
                        <a:spcBef>
                          <a:spcPts val="0"/>
                        </a:spcBef>
                        <a:spcAft>
                          <a:spcPts val="0"/>
                        </a:spcAft>
                        <a:buClr>
                          <a:srgbClr val="000000"/>
                        </a:buClr>
                        <a:buFont typeface="Arial"/>
                        <a:defRPr sz="1400" b="1" i="0" u="none" strike="noStrike" cap="none">
                          <a:solidFill>
                            <a:schemeClr val="lt1"/>
                          </a:solidFill>
                          <a:latin typeface="Georgia"/>
                          <a:sym typeface="Arial"/>
                        </a:defRPr>
                      </a:lvl9pPr>
                    </a:lstStyle>
                    <a:p>
                      <a:endParaRPr lang="en-US" sz="1200" b="0">
                        <a:solidFill>
                          <a:schemeClr val="tx1"/>
                        </a:solidFill>
                      </a:endParaRPr>
                    </a:p>
                    <a:p>
                      <a:endParaRPr lang="en-US" sz="1200" b="0">
                        <a:solidFill>
                          <a:schemeClr val="tx1"/>
                        </a:solidFill>
                      </a:endParaRPr>
                    </a:p>
                    <a:p>
                      <a:r>
                        <a:rPr lang="en-US" sz="1600" b="0">
                          <a:solidFill>
                            <a:schemeClr val="tx1"/>
                          </a:solidFill>
                        </a:rPr>
                        <a:t>46</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ap="flat" cmpd="sng" algn="ctr">
                      <a:noFill/>
                      <a:prstDash val="solid"/>
                      <a:round/>
                      <a:headEnd type="none" w="med" len="med"/>
                      <a:tailEnd type="none" w="med" len="med"/>
                    </a:lnBlToTr>
                    <a:solidFill>
                      <a:sysClr val="window" lastClr="FFFFFF"/>
                    </a:solidFill>
                  </a:tcPr>
                </a:tc>
                <a:extLst>
                  <a:ext uri="{0D108BD9-81ED-4DB2-BD59-A6C34878D82A}">
                    <a16:rowId xmlns:a16="http://schemas.microsoft.com/office/drawing/2014/main" val="727745014"/>
                  </a:ext>
                </a:extLst>
              </a:tr>
              <a:tr h="647342">
                <a:tc vMerge="1">
                  <a:txBody>
                    <a:bodyPr/>
                    <a:lstStyle/>
                    <a:p>
                      <a:endParaRPr lang="en-US"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ap="flat" cmpd="sng" algn="ctr">
                      <a:noFill/>
                      <a:prstDash val="solid"/>
                      <a:round/>
                      <a:headEnd type="none" w="med" len="med"/>
                      <a:tailEnd type="none" w="med" len="med"/>
                    </a:lnBlToTr>
                    <a:solidFill>
                      <a:schemeClr val="bg1"/>
                    </a:solidFill>
                  </a:tcPr>
                </a:tc>
                <a:tc>
                  <a:txBody>
                    <a:bodyPr/>
                    <a:lstStyle>
                      <a:lvl1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1pPr>
                      <a:lvl2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2pPr>
                      <a:lvl3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3pPr>
                      <a:lvl4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4pPr>
                      <a:lvl5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5pPr>
                      <a:lvl6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6pPr>
                      <a:lvl7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7pPr>
                      <a:lvl8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8pPr>
                      <a:lvl9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9pPr>
                    </a:lstStyle>
                    <a:p>
                      <a:endParaRPr lang="en-US" sz="1200"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ap="flat" cmpd="sng" algn="ctr">
                      <a:solidFill>
                        <a:sysClr val="windowText" lastClr="000000"/>
                      </a:solidFill>
                      <a:prstDash val="solid"/>
                      <a:round/>
                      <a:headEnd type="none" w="med" len="med"/>
                      <a:tailEnd type="none" w="med" len="med"/>
                    </a:lnBlToTr>
                    <a:solidFill>
                      <a:sysClr val="window" lastClr="FFFFFF"/>
                    </a:solidFill>
                  </a:tcPr>
                </a:tc>
                <a:tc>
                  <a:txBody>
                    <a:bodyPr/>
                    <a:lstStyle>
                      <a:lvl1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1pPr>
                      <a:lvl2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2pPr>
                      <a:lvl3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3pPr>
                      <a:lvl4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4pPr>
                      <a:lvl5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5pPr>
                      <a:lvl6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6pPr>
                      <a:lvl7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7pPr>
                      <a:lvl8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8pPr>
                      <a:lvl9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9pPr>
                    </a:lstStyle>
                    <a:p>
                      <a:endParaRPr lang="en-US" sz="1200"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ysClr val="windowText" lastClr="000000"/>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ysClr val="window" lastClr="FFFFFF"/>
                    </a:solidFill>
                  </a:tcPr>
                </a:tc>
                <a:tc>
                  <a:txBody>
                    <a:bodyPr/>
                    <a:lstStyle>
                      <a:lvl1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1pPr>
                      <a:lvl2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2pPr>
                      <a:lvl3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3pPr>
                      <a:lvl4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4pPr>
                      <a:lvl5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5pPr>
                      <a:lvl6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6pPr>
                      <a:lvl7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7pPr>
                      <a:lvl8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8pPr>
                      <a:lvl9pPr marR="0" algn="l" rtl="0">
                        <a:lnSpc>
                          <a:spcPct val="100000"/>
                        </a:lnSpc>
                        <a:spcBef>
                          <a:spcPts val="0"/>
                        </a:spcBef>
                        <a:spcAft>
                          <a:spcPts val="0"/>
                        </a:spcAft>
                        <a:buClr>
                          <a:srgbClr val="000000"/>
                        </a:buClr>
                        <a:buFont typeface="Arial"/>
                        <a:defRPr sz="1400" b="0" i="0" u="none" strike="noStrike" cap="none">
                          <a:solidFill>
                            <a:schemeClr val="dk1"/>
                          </a:solidFill>
                          <a:latin typeface="Georgia"/>
                          <a:sym typeface="Arial"/>
                        </a:defRPr>
                      </a:lvl9pPr>
                    </a:lstStyle>
                    <a:p>
                      <a:endParaRPr lang="en-US" sz="1200" b="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ap="flat" cmpd="sng" algn="ctr">
                      <a:solidFill>
                        <a:sysClr val="windowText" lastClr="000000"/>
                      </a:solidFill>
                      <a:prstDash val="solid"/>
                      <a:round/>
                      <a:headEnd type="none" w="med" len="med"/>
                      <a:tailEnd type="none" w="med" len="med"/>
                    </a:lnTlToBr>
                    <a:lnBlToTr w="12700" cap="flat" cmpd="sng" algn="ctr">
                      <a:noFill/>
                      <a:prstDash val="solid"/>
                      <a:round/>
                      <a:headEnd type="none" w="med" len="med"/>
                      <a:tailEnd type="none" w="med" len="med"/>
                    </a:lnBlToTr>
                    <a:solidFill>
                      <a:sysClr val="window" lastClr="FFFFFF"/>
                    </a:solidFill>
                  </a:tcPr>
                </a:tc>
                <a:tc vMerge="1">
                  <a:txBody>
                    <a:bodyPr/>
                    <a:lstStyle/>
                    <a:p>
                      <a:endParaRPr lang="en-US"/>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ap="flat" cmpd="sng" algn="ctr">
                      <a:noFill/>
                      <a:prstDash val="solid"/>
                      <a:round/>
                      <a:headEnd type="none" w="med" len="med"/>
                      <a:tailEnd type="none" w="med" len="med"/>
                    </a:lnTlToBr>
                    <a:lnBlToTr w="12700" cap="flat" cmpd="sng" algn="ctr">
                      <a:noFill/>
                      <a:prstDash val="solid"/>
                      <a:round/>
                      <a:headEnd type="none" w="med" len="med"/>
                      <a:tailEnd type="none" w="med" len="med"/>
                    </a:lnBlToTr>
                    <a:solidFill>
                      <a:schemeClr val="bg1"/>
                    </a:solidFill>
                  </a:tcPr>
                </a:tc>
                <a:extLst>
                  <a:ext uri="{0D108BD9-81ED-4DB2-BD59-A6C34878D82A}">
                    <a16:rowId xmlns:a16="http://schemas.microsoft.com/office/drawing/2014/main" val="2515014331"/>
                  </a:ext>
                </a:extLst>
              </a:tr>
            </a:tbl>
          </a:graphicData>
        </a:graphic>
      </p:graphicFrame>
      <p:sp>
        <p:nvSpPr>
          <p:cNvPr id="7" name="TextBox 6">
            <a:extLst>
              <a:ext uri="{FF2B5EF4-FFF2-40B4-BE49-F238E27FC236}">
                <a16:creationId xmlns:a16="http://schemas.microsoft.com/office/drawing/2014/main" id="{1E6B0CCF-2B34-4CF0-BB42-8E4B5580D2EB}"/>
              </a:ext>
            </a:extLst>
          </p:cNvPr>
          <p:cNvSpPr txBox="1"/>
          <p:nvPr/>
        </p:nvSpPr>
        <p:spPr>
          <a:xfrm>
            <a:off x="4572000" y="2013840"/>
            <a:ext cx="3516406" cy="1169551"/>
          </a:xfrm>
          <a:prstGeom prst="rect">
            <a:avLst/>
          </a:prstGeom>
          <a:solidFill>
            <a:schemeClr val="bg1"/>
          </a:solidFill>
        </p:spPr>
        <p:txBody>
          <a:bodyPr wrap="square" rtlCol="0">
            <a:spAutoFit/>
          </a:bodyPr>
          <a:lstStyle/>
          <a:p>
            <a:r>
              <a:rPr lang="en-US"/>
              <a:t>This is a CBC from a 5-year-old male who presents with easy bruising. In this patient with pancytopenia, what are three ways to differentiate between acute leukemia and aplastic anemia?</a:t>
            </a: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A12AEE-AD0A-4E78-AE12-B96F9C97CE29}"/>
              </a:ext>
            </a:extLst>
          </p:cNvPr>
          <p:cNvSpPr>
            <a:spLocks noGrp="1"/>
          </p:cNvSpPr>
          <p:nvPr>
            <p:ph type="title"/>
          </p:nvPr>
        </p:nvSpPr>
        <p:spPr>
          <a:xfrm>
            <a:off x="1032075" y="800071"/>
            <a:ext cx="7081800" cy="3188100"/>
          </a:xfrm>
        </p:spPr>
        <p:txBody>
          <a:bodyPr/>
          <a:lstStyle/>
          <a:p>
            <a:r>
              <a:rPr lang="en-US"/>
              <a:t>Findings to suggest Acute Leukemia in this patient include:</a:t>
            </a:r>
            <a:br>
              <a:rPr lang="en-US"/>
            </a:br>
            <a:r>
              <a:rPr lang="en-US" sz="1800"/>
              <a:t>Signs of tumor lysis (hyperkalemia, hyperphosphatemia, hypocalcemia, increased LDH, increased uric acid, </a:t>
            </a:r>
            <a:r>
              <a:rPr lang="en-US" sz="1800" err="1"/>
              <a:t>etc</a:t>
            </a:r>
            <a:r>
              <a:rPr lang="en-US" sz="1800"/>
              <a:t>)</a:t>
            </a:r>
            <a:br>
              <a:rPr lang="en-US" sz="1800"/>
            </a:br>
            <a:r>
              <a:rPr lang="en-US" sz="1800"/>
              <a:t>Bulky lymphadenopathy</a:t>
            </a:r>
            <a:br>
              <a:rPr lang="en-US" sz="1800"/>
            </a:br>
            <a:r>
              <a:rPr lang="en-US" sz="1800"/>
              <a:t>Signs of vascular compression (e.g. SVC syndrome)</a:t>
            </a:r>
            <a:br>
              <a:rPr lang="en-US" sz="1800"/>
            </a:br>
            <a:r>
              <a:rPr lang="en-US" sz="1800"/>
              <a:t>Mediastinal mass on CXR (more common with lymphoma)</a:t>
            </a:r>
            <a:br>
              <a:rPr lang="en-US" sz="1800"/>
            </a:br>
            <a:r>
              <a:rPr lang="en-US" sz="1800"/>
              <a:t>Presence of blasts on peripheral smear</a:t>
            </a:r>
            <a:endParaRPr lang="en-US"/>
          </a:p>
        </p:txBody>
      </p:sp>
    </p:spTree>
    <p:extLst>
      <p:ext uri="{BB962C8B-B14F-4D97-AF65-F5344CB8AC3E}">
        <p14:creationId xmlns:p14="http://schemas.microsoft.com/office/powerpoint/2010/main" val="1207434534"/>
      </p:ext>
    </p:extLst>
  </p:cSld>
  <p:clrMapOvr>
    <a:masterClrMapping/>
  </p:clrMapOvr>
</p:sld>
</file>

<file path=ppt/theme/theme1.xml><?xml version="1.0" encoding="utf-8"?>
<a:theme xmlns:a="http://schemas.openxmlformats.org/drawingml/2006/main" name="Jeoparty template">
  <a:themeElements>
    <a:clrScheme name="Custom 347">
      <a:dk1>
        <a:srgbClr val="000619"/>
      </a:dk1>
      <a:lt1>
        <a:srgbClr val="FFFFFF"/>
      </a:lt1>
      <a:dk2>
        <a:srgbClr val="E3E8FB"/>
      </a:dk2>
      <a:lt2>
        <a:srgbClr val="929FBE"/>
      </a:lt2>
      <a:accent1>
        <a:srgbClr val="080687"/>
      </a:accent1>
      <a:accent2>
        <a:srgbClr val="271BC3"/>
      </a:accent2>
      <a:accent3>
        <a:srgbClr val="026BD6"/>
      </a:accent3>
      <a:accent4>
        <a:srgbClr val="9B0EAA"/>
      </a:accent4>
      <a:accent5>
        <a:srgbClr val="EC0370"/>
      </a:accent5>
      <a:accent6>
        <a:srgbClr val="FCA11D"/>
      </a:accent6>
      <a:hlink>
        <a:srgbClr val="FFFFFF"/>
      </a:hlink>
      <a:folHlink>
        <a:srgbClr val="6611CC"/>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Jeoparty template">
  <a:themeElements>
    <a:clrScheme name="Custom 347">
      <a:dk1>
        <a:srgbClr val="000619"/>
      </a:dk1>
      <a:lt1>
        <a:srgbClr val="FFFFFF"/>
      </a:lt1>
      <a:dk2>
        <a:srgbClr val="E3E8FB"/>
      </a:dk2>
      <a:lt2>
        <a:srgbClr val="929FBE"/>
      </a:lt2>
      <a:accent1>
        <a:srgbClr val="080687"/>
      </a:accent1>
      <a:accent2>
        <a:srgbClr val="271BC3"/>
      </a:accent2>
      <a:accent3>
        <a:srgbClr val="026BD6"/>
      </a:accent3>
      <a:accent4>
        <a:srgbClr val="9B0EAA"/>
      </a:accent4>
      <a:accent5>
        <a:srgbClr val="EC0370"/>
      </a:accent5>
      <a:accent6>
        <a:srgbClr val="FCA11D"/>
      </a:accent6>
      <a:hlink>
        <a:srgbClr val="FFFFFF"/>
      </a:hlink>
      <a:folHlink>
        <a:srgbClr val="6611CC"/>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3273</Words>
  <Application>Microsoft Office PowerPoint</Application>
  <PresentationFormat>On-screen Show (16:9)</PresentationFormat>
  <Paragraphs>560</Paragraphs>
  <Slides>69</Slides>
  <Notes>46</Notes>
  <HiddenSlides>0</HiddenSlides>
  <MMClips>0</MMClips>
  <ScaleCrop>false</ScaleCrop>
  <HeadingPairs>
    <vt:vector size="4" baseType="variant">
      <vt:variant>
        <vt:lpstr>Theme</vt:lpstr>
      </vt:variant>
      <vt:variant>
        <vt:i4>2</vt:i4>
      </vt:variant>
      <vt:variant>
        <vt:lpstr>Slide Titles</vt:lpstr>
      </vt:variant>
      <vt:variant>
        <vt:i4>69</vt:i4>
      </vt:variant>
    </vt:vector>
  </HeadingPairs>
  <TitlesOfParts>
    <vt:vector size="71" baseType="lpstr">
      <vt:lpstr>Jeoparty template</vt:lpstr>
      <vt:lpstr>Jeoparty template</vt:lpstr>
      <vt:lpstr> Clinical Reasoning Review Game</vt:lpstr>
      <vt:lpstr>Let's Recap!</vt:lpstr>
      <vt:lpstr>PowerPoint Presentation</vt:lpstr>
      <vt:lpstr> </vt:lpstr>
      <vt:lpstr>Mentzer Index  MCV / RBC #   &gt;13 Suggests Iron-deficiency anemia  &lt;13 Suggests Thalassemia</vt:lpstr>
      <vt:lpstr>PowerPoint Presentation</vt:lpstr>
      <vt:lpstr>Answer: Wiskott-Aldritch Syndrome vs. Immune Thrombocytopenia  Differentiating factor: Mean Platelet Volume! WAS is a microthrombocytopenia ITP is a macrothrombocytopenia</vt:lpstr>
      <vt:lpstr>PowerPoint Presentation</vt:lpstr>
      <vt:lpstr>Findings to suggest Acute Leukemia in this patient include: Signs of tumor lysis (hyperkalemia, hyperphosphatemia, hypocalcemia, increased LDH, increased uric acid, etc) Bulky lymphadenopathy Signs of vascular compression (e.g. SVC syndrome) Mediastinal mass on CXR (more common with lymphoma) Presence of blasts on peripheral smear</vt:lpstr>
      <vt:lpstr>PowerPoint Presentation</vt:lpstr>
      <vt:lpstr>PowerPoint Presentation</vt:lpstr>
      <vt:lpstr>PowerPoint Presentation</vt:lpstr>
      <vt:lpstr>PowerPoint Presentation</vt:lpstr>
      <vt:lpstr>This is the ABG of a 2-year-old male who presents with moderate dehydration after 4 days of diarrhea and poor PO with other sick contacts at home</vt:lpstr>
      <vt:lpstr>PowerPoint Presentation</vt:lpstr>
      <vt:lpstr>PowerPoint Presentation</vt:lpstr>
      <vt:lpstr>(Na++K+)-(HCO3-+Cl-) (135+4.5)-(22+105) = 12</vt:lpstr>
      <vt:lpstr>8-12 (without K+) 12-16 (with K+ included)</vt:lpstr>
      <vt:lpstr> </vt:lpstr>
      <vt:lpstr>This is the ABG of a 2-week-old, first-born male presenting with projectile vomiting after every feed</vt:lpstr>
      <vt:lpstr>PowerPoint Presentation</vt:lpstr>
      <vt:lpstr>PowerPoint Presentation</vt:lpstr>
      <vt:lpstr>Electrolyte abnormalities – loss of hydrogen and chloride ions from vomiting gastric contents</vt:lpstr>
      <vt:lpstr>ABG for a patient with history of poorly controlled diabetes and new-onset DKA</vt:lpstr>
      <vt:lpstr>PowerPoint Presentation</vt:lpstr>
      <vt:lpstr>PowerPoint Presentation</vt:lpstr>
      <vt:lpstr>Is this patient adequately compensating? </vt:lpstr>
      <vt:lpstr>Expected CO2 = (Bicarb x 1.5) + 8 +/- 2 =(12x1.5)+8 +/-2 = 24-28</vt:lpstr>
      <vt:lpstr>This is the ABG of a 12-year-old boy with poorly-controlled asthma presenting with an asthma exacerbation in the setting of viral illness</vt:lpstr>
      <vt:lpstr>PowerPoint Presentation</vt:lpstr>
      <vt:lpstr>PowerPoint Presentation</vt:lpstr>
      <vt:lpstr>PowerPoint Presentation</vt:lpstr>
      <vt:lpstr>This is the ABG of a 14-year-old female presenting with tachypnea and tachycardia with reported tinnitus and vertigo after an unknown ingestion</vt:lpstr>
      <vt:lpstr>PowerPoint Presentation</vt:lpstr>
      <vt:lpstr>PowerPoint Presentation</vt:lpstr>
      <vt:lpstr>(Na++K+)-(HCO3-+Cl-) (140+4.2)-(14+110) = 20.2</vt:lpstr>
      <vt:lpstr>M: Methanol U: Uremia D: DKA P: Paracetamol/Propylene glycol I: Iron/Isoniazid L: Lactic acidosis E: Ethylene glycol S: Salicylates</vt:lpstr>
      <vt:lpstr>1. Identify the cause of the abnormality seen here.  2. Provide a differential including 4+ diagnoses in which you may see this. </vt:lpstr>
      <vt:lpstr>Answer: 1) Hyperkalemia peaked T waves 2) Renal failure, DKA, Adrenal Insufficiency, Congenital Adrenal Hyperplasia, Rhabdomyolysis 3) Bonus Question – What is the first treatment medication to administer?</vt:lpstr>
      <vt:lpstr>A 17-year-old girl presents with chest pain. Please take a moment to build a mini illness script of factors consistent with “non-cardiac” chest pain etiologies vs cardiac.  </vt:lpstr>
      <vt:lpstr>Example features of non-cardiac causes of chest pain – non-exertional, reproducible on exam (tenderness to palpation), pleuritic  Features of cardiac chest pain – “crushing” substernal, radiating to left arm, exertional, resolves with rest</vt:lpstr>
      <vt:lpstr>(What were some descriptors on your non cardiac list?)  Here are some examples:</vt:lpstr>
      <vt:lpstr>She has a recent diagnosis of Systemic Lupus Erythematosus in the last 6 months. Her EKG is shown: what is the dx?</vt:lpstr>
      <vt:lpstr>Pericarditis. </vt:lpstr>
      <vt:lpstr>ST elevation in V2-V6, II/III/aVL, PR depression in these leads as well ; reciprocal changes in AVR – consistent with pericarditis</vt:lpstr>
      <vt:lpstr>You are on cardiology consults and are asked to see a previously healthy baby admitted for spell rule out after their EKG showed this.   What is the diagnosis? What is the most likely underlying pathophysiology for this patient? </vt:lpstr>
      <vt:lpstr>PowerPoint Presentation</vt:lpstr>
      <vt:lpstr>Third degree heart block: complete dissociation between atria and ventricular contraction, i.e. able to “march out” P waves and QRS as separate entities</vt:lpstr>
      <vt:lpstr>Congenital heart block, likely due to neonatal lupus (mAb SS-A and SS-B crossing the placenta). Other causes include myocarditis, Lyme Disease (carditis), post operative/ablation (acute or chronic)</vt:lpstr>
      <vt:lpstr>A 5-year-old patient with history of secundum type atrial septal defect s/p surgical patch closure 4 weeks ago who presents to the emergency department after a week of progressive exercise intolerance, fatigue, fussiness, and fevers. Examination is notable for an ill appearing child with vital signs notable for a fever to 39.3C, HR 160, BP 82/40, RR 50. On exam, the patient’s cardiac examination is notable for muffled heart sounds. Exam is also notable for hepatomegaly and poor perfusion. You are concerned about how this child looks and have called the cardiology team for a STAT ECHO and gave additional temporizing recommendations for you to start before they get down there.  What is the mechanism of action of their temporizing measure? </vt:lpstr>
      <vt:lpstr>Rapid infusion of saline bolus to increase preload and prevent chamber collapse. </vt:lpstr>
      <vt:lpstr>Normally, the pericardial sac is filled with a very small amount of fluid.  In tamponade physiology, excess fluid builds up in the pericardial sac and compresses the heart, reducing cardiac output. If tamponade physiology, drainage is ultimate treatment.</vt:lpstr>
      <vt:lpstr>You are admitting a 4-week-old male with presumed bronchiolitis after episodes of cyanosis at home. After further discussion with the parents, you learn that this baby has had multiple episodes of cyanosis since birth. The baby looks well on your initial exam aside from some mild tachypnea and crackles and a systolic murmur (HR 140s and hard to further characterize), so you place on continuous pulse ox before leaving the room. You are called to the bedside due to the baby having a pulse ox reading of 78% and appearing cyanotic. You go to the room and the baby is alert but extremely fussy and with true cyanosis and an SpO2 of 78% with good waveform.  You have difficulty appreciating a murmur.   What does this baby have and what is the mechanism of action of your next steps?</vt:lpstr>
      <vt:lpstr>Tetralogy of Fallot with “Tet Spell”: treatment aimed at decreasing pulmonary vascular resistance (PVR) and increasing systemic vascular resistance (SVR)</vt:lpstr>
      <vt:lpstr>Hallmark of 4 abnormalities—all a reflection of anterior malalignment of the septum, resulting in malaligned VSD (1) with overriding aorta (2) which causes right ventricular outflow tract obstruction (3). This obstruction results in right ventricular hypertrophy (4).</vt:lpstr>
      <vt:lpstr>Tet spell pathophysiology: Not perfectly understood but PVR&gt;&gt;SVR, and with pre-existing right ventricular outflow tract obstruction, decreased flow to the lungs, causing cyanosis. These are often exacerbated by fussiness, crying or defecating (all of these can transiently decrease arterial O2 saturation.)  </vt:lpstr>
      <vt:lpstr> *Positioning: knee chest (if not further aggravating patient) increases SVR *Supplemental O2 (increase in arterial O2 will increase SVR and decrease PVR)  *Bolus: increase preload and decrease degree of RVOT *Morphine: mechanism not fully understood *Meds: B-blockers (improve RVOT), phenylephrine- increases SVR   </vt:lpstr>
      <vt:lpstr>Name three drugs that may cause tachycardia (in either therapeutic or supratherapeutic doses)</vt:lpstr>
      <vt:lpstr>Anticholinergic Toxicity (e.g. diphenhydramine intoxication) TCAs, MAOIs, or SSRIs (Serotonin Syndrome) Amphetamines</vt:lpstr>
      <vt:lpstr>Name 3 Cardiac etiologies for pathologic tachycardia and how you diagnose them  </vt:lpstr>
      <vt:lpstr> Arrhythmia – example of SVT (lack of P-waves, may resolve with vagal maneuvers) Myocarditis – may see EKG changes or signs of volume overload (pulmonary crackles, hepatomegaly) Cardiac Tamponade – Beck’s Triad (distant heart sounds, pulsus paradoxus, hypotension)</vt:lpstr>
      <vt:lpstr>Name 3 metabolic causes of tachycardia that may be diagnosed via BMP</vt:lpstr>
      <vt:lpstr>Hypoglycemia – this is an issue of substrate deficiency. Hyperkalemia Hypocalcemia (may precipitate arrhythmia)</vt:lpstr>
      <vt:lpstr>Name the diagnosis: A 17-year-old female w/ a PMH of PCOS presents with tachycardia following a flight home from college</vt:lpstr>
      <vt:lpstr>Answer – Pulmonary Embolism PE may present with isolated tachycardia or with symptoms including dyspnea, chest pain, hypoxemia, or hypotension. This patient had risk factors including immobilization and oral contraceptive use (for her PCOS). PE is a no-miss diagnosis.  Your illness script for PE should be activated any patient with unexplained, isolated tachycardia!</vt:lpstr>
      <vt:lpstr>Pathophysiology: Why is tachycardia often the first sign of shock?</vt:lpstr>
      <vt:lpstr>The definition of shock is inadequate cardiac output to meet metabolic demands. It can be due to decreased volume, increased metabolic demands, or inadequate cardiac output (CO) due to cardiac etiologies – in all of these cases, tachycardia occurs to attempt to increase CO and meet these metabolic demands! </vt:lpstr>
      <vt:lpstr>PowerPoint Presentation</vt:lpstr>
      <vt:lpstr>StatPearls [Internet]. Treasure Island (FL): StatPearls Publishing; 2023 Jan-. Available from: https://www.ncbi.nlm.nih.gov/books/NBK430685/ Zitelli BJ McIntire SC Nowalk AJ. Zitelli and Davis' Atlas of Pediatric Physical Diagnosis. Sixth ed. Philadelphia PA: Saunders/Elsevier; 2012. http://www.clinicalkey.com/dura/browse/bookChapter/3-s2.0-C20090425819. Accessed August 29 2023.</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his is Your Presentation Title</dc:title>
  <dc:creator>Bowen, James</dc:creator>
  <cp:lastModifiedBy>Bowen, Jimmy (He/Him/His)</cp:lastModifiedBy>
  <cp:revision>208</cp:revision>
  <dcterms:modified xsi:type="dcterms:W3CDTF">2024-03-08T14:37:32Z</dcterms:modified>
</cp:coreProperties>
</file>